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2"/>
    <p:sldId id="258" r:id="rId3"/>
  </p:sldIdLst>
  <p:sldSz cx="12192000" cy="6858000"/>
  <p:notesSz cx="7772400" cy="100584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95"/>
    <p:restoredTop sz="94648"/>
  </p:normalViewPr>
  <p:slideViewPr>
    <p:cSldViewPr snapToGrid="0">
      <p:cViewPr varScale="1">
        <p:scale>
          <a:sx n="98" d="100"/>
          <a:sy n="98" d="100"/>
        </p:scale>
        <p:origin x="864" y="4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DF62AAB5-030A-441B-834E-08500F7512BB}" type="slidenum">
              <a:t>‹#›</a:t>
            </a:fld>
            <a:endParaRPr/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560"/>
            <a:ext cx="1051524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24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81B8474C-0C3B-4981-8621-6C302A0E55F0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08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200" y="4098240"/>
            <a:ext cx="513108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52012F86-0F5A-41AD-ABB1-C2D25F1CE085}" type="slidenum">
              <a:t>‹#›</a:t>
            </a:fld>
            <a:endParaRPr/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560"/>
            <a:ext cx="338580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560"/>
            <a:ext cx="338580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560"/>
            <a:ext cx="338580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CF8EC37B-36C7-43B7-8E70-361B7901866B}" type="slidenum">
              <a:t>‹#›</a:t>
            </a:fld>
            <a:endParaRPr/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560"/>
            <a:ext cx="10515240" cy="4350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3200" b="0" strike="noStrike" spc="-1"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2" name="PlaceHolder 4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9B8E6A78-8574-462B-8E2A-8070C7587B20}" type="slidenum">
              <a:t>‹#›</a:t>
            </a:fld>
            <a:endParaRPr/>
          </a:p>
        </p:txBody>
      </p:sp>
      <p:sp>
        <p:nvSpPr>
          <p:cNvPr id="3" name="PlaceHolder 5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560"/>
            <a:ext cx="10515240" cy="4350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1CDDF4AE-DCC4-48ED-B629-4A7097F88271}" type="slidenum">
              <a:t>‹#›</a:t>
            </a:fld>
            <a:endParaRPr/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560"/>
            <a:ext cx="5131080" cy="4350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200" y="1825560"/>
            <a:ext cx="5131080" cy="4350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32BE73BE-1F58-49B8-87F6-8BCCC5D29767}" type="slidenum">
              <a:t>‹#›</a:t>
            </a:fld>
            <a:endParaRPr/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CE998303-5753-4492-9E43-7715ADC558B6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240" cy="614412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32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4D84AD88-C7B0-4EAC-93DB-C89EB1BDB852}" type="slidenum">
              <a:t>‹#›</a:t>
            </a:fld>
            <a:endParaRPr/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200" y="1825560"/>
            <a:ext cx="5131080" cy="4350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08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79CDCF06-9D65-4AAD-9AE5-631C23672E43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560"/>
            <a:ext cx="5131080" cy="43509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200" y="4098240"/>
            <a:ext cx="513108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37580F95-1485-461C-B2A5-A2E0EB7AC9BB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240" cy="2075040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t">
            <a:normAutofit/>
          </a:bodyPr>
          <a:lstStyle/>
          <a:p>
            <a:pPr>
              <a:lnSpc>
                <a:spcPct val="90000"/>
              </a:lnSpc>
              <a:spcBef>
                <a:spcPts val="1417"/>
              </a:spcBef>
              <a:buNone/>
            </a:pPr>
            <a:endParaRPr lang="en-US" sz="28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lstStyle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lstStyle/>
          <a:p>
            <a:fld id="{80BBE5B1-7697-434E-B333-B207D4163FC1}" type="slidenum">
              <a:t>‹#›</a:t>
            </a:fld>
            <a:endParaRPr/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/>
          <a:p>
            <a:pPr>
              <a:lnSpc>
                <a:spcPct val="90000"/>
              </a:lnSpc>
              <a:buNone/>
            </a:pPr>
            <a:r>
              <a:rPr lang="en-US" sz="4400" b="0" strike="noStrike" spc="-1">
                <a:solidFill>
                  <a:srgbClr val="000000"/>
                </a:solidFill>
                <a:latin typeface="Aptos Display"/>
              </a:rPr>
              <a:t>Click to edit Master title style</a:t>
            </a:r>
            <a:endParaRPr lang="en-US" sz="4400" b="0" strike="noStrike" spc="-1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10515240" cy="43509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/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</a:pPr>
            <a:r>
              <a:rPr lang="en-US" sz="2800" b="0" strike="noStrike" spc="-1">
                <a:solidFill>
                  <a:srgbClr val="000000"/>
                </a:solidFill>
                <a:latin typeface="Aptos"/>
              </a:rPr>
              <a:t>Click to edit Master text styles</a:t>
            </a:r>
          </a:p>
          <a:p>
            <a:pPr marL="685800" lvl="1" indent="-228600">
              <a:lnSpc>
                <a:spcPct val="9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</a:pPr>
            <a:r>
              <a:rPr lang="en-US" sz="2400" b="0" strike="noStrike" spc="-1">
                <a:solidFill>
                  <a:srgbClr val="000000"/>
                </a:solidFill>
                <a:latin typeface="Aptos"/>
              </a:rPr>
              <a:t>Second level</a:t>
            </a:r>
          </a:p>
          <a:p>
            <a:pPr marL="1143000" lvl="2" indent="-228600">
              <a:lnSpc>
                <a:spcPct val="9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</a:pPr>
            <a:r>
              <a:rPr lang="en-US" sz="2000" b="0" strike="noStrike" spc="-1">
                <a:solidFill>
                  <a:srgbClr val="000000"/>
                </a:solidFill>
                <a:latin typeface="Aptos"/>
              </a:rPr>
              <a:t>Third level</a:t>
            </a:r>
          </a:p>
          <a:p>
            <a:pPr marL="1600200" lvl="3" indent="-228600">
              <a:lnSpc>
                <a:spcPct val="9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</a:pPr>
            <a:r>
              <a:rPr lang="en-US" sz="1800" b="0" strike="noStrike" spc="-1">
                <a:solidFill>
                  <a:srgbClr val="000000"/>
                </a:solidFill>
                <a:latin typeface="Aptos"/>
              </a:rPr>
              <a:t>Fourth level</a:t>
            </a:r>
          </a:p>
          <a:p>
            <a:pPr marL="2057400" lvl="4" indent="-228600">
              <a:lnSpc>
                <a:spcPct val="9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</a:pPr>
            <a:r>
              <a:rPr lang="en-US" sz="1800" b="0" strike="noStrike" spc="-1">
                <a:solidFill>
                  <a:srgbClr val="000000"/>
                </a:solidFill>
                <a:latin typeface="Aptos"/>
              </a:rPr>
              <a:t>Fifth level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2840" cy="3646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>
              <a:lnSpc>
                <a:spcPct val="100000"/>
              </a:lnSpc>
              <a:buNone/>
              <a:defRPr lang="en-US" sz="1200" b="0" strike="noStrike" spc="-1">
                <a:solidFill>
                  <a:srgbClr val="787878"/>
                </a:solidFill>
                <a:latin typeface="Aptos"/>
              </a:defRPr>
            </a:lvl1pPr>
          </a:lstStyle>
          <a:p>
            <a:pPr>
              <a:lnSpc>
                <a:spcPct val="100000"/>
              </a:lnSpc>
              <a:buNone/>
            </a:pPr>
            <a:r>
              <a:rPr lang="en-US" sz="1200" b="0" strike="noStrike" spc="-1">
                <a:solidFill>
                  <a:srgbClr val="787878"/>
                </a:solidFill>
                <a:latin typeface="Aptos"/>
              </a:rPr>
              <a:t>&lt;date/time&gt;</a:t>
            </a:r>
            <a:endParaRPr lang="en-US" sz="12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440" cy="3646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ctr">
              <a:buNone/>
              <a:defRPr lang="en-US" sz="1400" b="0" strike="noStrike" spc="-1">
                <a:latin typeface="Times New Roman"/>
              </a:defRPr>
            </a:lvl1pPr>
          </a:lstStyle>
          <a:p>
            <a:pPr algn="ctr">
              <a:buNone/>
            </a:pPr>
            <a:r>
              <a:rPr lang="en-US" sz="1400" b="0" strike="noStrike" spc="-1">
                <a:latin typeface="Times New Roman"/>
              </a:rPr>
              <a:t>&lt;footer&gt;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2840" cy="3646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algn="r">
              <a:lnSpc>
                <a:spcPct val="100000"/>
              </a:lnSpc>
              <a:buNone/>
              <a:defRPr lang="en-US" sz="1200" b="0" strike="noStrike" spc="-1">
                <a:solidFill>
                  <a:srgbClr val="787878"/>
                </a:solidFill>
                <a:latin typeface="Aptos"/>
              </a:defRPr>
            </a:lvl1pPr>
          </a:lstStyle>
          <a:p>
            <a:pPr algn="r">
              <a:lnSpc>
                <a:spcPct val="100000"/>
              </a:lnSpc>
              <a:buNone/>
            </a:pPr>
            <a:fld id="{39127E18-37D8-43FC-8A1C-8CDC9C469ACD}" type="slidenum">
              <a:rPr lang="en-US" sz="1200" b="0" strike="noStrike" spc="-1">
                <a:solidFill>
                  <a:srgbClr val="787878"/>
                </a:solidFill>
                <a:latin typeface="Aptos"/>
              </a:rPr>
              <a:t>‹#›</a:t>
            </a:fld>
            <a:endParaRPr lang="en-US" sz="12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5"/>
          <p:cNvSpPr/>
          <p:nvPr/>
        </p:nvSpPr>
        <p:spPr>
          <a:xfrm>
            <a:off x="1278727" y="629540"/>
            <a:ext cx="696744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en-US" sz="1200" b="1" strike="noStrike" spc="-1" dirty="0">
                <a:solidFill>
                  <a:srgbClr val="000000"/>
                </a:solidFill>
                <a:latin typeface="Times New Roman"/>
                <a:ea typeface="굴림"/>
              </a:rPr>
              <a:t>FIGURE S1a </a:t>
            </a:r>
            <a:r>
              <a:rPr lang="en-US" sz="1200" b="0" strike="noStrike" spc="-1" dirty="0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endParaRPr lang="en-US" sz="1200" b="0" strike="noStrike" spc="-1" dirty="0">
              <a:latin typeface="Arial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4E594CA4-4B5B-6F8C-40CC-F4C60E5C07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8698" y="561310"/>
            <a:ext cx="7772400" cy="573538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그림 1"/>
          <p:cNvPicPr/>
          <p:nvPr/>
        </p:nvPicPr>
        <p:blipFill>
          <a:blip r:embed="rId2"/>
          <a:stretch/>
        </p:blipFill>
        <p:spPr>
          <a:xfrm>
            <a:off x="1465560" y="392760"/>
            <a:ext cx="2069640" cy="2057040"/>
          </a:xfrm>
          <a:prstGeom prst="rect">
            <a:avLst/>
          </a:prstGeom>
          <a:ln w="0">
            <a:noFill/>
          </a:ln>
        </p:spPr>
      </p:pic>
      <p:sp>
        <p:nvSpPr>
          <p:cNvPr id="47" name="직사각형 2"/>
          <p:cNvSpPr/>
          <p:nvPr/>
        </p:nvSpPr>
        <p:spPr>
          <a:xfrm>
            <a:off x="2318760" y="1251720"/>
            <a:ext cx="315360" cy="424080"/>
          </a:xfrm>
          <a:prstGeom prst="rect">
            <a:avLst/>
          </a:prstGeom>
          <a:noFill/>
          <a:ln w="6350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/>
          <a:lstStyle/>
          <a:p>
            <a:endParaRPr lang="ko-KR" altLang="en-US"/>
          </a:p>
        </p:txBody>
      </p:sp>
      <p:sp>
        <p:nvSpPr>
          <p:cNvPr id="48" name="직선 연결선[R] 6"/>
          <p:cNvSpPr/>
          <p:nvPr/>
        </p:nvSpPr>
        <p:spPr>
          <a:xfrm flipV="1">
            <a:off x="2644920" y="358560"/>
            <a:ext cx="1474920" cy="903960"/>
          </a:xfrm>
          <a:prstGeom prst="line">
            <a:avLst/>
          </a:prstGeom>
          <a:ln w="6350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/>
        </p:style>
        <p:txBody>
          <a:bodyPr/>
          <a:lstStyle/>
          <a:p>
            <a:endParaRPr lang="ko-KR" altLang="en-US"/>
          </a:p>
        </p:txBody>
      </p:sp>
      <p:sp>
        <p:nvSpPr>
          <p:cNvPr id="49" name="직선 연결선[R] 10"/>
          <p:cNvSpPr/>
          <p:nvPr/>
        </p:nvSpPr>
        <p:spPr>
          <a:xfrm>
            <a:off x="2634120" y="1676160"/>
            <a:ext cx="1485720" cy="4956480"/>
          </a:xfrm>
          <a:prstGeom prst="line">
            <a:avLst/>
          </a:prstGeom>
          <a:ln w="6350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/>
        </p:style>
        <p:txBody>
          <a:bodyPr/>
          <a:lstStyle/>
          <a:p>
            <a:endParaRPr lang="ko-KR" altLang="en-US"/>
          </a:p>
        </p:txBody>
      </p:sp>
      <p:grpSp>
        <p:nvGrpSpPr>
          <p:cNvPr id="50" name="그룹 3"/>
          <p:cNvGrpSpPr/>
          <p:nvPr/>
        </p:nvGrpSpPr>
        <p:grpSpPr>
          <a:xfrm>
            <a:off x="4102920" y="-633960"/>
            <a:ext cx="7176600" cy="7268760"/>
            <a:chOff x="4102920" y="-633960"/>
            <a:chExt cx="7176600" cy="7268760"/>
          </a:xfrm>
        </p:grpSpPr>
        <p:sp>
          <p:nvSpPr>
            <p:cNvPr id="51" name="직사각형 4"/>
            <p:cNvSpPr/>
            <p:nvPr/>
          </p:nvSpPr>
          <p:spPr>
            <a:xfrm>
              <a:off x="4102920" y="335520"/>
              <a:ext cx="7107480" cy="6299280"/>
            </a:xfrm>
            <a:prstGeom prst="rect">
              <a:avLst/>
            </a:prstGeom>
            <a:solidFill>
              <a:srgbClr val="DFF2FC"/>
            </a:solidFill>
            <a:ln w="6350"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52" name="자유형: 도형 292"/>
            <p:cNvSpPr/>
            <p:nvPr/>
          </p:nvSpPr>
          <p:spPr>
            <a:xfrm>
              <a:off x="10746000" y="1694520"/>
              <a:ext cx="98640" cy="44280"/>
            </a:xfrm>
            <a:custGeom>
              <a:avLst/>
              <a:gdLst/>
              <a:ahLst/>
              <a:cxnLst/>
              <a:rect l="l" t="t" r="r" b="b"/>
              <a:pathLst>
                <a:path w="78241" h="36377">
                  <a:moveTo>
                    <a:pt x="3949" y="36346"/>
                  </a:moveTo>
                  <a:cubicBezTo>
                    <a:pt x="3282" y="34397"/>
                    <a:pt x="2090" y="32321"/>
                    <a:pt x="161" y="29932"/>
                  </a:cubicBezTo>
                  <a:cubicBezTo>
                    <a:pt x="-295" y="26914"/>
                    <a:pt x="231" y="22826"/>
                    <a:pt x="1599" y="19997"/>
                  </a:cubicBezTo>
                  <a:cubicBezTo>
                    <a:pt x="4931" y="19179"/>
                    <a:pt x="7772" y="17198"/>
                    <a:pt x="10859" y="16349"/>
                  </a:cubicBezTo>
                  <a:cubicBezTo>
                    <a:pt x="11350" y="16192"/>
                    <a:pt x="13525" y="16507"/>
                    <a:pt x="14016" y="16349"/>
                  </a:cubicBezTo>
                  <a:cubicBezTo>
                    <a:pt x="20049" y="14526"/>
                    <a:pt x="25872" y="8552"/>
                    <a:pt x="32466" y="8238"/>
                  </a:cubicBezTo>
                  <a:cubicBezTo>
                    <a:pt x="35658" y="8080"/>
                    <a:pt x="41516" y="9464"/>
                    <a:pt x="44638" y="10312"/>
                  </a:cubicBezTo>
                  <a:cubicBezTo>
                    <a:pt x="49233" y="8269"/>
                    <a:pt x="52671" y="4810"/>
                    <a:pt x="57266" y="2735"/>
                  </a:cubicBezTo>
                  <a:cubicBezTo>
                    <a:pt x="61089" y="2672"/>
                    <a:pt x="65509" y="3364"/>
                    <a:pt x="69192" y="3018"/>
                  </a:cubicBezTo>
                  <a:cubicBezTo>
                    <a:pt x="72033" y="2735"/>
                    <a:pt x="75050" y="1446"/>
                    <a:pt x="78171" y="0"/>
                  </a:cubicBezTo>
                  <a:lnTo>
                    <a:pt x="78242" y="36377"/>
                  </a:lnTo>
                  <a:lnTo>
                    <a:pt x="3949" y="36346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53" name="자유형: 도형 294"/>
            <p:cNvSpPr/>
            <p:nvPr/>
          </p:nvSpPr>
          <p:spPr>
            <a:xfrm>
              <a:off x="6750720" y="-525240"/>
              <a:ext cx="1767240" cy="1397160"/>
            </a:xfrm>
            <a:custGeom>
              <a:avLst/>
              <a:gdLst/>
              <a:ahLst/>
              <a:cxnLst/>
              <a:rect l="l" t="t" r="r" b="b"/>
              <a:pathLst>
                <a:path w="1399361" h="1137473">
                  <a:moveTo>
                    <a:pt x="1399361" y="714525"/>
                  </a:moveTo>
                  <a:lnTo>
                    <a:pt x="1397958" y="712733"/>
                  </a:lnTo>
                  <a:cubicBezTo>
                    <a:pt x="1398765" y="709400"/>
                    <a:pt x="1396275" y="707796"/>
                    <a:pt x="1395047" y="705155"/>
                  </a:cubicBezTo>
                  <a:cubicBezTo>
                    <a:pt x="1393398" y="701634"/>
                    <a:pt x="1392837" y="694591"/>
                    <a:pt x="1393083" y="690787"/>
                  </a:cubicBezTo>
                  <a:cubicBezTo>
                    <a:pt x="1393328" y="687265"/>
                    <a:pt x="1393749" y="682989"/>
                    <a:pt x="1394556" y="679530"/>
                  </a:cubicBezTo>
                  <a:cubicBezTo>
                    <a:pt x="1395468" y="675600"/>
                    <a:pt x="1397678" y="671607"/>
                    <a:pt x="1397958" y="667520"/>
                  </a:cubicBezTo>
                  <a:cubicBezTo>
                    <a:pt x="1398555" y="658559"/>
                    <a:pt x="1387961" y="650919"/>
                    <a:pt x="1381683" y="645291"/>
                  </a:cubicBezTo>
                  <a:cubicBezTo>
                    <a:pt x="1376456" y="640606"/>
                    <a:pt x="1376491" y="639726"/>
                    <a:pt x="1370002" y="635890"/>
                  </a:cubicBezTo>
                  <a:cubicBezTo>
                    <a:pt x="1368571" y="635041"/>
                    <a:pt x="1366912" y="633658"/>
                    <a:pt x="1365389" y="632997"/>
                  </a:cubicBezTo>
                  <a:cubicBezTo>
                    <a:pt x="1361510" y="631331"/>
                    <a:pt x="1357669" y="630922"/>
                    <a:pt x="1353965" y="628564"/>
                  </a:cubicBezTo>
                  <a:cubicBezTo>
                    <a:pt x="1351215" y="626803"/>
                    <a:pt x="1349044" y="624194"/>
                    <a:pt x="1346430" y="622276"/>
                  </a:cubicBezTo>
                  <a:cubicBezTo>
                    <a:pt x="1344996" y="621238"/>
                    <a:pt x="1343217" y="620484"/>
                    <a:pt x="1341814" y="619415"/>
                  </a:cubicBezTo>
                  <a:cubicBezTo>
                    <a:pt x="1331463" y="611554"/>
                    <a:pt x="1335174" y="600487"/>
                    <a:pt x="1324557" y="592218"/>
                  </a:cubicBezTo>
                  <a:cubicBezTo>
                    <a:pt x="1319211" y="595959"/>
                    <a:pt x="1321817" y="602090"/>
                    <a:pt x="1316047" y="605801"/>
                  </a:cubicBezTo>
                  <a:cubicBezTo>
                    <a:pt x="1309165" y="610265"/>
                    <a:pt x="1299754" y="605612"/>
                    <a:pt x="1292226" y="606870"/>
                  </a:cubicBezTo>
                  <a:cubicBezTo>
                    <a:pt x="1291304" y="607027"/>
                    <a:pt x="1283766" y="610202"/>
                    <a:pt x="1282987" y="610768"/>
                  </a:cubicBezTo>
                  <a:cubicBezTo>
                    <a:pt x="1281766" y="611680"/>
                    <a:pt x="1280689" y="613378"/>
                    <a:pt x="1279585" y="614447"/>
                  </a:cubicBezTo>
                  <a:cubicBezTo>
                    <a:pt x="1275638" y="618251"/>
                    <a:pt x="1271173" y="621144"/>
                    <a:pt x="1265000" y="619918"/>
                  </a:cubicBezTo>
                  <a:lnTo>
                    <a:pt x="1260383" y="617308"/>
                  </a:lnTo>
                  <a:lnTo>
                    <a:pt x="1258686" y="613126"/>
                  </a:lnTo>
                  <a:lnTo>
                    <a:pt x="1262088" y="608945"/>
                  </a:lnTo>
                  <a:cubicBezTo>
                    <a:pt x="1261881" y="598160"/>
                    <a:pt x="1249587" y="594733"/>
                    <a:pt x="1243129" y="587502"/>
                  </a:cubicBezTo>
                  <a:cubicBezTo>
                    <a:pt x="1242133" y="586401"/>
                    <a:pt x="1237864" y="581842"/>
                    <a:pt x="1236808" y="580710"/>
                  </a:cubicBezTo>
                  <a:cubicBezTo>
                    <a:pt x="1235710" y="579547"/>
                    <a:pt x="1234991" y="577975"/>
                    <a:pt x="1233893" y="576780"/>
                  </a:cubicBezTo>
                  <a:cubicBezTo>
                    <a:pt x="1232161" y="574925"/>
                    <a:pt x="1228870" y="571844"/>
                    <a:pt x="1226843" y="570272"/>
                  </a:cubicBezTo>
                  <a:cubicBezTo>
                    <a:pt x="1222841" y="567128"/>
                    <a:pt x="1216986" y="565493"/>
                    <a:pt x="1213959" y="561374"/>
                  </a:cubicBezTo>
                  <a:cubicBezTo>
                    <a:pt x="1211360" y="557853"/>
                    <a:pt x="1210620" y="552633"/>
                    <a:pt x="1208368" y="548829"/>
                  </a:cubicBezTo>
                  <a:cubicBezTo>
                    <a:pt x="1205997" y="544804"/>
                    <a:pt x="1202426" y="541629"/>
                    <a:pt x="1199374" y="538107"/>
                  </a:cubicBezTo>
                  <a:cubicBezTo>
                    <a:pt x="1198392" y="536975"/>
                    <a:pt x="1197564" y="535183"/>
                    <a:pt x="1196459" y="534177"/>
                  </a:cubicBezTo>
                  <a:cubicBezTo>
                    <a:pt x="1192829" y="530939"/>
                    <a:pt x="1186294" y="528643"/>
                    <a:pt x="1181874" y="526348"/>
                  </a:cubicBezTo>
                  <a:cubicBezTo>
                    <a:pt x="1178693" y="524650"/>
                    <a:pt x="1175988" y="522261"/>
                    <a:pt x="1172884" y="520595"/>
                  </a:cubicBezTo>
                  <a:cubicBezTo>
                    <a:pt x="1171316" y="519746"/>
                    <a:pt x="1164767" y="516444"/>
                    <a:pt x="1163161" y="515627"/>
                  </a:cubicBezTo>
                  <a:cubicBezTo>
                    <a:pt x="1159902" y="513961"/>
                    <a:pt x="1155714" y="512168"/>
                    <a:pt x="1152224" y="510910"/>
                  </a:cubicBezTo>
                  <a:cubicBezTo>
                    <a:pt x="1147727" y="509307"/>
                    <a:pt x="1143662" y="509213"/>
                    <a:pt x="1139098" y="508301"/>
                  </a:cubicBezTo>
                  <a:cubicBezTo>
                    <a:pt x="1134934" y="507452"/>
                    <a:pt x="1130859" y="505629"/>
                    <a:pt x="1126705" y="504622"/>
                  </a:cubicBezTo>
                  <a:cubicBezTo>
                    <a:pt x="1123212" y="503805"/>
                    <a:pt x="1119539" y="503302"/>
                    <a:pt x="1116007" y="502547"/>
                  </a:cubicBezTo>
                  <a:cubicBezTo>
                    <a:pt x="1113134" y="501918"/>
                    <a:pt x="1109199" y="501667"/>
                    <a:pt x="1106529" y="500724"/>
                  </a:cubicBezTo>
                  <a:cubicBezTo>
                    <a:pt x="1103969" y="499812"/>
                    <a:pt x="1096438" y="493429"/>
                    <a:pt x="1094617" y="491291"/>
                  </a:cubicBezTo>
                  <a:cubicBezTo>
                    <a:pt x="1093597" y="490128"/>
                    <a:pt x="1092982" y="488556"/>
                    <a:pt x="1091941" y="487392"/>
                  </a:cubicBezTo>
                  <a:cubicBezTo>
                    <a:pt x="1090920" y="486229"/>
                    <a:pt x="1089349" y="485380"/>
                    <a:pt x="1088296" y="484248"/>
                  </a:cubicBezTo>
                  <a:cubicBezTo>
                    <a:pt x="1086227" y="482016"/>
                    <a:pt x="1084803" y="479186"/>
                    <a:pt x="1082705" y="476923"/>
                  </a:cubicBezTo>
                  <a:cubicBezTo>
                    <a:pt x="1079569" y="473558"/>
                    <a:pt x="1068618" y="465258"/>
                    <a:pt x="1067019" y="462460"/>
                  </a:cubicBezTo>
                  <a:cubicBezTo>
                    <a:pt x="1065286" y="456926"/>
                    <a:pt x="1064202" y="451958"/>
                    <a:pt x="1061554" y="446613"/>
                  </a:cubicBezTo>
                  <a:cubicBezTo>
                    <a:pt x="1055514" y="444852"/>
                    <a:pt x="1048863" y="443406"/>
                    <a:pt x="1043328" y="440576"/>
                  </a:cubicBezTo>
                  <a:cubicBezTo>
                    <a:pt x="1032440" y="435011"/>
                    <a:pt x="1021892" y="424227"/>
                    <a:pt x="1027768" y="412594"/>
                  </a:cubicBezTo>
                  <a:lnTo>
                    <a:pt x="1025091" y="408695"/>
                  </a:lnTo>
                  <a:cubicBezTo>
                    <a:pt x="1016673" y="407186"/>
                    <a:pt x="1001793" y="412877"/>
                    <a:pt x="995925" y="406337"/>
                  </a:cubicBezTo>
                  <a:cubicBezTo>
                    <a:pt x="997423" y="403978"/>
                    <a:pt x="997563" y="399325"/>
                    <a:pt x="996167" y="396936"/>
                  </a:cubicBezTo>
                  <a:cubicBezTo>
                    <a:pt x="990993" y="390019"/>
                    <a:pt x="978116" y="390773"/>
                    <a:pt x="974293" y="382536"/>
                  </a:cubicBezTo>
                  <a:cubicBezTo>
                    <a:pt x="972448" y="378574"/>
                    <a:pt x="972402" y="372977"/>
                    <a:pt x="970649" y="368953"/>
                  </a:cubicBezTo>
                  <a:cubicBezTo>
                    <a:pt x="966099" y="358514"/>
                    <a:pt x="950115" y="346189"/>
                    <a:pt x="942938" y="336788"/>
                  </a:cubicBezTo>
                  <a:cubicBezTo>
                    <a:pt x="936452" y="328299"/>
                    <a:pt x="931506" y="318678"/>
                    <a:pt x="926168" y="309592"/>
                  </a:cubicBezTo>
                  <a:cubicBezTo>
                    <a:pt x="921555" y="301763"/>
                    <a:pt x="915311" y="294689"/>
                    <a:pt x="910611" y="286859"/>
                  </a:cubicBezTo>
                  <a:cubicBezTo>
                    <a:pt x="908201" y="282835"/>
                    <a:pt x="907321" y="277899"/>
                    <a:pt x="904778" y="274032"/>
                  </a:cubicBezTo>
                  <a:cubicBezTo>
                    <a:pt x="902940" y="271265"/>
                    <a:pt x="899109" y="267555"/>
                    <a:pt x="895865" y="266203"/>
                  </a:cubicBezTo>
                  <a:lnTo>
                    <a:pt x="894002" y="265417"/>
                  </a:lnTo>
                  <a:lnTo>
                    <a:pt x="892139" y="264631"/>
                  </a:lnTo>
                  <a:cubicBezTo>
                    <a:pt x="886762" y="264002"/>
                    <a:pt x="878158" y="269504"/>
                    <a:pt x="870992" y="270133"/>
                  </a:cubicBezTo>
                  <a:cubicBezTo>
                    <a:pt x="865460" y="270605"/>
                    <a:pt x="860781" y="268403"/>
                    <a:pt x="855596" y="268655"/>
                  </a:cubicBezTo>
                  <a:cubicBezTo>
                    <a:pt x="840306" y="269284"/>
                    <a:pt x="834435" y="275667"/>
                    <a:pt x="815328" y="270133"/>
                  </a:cubicBezTo>
                  <a:cubicBezTo>
                    <a:pt x="795138" y="264285"/>
                    <a:pt x="797439" y="243030"/>
                    <a:pt x="772307" y="240578"/>
                  </a:cubicBezTo>
                  <a:cubicBezTo>
                    <a:pt x="765414" y="239918"/>
                    <a:pt x="758430" y="244257"/>
                    <a:pt x="751643" y="243974"/>
                  </a:cubicBezTo>
                  <a:cubicBezTo>
                    <a:pt x="747234" y="243785"/>
                    <a:pt x="743256" y="241616"/>
                    <a:pt x="738517" y="242402"/>
                  </a:cubicBezTo>
                  <a:cubicBezTo>
                    <a:pt x="725009" y="244665"/>
                    <a:pt x="724795" y="253815"/>
                    <a:pt x="704489" y="245546"/>
                  </a:cubicBezTo>
                  <a:lnTo>
                    <a:pt x="700115" y="242936"/>
                  </a:lnTo>
                  <a:cubicBezTo>
                    <a:pt x="697270" y="240483"/>
                    <a:pt x="676557" y="212941"/>
                    <a:pt x="674835" y="209451"/>
                  </a:cubicBezTo>
                  <a:cubicBezTo>
                    <a:pt x="672197" y="204137"/>
                    <a:pt x="674347" y="202628"/>
                    <a:pt x="667542" y="197975"/>
                  </a:cubicBezTo>
                  <a:lnTo>
                    <a:pt x="662197" y="197440"/>
                  </a:lnTo>
                  <a:cubicBezTo>
                    <a:pt x="657605" y="201308"/>
                    <a:pt x="663046" y="218789"/>
                    <a:pt x="659524" y="226712"/>
                  </a:cubicBezTo>
                  <a:lnTo>
                    <a:pt x="655634" y="229856"/>
                  </a:lnTo>
                  <a:cubicBezTo>
                    <a:pt x="652726" y="230926"/>
                    <a:pt x="646384" y="231083"/>
                    <a:pt x="643480" y="230108"/>
                  </a:cubicBezTo>
                  <a:cubicBezTo>
                    <a:pt x="640558" y="229165"/>
                    <a:pt x="621150" y="215079"/>
                    <a:pt x="617228" y="212344"/>
                  </a:cubicBezTo>
                  <a:cubicBezTo>
                    <a:pt x="612868" y="209294"/>
                    <a:pt x="607572" y="207156"/>
                    <a:pt x="603376" y="203980"/>
                  </a:cubicBezTo>
                  <a:cubicBezTo>
                    <a:pt x="580896" y="186908"/>
                    <a:pt x="576732" y="169646"/>
                    <a:pt x="577854" y="144367"/>
                  </a:cubicBezTo>
                  <a:cubicBezTo>
                    <a:pt x="578160" y="137513"/>
                    <a:pt x="576528" y="129181"/>
                    <a:pt x="579801" y="122673"/>
                  </a:cubicBezTo>
                  <a:cubicBezTo>
                    <a:pt x="580015" y="122233"/>
                    <a:pt x="582730" y="119309"/>
                    <a:pt x="583204" y="118743"/>
                  </a:cubicBezTo>
                  <a:cubicBezTo>
                    <a:pt x="591647" y="109027"/>
                    <a:pt x="593958" y="109090"/>
                    <a:pt x="594870" y="96011"/>
                  </a:cubicBezTo>
                  <a:cubicBezTo>
                    <a:pt x="595491" y="87144"/>
                    <a:pt x="593895" y="86012"/>
                    <a:pt x="588069" y="79001"/>
                  </a:cubicBezTo>
                  <a:cubicBezTo>
                    <a:pt x="587423" y="76045"/>
                    <a:pt x="587865" y="71832"/>
                    <a:pt x="589282" y="69066"/>
                  </a:cubicBezTo>
                  <a:cubicBezTo>
                    <a:pt x="599300" y="63437"/>
                    <a:pt x="606456" y="71486"/>
                    <a:pt x="611160" y="78215"/>
                  </a:cubicBezTo>
                  <a:lnTo>
                    <a:pt x="615534" y="79001"/>
                  </a:lnTo>
                  <a:cubicBezTo>
                    <a:pt x="618424" y="77680"/>
                    <a:pt x="627036" y="72964"/>
                    <a:pt x="629635" y="72744"/>
                  </a:cubicBezTo>
                  <a:cubicBezTo>
                    <a:pt x="635994" y="72147"/>
                    <a:pt x="647994" y="75165"/>
                    <a:pt x="654669" y="73247"/>
                  </a:cubicBezTo>
                  <a:lnTo>
                    <a:pt x="657830" y="69348"/>
                  </a:lnTo>
                  <a:cubicBezTo>
                    <a:pt x="659668" y="60671"/>
                    <a:pt x="653129" y="58973"/>
                    <a:pt x="648348" y="53659"/>
                  </a:cubicBezTo>
                  <a:cubicBezTo>
                    <a:pt x="645325" y="50263"/>
                    <a:pt x="643031" y="45956"/>
                    <a:pt x="640088" y="42403"/>
                  </a:cubicBezTo>
                  <a:lnTo>
                    <a:pt x="635468" y="44761"/>
                  </a:lnTo>
                  <a:cubicBezTo>
                    <a:pt x="633872" y="47780"/>
                    <a:pt x="631873" y="50704"/>
                    <a:pt x="629638" y="53376"/>
                  </a:cubicBezTo>
                  <a:cubicBezTo>
                    <a:pt x="625899" y="53659"/>
                    <a:pt x="622143" y="54099"/>
                    <a:pt x="618456" y="54697"/>
                  </a:cubicBezTo>
                  <a:cubicBezTo>
                    <a:pt x="608227" y="49761"/>
                    <a:pt x="598778" y="53848"/>
                    <a:pt x="588076" y="51018"/>
                  </a:cubicBezTo>
                  <a:cubicBezTo>
                    <a:pt x="584305" y="47905"/>
                    <a:pt x="580906" y="44478"/>
                    <a:pt x="577135" y="41366"/>
                  </a:cubicBezTo>
                  <a:cubicBezTo>
                    <a:pt x="580780" y="38347"/>
                    <a:pt x="583509" y="39448"/>
                    <a:pt x="587104" y="38221"/>
                  </a:cubicBezTo>
                  <a:cubicBezTo>
                    <a:pt x="592646" y="36335"/>
                    <a:pt x="601917" y="24262"/>
                    <a:pt x="612139" y="21746"/>
                  </a:cubicBezTo>
                  <a:cubicBezTo>
                    <a:pt x="615352" y="23821"/>
                    <a:pt x="620147" y="25425"/>
                    <a:pt x="624051" y="25928"/>
                  </a:cubicBezTo>
                  <a:lnTo>
                    <a:pt x="627941" y="23067"/>
                  </a:lnTo>
                  <a:cubicBezTo>
                    <a:pt x="629095" y="19577"/>
                    <a:pt x="629021" y="14640"/>
                    <a:pt x="630382" y="11528"/>
                  </a:cubicBezTo>
                  <a:cubicBezTo>
                    <a:pt x="615772" y="8195"/>
                    <a:pt x="600984" y="5051"/>
                    <a:pt x="586610" y="964"/>
                  </a:cubicBezTo>
                  <a:cubicBezTo>
                    <a:pt x="575185" y="-2275"/>
                    <a:pt x="529659" y="3510"/>
                    <a:pt x="516456" y="5680"/>
                  </a:cubicBezTo>
                  <a:cubicBezTo>
                    <a:pt x="508627" y="6969"/>
                    <a:pt x="482901" y="22784"/>
                    <a:pt x="475241" y="27689"/>
                  </a:cubicBezTo>
                  <a:cubicBezTo>
                    <a:pt x="469021" y="31713"/>
                    <a:pt x="454994" y="33317"/>
                    <a:pt x="448933" y="28475"/>
                  </a:cubicBezTo>
                  <a:cubicBezTo>
                    <a:pt x="441462" y="22532"/>
                    <a:pt x="425845" y="25802"/>
                    <a:pt x="418241" y="30047"/>
                  </a:cubicBezTo>
                  <a:cubicBezTo>
                    <a:pt x="411622" y="33757"/>
                    <a:pt x="402975" y="32625"/>
                    <a:pt x="395700" y="31273"/>
                  </a:cubicBezTo>
                  <a:cubicBezTo>
                    <a:pt x="395262" y="31210"/>
                    <a:pt x="390611" y="30298"/>
                    <a:pt x="390179" y="30047"/>
                  </a:cubicBezTo>
                  <a:cubicBezTo>
                    <a:pt x="386945" y="28254"/>
                    <a:pt x="383750" y="26399"/>
                    <a:pt x="380533" y="24545"/>
                  </a:cubicBezTo>
                  <a:cubicBezTo>
                    <a:pt x="379628" y="24545"/>
                    <a:pt x="369344" y="24513"/>
                    <a:pt x="369133" y="24545"/>
                  </a:cubicBezTo>
                  <a:cubicBezTo>
                    <a:pt x="368789" y="24639"/>
                    <a:pt x="358077" y="29544"/>
                    <a:pt x="357053" y="30015"/>
                  </a:cubicBezTo>
                  <a:cubicBezTo>
                    <a:pt x="356253" y="31399"/>
                    <a:pt x="355102" y="33034"/>
                    <a:pt x="354510" y="34480"/>
                  </a:cubicBezTo>
                  <a:lnTo>
                    <a:pt x="351289" y="44132"/>
                  </a:lnTo>
                  <a:cubicBezTo>
                    <a:pt x="350542" y="51396"/>
                    <a:pt x="353261" y="59759"/>
                    <a:pt x="351065" y="66896"/>
                  </a:cubicBezTo>
                  <a:cubicBezTo>
                    <a:pt x="349350" y="72493"/>
                    <a:pt x="345151" y="80573"/>
                    <a:pt x="344162" y="85981"/>
                  </a:cubicBezTo>
                  <a:cubicBezTo>
                    <a:pt x="342843" y="93149"/>
                    <a:pt x="345130" y="108776"/>
                    <a:pt x="342078" y="114938"/>
                  </a:cubicBezTo>
                  <a:cubicBezTo>
                    <a:pt x="333821" y="131602"/>
                    <a:pt x="296471" y="122516"/>
                    <a:pt x="286611" y="137450"/>
                  </a:cubicBezTo>
                  <a:cubicBezTo>
                    <a:pt x="285461" y="139211"/>
                    <a:pt x="284447" y="146411"/>
                    <a:pt x="285475" y="148109"/>
                  </a:cubicBezTo>
                  <a:lnTo>
                    <a:pt x="299972" y="171879"/>
                  </a:lnTo>
                  <a:cubicBezTo>
                    <a:pt x="302519" y="176060"/>
                    <a:pt x="302519" y="182474"/>
                    <a:pt x="299502" y="186499"/>
                  </a:cubicBezTo>
                  <a:cubicBezTo>
                    <a:pt x="296493" y="188637"/>
                    <a:pt x="291631" y="190712"/>
                    <a:pt x="287744" y="191026"/>
                  </a:cubicBezTo>
                  <a:cubicBezTo>
                    <a:pt x="290628" y="192347"/>
                    <a:pt x="293321" y="194391"/>
                    <a:pt x="295745" y="196214"/>
                  </a:cubicBezTo>
                  <a:cubicBezTo>
                    <a:pt x="304788" y="203069"/>
                    <a:pt x="308243" y="206873"/>
                    <a:pt x="315381" y="215456"/>
                  </a:cubicBezTo>
                  <a:cubicBezTo>
                    <a:pt x="317447" y="217940"/>
                    <a:pt x="320485" y="221147"/>
                    <a:pt x="320906" y="224354"/>
                  </a:cubicBezTo>
                  <a:cubicBezTo>
                    <a:pt x="321144" y="226209"/>
                    <a:pt x="320555" y="230328"/>
                    <a:pt x="319759" y="232026"/>
                  </a:cubicBezTo>
                  <a:lnTo>
                    <a:pt x="318370" y="235013"/>
                  </a:lnTo>
                  <a:lnTo>
                    <a:pt x="312852" y="238974"/>
                  </a:lnTo>
                  <a:lnTo>
                    <a:pt x="279252" y="252086"/>
                  </a:lnTo>
                  <a:cubicBezTo>
                    <a:pt x="274187" y="254066"/>
                    <a:pt x="270108" y="257305"/>
                    <a:pt x="265898" y="260418"/>
                  </a:cubicBezTo>
                  <a:cubicBezTo>
                    <a:pt x="264548" y="261423"/>
                    <a:pt x="263632" y="261832"/>
                    <a:pt x="262443" y="262964"/>
                  </a:cubicBezTo>
                  <a:lnTo>
                    <a:pt x="260297" y="266611"/>
                  </a:lnTo>
                  <a:cubicBezTo>
                    <a:pt x="253095" y="278779"/>
                    <a:pt x="262363" y="292865"/>
                    <a:pt x="256312" y="304561"/>
                  </a:cubicBezTo>
                  <a:lnTo>
                    <a:pt x="253239" y="310503"/>
                  </a:lnTo>
                  <a:cubicBezTo>
                    <a:pt x="249440" y="313868"/>
                    <a:pt x="235525" y="322294"/>
                    <a:pt x="230576" y="325595"/>
                  </a:cubicBezTo>
                  <a:lnTo>
                    <a:pt x="246792" y="334776"/>
                  </a:lnTo>
                  <a:cubicBezTo>
                    <a:pt x="246936" y="335248"/>
                    <a:pt x="248048" y="339021"/>
                    <a:pt x="248181" y="339241"/>
                  </a:cubicBezTo>
                  <a:cubicBezTo>
                    <a:pt x="252531" y="345812"/>
                    <a:pt x="256719" y="352572"/>
                    <a:pt x="261289" y="359049"/>
                  </a:cubicBezTo>
                  <a:cubicBezTo>
                    <a:pt x="263408" y="362036"/>
                    <a:pt x="266319" y="365778"/>
                    <a:pt x="268901" y="368450"/>
                  </a:cubicBezTo>
                  <a:cubicBezTo>
                    <a:pt x="270150" y="369739"/>
                    <a:pt x="272563" y="370588"/>
                    <a:pt x="273738" y="371908"/>
                  </a:cubicBezTo>
                  <a:cubicBezTo>
                    <a:pt x="284661" y="384202"/>
                    <a:pt x="285078" y="399923"/>
                    <a:pt x="278561" y="414008"/>
                  </a:cubicBezTo>
                  <a:lnTo>
                    <a:pt x="275804" y="419951"/>
                  </a:lnTo>
                  <a:cubicBezTo>
                    <a:pt x="268992" y="428912"/>
                    <a:pt x="260651" y="437558"/>
                    <a:pt x="253236" y="446173"/>
                  </a:cubicBezTo>
                  <a:cubicBezTo>
                    <a:pt x="250605" y="449254"/>
                    <a:pt x="241867" y="453813"/>
                    <a:pt x="238058" y="454851"/>
                  </a:cubicBezTo>
                  <a:lnTo>
                    <a:pt x="231148" y="455511"/>
                  </a:lnTo>
                  <a:cubicBezTo>
                    <a:pt x="219341" y="456643"/>
                    <a:pt x="194138" y="454819"/>
                    <a:pt x="183727" y="460070"/>
                  </a:cubicBezTo>
                  <a:cubicBezTo>
                    <a:pt x="180686" y="461579"/>
                    <a:pt x="177547" y="464252"/>
                    <a:pt x="175057" y="466327"/>
                  </a:cubicBezTo>
                  <a:cubicBezTo>
                    <a:pt x="171464" y="469314"/>
                    <a:pt x="167532" y="472175"/>
                    <a:pt x="164846" y="475885"/>
                  </a:cubicBezTo>
                  <a:cubicBezTo>
                    <a:pt x="151555" y="494310"/>
                    <a:pt x="166480" y="511822"/>
                    <a:pt x="165070" y="529618"/>
                  </a:cubicBezTo>
                  <a:cubicBezTo>
                    <a:pt x="164333" y="538893"/>
                    <a:pt x="162923" y="548860"/>
                    <a:pt x="161390" y="558072"/>
                  </a:cubicBezTo>
                  <a:cubicBezTo>
                    <a:pt x="157325" y="582565"/>
                    <a:pt x="128387" y="604354"/>
                    <a:pt x="116064" y="625420"/>
                  </a:cubicBezTo>
                  <a:cubicBezTo>
                    <a:pt x="110764" y="634507"/>
                    <a:pt x="106969" y="644411"/>
                    <a:pt x="101549" y="653403"/>
                  </a:cubicBezTo>
                  <a:cubicBezTo>
                    <a:pt x="100788" y="654661"/>
                    <a:pt x="100006" y="655163"/>
                    <a:pt x="99017" y="656295"/>
                  </a:cubicBezTo>
                  <a:cubicBezTo>
                    <a:pt x="93815" y="662238"/>
                    <a:pt x="90665" y="665413"/>
                    <a:pt x="83678" y="669752"/>
                  </a:cubicBezTo>
                  <a:cubicBezTo>
                    <a:pt x="71759" y="677109"/>
                    <a:pt x="66150" y="680128"/>
                    <a:pt x="51828" y="683618"/>
                  </a:cubicBezTo>
                  <a:cubicBezTo>
                    <a:pt x="41003" y="686227"/>
                    <a:pt x="29330" y="687705"/>
                    <a:pt x="18698" y="690787"/>
                  </a:cubicBezTo>
                  <a:cubicBezTo>
                    <a:pt x="17211" y="691227"/>
                    <a:pt x="16586" y="691887"/>
                    <a:pt x="15243" y="692579"/>
                  </a:cubicBezTo>
                  <a:cubicBezTo>
                    <a:pt x="10599" y="695031"/>
                    <a:pt x="2127" y="699056"/>
                    <a:pt x="745" y="704401"/>
                  </a:cubicBezTo>
                  <a:lnTo>
                    <a:pt x="128" y="710500"/>
                  </a:lnTo>
                  <a:cubicBezTo>
                    <a:pt x="-289" y="714651"/>
                    <a:pt x="202" y="719304"/>
                    <a:pt x="3278" y="722699"/>
                  </a:cubicBezTo>
                  <a:cubicBezTo>
                    <a:pt x="9722" y="729837"/>
                    <a:pt x="16492" y="736817"/>
                    <a:pt x="22227" y="744425"/>
                  </a:cubicBezTo>
                  <a:lnTo>
                    <a:pt x="28821" y="753166"/>
                  </a:lnTo>
                  <a:cubicBezTo>
                    <a:pt x="31694" y="757411"/>
                    <a:pt x="32564" y="766183"/>
                    <a:pt x="30442" y="770742"/>
                  </a:cubicBezTo>
                  <a:cubicBezTo>
                    <a:pt x="28446" y="775049"/>
                    <a:pt x="25499" y="779263"/>
                    <a:pt x="23766" y="783633"/>
                  </a:cubicBezTo>
                  <a:lnTo>
                    <a:pt x="20999" y="793191"/>
                  </a:lnTo>
                  <a:cubicBezTo>
                    <a:pt x="17628" y="804856"/>
                    <a:pt x="17937" y="806239"/>
                    <a:pt x="19382" y="818595"/>
                  </a:cubicBezTo>
                  <a:cubicBezTo>
                    <a:pt x="19648" y="820891"/>
                    <a:pt x="19578" y="822211"/>
                    <a:pt x="20066" y="824475"/>
                  </a:cubicBezTo>
                  <a:cubicBezTo>
                    <a:pt x="21034" y="828908"/>
                    <a:pt x="24987" y="842994"/>
                    <a:pt x="26748" y="846987"/>
                  </a:cubicBezTo>
                  <a:cubicBezTo>
                    <a:pt x="28751" y="851546"/>
                    <a:pt x="30445" y="853904"/>
                    <a:pt x="32809" y="858306"/>
                  </a:cubicBezTo>
                  <a:cubicBezTo>
                    <a:pt x="41449" y="874404"/>
                    <a:pt x="48839" y="888993"/>
                    <a:pt x="61278" y="902953"/>
                  </a:cubicBezTo>
                  <a:cubicBezTo>
                    <a:pt x="71145" y="914020"/>
                    <a:pt x="82783" y="924207"/>
                    <a:pt x="90798" y="936532"/>
                  </a:cubicBezTo>
                  <a:lnTo>
                    <a:pt x="87508" y="943040"/>
                  </a:lnTo>
                  <a:cubicBezTo>
                    <a:pt x="92029" y="961025"/>
                    <a:pt x="112248" y="952945"/>
                    <a:pt x="121813" y="959642"/>
                  </a:cubicBezTo>
                  <a:cubicBezTo>
                    <a:pt x="124655" y="963855"/>
                    <a:pt x="122866" y="968791"/>
                    <a:pt x="125721" y="973004"/>
                  </a:cubicBezTo>
                  <a:cubicBezTo>
                    <a:pt x="127236" y="974513"/>
                    <a:pt x="130319" y="975740"/>
                    <a:pt x="132456" y="975991"/>
                  </a:cubicBezTo>
                  <a:lnTo>
                    <a:pt x="136770" y="976463"/>
                  </a:lnTo>
                  <a:cubicBezTo>
                    <a:pt x="143568" y="975865"/>
                    <a:pt x="150787" y="966118"/>
                    <a:pt x="157707" y="963100"/>
                  </a:cubicBezTo>
                  <a:cubicBezTo>
                    <a:pt x="160570" y="961874"/>
                    <a:pt x="164916" y="960993"/>
                    <a:pt x="168062" y="960616"/>
                  </a:cubicBezTo>
                  <a:cubicBezTo>
                    <a:pt x="170223" y="961654"/>
                    <a:pt x="175011" y="964767"/>
                    <a:pt x="176354" y="966559"/>
                  </a:cubicBezTo>
                  <a:cubicBezTo>
                    <a:pt x="180367" y="971935"/>
                    <a:pt x="177950" y="981713"/>
                    <a:pt x="174053" y="986618"/>
                  </a:cubicBezTo>
                  <a:cubicBezTo>
                    <a:pt x="170602" y="988819"/>
                    <a:pt x="164537" y="992152"/>
                    <a:pt x="160236" y="992812"/>
                  </a:cubicBezTo>
                  <a:lnTo>
                    <a:pt x="154263" y="1001238"/>
                  </a:lnTo>
                  <a:cubicBezTo>
                    <a:pt x="154628" y="1011457"/>
                    <a:pt x="172391" y="1018217"/>
                    <a:pt x="171984" y="1028215"/>
                  </a:cubicBezTo>
                  <a:cubicBezTo>
                    <a:pt x="171584" y="1038088"/>
                    <a:pt x="161243" y="1041735"/>
                    <a:pt x="158167" y="1049752"/>
                  </a:cubicBezTo>
                  <a:cubicBezTo>
                    <a:pt x="157511" y="1053305"/>
                    <a:pt x="160012" y="1059530"/>
                    <a:pt x="161818" y="1062549"/>
                  </a:cubicBezTo>
                  <a:lnTo>
                    <a:pt x="171685" y="1078207"/>
                  </a:lnTo>
                  <a:lnTo>
                    <a:pt x="189235" y="1084904"/>
                  </a:lnTo>
                  <a:lnTo>
                    <a:pt x="205654" y="1083080"/>
                  </a:lnTo>
                  <a:lnTo>
                    <a:pt x="214711" y="1107416"/>
                  </a:lnTo>
                  <a:lnTo>
                    <a:pt x="228296" y="1125683"/>
                  </a:lnTo>
                  <a:lnTo>
                    <a:pt x="241562" y="1137474"/>
                  </a:lnTo>
                  <a:cubicBezTo>
                    <a:pt x="242400" y="1135807"/>
                    <a:pt x="242814" y="1133921"/>
                    <a:pt x="242814" y="1133921"/>
                  </a:cubicBezTo>
                  <a:cubicBezTo>
                    <a:pt x="240296" y="1130588"/>
                    <a:pt x="233908" y="1123797"/>
                    <a:pt x="234529" y="1119961"/>
                  </a:cubicBezTo>
                  <a:cubicBezTo>
                    <a:pt x="236329" y="1108768"/>
                    <a:pt x="237335" y="1095279"/>
                    <a:pt x="246364" y="1086444"/>
                  </a:cubicBezTo>
                  <a:lnTo>
                    <a:pt x="252457" y="1084369"/>
                  </a:lnTo>
                  <a:cubicBezTo>
                    <a:pt x="256838" y="1076698"/>
                    <a:pt x="274359" y="1065788"/>
                    <a:pt x="276355" y="1061449"/>
                  </a:cubicBezTo>
                  <a:lnTo>
                    <a:pt x="280336" y="1052802"/>
                  </a:lnTo>
                  <a:cubicBezTo>
                    <a:pt x="287271" y="1049815"/>
                    <a:pt x="293016" y="1045697"/>
                    <a:pt x="298832" y="1041295"/>
                  </a:cubicBezTo>
                  <a:lnTo>
                    <a:pt x="303652" y="1037616"/>
                  </a:lnTo>
                  <a:cubicBezTo>
                    <a:pt x="306794" y="1035855"/>
                    <a:pt x="311214" y="1035006"/>
                    <a:pt x="314189" y="1033057"/>
                  </a:cubicBezTo>
                  <a:cubicBezTo>
                    <a:pt x="319345" y="1029724"/>
                    <a:pt x="324407" y="1024914"/>
                    <a:pt x="329195" y="1021078"/>
                  </a:cubicBezTo>
                  <a:cubicBezTo>
                    <a:pt x="329437" y="1020889"/>
                    <a:pt x="340342" y="1017556"/>
                    <a:pt x="342180" y="1016205"/>
                  </a:cubicBezTo>
                  <a:cubicBezTo>
                    <a:pt x="344983" y="1014129"/>
                    <a:pt x="346768" y="1010168"/>
                    <a:pt x="349546" y="1008061"/>
                  </a:cubicBezTo>
                  <a:cubicBezTo>
                    <a:pt x="350851" y="1007055"/>
                    <a:pt x="358221" y="1002810"/>
                    <a:pt x="365636" y="998629"/>
                  </a:cubicBezTo>
                  <a:cubicBezTo>
                    <a:pt x="372297" y="994887"/>
                    <a:pt x="378955" y="991114"/>
                    <a:pt x="382133" y="990548"/>
                  </a:cubicBezTo>
                  <a:cubicBezTo>
                    <a:pt x="386324" y="989825"/>
                    <a:pt x="391810" y="993818"/>
                    <a:pt x="395665" y="994698"/>
                  </a:cubicBezTo>
                  <a:cubicBezTo>
                    <a:pt x="395665" y="994698"/>
                    <a:pt x="404445" y="995579"/>
                    <a:pt x="405750" y="995422"/>
                  </a:cubicBezTo>
                  <a:cubicBezTo>
                    <a:pt x="409672" y="994950"/>
                    <a:pt x="432072" y="988159"/>
                    <a:pt x="438249" y="985927"/>
                  </a:cubicBezTo>
                  <a:cubicBezTo>
                    <a:pt x="445562" y="983285"/>
                    <a:pt x="452847" y="978349"/>
                    <a:pt x="459491" y="974608"/>
                  </a:cubicBezTo>
                  <a:cubicBezTo>
                    <a:pt x="460866" y="973822"/>
                    <a:pt x="462908" y="973287"/>
                    <a:pt x="464416" y="972721"/>
                  </a:cubicBezTo>
                  <a:cubicBezTo>
                    <a:pt x="469446" y="973570"/>
                    <a:pt x="474662" y="974733"/>
                    <a:pt x="479724" y="975268"/>
                  </a:cubicBezTo>
                  <a:cubicBezTo>
                    <a:pt x="484852" y="975834"/>
                    <a:pt x="493547" y="976180"/>
                    <a:pt x="494340" y="976620"/>
                  </a:cubicBezTo>
                  <a:cubicBezTo>
                    <a:pt x="498977" y="979104"/>
                    <a:pt x="502464" y="984889"/>
                    <a:pt x="508381" y="985486"/>
                  </a:cubicBezTo>
                  <a:cubicBezTo>
                    <a:pt x="512622" y="985895"/>
                    <a:pt x="518112" y="981996"/>
                    <a:pt x="521542" y="982468"/>
                  </a:cubicBezTo>
                  <a:cubicBezTo>
                    <a:pt x="526751" y="983160"/>
                    <a:pt x="530627" y="985832"/>
                    <a:pt x="536369" y="984606"/>
                  </a:cubicBezTo>
                  <a:cubicBezTo>
                    <a:pt x="538505" y="982468"/>
                    <a:pt x="543114" y="978475"/>
                    <a:pt x="546359" y="977594"/>
                  </a:cubicBezTo>
                  <a:cubicBezTo>
                    <a:pt x="549954" y="978726"/>
                    <a:pt x="564462" y="978506"/>
                    <a:pt x="568338" y="976557"/>
                  </a:cubicBezTo>
                  <a:cubicBezTo>
                    <a:pt x="572347" y="974513"/>
                    <a:pt x="576977" y="971589"/>
                    <a:pt x="581183" y="970048"/>
                  </a:cubicBezTo>
                  <a:cubicBezTo>
                    <a:pt x="582285" y="969640"/>
                    <a:pt x="590177" y="968539"/>
                    <a:pt x="590177" y="968539"/>
                  </a:cubicBezTo>
                  <a:cubicBezTo>
                    <a:pt x="597259" y="967816"/>
                    <a:pt x="610743" y="972029"/>
                    <a:pt x="616351" y="975394"/>
                  </a:cubicBezTo>
                  <a:cubicBezTo>
                    <a:pt x="620213" y="977720"/>
                    <a:pt x="626520" y="984417"/>
                    <a:pt x="631315" y="984511"/>
                  </a:cubicBezTo>
                  <a:cubicBezTo>
                    <a:pt x="634539" y="984009"/>
                    <a:pt x="638018" y="983317"/>
                    <a:pt x="641070" y="982216"/>
                  </a:cubicBezTo>
                  <a:cubicBezTo>
                    <a:pt x="647215" y="983946"/>
                    <a:pt x="654880" y="985769"/>
                    <a:pt x="660520" y="988442"/>
                  </a:cubicBezTo>
                  <a:cubicBezTo>
                    <a:pt x="664210" y="990202"/>
                    <a:pt x="677161" y="997686"/>
                    <a:pt x="679991" y="998975"/>
                  </a:cubicBezTo>
                  <a:cubicBezTo>
                    <a:pt x="686200" y="1000044"/>
                    <a:pt x="693443" y="992057"/>
                    <a:pt x="697831" y="989385"/>
                  </a:cubicBezTo>
                  <a:cubicBezTo>
                    <a:pt x="699119" y="988599"/>
                    <a:pt x="734213" y="971589"/>
                    <a:pt x="746034" y="968917"/>
                  </a:cubicBezTo>
                  <a:lnTo>
                    <a:pt x="752218" y="967502"/>
                  </a:lnTo>
                  <a:cubicBezTo>
                    <a:pt x="755810" y="967533"/>
                    <a:pt x="761254" y="969168"/>
                    <a:pt x="764877" y="969829"/>
                  </a:cubicBezTo>
                  <a:lnTo>
                    <a:pt x="775025" y="978160"/>
                  </a:lnTo>
                  <a:cubicBezTo>
                    <a:pt x="785913" y="979827"/>
                    <a:pt x="797748" y="978066"/>
                    <a:pt x="808215" y="975142"/>
                  </a:cubicBezTo>
                  <a:cubicBezTo>
                    <a:pt x="808408" y="975236"/>
                    <a:pt x="820635" y="977877"/>
                    <a:pt x="825855" y="978946"/>
                  </a:cubicBezTo>
                  <a:cubicBezTo>
                    <a:pt x="834533" y="980707"/>
                    <a:pt x="833828" y="980518"/>
                    <a:pt x="841127" y="975708"/>
                  </a:cubicBezTo>
                  <a:cubicBezTo>
                    <a:pt x="843712" y="974010"/>
                    <a:pt x="846305" y="972250"/>
                    <a:pt x="848721" y="970363"/>
                  </a:cubicBezTo>
                  <a:cubicBezTo>
                    <a:pt x="852012" y="971023"/>
                    <a:pt x="856372" y="972407"/>
                    <a:pt x="859676" y="972595"/>
                  </a:cubicBezTo>
                  <a:cubicBezTo>
                    <a:pt x="860392" y="972658"/>
                    <a:pt x="865779" y="971526"/>
                    <a:pt x="866975" y="971464"/>
                  </a:cubicBezTo>
                  <a:cubicBezTo>
                    <a:pt x="871725" y="971212"/>
                    <a:pt x="894662" y="973224"/>
                    <a:pt x="899478" y="972501"/>
                  </a:cubicBezTo>
                  <a:cubicBezTo>
                    <a:pt x="906419" y="971495"/>
                    <a:pt x="910664" y="967848"/>
                    <a:pt x="915122" y="963540"/>
                  </a:cubicBezTo>
                  <a:lnTo>
                    <a:pt x="921730" y="962125"/>
                  </a:lnTo>
                  <a:lnTo>
                    <a:pt x="927115" y="964798"/>
                  </a:lnTo>
                  <a:lnTo>
                    <a:pt x="933400" y="978129"/>
                  </a:lnTo>
                  <a:cubicBezTo>
                    <a:pt x="938588" y="980550"/>
                    <a:pt x="943390" y="984857"/>
                    <a:pt x="947031" y="988913"/>
                  </a:cubicBezTo>
                  <a:cubicBezTo>
                    <a:pt x="949182" y="991271"/>
                    <a:pt x="950528" y="994887"/>
                    <a:pt x="953836" y="996302"/>
                  </a:cubicBezTo>
                  <a:lnTo>
                    <a:pt x="957200" y="996648"/>
                  </a:lnTo>
                  <a:cubicBezTo>
                    <a:pt x="961048" y="994856"/>
                    <a:pt x="968705" y="990548"/>
                    <a:pt x="972529" y="989511"/>
                  </a:cubicBezTo>
                  <a:cubicBezTo>
                    <a:pt x="977201" y="988222"/>
                    <a:pt x="983455" y="989102"/>
                    <a:pt x="988296" y="988096"/>
                  </a:cubicBezTo>
                  <a:lnTo>
                    <a:pt x="995451" y="984700"/>
                  </a:lnTo>
                  <a:cubicBezTo>
                    <a:pt x="997759" y="981210"/>
                    <a:pt x="1000081" y="976714"/>
                    <a:pt x="1002818" y="973538"/>
                  </a:cubicBezTo>
                  <a:cubicBezTo>
                    <a:pt x="1002898" y="973444"/>
                    <a:pt x="1010597" y="971526"/>
                    <a:pt x="1010871" y="971589"/>
                  </a:cubicBezTo>
                  <a:cubicBezTo>
                    <a:pt x="1016175" y="972973"/>
                    <a:pt x="1043051" y="979135"/>
                    <a:pt x="1047032" y="980644"/>
                  </a:cubicBezTo>
                  <a:cubicBezTo>
                    <a:pt x="1049214" y="981462"/>
                    <a:pt x="1051385" y="983285"/>
                    <a:pt x="1053595" y="983946"/>
                  </a:cubicBezTo>
                  <a:cubicBezTo>
                    <a:pt x="1053812" y="984009"/>
                    <a:pt x="1061694" y="985109"/>
                    <a:pt x="1061950" y="985109"/>
                  </a:cubicBezTo>
                  <a:cubicBezTo>
                    <a:pt x="1066500" y="985109"/>
                    <a:pt x="1074672" y="981808"/>
                    <a:pt x="1077577" y="981870"/>
                  </a:cubicBezTo>
                  <a:cubicBezTo>
                    <a:pt x="1083954" y="982028"/>
                    <a:pt x="1090468" y="985958"/>
                    <a:pt x="1095855" y="986713"/>
                  </a:cubicBezTo>
                  <a:cubicBezTo>
                    <a:pt x="1099079" y="987153"/>
                    <a:pt x="1103421" y="986021"/>
                    <a:pt x="1106768" y="986115"/>
                  </a:cubicBezTo>
                  <a:cubicBezTo>
                    <a:pt x="1106768" y="986115"/>
                    <a:pt x="1105737" y="934803"/>
                    <a:pt x="1105737" y="930873"/>
                  </a:cubicBezTo>
                  <a:cubicBezTo>
                    <a:pt x="1105737" y="926943"/>
                    <a:pt x="1105737" y="915938"/>
                    <a:pt x="1108367" y="912008"/>
                  </a:cubicBezTo>
                  <a:cubicBezTo>
                    <a:pt x="1110998" y="908078"/>
                    <a:pt x="1118014" y="896287"/>
                    <a:pt x="1118014" y="896287"/>
                  </a:cubicBezTo>
                  <a:lnTo>
                    <a:pt x="1104860" y="880567"/>
                  </a:lnTo>
                  <a:cubicBezTo>
                    <a:pt x="1104860" y="880567"/>
                    <a:pt x="1087321" y="881353"/>
                    <a:pt x="1083814" y="876636"/>
                  </a:cubicBezTo>
                  <a:cubicBezTo>
                    <a:pt x="1080306" y="871920"/>
                    <a:pt x="1068906" y="864846"/>
                    <a:pt x="1063644" y="866418"/>
                  </a:cubicBezTo>
                  <a:cubicBezTo>
                    <a:pt x="1058383" y="867990"/>
                    <a:pt x="1045229" y="871920"/>
                    <a:pt x="1038214" y="872706"/>
                  </a:cubicBezTo>
                  <a:cubicBezTo>
                    <a:pt x="1031198" y="873492"/>
                    <a:pt x="1022429" y="869562"/>
                    <a:pt x="1018044" y="867204"/>
                  </a:cubicBezTo>
                  <a:cubicBezTo>
                    <a:pt x="1013660" y="864846"/>
                    <a:pt x="1007521" y="860916"/>
                    <a:pt x="1007521" y="854627"/>
                  </a:cubicBezTo>
                  <a:cubicBezTo>
                    <a:pt x="1007521" y="848339"/>
                    <a:pt x="1007521" y="844409"/>
                    <a:pt x="1004891" y="834977"/>
                  </a:cubicBezTo>
                  <a:cubicBezTo>
                    <a:pt x="1002260" y="825544"/>
                    <a:pt x="1001383" y="812968"/>
                    <a:pt x="1008398" y="809824"/>
                  </a:cubicBezTo>
                  <a:cubicBezTo>
                    <a:pt x="1015414" y="806679"/>
                    <a:pt x="1024183" y="796461"/>
                    <a:pt x="1024183" y="796461"/>
                  </a:cubicBezTo>
                  <a:lnTo>
                    <a:pt x="1042598" y="773666"/>
                  </a:lnTo>
                  <a:cubicBezTo>
                    <a:pt x="1042598" y="773666"/>
                    <a:pt x="1048737" y="767378"/>
                    <a:pt x="1048737" y="757945"/>
                  </a:cubicBezTo>
                  <a:cubicBezTo>
                    <a:pt x="1048737" y="748513"/>
                    <a:pt x="1051367" y="735936"/>
                    <a:pt x="1046106" y="732792"/>
                  </a:cubicBezTo>
                  <a:cubicBezTo>
                    <a:pt x="1040844" y="729648"/>
                    <a:pt x="1030321" y="720216"/>
                    <a:pt x="1030321" y="720216"/>
                  </a:cubicBezTo>
                  <a:cubicBezTo>
                    <a:pt x="1030321" y="720216"/>
                    <a:pt x="1020675" y="715500"/>
                    <a:pt x="1017168" y="715500"/>
                  </a:cubicBezTo>
                  <a:cubicBezTo>
                    <a:pt x="1013660" y="715500"/>
                    <a:pt x="993491" y="716286"/>
                    <a:pt x="988229" y="716286"/>
                  </a:cubicBezTo>
                  <a:cubicBezTo>
                    <a:pt x="982968" y="716286"/>
                    <a:pt x="977706" y="717072"/>
                    <a:pt x="971568" y="708425"/>
                  </a:cubicBezTo>
                  <a:cubicBezTo>
                    <a:pt x="965429" y="699779"/>
                    <a:pt x="958414" y="688774"/>
                    <a:pt x="947891" y="687988"/>
                  </a:cubicBezTo>
                  <a:cubicBezTo>
                    <a:pt x="937368" y="687202"/>
                    <a:pt x="928598" y="680914"/>
                    <a:pt x="925968" y="677770"/>
                  </a:cubicBezTo>
                  <a:cubicBezTo>
                    <a:pt x="923337" y="674626"/>
                    <a:pt x="904045" y="656547"/>
                    <a:pt x="904045" y="656547"/>
                  </a:cubicBezTo>
                  <a:cubicBezTo>
                    <a:pt x="904045" y="656547"/>
                    <a:pt x="904922" y="649473"/>
                    <a:pt x="901414" y="643970"/>
                  </a:cubicBezTo>
                  <a:cubicBezTo>
                    <a:pt x="897906" y="638468"/>
                    <a:pt x="893522" y="628250"/>
                    <a:pt x="893522" y="628250"/>
                  </a:cubicBezTo>
                  <a:lnTo>
                    <a:pt x="895275" y="600739"/>
                  </a:lnTo>
                  <a:lnTo>
                    <a:pt x="929475" y="582660"/>
                  </a:lnTo>
                  <a:cubicBezTo>
                    <a:pt x="929475" y="582660"/>
                    <a:pt x="947891" y="572441"/>
                    <a:pt x="957537" y="577158"/>
                  </a:cubicBezTo>
                  <a:cubicBezTo>
                    <a:pt x="967183" y="581874"/>
                    <a:pt x="980337" y="581088"/>
                    <a:pt x="986475" y="580302"/>
                  </a:cubicBezTo>
                  <a:cubicBezTo>
                    <a:pt x="992614" y="579516"/>
                    <a:pt x="1003137" y="580302"/>
                    <a:pt x="1009275" y="585804"/>
                  </a:cubicBezTo>
                  <a:cubicBezTo>
                    <a:pt x="1015414" y="591306"/>
                    <a:pt x="1027691" y="594450"/>
                    <a:pt x="1036460" y="592878"/>
                  </a:cubicBezTo>
                  <a:cubicBezTo>
                    <a:pt x="1045229" y="591306"/>
                    <a:pt x="1067152" y="584232"/>
                    <a:pt x="1069783" y="596022"/>
                  </a:cubicBezTo>
                  <a:cubicBezTo>
                    <a:pt x="1072414" y="607813"/>
                    <a:pt x="1081183" y="617245"/>
                    <a:pt x="1081183" y="617245"/>
                  </a:cubicBezTo>
                  <a:lnTo>
                    <a:pt x="1113629" y="616459"/>
                  </a:lnTo>
                  <a:cubicBezTo>
                    <a:pt x="1113629" y="616459"/>
                    <a:pt x="1124152" y="605455"/>
                    <a:pt x="1127660" y="600739"/>
                  </a:cubicBezTo>
                  <a:cubicBezTo>
                    <a:pt x="1131167" y="596022"/>
                    <a:pt x="1142567" y="596022"/>
                    <a:pt x="1151337" y="600739"/>
                  </a:cubicBezTo>
                  <a:cubicBezTo>
                    <a:pt x="1160106" y="605455"/>
                    <a:pt x="1167998" y="611743"/>
                    <a:pt x="1169752" y="617245"/>
                  </a:cubicBezTo>
                  <a:cubicBezTo>
                    <a:pt x="1171506" y="622748"/>
                    <a:pt x="1197813" y="695849"/>
                    <a:pt x="1198690" y="699779"/>
                  </a:cubicBezTo>
                  <a:cubicBezTo>
                    <a:pt x="1199567" y="703709"/>
                    <a:pt x="1200444" y="728076"/>
                    <a:pt x="1196936" y="733578"/>
                  </a:cubicBezTo>
                  <a:cubicBezTo>
                    <a:pt x="1193429" y="739081"/>
                    <a:pt x="1191675" y="746155"/>
                    <a:pt x="1191675" y="754015"/>
                  </a:cubicBezTo>
                  <a:cubicBezTo>
                    <a:pt x="1191675" y="761875"/>
                    <a:pt x="1191675" y="793317"/>
                    <a:pt x="1191675" y="793317"/>
                  </a:cubicBezTo>
                  <a:cubicBezTo>
                    <a:pt x="1191675" y="793317"/>
                    <a:pt x="1184660" y="800391"/>
                    <a:pt x="1182029" y="805107"/>
                  </a:cubicBezTo>
                  <a:cubicBezTo>
                    <a:pt x="1179398" y="809824"/>
                    <a:pt x="1175890" y="824758"/>
                    <a:pt x="1184660" y="831046"/>
                  </a:cubicBezTo>
                  <a:cubicBezTo>
                    <a:pt x="1193429" y="837335"/>
                    <a:pt x="1206583" y="845195"/>
                    <a:pt x="1213598" y="849125"/>
                  </a:cubicBezTo>
                  <a:cubicBezTo>
                    <a:pt x="1220613" y="853055"/>
                    <a:pt x="1230259" y="859344"/>
                    <a:pt x="1229383" y="866418"/>
                  </a:cubicBezTo>
                  <a:cubicBezTo>
                    <a:pt x="1228506" y="873492"/>
                    <a:pt x="1227629" y="881353"/>
                    <a:pt x="1230259" y="885283"/>
                  </a:cubicBezTo>
                  <a:cubicBezTo>
                    <a:pt x="1232890" y="889213"/>
                    <a:pt x="1238152" y="893929"/>
                    <a:pt x="1241659" y="895501"/>
                  </a:cubicBezTo>
                  <a:cubicBezTo>
                    <a:pt x="1245167" y="897073"/>
                    <a:pt x="1252182" y="897859"/>
                    <a:pt x="1254813" y="903362"/>
                  </a:cubicBezTo>
                  <a:cubicBezTo>
                    <a:pt x="1257444" y="908864"/>
                    <a:pt x="1265336" y="911222"/>
                    <a:pt x="1265336" y="911222"/>
                  </a:cubicBezTo>
                  <a:lnTo>
                    <a:pt x="1286337" y="913140"/>
                  </a:lnTo>
                  <a:cubicBezTo>
                    <a:pt x="1289487" y="909901"/>
                    <a:pt x="1298393" y="907071"/>
                    <a:pt x="1301770" y="904619"/>
                  </a:cubicBezTo>
                  <a:cubicBezTo>
                    <a:pt x="1305250" y="902072"/>
                    <a:pt x="1333266" y="879340"/>
                    <a:pt x="1334809" y="877234"/>
                  </a:cubicBezTo>
                  <a:lnTo>
                    <a:pt x="1338608" y="870159"/>
                  </a:lnTo>
                  <a:cubicBezTo>
                    <a:pt x="1342996" y="862016"/>
                    <a:pt x="1347325" y="853841"/>
                    <a:pt x="1351674" y="845667"/>
                  </a:cubicBezTo>
                  <a:cubicBezTo>
                    <a:pt x="1352106" y="844849"/>
                    <a:pt x="1353169" y="843811"/>
                    <a:pt x="1353775" y="843088"/>
                  </a:cubicBezTo>
                  <a:lnTo>
                    <a:pt x="1352436" y="835951"/>
                  </a:lnTo>
                  <a:cubicBezTo>
                    <a:pt x="1350678" y="826582"/>
                    <a:pt x="1356490" y="821614"/>
                    <a:pt x="1360145" y="813533"/>
                  </a:cubicBezTo>
                  <a:cubicBezTo>
                    <a:pt x="1361899" y="809635"/>
                    <a:pt x="1359833" y="797467"/>
                    <a:pt x="1359591" y="794700"/>
                  </a:cubicBezTo>
                  <a:cubicBezTo>
                    <a:pt x="1359412" y="792656"/>
                    <a:pt x="1356585" y="776905"/>
                    <a:pt x="1356189" y="771245"/>
                  </a:cubicBezTo>
                  <a:cubicBezTo>
                    <a:pt x="1355512" y="761467"/>
                    <a:pt x="1357276" y="751720"/>
                    <a:pt x="1356276" y="741847"/>
                  </a:cubicBezTo>
                  <a:cubicBezTo>
                    <a:pt x="1358349" y="735779"/>
                    <a:pt x="1368690" y="732981"/>
                    <a:pt x="1373931" y="729931"/>
                  </a:cubicBezTo>
                  <a:cubicBezTo>
                    <a:pt x="1376105" y="728642"/>
                    <a:pt x="1377894" y="726598"/>
                    <a:pt x="1380034" y="725278"/>
                  </a:cubicBezTo>
                  <a:cubicBezTo>
                    <a:pt x="1384068" y="722699"/>
                    <a:pt x="1395012" y="716694"/>
                    <a:pt x="1399361" y="71452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54" name="자유형: 도형 295"/>
            <p:cNvSpPr/>
            <p:nvPr/>
          </p:nvSpPr>
          <p:spPr>
            <a:xfrm>
              <a:off x="7879680" y="182160"/>
              <a:ext cx="495720" cy="511560"/>
            </a:xfrm>
            <a:custGeom>
              <a:avLst/>
              <a:gdLst/>
              <a:ahLst/>
              <a:cxnLst/>
              <a:rect l="l" t="t" r="r" b="b"/>
              <a:pathLst>
                <a:path w="392815" h="416677">
                  <a:moveTo>
                    <a:pt x="213295" y="410232"/>
                  </a:moveTo>
                  <a:cubicBezTo>
                    <a:pt x="216252" y="410327"/>
                    <a:pt x="219574" y="411081"/>
                    <a:pt x="222531" y="411459"/>
                  </a:cubicBezTo>
                  <a:cubicBezTo>
                    <a:pt x="222752" y="411490"/>
                    <a:pt x="230921" y="415137"/>
                    <a:pt x="234085" y="416018"/>
                  </a:cubicBezTo>
                  <a:cubicBezTo>
                    <a:pt x="234271" y="416049"/>
                    <a:pt x="240322" y="416678"/>
                    <a:pt x="240561" y="416678"/>
                  </a:cubicBezTo>
                  <a:cubicBezTo>
                    <a:pt x="244142" y="416552"/>
                    <a:pt x="263508" y="414288"/>
                    <a:pt x="266542" y="413251"/>
                  </a:cubicBezTo>
                  <a:cubicBezTo>
                    <a:pt x="266837" y="413157"/>
                    <a:pt x="275841" y="409038"/>
                    <a:pt x="275950" y="408944"/>
                  </a:cubicBezTo>
                  <a:cubicBezTo>
                    <a:pt x="281723" y="404950"/>
                    <a:pt x="287265" y="399605"/>
                    <a:pt x="292667" y="395141"/>
                  </a:cubicBezTo>
                  <a:cubicBezTo>
                    <a:pt x="292755" y="395078"/>
                    <a:pt x="297399" y="393663"/>
                    <a:pt x="297824" y="393537"/>
                  </a:cubicBezTo>
                  <a:cubicBezTo>
                    <a:pt x="303713" y="395832"/>
                    <a:pt x="310174" y="393883"/>
                    <a:pt x="315779" y="395927"/>
                  </a:cubicBezTo>
                  <a:cubicBezTo>
                    <a:pt x="322269" y="394480"/>
                    <a:pt x="323370" y="390204"/>
                    <a:pt x="327597" y="387029"/>
                  </a:cubicBezTo>
                  <a:cubicBezTo>
                    <a:pt x="330354" y="384954"/>
                    <a:pt x="334310" y="383759"/>
                    <a:pt x="337082" y="381715"/>
                  </a:cubicBezTo>
                  <a:cubicBezTo>
                    <a:pt x="339428" y="379954"/>
                    <a:pt x="346047" y="373760"/>
                    <a:pt x="347601" y="371120"/>
                  </a:cubicBezTo>
                  <a:cubicBezTo>
                    <a:pt x="357205" y="368950"/>
                    <a:pt x="359804" y="366686"/>
                    <a:pt x="366087" y="360398"/>
                  </a:cubicBezTo>
                  <a:cubicBezTo>
                    <a:pt x="366185" y="360304"/>
                    <a:pt x="378732" y="354801"/>
                    <a:pt x="379233" y="354455"/>
                  </a:cubicBezTo>
                  <a:cubicBezTo>
                    <a:pt x="379486" y="354298"/>
                    <a:pt x="383137" y="349739"/>
                    <a:pt x="384151" y="348325"/>
                  </a:cubicBezTo>
                  <a:cubicBezTo>
                    <a:pt x="386670" y="344835"/>
                    <a:pt x="389795" y="340370"/>
                    <a:pt x="392815" y="337257"/>
                  </a:cubicBezTo>
                  <a:lnTo>
                    <a:pt x="371815" y="335308"/>
                  </a:lnTo>
                  <a:cubicBezTo>
                    <a:pt x="371815" y="335308"/>
                    <a:pt x="363922" y="332950"/>
                    <a:pt x="361292" y="327447"/>
                  </a:cubicBezTo>
                  <a:cubicBezTo>
                    <a:pt x="358661" y="321945"/>
                    <a:pt x="351645" y="321159"/>
                    <a:pt x="348138" y="319587"/>
                  </a:cubicBezTo>
                  <a:cubicBezTo>
                    <a:pt x="344630" y="318015"/>
                    <a:pt x="339369" y="313299"/>
                    <a:pt x="336738" y="309369"/>
                  </a:cubicBezTo>
                  <a:cubicBezTo>
                    <a:pt x="334107" y="305439"/>
                    <a:pt x="334984" y="297578"/>
                    <a:pt x="335861" y="290504"/>
                  </a:cubicBezTo>
                  <a:cubicBezTo>
                    <a:pt x="336738" y="283430"/>
                    <a:pt x="327092" y="277141"/>
                    <a:pt x="320076" y="273211"/>
                  </a:cubicBezTo>
                  <a:cubicBezTo>
                    <a:pt x="313061" y="269281"/>
                    <a:pt x="299907" y="261421"/>
                    <a:pt x="291138" y="255132"/>
                  </a:cubicBezTo>
                  <a:cubicBezTo>
                    <a:pt x="282369" y="248844"/>
                    <a:pt x="285876" y="233909"/>
                    <a:pt x="288507" y="229193"/>
                  </a:cubicBezTo>
                  <a:cubicBezTo>
                    <a:pt x="291138" y="224477"/>
                    <a:pt x="298153" y="217403"/>
                    <a:pt x="298153" y="217403"/>
                  </a:cubicBezTo>
                  <a:cubicBezTo>
                    <a:pt x="298153" y="217403"/>
                    <a:pt x="298153" y="185961"/>
                    <a:pt x="298153" y="178101"/>
                  </a:cubicBezTo>
                  <a:cubicBezTo>
                    <a:pt x="298153" y="170241"/>
                    <a:pt x="299907" y="163166"/>
                    <a:pt x="303415" y="157664"/>
                  </a:cubicBezTo>
                  <a:cubicBezTo>
                    <a:pt x="306922" y="152162"/>
                    <a:pt x="306046" y="127795"/>
                    <a:pt x="305169" y="123865"/>
                  </a:cubicBezTo>
                  <a:cubicBezTo>
                    <a:pt x="304292" y="119935"/>
                    <a:pt x="277984" y="46833"/>
                    <a:pt x="276230" y="41331"/>
                  </a:cubicBezTo>
                  <a:cubicBezTo>
                    <a:pt x="274476" y="35829"/>
                    <a:pt x="266584" y="29541"/>
                    <a:pt x="257815" y="24825"/>
                  </a:cubicBezTo>
                  <a:cubicBezTo>
                    <a:pt x="249046" y="20108"/>
                    <a:pt x="237646" y="20108"/>
                    <a:pt x="234138" y="24825"/>
                  </a:cubicBezTo>
                  <a:cubicBezTo>
                    <a:pt x="230630" y="29541"/>
                    <a:pt x="220107" y="40545"/>
                    <a:pt x="220107" y="40545"/>
                  </a:cubicBezTo>
                  <a:lnTo>
                    <a:pt x="187661" y="41331"/>
                  </a:lnTo>
                  <a:cubicBezTo>
                    <a:pt x="187661" y="41331"/>
                    <a:pt x="178892" y="31899"/>
                    <a:pt x="176261" y="20108"/>
                  </a:cubicBezTo>
                  <a:cubicBezTo>
                    <a:pt x="173630" y="8318"/>
                    <a:pt x="151707" y="15392"/>
                    <a:pt x="142938" y="16964"/>
                  </a:cubicBezTo>
                  <a:cubicBezTo>
                    <a:pt x="134169" y="18536"/>
                    <a:pt x="121892" y="15392"/>
                    <a:pt x="115754" y="9890"/>
                  </a:cubicBezTo>
                  <a:cubicBezTo>
                    <a:pt x="109615" y="4388"/>
                    <a:pt x="99092" y="3602"/>
                    <a:pt x="92954" y="4388"/>
                  </a:cubicBezTo>
                  <a:cubicBezTo>
                    <a:pt x="86815" y="5174"/>
                    <a:pt x="73661" y="5960"/>
                    <a:pt x="64015" y="1244"/>
                  </a:cubicBezTo>
                  <a:cubicBezTo>
                    <a:pt x="54369" y="-3473"/>
                    <a:pt x="35954" y="6746"/>
                    <a:pt x="35954" y="6746"/>
                  </a:cubicBezTo>
                  <a:lnTo>
                    <a:pt x="1754" y="24825"/>
                  </a:lnTo>
                  <a:lnTo>
                    <a:pt x="0" y="52336"/>
                  </a:lnTo>
                  <a:cubicBezTo>
                    <a:pt x="0" y="52336"/>
                    <a:pt x="4385" y="62554"/>
                    <a:pt x="7892" y="68056"/>
                  </a:cubicBezTo>
                  <a:cubicBezTo>
                    <a:pt x="11400" y="73559"/>
                    <a:pt x="10523" y="80633"/>
                    <a:pt x="10523" y="80633"/>
                  </a:cubicBezTo>
                  <a:cubicBezTo>
                    <a:pt x="10523" y="80633"/>
                    <a:pt x="29815" y="98712"/>
                    <a:pt x="32446" y="101856"/>
                  </a:cubicBezTo>
                  <a:cubicBezTo>
                    <a:pt x="35077" y="105000"/>
                    <a:pt x="43846" y="111288"/>
                    <a:pt x="54369" y="112074"/>
                  </a:cubicBezTo>
                  <a:cubicBezTo>
                    <a:pt x="64892" y="112860"/>
                    <a:pt x="71908" y="123865"/>
                    <a:pt x="78046" y="132511"/>
                  </a:cubicBezTo>
                  <a:cubicBezTo>
                    <a:pt x="84184" y="141158"/>
                    <a:pt x="89446" y="140371"/>
                    <a:pt x="94708" y="140371"/>
                  </a:cubicBezTo>
                  <a:cubicBezTo>
                    <a:pt x="99969" y="140371"/>
                    <a:pt x="120138" y="139585"/>
                    <a:pt x="123646" y="139585"/>
                  </a:cubicBezTo>
                  <a:cubicBezTo>
                    <a:pt x="127154" y="139585"/>
                    <a:pt x="136800" y="144302"/>
                    <a:pt x="136800" y="144302"/>
                  </a:cubicBezTo>
                  <a:cubicBezTo>
                    <a:pt x="136800" y="144302"/>
                    <a:pt x="147323" y="153734"/>
                    <a:pt x="152584" y="156878"/>
                  </a:cubicBezTo>
                  <a:cubicBezTo>
                    <a:pt x="157846" y="160022"/>
                    <a:pt x="155215" y="172599"/>
                    <a:pt x="155215" y="182031"/>
                  </a:cubicBezTo>
                  <a:cubicBezTo>
                    <a:pt x="155215" y="191464"/>
                    <a:pt x="149077" y="197752"/>
                    <a:pt x="149077" y="197752"/>
                  </a:cubicBezTo>
                  <a:lnTo>
                    <a:pt x="130661" y="220547"/>
                  </a:lnTo>
                  <a:cubicBezTo>
                    <a:pt x="130661" y="220547"/>
                    <a:pt x="121892" y="230765"/>
                    <a:pt x="114877" y="233909"/>
                  </a:cubicBezTo>
                  <a:cubicBezTo>
                    <a:pt x="107861" y="237054"/>
                    <a:pt x="108738" y="249630"/>
                    <a:pt x="111369" y="259063"/>
                  </a:cubicBezTo>
                  <a:cubicBezTo>
                    <a:pt x="114000" y="268495"/>
                    <a:pt x="114000" y="272425"/>
                    <a:pt x="114000" y="278713"/>
                  </a:cubicBezTo>
                  <a:cubicBezTo>
                    <a:pt x="114000" y="285002"/>
                    <a:pt x="120138" y="288932"/>
                    <a:pt x="124523" y="291290"/>
                  </a:cubicBezTo>
                  <a:cubicBezTo>
                    <a:pt x="128907" y="293648"/>
                    <a:pt x="137677" y="297578"/>
                    <a:pt x="144692" y="296792"/>
                  </a:cubicBezTo>
                  <a:cubicBezTo>
                    <a:pt x="151707" y="296006"/>
                    <a:pt x="164861" y="292076"/>
                    <a:pt x="170123" y="290504"/>
                  </a:cubicBezTo>
                  <a:cubicBezTo>
                    <a:pt x="175384" y="288932"/>
                    <a:pt x="186784" y="296006"/>
                    <a:pt x="190292" y="300722"/>
                  </a:cubicBezTo>
                  <a:cubicBezTo>
                    <a:pt x="193800" y="305439"/>
                    <a:pt x="211338" y="304652"/>
                    <a:pt x="211338" y="304652"/>
                  </a:cubicBezTo>
                  <a:lnTo>
                    <a:pt x="224492" y="320373"/>
                  </a:lnTo>
                  <a:cubicBezTo>
                    <a:pt x="224492" y="320373"/>
                    <a:pt x="217476" y="332164"/>
                    <a:pt x="214846" y="336094"/>
                  </a:cubicBezTo>
                  <a:cubicBezTo>
                    <a:pt x="212215" y="340024"/>
                    <a:pt x="212215" y="351028"/>
                    <a:pt x="212215" y="354959"/>
                  </a:cubicBezTo>
                  <a:cubicBezTo>
                    <a:pt x="212215" y="358889"/>
                    <a:pt x="213295" y="410232"/>
                    <a:pt x="213295" y="41023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55" name="자유형: 도형 296"/>
            <p:cNvSpPr/>
            <p:nvPr/>
          </p:nvSpPr>
          <p:spPr>
            <a:xfrm>
              <a:off x="4639680" y="255240"/>
              <a:ext cx="1863360" cy="1132200"/>
            </a:xfrm>
            <a:custGeom>
              <a:avLst/>
              <a:gdLst/>
              <a:ahLst/>
              <a:cxnLst/>
              <a:rect l="l" t="t" r="r" b="b"/>
              <a:pathLst>
                <a:path w="1475462" h="921828">
                  <a:moveTo>
                    <a:pt x="1432560" y="608767"/>
                  </a:moveTo>
                  <a:cubicBezTo>
                    <a:pt x="1431542" y="610151"/>
                    <a:pt x="1431557" y="612068"/>
                    <a:pt x="1431395" y="613640"/>
                  </a:cubicBezTo>
                  <a:cubicBezTo>
                    <a:pt x="1430283" y="624362"/>
                    <a:pt x="1443826" y="627915"/>
                    <a:pt x="1446191" y="636907"/>
                  </a:cubicBezTo>
                  <a:cubicBezTo>
                    <a:pt x="1444609" y="644044"/>
                    <a:pt x="1435352" y="648100"/>
                    <a:pt x="1433777" y="655237"/>
                  </a:cubicBezTo>
                  <a:lnTo>
                    <a:pt x="1434545" y="658193"/>
                  </a:lnTo>
                  <a:lnTo>
                    <a:pt x="1436078" y="664135"/>
                  </a:lnTo>
                  <a:cubicBezTo>
                    <a:pt x="1435836" y="666494"/>
                    <a:pt x="1435047" y="667720"/>
                    <a:pt x="1434391" y="669983"/>
                  </a:cubicBezTo>
                  <a:cubicBezTo>
                    <a:pt x="1431893" y="678661"/>
                    <a:pt x="1427961" y="686993"/>
                    <a:pt x="1432623" y="695577"/>
                  </a:cubicBezTo>
                  <a:cubicBezTo>
                    <a:pt x="1436352" y="698658"/>
                    <a:pt x="1443511" y="701079"/>
                    <a:pt x="1448271" y="702274"/>
                  </a:cubicBezTo>
                  <a:lnTo>
                    <a:pt x="1451494" y="706707"/>
                  </a:lnTo>
                  <a:lnTo>
                    <a:pt x="1442529" y="731514"/>
                  </a:lnTo>
                  <a:cubicBezTo>
                    <a:pt x="1442160" y="731200"/>
                    <a:pt x="1441775" y="730948"/>
                    <a:pt x="1441378" y="730728"/>
                  </a:cubicBezTo>
                  <a:cubicBezTo>
                    <a:pt x="1431841" y="728087"/>
                    <a:pt x="1426663" y="730005"/>
                    <a:pt x="1417799" y="732300"/>
                  </a:cubicBezTo>
                  <a:cubicBezTo>
                    <a:pt x="1414320" y="733180"/>
                    <a:pt x="1410381" y="733055"/>
                    <a:pt x="1406863" y="733841"/>
                  </a:cubicBezTo>
                  <a:cubicBezTo>
                    <a:pt x="1404260" y="734438"/>
                    <a:pt x="1380990" y="743713"/>
                    <a:pt x="1378426" y="745097"/>
                  </a:cubicBezTo>
                  <a:cubicBezTo>
                    <a:pt x="1377142" y="745789"/>
                    <a:pt x="1376002" y="747392"/>
                    <a:pt x="1374778" y="748241"/>
                  </a:cubicBezTo>
                  <a:cubicBezTo>
                    <a:pt x="1365019" y="754907"/>
                    <a:pt x="1326214" y="774652"/>
                    <a:pt x="1314982" y="774903"/>
                  </a:cubicBezTo>
                  <a:cubicBezTo>
                    <a:pt x="1311418" y="774966"/>
                    <a:pt x="1305988" y="773645"/>
                    <a:pt x="1303070" y="771759"/>
                  </a:cubicBezTo>
                  <a:cubicBezTo>
                    <a:pt x="1302337" y="769244"/>
                    <a:pt x="1299657" y="765880"/>
                    <a:pt x="1297237" y="764433"/>
                  </a:cubicBezTo>
                  <a:cubicBezTo>
                    <a:pt x="1288927" y="765691"/>
                    <a:pt x="1283108" y="765659"/>
                    <a:pt x="1275198" y="769055"/>
                  </a:cubicBezTo>
                  <a:cubicBezTo>
                    <a:pt x="1272701" y="770124"/>
                    <a:pt x="1269971" y="772262"/>
                    <a:pt x="1267583" y="773080"/>
                  </a:cubicBezTo>
                  <a:cubicBezTo>
                    <a:pt x="1265948" y="773614"/>
                    <a:pt x="1263654" y="773331"/>
                    <a:pt x="1261992" y="773866"/>
                  </a:cubicBezTo>
                  <a:cubicBezTo>
                    <a:pt x="1255871" y="775784"/>
                    <a:pt x="1250897" y="781034"/>
                    <a:pt x="1244246" y="782764"/>
                  </a:cubicBezTo>
                  <a:cubicBezTo>
                    <a:pt x="1238795" y="784147"/>
                    <a:pt x="1233460" y="783644"/>
                    <a:pt x="1228206" y="786159"/>
                  </a:cubicBezTo>
                  <a:cubicBezTo>
                    <a:pt x="1222748" y="796755"/>
                    <a:pt x="1238606" y="814834"/>
                    <a:pt x="1240844" y="825367"/>
                  </a:cubicBezTo>
                  <a:cubicBezTo>
                    <a:pt x="1241166" y="826876"/>
                    <a:pt x="1240647" y="828794"/>
                    <a:pt x="1240844" y="830334"/>
                  </a:cubicBezTo>
                  <a:cubicBezTo>
                    <a:pt x="1241229" y="833416"/>
                    <a:pt x="1242959" y="836654"/>
                    <a:pt x="1243032" y="839735"/>
                  </a:cubicBezTo>
                  <a:cubicBezTo>
                    <a:pt x="1243159" y="845049"/>
                    <a:pt x="1242317" y="851306"/>
                    <a:pt x="1241086" y="856462"/>
                  </a:cubicBezTo>
                  <a:cubicBezTo>
                    <a:pt x="1240247" y="860015"/>
                    <a:pt x="1239686" y="863976"/>
                    <a:pt x="1236224" y="866397"/>
                  </a:cubicBezTo>
                  <a:cubicBezTo>
                    <a:pt x="1233200" y="867152"/>
                    <a:pt x="1228865" y="867498"/>
                    <a:pt x="1225775" y="866932"/>
                  </a:cubicBezTo>
                  <a:cubicBezTo>
                    <a:pt x="1219724" y="865832"/>
                    <a:pt x="1197938" y="860832"/>
                    <a:pt x="1193444" y="858569"/>
                  </a:cubicBezTo>
                  <a:cubicBezTo>
                    <a:pt x="1186885" y="848067"/>
                    <a:pt x="1198797" y="837754"/>
                    <a:pt x="1194661" y="827442"/>
                  </a:cubicBezTo>
                  <a:cubicBezTo>
                    <a:pt x="1182413" y="821908"/>
                    <a:pt x="1181774" y="806093"/>
                    <a:pt x="1164278" y="812035"/>
                  </a:cubicBezTo>
                  <a:lnTo>
                    <a:pt x="1158687" y="809677"/>
                  </a:lnTo>
                  <a:lnTo>
                    <a:pt x="1156014" y="806030"/>
                  </a:lnTo>
                  <a:cubicBezTo>
                    <a:pt x="1155400" y="792196"/>
                    <a:pt x="1158932" y="777230"/>
                    <a:pt x="1157227" y="763647"/>
                  </a:cubicBezTo>
                  <a:cubicBezTo>
                    <a:pt x="1156645" y="759025"/>
                    <a:pt x="1154674" y="754215"/>
                    <a:pt x="1153825" y="749530"/>
                  </a:cubicBezTo>
                  <a:lnTo>
                    <a:pt x="1148963" y="747958"/>
                  </a:lnTo>
                  <a:cubicBezTo>
                    <a:pt x="1137714" y="752580"/>
                    <a:pt x="1140741" y="765219"/>
                    <a:pt x="1127328" y="768364"/>
                  </a:cubicBezTo>
                  <a:cubicBezTo>
                    <a:pt x="1116647" y="764968"/>
                    <a:pt x="1115139" y="741481"/>
                    <a:pt x="1105454" y="733055"/>
                  </a:cubicBezTo>
                  <a:cubicBezTo>
                    <a:pt x="1100726" y="728967"/>
                    <a:pt x="1094622" y="726766"/>
                    <a:pt x="1089413" y="723402"/>
                  </a:cubicBezTo>
                  <a:lnTo>
                    <a:pt x="1088926" y="719221"/>
                  </a:lnTo>
                  <a:lnTo>
                    <a:pt x="1092570" y="716328"/>
                  </a:lnTo>
                  <a:lnTo>
                    <a:pt x="1088926" y="713184"/>
                  </a:lnTo>
                  <a:cubicBezTo>
                    <a:pt x="1080770" y="710952"/>
                    <a:pt x="1064295" y="717460"/>
                    <a:pt x="1060728" y="724440"/>
                  </a:cubicBezTo>
                  <a:lnTo>
                    <a:pt x="1060973" y="729408"/>
                  </a:lnTo>
                  <a:cubicBezTo>
                    <a:pt x="1064340" y="737111"/>
                    <a:pt x="1080448" y="738557"/>
                    <a:pt x="1087467" y="746386"/>
                  </a:cubicBezTo>
                  <a:cubicBezTo>
                    <a:pt x="1087789" y="746763"/>
                    <a:pt x="1089975" y="749719"/>
                    <a:pt x="1090143" y="750064"/>
                  </a:cubicBezTo>
                  <a:cubicBezTo>
                    <a:pt x="1092791" y="755756"/>
                    <a:pt x="1091213" y="763050"/>
                    <a:pt x="1093545" y="769150"/>
                  </a:cubicBezTo>
                  <a:cubicBezTo>
                    <a:pt x="1094605" y="771916"/>
                    <a:pt x="1096815" y="774589"/>
                    <a:pt x="1097432" y="777513"/>
                  </a:cubicBezTo>
                  <a:cubicBezTo>
                    <a:pt x="1098105" y="780688"/>
                    <a:pt x="1097456" y="784681"/>
                    <a:pt x="1095005" y="787197"/>
                  </a:cubicBezTo>
                  <a:cubicBezTo>
                    <a:pt x="1085313" y="784367"/>
                    <a:pt x="1085313" y="777293"/>
                    <a:pt x="1070696" y="774652"/>
                  </a:cubicBezTo>
                  <a:cubicBezTo>
                    <a:pt x="1054473" y="771665"/>
                    <a:pt x="1051794" y="780909"/>
                    <a:pt x="1035939" y="772545"/>
                  </a:cubicBezTo>
                  <a:cubicBezTo>
                    <a:pt x="1031459" y="762610"/>
                    <a:pt x="1028288" y="747518"/>
                    <a:pt x="1017951" y="740915"/>
                  </a:cubicBezTo>
                  <a:cubicBezTo>
                    <a:pt x="1014865" y="738934"/>
                    <a:pt x="1010953" y="737677"/>
                    <a:pt x="1007740" y="735664"/>
                  </a:cubicBezTo>
                  <a:cubicBezTo>
                    <a:pt x="1004994" y="730319"/>
                    <a:pt x="1000616" y="720007"/>
                    <a:pt x="996558" y="715793"/>
                  </a:cubicBezTo>
                  <a:cubicBezTo>
                    <a:pt x="989322" y="708310"/>
                    <a:pt x="978062" y="701048"/>
                    <a:pt x="975656" y="690703"/>
                  </a:cubicBezTo>
                  <a:cubicBezTo>
                    <a:pt x="974951" y="687685"/>
                    <a:pt x="975410" y="684226"/>
                    <a:pt x="974684" y="681051"/>
                  </a:cubicBezTo>
                  <a:lnTo>
                    <a:pt x="968609" y="679982"/>
                  </a:lnTo>
                  <a:cubicBezTo>
                    <a:pt x="965126" y="682088"/>
                    <a:pt x="958966" y="681837"/>
                    <a:pt x="955402" y="680265"/>
                  </a:cubicBezTo>
                  <a:cubicBezTo>
                    <a:pt x="944953" y="675643"/>
                    <a:pt x="943164" y="665582"/>
                    <a:pt x="945518" y="655929"/>
                  </a:cubicBezTo>
                  <a:cubicBezTo>
                    <a:pt x="946454" y="652093"/>
                    <a:pt x="948580" y="648446"/>
                    <a:pt x="949404" y="644453"/>
                  </a:cubicBezTo>
                  <a:cubicBezTo>
                    <a:pt x="944164" y="635398"/>
                    <a:pt x="929554" y="636970"/>
                    <a:pt x="920238" y="634486"/>
                  </a:cubicBezTo>
                  <a:cubicBezTo>
                    <a:pt x="916983" y="633637"/>
                    <a:pt x="911633" y="631656"/>
                    <a:pt x="908571" y="630305"/>
                  </a:cubicBezTo>
                  <a:cubicBezTo>
                    <a:pt x="906972" y="629613"/>
                    <a:pt x="905565" y="628103"/>
                    <a:pt x="903955" y="627443"/>
                  </a:cubicBezTo>
                  <a:cubicBezTo>
                    <a:pt x="894267" y="623513"/>
                    <a:pt x="874147" y="626720"/>
                    <a:pt x="865549" y="632159"/>
                  </a:cubicBezTo>
                  <a:lnTo>
                    <a:pt x="859474" y="632159"/>
                  </a:lnTo>
                  <a:cubicBezTo>
                    <a:pt x="855700" y="629959"/>
                    <a:pt x="855977" y="627758"/>
                    <a:pt x="853883" y="625085"/>
                  </a:cubicBezTo>
                  <a:cubicBezTo>
                    <a:pt x="853318" y="624362"/>
                    <a:pt x="838600" y="614049"/>
                    <a:pt x="837842" y="613861"/>
                  </a:cubicBezTo>
                  <a:cubicBezTo>
                    <a:pt x="829873" y="611597"/>
                    <a:pt x="820868" y="614112"/>
                    <a:pt x="812320" y="611219"/>
                  </a:cubicBezTo>
                  <a:cubicBezTo>
                    <a:pt x="809935" y="609616"/>
                    <a:pt x="807290" y="606220"/>
                    <a:pt x="806487" y="603642"/>
                  </a:cubicBezTo>
                  <a:lnTo>
                    <a:pt x="801871" y="602353"/>
                  </a:lnTo>
                  <a:lnTo>
                    <a:pt x="794091" y="608610"/>
                  </a:lnTo>
                  <a:cubicBezTo>
                    <a:pt x="789387" y="608578"/>
                    <a:pt x="786307" y="606378"/>
                    <a:pt x="782179" y="605749"/>
                  </a:cubicBezTo>
                  <a:cubicBezTo>
                    <a:pt x="779278" y="605277"/>
                    <a:pt x="776198" y="606503"/>
                    <a:pt x="773189" y="605466"/>
                  </a:cubicBezTo>
                  <a:lnTo>
                    <a:pt x="768811" y="604711"/>
                  </a:lnTo>
                  <a:cubicBezTo>
                    <a:pt x="764816" y="607572"/>
                    <a:pt x="760052" y="609302"/>
                    <a:pt x="755927" y="612005"/>
                  </a:cubicBezTo>
                  <a:cubicBezTo>
                    <a:pt x="754650" y="614364"/>
                    <a:pt x="754566" y="618828"/>
                    <a:pt x="755927" y="621155"/>
                  </a:cubicBezTo>
                  <a:cubicBezTo>
                    <a:pt x="759361" y="624488"/>
                    <a:pt x="763953" y="627443"/>
                    <a:pt x="767110" y="630839"/>
                  </a:cubicBezTo>
                  <a:cubicBezTo>
                    <a:pt x="768194" y="632002"/>
                    <a:pt x="768723" y="633575"/>
                    <a:pt x="769783" y="634769"/>
                  </a:cubicBezTo>
                  <a:cubicBezTo>
                    <a:pt x="772143" y="637410"/>
                    <a:pt x="775265" y="638479"/>
                    <a:pt x="778047" y="640523"/>
                  </a:cubicBezTo>
                  <a:cubicBezTo>
                    <a:pt x="788864" y="648383"/>
                    <a:pt x="793880" y="651245"/>
                    <a:pt x="806971" y="655929"/>
                  </a:cubicBezTo>
                  <a:cubicBezTo>
                    <a:pt x="813636" y="658319"/>
                    <a:pt x="817747" y="660237"/>
                    <a:pt x="825201" y="658570"/>
                  </a:cubicBezTo>
                  <a:cubicBezTo>
                    <a:pt x="831518" y="657124"/>
                    <a:pt x="836513" y="651873"/>
                    <a:pt x="842458" y="649138"/>
                  </a:cubicBezTo>
                  <a:lnTo>
                    <a:pt x="847562" y="650459"/>
                  </a:lnTo>
                  <a:cubicBezTo>
                    <a:pt x="850782" y="656464"/>
                    <a:pt x="843858" y="665613"/>
                    <a:pt x="842700" y="671870"/>
                  </a:cubicBezTo>
                  <a:lnTo>
                    <a:pt x="845619" y="675549"/>
                  </a:lnTo>
                  <a:cubicBezTo>
                    <a:pt x="856675" y="671901"/>
                    <a:pt x="860193" y="669040"/>
                    <a:pt x="873084" y="670832"/>
                  </a:cubicBezTo>
                  <a:lnTo>
                    <a:pt x="874055" y="675549"/>
                  </a:lnTo>
                  <a:cubicBezTo>
                    <a:pt x="872488" y="678378"/>
                    <a:pt x="870800" y="682183"/>
                    <a:pt x="868710" y="684698"/>
                  </a:cubicBezTo>
                  <a:cubicBezTo>
                    <a:pt x="865314" y="688754"/>
                    <a:pt x="860653" y="690294"/>
                    <a:pt x="858502" y="695671"/>
                  </a:cubicBezTo>
                  <a:lnTo>
                    <a:pt x="860446" y="699853"/>
                  </a:lnTo>
                  <a:cubicBezTo>
                    <a:pt x="873729" y="703909"/>
                    <a:pt x="877388" y="696111"/>
                    <a:pt x="887427" y="694382"/>
                  </a:cubicBezTo>
                  <a:lnTo>
                    <a:pt x="890342" y="696740"/>
                  </a:lnTo>
                  <a:cubicBezTo>
                    <a:pt x="889584" y="699475"/>
                    <a:pt x="883298" y="706455"/>
                    <a:pt x="880864" y="708499"/>
                  </a:cubicBezTo>
                  <a:cubicBezTo>
                    <a:pt x="877539" y="711266"/>
                    <a:pt x="849361" y="725540"/>
                    <a:pt x="845131" y="726264"/>
                  </a:cubicBezTo>
                  <a:cubicBezTo>
                    <a:pt x="836569" y="727741"/>
                    <a:pt x="829294" y="723717"/>
                    <a:pt x="822766" y="719472"/>
                  </a:cubicBezTo>
                  <a:cubicBezTo>
                    <a:pt x="821107" y="714064"/>
                    <a:pt x="808662" y="701456"/>
                    <a:pt x="803081" y="699067"/>
                  </a:cubicBezTo>
                  <a:lnTo>
                    <a:pt x="799433" y="702211"/>
                  </a:lnTo>
                  <a:cubicBezTo>
                    <a:pt x="797672" y="706550"/>
                    <a:pt x="796697" y="713907"/>
                    <a:pt x="798219" y="718435"/>
                  </a:cubicBezTo>
                  <a:cubicBezTo>
                    <a:pt x="799636" y="722616"/>
                    <a:pt x="803348" y="726326"/>
                    <a:pt x="805266" y="730445"/>
                  </a:cubicBezTo>
                  <a:cubicBezTo>
                    <a:pt x="806487" y="733055"/>
                    <a:pt x="807760" y="736262"/>
                    <a:pt x="808185" y="739060"/>
                  </a:cubicBezTo>
                  <a:cubicBezTo>
                    <a:pt x="809153" y="745506"/>
                    <a:pt x="808444" y="750442"/>
                    <a:pt x="811022" y="756761"/>
                  </a:cubicBezTo>
                  <a:cubicBezTo>
                    <a:pt x="811812" y="758711"/>
                    <a:pt x="811563" y="757673"/>
                    <a:pt x="811671" y="759906"/>
                  </a:cubicBezTo>
                  <a:lnTo>
                    <a:pt x="811833" y="763396"/>
                  </a:lnTo>
                  <a:cubicBezTo>
                    <a:pt x="811727" y="763867"/>
                    <a:pt x="809746" y="767200"/>
                    <a:pt x="809405" y="767829"/>
                  </a:cubicBezTo>
                  <a:lnTo>
                    <a:pt x="803814" y="768866"/>
                  </a:lnTo>
                  <a:lnTo>
                    <a:pt x="800166" y="772010"/>
                  </a:lnTo>
                  <a:cubicBezTo>
                    <a:pt x="798753" y="774777"/>
                    <a:pt x="798311" y="778991"/>
                    <a:pt x="798953" y="781946"/>
                  </a:cubicBezTo>
                  <a:cubicBezTo>
                    <a:pt x="801597" y="786505"/>
                    <a:pt x="808490" y="788580"/>
                    <a:pt x="813534" y="790310"/>
                  </a:cubicBezTo>
                  <a:cubicBezTo>
                    <a:pt x="813253" y="793328"/>
                    <a:pt x="811264" y="798170"/>
                    <a:pt x="808672" y="800245"/>
                  </a:cubicBezTo>
                  <a:cubicBezTo>
                    <a:pt x="801043" y="803546"/>
                    <a:pt x="795297" y="803578"/>
                    <a:pt x="787037" y="803924"/>
                  </a:cubicBezTo>
                  <a:lnTo>
                    <a:pt x="784610" y="809143"/>
                  </a:lnTo>
                  <a:cubicBezTo>
                    <a:pt x="787423" y="815651"/>
                    <a:pt x="791548" y="818858"/>
                    <a:pt x="797006" y="823511"/>
                  </a:cubicBezTo>
                  <a:cubicBezTo>
                    <a:pt x="797265" y="827882"/>
                    <a:pt x="794915" y="830020"/>
                    <a:pt x="793600" y="833730"/>
                  </a:cubicBezTo>
                  <a:cubicBezTo>
                    <a:pt x="791839" y="838698"/>
                    <a:pt x="792263" y="844986"/>
                    <a:pt x="785094" y="846778"/>
                  </a:cubicBezTo>
                  <a:cubicBezTo>
                    <a:pt x="778853" y="847187"/>
                    <a:pt x="760193" y="839044"/>
                    <a:pt x="756166" y="834768"/>
                  </a:cubicBezTo>
                  <a:cubicBezTo>
                    <a:pt x="758814" y="833353"/>
                    <a:pt x="761227" y="829108"/>
                    <a:pt x="761273" y="826404"/>
                  </a:cubicBezTo>
                  <a:lnTo>
                    <a:pt x="754468" y="826153"/>
                  </a:lnTo>
                  <a:cubicBezTo>
                    <a:pt x="751532" y="824392"/>
                    <a:pt x="748694" y="822348"/>
                    <a:pt x="746204" y="820116"/>
                  </a:cubicBezTo>
                  <a:lnTo>
                    <a:pt x="741342" y="819864"/>
                  </a:lnTo>
                  <a:cubicBezTo>
                    <a:pt x="736575" y="826750"/>
                    <a:pt x="730451" y="826781"/>
                    <a:pt x="730893" y="837126"/>
                  </a:cubicBezTo>
                  <a:cubicBezTo>
                    <a:pt x="727852" y="838100"/>
                    <a:pt x="722699" y="837880"/>
                    <a:pt x="719710" y="836843"/>
                  </a:cubicBezTo>
                  <a:cubicBezTo>
                    <a:pt x="717223" y="832912"/>
                    <a:pt x="712534" y="830680"/>
                    <a:pt x="711201" y="826153"/>
                  </a:cubicBezTo>
                  <a:cubicBezTo>
                    <a:pt x="711397" y="823071"/>
                    <a:pt x="713172" y="819078"/>
                    <a:pt x="715333" y="816720"/>
                  </a:cubicBezTo>
                  <a:lnTo>
                    <a:pt x="713877" y="813073"/>
                  </a:lnTo>
                  <a:cubicBezTo>
                    <a:pt x="704652" y="814928"/>
                    <a:pt x="701656" y="823763"/>
                    <a:pt x="694918" y="828762"/>
                  </a:cubicBezTo>
                  <a:lnTo>
                    <a:pt x="693459" y="835019"/>
                  </a:lnTo>
                  <a:lnTo>
                    <a:pt x="695406" y="838949"/>
                  </a:lnTo>
                  <a:cubicBezTo>
                    <a:pt x="694497" y="844546"/>
                    <a:pt x="688517" y="850582"/>
                    <a:pt x="686166" y="856462"/>
                  </a:cubicBezTo>
                  <a:cubicBezTo>
                    <a:pt x="682845" y="864794"/>
                    <a:pt x="680344" y="874855"/>
                    <a:pt x="672069" y="880515"/>
                  </a:cubicBezTo>
                  <a:cubicBezTo>
                    <a:pt x="662672" y="886960"/>
                    <a:pt x="647396" y="880012"/>
                    <a:pt x="636094" y="880515"/>
                  </a:cubicBezTo>
                  <a:cubicBezTo>
                    <a:pt x="632548" y="880672"/>
                    <a:pt x="628784" y="882087"/>
                    <a:pt x="625154" y="882338"/>
                  </a:cubicBezTo>
                  <a:cubicBezTo>
                    <a:pt x="619387" y="882747"/>
                    <a:pt x="612547" y="881772"/>
                    <a:pt x="606928" y="882873"/>
                  </a:cubicBezTo>
                  <a:cubicBezTo>
                    <a:pt x="600470" y="884130"/>
                    <a:pt x="587050" y="895826"/>
                    <a:pt x="584075" y="900920"/>
                  </a:cubicBezTo>
                  <a:cubicBezTo>
                    <a:pt x="582020" y="904410"/>
                    <a:pt x="581627" y="908780"/>
                    <a:pt x="579943" y="912396"/>
                  </a:cubicBezTo>
                  <a:cubicBezTo>
                    <a:pt x="578501" y="915509"/>
                    <a:pt x="576050" y="918339"/>
                    <a:pt x="574597" y="921577"/>
                  </a:cubicBezTo>
                  <a:cubicBezTo>
                    <a:pt x="571476" y="921168"/>
                    <a:pt x="567715" y="921200"/>
                    <a:pt x="564632" y="921829"/>
                  </a:cubicBezTo>
                  <a:cubicBezTo>
                    <a:pt x="562815" y="919376"/>
                    <a:pt x="561258" y="916672"/>
                    <a:pt x="560012" y="913968"/>
                  </a:cubicBezTo>
                  <a:cubicBezTo>
                    <a:pt x="560795" y="909032"/>
                    <a:pt x="562033" y="902429"/>
                    <a:pt x="560984" y="897524"/>
                  </a:cubicBezTo>
                  <a:cubicBezTo>
                    <a:pt x="560044" y="893091"/>
                    <a:pt x="556543" y="889475"/>
                    <a:pt x="555880" y="884697"/>
                  </a:cubicBezTo>
                  <a:cubicBezTo>
                    <a:pt x="557792" y="878565"/>
                    <a:pt x="567828" y="863379"/>
                    <a:pt x="572651" y="858537"/>
                  </a:cubicBezTo>
                  <a:cubicBezTo>
                    <a:pt x="573331" y="857877"/>
                    <a:pt x="576148" y="855991"/>
                    <a:pt x="576537" y="855424"/>
                  </a:cubicBezTo>
                  <a:cubicBezTo>
                    <a:pt x="577000" y="854764"/>
                    <a:pt x="580164" y="846118"/>
                    <a:pt x="580673" y="844703"/>
                  </a:cubicBezTo>
                  <a:lnTo>
                    <a:pt x="585047" y="842345"/>
                  </a:lnTo>
                  <a:cubicBezTo>
                    <a:pt x="592883" y="841276"/>
                    <a:pt x="598246" y="848602"/>
                    <a:pt x="605953" y="848602"/>
                  </a:cubicBezTo>
                  <a:cubicBezTo>
                    <a:pt x="617135" y="848602"/>
                    <a:pt x="641724" y="839641"/>
                    <a:pt x="647519" y="830586"/>
                  </a:cubicBezTo>
                  <a:lnTo>
                    <a:pt x="644600" y="826656"/>
                  </a:lnTo>
                  <a:cubicBezTo>
                    <a:pt x="632302" y="825115"/>
                    <a:pt x="621874" y="832284"/>
                    <a:pt x="610814" y="831372"/>
                  </a:cubicBezTo>
                  <a:cubicBezTo>
                    <a:pt x="604732" y="830837"/>
                    <a:pt x="599990" y="826750"/>
                    <a:pt x="594286" y="825083"/>
                  </a:cubicBezTo>
                  <a:cubicBezTo>
                    <a:pt x="593879" y="820336"/>
                    <a:pt x="596892" y="814236"/>
                    <a:pt x="601575" y="811752"/>
                  </a:cubicBezTo>
                  <a:cubicBezTo>
                    <a:pt x="605630" y="811312"/>
                    <a:pt x="610186" y="811470"/>
                    <a:pt x="614217" y="812004"/>
                  </a:cubicBezTo>
                  <a:cubicBezTo>
                    <a:pt x="617980" y="808231"/>
                    <a:pt x="618166" y="802289"/>
                    <a:pt x="622968" y="799459"/>
                  </a:cubicBezTo>
                  <a:lnTo>
                    <a:pt x="628802" y="800528"/>
                  </a:lnTo>
                  <a:cubicBezTo>
                    <a:pt x="636968" y="796692"/>
                    <a:pt x="645646" y="787951"/>
                    <a:pt x="655779" y="787700"/>
                  </a:cubicBezTo>
                  <a:cubicBezTo>
                    <a:pt x="660915" y="787574"/>
                    <a:pt x="666850" y="789932"/>
                    <a:pt x="672311" y="789806"/>
                  </a:cubicBezTo>
                  <a:cubicBezTo>
                    <a:pt x="676769" y="789712"/>
                    <a:pt x="679642" y="788423"/>
                    <a:pt x="684220" y="790592"/>
                  </a:cubicBezTo>
                  <a:cubicBezTo>
                    <a:pt x="687345" y="792039"/>
                    <a:pt x="691119" y="798642"/>
                    <a:pt x="693701" y="801314"/>
                  </a:cubicBezTo>
                  <a:lnTo>
                    <a:pt x="700022" y="801817"/>
                  </a:lnTo>
                  <a:cubicBezTo>
                    <a:pt x="702568" y="800151"/>
                    <a:pt x="706578" y="798862"/>
                    <a:pt x="708770" y="797101"/>
                  </a:cubicBezTo>
                  <a:cubicBezTo>
                    <a:pt x="713656" y="793233"/>
                    <a:pt x="720584" y="779399"/>
                    <a:pt x="715820" y="774117"/>
                  </a:cubicBezTo>
                  <a:cubicBezTo>
                    <a:pt x="703747" y="771005"/>
                    <a:pt x="701614" y="782072"/>
                    <a:pt x="687384" y="777230"/>
                  </a:cubicBezTo>
                  <a:cubicBezTo>
                    <a:pt x="681094" y="770942"/>
                    <a:pt x="683785" y="763081"/>
                    <a:pt x="677664" y="756321"/>
                  </a:cubicBezTo>
                  <a:cubicBezTo>
                    <a:pt x="681596" y="746575"/>
                    <a:pt x="689765" y="746952"/>
                    <a:pt x="698566" y="743776"/>
                  </a:cubicBezTo>
                  <a:cubicBezTo>
                    <a:pt x="701425" y="742770"/>
                    <a:pt x="704627" y="740538"/>
                    <a:pt x="707318" y="739060"/>
                  </a:cubicBezTo>
                  <a:lnTo>
                    <a:pt x="708044" y="733338"/>
                  </a:lnTo>
                  <a:cubicBezTo>
                    <a:pt x="706490" y="730319"/>
                    <a:pt x="703656" y="728810"/>
                    <a:pt x="700755" y="727050"/>
                  </a:cubicBezTo>
                  <a:cubicBezTo>
                    <a:pt x="698478" y="725666"/>
                    <a:pt x="693866" y="722365"/>
                    <a:pt x="691516" y="721547"/>
                  </a:cubicBezTo>
                  <a:cubicBezTo>
                    <a:pt x="681115" y="718057"/>
                    <a:pt x="664994" y="723905"/>
                    <a:pt x="658705" y="711895"/>
                  </a:cubicBezTo>
                  <a:cubicBezTo>
                    <a:pt x="658266" y="709128"/>
                    <a:pt x="658761" y="705261"/>
                    <a:pt x="660160" y="702745"/>
                  </a:cubicBezTo>
                  <a:lnTo>
                    <a:pt x="655544" y="700136"/>
                  </a:lnTo>
                  <a:lnTo>
                    <a:pt x="649711" y="700387"/>
                  </a:lnTo>
                  <a:cubicBezTo>
                    <a:pt x="649115" y="701048"/>
                    <a:pt x="636231" y="710354"/>
                    <a:pt x="633912" y="712146"/>
                  </a:cubicBezTo>
                  <a:cubicBezTo>
                    <a:pt x="634365" y="715007"/>
                    <a:pt x="635673" y="718309"/>
                    <a:pt x="637315" y="720793"/>
                  </a:cubicBezTo>
                  <a:lnTo>
                    <a:pt x="634400" y="725478"/>
                  </a:lnTo>
                  <a:cubicBezTo>
                    <a:pt x="625462" y="725478"/>
                    <a:pt x="608994" y="718435"/>
                    <a:pt x="601828" y="721547"/>
                  </a:cubicBezTo>
                  <a:lnTo>
                    <a:pt x="600130" y="725729"/>
                  </a:lnTo>
                  <a:cubicBezTo>
                    <a:pt x="604304" y="735287"/>
                    <a:pt x="634411" y="742864"/>
                    <a:pt x="643881" y="748492"/>
                  </a:cubicBezTo>
                  <a:cubicBezTo>
                    <a:pt x="648455" y="751196"/>
                    <a:pt x="653050" y="759623"/>
                    <a:pt x="653362" y="764433"/>
                  </a:cubicBezTo>
                  <a:lnTo>
                    <a:pt x="650686" y="768866"/>
                  </a:lnTo>
                  <a:lnTo>
                    <a:pt x="645825" y="770438"/>
                  </a:lnTo>
                  <a:cubicBezTo>
                    <a:pt x="639700" y="767326"/>
                    <a:pt x="635372" y="762390"/>
                    <a:pt x="630268" y="758177"/>
                  </a:cubicBezTo>
                  <a:cubicBezTo>
                    <a:pt x="623652" y="755850"/>
                    <a:pt x="617514" y="758459"/>
                    <a:pt x="610579" y="756605"/>
                  </a:cubicBezTo>
                  <a:cubicBezTo>
                    <a:pt x="600007" y="753743"/>
                    <a:pt x="590526" y="743556"/>
                    <a:pt x="578494" y="747172"/>
                  </a:cubicBezTo>
                  <a:cubicBezTo>
                    <a:pt x="575811" y="748901"/>
                    <a:pt x="573089" y="751668"/>
                    <a:pt x="571444" y="754246"/>
                  </a:cubicBezTo>
                  <a:cubicBezTo>
                    <a:pt x="568768" y="762798"/>
                    <a:pt x="579396" y="769589"/>
                    <a:pt x="587976" y="766005"/>
                  </a:cubicBezTo>
                  <a:lnTo>
                    <a:pt x="592592" y="768866"/>
                  </a:lnTo>
                  <a:cubicBezTo>
                    <a:pt x="590129" y="771130"/>
                    <a:pt x="587243" y="772451"/>
                    <a:pt x="584570" y="774369"/>
                  </a:cubicBezTo>
                  <a:cubicBezTo>
                    <a:pt x="579038" y="778330"/>
                    <a:pt x="575822" y="783613"/>
                    <a:pt x="568771" y="786128"/>
                  </a:cubicBezTo>
                  <a:cubicBezTo>
                    <a:pt x="565456" y="787322"/>
                    <a:pt x="562429" y="787260"/>
                    <a:pt x="559290" y="789272"/>
                  </a:cubicBezTo>
                  <a:cubicBezTo>
                    <a:pt x="553478" y="793013"/>
                    <a:pt x="546122" y="803389"/>
                    <a:pt x="538630" y="803137"/>
                  </a:cubicBezTo>
                  <a:lnTo>
                    <a:pt x="534014" y="800245"/>
                  </a:lnTo>
                  <a:lnTo>
                    <a:pt x="537658" y="792133"/>
                  </a:lnTo>
                  <a:lnTo>
                    <a:pt x="533042" y="789272"/>
                  </a:lnTo>
                  <a:cubicBezTo>
                    <a:pt x="522635" y="790372"/>
                    <a:pt x="511610" y="788014"/>
                    <a:pt x="501199" y="788234"/>
                  </a:cubicBezTo>
                  <a:cubicBezTo>
                    <a:pt x="496085" y="788329"/>
                    <a:pt x="489946" y="790089"/>
                    <a:pt x="484913" y="791096"/>
                  </a:cubicBezTo>
                  <a:lnTo>
                    <a:pt x="478592" y="789272"/>
                  </a:lnTo>
                  <a:lnTo>
                    <a:pt x="478350" y="786662"/>
                  </a:lnTo>
                  <a:cubicBezTo>
                    <a:pt x="479560" y="784116"/>
                    <a:pt x="482289" y="780594"/>
                    <a:pt x="484913" y="779085"/>
                  </a:cubicBezTo>
                  <a:cubicBezTo>
                    <a:pt x="488971" y="776695"/>
                    <a:pt x="494447" y="775721"/>
                    <a:pt x="498768" y="773331"/>
                  </a:cubicBezTo>
                  <a:cubicBezTo>
                    <a:pt x="503409" y="770753"/>
                    <a:pt x="506675" y="767326"/>
                    <a:pt x="510919" y="764433"/>
                  </a:cubicBezTo>
                  <a:cubicBezTo>
                    <a:pt x="513536" y="762641"/>
                    <a:pt x="516854" y="761509"/>
                    <a:pt x="519429" y="759717"/>
                  </a:cubicBezTo>
                  <a:cubicBezTo>
                    <a:pt x="527668" y="753995"/>
                    <a:pt x="532432" y="747015"/>
                    <a:pt x="538388" y="739595"/>
                  </a:cubicBezTo>
                  <a:cubicBezTo>
                    <a:pt x="538644" y="737299"/>
                    <a:pt x="537939" y="732143"/>
                    <a:pt x="536441" y="730194"/>
                  </a:cubicBezTo>
                  <a:cubicBezTo>
                    <a:pt x="535381" y="728810"/>
                    <a:pt x="520716" y="719692"/>
                    <a:pt x="518941" y="719221"/>
                  </a:cubicBezTo>
                  <a:cubicBezTo>
                    <a:pt x="507934" y="716171"/>
                    <a:pt x="505945" y="723276"/>
                    <a:pt x="489775" y="713184"/>
                  </a:cubicBezTo>
                  <a:lnTo>
                    <a:pt x="487589" y="709285"/>
                  </a:lnTo>
                  <a:cubicBezTo>
                    <a:pt x="487365" y="703971"/>
                    <a:pt x="490427" y="699570"/>
                    <a:pt x="492689" y="694885"/>
                  </a:cubicBezTo>
                  <a:lnTo>
                    <a:pt x="490017" y="691238"/>
                  </a:lnTo>
                  <a:lnTo>
                    <a:pt x="482482" y="689917"/>
                  </a:lnTo>
                  <a:cubicBezTo>
                    <a:pt x="462909" y="699067"/>
                    <a:pt x="472650" y="717649"/>
                    <a:pt x="461338" y="731231"/>
                  </a:cubicBezTo>
                  <a:cubicBezTo>
                    <a:pt x="455831" y="737834"/>
                    <a:pt x="444568" y="743556"/>
                    <a:pt x="436545" y="747172"/>
                  </a:cubicBezTo>
                  <a:cubicBezTo>
                    <a:pt x="429653" y="750316"/>
                    <a:pt x="423693" y="753460"/>
                    <a:pt x="415401" y="751637"/>
                  </a:cubicBezTo>
                  <a:cubicBezTo>
                    <a:pt x="409985" y="750442"/>
                    <a:pt x="406327" y="745663"/>
                    <a:pt x="400816" y="744059"/>
                  </a:cubicBezTo>
                  <a:cubicBezTo>
                    <a:pt x="399094" y="744751"/>
                    <a:pt x="391952" y="746763"/>
                    <a:pt x="390367" y="746669"/>
                  </a:cubicBezTo>
                  <a:cubicBezTo>
                    <a:pt x="384491" y="746292"/>
                    <a:pt x="378023" y="742141"/>
                    <a:pt x="372379" y="740915"/>
                  </a:cubicBezTo>
                  <a:cubicBezTo>
                    <a:pt x="365911" y="739500"/>
                    <a:pt x="358685" y="740003"/>
                    <a:pt x="351961" y="738557"/>
                  </a:cubicBezTo>
                  <a:cubicBezTo>
                    <a:pt x="350214" y="738180"/>
                    <a:pt x="347489" y="737645"/>
                    <a:pt x="345886" y="736985"/>
                  </a:cubicBezTo>
                  <a:cubicBezTo>
                    <a:pt x="342315" y="735507"/>
                    <a:pt x="335166" y="727867"/>
                    <a:pt x="330087" y="724691"/>
                  </a:cubicBezTo>
                  <a:cubicBezTo>
                    <a:pt x="321963" y="723748"/>
                    <a:pt x="319231" y="724911"/>
                    <a:pt x="312100" y="725226"/>
                  </a:cubicBezTo>
                  <a:cubicBezTo>
                    <a:pt x="307007" y="725446"/>
                    <a:pt x="293011" y="721296"/>
                    <a:pt x="289251" y="718151"/>
                  </a:cubicBezTo>
                  <a:cubicBezTo>
                    <a:pt x="287434" y="716642"/>
                    <a:pt x="285084" y="712461"/>
                    <a:pt x="284386" y="710323"/>
                  </a:cubicBezTo>
                  <a:cubicBezTo>
                    <a:pt x="285462" y="704475"/>
                    <a:pt x="291183" y="693502"/>
                    <a:pt x="288034" y="688345"/>
                  </a:cubicBezTo>
                  <a:lnTo>
                    <a:pt x="283656" y="687308"/>
                  </a:lnTo>
                  <a:cubicBezTo>
                    <a:pt x="277721" y="690515"/>
                    <a:pt x="273701" y="695734"/>
                    <a:pt x="267615" y="698815"/>
                  </a:cubicBezTo>
                  <a:lnTo>
                    <a:pt x="264458" y="696205"/>
                  </a:lnTo>
                  <a:cubicBezTo>
                    <a:pt x="263368" y="686144"/>
                    <a:pt x="269797" y="669449"/>
                    <a:pt x="281958" y="666399"/>
                  </a:cubicBezTo>
                  <a:cubicBezTo>
                    <a:pt x="290194" y="664324"/>
                    <a:pt x="298030" y="669072"/>
                    <a:pt x="306266" y="665362"/>
                  </a:cubicBezTo>
                  <a:cubicBezTo>
                    <a:pt x="312184" y="662689"/>
                    <a:pt x="327716" y="652219"/>
                    <a:pt x="332760" y="651747"/>
                  </a:cubicBezTo>
                  <a:cubicBezTo>
                    <a:pt x="350249" y="650144"/>
                    <a:pt x="352715" y="663286"/>
                    <a:pt x="362414" y="665613"/>
                  </a:cubicBezTo>
                  <a:cubicBezTo>
                    <a:pt x="366728" y="666651"/>
                    <a:pt x="413496" y="665613"/>
                    <a:pt x="417106" y="664292"/>
                  </a:cubicBezTo>
                  <a:cubicBezTo>
                    <a:pt x="423090" y="662155"/>
                    <a:pt x="429565" y="655049"/>
                    <a:pt x="430477" y="649389"/>
                  </a:cubicBezTo>
                  <a:lnTo>
                    <a:pt x="428530" y="645491"/>
                  </a:lnTo>
                  <a:cubicBezTo>
                    <a:pt x="419972" y="647283"/>
                    <a:pt x="408547" y="649924"/>
                    <a:pt x="399848" y="648886"/>
                  </a:cubicBezTo>
                  <a:lnTo>
                    <a:pt x="395232" y="645994"/>
                  </a:lnTo>
                  <a:lnTo>
                    <a:pt x="393531" y="641812"/>
                  </a:lnTo>
                  <a:cubicBezTo>
                    <a:pt x="389560" y="638353"/>
                    <a:pt x="381359" y="637882"/>
                    <a:pt x="376031" y="636844"/>
                  </a:cubicBezTo>
                  <a:lnTo>
                    <a:pt x="370927" y="638699"/>
                  </a:lnTo>
                  <a:lnTo>
                    <a:pt x="368009" y="636058"/>
                  </a:lnTo>
                  <a:cubicBezTo>
                    <a:pt x="368479" y="634235"/>
                    <a:pt x="370138" y="626091"/>
                    <a:pt x="369956" y="624582"/>
                  </a:cubicBezTo>
                  <a:cubicBezTo>
                    <a:pt x="369436" y="620306"/>
                    <a:pt x="364161" y="616879"/>
                    <a:pt x="363151" y="612540"/>
                  </a:cubicBezTo>
                  <a:cubicBezTo>
                    <a:pt x="361376" y="604900"/>
                    <a:pt x="372155" y="591726"/>
                    <a:pt x="380650" y="590311"/>
                  </a:cubicBezTo>
                  <a:cubicBezTo>
                    <a:pt x="389634" y="588802"/>
                    <a:pt x="398178" y="592795"/>
                    <a:pt x="406902" y="592418"/>
                  </a:cubicBezTo>
                  <a:cubicBezTo>
                    <a:pt x="418684" y="591883"/>
                    <a:pt x="434921" y="584557"/>
                    <a:pt x="446763" y="587985"/>
                  </a:cubicBezTo>
                  <a:cubicBezTo>
                    <a:pt x="447275" y="588110"/>
                    <a:pt x="450720" y="590217"/>
                    <a:pt x="451383" y="590594"/>
                  </a:cubicBezTo>
                  <a:cubicBezTo>
                    <a:pt x="468087" y="600026"/>
                    <a:pt x="454568" y="616093"/>
                    <a:pt x="478606" y="617508"/>
                  </a:cubicBezTo>
                  <a:cubicBezTo>
                    <a:pt x="482009" y="617697"/>
                    <a:pt x="486555" y="617256"/>
                    <a:pt x="489055" y="614898"/>
                  </a:cubicBezTo>
                  <a:lnTo>
                    <a:pt x="490515" y="610717"/>
                  </a:lnTo>
                  <a:cubicBezTo>
                    <a:pt x="488919" y="606598"/>
                    <a:pt x="485797" y="602416"/>
                    <a:pt x="484923" y="598172"/>
                  </a:cubicBezTo>
                  <a:cubicBezTo>
                    <a:pt x="482556" y="586695"/>
                    <a:pt x="495731" y="576225"/>
                    <a:pt x="507527" y="574905"/>
                  </a:cubicBezTo>
                  <a:lnTo>
                    <a:pt x="508499" y="571226"/>
                  </a:lnTo>
                  <a:cubicBezTo>
                    <a:pt x="506440" y="562957"/>
                    <a:pt x="488561" y="556700"/>
                    <a:pt x="480304" y="555820"/>
                  </a:cubicBezTo>
                  <a:cubicBezTo>
                    <a:pt x="472815" y="555002"/>
                    <a:pt x="463653" y="556323"/>
                    <a:pt x="455996" y="556323"/>
                  </a:cubicBezTo>
                  <a:cubicBezTo>
                    <a:pt x="449398" y="556323"/>
                    <a:pt x="442863" y="555160"/>
                    <a:pt x="436307" y="555034"/>
                  </a:cubicBezTo>
                  <a:cubicBezTo>
                    <a:pt x="434343" y="554971"/>
                    <a:pt x="432168" y="555442"/>
                    <a:pt x="430232" y="555286"/>
                  </a:cubicBezTo>
                  <a:cubicBezTo>
                    <a:pt x="423181" y="554751"/>
                    <a:pt x="417734" y="551481"/>
                    <a:pt x="411273" y="550066"/>
                  </a:cubicBezTo>
                  <a:cubicBezTo>
                    <a:pt x="397568" y="547048"/>
                    <a:pt x="382552" y="547897"/>
                    <a:pt x="368977" y="551355"/>
                  </a:cubicBezTo>
                  <a:cubicBezTo>
                    <a:pt x="360109" y="553651"/>
                    <a:pt x="348138" y="558367"/>
                    <a:pt x="340053" y="562360"/>
                  </a:cubicBezTo>
                  <a:cubicBezTo>
                    <a:pt x="338642" y="563051"/>
                    <a:pt x="337355" y="564341"/>
                    <a:pt x="335920" y="564969"/>
                  </a:cubicBezTo>
                  <a:cubicBezTo>
                    <a:pt x="329396" y="567736"/>
                    <a:pt x="322051" y="568239"/>
                    <a:pt x="315257" y="569937"/>
                  </a:cubicBezTo>
                  <a:cubicBezTo>
                    <a:pt x="311689" y="570817"/>
                    <a:pt x="308634" y="572452"/>
                    <a:pt x="304807" y="572798"/>
                  </a:cubicBezTo>
                  <a:cubicBezTo>
                    <a:pt x="291871" y="573993"/>
                    <a:pt x="282765" y="571981"/>
                    <a:pt x="272477" y="564686"/>
                  </a:cubicBezTo>
                  <a:cubicBezTo>
                    <a:pt x="271137" y="563743"/>
                    <a:pt x="269987" y="562140"/>
                    <a:pt x="268590" y="561291"/>
                  </a:cubicBezTo>
                  <a:cubicBezTo>
                    <a:pt x="259909" y="556134"/>
                    <a:pt x="247309" y="558932"/>
                    <a:pt x="237965" y="552141"/>
                  </a:cubicBezTo>
                  <a:cubicBezTo>
                    <a:pt x="228326" y="545130"/>
                    <a:pt x="222107" y="536672"/>
                    <a:pt x="214386" y="528372"/>
                  </a:cubicBezTo>
                  <a:cubicBezTo>
                    <a:pt x="213194" y="527083"/>
                    <a:pt x="193856" y="515072"/>
                    <a:pt x="192267" y="514506"/>
                  </a:cubicBezTo>
                  <a:cubicBezTo>
                    <a:pt x="191663" y="514286"/>
                    <a:pt x="187328" y="513846"/>
                    <a:pt x="186433" y="513720"/>
                  </a:cubicBezTo>
                  <a:cubicBezTo>
                    <a:pt x="178478" y="518436"/>
                    <a:pt x="181000" y="525856"/>
                    <a:pt x="177682" y="532553"/>
                  </a:cubicBezTo>
                  <a:cubicBezTo>
                    <a:pt x="175093" y="535257"/>
                    <a:pt x="168004" y="538150"/>
                    <a:pt x="164068" y="538810"/>
                  </a:cubicBezTo>
                  <a:cubicBezTo>
                    <a:pt x="158358" y="539785"/>
                    <a:pt x="151904" y="538936"/>
                    <a:pt x="146085" y="539596"/>
                  </a:cubicBezTo>
                  <a:cubicBezTo>
                    <a:pt x="142342" y="540037"/>
                    <a:pt x="138645" y="541262"/>
                    <a:pt x="134902" y="541703"/>
                  </a:cubicBezTo>
                  <a:cubicBezTo>
                    <a:pt x="130882" y="542143"/>
                    <a:pt x="126729" y="541609"/>
                    <a:pt x="122748" y="541954"/>
                  </a:cubicBezTo>
                  <a:cubicBezTo>
                    <a:pt x="107742" y="543306"/>
                    <a:pt x="103350" y="544281"/>
                    <a:pt x="87503" y="542740"/>
                  </a:cubicBezTo>
                  <a:cubicBezTo>
                    <a:pt x="72097" y="541231"/>
                    <a:pt x="57614" y="534314"/>
                    <a:pt x="42050" y="532553"/>
                  </a:cubicBezTo>
                  <a:cubicBezTo>
                    <a:pt x="33414" y="531579"/>
                    <a:pt x="17851" y="531705"/>
                    <a:pt x="10449" y="527303"/>
                  </a:cubicBezTo>
                  <a:cubicBezTo>
                    <a:pt x="4648" y="523876"/>
                    <a:pt x="558" y="518405"/>
                    <a:pt x="0" y="512148"/>
                  </a:cubicBezTo>
                  <a:cubicBezTo>
                    <a:pt x="2315" y="506803"/>
                    <a:pt x="16528" y="501709"/>
                    <a:pt x="22604" y="501426"/>
                  </a:cubicBezTo>
                  <a:cubicBezTo>
                    <a:pt x="29545" y="501144"/>
                    <a:pt x="36687" y="503785"/>
                    <a:pt x="43509" y="504571"/>
                  </a:cubicBezTo>
                  <a:cubicBezTo>
                    <a:pt x="49641" y="505262"/>
                    <a:pt x="56042" y="504445"/>
                    <a:pt x="62226" y="504571"/>
                  </a:cubicBezTo>
                  <a:cubicBezTo>
                    <a:pt x="69350" y="500200"/>
                    <a:pt x="76920" y="496647"/>
                    <a:pt x="82641" y="490705"/>
                  </a:cubicBezTo>
                  <a:cubicBezTo>
                    <a:pt x="88478" y="484637"/>
                    <a:pt x="91126" y="476242"/>
                    <a:pt x="98682" y="471368"/>
                  </a:cubicBezTo>
                  <a:lnTo>
                    <a:pt x="104273" y="470331"/>
                  </a:lnTo>
                  <a:cubicBezTo>
                    <a:pt x="111102" y="472972"/>
                    <a:pt x="121573" y="474481"/>
                    <a:pt x="128581" y="471620"/>
                  </a:cubicBezTo>
                  <a:cubicBezTo>
                    <a:pt x="129739" y="468161"/>
                    <a:pt x="130914" y="463885"/>
                    <a:pt x="132717" y="460647"/>
                  </a:cubicBezTo>
                  <a:cubicBezTo>
                    <a:pt x="136400" y="454044"/>
                    <a:pt x="143584" y="447504"/>
                    <a:pt x="149003" y="442097"/>
                  </a:cubicBezTo>
                  <a:cubicBezTo>
                    <a:pt x="151627" y="439455"/>
                    <a:pt x="152616" y="436123"/>
                    <a:pt x="154836" y="433450"/>
                  </a:cubicBezTo>
                  <a:cubicBezTo>
                    <a:pt x="156573" y="431375"/>
                    <a:pt x="164061" y="425936"/>
                    <a:pt x="166748" y="424835"/>
                  </a:cubicBezTo>
                  <a:cubicBezTo>
                    <a:pt x="176184" y="424804"/>
                    <a:pt x="179871" y="427319"/>
                    <a:pt x="187328" y="431532"/>
                  </a:cubicBezTo>
                  <a:cubicBezTo>
                    <a:pt x="192186" y="434299"/>
                    <a:pt x="197960" y="436846"/>
                    <a:pt x="201748" y="440776"/>
                  </a:cubicBezTo>
                  <a:cubicBezTo>
                    <a:pt x="209181" y="448479"/>
                    <a:pt x="208241" y="463540"/>
                    <a:pt x="220223" y="467438"/>
                  </a:cubicBezTo>
                  <a:lnTo>
                    <a:pt x="224355" y="465080"/>
                  </a:lnTo>
                  <a:cubicBezTo>
                    <a:pt x="225839" y="461810"/>
                    <a:pt x="228171" y="459609"/>
                    <a:pt x="230188" y="456717"/>
                  </a:cubicBezTo>
                  <a:cubicBezTo>
                    <a:pt x="239417" y="443480"/>
                    <a:pt x="241255" y="441248"/>
                    <a:pt x="258145" y="436594"/>
                  </a:cubicBezTo>
                  <a:cubicBezTo>
                    <a:pt x="261796" y="435588"/>
                    <a:pt x="264564" y="434142"/>
                    <a:pt x="268594" y="434236"/>
                  </a:cubicBezTo>
                  <a:lnTo>
                    <a:pt x="272481" y="430840"/>
                  </a:lnTo>
                  <a:lnTo>
                    <a:pt x="273210" y="427194"/>
                  </a:lnTo>
                  <a:lnTo>
                    <a:pt x="269324" y="424049"/>
                  </a:lnTo>
                  <a:cubicBezTo>
                    <a:pt x="263013" y="423546"/>
                    <a:pt x="257036" y="422477"/>
                    <a:pt x="250849" y="424049"/>
                  </a:cubicBezTo>
                  <a:cubicBezTo>
                    <a:pt x="247078" y="425024"/>
                    <a:pt x="244928" y="426722"/>
                    <a:pt x="241609" y="428231"/>
                  </a:cubicBezTo>
                  <a:cubicBezTo>
                    <a:pt x="232402" y="432412"/>
                    <a:pt x="217589" y="435211"/>
                    <a:pt x="208065" y="431092"/>
                  </a:cubicBezTo>
                  <a:cubicBezTo>
                    <a:pt x="206168" y="428545"/>
                    <a:pt x="200205" y="422792"/>
                    <a:pt x="197370" y="421157"/>
                  </a:cubicBezTo>
                  <a:cubicBezTo>
                    <a:pt x="195743" y="420245"/>
                    <a:pt x="193645" y="419993"/>
                    <a:pt x="192025" y="419081"/>
                  </a:cubicBezTo>
                  <a:cubicBezTo>
                    <a:pt x="189050" y="417415"/>
                    <a:pt x="186749" y="414680"/>
                    <a:pt x="183515" y="413076"/>
                  </a:cubicBezTo>
                  <a:cubicBezTo>
                    <a:pt x="180064" y="411347"/>
                    <a:pt x="176679" y="410498"/>
                    <a:pt x="173550" y="408108"/>
                  </a:cubicBezTo>
                  <a:cubicBezTo>
                    <a:pt x="171368" y="405404"/>
                    <a:pt x="171508" y="402103"/>
                    <a:pt x="171361" y="398959"/>
                  </a:cubicBezTo>
                  <a:cubicBezTo>
                    <a:pt x="171122" y="393771"/>
                    <a:pt x="170509" y="388426"/>
                    <a:pt x="171361" y="383270"/>
                  </a:cubicBezTo>
                  <a:cubicBezTo>
                    <a:pt x="174213" y="366040"/>
                    <a:pt x="182884" y="358557"/>
                    <a:pt x="174037" y="340635"/>
                  </a:cubicBezTo>
                  <a:cubicBezTo>
                    <a:pt x="172613" y="337743"/>
                    <a:pt x="171442" y="335039"/>
                    <a:pt x="169176" y="332555"/>
                  </a:cubicBezTo>
                  <a:cubicBezTo>
                    <a:pt x="174276" y="326392"/>
                    <a:pt x="182505" y="321676"/>
                    <a:pt x="186433" y="314759"/>
                  </a:cubicBezTo>
                  <a:cubicBezTo>
                    <a:pt x="187338" y="313156"/>
                    <a:pt x="187633" y="310955"/>
                    <a:pt x="188377" y="309288"/>
                  </a:cubicBezTo>
                  <a:cubicBezTo>
                    <a:pt x="190927" y="303472"/>
                    <a:pt x="195147" y="296240"/>
                    <a:pt x="198830" y="290958"/>
                  </a:cubicBezTo>
                  <a:cubicBezTo>
                    <a:pt x="202551" y="285645"/>
                    <a:pt x="216996" y="271496"/>
                    <a:pt x="218515" y="268226"/>
                  </a:cubicBezTo>
                  <a:cubicBezTo>
                    <a:pt x="219339" y="266465"/>
                    <a:pt x="219265" y="264044"/>
                    <a:pt x="219974" y="262220"/>
                  </a:cubicBezTo>
                  <a:cubicBezTo>
                    <a:pt x="223012" y="254329"/>
                    <a:pt x="229564" y="247286"/>
                    <a:pt x="233829" y="239992"/>
                  </a:cubicBezTo>
                  <a:cubicBezTo>
                    <a:pt x="238396" y="232163"/>
                    <a:pt x="241736" y="223831"/>
                    <a:pt x="246225" y="215939"/>
                  </a:cubicBezTo>
                  <a:lnTo>
                    <a:pt x="251329" y="214619"/>
                  </a:lnTo>
                  <a:lnTo>
                    <a:pt x="254974" y="217511"/>
                  </a:lnTo>
                  <a:cubicBezTo>
                    <a:pt x="256864" y="223957"/>
                    <a:pt x="255300" y="230779"/>
                    <a:pt x="257650" y="237099"/>
                  </a:cubicBezTo>
                  <a:lnTo>
                    <a:pt x="261536" y="238954"/>
                  </a:lnTo>
                  <a:cubicBezTo>
                    <a:pt x="263978" y="238137"/>
                    <a:pt x="268026" y="235087"/>
                    <a:pt x="269071" y="232949"/>
                  </a:cubicBezTo>
                  <a:cubicBezTo>
                    <a:pt x="272024" y="226880"/>
                    <a:pt x="272950" y="217260"/>
                    <a:pt x="276363" y="209934"/>
                  </a:cubicBezTo>
                  <a:cubicBezTo>
                    <a:pt x="276942" y="208676"/>
                    <a:pt x="293134" y="187705"/>
                    <a:pt x="294838" y="185881"/>
                  </a:cubicBezTo>
                  <a:cubicBezTo>
                    <a:pt x="295081" y="182297"/>
                    <a:pt x="296217" y="178115"/>
                    <a:pt x="296056" y="174625"/>
                  </a:cubicBezTo>
                  <a:cubicBezTo>
                    <a:pt x="295740" y="167865"/>
                    <a:pt x="283358" y="155666"/>
                    <a:pt x="276121" y="154251"/>
                  </a:cubicBezTo>
                  <a:lnTo>
                    <a:pt x="273203" y="150321"/>
                  </a:lnTo>
                  <a:cubicBezTo>
                    <a:pt x="271793" y="144221"/>
                    <a:pt x="281667" y="139379"/>
                    <a:pt x="277093" y="126520"/>
                  </a:cubicBezTo>
                  <a:cubicBezTo>
                    <a:pt x="275543" y="122181"/>
                    <a:pt x="272098" y="117968"/>
                    <a:pt x="270043" y="113723"/>
                  </a:cubicBezTo>
                  <a:cubicBezTo>
                    <a:pt x="270856" y="110642"/>
                    <a:pt x="272929" y="106838"/>
                    <a:pt x="275388" y="104574"/>
                  </a:cubicBezTo>
                  <a:cubicBezTo>
                    <a:pt x="286778" y="100455"/>
                    <a:pt x="291524" y="111963"/>
                    <a:pt x="301156" y="113472"/>
                  </a:cubicBezTo>
                  <a:cubicBezTo>
                    <a:pt x="311605" y="115107"/>
                    <a:pt x="323419" y="103945"/>
                    <a:pt x="332995" y="115798"/>
                  </a:cubicBezTo>
                  <a:cubicBezTo>
                    <a:pt x="333683" y="121489"/>
                    <a:pt x="329028" y="125577"/>
                    <a:pt x="325703" y="129915"/>
                  </a:cubicBezTo>
                  <a:cubicBezTo>
                    <a:pt x="328891" y="139505"/>
                    <a:pt x="346328" y="142178"/>
                    <a:pt x="354388" y="136204"/>
                  </a:cubicBezTo>
                  <a:cubicBezTo>
                    <a:pt x="358054" y="131425"/>
                    <a:pt x="356314" y="125231"/>
                    <a:pt x="359734" y="120515"/>
                  </a:cubicBezTo>
                  <a:cubicBezTo>
                    <a:pt x="366841" y="110736"/>
                    <a:pt x="382622" y="117685"/>
                    <a:pt x="392791" y="114761"/>
                  </a:cubicBezTo>
                  <a:cubicBezTo>
                    <a:pt x="397130" y="105297"/>
                    <a:pt x="388883" y="99669"/>
                    <a:pt x="387929" y="90960"/>
                  </a:cubicBezTo>
                  <a:cubicBezTo>
                    <a:pt x="387375" y="85898"/>
                    <a:pt x="390177" y="79830"/>
                    <a:pt x="391089" y="74767"/>
                  </a:cubicBezTo>
                  <a:cubicBezTo>
                    <a:pt x="389956" y="72315"/>
                    <a:pt x="388816" y="68479"/>
                    <a:pt x="387199" y="66404"/>
                  </a:cubicBezTo>
                  <a:cubicBezTo>
                    <a:pt x="384218" y="62537"/>
                    <a:pt x="378135" y="61468"/>
                    <a:pt x="376017" y="56972"/>
                  </a:cubicBezTo>
                  <a:cubicBezTo>
                    <a:pt x="377451" y="54016"/>
                    <a:pt x="380780" y="50872"/>
                    <a:pt x="381850" y="48105"/>
                  </a:cubicBezTo>
                  <a:cubicBezTo>
                    <a:pt x="382071" y="47539"/>
                    <a:pt x="382857" y="38578"/>
                    <a:pt x="383067" y="37101"/>
                  </a:cubicBezTo>
                  <a:cubicBezTo>
                    <a:pt x="386080" y="35937"/>
                    <a:pt x="391472" y="36000"/>
                    <a:pt x="394492" y="37101"/>
                  </a:cubicBezTo>
                  <a:cubicBezTo>
                    <a:pt x="395088" y="37509"/>
                    <a:pt x="410126" y="53733"/>
                    <a:pt x="410532" y="54362"/>
                  </a:cubicBezTo>
                  <a:cubicBezTo>
                    <a:pt x="415685" y="62411"/>
                    <a:pt x="416004" y="73227"/>
                    <a:pt x="428520" y="75805"/>
                  </a:cubicBezTo>
                  <a:lnTo>
                    <a:pt x="433866" y="75019"/>
                  </a:lnTo>
                  <a:lnTo>
                    <a:pt x="437271" y="71089"/>
                  </a:lnTo>
                  <a:cubicBezTo>
                    <a:pt x="440281" y="61719"/>
                    <a:pt x="430642" y="50149"/>
                    <a:pt x="433136" y="42100"/>
                  </a:cubicBezTo>
                  <a:cubicBezTo>
                    <a:pt x="435188" y="39836"/>
                    <a:pt x="438436" y="37509"/>
                    <a:pt x="441400" y="36315"/>
                  </a:cubicBezTo>
                  <a:cubicBezTo>
                    <a:pt x="448342" y="38610"/>
                    <a:pt x="454038" y="42949"/>
                    <a:pt x="458900" y="47822"/>
                  </a:cubicBezTo>
                  <a:cubicBezTo>
                    <a:pt x="478266" y="52475"/>
                    <a:pt x="489336" y="33988"/>
                    <a:pt x="504114" y="35277"/>
                  </a:cubicBezTo>
                  <a:cubicBezTo>
                    <a:pt x="515517" y="36283"/>
                    <a:pt x="522115" y="48482"/>
                    <a:pt x="543733" y="49143"/>
                  </a:cubicBezTo>
                  <a:cubicBezTo>
                    <a:pt x="550233" y="45936"/>
                    <a:pt x="549086" y="36063"/>
                    <a:pt x="554916" y="31378"/>
                  </a:cubicBezTo>
                  <a:cubicBezTo>
                    <a:pt x="559188" y="30875"/>
                    <a:pt x="563527" y="31976"/>
                    <a:pt x="567557" y="31630"/>
                  </a:cubicBezTo>
                  <a:cubicBezTo>
                    <a:pt x="569610" y="31441"/>
                    <a:pt x="581048" y="28391"/>
                    <a:pt x="582872" y="27448"/>
                  </a:cubicBezTo>
                  <a:cubicBezTo>
                    <a:pt x="586453" y="23424"/>
                    <a:pt x="589733" y="18676"/>
                    <a:pt x="590891" y="13582"/>
                  </a:cubicBezTo>
                  <a:lnTo>
                    <a:pt x="595265" y="11224"/>
                  </a:lnTo>
                  <a:cubicBezTo>
                    <a:pt x="599183" y="11319"/>
                    <a:pt x="605493" y="11853"/>
                    <a:pt x="609120" y="13048"/>
                  </a:cubicBezTo>
                  <a:cubicBezTo>
                    <a:pt x="610691" y="13582"/>
                    <a:pt x="612182" y="15029"/>
                    <a:pt x="613736" y="15689"/>
                  </a:cubicBezTo>
                  <a:cubicBezTo>
                    <a:pt x="623600" y="19682"/>
                    <a:pt x="644144" y="27982"/>
                    <a:pt x="650683" y="15155"/>
                  </a:cubicBezTo>
                  <a:cubicBezTo>
                    <a:pt x="649978" y="10281"/>
                    <a:pt x="650402" y="3867"/>
                    <a:pt x="654089" y="0"/>
                  </a:cubicBezTo>
                  <a:lnTo>
                    <a:pt x="660160" y="1572"/>
                  </a:lnTo>
                  <a:cubicBezTo>
                    <a:pt x="669186" y="12356"/>
                    <a:pt x="701295" y="16915"/>
                    <a:pt x="704645" y="29523"/>
                  </a:cubicBezTo>
                  <a:cubicBezTo>
                    <a:pt x="705704" y="33516"/>
                    <a:pt x="704010" y="41722"/>
                    <a:pt x="703428" y="45999"/>
                  </a:cubicBezTo>
                  <a:lnTo>
                    <a:pt x="705616" y="50180"/>
                  </a:lnTo>
                  <a:lnTo>
                    <a:pt x="710962" y="52538"/>
                  </a:lnTo>
                  <a:cubicBezTo>
                    <a:pt x="723186" y="52979"/>
                    <a:pt x="728017" y="37918"/>
                    <a:pt x="726761" y="29272"/>
                  </a:cubicBezTo>
                  <a:lnTo>
                    <a:pt x="729679" y="25342"/>
                  </a:lnTo>
                  <a:cubicBezTo>
                    <a:pt x="734015" y="24776"/>
                    <a:pt x="738056" y="26410"/>
                    <a:pt x="741346" y="28737"/>
                  </a:cubicBezTo>
                  <a:cubicBezTo>
                    <a:pt x="749445" y="34460"/>
                    <a:pt x="751651" y="44018"/>
                    <a:pt x="758362" y="50715"/>
                  </a:cubicBezTo>
                  <a:cubicBezTo>
                    <a:pt x="761424" y="53765"/>
                    <a:pt x="765696" y="57600"/>
                    <a:pt x="769299" y="60116"/>
                  </a:cubicBezTo>
                  <a:cubicBezTo>
                    <a:pt x="777598" y="65901"/>
                    <a:pt x="812152" y="79641"/>
                    <a:pt x="821075" y="73730"/>
                  </a:cubicBezTo>
                  <a:lnTo>
                    <a:pt x="821374" y="72535"/>
                  </a:lnTo>
                  <a:cubicBezTo>
                    <a:pt x="821458" y="72818"/>
                    <a:pt x="822570" y="73384"/>
                    <a:pt x="822703" y="73698"/>
                  </a:cubicBezTo>
                  <a:cubicBezTo>
                    <a:pt x="823275" y="75050"/>
                    <a:pt x="823818" y="77251"/>
                    <a:pt x="824085" y="78666"/>
                  </a:cubicBezTo>
                  <a:cubicBezTo>
                    <a:pt x="824994" y="83571"/>
                    <a:pt x="823892" y="88350"/>
                    <a:pt x="823857" y="93255"/>
                  </a:cubicBezTo>
                  <a:cubicBezTo>
                    <a:pt x="823808" y="99669"/>
                    <a:pt x="824162" y="106177"/>
                    <a:pt x="824313" y="112591"/>
                  </a:cubicBezTo>
                  <a:cubicBezTo>
                    <a:pt x="826351" y="114918"/>
                    <a:pt x="832174" y="123187"/>
                    <a:pt x="831911" y="126457"/>
                  </a:cubicBezTo>
                  <a:lnTo>
                    <a:pt x="829613" y="154911"/>
                  </a:lnTo>
                  <a:cubicBezTo>
                    <a:pt x="829603" y="155037"/>
                    <a:pt x="831083" y="158779"/>
                    <a:pt x="831216" y="159125"/>
                  </a:cubicBezTo>
                  <a:cubicBezTo>
                    <a:pt x="834138" y="161294"/>
                    <a:pt x="838158" y="163338"/>
                    <a:pt x="841802" y="164312"/>
                  </a:cubicBezTo>
                  <a:lnTo>
                    <a:pt x="845955" y="169280"/>
                  </a:lnTo>
                  <a:cubicBezTo>
                    <a:pt x="847127" y="173870"/>
                    <a:pt x="845735" y="178932"/>
                    <a:pt x="842500" y="182643"/>
                  </a:cubicBezTo>
                  <a:cubicBezTo>
                    <a:pt x="847976" y="188680"/>
                    <a:pt x="852911" y="185975"/>
                    <a:pt x="857913" y="190566"/>
                  </a:cubicBezTo>
                  <a:cubicBezTo>
                    <a:pt x="859927" y="194716"/>
                    <a:pt x="857219" y="199244"/>
                    <a:pt x="858376" y="203677"/>
                  </a:cubicBezTo>
                  <a:cubicBezTo>
                    <a:pt x="860639" y="205783"/>
                    <a:pt x="862761" y="209242"/>
                    <a:pt x="863452" y="212103"/>
                  </a:cubicBezTo>
                  <a:cubicBezTo>
                    <a:pt x="862961" y="215184"/>
                    <a:pt x="860239" y="219429"/>
                    <a:pt x="857692" y="221504"/>
                  </a:cubicBezTo>
                  <a:lnTo>
                    <a:pt x="857457" y="245525"/>
                  </a:lnTo>
                  <a:cubicBezTo>
                    <a:pt x="857454" y="245871"/>
                    <a:pt x="859169" y="249078"/>
                    <a:pt x="859302" y="249738"/>
                  </a:cubicBezTo>
                  <a:cubicBezTo>
                    <a:pt x="859863" y="252379"/>
                    <a:pt x="858737" y="256090"/>
                    <a:pt x="860214" y="258637"/>
                  </a:cubicBezTo>
                  <a:cubicBezTo>
                    <a:pt x="865107" y="267094"/>
                    <a:pt x="881274" y="278853"/>
                    <a:pt x="882776" y="285645"/>
                  </a:cubicBezTo>
                  <a:cubicBezTo>
                    <a:pt x="882755" y="289638"/>
                    <a:pt x="873999" y="300579"/>
                    <a:pt x="870127" y="302717"/>
                  </a:cubicBezTo>
                  <a:cubicBezTo>
                    <a:pt x="868377" y="303692"/>
                    <a:pt x="862887" y="304604"/>
                    <a:pt x="859306" y="306679"/>
                  </a:cubicBezTo>
                  <a:lnTo>
                    <a:pt x="859762" y="311143"/>
                  </a:lnTo>
                  <a:cubicBezTo>
                    <a:pt x="862859" y="314382"/>
                    <a:pt x="877960" y="320261"/>
                    <a:pt x="881864" y="321048"/>
                  </a:cubicBezTo>
                  <a:cubicBezTo>
                    <a:pt x="882032" y="321079"/>
                    <a:pt x="892064" y="320356"/>
                    <a:pt x="892913" y="320293"/>
                  </a:cubicBezTo>
                  <a:cubicBezTo>
                    <a:pt x="900244" y="322336"/>
                    <a:pt x="902927" y="331800"/>
                    <a:pt x="904429" y="337617"/>
                  </a:cubicBezTo>
                  <a:lnTo>
                    <a:pt x="902583" y="341579"/>
                  </a:lnTo>
                  <a:cubicBezTo>
                    <a:pt x="899132" y="343717"/>
                    <a:pt x="894326" y="346012"/>
                    <a:pt x="891292" y="348527"/>
                  </a:cubicBezTo>
                  <a:cubicBezTo>
                    <a:pt x="891187" y="348622"/>
                    <a:pt x="888981" y="352583"/>
                    <a:pt x="888763" y="352961"/>
                  </a:cubicBezTo>
                  <a:cubicBezTo>
                    <a:pt x="893264" y="355350"/>
                    <a:pt x="896315" y="354407"/>
                    <a:pt x="899346" y="355444"/>
                  </a:cubicBezTo>
                  <a:cubicBezTo>
                    <a:pt x="903004" y="356702"/>
                    <a:pt x="904141" y="359532"/>
                    <a:pt x="909487" y="359154"/>
                  </a:cubicBezTo>
                  <a:cubicBezTo>
                    <a:pt x="915509" y="357645"/>
                    <a:pt x="917881" y="351231"/>
                    <a:pt x="922135" y="347521"/>
                  </a:cubicBezTo>
                  <a:cubicBezTo>
                    <a:pt x="934426" y="344031"/>
                    <a:pt x="939032" y="355696"/>
                    <a:pt x="947226" y="360160"/>
                  </a:cubicBezTo>
                  <a:lnTo>
                    <a:pt x="952056" y="360160"/>
                  </a:lnTo>
                  <a:cubicBezTo>
                    <a:pt x="954066" y="355633"/>
                    <a:pt x="952442" y="350696"/>
                    <a:pt x="955504" y="346546"/>
                  </a:cubicBezTo>
                  <a:cubicBezTo>
                    <a:pt x="958738" y="345037"/>
                    <a:pt x="967721" y="342333"/>
                    <a:pt x="971397" y="344062"/>
                  </a:cubicBezTo>
                  <a:cubicBezTo>
                    <a:pt x="976115" y="348716"/>
                    <a:pt x="977567" y="355602"/>
                    <a:pt x="978528" y="361638"/>
                  </a:cubicBezTo>
                  <a:cubicBezTo>
                    <a:pt x="982331" y="367643"/>
                    <a:pt x="988431" y="366292"/>
                    <a:pt x="991879" y="372297"/>
                  </a:cubicBezTo>
                  <a:cubicBezTo>
                    <a:pt x="992742" y="374655"/>
                    <a:pt x="992198" y="378931"/>
                    <a:pt x="990490" y="380943"/>
                  </a:cubicBezTo>
                  <a:cubicBezTo>
                    <a:pt x="992226" y="383364"/>
                    <a:pt x="994008" y="386948"/>
                    <a:pt x="994183" y="389873"/>
                  </a:cubicBezTo>
                  <a:cubicBezTo>
                    <a:pt x="1000978" y="392451"/>
                    <a:pt x="1008330" y="394809"/>
                    <a:pt x="1014903" y="397796"/>
                  </a:cubicBezTo>
                  <a:cubicBezTo>
                    <a:pt x="1017569" y="398990"/>
                    <a:pt x="1020891" y="402575"/>
                    <a:pt x="1022571" y="404556"/>
                  </a:cubicBezTo>
                  <a:cubicBezTo>
                    <a:pt x="1025216" y="407637"/>
                    <a:pt x="1028538" y="410875"/>
                    <a:pt x="1030084" y="414617"/>
                  </a:cubicBezTo>
                  <a:cubicBezTo>
                    <a:pt x="1033676" y="423326"/>
                    <a:pt x="1034939" y="432444"/>
                    <a:pt x="1036689" y="441531"/>
                  </a:cubicBezTo>
                  <a:cubicBezTo>
                    <a:pt x="1038808" y="452535"/>
                    <a:pt x="1040664" y="468790"/>
                    <a:pt x="1051955" y="476022"/>
                  </a:cubicBezTo>
                  <a:lnTo>
                    <a:pt x="1056792" y="478002"/>
                  </a:lnTo>
                  <a:cubicBezTo>
                    <a:pt x="1063060" y="478694"/>
                    <a:pt x="1078448" y="478977"/>
                    <a:pt x="1084871" y="477751"/>
                  </a:cubicBezTo>
                  <a:cubicBezTo>
                    <a:pt x="1090055" y="476777"/>
                    <a:pt x="1095124" y="474638"/>
                    <a:pt x="1100291" y="473538"/>
                  </a:cubicBezTo>
                  <a:cubicBezTo>
                    <a:pt x="1106703" y="472186"/>
                    <a:pt x="1114209" y="472532"/>
                    <a:pt x="1120092" y="469576"/>
                  </a:cubicBezTo>
                  <a:cubicBezTo>
                    <a:pt x="1126665" y="466306"/>
                    <a:pt x="1138584" y="457943"/>
                    <a:pt x="1146782" y="457943"/>
                  </a:cubicBezTo>
                  <a:cubicBezTo>
                    <a:pt x="1157522" y="457943"/>
                    <a:pt x="1162349" y="471494"/>
                    <a:pt x="1171651" y="473035"/>
                  </a:cubicBezTo>
                  <a:cubicBezTo>
                    <a:pt x="1178084" y="473255"/>
                    <a:pt x="1187709" y="465206"/>
                    <a:pt x="1191438" y="461433"/>
                  </a:cubicBezTo>
                  <a:cubicBezTo>
                    <a:pt x="1197875" y="454862"/>
                    <a:pt x="1198899" y="449265"/>
                    <a:pt x="1208475" y="445335"/>
                  </a:cubicBezTo>
                  <a:cubicBezTo>
                    <a:pt x="1223246" y="439235"/>
                    <a:pt x="1228595" y="451969"/>
                    <a:pt x="1240233" y="448039"/>
                  </a:cubicBezTo>
                  <a:cubicBezTo>
                    <a:pt x="1247831" y="440462"/>
                    <a:pt x="1257365" y="435431"/>
                    <a:pt x="1266236" y="429237"/>
                  </a:cubicBezTo>
                  <a:cubicBezTo>
                    <a:pt x="1269649" y="426848"/>
                    <a:pt x="1272034" y="423672"/>
                    <a:pt x="1276377" y="422288"/>
                  </a:cubicBezTo>
                  <a:cubicBezTo>
                    <a:pt x="1281189" y="420779"/>
                    <a:pt x="1287264" y="419270"/>
                    <a:pt x="1292263" y="418327"/>
                  </a:cubicBezTo>
                  <a:cubicBezTo>
                    <a:pt x="1295739" y="417698"/>
                    <a:pt x="1299559" y="417918"/>
                    <a:pt x="1303066" y="417352"/>
                  </a:cubicBezTo>
                  <a:cubicBezTo>
                    <a:pt x="1306546" y="416786"/>
                    <a:pt x="1310166" y="415246"/>
                    <a:pt x="1313649" y="414868"/>
                  </a:cubicBezTo>
                  <a:cubicBezTo>
                    <a:pt x="1319247" y="414271"/>
                    <a:pt x="1329262" y="413674"/>
                    <a:pt x="1334839" y="413894"/>
                  </a:cubicBezTo>
                  <a:cubicBezTo>
                    <a:pt x="1335022" y="413894"/>
                    <a:pt x="1345425" y="415969"/>
                    <a:pt x="1345874" y="416126"/>
                  </a:cubicBezTo>
                  <a:cubicBezTo>
                    <a:pt x="1366717" y="421943"/>
                    <a:pt x="1384557" y="433450"/>
                    <a:pt x="1404330" y="441374"/>
                  </a:cubicBezTo>
                  <a:cubicBezTo>
                    <a:pt x="1411156" y="444109"/>
                    <a:pt x="1423773" y="447064"/>
                    <a:pt x="1431276" y="449296"/>
                  </a:cubicBezTo>
                  <a:cubicBezTo>
                    <a:pt x="1441385" y="452252"/>
                    <a:pt x="1455254" y="469042"/>
                    <a:pt x="1459120" y="477028"/>
                  </a:cubicBezTo>
                  <a:cubicBezTo>
                    <a:pt x="1465851" y="490894"/>
                    <a:pt x="1462814" y="492466"/>
                    <a:pt x="1475462" y="504256"/>
                  </a:cubicBezTo>
                  <a:cubicBezTo>
                    <a:pt x="1475322" y="508312"/>
                    <a:pt x="1474908" y="519065"/>
                    <a:pt x="1473154" y="522806"/>
                  </a:cubicBezTo>
                  <a:lnTo>
                    <a:pt x="1467405" y="524064"/>
                  </a:lnTo>
                  <a:cubicBezTo>
                    <a:pt x="1466111" y="521863"/>
                    <a:pt x="1463582" y="520386"/>
                    <a:pt x="1462101" y="518342"/>
                  </a:cubicBezTo>
                  <a:cubicBezTo>
                    <a:pt x="1459359" y="514600"/>
                    <a:pt x="1456342" y="501018"/>
                    <a:pt x="1455433" y="496553"/>
                  </a:cubicBezTo>
                  <a:lnTo>
                    <a:pt x="1450140" y="495327"/>
                  </a:lnTo>
                  <a:cubicBezTo>
                    <a:pt x="1442539" y="500483"/>
                    <a:pt x="1445201" y="505640"/>
                    <a:pt x="1434412" y="510104"/>
                  </a:cubicBezTo>
                  <a:cubicBezTo>
                    <a:pt x="1432325" y="510953"/>
                    <a:pt x="1429006" y="511519"/>
                    <a:pt x="1426663" y="511173"/>
                  </a:cubicBezTo>
                  <a:lnTo>
                    <a:pt x="1422745" y="515386"/>
                  </a:lnTo>
                  <a:cubicBezTo>
                    <a:pt x="1424113" y="517681"/>
                    <a:pt x="1425127" y="521706"/>
                    <a:pt x="1424590" y="524284"/>
                  </a:cubicBezTo>
                  <a:lnTo>
                    <a:pt x="1419985" y="529912"/>
                  </a:lnTo>
                  <a:cubicBezTo>
                    <a:pt x="1415249" y="535698"/>
                    <a:pt x="1415849" y="540539"/>
                    <a:pt x="1421367" y="545853"/>
                  </a:cubicBezTo>
                  <a:lnTo>
                    <a:pt x="1431514" y="542363"/>
                  </a:lnTo>
                  <a:lnTo>
                    <a:pt x="1436793" y="545350"/>
                  </a:lnTo>
                  <a:cubicBezTo>
                    <a:pt x="1437186" y="547897"/>
                    <a:pt x="1436758" y="556795"/>
                    <a:pt x="1436109" y="558713"/>
                  </a:cubicBezTo>
                  <a:cubicBezTo>
                    <a:pt x="1434801" y="562548"/>
                    <a:pt x="1429322" y="573805"/>
                    <a:pt x="1425050" y="576037"/>
                  </a:cubicBezTo>
                  <a:lnTo>
                    <a:pt x="1425050" y="580502"/>
                  </a:lnTo>
                  <a:cubicBezTo>
                    <a:pt x="1427151" y="582451"/>
                    <a:pt x="1431869" y="584400"/>
                    <a:pt x="1434959" y="584211"/>
                  </a:cubicBezTo>
                  <a:cubicBezTo>
                    <a:pt x="1438442" y="587356"/>
                    <a:pt x="1443574" y="593047"/>
                    <a:pt x="1442090" y="597826"/>
                  </a:cubicBezTo>
                  <a:cubicBezTo>
                    <a:pt x="1438179" y="599806"/>
                    <a:pt x="1434131" y="605151"/>
                    <a:pt x="1432560" y="608767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56" name="자유형: 도형 297"/>
            <p:cNvSpPr/>
            <p:nvPr/>
          </p:nvSpPr>
          <p:spPr>
            <a:xfrm>
              <a:off x="6446520" y="779760"/>
              <a:ext cx="609120" cy="498600"/>
            </a:xfrm>
            <a:custGeom>
              <a:avLst/>
              <a:gdLst/>
              <a:ahLst/>
              <a:cxnLst/>
              <a:rect l="l" t="t" r="r" b="b"/>
              <a:pathLst>
                <a:path w="482349" h="406096">
                  <a:moveTo>
                    <a:pt x="240586" y="352080"/>
                  </a:moveTo>
                  <a:cubicBezTo>
                    <a:pt x="243431" y="345383"/>
                    <a:pt x="247640" y="334410"/>
                    <a:pt x="249892" y="327556"/>
                  </a:cubicBezTo>
                  <a:cubicBezTo>
                    <a:pt x="249892" y="327556"/>
                    <a:pt x="251400" y="316331"/>
                    <a:pt x="251418" y="313690"/>
                  </a:cubicBezTo>
                  <a:cubicBezTo>
                    <a:pt x="251460" y="307496"/>
                    <a:pt x="249633" y="298472"/>
                    <a:pt x="250590" y="292624"/>
                  </a:cubicBezTo>
                  <a:cubicBezTo>
                    <a:pt x="250951" y="290455"/>
                    <a:pt x="255455" y="283004"/>
                    <a:pt x="254891" y="280928"/>
                  </a:cubicBezTo>
                  <a:cubicBezTo>
                    <a:pt x="252098" y="270553"/>
                    <a:pt x="249373" y="260366"/>
                    <a:pt x="244606" y="250556"/>
                  </a:cubicBezTo>
                  <a:lnTo>
                    <a:pt x="247019" y="244299"/>
                  </a:lnTo>
                  <a:cubicBezTo>
                    <a:pt x="247019" y="244299"/>
                    <a:pt x="254161" y="242853"/>
                    <a:pt x="255950" y="243136"/>
                  </a:cubicBezTo>
                  <a:cubicBezTo>
                    <a:pt x="258482" y="243513"/>
                    <a:pt x="261520" y="244708"/>
                    <a:pt x="264004" y="245431"/>
                  </a:cubicBezTo>
                  <a:cubicBezTo>
                    <a:pt x="274439" y="244676"/>
                    <a:pt x="283082" y="237414"/>
                    <a:pt x="293191" y="235275"/>
                  </a:cubicBezTo>
                  <a:cubicBezTo>
                    <a:pt x="293496" y="235212"/>
                    <a:pt x="303753" y="234144"/>
                    <a:pt x="304033" y="234144"/>
                  </a:cubicBezTo>
                  <a:cubicBezTo>
                    <a:pt x="310593" y="234238"/>
                    <a:pt x="316917" y="236691"/>
                    <a:pt x="323459" y="234364"/>
                  </a:cubicBezTo>
                  <a:cubicBezTo>
                    <a:pt x="329404" y="231157"/>
                    <a:pt x="332021" y="224554"/>
                    <a:pt x="336044" y="219838"/>
                  </a:cubicBezTo>
                  <a:cubicBezTo>
                    <a:pt x="339278" y="216033"/>
                    <a:pt x="343404" y="211977"/>
                    <a:pt x="347073" y="208519"/>
                  </a:cubicBezTo>
                  <a:cubicBezTo>
                    <a:pt x="362089" y="194307"/>
                    <a:pt x="381269" y="183963"/>
                    <a:pt x="391217" y="166073"/>
                  </a:cubicBezTo>
                  <a:cubicBezTo>
                    <a:pt x="392027" y="164595"/>
                    <a:pt x="393630" y="162332"/>
                    <a:pt x="394212" y="160697"/>
                  </a:cubicBezTo>
                  <a:cubicBezTo>
                    <a:pt x="395454" y="157270"/>
                    <a:pt x="397906" y="144504"/>
                    <a:pt x="398857" y="141863"/>
                  </a:cubicBezTo>
                  <a:cubicBezTo>
                    <a:pt x="400231" y="138028"/>
                    <a:pt x="401375" y="133343"/>
                    <a:pt x="403206" y="129727"/>
                  </a:cubicBezTo>
                  <a:cubicBezTo>
                    <a:pt x="406279" y="123627"/>
                    <a:pt x="412193" y="117496"/>
                    <a:pt x="418100" y="113440"/>
                  </a:cubicBezTo>
                  <a:cubicBezTo>
                    <a:pt x="419913" y="112182"/>
                    <a:pt x="434989" y="104134"/>
                    <a:pt x="439784" y="100832"/>
                  </a:cubicBezTo>
                  <a:cubicBezTo>
                    <a:pt x="445277" y="97059"/>
                    <a:pt x="450283" y="92217"/>
                    <a:pt x="455941" y="88696"/>
                  </a:cubicBezTo>
                  <a:cubicBezTo>
                    <a:pt x="455941" y="88696"/>
                    <a:pt x="476397" y="80395"/>
                    <a:pt x="479944" y="78006"/>
                  </a:cubicBezTo>
                  <a:cubicBezTo>
                    <a:pt x="480519" y="77628"/>
                    <a:pt x="481624" y="76371"/>
                    <a:pt x="482350" y="74925"/>
                  </a:cubicBezTo>
                  <a:lnTo>
                    <a:pt x="469084" y="63134"/>
                  </a:lnTo>
                  <a:lnTo>
                    <a:pt x="455498" y="44867"/>
                  </a:lnTo>
                  <a:lnTo>
                    <a:pt x="446442" y="20531"/>
                  </a:lnTo>
                  <a:lnTo>
                    <a:pt x="430022" y="22355"/>
                  </a:lnTo>
                  <a:lnTo>
                    <a:pt x="412473" y="15626"/>
                  </a:lnTo>
                  <a:lnTo>
                    <a:pt x="402606" y="0"/>
                  </a:lnTo>
                  <a:cubicBezTo>
                    <a:pt x="390922" y="9244"/>
                    <a:pt x="377330" y="19745"/>
                    <a:pt x="361682" y="23109"/>
                  </a:cubicBezTo>
                  <a:cubicBezTo>
                    <a:pt x="353435" y="24870"/>
                    <a:pt x="343951" y="24430"/>
                    <a:pt x="335592" y="24524"/>
                  </a:cubicBezTo>
                  <a:cubicBezTo>
                    <a:pt x="326307" y="24618"/>
                    <a:pt x="314735" y="24650"/>
                    <a:pt x="305749" y="22103"/>
                  </a:cubicBezTo>
                  <a:cubicBezTo>
                    <a:pt x="294854" y="19022"/>
                    <a:pt x="286099" y="9998"/>
                    <a:pt x="275376" y="8992"/>
                  </a:cubicBezTo>
                  <a:cubicBezTo>
                    <a:pt x="272201" y="8678"/>
                    <a:pt x="269479" y="8898"/>
                    <a:pt x="266241" y="8332"/>
                  </a:cubicBezTo>
                  <a:cubicBezTo>
                    <a:pt x="265491" y="8206"/>
                    <a:pt x="265084" y="7986"/>
                    <a:pt x="264319" y="8017"/>
                  </a:cubicBezTo>
                  <a:cubicBezTo>
                    <a:pt x="258847" y="8112"/>
                    <a:pt x="253228" y="9150"/>
                    <a:pt x="247749" y="9495"/>
                  </a:cubicBezTo>
                  <a:cubicBezTo>
                    <a:pt x="238839" y="10030"/>
                    <a:pt x="230709" y="9967"/>
                    <a:pt x="221824" y="8992"/>
                  </a:cubicBezTo>
                  <a:lnTo>
                    <a:pt x="203566" y="7011"/>
                  </a:lnTo>
                  <a:cubicBezTo>
                    <a:pt x="202230" y="6980"/>
                    <a:pt x="201504" y="7326"/>
                    <a:pt x="200185" y="7515"/>
                  </a:cubicBezTo>
                  <a:cubicBezTo>
                    <a:pt x="193548" y="8489"/>
                    <a:pt x="187557" y="9652"/>
                    <a:pt x="183993" y="15438"/>
                  </a:cubicBezTo>
                  <a:cubicBezTo>
                    <a:pt x="180963" y="44364"/>
                    <a:pt x="210680" y="53985"/>
                    <a:pt x="211150" y="72881"/>
                  </a:cubicBezTo>
                  <a:cubicBezTo>
                    <a:pt x="211374" y="81873"/>
                    <a:pt x="204896" y="91809"/>
                    <a:pt x="198101" y="98034"/>
                  </a:cubicBezTo>
                  <a:cubicBezTo>
                    <a:pt x="193696" y="102090"/>
                    <a:pt x="187831" y="108158"/>
                    <a:pt x="181692" y="110233"/>
                  </a:cubicBezTo>
                  <a:cubicBezTo>
                    <a:pt x="176473" y="112026"/>
                    <a:pt x="170243" y="110013"/>
                    <a:pt x="166732" y="106303"/>
                  </a:cubicBezTo>
                  <a:cubicBezTo>
                    <a:pt x="164312" y="103725"/>
                    <a:pt x="162526" y="100329"/>
                    <a:pt x="160285" y="97625"/>
                  </a:cubicBezTo>
                  <a:cubicBezTo>
                    <a:pt x="150811" y="86149"/>
                    <a:pt x="137871" y="84892"/>
                    <a:pt x="123682" y="90205"/>
                  </a:cubicBezTo>
                  <a:cubicBezTo>
                    <a:pt x="112110" y="94544"/>
                    <a:pt x="111745" y="111491"/>
                    <a:pt x="108729" y="120169"/>
                  </a:cubicBezTo>
                  <a:lnTo>
                    <a:pt x="105656" y="125922"/>
                  </a:lnTo>
                  <a:cubicBezTo>
                    <a:pt x="105056" y="127055"/>
                    <a:pt x="105042" y="127872"/>
                    <a:pt x="104120" y="128815"/>
                  </a:cubicBezTo>
                  <a:cubicBezTo>
                    <a:pt x="99560" y="133437"/>
                    <a:pt x="89956" y="140291"/>
                    <a:pt x="84550" y="144662"/>
                  </a:cubicBezTo>
                  <a:cubicBezTo>
                    <a:pt x="81758" y="151673"/>
                    <a:pt x="80460" y="161011"/>
                    <a:pt x="78114" y="166702"/>
                  </a:cubicBezTo>
                  <a:cubicBezTo>
                    <a:pt x="77623" y="167897"/>
                    <a:pt x="76995" y="168400"/>
                    <a:pt x="76276" y="169500"/>
                  </a:cubicBezTo>
                  <a:lnTo>
                    <a:pt x="72596" y="175128"/>
                  </a:lnTo>
                  <a:cubicBezTo>
                    <a:pt x="68752" y="179436"/>
                    <a:pt x="56328" y="182737"/>
                    <a:pt x="50719" y="183051"/>
                  </a:cubicBezTo>
                  <a:lnTo>
                    <a:pt x="31847" y="183051"/>
                  </a:lnTo>
                  <a:cubicBezTo>
                    <a:pt x="22005" y="183051"/>
                    <a:pt x="11896" y="182706"/>
                    <a:pt x="2106" y="181637"/>
                  </a:cubicBezTo>
                  <a:cubicBezTo>
                    <a:pt x="1088" y="183020"/>
                    <a:pt x="1103" y="184938"/>
                    <a:pt x="941" y="186510"/>
                  </a:cubicBezTo>
                  <a:cubicBezTo>
                    <a:pt x="-171" y="197231"/>
                    <a:pt x="13372" y="200784"/>
                    <a:pt x="15737" y="209777"/>
                  </a:cubicBezTo>
                  <a:cubicBezTo>
                    <a:pt x="14155" y="216914"/>
                    <a:pt x="4898" y="220970"/>
                    <a:pt x="3323" y="228107"/>
                  </a:cubicBezTo>
                  <a:lnTo>
                    <a:pt x="4091" y="231062"/>
                  </a:lnTo>
                  <a:lnTo>
                    <a:pt x="5624" y="237005"/>
                  </a:lnTo>
                  <a:cubicBezTo>
                    <a:pt x="5382" y="239363"/>
                    <a:pt x="4593" y="240589"/>
                    <a:pt x="3937" y="242884"/>
                  </a:cubicBezTo>
                  <a:cubicBezTo>
                    <a:pt x="1439" y="251531"/>
                    <a:pt x="-2493" y="259863"/>
                    <a:pt x="2169" y="268446"/>
                  </a:cubicBezTo>
                  <a:cubicBezTo>
                    <a:pt x="5898" y="271559"/>
                    <a:pt x="13057" y="273948"/>
                    <a:pt x="17817" y="275143"/>
                  </a:cubicBezTo>
                  <a:lnTo>
                    <a:pt x="21040" y="279608"/>
                  </a:lnTo>
                  <a:lnTo>
                    <a:pt x="12075" y="304415"/>
                  </a:lnTo>
                  <a:cubicBezTo>
                    <a:pt x="18195" y="309571"/>
                    <a:pt x="20426" y="326267"/>
                    <a:pt x="32317" y="333656"/>
                  </a:cubicBezTo>
                  <a:cubicBezTo>
                    <a:pt x="41490" y="339378"/>
                    <a:pt x="53388" y="342145"/>
                    <a:pt x="62210" y="348559"/>
                  </a:cubicBezTo>
                  <a:cubicBezTo>
                    <a:pt x="67257" y="352237"/>
                    <a:pt x="70341" y="358557"/>
                    <a:pt x="75823" y="361890"/>
                  </a:cubicBezTo>
                  <a:cubicBezTo>
                    <a:pt x="85922" y="368052"/>
                    <a:pt x="100419" y="370096"/>
                    <a:pt x="111798" y="373932"/>
                  </a:cubicBezTo>
                  <a:cubicBezTo>
                    <a:pt x="119164" y="376416"/>
                    <a:pt x="128961" y="382515"/>
                    <a:pt x="135131" y="387011"/>
                  </a:cubicBezTo>
                  <a:cubicBezTo>
                    <a:pt x="144525" y="393834"/>
                    <a:pt x="152768" y="404839"/>
                    <a:pt x="165515" y="406096"/>
                  </a:cubicBezTo>
                  <a:cubicBezTo>
                    <a:pt x="177367" y="400437"/>
                    <a:pt x="187610" y="389936"/>
                    <a:pt x="201977" y="389621"/>
                  </a:cubicBezTo>
                  <a:cubicBezTo>
                    <a:pt x="206158" y="389527"/>
                    <a:pt x="210399" y="389967"/>
                    <a:pt x="214619" y="389873"/>
                  </a:cubicBezTo>
                  <a:cubicBezTo>
                    <a:pt x="217179" y="385848"/>
                    <a:pt x="220466" y="381698"/>
                    <a:pt x="222153" y="377328"/>
                  </a:cubicBezTo>
                  <a:cubicBezTo>
                    <a:pt x="223595" y="373586"/>
                    <a:pt x="223770" y="368838"/>
                    <a:pt x="225556" y="365285"/>
                  </a:cubicBezTo>
                  <a:cubicBezTo>
                    <a:pt x="228085" y="360255"/>
                    <a:pt x="235121" y="354533"/>
                    <a:pt x="240586" y="35208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57" name="자유형: 도형 298"/>
            <p:cNvSpPr/>
            <p:nvPr/>
          </p:nvSpPr>
          <p:spPr>
            <a:xfrm>
              <a:off x="6856560" y="1357920"/>
              <a:ext cx="426240" cy="290520"/>
            </a:xfrm>
            <a:custGeom>
              <a:avLst/>
              <a:gdLst/>
              <a:ahLst/>
              <a:cxnLst/>
              <a:rect l="l" t="t" r="r" b="b"/>
              <a:pathLst>
                <a:path w="337807" h="236820">
                  <a:moveTo>
                    <a:pt x="0" y="116558"/>
                  </a:moveTo>
                  <a:lnTo>
                    <a:pt x="2473" y="112093"/>
                  </a:lnTo>
                  <a:lnTo>
                    <a:pt x="12603" y="104673"/>
                  </a:lnTo>
                  <a:lnTo>
                    <a:pt x="16051" y="99737"/>
                  </a:lnTo>
                  <a:lnTo>
                    <a:pt x="16185" y="96907"/>
                  </a:lnTo>
                  <a:cubicBezTo>
                    <a:pt x="15469" y="94109"/>
                    <a:pt x="19608" y="88072"/>
                    <a:pt x="21565" y="86091"/>
                  </a:cubicBezTo>
                  <a:lnTo>
                    <a:pt x="27311" y="85840"/>
                  </a:lnTo>
                  <a:cubicBezTo>
                    <a:pt x="35372" y="87789"/>
                    <a:pt x="38213" y="97567"/>
                    <a:pt x="44828" y="101466"/>
                  </a:cubicBezTo>
                  <a:cubicBezTo>
                    <a:pt x="48027" y="103321"/>
                    <a:pt x="52233" y="104516"/>
                    <a:pt x="55632" y="106151"/>
                  </a:cubicBezTo>
                  <a:cubicBezTo>
                    <a:pt x="58722" y="107660"/>
                    <a:pt x="62100" y="110490"/>
                    <a:pt x="65994" y="110112"/>
                  </a:cubicBezTo>
                  <a:cubicBezTo>
                    <a:pt x="67351" y="109987"/>
                    <a:pt x="68053" y="109609"/>
                    <a:pt x="69368" y="109295"/>
                  </a:cubicBezTo>
                  <a:lnTo>
                    <a:pt x="76120" y="107629"/>
                  </a:lnTo>
                  <a:cubicBezTo>
                    <a:pt x="78779" y="106622"/>
                    <a:pt x="82771" y="103195"/>
                    <a:pt x="86717" y="101718"/>
                  </a:cubicBezTo>
                  <a:cubicBezTo>
                    <a:pt x="92249" y="99611"/>
                    <a:pt x="98257" y="98353"/>
                    <a:pt x="103280" y="95272"/>
                  </a:cubicBezTo>
                  <a:cubicBezTo>
                    <a:pt x="104971" y="90996"/>
                    <a:pt x="103870" y="86028"/>
                    <a:pt x="103975" y="81658"/>
                  </a:cubicBezTo>
                  <a:cubicBezTo>
                    <a:pt x="104049" y="78702"/>
                    <a:pt x="104108" y="74867"/>
                    <a:pt x="104669" y="72005"/>
                  </a:cubicBezTo>
                  <a:cubicBezTo>
                    <a:pt x="104950" y="70559"/>
                    <a:pt x="106315" y="68987"/>
                    <a:pt x="106739" y="67541"/>
                  </a:cubicBezTo>
                  <a:lnTo>
                    <a:pt x="112807" y="46947"/>
                  </a:lnTo>
                  <a:cubicBezTo>
                    <a:pt x="113737" y="46821"/>
                    <a:pt x="123632" y="45532"/>
                    <a:pt x="123884" y="45438"/>
                  </a:cubicBezTo>
                  <a:cubicBezTo>
                    <a:pt x="127248" y="44180"/>
                    <a:pt x="135734" y="37797"/>
                    <a:pt x="137400" y="34433"/>
                  </a:cubicBezTo>
                  <a:lnTo>
                    <a:pt x="143615" y="34024"/>
                  </a:lnTo>
                  <a:lnTo>
                    <a:pt x="161967" y="59618"/>
                  </a:lnTo>
                  <a:cubicBezTo>
                    <a:pt x="165994" y="56945"/>
                    <a:pt x="169919" y="51066"/>
                    <a:pt x="171775" y="47041"/>
                  </a:cubicBezTo>
                  <a:cubicBezTo>
                    <a:pt x="170196" y="43299"/>
                    <a:pt x="168860" y="39181"/>
                    <a:pt x="168169" y="35219"/>
                  </a:cubicBezTo>
                  <a:cubicBezTo>
                    <a:pt x="171736" y="33459"/>
                    <a:pt x="176507" y="28396"/>
                    <a:pt x="177163" y="24718"/>
                  </a:cubicBezTo>
                  <a:lnTo>
                    <a:pt x="177005" y="18775"/>
                  </a:lnTo>
                  <a:lnTo>
                    <a:pt x="176924" y="15788"/>
                  </a:lnTo>
                  <a:cubicBezTo>
                    <a:pt x="180835" y="10601"/>
                    <a:pt x="187524" y="11575"/>
                    <a:pt x="192818" y="7865"/>
                  </a:cubicBezTo>
                  <a:lnTo>
                    <a:pt x="194884" y="3904"/>
                  </a:lnTo>
                  <a:lnTo>
                    <a:pt x="198875" y="1608"/>
                  </a:lnTo>
                  <a:cubicBezTo>
                    <a:pt x="205712" y="-2353"/>
                    <a:pt x="209475" y="2017"/>
                    <a:pt x="216056" y="3904"/>
                  </a:cubicBezTo>
                  <a:cubicBezTo>
                    <a:pt x="218606" y="4658"/>
                    <a:pt x="229831" y="4658"/>
                    <a:pt x="232630" y="4658"/>
                  </a:cubicBezTo>
                  <a:cubicBezTo>
                    <a:pt x="238112" y="67"/>
                    <a:pt x="248257" y="2143"/>
                    <a:pt x="254725" y="3432"/>
                  </a:cubicBezTo>
                  <a:cubicBezTo>
                    <a:pt x="258004" y="5853"/>
                    <a:pt x="264532" y="12204"/>
                    <a:pt x="264630" y="16291"/>
                  </a:cubicBezTo>
                  <a:cubicBezTo>
                    <a:pt x="264746" y="21039"/>
                    <a:pt x="263403" y="26101"/>
                    <a:pt x="263252" y="30880"/>
                  </a:cubicBezTo>
                  <a:cubicBezTo>
                    <a:pt x="263101" y="35691"/>
                    <a:pt x="263557" y="40690"/>
                    <a:pt x="263708" y="45500"/>
                  </a:cubicBezTo>
                  <a:cubicBezTo>
                    <a:pt x="267843" y="51946"/>
                    <a:pt x="274048" y="53518"/>
                    <a:pt x="272989" y="61913"/>
                  </a:cubicBezTo>
                  <a:lnTo>
                    <a:pt x="272217" y="68044"/>
                  </a:lnTo>
                  <a:cubicBezTo>
                    <a:pt x="273968" y="72980"/>
                    <a:pt x="279124" y="76344"/>
                    <a:pt x="281888" y="80903"/>
                  </a:cubicBezTo>
                  <a:cubicBezTo>
                    <a:pt x="284270" y="94738"/>
                    <a:pt x="258937" y="112408"/>
                    <a:pt x="272684" y="125456"/>
                  </a:cubicBezTo>
                  <a:lnTo>
                    <a:pt x="283039" y="124230"/>
                  </a:lnTo>
                  <a:cubicBezTo>
                    <a:pt x="290079" y="117438"/>
                    <a:pt x="295438" y="119136"/>
                    <a:pt x="304446" y="117281"/>
                  </a:cubicBezTo>
                  <a:cubicBezTo>
                    <a:pt x="311676" y="115803"/>
                    <a:pt x="319606" y="112313"/>
                    <a:pt x="325162" y="107880"/>
                  </a:cubicBezTo>
                  <a:cubicBezTo>
                    <a:pt x="332599" y="113477"/>
                    <a:pt x="336587" y="126430"/>
                    <a:pt x="337808" y="134637"/>
                  </a:cubicBezTo>
                  <a:lnTo>
                    <a:pt x="333911" y="138567"/>
                  </a:lnTo>
                  <a:cubicBezTo>
                    <a:pt x="325233" y="140422"/>
                    <a:pt x="314429" y="143157"/>
                    <a:pt x="309746" y="150703"/>
                  </a:cubicBezTo>
                  <a:cubicBezTo>
                    <a:pt x="308954" y="151992"/>
                    <a:pt x="308855" y="153847"/>
                    <a:pt x="308122" y="155168"/>
                  </a:cubicBezTo>
                  <a:cubicBezTo>
                    <a:pt x="306449" y="158186"/>
                    <a:pt x="304232" y="161204"/>
                    <a:pt x="302338" y="164129"/>
                  </a:cubicBezTo>
                  <a:lnTo>
                    <a:pt x="303653" y="170794"/>
                  </a:lnTo>
                  <a:lnTo>
                    <a:pt x="316646" y="173247"/>
                  </a:lnTo>
                  <a:lnTo>
                    <a:pt x="316646" y="177711"/>
                  </a:lnTo>
                  <a:cubicBezTo>
                    <a:pt x="313531" y="180101"/>
                    <a:pt x="306246" y="186704"/>
                    <a:pt x="305372" y="190571"/>
                  </a:cubicBezTo>
                  <a:lnTo>
                    <a:pt x="299844" y="194061"/>
                  </a:lnTo>
                  <a:lnTo>
                    <a:pt x="294320" y="192803"/>
                  </a:lnTo>
                  <a:lnTo>
                    <a:pt x="290619" y="197268"/>
                  </a:lnTo>
                  <a:lnTo>
                    <a:pt x="294558" y="201481"/>
                  </a:lnTo>
                  <a:lnTo>
                    <a:pt x="279815" y="213334"/>
                  </a:lnTo>
                  <a:cubicBezTo>
                    <a:pt x="275385" y="213775"/>
                    <a:pt x="271467" y="212297"/>
                    <a:pt x="269232" y="212359"/>
                  </a:cubicBezTo>
                  <a:cubicBezTo>
                    <a:pt x="265988" y="212454"/>
                    <a:pt x="262115" y="213366"/>
                    <a:pt x="258878" y="213838"/>
                  </a:cubicBezTo>
                  <a:cubicBezTo>
                    <a:pt x="256201" y="218208"/>
                    <a:pt x="248000" y="225816"/>
                    <a:pt x="243914" y="228709"/>
                  </a:cubicBezTo>
                  <a:cubicBezTo>
                    <a:pt x="240035" y="231413"/>
                    <a:pt x="231823" y="235123"/>
                    <a:pt x="226902" y="236821"/>
                  </a:cubicBezTo>
                  <a:lnTo>
                    <a:pt x="222096" y="234086"/>
                  </a:lnTo>
                  <a:cubicBezTo>
                    <a:pt x="221454" y="230596"/>
                    <a:pt x="218827" y="224119"/>
                    <a:pt x="215593" y="221760"/>
                  </a:cubicBezTo>
                  <a:lnTo>
                    <a:pt x="215593" y="208901"/>
                  </a:lnTo>
                  <a:cubicBezTo>
                    <a:pt x="210082" y="208021"/>
                    <a:pt x="207227" y="211416"/>
                    <a:pt x="205010" y="211605"/>
                  </a:cubicBezTo>
                  <a:cubicBezTo>
                    <a:pt x="200064" y="212077"/>
                    <a:pt x="193715" y="211259"/>
                    <a:pt x="188675" y="211133"/>
                  </a:cubicBezTo>
                  <a:cubicBezTo>
                    <a:pt x="180488" y="216667"/>
                    <a:pt x="171063" y="219025"/>
                    <a:pt x="162202" y="223270"/>
                  </a:cubicBezTo>
                  <a:cubicBezTo>
                    <a:pt x="160477" y="224087"/>
                    <a:pt x="159070" y="226099"/>
                    <a:pt x="157358" y="226980"/>
                  </a:cubicBezTo>
                  <a:cubicBezTo>
                    <a:pt x="153030" y="229181"/>
                    <a:pt x="146323" y="228835"/>
                    <a:pt x="141946" y="226980"/>
                  </a:cubicBezTo>
                  <a:lnTo>
                    <a:pt x="131117" y="229212"/>
                  </a:lnTo>
                  <a:lnTo>
                    <a:pt x="120524" y="225502"/>
                  </a:lnTo>
                  <a:cubicBezTo>
                    <a:pt x="114042" y="226603"/>
                    <a:pt x="106711" y="233205"/>
                    <a:pt x="100050" y="229935"/>
                  </a:cubicBezTo>
                  <a:cubicBezTo>
                    <a:pt x="96314" y="222484"/>
                    <a:pt x="82266" y="191766"/>
                    <a:pt x="77485" y="187112"/>
                  </a:cubicBezTo>
                  <a:cubicBezTo>
                    <a:pt x="69003" y="184880"/>
                    <a:pt x="62233" y="197299"/>
                    <a:pt x="51479" y="197268"/>
                  </a:cubicBezTo>
                  <a:cubicBezTo>
                    <a:pt x="46807" y="194124"/>
                    <a:pt x="42517" y="189753"/>
                    <a:pt x="38813" y="185729"/>
                  </a:cubicBezTo>
                  <a:cubicBezTo>
                    <a:pt x="43576" y="181736"/>
                    <a:pt x="45937" y="175668"/>
                    <a:pt x="43667" y="170008"/>
                  </a:cubicBezTo>
                  <a:lnTo>
                    <a:pt x="38830" y="166078"/>
                  </a:lnTo>
                  <a:cubicBezTo>
                    <a:pt x="39005" y="163060"/>
                    <a:pt x="39904" y="159695"/>
                    <a:pt x="41124" y="156897"/>
                  </a:cubicBezTo>
                  <a:cubicBezTo>
                    <a:pt x="40833" y="154854"/>
                    <a:pt x="38188" y="149508"/>
                    <a:pt x="36522" y="148251"/>
                  </a:cubicBezTo>
                  <a:cubicBezTo>
                    <a:pt x="29815" y="143157"/>
                    <a:pt x="22726" y="138221"/>
                    <a:pt x="16262" y="132907"/>
                  </a:cubicBezTo>
                  <a:cubicBezTo>
                    <a:pt x="14697" y="131618"/>
                    <a:pt x="13631" y="129543"/>
                    <a:pt x="12119" y="128191"/>
                  </a:cubicBezTo>
                  <a:cubicBezTo>
                    <a:pt x="9278" y="125644"/>
                    <a:pt x="5055" y="122909"/>
                    <a:pt x="1308" y="121494"/>
                  </a:cubicBezTo>
                  <a:lnTo>
                    <a:pt x="0" y="116558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58" name="자유형: 도형 299"/>
            <p:cNvSpPr/>
            <p:nvPr/>
          </p:nvSpPr>
          <p:spPr>
            <a:xfrm>
              <a:off x="6597720" y="701280"/>
              <a:ext cx="1381320" cy="1543320"/>
            </a:xfrm>
            <a:custGeom>
              <a:avLst/>
              <a:gdLst/>
              <a:ahLst/>
              <a:cxnLst/>
              <a:rect l="l" t="t" r="r" b="b"/>
              <a:pathLst>
                <a:path w="1093717" h="1256679">
                  <a:moveTo>
                    <a:pt x="221062" y="631342"/>
                  </a:moveTo>
                  <a:lnTo>
                    <a:pt x="209304" y="628796"/>
                  </a:lnTo>
                  <a:lnTo>
                    <a:pt x="192341" y="634172"/>
                  </a:lnTo>
                  <a:lnTo>
                    <a:pt x="188795" y="624457"/>
                  </a:lnTo>
                  <a:lnTo>
                    <a:pt x="170035" y="622319"/>
                  </a:lnTo>
                  <a:lnTo>
                    <a:pt x="157274" y="609459"/>
                  </a:lnTo>
                  <a:lnTo>
                    <a:pt x="139782" y="594682"/>
                  </a:lnTo>
                  <a:lnTo>
                    <a:pt x="112856" y="583803"/>
                  </a:lnTo>
                  <a:lnTo>
                    <a:pt x="100513" y="592481"/>
                  </a:lnTo>
                  <a:lnTo>
                    <a:pt x="92684" y="609302"/>
                  </a:lnTo>
                  <a:lnTo>
                    <a:pt x="82343" y="606975"/>
                  </a:lnTo>
                  <a:lnTo>
                    <a:pt x="69351" y="618608"/>
                  </a:lnTo>
                  <a:cubicBezTo>
                    <a:pt x="63465" y="619583"/>
                    <a:pt x="57148" y="619803"/>
                    <a:pt x="52254" y="616408"/>
                  </a:cubicBezTo>
                  <a:cubicBezTo>
                    <a:pt x="54811" y="614238"/>
                    <a:pt x="56253" y="610119"/>
                    <a:pt x="56144" y="607007"/>
                  </a:cubicBezTo>
                  <a:lnTo>
                    <a:pt x="51279" y="605183"/>
                  </a:lnTo>
                  <a:cubicBezTo>
                    <a:pt x="46291" y="606661"/>
                    <a:pt x="41928" y="609428"/>
                    <a:pt x="36940" y="610937"/>
                  </a:cubicBezTo>
                  <a:lnTo>
                    <a:pt x="34509" y="609082"/>
                  </a:lnTo>
                  <a:lnTo>
                    <a:pt x="33537" y="604397"/>
                  </a:lnTo>
                  <a:cubicBezTo>
                    <a:pt x="29735" y="601756"/>
                    <a:pt x="27806" y="597700"/>
                    <a:pt x="24789" y="594462"/>
                  </a:cubicBezTo>
                  <a:cubicBezTo>
                    <a:pt x="21604" y="591035"/>
                    <a:pt x="17216" y="588519"/>
                    <a:pt x="14820" y="584526"/>
                  </a:cubicBezTo>
                  <a:cubicBezTo>
                    <a:pt x="9773" y="576069"/>
                    <a:pt x="14676" y="564655"/>
                    <a:pt x="6802" y="557329"/>
                  </a:cubicBezTo>
                  <a:cubicBezTo>
                    <a:pt x="10208" y="550067"/>
                    <a:pt x="6970" y="535132"/>
                    <a:pt x="4125" y="527775"/>
                  </a:cubicBezTo>
                  <a:cubicBezTo>
                    <a:pt x="2996" y="524851"/>
                    <a:pt x="926" y="522210"/>
                    <a:pt x="239" y="519160"/>
                  </a:cubicBezTo>
                  <a:cubicBezTo>
                    <a:pt x="-603" y="515418"/>
                    <a:pt x="997" y="511802"/>
                    <a:pt x="1694" y="508186"/>
                  </a:cubicBezTo>
                  <a:cubicBezTo>
                    <a:pt x="2842" y="502213"/>
                    <a:pt x="2364" y="483128"/>
                    <a:pt x="726" y="477343"/>
                  </a:cubicBezTo>
                  <a:cubicBezTo>
                    <a:pt x="6844" y="476557"/>
                    <a:pt x="13154" y="476211"/>
                    <a:pt x="19201" y="477594"/>
                  </a:cubicBezTo>
                  <a:cubicBezTo>
                    <a:pt x="25806" y="479103"/>
                    <a:pt x="36407" y="484543"/>
                    <a:pt x="43022" y="481776"/>
                  </a:cubicBezTo>
                  <a:cubicBezTo>
                    <a:pt x="48238" y="483474"/>
                    <a:pt x="53489" y="485454"/>
                    <a:pt x="59063" y="485958"/>
                  </a:cubicBezTo>
                  <a:cubicBezTo>
                    <a:pt x="67495" y="486712"/>
                    <a:pt x="89965" y="482813"/>
                    <a:pt x="93820" y="475236"/>
                  </a:cubicBezTo>
                  <a:cubicBezTo>
                    <a:pt x="103452" y="477877"/>
                    <a:pt x="106585" y="485486"/>
                    <a:pt x="108651" y="493283"/>
                  </a:cubicBezTo>
                  <a:cubicBezTo>
                    <a:pt x="109840" y="497780"/>
                    <a:pt x="112323" y="501930"/>
                    <a:pt x="112537" y="506614"/>
                  </a:cubicBezTo>
                  <a:cubicBezTo>
                    <a:pt x="112692" y="509979"/>
                    <a:pt x="110278" y="526454"/>
                    <a:pt x="109135" y="529630"/>
                  </a:cubicBezTo>
                  <a:cubicBezTo>
                    <a:pt x="105234" y="540414"/>
                    <a:pt x="100089" y="548998"/>
                    <a:pt x="105487" y="560725"/>
                  </a:cubicBezTo>
                  <a:cubicBezTo>
                    <a:pt x="112997" y="577043"/>
                    <a:pt x="159916" y="584683"/>
                    <a:pt x="172817" y="597071"/>
                  </a:cubicBezTo>
                  <a:lnTo>
                    <a:pt x="177921" y="597323"/>
                  </a:lnTo>
                  <a:lnTo>
                    <a:pt x="181081" y="593676"/>
                  </a:lnTo>
                  <a:cubicBezTo>
                    <a:pt x="180955" y="581445"/>
                    <a:pt x="159460" y="573805"/>
                    <a:pt x="149238" y="569088"/>
                  </a:cubicBezTo>
                  <a:cubicBezTo>
                    <a:pt x="145394" y="567328"/>
                    <a:pt x="126554" y="553934"/>
                    <a:pt x="124930" y="551041"/>
                  </a:cubicBezTo>
                  <a:cubicBezTo>
                    <a:pt x="117132" y="537207"/>
                    <a:pt x="145261" y="505357"/>
                    <a:pt x="136355" y="487530"/>
                  </a:cubicBezTo>
                  <a:cubicBezTo>
                    <a:pt x="132942" y="485329"/>
                    <a:pt x="125635" y="476588"/>
                    <a:pt x="125172" y="472878"/>
                  </a:cubicBezTo>
                  <a:cubicBezTo>
                    <a:pt x="124000" y="463445"/>
                    <a:pt x="132065" y="455648"/>
                    <a:pt x="127603" y="440210"/>
                  </a:cubicBezTo>
                  <a:cubicBezTo>
                    <a:pt x="130328" y="433734"/>
                    <a:pt x="137758" y="420120"/>
                    <a:pt x="134650" y="413548"/>
                  </a:cubicBezTo>
                  <a:cubicBezTo>
                    <a:pt x="130241" y="413076"/>
                    <a:pt x="125067" y="414397"/>
                    <a:pt x="121061" y="416001"/>
                  </a:cubicBezTo>
                  <a:cubicBezTo>
                    <a:pt x="123906" y="409304"/>
                    <a:pt x="128059" y="398331"/>
                    <a:pt x="130314" y="391476"/>
                  </a:cubicBezTo>
                  <a:cubicBezTo>
                    <a:pt x="130314" y="391476"/>
                    <a:pt x="131823" y="380252"/>
                    <a:pt x="131840" y="377642"/>
                  </a:cubicBezTo>
                  <a:cubicBezTo>
                    <a:pt x="131882" y="371448"/>
                    <a:pt x="130055" y="362393"/>
                    <a:pt x="131012" y="356545"/>
                  </a:cubicBezTo>
                  <a:cubicBezTo>
                    <a:pt x="131374" y="354376"/>
                    <a:pt x="135878" y="346956"/>
                    <a:pt x="135313" y="344849"/>
                  </a:cubicBezTo>
                  <a:cubicBezTo>
                    <a:pt x="132521" y="334504"/>
                    <a:pt x="129795" y="324318"/>
                    <a:pt x="125028" y="314508"/>
                  </a:cubicBezTo>
                  <a:lnTo>
                    <a:pt x="127441" y="308220"/>
                  </a:lnTo>
                  <a:cubicBezTo>
                    <a:pt x="127441" y="308220"/>
                    <a:pt x="134583" y="306805"/>
                    <a:pt x="136372" y="307056"/>
                  </a:cubicBezTo>
                  <a:cubicBezTo>
                    <a:pt x="138905" y="307465"/>
                    <a:pt x="141942" y="308628"/>
                    <a:pt x="144426" y="309351"/>
                  </a:cubicBezTo>
                  <a:cubicBezTo>
                    <a:pt x="154861" y="308597"/>
                    <a:pt x="163504" y="301334"/>
                    <a:pt x="173613" y="299196"/>
                  </a:cubicBezTo>
                  <a:cubicBezTo>
                    <a:pt x="173918" y="299133"/>
                    <a:pt x="184175" y="298096"/>
                    <a:pt x="184456" y="298096"/>
                  </a:cubicBezTo>
                  <a:cubicBezTo>
                    <a:pt x="191015" y="298159"/>
                    <a:pt x="197339" y="300642"/>
                    <a:pt x="203881" y="298284"/>
                  </a:cubicBezTo>
                  <a:cubicBezTo>
                    <a:pt x="209826" y="295077"/>
                    <a:pt x="212443" y="288474"/>
                    <a:pt x="216467" y="283758"/>
                  </a:cubicBezTo>
                  <a:cubicBezTo>
                    <a:pt x="219701" y="279954"/>
                    <a:pt x="223826" y="275898"/>
                    <a:pt x="227495" y="272439"/>
                  </a:cubicBezTo>
                  <a:cubicBezTo>
                    <a:pt x="242511" y="258228"/>
                    <a:pt x="261691" y="247884"/>
                    <a:pt x="271639" y="229993"/>
                  </a:cubicBezTo>
                  <a:cubicBezTo>
                    <a:pt x="272449" y="228516"/>
                    <a:pt x="274052" y="226252"/>
                    <a:pt x="274635" y="224617"/>
                  </a:cubicBezTo>
                  <a:cubicBezTo>
                    <a:pt x="275876" y="221190"/>
                    <a:pt x="278328" y="208456"/>
                    <a:pt x="279279" y="205784"/>
                  </a:cubicBezTo>
                  <a:cubicBezTo>
                    <a:pt x="280654" y="201948"/>
                    <a:pt x="281797" y="197294"/>
                    <a:pt x="283628" y="193648"/>
                  </a:cubicBezTo>
                  <a:cubicBezTo>
                    <a:pt x="286701" y="187579"/>
                    <a:pt x="292615" y="181417"/>
                    <a:pt x="298522" y="177361"/>
                  </a:cubicBezTo>
                  <a:cubicBezTo>
                    <a:pt x="300335" y="176134"/>
                    <a:pt x="315411" y="168086"/>
                    <a:pt x="320206" y="164753"/>
                  </a:cubicBezTo>
                  <a:cubicBezTo>
                    <a:pt x="325699" y="160980"/>
                    <a:pt x="330705" y="156138"/>
                    <a:pt x="336363" y="152616"/>
                  </a:cubicBezTo>
                  <a:cubicBezTo>
                    <a:pt x="336363" y="152616"/>
                    <a:pt x="356820" y="144316"/>
                    <a:pt x="360366" y="141926"/>
                  </a:cubicBezTo>
                  <a:cubicBezTo>
                    <a:pt x="360941" y="141549"/>
                    <a:pt x="362046" y="140323"/>
                    <a:pt x="362772" y="138877"/>
                  </a:cubicBezTo>
                  <a:cubicBezTo>
                    <a:pt x="363610" y="137179"/>
                    <a:pt x="364024" y="135292"/>
                    <a:pt x="364024" y="135292"/>
                  </a:cubicBezTo>
                  <a:cubicBezTo>
                    <a:pt x="361506" y="131960"/>
                    <a:pt x="355118" y="125200"/>
                    <a:pt x="355739" y="121332"/>
                  </a:cubicBezTo>
                  <a:cubicBezTo>
                    <a:pt x="357539" y="110171"/>
                    <a:pt x="358545" y="96651"/>
                    <a:pt x="367574" y="87816"/>
                  </a:cubicBezTo>
                  <a:lnTo>
                    <a:pt x="373667" y="85772"/>
                  </a:lnTo>
                  <a:cubicBezTo>
                    <a:pt x="378048" y="78101"/>
                    <a:pt x="395569" y="67191"/>
                    <a:pt x="397565" y="62852"/>
                  </a:cubicBezTo>
                  <a:lnTo>
                    <a:pt x="401546" y="54174"/>
                  </a:lnTo>
                  <a:cubicBezTo>
                    <a:pt x="408481" y="51187"/>
                    <a:pt x="414226" y="47099"/>
                    <a:pt x="420042" y="42666"/>
                  </a:cubicBezTo>
                  <a:lnTo>
                    <a:pt x="424862" y="38987"/>
                  </a:lnTo>
                  <a:cubicBezTo>
                    <a:pt x="428005" y="37227"/>
                    <a:pt x="432424" y="36378"/>
                    <a:pt x="435399" y="34460"/>
                  </a:cubicBezTo>
                  <a:cubicBezTo>
                    <a:pt x="440555" y="31096"/>
                    <a:pt x="445617" y="26285"/>
                    <a:pt x="450405" y="22449"/>
                  </a:cubicBezTo>
                  <a:cubicBezTo>
                    <a:pt x="450647" y="22261"/>
                    <a:pt x="461552" y="18928"/>
                    <a:pt x="463390" y="17576"/>
                  </a:cubicBezTo>
                  <a:cubicBezTo>
                    <a:pt x="466193" y="15532"/>
                    <a:pt x="467978" y="11539"/>
                    <a:pt x="470756" y="9432"/>
                  </a:cubicBezTo>
                  <a:cubicBezTo>
                    <a:pt x="472061" y="8426"/>
                    <a:pt x="479375" y="4213"/>
                    <a:pt x="486790" y="0"/>
                  </a:cubicBezTo>
                  <a:lnTo>
                    <a:pt x="490645" y="26631"/>
                  </a:lnTo>
                  <a:cubicBezTo>
                    <a:pt x="490683" y="26945"/>
                    <a:pt x="488877" y="30247"/>
                    <a:pt x="488796" y="30844"/>
                  </a:cubicBezTo>
                  <a:cubicBezTo>
                    <a:pt x="487954" y="36975"/>
                    <a:pt x="488158" y="44615"/>
                    <a:pt x="489214" y="50809"/>
                  </a:cubicBezTo>
                  <a:lnTo>
                    <a:pt x="500358" y="54991"/>
                  </a:lnTo>
                  <a:cubicBezTo>
                    <a:pt x="506405" y="54488"/>
                    <a:pt x="514732" y="50778"/>
                    <a:pt x="519239" y="47225"/>
                  </a:cubicBezTo>
                  <a:lnTo>
                    <a:pt x="527570" y="51375"/>
                  </a:lnTo>
                  <a:cubicBezTo>
                    <a:pt x="527805" y="51816"/>
                    <a:pt x="530275" y="56092"/>
                    <a:pt x="530292" y="56249"/>
                  </a:cubicBezTo>
                  <a:cubicBezTo>
                    <a:pt x="530846" y="60682"/>
                    <a:pt x="530089" y="66247"/>
                    <a:pt x="529997" y="70743"/>
                  </a:cubicBezTo>
                  <a:lnTo>
                    <a:pt x="537399" y="74893"/>
                  </a:lnTo>
                  <a:cubicBezTo>
                    <a:pt x="537122" y="77629"/>
                    <a:pt x="535256" y="83603"/>
                    <a:pt x="532495" y="85300"/>
                  </a:cubicBezTo>
                  <a:lnTo>
                    <a:pt x="535526" y="89639"/>
                  </a:lnTo>
                  <a:lnTo>
                    <a:pt x="541591" y="98349"/>
                  </a:lnTo>
                  <a:cubicBezTo>
                    <a:pt x="542159" y="99449"/>
                    <a:pt x="542046" y="100235"/>
                    <a:pt x="542337" y="101430"/>
                  </a:cubicBezTo>
                  <a:lnTo>
                    <a:pt x="543835" y="107593"/>
                  </a:lnTo>
                  <a:cubicBezTo>
                    <a:pt x="544600" y="112780"/>
                    <a:pt x="543632" y="121395"/>
                    <a:pt x="546838" y="125891"/>
                  </a:cubicBezTo>
                  <a:cubicBezTo>
                    <a:pt x="549770" y="126992"/>
                    <a:pt x="554116" y="127149"/>
                    <a:pt x="557200" y="126646"/>
                  </a:cubicBezTo>
                  <a:lnTo>
                    <a:pt x="562489" y="130356"/>
                  </a:lnTo>
                  <a:lnTo>
                    <a:pt x="565025" y="139285"/>
                  </a:lnTo>
                  <a:lnTo>
                    <a:pt x="569855" y="139506"/>
                  </a:lnTo>
                  <a:cubicBezTo>
                    <a:pt x="578305" y="134789"/>
                    <a:pt x="587885" y="130199"/>
                    <a:pt x="595865" y="124917"/>
                  </a:cubicBezTo>
                  <a:cubicBezTo>
                    <a:pt x="599022" y="122810"/>
                    <a:pt x="602537" y="118629"/>
                    <a:pt x="605308" y="115987"/>
                  </a:cubicBezTo>
                  <a:cubicBezTo>
                    <a:pt x="605395" y="113283"/>
                    <a:pt x="607307" y="109259"/>
                    <a:pt x="609443" y="107341"/>
                  </a:cubicBezTo>
                  <a:lnTo>
                    <a:pt x="624863" y="105832"/>
                  </a:lnTo>
                  <a:lnTo>
                    <a:pt x="630626" y="108819"/>
                  </a:lnTo>
                  <a:cubicBezTo>
                    <a:pt x="630945" y="111523"/>
                    <a:pt x="629198" y="115893"/>
                    <a:pt x="626925" y="117748"/>
                  </a:cubicBezTo>
                  <a:lnTo>
                    <a:pt x="627851" y="122181"/>
                  </a:lnTo>
                  <a:lnTo>
                    <a:pt x="624624" y="126646"/>
                  </a:lnTo>
                  <a:lnTo>
                    <a:pt x="626013" y="131111"/>
                  </a:lnTo>
                  <a:cubicBezTo>
                    <a:pt x="624523" y="136361"/>
                    <a:pt x="619370" y="139726"/>
                    <a:pt x="617493" y="144945"/>
                  </a:cubicBezTo>
                  <a:lnTo>
                    <a:pt x="618637" y="153371"/>
                  </a:lnTo>
                  <a:lnTo>
                    <a:pt x="623940" y="156106"/>
                  </a:lnTo>
                  <a:lnTo>
                    <a:pt x="625091" y="160791"/>
                  </a:lnTo>
                  <a:lnTo>
                    <a:pt x="635674" y="165256"/>
                  </a:lnTo>
                  <a:cubicBezTo>
                    <a:pt x="638185" y="163369"/>
                    <a:pt x="643166" y="161672"/>
                    <a:pt x="646477" y="161797"/>
                  </a:cubicBezTo>
                  <a:cubicBezTo>
                    <a:pt x="648484" y="163747"/>
                    <a:pt x="649729" y="166734"/>
                    <a:pt x="650560" y="169123"/>
                  </a:cubicBezTo>
                  <a:cubicBezTo>
                    <a:pt x="651307" y="171324"/>
                    <a:pt x="653145" y="177550"/>
                    <a:pt x="655015" y="179373"/>
                  </a:cubicBezTo>
                  <a:cubicBezTo>
                    <a:pt x="657134" y="181448"/>
                    <a:pt x="666902" y="185661"/>
                    <a:pt x="669747" y="186793"/>
                  </a:cubicBezTo>
                  <a:cubicBezTo>
                    <a:pt x="670603" y="183680"/>
                    <a:pt x="672224" y="180002"/>
                    <a:pt x="674356" y="177392"/>
                  </a:cubicBezTo>
                  <a:cubicBezTo>
                    <a:pt x="679337" y="174499"/>
                    <a:pt x="688769" y="172927"/>
                    <a:pt x="694585" y="173934"/>
                  </a:cubicBezTo>
                  <a:lnTo>
                    <a:pt x="698742" y="165004"/>
                  </a:lnTo>
                  <a:lnTo>
                    <a:pt x="704038" y="163526"/>
                  </a:lnTo>
                  <a:lnTo>
                    <a:pt x="709798" y="167237"/>
                  </a:lnTo>
                  <a:lnTo>
                    <a:pt x="720391" y="167740"/>
                  </a:lnTo>
                  <a:cubicBezTo>
                    <a:pt x="723425" y="169972"/>
                    <a:pt x="726551" y="173431"/>
                    <a:pt x="728206" y="176638"/>
                  </a:cubicBezTo>
                  <a:lnTo>
                    <a:pt x="733966" y="176386"/>
                  </a:lnTo>
                  <a:cubicBezTo>
                    <a:pt x="735842" y="173305"/>
                    <a:pt x="739582" y="170035"/>
                    <a:pt x="742939" y="168243"/>
                  </a:cubicBezTo>
                  <a:cubicBezTo>
                    <a:pt x="752718" y="168306"/>
                    <a:pt x="759263" y="178304"/>
                    <a:pt x="758807" y="186290"/>
                  </a:cubicBezTo>
                  <a:cubicBezTo>
                    <a:pt x="758179" y="197389"/>
                    <a:pt x="756741" y="208865"/>
                    <a:pt x="757671" y="219964"/>
                  </a:cubicBezTo>
                  <a:lnTo>
                    <a:pt x="762971" y="224177"/>
                  </a:lnTo>
                  <a:cubicBezTo>
                    <a:pt x="762441" y="231566"/>
                    <a:pt x="765233" y="235653"/>
                    <a:pt x="767113" y="242256"/>
                  </a:cubicBezTo>
                  <a:cubicBezTo>
                    <a:pt x="767906" y="245054"/>
                    <a:pt x="767875" y="248135"/>
                    <a:pt x="768730" y="250902"/>
                  </a:cubicBezTo>
                  <a:cubicBezTo>
                    <a:pt x="770179" y="255587"/>
                    <a:pt x="776247" y="260240"/>
                    <a:pt x="781386" y="261309"/>
                  </a:cubicBezTo>
                  <a:cubicBezTo>
                    <a:pt x="784891" y="262032"/>
                    <a:pt x="786932" y="261749"/>
                    <a:pt x="790664" y="262975"/>
                  </a:cubicBezTo>
                  <a:cubicBezTo>
                    <a:pt x="794856" y="264328"/>
                    <a:pt x="798570" y="267755"/>
                    <a:pt x="803260" y="268006"/>
                  </a:cubicBezTo>
                  <a:cubicBezTo>
                    <a:pt x="814050" y="268572"/>
                    <a:pt x="826555" y="268037"/>
                    <a:pt x="836853" y="271465"/>
                  </a:cubicBezTo>
                  <a:cubicBezTo>
                    <a:pt x="841304" y="274609"/>
                    <a:pt x="844311" y="284293"/>
                    <a:pt x="844437" y="289292"/>
                  </a:cubicBezTo>
                  <a:cubicBezTo>
                    <a:pt x="844458" y="290046"/>
                    <a:pt x="843900" y="293285"/>
                    <a:pt x="843984" y="293757"/>
                  </a:cubicBezTo>
                  <a:cubicBezTo>
                    <a:pt x="844023" y="293977"/>
                    <a:pt x="845843" y="297529"/>
                    <a:pt x="846058" y="297970"/>
                  </a:cubicBezTo>
                  <a:cubicBezTo>
                    <a:pt x="849653" y="299605"/>
                    <a:pt x="857342" y="302843"/>
                    <a:pt x="861488" y="303158"/>
                  </a:cubicBezTo>
                  <a:cubicBezTo>
                    <a:pt x="863189" y="303283"/>
                    <a:pt x="865062" y="302843"/>
                    <a:pt x="866777" y="302906"/>
                  </a:cubicBezTo>
                  <a:cubicBezTo>
                    <a:pt x="872105" y="303158"/>
                    <a:pt x="883688" y="306710"/>
                    <a:pt x="887718" y="309100"/>
                  </a:cubicBezTo>
                  <a:cubicBezTo>
                    <a:pt x="890830" y="310923"/>
                    <a:pt x="892278" y="315105"/>
                    <a:pt x="894165" y="317778"/>
                  </a:cubicBezTo>
                  <a:cubicBezTo>
                    <a:pt x="896431" y="320953"/>
                    <a:pt x="899090" y="324066"/>
                    <a:pt x="901525" y="327179"/>
                  </a:cubicBezTo>
                  <a:cubicBezTo>
                    <a:pt x="897235" y="338341"/>
                    <a:pt x="900262" y="339284"/>
                    <a:pt x="901525" y="349691"/>
                  </a:cubicBezTo>
                  <a:cubicBezTo>
                    <a:pt x="902138" y="354753"/>
                    <a:pt x="897940" y="358243"/>
                    <a:pt x="896000" y="362582"/>
                  </a:cubicBezTo>
                  <a:cubicBezTo>
                    <a:pt x="895804" y="363022"/>
                    <a:pt x="895516" y="366292"/>
                    <a:pt x="895319" y="367047"/>
                  </a:cubicBezTo>
                  <a:cubicBezTo>
                    <a:pt x="894569" y="369845"/>
                    <a:pt x="893467" y="372674"/>
                    <a:pt x="892555" y="375441"/>
                  </a:cubicBezTo>
                  <a:lnTo>
                    <a:pt x="887722" y="379183"/>
                  </a:lnTo>
                  <a:lnTo>
                    <a:pt x="871387" y="381164"/>
                  </a:lnTo>
                  <a:cubicBezTo>
                    <a:pt x="868514" y="383710"/>
                    <a:pt x="864340" y="386697"/>
                    <a:pt x="861954" y="389558"/>
                  </a:cubicBezTo>
                  <a:cubicBezTo>
                    <a:pt x="859997" y="391916"/>
                    <a:pt x="859229" y="395532"/>
                    <a:pt x="857359" y="397985"/>
                  </a:cubicBezTo>
                  <a:cubicBezTo>
                    <a:pt x="856812" y="398708"/>
                    <a:pt x="852855" y="401380"/>
                    <a:pt x="852498" y="401946"/>
                  </a:cubicBezTo>
                  <a:cubicBezTo>
                    <a:pt x="850954" y="404399"/>
                    <a:pt x="849926" y="408643"/>
                    <a:pt x="848881" y="411379"/>
                  </a:cubicBezTo>
                  <a:cubicBezTo>
                    <a:pt x="837193" y="413360"/>
                    <a:pt x="827070" y="420559"/>
                    <a:pt x="822353" y="430401"/>
                  </a:cubicBezTo>
                  <a:cubicBezTo>
                    <a:pt x="822279" y="434362"/>
                    <a:pt x="824433" y="435557"/>
                    <a:pt x="826039" y="438576"/>
                  </a:cubicBezTo>
                  <a:cubicBezTo>
                    <a:pt x="827453" y="441248"/>
                    <a:pt x="828526" y="444235"/>
                    <a:pt x="829733" y="447002"/>
                  </a:cubicBezTo>
                  <a:cubicBezTo>
                    <a:pt x="828126" y="450240"/>
                    <a:pt x="826965" y="454327"/>
                    <a:pt x="826730" y="457880"/>
                  </a:cubicBezTo>
                  <a:cubicBezTo>
                    <a:pt x="830059" y="463131"/>
                    <a:pt x="834514" y="467690"/>
                    <a:pt x="838849" y="472281"/>
                  </a:cubicBezTo>
                  <a:cubicBezTo>
                    <a:pt x="840133" y="473632"/>
                    <a:pt x="841055" y="474261"/>
                    <a:pt x="842143" y="475739"/>
                  </a:cubicBezTo>
                  <a:cubicBezTo>
                    <a:pt x="842522" y="476274"/>
                    <a:pt x="842378" y="476683"/>
                    <a:pt x="842529" y="477311"/>
                  </a:cubicBezTo>
                  <a:lnTo>
                    <a:pt x="843304" y="480424"/>
                  </a:lnTo>
                  <a:cubicBezTo>
                    <a:pt x="843041" y="486618"/>
                    <a:pt x="836664" y="494195"/>
                    <a:pt x="832255" y="498503"/>
                  </a:cubicBezTo>
                  <a:cubicBezTo>
                    <a:pt x="829985" y="500703"/>
                    <a:pt x="826846" y="502433"/>
                    <a:pt x="824657" y="504696"/>
                  </a:cubicBezTo>
                  <a:cubicBezTo>
                    <a:pt x="823447" y="505923"/>
                    <a:pt x="821195" y="510293"/>
                    <a:pt x="821069" y="512148"/>
                  </a:cubicBezTo>
                  <a:cubicBezTo>
                    <a:pt x="823615" y="512494"/>
                    <a:pt x="827351" y="512620"/>
                    <a:pt x="829736" y="513343"/>
                  </a:cubicBezTo>
                  <a:cubicBezTo>
                    <a:pt x="833423" y="514475"/>
                    <a:pt x="834675" y="517399"/>
                    <a:pt x="840084" y="517053"/>
                  </a:cubicBezTo>
                  <a:cubicBezTo>
                    <a:pt x="842865" y="514506"/>
                    <a:pt x="846931" y="511928"/>
                    <a:pt x="850667" y="510639"/>
                  </a:cubicBezTo>
                  <a:lnTo>
                    <a:pt x="855272" y="519788"/>
                  </a:lnTo>
                  <a:cubicBezTo>
                    <a:pt x="854048" y="524064"/>
                    <a:pt x="852648" y="528372"/>
                    <a:pt x="851589" y="532648"/>
                  </a:cubicBezTo>
                  <a:cubicBezTo>
                    <a:pt x="851200" y="534251"/>
                    <a:pt x="851319" y="536044"/>
                    <a:pt x="850898" y="537616"/>
                  </a:cubicBezTo>
                  <a:cubicBezTo>
                    <a:pt x="849407" y="543212"/>
                    <a:pt x="844665" y="555506"/>
                    <a:pt x="845374" y="561134"/>
                  </a:cubicBezTo>
                  <a:cubicBezTo>
                    <a:pt x="845405" y="561354"/>
                    <a:pt x="848537" y="569309"/>
                    <a:pt x="848829" y="570032"/>
                  </a:cubicBezTo>
                  <a:lnTo>
                    <a:pt x="843069" y="573773"/>
                  </a:lnTo>
                  <a:lnTo>
                    <a:pt x="841014" y="578206"/>
                  </a:lnTo>
                  <a:lnTo>
                    <a:pt x="836166" y="581194"/>
                  </a:lnTo>
                  <a:lnTo>
                    <a:pt x="835941" y="585407"/>
                  </a:lnTo>
                  <a:cubicBezTo>
                    <a:pt x="840361" y="591475"/>
                    <a:pt x="847440" y="595562"/>
                    <a:pt x="854578" y="598769"/>
                  </a:cubicBezTo>
                  <a:cubicBezTo>
                    <a:pt x="857384" y="596002"/>
                    <a:pt x="865732" y="594745"/>
                    <a:pt x="869555" y="594808"/>
                  </a:cubicBezTo>
                  <a:lnTo>
                    <a:pt x="877595" y="586381"/>
                  </a:lnTo>
                  <a:cubicBezTo>
                    <a:pt x="881106" y="586287"/>
                    <a:pt x="885978" y="582986"/>
                    <a:pt x="887732" y="580439"/>
                  </a:cubicBezTo>
                  <a:cubicBezTo>
                    <a:pt x="891731" y="580942"/>
                    <a:pt x="894169" y="582954"/>
                    <a:pt x="897624" y="584401"/>
                  </a:cubicBezTo>
                  <a:cubicBezTo>
                    <a:pt x="901205" y="585878"/>
                    <a:pt x="905071" y="586916"/>
                    <a:pt x="908673" y="588362"/>
                  </a:cubicBezTo>
                  <a:cubicBezTo>
                    <a:pt x="913633" y="590374"/>
                    <a:pt x="918572" y="593676"/>
                    <a:pt x="924100" y="594304"/>
                  </a:cubicBezTo>
                  <a:lnTo>
                    <a:pt x="930537" y="603454"/>
                  </a:lnTo>
                  <a:cubicBezTo>
                    <a:pt x="933206" y="604932"/>
                    <a:pt x="937573" y="605749"/>
                    <a:pt x="940670" y="605435"/>
                  </a:cubicBezTo>
                  <a:cubicBezTo>
                    <a:pt x="943582" y="608107"/>
                    <a:pt x="946672" y="611534"/>
                    <a:pt x="949864" y="613861"/>
                  </a:cubicBezTo>
                  <a:cubicBezTo>
                    <a:pt x="952930" y="616125"/>
                    <a:pt x="956981" y="617697"/>
                    <a:pt x="960222" y="619803"/>
                  </a:cubicBezTo>
                  <a:cubicBezTo>
                    <a:pt x="964396" y="622508"/>
                    <a:pt x="970082" y="627978"/>
                    <a:pt x="970819" y="632694"/>
                  </a:cubicBezTo>
                  <a:lnTo>
                    <a:pt x="975887" y="635650"/>
                  </a:lnTo>
                  <a:cubicBezTo>
                    <a:pt x="980854" y="636184"/>
                    <a:pt x="983590" y="633606"/>
                    <a:pt x="986923" y="633418"/>
                  </a:cubicBezTo>
                  <a:cubicBezTo>
                    <a:pt x="995916" y="632914"/>
                    <a:pt x="1003584" y="635021"/>
                    <a:pt x="1013164" y="632946"/>
                  </a:cubicBezTo>
                  <a:lnTo>
                    <a:pt x="1037784" y="642818"/>
                  </a:lnTo>
                  <a:cubicBezTo>
                    <a:pt x="1041341" y="642221"/>
                    <a:pt x="1045459" y="640523"/>
                    <a:pt x="1048381" y="638605"/>
                  </a:cubicBezTo>
                  <a:lnTo>
                    <a:pt x="1053211" y="640838"/>
                  </a:lnTo>
                  <a:cubicBezTo>
                    <a:pt x="1054211" y="645805"/>
                    <a:pt x="1057915" y="646497"/>
                    <a:pt x="1061030" y="649516"/>
                  </a:cubicBezTo>
                  <a:cubicBezTo>
                    <a:pt x="1064758" y="653100"/>
                    <a:pt x="1068041" y="659734"/>
                    <a:pt x="1073934" y="660897"/>
                  </a:cubicBezTo>
                  <a:lnTo>
                    <a:pt x="1084969" y="660646"/>
                  </a:lnTo>
                  <a:cubicBezTo>
                    <a:pt x="1088347" y="662658"/>
                    <a:pt x="1091936" y="666305"/>
                    <a:pt x="1093718" y="669575"/>
                  </a:cubicBezTo>
                  <a:cubicBezTo>
                    <a:pt x="1093293" y="672373"/>
                    <a:pt x="1091722" y="675612"/>
                    <a:pt x="1090038" y="677970"/>
                  </a:cubicBezTo>
                  <a:cubicBezTo>
                    <a:pt x="1081953" y="682340"/>
                    <a:pt x="1070756" y="682372"/>
                    <a:pt x="1061717" y="682686"/>
                  </a:cubicBezTo>
                  <a:cubicBezTo>
                    <a:pt x="1059886" y="687779"/>
                    <a:pt x="1055154" y="687685"/>
                    <a:pt x="1053432" y="689635"/>
                  </a:cubicBezTo>
                  <a:cubicBezTo>
                    <a:pt x="1050359" y="693093"/>
                    <a:pt x="1047697" y="698375"/>
                    <a:pt x="1045157" y="702243"/>
                  </a:cubicBezTo>
                  <a:cubicBezTo>
                    <a:pt x="1039591" y="703720"/>
                    <a:pt x="1034227" y="707084"/>
                    <a:pt x="1030657" y="711140"/>
                  </a:cubicBezTo>
                  <a:lnTo>
                    <a:pt x="1025367" y="712146"/>
                  </a:lnTo>
                  <a:lnTo>
                    <a:pt x="1021912" y="716611"/>
                  </a:lnTo>
                  <a:lnTo>
                    <a:pt x="1022147" y="720824"/>
                  </a:lnTo>
                  <a:cubicBezTo>
                    <a:pt x="1027510" y="723277"/>
                    <a:pt x="1033684" y="722019"/>
                    <a:pt x="1038254" y="726012"/>
                  </a:cubicBezTo>
                  <a:lnTo>
                    <a:pt x="1041699" y="734690"/>
                  </a:lnTo>
                  <a:cubicBezTo>
                    <a:pt x="1044259" y="736545"/>
                    <a:pt x="1049226" y="737991"/>
                    <a:pt x="1052513" y="737897"/>
                  </a:cubicBezTo>
                  <a:lnTo>
                    <a:pt x="1053432" y="741859"/>
                  </a:lnTo>
                  <a:cubicBezTo>
                    <a:pt x="1052246" y="743714"/>
                    <a:pt x="1050447" y="748650"/>
                    <a:pt x="1050682" y="750756"/>
                  </a:cubicBezTo>
                  <a:cubicBezTo>
                    <a:pt x="1050973" y="753460"/>
                    <a:pt x="1052239" y="756259"/>
                    <a:pt x="1052737" y="758931"/>
                  </a:cubicBezTo>
                  <a:cubicBezTo>
                    <a:pt x="1053888" y="765157"/>
                    <a:pt x="1054309" y="771319"/>
                    <a:pt x="1055971" y="777513"/>
                  </a:cubicBezTo>
                  <a:cubicBezTo>
                    <a:pt x="1054814" y="781349"/>
                    <a:pt x="1051731" y="782732"/>
                    <a:pt x="1049531" y="785688"/>
                  </a:cubicBezTo>
                  <a:cubicBezTo>
                    <a:pt x="1046402" y="789901"/>
                    <a:pt x="1047683" y="794932"/>
                    <a:pt x="1046536" y="799554"/>
                  </a:cubicBezTo>
                  <a:cubicBezTo>
                    <a:pt x="1045662" y="803043"/>
                    <a:pt x="1040173" y="807037"/>
                    <a:pt x="1039633" y="808451"/>
                  </a:cubicBezTo>
                  <a:cubicBezTo>
                    <a:pt x="1037290" y="814614"/>
                    <a:pt x="1037879" y="825084"/>
                    <a:pt x="1033185" y="830240"/>
                  </a:cubicBezTo>
                  <a:lnTo>
                    <a:pt x="1022150" y="831467"/>
                  </a:lnTo>
                  <a:cubicBezTo>
                    <a:pt x="1019151" y="835176"/>
                    <a:pt x="1021803" y="854324"/>
                    <a:pt x="1022150" y="859198"/>
                  </a:cubicBezTo>
                  <a:cubicBezTo>
                    <a:pt x="1022378" y="862499"/>
                    <a:pt x="1021698" y="865297"/>
                    <a:pt x="1022841" y="868599"/>
                  </a:cubicBezTo>
                  <a:cubicBezTo>
                    <a:pt x="1023939" y="871774"/>
                    <a:pt x="1025668" y="874384"/>
                    <a:pt x="1026279" y="877780"/>
                  </a:cubicBezTo>
                  <a:cubicBezTo>
                    <a:pt x="1028885" y="892180"/>
                    <a:pt x="1017755" y="900355"/>
                    <a:pt x="1028829" y="913686"/>
                  </a:cubicBezTo>
                  <a:lnTo>
                    <a:pt x="1028134" y="917647"/>
                  </a:lnTo>
                  <a:cubicBezTo>
                    <a:pt x="1024862" y="922364"/>
                    <a:pt x="1022431" y="921829"/>
                    <a:pt x="1018923" y="924313"/>
                  </a:cubicBezTo>
                  <a:cubicBezTo>
                    <a:pt x="1015373" y="926828"/>
                    <a:pt x="1014703" y="929815"/>
                    <a:pt x="1012943" y="933242"/>
                  </a:cubicBezTo>
                  <a:cubicBezTo>
                    <a:pt x="1007962" y="942894"/>
                    <a:pt x="1006232" y="943303"/>
                    <a:pt x="1006029" y="954276"/>
                  </a:cubicBezTo>
                  <a:lnTo>
                    <a:pt x="1009723" y="959244"/>
                  </a:lnTo>
                  <a:cubicBezTo>
                    <a:pt x="1009063" y="963237"/>
                    <a:pt x="1006566" y="967702"/>
                    <a:pt x="1004549" y="971286"/>
                  </a:cubicBezTo>
                  <a:cubicBezTo>
                    <a:pt x="999943" y="976851"/>
                    <a:pt x="995061" y="987290"/>
                    <a:pt x="994976" y="994364"/>
                  </a:cubicBezTo>
                  <a:cubicBezTo>
                    <a:pt x="992437" y="995496"/>
                    <a:pt x="985639" y="999237"/>
                    <a:pt x="983941" y="1001061"/>
                  </a:cubicBezTo>
                  <a:cubicBezTo>
                    <a:pt x="983520" y="1001501"/>
                    <a:pt x="982352" y="1004645"/>
                    <a:pt x="981857" y="1005274"/>
                  </a:cubicBezTo>
                  <a:cubicBezTo>
                    <a:pt x="980721" y="1006721"/>
                    <a:pt x="978588" y="1007789"/>
                    <a:pt x="977483" y="1009236"/>
                  </a:cubicBezTo>
                  <a:cubicBezTo>
                    <a:pt x="976042" y="1011122"/>
                    <a:pt x="974744" y="1015839"/>
                    <a:pt x="974733" y="1018165"/>
                  </a:cubicBezTo>
                  <a:lnTo>
                    <a:pt x="966897" y="1026560"/>
                  </a:lnTo>
                  <a:cubicBezTo>
                    <a:pt x="966897" y="1029641"/>
                    <a:pt x="965775" y="1033509"/>
                    <a:pt x="964137" y="1036213"/>
                  </a:cubicBezTo>
                  <a:cubicBezTo>
                    <a:pt x="961643" y="1037564"/>
                    <a:pt x="957935" y="1037659"/>
                    <a:pt x="955238" y="1037533"/>
                  </a:cubicBezTo>
                  <a:cubicBezTo>
                    <a:pt x="945262" y="1037093"/>
                    <a:pt x="940674" y="1036621"/>
                    <a:pt x="933532" y="1029767"/>
                  </a:cubicBezTo>
                  <a:cubicBezTo>
                    <a:pt x="932378" y="1028667"/>
                    <a:pt x="931543" y="1026812"/>
                    <a:pt x="930305" y="1025805"/>
                  </a:cubicBezTo>
                  <a:cubicBezTo>
                    <a:pt x="926026" y="1022441"/>
                    <a:pt x="920105" y="1024202"/>
                    <a:pt x="915348" y="1021372"/>
                  </a:cubicBezTo>
                  <a:cubicBezTo>
                    <a:pt x="913703" y="1026057"/>
                    <a:pt x="917828" y="1030396"/>
                    <a:pt x="918572" y="1034735"/>
                  </a:cubicBezTo>
                  <a:cubicBezTo>
                    <a:pt x="919094" y="1037816"/>
                    <a:pt x="918056" y="1041494"/>
                    <a:pt x="918340" y="1044639"/>
                  </a:cubicBezTo>
                  <a:cubicBezTo>
                    <a:pt x="918600" y="1047531"/>
                    <a:pt x="920122" y="1050581"/>
                    <a:pt x="920263" y="1053474"/>
                  </a:cubicBezTo>
                  <a:cubicBezTo>
                    <a:pt x="920455" y="1057435"/>
                    <a:pt x="919663" y="1062057"/>
                    <a:pt x="919386" y="1066050"/>
                  </a:cubicBezTo>
                  <a:cubicBezTo>
                    <a:pt x="911848" y="1070955"/>
                    <a:pt x="904190" y="1076929"/>
                    <a:pt x="898073" y="1083249"/>
                  </a:cubicBezTo>
                  <a:lnTo>
                    <a:pt x="887497" y="1082022"/>
                  </a:lnTo>
                  <a:lnTo>
                    <a:pt x="887953" y="1086707"/>
                  </a:lnTo>
                  <a:lnTo>
                    <a:pt x="892559" y="1089694"/>
                  </a:lnTo>
                  <a:lnTo>
                    <a:pt x="892327" y="1094159"/>
                  </a:lnTo>
                  <a:lnTo>
                    <a:pt x="886575" y="1096863"/>
                  </a:lnTo>
                  <a:cubicBezTo>
                    <a:pt x="883442" y="1095260"/>
                    <a:pt x="874480" y="1091864"/>
                    <a:pt x="870695" y="1093153"/>
                  </a:cubicBezTo>
                  <a:cubicBezTo>
                    <a:pt x="866669" y="1096769"/>
                    <a:pt x="862042" y="1101045"/>
                    <a:pt x="859190" y="1105541"/>
                  </a:cubicBezTo>
                  <a:cubicBezTo>
                    <a:pt x="860597" y="1108654"/>
                    <a:pt x="862207" y="1115319"/>
                    <a:pt x="860807" y="1118652"/>
                  </a:cubicBezTo>
                  <a:lnTo>
                    <a:pt x="855497" y="1120884"/>
                  </a:lnTo>
                  <a:cubicBezTo>
                    <a:pt x="851231" y="1119972"/>
                    <a:pt x="849155" y="1117300"/>
                    <a:pt x="845591" y="1115696"/>
                  </a:cubicBezTo>
                  <a:cubicBezTo>
                    <a:pt x="841715" y="1113904"/>
                    <a:pt x="829873" y="1108999"/>
                    <a:pt x="825362" y="1109502"/>
                  </a:cubicBezTo>
                  <a:cubicBezTo>
                    <a:pt x="825053" y="1109534"/>
                    <a:pt x="815730" y="1111640"/>
                    <a:pt x="815457" y="1111735"/>
                  </a:cubicBezTo>
                  <a:cubicBezTo>
                    <a:pt x="811559" y="1113087"/>
                    <a:pt x="809469" y="1116231"/>
                    <a:pt x="804421" y="1115193"/>
                  </a:cubicBezTo>
                  <a:cubicBezTo>
                    <a:pt x="800991" y="1114470"/>
                    <a:pt x="797437" y="1112678"/>
                    <a:pt x="794046" y="1111735"/>
                  </a:cubicBezTo>
                  <a:cubicBezTo>
                    <a:pt x="786150" y="1109471"/>
                    <a:pt x="779162" y="1110508"/>
                    <a:pt x="773578" y="1116168"/>
                  </a:cubicBezTo>
                  <a:cubicBezTo>
                    <a:pt x="771140" y="1118652"/>
                    <a:pt x="769260" y="1121701"/>
                    <a:pt x="769422" y="1125097"/>
                  </a:cubicBezTo>
                  <a:cubicBezTo>
                    <a:pt x="769499" y="1126669"/>
                    <a:pt x="770355" y="1128430"/>
                    <a:pt x="770572" y="1130033"/>
                  </a:cubicBezTo>
                  <a:cubicBezTo>
                    <a:pt x="770951" y="1132800"/>
                    <a:pt x="771039" y="1135693"/>
                    <a:pt x="771267" y="1138460"/>
                  </a:cubicBezTo>
                  <a:lnTo>
                    <a:pt x="761599" y="1144905"/>
                  </a:lnTo>
                  <a:lnTo>
                    <a:pt x="760684" y="1149338"/>
                  </a:lnTo>
                  <a:lnTo>
                    <a:pt x="755370" y="1150345"/>
                  </a:lnTo>
                  <a:cubicBezTo>
                    <a:pt x="752283" y="1152765"/>
                    <a:pt x="749144" y="1156035"/>
                    <a:pt x="747092" y="1159274"/>
                  </a:cubicBezTo>
                  <a:cubicBezTo>
                    <a:pt x="744391" y="1160186"/>
                    <a:pt x="739554" y="1159431"/>
                    <a:pt x="737200" y="1158016"/>
                  </a:cubicBezTo>
                  <a:cubicBezTo>
                    <a:pt x="735225" y="1160500"/>
                    <a:pt x="730300" y="1163299"/>
                    <a:pt x="726838" y="1163456"/>
                  </a:cubicBezTo>
                  <a:cubicBezTo>
                    <a:pt x="724092" y="1162292"/>
                    <a:pt x="719942" y="1161852"/>
                    <a:pt x="716954" y="1162229"/>
                  </a:cubicBezTo>
                  <a:cubicBezTo>
                    <a:pt x="713460" y="1165468"/>
                    <a:pt x="708297" y="1170970"/>
                    <a:pt x="709128" y="1175844"/>
                  </a:cubicBezTo>
                  <a:cubicBezTo>
                    <a:pt x="713183" y="1177195"/>
                    <a:pt x="718080" y="1184238"/>
                    <a:pt x="719711" y="1187477"/>
                  </a:cubicBezTo>
                  <a:lnTo>
                    <a:pt x="718115" y="1191942"/>
                  </a:lnTo>
                  <a:cubicBezTo>
                    <a:pt x="714860" y="1191690"/>
                    <a:pt x="710436" y="1192287"/>
                    <a:pt x="707511" y="1193671"/>
                  </a:cubicBezTo>
                  <a:cubicBezTo>
                    <a:pt x="705329" y="1195274"/>
                    <a:pt x="702965" y="1199204"/>
                    <a:pt x="703140" y="1201845"/>
                  </a:cubicBezTo>
                  <a:lnTo>
                    <a:pt x="697847" y="1205304"/>
                  </a:lnTo>
                  <a:lnTo>
                    <a:pt x="687251" y="1206279"/>
                  </a:lnTo>
                  <a:cubicBezTo>
                    <a:pt x="685079" y="1204455"/>
                    <a:pt x="680330" y="1203009"/>
                    <a:pt x="677359" y="1203323"/>
                  </a:cubicBezTo>
                  <a:lnTo>
                    <a:pt x="675980" y="1208040"/>
                  </a:lnTo>
                  <a:cubicBezTo>
                    <a:pt x="671049" y="1212819"/>
                    <a:pt x="664763" y="1212819"/>
                    <a:pt x="659406" y="1217441"/>
                  </a:cubicBezTo>
                  <a:lnTo>
                    <a:pt x="653899" y="1217692"/>
                  </a:lnTo>
                  <a:lnTo>
                    <a:pt x="649048" y="1221874"/>
                  </a:lnTo>
                  <a:cubicBezTo>
                    <a:pt x="646277" y="1222880"/>
                    <a:pt x="641202" y="1223068"/>
                    <a:pt x="638448" y="1221874"/>
                  </a:cubicBezTo>
                  <a:cubicBezTo>
                    <a:pt x="638448" y="1222282"/>
                    <a:pt x="638395" y="1225930"/>
                    <a:pt x="638448" y="1226087"/>
                  </a:cubicBezTo>
                  <a:cubicBezTo>
                    <a:pt x="639992" y="1230929"/>
                    <a:pt x="643506" y="1231023"/>
                    <a:pt x="642370" y="1238475"/>
                  </a:cubicBezTo>
                  <a:cubicBezTo>
                    <a:pt x="642282" y="1239072"/>
                    <a:pt x="642450" y="1239449"/>
                    <a:pt x="642145" y="1239953"/>
                  </a:cubicBezTo>
                  <a:cubicBezTo>
                    <a:pt x="641082" y="1241776"/>
                    <a:pt x="640177" y="1242625"/>
                    <a:pt x="638922" y="1244323"/>
                  </a:cubicBezTo>
                  <a:cubicBezTo>
                    <a:pt x="635922" y="1248410"/>
                    <a:pt x="633025" y="1253378"/>
                    <a:pt x="628858" y="1256679"/>
                  </a:cubicBezTo>
                  <a:cubicBezTo>
                    <a:pt x="627423" y="1255484"/>
                    <a:pt x="625122" y="1253975"/>
                    <a:pt x="623965" y="1252592"/>
                  </a:cubicBezTo>
                  <a:cubicBezTo>
                    <a:pt x="622990" y="1251428"/>
                    <a:pt x="622488" y="1249416"/>
                    <a:pt x="621664" y="1248127"/>
                  </a:cubicBezTo>
                  <a:cubicBezTo>
                    <a:pt x="620496" y="1246303"/>
                    <a:pt x="615659" y="1240644"/>
                    <a:pt x="613845" y="1239732"/>
                  </a:cubicBezTo>
                  <a:cubicBezTo>
                    <a:pt x="607840" y="1236651"/>
                    <a:pt x="606402" y="1238915"/>
                    <a:pt x="600411" y="1233444"/>
                  </a:cubicBezTo>
                  <a:lnTo>
                    <a:pt x="598874" y="1232061"/>
                  </a:lnTo>
                  <a:cubicBezTo>
                    <a:pt x="596444" y="1233884"/>
                    <a:pt x="591024" y="1235551"/>
                    <a:pt x="587818" y="1234765"/>
                  </a:cubicBezTo>
                  <a:cubicBezTo>
                    <a:pt x="583385" y="1230583"/>
                    <a:pt x="577116" y="1229357"/>
                    <a:pt x="572405" y="1225364"/>
                  </a:cubicBezTo>
                  <a:cubicBezTo>
                    <a:pt x="569350" y="1225458"/>
                    <a:pt x="565330" y="1224295"/>
                    <a:pt x="562752" y="1222880"/>
                  </a:cubicBezTo>
                  <a:lnTo>
                    <a:pt x="563650" y="1218667"/>
                  </a:lnTo>
                  <a:lnTo>
                    <a:pt x="560900" y="1214233"/>
                  </a:lnTo>
                  <a:lnTo>
                    <a:pt x="561128" y="1210240"/>
                  </a:lnTo>
                  <a:cubicBezTo>
                    <a:pt x="549911" y="1199173"/>
                    <a:pt x="543625" y="1203512"/>
                    <a:pt x="535803" y="1199110"/>
                  </a:cubicBezTo>
                  <a:cubicBezTo>
                    <a:pt x="534014" y="1198104"/>
                    <a:pt x="532548" y="1196375"/>
                    <a:pt x="530755" y="1195400"/>
                  </a:cubicBezTo>
                  <a:cubicBezTo>
                    <a:pt x="528195" y="1193985"/>
                    <a:pt x="523870" y="1192822"/>
                    <a:pt x="520849" y="1192696"/>
                  </a:cubicBezTo>
                  <a:lnTo>
                    <a:pt x="516244" y="1187980"/>
                  </a:lnTo>
                  <a:cubicBezTo>
                    <a:pt x="511063" y="1188420"/>
                    <a:pt x="504756" y="1189080"/>
                    <a:pt x="499912" y="1190935"/>
                  </a:cubicBezTo>
                  <a:cubicBezTo>
                    <a:pt x="496440" y="1189238"/>
                    <a:pt x="489101" y="1186376"/>
                    <a:pt x="484941" y="1186722"/>
                  </a:cubicBezTo>
                  <a:cubicBezTo>
                    <a:pt x="480283" y="1188735"/>
                    <a:pt x="472882" y="1192476"/>
                    <a:pt x="469525" y="1196155"/>
                  </a:cubicBezTo>
                  <a:cubicBezTo>
                    <a:pt x="468799" y="1198639"/>
                    <a:pt x="470409" y="1202852"/>
                    <a:pt x="472047" y="1204801"/>
                  </a:cubicBezTo>
                  <a:lnTo>
                    <a:pt x="468150" y="1209517"/>
                  </a:lnTo>
                  <a:cubicBezTo>
                    <a:pt x="465074" y="1208763"/>
                    <a:pt x="460819" y="1209046"/>
                    <a:pt x="457781" y="1209769"/>
                  </a:cubicBezTo>
                  <a:lnTo>
                    <a:pt x="452951" y="1213730"/>
                  </a:lnTo>
                  <a:lnTo>
                    <a:pt x="449500" y="1213636"/>
                  </a:lnTo>
                  <a:cubicBezTo>
                    <a:pt x="442940" y="1213479"/>
                    <a:pt x="441288" y="1213165"/>
                    <a:pt x="435988" y="1216623"/>
                  </a:cubicBezTo>
                  <a:lnTo>
                    <a:pt x="432456" y="1218918"/>
                  </a:lnTo>
                  <a:cubicBezTo>
                    <a:pt x="429271" y="1220050"/>
                    <a:pt x="425195" y="1220239"/>
                    <a:pt x="421873" y="1221150"/>
                  </a:cubicBezTo>
                  <a:cubicBezTo>
                    <a:pt x="418292" y="1222125"/>
                    <a:pt x="416124" y="1223854"/>
                    <a:pt x="411985" y="1223634"/>
                  </a:cubicBezTo>
                  <a:cubicBezTo>
                    <a:pt x="408526" y="1221434"/>
                    <a:pt x="401434" y="1217535"/>
                    <a:pt x="397028" y="1217189"/>
                  </a:cubicBezTo>
                  <a:lnTo>
                    <a:pt x="389567" y="1222534"/>
                  </a:lnTo>
                  <a:cubicBezTo>
                    <a:pt x="384811" y="1208826"/>
                    <a:pt x="394464" y="1198576"/>
                    <a:pt x="388196" y="1193168"/>
                  </a:cubicBezTo>
                  <a:cubicBezTo>
                    <a:pt x="385635" y="1190967"/>
                    <a:pt x="382422" y="1189772"/>
                    <a:pt x="380174" y="1187162"/>
                  </a:cubicBezTo>
                  <a:lnTo>
                    <a:pt x="384551" y="1184804"/>
                  </a:lnTo>
                  <a:cubicBezTo>
                    <a:pt x="397575" y="1190904"/>
                    <a:pt x="424876" y="1183201"/>
                    <a:pt x="423929" y="1167575"/>
                  </a:cubicBezTo>
                  <a:lnTo>
                    <a:pt x="419555" y="1164933"/>
                  </a:lnTo>
                  <a:lnTo>
                    <a:pt x="413963" y="1165719"/>
                  </a:lnTo>
                  <a:cubicBezTo>
                    <a:pt x="409060" y="1173297"/>
                    <a:pt x="394355" y="1181975"/>
                    <a:pt x="386495" y="1172259"/>
                  </a:cubicBezTo>
                  <a:cubicBezTo>
                    <a:pt x="382580" y="1172259"/>
                    <a:pt x="378662" y="1172574"/>
                    <a:pt x="374828" y="1173297"/>
                  </a:cubicBezTo>
                  <a:cubicBezTo>
                    <a:pt x="372415" y="1175372"/>
                    <a:pt x="369405" y="1177070"/>
                    <a:pt x="367536" y="1179585"/>
                  </a:cubicBezTo>
                  <a:cubicBezTo>
                    <a:pt x="362586" y="1186251"/>
                    <a:pt x="364547" y="1197475"/>
                    <a:pt x="368507" y="1204172"/>
                  </a:cubicBezTo>
                  <a:cubicBezTo>
                    <a:pt x="370050" y="1206782"/>
                    <a:pt x="372110" y="1209171"/>
                    <a:pt x="373123" y="1212001"/>
                  </a:cubicBezTo>
                  <a:cubicBezTo>
                    <a:pt x="366143" y="1220742"/>
                    <a:pt x="364950" y="1221025"/>
                    <a:pt x="353680" y="1223508"/>
                  </a:cubicBezTo>
                  <a:cubicBezTo>
                    <a:pt x="350344" y="1224232"/>
                    <a:pt x="347587" y="1226307"/>
                    <a:pt x="344199" y="1226904"/>
                  </a:cubicBezTo>
                  <a:cubicBezTo>
                    <a:pt x="340176" y="1227627"/>
                    <a:pt x="336051" y="1226244"/>
                    <a:pt x="332045" y="1227156"/>
                  </a:cubicBezTo>
                  <a:cubicBezTo>
                    <a:pt x="328692" y="1227942"/>
                    <a:pt x="326222" y="1230457"/>
                    <a:pt x="322809" y="1231086"/>
                  </a:cubicBezTo>
                  <a:cubicBezTo>
                    <a:pt x="313707" y="1232815"/>
                    <a:pt x="305579" y="1225081"/>
                    <a:pt x="303604" y="1217755"/>
                  </a:cubicBezTo>
                  <a:cubicBezTo>
                    <a:pt x="297270" y="1213888"/>
                    <a:pt x="284859" y="1207882"/>
                    <a:pt x="280271" y="1204424"/>
                  </a:cubicBezTo>
                  <a:cubicBezTo>
                    <a:pt x="274414" y="1199990"/>
                    <a:pt x="272846" y="1195023"/>
                    <a:pt x="269331" y="1189521"/>
                  </a:cubicBezTo>
                  <a:cubicBezTo>
                    <a:pt x="265458" y="1183452"/>
                    <a:pt x="245037" y="1171033"/>
                    <a:pt x="238463" y="1165719"/>
                  </a:cubicBezTo>
                  <a:cubicBezTo>
                    <a:pt x="235492" y="1163330"/>
                    <a:pt x="233209" y="1156696"/>
                    <a:pt x="232872" y="1153174"/>
                  </a:cubicBezTo>
                  <a:lnTo>
                    <a:pt x="237734" y="1151602"/>
                  </a:lnTo>
                  <a:cubicBezTo>
                    <a:pt x="244346" y="1152923"/>
                    <a:pt x="259439" y="1156727"/>
                    <a:pt x="265441" y="1156318"/>
                  </a:cubicBezTo>
                  <a:cubicBezTo>
                    <a:pt x="269282" y="1156067"/>
                    <a:pt x="272695" y="1155124"/>
                    <a:pt x="276623" y="1155281"/>
                  </a:cubicBezTo>
                  <a:cubicBezTo>
                    <a:pt x="280598" y="1155438"/>
                    <a:pt x="284642" y="1156130"/>
                    <a:pt x="288532" y="1154998"/>
                  </a:cubicBezTo>
                  <a:lnTo>
                    <a:pt x="288532" y="1149779"/>
                  </a:lnTo>
                  <a:cubicBezTo>
                    <a:pt x="286266" y="1147389"/>
                    <a:pt x="283393" y="1145440"/>
                    <a:pt x="280271" y="1144025"/>
                  </a:cubicBezTo>
                  <a:lnTo>
                    <a:pt x="282218" y="1139592"/>
                  </a:lnTo>
                  <a:cubicBezTo>
                    <a:pt x="295000" y="1136762"/>
                    <a:pt x="306141" y="1145534"/>
                    <a:pt x="313815" y="1144276"/>
                  </a:cubicBezTo>
                  <a:lnTo>
                    <a:pt x="316004" y="1141164"/>
                  </a:lnTo>
                  <a:cubicBezTo>
                    <a:pt x="316099" y="1137799"/>
                    <a:pt x="315734" y="1134467"/>
                    <a:pt x="314787" y="1131228"/>
                  </a:cubicBezTo>
                  <a:cubicBezTo>
                    <a:pt x="310066" y="1127392"/>
                    <a:pt x="303250" y="1127424"/>
                    <a:pt x="297771" y="1124940"/>
                  </a:cubicBezTo>
                  <a:cubicBezTo>
                    <a:pt x="292727" y="1110414"/>
                    <a:pt x="290858" y="1109502"/>
                    <a:pt x="289023" y="1093058"/>
                  </a:cubicBezTo>
                  <a:cubicBezTo>
                    <a:pt x="288220" y="1085890"/>
                    <a:pt x="295379" y="1078218"/>
                    <a:pt x="293397" y="1071081"/>
                  </a:cubicBezTo>
                  <a:lnTo>
                    <a:pt x="289753" y="1067937"/>
                  </a:lnTo>
                  <a:cubicBezTo>
                    <a:pt x="273631" y="1067780"/>
                    <a:pt x="279174" y="1089474"/>
                    <a:pt x="277353" y="1098529"/>
                  </a:cubicBezTo>
                  <a:cubicBezTo>
                    <a:pt x="276557" y="1102491"/>
                    <a:pt x="274796" y="1105635"/>
                    <a:pt x="272979" y="1109251"/>
                  </a:cubicBezTo>
                  <a:cubicBezTo>
                    <a:pt x="269310" y="1116545"/>
                    <a:pt x="268843" y="1128682"/>
                    <a:pt x="256938" y="1128587"/>
                  </a:cubicBezTo>
                  <a:lnTo>
                    <a:pt x="253048" y="1126512"/>
                  </a:lnTo>
                  <a:cubicBezTo>
                    <a:pt x="253157" y="1121104"/>
                    <a:pt x="252171" y="1115508"/>
                    <a:pt x="254265" y="1110288"/>
                  </a:cubicBezTo>
                  <a:lnTo>
                    <a:pt x="251592" y="1106641"/>
                  </a:lnTo>
                  <a:cubicBezTo>
                    <a:pt x="241055" y="1112206"/>
                    <a:pt x="245198" y="1130600"/>
                    <a:pt x="225934" y="1129688"/>
                  </a:cubicBezTo>
                  <a:cubicBezTo>
                    <a:pt x="215134" y="1129184"/>
                    <a:pt x="213615" y="1124563"/>
                    <a:pt x="204681" y="1121544"/>
                  </a:cubicBezTo>
                  <a:cubicBezTo>
                    <a:pt x="198553" y="1119469"/>
                    <a:pt x="191779" y="1119627"/>
                    <a:pt x="185722" y="1117362"/>
                  </a:cubicBezTo>
                  <a:lnTo>
                    <a:pt x="183045" y="1113716"/>
                  </a:lnTo>
                  <a:lnTo>
                    <a:pt x="184017" y="1108716"/>
                  </a:lnTo>
                  <a:cubicBezTo>
                    <a:pt x="191253" y="1105666"/>
                    <a:pt x="198725" y="1099347"/>
                    <a:pt x="206379" y="1097743"/>
                  </a:cubicBezTo>
                  <a:lnTo>
                    <a:pt x="212941" y="1090166"/>
                  </a:lnTo>
                  <a:lnTo>
                    <a:pt x="211724" y="1085450"/>
                  </a:lnTo>
                  <a:cubicBezTo>
                    <a:pt x="207974" y="1085450"/>
                    <a:pt x="204197" y="1085733"/>
                    <a:pt x="200542" y="1086519"/>
                  </a:cubicBezTo>
                  <a:lnTo>
                    <a:pt x="195925" y="1083626"/>
                  </a:lnTo>
                  <a:cubicBezTo>
                    <a:pt x="196052" y="1077967"/>
                    <a:pt x="199311" y="1072810"/>
                    <a:pt x="199570" y="1067151"/>
                  </a:cubicBezTo>
                  <a:cubicBezTo>
                    <a:pt x="199724" y="1063881"/>
                    <a:pt x="198251" y="1060768"/>
                    <a:pt x="198353" y="1057498"/>
                  </a:cubicBezTo>
                  <a:cubicBezTo>
                    <a:pt x="198991" y="1037564"/>
                    <a:pt x="218098" y="1048569"/>
                    <a:pt x="230925" y="1043884"/>
                  </a:cubicBezTo>
                  <a:cubicBezTo>
                    <a:pt x="236650" y="1041809"/>
                    <a:pt x="239744" y="1034326"/>
                    <a:pt x="246482" y="1032125"/>
                  </a:cubicBezTo>
                  <a:cubicBezTo>
                    <a:pt x="255711" y="1029107"/>
                    <a:pt x="262144" y="1037313"/>
                    <a:pt x="276139" y="1031622"/>
                  </a:cubicBezTo>
                  <a:cubicBezTo>
                    <a:pt x="282239" y="1022378"/>
                    <a:pt x="276434" y="1017536"/>
                    <a:pt x="276627" y="1007570"/>
                  </a:cubicBezTo>
                  <a:lnTo>
                    <a:pt x="279784" y="1003639"/>
                  </a:lnTo>
                  <a:lnTo>
                    <a:pt x="279296" y="999709"/>
                  </a:lnTo>
                  <a:cubicBezTo>
                    <a:pt x="259825" y="1002036"/>
                    <a:pt x="259250" y="1011154"/>
                    <a:pt x="243079" y="1016436"/>
                  </a:cubicBezTo>
                  <a:cubicBezTo>
                    <a:pt x="236839" y="1015210"/>
                    <a:pt x="230361" y="1016373"/>
                    <a:pt x="224120" y="1015147"/>
                  </a:cubicBezTo>
                  <a:cubicBezTo>
                    <a:pt x="221591" y="1007632"/>
                    <a:pt x="222864" y="1002256"/>
                    <a:pt x="223391" y="994741"/>
                  </a:cubicBezTo>
                  <a:lnTo>
                    <a:pt x="220963" y="993169"/>
                  </a:lnTo>
                  <a:cubicBezTo>
                    <a:pt x="215035" y="997697"/>
                    <a:pt x="210931" y="1004708"/>
                    <a:pt x="201843" y="1002853"/>
                  </a:cubicBezTo>
                  <a:cubicBezTo>
                    <a:pt x="198700" y="1002193"/>
                    <a:pt x="198163" y="1001407"/>
                    <a:pt x="194940" y="1002413"/>
                  </a:cubicBezTo>
                  <a:cubicBezTo>
                    <a:pt x="188352" y="1004488"/>
                    <a:pt x="186763" y="1010619"/>
                    <a:pt x="182558" y="1014864"/>
                  </a:cubicBezTo>
                  <a:cubicBezTo>
                    <a:pt x="179124" y="1018354"/>
                    <a:pt x="174722" y="1020932"/>
                    <a:pt x="171133" y="1024296"/>
                  </a:cubicBezTo>
                  <a:cubicBezTo>
                    <a:pt x="165005" y="1030019"/>
                    <a:pt x="161806" y="1038005"/>
                    <a:pt x="154605" y="1042847"/>
                  </a:cubicBezTo>
                  <a:cubicBezTo>
                    <a:pt x="149403" y="1046368"/>
                    <a:pt x="142882" y="1046682"/>
                    <a:pt x="136860" y="1048349"/>
                  </a:cubicBezTo>
                  <a:lnTo>
                    <a:pt x="140262" y="1047563"/>
                  </a:lnTo>
                  <a:lnTo>
                    <a:pt x="134671" y="1048600"/>
                  </a:lnTo>
                  <a:cubicBezTo>
                    <a:pt x="115031" y="1039483"/>
                    <a:pt x="132307" y="1028195"/>
                    <a:pt x="142693" y="1020115"/>
                  </a:cubicBezTo>
                  <a:lnTo>
                    <a:pt x="142451" y="1014864"/>
                  </a:lnTo>
                  <a:lnTo>
                    <a:pt x="139778" y="1011217"/>
                  </a:lnTo>
                  <a:cubicBezTo>
                    <a:pt x="132591" y="1009330"/>
                    <a:pt x="126993" y="1015021"/>
                    <a:pt x="121061" y="1017505"/>
                  </a:cubicBezTo>
                  <a:cubicBezTo>
                    <a:pt x="117925" y="1018794"/>
                    <a:pt x="114460" y="1019297"/>
                    <a:pt x="111338" y="1020618"/>
                  </a:cubicBezTo>
                  <a:lnTo>
                    <a:pt x="106964" y="1018008"/>
                  </a:lnTo>
                  <a:cubicBezTo>
                    <a:pt x="105522" y="1013826"/>
                    <a:pt x="108447" y="1010053"/>
                    <a:pt x="110121" y="1006343"/>
                  </a:cubicBezTo>
                  <a:cubicBezTo>
                    <a:pt x="112453" y="1001155"/>
                    <a:pt x="115512" y="993798"/>
                    <a:pt x="120573" y="990308"/>
                  </a:cubicBezTo>
                  <a:cubicBezTo>
                    <a:pt x="132563" y="982039"/>
                    <a:pt x="148649" y="987510"/>
                    <a:pt x="154601" y="970940"/>
                  </a:cubicBezTo>
                  <a:cubicBezTo>
                    <a:pt x="152444" y="965564"/>
                    <a:pt x="149743" y="963048"/>
                    <a:pt x="142689" y="962860"/>
                  </a:cubicBezTo>
                  <a:cubicBezTo>
                    <a:pt x="136379" y="966256"/>
                    <a:pt x="130865" y="968299"/>
                    <a:pt x="124214" y="970940"/>
                  </a:cubicBezTo>
                  <a:lnTo>
                    <a:pt x="119353" y="969368"/>
                  </a:lnTo>
                  <a:lnTo>
                    <a:pt x="117651" y="965187"/>
                  </a:lnTo>
                  <a:cubicBezTo>
                    <a:pt x="119104" y="960062"/>
                    <a:pt x="120931" y="953930"/>
                    <a:pt x="118869" y="948743"/>
                  </a:cubicBezTo>
                  <a:cubicBezTo>
                    <a:pt x="112415" y="945190"/>
                    <a:pt x="107083" y="942517"/>
                    <a:pt x="105255" y="935380"/>
                  </a:cubicBezTo>
                  <a:lnTo>
                    <a:pt x="107686" y="930695"/>
                  </a:lnTo>
                  <a:lnTo>
                    <a:pt x="112790" y="929375"/>
                  </a:lnTo>
                  <a:cubicBezTo>
                    <a:pt x="115705" y="931544"/>
                    <a:pt x="119163" y="933085"/>
                    <a:pt x="122755" y="934091"/>
                  </a:cubicBezTo>
                  <a:cubicBezTo>
                    <a:pt x="129318" y="932299"/>
                    <a:pt x="127484" y="924784"/>
                    <a:pt x="138799" y="923370"/>
                  </a:cubicBezTo>
                  <a:cubicBezTo>
                    <a:pt x="144710" y="927645"/>
                    <a:pt x="161715" y="930664"/>
                    <a:pt x="163834" y="932519"/>
                  </a:cubicBezTo>
                  <a:cubicBezTo>
                    <a:pt x="167987" y="936166"/>
                    <a:pt x="167520" y="939782"/>
                    <a:pt x="173803" y="942706"/>
                  </a:cubicBezTo>
                  <a:cubicBezTo>
                    <a:pt x="180632" y="941354"/>
                    <a:pt x="185781" y="936795"/>
                    <a:pt x="190573" y="932519"/>
                  </a:cubicBezTo>
                  <a:lnTo>
                    <a:pt x="195435" y="934091"/>
                  </a:lnTo>
                  <a:cubicBezTo>
                    <a:pt x="195862" y="935632"/>
                    <a:pt x="196617" y="937204"/>
                    <a:pt x="196652" y="938807"/>
                  </a:cubicBezTo>
                  <a:cubicBezTo>
                    <a:pt x="196792" y="945536"/>
                    <a:pt x="187893" y="960250"/>
                    <a:pt x="202485" y="966759"/>
                  </a:cubicBezTo>
                  <a:cubicBezTo>
                    <a:pt x="229978" y="961854"/>
                    <a:pt x="214015" y="921766"/>
                    <a:pt x="235541" y="914472"/>
                  </a:cubicBezTo>
                  <a:lnTo>
                    <a:pt x="238218" y="909787"/>
                  </a:lnTo>
                  <a:lnTo>
                    <a:pt x="242592" y="907429"/>
                  </a:lnTo>
                  <a:cubicBezTo>
                    <a:pt x="251526" y="911485"/>
                    <a:pt x="255967" y="925350"/>
                    <a:pt x="268601" y="924690"/>
                  </a:cubicBezTo>
                  <a:cubicBezTo>
                    <a:pt x="271516" y="924501"/>
                    <a:pt x="275459" y="921515"/>
                    <a:pt x="276623" y="919188"/>
                  </a:cubicBezTo>
                  <a:cubicBezTo>
                    <a:pt x="274855" y="912428"/>
                    <a:pt x="266437" y="904725"/>
                    <a:pt x="259365" y="902178"/>
                  </a:cubicBezTo>
                  <a:lnTo>
                    <a:pt x="257661" y="897997"/>
                  </a:lnTo>
                  <a:cubicBezTo>
                    <a:pt x="258457" y="895072"/>
                    <a:pt x="260270" y="892368"/>
                    <a:pt x="262526" y="890168"/>
                  </a:cubicBezTo>
                  <a:lnTo>
                    <a:pt x="261554" y="885734"/>
                  </a:lnTo>
                  <a:lnTo>
                    <a:pt x="257910" y="882307"/>
                  </a:lnTo>
                  <a:cubicBezTo>
                    <a:pt x="246180" y="880766"/>
                    <a:pt x="234882" y="896802"/>
                    <a:pt x="223636" y="893563"/>
                  </a:cubicBezTo>
                  <a:cubicBezTo>
                    <a:pt x="220251" y="892588"/>
                    <a:pt x="217691" y="889664"/>
                    <a:pt x="214158" y="888596"/>
                  </a:cubicBezTo>
                  <a:cubicBezTo>
                    <a:pt x="209683" y="887275"/>
                    <a:pt x="202215" y="885420"/>
                    <a:pt x="197630" y="885451"/>
                  </a:cubicBezTo>
                  <a:lnTo>
                    <a:pt x="193986" y="882307"/>
                  </a:lnTo>
                  <a:lnTo>
                    <a:pt x="196659" y="877874"/>
                  </a:lnTo>
                  <a:cubicBezTo>
                    <a:pt x="196027" y="875013"/>
                    <a:pt x="194003" y="871963"/>
                    <a:pt x="191313" y="870297"/>
                  </a:cubicBezTo>
                  <a:lnTo>
                    <a:pt x="190096" y="865580"/>
                  </a:lnTo>
                  <a:lnTo>
                    <a:pt x="186451" y="862436"/>
                  </a:lnTo>
                  <a:cubicBezTo>
                    <a:pt x="184280" y="862153"/>
                    <a:pt x="182102" y="861556"/>
                    <a:pt x="179888" y="861650"/>
                  </a:cubicBezTo>
                  <a:cubicBezTo>
                    <a:pt x="170242" y="862090"/>
                    <a:pt x="148270" y="869259"/>
                    <a:pt x="141237" y="859041"/>
                  </a:cubicBezTo>
                  <a:lnTo>
                    <a:pt x="143426" y="853570"/>
                  </a:lnTo>
                  <a:cubicBezTo>
                    <a:pt x="149866" y="849294"/>
                    <a:pt x="160596" y="847124"/>
                    <a:pt x="168460" y="846244"/>
                  </a:cubicBezTo>
                  <a:cubicBezTo>
                    <a:pt x="172087" y="843037"/>
                    <a:pt x="176707" y="840427"/>
                    <a:pt x="179159" y="836309"/>
                  </a:cubicBezTo>
                  <a:cubicBezTo>
                    <a:pt x="182235" y="831152"/>
                    <a:pt x="185946" y="815117"/>
                    <a:pt x="177163" y="812224"/>
                  </a:cubicBezTo>
                  <a:lnTo>
                    <a:pt x="189647" y="791379"/>
                  </a:lnTo>
                  <a:lnTo>
                    <a:pt x="193333" y="782450"/>
                  </a:lnTo>
                  <a:lnTo>
                    <a:pt x="198167" y="779243"/>
                  </a:lnTo>
                  <a:lnTo>
                    <a:pt x="203453" y="777765"/>
                  </a:lnTo>
                  <a:lnTo>
                    <a:pt x="206449" y="773049"/>
                  </a:lnTo>
                  <a:lnTo>
                    <a:pt x="205993" y="768364"/>
                  </a:lnTo>
                  <a:lnTo>
                    <a:pt x="204147" y="764402"/>
                  </a:lnTo>
                  <a:lnTo>
                    <a:pt x="204369" y="759434"/>
                  </a:lnTo>
                  <a:lnTo>
                    <a:pt x="210595" y="753492"/>
                  </a:lnTo>
                  <a:lnTo>
                    <a:pt x="210353" y="744594"/>
                  </a:lnTo>
                  <a:lnTo>
                    <a:pt x="207143" y="739627"/>
                  </a:lnTo>
                  <a:lnTo>
                    <a:pt x="202299" y="739155"/>
                  </a:lnTo>
                  <a:lnTo>
                    <a:pt x="191958" y="733212"/>
                  </a:lnTo>
                  <a:lnTo>
                    <a:pt x="181358" y="722805"/>
                  </a:lnTo>
                  <a:lnTo>
                    <a:pt x="181590" y="713876"/>
                  </a:lnTo>
                  <a:lnTo>
                    <a:pt x="179292" y="700513"/>
                  </a:lnTo>
                  <a:lnTo>
                    <a:pt x="179517" y="695577"/>
                  </a:lnTo>
                  <a:lnTo>
                    <a:pt x="185845" y="680108"/>
                  </a:lnTo>
                  <a:lnTo>
                    <a:pt x="204842" y="650993"/>
                  </a:lnTo>
                  <a:lnTo>
                    <a:pt x="206221" y="655961"/>
                  </a:lnTo>
                  <a:cubicBezTo>
                    <a:pt x="209967" y="657344"/>
                    <a:pt x="214186" y="660080"/>
                    <a:pt x="217031" y="662626"/>
                  </a:cubicBezTo>
                  <a:cubicBezTo>
                    <a:pt x="218543" y="664010"/>
                    <a:pt x="219606" y="666054"/>
                    <a:pt x="221174" y="667343"/>
                  </a:cubicBezTo>
                  <a:cubicBezTo>
                    <a:pt x="227642" y="672656"/>
                    <a:pt x="234728" y="677592"/>
                    <a:pt x="241434" y="682686"/>
                  </a:cubicBezTo>
                  <a:cubicBezTo>
                    <a:pt x="243100" y="683944"/>
                    <a:pt x="245745" y="689289"/>
                    <a:pt x="246036" y="691364"/>
                  </a:cubicBezTo>
                  <a:cubicBezTo>
                    <a:pt x="244812" y="694131"/>
                    <a:pt x="243918" y="697527"/>
                    <a:pt x="243742" y="700513"/>
                  </a:cubicBezTo>
                  <a:lnTo>
                    <a:pt x="248580" y="704475"/>
                  </a:lnTo>
                  <a:cubicBezTo>
                    <a:pt x="250849" y="710103"/>
                    <a:pt x="248492" y="716202"/>
                    <a:pt x="243725" y="720196"/>
                  </a:cubicBezTo>
                  <a:cubicBezTo>
                    <a:pt x="247432" y="724220"/>
                    <a:pt x="251719" y="728559"/>
                    <a:pt x="256391" y="731703"/>
                  </a:cubicBezTo>
                  <a:cubicBezTo>
                    <a:pt x="267146" y="731766"/>
                    <a:pt x="273915" y="719315"/>
                    <a:pt x="282397" y="721548"/>
                  </a:cubicBezTo>
                  <a:cubicBezTo>
                    <a:pt x="287175" y="726232"/>
                    <a:pt x="301223" y="756950"/>
                    <a:pt x="304962" y="764402"/>
                  </a:cubicBezTo>
                  <a:cubicBezTo>
                    <a:pt x="311623" y="767640"/>
                    <a:pt x="318954" y="761038"/>
                    <a:pt x="325436" y="759937"/>
                  </a:cubicBezTo>
                  <a:lnTo>
                    <a:pt x="336030" y="763647"/>
                  </a:lnTo>
                  <a:lnTo>
                    <a:pt x="346858" y="761415"/>
                  </a:lnTo>
                  <a:cubicBezTo>
                    <a:pt x="351235" y="763270"/>
                    <a:pt x="357938" y="763647"/>
                    <a:pt x="362271" y="761415"/>
                  </a:cubicBezTo>
                  <a:cubicBezTo>
                    <a:pt x="363982" y="760535"/>
                    <a:pt x="365389" y="758522"/>
                    <a:pt x="367115" y="757705"/>
                  </a:cubicBezTo>
                  <a:cubicBezTo>
                    <a:pt x="375972" y="753460"/>
                    <a:pt x="385400" y="751134"/>
                    <a:pt x="393587" y="745569"/>
                  </a:cubicBezTo>
                  <a:cubicBezTo>
                    <a:pt x="398631" y="745726"/>
                    <a:pt x="404977" y="746512"/>
                    <a:pt x="409922" y="746072"/>
                  </a:cubicBezTo>
                  <a:cubicBezTo>
                    <a:pt x="412139" y="745852"/>
                    <a:pt x="414991" y="742456"/>
                    <a:pt x="420505" y="743336"/>
                  </a:cubicBezTo>
                  <a:lnTo>
                    <a:pt x="420505" y="756227"/>
                  </a:lnTo>
                  <a:cubicBezTo>
                    <a:pt x="423739" y="758585"/>
                    <a:pt x="426367" y="765031"/>
                    <a:pt x="427008" y="768521"/>
                  </a:cubicBezTo>
                  <a:lnTo>
                    <a:pt x="431814" y="771256"/>
                  </a:lnTo>
                  <a:cubicBezTo>
                    <a:pt x="436732" y="769558"/>
                    <a:pt x="444943" y="765880"/>
                    <a:pt x="448826" y="763145"/>
                  </a:cubicBezTo>
                  <a:cubicBezTo>
                    <a:pt x="452913" y="760252"/>
                    <a:pt x="461113" y="752674"/>
                    <a:pt x="463786" y="748304"/>
                  </a:cubicBezTo>
                  <a:cubicBezTo>
                    <a:pt x="467028" y="747833"/>
                    <a:pt x="470900" y="746921"/>
                    <a:pt x="474145" y="746795"/>
                  </a:cubicBezTo>
                  <a:cubicBezTo>
                    <a:pt x="476379" y="746732"/>
                    <a:pt x="480297" y="748210"/>
                    <a:pt x="484727" y="747801"/>
                  </a:cubicBezTo>
                  <a:lnTo>
                    <a:pt x="499467" y="735916"/>
                  </a:lnTo>
                  <a:lnTo>
                    <a:pt x="495528" y="731703"/>
                  </a:lnTo>
                  <a:lnTo>
                    <a:pt x="499228" y="727238"/>
                  </a:lnTo>
                  <a:lnTo>
                    <a:pt x="504756" y="728496"/>
                  </a:lnTo>
                  <a:lnTo>
                    <a:pt x="510284" y="725038"/>
                  </a:lnTo>
                  <a:cubicBezTo>
                    <a:pt x="511158" y="721170"/>
                    <a:pt x="518443" y="714536"/>
                    <a:pt x="521558" y="712146"/>
                  </a:cubicBezTo>
                  <a:lnTo>
                    <a:pt x="521558" y="707682"/>
                  </a:lnTo>
                  <a:lnTo>
                    <a:pt x="508566" y="705261"/>
                  </a:lnTo>
                  <a:lnTo>
                    <a:pt x="507250" y="698564"/>
                  </a:lnTo>
                  <a:cubicBezTo>
                    <a:pt x="509144" y="695640"/>
                    <a:pt x="511365" y="692653"/>
                    <a:pt x="513034" y="689635"/>
                  </a:cubicBezTo>
                  <a:cubicBezTo>
                    <a:pt x="513768" y="688283"/>
                    <a:pt x="513866" y="686459"/>
                    <a:pt x="514658" y="685170"/>
                  </a:cubicBezTo>
                  <a:cubicBezTo>
                    <a:pt x="519341" y="677624"/>
                    <a:pt x="530145" y="674857"/>
                    <a:pt x="538823" y="673034"/>
                  </a:cubicBezTo>
                  <a:lnTo>
                    <a:pt x="542720" y="669072"/>
                  </a:lnTo>
                  <a:cubicBezTo>
                    <a:pt x="541496" y="660866"/>
                    <a:pt x="537511" y="647912"/>
                    <a:pt x="530071" y="642347"/>
                  </a:cubicBezTo>
                  <a:cubicBezTo>
                    <a:pt x="524519" y="646749"/>
                    <a:pt x="516584" y="650239"/>
                    <a:pt x="509358" y="651748"/>
                  </a:cubicBezTo>
                  <a:cubicBezTo>
                    <a:pt x="500354" y="653603"/>
                    <a:pt x="494991" y="651874"/>
                    <a:pt x="487951" y="658665"/>
                  </a:cubicBezTo>
                  <a:lnTo>
                    <a:pt x="477596" y="659922"/>
                  </a:lnTo>
                  <a:cubicBezTo>
                    <a:pt x="463850" y="646843"/>
                    <a:pt x="489182" y="629173"/>
                    <a:pt x="486800" y="615339"/>
                  </a:cubicBezTo>
                  <a:cubicBezTo>
                    <a:pt x="484033" y="610811"/>
                    <a:pt x="478880" y="607416"/>
                    <a:pt x="477126" y="602479"/>
                  </a:cubicBezTo>
                  <a:lnTo>
                    <a:pt x="477901" y="596380"/>
                  </a:lnTo>
                  <a:cubicBezTo>
                    <a:pt x="478964" y="587985"/>
                    <a:pt x="472756" y="586381"/>
                    <a:pt x="468620" y="579936"/>
                  </a:cubicBezTo>
                  <a:cubicBezTo>
                    <a:pt x="468473" y="575157"/>
                    <a:pt x="468017" y="570126"/>
                    <a:pt x="468168" y="565347"/>
                  </a:cubicBezTo>
                  <a:cubicBezTo>
                    <a:pt x="468318" y="560536"/>
                    <a:pt x="469662" y="555506"/>
                    <a:pt x="469546" y="550727"/>
                  </a:cubicBezTo>
                  <a:cubicBezTo>
                    <a:pt x="469448" y="546640"/>
                    <a:pt x="462917" y="540320"/>
                    <a:pt x="459640" y="537867"/>
                  </a:cubicBezTo>
                  <a:cubicBezTo>
                    <a:pt x="453172" y="536578"/>
                    <a:pt x="443031" y="534534"/>
                    <a:pt x="437545" y="539094"/>
                  </a:cubicBezTo>
                  <a:cubicBezTo>
                    <a:pt x="434746" y="539094"/>
                    <a:pt x="423522" y="539094"/>
                    <a:pt x="420972" y="538370"/>
                  </a:cubicBezTo>
                  <a:cubicBezTo>
                    <a:pt x="414388" y="536453"/>
                    <a:pt x="410628" y="532082"/>
                    <a:pt x="403791" y="536044"/>
                  </a:cubicBezTo>
                  <a:lnTo>
                    <a:pt x="399799" y="538370"/>
                  </a:lnTo>
                  <a:lnTo>
                    <a:pt x="397733" y="542332"/>
                  </a:lnTo>
                  <a:cubicBezTo>
                    <a:pt x="392440" y="546010"/>
                    <a:pt x="385751" y="545036"/>
                    <a:pt x="381840" y="550255"/>
                  </a:cubicBezTo>
                  <a:lnTo>
                    <a:pt x="381921" y="553211"/>
                  </a:lnTo>
                  <a:lnTo>
                    <a:pt x="382078" y="559153"/>
                  </a:lnTo>
                  <a:cubicBezTo>
                    <a:pt x="381419" y="562863"/>
                    <a:pt x="376645" y="567925"/>
                    <a:pt x="373085" y="569654"/>
                  </a:cubicBezTo>
                  <a:cubicBezTo>
                    <a:pt x="373776" y="573616"/>
                    <a:pt x="375112" y="577735"/>
                    <a:pt x="376691" y="581476"/>
                  </a:cubicBezTo>
                  <a:cubicBezTo>
                    <a:pt x="374835" y="585501"/>
                    <a:pt x="370913" y="591412"/>
                    <a:pt x="366883" y="594053"/>
                  </a:cubicBezTo>
                  <a:lnTo>
                    <a:pt x="348531" y="568491"/>
                  </a:lnTo>
                  <a:lnTo>
                    <a:pt x="342312" y="568868"/>
                  </a:lnTo>
                  <a:cubicBezTo>
                    <a:pt x="340646" y="572232"/>
                    <a:pt x="332164" y="578615"/>
                    <a:pt x="328800" y="579873"/>
                  </a:cubicBezTo>
                  <a:cubicBezTo>
                    <a:pt x="328548" y="579967"/>
                    <a:pt x="318645" y="581256"/>
                    <a:pt x="317723" y="581382"/>
                  </a:cubicBezTo>
                  <a:lnTo>
                    <a:pt x="311655" y="601976"/>
                  </a:lnTo>
                  <a:cubicBezTo>
                    <a:pt x="311230" y="603422"/>
                    <a:pt x="309866" y="604994"/>
                    <a:pt x="309585" y="606441"/>
                  </a:cubicBezTo>
                  <a:cubicBezTo>
                    <a:pt x="309024" y="609302"/>
                    <a:pt x="308961" y="613169"/>
                    <a:pt x="308891" y="616093"/>
                  </a:cubicBezTo>
                  <a:cubicBezTo>
                    <a:pt x="308785" y="620495"/>
                    <a:pt x="309887" y="625463"/>
                    <a:pt x="308196" y="629707"/>
                  </a:cubicBezTo>
                  <a:cubicBezTo>
                    <a:pt x="303173" y="632789"/>
                    <a:pt x="297164" y="634046"/>
                    <a:pt x="291633" y="636153"/>
                  </a:cubicBezTo>
                  <a:cubicBezTo>
                    <a:pt x="287687" y="637631"/>
                    <a:pt x="283695" y="641058"/>
                    <a:pt x="281036" y="642095"/>
                  </a:cubicBezTo>
                  <a:lnTo>
                    <a:pt x="274284" y="643730"/>
                  </a:lnTo>
                  <a:cubicBezTo>
                    <a:pt x="272965" y="644076"/>
                    <a:pt x="272267" y="644422"/>
                    <a:pt x="270909" y="644548"/>
                  </a:cubicBezTo>
                  <a:cubicBezTo>
                    <a:pt x="267016" y="644925"/>
                    <a:pt x="263638" y="642095"/>
                    <a:pt x="260548" y="640617"/>
                  </a:cubicBezTo>
                  <a:cubicBezTo>
                    <a:pt x="257149" y="638951"/>
                    <a:pt x="252943" y="637788"/>
                    <a:pt x="249744" y="635901"/>
                  </a:cubicBezTo>
                  <a:cubicBezTo>
                    <a:pt x="243129" y="632034"/>
                    <a:pt x="240287" y="622256"/>
                    <a:pt x="232227" y="620306"/>
                  </a:cubicBezTo>
                  <a:lnTo>
                    <a:pt x="226481" y="620558"/>
                  </a:lnTo>
                  <a:cubicBezTo>
                    <a:pt x="224485" y="622508"/>
                    <a:pt x="220346" y="628544"/>
                    <a:pt x="221062" y="63134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59" name="자유형: 도형 300"/>
            <p:cNvSpPr/>
            <p:nvPr/>
          </p:nvSpPr>
          <p:spPr>
            <a:xfrm>
              <a:off x="6685200" y="1418760"/>
              <a:ext cx="191160" cy="282240"/>
            </a:xfrm>
            <a:custGeom>
              <a:avLst/>
              <a:gdLst/>
              <a:ahLst/>
              <a:cxnLst/>
              <a:rect l="l" t="t" r="r" b="b"/>
              <a:pathLst>
                <a:path w="151710" h="230173">
                  <a:moveTo>
                    <a:pt x="135526" y="67190"/>
                  </a:moveTo>
                  <a:lnTo>
                    <a:pt x="137999" y="62725"/>
                  </a:lnTo>
                  <a:lnTo>
                    <a:pt x="148129" y="55305"/>
                  </a:lnTo>
                  <a:lnTo>
                    <a:pt x="151577" y="50369"/>
                  </a:lnTo>
                  <a:lnTo>
                    <a:pt x="151711" y="47539"/>
                  </a:lnTo>
                  <a:lnTo>
                    <a:pt x="139953" y="44993"/>
                  </a:lnTo>
                  <a:lnTo>
                    <a:pt x="122990" y="50369"/>
                  </a:lnTo>
                  <a:lnTo>
                    <a:pt x="119444" y="40654"/>
                  </a:lnTo>
                  <a:lnTo>
                    <a:pt x="100685" y="38516"/>
                  </a:lnTo>
                  <a:lnTo>
                    <a:pt x="87924" y="25656"/>
                  </a:lnTo>
                  <a:lnTo>
                    <a:pt x="70431" y="10879"/>
                  </a:lnTo>
                  <a:lnTo>
                    <a:pt x="43506" y="0"/>
                  </a:lnTo>
                  <a:lnTo>
                    <a:pt x="31162" y="8678"/>
                  </a:lnTo>
                  <a:lnTo>
                    <a:pt x="23333" y="25499"/>
                  </a:lnTo>
                  <a:lnTo>
                    <a:pt x="12992" y="23172"/>
                  </a:lnTo>
                  <a:lnTo>
                    <a:pt x="0" y="34805"/>
                  </a:lnTo>
                  <a:cubicBezTo>
                    <a:pt x="1652" y="34523"/>
                    <a:pt x="3230" y="34271"/>
                    <a:pt x="4777" y="33925"/>
                  </a:cubicBezTo>
                  <a:lnTo>
                    <a:pt x="8422" y="37321"/>
                  </a:lnTo>
                  <a:cubicBezTo>
                    <a:pt x="10327" y="52759"/>
                    <a:pt x="21246" y="48860"/>
                    <a:pt x="33702" y="54834"/>
                  </a:cubicBezTo>
                  <a:lnTo>
                    <a:pt x="35648" y="59015"/>
                  </a:lnTo>
                  <a:lnTo>
                    <a:pt x="34431" y="63732"/>
                  </a:lnTo>
                  <a:lnTo>
                    <a:pt x="30545" y="66876"/>
                  </a:lnTo>
                  <a:lnTo>
                    <a:pt x="29328" y="71561"/>
                  </a:lnTo>
                  <a:cubicBezTo>
                    <a:pt x="31874" y="73636"/>
                    <a:pt x="34105" y="75994"/>
                    <a:pt x="35891" y="78635"/>
                  </a:cubicBezTo>
                  <a:lnTo>
                    <a:pt x="34431" y="83602"/>
                  </a:lnTo>
                  <a:cubicBezTo>
                    <a:pt x="35428" y="86432"/>
                    <a:pt x="36985" y="89105"/>
                    <a:pt x="39051" y="91431"/>
                  </a:cubicBezTo>
                  <a:cubicBezTo>
                    <a:pt x="38244" y="98412"/>
                    <a:pt x="31046" y="103788"/>
                    <a:pt x="32001" y="111051"/>
                  </a:cubicBezTo>
                  <a:cubicBezTo>
                    <a:pt x="32804" y="117150"/>
                    <a:pt x="46361" y="125262"/>
                    <a:pt x="48771" y="138216"/>
                  </a:cubicBezTo>
                  <a:cubicBezTo>
                    <a:pt x="47732" y="139096"/>
                    <a:pt x="46750" y="140071"/>
                    <a:pt x="45610" y="140857"/>
                  </a:cubicBezTo>
                  <a:cubicBezTo>
                    <a:pt x="39107" y="145259"/>
                    <a:pt x="13610" y="135072"/>
                    <a:pt x="8418" y="140323"/>
                  </a:cubicBezTo>
                  <a:cubicBezTo>
                    <a:pt x="7233" y="141518"/>
                    <a:pt x="6300" y="142932"/>
                    <a:pt x="5262" y="144253"/>
                  </a:cubicBezTo>
                  <a:cubicBezTo>
                    <a:pt x="6405" y="156955"/>
                    <a:pt x="19482" y="164312"/>
                    <a:pt x="25680" y="174562"/>
                  </a:cubicBezTo>
                  <a:cubicBezTo>
                    <a:pt x="34835" y="189748"/>
                    <a:pt x="24540" y="199527"/>
                    <a:pt x="37346" y="210122"/>
                  </a:cubicBezTo>
                  <a:cubicBezTo>
                    <a:pt x="48673" y="219523"/>
                    <a:pt x="66664" y="214241"/>
                    <a:pt x="73079" y="219272"/>
                  </a:cubicBezTo>
                  <a:cubicBezTo>
                    <a:pt x="75608" y="221284"/>
                    <a:pt x="76113" y="224617"/>
                    <a:pt x="78670" y="226598"/>
                  </a:cubicBezTo>
                  <a:cubicBezTo>
                    <a:pt x="88316" y="234081"/>
                    <a:pt x="103785" y="227321"/>
                    <a:pt x="107788" y="228421"/>
                  </a:cubicBezTo>
                  <a:lnTo>
                    <a:pt x="120271" y="207544"/>
                  </a:lnTo>
                  <a:lnTo>
                    <a:pt x="123958" y="198647"/>
                  </a:lnTo>
                  <a:lnTo>
                    <a:pt x="128792" y="195439"/>
                  </a:lnTo>
                  <a:lnTo>
                    <a:pt x="134078" y="193930"/>
                  </a:lnTo>
                  <a:lnTo>
                    <a:pt x="137073" y="189246"/>
                  </a:lnTo>
                  <a:lnTo>
                    <a:pt x="136617" y="184529"/>
                  </a:lnTo>
                  <a:lnTo>
                    <a:pt x="134772" y="180568"/>
                  </a:lnTo>
                  <a:lnTo>
                    <a:pt x="134993" y="175631"/>
                  </a:lnTo>
                  <a:lnTo>
                    <a:pt x="141219" y="169657"/>
                  </a:lnTo>
                  <a:lnTo>
                    <a:pt x="140977" y="160760"/>
                  </a:lnTo>
                  <a:lnTo>
                    <a:pt x="137768" y="155823"/>
                  </a:lnTo>
                  <a:lnTo>
                    <a:pt x="132924" y="155320"/>
                  </a:lnTo>
                  <a:lnTo>
                    <a:pt x="122583" y="149378"/>
                  </a:lnTo>
                  <a:lnTo>
                    <a:pt x="111983" y="138971"/>
                  </a:lnTo>
                  <a:lnTo>
                    <a:pt x="112214" y="130073"/>
                  </a:lnTo>
                  <a:lnTo>
                    <a:pt x="109917" y="116679"/>
                  </a:lnTo>
                  <a:lnTo>
                    <a:pt x="110141" y="111743"/>
                  </a:lnTo>
                  <a:lnTo>
                    <a:pt x="116469" y="96273"/>
                  </a:lnTo>
                  <a:lnTo>
                    <a:pt x="135526" y="67190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60" name="자유형: 도형 301"/>
            <p:cNvSpPr/>
            <p:nvPr/>
          </p:nvSpPr>
          <p:spPr>
            <a:xfrm>
              <a:off x="7212600" y="352440"/>
              <a:ext cx="2347920" cy="1738080"/>
            </a:xfrm>
            <a:custGeom>
              <a:avLst/>
              <a:gdLst/>
              <a:ahLst/>
              <a:cxnLst/>
              <a:rect l="l" t="t" r="r" b="b"/>
              <a:pathLst>
                <a:path w="1858852" h="1415017">
                  <a:moveTo>
                    <a:pt x="1033634" y="0"/>
                  </a:moveTo>
                  <a:cubicBezTo>
                    <a:pt x="1029320" y="2170"/>
                    <a:pt x="1018446" y="8080"/>
                    <a:pt x="1014412" y="10596"/>
                  </a:cubicBezTo>
                  <a:cubicBezTo>
                    <a:pt x="1012273" y="11948"/>
                    <a:pt x="1010484" y="13991"/>
                    <a:pt x="1008309" y="15249"/>
                  </a:cubicBezTo>
                  <a:cubicBezTo>
                    <a:pt x="1003061" y="18330"/>
                    <a:pt x="992721" y="21128"/>
                    <a:pt x="990648" y="27165"/>
                  </a:cubicBezTo>
                  <a:cubicBezTo>
                    <a:pt x="991644" y="37069"/>
                    <a:pt x="989879" y="46816"/>
                    <a:pt x="990560" y="56594"/>
                  </a:cubicBezTo>
                  <a:cubicBezTo>
                    <a:pt x="990953" y="62254"/>
                    <a:pt x="993784" y="78006"/>
                    <a:pt x="993962" y="80018"/>
                  </a:cubicBezTo>
                  <a:cubicBezTo>
                    <a:pt x="994204" y="82816"/>
                    <a:pt x="996270" y="94984"/>
                    <a:pt x="994517" y="98852"/>
                  </a:cubicBezTo>
                  <a:cubicBezTo>
                    <a:pt x="990862" y="106932"/>
                    <a:pt x="985049" y="111900"/>
                    <a:pt x="986807" y="121269"/>
                  </a:cubicBezTo>
                  <a:lnTo>
                    <a:pt x="988147" y="128438"/>
                  </a:lnTo>
                  <a:cubicBezTo>
                    <a:pt x="987540" y="129161"/>
                    <a:pt x="986477" y="130199"/>
                    <a:pt x="986046" y="130985"/>
                  </a:cubicBezTo>
                  <a:cubicBezTo>
                    <a:pt x="981700" y="139159"/>
                    <a:pt x="977368" y="147334"/>
                    <a:pt x="972979" y="155509"/>
                  </a:cubicBezTo>
                  <a:lnTo>
                    <a:pt x="969180" y="162552"/>
                  </a:lnTo>
                  <a:cubicBezTo>
                    <a:pt x="967641" y="164690"/>
                    <a:pt x="939621" y="187390"/>
                    <a:pt x="936142" y="189937"/>
                  </a:cubicBezTo>
                  <a:cubicBezTo>
                    <a:pt x="932760" y="192421"/>
                    <a:pt x="923858" y="195219"/>
                    <a:pt x="920708" y="198489"/>
                  </a:cubicBezTo>
                  <a:cubicBezTo>
                    <a:pt x="917695" y="201602"/>
                    <a:pt x="914562" y="206067"/>
                    <a:pt x="912044" y="209557"/>
                  </a:cubicBezTo>
                  <a:cubicBezTo>
                    <a:pt x="911030" y="210971"/>
                    <a:pt x="907379" y="215531"/>
                    <a:pt x="907126" y="215688"/>
                  </a:cubicBezTo>
                  <a:cubicBezTo>
                    <a:pt x="906624" y="216033"/>
                    <a:pt x="894078" y="221536"/>
                    <a:pt x="893979" y="221630"/>
                  </a:cubicBezTo>
                  <a:cubicBezTo>
                    <a:pt x="887701" y="227887"/>
                    <a:pt x="885101" y="230150"/>
                    <a:pt x="875494" y="232320"/>
                  </a:cubicBezTo>
                  <a:cubicBezTo>
                    <a:pt x="873943" y="234993"/>
                    <a:pt x="867321" y="241186"/>
                    <a:pt x="864974" y="242916"/>
                  </a:cubicBezTo>
                  <a:cubicBezTo>
                    <a:pt x="862203" y="244991"/>
                    <a:pt x="858247" y="246186"/>
                    <a:pt x="855489" y="248261"/>
                  </a:cubicBezTo>
                  <a:cubicBezTo>
                    <a:pt x="851263" y="251436"/>
                    <a:pt x="850158" y="255712"/>
                    <a:pt x="843672" y="257127"/>
                  </a:cubicBezTo>
                  <a:cubicBezTo>
                    <a:pt x="838067" y="255115"/>
                    <a:pt x="831606" y="257064"/>
                    <a:pt x="825716" y="254769"/>
                  </a:cubicBezTo>
                  <a:cubicBezTo>
                    <a:pt x="825292" y="254895"/>
                    <a:pt x="820651" y="256278"/>
                    <a:pt x="820560" y="256373"/>
                  </a:cubicBezTo>
                  <a:cubicBezTo>
                    <a:pt x="815158" y="260837"/>
                    <a:pt x="809620" y="266183"/>
                    <a:pt x="803842" y="270176"/>
                  </a:cubicBezTo>
                  <a:cubicBezTo>
                    <a:pt x="803737" y="270238"/>
                    <a:pt x="794729" y="274389"/>
                    <a:pt x="794435" y="274483"/>
                  </a:cubicBezTo>
                  <a:cubicBezTo>
                    <a:pt x="791401" y="275489"/>
                    <a:pt x="772035" y="277784"/>
                    <a:pt x="768453" y="277910"/>
                  </a:cubicBezTo>
                  <a:cubicBezTo>
                    <a:pt x="768218" y="277910"/>
                    <a:pt x="762164" y="277281"/>
                    <a:pt x="761978" y="277250"/>
                  </a:cubicBezTo>
                  <a:cubicBezTo>
                    <a:pt x="758814" y="276369"/>
                    <a:pt x="750645" y="272722"/>
                    <a:pt x="750424" y="272691"/>
                  </a:cubicBezTo>
                  <a:cubicBezTo>
                    <a:pt x="747467" y="272313"/>
                    <a:pt x="744145" y="271559"/>
                    <a:pt x="741188" y="271464"/>
                  </a:cubicBezTo>
                  <a:cubicBezTo>
                    <a:pt x="737842" y="271370"/>
                    <a:pt x="733443" y="272471"/>
                    <a:pt x="730219" y="272031"/>
                  </a:cubicBezTo>
                  <a:cubicBezTo>
                    <a:pt x="724832" y="271307"/>
                    <a:pt x="718318" y="267377"/>
                    <a:pt x="711941" y="267220"/>
                  </a:cubicBezTo>
                  <a:cubicBezTo>
                    <a:pt x="709037" y="267126"/>
                    <a:pt x="700864" y="270458"/>
                    <a:pt x="696314" y="270458"/>
                  </a:cubicBezTo>
                  <a:cubicBezTo>
                    <a:pt x="696058" y="270458"/>
                    <a:pt x="688176" y="269358"/>
                    <a:pt x="687959" y="269295"/>
                  </a:cubicBezTo>
                  <a:cubicBezTo>
                    <a:pt x="685749" y="268635"/>
                    <a:pt x="683578" y="266811"/>
                    <a:pt x="681396" y="265962"/>
                  </a:cubicBezTo>
                  <a:cubicBezTo>
                    <a:pt x="677415" y="264453"/>
                    <a:pt x="650539" y="258322"/>
                    <a:pt x="645235" y="256939"/>
                  </a:cubicBezTo>
                  <a:cubicBezTo>
                    <a:pt x="644962" y="256876"/>
                    <a:pt x="637266" y="258762"/>
                    <a:pt x="637182" y="258856"/>
                  </a:cubicBezTo>
                  <a:cubicBezTo>
                    <a:pt x="634449" y="262064"/>
                    <a:pt x="632127" y="266528"/>
                    <a:pt x="629816" y="270050"/>
                  </a:cubicBezTo>
                  <a:lnTo>
                    <a:pt x="622660" y="273414"/>
                  </a:lnTo>
                  <a:cubicBezTo>
                    <a:pt x="617819" y="274452"/>
                    <a:pt x="611565" y="273540"/>
                    <a:pt x="606893" y="274829"/>
                  </a:cubicBezTo>
                  <a:cubicBezTo>
                    <a:pt x="603069" y="275898"/>
                    <a:pt x="595412" y="280205"/>
                    <a:pt x="591564" y="281998"/>
                  </a:cubicBezTo>
                  <a:lnTo>
                    <a:pt x="588200" y="281651"/>
                  </a:lnTo>
                  <a:cubicBezTo>
                    <a:pt x="584893" y="280237"/>
                    <a:pt x="583546" y="276621"/>
                    <a:pt x="581395" y="274231"/>
                  </a:cubicBezTo>
                  <a:cubicBezTo>
                    <a:pt x="577754" y="270207"/>
                    <a:pt x="572956" y="265899"/>
                    <a:pt x="567765" y="263479"/>
                  </a:cubicBezTo>
                  <a:lnTo>
                    <a:pt x="561479" y="250148"/>
                  </a:lnTo>
                  <a:lnTo>
                    <a:pt x="556094" y="247475"/>
                  </a:lnTo>
                  <a:lnTo>
                    <a:pt x="549486" y="248858"/>
                  </a:lnTo>
                  <a:cubicBezTo>
                    <a:pt x="545028" y="253166"/>
                    <a:pt x="540783" y="256845"/>
                    <a:pt x="533842" y="257850"/>
                  </a:cubicBezTo>
                  <a:cubicBezTo>
                    <a:pt x="529026" y="258574"/>
                    <a:pt x="506092" y="256561"/>
                    <a:pt x="501340" y="256813"/>
                  </a:cubicBezTo>
                  <a:cubicBezTo>
                    <a:pt x="500143" y="256876"/>
                    <a:pt x="494756" y="258008"/>
                    <a:pt x="494040" y="257945"/>
                  </a:cubicBezTo>
                  <a:cubicBezTo>
                    <a:pt x="490736" y="257756"/>
                    <a:pt x="486372" y="256373"/>
                    <a:pt x="483086" y="255681"/>
                  </a:cubicBezTo>
                  <a:cubicBezTo>
                    <a:pt x="480669" y="257599"/>
                    <a:pt x="478076" y="259360"/>
                    <a:pt x="475491" y="261058"/>
                  </a:cubicBezTo>
                  <a:cubicBezTo>
                    <a:pt x="468192" y="265868"/>
                    <a:pt x="468893" y="266057"/>
                    <a:pt x="460219" y="264265"/>
                  </a:cubicBezTo>
                  <a:cubicBezTo>
                    <a:pt x="454999" y="263195"/>
                    <a:pt x="442768" y="260586"/>
                    <a:pt x="442579" y="260460"/>
                  </a:cubicBezTo>
                  <a:cubicBezTo>
                    <a:pt x="432112" y="263416"/>
                    <a:pt x="420280" y="265145"/>
                    <a:pt x="409389" y="263510"/>
                  </a:cubicBezTo>
                  <a:lnTo>
                    <a:pt x="399241" y="255178"/>
                  </a:lnTo>
                  <a:cubicBezTo>
                    <a:pt x="395618" y="254518"/>
                    <a:pt x="390174" y="252883"/>
                    <a:pt x="386582" y="252851"/>
                  </a:cubicBezTo>
                  <a:lnTo>
                    <a:pt x="380398" y="254235"/>
                  </a:lnTo>
                  <a:cubicBezTo>
                    <a:pt x="368574" y="256939"/>
                    <a:pt x="333483" y="273948"/>
                    <a:pt x="332195" y="274734"/>
                  </a:cubicBezTo>
                  <a:cubicBezTo>
                    <a:pt x="327807" y="277407"/>
                    <a:pt x="320564" y="285393"/>
                    <a:pt x="314355" y="284324"/>
                  </a:cubicBezTo>
                  <a:cubicBezTo>
                    <a:pt x="311525" y="283035"/>
                    <a:pt x="298574" y="275552"/>
                    <a:pt x="294884" y="273791"/>
                  </a:cubicBezTo>
                  <a:cubicBezTo>
                    <a:pt x="289244" y="271119"/>
                    <a:pt x="281580" y="269295"/>
                    <a:pt x="275434" y="267566"/>
                  </a:cubicBezTo>
                  <a:cubicBezTo>
                    <a:pt x="272379" y="268666"/>
                    <a:pt x="268903" y="269327"/>
                    <a:pt x="265679" y="269861"/>
                  </a:cubicBezTo>
                  <a:cubicBezTo>
                    <a:pt x="260884" y="269735"/>
                    <a:pt x="254577" y="263070"/>
                    <a:pt x="250715" y="260743"/>
                  </a:cubicBezTo>
                  <a:cubicBezTo>
                    <a:pt x="245107" y="257379"/>
                    <a:pt x="231623" y="253166"/>
                    <a:pt x="224541" y="253889"/>
                  </a:cubicBezTo>
                  <a:cubicBezTo>
                    <a:pt x="224541" y="253889"/>
                    <a:pt x="216645" y="254989"/>
                    <a:pt x="215547" y="255398"/>
                  </a:cubicBezTo>
                  <a:cubicBezTo>
                    <a:pt x="211338" y="256939"/>
                    <a:pt x="206708" y="259863"/>
                    <a:pt x="202702" y="261875"/>
                  </a:cubicBezTo>
                  <a:cubicBezTo>
                    <a:pt x="198830" y="263856"/>
                    <a:pt x="184322" y="264044"/>
                    <a:pt x="180723" y="262944"/>
                  </a:cubicBezTo>
                  <a:cubicBezTo>
                    <a:pt x="177479" y="263793"/>
                    <a:pt x="172873" y="267786"/>
                    <a:pt x="170730" y="269955"/>
                  </a:cubicBezTo>
                  <a:cubicBezTo>
                    <a:pt x="164991" y="271150"/>
                    <a:pt x="161119" y="268509"/>
                    <a:pt x="155906" y="267786"/>
                  </a:cubicBezTo>
                  <a:cubicBezTo>
                    <a:pt x="152476" y="267346"/>
                    <a:pt x="146986" y="271245"/>
                    <a:pt x="142745" y="270836"/>
                  </a:cubicBezTo>
                  <a:cubicBezTo>
                    <a:pt x="136828" y="270238"/>
                    <a:pt x="133341" y="264453"/>
                    <a:pt x="128704" y="261969"/>
                  </a:cubicBezTo>
                  <a:cubicBezTo>
                    <a:pt x="127911" y="261529"/>
                    <a:pt x="119216" y="261152"/>
                    <a:pt x="114088" y="260617"/>
                  </a:cubicBezTo>
                  <a:cubicBezTo>
                    <a:pt x="109026" y="260083"/>
                    <a:pt x="103807" y="258888"/>
                    <a:pt x="98780" y="258039"/>
                  </a:cubicBezTo>
                  <a:cubicBezTo>
                    <a:pt x="97268" y="258637"/>
                    <a:pt x="95227" y="259171"/>
                    <a:pt x="93855" y="259926"/>
                  </a:cubicBezTo>
                  <a:cubicBezTo>
                    <a:pt x="87212" y="263699"/>
                    <a:pt x="79926" y="268635"/>
                    <a:pt x="72613" y="271276"/>
                  </a:cubicBezTo>
                  <a:cubicBezTo>
                    <a:pt x="66436" y="273508"/>
                    <a:pt x="44039" y="280300"/>
                    <a:pt x="40114" y="280771"/>
                  </a:cubicBezTo>
                  <a:cubicBezTo>
                    <a:pt x="38809" y="280928"/>
                    <a:pt x="30029" y="280017"/>
                    <a:pt x="30029" y="280017"/>
                  </a:cubicBezTo>
                  <a:cubicBezTo>
                    <a:pt x="26171" y="279136"/>
                    <a:pt x="20688" y="275175"/>
                    <a:pt x="16497" y="275898"/>
                  </a:cubicBezTo>
                  <a:cubicBezTo>
                    <a:pt x="13319" y="276464"/>
                    <a:pt x="6661" y="280205"/>
                    <a:pt x="0" y="283978"/>
                  </a:cubicBezTo>
                  <a:lnTo>
                    <a:pt x="3799" y="310609"/>
                  </a:lnTo>
                  <a:cubicBezTo>
                    <a:pt x="3838" y="310892"/>
                    <a:pt x="2031" y="314194"/>
                    <a:pt x="1950" y="314791"/>
                  </a:cubicBezTo>
                  <a:cubicBezTo>
                    <a:pt x="1109" y="320953"/>
                    <a:pt x="1312" y="328594"/>
                    <a:pt x="2368" y="334756"/>
                  </a:cubicBezTo>
                  <a:lnTo>
                    <a:pt x="13512" y="338969"/>
                  </a:lnTo>
                  <a:cubicBezTo>
                    <a:pt x="19559" y="338435"/>
                    <a:pt x="27886" y="334724"/>
                    <a:pt x="32394" y="331172"/>
                  </a:cubicBezTo>
                  <a:lnTo>
                    <a:pt x="40724" y="335353"/>
                  </a:lnTo>
                  <a:cubicBezTo>
                    <a:pt x="40959" y="335762"/>
                    <a:pt x="43429" y="340070"/>
                    <a:pt x="43446" y="340227"/>
                  </a:cubicBezTo>
                  <a:cubicBezTo>
                    <a:pt x="44000" y="344629"/>
                    <a:pt x="43243" y="350225"/>
                    <a:pt x="43152" y="354721"/>
                  </a:cubicBezTo>
                  <a:lnTo>
                    <a:pt x="50553" y="358872"/>
                  </a:lnTo>
                  <a:cubicBezTo>
                    <a:pt x="50276" y="361575"/>
                    <a:pt x="48410" y="367549"/>
                    <a:pt x="45649" y="369278"/>
                  </a:cubicBezTo>
                  <a:lnTo>
                    <a:pt x="48680" y="373617"/>
                  </a:lnTo>
                  <a:lnTo>
                    <a:pt x="54745" y="382295"/>
                  </a:lnTo>
                  <a:cubicBezTo>
                    <a:pt x="55313" y="383427"/>
                    <a:pt x="55200" y="384182"/>
                    <a:pt x="55492" y="385376"/>
                  </a:cubicBezTo>
                  <a:lnTo>
                    <a:pt x="56989" y="391539"/>
                  </a:lnTo>
                  <a:cubicBezTo>
                    <a:pt x="57754" y="396727"/>
                    <a:pt x="56786" y="405373"/>
                    <a:pt x="59992" y="409869"/>
                  </a:cubicBezTo>
                  <a:cubicBezTo>
                    <a:pt x="62924" y="410938"/>
                    <a:pt x="67271" y="411096"/>
                    <a:pt x="70354" y="410592"/>
                  </a:cubicBezTo>
                  <a:lnTo>
                    <a:pt x="75643" y="414334"/>
                  </a:lnTo>
                  <a:lnTo>
                    <a:pt x="78179" y="423232"/>
                  </a:lnTo>
                  <a:lnTo>
                    <a:pt x="83010" y="423484"/>
                  </a:lnTo>
                  <a:cubicBezTo>
                    <a:pt x="91460" y="418736"/>
                    <a:pt x="101039" y="414177"/>
                    <a:pt x="109019" y="408863"/>
                  </a:cubicBezTo>
                  <a:cubicBezTo>
                    <a:pt x="112176" y="406788"/>
                    <a:pt x="115691" y="402575"/>
                    <a:pt x="118462" y="399965"/>
                  </a:cubicBezTo>
                  <a:cubicBezTo>
                    <a:pt x="118549" y="397230"/>
                    <a:pt x="120461" y="393206"/>
                    <a:pt x="122597" y="391287"/>
                  </a:cubicBezTo>
                  <a:lnTo>
                    <a:pt x="138017" y="389810"/>
                  </a:lnTo>
                  <a:lnTo>
                    <a:pt x="143780" y="392765"/>
                  </a:lnTo>
                  <a:cubicBezTo>
                    <a:pt x="144099" y="395469"/>
                    <a:pt x="142352" y="399871"/>
                    <a:pt x="140080" y="401695"/>
                  </a:cubicBezTo>
                  <a:lnTo>
                    <a:pt x="141006" y="406159"/>
                  </a:lnTo>
                  <a:lnTo>
                    <a:pt x="137779" y="410592"/>
                  </a:lnTo>
                  <a:lnTo>
                    <a:pt x="139168" y="415057"/>
                  </a:lnTo>
                  <a:cubicBezTo>
                    <a:pt x="137677" y="420340"/>
                    <a:pt x="132524" y="423704"/>
                    <a:pt x="130647" y="428923"/>
                  </a:cubicBezTo>
                  <a:lnTo>
                    <a:pt x="131791" y="437349"/>
                  </a:lnTo>
                  <a:lnTo>
                    <a:pt x="137095" y="440053"/>
                  </a:lnTo>
                  <a:lnTo>
                    <a:pt x="138245" y="444769"/>
                  </a:lnTo>
                  <a:lnTo>
                    <a:pt x="148828" y="449234"/>
                  </a:lnTo>
                  <a:cubicBezTo>
                    <a:pt x="151339" y="447316"/>
                    <a:pt x="156320" y="445618"/>
                    <a:pt x="159631" y="445744"/>
                  </a:cubicBezTo>
                  <a:cubicBezTo>
                    <a:pt x="161638" y="447693"/>
                    <a:pt x="162883" y="450680"/>
                    <a:pt x="163714" y="453101"/>
                  </a:cubicBezTo>
                  <a:cubicBezTo>
                    <a:pt x="164462" y="455271"/>
                    <a:pt x="166299" y="461528"/>
                    <a:pt x="168169" y="463320"/>
                  </a:cubicBezTo>
                  <a:cubicBezTo>
                    <a:pt x="170288" y="465395"/>
                    <a:pt x="180057" y="469639"/>
                    <a:pt x="182901" y="470771"/>
                  </a:cubicBezTo>
                  <a:cubicBezTo>
                    <a:pt x="183754" y="467627"/>
                    <a:pt x="185378" y="463980"/>
                    <a:pt x="187507" y="461339"/>
                  </a:cubicBezTo>
                  <a:cubicBezTo>
                    <a:pt x="192491" y="458477"/>
                    <a:pt x="201924" y="456874"/>
                    <a:pt x="207739" y="457880"/>
                  </a:cubicBezTo>
                  <a:lnTo>
                    <a:pt x="211892" y="448983"/>
                  </a:lnTo>
                  <a:lnTo>
                    <a:pt x="217192" y="447473"/>
                  </a:lnTo>
                  <a:lnTo>
                    <a:pt x="222952" y="451183"/>
                  </a:lnTo>
                  <a:lnTo>
                    <a:pt x="233545" y="451686"/>
                  </a:lnTo>
                  <a:cubicBezTo>
                    <a:pt x="236580" y="453919"/>
                    <a:pt x="239705" y="457409"/>
                    <a:pt x="241357" y="460584"/>
                  </a:cubicBezTo>
                  <a:lnTo>
                    <a:pt x="247120" y="460364"/>
                  </a:lnTo>
                  <a:cubicBezTo>
                    <a:pt x="248997" y="457283"/>
                    <a:pt x="252736" y="453982"/>
                    <a:pt x="256089" y="452189"/>
                  </a:cubicBezTo>
                  <a:cubicBezTo>
                    <a:pt x="265872" y="452252"/>
                    <a:pt x="272414" y="462251"/>
                    <a:pt x="271961" y="470268"/>
                  </a:cubicBezTo>
                  <a:cubicBezTo>
                    <a:pt x="271334" y="481367"/>
                    <a:pt x="269892" y="492812"/>
                    <a:pt x="270825" y="503942"/>
                  </a:cubicBezTo>
                  <a:lnTo>
                    <a:pt x="276125" y="508123"/>
                  </a:lnTo>
                  <a:cubicBezTo>
                    <a:pt x="275595" y="515512"/>
                    <a:pt x="278388" y="519600"/>
                    <a:pt x="280268" y="526202"/>
                  </a:cubicBezTo>
                  <a:cubicBezTo>
                    <a:pt x="281060" y="529001"/>
                    <a:pt x="281029" y="532113"/>
                    <a:pt x="281885" y="534880"/>
                  </a:cubicBezTo>
                  <a:cubicBezTo>
                    <a:pt x="283330" y="539533"/>
                    <a:pt x="289402" y="544218"/>
                    <a:pt x="294537" y="545287"/>
                  </a:cubicBezTo>
                  <a:cubicBezTo>
                    <a:pt x="298045" y="545979"/>
                    <a:pt x="300086" y="545696"/>
                    <a:pt x="303815" y="546922"/>
                  </a:cubicBezTo>
                  <a:cubicBezTo>
                    <a:pt x="308006" y="548306"/>
                    <a:pt x="311721" y="551701"/>
                    <a:pt x="316414" y="551953"/>
                  </a:cubicBezTo>
                  <a:cubicBezTo>
                    <a:pt x="327204" y="552550"/>
                    <a:pt x="339709" y="551984"/>
                    <a:pt x="350004" y="555411"/>
                  </a:cubicBezTo>
                  <a:cubicBezTo>
                    <a:pt x="354459" y="558556"/>
                    <a:pt x="357465" y="568239"/>
                    <a:pt x="357591" y="573238"/>
                  </a:cubicBezTo>
                  <a:cubicBezTo>
                    <a:pt x="357612" y="573993"/>
                    <a:pt x="357054" y="577263"/>
                    <a:pt x="357135" y="577703"/>
                  </a:cubicBezTo>
                  <a:cubicBezTo>
                    <a:pt x="357177" y="577924"/>
                    <a:pt x="358998" y="581476"/>
                    <a:pt x="359212" y="581916"/>
                  </a:cubicBezTo>
                  <a:cubicBezTo>
                    <a:pt x="362807" y="583583"/>
                    <a:pt x="370496" y="586821"/>
                    <a:pt x="374639" y="587104"/>
                  </a:cubicBezTo>
                  <a:cubicBezTo>
                    <a:pt x="376343" y="587230"/>
                    <a:pt x="378216" y="586790"/>
                    <a:pt x="379932" y="586853"/>
                  </a:cubicBezTo>
                  <a:cubicBezTo>
                    <a:pt x="385260" y="587104"/>
                    <a:pt x="396842" y="590689"/>
                    <a:pt x="400873" y="593047"/>
                  </a:cubicBezTo>
                  <a:cubicBezTo>
                    <a:pt x="403984" y="594902"/>
                    <a:pt x="405432" y="599083"/>
                    <a:pt x="407319" y="601724"/>
                  </a:cubicBezTo>
                  <a:cubicBezTo>
                    <a:pt x="409585" y="604932"/>
                    <a:pt x="412244" y="608013"/>
                    <a:pt x="414679" y="611125"/>
                  </a:cubicBezTo>
                  <a:cubicBezTo>
                    <a:pt x="410389" y="622319"/>
                    <a:pt x="413416" y="623230"/>
                    <a:pt x="414679" y="633669"/>
                  </a:cubicBezTo>
                  <a:cubicBezTo>
                    <a:pt x="415289" y="638699"/>
                    <a:pt x="411094" y="642189"/>
                    <a:pt x="409154" y="646528"/>
                  </a:cubicBezTo>
                  <a:cubicBezTo>
                    <a:pt x="408958" y="646969"/>
                    <a:pt x="408670" y="650239"/>
                    <a:pt x="408474" y="650993"/>
                  </a:cubicBezTo>
                  <a:cubicBezTo>
                    <a:pt x="407719" y="653791"/>
                    <a:pt x="406622" y="656621"/>
                    <a:pt x="405709" y="659419"/>
                  </a:cubicBezTo>
                  <a:lnTo>
                    <a:pt x="400876" y="663129"/>
                  </a:lnTo>
                  <a:lnTo>
                    <a:pt x="384537" y="665110"/>
                  </a:lnTo>
                  <a:cubicBezTo>
                    <a:pt x="381668" y="667657"/>
                    <a:pt x="377494" y="670644"/>
                    <a:pt x="375108" y="673505"/>
                  </a:cubicBezTo>
                  <a:cubicBezTo>
                    <a:pt x="373151" y="675863"/>
                    <a:pt x="372383" y="679479"/>
                    <a:pt x="370513" y="681931"/>
                  </a:cubicBezTo>
                  <a:cubicBezTo>
                    <a:pt x="369966" y="682654"/>
                    <a:pt x="366010" y="685327"/>
                    <a:pt x="365648" y="685893"/>
                  </a:cubicBezTo>
                  <a:cubicBezTo>
                    <a:pt x="364108" y="688345"/>
                    <a:pt x="363081" y="692621"/>
                    <a:pt x="362035" y="695357"/>
                  </a:cubicBezTo>
                  <a:cubicBezTo>
                    <a:pt x="350348" y="697306"/>
                    <a:pt x="340224" y="704506"/>
                    <a:pt x="335507" y="714379"/>
                  </a:cubicBezTo>
                  <a:cubicBezTo>
                    <a:pt x="335429" y="718340"/>
                    <a:pt x="337587" y="719504"/>
                    <a:pt x="339193" y="722522"/>
                  </a:cubicBezTo>
                  <a:cubicBezTo>
                    <a:pt x="340607" y="725195"/>
                    <a:pt x="341680" y="728213"/>
                    <a:pt x="342887" y="730948"/>
                  </a:cubicBezTo>
                  <a:cubicBezTo>
                    <a:pt x="341280" y="734218"/>
                    <a:pt x="340119" y="738305"/>
                    <a:pt x="339884" y="741858"/>
                  </a:cubicBezTo>
                  <a:cubicBezTo>
                    <a:pt x="343213" y="747109"/>
                    <a:pt x="347668" y="751668"/>
                    <a:pt x="352003" y="756227"/>
                  </a:cubicBezTo>
                  <a:cubicBezTo>
                    <a:pt x="353284" y="757579"/>
                    <a:pt x="354210" y="758208"/>
                    <a:pt x="355297" y="759686"/>
                  </a:cubicBezTo>
                  <a:cubicBezTo>
                    <a:pt x="355676" y="760220"/>
                    <a:pt x="355529" y="760661"/>
                    <a:pt x="355679" y="761258"/>
                  </a:cubicBezTo>
                  <a:lnTo>
                    <a:pt x="356458" y="764370"/>
                  </a:lnTo>
                  <a:cubicBezTo>
                    <a:pt x="356195" y="770596"/>
                    <a:pt x="349818" y="778173"/>
                    <a:pt x="345409" y="782449"/>
                  </a:cubicBezTo>
                  <a:cubicBezTo>
                    <a:pt x="343139" y="784650"/>
                    <a:pt x="340000" y="786379"/>
                    <a:pt x="337811" y="788643"/>
                  </a:cubicBezTo>
                  <a:cubicBezTo>
                    <a:pt x="336601" y="789901"/>
                    <a:pt x="334349" y="794271"/>
                    <a:pt x="334219" y="796095"/>
                  </a:cubicBezTo>
                  <a:cubicBezTo>
                    <a:pt x="336769" y="796441"/>
                    <a:pt x="340505" y="796566"/>
                    <a:pt x="342890" y="797321"/>
                  </a:cubicBezTo>
                  <a:cubicBezTo>
                    <a:pt x="346577" y="798422"/>
                    <a:pt x="347829" y="801377"/>
                    <a:pt x="353238" y="801031"/>
                  </a:cubicBezTo>
                  <a:cubicBezTo>
                    <a:pt x="356020" y="798484"/>
                    <a:pt x="360082" y="795875"/>
                    <a:pt x="363821" y="794586"/>
                  </a:cubicBezTo>
                  <a:lnTo>
                    <a:pt x="368423" y="803735"/>
                  </a:lnTo>
                  <a:cubicBezTo>
                    <a:pt x="367202" y="808011"/>
                    <a:pt x="365803" y="812318"/>
                    <a:pt x="364743" y="816626"/>
                  </a:cubicBezTo>
                  <a:cubicBezTo>
                    <a:pt x="364354" y="818229"/>
                    <a:pt x="364473" y="819990"/>
                    <a:pt x="364052" y="821562"/>
                  </a:cubicBezTo>
                  <a:cubicBezTo>
                    <a:pt x="362561" y="827159"/>
                    <a:pt x="357819" y="839452"/>
                    <a:pt x="358528" y="845081"/>
                  </a:cubicBezTo>
                  <a:cubicBezTo>
                    <a:pt x="358559" y="845332"/>
                    <a:pt x="361688" y="853255"/>
                    <a:pt x="361983" y="854010"/>
                  </a:cubicBezTo>
                  <a:lnTo>
                    <a:pt x="356223" y="857720"/>
                  </a:lnTo>
                  <a:lnTo>
                    <a:pt x="354168" y="862184"/>
                  </a:lnTo>
                  <a:lnTo>
                    <a:pt x="349320" y="865140"/>
                  </a:lnTo>
                  <a:lnTo>
                    <a:pt x="349095" y="869353"/>
                  </a:lnTo>
                  <a:cubicBezTo>
                    <a:pt x="353515" y="875453"/>
                    <a:pt x="360594" y="879540"/>
                    <a:pt x="367732" y="882716"/>
                  </a:cubicBezTo>
                  <a:cubicBezTo>
                    <a:pt x="370534" y="879949"/>
                    <a:pt x="378886" y="878723"/>
                    <a:pt x="382710" y="878754"/>
                  </a:cubicBezTo>
                  <a:lnTo>
                    <a:pt x="390749" y="870328"/>
                  </a:lnTo>
                  <a:cubicBezTo>
                    <a:pt x="394260" y="870265"/>
                    <a:pt x="399133" y="866964"/>
                    <a:pt x="400886" y="864386"/>
                  </a:cubicBezTo>
                  <a:cubicBezTo>
                    <a:pt x="404885" y="864888"/>
                    <a:pt x="407319" y="866932"/>
                    <a:pt x="410778" y="868347"/>
                  </a:cubicBezTo>
                  <a:cubicBezTo>
                    <a:pt x="414359" y="869856"/>
                    <a:pt x="418225" y="870862"/>
                    <a:pt x="421827" y="872309"/>
                  </a:cubicBezTo>
                  <a:cubicBezTo>
                    <a:pt x="426787" y="874321"/>
                    <a:pt x="431726" y="877654"/>
                    <a:pt x="437254" y="878251"/>
                  </a:cubicBezTo>
                  <a:lnTo>
                    <a:pt x="443691" y="887432"/>
                  </a:lnTo>
                  <a:cubicBezTo>
                    <a:pt x="446360" y="888878"/>
                    <a:pt x="450727" y="889727"/>
                    <a:pt x="453824" y="889413"/>
                  </a:cubicBezTo>
                  <a:cubicBezTo>
                    <a:pt x="456736" y="892085"/>
                    <a:pt x="459826" y="895481"/>
                    <a:pt x="463014" y="897839"/>
                  </a:cubicBezTo>
                  <a:cubicBezTo>
                    <a:pt x="466084" y="900071"/>
                    <a:pt x="470132" y="901675"/>
                    <a:pt x="473376" y="903750"/>
                  </a:cubicBezTo>
                  <a:cubicBezTo>
                    <a:pt x="477550" y="906454"/>
                    <a:pt x="483233" y="911925"/>
                    <a:pt x="483973" y="916641"/>
                  </a:cubicBezTo>
                  <a:lnTo>
                    <a:pt x="489042" y="919596"/>
                  </a:lnTo>
                  <a:cubicBezTo>
                    <a:pt x="494008" y="920131"/>
                    <a:pt x="496744" y="917584"/>
                    <a:pt x="500077" y="917396"/>
                  </a:cubicBezTo>
                  <a:cubicBezTo>
                    <a:pt x="509070" y="916861"/>
                    <a:pt x="516738" y="918968"/>
                    <a:pt x="526318" y="916892"/>
                  </a:cubicBezTo>
                  <a:lnTo>
                    <a:pt x="550938" y="926797"/>
                  </a:lnTo>
                  <a:cubicBezTo>
                    <a:pt x="554495" y="926167"/>
                    <a:pt x="558613" y="924470"/>
                    <a:pt x="561535" y="922583"/>
                  </a:cubicBezTo>
                  <a:lnTo>
                    <a:pt x="566365" y="924816"/>
                  </a:lnTo>
                  <a:cubicBezTo>
                    <a:pt x="567365" y="929752"/>
                    <a:pt x="571069" y="930475"/>
                    <a:pt x="574184" y="933462"/>
                  </a:cubicBezTo>
                  <a:cubicBezTo>
                    <a:pt x="577912" y="937046"/>
                    <a:pt x="581195" y="943681"/>
                    <a:pt x="587088" y="944875"/>
                  </a:cubicBezTo>
                  <a:lnTo>
                    <a:pt x="598124" y="944624"/>
                  </a:lnTo>
                  <a:cubicBezTo>
                    <a:pt x="601501" y="946636"/>
                    <a:pt x="605090" y="950252"/>
                    <a:pt x="606872" y="953522"/>
                  </a:cubicBezTo>
                  <a:cubicBezTo>
                    <a:pt x="606447" y="956320"/>
                    <a:pt x="604876" y="959590"/>
                    <a:pt x="603192" y="961948"/>
                  </a:cubicBezTo>
                  <a:cubicBezTo>
                    <a:pt x="595107" y="966287"/>
                    <a:pt x="583910" y="966318"/>
                    <a:pt x="574871" y="966664"/>
                  </a:cubicBezTo>
                  <a:cubicBezTo>
                    <a:pt x="573040" y="971757"/>
                    <a:pt x="568308" y="971632"/>
                    <a:pt x="566586" y="973581"/>
                  </a:cubicBezTo>
                  <a:cubicBezTo>
                    <a:pt x="563513" y="977040"/>
                    <a:pt x="560851" y="982322"/>
                    <a:pt x="558311" y="986189"/>
                  </a:cubicBezTo>
                  <a:cubicBezTo>
                    <a:pt x="552745" y="987667"/>
                    <a:pt x="547381" y="991031"/>
                    <a:pt x="543811" y="995118"/>
                  </a:cubicBezTo>
                  <a:lnTo>
                    <a:pt x="538521" y="996093"/>
                  </a:lnTo>
                  <a:lnTo>
                    <a:pt x="535066" y="1000558"/>
                  </a:lnTo>
                  <a:lnTo>
                    <a:pt x="535301" y="1004771"/>
                  </a:lnTo>
                  <a:cubicBezTo>
                    <a:pt x="540664" y="1007255"/>
                    <a:pt x="546838" y="1005966"/>
                    <a:pt x="551408" y="1009959"/>
                  </a:cubicBezTo>
                  <a:lnTo>
                    <a:pt x="554853" y="1018637"/>
                  </a:lnTo>
                  <a:cubicBezTo>
                    <a:pt x="557413" y="1020491"/>
                    <a:pt x="562380" y="1021970"/>
                    <a:pt x="565667" y="1021844"/>
                  </a:cubicBezTo>
                  <a:lnTo>
                    <a:pt x="566586" y="1025805"/>
                  </a:lnTo>
                  <a:cubicBezTo>
                    <a:pt x="565400" y="1027692"/>
                    <a:pt x="563601" y="1032597"/>
                    <a:pt x="563836" y="1034735"/>
                  </a:cubicBezTo>
                  <a:cubicBezTo>
                    <a:pt x="564127" y="1037407"/>
                    <a:pt x="565393" y="1040237"/>
                    <a:pt x="565892" y="1042909"/>
                  </a:cubicBezTo>
                  <a:cubicBezTo>
                    <a:pt x="567042" y="1049135"/>
                    <a:pt x="567463" y="1055266"/>
                    <a:pt x="569126" y="1061460"/>
                  </a:cubicBezTo>
                  <a:cubicBezTo>
                    <a:pt x="567968" y="1065327"/>
                    <a:pt x="564885" y="1066679"/>
                    <a:pt x="562685" y="1069634"/>
                  </a:cubicBezTo>
                  <a:cubicBezTo>
                    <a:pt x="559557" y="1073848"/>
                    <a:pt x="560837" y="1078910"/>
                    <a:pt x="559690" y="1083500"/>
                  </a:cubicBezTo>
                  <a:cubicBezTo>
                    <a:pt x="558816" y="1087022"/>
                    <a:pt x="553327" y="1091015"/>
                    <a:pt x="552787" y="1092398"/>
                  </a:cubicBezTo>
                  <a:cubicBezTo>
                    <a:pt x="550444" y="1098592"/>
                    <a:pt x="551033" y="1109062"/>
                    <a:pt x="546340" y="1114187"/>
                  </a:cubicBezTo>
                  <a:lnTo>
                    <a:pt x="535304" y="1115445"/>
                  </a:lnTo>
                  <a:cubicBezTo>
                    <a:pt x="532305" y="1119123"/>
                    <a:pt x="534957" y="1138303"/>
                    <a:pt x="535304" y="1143176"/>
                  </a:cubicBezTo>
                  <a:cubicBezTo>
                    <a:pt x="535532" y="1146446"/>
                    <a:pt x="534852" y="1149276"/>
                    <a:pt x="535995" y="1152577"/>
                  </a:cubicBezTo>
                  <a:cubicBezTo>
                    <a:pt x="537093" y="1155721"/>
                    <a:pt x="538823" y="1158331"/>
                    <a:pt x="539433" y="1161726"/>
                  </a:cubicBezTo>
                  <a:cubicBezTo>
                    <a:pt x="542039" y="1176126"/>
                    <a:pt x="530909" y="1184301"/>
                    <a:pt x="541983" y="1197632"/>
                  </a:cubicBezTo>
                  <a:lnTo>
                    <a:pt x="541288" y="1201594"/>
                  </a:lnTo>
                  <a:cubicBezTo>
                    <a:pt x="538016" y="1206310"/>
                    <a:pt x="535585" y="1205776"/>
                    <a:pt x="532077" y="1208260"/>
                  </a:cubicBezTo>
                  <a:cubicBezTo>
                    <a:pt x="528528" y="1210775"/>
                    <a:pt x="527858" y="1213762"/>
                    <a:pt x="526097" y="1217189"/>
                  </a:cubicBezTo>
                  <a:cubicBezTo>
                    <a:pt x="521116" y="1226841"/>
                    <a:pt x="519387" y="1227281"/>
                    <a:pt x="519183" y="1238223"/>
                  </a:cubicBezTo>
                  <a:lnTo>
                    <a:pt x="522877" y="1243191"/>
                  </a:lnTo>
                  <a:cubicBezTo>
                    <a:pt x="522217" y="1247215"/>
                    <a:pt x="519720" y="1251680"/>
                    <a:pt x="517703" y="1255233"/>
                  </a:cubicBezTo>
                  <a:lnTo>
                    <a:pt x="522835" y="1274097"/>
                  </a:lnTo>
                  <a:cubicBezTo>
                    <a:pt x="523834" y="1277776"/>
                    <a:pt x="524136" y="1279914"/>
                    <a:pt x="525402" y="1283530"/>
                  </a:cubicBezTo>
                  <a:cubicBezTo>
                    <a:pt x="527160" y="1288560"/>
                    <a:pt x="535708" y="1302772"/>
                    <a:pt x="540815" y="1306325"/>
                  </a:cubicBezTo>
                  <a:cubicBezTo>
                    <a:pt x="545063" y="1309281"/>
                    <a:pt x="549728" y="1311984"/>
                    <a:pt x="554130" y="1314751"/>
                  </a:cubicBezTo>
                  <a:cubicBezTo>
                    <a:pt x="558315" y="1312865"/>
                    <a:pt x="563345" y="1314311"/>
                    <a:pt x="567744" y="1313997"/>
                  </a:cubicBezTo>
                  <a:cubicBezTo>
                    <a:pt x="577249" y="1313274"/>
                    <a:pt x="580533" y="1310695"/>
                    <a:pt x="588467" y="1308557"/>
                  </a:cubicBezTo>
                  <a:cubicBezTo>
                    <a:pt x="594020" y="1307016"/>
                    <a:pt x="598895" y="1309972"/>
                    <a:pt x="604574" y="1307300"/>
                  </a:cubicBezTo>
                  <a:lnTo>
                    <a:pt x="609183" y="1302835"/>
                  </a:lnTo>
                  <a:lnTo>
                    <a:pt x="614231" y="1305319"/>
                  </a:lnTo>
                  <a:cubicBezTo>
                    <a:pt x="617595" y="1304376"/>
                    <a:pt x="621758" y="1301326"/>
                    <a:pt x="623905" y="1298905"/>
                  </a:cubicBezTo>
                  <a:cubicBezTo>
                    <a:pt x="632074" y="1298119"/>
                    <a:pt x="639300" y="1301011"/>
                    <a:pt x="644625" y="1306577"/>
                  </a:cubicBezTo>
                  <a:lnTo>
                    <a:pt x="649455" y="1306073"/>
                  </a:lnTo>
                  <a:lnTo>
                    <a:pt x="654050" y="1297647"/>
                  </a:lnTo>
                  <a:lnTo>
                    <a:pt x="659357" y="1295163"/>
                  </a:lnTo>
                  <a:lnTo>
                    <a:pt x="664415" y="1296673"/>
                  </a:lnTo>
                  <a:cubicBezTo>
                    <a:pt x="664910" y="1296421"/>
                    <a:pt x="669551" y="1294063"/>
                    <a:pt x="669705" y="1293937"/>
                  </a:cubicBezTo>
                  <a:cubicBezTo>
                    <a:pt x="671262" y="1292522"/>
                    <a:pt x="676510" y="1282084"/>
                    <a:pt x="677078" y="1280323"/>
                  </a:cubicBezTo>
                  <a:lnTo>
                    <a:pt x="677078" y="1276110"/>
                  </a:lnTo>
                  <a:cubicBezTo>
                    <a:pt x="676264" y="1273186"/>
                    <a:pt x="673528" y="1270482"/>
                    <a:pt x="673619" y="1267212"/>
                  </a:cubicBezTo>
                  <a:cubicBezTo>
                    <a:pt x="673704" y="1264099"/>
                    <a:pt x="675489" y="1261395"/>
                    <a:pt x="674546" y="1258031"/>
                  </a:cubicBezTo>
                  <a:cubicBezTo>
                    <a:pt x="672886" y="1252120"/>
                    <a:pt x="668481" y="1246398"/>
                    <a:pt x="670396" y="1240204"/>
                  </a:cubicBezTo>
                  <a:cubicBezTo>
                    <a:pt x="671269" y="1237406"/>
                    <a:pt x="673704" y="1233507"/>
                    <a:pt x="676377" y="1231778"/>
                  </a:cubicBezTo>
                  <a:cubicBezTo>
                    <a:pt x="677787" y="1230866"/>
                    <a:pt x="680249" y="1230709"/>
                    <a:pt x="681677" y="1229828"/>
                  </a:cubicBezTo>
                  <a:cubicBezTo>
                    <a:pt x="683441" y="1228696"/>
                    <a:pt x="684732" y="1226464"/>
                    <a:pt x="686507" y="1225363"/>
                  </a:cubicBezTo>
                  <a:cubicBezTo>
                    <a:pt x="690884" y="1222659"/>
                    <a:pt x="697524" y="1222440"/>
                    <a:pt x="702397" y="1220899"/>
                  </a:cubicBezTo>
                  <a:cubicBezTo>
                    <a:pt x="707777" y="1219201"/>
                    <a:pt x="712569" y="1216245"/>
                    <a:pt x="718269" y="1215208"/>
                  </a:cubicBezTo>
                  <a:cubicBezTo>
                    <a:pt x="721222" y="1216623"/>
                    <a:pt x="729953" y="1219893"/>
                    <a:pt x="733461" y="1218666"/>
                  </a:cubicBezTo>
                  <a:lnTo>
                    <a:pt x="744282" y="1223886"/>
                  </a:lnTo>
                  <a:cubicBezTo>
                    <a:pt x="745973" y="1228319"/>
                    <a:pt x="744492" y="1233098"/>
                    <a:pt x="747975" y="1236997"/>
                  </a:cubicBezTo>
                  <a:cubicBezTo>
                    <a:pt x="752820" y="1242436"/>
                    <a:pt x="757548" y="1243505"/>
                    <a:pt x="759386" y="1250925"/>
                  </a:cubicBezTo>
                  <a:lnTo>
                    <a:pt x="760165" y="1254069"/>
                  </a:lnTo>
                  <a:cubicBezTo>
                    <a:pt x="759887" y="1256648"/>
                    <a:pt x="758025" y="1259415"/>
                    <a:pt x="757636" y="1261993"/>
                  </a:cubicBezTo>
                  <a:cubicBezTo>
                    <a:pt x="756994" y="1266269"/>
                    <a:pt x="761406" y="1272211"/>
                    <a:pt x="764763" y="1274884"/>
                  </a:cubicBezTo>
                  <a:cubicBezTo>
                    <a:pt x="768576" y="1276896"/>
                    <a:pt x="777054" y="1274475"/>
                    <a:pt x="780874" y="1273406"/>
                  </a:cubicBezTo>
                  <a:cubicBezTo>
                    <a:pt x="782814" y="1272840"/>
                    <a:pt x="784666" y="1271676"/>
                    <a:pt x="786613" y="1271174"/>
                  </a:cubicBezTo>
                  <a:cubicBezTo>
                    <a:pt x="789955" y="1270293"/>
                    <a:pt x="793979" y="1270230"/>
                    <a:pt x="797209" y="1269193"/>
                  </a:cubicBezTo>
                  <a:cubicBezTo>
                    <a:pt x="800801" y="1267998"/>
                    <a:pt x="804267" y="1265608"/>
                    <a:pt x="807803" y="1264225"/>
                  </a:cubicBezTo>
                  <a:cubicBezTo>
                    <a:pt x="811030" y="1262968"/>
                    <a:pt x="814744" y="1262370"/>
                    <a:pt x="817919" y="1261018"/>
                  </a:cubicBezTo>
                  <a:cubicBezTo>
                    <a:pt x="822100" y="1259226"/>
                    <a:pt x="834040" y="1249793"/>
                    <a:pt x="834710" y="1245926"/>
                  </a:cubicBezTo>
                  <a:cubicBezTo>
                    <a:pt x="833735" y="1243537"/>
                    <a:pt x="833219" y="1240267"/>
                    <a:pt x="833570" y="1237751"/>
                  </a:cubicBezTo>
                  <a:lnTo>
                    <a:pt x="844647" y="1237971"/>
                  </a:lnTo>
                  <a:cubicBezTo>
                    <a:pt x="847597" y="1242625"/>
                    <a:pt x="858604" y="1251208"/>
                    <a:pt x="864648" y="1251365"/>
                  </a:cubicBezTo>
                  <a:cubicBezTo>
                    <a:pt x="871933" y="1250045"/>
                    <a:pt x="875929" y="1242593"/>
                    <a:pt x="876153" y="1236494"/>
                  </a:cubicBezTo>
                  <a:cubicBezTo>
                    <a:pt x="879991" y="1232123"/>
                    <a:pt x="890991" y="1225646"/>
                    <a:pt x="896179" y="1223131"/>
                  </a:cubicBezTo>
                  <a:cubicBezTo>
                    <a:pt x="896365" y="1223037"/>
                    <a:pt x="901384" y="1222219"/>
                    <a:pt x="901921" y="1222156"/>
                  </a:cubicBezTo>
                  <a:cubicBezTo>
                    <a:pt x="906670" y="1225081"/>
                    <a:pt x="912861" y="1228130"/>
                    <a:pt x="917116" y="1231557"/>
                  </a:cubicBezTo>
                  <a:cubicBezTo>
                    <a:pt x="919028" y="1233067"/>
                    <a:pt x="919042" y="1237374"/>
                    <a:pt x="924475" y="1239952"/>
                  </a:cubicBezTo>
                  <a:lnTo>
                    <a:pt x="940155" y="1239732"/>
                  </a:lnTo>
                  <a:cubicBezTo>
                    <a:pt x="942792" y="1243348"/>
                    <a:pt x="951867" y="1254604"/>
                    <a:pt x="956718" y="1256050"/>
                  </a:cubicBezTo>
                  <a:cubicBezTo>
                    <a:pt x="960012" y="1255359"/>
                    <a:pt x="964189" y="1254887"/>
                    <a:pt x="967314" y="1253818"/>
                  </a:cubicBezTo>
                  <a:cubicBezTo>
                    <a:pt x="968963" y="1253283"/>
                    <a:pt x="970503" y="1251491"/>
                    <a:pt x="972148" y="1250862"/>
                  </a:cubicBezTo>
                  <a:cubicBezTo>
                    <a:pt x="974147" y="1250076"/>
                    <a:pt x="979847" y="1250045"/>
                    <a:pt x="982033" y="1250360"/>
                  </a:cubicBezTo>
                  <a:cubicBezTo>
                    <a:pt x="985341" y="1246586"/>
                    <a:pt x="992226" y="1243474"/>
                    <a:pt x="997452" y="1245926"/>
                  </a:cubicBezTo>
                  <a:cubicBezTo>
                    <a:pt x="1000427" y="1247278"/>
                    <a:pt x="1003584" y="1250579"/>
                    <a:pt x="1007783" y="1252340"/>
                  </a:cubicBezTo>
                  <a:cubicBezTo>
                    <a:pt x="1006415" y="1254698"/>
                    <a:pt x="1005783" y="1258911"/>
                    <a:pt x="1006415" y="1261489"/>
                  </a:cubicBezTo>
                  <a:lnTo>
                    <a:pt x="1002967" y="1265954"/>
                  </a:lnTo>
                  <a:cubicBezTo>
                    <a:pt x="1002518" y="1266080"/>
                    <a:pt x="997793" y="1267369"/>
                    <a:pt x="997680" y="1267463"/>
                  </a:cubicBezTo>
                  <a:cubicBezTo>
                    <a:pt x="994464" y="1269570"/>
                    <a:pt x="991156" y="1273092"/>
                    <a:pt x="988252" y="1275607"/>
                  </a:cubicBezTo>
                  <a:lnTo>
                    <a:pt x="983422" y="1276361"/>
                  </a:lnTo>
                  <a:cubicBezTo>
                    <a:pt x="980889" y="1278248"/>
                    <a:pt x="978283" y="1282996"/>
                    <a:pt x="978816" y="1286014"/>
                  </a:cubicBezTo>
                  <a:lnTo>
                    <a:pt x="973281" y="1289472"/>
                  </a:lnTo>
                  <a:lnTo>
                    <a:pt x="962937" y="1289221"/>
                  </a:lnTo>
                  <a:cubicBezTo>
                    <a:pt x="959005" y="1291893"/>
                    <a:pt x="955332" y="1298087"/>
                    <a:pt x="953733" y="1302112"/>
                  </a:cubicBezTo>
                  <a:cubicBezTo>
                    <a:pt x="955458" y="1306608"/>
                    <a:pt x="959159" y="1311230"/>
                    <a:pt x="962256" y="1314971"/>
                  </a:cubicBezTo>
                  <a:lnTo>
                    <a:pt x="973053" y="1317204"/>
                  </a:lnTo>
                  <a:lnTo>
                    <a:pt x="977203" y="1321920"/>
                  </a:lnTo>
                  <a:lnTo>
                    <a:pt x="982485" y="1321668"/>
                  </a:lnTo>
                  <a:cubicBezTo>
                    <a:pt x="983825" y="1318650"/>
                    <a:pt x="987550" y="1315003"/>
                    <a:pt x="990553" y="1313242"/>
                  </a:cubicBezTo>
                  <a:cubicBezTo>
                    <a:pt x="996249" y="1313462"/>
                    <a:pt x="997600" y="1310444"/>
                    <a:pt x="1001602" y="1308777"/>
                  </a:cubicBezTo>
                  <a:cubicBezTo>
                    <a:pt x="1002230" y="1308526"/>
                    <a:pt x="1005713" y="1308306"/>
                    <a:pt x="1006450" y="1308054"/>
                  </a:cubicBezTo>
                  <a:cubicBezTo>
                    <a:pt x="1009957" y="1306734"/>
                    <a:pt x="1013605" y="1304690"/>
                    <a:pt x="1017043" y="1303118"/>
                  </a:cubicBezTo>
                  <a:cubicBezTo>
                    <a:pt x="1020375" y="1302552"/>
                    <a:pt x="1025672" y="1304942"/>
                    <a:pt x="1027812" y="1307048"/>
                  </a:cubicBezTo>
                  <a:lnTo>
                    <a:pt x="1033143" y="1304344"/>
                  </a:lnTo>
                  <a:cubicBezTo>
                    <a:pt x="1037738" y="1306608"/>
                    <a:pt x="1044157" y="1305979"/>
                    <a:pt x="1048787" y="1304093"/>
                  </a:cubicBezTo>
                  <a:cubicBezTo>
                    <a:pt x="1056083" y="1305791"/>
                    <a:pt x="1064326" y="1310853"/>
                    <a:pt x="1066291" y="1317707"/>
                  </a:cubicBezTo>
                  <a:lnTo>
                    <a:pt x="1062608" y="1326636"/>
                  </a:lnTo>
                  <a:cubicBezTo>
                    <a:pt x="1066957" y="1328617"/>
                    <a:pt x="1079831" y="1335440"/>
                    <a:pt x="1081935" y="1339747"/>
                  </a:cubicBezTo>
                  <a:lnTo>
                    <a:pt x="1081935" y="1344212"/>
                  </a:lnTo>
                  <a:lnTo>
                    <a:pt x="1088389" y="1346916"/>
                  </a:lnTo>
                  <a:lnTo>
                    <a:pt x="1093686" y="1344935"/>
                  </a:lnTo>
                  <a:lnTo>
                    <a:pt x="1098737" y="1346444"/>
                  </a:lnTo>
                  <a:lnTo>
                    <a:pt x="1104244" y="1343457"/>
                  </a:lnTo>
                  <a:cubicBezTo>
                    <a:pt x="1111716" y="1344495"/>
                    <a:pt x="1123256" y="1346350"/>
                    <a:pt x="1129570" y="1341225"/>
                  </a:cubicBezTo>
                  <a:cubicBezTo>
                    <a:pt x="1132797" y="1338584"/>
                    <a:pt x="1132972" y="1336100"/>
                    <a:pt x="1138304" y="1333553"/>
                  </a:cubicBezTo>
                  <a:cubicBezTo>
                    <a:pt x="1145495" y="1334874"/>
                    <a:pt x="1153246" y="1339024"/>
                    <a:pt x="1156964" y="1344935"/>
                  </a:cubicBezTo>
                  <a:cubicBezTo>
                    <a:pt x="1158894" y="1347985"/>
                    <a:pt x="1158157" y="1350657"/>
                    <a:pt x="1161805" y="1354116"/>
                  </a:cubicBezTo>
                  <a:lnTo>
                    <a:pt x="1167102" y="1352606"/>
                  </a:lnTo>
                  <a:lnTo>
                    <a:pt x="1172153" y="1354116"/>
                  </a:lnTo>
                  <a:cubicBezTo>
                    <a:pt x="1175450" y="1358832"/>
                    <a:pt x="1180817" y="1362479"/>
                    <a:pt x="1186429" y="1364743"/>
                  </a:cubicBezTo>
                  <a:cubicBezTo>
                    <a:pt x="1189691" y="1365057"/>
                    <a:pt x="1194146" y="1364146"/>
                    <a:pt x="1197022" y="1362762"/>
                  </a:cubicBezTo>
                  <a:cubicBezTo>
                    <a:pt x="1206423" y="1364397"/>
                    <a:pt x="1211754" y="1376659"/>
                    <a:pt x="1227855" y="1370182"/>
                  </a:cubicBezTo>
                  <a:lnTo>
                    <a:pt x="1232660" y="1371943"/>
                  </a:lnTo>
                  <a:cubicBezTo>
                    <a:pt x="1236098" y="1371283"/>
                    <a:pt x="1240062" y="1369396"/>
                    <a:pt x="1242798" y="1367479"/>
                  </a:cubicBezTo>
                  <a:lnTo>
                    <a:pt x="1248550" y="1368956"/>
                  </a:lnTo>
                  <a:cubicBezTo>
                    <a:pt x="1249392" y="1371346"/>
                    <a:pt x="1253391" y="1376408"/>
                    <a:pt x="1255706" y="1377634"/>
                  </a:cubicBezTo>
                  <a:cubicBezTo>
                    <a:pt x="1258687" y="1379206"/>
                    <a:pt x="1262862" y="1380024"/>
                    <a:pt x="1266089" y="1381344"/>
                  </a:cubicBezTo>
                  <a:cubicBezTo>
                    <a:pt x="1269035" y="1382570"/>
                    <a:pt x="1272017" y="1384142"/>
                    <a:pt x="1274893" y="1385526"/>
                  </a:cubicBezTo>
                  <a:cubicBezTo>
                    <a:pt x="1280400" y="1387475"/>
                    <a:pt x="1286293" y="1389236"/>
                    <a:pt x="1291624" y="1391499"/>
                  </a:cubicBezTo>
                  <a:cubicBezTo>
                    <a:pt x="1293203" y="1392160"/>
                    <a:pt x="1294676" y="1393669"/>
                    <a:pt x="1296220" y="1394455"/>
                  </a:cubicBezTo>
                  <a:cubicBezTo>
                    <a:pt x="1297728" y="1395241"/>
                    <a:pt x="1299868" y="1395555"/>
                    <a:pt x="1301271" y="1396436"/>
                  </a:cubicBezTo>
                  <a:cubicBezTo>
                    <a:pt x="1306322" y="1399517"/>
                    <a:pt x="1311162" y="1403259"/>
                    <a:pt x="1316003" y="1406591"/>
                  </a:cubicBezTo>
                  <a:cubicBezTo>
                    <a:pt x="1322773" y="1408792"/>
                    <a:pt x="1329578" y="1403196"/>
                    <a:pt x="1336488" y="1404862"/>
                  </a:cubicBezTo>
                  <a:cubicBezTo>
                    <a:pt x="1343679" y="1406560"/>
                    <a:pt x="1348975" y="1412754"/>
                    <a:pt x="1356061" y="1415018"/>
                  </a:cubicBezTo>
                  <a:lnTo>
                    <a:pt x="1361813" y="1414263"/>
                  </a:lnTo>
                  <a:lnTo>
                    <a:pt x="1366198" y="1410050"/>
                  </a:lnTo>
                  <a:lnTo>
                    <a:pt x="1361287" y="1400649"/>
                  </a:lnTo>
                  <a:cubicBezTo>
                    <a:pt x="1357850" y="1394109"/>
                    <a:pt x="1356622" y="1389959"/>
                    <a:pt x="1361813" y="1383828"/>
                  </a:cubicBezTo>
                  <a:lnTo>
                    <a:pt x="1367566" y="1384300"/>
                  </a:lnTo>
                  <a:cubicBezTo>
                    <a:pt x="1371389" y="1376439"/>
                    <a:pt x="1379177" y="1373861"/>
                    <a:pt x="1379633" y="1363957"/>
                  </a:cubicBezTo>
                  <a:cubicBezTo>
                    <a:pt x="1385806" y="1365403"/>
                    <a:pt x="1392470" y="1366630"/>
                    <a:pt x="1398890" y="1367007"/>
                  </a:cubicBezTo>
                  <a:lnTo>
                    <a:pt x="1405238" y="1375150"/>
                  </a:lnTo>
                  <a:cubicBezTo>
                    <a:pt x="1410325" y="1374993"/>
                    <a:pt x="1416147" y="1374301"/>
                    <a:pt x="1421199" y="1374584"/>
                  </a:cubicBezTo>
                  <a:cubicBezTo>
                    <a:pt x="1421304" y="1374615"/>
                    <a:pt x="1424566" y="1376125"/>
                    <a:pt x="1424881" y="1376250"/>
                  </a:cubicBezTo>
                  <a:cubicBezTo>
                    <a:pt x="1427056" y="1381250"/>
                    <a:pt x="1429371" y="1388418"/>
                    <a:pt x="1432213" y="1392977"/>
                  </a:cubicBezTo>
                  <a:lnTo>
                    <a:pt x="1438491" y="1398228"/>
                  </a:lnTo>
                  <a:cubicBezTo>
                    <a:pt x="1442210" y="1400083"/>
                    <a:pt x="1447506" y="1399737"/>
                    <a:pt x="1451294" y="1401026"/>
                  </a:cubicBezTo>
                  <a:cubicBezTo>
                    <a:pt x="1453855" y="1401907"/>
                    <a:pt x="1457889" y="1405082"/>
                    <a:pt x="1460835" y="1404202"/>
                  </a:cubicBezTo>
                  <a:lnTo>
                    <a:pt x="1462870" y="1396184"/>
                  </a:lnTo>
                  <a:lnTo>
                    <a:pt x="1469359" y="1398700"/>
                  </a:lnTo>
                  <a:lnTo>
                    <a:pt x="1472937" y="1403887"/>
                  </a:lnTo>
                  <a:lnTo>
                    <a:pt x="1478409" y="1403887"/>
                  </a:lnTo>
                  <a:lnTo>
                    <a:pt x="1477111" y="1391248"/>
                  </a:lnTo>
                  <a:cubicBezTo>
                    <a:pt x="1481075" y="1387066"/>
                    <a:pt x="1485144" y="1381784"/>
                    <a:pt x="1487950" y="1376879"/>
                  </a:cubicBezTo>
                  <a:cubicBezTo>
                    <a:pt x="1490475" y="1372415"/>
                    <a:pt x="1489949" y="1366630"/>
                    <a:pt x="1494404" y="1363265"/>
                  </a:cubicBezTo>
                  <a:cubicBezTo>
                    <a:pt x="1498613" y="1361505"/>
                    <a:pt x="1504120" y="1360781"/>
                    <a:pt x="1508645" y="1360310"/>
                  </a:cubicBezTo>
                  <a:cubicBezTo>
                    <a:pt x="1516362" y="1362385"/>
                    <a:pt x="1519764" y="1372760"/>
                    <a:pt x="1527060" y="1373421"/>
                  </a:cubicBezTo>
                  <a:cubicBezTo>
                    <a:pt x="1531410" y="1371409"/>
                    <a:pt x="1533725" y="1372697"/>
                    <a:pt x="1537654" y="1372163"/>
                  </a:cubicBezTo>
                  <a:cubicBezTo>
                    <a:pt x="1541407" y="1371692"/>
                    <a:pt x="1545440" y="1370497"/>
                    <a:pt x="1549159" y="1369711"/>
                  </a:cubicBezTo>
                  <a:cubicBezTo>
                    <a:pt x="1560594" y="1373609"/>
                    <a:pt x="1573046" y="1374521"/>
                    <a:pt x="1584832" y="1377131"/>
                  </a:cubicBezTo>
                  <a:cubicBezTo>
                    <a:pt x="1591917" y="1378703"/>
                    <a:pt x="1599038" y="1380935"/>
                    <a:pt x="1606018" y="1382822"/>
                  </a:cubicBezTo>
                  <a:lnTo>
                    <a:pt x="1610859" y="1381596"/>
                  </a:lnTo>
                  <a:cubicBezTo>
                    <a:pt x="1616717" y="1377634"/>
                    <a:pt x="1616892" y="1369176"/>
                    <a:pt x="1620751" y="1363768"/>
                  </a:cubicBezTo>
                  <a:cubicBezTo>
                    <a:pt x="1625627" y="1360719"/>
                    <a:pt x="1635238" y="1354493"/>
                    <a:pt x="1641692" y="1354839"/>
                  </a:cubicBezTo>
                  <a:cubicBezTo>
                    <a:pt x="1650320" y="1361693"/>
                    <a:pt x="1657827" y="1359146"/>
                    <a:pt x="1662632" y="1362511"/>
                  </a:cubicBezTo>
                  <a:cubicBezTo>
                    <a:pt x="1665474" y="1364523"/>
                    <a:pt x="1666561" y="1367667"/>
                    <a:pt x="1670700" y="1369711"/>
                  </a:cubicBezTo>
                  <a:cubicBezTo>
                    <a:pt x="1672384" y="1370528"/>
                    <a:pt x="1674839" y="1370748"/>
                    <a:pt x="1676453" y="1371692"/>
                  </a:cubicBezTo>
                  <a:cubicBezTo>
                    <a:pt x="1679855" y="1373578"/>
                    <a:pt x="1682731" y="1376439"/>
                    <a:pt x="1686134" y="1378357"/>
                  </a:cubicBezTo>
                  <a:cubicBezTo>
                    <a:pt x="1688870" y="1379929"/>
                    <a:pt x="1693325" y="1380778"/>
                    <a:pt x="1695780" y="1382570"/>
                  </a:cubicBezTo>
                  <a:cubicBezTo>
                    <a:pt x="1698937" y="1384865"/>
                    <a:pt x="1701287" y="1388953"/>
                    <a:pt x="1704304" y="1391499"/>
                  </a:cubicBezTo>
                  <a:cubicBezTo>
                    <a:pt x="1704935" y="1392034"/>
                    <a:pt x="1708759" y="1393449"/>
                    <a:pt x="1709355" y="1393952"/>
                  </a:cubicBezTo>
                  <a:cubicBezTo>
                    <a:pt x="1712372" y="1396593"/>
                    <a:pt x="1715177" y="1400397"/>
                    <a:pt x="1717878" y="1403353"/>
                  </a:cubicBezTo>
                  <a:cubicBezTo>
                    <a:pt x="1722403" y="1405271"/>
                    <a:pt x="1735557" y="1406026"/>
                    <a:pt x="1740222" y="1405837"/>
                  </a:cubicBezTo>
                  <a:cubicBezTo>
                    <a:pt x="1743169" y="1405742"/>
                    <a:pt x="1747343" y="1404454"/>
                    <a:pt x="1750324" y="1403856"/>
                  </a:cubicBezTo>
                  <a:lnTo>
                    <a:pt x="1754253" y="1399894"/>
                  </a:lnTo>
                  <a:cubicBezTo>
                    <a:pt x="1754674" y="1396970"/>
                    <a:pt x="1755621" y="1393418"/>
                    <a:pt x="1755621" y="1390493"/>
                  </a:cubicBezTo>
                  <a:cubicBezTo>
                    <a:pt x="1755621" y="1389047"/>
                    <a:pt x="1754885" y="1387475"/>
                    <a:pt x="1754920" y="1386029"/>
                  </a:cubicBezTo>
                  <a:cubicBezTo>
                    <a:pt x="1755130" y="1380275"/>
                    <a:pt x="1756463" y="1373578"/>
                    <a:pt x="1758848" y="1368202"/>
                  </a:cubicBezTo>
                  <a:cubicBezTo>
                    <a:pt x="1760848" y="1363705"/>
                    <a:pt x="1768038" y="1358329"/>
                    <a:pt x="1772212" y="1355594"/>
                  </a:cubicBezTo>
                  <a:cubicBezTo>
                    <a:pt x="1775475" y="1353455"/>
                    <a:pt x="1779965" y="1352167"/>
                    <a:pt x="1783016" y="1349871"/>
                  </a:cubicBezTo>
                  <a:cubicBezTo>
                    <a:pt x="1784700" y="1348645"/>
                    <a:pt x="1785928" y="1344495"/>
                    <a:pt x="1791084" y="1341476"/>
                  </a:cubicBezTo>
                  <a:cubicBezTo>
                    <a:pt x="1792487" y="1340627"/>
                    <a:pt x="1794451" y="1340282"/>
                    <a:pt x="1795924" y="1339496"/>
                  </a:cubicBezTo>
                  <a:cubicBezTo>
                    <a:pt x="1806062" y="1334088"/>
                    <a:pt x="1815708" y="1327957"/>
                    <a:pt x="1826301" y="1323146"/>
                  </a:cubicBezTo>
                  <a:cubicBezTo>
                    <a:pt x="1829598" y="1321637"/>
                    <a:pt x="1833422" y="1320756"/>
                    <a:pt x="1836649" y="1319184"/>
                  </a:cubicBezTo>
                  <a:cubicBezTo>
                    <a:pt x="1842857" y="1316197"/>
                    <a:pt x="1852819" y="1310853"/>
                    <a:pt x="1858852" y="1307551"/>
                  </a:cubicBezTo>
                  <a:cubicBezTo>
                    <a:pt x="1857555" y="1305979"/>
                    <a:pt x="1856152" y="1304501"/>
                    <a:pt x="1855169" y="1302772"/>
                  </a:cubicBezTo>
                  <a:cubicBezTo>
                    <a:pt x="1834299" y="1266709"/>
                    <a:pt x="1857274" y="1256773"/>
                    <a:pt x="1850785" y="1232689"/>
                  </a:cubicBezTo>
                  <a:cubicBezTo>
                    <a:pt x="1845418" y="1212661"/>
                    <a:pt x="1834018" y="1203166"/>
                    <a:pt x="1822092" y="1186942"/>
                  </a:cubicBezTo>
                  <a:cubicBezTo>
                    <a:pt x="1817532" y="1180717"/>
                    <a:pt x="1815042" y="1173517"/>
                    <a:pt x="1810937" y="1167071"/>
                  </a:cubicBezTo>
                  <a:cubicBezTo>
                    <a:pt x="1778562" y="1160060"/>
                    <a:pt x="1785752" y="1122582"/>
                    <a:pt x="1767407" y="1102239"/>
                  </a:cubicBezTo>
                  <a:cubicBezTo>
                    <a:pt x="1765232" y="1099818"/>
                    <a:pt x="1762251" y="1098215"/>
                    <a:pt x="1759620" y="1096234"/>
                  </a:cubicBezTo>
                  <a:cubicBezTo>
                    <a:pt x="1747764" y="1087179"/>
                    <a:pt x="1735627" y="1073376"/>
                    <a:pt x="1728542" y="1060925"/>
                  </a:cubicBezTo>
                  <a:cubicBezTo>
                    <a:pt x="1722368" y="1050109"/>
                    <a:pt x="1723491" y="1037187"/>
                    <a:pt x="1715388" y="1026937"/>
                  </a:cubicBezTo>
                  <a:cubicBezTo>
                    <a:pt x="1703286" y="1011562"/>
                    <a:pt x="1684029" y="1003670"/>
                    <a:pt x="1674559" y="986158"/>
                  </a:cubicBezTo>
                  <a:cubicBezTo>
                    <a:pt x="1669823" y="977386"/>
                    <a:pt x="1671787" y="967387"/>
                    <a:pt x="1669227" y="958175"/>
                  </a:cubicBezTo>
                  <a:cubicBezTo>
                    <a:pt x="1668385" y="955188"/>
                    <a:pt x="1666912" y="952358"/>
                    <a:pt x="1666526" y="949277"/>
                  </a:cubicBezTo>
                  <a:cubicBezTo>
                    <a:pt x="1665930" y="944404"/>
                    <a:pt x="1666456" y="939687"/>
                    <a:pt x="1663860" y="935160"/>
                  </a:cubicBezTo>
                  <a:cubicBezTo>
                    <a:pt x="1658634" y="926042"/>
                    <a:pt x="1629169" y="903310"/>
                    <a:pt x="1619383" y="891488"/>
                  </a:cubicBezTo>
                  <a:cubicBezTo>
                    <a:pt x="1617839" y="889633"/>
                    <a:pt x="1613840" y="886363"/>
                    <a:pt x="1613069" y="884445"/>
                  </a:cubicBezTo>
                  <a:lnTo>
                    <a:pt x="1607948" y="871900"/>
                  </a:lnTo>
                  <a:cubicBezTo>
                    <a:pt x="1606404" y="867875"/>
                    <a:pt x="1611841" y="852186"/>
                    <a:pt x="1610403" y="844955"/>
                  </a:cubicBezTo>
                  <a:cubicBezTo>
                    <a:pt x="1610333" y="844672"/>
                    <a:pt x="1600652" y="830837"/>
                    <a:pt x="1599705" y="829800"/>
                  </a:cubicBezTo>
                  <a:cubicBezTo>
                    <a:pt x="1595285" y="824989"/>
                    <a:pt x="1588480" y="822254"/>
                    <a:pt x="1584621" y="817003"/>
                  </a:cubicBezTo>
                  <a:cubicBezTo>
                    <a:pt x="1576308" y="805621"/>
                    <a:pt x="1565891" y="795686"/>
                    <a:pt x="1556911" y="784839"/>
                  </a:cubicBezTo>
                  <a:cubicBezTo>
                    <a:pt x="1549790" y="776192"/>
                    <a:pt x="1540004" y="770187"/>
                    <a:pt x="1533094" y="761289"/>
                  </a:cubicBezTo>
                  <a:cubicBezTo>
                    <a:pt x="1526674" y="753052"/>
                    <a:pt x="1512293" y="742393"/>
                    <a:pt x="1503910" y="734910"/>
                  </a:cubicBezTo>
                  <a:cubicBezTo>
                    <a:pt x="1497385" y="729030"/>
                    <a:pt x="1489107" y="716957"/>
                    <a:pt x="1482548" y="709788"/>
                  </a:cubicBezTo>
                  <a:cubicBezTo>
                    <a:pt x="1479286" y="706267"/>
                    <a:pt x="1474936" y="703751"/>
                    <a:pt x="1471849" y="700136"/>
                  </a:cubicBezTo>
                  <a:cubicBezTo>
                    <a:pt x="1467815" y="695420"/>
                    <a:pt x="1465395" y="689760"/>
                    <a:pt x="1461151" y="685233"/>
                  </a:cubicBezTo>
                  <a:cubicBezTo>
                    <a:pt x="1455434" y="679133"/>
                    <a:pt x="1446348" y="680422"/>
                    <a:pt x="1440491" y="675014"/>
                  </a:cubicBezTo>
                  <a:cubicBezTo>
                    <a:pt x="1436422" y="671304"/>
                    <a:pt x="1424145" y="645553"/>
                    <a:pt x="1420778" y="639203"/>
                  </a:cubicBezTo>
                  <a:cubicBezTo>
                    <a:pt x="1415586" y="629299"/>
                    <a:pt x="1403976" y="623639"/>
                    <a:pt x="1396469" y="615684"/>
                  </a:cubicBezTo>
                  <a:cubicBezTo>
                    <a:pt x="1387946" y="606598"/>
                    <a:pt x="1384473" y="594304"/>
                    <a:pt x="1378756" y="583772"/>
                  </a:cubicBezTo>
                  <a:cubicBezTo>
                    <a:pt x="1372371" y="572107"/>
                    <a:pt x="1362445" y="560599"/>
                    <a:pt x="1352728" y="551104"/>
                  </a:cubicBezTo>
                  <a:cubicBezTo>
                    <a:pt x="1347432" y="545916"/>
                    <a:pt x="1346310" y="540508"/>
                    <a:pt x="1342767" y="535415"/>
                  </a:cubicBezTo>
                  <a:cubicBezTo>
                    <a:pt x="1341890" y="534157"/>
                    <a:pt x="1340416" y="533402"/>
                    <a:pt x="1339364" y="532271"/>
                  </a:cubicBezTo>
                  <a:cubicBezTo>
                    <a:pt x="1338242" y="531076"/>
                    <a:pt x="1337505" y="529598"/>
                    <a:pt x="1336453" y="528340"/>
                  </a:cubicBezTo>
                  <a:cubicBezTo>
                    <a:pt x="1331367" y="522241"/>
                    <a:pt x="1323369" y="518028"/>
                    <a:pt x="1318458" y="512148"/>
                  </a:cubicBezTo>
                  <a:cubicBezTo>
                    <a:pt x="1313407" y="506111"/>
                    <a:pt x="1308847" y="499949"/>
                    <a:pt x="1303376" y="494101"/>
                  </a:cubicBezTo>
                  <a:cubicBezTo>
                    <a:pt x="1297833" y="488158"/>
                    <a:pt x="1298465" y="479166"/>
                    <a:pt x="1293413" y="473444"/>
                  </a:cubicBezTo>
                  <a:cubicBezTo>
                    <a:pt x="1282154" y="460679"/>
                    <a:pt x="1264089" y="453164"/>
                    <a:pt x="1255250" y="437884"/>
                  </a:cubicBezTo>
                  <a:cubicBezTo>
                    <a:pt x="1245148" y="420434"/>
                    <a:pt x="1248796" y="409429"/>
                    <a:pt x="1245043" y="391602"/>
                  </a:cubicBezTo>
                  <a:cubicBezTo>
                    <a:pt x="1237080" y="387074"/>
                    <a:pt x="1228486" y="378208"/>
                    <a:pt x="1228767" y="369121"/>
                  </a:cubicBezTo>
                  <a:cubicBezTo>
                    <a:pt x="1228942" y="363085"/>
                    <a:pt x="1230451" y="360884"/>
                    <a:pt x="1227048" y="354753"/>
                  </a:cubicBezTo>
                  <a:cubicBezTo>
                    <a:pt x="1224838" y="350697"/>
                    <a:pt x="1220945" y="347584"/>
                    <a:pt x="1218805" y="343497"/>
                  </a:cubicBezTo>
                  <a:cubicBezTo>
                    <a:pt x="1212105" y="330732"/>
                    <a:pt x="1200425" y="317243"/>
                    <a:pt x="1196917" y="303252"/>
                  </a:cubicBezTo>
                  <a:cubicBezTo>
                    <a:pt x="1195198" y="296366"/>
                    <a:pt x="1192182" y="282532"/>
                    <a:pt x="1188674" y="276589"/>
                  </a:cubicBezTo>
                  <a:cubicBezTo>
                    <a:pt x="1187131" y="273980"/>
                    <a:pt x="1184640" y="272031"/>
                    <a:pt x="1182571" y="269767"/>
                  </a:cubicBezTo>
                  <a:cubicBezTo>
                    <a:pt x="1179308" y="266245"/>
                    <a:pt x="1177554" y="261812"/>
                    <a:pt x="1174328" y="258291"/>
                  </a:cubicBezTo>
                  <a:cubicBezTo>
                    <a:pt x="1169276" y="252788"/>
                    <a:pt x="1163629" y="246437"/>
                    <a:pt x="1160718" y="239709"/>
                  </a:cubicBezTo>
                  <a:cubicBezTo>
                    <a:pt x="1157561" y="232477"/>
                    <a:pt x="1158473" y="224617"/>
                    <a:pt x="1154158" y="217228"/>
                  </a:cubicBezTo>
                  <a:cubicBezTo>
                    <a:pt x="1153492" y="216096"/>
                    <a:pt x="1138865" y="194528"/>
                    <a:pt x="1138830" y="194496"/>
                  </a:cubicBezTo>
                  <a:cubicBezTo>
                    <a:pt x="1132306" y="187327"/>
                    <a:pt x="1126518" y="180914"/>
                    <a:pt x="1121818" y="172519"/>
                  </a:cubicBezTo>
                  <a:cubicBezTo>
                    <a:pt x="1116872" y="163715"/>
                    <a:pt x="1117363" y="154723"/>
                    <a:pt x="1114276" y="145605"/>
                  </a:cubicBezTo>
                  <a:cubicBezTo>
                    <a:pt x="1112838" y="141266"/>
                    <a:pt x="1108173" y="138373"/>
                    <a:pt x="1106033" y="134349"/>
                  </a:cubicBezTo>
                  <a:cubicBezTo>
                    <a:pt x="1101718" y="126269"/>
                    <a:pt x="1096843" y="118408"/>
                    <a:pt x="1092423" y="110296"/>
                  </a:cubicBezTo>
                  <a:cubicBezTo>
                    <a:pt x="1087933" y="102153"/>
                    <a:pt x="1088109" y="92406"/>
                    <a:pt x="1083163" y="84420"/>
                  </a:cubicBezTo>
                  <a:cubicBezTo>
                    <a:pt x="1081514" y="81747"/>
                    <a:pt x="1078498" y="80018"/>
                    <a:pt x="1076849" y="77346"/>
                  </a:cubicBezTo>
                  <a:cubicBezTo>
                    <a:pt x="1075236" y="74736"/>
                    <a:pt x="1073973" y="72189"/>
                    <a:pt x="1072219" y="69517"/>
                  </a:cubicBezTo>
                  <a:cubicBezTo>
                    <a:pt x="1068992" y="64518"/>
                    <a:pt x="1068957" y="57632"/>
                    <a:pt x="1065905" y="52255"/>
                  </a:cubicBezTo>
                  <a:cubicBezTo>
                    <a:pt x="1062117" y="45527"/>
                    <a:pt x="1055452" y="40371"/>
                    <a:pt x="1052050" y="33454"/>
                  </a:cubicBezTo>
                  <a:cubicBezTo>
                    <a:pt x="1050015" y="29335"/>
                    <a:pt x="1035493" y="1698"/>
                    <a:pt x="1033634" y="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61" name="자유형: 도형 302"/>
            <p:cNvSpPr/>
            <p:nvPr/>
          </p:nvSpPr>
          <p:spPr>
            <a:xfrm>
              <a:off x="6169320" y="2064960"/>
              <a:ext cx="1600200" cy="1185480"/>
            </a:xfrm>
            <a:custGeom>
              <a:avLst/>
              <a:gdLst/>
              <a:ahLst/>
              <a:cxnLst/>
              <a:rect l="l" t="t" r="r" b="b"/>
              <a:pathLst>
                <a:path w="1267138" h="965332">
                  <a:moveTo>
                    <a:pt x="1140234" y="729995"/>
                  </a:moveTo>
                  <a:cubicBezTo>
                    <a:pt x="1151767" y="734082"/>
                    <a:pt x="1163591" y="720876"/>
                    <a:pt x="1174704" y="720153"/>
                  </a:cubicBezTo>
                  <a:lnTo>
                    <a:pt x="1176531" y="724366"/>
                  </a:lnTo>
                  <a:lnTo>
                    <a:pt x="1182073" y="726096"/>
                  </a:lnTo>
                  <a:cubicBezTo>
                    <a:pt x="1184195" y="728611"/>
                    <a:pt x="1186223" y="731787"/>
                    <a:pt x="1187373" y="734774"/>
                  </a:cubicBezTo>
                  <a:cubicBezTo>
                    <a:pt x="1198703" y="740307"/>
                    <a:pt x="1201141" y="733233"/>
                    <a:pt x="1208556" y="734774"/>
                  </a:cubicBezTo>
                  <a:cubicBezTo>
                    <a:pt x="1214509" y="736786"/>
                    <a:pt x="1217592" y="742508"/>
                    <a:pt x="1222847" y="745652"/>
                  </a:cubicBezTo>
                  <a:lnTo>
                    <a:pt x="1225604" y="759266"/>
                  </a:lnTo>
                  <a:cubicBezTo>
                    <a:pt x="1223885" y="762128"/>
                    <a:pt x="1220395" y="768730"/>
                    <a:pt x="1220521" y="772126"/>
                  </a:cubicBezTo>
                  <a:lnTo>
                    <a:pt x="1224656" y="776842"/>
                  </a:lnTo>
                  <a:lnTo>
                    <a:pt x="1221209" y="781527"/>
                  </a:lnTo>
                  <a:cubicBezTo>
                    <a:pt x="1221942" y="784451"/>
                    <a:pt x="1224899" y="788287"/>
                    <a:pt x="1227424" y="790173"/>
                  </a:cubicBezTo>
                  <a:cubicBezTo>
                    <a:pt x="1229837" y="794544"/>
                    <a:pt x="1222152" y="806586"/>
                    <a:pt x="1220714" y="811176"/>
                  </a:cubicBezTo>
                  <a:cubicBezTo>
                    <a:pt x="1220665" y="811333"/>
                    <a:pt x="1219781" y="820200"/>
                    <a:pt x="1219781" y="820577"/>
                  </a:cubicBezTo>
                  <a:cubicBezTo>
                    <a:pt x="1219781" y="829129"/>
                    <a:pt x="1232854" y="836015"/>
                    <a:pt x="1238463" y="841422"/>
                  </a:cubicBezTo>
                  <a:cubicBezTo>
                    <a:pt x="1239880" y="842806"/>
                    <a:pt x="1242160" y="848937"/>
                    <a:pt x="1242395" y="850855"/>
                  </a:cubicBezTo>
                  <a:cubicBezTo>
                    <a:pt x="1242770" y="853936"/>
                    <a:pt x="1241984" y="856577"/>
                    <a:pt x="1243075" y="859753"/>
                  </a:cubicBezTo>
                  <a:cubicBezTo>
                    <a:pt x="1251361" y="862237"/>
                    <a:pt x="1255440" y="874090"/>
                    <a:pt x="1257425" y="880630"/>
                  </a:cubicBezTo>
                  <a:lnTo>
                    <a:pt x="1267138" y="885881"/>
                  </a:lnTo>
                  <a:lnTo>
                    <a:pt x="1248782" y="898489"/>
                  </a:lnTo>
                  <a:lnTo>
                    <a:pt x="1263690" y="918139"/>
                  </a:lnTo>
                  <a:lnTo>
                    <a:pt x="1247028" y="929144"/>
                  </a:lnTo>
                  <a:lnTo>
                    <a:pt x="1247028" y="942506"/>
                  </a:lnTo>
                  <a:cubicBezTo>
                    <a:pt x="1240167" y="938168"/>
                    <a:pt x="1233149" y="933043"/>
                    <a:pt x="1225982" y="929144"/>
                  </a:cubicBezTo>
                  <a:cubicBezTo>
                    <a:pt x="1214053" y="922698"/>
                    <a:pt x="1193624" y="915184"/>
                    <a:pt x="1180382" y="911065"/>
                  </a:cubicBezTo>
                  <a:lnTo>
                    <a:pt x="1175998" y="914995"/>
                  </a:lnTo>
                  <a:lnTo>
                    <a:pt x="1183890" y="925214"/>
                  </a:lnTo>
                  <a:cubicBezTo>
                    <a:pt x="1182235" y="932257"/>
                    <a:pt x="1180660" y="939331"/>
                    <a:pt x="1179506" y="946437"/>
                  </a:cubicBezTo>
                  <a:cubicBezTo>
                    <a:pt x="1178646" y="951750"/>
                    <a:pt x="1176598" y="953888"/>
                    <a:pt x="1173367" y="958227"/>
                  </a:cubicBezTo>
                  <a:cubicBezTo>
                    <a:pt x="1170143" y="962566"/>
                    <a:pt x="1162234" y="964201"/>
                    <a:pt x="1156706" y="964547"/>
                  </a:cubicBezTo>
                  <a:lnTo>
                    <a:pt x="1152321" y="957441"/>
                  </a:lnTo>
                  <a:cubicBezTo>
                    <a:pt x="1147800" y="957976"/>
                    <a:pt x="1141640" y="962000"/>
                    <a:pt x="1139167" y="965333"/>
                  </a:cubicBezTo>
                  <a:lnTo>
                    <a:pt x="1123383" y="958227"/>
                  </a:lnTo>
                  <a:lnTo>
                    <a:pt x="1114613" y="960617"/>
                  </a:lnTo>
                  <a:cubicBezTo>
                    <a:pt x="1111990" y="955460"/>
                    <a:pt x="1108096" y="946248"/>
                    <a:pt x="1104967" y="941720"/>
                  </a:cubicBezTo>
                  <a:cubicBezTo>
                    <a:pt x="1104908" y="941658"/>
                    <a:pt x="1099299" y="938105"/>
                    <a:pt x="1098829" y="937790"/>
                  </a:cubicBezTo>
                  <a:lnTo>
                    <a:pt x="1102336" y="929930"/>
                  </a:lnTo>
                  <a:lnTo>
                    <a:pt x="1097952" y="919712"/>
                  </a:lnTo>
                  <a:lnTo>
                    <a:pt x="1069890" y="937004"/>
                  </a:lnTo>
                  <a:cubicBezTo>
                    <a:pt x="1069231" y="936627"/>
                    <a:pt x="1062145" y="932445"/>
                    <a:pt x="1061998" y="932288"/>
                  </a:cubicBezTo>
                  <a:cubicBezTo>
                    <a:pt x="1057105" y="927226"/>
                    <a:pt x="1042916" y="903268"/>
                    <a:pt x="1039198" y="896917"/>
                  </a:cubicBezTo>
                  <a:cubicBezTo>
                    <a:pt x="1039342" y="896099"/>
                    <a:pt x="1040973" y="886949"/>
                    <a:pt x="1040952" y="886698"/>
                  </a:cubicBezTo>
                  <a:cubicBezTo>
                    <a:pt x="1040422" y="880378"/>
                    <a:pt x="1037893" y="871921"/>
                    <a:pt x="1036567" y="865475"/>
                  </a:cubicBezTo>
                  <a:lnTo>
                    <a:pt x="1028675" y="860759"/>
                  </a:lnTo>
                  <a:lnTo>
                    <a:pt x="1030429" y="842680"/>
                  </a:lnTo>
                  <a:lnTo>
                    <a:pt x="1024161" y="838090"/>
                  </a:lnTo>
                  <a:lnTo>
                    <a:pt x="1020685" y="829160"/>
                  </a:lnTo>
                  <a:lnTo>
                    <a:pt x="984948" y="835857"/>
                  </a:lnTo>
                  <a:lnTo>
                    <a:pt x="983924" y="841485"/>
                  </a:lnTo>
                  <a:lnTo>
                    <a:pt x="964660" y="846610"/>
                  </a:lnTo>
                  <a:lnTo>
                    <a:pt x="951026" y="843403"/>
                  </a:lnTo>
                  <a:cubicBezTo>
                    <a:pt x="948938" y="849566"/>
                    <a:pt x="948595" y="856326"/>
                    <a:pt x="947904" y="862708"/>
                  </a:cubicBezTo>
                  <a:cubicBezTo>
                    <a:pt x="947532" y="866135"/>
                    <a:pt x="945420" y="874656"/>
                    <a:pt x="940492" y="868242"/>
                  </a:cubicBezTo>
                  <a:lnTo>
                    <a:pt x="934262" y="860067"/>
                  </a:lnTo>
                  <a:cubicBezTo>
                    <a:pt x="927783" y="858401"/>
                    <a:pt x="920544" y="856860"/>
                    <a:pt x="913798" y="856860"/>
                  </a:cubicBezTo>
                  <a:cubicBezTo>
                    <a:pt x="908298" y="856860"/>
                    <a:pt x="905850" y="861796"/>
                    <a:pt x="905839" y="866073"/>
                  </a:cubicBezTo>
                  <a:cubicBezTo>
                    <a:pt x="904173" y="865790"/>
                    <a:pt x="887312" y="862551"/>
                    <a:pt x="886747" y="862551"/>
                  </a:cubicBezTo>
                  <a:cubicBezTo>
                    <a:pt x="886530" y="862551"/>
                    <a:pt x="873656" y="866010"/>
                    <a:pt x="872583" y="866293"/>
                  </a:cubicBezTo>
                  <a:lnTo>
                    <a:pt x="862092" y="863809"/>
                  </a:lnTo>
                  <a:cubicBezTo>
                    <a:pt x="856469" y="865884"/>
                    <a:pt x="852593" y="870663"/>
                    <a:pt x="850898" y="875725"/>
                  </a:cubicBezTo>
                  <a:cubicBezTo>
                    <a:pt x="847654" y="885409"/>
                    <a:pt x="842813" y="887704"/>
                    <a:pt x="833451" y="881070"/>
                  </a:cubicBezTo>
                  <a:cubicBezTo>
                    <a:pt x="828264" y="877423"/>
                    <a:pt x="821010" y="874782"/>
                    <a:pt x="814363" y="876763"/>
                  </a:cubicBezTo>
                  <a:cubicBezTo>
                    <a:pt x="809175" y="872549"/>
                    <a:pt x="802878" y="868242"/>
                    <a:pt x="798199" y="863620"/>
                  </a:cubicBezTo>
                  <a:cubicBezTo>
                    <a:pt x="795628" y="861073"/>
                    <a:pt x="793211" y="856766"/>
                    <a:pt x="791086" y="853842"/>
                  </a:cubicBezTo>
                  <a:lnTo>
                    <a:pt x="791549" y="830449"/>
                  </a:lnTo>
                  <a:cubicBezTo>
                    <a:pt x="784902" y="827054"/>
                    <a:pt x="778395" y="819854"/>
                    <a:pt x="774522" y="814069"/>
                  </a:cubicBezTo>
                  <a:lnTo>
                    <a:pt x="767132" y="818785"/>
                  </a:lnTo>
                  <a:cubicBezTo>
                    <a:pt x="764294" y="818408"/>
                    <a:pt x="761730" y="814666"/>
                    <a:pt x="760341" y="812842"/>
                  </a:cubicBezTo>
                  <a:cubicBezTo>
                    <a:pt x="756475" y="807749"/>
                    <a:pt x="748685" y="808315"/>
                    <a:pt x="744535" y="812748"/>
                  </a:cubicBezTo>
                  <a:cubicBezTo>
                    <a:pt x="740459" y="817087"/>
                    <a:pt x="716831" y="805705"/>
                    <a:pt x="712675" y="802655"/>
                  </a:cubicBezTo>
                  <a:cubicBezTo>
                    <a:pt x="706378" y="797971"/>
                    <a:pt x="698283" y="802058"/>
                    <a:pt x="692534" y="805548"/>
                  </a:cubicBezTo>
                  <a:cubicBezTo>
                    <a:pt x="683621" y="810956"/>
                    <a:pt x="687448" y="818030"/>
                    <a:pt x="671372" y="814100"/>
                  </a:cubicBezTo>
                  <a:cubicBezTo>
                    <a:pt x="655836" y="810295"/>
                    <a:pt x="650301" y="821426"/>
                    <a:pt x="641827" y="830575"/>
                  </a:cubicBezTo>
                  <a:cubicBezTo>
                    <a:pt x="627199" y="846390"/>
                    <a:pt x="648372" y="875316"/>
                    <a:pt x="621780" y="889528"/>
                  </a:cubicBezTo>
                  <a:cubicBezTo>
                    <a:pt x="620345" y="887547"/>
                    <a:pt x="619149" y="885409"/>
                    <a:pt x="618104" y="883240"/>
                  </a:cubicBezTo>
                  <a:cubicBezTo>
                    <a:pt x="613923" y="887201"/>
                    <a:pt x="606648" y="891037"/>
                    <a:pt x="600604" y="891855"/>
                  </a:cubicBezTo>
                  <a:cubicBezTo>
                    <a:pt x="596795" y="892389"/>
                    <a:pt x="592884" y="891760"/>
                    <a:pt x="589180" y="892923"/>
                  </a:cubicBezTo>
                  <a:cubicBezTo>
                    <a:pt x="582803" y="894904"/>
                    <a:pt x="578032" y="900155"/>
                    <a:pt x="572652" y="903110"/>
                  </a:cubicBezTo>
                  <a:cubicBezTo>
                    <a:pt x="569600" y="904777"/>
                    <a:pt x="557453" y="909682"/>
                    <a:pt x="553935" y="910436"/>
                  </a:cubicBezTo>
                  <a:cubicBezTo>
                    <a:pt x="547364" y="911820"/>
                    <a:pt x="539300" y="911128"/>
                    <a:pt x="533758" y="915121"/>
                  </a:cubicBezTo>
                  <a:cubicBezTo>
                    <a:pt x="526084" y="920686"/>
                    <a:pt x="520468" y="929616"/>
                    <a:pt x="510909" y="933168"/>
                  </a:cubicBezTo>
                  <a:cubicBezTo>
                    <a:pt x="507436" y="934458"/>
                    <a:pt x="503378" y="933703"/>
                    <a:pt x="499727" y="933955"/>
                  </a:cubicBezTo>
                  <a:cubicBezTo>
                    <a:pt x="493658" y="934395"/>
                    <a:pt x="489737" y="936155"/>
                    <a:pt x="484170" y="937633"/>
                  </a:cubicBezTo>
                  <a:cubicBezTo>
                    <a:pt x="479561" y="938828"/>
                    <a:pt x="470788" y="937948"/>
                    <a:pt x="465941" y="937350"/>
                  </a:cubicBezTo>
                  <a:lnTo>
                    <a:pt x="470802" y="938671"/>
                  </a:lnTo>
                  <a:cubicBezTo>
                    <a:pt x="467526" y="939488"/>
                    <a:pt x="464590" y="937539"/>
                    <a:pt x="461809" y="936313"/>
                  </a:cubicBezTo>
                  <a:cubicBezTo>
                    <a:pt x="440482" y="926912"/>
                    <a:pt x="451987" y="916410"/>
                    <a:pt x="446010" y="903362"/>
                  </a:cubicBezTo>
                  <a:cubicBezTo>
                    <a:pt x="443035" y="896885"/>
                    <a:pt x="434764" y="895502"/>
                    <a:pt x="429240" y="891855"/>
                  </a:cubicBezTo>
                  <a:cubicBezTo>
                    <a:pt x="425950" y="889685"/>
                    <a:pt x="423522" y="878901"/>
                    <a:pt x="421705" y="875128"/>
                  </a:cubicBezTo>
                  <a:cubicBezTo>
                    <a:pt x="425279" y="871921"/>
                    <a:pt x="430387" y="870097"/>
                    <a:pt x="432888" y="865978"/>
                  </a:cubicBezTo>
                  <a:lnTo>
                    <a:pt x="431916" y="861262"/>
                  </a:lnTo>
                  <a:cubicBezTo>
                    <a:pt x="424122" y="853244"/>
                    <a:pt x="414300" y="856892"/>
                    <a:pt x="405910" y="850541"/>
                  </a:cubicBezTo>
                  <a:cubicBezTo>
                    <a:pt x="398702" y="845101"/>
                    <a:pt x="391487" y="826991"/>
                    <a:pt x="386951" y="824664"/>
                  </a:cubicBezTo>
                  <a:cubicBezTo>
                    <a:pt x="373043" y="817527"/>
                    <a:pt x="361131" y="831079"/>
                    <a:pt x="355350" y="818659"/>
                  </a:cubicBezTo>
                  <a:cubicBezTo>
                    <a:pt x="346251" y="815641"/>
                    <a:pt x="334876" y="816018"/>
                    <a:pt x="325209" y="816836"/>
                  </a:cubicBezTo>
                  <a:cubicBezTo>
                    <a:pt x="321733" y="817118"/>
                    <a:pt x="317618" y="827022"/>
                    <a:pt x="316703" y="829632"/>
                  </a:cubicBezTo>
                  <a:lnTo>
                    <a:pt x="311353" y="830701"/>
                  </a:lnTo>
                  <a:lnTo>
                    <a:pt x="308681" y="826771"/>
                  </a:lnTo>
                  <a:cubicBezTo>
                    <a:pt x="310210" y="820766"/>
                    <a:pt x="317674" y="808378"/>
                    <a:pt x="320835" y="802435"/>
                  </a:cubicBezTo>
                  <a:cubicBezTo>
                    <a:pt x="324707" y="801398"/>
                    <a:pt x="328583" y="802593"/>
                    <a:pt x="332501" y="802184"/>
                  </a:cubicBezTo>
                  <a:cubicBezTo>
                    <a:pt x="338899" y="801524"/>
                    <a:pt x="345048" y="794041"/>
                    <a:pt x="356080" y="793317"/>
                  </a:cubicBezTo>
                  <a:cubicBezTo>
                    <a:pt x="364263" y="787438"/>
                    <a:pt x="363583" y="779452"/>
                    <a:pt x="376744" y="780489"/>
                  </a:cubicBezTo>
                  <a:cubicBezTo>
                    <a:pt x="380472" y="784136"/>
                    <a:pt x="384436" y="788130"/>
                    <a:pt x="390111" y="789104"/>
                  </a:cubicBezTo>
                  <a:lnTo>
                    <a:pt x="394247" y="786495"/>
                  </a:lnTo>
                  <a:cubicBezTo>
                    <a:pt x="392591" y="780112"/>
                    <a:pt x="387519" y="776528"/>
                    <a:pt x="383552" y="771591"/>
                  </a:cubicBezTo>
                  <a:cubicBezTo>
                    <a:pt x="380644" y="768007"/>
                    <a:pt x="381139" y="762473"/>
                    <a:pt x="376018" y="760367"/>
                  </a:cubicBezTo>
                  <a:cubicBezTo>
                    <a:pt x="368206" y="757160"/>
                    <a:pt x="356178" y="765869"/>
                    <a:pt x="349521" y="760367"/>
                  </a:cubicBezTo>
                  <a:cubicBezTo>
                    <a:pt x="350180" y="754079"/>
                    <a:pt x="341860" y="750651"/>
                    <a:pt x="343603" y="739364"/>
                  </a:cubicBezTo>
                  <a:cubicBezTo>
                    <a:pt x="344824" y="731441"/>
                    <a:pt x="348770" y="716946"/>
                    <a:pt x="354137" y="710690"/>
                  </a:cubicBezTo>
                  <a:cubicBezTo>
                    <a:pt x="360503" y="703269"/>
                    <a:pt x="373527" y="700220"/>
                    <a:pt x="363860" y="686637"/>
                  </a:cubicBezTo>
                  <a:lnTo>
                    <a:pt x="365807" y="682455"/>
                  </a:lnTo>
                  <a:cubicBezTo>
                    <a:pt x="370676" y="681009"/>
                    <a:pt x="375488" y="679311"/>
                    <a:pt x="379904" y="676953"/>
                  </a:cubicBezTo>
                  <a:lnTo>
                    <a:pt x="380392" y="671199"/>
                  </a:lnTo>
                  <a:lnTo>
                    <a:pt x="376747" y="668055"/>
                  </a:lnTo>
                  <a:cubicBezTo>
                    <a:pt x="372871" y="667426"/>
                    <a:pt x="368974" y="668244"/>
                    <a:pt x="365081" y="668055"/>
                  </a:cubicBezTo>
                  <a:cubicBezTo>
                    <a:pt x="360275" y="667866"/>
                    <a:pt x="355736" y="666231"/>
                    <a:pt x="350980" y="665728"/>
                  </a:cubicBezTo>
                  <a:cubicBezTo>
                    <a:pt x="343645" y="664942"/>
                    <a:pt x="333634" y="666326"/>
                    <a:pt x="328860" y="659975"/>
                  </a:cubicBezTo>
                  <a:cubicBezTo>
                    <a:pt x="327043" y="657554"/>
                    <a:pt x="326461" y="654504"/>
                    <a:pt x="325212" y="651863"/>
                  </a:cubicBezTo>
                  <a:lnTo>
                    <a:pt x="327401" y="646361"/>
                  </a:lnTo>
                  <a:cubicBezTo>
                    <a:pt x="334915" y="641015"/>
                    <a:pt x="371577" y="637714"/>
                    <a:pt x="381847" y="630671"/>
                  </a:cubicBezTo>
                  <a:cubicBezTo>
                    <a:pt x="382132" y="627842"/>
                    <a:pt x="381581" y="624006"/>
                    <a:pt x="379901" y="621522"/>
                  </a:cubicBezTo>
                  <a:cubicBezTo>
                    <a:pt x="378939" y="620107"/>
                    <a:pt x="368462" y="612718"/>
                    <a:pt x="366775" y="612372"/>
                  </a:cubicBezTo>
                  <a:cubicBezTo>
                    <a:pt x="352927" y="609543"/>
                    <a:pt x="347693" y="615642"/>
                    <a:pt x="336633" y="612372"/>
                  </a:cubicBezTo>
                  <a:cubicBezTo>
                    <a:pt x="325300" y="609040"/>
                    <a:pt x="327787" y="602940"/>
                    <a:pt x="320593" y="596966"/>
                  </a:cubicBezTo>
                  <a:cubicBezTo>
                    <a:pt x="315686" y="592879"/>
                    <a:pt x="310740" y="594514"/>
                    <a:pt x="309168" y="587031"/>
                  </a:cubicBezTo>
                  <a:lnTo>
                    <a:pt x="314030" y="585207"/>
                  </a:lnTo>
                  <a:lnTo>
                    <a:pt x="320351" y="585962"/>
                  </a:lnTo>
                  <a:lnTo>
                    <a:pt x="325212" y="584138"/>
                  </a:lnTo>
                  <a:cubicBezTo>
                    <a:pt x="322813" y="579108"/>
                    <a:pt x="313714" y="574800"/>
                    <a:pt x="319379" y="567946"/>
                  </a:cubicBezTo>
                  <a:cubicBezTo>
                    <a:pt x="320747" y="566279"/>
                    <a:pt x="339885" y="563670"/>
                    <a:pt x="344417" y="561154"/>
                  </a:cubicBezTo>
                  <a:cubicBezTo>
                    <a:pt x="349882" y="558073"/>
                    <a:pt x="358595" y="546849"/>
                    <a:pt x="365810" y="541284"/>
                  </a:cubicBezTo>
                  <a:cubicBezTo>
                    <a:pt x="378803" y="541598"/>
                    <a:pt x="382563" y="538831"/>
                    <a:pt x="385983" y="527952"/>
                  </a:cubicBezTo>
                  <a:cubicBezTo>
                    <a:pt x="394521" y="528456"/>
                    <a:pt x="400747" y="529776"/>
                    <a:pt x="405917" y="522199"/>
                  </a:cubicBezTo>
                  <a:lnTo>
                    <a:pt x="403241" y="518520"/>
                  </a:lnTo>
                  <a:cubicBezTo>
                    <a:pt x="399158" y="517734"/>
                    <a:pt x="394980" y="518174"/>
                    <a:pt x="390845" y="518017"/>
                  </a:cubicBezTo>
                  <a:cubicBezTo>
                    <a:pt x="384622" y="517734"/>
                    <a:pt x="371381" y="514150"/>
                    <a:pt x="366052" y="516948"/>
                  </a:cubicBezTo>
                  <a:cubicBezTo>
                    <a:pt x="358823" y="520784"/>
                    <a:pt x="348924" y="528864"/>
                    <a:pt x="342961" y="534744"/>
                  </a:cubicBezTo>
                  <a:cubicBezTo>
                    <a:pt x="335914" y="541692"/>
                    <a:pt x="327282" y="557696"/>
                    <a:pt x="314524" y="546754"/>
                  </a:cubicBezTo>
                  <a:cubicBezTo>
                    <a:pt x="312065" y="544648"/>
                    <a:pt x="305341" y="533738"/>
                    <a:pt x="305047" y="530814"/>
                  </a:cubicBezTo>
                  <a:cubicBezTo>
                    <a:pt x="304868" y="529084"/>
                    <a:pt x="305475" y="527323"/>
                    <a:pt x="305047" y="525594"/>
                  </a:cubicBezTo>
                  <a:cubicBezTo>
                    <a:pt x="304689" y="524148"/>
                    <a:pt x="303496" y="522985"/>
                    <a:pt x="302858" y="521664"/>
                  </a:cubicBezTo>
                  <a:cubicBezTo>
                    <a:pt x="297519" y="510565"/>
                    <a:pt x="294468" y="511068"/>
                    <a:pt x="298726" y="497863"/>
                  </a:cubicBezTo>
                  <a:cubicBezTo>
                    <a:pt x="299504" y="495474"/>
                    <a:pt x="310347" y="486670"/>
                    <a:pt x="313065" y="484815"/>
                  </a:cubicBezTo>
                  <a:cubicBezTo>
                    <a:pt x="321473" y="478998"/>
                    <a:pt x="323304" y="478904"/>
                    <a:pt x="324490" y="468843"/>
                  </a:cubicBezTo>
                  <a:cubicBezTo>
                    <a:pt x="311848" y="457870"/>
                    <a:pt x="302889" y="471012"/>
                    <a:pt x="293864" y="467019"/>
                  </a:cubicBezTo>
                  <a:cubicBezTo>
                    <a:pt x="291577" y="466013"/>
                    <a:pt x="289248" y="461611"/>
                    <a:pt x="288760" y="459442"/>
                  </a:cubicBezTo>
                  <a:cubicBezTo>
                    <a:pt x="287403" y="453374"/>
                    <a:pt x="287796" y="445859"/>
                    <a:pt x="287063" y="439571"/>
                  </a:cubicBezTo>
                  <a:cubicBezTo>
                    <a:pt x="286512" y="434886"/>
                    <a:pt x="283025" y="430767"/>
                    <a:pt x="283173" y="425988"/>
                  </a:cubicBezTo>
                  <a:cubicBezTo>
                    <a:pt x="283320" y="421209"/>
                    <a:pt x="287217" y="417027"/>
                    <a:pt x="291195" y="414198"/>
                  </a:cubicBezTo>
                  <a:cubicBezTo>
                    <a:pt x="298926" y="414921"/>
                    <a:pt x="305320" y="410802"/>
                    <a:pt x="312827" y="410802"/>
                  </a:cubicBezTo>
                  <a:cubicBezTo>
                    <a:pt x="319126" y="410802"/>
                    <a:pt x="322592" y="415172"/>
                    <a:pt x="328141" y="416839"/>
                  </a:cubicBezTo>
                  <a:lnTo>
                    <a:pt x="333003" y="415267"/>
                  </a:lnTo>
                  <a:cubicBezTo>
                    <a:pt x="339822" y="405268"/>
                    <a:pt x="327478" y="393572"/>
                    <a:pt x="327170" y="383102"/>
                  </a:cubicBezTo>
                  <a:cubicBezTo>
                    <a:pt x="327061" y="379424"/>
                    <a:pt x="328120" y="375808"/>
                    <a:pt x="327899" y="372129"/>
                  </a:cubicBezTo>
                  <a:cubicBezTo>
                    <a:pt x="321028" y="368325"/>
                    <a:pt x="313065" y="367570"/>
                    <a:pt x="306264" y="363231"/>
                  </a:cubicBezTo>
                  <a:cubicBezTo>
                    <a:pt x="309445" y="349491"/>
                    <a:pt x="327187" y="356503"/>
                    <a:pt x="330572" y="343360"/>
                  </a:cubicBezTo>
                  <a:cubicBezTo>
                    <a:pt x="326380" y="339399"/>
                    <a:pt x="319604" y="335060"/>
                    <a:pt x="317204" y="330029"/>
                  </a:cubicBezTo>
                  <a:cubicBezTo>
                    <a:pt x="311960" y="329621"/>
                    <a:pt x="302781" y="329903"/>
                    <a:pt x="298729" y="326633"/>
                  </a:cubicBezTo>
                  <a:cubicBezTo>
                    <a:pt x="289515" y="319150"/>
                    <a:pt x="301118" y="301543"/>
                    <a:pt x="310638" y="298399"/>
                  </a:cubicBezTo>
                  <a:lnTo>
                    <a:pt x="310399" y="293148"/>
                  </a:lnTo>
                  <a:cubicBezTo>
                    <a:pt x="307625" y="290727"/>
                    <a:pt x="303510" y="289155"/>
                    <a:pt x="299701" y="288715"/>
                  </a:cubicBezTo>
                  <a:cubicBezTo>
                    <a:pt x="296632" y="285100"/>
                    <a:pt x="295025" y="280698"/>
                    <a:pt x="292170" y="276956"/>
                  </a:cubicBezTo>
                  <a:lnTo>
                    <a:pt x="287305" y="275636"/>
                  </a:lnTo>
                  <a:cubicBezTo>
                    <a:pt x="277360" y="280698"/>
                    <a:pt x="284464" y="289941"/>
                    <a:pt x="272478" y="296292"/>
                  </a:cubicBezTo>
                  <a:cubicBezTo>
                    <a:pt x="269163" y="295695"/>
                    <a:pt x="266003" y="294532"/>
                    <a:pt x="263000" y="293148"/>
                  </a:cubicBezTo>
                  <a:lnTo>
                    <a:pt x="258622" y="295506"/>
                  </a:lnTo>
                  <a:cubicBezTo>
                    <a:pt x="256777" y="304499"/>
                    <a:pt x="259608" y="306260"/>
                    <a:pt x="264698" y="313302"/>
                  </a:cubicBezTo>
                  <a:cubicBezTo>
                    <a:pt x="263989" y="321603"/>
                    <a:pt x="246896" y="354365"/>
                    <a:pt x="240147" y="360370"/>
                  </a:cubicBezTo>
                  <a:cubicBezTo>
                    <a:pt x="238706" y="361628"/>
                    <a:pt x="233241" y="363577"/>
                    <a:pt x="231157" y="364269"/>
                  </a:cubicBezTo>
                  <a:cubicBezTo>
                    <a:pt x="218024" y="360464"/>
                    <a:pt x="217824" y="370054"/>
                    <a:pt x="209764" y="376028"/>
                  </a:cubicBezTo>
                  <a:cubicBezTo>
                    <a:pt x="208708" y="374833"/>
                    <a:pt x="207501" y="373701"/>
                    <a:pt x="206607" y="372381"/>
                  </a:cubicBezTo>
                  <a:cubicBezTo>
                    <a:pt x="203545" y="367916"/>
                    <a:pt x="216597" y="348768"/>
                    <a:pt x="214871" y="340751"/>
                  </a:cubicBezTo>
                  <a:cubicBezTo>
                    <a:pt x="214226" y="337764"/>
                    <a:pt x="212293" y="335154"/>
                    <a:pt x="210981" y="332387"/>
                  </a:cubicBezTo>
                  <a:cubicBezTo>
                    <a:pt x="212900" y="327294"/>
                    <a:pt x="219887" y="315598"/>
                    <a:pt x="219491" y="310944"/>
                  </a:cubicBezTo>
                  <a:cubicBezTo>
                    <a:pt x="219073" y="306071"/>
                    <a:pt x="212552" y="302329"/>
                    <a:pt x="207579" y="301795"/>
                  </a:cubicBezTo>
                  <a:lnTo>
                    <a:pt x="204173" y="298148"/>
                  </a:lnTo>
                  <a:cubicBezTo>
                    <a:pt x="203671" y="294469"/>
                    <a:pt x="203899" y="290759"/>
                    <a:pt x="204660" y="287143"/>
                  </a:cubicBezTo>
                  <a:cubicBezTo>
                    <a:pt x="201721" y="281924"/>
                    <a:pt x="192930" y="276013"/>
                    <a:pt x="186185" y="278780"/>
                  </a:cubicBezTo>
                  <a:cubicBezTo>
                    <a:pt x="172996" y="284188"/>
                    <a:pt x="176515" y="308900"/>
                    <a:pt x="171116" y="318270"/>
                  </a:cubicBezTo>
                  <a:cubicBezTo>
                    <a:pt x="165581" y="320503"/>
                    <a:pt x="158674" y="318081"/>
                    <a:pt x="153129" y="316950"/>
                  </a:cubicBezTo>
                  <a:lnTo>
                    <a:pt x="149968" y="320880"/>
                  </a:lnTo>
                  <a:cubicBezTo>
                    <a:pt x="150319" y="336978"/>
                    <a:pt x="173007" y="352007"/>
                    <a:pt x="177437" y="362980"/>
                  </a:cubicBezTo>
                  <a:cubicBezTo>
                    <a:pt x="174385" y="368671"/>
                    <a:pt x="160512" y="372852"/>
                    <a:pt x="167956" y="382851"/>
                  </a:cubicBezTo>
                  <a:cubicBezTo>
                    <a:pt x="173382" y="384391"/>
                    <a:pt x="177676" y="387881"/>
                    <a:pt x="182299" y="390679"/>
                  </a:cubicBezTo>
                  <a:lnTo>
                    <a:pt x="183516" y="395144"/>
                  </a:lnTo>
                  <a:cubicBezTo>
                    <a:pt x="177647" y="399640"/>
                    <a:pt x="167342" y="400017"/>
                    <a:pt x="159695" y="404011"/>
                  </a:cubicBezTo>
                  <a:cubicBezTo>
                    <a:pt x="158446" y="407155"/>
                    <a:pt x="156573" y="410142"/>
                    <a:pt x="154104" y="412657"/>
                  </a:cubicBezTo>
                  <a:lnTo>
                    <a:pt x="147299" y="411871"/>
                  </a:lnTo>
                  <a:cubicBezTo>
                    <a:pt x="146383" y="414858"/>
                    <a:pt x="144153" y="418002"/>
                    <a:pt x="141224" y="419700"/>
                  </a:cubicBezTo>
                  <a:lnTo>
                    <a:pt x="138063" y="417090"/>
                  </a:lnTo>
                  <a:cubicBezTo>
                    <a:pt x="139298" y="413223"/>
                    <a:pt x="141178" y="398006"/>
                    <a:pt x="138551" y="395144"/>
                  </a:cubicBezTo>
                  <a:lnTo>
                    <a:pt x="138793" y="393038"/>
                  </a:lnTo>
                  <a:cubicBezTo>
                    <a:pt x="144111" y="387818"/>
                    <a:pt x="146085" y="382442"/>
                    <a:pt x="146085" y="375430"/>
                  </a:cubicBezTo>
                  <a:cubicBezTo>
                    <a:pt x="146085" y="352164"/>
                    <a:pt x="123363" y="349240"/>
                    <a:pt x="119346" y="336317"/>
                  </a:cubicBezTo>
                  <a:cubicBezTo>
                    <a:pt x="121900" y="332136"/>
                    <a:pt x="127165" y="330375"/>
                    <a:pt x="130529" y="326885"/>
                  </a:cubicBezTo>
                  <a:cubicBezTo>
                    <a:pt x="130480" y="321571"/>
                    <a:pt x="125600" y="318805"/>
                    <a:pt x="124938" y="314088"/>
                  </a:cubicBezTo>
                  <a:cubicBezTo>
                    <a:pt x="124218" y="308963"/>
                    <a:pt x="128245" y="303587"/>
                    <a:pt x="124208" y="298934"/>
                  </a:cubicBezTo>
                  <a:cubicBezTo>
                    <a:pt x="119715" y="301701"/>
                    <a:pt x="115526" y="302612"/>
                    <a:pt x="110595" y="304405"/>
                  </a:cubicBezTo>
                  <a:cubicBezTo>
                    <a:pt x="102264" y="307423"/>
                    <a:pt x="103330" y="322232"/>
                    <a:pt x="97223" y="327671"/>
                  </a:cubicBezTo>
                  <a:cubicBezTo>
                    <a:pt x="90594" y="333582"/>
                    <a:pt x="83912" y="330092"/>
                    <a:pt x="76321" y="332104"/>
                  </a:cubicBezTo>
                  <a:cubicBezTo>
                    <a:pt x="70305" y="333708"/>
                    <a:pt x="66303" y="338361"/>
                    <a:pt x="58092" y="339965"/>
                  </a:cubicBezTo>
                  <a:cubicBezTo>
                    <a:pt x="31752" y="345121"/>
                    <a:pt x="20654" y="320251"/>
                    <a:pt x="33054" y="310410"/>
                  </a:cubicBezTo>
                  <a:cubicBezTo>
                    <a:pt x="48919" y="297865"/>
                    <a:pt x="72547" y="323835"/>
                    <a:pt x="79965" y="305191"/>
                  </a:cubicBezTo>
                  <a:cubicBezTo>
                    <a:pt x="78769" y="302424"/>
                    <a:pt x="75714" y="300003"/>
                    <a:pt x="72673" y="298934"/>
                  </a:cubicBezTo>
                  <a:cubicBezTo>
                    <a:pt x="72014" y="295664"/>
                    <a:pt x="73273" y="288747"/>
                    <a:pt x="70730" y="286357"/>
                  </a:cubicBezTo>
                  <a:cubicBezTo>
                    <a:pt x="67734" y="283559"/>
                    <a:pt x="59424" y="284125"/>
                    <a:pt x="55415" y="279063"/>
                  </a:cubicBezTo>
                  <a:cubicBezTo>
                    <a:pt x="57965" y="276548"/>
                    <a:pt x="59344" y="272177"/>
                    <a:pt x="59063" y="268844"/>
                  </a:cubicBezTo>
                  <a:cubicBezTo>
                    <a:pt x="52321" y="265354"/>
                    <a:pt x="48579" y="268058"/>
                    <a:pt x="42289" y="269630"/>
                  </a:cubicBezTo>
                  <a:cubicBezTo>
                    <a:pt x="38659" y="270542"/>
                    <a:pt x="34786" y="270008"/>
                    <a:pt x="31107" y="270668"/>
                  </a:cubicBezTo>
                  <a:cubicBezTo>
                    <a:pt x="28627" y="269127"/>
                    <a:pt x="26859" y="266455"/>
                    <a:pt x="26003" y="263877"/>
                  </a:cubicBezTo>
                  <a:cubicBezTo>
                    <a:pt x="11745" y="272774"/>
                    <a:pt x="26561" y="285163"/>
                    <a:pt x="23330" y="295790"/>
                  </a:cubicBezTo>
                  <a:cubicBezTo>
                    <a:pt x="22653" y="298022"/>
                    <a:pt x="21043" y="299971"/>
                    <a:pt x="19847" y="301984"/>
                  </a:cubicBezTo>
                  <a:cubicBezTo>
                    <a:pt x="17578" y="305788"/>
                    <a:pt x="14421" y="308900"/>
                    <a:pt x="9963" y="310693"/>
                  </a:cubicBezTo>
                  <a:lnTo>
                    <a:pt x="4371" y="309655"/>
                  </a:lnTo>
                  <a:lnTo>
                    <a:pt x="723" y="306228"/>
                  </a:lnTo>
                  <a:cubicBezTo>
                    <a:pt x="3081" y="296576"/>
                    <a:pt x="8016" y="287269"/>
                    <a:pt x="8016" y="277239"/>
                  </a:cubicBezTo>
                  <a:cubicBezTo>
                    <a:pt x="8016" y="266360"/>
                    <a:pt x="-1613" y="268373"/>
                    <a:pt x="236" y="255513"/>
                  </a:cubicBezTo>
                  <a:cubicBezTo>
                    <a:pt x="3203" y="254035"/>
                    <a:pt x="5834" y="252118"/>
                    <a:pt x="8745" y="250546"/>
                  </a:cubicBezTo>
                  <a:cubicBezTo>
                    <a:pt x="11681" y="249005"/>
                    <a:pt x="15115" y="248313"/>
                    <a:pt x="17985" y="246647"/>
                  </a:cubicBezTo>
                  <a:cubicBezTo>
                    <a:pt x="34443" y="236994"/>
                    <a:pt x="25730" y="224763"/>
                    <a:pt x="35243" y="216054"/>
                  </a:cubicBezTo>
                  <a:cubicBezTo>
                    <a:pt x="46569" y="222028"/>
                    <a:pt x="38084" y="232750"/>
                    <a:pt x="44478" y="241396"/>
                  </a:cubicBezTo>
                  <a:lnTo>
                    <a:pt x="48610" y="242182"/>
                  </a:lnTo>
                  <a:lnTo>
                    <a:pt x="51771" y="238535"/>
                  </a:lnTo>
                  <a:cubicBezTo>
                    <a:pt x="59312" y="238724"/>
                    <a:pt x="61343" y="247056"/>
                    <a:pt x="67569" y="249508"/>
                  </a:cubicBezTo>
                  <a:lnTo>
                    <a:pt x="70975" y="247684"/>
                  </a:lnTo>
                  <a:cubicBezTo>
                    <a:pt x="68590" y="233158"/>
                    <a:pt x="59025" y="233378"/>
                    <a:pt x="55903" y="224669"/>
                  </a:cubicBezTo>
                  <a:lnTo>
                    <a:pt x="58092" y="222311"/>
                  </a:lnTo>
                  <a:cubicBezTo>
                    <a:pt x="60270" y="222185"/>
                    <a:pt x="68394" y="221651"/>
                    <a:pt x="70004" y="222060"/>
                  </a:cubicBezTo>
                  <a:cubicBezTo>
                    <a:pt x="80018" y="224543"/>
                    <a:pt x="85483" y="230517"/>
                    <a:pt x="95526" y="220487"/>
                  </a:cubicBezTo>
                  <a:lnTo>
                    <a:pt x="94308" y="215771"/>
                  </a:lnTo>
                  <a:lnTo>
                    <a:pt x="89689" y="212910"/>
                  </a:lnTo>
                  <a:cubicBezTo>
                    <a:pt x="84248" y="216809"/>
                    <a:pt x="78762" y="214042"/>
                    <a:pt x="72919" y="212910"/>
                  </a:cubicBezTo>
                  <a:cubicBezTo>
                    <a:pt x="68608" y="212061"/>
                    <a:pt x="64167" y="212187"/>
                    <a:pt x="59796" y="211873"/>
                  </a:cubicBezTo>
                  <a:lnTo>
                    <a:pt x="57120" y="208194"/>
                  </a:lnTo>
                  <a:cubicBezTo>
                    <a:pt x="57453" y="203918"/>
                    <a:pt x="61589" y="191876"/>
                    <a:pt x="63683" y="187820"/>
                  </a:cubicBezTo>
                  <a:cubicBezTo>
                    <a:pt x="66121" y="183072"/>
                    <a:pt x="69895" y="181532"/>
                    <a:pt x="71217" y="175778"/>
                  </a:cubicBezTo>
                  <a:cubicBezTo>
                    <a:pt x="64977" y="162195"/>
                    <a:pt x="54559" y="175621"/>
                    <a:pt x="51041" y="155404"/>
                  </a:cubicBezTo>
                  <a:cubicBezTo>
                    <a:pt x="55447" y="148707"/>
                    <a:pt x="65626" y="147701"/>
                    <a:pt x="69758" y="139966"/>
                  </a:cubicBezTo>
                  <a:cubicBezTo>
                    <a:pt x="71849" y="139589"/>
                    <a:pt x="91183" y="136948"/>
                    <a:pt x="92120" y="137105"/>
                  </a:cubicBezTo>
                  <a:cubicBezTo>
                    <a:pt x="94393" y="147166"/>
                    <a:pt x="85339" y="152826"/>
                    <a:pt x="84340" y="162447"/>
                  </a:cubicBezTo>
                  <a:cubicBezTo>
                    <a:pt x="91306" y="173734"/>
                    <a:pt x="104326" y="161409"/>
                    <a:pt x="114236" y="163484"/>
                  </a:cubicBezTo>
                  <a:cubicBezTo>
                    <a:pt x="117698" y="164207"/>
                    <a:pt x="121700" y="166471"/>
                    <a:pt x="124688" y="168200"/>
                  </a:cubicBezTo>
                  <a:lnTo>
                    <a:pt x="129062" y="165591"/>
                  </a:lnTo>
                  <a:cubicBezTo>
                    <a:pt x="131371" y="161126"/>
                    <a:pt x="135250" y="142261"/>
                    <a:pt x="134896" y="137357"/>
                  </a:cubicBezTo>
                  <a:cubicBezTo>
                    <a:pt x="134559" y="132672"/>
                    <a:pt x="131476" y="128647"/>
                    <a:pt x="130760" y="124026"/>
                  </a:cubicBezTo>
                  <a:cubicBezTo>
                    <a:pt x="129729" y="117360"/>
                    <a:pt x="132240" y="113492"/>
                    <a:pt x="132949" y="107299"/>
                  </a:cubicBezTo>
                  <a:cubicBezTo>
                    <a:pt x="134054" y="97615"/>
                    <a:pt x="125860" y="83623"/>
                    <a:pt x="141375" y="80259"/>
                  </a:cubicBezTo>
                  <a:cubicBezTo>
                    <a:pt x="144328" y="79630"/>
                    <a:pt x="147622" y="79473"/>
                    <a:pt x="150449" y="80605"/>
                  </a:cubicBezTo>
                  <a:cubicBezTo>
                    <a:pt x="146583" y="87837"/>
                    <a:pt x="146882" y="93559"/>
                    <a:pt x="154339" y="98652"/>
                  </a:cubicBezTo>
                  <a:cubicBezTo>
                    <a:pt x="157391" y="111543"/>
                    <a:pt x="151129" y="120598"/>
                    <a:pt x="158955" y="137357"/>
                  </a:cubicBezTo>
                  <a:cubicBezTo>
                    <a:pt x="159972" y="139526"/>
                    <a:pt x="164876" y="148613"/>
                    <a:pt x="164788" y="150153"/>
                  </a:cubicBezTo>
                  <a:cubicBezTo>
                    <a:pt x="163925" y="165056"/>
                    <a:pt x="146997" y="176250"/>
                    <a:pt x="146071" y="180243"/>
                  </a:cubicBezTo>
                  <a:lnTo>
                    <a:pt x="144612" y="186500"/>
                  </a:lnTo>
                  <a:cubicBezTo>
                    <a:pt x="144279" y="188103"/>
                    <a:pt x="152838" y="199265"/>
                    <a:pt x="154093" y="201937"/>
                  </a:cubicBezTo>
                  <a:cubicBezTo>
                    <a:pt x="149281" y="212847"/>
                    <a:pt x="142002" y="212910"/>
                    <a:pt x="130757" y="211590"/>
                  </a:cubicBezTo>
                  <a:cubicBezTo>
                    <a:pt x="127870" y="217658"/>
                    <a:pt x="130950" y="219984"/>
                    <a:pt x="132704" y="225204"/>
                  </a:cubicBezTo>
                  <a:cubicBezTo>
                    <a:pt x="134436" y="230329"/>
                    <a:pt x="134394" y="233221"/>
                    <a:pt x="138049" y="238000"/>
                  </a:cubicBezTo>
                  <a:lnTo>
                    <a:pt x="142185" y="236711"/>
                  </a:lnTo>
                  <a:cubicBezTo>
                    <a:pt x="146433" y="231649"/>
                    <a:pt x="151343" y="227310"/>
                    <a:pt x="155553" y="222060"/>
                  </a:cubicBezTo>
                  <a:cubicBezTo>
                    <a:pt x="159429" y="222783"/>
                    <a:pt x="163655" y="222846"/>
                    <a:pt x="167465" y="221808"/>
                  </a:cubicBezTo>
                  <a:cubicBezTo>
                    <a:pt x="175336" y="225361"/>
                    <a:pt x="182004" y="230832"/>
                    <a:pt x="188125" y="236428"/>
                  </a:cubicBezTo>
                  <a:lnTo>
                    <a:pt x="193716" y="237497"/>
                  </a:lnTo>
                  <a:cubicBezTo>
                    <a:pt x="193972" y="235674"/>
                    <a:pt x="194446" y="233850"/>
                    <a:pt x="194446" y="231995"/>
                  </a:cubicBezTo>
                  <a:cubicBezTo>
                    <a:pt x="194446" y="230454"/>
                    <a:pt x="185869" y="218192"/>
                    <a:pt x="184239" y="216557"/>
                  </a:cubicBezTo>
                  <a:cubicBezTo>
                    <a:pt x="173926" y="206307"/>
                    <a:pt x="159888" y="192976"/>
                    <a:pt x="175245" y="179960"/>
                  </a:cubicBezTo>
                  <a:lnTo>
                    <a:pt x="180590" y="178922"/>
                  </a:lnTo>
                  <a:lnTo>
                    <a:pt x="184968" y="181783"/>
                  </a:lnTo>
                  <a:cubicBezTo>
                    <a:pt x="183824" y="192065"/>
                    <a:pt x="188914" y="197535"/>
                    <a:pt x="200767" y="194863"/>
                  </a:cubicBezTo>
                  <a:cubicBezTo>
                    <a:pt x="200861" y="191090"/>
                    <a:pt x="201808" y="187349"/>
                    <a:pt x="203440" y="183890"/>
                  </a:cubicBezTo>
                  <a:cubicBezTo>
                    <a:pt x="213594" y="178922"/>
                    <a:pt x="226734" y="181280"/>
                    <a:pt x="230666" y="178922"/>
                  </a:cubicBezTo>
                  <a:lnTo>
                    <a:pt x="230424" y="173954"/>
                  </a:lnTo>
                  <a:cubicBezTo>
                    <a:pt x="222844" y="166283"/>
                    <a:pt x="215625" y="171282"/>
                    <a:pt x="209760" y="165340"/>
                  </a:cubicBezTo>
                  <a:lnTo>
                    <a:pt x="209760" y="160340"/>
                  </a:lnTo>
                  <a:lnTo>
                    <a:pt x="213896" y="158014"/>
                  </a:lnTo>
                  <a:cubicBezTo>
                    <a:pt x="230231" y="161032"/>
                    <a:pt x="230792" y="152511"/>
                    <a:pt x="239663" y="143614"/>
                  </a:cubicBezTo>
                  <a:cubicBezTo>
                    <a:pt x="241982" y="141318"/>
                    <a:pt x="244830" y="139369"/>
                    <a:pt x="246465" y="136571"/>
                  </a:cubicBezTo>
                  <a:lnTo>
                    <a:pt x="244764" y="132389"/>
                  </a:lnTo>
                  <a:cubicBezTo>
                    <a:pt x="242175" y="131383"/>
                    <a:pt x="239050" y="129308"/>
                    <a:pt x="237962" y="126887"/>
                  </a:cubicBezTo>
                  <a:cubicBezTo>
                    <a:pt x="245669" y="118366"/>
                    <a:pt x="252614" y="109122"/>
                    <a:pt x="235773" y="104154"/>
                  </a:cubicBezTo>
                  <a:cubicBezTo>
                    <a:pt x="229081" y="106135"/>
                    <a:pt x="222598" y="108839"/>
                    <a:pt x="215601" y="109908"/>
                  </a:cubicBezTo>
                  <a:cubicBezTo>
                    <a:pt x="212907" y="108399"/>
                    <a:pt x="210679" y="105381"/>
                    <a:pt x="210251" y="102582"/>
                  </a:cubicBezTo>
                  <a:cubicBezTo>
                    <a:pt x="203478" y="98275"/>
                    <a:pt x="186592" y="91987"/>
                    <a:pt x="184245" y="85573"/>
                  </a:cubicBezTo>
                  <a:cubicBezTo>
                    <a:pt x="184070" y="85101"/>
                    <a:pt x="184645" y="81863"/>
                    <a:pt x="184733" y="81140"/>
                  </a:cubicBezTo>
                  <a:lnTo>
                    <a:pt x="189349" y="79568"/>
                  </a:lnTo>
                  <a:cubicBezTo>
                    <a:pt x="198434" y="82208"/>
                    <a:pt x="203394" y="86139"/>
                    <a:pt x="211469" y="80102"/>
                  </a:cubicBezTo>
                  <a:cubicBezTo>
                    <a:pt x="211725" y="78184"/>
                    <a:pt x="212198" y="76266"/>
                    <a:pt x="212198" y="74348"/>
                  </a:cubicBezTo>
                  <a:cubicBezTo>
                    <a:pt x="212198" y="70890"/>
                    <a:pt x="202180" y="62054"/>
                    <a:pt x="198585" y="61017"/>
                  </a:cubicBezTo>
                  <a:cubicBezTo>
                    <a:pt x="193085" y="59382"/>
                    <a:pt x="186603" y="61268"/>
                    <a:pt x="181085" y="62054"/>
                  </a:cubicBezTo>
                  <a:lnTo>
                    <a:pt x="175981" y="59980"/>
                  </a:lnTo>
                  <a:cubicBezTo>
                    <a:pt x="199911" y="37373"/>
                    <a:pt x="211683" y="61426"/>
                    <a:pt x="225812" y="58408"/>
                  </a:cubicBezTo>
                  <a:lnTo>
                    <a:pt x="228239" y="54980"/>
                  </a:lnTo>
                  <a:cubicBezTo>
                    <a:pt x="225548" y="51207"/>
                    <a:pt x="221679" y="48221"/>
                    <a:pt x="219249" y="44290"/>
                  </a:cubicBezTo>
                  <a:cubicBezTo>
                    <a:pt x="223823" y="42026"/>
                    <a:pt x="241112" y="43661"/>
                    <a:pt x="248415" y="42970"/>
                  </a:cubicBezTo>
                  <a:cubicBezTo>
                    <a:pt x="253866" y="42467"/>
                    <a:pt x="261106" y="43630"/>
                    <a:pt x="264943" y="47403"/>
                  </a:cubicBezTo>
                  <a:cubicBezTo>
                    <a:pt x="266045" y="48503"/>
                    <a:pt x="266736" y="49855"/>
                    <a:pt x="267620" y="51081"/>
                  </a:cubicBezTo>
                  <a:cubicBezTo>
                    <a:pt x="268988" y="52968"/>
                    <a:pt x="272387" y="57055"/>
                    <a:pt x="271506" y="59445"/>
                  </a:cubicBezTo>
                  <a:cubicBezTo>
                    <a:pt x="270857" y="61205"/>
                    <a:pt x="270092" y="62966"/>
                    <a:pt x="269317" y="64664"/>
                  </a:cubicBezTo>
                  <a:cubicBezTo>
                    <a:pt x="267136" y="69506"/>
                    <a:pt x="246377" y="79096"/>
                    <a:pt x="255465" y="93433"/>
                  </a:cubicBezTo>
                  <a:cubicBezTo>
                    <a:pt x="268262" y="99407"/>
                    <a:pt x="268528" y="90006"/>
                    <a:pt x="276855" y="84786"/>
                  </a:cubicBezTo>
                  <a:cubicBezTo>
                    <a:pt x="286908" y="88686"/>
                    <a:pt x="283955" y="91075"/>
                    <a:pt x="289009" y="98935"/>
                  </a:cubicBezTo>
                  <a:cubicBezTo>
                    <a:pt x="290634" y="101451"/>
                    <a:pt x="293180" y="103494"/>
                    <a:pt x="294359" y="106230"/>
                  </a:cubicBezTo>
                  <a:cubicBezTo>
                    <a:pt x="299361" y="117957"/>
                    <a:pt x="279739" y="123994"/>
                    <a:pt x="276610" y="134747"/>
                  </a:cubicBezTo>
                  <a:cubicBezTo>
                    <a:pt x="274891" y="140658"/>
                    <a:pt x="279528" y="147732"/>
                    <a:pt x="280745" y="153297"/>
                  </a:cubicBezTo>
                  <a:cubicBezTo>
                    <a:pt x="281787" y="158076"/>
                    <a:pt x="281482" y="163579"/>
                    <a:pt x="282201" y="168452"/>
                  </a:cubicBezTo>
                  <a:cubicBezTo>
                    <a:pt x="283096" y="174520"/>
                    <a:pt x="285081" y="180966"/>
                    <a:pt x="286337" y="187034"/>
                  </a:cubicBezTo>
                  <a:lnTo>
                    <a:pt x="289739" y="190146"/>
                  </a:lnTo>
                  <a:lnTo>
                    <a:pt x="295085" y="190430"/>
                  </a:lnTo>
                  <a:cubicBezTo>
                    <a:pt x="301444" y="186625"/>
                    <a:pt x="304019" y="179803"/>
                    <a:pt x="306509" y="173703"/>
                  </a:cubicBezTo>
                  <a:cubicBezTo>
                    <a:pt x="308028" y="169961"/>
                    <a:pt x="310294" y="166220"/>
                    <a:pt x="310641" y="162195"/>
                  </a:cubicBezTo>
                  <a:cubicBezTo>
                    <a:pt x="311869" y="147984"/>
                    <a:pt x="303209" y="128962"/>
                    <a:pt x="322311" y="121133"/>
                  </a:cubicBezTo>
                  <a:cubicBezTo>
                    <a:pt x="322883" y="119844"/>
                    <a:pt x="323616" y="118555"/>
                    <a:pt x="324009" y="117203"/>
                  </a:cubicBezTo>
                  <a:cubicBezTo>
                    <a:pt x="325556" y="111920"/>
                    <a:pt x="313525" y="102300"/>
                    <a:pt x="328387" y="96829"/>
                  </a:cubicBezTo>
                  <a:cubicBezTo>
                    <a:pt x="330323" y="97175"/>
                    <a:pt x="332322" y="97363"/>
                    <a:pt x="334220" y="97866"/>
                  </a:cubicBezTo>
                  <a:cubicBezTo>
                    <a:pt x="338514" y="98998"/>
                    <a:pt x="342926" y="109279"/>
                    <a:pt x="345157" y="112769"/>
                  </a:cubicBezTo>
                  <a:cubicBezTo>
                    <a:pt x="346813" y="115379"/>
                    <a:pt x="349398" y="117266"/>
                    <a:pt x="351478" y="119561"/>
                  </a:cubicBezTo>
                  <a:cubicBezTo>
                    <a:pt x="355217" y="123711"/>
                    <a:pt x="363569" y="141004"/>
                    <a:pt x="367764" y="142324"/>
                  </a:cubicBezTo>
                  <a:cubicBezTo>
                    <a:pt x="369655" y="142890"/>
                    <a:pt x="371658" y="143205"/>
                    <a:pt x="373597" y="143614"/>
                  </a:cubicBezTo>
                  <a:lnTo>
                    <a:pt x="377971" y="141255"/>
                  </a:lnTo>
                  <a:lnTo>
                    <a:pt x="377729" y="136036"/>
                  </a:lnTo>
                  <a:cubicBezTo>
                    <a:pt x="369476" y="126321"/>
                    <a:pt x="368953" y="113430"/>
                    <a:pt x="362660" y="102834"/>
                  </a:cubicBezTo>
                  <a:cubicBezTo>
                    <a:pt x="359142" y="96923"/>
                    <a:pt x="351867" y="89251"/>
                    <a:pt x="345403" y="85856"/>
                  </a:cubicBezTo>
                  <a:cubicBezTo>
                    <a:pt x="342176" y="84126"/>
                    <a:pt x="338429" y="83246"/>
                    <a:pt x="335679" y="80856"/>
                  </a:cubicBezTo>
                  <a:cubicBezTo>
                    <a:pt x="330018" y="75983"/>
                    <a:pt x="328534" y="68469"/>
                    <a:pt x="323041" y="63438"/>
                  </a:cubicBezTo>
                  <a:cubicBezTo>
                    <a:pt x="317759" y="58596"/>
                    <a:pt x="307776" y="57904"/>
                    <a:pt x="304812" y="51050"/>
                  </a:cubicBezTo>
                  <a:lnTo>
                    <a:pt x="306025" y="46114"/>
                  </a:lnTo>
                  <a:cubicBezTo>
                    <a:pt x="318713" y="41712"/>
                    <a:pt x="324613" y="50201"/>
                    <a:pt x="331793" y="57873"/>
                  </a:cubicBezTo>
                  <a:cubicBezTo>
                    <a:pt x="334750" y="61017"/>
                    <a:pt x="338412" y="63564"/>
                    <a:pt x="341460" y="66645"/>
                  </a:cubicBezTo>
                  <a:cubicBezTo>
                    <a:pt x="342877" y="68060"/>
                    <a:pt x="343796" y="69915"/>
                    <a:pt x="345406" y="71204"/>
                  </a:cubicBezTo>
                  <a:cubicBezTo>
                    <a:pt x="345511" y="71267"/>
                    <a:pt x="367241" y="76486"/>
                    <a:pt x="370444" y="77461"/>
                  </a:cubicBezTo>
                  <a:lnTo>
                    <a:pt x="375548" y="75889"/>
                  </a:lnTo>
                  <a:lnTo>
                    <a:pt x="376516" y="71204"/>
                  </a:lnTo>
                  <a:cubicBezTo>
                    <a:pt x="360170" y="46051"/>
                    <a:pt x="343301" y="67305"/>
                    <a:pt x="334711" y="43756"/>
                  </a:cubicBezTo>
                  <a:cubicBezTo>
                    <a:pt x="336718" y="37876"/>
                    <a:pt x="336276" y="37342"/>
                    <a:pt x="335679" y="31462"/>
                  </a:cubicBezTo>
                  <a:cubicBezTo>
                    <a:pt x="335483" y="29513"/>
                    <a:pt x="336409" y="27658"/>
                    <a:pt x="336409" y="25708"/>
                  </a:cubicBezTo>
                  <a:cubicBezTo>
                    <a:pt x="336409" y="14892"/>
                    <a:pt x="326103" y="7787"/>
                    <a:pt x="315265" y="6089"/>
                  </a:cubicBezTo>
                  <a:lnTo>
                    <a:pt x="311859" y="2693"/>
                  </a:lnTo>
                  <a:lnTo>
                    <a:pt x="314777" y="84"/>
                  </a:lnTo>
                  <a:cubicBezTo>
                    <a:pt x="320372" y="-136"/>
                    <a:pt x="328425" y="-74"/>
                    <a:pt x="333494" y="2190"/>
                  </a:cubicBezTo>
                  <a:cubicBezTo>
                    <a:pt x="338268" y="4297"/>
                    <a:pt x="341818" y="8101"/>
                    <a:pt x="345890" y="11057"/>
                  </a:cubicBezTo>
                  <a:cubicBezTo>
                    <a:pt x="352667" y="16024"/>
                    <a:pt x="362418" y="19515"/>
                    <a:pt x="368494" y="24671"/>
                  </a:cubicBezTo>
                  <a:cubicBezTo>
                    <a:pt x="369704" y="25677"/>
                    <a:pt x="370872" y="26903"/>
                    <a:pt x="371896" y="28067"/>
                  </a:cubicBezTo>
                  <a:cubicBezTo>
                    <a:pt x="373874" y="30330"/>
                    <a:pt x="374527" y="35487"/>
                    <a:pt x="375625" y="38348"/>
                  </a:cubicBezTo>
                  <a:cubicBezTo>
                    <a:pt x="378708" y="46397"/>
                    <a:pt x="384383" y="53408"/>
                    <a:pt x="390613" y="59696"/>
                  </a:cubicBezTo>
                  <a:cubicBezTo>
                    <a:pt x="396506" y="65639"/>
                    <a:pt x="408039" y="65891"/>
                    <a:pt x="412006" y="71204"/>
                  </a:cubicBezTo>
                  <a:cubicBezTo>
                    <a:pt x="417244" y="78215"/>
                    <a:pt x="412136" y="87616"/>
                    <a:pt x="417110" y="94471"/>
                  </a:cubicBezTo>
                  <a:cubicBezTo>
                    <a:pt x="432684" y="100916"/>
                    <a:pt x="418429" y="117108"/>
                    <a:pt x="422701" y="127924"/>
                  </a:cubicBezTo>
                  <a:lnTo>
                    <a:pt x="427563" y="128207"/>
                  </a:lnTo>
                  <a:cubicBezTo>
                    <a:pt x="433368" y="122076"/>
                    <a:pt x="434336" y="115819"/>
                    <a:pt x="435827" y="108336"/>
                  </a:cubicBezTo>
                  <a:cubicBezTo>
                    <a:pt x="436774" y="103557"/>
                    <a:pt x="440731" y="98181"/>
                    <a:pt x="443358" y="93936"/>
                  </a:cubicBezTo>
                  <a:lnTo>
                    <a:pt x="449679" y="94471"/>
                  </a:lnTo>
                  <a:cubicBezTo>
                    <a:pt x="455102" y="91578"/>
                    <a:pt x="463647" y="88057"/>
                    <a:pt x="464994" y="81926"/>
                  </a:cubicBezTo>
                  <a:cubicBezTo>
                    <a:pt x="465723" y="78593"/>
                    <a:pt x="463534" y="75543"/>
                    <a:pt x="463534" y="72241"/>
                  </a:cubicBezTo>
                  <a:cubicBezTo>
                    <a:pt x="463534" y="67242"/>
                    <a:pt x="468136" y="61489"/>
                    <a:pt x="470585" y="57087"/>
                  </a:cubicBezTo>
                  <a:lnTo>
                    <a:pt x="474717" y="55766"/>
                  </a:lnTo>
                  <a:cubicBezTo>
                    <a:pt x="476166" y="58565"/>
                    <a:pt x="477035" y="61614"/>
                    <a:pt x="477393" y="64664"/>
                  </a:cubicBezTo>
                  <a:cubicBezTo>
                    <a:pt x="507352" y="80291"/>
                    <a:pt x="487790" y="90541"/>
                    <a:pt x="496110" y="101262"/>
                  </a:cubicBezTo>
                  <a:cubicBezTo>
                    <a:pt x="497647" y="101105"/>
                    <a:pt x="499214" y="101042"/>
                    <a:pt x="500726" y="100759"/>
                  </a:cubicBezTo>
                  <a:cubicBezTo>
                    <a:pt x="508370" y="99281"/>
                    <a:pt x="507921" y="79505"/>
                    <a:pt x="518472" y="75637"/>
                  </a:cubicBezTo>
                  <a:cubicBezTo>
                    <a:pt x="523916" y="73657"/>
                    <a:pt x="536666" y="73499"/>
                    <a:pt x="541805" y="76172"/>
                  </a:cubicBezTo>
                  <a:cubicBezTo>
                    <a:pt x="548796" y="79819"/>
                    <a:pt x="550634" y="90258"/>
                    <a:pt x="553471" y="96294"/>
                  </a:cubicBezTo>
                  <a:cubicBezTo>
                    <a:pt x="556656" y="103086"/>
                    <a:pt x="561030" y="104060"/>
                    <a:pt x="561981" y="112769"/>
                  </a:cubicBezTo>
                  <a:cubicBezTo>
                    <a:pt x="562409" y="116700"/>
                    <a:pt x="545467" y="134181"/>
                    <a:pt x="543752" y="143362"/>
                  </a:cubicBezTo>
                  <a:lnTo>
                    <a:pt x="547396" y="146758"/>
                  </a:lnTo>
                  <a:cubicBezTo>
                    <a:pt x="564289" y="141507"/>
                    <a:pt x="565885" y="122673"/>
                    <a:pt x="571459" y="121416"/>
                  </a:cubicBezTo>
                  <a:cubicBezTo>
                    <a:pt x="573279" y="120976"/>
                    <a:pt x="575195" y="120881"/>
                    <a:pt x="577050" y="120630"/>
                  </a:cubicBezTo>
                  <a:cubicBezTo>
                    <a:pt x="583606" y="124717"/>
                    <a:pt x="581996" y="131225"/>
                    <a:pt x="584343" y="137105"/>
                  </a:cubicBezTo>
                  <a:cubicBezTo>
                    <a:pt x="597128" y="169049"/>
                    <a:pt x="581087" y="170496"/>
                    <a:pt x="583855" y="193825"/>
                  </a:cubicBezTo>
                  <a:cubicBezTo>
                    <a:pt x="585574" y="208351"/>
                    <a:pt x="600443" y="220865"/>
                    <a:pt x="601600" y="230958"/>
                  </a:cubicBezTo>
                  <a:cubicBezTo>
                    <a:pt x="602639" y="240013"/>
                    <a:pt x="595546" y="246804"/>
                    <a:pt x="587015" y="250577"/>
                  </a:cubicBezTo>
                  <a:lnTo>
                    <a:pt x="584830" y="255796"/>
                  </a:lnTo>
                  <a:cubicBezTo>
                    <a:pt x="586346" y="260103"/>
                    <a:pt x="589278" y="264065"/>
                    <a:pt x="593091" y="267021"/>
                  </a:cubicBezTo>
                  <a:lnTo>
                    <a:pt x="599654" y="267555"/>
                  </a:lnTo>
                  <a:lnTo>
                    <a:pt x="602814" y="263625"/>
                  </a:lnTo>
                  <a:cubicBezTo>
                    <a:pt x="601060" y="249099"/>
                    <a:pt x="606290" y="253815"/>
                    <a:pt x="615456" y="246364"/>
                  </a:cubicBezTo>
                  <a:cubicBezTo>
                    <a:pt x="623653" y="239730"/>
                    <a:pt x="624776" y="226367"/>
                    <a:pt x="619830" y="217878"/>
                  </a:cubicBezTo>
                  <a:cubicBezTo>
                    <a:pt x="617550" y="213979"/>
                    <a:pt x="613628" y="210835"/>
                    <a:pt x="612537" y="206370"/>
                  </a:cubicBezTo>
                  <a:lnTo>
                    <a:pt x="613997" y="203509"/>
                  </a:lnTo>
                  <a:cubicBezTo>
                    <a:pt x="620840" y="200396"/>
                    <a:pt x="637281" y="207188"/>
                    <a:pt x="643409" y="210552"/>
                  </a:cubicBezTo>
                  <a:lnTo>
                    <a:pt x="649000" y="210300"/>
                  </a:lnTo>
                  <a:lnTo>
                    <a:pt x="649000" y="205081"/>
                  </a:lnTo>
                  <a:cubicBezTo>
                    <a:pt x="643921" y="200868"/>
                    <a:pt x="639157" y="195963"/>
                    <a:pt x="632959" y="193039"/>
                  </a:cubicBezTo>
                  <a:cubicBezTo>
                    <a:pt x="631233" y="192222"/>
                    <a:pt x="629287" y="191844"/>
                    <a:pt x="627613" y="190964"/>
                  </a:cubicBezTo>
                  <a:cubicBezTo>
                    <a:pt x="625940" y="190052"/>
                    <a:pt x="624709" y="188669"/>
                    <a:pt x="622994" y="187820"/>
                  </a:cubicBezTo>
                  <a:cubicBezTo>
                    <a:pt x="619395" y="186059"/>
                    <a:pt x="615115" y="185808"/>
                    <a:pt x="611569" y="183890"/>
                  </a:cubicBezTo>
                  <a:cubicBezTo>
                    <a:pt x="606413" y="173137"/>
                    <a:pt x="614625" y="169804"/>
                    <a:pt x="619104" y="161158"/>
                  </a:cubicBezTo>
                  <a:cubicBezTo>
                    <a:pt x="630356" y="161787"/>
                    <a:pt x="633980" y="155498"/>
                    <a:pt x="642682" y="152260"/>
                  </a:cubicBezTo>
                  <a:cubicBezTo>
                    <a:pt x="649259" y="149839"/>
                    <a:pt x="669330" y="149241"/>
                    <a:pt x="679387" y="144934"/>
                  </a:cubicBezTo>
                  <a:cubicBezTo>
                    <a:pt x="684126" y="142922"/>
                    <a:pt x="687097" y="138740"/>
                    <a:pt x="691541" y="136319"/>
                  </a:cubicBezTo>
                  <a:cubicBezTo>
                    <a:pt x="695926" y="133929"/>
                    <a:pt x="701096" y="133112"/>
                    <a:pt x="705884" y="131603"/>
                  </a:cubicBezTo>
                  <a:cubicBezTo>
                    <a:pt x="714144" y="129025"/>
                    <a:pt x="721718" y="125975"/>
                    <a:pt x="729217" y="121950"/>
                  </a:cubicBezTo>
                  <a:lnTo>
                    <a:pt x="730431" y="116983"/>
                  </a:lnTo>
                  <a:cubicBezTo>
                    <a:pt x="729610" y="115505"/>
                    <a:pt x="729129" y="113996"/>
                    <a:pt x="728642" y="112581"/>
                  </a:cubicBezTo>
                  <a:lnTo>
                    <a:pt x="736103" y="107236"/>
                  </a:lnTo>
                  <a:cubicBezTo>
                    <a:pt x="740508" y="107581"/>
                    <a:pt x="747597" y="111512"/>
                    <a:pt x="751059" y="113681"/>
                  </a:cubicBezTo>
                  <a:cubicBezTo>
                    <a:pt x="755202" y="113901"/>
                    <a:pt x="757370" y="112204"/>
                    <a:pt x="760947" y="111197"/>
                  </a:cubicBezTo>
                  <a:cubicBezTo>
                    <a:pt x="764266" y="110286"/>
                    <a:pt x="768342" y="110128"/>
                    <a:pt x="771530" y="108965"/>
                  </a:cubicBezTo>
                  <a:lnTo>
                    <a:pt x="775062" y="106670"/>
                  </a:lnTo>
                  <a:cubicBezTo>
                    <a:pt x="780363" y="103211"/>
                    <a:pt x="782011" y="103557"/>
                    <a:pt x="788574" y="103714"/>
                  </a:cubicBezTo>
                  <a:lnTo>
                    <a:pt x="792026" y="103777"/>
                  </a:lnTo>
                  <a:lnTo>
                    <a:pt x="796856" y="99816"/>
                  </a:lnTo>
                  <a:cubicBezTo>
                    <a:pt x="799893" y="99092"/>
                    <a:pt x="804148" y="98841"/>
                    <a:pt x="807224" y="99564"/>
                  </a:cubicBezTo>
                  <a:lnTo>
                    <a:pt x="811121" y="94879"/>
                  </a:lnTo>
                  <a:cubicBezTo>
                    <a:pt x="809483" y="92899"/>
                    <a:pt x="807873" y="88686"/>
                    <a:pt x="808599" y="86202"/>
                  </a:cubicBezTo>
                  <a:cubicBezTo>
                    <a:pt x="811956" y="82523"/>
                    <a:pt x="819354" y="78781"/>
                    <a:pt x="824016" y="76801"/>
                  </a:cubicBezTo>
                  <a:cubicBezTo>
                    <a:pt x="828176" y="76455"/>
                    <a:pt x="835510" y="79284"/>
                    <a:pt x="838986" y="81014"/>
                  </a:cubicBezTo>
                  <a:cubicBezTo>
                    <a:pt x="843831" y="79127"/>
                    <a:pt x="850141" y="78498"/>
                    <a:pt x="855318" y="78027"/>
                  </a:cubicBezTo>
                  <a:lnTo>
                    <a:pt x="859924" y="82743"/>
                  </a:lnTo>
                  <a:cubicBezTo>
                    <a:pt x="862944" y="82900"/>
                    <a:pt x="867269" y="84063"/>
                    <a:pt x="869830" y="85447"/>
                  </a:cubicBezTo>
                  <a:cubicBezTo>
                    <a:pt x="871626" y="86453"/>
                    <a:pt x="873092" y="88151"/>
                    <a:pt x="874877" y="89157"/>
                  </a:cubicBezTo>
                  <a:cubicBezTo>
                    <a:pt x="882696" y="93590"/>
                    <a:pt x="888982" y="89220"/>
                    <a:pt x="900203" y="100319"/>
                  </a:cubicBezTo>
                  <a:lnTo>
                    <a:pt x="899975" y="104280"/>
                  </a:lnTo>
                  <a:lnTo>
                    <a:pt x="902725" y="108745"/>
                  </a:lnTo>
                  <a:lnTo>
                    <a:pt x="901827" y="112958"/>
                  </a:lnTo>
                  <a:cubicBezTo>
                    <a:pt x="904405" y="114341"/>
                    <a:pt x="908425" y="115536"/>
                    <a:pt x="911480" y="115411"/>
                  </a:cubicBezTo>
                  <a:cubicBezTo>
                    <a:pt x="916191" y="119403"/>
                    <a:pt x="922459" y="120630"/>
                    <a:pt x="926893" y="124843"/>
                  </a:cubicBezTo>
                  <a:cubicBezTo>
                    <a:pt x="930099" y="125629"/>
                    <a:pt x="935518" y="123963"/>
                    <a:pt x="937949" y="122108"/>
                  </a:cubicBezTo>
                  <a:lnTo>
                    <a:pt x="939485" y="123522"/>
                  </a:lnTo>
                  <a:cubicBezTo>
                    <a:pt x="945476" y="128962"/>
                    <a:pt x="946915" y="126698"/>
                    <a:pt x="952920" y="129779"/>
                  </a:cubicBezTo>
                  <a:cubicBezTo>
                    <a:pt x="954737" y="130723"/>
                    <a:pt x="959570" y="136350"/>
                    <a:pt x="960738" y="138206"/>
                  </a:cubicBezTo>
                  <a:cubicBezTo>
                    <a:pt x="961562" y="139495"/>
                    <a:pt x="962064" y="141507"/>
                    <a:pt x="963039" y="142639"/>
                  </a:cubicBezTo>
                  <a:cubicBezTo>
                    <a:pt x="964193" y="144022"/>
                    <a:pt x="966494" y="145531"/>
                    <a:pt x="967933" y="146726"/>
                  </a:cubicBezTo>
                  <a:cubicBezTo>
                    <a:pt x="971840" y="150216"/>
                    <a:pt x="977782" y="153014"/>
                    <a:pt x="982602" y="155278"/>
                  </a:cubicBezTo>
                  <a:cubicBezTo>
                    <a:pt x="986997" y="160215"/>
                    <a:pt x="983040" y="164711"/>
                    <a:pt x="986274" y="169144"/>
                  </a:cubicBezTo>
                  <a:lnTo>
                    <a:pt x="983282" y="173357"/>
                  </a:lnTo>
                  <a:lnTo>
                    <a:pt x="986506" y="177822"/>
                  </a:lnTo>
                  <a:cubicBezTo>
                    <a:pt x="990031" y="179928"/>
                    <a:pt x="998723" y="179834"/>
                    <a:pt x="1002627" y="179299"/>
                  </a:cubicBezTo>
                  <a:lnTo>
                    <a:pt x="1007233" y="182758"/>
                  </a:lnTo>
                  <a:cubicBezTo>
                    <a:pt x="1005952" y="188386"/>
                    <a:pt x="1005117" y="194360"/>
                    <a:pt x="1004932" y="200082"/>
                  </a:cubicBezTo>
                  <a:lnTo>
                    <a:pt x="1015062" y="205301"/>
                  </a:lnTo>
                  <a:lnTo>
                    <a:pt x="1019888" y="204547"/>
                  </a:lnTo>
                  <a:cubicBezTo>
                    <a:pt x="1024536" y="207691"/>
                    <a:pt x="1025210" y="210238"/>
                    <a:pt x="1028180" y="212973"/>
                  </a:cubicBezTo>
                  <a:cubicBezTo>
                    <a:pt x="1031927" y="216400"/>
                    <a:pt x="1038777" y="218287"/>
                    <a:pt x="1044049" y="218161"/>
                  </a:cubicBezTo>
                  <a:cubicBezTo>
                    <a:pt x="1049767" y="222531"/>
                    <a:pt x="1057396" y="228191"/>
                    <a:pt x="1060637" y="234511"/>
                  </a:cubicBezTo>
                  <a:lnTo>
                    <a:pt x="1056954" y="243660"/>
                  </a:lnTo>
                  <a:cubicBezTo>
                    <a:pt x="1059301" y="245703"/>
                    <a:pt x="1061763" y="249162"/>
                    <a:pt x="1062465" y="252086"/>
                  </a:cubicBezTo>
                  <a:cubicBezTo>
                    <a:pt x="1066832" y="253281"/>
                    <a:pt x="1072219" y="260575"/>
                    <a:pt x="1073970" y="263971"/>
                  </a:cubicBezTo>
                  <a:cubicBezTo>
                    <a:pt x="1072055" y="269976"/>
                    <a:pt x="1067011" y="277491"/>
                    <a:pt x="1059241" y="278057"/>
                  </a:cubicBezTo>
                  <a:cubicBezTo>
                    <a:pt x="1055839" y="274913"/>
                    <a:pt x="1049146" y="269190"/>
                    <a:pt x="1044526" y="267430"/>
                  </a:cubicBezTo>
                  <a:cubicBezTo>
                    <a:pt x="1038739" y="268373"/>
                    <a:pt x="1034193" y="264977"/>
                    <a:pt x="1028405" y="265197"/>
                  </a:cubicBezTo>
                  <a:cubicBezTo>
                    <a:pt x="1024799" y="266581"/>
                    <a:pt x="1020863" y="269253"/>
                    <a:pt x="1018268" y="271894"/>
                  </a:cubicBezTo>
                  <a:lnTo>
                    <a:pt x="1007454" y="273120"/>
                  </a:lnTo>
                  <a:lnTo>
                    <a:pt x="1005402" y="277585"/>
                  </a:lnTo>
                  <a:cubicBezTo>
                    <a:pt x="1007145" y="280257"/>
                    <a:pt x="1010218" y="287552"/>
                    <a:pt x="1008376" y="290696"/>
                  </a:cubicBezTo>
                  <a:lnTo>
                    <a:pt x="1002623" y="291954"/>
                  </a:lnTo>
                  <a:lnTo>
                    <a:pt x="997569" y="289721"/>
                  </a:lnTo>
                  <a:cubicBezTo>
                    <a:pt x="994749" y="291860"/>
                    <a:pt x="985303" y="299217"/>
                    <a:pt x="983521" y="302078"/>
                  </a:cubicBezTo>
                  <a:cubicBezTo>
                    <a:pt x="982398" y="303901"/>
                    <a:pt x="981711" y="313397"/>
                    <a:pt x="981676" y="315472"/>
                  </a:cubicBezTo>
                  <a:cubicBezTo>
                    <a:pt x="977449" y="317295"/>
                    <a:pt x="969013" y="322389"/>
                    <a:pt x="967175" y="326602"/>
                  </a:cubicBezTo>
                  <a:cubicBezTo>
                    <a:pt x="968701" y="329746"/>
                    <a:pt x="971395" y="333079"/>
                    <a:pt x="974085" y="335500"/>
                  </a:cubicBezTo>
                  <a:cubicBezTo>
                    <a:pt x="975937" y="342983"/>
                    <a:pt x="965340" y="347448"/>
                    <a:pt x="960738" y="351598"/>
                  </a:cubicBezTo>
                  <a:cubicBezTo>
                    <a:pt x="957802" y="354239"/>
                    <a:pt x="955101" y="357855"/>
                    <a:pt x="952460" y="360747"/>
                  </a:cubicBezTo>
                  <a:lnTo>
                    <a:pt x="952460" y="365715"/>
                  </a:lnTo>
                  <a:lnTo>
                    <a:pt x="947160" y="367947"/>
                  </a:lnTo>
                  <a:lnTo>
                    <a:pt x="947855" y="372632"/>
                  </a:lnTo>
                  <a:cubicBezTo>
                    <a:pt x="952895" y="370683"/>
                    <a:pt x="957936" y="374456"/>
                    <a:pt x="962562" y="375368"/>
                  </a:cubicBezTo>
                  <a:cubicBezTo>
                    <a:pt x="966126" y="376091"/>
                    <a:pt x="968511" y="374173"/>
                    <a:pt x="973401" y="376845"/>
                  </a:cubicBezTo>
                  <a:cubicBezTo>
                    <a:pt x="975737" y="380398"/>
                    <a:pt x="974222" y="382662"/>
                    <a:pt x="974997" y="385775"/>
                  </a:cubicBezTo>
                  <a:cubicBezTo>
                    <a:pt x="975741" y="388762"/>
                    <a:pt x="977519" y="391717"/>
                    <a:pt x="978449" y="394673"/>
                  </a:cubicBezTo>
                  <a:cubicBezTo>
                    <a:pt x="978852" y="395962"/>
                    <a:pt x="978645" y="397659"/>
                    <a:pt x="979143" y="398886"/>
                  </a:cubicBezTo>
                  <a:cubicBezTo>
                    <a:pt x="979676" y="400206"/>
                    <a:pt x="981093" y="401873"/>
                    <a:pt x="981893" y="403099"/>
                  </a:cubicBezTo>
                  <a:cubicBezTo>
                    <a:pt x="982304" y="406306"/>
                    <a:pt x="980757" y="409041"/>
                    <a:pt x="980757" y="412028"/>
                  </a:cubicBezTo>
                  <a:cubicBezTo>
                    <a:pt x="980757" y="414827"/>
                    <a:pt x="981535" y="418096"/>
                    <a:pt x="981893" y="420926"/>
                  </a:cubicBezTo>
                  <a:cubicBezTo>
                    <a:pt x="985001" y="421398"/>
                    <a:pt x="988824" y="421618"/>
                    <a:pt x="991813" y="422404"/>
                  </a:cubicBezTo>
                  <a:cubicBezTo>
                    <a:pt x="997334" y="423882"/>
                    <a:pt x="1008653" y="432654"/>
                    <a:pt x="1007920" y="438250"/>
                  </a:cubicBezTo>
                  <a:cubicBezTo>
                    <a:pt x="1010845" y="439696"/>
                    <a:pt x="1015174" y="440577"/>
                    <a:pt x="1018503" y="440482"/>
                  </a:cubicBezTo>
                  <a:lnTo>
                    <a:pt x="1024487" y="449632"/>
                  </a:lnTo>
                  <a:lnTo>
                    <a:pt x="1029545" y="452116"/>
                  </a:lnTo>
                  <a:lnTo>
                    <a:pt x="1030233" y="462020"/>
                  </a:lnTo>
                  <a:lnTo>
                    <a:pt x="1025402" y="464755"/>
                  </a:lnTo>
                  <a:lnTo>
                    <a:pt x="1024252" y="468717"/>
                  </a:lnTo>
                  <a:lnTo>
                    <a:pt x="1031615" y="477866"/>
                  </a:lnTo>
                  <a:cubicBezTo>
                    <a:pt x="1031548" y="478401"/>
                    <a:pt x="1030895" y="484217"/>
                    <a:pt x="1030829" y="484343"/>
                  </a:cubicBezTo>
                  <a:cubicBezTo>
                    <a:pt x="1029426" y="487142"/>
                    <a:pt x="1025894" y="490757"/>
                    <a:pt x="1023884" y="493367"/>
                  </a:cubicBezTo>
                  <a:lnTo>
                    <a:pt x="1029805" y="501416"/>
                  </a:lnTo>
                  <a:cubicBezTo>
                    <a:pt x="1030531" y="506352"/>
                    <a:pt x="1031366" y="511446"/>
                    <a:pt x="1031366" y="516413"/>
                  </a:cubicBezTo>
                  <a:cubicBezTo>
                    <a:pt x="1031366" y="520658"/>
                    <a:pt x="1031474" y="519495"/>
                    <a:pt x="1028370" y="522230"/>
                  </a:cubicBezTo>
                  <a:cubicBezTo>
                    <a:pt x="1024778" y="525406"/>
                    <a:pt x="1026272" y="526884"/>
                    <a:pt x="1027086" y="531034"/>
                  </a:cubicBezTo>
                  <a:cubicBezTo>
                    <a:pt x="1028258" y="537071"/>
                    <a:pt x="1024473" y="540906"/>
                    <a:pt x="1018801" y="543359"/>
                  </a:cubicBezTo>
                  <a:cubicBezTo>
                    <a:pt x="1013613" y="545622"/>
                    <a:pt x="1012996" y="555998"/>
                    <a:pt x="1010653" y="556595"/>
                  </a:cubicBezTo>
                  <a:cubicBezTo>
                    <a:pt x="1005153" y="557979"/>
                    <a:pt x="999761" y="560557"/>
                    <a:pt x="994616" y="562789"/>
                  </a:cubicBezTo>
                  <a:cubicBezTo>
                    <a:pt x="990122" y="562035"/>
                    <a:pt x="985825" y="560903"/>
                    <a:pt x="981574" y="559394"/>
                  </a:cubicBezTo>
                  <a:cubicBezTo>
                    <a:pt x="976677" y="557633"/>
                    <a:pt x="971896" y="563733"/>
                    <a:pt x="968676" y="566279"/>
                  </a:cubicBezTo>
                  <a:cubicBezTo>
                    <a:pt x="965217" y="569015"/>
                    <a:pt x="963176" y="571939"/>
                    <a:pt x="963176" y="576215"/>
                  </a:cubicBezTo>
                  <a:cubicBezTo>
                    <a:pt x="963176" y="587785"/>
                    <a:pt x="960251" y="599638"/>
                    <a:pt x="959181" y="611209"/>
                  </a:cubicBezTo>
                  <a:cubicBezTo>
                    <a:pt x="958728" y="616083"/>
                    <a:pt x="958192" y="628470"/>
                    <a:pt x="956182" y="632338"/>
                  </a:cubicBezTo>
                  <a:cubicBezTo>
                    <a:pt x="951138" y="642022"/>
                    <a:pt x="924939" y="677141"/>
                    <a:pt x="933147" y="686008"/>
                  </a:cubicBezTo>
                  <a:cubicBezTo>
                    <a:pt x="936461" y="689624"/>
                    <a:pt x="944933" y="693837"/>
                    <a:pt x="949791" y="695943"/>
                  </a:cubicBezTo>
                  <a:cubicBezTo>
                    <a:pt x="952881" y="700377"/>
                    <a:pt x="962882" y="702483"/>
                    <a:pt x="968343" y="704275"/>
                  </a:cubicBezTo>
                  <a:cubicBezTo>
                    <a:pt x="965691" y="705784"/>
                    <a:pt x="958286" y="710249"/>
                    <a:pt x="957869" y="712985"/>
                  </a:cubicBezTo>
                  <a:cubicBezTo>
                    <a:pt x="957245" y="717104"/>
                    <a:pt x="966736" y="735245"/>
                    <a:pt x="969515" y="738955"/>
                  </a:cubicBezTo>
                  <a:lnTo>
                    <a:pt x="977884" y="741502"/>
                  </a:lnTo>
                  <a:cubicBezTo>
                    <a:pt x="981223" y="733327"/>
                    <a:pt x="990852" y="745967"/>
                    <a:pt x="992241" y="749520"/>
                  </a:cubicBezTo>
                  <a:lnTo>
                    <a:pt x="1002473" y="775741"/>
                  </a:lnTo>
                  <a:lnTo>
                    <a:pt x="1014308" y="765712"/>
                  </a:lnTo>
                  <a:cubicBezTo>
                    <a:pt x="1013592" y="748105"/>
                    <a:pt x="1022042" y="753701"/>
                    <a:pt x="1029324" y="743891"/>
                  </a:cubicBezTo>
                  <a:lnTo>
                    <a:pt x="1025711" y="737383"/>
                  </a:lnTo>
                  <a:lnTo>
                    <a:pt x="1029798" y="720531"/>
                  </a:lnTo>
                  <a:cubicBezTo>
                    <a:pt x="1030120" y="719179"/>
                    <a:pt x="1026648" y="709023"/>
                    <a:pt x="1026350" y="705973"/>
                  </a:cubicBezTo>
                  <a:cubicBezTo>
                    <a:pt x="1025441" y="696729"/>
                    <a:pt x="1054699" y="694811"/>
                    <a:pt x="1051584" y="707954"/>
                  </a:cubicBezTo>
                  <a:cubicBezTo>
                    <a:pt x="1048806" y="719682"/>
                    <a:pt x="1047536" y="719933"/>
                    <a:pt x="1052976" y="731346"/>
                  </a:cubicBezTo>
                  <a:cubicBezTo>
                    <a:pt x="1059736" y="734113"/>
                    <a:pt x="1067168" y="746407"/>
                    <a:pt x="1070340" y="752569"/>
                  </a:cubicBezTo>
                  <a:cubicBezTo>
                    <a:pt x="1074079" y="754141"/>
                    <a:pt x="1081055" y="756374"/>
                    <a:pt x="1084240" y="758417"/>
                  </a:cubicBezTo>
                  <a:cubicBezTo>
                    <a:pt x="1084574" y="758638"/>
                    <a:pt x="1092610" y="766655"/>
                    <a:pt x="1093420" y="767441"/>
                  </a:cubicBezTo>
                  <a:lnTo>
                    <a:pt x="1104757" y="761970"/>
                  </a:lnTo>
                  <a:cubicBezTo>
                    <a:pt x="1104031" y="760775"/>
                    <a:pt x="1102694" y="758292"/>
                    <a:pt x="1103922" y="757128"/>
                  </a:cubicBezTo>
                  <a:cubicBezTo>
                    <a:pt x="1105574" y="755556"/>
                    <a:pt x="1114438" y="750903"/>
                    <a:pt x="1117188" y="749268"/>
                  </a:cubicBezTo>
                  <a:lnTo>
                    <a:pt x="1120173" y="740433"/>
                  </a:lnTo>
                  <a:cubicBezTo>
                    <a:pt x="1125982" y="736283"/>
                    <a:pt x="1133278" y="732353"/>
                    <a:pt x="1140234" y="72999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62" name="자유형: 도형 303"/>
            <p:cNvSpPr/>
            <p:nvPr/>
          </p:nvSpPr>
          <p:spPr>
            <a:xfrm>
              <a:off x="7346160" y="2671200"/>
              <a:ext cx="330480" cy="346680"/>
            </a:xfrm>
            <a:custGeom>
              <a:avLst/>
              <a:gdLst/>
              <a:ahLst/>
              <a:cxnLst/>
              <a:rect l="l" t="t" r="r" b="b"/>
              <a:pathLst>
                <a:path w="261923" h="282344">
                  <a:moveTo>
                    <a:pt x="98287" y="8019"/>
                  </a:moveTo>
                  <a:cubicBezTo>
                    <a:pt x="100697" y="8490"/>
                    <a:pt x="103050" y="9088"/>
                    <a:pt x="105439" y="9591"/>
                  </a:cubicBezTo>
                  <a:cubicBezTo>
                    <a:pt x="108056" y="10125"/>
                    <a:pt x="113465" y="3774"/>
                    <a:pt x="114026" y="1636"/>
                  </a:cubicBezTo>
                  <a:cubicBezTo>
                    <a:pt x="114692" y="-880"/>
                    <a:pt x="120452" y="-219"/>
                    <a:pt x="121508" y="1761"/>
                  </a:cubicBezTo>
                  <a:cubicBezTo>
                    <a:pt x="122865" y="4308"/>
                    <a:pt x="128320" y="7641"/>
                    <a:pt x="130701" y="9968"/>
                  </a:cubicBezTo>
                  <a:cubicBezTo>
                    <a:pt x="134777" y="13898"/>
                    <a:pt x="134949" y="14590"/>
                    <a:pt x="134255" y="19683"/>
                  </a:cubicBezTo>
                  <a:cubicBezTo>
                    <a:pt x="133536" y="24965"/>
                    <a:pt x="132708" y="30247"/>
                    <a:pt x="131992" y="35530"/>
                  </a:cubicBezTo>
                  <a:cubicBezTo>
                    <a:pt x="130600" y="45874"/>
                    <a:pt x="155195" y="39428"/>
                    <a:pt x="160980" y="39428"/>
                  </a:cubicBezTo>
                  <a:cubicBezTo>
                    <a:pt x="163481" y="39428"/>
                    <a:pt x="166760" y="43044"/>
                    <a:pt x="168167" y="44773"/>
                  </a:cubicBezTo>
                  <a:lnTo>
                    <a:pt x="175842" y="45308"/>
                  </a:lnTo>
                  <a:cubicBezTo>
                    <a:pt x="182450" y="42415"/>
                    <a:pt x="183461" y="41598"/>
                    <a:pt x="184394" y="35153"/>
                  </a:cubicBezTo>
                  <a:cubicBezTo>
                    <a:pt x="184622" y="33549"/>
                    <a:pt x="186389" y="28015"/>
                    <a:pt x="187449" y="26946"/>
                  </a:cubicBezTo>
                  <a:cubicBezTo>
                    <a:pt x="188666" y="25689"/>
                    <a:pt x="189760" y="24368"/>
                    <a:pt x="190749" y="22953"/>
                  </a:cubicBezTo>
                  <a:lnTo>
                    <a:pt x="199301" y="22167"/>
                  </a:lnTo>
                  <a:lnTo>
                    <a:pt x="202370" y="24525"/>
                  </a:lnTo>
                  <a:lnTo>
                    <a:pt x="199080" y="37290"/>
                  </a:lnTo>
                  <a:lnTo>
                    <a:pt x="201055" y="40655"/>
                  </a:lnTo>
                  <a:cubicBezTo>
                    <a:pt x="205822" y="41126"/>
                    <a:pt x="211368" y="41535"/>
                    <a:pt x="216180" y="41063"/>
                  </a:cubicBezTo>
                  <a:cubicBezTo>
                    <a:pt x="216622" y="50401"/>
                    <a:pt x="215556" y="48641"/>
                    <a:pt x="207414" y="53609"/>
                  </a:cubicBezTo>
                  <a:lnTo>
                    <a:pt x="204563" y="61469"/>
                  </a:lnTo>
                  <a:cubicBezTo>
                    <a:pt x="209537" y="66877"/>
                    <a:pt x="214002" y="77190"/>
                    <a:pt x="216401" y="83698"/>
                  </a:cubicBezTo>
                  <a:lnTo>
                    <a:pt x="223417" y="86245"/>
                  </a:lnTo>
                  <a:lnTo>
                    <a:pt x="227801" y="70335"/>
                  </a:lnTo>
                  <a:lnTo>
                    <a:pt x="234378" y="69140"/>
                  </a:lnTo>
                  <a:lnTo>
                    <a:pt x="241176" y="73071"/>
                  </a:lnTo>
                  <a:lnTo>
                    <a:pt x="251481" y="72096"/>
                  </a:lnTo>
                  <a:lnTo>
                    <a:pt x="253018" y="80931"/>
                  </a:lnTo>
                  <a:lnTo>
                    <a:pt x="258279" y="84673"/>
                  </a:lnTo>
                  <a:lnTo>
                    <a:pt x="261924" y="93350"/>
                  </a:lnTo>
                  <a:lnTo>
                    <a:pt x="259072" y="95740"/>
                  </a:lnTo>
                  <a:cubicBezTo>
                    <a:pt x="254540" y="95331"/>
                    <a:pt x="244203" y="96494"/>
                    <a:pt x="240229" y="98098"/>
                  </a:cubicBezTo>
                  <a:cubicBezTo>
                    <a:pt x="240043" y="98192"/>
                    <a:pt x="235830" y="101714"/>
                    <a:pt x="235399" y="102059"/>
                  </a:cubicBezTo>
                  <a:cubicBezTo>
                    <a:pt x="233284" y="106619"/>
                    <a:pt x="235248" y="111398"/>
                    <a:pt x="234476" y="115957"/>
                  </a:cubicBezTo>
                  <a:cubicBezTo>
                    <a:pt x="233680" y="120641"/>
                    <a:pt x="230018" y="125043"/>
                    <a:pt x="230797" y="130042"/>
                  </a:cubicBezTo>
                  <a:lnTo>
                    <a:pt x="224279" y="138657"/>
                  </a:lnTo>
                  <a:lnTo>
                    <a:pt x="219681" y="139160"/>
                  </a:lnTo>
                  <a:lnTo>
                    <a:pt x="219000" y="143122"/>
                  </a:lnTo>
                  <a:lnTo>
                    <a:pt x="214626" y="147586"/>
                  </a:lnTo>
                  <a:cubicBezTo>
                    <a:pt x="215672" y="154315"/>
                    <a:pt x="214875" y="160698"/>
                    <a:pt x="209330" y="165665"/>
                  </a:cubicBezTo>
                  <a:cubicBezTo>
                    <a:pt x="208618" y="169030"/>
                    <a:pt x="208162" y="176010"/>
                    <a:pt x="210024" y="179280"/>
                  </a:cubicBezTo>
                  <a:lnTo>
                    <a:pt x="206558" y="183461"/>
                  </a:lnTo>
                  <a:cubicBezTo>
                    <a:pt x="206474" y="188240"/>
                    <a:pt x="210435" y="191730"/>
                    <a:pt x="210252" y="196604"/>
                  </a:cubicBezTo>
                  <a:cubicBezTo>
                    <a:pt x="207137" y="198710"/>
                    <a:pt x="205099" y="202106"/>
                    <a:pt x="204485" y="205502"/>
                  </a:cubicBezTo>
                  <a:cubicBezTo>
                    <a:pt x="204236" y="206916"/>
                    <a:pt x="204615" y="208614"/>
                    <a:pt x="204264" y="209966"/>
                  </a:cubicBezTo>
                  <a:cubicBezTo>
                    <a:pt x="204089" y="210626"/>
                    <a:pt x="202181" y="214053"/>
                    <a:pt x="202174" y="214399"/>
                  </a:cubicBezTo>
                  <a:cubicBezTo>
                    <a:pt x="202163" y="214683"/>
                    <a:pt x="203710" y="227228"/>
                    <a:pt x="203791" y="227542"/>
                  </a:cubicBezTo>
                  <a:cubicBezTo>
                    <a:pt x="204110" y="228768"/>
                    <a:pt x="207769" y="233516"/>
                    <a:pt x="208649" y="236660"/>
                  </a:cubicBezTo>
                  <a:cubicBezTo>
                    <a:pt x="201697" y="239018"/>
                    <a:pt x="194453" y="242948"/>
                    <a:pt x="188606" y="247035"/>
                  </a:cubicBezTo>
                  <a:lnTo>
                    <a:pt x="185621" y="255871"/>
                  </a:lnTo>
                  <a:cubicBezTo>
                    <a:pt x="182871" y="257537"/>
                    <a:pt x="174004" y="262159"/>
                    <a:pt x="172355" y="263731"/>
                  </a:cubicBezTo>
                  <a:cubicBezTo>
                    <a:pt x="171127" y="264894"/>
                    <a:pt x="172464" y="267378"/>
                    <a:pt x="173190" y="268573"/>
                  </a:cubicBezTo>
                  <a:lnTo>
                    <a:pt x="161853" y="274044"/>
                  </a:lnTo>
                  <a:cubicBezTo>
                    <a:pt x="161043" y="273258"/>
                    <a:pt x="153007" y="265272"/>
                    <a:pt x="152673" y="265052"/>
                  </a:cubicBezTo>
                  <a:cubicBezTo>
                    <a:pt x="149489" y="263008"/>
                    <a:pt x="142515" y="260775"/>
                    <a:pt x="138772" y="259203"/>
                  </a:cubicBezTo>
                  <a:cubicBezTo>
                    <a:pt x="135602" y="253009"/>
                    <a:pt x="128169" y="240747"/>
                    <a:pt x="121410" y="237980"/>
                  </a:cubicBezTo>
                  <a:cubicBezTo>
                    <a:pt x="115966" y="226567"/>
                    <a:pt x="117239" y="226284"/>
                    <a:pt x="120017" y="214557"/>
                  </a:cubicBezTo>
                  <a:cubicBezTo>
                    <a:pt x="123132" y="201414"/>
                    <a:pt x="93874" y="203332"/>
                    <a:pt x="94783" y="212576"/>
                  </a:cubicBezTo>
                  <a:cubicBezTo>
                    <a:pt x="95081" y="215626"/>
                    <a:pt x="98553" y="225781"/>
                    <a:pt x="98231" y="227133"/>
                  </a:cubicBezTo>
                  <a:lnTo>
                    <a:pt x="94144" y="244017"/>
                  </a:lnTo>
                  <a:lnTo>
                    <a:pt x="97757" y="250526"/>
                  </a:lnTo>
                  <a:cubicBezTo>
                    <a:pt x="90475" y="260304"/>
                    <a:pt x="82025" y="254707"/>
                    <a:pt x="82741" y="272314"/>
                  </a:cubicBezTo>
                  <a:lnTo>
                    <a:pt x="70906" y="282344"/>
                  </a:lnTo>
                  <a:lnTo>
                    <a:pt x="60677" y="256122"/>
                  </a:lnTo>
                  <a:cubicBezTo>
                    <a:pt x="59288" y="252569"/>
                    <a:pt x="49656" y="239930"/>
                    <a:pt x="46317" y="248136"/>
                  </a:cubicBezTo>
                  <a:lnTo>
                    <a:pt x="37951" y="245589"/>
                  </a:lnTo>
                  <a:cubicBezTo>
                    <a:pt x="35170" y="241879"/>
                    <a:pt x="25678" y="223706"/>
                    <a:pt x="26306" y="219619"/>
                  </a:cubicBezTo>
                  <a:cubicBezTo>
                    <a:pt x="26723" y="216883"/>
                    <a:pt x="34124" y="212418"/>
                    <a:pt x="36780" y="210878"/>
                  </a:cubicBezTo>
                  <a:cubicBezTo>
                    <a:pt x="31318" y="209086"/>
                    <a:pt x="21318" y="207011"/>
                    <a:pt x="18227" y="202546"/>
                  </a:cubicBezTo>
                  <a:cubicBezTo>
                    <a:pt x="13366" y="200471"/>
                    <a:pt x="4895" y="196226"/>
                    <a:pt x="1580" y="192642"/>
                  </a:cubicBezTo>
                  <a:cubicBezTo>
                    <a:pt x="-6628" y="183744"/>
                    <a:pt x="19571" y="148624"/>
                    <a:pt x="24615" y="138940"/>
                  </a:cubicBezTo>
                  <a:cubicBezTo>
                    <a:pt x="26625" y="135073"/>
                    <a:pt x="27165" y="122717"/>
                    <a:pt x="27614" y="117812"/>
                  </a:cubicBezTo>
                  <a:cubicBezTo>
                    <a:pt x="28687" y="106273"/>
                    <a:pt x="31613" y="94419"/>
                    <a:pt x="31613" y="82817"/>
                  </a:cubicBezTo>
                  <a:cubicBezTo>
                    <a:pt x="31613" y="78573"/>
                    <a:pt x="33654" y="75618"/>
                    <a:pt x="37109" y="72882"/>
                  </a:cubicBezTo>
                  <a:cubicBezTo>
                    <a:pt x="40329" y="70367"/>
                    <a:pt x="45107" y="64267"/>
                    <a:pt x="50007" y="65996"/>
                  </a:cubicBezTo>
                  <a:cubicBezTo>
                    <a:pt x="54262" y="67505"/>
                    <a:pt x="58555" y="68637"/>
                    <a:pt x="63052" y="69423"/>
                  </a:cubicBezTo>
                  <a:cubicBezTo>
                    <a:pt x="68194" y="67160"/>
                    <a:pt x="73589" y="64613"/>
                    <a:pt x="79086" y="63198"/>
                  </a:cubicBezTo>
                  <a:cubicBezTo>
                    <a:pt x="81429" y="62601"/>
                    <a:pt x="82046" y="52225"/>
                    <a:pt x="87234" y="49993"/>
                  </a:cubicBezTo>
                  <a:cubicBezTo>
                    <a:pt x="92906" y="47509"/>
                    <a:pt x="96694" y="43673"/>
                    <a:pt x="95519" y="37668"/>
                  </a:cubicBezTo>
                  <a:cubicBezTo>
                    <a:pt x="94709" y="33518"/>
                    <a:pt x="93211" y="32008"/>
                    <a:pt x="96803" y="28864"/>
                  </a:cubicBezTo>
                  <a:cubicBezTo>
                    <a:pt x="99911" y="26128"/>
                    <a:pt x="99799" y="27261"/>
                    <a:pt x="99799" y="23047"/>
                  </a:cubicBezTo>
                  <a:cubicBezTo>
                    <a:pt x="99795" y="18048"/>
                    <a:pt x="99013" y="12955"/>
                    <a:pt x="98287" y="801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63" name="자유형: 도형 304"/>
            <p:cNvSpPr/>
            <p:nvPr/>
          </p:nvSpPr>
          <p:spPr>
            <a:xfrm>
              <a:off x="7365960" y="1845360"/>
              <a:ext cx="1456920" cy="1362240"/>
            </a:xfrm>
            <a:custGeom>
              <a:avLst/>
              <a:gdLst/>
              <a:ahLst/>
              <a:cxnLst/>
              <a:rect l="l" t="t" r="r" b="b"/>
              <a:pathLst>
                <a:path w="1153670" h="1109030">
                  <a:moveTo>
                    <a:pt x="193105" y="908781"/>
                  </a:moveTo>
                  <a:cubicBezTo>
                    <a:pt x="204638" y="912868"/>
                    <a:pt x="216463" y="899663"/>
                    <a:pt x="227575" y="898940"/>
                  </a:cubicBezTo>
                  <a:lnTo>
                    <a:pt x="229403" y="903153"/>
                  </a:lnTo>
                  <a:lnTo>
                    <a:pt x="234945" y="904882"/>
                  </a:lnTo>
                  <a:cubicBezTo>
                    <a:pt x="237067" y="907397"/>
                    <a:pt x="239094" y="910573"/>
                    <a:pt x="240245" y="913560"/>
                  </a:cubicBezTo>
                  <a:cubicBezTo>
                    <a:pt x="251575" y="919094"/>
                    <a:pt x="254013" y="912019"/>
                    <a:pt x="261428" y="913560"/>
                  </a:cubicBezTo>
                  <a:cubicBezTo>
                    <a:pt x="267380" y="915572"/>
                    <a:pt x="270464" y="921294"/>
                    <a:pt x="275718" y="924438"/>
                  </a:cubicBezTo>
                  <a:lnTo>
                    <a:pt x="278475" y="938052"/>
                  </a:lnTo>
                  <a:cubicBezTo>
                    <a:pt x="276756" y="940914"/>
                    <a:pt x="273266" y="947516"/>
                    <a:pt x="273392" y="950912"/>
                  </a:cubicBezTo>
                  <a:lnTo>
                    <a:pt x="277528" y="955628"/>
                  </a:lnTo>
                  <a:lnTo>
                    <a:pt x="274080" y="960313"/>
                  </a:lnTo>
                  <a:cubicBezTo>
                    <a:pt x="274813" y="963237"/>
                    <a:pt x="277770" y="967073"/>
                    <a:pt x="280296" y="968959"/>
                  </a:cubicBezTo>
                  <a:cubicBezTo>
                    <a:pt x="282709" y="973330"/>
                    <a:pt x="275024" y="985372"/>
                    <a:pt x="273586" y="989962"/>
                  </a:cubicBezTo>
                  <a:cubicBezTo>
                    <a:pt x="273536" y="990119"/>
                    <a:pt x="272652" y="998986"/>
                    <a:pt x="272652" y="999363"/>
                  </a:cubicBezTo>
                  <a:cubicBezTo>
                    <a:pt x="272652" y="1007915"/>
                    <a:pt x="285726" y="1014801"/>
                    <a:pt x="291334" y="1020209"/>
                  </a:cubicBezTo>
                  <a:cubicBezTo>
                    <a:pt x="292751" y="1021592"/>
                    <a:pt x="295031" y="1027723"/>
                    <a:pt x="295266" y="1029641"/>
                  </a:cubicBezTo>
                  <a:cubicBezTo>
                    <a:pt x="295642" y="1032722"/>
                    <a:pt x="294856" y="1035364"/>
                    <a:pt x="295947" y="1038539"/>
                  </a:cubicBezTo>
                  <a:cubicBezTo>
                    <a:pt x="304232" y="1041023"/>
                    <a:pt x="308311" y="1052876"/>
                    <a:pt x="310297" y="1059416"/>
                  </a:cubicBezTo>
                  <a:lnTo>
                    <a:pt x="320010" y="1064667"/>
                  </a:lnTo>
                  <a:cubicBezTo>
                    <a:pt x="320346" y="1069635"/>
                    <a:pt x="324738" y="1070798"/>
                    <a:pt x="326239" y="1073848"/>
                  </a:cubicBezTo>
                  <a:cubicBezTo>
                    <a:pt x="328554" y="1078564"/>
                    <a:pt x="327021" y="1083186"/>
                    <a:pt x="332315" y="1089411"/>
                  </a:cubicBezTo>
                  <a:cubicBezTo>
                    <a:pt x="335209" y="1088657"/>
                    <a:pt x="339007" y="1085261"/>
                    <a:pt x="340614" y="1083123"/>
                  </a:cubicBezTo>
                  <a:lnTo>
                    <a:pt x="340393" y="1074194"/>
                  </a:lnTo>
                  <a:lnTo>
                    <a:pt x="350127" y="1067371"/>
                  </a:lnTo>
                  <a:lnTo>
                    <a:pt x="355209" y="1067402"/>
                  </a:lnTo>
                  <a:lnTo>
                    <a:pt x="359850" y="1071175"/>
                  </a:lnTo>
                  <a:cubicBezTo>
                    <a:pt x="359485" y="1075797"/>
                    <a:pt x="361484" y="1085355"/>
                    <a:pt x="365420" y="1088531"/>
                  </a:cubicBezTo>
                  <a:cubicBezTo>
                    <a:pt x="368521" y="1088971"/>
                    <a:pt x="373207" y="1089191"/>
                    <a:pt x="376090" y="1090103"/>
                  </a:cubicBezTo>
                  <a:cubicBezTo>
                    <a:pt x="376234" y="1090166"/>
                    <a:pt x="380773" y="1093310"/>
                    <a:pt x="381198" y="1093624"/>
                  </a:cubicBezTo>
                  <a:lnTo>
                    <a:pt x="383422" y="1090858"/>
                  </a:lnTo>
                  <a:cubicBezTo>
                    <a:pt x="385488" y="1091392"/>
                    <a:pt x="388013" y="1093687"/>
                    <a:pt x="388848" y="1095416"/>
                  </a:cubicBezTo>
                  <a:lnTo>
                    <a:pt x="393485" y="1093499"/>
                  </a:lnTo>
                  <a:lnTo>
                    <a:pt x="396730" y="1098215"/>
                  </a:lnTo>
                  <a:lnTo>
                    <a:pt x="401612" y="1094316"/>
                  </a:lnTo>
                  <a:lnTo>
                    <a:pt x="407183" y="1096580"/>
                  </a:lnTo>
                  <a:lnTo>
                    <a:pt x="411820" y="1096108"/>
                  </a:lnTo>
                  <a:lnTo>
                    <a:pt x="414114" y="1100290"/>
                  </a:lnTo>
                  <a:lnTo>
                    <a:pt x="410385" y="1106956"/>
                  </a:lnTo>
                  <a:lnTo>
                    <a:pt x="418074" y="1109030"/>
                  </a:lnTo>
                  <a:cubicBezTo>
                    <a:pt x="422248" y="1106107"/>
                    <a:pt x="428099" y="1104754"/>
                    <a:pt x="433125" y="1106672"/>
                  </a:cubicBezTo>
                  <a:cubicBezTo>
                    <a:pt x="437696" y="1105918"/>
                    <a:pt x="445466" y="1100101"/>
                    <a:pt x="448633" y="1097366"/>
                  </a:cubicBezTo>
                  <a:lnTo>
                    <a:pt x="452102" y="1096989"/>
                  </a:lnTo>
                  <a:cubicBezTo>
                    <a:pt x="456560" y="1096454"/>
                    <a:pt x="457949" y="1096454"/>
                    <a:pt x="459170" y="1096045"/>
                  </a:cubicBezTo>
                  <a:cubicBezTo>
                    <a:pt x="460405" y="1095636"/>
                    <a:pt x="461457" y="1094788"/>
                    <a:pt x="465354" y="1092587"/>
                  </a:cubicBezTo>
                  <a:cubicBezTo>
                    <a:pt x="466585" y="1091864"/>
                    <a:pt x="467140" y="1091235"/>
                    <a:pt x="468507" y="1090795"/>
                  </a:cubicBezTo>
                  <a:cubicBezTo>
                    <a:pt x="473453" y="1089191"/>
                    <a:pt x="480335" y="1088562"/>
                    <a:pt x="485565" y="1087588"/>
                  </a:cubicBezTo>
                  <a:cubicBezTo>
                    <a:pt x="488663" y="1089254"/>
                    <a:pt x="492363" y="1090889"/>
                    <a:pt x="495243" y="1092807"/>
                  </a:cubicBezTo>
                  <a:cubicBezTo>
                    <a:pt x="499736" y="1095794"/>
                    <a:pt x="502283" y="1101359"/>
                    <a:pt x="509909" y="1100636"/>
                  </a:cubicBezTo>
                  <a:cubicBezTo>
                    <a:pt x="512231" y="1098624"/>
                    <a:pt x="515546" y="1093876"/>
                    <a:pt x="515514" y="1090826"/>
                  </a:cubicBezTo>
                  <a:cubicBezTo>
                    <a:pt x="518959" y="1088782"/>
                    <a:pt x="522343" y="1089097"/>
                    <a:pt x="525862" y="1087870"/>
                  </a:cubicBezTo>
                  <a:cubicBezTo>
                    <a:pt x="534235" y="1084915"/>
                    <a:pt x="537223" y="1071647"/>
                    <a:pt x="547921" y="1073722"/>
                  </a:cubicBezTo>
                  <a:lnTo>
                    <a:pt x="553446" y="1076426"/>
                  </a:lnTo>
                  <a:cubicBezTo>
                    <a:pt x="554905" y="1075923"/>
                    <a:pt x="557213" y="1075420"/>
                    <a:pt x="558501" y="1074697"/>
                  </a:cubicBezTo>
                  <a:cubicBezTo>
                    <a:pt x="560216" y="1073753"/>
                    <a:pt x="561672" y="1072024"/>
                    <a:pt x="563331" y="1070986"/>
                  </a:cubicBezTo>
                  <a:cubicBezTo>
                    <a:pt x="564836" y="1070012"/>
                    <a:pt x="567305" y="1069320"/>
                    <a:pt x="568620" y="1068251"/>
                  </a:cubicBezTo>
                  <a:cubicBezTo>
                    <a:pt x="571651" y="1065736"/>
                    <a:pt x="571542" y="1062812"/>
                    <a:pt x="576870" y="1061019"/>
                  </a:cubicBezTo>
                  <a:cubicBezTo>
                    <a:pt x="584545" y="1050487"/>
                    <a:pt x="568259" y="1043475"/>
                    <a:pt x="584563" y="1025711"/>
                  </a:cubicBezTo>
                  <a:cubicBezTo>
                    <a:pt x="585061" y="1022881"/>
                    <a:pt x="584735" y="1019297"/>
                    <a:pt x="583847" y="1016530"/>
                  </a:cubicBezTo>
                  <a:lnTo>
                    <a:pt x="585889" y="1011783"/>
                  </a:lnTo>
                  <a:cubicBezTo>
                    <a:pt x="590343" y="1011154"/>
                    <a:pt x="598864" y="1008261"/>
                    <a:pt x="601663" y="1004771"/>
                  </a:cubicBezTo>
                  <a:cubicBezTo>
                    <a:pt x="601775" y="1000998"/>
                    <a:pt x="601252" y="994301"/>
                    <a:pt x="602084" y="990843"/>
                  </a:cubicBezTo>
                  <a:cubicBezTo>
                    <a:pt x="602133" y="990623"/>
                    <a:pt x="606672" y="982793"/>
                    <a:pt x="607072" y="982102"/>
                  </a:cubicBezTo>
                  <a:cubicBezTo>
                    <a:pt x="602014" y="976662"/>
                    <a:pt x="599449" y="966570"/>
                    <a:pt x="596447" y="959998"/>
                  </a:cubicBezTo>
                  <a:cubicBezTo>
                    <a:pt x="595054" y="956949"/>
                    <a:pt x="592623" y="953679"/>
                    <a:pt x="591578" y="950566"/>
                  </a:cubicBezTo>
                  <a:cubicBezTo>
                    <a:pt x="591526" y="950409"/>
                    <a:pt x="591775" y="946510"/>
                    <a:pt x="591796" y="946102"/>
                  </a:cubicBezTo>
                  <a:lnTo>
                    <a:pt x="596131" y="941605"/>
                  </a:lnTo>
                  <a:cubicBezTo>
                    <a:pt x="605732" y="942234"/>
                    <a:pt x="614785" y="927425"/>
                    <a:pt x="627714" y="933745"/>
                  </a:cubicBezTo>
                  <a:cubicBezTo>
                    <a:pt x="631854" y="935757"/>
                    <a:pt x="639195" y="940316"/>
                    <a:pt x="641268" y="944341"/>
                  </a:cubicBezTo>
                  <a:cubicBezTo>
                    <a:pt x="647056" y="944624"/>
                    <a:pt x="652742" y="942769"/>
                    <a:pt x="657046" y="939279"/>
                  </a:cubicBezTo>
                  <a:cubicBezTo>
                    <a:pt x="655513" y="936764"/>
                    <a:pt x="652188" y="929689"/>
                    <a:pt x="653128" y="926639"/>
                  </a:cubicBezTo>
                  <a:cubicBezTo>
                    <a:pt x="649872" y="926734"/>
                    <a:pt x="645053" y="923778"/>
                    <a:pt x="643036" y="921735"/>
                  </a:cubicBezTo>
                  <a:cubicBezTo>
                    <a:pt x="643320" y="917238"/>
                    <a:pt x="641359" y="912176"/>
                    <a:pt x="638413" y="908592"/>
                  </a:cubicBezTo>
                  <a:lnTo>
                    <a:pt x="638637" y="904127"/>
                  </a:lnTo>
                  <a:cubicBezTo>
                    <a:pt x="640556" y="900134"/>
                    <a:pt x="648354" y="894506"/>
                    <a:pt x="652142" y="892148"/>
                  </a:cubicBezTo>
                  <a:lnTo>
                    <a:pt x="648448" y="887212"/>
                  </a:lnTo>
                  <a:lnTo>
                    <a:pt x="638813" y="884256"/>
                  </a:lnTo>
                  <a:lnTo>
                    <a:pt x="635579" y="880043"/>
                  </a:lnTo>
                  <a:cubicBezTo>
                    <a:pt x="634235" y="879823"/>
                    <a:pt x="621144" y="877591"/>
                    <a:pt x="620657" y="877622"/>
                  </a:cubicBezTo>
                  <a:cubicBezTo>
                    <a:pt x="619998" y="877622"/>
                    <a:pt x="611740" y="880358"/>
                    <a:pt x="610316" y="880609"/>
                  </a:cubicBezTo>
                  <a:cubicBezTo>
                    <a:pt x="607475" y="881112"/>
                    <a:pt x="603627" y="880138"/>
                    <a:pt x="599544" y="881144"/>
                  </a:cubicBezTo>
                  <a:cubicBezTo>
                    <a:pt x="594970" y="885200"/>
                    <a:pt x="595033" y="890293"/>
                    <a:pt x="589253" y="893846"/>
                  </a:cubicBezTo>
                  <a:cubicBezTo>
                    <a:pt x="581900" y="895292"/>
                    <a:pt x="574822" y="890859"/>
                    <a:pt x="569245" y="887149"/>
                  </a:cubicBezTo>
                  <a:lnTo>
                    <a:pt x="569448" y="882433"/>
                  </a:lnTo>
                  <a:cubicBezTo>
                    <a:pt x="567168" y="881867"/>
                    <a:pt x="560897" y="879352"/>
                    <a:pt x="559300" y="877968"/>
                  </a:cubicBezTo>
                  <a:cubicBezTo>
                    <a:pt x="558003" y="876836"/>
                    <a:pt x="557354" y="874635"/>
                    <a:pt x="556070" y="873504"/>
                  </a:cubicBezTo>
                  <a:cubicBezTo>
                    <a:pt x="552717" y="870485"/>
                    <a:pt x="545389" y="869070"/>
                    <a:pt x="540882" y="869039"/>
                  </a:cubicBezTo>
                  <a:lnTo>
                    <a:pt x="536265" y="864794"/>
                  </a:lnTo>
                  <a:cubicBezTo>
                    <a:pt x="536069" y="861053"/>
                    <a:pt x="535329" y="854607"/>
                    <a:pt x="533445" y="851117"/>
                  </a:cubicBezTo>
                  <a:lnTo>
                    <a:pt x="527707" y="853129"/>
                  </a:lnTo>
                  <a:cubicBezTo>
                    <a:pt x="527272" y="856085"/>
                    <a:pt x="523220" y="859826"/>
                    <a:pt x="520390" y="861084"/>
                  </a:cubicBezTo>
                  <a:cubicBezTo>
                    <a:pt x="519986" y="864794"/>
                    <a:pt x="518152" y="871302"/>
                    <a:pt x="515377" y="874290"/>
                  </a:cubicBezTo>
                  <a:cubicBezTo>
                    <a:pt x="510659" y="875987"/>
                    <a:pt x="508513" y="873032"/>
                    <a:pt x="505008" y="872780"/>
                  </a:cubicBezTo>
                  <a:cubicBezTo>
                    <a:pt x="500371" y="872466"/>
                    <a:pt x="494756" y="873126"/>
                    <a:pt x="490059" y="873283"/>
                  </a:cubicBezTo>
                  <a:cubicBezTo>
                    <a:pt x="488908" y="870359"/>
                    <a:pt x="487544" y="867341"/>
                    <a:pt x="486572" y="864323"/>
                  </a:cubicBezTo>
                  <a:cubicBezTo>
                    <a:pt x="486088" y="862845"/>
                    <a:pt x="486144" y="861084"/>
                    <a:pt x="485625" y="859606"/>
                  </a:cubicBezTo>
                  <a:cubicBezTo>
                    <a:pt x="485365" y="858883"/>
                    <a:pt x="483650" y="856148"/>
                    <a:pt x="483538" y="855613"/>
                  </a:cubicBezTo>
                  <a:cubicBezTo>
                    <a:pt x="482629" y="851274"/>
                    <a:pt x="484085" y="845615"/>
                    <a:pt x="480493" y="841968"/>
                  </a:cubicBezTo>
                  <a:cubicBezTo>
                    <a:pt x="480504" y="838792"/>
                    <a:pt x="483994" y="834327"/>
                    <a:pt x="486919" y="832755"/>
                  </a:cubicBezTo>
                  <a:cubicBezTo>
                    <a:pt x="486130" y="830334"/>
                    <a:pt x="487049" y="826090"/>
                    <a:pt x="488736" y="824078"/>
                  </a:cubicBezTo>
                  <a:lnTo>
                    <a:pt x="498614" y="820839"/>
                  </a:lnTo>
                  <a:lnTo>
                    <a:pt x="506426" y="811910"/>
                  </a:lnTo>
                  <a:cubicBezTo>
                    <a:pt x="511635" y="811973"/>
                    <a:pt x="518545" y="807508"/>
                    <a:pt x="520926" y="803484"/>
                  </a:cubicBezTo>
                  <a:lnTo>
                    <a:pt x="521074" y="798924"/>
                  </a:lnTo>
                  <a:cubicBezTo>
                    <a:pt x="516689" y="793171"/>
                    <a:pt x="513518" y="787857"/>
                    <a:pt x="514630" y="780846"/>
                  </a:cubicBezTo>
                  <a:cubicBezTo>
                    <a:pt x="512220" y="778928"/>
                    <a:pt x="509674" y="774841"/>
                    <a:pt x="509330" y="771948"/>
                  </a:cubicBezTo>
                  <a:lnTo>
                    <a:pt x="499431" y="768238"/>
                  </a:lnTo>
                  <a:lnTo>
                    <a:pt x="497600" y="759089"/>
                  </a:lnTo>
                  <a:lnTo>
                    <a:pt x="502658" y="758334"/>
                  </a:lnTo>
                  <a:cubicBezTo>
                    <a:pt x="506913" y="754655"/>
                    <a:pt x="514935" y="746826"/>
                    <a:pt x="512799" y="740758"/>
                  </a:cubicBezTo>
                  <a:cubicBezTo>
                    <a:pt x="510863" y="738746"/>
                    <a:pt x="508429" y="735224"/>
                    <a:pt x="507941" y="732583"/>
                  </a:cubicBezTo>
                  <a:cubicBezTo>
                    <a:pt x="507660" y="731043"/>
                    <a:pt x="508137" y="729219"/>
                    <a:pt x="507941" y="727616"/>
                  </a:cubicBezTo>
                  <a:cubicBezTo>
                    <a:pt x="507853" y="726893"/>
                    <a:pt x="506769" y="723623"/>
                    <a:pt x="506790" y="723182"/>
                  </a:cubicBezTo>
                  <a:cubicBezTo>
                    <a:pt x="506980" y="719472"/>
                    <a:pt x="510200" y="716706"/>
                    <a:pt x="511407" y="713530"/>
                  </a:cubicBezTo>
                  <a:cubicBezTo>
                    <a:pt x="513374" y="708311"/>
                    <a:pt x="508811" y="705732"/>
                    <a:pt x="514402" y="695954"/>
                  </a:cubicBezTo>
                  <a:cubicBezTo>
                    <a:pt x="513129" y="690012"/>
                    <a:pt x="506864" y="684698"/>
                    <a:pt x="507488" y="678598"/>
                  </a:cubicBezTo>
                  <a:cubicBezTo>
                    <a:pt x="512476" y="677592"/>
                    <a:pt x="519088" y="676555"/>
                    <a:pt x="523613" y="674637"/>
                  </a:cubicBezTo>
                  <a:cubicBezTo>
                    <a:pt x="527314" y="673096"/>
                    <a:pt x="529801" y="669889"/>
                    <a:pt x="534659" y="668443"/>
                  </a:cubicBezTo>
                  <a:cubicBezTo>
                    <a:pt x="533947" y="661275"/>
                    <a:pt x="528363" y="659608"/>
                    <a:pt x="530509" y="650396"/>
                  </a:cubicBezTo>
                  <a:lnTo>
                    <a:pt x="527058" y="646183"/>
                  </a:lnTo>
                  <a:cubicBezTo>
                    <a:pt x="522999" y="646906"/>
                    <a:pt x="515503" y="644830"/>
                    <a:pt x="511880" y="643447"/>
                  </a:cubicBezTo>
                  <a:cubicBezTo>
                    <a:pt x="501399" y="636059"/>
                    <a:pt x="511827" y="626626"/>
                    <a:pt x="499670" y="616471"/>
                  </a:cubicBezTo>
                  <a:cubicBezTo>
                    <a:pt x="490276" y="608641"/>
                    <a:pt x="479781" y="614050"/>
                    <a:pt x="473660" y="609050"/>
                  </a:cubicBezTo>
                  <a:cubicBezTo>
                    <a:pt x="470900" y="610339"/>
                    <a:pt x="466684" y="611314"/>
                    <a:pt x="463541" y="611031"/>
                  </a:cubicBezTo>
                  <a:lnTo>
                    <a:pt x="460549" y="606567"/>
                  </a:lnTo>
                  <a:cubicBezTo>
                    <a:pt x="457325" y="605403"/>
                    <a:pt x="447535" y="600593"/>
                    <a:pt x="445802" y="597637"/>
                  </a:cubicBezTo>
                  <a:cubicBezTo>
                    <a:pt x="445729" y="597543"/>
                    <a:pt x="443070" y="589211"/>
                    <a:pt x="443045" y="588991"/>
                  </a:cubicBezTo>
                  <a:cubicBezTo>
                    <a:pt x="443024" y="588834"/>
                    <a:pt x="444097" y="584935"/>
                    <a:pt x="444199" y="584526"/>
                  </a:cubicBezTo>
                  <a:cubicBezTo>
                    <a:pt x="448738" y="580847"/>
                    <a:pt x="454649" y="581791"/>
                    <a:pt x="459861" y="580061"/>
                  </a:cubicBezTo>
                  <a:cubicBezTo>
                    <a:pt x="463656" y="578835"/>
                    <a:pt x="465375" y="575691"/>
                    <a:pt x="470896" y="575125"/>
                  </a:cubicBezTo>
                  <a:cubicBezTo>
                    <a:pt x="473071" y="576823"/>
                    <a:pt x="477789" y="578961"/>
                    <a:pt x="480795" y="578835"/>
                  </a:cubicBezTo>
                  <a:cubicBezTo>
                    <a:pt x="483089" y="577106"/>
                    <a:pt x="488151" y="575659"/>
                    <a:pt x="491150" y="576351"/>
                  </a:cubicBezTo>
                  <a:lnTo>
                    <a:pt x="493223" y="572390"/>
                  </a:lnTo>
                  <a:cubicBezTo>
                    <a:pt x="490890" y="570032"/>
                    <a:pt x="485243" y="563020"/>
                    <a:pt x="485625" y="559530"/>
                  </a:cubicBezTo>
                  <a:lnTo>
                    <a:pt x="489069" y="555066"/>
                  </a:lnTo>
                  <a:lnTo>
                    <a:pt x="494373" y="555569"/>
                  </a:lnTo>
                  <a:lnTo>
                    <a:pt x="500129" y="552582"/>
                  </a:lnTo>
                  <a:cubicBezTo>
                    <a:pt x="502273" y="546356"/>
                    <a:pt x="507573" y="541451"/>
                    <a:pt x="509846" y="535257"/>
                  </a:cubicBezTo>
                  <a:lnTo>
                    <a:pt x="512325" y="534503"/>
                  </a:lnTo>
                  <a:cubicBezTo>
                    <a:pt x="513774" y="537207"/>
                    <a:pt x="514869" y="541954"/>
                    <a:pt x="514079" y="544942"/>
                  </a:cubicBezTo>
                  <a:lnTo>
                    <a:pt x="519341" y="549060"/>
                  </a:lnTo>
                  <a:lnTo>
                    <a:pt x="520000" y="551418"/>
                  </a:lnTo>
                  <a:lnTo>
                    <a:pt x="518103" y="557015"/>
                  </a:lnTo>
                  <a:lnTo>
                    <a:pt x="520000" y="560442"/>
                  </a:lnTo>
                  <a:cubicBezTo>
                    <a:pt x="523701" y="561385"/>
                    <a:pt x="528258" y="561479"/>
                    <a:pt x="532060" y="561228"/>
                  </a:cubicBezTo>
                  <a:lnTo>
                    <a:pt x="536665" y="565158"/>
                  </a:lnTo>
                  <a:cubicBezTo>
                    <a:pt x="535883" y="567737"/>
                    <a:pt x="539524" y="573239"/>
                    <a:pt x="541138" y="575094"/>
                  </a:cubicBezTo>
                  <a:lnTo>
                    <a:pt x="540096" y="580722"/>
                  </a:lnTo>
                  <a:lnTo>
                    <a:pt x="544723" y="583205"/>
                  </a:lnTo>
                  <a:lnTo>
                    <a:pt x="546747" y="581288"/>
                  </a:lnTo>
                  <a:lnTo>
                    <a:pt x="547406" y="574402"/>
                  </a:lnTo>
                  <a:cubicBezTo>
                    <a:pt x="548651" y="572201"/>
                    <a:pt x="552590" y="569906"/>
                    <a:pt x="555291" y="569654"/>
                  </a:cubicBezTo>
                  <a:cubicBezTo>
                    <a:pt x="555463" y="566699"/>
                    <a:pt x="555702" y="563743"/>
                    <a:pt x="555470" y="560788"/>
                  </a:cubicBezTo>
                  <a:cubicBezTo>
                    <a:pt x="555326" y="558964"/>
                    <a:pt x="557438" y="556197"/>
                    <a:pt x="557445" y="555977"/>
                  </a:cubicBezTo>
                  <a:cubicBezTo>
                    <a:pt x="557550" y="551953"/>
                    <a:pt x="557006" y="547237"/>
                    <a:pt x="560342" y="543935"/>
                  </a:cubicBezTo>
                  <a:lnTo>
                    <a:pt x="558704" y="539879"/>
                  </a:lnTo>
                  <a:lnTo>
                    <a:pt x="554088" y="536610"/>
                  </a:lnTo>
                  <a:lnTo>
                    <a:pt x="555210" y="527743"/>
                  </a:lnTo>
                  <a:cubicBezTo>
                    <a:pt x="552688" y="525448"/>
                    <a:pt x="546182" y="524221"/>
                    <a:pt x="542804" y="524284"/>
                  </a:cubicBezTo>
                  <a:lnTo>
                    <a:pt x="539296" y="517619"/>
                  </a:lnTo>
                  <a:cubicBezTo>
                    <a:pt x="536157" y="514538"/>
                    <a:pt x="527054" y="512871"/>
                    <a:pt x="522750" y="512745"/>
                  </a:cubicBezTo>
                  <a:cubicBezTo>
                    <a:pt x="520874" y="514380"/>
                    <a:pt x="516051" y="517116"/>
                    <a:pt x="513206" y="516833"/>
                  </a:cubicBezTo>
                  <a:lnTo>
                    <a:pt x="509597" y="514978"/>
                  </a:lnTo>
                  <a:cubicBezTo>
                    <a:pt x="514844" y="509318"/>
                    <a:pt x="516854" y="502496"/>
                    <a:pt x="526142" y="501112"/>
                  </a:cubicBezTo>
                  <a:cubicBezTo>
                    <a:pt x="532098" y="503470"/>
                    <a:pt x="540850" y="504665"/>
                    <a:pt x="547318" y="503816"/>
                  </a:cubicBezTo>
                  <a:lnTo>
                    <a:pt x="552597" y="499854"/>
                  </a:lnTo>
                  <a:cubicBezTo>
                    <a:pt x="552236" y="497088"/>
                    <a:pt x="554558" y="492812"/>
                    <a:pt x="556754" y="490957"/>
                  </a:cubicBezTo>
                  <a:cubicBezTo>
                    <a:pt x="559448" y="492120"/>
                    <a:pt x="564250" y="492466"/>
                    <a:pt x="567119" y="491680"/>
                  </a:cubicBezTo>
                  <a:lnTo>
                    <a:pt x="565954" y="482530"/>
                  </a:lnTo>
                  <a:cubicBezTo>
                    <a:pt x="570059" y="478569"/>
                    <a:pt x="569325" y="472941"/>
                    <a:pt x="573100" y="468665"/>
                  </a:cubicBezTo>
                  <a:lnTo>
                    <a:pt x="578396" y="465961"/>
                  </a:lnTo>
                  <a:cubicBezTo>
                    <a:pt x="581883" y="466590"/>
                    <a:pt x="586766" y="469451"/>
                    <a:pt x="588976" y="471903"/>
                  </a:cubicBezTo>
                  <a:cubicBezTo>
                    <a:pt x="591017" y="474167"/>
                    <a:pt x="591491" y="477122"/>
                    <a:pt x="595416" y="480549"/>
                  </a:cubicBezTo>
                  <a:lnTo>
                    <a:pt x="611537" y="478569"/>
                  </a:lnTo>
                  <a:cubicBezTo>
                    <a:pt x="612947" y="475487"/>
                    <a:pt x="616318" y="472060"/>
                    <a:pt x="619352" y="470174"/>
                  </a:cubicBezTo>
                  <a:lnTo>
                    <a:pt x="624182" y="470394"/>
                  </a:lnTo>
                  <a:cubicBezTo>
                    <a:pt x="628227" y="474261"/>
                    <a:pt x="633288" y="478726"/>
                    <a:pt x="638697" y="481053"/>
                  </a:cubicBezTo>
                  <a:cubicBezTo>
                    <a:pt x="640300" y="481744"/>
                    <a:pt x="642478" y="481996"/>
                    <a:pt x="643983" y="482782"/>
                  </a:cubicBezTo>
                  <a:cubicBezTo>
                    <a:pt x="647652" y="484700"/>
                    <a:pt x="649627" y="487750"/>
                    <a:pt x="654580" y="487970"/>
                  </a:cubicBezTo>
                  <a:cubicBezTo>
                    <a:pt x="658280" y="488158"/>
                    <a:pt x="660890" y="486366"/>
                    <a:pt x="665857" y="487498"/>
                  </a:cubicBezTo>
                  <a:lnTo>
                    <a:pt x="671371" y="484260"/>
                  </a:lnTo>
                  <a:cubicBezTo>
                    <a:pt x="671371" y="477091"/>
                    <a:pt x="658536" y="468633"/>
                    <a:pt x="653187" y="464703"/>
                  </a:cubicBezTo>
                  <a:cubicBezTo>
                    <a:pt x="651717" y="463634"/>
                    <a:pt x="649644" y="463037"/>
                    <a:pt x="648133" y="461999"/>
                  </a:cubicBezTo>
                  <a:cubicBezTo>
                    <a:pt x="644649" y="459610"/>
                    <a:pt x="637410" y="453573"/>
                    <a:pt x="636627" y="449611"/>
                  </a:cubicBezTo>
                  <a:cubicBezTo>
                    <a:pt x="637708" y="440556"/>
                    <a:pt x="647305" y="438387"/>
                    <a:pt x="647224" y="422131"/>
                  </a:cubicBezTo>
                  <a:cubicBezTo>
                    <a:pt x="649308" y="419207"/>
                    <a:pt x="652465" y="416315"/>
                    <a:pt x="655492" y="414208"/>
                  </a:cubicBezTo>
                  <a:cubicBezTo>
                    <a:pt x="656267" y="410844"/>
                    <a:pt x="655457" y="406977"/>
                    <a:pt x="655948" y="404556"/>
                  </a:cubicBezTo>
                  <a:cubicBezTo>
                    <a:pt x="656225" y="403172"/>
                    <a:pt x="657519" y="401475"/>
                    <a:pt x="658021" y="400091"/>
                  </a:cubicBezTo>
                  <a:cubicBezTo>
                    <a:pt x="658252" y="399462"/>
                    <a:pt x="658989" y="395972"/>
                    <a:pt x="659185" y="395658"/>
                  </a:cubicBezTo>
                  <a:cubicBezTo>
                    <a:pt x="659340" y="395406"/>
                    <a:pt x="663110" y="391634"/>
                    <a:pt x="663559" y="391193"/>
                  </a:cubicBezTo>
                  <a:cubicBezTo>
                    <a:pt x="669484" y="392136"/>
                    <a:pt x="675152" y="394809"/>
                    <a:pt x="679414" y="398613"/>
                  </a:cubicBezTo>
                  <a:lnTo>
                    <a:pt x="682652" y="407763"/>
                  </a:lnTo>
                  <a:lnTo>
                    <a:pt x="687938" y="407040"/>
                  </a:lnTo>
                  <a:lnTo>
                    <a:pt x="690467" y="402575"/>
                  </a:lnTo>
                  <a:cubicBezTo>
                    <a:pt x="694185" y="401946"/>
                    <a:pt x="698478" y="400091"/>
                    <a:pt x="701516" y="398110"/>
                  </a:cubicBezTo>
                  <a:lnTo>
                    <a:pt x="704754" y="389432"/>
                  </a:lnTo>
                  <a:cubicBezTo>
                    <a:pt x="709394" y="384307"/>
                    <a:pt x="714901" y="386225"/>
                    <a:pt x="720177" y="382767"/>
                  </a:cubicBezTo>
                  <a:lnTo>
                    <a:pt x="723162" y="377831"/>
                  </a:lnTo>
                  <a:cubicBezTo>
                    <a:pt x="730995" y="375598"/>
                    <a:pt x="743833" y="390218"/>
                    <a:pt x="754012" y="386980"/>
                  </a:cubicBezTo>
                  <a:cubicBezTo>
                    <a:pt x="758109" y="390156"/>
                    <a:pt x="764290" y="389307"/>
                    <a:pt x="769183" y="390187"/>
                  </a:cubicBezTo>
                  <a:cubicBezTo>
                    <a:pt x="774462" y="391162"/>
                    <a:pt x="779843" y="392702"/>
                    <a:pt x="785062" y="393897"/>
                  </a:cubicBezTo>
                  <a:lnTo>
                    <a:pt x="790373" y="390439"/>
                  </a:lnTo>
                  <a:cubicBezTo>
                    <a:pt x="789440" y="387515"/>
                    <a:pt x="787854" y="383993"/>
                    <a:pt x="787363" y="381038"/>
                  </a:cubicBezTo>
                  <a:cubicBezTo>
                    <a:pt x="787268" y="380440"/>
                    <a:pt x="788159" y="377202"/>
                    <a:pt x="788075" y="376573"/>
                  </a:cubicBezTo>
                  <a:cubicBezTo>
                    <a:pt x="787686" y="373680"/>
                    <a:pt x="786335" y="370285"/>
                    <a:pt x="785543" y="367423"/>
                  </a:cubicBezTo>
                  <a:lnTo>
                    <a:pt x="789664" y="362707"/>
                  </a:lnTo>
                  <a:lnTo>
                    <a:pt x="800033" y="364216"/>
                  </a:lnTo>
                  <a:lnTo>
                    <a:pt x="805319" y="361984"/>
                  </a:lnTo>
                  <a:lnTo>
                    <a:pt x="802790" y="352552"/>
                  </a:lnTo>
                  <a:lnTo>
                    <a:pt x="811766" y="343402"/>
                  </a:lnTo>
                  <a:cubicBezTo>
                    <a:pt x="814646" y="344786"/>
                    <a:pt x="817978" y="346798"/>
                    <a:pt x="820995" y="347867"/>
                  </a:cubicBezTo>
                  <a:cubicBezTo>
                    <a:pt x="821851" y="348150"/>
                    <a:pt x="825137" y="348056"/>
                    <a:pt x="826053" y="348370"/>
                  </a:cubicBezTo>
                  <a:cubicBezTo>
                    <a:pt x="829427" y="349439"/>
                    <a:pt x="834054" y="352772"/>
                    <a:pt x="835937" y="355539"/>
                  </a:cubicBezTo>
                  <a:cubicBezTo>
                    <a:pt x="839193" y="355539"/>
                    <a:pt x="843107" y="356325"/>
                    <a:pt x="846078" y="357519"/>
                  </a:cubicBezTo>
                  <a:cubicBezTo>
                    <a:pt x="846120" y="357897"/>
                    <a:pt x="846464" y="361858"/>
                    <a:pt x="846534" y="361984"/>
                  </a:cubicBezTo>
                  <a:cubicBezTo>
                    <a:pt x="846783" y="362393"/>
                    <a:pt x="856945" y="376384"/>
                    <a:pt x="857131" y="376573"/>
                  </a:cubicBezTo>
                  <a:cubicBezTo>
                    <a:pt x="859639" y="379151"/>
                    <a:pt x="867373" y="382453"/>
                    <a:pt x="871386" y="386729"/>
                  </a:cubicBezTo>
                  <a:cubicBezTo>
                    <a:pt x="872049" y="390187"/>
                    <a:pt x="874185" y="392702"/>
                    <a:pt x="875308" y="395878"/>
                  </a:cubicBezTo>
                  <a:cubicBezTo>
                    <a:pt x="876367" y="398896"/>
                    <a:pt x="876146" y="401758"/>
                    <a:pt x="877837" y="404807"/>
                  </a:cubicBezTo>
                  <a:lnTo>
                    <a:pt x="882895" y="408014"/>
                  </a:lnTo>
                  <a:cubicBezTo>
                    <a:pt x="886666" y="404367"/>
                    <a:pt x="891962" y="400342"/>
                    <a:pt x="897855" y="401097"/>
                  </a:cubicBezTo>
                  <a:cubicBezTo>
                    <a:pt x="903082" y="401758"/>
                    <a:pt x="908519" y="403078"/>
                    <a:pt x="913710" y="404053"/>
                  </a:cubicBezTo>
                  <a:cubicBezTo>
                    <a:pt x="918586" y="402701"/>
                    <a:pt x="925601" y="396633"/>
                    <a:pt x="928933" y="393426"/>
                  </a:cubicBezTo>
                  <a:cubicBezTo>
                    <a:pt x="935212" y="392168"/>
                    <a:pt x="944192" y="395061"/>
                    <a:pt x="950576" y="395658"/>
                  </a:cubicBezTo>
                  <a:cubicBezTo>
                    <a:pt x="962221" y="396727"/>
                    <a:pt x="968605" y="384056"/>
                    <a:pt x="969903" y="375598"/>
                  </a:cubicBezTo>
                  <a:cubicBezTo>
                    <a:pt x="972499" y="373177"/>
                    <a:pt x="976252" y="370348"/>
                    <a:pt x="978392" y="367675"/>
                  </a:cubicBezTo>
                  <a:cubicBezTo>
                    <a:pt x="979549" y="366229"/>
                    <a:pt x="981513" y="354973"/>
                    <a:pt x="981408" y="353558"/>
                  </a:cubicBezTo>
                  <a:cubicBezTo>
                    <a:pt x="981198" y="349879"/>
                    <a:pt x="978602" y="342270"/>
                    <a:pt x="974744" y="340196"/>
                  </a:cubicBezTo>
                  <a:lnTo>
                    <a:pt x="963905" y="336957"/>
                  </a:lnTo>
                  <a:lnTo>
                    <a:pt x="960923" y="332995"/>
                  </a:lnTo>
                  <a:lnTo>
                    <a:pt x="965308" y="319884"/>
                  </a:lnTo>
                  <a:lnTo>
                    <a:pt x="970570" y="316897"/>
                  </a:lnTo>
                  <a:cubicBezTo>
                    <a:pt x="973200" y="313376"/>
                    <a:pt x="976919" y="299542"/>
                    <a:pt x="976111" y="295392"/>
                  </a:cubicBezTo>
                  <a:lnTo>
                    <a:pt x="979795" y="291178"/>
                  </a:lnTo>
                  <a:cubicBezTo>
                    <a:pt x="982636" y="290707"/>
                    <a:pt x="988985" y="287468"/>
                    <a:pt x="990388" y="285204"/>
                  </a:cubicBezTo>
                  <a:cubicBezTo>
                    <a:pt x="993019" y="280991"/>
                    <a:pt x="993931" y="275552"/>
                    <a:pt x="996597" y="271370"/>
                  </a:cubicBezTo>
                  <a:lnTo>
                    <a:pt x="1001648" y="267409"/>
                  </a:lnTo>
                  <a:cubicBezTo>
                    <a:pt x="1002279" y="267063"/>
                    <a:pt x="1005646" y="266528"/>
                    <a:pt x="1006488" y="266151"/>
                  </a:cubicBezTo>
                  <a:cubicBezTo>
                    <a:pt x="1009715" y="264736"/>
                    <a:pt x="1013960" y="261623"/>
                    <a:pt x="1015713" y="258731"/>
                  </a:cubicBezTo>
                  <a:cubicBezTo>
                    <a:pt x="1018730" y="257284"/>
                    <a:pt x="1024167" y="256813"/>
                    <a:pt x="1025395" y="256247"/>
                  </a:cubicBezTo>
                  <a:cubicBezTo>
                    <a:pt x="1034234" y="252128"/>
                    <a:pt x="1033077" y="244645"/>
                    <a:pt x="1038969" y="238923"/>
                  </a:cubicBezTo>
                  <a:cubicBezTo>
                    <a:pt x="1047002" y="235622"/>
                    <a:pt x="1056402" y="236345"/>
                    <a:pt x="1064260" y="232006"/>
                  </a:cubicBezTo>
                  <a:cubicBezTo>
                    <a:pt x="1068714" y="229522"/>
                    <a:pt x="1069381" y="224743"/>
                    <a:pt x="1070468" y="223579"/>
                  </a:cubicBezTo>
                  <a:cubicBezTo>
                    <a:pt x="1074397" y="219240"/>
                    <a:pt x="1080465" y="216380"/>
                    <a:pt x="1082921" y="210940"/>
                  </a:cubicBezTo>
                  <a:cubicBezTo>
                    <a:pt x="1082710" y="210217"/>
                    <a:pt x="1080395" y="202514"/>
                    <a:pt x="1080395" y="202293"/>
                  </a:cubicBezTo>
                  <a:lnTo>
                    <a:pt x="1081518" y="198332"/>
                  </a:lnTo>
                  <a:cubicBezTo>
                    <a:pt x="1081693" y="198112"/>
                    <a:pt x="1090287" y="190063"/>
                    <a:pt x="1090498" y="189906"/>
                  </a:cubicBezTo>
                  <a:lnTo>
                    <a:pt x="1095794" y="188176"/>
                  </a:lnTo>
                  <a:cubicBezTo>
                    <a:pt x="1099267" y="187799"/>
                    <a:pt x="1103511" y="188176"/>
                    <a:pt x="1107054" y="188176"/>
                  </a:cubicBezTo>
                  <a:cubicBezTo>
                    <a:pt x="1110526" y="186290"/>
                    <a:pt x="1114034" y="183335"/>
                    <a:pt x="1116489" y="180505"/>
                  </a:cubicBezTo>
                  <a:cubicBezTo>
                    <a:pt x="1121646" y="180568"/>
                    <a:pt x="1127714" y="185567"/>
                    <a:pt x="1130766" y="188899"/>
                  </a:cubicBezTo>
                  <a:lnTo>
                    <a:pt x="1136553" y="186196"/>
                  </a:lnTo>
                  <a:cubicBezTo>
                    <a:pt x="1139009" y="177926"/>
                    <a:pt x="1143393" y="170915"/>
                    <a:pt x="1153671" y="170318"/>
                  </a:cubicBezTo>
                  <a:cubicBezTo>
                    <a:pt x="1150794" y="168934"/>
                    <a:pt x="1147813" y="167362"/>
                    <a:pt x="1144832" y="166136"/>
                  </a:cubicBezTo>
                  <a:cubicBezTo>
                    <a:pt x="1141639" y="164816"/>
                    <a:pt x="1137465" y="163998"/>
                    <a:pt x="1134484" y="162426"/>
                  </a:cubicBezTo>
                  <a:cubicBezTo>
                    <a:pt x="1132169" y="161200"/>
                    <a:pt x="1128135" y="156138"/>
                    <a:pt x="1127328" y="153748"/>
                  </a:cubicBezTo>
                  <a:lnTo>
                    <a:pt x="1121576" y="152271"/>
                  </a:lnTo>
                  <a:cubicBezTo>
                    <a:pt x="1118839" y="154188"/>
                    <a:pt x="1114876" y="156075"/>
                    <a:pt x="1111438" y="156735"/>
                  </a:cubicBezTo>
                  <a:lnTo>
                    <a:pt x="1106598" y="155006"/>
                  </a:lnTo>
                  <a:cubicBezTo>
                    <a:pt x="1090532" y="161451"/>
                    <a:pt x="1085201" y="149189"/>
                    <a:pt x="1075765" y="147586"/>
                  </a:cubicBezTo>
                  <a:cubicBezTo>
                    <a:pt x="1072889" y="148969"/>
                    <a:pt x="1068469" y="149850"/>
                    <a:pt x="1065172" y="149535"/>
                  </a:cubicBezTo>
                  <a:cubicBezTo>
                    <a:pt x="1059595" y="147271"/>
                    <a:pt x="1054193" y="143624"/>
                    <a:pt x="1050931" y="138908"/>
                  </a:cubicBezTo>
                  <a:lnTo>
                    <a:pt x="1045879" y="137430"/>
                  </a:lnTo>
                  <a:lnTo>
                    <a:pt x="1040548" y="138908"/>
                  </a:lnTo>
                  <a:cubicBezTo>
                    <a:pt x="1036900" y="135449"/>
                    <a:pt x="1037636" y="132808"/>
                    <a:pt x="1035742" y="129758"/>
                  </a:cubicBezTo>
                  <a:cubicBezTo>
                    <a:pt x="1031989" y="123816"/>
                    <a:pt x="1024272" y="119697"/>
                    <a:pt x="1017081" y="118345"/>
                  </a:cubicBezTo>
                  <a:cubicBezTo>
                    <a:pt x="1011750" y="120892"/>
                    <a:pt x="1011575" y="123376"/>
                    <a:pt x="1008312" y="126017"/>
                  </a:cubicBezTo>
                  <a:cubicBezTo>
                    <a:pt x="1001998" y="131142"/>
                    <a:pt x="990493" y="129287"/>
                    <a:pt x="983022" y="128249"/>
                  </a:cubicBezTo>
                  <a:lnTo>
                    <a:pt x="977480" y="131236"/>
                  </a:lnTo>
                  <a:lnTo>
                    <a:pt x="972429" y="129727"/>
                  </a:lnTo>
                  <a:lnTo>
                    <a:pt x="967167" y="131708"/>
                  </a:lnTo>
                  <a:lnTo>
                    <a:pt x="960713" y="129004"/>
                  </a:lnTo>
                  <a:lnTo>
                    <a:pt x="960713" y="124539"/>
                  </a:lnTo>
                  <a:cubicBezTo>
                    <a:pt x="958608" y="120232"/>
                    <a:pt x="945735" y="113409"/>
                    <a:pt x="941350" y="111428"/>
                  </a:cubicBezTo>
                  <a:lnTo>
                    <a:pt x="945069" y="102499"/>
                  </a:lnTo>
                  <a:cubicBezTo>
                    <a:pt x="943104" y="95645"/>
                    <a:pt x="934861" y="90583"/>
                    <a:pt x="927565" y="88885"/>
                  </a:cubicBezTo>
                  <a:cubicBezTo>
                    <a:pt x="922935" y="90771"/>
                    <a:pt x="916516" y="91400"/>
                    <a:pt x="911886" y="89136"/>
                  </a:cubicBezTo>
                  <a:lnTo>
                    <a:pt x="906589" y="91872"/>
                  </a:lnTo>
                  <a:cubicBezTo>
                    <a:pt x="904450" y="89734"/>
                    <a:pt x="899118" y="87344"/>
                    <a:pt x="895786" y="87910"/>
                  </a:cubicBezTo>
                  <a:cubicBezTo>
                    <a:pt x="892383" y="89482"/>
                    <a:pt x="888735" y="91557"/>
                    <a:pt x="885193" y="92846"/>
                  </a:cubicBezTo>
                  <a:cubicBezTo>
                    <a:pt x="884456" y="93129"/>
                    <a:pt x="880994" y="93318"/>
                    <a:pt x="880366" y="93601"/>
                  </a:cubicBezTo>
                  <a:cubicBezTo>
                    <a:pt x="876360" y="95236"/>
                    <a:pt x="875013" y="98254"/>
                    <a:pt x="869317" y="98066"/>
                  </a:cubicBezTo>
                  <a:cubicBezTo>
                    <a:pt x="866318" y="99795"/>
                    <a:pt x="862589" y="103442"/>
                    <a:pt x="861249" y="106460"/>
                  </a:cubicBezTo>
                  <a:lnTo>
                    <a:pt x="855966" y="106712"/>
                  </a:lnTo>
                  <a:lnTo>
                    <a:pt x="851817" y="101996"/>
                  </a:lnTo>
                  <a:lnTo>
                    <a:pt x="841020" y="99795"/>
                  </a:lnTo>
                  <a:cubicBezTo>
                    <a:pt x="837923" y="96022"/>
                    <a:pt x="834222" y="91400"/>
                    <a:pt x="832497" y="86904"/>
                  </a:cubicBezTo>
                  <a:cubicBezTo>
                    <a:pt x="834096" y="82879"/>
                    <a:pt x="837769" y="76717"/>
                    <a:pt x="841701" y="74045"/>
                  </a:cubicBezTo>
                  <a:lnTo>
                    <a:pt x="852045" y="74296"/>
                  </a:lnTo>
                  <a:lnTo>
                    <a:pt x="857580" y="70806"/>
                  </a:lnTo>
                  <a:cubicBezTo>
                    <a:pt x="857047" y="67788"/>
                    <a:pt x="859653" y="63040"/>
                    <a:pt x="862186" y="61154"/>
                  </a:cubicBezTo>
                  <a:lnTo>
                    <a:pt x="867016" y="60430"/>
                  </a:lnTo>
                  <a:cubicBezTo>
                    <a:pt x="869920" y="57915"/>
                    <a:pt x="873228" y="54362"/>
                    <a:pt x="876444" y="52255"/>
                  </a:cubicBezTo>
                  <a:cubicBezTo>
                    <a:pt x="876557" y="52161"/>
                    <a:pt x="881281" y="50904"/>
                    <a:pt x="881730" y="50778"/>
                  </a:cubicBezTo>
                  <a:lnTo>
                    <a:pt x="885193" y="46313"/>
                  </a:lnTo>
                  <a:cubicBezTo>
                    <a:pt x="884561" y="43704"/>
                    <a:pt x="885157" y="39491"/>
                    <a:pt x="886560" y="37132"/>
                  </a:cubicBezTo>
                  <a:cubicBezTo>
                    <a:pt x="882348" y="35372"/>
                    <a:pt x="879187" y="32101"/>
                    <a:pt x="876216" y="30718"/>
                  </a:cubicBezTo>
                  <a:cubicBezTo>
                    <a:pt x="870990" y="28266"/>
                    <a:pt x="864104" y="31378"/>
                    <a:pt x="860797" y="35152"/>
                  </a:cubicBezTo>
                  <a:cubicBezTo>
                    <a:pt x="858611" y="34837"/>
                    <a:pt x="852911" y="34900"/>
                    <a:pt x="850912" y="35654"/>
                  </a:cubicBezTo>
                  <a:cubicBezTo>
                    <a:pt x="849267" y="36283"/>
                    <a:pt x="847727" y="38075"/>
                    <a:pt x="846078" y="38642"/>
                  </a:cubicBezTo>
                  <a:cubicBezTo>
                    <a:pt x="842953" y="39679"/>
                    <a:pt x="838779" y="40151"/>
                    <a:pt x="835482" y="40842"/>
                  </a:cubicBezTo>
                  <a:cubicBezTo>
                    <a:pt x="830630" y="39396"/>
                    <a:pt x="821556" y="28140"/>
                    <a:pt x="818918" y="24524"/>
                  </a:cubicBezTo>
                  <a:lnTo>
                    <a:pt x="803239" y="24776"/>
                  </a:lnTo>
                  <a:cubicBezTo>
                    <a:pt x="797806" y="22166"/>
                    <a:pt x="797791" y="17890"/>
                    <a:pt x="795880" y="16350"/>
                  </a:cubicBezTo>
                  <a:cubicBezTo>
                    <a:pt x="791625" y="12954"/>
                    <a:pt x="785430" y="9873"/>
                    <a:pt x="780685" y="6948"/>
                  </a:cubicBezTo>
                  <a:cubicBezTo>
                    <a:pt x="780151" y="7043"/>
                    <a:pt x="775128" y="7829"/>
                    <a:pt x="774942" y="7923"/>
                  </a:cubicBezTo>
                  <a:cubicBezTo>
                    <a:pt x="769755" y="10439"/>
                    <a:pt x="758754" y="16915"/>
                    <a:pt x="754917" y="21317"/>
                  </a:cubicBezTo>
                  <a:cubicBezTo>
                    <a:pt x="754693" y="27385"/>
                    <a:pt x="750697" y="34837"/>
                    <a:pt x="743412" y="36158"/>
                  </a:cubicBezTo>
                  <a:cubicBezTo>
                    <a:pt x="737368" y="36001"/>
                    <a:pt x="726361" y="27417"/>
                    <a:pt x="723411" y="22795"/>
                  </a:cubicBezTo>
                  <a:lnTo>
                    <a:pt x="712334" y="22544"/>
                  </a:lnTo>
                  <a:cubicBezTo>
                    <a:pt x="711983" y="25059"/>
                    <a:pt x="712499" y="28329"/>
                    <a:pt x="713474" y="30718"/>
                  </a:cubicBezTo>
                  <a:cubicBezTo>
                    <a:pt x="712804" y="34585"/>
                    <a:pt x="700864" y="44018"/>
                    <a:pt x="696683" y="45810"/>
                  </a:cubicBezTo>
                  <a:cubicBezTo>
                    <a:pt x="693512" y="47162"/>
                    <a:pt x="689793" y="47760"/>
                    <a:pt x="686566" y="49017"/>
                  </a:cubicBezTo>
                  <a:cubicBezTo>
                    <a:pt x="683031" y="50432"/>
                    <a:pt x="679568" y="52822"/>
                    <a:pt x="675973" y="53985"/>
                  </a:cubicBezTo>
                  <a:cubicBezTo>
                    <a:pt x="672739" y="55054"/>
                    <a:pt x="668719" y="55085"/>
                    <a:pt x="665376" y="55966"/>
                  </a:cubicBezTo>
                  <a:cubicBezTo>
                    <a:pt x="663430" y="56469"/>
                    <a:pt x="661578" y="57632"/>
                    <a:pt x="659638" y="58198"/>
                  </a:cubicBezTo>
                  <a:cubicBezTo>
                    <a:pt x="655818" y="59267"/>
                    <a:pt x="647340" y="61688"/>
                    <a:pt x="643527" y="59676"/>
                  </a:cubicBezTo>
                  <a:cubicBezTo>
                    <a:pt x="640170" y="57003"/>
                    <a:pt x="635757" y="51061"/>
                    <a:pt x="636399" y="46785"/>
                  </a:cubicBezTo>
                  <a:cubicBezTo>
                    <a:pt x="636785" y="44207"/>
                    <a:pt x="638651" y="41440"/>
                    <a:pt x="638928" y="38861"/>
                  </a:cubicBezTo>
                  <a:lnTo>
                    <a:pt x="638150" y="35749"/>
                  </a:lnTo>
                  <a:cubicBezTo>
                    <a:pt x="636315" y="28297"/>
                    <a:pt x="631583" y="27228"/>
                    <a:pt x="626739" y="21789"/>
                  </a:cubicBezTo>
                  <a:cubicBezTo>
                    <a:pt x="623256" y="17890"/>
                    <a:pt x="624740" y="13111"/>
                    <a:pt x="623046" y="8678"/>
                  </a:cubicBezTo>
                  <a:lnTo>
                    <a:pt x="612224" y="3458"/>
                  </a:lnTo>
                  <a:cubicBezTo>
                    <a:pt x="608717" y="4685"/>
                    <a:pt x="599986" y="1446"/>
                    <a:pt x="597033" y="0"/>
                  </a:cubicBezTo>
                  <a:cubicBezTo>
                    <a:pt x="591333" y="1037"/>
                    <a:pt x="586541" y="3993"/>
                    <a:pt x="581160" y="5691"/>
                  </a:cubicBezTo>
                  <a:cubicBezTo>
                    <a:pt x="576285" y="7232"/>
                    <a:pt x="569648" y="7452"/>
                    <a:pt x="565270" y="10155"/>
                  </a:cubicBezTo>
                  <a:cubicBezTo>
                    <a:pt x="563496" y="11256"/>
                    <a:pt x="562205" y="13488"/>
                    <a:pt x="560441" y="14620"/>
                  </a:cubicBezTo>
                  <a:cubicBezTo>
                    <a:pt x="559016" y="15501"/>
                    <a:pt x="556554" y="15689"/>
                    <a:pt x="555140" y="16601"/>
                  </a:cubicBezTo>
                  <a:cubicBezTo>
                    <a:pt x="552468" y="18330"/>
                    <a:pt x="550033" y="22198"/>
                    <a:pt x="549160" y="25027"/>
                  </a:cubicBezTo>
                  <a:cubicBezTo>
                    <a:pt x="547245" y="31190"/>
                    <a:pt x="551650" y="36944"/>
                    <a:pt x="553309" y="42823"/>
                  </a:cubicBezTo>
                  <a:cubicBezTo>
                    <a:pt x="554256" y="46219"/>
                    <a:pt x="552471" y="48891"/>
                    <a:pt x="552383" y="52004"/>
                  </a:cubicBezTo>
                  <a:cubicBezTo>
                    <a:pt x="552296" y="55274"/>
                    <a:pt x="555028" y="57978"/>
                    <a:pt x="555842" y="60902"/>
                  </a:cubicBezTo>
                  <a:lnTo>
                    <a:pt x="555842" y="65115"/>
                  </a:lnTo>
                  <a:cubicBezTo>
                    <a:pt x="555277" y="66876"/>
                    <a:pt x="550030" y="77314"/>
                    <a:pt x="548469" y="78729"/>
                  </a:cubicBezTo>
                  <a:cubicBezTo>
                    <a:pt x="548314" y="78855"/>
                    <a:pt x="543674" y="81213"/>
                    <a:pt x="543179" y="81465"/>
                  </a:cubicBezTo>
                  <a:lnTo>
                    <a:pt x="538121" y="79956"/>
                  </a:lnTo>
                  <a:lnTo>
                    <a:pt x="532814" y="82439"/>
                  </a:lnTo>
                  <a:lnTo>
                    <a:pt x="528219" y="90866"/>
                  </a:lnTo>
                  <a:lnTo>
                    <a:pt x="523389" y="91369"/>
                  </a:lnTo>
                  <a:cubicBezTo>
                    <a:pt x="518061" y="85804"/>
                    <a:pt x="510838" y="82911"/>
                    <a:pt x="502669" y="83697"/>
                  </a:cubicBezTo>
                  <a:cubicBezTo>
                    <a:pt x="500526" y="86118"/>
                    <a:pt x="496358" y="89168"/>
                    <a:pt x="492995" y="90111"/>
                  </a:cubicBezTo>
                  <a:lnTo>
                    <a:pt x="487947" y="87658"/>
                  </a:lnTo>
                  <a:lnTo>
                    <a:pt x="483338" y="92092"/>
                  </a:lnTo>
                  <a:cubicBezTo>
                    <a:pt x="477659" y="94764"/>
                    <a:pt x="472783" y="91809"/>
                    <a:pt x="467231" y="93350"/>
                  </a:cubicBezTo>
                  <a:cubicBezTo>
                    <a:pt x="459296" y="95487"/>
                    <a:pt x="456013" y="98097"/>
                    <a:pt x="446507" y="98789"/>
                  </a:cubicBezTo>
                  <a:cubicBezTo>
                    <a:pt x="442109" y="99103"/>
                    <a:pt x="437079" y="97688"/>
                    <a:pt x="432894" y="99543"/>
                  </a:cubicBezTo>
                  <a:cubicBezTo>
                    <a:pt x="428492" y="96777"/>
                    <a:pt x="423827" y="94073"/>
                    <a:pt x="419579" y="91117"/>
                  </a:cubicBezTo>
                  <a:cubicBezTo>
                    <a:pt x="414472" y="87564"/>
                    <a:pt x="405923" y="73353"/>
                    <a:pt x="404166" y="68322"/>
                  </a:cubicBezTo>
                  <a:cubicBezTo>
                    <a:pt x="402900" y="64706"/>
                    <a:pt x="402598" y="62568"/>
                    <a:pt x="401598" y="58890"/>
                  </a:cubicBezTo>
                  <a:lnTo>
                    <a:pt x="396467" y="40025"/>
                  </a:lnTo>
                  <a:cubicBezTo>
                    <a:pt x="391861" y="45621"/>
                    <a:pt x="386978" y="56060"/>
                    <a:pt x="386894" y="63134"/>
                  </a:cubicBezTo>
                  <a:cubicBezTo>
                    <a:pt x="384355" y="64235"/>
                    <a:pt x="377557" y="67976"/>
                    <a:pt x="375859" y="69831"/>
                  </a:cubicBezTo>
                  <a:cubicBezTo>
                    <a:pt x="375438" y="70271"/>
                    <a:pt x="374270" y="73415"/>
                    <a:pt x="373776" y="74045"/>
                  </a:cubicBezTo>
                  <a:cubicBezTo>
                    <a:pt x="372639" y="75459"/>
                    <a:pt x="370506" y="76528"/>
                    <a:pt x="369401" y="78006"/>
                  </a:cubicBezTo>
                  <a:cubicBezTo>
                    <a:pt x="367960" y="79893"/>
                    <a:pt x="366662" y="84609"/>
                    <a:pt x="366651" y="86904"/>
                  </a:cubicBezTo>
                  <a:lnTo>
                    <a:pt x="358815" y="95330"/>
                  </a:lnTo>
                  <a:cubicBezTo>
                    <a:pt x="358815" y="98380"/>
                    <a:pt x="357693" y="102279"/>
                    <a:pt x="356055" y="104983"/>
                  </a:cubicBezTo>
                  <a:cubicBezTo>
                    <a:pt x="353561" y="106303"/>
                    <a:pt x="349853" y="106429"/>
                    <a:pt x="347156" y="106303"/>
                  </a:cubicBezTo>
                  <a:cubicBezTo>
                    <a:pt x="337180" y="105832"/>
                    <a:pt x="332592" y="105360"/>
                    <a:pt x="325450" y="98537"/>
                  </a:cubicBezTo>
                  <a:cubicBezTo>
                    <a:pt x="324296" y="97437"/>
                    <a:pt x="323461" y="95550"/>
                    <a:pt x="322223" y="94575"/>
                  </a:cubicBezTo>
                  <a:cubicBezTo>
                    <a:pt x="317944" y="91180"/>
                    <a:pt x="312023" y="92972"/>
                    <a:pt x="307266" y="90111"/>
                  </a:cubicBezTo>
                  <a:cubicBezTo>
                    <a:pt x="305621" y="94827"/>
                    <a:pt x="309746" y="99135"/>
                    <a:pt x="310490" y="103505"/>
                  </a:cubicBezTo>
                  <a:cubicBezTo>
                    <a:pt x="311012" y="106555"/>
                    <a:pt x="309974" y="110265"/>
                    <a:pt x="310258" y="113409"/>
                  </a:cubicBezTo>
                  <a:cubicBezTo>
                    <a:pt x="310518" y="116301"/>
                    <a:pt x="312040" y="119351"/>
                    <a:pt x="312181" y="122212"/>
                  </a:cubicBezTo>
                  <a:cubicBezTo>
                    <a:pt x="312373" y="126206"/>
                    <a:pt x="311581" y="130796"/>
                    <a:pt x="311304" y="134789"/>
                  </a:cubicBezTo>
                  <a:cubicBezTo>
                    <a:pt x="303766" y="139726"/>
                    <a:pt x="296108" y="145668"/>
                    <a:pt x="289991" y="152019"/>
                  </a:cubicBezTo>
                  <a:lnTo>
                    <a:pt x="279415" y="150761"/>
                  </a:lnTo>
                  <a:lnTo>
                    <a:pt x="279871" y="155478"/>
                  </a:lnTo>
                  <a:lnTo>
                    <a:pt x="284477" y="158433"/>
                  </a:lnTo>
                  <a:lnTo>
                    <a:pt x="284245" y="162898"/>
                  </a:lnTo>
                  <a:lnTo>
                    <a:pt x="278493" y="165633"/>
                  </a:lnTo>
                  <a:cubicBezTo>
                    <a:pt x="275360" y="164030"/>
                    <a:pt x="266398" y="160634"/>
                    <a:pt x="262613" y="161923"/>
                  </a:cubicBezTo>
                  <a:cubicBezTo>
                    <a:pt x="258587" y="165539"/>
                    <a:pt x="253960" y="169815"/>
                    <a:pt x="251108" y="174280"/>
                  </a:cubicBezTo>
                  <a:cubicBezTo>
                    <a:pt x="252515" y="177392"/>
                    <a:pt x="254125" y="184058"/>
                    <a:pt x="252725" y="187422"/>
                  </a:cubicBezTo>
                  <a:lnTo>
                    <a:pt x="247415" y="189654"/>
                  </a:lnTo>
                  <a:cubicBezTo>
                    <a:pt x="243149" y="188742"/>
                    <a:pt x="241073" y="186070"/>
                    <a:pt x="237509" y="184435"/>
                  </a:cubicBezTo>
                  <a:cubicBezTo>
                    <a:pt x="233633" y="182674"/>
                    <a:pt x="221791" y="177738"/>
                    <a:pt x="217280" y="178273"/>
                  </a:cubicBezTo>
                  <a:cubicBezTo>
                    <a:pt x="216971" y="178304"/>
                    <a:pt x="207648" y="180379"/>
                    <a:pt x="207374" y="180473"/>
                  </a:cubicBezTo>
                  <a:cubicBezTo>
                    <a:pt x="203477" y="181825"/>
                    <a:pt x="201387" y="184969"/>
                    <a:pt x="196339" y="183932"/>
                  </a:cubicBezTo>
                  <a:cubicBezTo>
                    <a:pt x="192909" y="183240"/>
                    <a:pt x="189355" y="181448"/>
                    <a:pt x="185963" y="180473"/>
                  </a:cubicBezTo>
                  <a:cubicBezTo>
                    <a:pt x="178068" y="178241"/>
                    <a:pt x="171080" y="179247"/>
                    <a:pt x="165496" y="184938"/>
                  </a:cubicBezTo>
                  <a:cubicBezTo>
                    <a:pt x="163058" y="187422"/>
                    <a:pt x="161178" y="190440"/>
                    <a:pt x="161340" y="193836"/>
                  </a:cubicBezTo>
                  <a:cubicBezTo>
                    <a:pt x="161417" y="195439"/>
                    <a:pt x="162273" y="197200"/>
                    <a:pt x="162490" y="198804"/>
                  </a:cubicBezTo>
                  <a:cubicBezTo>
                    <a:pt x="162869" y="201539"/>
                    <a:pt x="162957" y="204432"/>
                    <a:pt x="163185" y="207230"/>
                  </a:cubicBezTo>
                  <a:lnTo>
                    <a:pt x="153517" y="213644"/>
                  </a:lnTo>
                  <a:lnTo>
                    <a:pt x="152602" y="218109"/>
                  </a:lnTo>
                  <a:lnTo>
                    <a:pt x="147288" y="219083"/>
                  </a:lnTo>
                  <a:cubicBezTo>
                    <a:pt x="144201" y="221536"/>
                    <a:pt x="141062" y="224806"/>
                    <a:pt x="139010" y="228013"/>
                  </a:cubicBezTo>
                  <a:cubicBezTo>
                    <a:pt x="136309" y="228925"/>
                    <a:pt x="131472" y="228201"/>
                    <a:pt x="129118" y="226786"/>
                  </a:cubicBezTo>
                  <a:cubicBezTo>
                    <a:pt x="127143" y="229239"/>
                    <a:pt x="122218" y="232069"/>
                    <a:pt x="118756" y="232226"/>
                  </a:cubicBezTo>
                  <a:cubicBezTo>
                    <a:pt x="116010" y="231062"/>
                    <a:pt x="111860" y="230622"/>
                    <a:pt x="108872" y="230968"/>
                  </a:cubicBezTo>
                  <a:cubicBezTo>
                    <a:pt x="105378" y="234238"/>
                    <a:pt x="100215" y="239740"/>
                    <a:pt x="101046" y="244614"/>
                  </a:cubicBezTo>
                  <a:cubicBezTo>
                    <a:pt x="105101" y="245966"/>
                    <a:pt x="109998" y="252977"/>
                    <a:pt x="111629" y="256215"/>
                  </a:cubicBezTo>
                  <a:lnTo>
                    <a:pt x="110033" y="260680"/>
                  </a:lnTo>
                  <a:cubicBezTo>
                    <a:pt x="106777" y="260429"/>
                    <a:pt x="102354" y="261058"/>
                    <a:pt x="99429" y="262409"/>
                  </a:cubicBezTo>
                  <a:cubicBezTo>
                    <a:pt x="97247" y="264044"/>
                    <a:pt x="94883" y="267975"/>
                    <a:pt x="95058" y="270584"/>
                  </a:cubicBezTo>
                  <a:lnTo>
                    <a:pt x="89765" y="274074"/>
                  </a:lnTo>
                  <a:lnTo>
                    <a:pt x="79168" y="275049"/>
                  </a:lnTo>
                  <a:cubicBezTo>
                    <a:pt x="76997" y="273225"/>
                    <a:pt x="72248" y="271779"/>
                    <a:pt x="69277" y="272094"/>
                  </a:cubicBezTo>
                  <a:lnTo>
                    <a:pt x="67898" y="276778"/>
                  </a:lnTo>
                  <a:cubicBezTo>
                    <a:pt x="62966" y="281589"/>
                    <a:pt x="56681" y="281557"/>
                    <a:pt x="51325" y="286179"/>
                  </a:cubicBezTo>
                  <a:lnTo>
                    <a:pt x="45817" y="286431"/>
                  </a:lnTo>
                  <a:lnTo>
                    <a:pt x="40966" y="290644"/>
                  </a:lnTo>
                  <a:cubicBezTo>
                    <a:pt x="38195" y="291650"/>
                    <a:pt x="33120" y="291839"/>
                    <a:pt x="30366" y="290644"/>
                  </a:cubicBezTo>
                  <a:cubicBezTo>
                    <a:pt x="30366" y="291053"/>
                    <a:pt x="30314" y="294700"/>
                    <a:pt x="30366" y="294857"/>
                  </a:cubicBezTo>
                  <a:cubicBezTo>
                    <a:pt x="31909" y="299668"/>
                    <a:pt x="35424" y="299762"/>
                    <a:pt x="34288" y="307245"/>
                  </a:cubicBezTo>
                  <a:cubicBezTo>
                    <a:pt x="34200" y="307811"/>
                    <a:pt x="34368" y="308220"/>
                    <a:pt x="34063" y="308723"/>
                  </a:cubicBezTo>
                  <a:cubicBezTo>
                    <a:pt x="33000" y="310515"/>
                    <a:pt x="32095" y="311395"/>
                    <a:pt x="30840" y="313093"/>
                  </a:cubicBezTo>
                  <a:cubicBezTo>
                    <a:pt x="27841" y="317149"/>
                    <a:pt x="24999" y="322148"/>
                    <a:pt x="20829" y="325418"/>
                  </a:cubicBezTo>
                  <a:cubicBezTo>
                    <a:pt x="24736" y="328939"/>
                    <a:pt x="30622" y="331706"/>
                    <a:pt x="35442" y="333970"/>
                  </a:cubicBezTo>
                  <a:cubicBezTo>
                    <a:pt x="39837" y="338906"/>
                    <a:pt x="35880" y="343434"/>
                    <a:pt x="39114" y="347836"/>
                  </a:cubicBezTo>
                  <a:lnTo>
                    <a:pt x="36122" y="352049"/>
                  </a:lnTo>
                  <a:lnTo>
                    <a:pt x="39346" y="356513"/>
                  </a:lnTo>
                  <a:cubicBezTo>
                    <a:pt x="42871" y="358652"/>
                    <a:pt x="51563" y="358526"/>
                    <a:pt x="55467" y="357991"/>
                  </a:cubicBezTo>
                  <a:lnTo>
                    <a:pt x="60073" y="361450"/>
                  </a:lnTo>
                  <a:cubicBezTo>
                    <a:pt x="58792" y="367078"/>
                    <a:pt x="57958" y="373052"/>
                    <a:pt x="57772" y="378774"/>
                  </a:cubicBezTo>
                  <a:lnTo>
                    <a:pt x="67902" y="383993"/>
                  </a:lnTo>
                  <a:lnTo>
                    <a:pt x="72728" y="383239"/>
                  </a:lnTo>
                  <a:cubicBezTo>
                    <a:pt x="77376" y="386383"/>
                    <a:pt x="78050" y="388930"/>
                    <a:pt x="81021" y="391665"/>
                  </a:cubicBezTo>
                  <a:cubicBezTo>
                    <a:pt x="84767" y="395123"/>
                    <a:pt x="91617" y="396978"/>
                    <a:pt x="96889" y="396853"/>
                  </a:cubicBezTo>
                  <a:cubicBezTo>
                    <a:pt x="102607" y="401223"/>
                    <a:pt x="110236" y="406883"/>
                    <a:pt x="113477" y="413202"/>
                  </a:cubicBezTo>
                  <a:lnTo>
                    <a:pt x="109794" y="422351"/>
                  </a:lnTo>
                  <a:cubicBezTo>
                    <a:pt x="112141" y="424395"/>
                    <a:pt x="114603" y="427885"/>
                    <a:pt x="115305" y="430778"/>
                  </a:cubicBezTo>
                  <a:cubicBezTo>
                    <a:pt x="119672" y="432004"/>
                    <a:pt x="125060" y="439267"/>
                    <a:pt x="126810" y="442663"/>
                  </a:cubicBezTo>
                  <a:cubicBezTo>
                    <a:pt x="124895" y="448668"/>
                    <a:pt x="119851" y="456182"/>
                    <a:pt x="112081" y="456780"/>
                  </a:cubicBezTo>
                  <a:cubicBezTo>
                    <a:pt x="108679" y="453604"/>
                    <a:pt x="101986" y="447882"/>
                    <a:pt x="97366" y="446121"/>
                  </a:cubicBezTo>
                  <a:cubicBezTo>
                    <a:pt x="91579" y="447096"/>
                    <a:pt x="87033" y="443669"/>
                    <a:pt x="81245" y="443889"/>
                  </a:cubicBezTo>
                  <a:cubicBezTo>
                    <a:pt x="77639" y="445272"/>
                    <a:pt x="73704" y="447945"/>
                    <a:pt x="71108" y="450586"/>
                  </a:cubicBezTo>
                  <a:lnTo>
                    <a:pt x="60294" y="451812"/>
                  </a:lnTo>
                  <a:lnTo>
                    <a:pt x="58242" y="456277"/>
                  </a:lnTo>
                  <a:cubicBezTo>
                    <a:pt x="59985" y="458949"/>
                    <a:pt x="63058" y="466244"/>
                    <a:pt x="61216" y="469419"/>
                  </a:cubicBezTo>
                  <a:lnTo>
                    <a:pt x="55464" y="470646"/>
                  </a:lnTo>
                  <a:lnTo>
                    <a:pt x="50409" y="468413"/>
                  </a:lnTo>
                  <a:cubicBezTo>
                    <a:pt x="47589" y="470551"/>
                    <a:pt x="38143" y="477908"/>
                    <a:pt x="36361" y="480801"/>
                  </a:cubicBezTo>
                  <a:cubicBezTo>
                    <a:pt x="35238" y="482593"/>
                    <a:pt x="34551" y="492088"/>
                    <a:pt x="34516" y="494164"/>
                  </a:cubicBezTo>
                  <a:cubicBezTo>
                    <a:pt x="30289" y="495987"/>
                    <a:pt x="21853" y="501081"/>
                    <a:pt x="20015" y="505294"/>
                  </a:cubicBezTo>
                  <a:cubicBezTo>
                    <a:pt x="21541" y="508438"/>
                    <a:pt x="24235" y="511771"/>
                    <a:pt x="26925" y="514223"/>
                  </a:cubicBezTo>
                  <a:cubicBezTo>
                    <a:pt x="28777" y="521675"/>
                    <a:pt x="18180" y="526139"/>
                    <a:pt x="13578" y="530290"/>
                  </a:cubicBezTo>
                  <a:cubicBezTo>
                    <a:pt x="10642" y="532962"/>
                    <a:pt x="7942" y="536547"/>
                    <a:pt x="5300" y="539470"/>
                  </a:cubicBezTo>
                  <a:lnTo>
                    <a:pt x="5300" y="544407"/>
                  </a:lnTo>
                  <a:lnTo>
                    <a:pt x="0" y="546639"/>
                  </a:lnTo>
                  <a:lnTo>
                    <a:pt x="695" y="551324"/>
                  </a:lnTo>
                  <a:cubicBezTo>
                    <a:pt x="5735" y="549375"/>
                    <a:pt x="10776" y="553148"/>
                    <a:pt x="15402" y="554059"/>
                  </a:cubicBezTo>
                  <a:cubicBezTo>
                    <a:pt x="18966" y="554783"/>
                    <a:pt x="21351" y="552896"/>
                    <a:pt x="26241" y="555569"/>
                  </a:cubicBezTo>
                  <a:cubicBezTo>
                    <a:pt x="28577" y="559090"/>
                    <a:pt x="27062" y="561354"/>
                    <a:pt x="27837" y="564467"/>
                  </a:cubicBezTo>
                  <a:cubicBezTo>
                    <a:pt x="28581" y="567453"/>
                    <a:pt x="30359" y="570440"/>
                    <a:pt x="31288" y="573364"/>
                  </a:cubicBezTo>
                  <a:cubicBezTo>
                    <a:pt x="31692" y="574653"/>
                    <a:pt x="31485" y="576351"/>
                    <a:pt x="31983" y="577578"/>
                  </a:cubicBezTo>
                  <a:cubicBezTo>
                    <a:pt x="32516" y="578898"/>
                    <a:pt x="33933" y="580564"/>
                    <a:pt x="34733" y="581791"/>
                  </a:cubicBezTo>
                  <a:cubicBezTo>
                    <a:pt x="35143" y="584998"/>
                    <a:pt x="33597" y="587733"/>
                    <a:pt x="33597" y="590720"/>
                  </a:cubicBezTo>
                  <a:cubicBezTo>
                    <a:pt x="33597" y="593518"/>
                    <a:pt x="34375" y="596820"/>
                    <a:pt x="34733" y="599618"/>
                  </a:cubicBezTo>
                  <a:cubicBezTo>
                    <a:pt x="37841" y="600089"/>
                    <a:pt x="41664" y="600310"/>
                    <a:pt x="44653" y="601127"/>
                  </a:cubicBezTo>
                  <a:cubicBezTo>
                    <a:pt x="50174" y="602573"/>
                    <a:pt x="61493" y="611346"/>
                    <a:pt x="60760" y="616942"/>
                  </a:cubicBezTo>
                  <a:cubicBezTo>
                    <a:pt x="63686" y="618389"/>
                    <a:pt x="68014" y="619269"/>
                    <a:pt x="71343" y="619175"/>
                  </a:cubicBezTo>
                  <a:lnTo>
                    <a:pt x="77327" y="628324"/>
                  </a:lnTo>
                  <a:lnTo>
                    <a:pt x="82385" y="630808"/>
                  </a:lnTo>
                  <a:lnTo>
                    <a:pt x="83072" y="640712"/>
                  </a:lnTo>
                  <a:lnTo>
                    <a:pt x="78243" y="643447"/>
                  </a:lnTo>
                  <a:lnTo>
                    <a:pt x="77092" y="647409"/>
                  </a:lnTo>
                  <a:lnTo>
                    <a:pt x="84455" y="656558"/>
                  </a:lnTo>
                  <a:cubicBezTo>
                    <a:pt x="84388" y="657093"/>
                    <a:pt x="83735" y="662909"/>
                    <a:pt x="83669" y="663035"/>
                  </a:cubicBezTo>
                  <a:cubicBezTo>
                    <a:pt x="82266" y="665865"/>
                    <a:pt x="78733" y="669449"/>
                    <a:pt x="76724" y="672059"/>
                  </a:cubicBezTo>
                  <a:lnTo>
                    <a:pt x="82697" y="680108"/>
                  </a:lnTo>
                  <a:cubicBezTo>
                    <a:pt x="85107" y="680579"/>
                    <a:pt x="87457" y="681177"/>
                    <a:pt x="89849" y="681680"/>
                  </a:cubicBezTo>
                  <a:cubicBezTo>
                    <a:pt x="92466" y="682214"/>
                    <a:pt x="97875" y="675863"/>
                    <a:pt x="98436" y="673757"/>
                  </a:cubicBezTo>
                  <a:cubicBezTo>
                    <a:pt x="99103" y="671210"/>
                    <a:pt x="104859" y="671870"/>
                    <a:pt x="105918" y="673851"/>
                  </a:cubicBezTo>
                  <a:cubicBezTo>
                    <a:pt x="107276" y="676398"/>
                    <a:pt x="112730" y="679762"/>
                    <a:pt x="115108" y="682057"/>
                  </a:cubicBezTo>
                  <a:cubicBezTo>
                    <a:pt x="119184" y="685987"/>
                    <a:pt x="119356" y="686679"/>
                    <a:pt x="118665" y="691772"/>
                  </a:cubicBezTo>
                  <a:cubicBezTo>
                    <a:pt x="117946" y="697055"/>
                    <a:pt x="117118" y="702337"/>
                    <a:pt x="116403" y="707619"/>
                  </a:cubicBezTo>
                  <a:cubicBezTo>
                    <a:pt x="115006" y="717963"/>
                    <a:pt x="139606" y="711518"/>
                    <a:pt x="145390" y="711518"/>
                  </a:cubicBezTo>
                  <a:cubicBezTo>
                    <a:pt x="147891" y="711518"/>
                    <a:pt x="151171" y="715134"/>
                    <a:pt x="152577" y="716863"/>
                  </a:cubicBezTo>
                  <a:lnTo>
                    <a:pt x="160252" y="717397"/>
                  </a:lnTo>
                  <a:cubicBezTo>
                    <a:pt x="166861" y="714505"/>
                    <a:pt x="167871" y="713687"/>
                    <a:pt x="168804" y="707242"/>
                  </a:cubicBezTo>
                  <a:cubicBezTo>
                    <a:pt x="169032" y="705638"/>
                    <a:pt x="170800" y="700105"/>
                    <a:pt x="171859" y="699035"/>
                  </a:cubicBezTo>
                  <a:cubicBezTo>
                    <a:pt x="173073" y="697778"/>
                    <a:pt x="174167" y="696457"/>
                    <a:pt x="175160" y="695043"/>
                  </a:cubicBezTo>
                  <a:lnTo>
                    <a:pt x="183712" y="694256"/>
                  </a:lnTo>
                  <a:lnTo>
                    <a:pt x="186781" y="696615"/>
                  </a:lnTo>
                  <a:lnTo>
                    <a:pt x="183491" y="709411"/>
                  </a:lnTo>
                  <a:lnTo>
                    <a:pt x="185465" y="712744"/>
                  </a:lnTo>
                  <a:cubicBezTo>
                    <a:pt x="190232" y="713215"/>
                    <a:pt x="195778" y="713656"/>
                    <a:pt x="200587" y="713184"/>
                  </a:cubicBezTo>
                  <a:cubicBezTo>
                    <a:pt x="201033" y="722491"/>
                    <a:pt x="199963" y="720730"/>
                    <a:pt x="191825" y="725698"/>
                  </a:cubicBezTo>
                  <a:lnTo>
                    <a:pt x="188973" y="733558"/>
                  </a:lnTo>
                  <a:cubicBezTo>
                    <a:pt x="193947" y="738966"/>
                    <a:pt x="198412" y="749279"/>
                    <a:pt x="200812" y="755787"/>
                  </a:cubicBezTo>
                  <a:lnTo>
                    <a:pt x="207827" y="758334"/>
                  </a:lnTo>
                  <a:lnTo>
                    <a:pt x="212212" y="742424"/>
                  </a:lnTo>
                  <a:lnTo>
                    <a:pt x="218788" y="741230"/>
                  </a:lnTo>
                  <a:lnTo>
                    <a:pt x="225586" y="745160"/>
                  </a:lnTo>
                  <a:lnTo>
                    <a:pt x="235892" y="744185"/>
                  </a:lnTo>
                  <a:lnTo>
                    <a:pt x="237428" y="753020"/>
                  </a:lnTo>
                  <a:lnTo>
                    <a:pt x="242690" y="756762"/>
                  </a:lnTo>
                  <a:lnTo>
                    <a:pt x="246334" y="765471"/>
                  </a:lnTo>
                  <a:lnTo>
                    <a:pt x="243482" y="767829"/>
                  </a:lnTo>
                  <a:cubicBezTo>
                    <a:pt x="238951" y="767420"/>
                    <a:pt x="228613" y="768584"/>
                    <a:pt x="224639" y="770218"/>
                  </a:cubicBezTo>
                  <a:cubicBezTo>
                    <a:pt x="224453" y="770281"/>
                    <a:pt x="220241" y="773803"/>
                    <a:pt x="219809" y="774149"/>
                  </a:cubicBezTo>
                  <a:cubicBezTo>
                    <a:pt x="217691" y="778708"/>
                    <a:pt x="219658" y="783487"/>
                    <a:pt x="218883" y="788046"/>
                  </a:cubicBezTo>
                  <a:cubicBezTo>
                    <a:pt x="218090" y="792731"/>
                    <a:pt x="214428" y="797132"/>
                    <a:pt x="215203" y="802132"/>
                  </a:cubicBezTo>
                  <a:lnTo>
                    <a:pt x="208690" y="810746"/>
                  </a:lnTo>
                  <a:lnTo>
                    <a:pt x="204091" y="811250"/>
                  </a:lnTo>
                  <a:lnTo>
                    <a:pt x="203411" y="815211"/>
                  </a:lnTo>
                  <a:lnTo>
                    <a:pt x="199037" y="819676"/>
                  </a:lnTo>
                  <a:cubicBezTo>
                    <a:pt x="200082" y="826404"/>
                    <a:pt x="199282" y="832787"/>
                    <a:pt x="193740" y="837755"/>
                  </a:cubicBezTo>
                  <a:cubicBezTo>
                    <a:pt x="193028" y="841119"/>
                    <a:pt x="192572" y="848130"/>
                    <a:pt x="194431" y="851369"/>
                  </a:cubicBezTo>
                  <a:lnTo>
                    <a:pt x="190969" y="855582"/>
                  </a:lnTo>
                  <a:cubicBezTo>
                    <a:pt x="190885" y="860329"/>
                    <a:pt x="194845" y="863819"/>
                    <a:pt x="194663" y="868693"/>
                  </a:cubicBezTo>
                  <a:cubicBezTo>
                    <a:pt x="191548" y="870799"/>
                    <a:pt x="189506" y="874195"/>
                    <a:pt x="188896" y="877591"/>
                  </a:cubicBezTo>
                  <a:cubicBezTo>
                    <a:pt x="188647" y="879006"/>
                    <a:pt x="189026" y="880703"/>
                    <a:pt x="188675" y="882056"/>
                  </a:cubicBezTo>
                  <a:cubicBezTo>
                    <a:pt x="188500" y="882716"/>
                    <a:pt x="186591" y="886143"/>
                    <a:pt x="186581" y="886520"/>
                  </a:cubicBezTo>
                  <a:cubicBezTo>
                    <a:pt x="186574" y="886772"/>
                    <a:pt x="188117" y="899317"/>
                    <a:pt x="188198" y="899631"/>
                  </a:cubicBezTo>
                  <a:cubicBezTo>
                    <a:pt x="188510" y="900857"/>
                    <a:pt x="192225" y="905637"/>
                    <a:pt x="193105" y="908781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64" name="자유형: 도형 305"/>
            <p:cNvSpPr/>
            <p:nvPr/>
          </p:nvSpPr>
          <p:spPr>
            <a:xfrm>
              <a:off x="7925400" y="1958760"/>
              <a:ext cx="1870560" cy="1734480"/>
            </a:xfrm>
            <a:custGeom>
              <a:avLst/>
              <a:gdLst/>
              <a:ahLst/>
              <a:cxnLst/>
              <a:rect l="l" t="t" r="r" b="b"/>
              <a:pathLst>
                <a:path w="1481079" h="1412281">
                  <a:moveTo>
                    <a:pt x="494517" y="1371660"/>
                  </a:moveTo>
                  <a:cubicBezTo>
                    <a:pt x="494517" y="1371660"/>
                    <a:pt x="501533" y="1363360"/>
                    <a:pt x="500200" y="1361284"/>
                  </a:cubicBezTo>
                  <a:cubicBezTo>
                    <a:pt x="498867" y="1359178"/>
                    <a:pt x="505566" y="1353770"/>
                    <a:pt x="506233" y="1349557"/>
                  </a:cubicBezTo>
                  <a:cubicBezTo>
                    <a:pt x="506899" y="1345343"/>
                    <a:pt x="503567" y="1341162"/>
                    <a:pt x="497955" y="1337075"/>
                  </a:cubicBezTo>
                  <a:cubicBezTo>
                    <a:pt x="492377" y="1332987"/>
                    <a:pt x="488133" y="1332201"/>
                    <a:pt x="477294" y="1320631"/>
                  </a:cubicBezTo>
                  <a:cubicBezTo>
                    <a:pt x="466421" y="1309029"/>
                    <a:pt x="464772" y="1295635"/>
                    <a:pt x="466947" y="1289818"/>
                  </a:cubicBezTo>
                  <a:cubicBezTo>
                    <a:pt x="469087" y="1284001"/>
                    <a:pt x="474173" y="1286108"/>
                    <a:pt x="480662" y="1289221"/>
                  </a:cubicBezTo>
                  <a:cubicBezTo>
                    <a:pt x="487151" y="1292334"/>
                    <a:pt x="525209" y="1297176"/>
                    <a:pt x="525209" y="1297176"/>
                  </a:cubicBezTo>
                  <a:cubicBezTo>
                    <a:pt x="525209" y="1297176"/>
                    <a:pt x="530261" y="1295635"/>
                    <a:pt x="533558" y="1290856"/>
                  </a:cubicBezTo>
                  <a:cubicBezTo>
                    <a:pt x="536855" y="1286077"/>
                    <a:pt x="532962" y="1275890"/>
                    <a:pt x="533067" y="1269884"/>
                  </a:cubicBezTo>
                  <a:cubicBezTo>
                    <a:pt x="533137" y="1263879"/>
                    <a:pt x="521561" y="1261552"/>
                    <a:pt x="506864" y="1255767"/>
                  </a:cubicBezTo>
                  <a:cubicBezTo>
                    <a:pt x="492202" y="1249982"/>
                    <a:pt x="495499" y="1234010"/>
                    <a:pt x="501954" y="1229105"/>
                  </a:cubicBezTo>
                  <a:cubicBezTo>
                    <a:pt x="508373" y="1224232"/>
                    <a:pt x="510828" y="1210052"/>
                    <a:pt x="515213" y="1204298"/>
                  </a:cubicBezTo>
                  <a:cubicBezTo>
                    <a:pt x="519562" y="1198575"/>
                    <a:pt x="526928" y="1196249"/>
                    <a:pt x="530962" y="1196249"/>
                  </a:cubicBezTo>
                  <a:cubicBezTo>
                    <a:pt x="534961" y="1196249"/>
                    <a:pt x="555656" y="1196846"/>
                    <a:pt x="565548" y="1196249"/>
                  </a:cubicBezTo>
                  <a:cubicBezTo>
                    <a:pt x="575440" y="1195620"/>
                    <a:pt x="573124" y="1182634"/>
                    <a:pt x="573124" y="1182634"/>
                  </a:cubicBezTo>
                  <a:lnTo>
                    <a:pt x="549728" y="1164556"/>
                  </a:lnTo>
                  <a:cubicBezTo>
                    <a:pt x="549728" y="1164556"/>
                    <a:pt x="531629" y="1162764"/>
                    <a:pt x="526262" y="1162135"/>
                  </a:cubicBezTo>
                  <a:cubicBezTo>
                    <a:pt x="520895" y="1161537"/>
                    <a:pt x="513529" y="1162135"/>
                    <a:pt x="501533" y="1156758"/>
                  </a:cubicBezTo>
                  <a:cubicBezTo>
                    <a:pt x="489571" y="1151350"/>
                    <a:pt x="497534" y="1141132"/>
                    <a:pt x="499218" y="1135535"/>
                  </a:cubicBezTo>
                  <a:cubicBezTo>
                    <a:pt x="500866" y="1129970"/>
                    <a:pt x="507636" y="1126008"/>
                    <a:pt x="507636" y="1126008"/>
                  </a:cubicBezTo>
                  <a:lnTo>
                    <a:pt x="528437" y="1088436"/>
                  </a:lnTo>
                  <a:lnTo>
                    <a:pt x="553306" y="1076740"/>
                  </a:lnTo>
                  <a:lnTo>
                    <a:pt x="572318" y="1084287"/>
                  </a:lnTo>
                  <a:cubicBezTo>
                    <a:pt x="572318" y="1084287"/>
                    <a:pt x="566951" y="1098623"/>
                    <a:pt x="563022" y="1104629"/>
                  </a:cubicBezTo>
                  <a:cubicBezTo>
                    <a:pt x="559094" y="1110634"/>
                    <a:pt x="564952" y="1118368"/>
                    <a:pt x="569863" y="1118086"/>
                  </a:cubicBezTo>
                  <a:cubicBezTo>
                    <a:pt x="574738" y="1117803"/>
                    <a:pt x="582630" y="1117488"/>
                    <a:pt x="582630" y="1117488"/>
                  </a:cubicBezTo>
                  <a:lnTo>
                    <a:pt x="592522" y="1124908"/>
                  </a:lnTo>
                  <a:lnTo>
                    <a:pt x="623285" y="1047154"/>
                  </a:lnTo>
                  <a:lnTo>
                    <a:pt x="633071" y="1058598"/>
                  </a:lnTo>
                  <a:lnTo>
                    <a:pt x="640542" y="1049858"/>
                  </a:lnTo>
                  <a:lnTo>
                    <a:pt x="648855" y="1045173"/>
                  </a:lnTo>
                  <a:lnTo>
                    <a:pt x="661202" y="1046525"/>
                  </a:lnTo>
                  <a:lnTo>
                    <a:pt x="675268" y="1039325"/>
                  </a:lnTo>
                  <a:lnTo>
                    <a:pt x="701997" y="1018354"/>
                  </a:lnTo>
                  <a:lnTo>
                    <a:pt x="715151" y="1017945"/>
                  </a:lnTo>
                  <a:lnTo>
                    <a:pt x="752648" y="1013700"/>
                  </a:lnTo>
                  <a:lnTo>
                    <a:pt x="770782" y="1015367"/>
                  </a:lnTo>
                  <a:lnTo>
                    <a:pt x="780499" y="1037501"/>
                  </a:lnTo>
                  <a:lnTo>
                    <a:pt x="794810" y="1050738"/>
                  </a:lnTo>
                  <a:lnTo>
                    <a:pt x="785866" y="1087587"/>
                  </a:lnTo>
                  <a:cubicBezTo>
                    <a:pt x="785866" y="1087587"/>
                    <a:pt x="788777" y="1093215"/>
                    <a:pt x="798178" y="1099221"/>
                  </a:cubicBezTo>
                  <a:cubicBezTo>
                    <a:pt x="807543" y="1105226"/>
                    <a:pt x="804211" y="1111231"/>
                    <a:pt x="804211" y="1114187"/>
                  </a:cubicBezTo>
                  <a:cubicBezTo>
                    <a:pt x="804211" y="1117111"/>
                    <a:pt x="806877" y="1143522"/>
                    <a:pt x="806877" y="1143522"/>
                  </a:cubicBezTo>
                  <a:lnTo>
                    <a:pt x="783586" y="1157670"/>
                  </a:lnTo>
                  <a:lnTo>
                    <a:pt x="775378" y="1156758"/>
                  </a:lnTo>
                  <a:lnTo>
                    <a:pt x="765872" y="1175938"/>
                  </a:lnTo>
                  <a:lnTo>
                    <a:pt x="754788" y="1206467"/>
                  </a:lnTo>
                  <a:lnTo>
                    <a:pt x="740687" y="1217786"/>
                  </a:lnTo>
                  <a:cubicBezTo>
                    <a:pt x="740687" y="1217786"/>
                    <a:pt x="750087" y="1232815"/>
                    <a:pt x="750087" y="1245958"/>
                  </a:cubicBezTo>
                  <a:cubicBezTo>
                    <a:pt x="750087" y="1259100"/>
                    <a:pt x="744896" y="1267526"/>
                    <a:pt x="744896" y="1267526"/>
                  </a:cubicBezTo>
                  <a:lnTo>
                    <a:pt x="722026" y="1277116"/>
                  </a:lnTo>
                  <a:lnTo>
                    <a:pt x="708872" y="1287115"/>
                  </a:lnTo>
                  <a:lnTo>
                    <a:pt x="695964" y="1288529"/>
                  </a:lnTo>
                  <a:lnTo>
                    <a:pt x="686107" y="1286768"/>
                  </a:lnTo>
                  <a:lnTo>
                    <a:pt x="683862" y="1259320"/>
                  </a:lnTo>
                  <a:lnTo>
                    <a:pt x="666499" y="1262276"/>
                  </a:lnTo>
                  <a:lnTo>
                    <a:pt x="654643" y="1259666"/>
                  </a:lnTo>
                  <a:lnTo>
                    <a:pt x="615006" y="1280009"/>
                  </a:lnTo>
                  <a:lnTo>
                    <a:pt x="617356" y="1299408"/>
                  </a:lnTo>
                  <a:lnTo>
                    <a:pt x="610797" y="1308966"/>
                  </a:lnTo>
                  <a:cubicBezTo>
                    <a:pt x="610797" y="1308966"/>
                    <a:pt x="616479" y="1328019"/>
                    <a:pt x="617146" y="1330409"/>
                  </a:cubicBezTo>
                  <a:cubicBezTo>
                    <a:pt x="617812" y="1332830"/>
                    <a:pt x="621075" y="1341759"/>
                    <a:pt x="619145" y="1351978"/>
                  </a:cubicBezTo>
                  <a:cubicBezTo>
                    <a:pt x="617216" y="1362165"/>
                    <a:pt x="623776" y="1364586"/>
                    <a:pt x="627915" y="1365655"/>
                  </a:cubicBezTo>
                  <a:cubicBezTo>
                    <a:pt x="632089" y="1366787"/>
                    <a:pt x="649136" y="1386721"/>
                    <a:pt x="652047" y="1391028"/>
                  </a:cubicBezTo>
                  <a:cubicBezTo>
                    <a:pt x="654994" y="1395304"/>
                    <a:pt x="661869" y="1396845"/>
                    <a:pt x="669235" y="1396845"/>
                  </a:cubicBezTo>
                  <a:cubicBezTo>
                    <a:pt x="676601" y="1396845"/>
                    <a:pt x="697963" y="1395052"/>
                    <a:pt x="702243" y="1393417"/>
                  </a:cubicBezTo>
                  <a:cubicBezTo>
                    <a:pt x="706487" y="1391751"/>
                    <a:pt x="717010" y="1385588"/>
                    <a:pt x="717010" y="1385588"/>
                  </a:cubicBezTo>
                  <a:lnTo>
                    <a:pt x="746158" y="1387633"/>
                  </a:lnTo>
                  <a:lnTo>
                    <a:pt x="750543" y="1396593"/>
                  </a:lnTo>
                  <a:lnTo>
                    <a:pt x="755910" y="1401498"/>
                  </a:lnTo>
                  <a:lnTo>
                    <a:pt x="776009" y="1401813"/>
                  </a:lnTo>
                  <a:lnTo>
                    <a:pt x="805965" y="1411119"/>
                  </a:lnTo>
                  <a:lnTo>
                    <a:pt x="827853" y="1412282"/>
                  </a:lnTo>
                  <a:lnTo>
                    <a:pt x="836376" y="1395461"/>
                  </a:lnTo>
                  <a:lnTo>
                    <a:pt x="863947" y="1385431"/>
                  </a:lnTo>
                  <a:lnTo>
                    <a:pt x="870225" y="1390368"/>
                  </a:lnTo>
                  <a:lnTo>
                    <a:pt x="879416" y="1388072"/>
                  </a:lnTo>
                  <a:lnTo>
                    <a:pt x="886045" y="1376911"/>
                  </a:lnTo>
                  <a:lnTo>
                    <a:pt x="896288" y="1365780"/>
                  </a:lnTo>
                  <a:lnTo>
                    <a:pt x="898392" y="1352104"/>
                  </a:lnTo>
                  <a:lnTo>
                    <a:pt x="925787" y="1351726"/>
                  </a:lnTo>
                  <a:lnTo>
                    <a:pt x="932382" y="1342137"/>
                  </a:lnTo>
                  <a:lnTo>
                    <a:pt x="938730" y="1343048"/>
                  </a:lnTo>
                  <a:lnTo>
                    <a:pt x="959181" y="1357951"/>
                  </a:lnTo>
                  <a:lnTo>
                    <a:pt x="972580" y="1369302"/>
                  </a:lnTo>
                  <a:lnTo>
                    <a:pt x="987908" y="1373484"/>
                  </a:lnTo>
                  <a:lnTo>
                    <a:pt x="1003552" y="1366629"/>
                  </a:lnTo>
                  <a:lnTo>
                    <a:pt x="1021652" y="1350783"/>
                  </a:lnTo>
                  <a:lnTo>
                    <a:pt x="1033473" y="1352575"/>
                  </a:lnTo>
                  <a:lnTo>
                    <a:pt x="1042909" y="1338207"/>
                  </a:lnTo>
                  <a:lnTo>
                    <a:pt x="1063709" y="1346570"/>
                  </a:lnTo>
                  <a:lnTo>
                    <a:pt x="1069322" y="1339401"/>
                  </a:lnTo>
                  <a:lnTo>
                    <a:pt x="1058658" y="1327171"/>
                  </a:lnTo>
                  <a:lnTo>
                    <a:pt x="1062131" y="1308872"/>
                  </a:lnTo>
                  <a:lnTo>
                    <a:pt x="1071146" y="1294314"/>
                  </a:lnTo>
                  <a:lnTo>
                    <a:pt x="1084931" y="1288875"/>
                  </a:lnTo>
                  <a:lnTo>
                    <a:pt x="1105065" y="1285951"/>
                  </a:lnTo>
                  <a:lnTo>
                    <a:pt x="1119026" y="1273280"/>
                  </a:lnTo>
                  <a:lnTo>
                    <a:pt x="1128882" y="1270482"/>
                  </a:lnTo>
                  <a:lnTo>
                    <a:pt x="1134424" y="1278342"/>
                  </a:lnTo>
                  <a:lnTo>
                    <a:pt x="1146315" y="1279316"/>
                  </a:lnTo>
                  <a:lnTo>
                    <a:pt x="1154629" y="1273028"/>
                  </a:lnTo>
                  <a:lnTo>
                    <a:pt x="1173816" y="1273311"/>
                  </a:lnTo>
                  <a:cubicBezTo>
                    <a:pt x="1173816" y="1273311"/>
                    <a:pt x="1189285" y="1281235"/>
                    <a:pt x="1191845" y="1284882"/>
                  </a:cubicBezTo>
                  <a:cubicBezTo>
                    <a:pt x="1194371" y="1288498"/>
                    <a:pt x="1201737" y="1290824"/>
                    <a:pt x="1201737" y="1290824"/>
                  </a:cubicBezTo>
                  <a:lnTo>
                    <a:pt x="1215417" y="1293277"/>
                  </a:lnTo>
                  <a:lnTo>
                    <a:pt x="1218960" y="1298999"/>
                  </a:lnTo>
                  <a:lnTo>
                    <a:pt x="1213067" y="1322611"/>
                  </a:lnTo>
                  <a:cubicBezTo>
                    <a:pt x="1213067" y="1322611"/>
                    <a:pt x="1215206" y="1330000"/>
                    <a:pt x="1216469" y="1332012"/>
                  </a:cubicBezTo>
                  <a:cubicBezTo>
                    <a:pt x="1217767" y="1333993"/>
                    <a:pt x="1234639" y="1337138"/>
                    <a:pt x="1234639" y="1337138"/>
                  </a:cubicBezTo>
                  <a:lnTo>
                    <a:pt x="1243689" y="1341288"/>
                  </a:lnTo>
                  <a:lnTo>
                    <a:pt x="1258526" y="1328617"/>
                  </a:lnTo>
                  <a:lnTo>
                    <a:pt x="1267646" y="1329591"/>
                  </a:lnTo>
                  <a:lnTo>
                    <a:pt x="1293884" y="1314248"/>
                  </a:lnTo>
                  <a:lnTo>
                    <a:pt x="1307985" y="1314782"/>
                  </a:lnTo>
                  <a:lnTo>
                    <a:pt x="1340711" y="1326196"/>
                  </a:lnTo>
                  <a:lnTo>
                    <a:pt x="1380033" y="1337106"/>
                  </a:lnTo>
                  <a:cubicBezTo>
                    <a:pt x="1384452" y="1326762"/>
                    <a:pt x="1392169" y="1317738"/>
                    <a:pt x="1397115" y="1306891"/>
                  </a:cubicBezTo>
                  <a:cubicBezTo>
                    <a:pt x="1400517" y="1299376"/>
                    <a:pt x="1401324" y="1290950"/>
                    <a:pt x="1403183" y="1283090"/>
                  </a:cubicBezTo>
                  <a:cubicBezTo>
                    <a:pt x="1404551" y="1277273"/>
                    <a:pt x="1406901" y="1271488"/>
                    <a:pt x="1407533" y="1265577"/>
                  </a:cubicBezTo>
                  <a:cubicBezTo>
                    <a:pt x="1408655" y="1255233"/>
                    <a:pt x="1409216" y="1247875"/>
                    <a:pt x="1411917" y="1237595"/>
                  </a:cubicBezTo>
                  <a:cubicBezTo>
                    <a:pt x="1413391" y="1232029"/>
                    <a:pt x="1413110" y="1226212"/>
                    <a:pt x="1414338" y="1220616"/>
                  </a:cubicBezTo>
                  <a:cubicBezTo>
                    <a:pt x="1415460" y="1215711"/>
                    <a:pt x="1417565" y="1208260"/>
                    <a:pt x="1420687" y="1204141"/>
                  </a:cubicBezTo>
                  <a:cubicBezTo>
                    <a:pt x="1423633" y="1200147"/>
                    <a:pt x="1428544" y="1197098"/>
                    <a:pt x="1430157" y="1192381"/>
                  </a:cubicBezTo>
                  <a:cubicBezTo>
                    <a:pt x="1431385" y="1188797"/>
                    <a:pt x="1430122" y="1185024"/>
                    <a:pt x="1430894" y="1181377"/>
                  </a:cubicBezTo>
                  <a:cubicBezTo>
                    <a:pt x="1432367" y="1174397"/>
                    <a:pt x="1438821" y="1168832"/>
                    <a:pt x="1442294" y="1162827"/>
                  </a:cubicBezTo>
                  <a:cubicBezTo>
                    <a:pt x="1450221" y="1149244"/>
                    <a:pt x="1439803" y="1146005"/>
                    <a:pt x="1438436" y="1140095"/>
                  </a:cubicBezTo>
                  <a:cubicBezTo>
                    <a:pt x="1437559" y="1136353"/>
                    <a:pt x="1440680" y="1133429"/>
                    <a:pt x="1442048" y="1130159"/>
                  </a:cubicBezTo>
                  <a:cubicBezTo>
                    <a:pt x="1449099" y="1113652"/>
                    <a:pt x="1436015" y="1111735"/>
                    <a:pt x="1440365" y="1100069"/>
                  </a:cubicBezTo>
                  <a:cubicBezTo>
                    <a:pt x="1443206" y="1092398"/>
                    <a:pt x="1452045" y="1087242"/>
                    <a:pt x="1455448" y="1079161"/>
                  </a:cubicBezTo>
                  <a:cubicBezTo>
                    <a:pt x="1457868" y="1073344"/>
                    <a:pt x="1457868" y="1066899"/>
                    <a:pt x="1460534" y="1061145"/>
                  </a:cubicBezTo>
                  <a:cubicBezTo>
                    <a:pt x="1462182" y="1057561"/>
                    <a:pt x="1463305" y="1053851"/>
                    <a:pt x="1464918" y="1050424"/>
                  </a:cubicBezTo>
                  <a:cubicBezTo>
                    <a:pt x="1467725" y="1044419"/>
                    <a:pt x="1475056" y="1040834"/>
                    <a:pt x="1477792" y="1034452"/>
                  </a:cubicBezTo>
                  <a:cubicBezTo>
                    <a:pt x="1479125" y="1031402"/>
                    <a:pt x="1479405" y="1028100"/>
                    <a:pt x="1479896" y="1024862"/>
                  </a:cubicBezTo>
                  <a:cubicBezTo>
                    <a:pt x="1483088" y="1004174"/>
                    <a:pt x="1479581" y="996628"/>
                    <a:pt x="1472284" y="977543"/>
                  </a:cubicBezTo>
                  <a:cubicBezTo>
                    <a:pt x="1470987" y="974178"/>
                    <a:pt x="1471092" y="970500"/>
                    <a:pt x="1469303" y="967262"/>
                  </a:cubicBezTo>
                  <a:cubicBezTo>
                    <a:pt x="1467163" y="963457"/>
                    <a:pt x="1464006" y="959527"/>
                    <a:pt x="1461270" y="956037"/>
                  </a:cubicBezTo>
                  <a:lnTo>
                    <a:pt x="1455448" y="954182"/>
                  </a:lnTo>
                  <a:lnTo>
                    <a:pt x="1450326" y="955502"/>
                  </a:lnTo>
                  <a:cubicBezTo>
                    <a:pt x="1446854" y="959841"/>
                    <a:pt x="1444855" y="972984"/>
                    <a:pt x="1440365" y="975122"/>
                  </a:cubicBezTo>
                  <a:cubicBezTo>
                    <a:pt x="1437944" y="976254"/>
                    <a:pt x="1435138" y="976694"/>
                    <a:pt x="1432753" y="977952"/>
                  </a:cubicBezTo>
                  <a:cubicBezTo>
                    <a:pt x="1423072" y="983045"/>
                    <a:pt x="1417705" y="992760"/>
                    <a:pt x="1410234" y="999961"/>
                  </a:cubicBezTo>
                  <a:cubicBezTo>
                    <a:pt x="1405463" y="1004488"/>
                    <a:pt x="1400412" y="1008795"/>
                    <a:pt x="1395887" y="1013543"/>
                  </a:cubicBezTo>
                  <a:cubicBezTo>
                    <a:pt x="1389959" y="1019737"/>
                    <a:pt x="1385995" y="1025459"/>
                    <a:pt x="1377647" y="1029484"/>
                  </a:cubicBezTo>
                  <a:cubicBezTo>
                    <a:pt x="1371298" y="1032565"/>
                    <a:pt x="1353269" y="1029421"/>
                    <a:pt x="1346534" y="1027126"/>
                  </a:cubicBezTo>
                  <a:cubicBezTo>
                    <a:pt x="1341308" y="1025365"/>
                    <a:pt x="1323874" y="1014109"/>
                    <a:pt x="1320542" y="1010148"/>
                  </a:cubicBezTo>
                  <a:cubicBezTo>
                    <a:pt x="1317455" y="1006500"/>
                    <a:pt x="1314474" y="997194"/>
                    <a:pt x="1314474" y="992635"/>
                  </a:cubicBezTo>
                  <a:cubicBezTo>
                    <a:pt x="1314474" y="990245"/>
                    <a:pt x="1316859" y="977197"/>
                    <a:pt x="1317876" y="975373"/>
                  </a:cubicBezTo>
                  <a:cubicBezTo>
                    <a:pt x="1323278" y="965564"/>
                    <a:pt x="1349059" y="963646"/>
                    <a:pt x="1351164" y="946604"/>
                  </a:cubicBezTo>
                  <a:cubicBezTo>
                    <a:pt x="1352708" y="934091"/>
                    <a:pt x="1342220" y="931733"/>
                    <a:pt x="1335380" y="924124"/>
                  </a:cubicBezTo>
                  <a:cubicBezTo>
                    <a:pt x="1321630" y="908938"/>
                    <a:pt x="1332468" y="886363"/>
                    <a:pt x="1325172" y="873157"/>
                  </a:cubicBezTo>
                  <a:cubicBezTo>
                    <a:pt x="1320858" y="865360"/>
                    <a:pt x="1306757" y="861273"/>
                    <a:pt x="1305950" y="852218"/>
                  </a:cubicBezTo>
                  <a:cubicBezTo>
                    <a:pt x="1305354" y="845426"/>
                    <a:pt x="1314755" y="836780"/>
                    <a:pt x="1315421" y="826876"/>
                  </a:cubicBezTo>
                  <a:cubicBezTo>
                    <a:pt x="1316544" y="810306"/>
                    <a:pt x="1312334" y="784965"/>
                    <a:pt x="1311282" y="767766"/>
                  </a:cubicBezTo>
                  <a:cubicBezTo>
                    <a:pt x="1311036" y="763333"/>
                    <a:pt x="1311808" y="758900"/>
                    <a:pt x="1311282" y="754435"/>
                  </a:cubicBezTo>
                  <a:cubicBezTo>
                    <a:pt x="1310896" y="751134"/>
                    <a:pt x="1310089" y="747864"/>
                    <a:pt x="1310335" y="744531"/>
                  </a:cubicBezTo>
                  <a:cubicBezTo>
                    <a:pt x="1312685" y="711140"/>
                    <a:pt x="1354286" y="693124"/>
                    <a:pt x="1357724" y="662406"/>
                  </a:cubicBezTo>
                  <a:cubicBezTo>
                    <a:pt x="1359863" y="643604"/>
                    <a:pt x="1354461" y="624771"/>
                    <a:pt x="1357724" y="605937"/>
                  </a:cubicBezTo>
                  <a:cubicBezTo>
                    <a:pt x="1359582" y="595122"/>
                    <a:pt x="1370386" y="584966"/>
                    <a:pt x="1367194" y="573270"/>
                  </a:cubicBezTo>
                  <a:cubicBezTo>
                    <a:pt x="1365651" y="567548"/>
                    <a:pt x="1362459" y="561920"/>
                    <a:pt x="1360880" y="556009"/>
                  </a:cubicBezTo>
                  <a:cubicBezTo>
                    <a:pt x="1359267" y="549972"/>
                    <a:pt x="1359442" y="543841"/>
                    <a:pt x="1356040" y="538244"/>
                  </a:cubicBezTo>
                  <a:cubicBezTo>
                    <a:pt x="1352006" y="531610"/>
                    <a:pt x="1346254" y="526360"/>
                    <a:pt x="1344359" y="518625"/>
                  </a:cubicBezTo>
                  <a:cubicBezTo>
                    <a:pt x="1343412" y="514758"/>
                    <a:pt x="1341974" y="510450"/>
                    <a:pt x="1341272" y="506583"/>
                  </a:cubicBezTo>
                  <a:cubicBezTo>
                    <a:pt x="1340536" y="502590"/>
                    <a:pt x="1342325" y="498377"/>
                    <a:pt x="1341939" y="494321"/>
                  </a:cubicBezTo>
                  <a:cubicBezTo>
                    <a:pt x="1340922" y="483756"/>
                    <a:pt x="1336397" y="469388"/>
                    <a:pt x="1343623" y="459547"/>
                  </a:cubicBezTo>
                  <a:cubicBezTo>
                    <a:pt x="1346990" y="454956"/>
                    <a:pt x="1349971" y="451938"/>
                    <a:pt x="1352602" y="446718"/>
                  </a:cubicBezTo>
                  <a:cubicBezTo>
                    <a:pt x="1355093" y="441845"/>
                    <a:pt x="1356531" y="436406"/>
                    <a:pt x="1360635" y="432350"/>
                  </a:cubicBezTo>
                  <a:cubicBezTo>
                    <a:pt x="1364599" y="428420"/>
                    <a:pt x="1379717" y="420874"/>
                    <a:pt x="1380804" y="418736"/>
                  </a:cubicBezTo>
                  <a:cubicBezTo>
                    <a:pt x="1384978" y="410655"/>
                    <a:pt x="1386907" y="385314"/>
                    <a:pt x="1385925" y="376384"/>
                  </a:cubicBezTo>
                  <a:cubicBezTo>
                    <a:pt x="1385154" y="369593"/>
                    <a:pt x="1383330" y="363745"/>
                    <a:pt x="1383961" y="356796"/>
                  </a:cubicBezTo>
                  <a:cubicBezTo>
                    <a:pt x="1384663" y="349313"/>
                    <a:pt x="1388556" y="342145"/>
                    <a:pt x="1387364" y="334567"/>
                  </a:cubicBezTo>
                  <a:cubicBezTo>
                    <a:pt x="1385364" y="321582"/>
                    <a:pt x="1374911" y="309508"/>
                    <a:pt x="1369895" y="297435"/>
                  </a:cubicBezTo>
                  <a:cubicBezTo>
                    <a:pt x="1365125" y="286022"/>
                    <a:pt x="1360565" y="274483"/>
                    <a:pt x="1356250" y="262912"/>
                  </a:cubicBezTo>
                  <a:cubicBezTo>
                    <a:pt x="1354707" y="258699"/>
                    <a:pt x="1351936" y="254769"/>
                    <a:pt x="1350919" y="250367"/>
                  </a:cubicBezTo>
                  <a:cubicBezTo>
                    <a:pt x="1350147" y="247003"/>
                    <a:pt x="1349480" y="244739"/>
                    <a:pt x="1348253" y="241501"/>
                  </a:cubicBezTo>
                  <a:cubicBezTo>
                    <a:pt x="1344605" y="231817"/>
                    <a:pt x="1345622" y="222322"/>
                    <a:pt x="1344850" y="212480"/>
                  </a:cubicBezTo>
                  <a:cubicBezTo>
                    <a:pt x="1344114" y="202923"/>
                    <a:pt x="1339694" y="194150"/>
                    <a:pt x="1338782" y="185001"/>
                  </a:cubicBezTo>
                  <a:cubicBezTo>
                    <a:pt x="1337203" y="169406"/>
                    <a:pt x="1340501" y="153968"/>
                    <a:pt x="1339484" y="138468"/>
                  </a:cubicBezTo>
                  <a:cubicBezTo>
                    <a:pt x="1338852" y="128721"/>
                    <a:pt x="1335625" y="117999"/>
                    <a:pt x="1337800" y="108410"/>
                  </a:cubicBezTo>
                  <a:cubicBezTo>
                    <a:pt x="1341097" y="93632"/>
                    <a:pt x="1353128" y="89419"/>
                    <a:pt x="1353093" y="80961"/>
                  </a:cubicBezTo>
                  <a:cubicBezTo>
                    <a:pt x="1353093" y="74705"/>
                    <a:pt x="1343342" y="65650"/>
                    <a:pt x="1338852" y="61091"/>
                  </a:cubicBezTo>
                  <a:cubicBezTo>
                    <a:pt x="1336993" y="59204"/>
                    <a:pt x="1335871" y="56846"/>
                    <a:pt x="1333906" y="55085"/>
                  </a:cubicBezTo>
                  <a:cubicBezTo>
                    <a:pt x="1327101" y="48923"/>
                    <a:pt x="1316929" y="43421"/>
                    <a:pt x="1313492" y="34680"/>
                  </a:cubicBezTo>
                  <a:cubicBezTo>
                    <a:pt x="1311071" y="28549"/>
                    <a:pt x="1312404" y="24587"/>
                    <a:pt x="1308370" y="17167"/>
                  </a:cubicBezTo>
                  <a:cubicBezTo>
                    <a:pt x="1304898" y="10753"/>
                    <a:pt x="1299180" y="5691"/>
                    <a:pt x="1294550" y="0"/>
                  </a:cubicBezTo>
                  <a:cubicBezTo>
                    <a:pt x="1288517" y="3270"/>
                    <a:pt x="1278555" y="8615"/>
                    <a:pt x="1272381" y="11633"/>
                  </a:cubicBezTo>
                  <a:cubicBezTo>
                    <a:pt x="1269120" y="13205"/>
                    <a:pt x="1265296" y="14086"/>
                    <a:pt x="1261999" y="15595"/>
                  </a:cubicBezTo>
                  <a:cubicBezTo>
                    <a:pt x="1251406" y="20405"/>
                    <a:pt x="1241795" y="26536"/>
                    <a:pt x="1231622" y="31945"/>
                  </a:cubicBezTo>
                  <a:cubicBezTo>
                    <a:pt x="1230184" y="32699"/>
                    <a:pt x="1228220" y="33076"/>
                    <a:pt x="1226817" y="33925"/>
                  </a:cubicBezTo>
                  <a:cubicBezTo>
                    <a:pt x="1221660" y="36944"/>
                    <a:pt x="1220398" y="41094"/>
                    <a:pt x="1218749" y="42320"/>
                  </a:cubicBezTo>
                  <a:cubicBezTo>
                    <a:pt x="1215698" y="44584"/>
                    <a:pt x="1211173" y="45904"/>
                    <a:pt x="1207945" y="48042"/>
                  </a:cubicBezTo>
                  <a:cubicBezTo>
                    <a:pt x="1203771" y="50778"/>
                    <a:pt x="1196580" y="56123"/>
                    <a:pt x="1194581" y="60650"/>
                  </a:cubicBezTo>
                  <a:cubicBezTo>
                    <a:pt x="1192161" y="66027"/>
                    <a:pt x="1190828" y="72724"/>
                    <a:pt x="1190653" y="78477"/>
                  </a:cubicBezTo>
                  <a:cubicBezTo>
                    <a:pt x="1190582" y="79893"/>
                    <a:pt x="1191319" y="81496"/>
                    <a:pt x="1191319" y="82942"/>
                  </a:cubicBezTo>
                  <a:cubicBezTo>
                    <a:pt x="1191319" y="85835"/>
                    <a:pt x="1190372" y="89419"/>
                    <a:pt x="1189951" y="92343"/>
                  </a:cubicBezTo>
                  <a:lnTo>
                    <a:pt x="1186057" y="96305"/>
                  </a:lnTo>
                  <a:cubicBezTo>
                    <a:pt x="1183076" y="96871"/>
                    <a:pt x="1178902" y="98160"/>
                    <a:pt x="1175920" y="98286"/>
                  </a:cubicBezTo>
                  <a:cubicBezTo>
                    <a:pt x="1171290" y="98443"/>
                    <a:pt x="1158136" y="97688"/>
                    <a:pt x="1153611" y="95802"/>
                  </a:cubicBezTo>
                  <a:cubicBezTo>
                    <a:pt x="1150910" y="92846"/>
                    <a:pt x="1148104" y="89042"/>
                    <a:pt x="1145088" y="86401"/>
                  </a:cubicBezTo>
                  <a:cubicBezTo>
                    <a:pt x="1144491" y="85898"/>
                    <a:pt x="1140668" y="84451"/>
                    <a:pt x="1140037" y="83917"/>
                  </a:cubicBezTo>
                  <a:cubicBezTo>
                    <a:pt x="1136985" y="81402"/>
                    <a:pt x="1134670" y="77314"/>
                    <a:pt x="1131513" y="75019"/>
                  </a:cubicBezTo>
                  <a:cubicBezTo>
                    <a:pt x="1129022" y="73227"/>
                    <a:pt x="1124603" y="72347"/>
                    <a:pt x="1121832" y="70806"/>
                  </a:cubicBezTo>
                  <a:cubicBezTo>
                    <a:pt x="1118464" y="68888"/>
                    <a:pt x="1115553" y="66027"/>
                    <a:pt x="1112186" y="64109"/>
                  </a:cubicBezTo>
                  <a:cubicBezTo>
                    <a:pt x="1110572" y="63197"/>
                    <a:pt x="1108117" y="62977"/>
                    <a:pt x="1106398" y="62128"/>
                  </a:cubicBezTo>
                  <a:cubicBezTo>
                    <a:pt x="1102259" y="60116"/>
                    <a:pt x="1101172" y="56972"/>
                    <a:pt x="1098330" y="54959"/>
                  </a:cubicBezTo>
                  <a:cubicBezTo>
                    <a:pt x="1093560" y="51595"/>
                    <a:pt x="1086053" y="54110"/>
                    <a:pt x="1077424" y="47288"/>
                  </a:cubicBezTo>
                  <a:cubicBezTo>
                    <a:pt x="1070935" y="46942"/>
                    <a:pt x="1061359" y="53136"/>
                    <a:pt x="1056484" y="56217"/>
                  </a:cubicBezTo>
                  <a:cubicBezTo>
                    <a:pt x="1052625" y="61625"/>
                    <a:pt x="1052450" y="70083"/>
                    <a:pt x="1046592" y="74013"/>
                  </a:cubicBezTo>
                  <a:lnTo>
                    <a:pt x="1041716" y="75270"/>
                  </a:lnTo>
                  <a:cubicBezTo>
                    <a:pt x="1034736" y="73384"/>
                    <a:pt x="1027616" y="71120"/>
                    <a:pt x="1020565" y="69548"/>
                  </a:cubicBezTo>
                  <a:cubicBezTo>
                    <a:pt x="1008779" y="66939"/>
                    <a:pt x="996292" y="66058"/>
                    <a:pt x="984892" y="62128"/>
                  </a:cubicBezTo>
                  <a:cubicBezTo>
                    <a:pt x="981173" y="62946"/>
                    <a:pt x="977140" y="64109"/>
                    <a:pt x="973386" y="64612"/>
                  </a:cubicBezTo>
                  <a:cubicBezTo>
                    <a:pt x="969458" y="65146"/>
                    <a:pt x="967108" y="63858"/>
                    <a:pt x="962793" y="65838"/>
                  </a:cubicBezTo>
                  <a:cubicBezTo>
                    <a:pt x="955462" y="65209"/>
                    <a:pt x="952095" y="54834"/>
                    <a:pt x="944378" y="52727"/>
                  </a:cubicBezTo>
                  <a:cubicBezTo>
                    <a:pt x="939818" y="53230"/>
                    <a:pt x="934311" y="53953"/>
                    <a:pt x="930102" y="55714"/>
                  </a:cubicBezTo>
                  <a:cubicBezTo>
                    <a:pt x="925682" y="59078"/>
                    <a:pt x="926208" y="64864"/>
                    <a:pt x="923683" y="69328"/>
                  </a:cubicBezTo>
                  <a:cubicBezTo>
                    <a:pt x="920876" y="74233"/>
                    <a:pt x="916807" y="79515"/>
                    <a:pt x="912844" y="83697"/>
                  </a:cubicBezTo>
                  <a:lnTo>
                    <a:pt x="914106" y="96336"/>
                  </a:lnTo>
                  <a:lnTo>
                    <a:pt x="908670" y="96336"/>
                  </a:lnTo>
                  <a:lnTo>
                    <a:pt x="905057" y="91148"/>
                  </a:lnTo>
                  <a:lnTo>
                    <a:pt x="898568" y="88633"/>
                  </a:lnTo>
                  <a:lnTo>
                    <a:pt x="896533" y="96651"/>
                  </a:lnTo>
                  <a:cubicBezTo>
                    <a:pt x="893622" y="97531"/>
                    <a:pt x="889588" y="94356"/>
                    <a:pt x="887027" y="93475"/>
                  </a:cubicBezTo>
                  <a:cubicBezTo>
                    <a:pt x="883239" y="92155"/>
                    <a:pt x="877907" y="92532"/>
                    <a:pt x="874224" y="90677"/>
                  </a:cubicBezTo>
                  <a:lnTo>
                    <a:pt x="867946" y="85426"/>
                  </a:lnTo>
                  <a:cubicBezTo>
                    <a:pt x="865104" y="80836"/>
                    <a:pt x="862789" y="73698"/>
                    <a:pt x="860579" y="68699"/>
                  </a:cubicBezTo>
                  <a:cubicBezTo>
                    <a:pt x="860299" y="68574"/>
                    <a:pt x="857002" y="67033"/>
                    <a:pt x="856931" y="67033"/>
                  </a:cubicBezTo>
                  <a:cubicBezTo>
                    <a:pt x="851880" y="66750"/>
                    <a:pt x="846058" y="67410"/>
                    <a:pt x="840971" y="67599"/>
                  </a:cubicBezTo>
                  <a:lnTo>
                    <a:pt x="834623" y="59456"/>
                  </a:lnTo>
                  <a:cubicBezTo>
                    <a:pt x="828203" y="59047"/>
                    <a:pt x="821539" y="57852"/>
                    <a:pt x="815330" y="56374"/>
                  </a:cubicBezTo>
                  <a:cubicBezTo>
                    <a:pt x="814874" y="66310"/>
                    <a:pt x="807122" y="68888"/>
                    <a:pt x="803299" y="76748"/>
                  </a:cubicBezTo>
                  <a:lnTo>
                    <a:pt x="797546" y="76245"/>
                  </a:lnTo>
                  <a:cubicBezTo>
                    <a:pt x="792355" y="82408"/>
                    <a:pt x="793582" y="86527"/>
                    <a:pt x="796985" y="93098"/>
                  </a:cubicBezTo>
                  <a:lnTo>
                    <a:pt x="801896" y="102499"/>
                  </a:lnTo>
                  <a:lnTo>
                    <a:pt x="797546" y="106712"/>
                  </a:lnTo>
                  <a:lnTo>
                    <a:pt x="791793" y="107435"/>
                  </a:lnTo>
                  <a:cubicBezTo>
                    <a:pt x="784708" y="105203"/>
                    <a:pt x="779412" y="99009"/>
                    <a:pt x="772186" y="97279"/>
                  </a:cubicBezTo>
                  <a:cubicBezTo>
                    <a:pt x="765276" y="95645"/>
                    <a:pt x="758470" y="101241"/>
                    <a:pt x="751701" y="99040"/>
                  </a:cubicBezTo>
                  <a:cubicBezTo>
                    <a:pt x="746860" y="95676"/>
                    <a:pt x="742020" y="91966"/>
                    <a:pt x="737003" y="88885"/>
                  </a:cubicBezTo>
                  <a:cubicBezTo>
                    <a:pt x="735601" y="88004"/>
                    <a:pt x="733461" y="87658"/>
                    <a:pt x="731953" y="86904"/>
                  </a:cubicBezTo>
                  <a:cubicBezTo>
                    <a:pt x="730374" y="86118"/>
                    <a:pt x="728936" y="84609"/>
                    <a:pt x="727322" y="83917"/>
                  </a:cubicBezTo>
                  <a:cubicBezTo>
                    <a:pt x="721991" y="81685"/>
                    <a:pt x="716133" y="79924"/>
                    <a:pt x="710626" y="77975"/>
                  </a:cubicBezTo>
                  <a:cubicBezTo>
                    <a:pt x="700348" y="78540"/>
                    <a:pt x="695964" y="85583"/>
                    <a:pt x="693508" y="93821"/>
                  </a:cubicBezTo>
                  <a:lnTo>
                    <a:pt x="687721" y="96556"/>
                  </a:lnTo>
                  <a:cubicBezTo>
                    <a:pt x="684669" y="93192"/>
                    <a:pt x="678601" y="88225"/>
                    <a:pt x="673444" y="88130"/>
                  </a:cubicBezTo>
                  <a:cubicBezTo>
                    <a:pt x="670989" y="90991"/>
                    <a:pt x="667481" y="93947"/>
                    <a:pt x="664009" y="95802"/>
                  </a:cubicBezTo>
                  <a:cubicBezTo>
                    <a:pt x="660466" y="95802"/>
                    <a:pt x="656222" y="95424"/>
                    <a:pt x="652749" y="95802"/>
                  </a:cubicBezTo>
                  <a:lnTo>
                    <a:pt x="647453" y="97531"/>
                  </a:lnTo>
                  <a:cubicBezTo>
                    <a:pt x="647242" y="97688"/>
                    <a:pt x="638648" y="105737"/>
                    <a:pt x="638473" y="105957"/>
                  </a:cubicBezTo>
                  <a:lnTo>
                    <a:pt x="637350" y="109919"/>
                  </a:lnTo>
                  <a:cubicBezTo>
                    <a:pt x="637350" y="110139"/>
                    <a:pt x="639665" y="117874"/>
                    <a:pt x="639876" y="118597"/>
                  </a:cubicBezTo>
                  <a:cubicBezTo>
                    <a:pt x="637420" y="124036"/>
                    <a:pt x="631352" y="126897"/>
                    <a:pt x="627423" y="131205"/>
                  </a:cubicBezTo>
                  <a:cubicBezTo>
                    <a:pt x="626336" y="132399"/>
                    <a:pt x="625670" y="137179"/>
                    <a:pt x="621215" y="139631"/>
                  </a:cubicBezTo>
                  <a:cubicBezTo>
                    <a:pt x="613393" y="144002"/>
                    <a:pt x="603957" y="143278"/>
                    <a:pt x="595924" y="146580"/>
                  </a:cubicBezTo>
                  <a:cubicBezTo>
                    <a:pt x="590032" y="152271"/>
                    <a:pt x="591189" y="159785"/>
                    <a:pt x="582350" y="163904"/>
                  </a:cubicBezTo>
                  <a:cubicBezTo>
                    <a:pt x="581122" y="164470"/>
                    <a:pt x="575685" y="164941"/>
                    <a:pt x="572668" y="166388"/>
                  </a:cubicBezTo>
                  <a:cubicBezTo>
                    <a:pt x="570915" y="169249"/>
                    <a:pt x="566670" y="172361"/>
                    <a:pt x="563443" y="173808"/>
                  </a:cubicBezTo>
                  <a:cubicBezTo>
                    <a:pt x="562637" y="174185"/>
                    <a:pt x="559234" y="174688"/>
                    <a:pt x="558603" y="175034"/>
                  </a:cubicBezTo>
                  <a:lnTo>
                    <a:pt x="553552" y="178996"/>
                  </a:lnTo>
                  <a:cubicBezTo>
                    <a:pt x="550886" y="183209"/>
                    <a:pt x="549974" y="188648"/>
                    <a:pt x="547343" y="192861"/>
                  </a:cubicBezTo>
                  <a:cubicBezTo>
                    <a:pt x="545940" y="195125"/>
                    <a:pt x="539591" y="198363"/>
                    <a:pt x="536750" y="198804"/>
                  </a:cubicBezTo>
                  <a:lnTo>
                    <a:pt x="533067" y="203017"/>
                  </a:lnTo>
                  <a:cubicBezTo>
                    <a:pt x="533874" y="207199"/>
                    <a:pt x="530155" y="221033"/>
                    <a:pt x="527525" y="224554"/>
                  </a:cubicBezTo>
                  <a:lnTo>
                    <a:pt x="522263" y="227510"/>
                  </a:lnTo>
                  <a:lnTo>
                    <a:pt x="517878" y="240652"/>
                  </a:lnTo>
                  <a:lnTo>
                    <a:pt x="520860" y="244614"/>
                  </a:lnTo>
                  <a:lnTo>
                    <a:pt x="531699" y="247820"/>
                  </a:lnTo>
                  <a:cubicBezTo>
                    <a:pt x="535557" y="249927"/>
                    <a:pt x="538153" y="257536"/>
                    <a:pt x="538363" y="261183"/>
                  </a:cubicBezTo>
                  <a:cubicBezTo>
                    <a:pt x="538433" y="262598"/>
                    <a:pt x="536504" y="273885"/>
                    <a:pt x="535347" y="275301"/>
                  </a:cubicBezTo>
                  <a:cubicBezTo>
                    <a:pt x="533207" y="278004"/>
                    <a:pt x="529454" y="280803"/>
                    <a:pt x="526858" y="283223"/>
                  </a:cubicBezTo>
                  <a:cubicBezTo>
                    <a:pt x="525561" y="291713"/>
                    <a:pt x="519176" y="304384"/>
                    <a:pt x="507531" y="303283"/>
                  </a:cubicBezTo>
                  <a:cubicBezTo>
                    <a:pt x="501147" y="302686"/>
                    <a:pt x="492167" y="299825"/>
                    <a:pt x="485888" y="301051"/>
                  </a:cubicBezTo>
                  <a:cubicBezTo>
                    <a:pt x="482556" y="304258"/>
                    <a:pt x="475541" y="310357"/>
                    <a:pt x="470665" y="311710"/>
                  </a:cubicBezTo>
                  <a:cubicBezTo>
                    <a:pt x="465474" y="310735"/>
                    <a:pt x="460037" y="309414"/>
                    <a:pt x="454810" y="308722"/>
                  </a:cubicBezTo>
                  <a:cubicBezTo>
                    <a:pt x="448917" y="307968"/>
                    <a:pt x="443621" y="312024"/>
                    <a:pt x="439850" y="315671"/>
                  </a:cubicBezTo>
                  <a:lnTo>
                    <a:pt x="434792" y="312433"/>
                  </a:lnTo>
                  <a:cubicBezTo>
                    <a:pt x="433105" y="309414"/>
                    <a:pt x="433326" y="306522"/>
                    <a:pt x="432263" y="303535"/>
                  </a:cubicBezTo>
                  <a:cubicBezTo>
                    <a:pt x="431141" y="300359"/>
                    <a:pt x="429008" y="297844"/>
                    <a:pt x="428345" y="294354"/>
                  </a:cubicBezTo>
                  <a:cubicBezTo>
                    <a:pt x="424325" y="290078"/>
                    <a:pt x="416591" y="286808"/>
                    <a:pt x="414086" y="284230"/>
                  </a:cubicBezTo>
                  <a:cubicBezTo>
                    <a:pt x="413897" y="284041"/>
                    <a:pt x="403738" y="270050"/>
                    <a:pt x="403489" y="269610"/>
                  </a:cubicBezTo>
                  <a:cubicBezTo>
                    <a:pt x="403419" y="269484"/>
                    <a:pt x="403075" y="265553"/>
                    <a:pt x="403033" y="265145"/>
                  </a:cubicBezTo>
                  <a:cubicBezTo>
                    <a:pt x="400066" y="263981"/>
                    <a:pt x="396148" y="263195"/>
                    <a:pt x="392893" y="263164"/>
                  </a:cubicBezTo>
                  <a:cubicBezTo>
                    <a:pt x="391009" y="260429"/>
                    <a:pt x="386386" y="257064"/>
                    <a:pt x="383008" y="255996"/>
                  </a:cubicBezTo>
                  <a:cubicBezTo>
                    <a:pt x="382089" y="255712"/>
                    <a:pt x="378806" y="255807"/>
                    <a:pt x="377953" y="255492"/>
                  </a:cubicBezTo>
                  <a:cubicBezTo>
                    <a:pt x="374937" y="254455"/>
                    <a:pt x="371601" y="252443"/>
                    <a:pt x="368721" y="251028"/>
                  </a:cubicBezTo>
                  <a:lnTo>
                    <a:pt x="359745" y="260209"/>
                  </a:lnTo>
                  <a:lnTo>
                    <a:pt x="362274" y="269610"/>
                  </a:lnTo>
                  <a:lnTo>
                    <a:pt x="356988" y="271842"/>
                  </a:lnTo>
                  <a:lnTo>
                    <a:pt x="346623" y="270364"/>
                  </a:lnTo>
                  <a:lnTo>
                    <a:pt x="342498" y="275049"/>
                  </a:lnTo>
                  <a:cubicBezTo>
                    <a:pt x="343290" y="277910"/>
                    <a:pt x="344637" y="281306"/>
                    <a:pt x="345030" y="284230"/>
                  </a:cubicBezTo>
                  <a:cubicBezTo>
                    <a:pt x="345111" y="284858"/>
                    <a:pt x="344227" y="288097"/>
                    <a:pt x="344322" y="288663"/>
                  </a:cubicBezTo>
                  <a:cubicBezTo>
                    <a:pt x="344813" y="291618"/>
                    <a:pt x="346398" y="295171"/>
                    <a:pt x="347328" y="298096"/>
                  </a:cubicBezTo>
                  <a:lnTo>
                    <a:pt x="342017" y="301554"/>
                  </a:lnTo>
                  <a:cubicBezTo>
                    <a:pt x="336798" y="300328"/>
                    <a:pt x="331417" y="298787"/>
                    <a:pt x="326138" y="297844"/>
                  </a:cubicBezTo>
                  <a:cubicBezTo>
                    <a:pt x="321241" y="296963"/>
                    <a:pt x="315064" y="297812"/>
                    <a:pt x="310967" y="294605"/>
                  </a:cubicBezTo>
                  <a:cubicBezTo>
                    <a:pt x="300788" y="297844"/>
                    <a:pt x="287950" y="283255"/>
                    <a:pt x="280117" y="285456"/>
                  </a:cubicBezTo>
                  <a:lnTo>
                    <a:pt x="277132" y="290392"/>
                  </a:lnTo>
                  <a:cubicBezTo>
                    <a:pt x="271856" y="293851"/>
                    <a:pt x="266349" y="291964"/>
                    <a:pt x="261709" y="297089"/>
                  </a:cubicBezTo>
                  <a:lnTo>
                    <a:pt x="258471" y="305767"/>
                  </a:lnTo>
                  <a:cubicBezTo>
                    <a:pt x="255433" y="307716"/>
                    <a:pt x="251140" y="309603"/>
                    <a:pt x="247422" y="310200"/>
                  </a:cubicBezTo>
                  <a:lnTo>
                    <a:pt x="244893" y="314665"/>
                  </a:lnTo>
                  <a:lnTo>
                    <a:pt x="239607" y="315419"/>
                  </a:lnTo>
                  <a:lnTo>
                    <a:pt x="236369" y="306270"/>
                  </a:lnTo>
                  <a:cubicBezTo>
                    <a:pt x="232107" y="302434"/>
                    <a:pt x="226443" y="299762"/>
                    <a:pt x="220515" y="298819"/>
                  </a:cubicBezTo>
                  <a:cubicBezTo>
                    <a:pt x="220065" y="299290"/>
                    <a:pt x="216295" y="303032"/>
                    <a:pt x="216140" y="303283"/>
                  </a:cubicBezTo>
                  <a:cubicBezTo>
                    <a:pt x="215944" y="303598"/>
                    <a:pt x="215207" y="307088"/>
                    <a:pt x="214979" y="307748"/>
                  </a:cubicBezTo>
                  <a:cubicBezTo>
                    <a:pt x="214474" y="309131"/>
                    <a:pt x="213183" y="310798"/>
                    <a:pt x="212903" y="312181"/>
                  </a:cubicBezTo>
                  <a:cubicBezTo>
                    <a:pt x="212412" y="314633"/>
                    <a:pt x="213226" y="318501"/>
                    <a:pt x="212447" y="321834"/>
                  </a:cubicBezTo>
                  <a:cubicBezTo>
                    <a:pt x="209420" y="323972"/>
                    <a:pt x="206259" y="326864"/>
                    <a:pt x="204179" y="329788"/>
                  </a:cubicBezTo>
                  <a:cubicBezTo>
                    <a:pt x="204260" y="346044"/>
                    <a:pt x="194663" y="348213"/>
                    <a:pt x="193582" y="357268"/>
                  </a:cubicBezTo>
                  <a:cubicBezTo>
                    <a:pt x="194372" y="361198"/>
                    <a:pt x="201604" y="367235"/>
                    <a:pt x="205088" y="369625"/>
                  </a:cubicBezTo>
                  <a:cubicBezTo>
                    <a:pt x="206603" y="370662"/>
                    <a:pt x="208672" y="371291"/>
                    <a:pt x="210142" y="372360"/>
                  </a:cubicBezTo>
                  <a:cubicBezTo>
                    <a:pt x="215488" y="376259"/>
                    <a:pt x="228330" y="384716"/>
                    <a:pt x="228326" y="391916"/>
                  </a:cubicBezTo>
                  <a:lnTo>
                    <a:pt x="222815" y="395123"/>
                  </a:lnTo>
                  <a:cubicBezTo>
                    <a:pt x="217849" y="393992"/>
                    <a:pt x="215235" y="395784"/>
                    <a:pt x="211535" y="395626"/>
                  </a:cubicBezTo>
                  <a:cubicBezTo>
                    <a:pt x="206585" y="395406"/>
                    <a:pt x="204607" y="392357"/>
                    <a:pt x="200938" y="390439"/>
                  </a:cubicBezTo>
                  <a:cubicBezTo>
                    <a:pt x="199433" y="389621"/>
                    <a:pt x="197255" y="389369"/>
                    <a:pt x="195655" y="388678"/>
                  </a:cubicBezTo>
                  <a:cubicBezTo>
                    <a:pt x="190243" y="386351"/>
                    <a:pt x="185185" y="381918"/>
                    <a:pt x="181137" y="378051"/>
                  </a:cubicBezTo>
                  <a:lnTo>
                    <a:pt x="176307" y="377799"/>
                  </a:lnTo>
                  <a:cubicBezTo>
                    <a:pt x="173276" y="379686"/>
                    <a:pt x="169909" y="383113"/>
                    <a:pt x="168496" y="386225"/>
                  </a:cubicBezTo>
                  <a:lnTo>
                    <a:pt x="152374" y="388206"/>
                  </a:lnTo>
                  <a:cubicBezTo>
                    <a:pt x="148446" y="384779"/>
                    <a:pt x="147972" y="381792"/>
                    <a:pt x="145931" y="379528"/>
                  </a:cubicBezTo>
                  <a:cubicBezTo>
                    <a:pt x="143721" y="377076"/>
                    <a:pt x="138842" y="374246"/>
                    <a:pt x="135355" y="373586"/>
                  </a:cubicBezTo>
                  <a:lnTo>
                    <a:pt x="130055" y="376321"/>
                  </a:lnTo>
                  <a:cubicBezTo>
                    <a:pt x="126280" y="380598"/>
                    <a:pt x="127014" y="386225"/>
                    <a:pt x="122913" y="390187"/>
                  </a:cubicBezTo>
                  <a:lnTo>
                    <a:pt x="124074" y="399337"/>
                  </a:lnTo>
                  <a:cubicBezTo>
                    <a:pt x="121208" y="400091"/>
                    <a:pt x="116403" y="399777"/>
                    <a:pt x="113709" y="398582"/>
                  </a:cubicBezTo>
                  <a:cubicBezTo>
                    <a:pt x="111513" y="400437"/>
                    <a:pt x="109198" y="404744"/>
                    <a:pt x="109552" y="407511"/>
                  </a:cubicBezTo>
                  <a:lnTo>
                    <a:pt x="104273" y="411473"/>
                  </a:lnTo>
                  <a:cubicBezTo>
                    <a:pt x="97805" y="412322"/>
                    <a:pt x="89053" y="411127"/>
                    <a:pt x="83097" y="408737"/>
                  </a:cubicBezTo>
                  <a:cubicBezTo>
                    <a:pt x="73813" y="410121"/>
                    <a:pt x="71799" y="416975"/>
                    <a:pt x="66555" y="422603"/>
                  </a:cubicBezTo>
                  <a:lnTo>
                    <a:pt x="70161" y="424490"/>
                  </a:lnTo>
                  <a:cubicBezTo>
                    <a:pt x="73006" y="424772"/>
                    <a:pt x="77829" y="422037"/>
                    <a:pt x="79706" y="420371"/>
                  </a:cubicBezTo>
                  <a:cubicBezTo>
                    <a:pt x="84009" y="420496"/>
                    <a:pt x="93112" y="422194"/>
                    <a:pt x="96251" y="425276"/>
                  </a:cubicBezTo>
                  <a:lnTo>
                    <a:pt x="99759" y="431941"/>
                  </a:lnTo>
                  <a:cubicBezTo>
                    <a:pt x="103140" y="431878"/>
                    <a:pt x="109644" y="433104"/>
                    <a:pt x="112169" y="435368"/>
                  </a:cubicBezTo>
                  <a:lnTo>
                    <a:pt x="111047" y="444235"/>
                  </a:lnTo>
                  <a:lnTo>
                    <a:pt x="115659" y="447536"/>
                  </a:lnTo>
                  <a:lnTo>
                    <a:pt x="117297" y="451592"/>
                  </a:lnTo>
                  <a:cubicBezTo>
                    <a:pt x="113965" y="454862"/>
                    <a:pt x="114505" y="459578"/>
                    <a:pt x="114400" y="463634"/>
                  </a:cubicBezTo>
                  <a:cubicBezTo>
                    <a:pt x="114396" y="463854"/>
                    <a:pt x="112281" y="466621"/>
                    <a:pt x="112429" y="468445"/>
                  </a:cubicBezTo>
                  <a:cubicBezTo>
                    <a:pt x="112660" y="471369"/>
                    <a:pt x="112418" y="474356"/>
                    <a:pt x="112246" y="477311"/>
                  </a:cubicBezTo>
                  <a:cubicBezTo>
                    <a:pt x="109542" y="477563"/>
                    <a:pt x="105606" y="479858"/>
                    <a:pt x="104361" y="482058"/>
                  </a:cubicBezTo>
                  <a:lnTo>
                    <a:pt x="103702" y="488944"/>
                  </a:lnTo>
                  <a:lnTo>
                    <a:pt x="101678" y="490831"/>
                  </a:lnTo>
                  <a:lnTo>
                    <a:pt x="97051" y="488347"/>
                  </a:lnTo>
                  <a:lnTo>
                    <a:pt x="98093" y="482719"/>
                  </a:lnTo>
                  <a:cubicBezTo>
                    <a:pt x="96479" y="480895"/>
                    <a:pt x="92838" y="475361"/>
                    <a:pt x="93620" y="472815"/>
                  </a:cubicBezTo>
                  <a:lnTo>
                    <a:pt x="89015" y="468885"/>
                  </a:lnTo>
                  <a:cubicBezTo>
                    <a:pt x="85216" y="469136"/>
                    <a:pt x="80656" y="469011"/>
                    <a:pt x="76956" y="468099"/>
                  </a:cubicBezTo>
                  <a:lnTo>
                    <a:pt x="75058" y="464640"/>
                  </a:lnTo>
                  <a:lnTo>
                    <a:pt x="76956" y="459075"/>
                  </a:lnTo>
                  <a:lnTo>
                    <a:pt x="76296" y="456717"/>
                  </a:lnTo>
                  <a:lnTo>
                    <a:pt x="71034" y="452567"/>
                  </a:lnTo>
                  <a:cubicBezTo>
                    <a:pt x="71824" y="449611"/>
                    <a:pt x="70729" y="444832"/>
                    <a:pt x="69281" y="442160"/>
                  </a:cubicBezTo>
                  <a:lnTo>
                    <a:pt x="66801" y="442914"/>
                  </a:lnTo>
                  <a:cubicBezTo>
                    <a:pt x="64531" y="449108"/>
                    <a:pt x="59231" y="454013"/>
                    <a:pt x="57084" y="460238"/>
                  </a:cubicBezTo>
                  <a:lnTo>
                    <a:pt x="51328" y="463194"/>
                  </a:lnTo>
                  <a:lnTo>
                    <a:pt x="46025" y="462722"/>
                  </a:lnTo>
                  <a:lnTo>
                    <a:pt x="42580" y="467155"/>
                  </a:lnTo>
                  <a:cubicBezTo>
                    <a:pt x="42198" y="470645"/>
                    <a:pt x="47845" y="477657"/>
                    <a:pt x="50178" y="480047"/>
                  </a:cubicBezTo>
                  <a:lnTo>
                    <a:pt x="48105" y="484008"/>
                  </a:lnTo>
                  <a:cubicBezTo>
                    <a:pt x="45106" y="483285"/>
                    <a:pt x="40044" y="484731"/>
                    <a:pt x="37750" y="486492"/>
                  </a:cubicBezTo>
                  <a:cubicBezTo>
                    <a:pt x="34747" y="486586"/>
                    <a:pt x="30026" y="484480"/>
                    <a:pt x="27851" y="482782"/>
                  </a:cubicBezTo>
                  <a:cubicBezTo>
                    <a:pt x="22334" y="483348"/>
                    <a:pt x="20611" y="486460"/>
                    <a:pt x="16816" y="487718"/>
                  </a:cubicBezTo>
                  <a:cubicBezTo>
                    <a:pt x="11604" y="489416"/>
                    <a:pt x="5693" y="488504"/>
                    <a:pt x="1158" y="492183"/>
                  </a:cubicBezTo>
                  <a:cubicBezTo>
                    <a:pt x="1053" y="492592"/>
                    <a:pt x="-21" y="496490"/>
                    <a:pt x="0" y="496616"/>
                  </a:cubicBezTo>
                  <a:cubicBezTo>
                    <a:pt x="25" y="496836"/>
                    <a:pt x="2687" y="505168"/>
                    <a:pt x="2757" y="505294"/>
                  </a:cubicBezTo>
                  <a:cubicBezTo>
                    <a:pt x="4490" y="508249"/>
                    <a:pt x="14280" y="513060"/>
                    <a:pt x="17504" y="514223"/>
                  </a:cubicBezTo>
                  <a:lnTo>
                    <a:pt x="20496" y="518656"/>
                  </a:lnTo>
                  <a:cubicBezTo>
                    <a:pt x="23639" y="518940"/>
                    <a:pt x="27855" y="517996"/>
                    <a:pt x="30619" y="516675"/>
                  </a:cubicBezTo>
                  <a:cubicBezTo>
                    <a:pt x="36736" y="521675"/>
                    <a:pt x="47231" y="516267"/>
                    <a:pt x="56625" y="524096"/>
                  </a:cubicBezTo>
                  <a:cubicBezTo>
                    <a:pt x="68786" y="534251"/>
                    <a:pt x="58354" y="543684"/>
                    <a:pt x="68835" y="551104"/>
                  </a:cubicBezTo>
                  <a:cubicBezTo>
                    <a:pt x="72462" y="552456"/>
                    <a:pt x="79958" y="554531"/>
                    <a:pt x="84013" y="553808"/>
                  </a:cubicBezTo>
                  <a:lnTo>
                    <a:pt x="87464" y="558021"/>
                  </a:lnTo>
                  <a:cubicBezTo>
                    <a:pt x="85321" y="567265"/>
                    <a:pt x="90898" y="568899"/>
                    <a:pt x="91614" y="576100"/>
                  </a:cubicBezTo>
                  <a:cubicBezTo>
                    <a:pt x="86752" y="577515"/>
                    <a:pt x="84265" y="580721"/>
                    <a:pt x="80568" y="582294"/>
                  </a:cubicBezTo>
                  <a:cubicBezTo>
                    <a:pt x="76047" y="584180"/>
                    <a:pt x="69435" y="585249"/>
                    <a:pt x="64444" y="586255"/>
                  </a:cubicBezTo>
                  <a:cubicBezTo>
                    <a:pt x="63816" y="592355"/>
                    <a:pt x="70080" y="597668"/>
                    <a:pt x="71361" y="603579"/>
                  </a:cubicBezTo>
                  <a:cubicBezTo>
                    <a:pt x="65769" y="613358"/>
                    <a:pt x="70329" y="615967"/>
                    <a:pt x="68365" y="621155"/>
                  </a:cubicBezTo>
                  <a:cubicBezTo>
                    <a:pt x="67155" y="624362"/>
                    <a:pt x="63935" y="627097"/>
                    <a:pt x="63752" y="630808"/>
                  </a:cubicBezTo>
                  <a:cubicBezTo>
                    <a:pt x="63728" y="631279"/>
                    <a:pt x="64812" y="634518"/>
                    <a:pt x="64903" y="635272"/>
                  </a:cubicBezTo>
                  <a:cubicBezTo>
                    <a:pt x="65096" y="636845"/>
                    <a:pt x="64622" y="638668"/>
                    <a:pt x="64903" y="640209"/>
                  </a:cubicBezTo>
                  <a:cubicBezTo>
                    <a:pt x="65387" y="642881"/>
                    <a:pt x="67821" y="646402"/>
                    <a:pt x="69758" y="648383"/>
                  </a:cubicBezTo>
                  <a:cubicBezTo>
                    <a:pt x="71894" y="654452"/>
                    <a:pt x="63875" y="662280"/>
                    <a:pt x="59617" y="665959"/>
                  </a:cubicBezTo>
                  <a:lnTo>
                    <a:pt x="54559" y="666714"/>
                  </a:lnTo>
                  <a:lnTo>
                    <a:pt x="56393" y="675863"/>
                  </a:lnTo>
                  <a:lnTo>
                    <a:pt x="66292" y="679573"/>
                  </a:lnTo>
                  <a:cubicBezTo>
                    <a:pt x="66632" y="682497"/>
                    <a:pt x="69179" y="686585"/>
                    <a:pt x="71589" y="688502"/>
                  </a:cubicBezTo>
                  <a:cubicBezTo>
                    <a:pt x="70480" y="695482"/>
                    <a:pt x="73648" y="700828"/>
                    <a:pt x="78032" y="706550"/>
                  </a:cubicBezTo>
                  <a:lnTo>
                    <a:pt x="77885" y="711109"/>
                  </a:lnTo>
                  <a:cubicBezTo>
                    <a:pt x="75503" y="715165"/>
                    <a:pt x="68597" y="719598"/>
                    <a:pt x="63384" y="719567"/>
                  </a:cubicBezTo>
                  <a:lnTo>
                    <a:pt x="55573" y="728496"/>
                  </a:lnTo>
                  <a:lnTo>
                    <a:pt x="45695" y="731703"/>
                  </a:lnTo>
                  <a:cubicBezTo>
                    <a:pt x="44011" y="733747"/>
                    <a:pt x="43096" y="737960"/>
                    <a:pt x="43878" y="740412"/>
                  </a:cubicBezTo>
                  <a:cubicBezTo>
                    <a:pt x="40956" y="741953"/>
                    <a:pt x="37462" y="746449"/>
                    <a:pt x="37452" y="749593"/>
                  </a:cubicBezTo>
                  <a:cubicBezTo>
                    <a:pt x="41044" y="753272"/>
                    <a:pt x="39588" y="758931"/>
                    <a:pt x="40496" y="763270"/>
                  </a:cubicBezTo>
                  <a:cubicBezTo>
                    <a:pt x="40605" y="763773"/>
                    <a:pt x="42324" y="766509"/>
                    <a:pt x="42584" y="767263"/>
                  </a:cubicBezTo>
                  <a:cubicBezTo>
                    <a:pt x="43099" y="768741"/>
                    <a:pt x="43047" y="770470"/>
                    <a:pt x="43534" y="771979"/>
                  </a:cubicBezTo>
                  <a:cubicBezTo>
                    <a:pt x="44502" y="774966"/>
                    <a:pt x="45870" y="777984"/>
                    <a:pt x="47017" y="780940"/>
                  </a:cubicBezTo>
                  <a:cubicBezTo>
                    <a:pt x="51714" y="780783"/>
                    <a:pt x="57326" y="780091"/>
                    <a:pt x="61967" y="780437"/>
                  </a:cubicBezTo>
                  <a:cubicBezTo>
                    <a:pt x="65471" y="780689"/>
                    <a:pt x="67618" y="783644"/>
                    <a:pt x="72336" y="781915"/>
                  </a:cubicBezTo>
                  <a:cubicBezTo>
                    <a:pt x="75110" y="778959"/>
                    <a:pt x="76941" y="772420"/>
                    <a:pt x="77348" y="768709"/>
                  </a:cubicBezTo>
                  <a:cubicBezTo>
                    <a:pt x="80179" y="767483"/>
                    <a:pt x="84230" y="763710"/>
                    <a:pt x="84665" y="760755"/>
                  </a:cubicBezTo>
                  <a:lnTo>
                    <a:pt x="90404" y="758774"/>
                  </a:lnTo>
                  <a:cubicBezTo>
                    <a:pt x="92287" y="762264"/>
                    <a:pt x="93028" y="768678"/>
                    <a:pt x="93224" y="772451"/>
                  </a:cubicBezTo>
                  <a:lnTo>
                    <a:pt x="97840" y="776664"/>
                  </a:lnTo>
                  <a:cubicBezTo>
                    <a:pt x="102347" y="776696"/>
                    <a:pt x="109675" y="778110"/>
                    <a:pt x="113029" y="781129"/>
                  </a:cubicBezTo>
                  <a:cubicBezTo>
                    <a:pt x="114312" y="782292"/>
                    <a:pt x="114961" y="784493"/>
                    <a:pt x="116259" y="785593"/>
                  </a:cubicBezTo>
                  <a:cubicBezTo>
                    <a:pt x="117855" y="787008"/>
                    <a:pt x="124123" y="789492"/>
                    <a:pt x="126407" y="790058"/>
                  </a:cubicBezTo>
                  <a:lnTo>
                    <a:pt x="126203" y="794806"/>
                  </a:lnTo>
                  <a:cubicBezTo>
                    <a:pt x="131781" y="798516"/>
                    <a:pt x="138859" y="802949"/>
                    <a:pt x="146211" y="801471"/>
                  </a:cubicBezTo>
                  <a:cubicBezTo>
                    <a:pt x="151988" y="797950"/>
                    <a:pt x="151929" y="792825"/>
                    <a:pt x="156503" y="788769"/>
                  </a:cubicBezTo>
                  <a:cubicBezTo>
                    <a:pt x="160586" y="787794"/>
                    <a:pt x="164437" y="788737"/>
                    <a:pt x="167275" y="788266"/>
                  </a:cubicBezTo>
                  <a:cubicBezTo>
                    <a:pt x="168699" y="788014"/>
                    <a:pt x="176956" y="785279"/>
                    <a:pt x="177615" y="785248"/>
                  </a:cubicBezTo>
                  <a:cubicBezTo>
                    <a:pt x="178103" y="785248"/>
                    <a:pt x="191194" y="787480"/>
                    <a:pt x="192537" y="787700"/>
                  </a:cubicBezTo>
                  <a:lnTo>
                    <a:pt x="195771" y="791882"/>
                  </a:lnTo>
                  <a:lnTo>
                    <a:pt x="205407" y="794837"/>
                  </a:lnTo>
                  <a:lnTo>
                    <a:pt x="209100" y="799805"/>
                  </a:lnTo>
                  <a:cubicBezTo>
                    <a:pt x="205312" y="802132"/>
                    <a:pt x="197515" y="807791"/>
                    <a:pt x="195596" y="811784"/>
                  </a:cubicBezTo>
                  <a:lnTo>
                    <a:pt x="195371" y="816217"/>
                  </a:lnTo>
                  <a:cubicBezTo>
                    <a:pt x="198321" y="819802"/>
                    <a:pt x="200279" y="824895"/>
                    <a:pt x="199994" y="829391"/>
                  </a:cubicBezTo>
                  <a:cubicBezTo>
                    <a:pt x="202011" y="831435"/>
                    <a:pt x="206831" y="834390"/>
                    <a:pt x="210086" y="834296"/>
                  </a:cubicBezTo>
                  <a:cubicBezTo>
                    <a:pt x="209146" y="837315"/>
                    <a:pt x="212475" y="844420"/>
                    <a:pt x="214004" y="846935"/>
                  </a:cubicBezTo>
                  <a:cubicBezTo>
                    <a:pt x="209700" y="850394"/>
                    <a:pt x="204014" y="852280"/>
                    <a:pt x="198227" y="851997"/>
                  </a:cubicBezTo>
                  <a:cubicBezTo>
                    <a:pt x="196154" y="847941"/>
                    <a:pt x="188809" y="843414"/>
                    <a:pt x="184673" y="841402"/>
                  </a:cubicBezTo>
                  <a:cubicBezTo>
                    <a:pt x="171744" y="835082"/>
                    <a:pt x="162690" y="849891"/>
                    <a:pt x="153090" y="849231"/>
                  </a:cubicBezTo>
                  <a:lnTo>
                    <a:pt x="148754" y="853727"/>
                  </a:lnTo>
                  <a:cubicBezTo>
                    <a:pt x="148733" y="854167"/>
                    <a:pt x="148488" y="858066"/>
                    <a:pt x="148537" y="858223"/>
                  </a:cubicBezTo>
                  <a:cubicBezTo>
                    <a:pt x="149582" y="861335"/>
                    <a:pt x="152009" y="864574"/>
                    <a:pt x="153405" y="867655"/>
                  </a:cubicBezTo>
                  <a:cubicBezTo>
                    <a:pt x="156408" y="874227"/>
                    <a:pt x="158972" y="884319"/>
                    <a:pt x="164030" y="889727"/>
                  </a:cubicBezTo>
                  <a:cubicBezTo>
                    <a:pt x="163630" y="890450"/>
                    <a:pt x="159091" y="898279"/>
                    <a:pt x="159042" y="898468"/>
                  </a:cubicBezTo>
                  <a:cubicBezTo>
                    <a:pt x="158214" y="901958"/>
                    <a:pt x="158734" y="908655"/>
                    <a:pt x="158621" y="912396"/>
                  </a:cubicBezTo>
                  <a:cubicBezTo>
                    <a:pt x="155822" y="915918"/>
                    <a:pt x="147298" y="918779"/>
                    <a:pt x="142847" y="919439"/>
                  </a:cubicBezTo>
                  <a:lnTo>
                    <a:pt x="140806" y="924156"/>
                  </a:lnTo>
                  <a:cubicBezTo>
                    <a:pt x="141693" y="926922"/>
                    <a:pt x="142019" y="930506"/>
                    <a:pt x="141521" y="933368"/>
                  </a:cubicBezTo>
                  <a:cubicBezTo>
                    <a:pt x="125218" y="951101"/>
                    <a:pt x="141504" y="958143"/>
                    <a:pt x="133829" y="968645"/>
                  </a:cubicBezTo>
                  <a:cubicBezTo>
                    <a:pt x="128501" y="970437"/>
                    <a:pt x="128613" y="973361"/>
                    <a:pt x="125579" y="975876"/>
                  </a:cubicBezTo>
                  <a:cubicBezTo>
                    <a:pt x="124264" y="976977"/>
                    <a:pt x="121794" y="977637"/>
                    <a:pt x="120293" y="978612"/>
                  </a:cubicBezTo>
                  <a:cubicBezTo>
                    <a:pt x="118630" y="979681"/>
                    <a:pt x="117175" y="981410"/>
                    <a:pt x="115463" y="982353"/>
                  </a:cubicBezTo>
                  <a:cubicBezTo>
                    <a:pt x="114172" y="983045"/>
                    <a:pt x="111864" y="983579"/>
                    <a:pt x="110405" y="984083"/>
                  </a:cubicBezTo>
                  <a:lnTo>
                    <a:pt x="104880" y="981347"/>
                  </a:lnTo>
                  <a:cubicBezTo>
                    <a:pt x="94182" y="979303"/>
                    <a:pt x="91193" y="992572"/>
                    <a:pt x="82820" y="995496"/>
                  </a:cubicBezTo>
                  <a:cubicBezTo>
                    <a:pt x="79306" y="996754"/>
                    <a:pt x="75917" y="996408"/>
                    <a:pt x="72473" y="998483"/>
                  </a:cubicBezTo>
                  <a:cubicBezTo>
                    <a:pt x="72508" y="1001533"/>
                    <a:pt x="69189" y="1006249"/>
                    <a:pt x="66871" y="1008261"/>
                  </a:cubicBezTo>
                  <a:lnTo>
                    <a:pt x="65100" y="1011185"/>
                  </a:lnTo>
                  <a:lnTo>
                    <a:pt x="64296" y="1015555"/>
                  </a:lnTo>
                  <a:lnTo>
                    <a:pt x="66040" y="1019957"/>
                  </a:lnTo>
                  <a:lnTo>
                    <a:pt x="70715" y="1024265"/>
                  </a:lnTo>
                  <a:lnTo>
                    <a:pt x="71817" y="1025711"/>
                  </a:lnTo>
                  <a:lnTo>
                    <a:pt x="73434" y="1027943"/>
                  </a:lnTo>
                  <a:lnTo>
                    <a:pt x="74584" y="1032628"/>
                  </a:lnTo>
                  <a:lnTo>
                    <a:pt x="77808" y="1037344"/>
                  </a:lnTo>
                  <a:lnTo>
                    <a:pt x="78029" y="1041809"/>
                  </a:lnTo>
                  <a:lnTo>
                    <a:pt x="76654" y="1046242"/>
                  </a:lnTo>
                  <a:lnTo>
                    <a:pt x="81705" y="1048474"/>
                  </a:lnTo>
                  <a:lnTo>
                    <a:pt x="82859" y="1052939"/>
                  </a:lnTo>
                  <a:lnTo>
                    <a:pt x="86079" y="1057152"/>
                  </a:lnTo>
                  <a:lnTo>
                    <a:pt x="86310" y="1061617"/>
                  </a:lnTo>
                  <a:lnTo>
                    <a:pt x="87461" y="1066553"/>
                  </a:lnTo>
                  <a:lnTo>
                    <a:pt x="92063" y="1069508"/>
                  </a:lnTo>
                  <a:lnTo>
                    <a:pt x="92996" y="1073502"/>
                  </a:lnTo>
                  <a:lnTo>
                    <a:pt x="90916" y="1077935"/>
                  </a:lnTo>
                  <a:lnTo>
                    <a:pt x="87008" y="1081897"/>
                  </a:lnTo>
                  <a:lnTo>
                    <a:pt x="76412" y="1086833"/>
                  </a:lnTo>
                  <a:lnTo>
                    <a:pt x="71357" y="1088342"/>
                  </a:lnTo>
                  <a:lnTo>
                    <a:pt x="70424" y="1097743"/>
                  </a:lnTo>
                  <a:lnTo>
                    <a:pt x="73451" y="1103213"/>
                  </a:lnTo>
                  <a:cubicBezTo>
                    <a:pt x="75889" y="1106987"/>
                    <a:pt x="74114" y="1112395"/>
                    <a:pt x="72276" y="1116073"/>
                  </a:cubicBezTo>
                  <a:cubicBezTo>
                    <a:pt x="72301" y="1118903"/>
                    <a:pt x="73813" y="1121230"/>
                    <a:pt x="75573" y="1123399"/>
                  </a:cubicBezTo>
                  <a:cubicBezTo>
                    <a:pt x="79267" y="1127958"/>
                    <a:pt x="86816" y="1127769"/>
                    <a:pt x="92291" y="1126197"/>
                  </a:cubicBezTo>
                  <a:cubicBezTo>
                    <a:pt x="93862" y="1125757"/>
                    <a:pt x="95553" y="1124562"/>
                    <a:pt x="97128" y="1124217"/>
                  </a:cubicBezTo>
                  <a:cubicBezTo>
                    <a:pt x="97440" y="1124154"/>
                    <a:pt x="101597" y="1124217"/>
                    <a:pt x="102183" y="1124217"/>
                  </a:cubicBezTo>
                  <a:cubicBezTo>
                    <a:pt x="102730" y="1127267"/>
                    <a:pt x="105473" y="1131323"/>
                    <a:pt x="107942" y="1133397"/>
                  </a:cubicBezTo>
                  <a:cubicBezTo>
                    <a:pt x="107360" y="1137893"/>
                    <a:pt x="108700" y="1143208"/>
                    <a:pt x="112316" y="1146508"/>
                  </a:cubicBezTo>
                  <a:lnTo>
                    <a:pt x="111166" y="1150973"/>
                  </a:lnTo>
                  <a:lnTo>
                    <a:pt x="106325" y="1155438"/>
                  </a:lnTo>
                  <a:lnTo>
                    <a:pt x="110927" y="1156664"/>
                  </a:lnTo>
                  <a:cubicBezTo>
                    <a:pt x="115119" y="1154872"/>
                    <a:pt x="118455" y="1155753"/>
                    <a:pt x="121296" y="1154935"/>
                  </a:cubicBezTo>
                  <a:cubicBezTo>
                    <a:pt x="124421" y="1154023"/>
                    <a:pt x="126677" y="1151508"/>
                    <a:pt x="131195" y="1150722"/>
                  </a:cubicBezTo>
                  <a:cubicBezTo>
                    <a:pt x="134145" y="1153206"/>
                    <a:pt x="141234" y="1158267"/>
                    <a:pt x="145453" y="1158897"/>
                  </a:cubicBezTo>
                  <a:lnTo>
                    <a:pt x="150754" y="1155438"/>
                  </a:lnTo>
                  <a:lnTo>
                    <a:pt x="156278" y="1155909"/>
                  </a:lnTo>
                  <a:lnTo>
                    <a:pt x="165493" y="1173265"/>
                  </a:lnTo>
                  <a:cubicBezTo>
                    <a:pt x="168895" y="1173988"/>
                    <a:pt x="173206" y="1176755"/>
                    <a:pt x="175609" y="1178956"/>
                  </a:cubicBezTo>
                  <a:cubicBezTo>
                    <a:pt x="178783" y="1178642"/>
                    <a:pt x="182649" y="1178611"/>
                    <a:pt x="185725" y="1177950"/>
                  </a:cubicBezTo>
                  <a:cubicBezTo>
                    <a:pt x="187486" y="1177604"/>
                    <a:pt x="189271" y="1176158"/>
                    <a:pt x="191036" y="1175717"/>
                  </a:cubicBezTo>
                  <a:cubicBezTo>
                    <a:pt x="195820" y="1174586"/>
                    <a:pt x="203232" y="1176629"/>
                    <a:pt x="206691" y="1179711"/>
                  </a:cubicBezTo>
                  <a:cubicBezTo>
                    <a:pt x="209195" y="1178076"/>
                    <a:pt x="213667" y="1176472"/>
                    <a:pt x="216803" y="1176472"/>
                  </a:cubicBezTo>
                  <a:cubicBezTo>
                    <a:pt x="218982" y="1174208"/>
                    <a:pt x="223714" y="1171347"/>
                    <a:pt x="227144" y="1171033"/>
                  </a:cubicBezTo>
                  <a:cubicBezTo>
                    <a:pt x="231988" y="1171693"/>
                    <a:pt x="238782" y="1175152"/>
                    <a:pt x="242799" y="1177478"/>
                  </a:cubicBezTo>
                  <a:lnTo>
                    <a:pt x="247882" y="1177227"/>
                  </a:lnTo>
                  <a:cubicBezTo>
                    <a:pt x="250793" y="1178956"/>
                    <a:pt x="254423" y="1181629"/>
                    <a:pt x="257542" y="1182918"/>
                  </a:cubicBezTo>
                  <a:cubicBezTo>
                    <a:pt x="260432" y="1184081"/>
                    <a:pt x="263687" y="1182509"/>
                    <a:pt x="268566" y="1186125"/>
                  </a:cubicBezTo>
                  <a:cubicBezTo>
                    <a:pt x="271611" y="1190149"/>
                    <a:pt x="270050" y="1195997"/>
                    <a:pt x="270411" y="1200494"/>
                  </a:cubicBezTo>
                  <a:cubicBezTo>
                    <a:pt x="270608" y="1202915"/>
                    <a:pt x="271990" y="1205776"/>
                    <a:pt x="273042" y="1207913"/>
                  </a:cubicBezTo>
                  <a:lnTo>
                    <a:pt x="275974" y="1213856"/>
                  </a:lnTo>
                  <a:cubicBezTo>
                    <a:pt x="279886" y="1219390"/>
                    <a:pt x="288928" y="1221874"/>
                    <a:pt x="295751" y="1219798"/>
                  </a:cubicBezTo>
                  <a:cubicBezTo>
                    <a:pt x="304685" y="1226873"/>
                    <a:pt x="300858" y="1230048"/>
                    <a:pt x="304043" y="1238129"/>
                  </a:cubicBezTo>
                  <a:cubicBezTo>
                    <a:pt x="309725" y="1242593"/>
                    <a:pt x="317993" y="1243253"/>
                    <a:pt x="323132" y="1248284"/>
                  </a:cubicBezTo>
                  <a:cubicBezTo>
                    <a:pt x="325057" y="1250140"/>
                    <a:pt x="330684" y="1259194"/>
                    <a:pt x="331424" y="1261144"/>
                  </a:cubicBezTo>
                  <a:cubicBezTo>
                    <a:pt x="331645" y="1261710"/>
                    <a:pt x="331424" y="1262118"/>
                    <a:pt x="331424" y="1262716"/>
                  </a:cubicBezTo>
                  <a:cubicBezTo>
                    <a:pt x="331424" y="1266206"/>
                    <a:pt x="331200" y="1265074"/>
                    <a:pt x="332346" y="1269004"/>
                  </a:cubicBezTo>
                  <a:lnTo>
                    <a:pt x="334181" y="1275261"/>
                  </a:lnTo>
                  <a:cubicBezTo>
                    <a:pt x="334181" y="1277870"/>
                    <a:pt x="332048" y="1280795"/>
                    <a:pt x="333017" y="1283687"/>
                  </a:cubicBezTo>
                  <a:cubicBezTo>
                    <a:pt x="334577" y="1288341"/>
                    <a:pt x="340947" y="1302804"/>
                    <a:pt x="338555" y="1307205"/>
                  </a:cubicBezTo>
                  <a:lnTo>
                    <a:pt x="328190" y="1309910"/>
                  </a:lnTo>
                  <a:lnTo>
                    <a:pt x="320827" y="1317832"/>
                  </a:lnTo>
                  <a:cubicBezTo>
                    <a:pt x="318491" y="1319122"/>
                    <a:pt x="313714" y="1319656"/>
                    <a:pt x="311167" y="1318587"/>
                  </a:cubicBezTo>
                  <a:lnTo>
                    <a:pt x="305884" y="1320316"/>
                  </a:lnTo>
                  <a:cubicBezTo>
                    <a:pt x="304067" y="1323272"/>
                    <a:pt x="301142" y="1330723"/>
                    <a:pt x="302647" y="1334182"/>
                  </a:cubicBezTo>
                  <a:cubicBezTo>
                    <a:pt x="309929" y="1334685"/>
                    <a:pt x="314254" y="1330252"/>
                    <a:pt x="323128" y="1333207"/>
                  </a:cubicBezTo>
                  <a:lnTo>
                    <a:pt x="332108" y="1341602"/>
                  </a:lnTo>
                  <a:cubicBezTo>
                    <a:pt x="335149" y="1341413"/>
                    <a:pt x="339755" y="1343678"/>
                    <a:pt x="341768" y="1345564"/>
                  </a:cubicBezTo>
                  <a:lnTo>
                    <a:pt x="357875" y="1346822"/>
                  </a:lnTo>
                  <a:lnTo>
                    <a:pt x="362706" y="1343583"/>
                  </a:lnTo>
                  <a:cubicBezTo>
                    <a:pt x="362755" y="1340816"/>
                    <a:pt x="365091" y="1336791"/>
                    <a:pt x="367308" y="1334937"/>
                  </a:cubicBezTo>
                  <a:cubicBezTo>
                    <a:pt x="372958" y="1334685"/>
                    <a:pt x="378820" y="1340313"/>
                    <a:pt x="381370" y="1344338"/>
                  </a:cubicBezTo>
                  <a:lnTo>
                    <a:pt x="384825" y="1343771"/>
                  </a:lnTo>
                  <a:lnTo>
                    <a:pt x="391735" y="1342608"/>
                  </a:lnTo>
                  <a:cubicBezTo>
                    <a:pt x="394369" y="1341728"/>
                    <a:pt x="397859" y="1338363"/>
                    <a:pt x="401623" y="1337169"/>
                  </a:cubicBezTo>
                  <a:cubicBezTo>
                    <a:pt x="406895" y="1338395"/>
                    <a:pt x="413511" y="1336980"/>
                    <a:pt x="417731" y="1333930"/>
                  </a:cubicBezTo>
                  <a:cubicBezTo>
                    <a:pt x="422561" y="1332956"/>
                    <a:pt x="433336" y="1340816"/>
                    <a:pt x="437756" y="1342860"/>
                  </a:cubicBezTo>
                  <a:cubicBezTo>
                    <a:pt x="443761" y="1345595"/>
                    <a:pt x="452425" y="1340533"/>
                    <a:pt x="458248" y="1344589"/>
                  </a:cubicBezTo>
                  <a:cubicBezTo>
                    <a:pt x="461405" y="1347953"/>
                    <a:pt x="465965" y="1353172"/>
                    <a:pt x="467438" y="1357480"/>
                  </a:cubicBezTo>
                  <a:cubicBezTo>
                    <a:pt x="468420" y="1360341"/>
                    <a:pt x="468701" y="1363863"/>
                    <a:pt x="469964" y="1366629"/>
                  </a:cubicBezTo>
                  <a:cubicBezTo>
                    <a:pt x="472208" y="1371503"/>
                    <a:pt x="478592" y="1374678"/>
                    <a:pt x="484029" y="1376030"/>
                  </a:cubicBezTo>
                  <a:lnTo>
                    <a:pt x="494517" y="1371660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65" name="자유형: 도형 306"/>
            <p:cNvSpPr/>
            <p:nvPr/>
          </p:nvSpPr>
          <p:spPr>
            <a:xfrm>
              <a:off x="8514360" y="3204360"/>
              <a:ext cx="430200" cy="439560"/>
            </a:xfrm>
            <a:custGeom>
              <a:avLst/>
              <a:gdLst/>
              <a:ahLst/>
              <a:cxnLst/>
              <a:rect l="l" t="t" r="r" b="b"/>
              <a:pathLst>
                <a:path w="340760" h="357959">
                  <a:moveTo>
                    <a:pt x="28401" y="357960"/>
                  </a:moveTo>
                  <a:lnTo>
                    <a:pt x="42712" y="356199"/>
                  </a:lnTo>
                  <a:lnTo>
                    <a:pt x="55445" y="353809"/>
                  </a:lnTo>
                  <a:cubicBezTo>
                    <a:pt x="55445" y="353809"/>
                    <a:pt x="69511" y="343056"/>
                    <a:pt x="74457" y="338529"/>
                  </a:cubicBezTo>
                  <a:cubicBezTo>
                    <a:pt x="79368" y="334001"/>
                    <a:pt x="92767" y="334787"/>
                    <a:pt x="92767" y="334787"/>
                  </a:cubicBezTo>
                  <a:cubicBezTo>
                    <a:pt x="92767" y="334787"/>
                    <a:pt x="113568" y="337051"/>
                    <a:pt x="121109" y="334410"/>
                  </a:cubicBezTo>
                  <a:cubicBezTo>
                    <a:pt x="128616" y="331769"/>
                    <a:pt x="132159" y="329757"/>
                    <a:pt x="132159" y="329757"/>
                  </a:cubicBezTo>
                  <a:lnTo>
                    <a:pt x="129668" y="314382"/>
                  </a:lnTo>
                  <a:lnTo>
                    <a:pt x="130861" y="302309"/>
                  </a:lnTo>
                  <a:lnTo>
                    <a:pt x="144681" y="295266"/>
                  </a:lnTo>
                  <a:lnTo>
                    <a:pt x="151240" y="285707"/>
                  </a:lnTo>
                  <a:lnTo>
                    <a:pt x="148890" y="266308"/>
                  </a:lnTo>
                  <a:lnTo>
                    <a:pt x="188527" y="245965"/>
                  </a:lnTo>
                  <a:lnTo>
                    <a:pt x="200383" y="248575"/>
                  </a:lnTo>
                  <a:lnTo>
                    <a:pt x="217746" y="245620"/>
                  </a:lnTo>
                  <a:lnTo>
                    <a:pt x="219956" y="273068"/>
                  </a:lnTo>
                  <a:lnTo>
                    <a:pt x="229847" y="274829"/>
                  </a:lnTo>
                  <a:lnTo>
                    <a:pt x="242756" y="273414"/>
                  </a:lnTo>
                  <a:lnTo>
                    <a:pt x="255909" y="263415"/>
                  </a:lnTo>
                  <a:lnTo>
                    <a:pt x="278780" y="253826"/>
                  </a:lnTo>
                  <a:cubicBezTo>
                    <a:pt x="278780" y="253826"/>
                    <a:pt x="283971" y="245399"/>
                    <a:pt x="283971" y="232257"/>
                  </a:cubicBezTo>
                  <a:cubicBezTo>
                    <a:pt x="283971" y="219115"/>
                    <a:pt x="274570" y="204086"/>
                    <a:pt x="274570" y="204086"/>
                  </a:cubicBezTo>
                  <a:lnTo>
                    <a:pt x="288636" y="192767"/>
                  </a:lnTo>
                  <a:lnTo>
                    <a:pt x="299755" y="162237"/>
                  </a:lnTo>
                  <a:lnTo>
                    <a:pt x="309262" y="143058"/>
                  </a:lnTo>
                  <a:lnTo>
                    <a:pt x="317469" y="143970"/>
                  </a:lnTo>
                  <a:lnTo>
                    <a:pt x="340760" y="129821"/>
                  </a:lnTo>
                  <a:cubicBezTo>
                    <a:pt x="340760" y="129821"/>
                    <a:pt x="338059" y="103411"/>
                    <a:pt x="338059" y="100487"/>
                  </a:cubicBezTo>
                  <a:cubicBezTo>
                    <a:pt x="338059" y="97531"/>
                    <a:pt x="341427" y="91526"/>
                    <a:pt x="332026" y="85521"/>
                  </a:cubicBezTo>
                  <a:cubicBezTo>
                    <a:pt x="322661" y="79515"/>
                    <a:pt x="319749" y="73887"/>
                    <a:pt x="319749" y="73887"/>
                  </a:cubicBezTo>
                  <a:lnTo>
                    <a:pt x="328694" y="37038"/>
                  </a:lnTo>
                  <a:lnTo>
                    <a:pt x="314348" y="23801"/>
                  </a:lnTo>
                  <a:lnTo>
                    <a:pt x="304631" y="1666"/>
                  </a:lnTo>
                  <a:lnTo>
                    <a:pt x="286497" y="0"/>
                  </a:lnTo>
                  <a:lnTo>
                    <a:pt x="249034" y="4245"/>
                  </a:lnTo>
                  <a:lnTo>
                    <a:pt x="235881" y="4653"/>
                  </a:lnTo>
                  <a:lnTo>
                    <a:pt x="209152" y="25625"/>
                  </a:lnTo>
                  <a:lnTo>
                    <a:pt x="195086" y="32825"/>
                  </a:lnTo>
                  <a:lnTo>
                    <a:pt x="182739" y="31473"/>
                  </a:lnTo>
                  <a:lnTo>
                    <a:pt x="174426" y="36157"/>
                  </a:lnTo>
                  <a:lnTo>
                    <a:pt x="166954" y="44898"/>
                  </a:lnTo>
                  <a:lnTo>
                    <a:pt x="157168" y="33454"/>
                  </a:lnTo>
                  <a:lnTo>
                    <a:pt x="126406" y="111208"/>
                  </a:lnTo>
                  <a:lnTo>
                    <a:pt x="116514" y="103788"/>
                  </a:lnTo>
                  <a:cubicBezTo>
                    <a:pt x="116514" y="103788"/>
                    <a:pt x="108622" y="104102"/>
                    <a:pt x="103746" y="104385"/>
                  </a:cubicBezTo>
                  <a:cubicBezTo>
                    <a:pt x="98836" y="104668"/>
                    <a:pt x="92978" y="96934"/>
                    <a:pt x="96906" y="90929"/>
                  </a:cubicBezTo>
                  <a:cubicBezTo>
                    <a:pt x="100835" y="84923"/>
                    <a:pt x="106202" y="70586"/>
                    <a:pt x="106202" y="70586"/>
                  </a:cubicBezTo>
                  <a:lnTo>
                    <a:pt x="87190" y="63040"/>
                  </a:lnTo>
                  <a:lnTo>
                    <a:pt x="62320" y="74736"/>
                  </a:lnTo>
                  <a:lnTo>
                    <a:pt x="41485" y="112308"/>
                  </a:lnTo>
                  <a:cubicBezTo>
                    <a:pt x="41485" y="112308"/>
                    <a:pt x="34750" y="116270"/>
                    <a:pt x="33066" y="121835"/>
                  </a:cubicBezTo>
                  <a:cubicBezTo>
                    <a:pt x="31418" y="127431"/>
                    <a:pt x="23455" y="137650"/>
                    <a:pt x="35417" y="143058"/>
                  </a:cubicBezTo>
                  <a:cubicBezTo>
                    <a:pt x="47413" y="148435"/>
                    <a:pt x="54779" y="147837"/>
                    <a:pt x="60146" y="148435"/>
                  </a:cubicBezTo>
                  <a:cubicBezTo>
                    <a:pt x="65513" y="149064"/>
                    <a:pt x="83612" y="150855"/>
                    <a:pt x="83612" y="150855"/>
                  </a:cubicBezTo>
                  <a:lnTo>
                    <a:pt x="107008" y="168934"/>
                  </a:lnTo>
                  <a:cubicBezTo>
                    <a:pt x="107008" y="168934"/>
                    <a:pt x="109323" y="181920"/>
                    <a:pt x="99432" y="182548"/>
                  </a:cubicBezTo>
                  <a:cubicBezTo>
                    <a:pt x="89540" y="183145"/>
                    <a:pt x="68845" y="182548"/>
                    <a:pt x="64811" y="182548"/>
                  </a:cubicBezTo>
                  <a:cubicBezTo>
                    <a:pt x="60812" y="182548"/>
                    <a:pt x="53446" y="184875"/>
                    <a:pt x="49096" y="190597"/>
                  </a:cubicBezTo>
                  <a:cubicBezTo>
                    <a:pt x="44712" y="196351"/>
                    <a:pt x="42257" y="210531"/>
                    <a:pt x="35837" y="215404"/>
                  </a:cubicBezTo>
                  <a:cubicBezTo>
                    <a:pt x="29383" y="220309"/>
                    <a:pt x="26086" y="236282"/>
                    <a:pt x="40748" y="242066"/>
                  </a:cubicBezTo>
                  <a:cubicBezTo>
                    <a:pt x="55445" y="247852"/>
                    <a:pt x="67021" y="250179"/>
                    <a:pt x="66950" y="256184"/>
                  </a:cubicBezTo>
                  <a:cubicBezTo>
                    <a:pt x="66845" y="262189"/>
                    <a:pt x="70739" y="272376"/>
                    <a:pt x="67441" y="277156"/>
                  </a:cubicBezTo>
                  <a:cubicBezTo>
                    <a:pt x="64144" y="281935"/>
                    <a:pt x="59093" y="283475"/>
                    <a:pt x="59093" y="283475"/>
                  </a:cubicBezTo>
                  <a:cubicBezTo>
                    <a:pt x="59093" y="283475"/>
                    <a:pt x="21035" y="278633"/>
                    <a:pt x="14546" y="275521"/>
                  </a:cubicBezTo>
                  <a:cubicBezTo>
                    <a:pt x="8021" y="272408"/>
                    <a:pt x="2970" y="270301"/>
                    <a:pt x="831" y="276118"/>
                  </a:cubicBezTo>
                  <a:cubicBezTo>
                    <a:pt x="-1344" y="281935"/>
                    <a:pt x="305" y="295329"/>
                    <a:pt x="11178" y="306930"/>
                  </a:cubicBezTo>
                  <a:cubicBezTo>
                    <a:pt x="22017" y="318532"/>
                    <a:pt x="26261" y="319287"/>
                    <a:pt x="31839" y="323374"/>
                  </a:cubicBezTo>
                  <a:cubicBezTo>
                    <a:pt x="37451" y="327462"/>
                    <a:pt x="40783" y="331643"/>
                    <a:pt x="40117" y="335856"/>
                  </a:cubicBezTo>
                  <a:cubicBezTo>
                    <a:pt x="39450" y="340070"/>
                    <a:pt x="32751" y="345477"/>
                    <a:pt x="34084" y="347584"/>
                  </a:cubicBezTo>
                  <a:cubicBezTo>
                    <a:pt x="35417" y="349659"/>
                    <a:pt x="28401" y="357960"/>
                    <a:pt x="28401" y="35796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66" name="자유형: 도형 307"/>
            <p:cNvSpPr/>
            <p:nvPr/>
          </p:nvSpPr>
          <p:spPr>
            <a:xfrm>
              <a:off x="9167040" y="3519720"/>
              <a:ext cx="511560" cy="439200"/>
            </a:xfrm>
            <a:custGeom>
              <a:avLst/>
              <a:gdLst/>
              <a:ahLst/>
              <a:cxnLst/>
              <a:rect l="l" t="t" r="r" b="b"/>
              <a:pathLst>
                <a:path w="405229" h="357833">
                  <a:moveTo>
                    <a:pt x="186784" y="303660"/>
                  </a:moveTo>
                  <a:lnTo>
                    <a:pt x="199412" y="309320"/>
                  </a:lnTo>
                  <a:lnTo>
                    <a:pt x="222177" y="305452"/>
                  </a:lnTo>
                  <a:lnTo>
                    <a:pt x="241504" y="305107"/>
                  </a:lnTo>
                  <a:lnTo>
                    <a:pt x="251256" y="318972"/>
                  </a:lnTo>
                  <a:lnTo>
                    <a:pt x="254448" y="340792"/>
                  </a:lnTo>
                  <a:lnTo>
                    <a:pt x="280159" y="357833"/>
                  </a:lnTo>
                  <a:cubicBezTo>
                    <a:pt x="284474" y="351200"/>
                    <a:pt x="289805" y="343150"/>
                    <a:pt x="294576" y="340195"/>
                  </a:cubicBezTo>
                  <a:cubicBezTo>
                    <a:pt x="300714" y="336422"/>
                    <a:pt x="307870" y="337522"/>
                    <a:pt x="313763" y="334190"/>
                  </a:cubicBezTo>
                  <a:cubicBezTo>
                    <a:pt x="315727" y="333089"/>
                    <a:pt x="319480" y="327116"/>
                    <a:pt x="319340" y="325040"/>
                  </a:cubicBezTo>
                  <a:cubicBezTo>
                    <a:pt x="318989" y="317369"/>
                    <a:pt x="307168" y="314601"/>
                    <a:pt x="306466" y="306238"/>
                  </a:cubicBezTo>
                  <a:cubicBezTo>
                    <a:pt x="306011" y="300736"/>
                    <a:pt x="318919" y="293222"/>
                    <a:pt x="319586" y="277721"/>
                  </a:cubicBezTo>
                  <a:cubicBezTo>
                    <a:pt x="320392" y="259831"/>
                    <a:pt x="300433" y="253543"/>
                    <a:pt x="306958" y="239803"/>
                  </a:cubicBezTo>
                  <a:cubicBezTo>
                    <a:pt x="318638" y="238105"/>
                    <a:pt x="329933" y="241658"/>
                    <a:pt x="334423" y="228578"/>
                  </a:cubicBezTo>
                  <a:cubicBezTo>
                    <a:pt x="335861" y="224428"/>
                    <a:pt x="331757" y="200218"/>
                    <a:pt x="328355" y="195879"/>
                  </a:cubicBezTo>
                  <a:cubicBezTo>
                    <a:pt x="326811" y="193930"/>
                    <a:pt x="316639" y="190471"/>
                    <a:pt x="313517" y="188050"/>
                  </a:cubicBezTo>
                  <a:cubicBezTo>
                    <a:pt x="313096" y="182737"/>
                    <a:pt x="317341" y="178178"/>
                    <a:pt x="317165" y="172896"/>
                  </a:cubicBezTo>
                  <a:lnTo>
                    <a:pt x="321550" y="170538"/>
                  </a:lnTo>
                  <a:cubicBezTo>
                    <a:pt x="327443" y="171984"/>
                    <a:pt x="331336" y="175223"/>
                    <a:pt x="336142" y="178367"/>
                  </a:cubicBezTo>
                  <a:cubicBezTo>
                    <a:pt x="353365" y="189780"/>
                    <a:pt x="343017" y="204495"/>
                    <a:pt x="349015" y="217605"/>
                  </a:cubicBezTo>
                  <a:cubicBezTo>
                    <a:pt x="350278" y="220403"/>
                    <a:pt x="352873" y="222479"/>
                    <a:pt x="354346" y="225182"/>
                  </a:cubicBezTo>
                  <a:lnTo>
                    <a:pt x="360660" y="225686"/>
                  </a:lnTo>
                  <a:cubicBezTo>
                    <a:pt x="364729" y="222667"/>
                    <a:pt x="370412" y="223171"/>
                    <a:pt x="375007" y="221252"/>
                  </a:cubicBezTo>
                  <a:cubicBezTo>
                    <a:pt x="374866" y="217605"/>
                    <a:pt x="377287" y="215593"/>
                    <a:pt x="378409" y="212355"/>
                  </a:cubicBezTo>
                  <a:cubicBezTo>
                    <a:pt x="380865" y="205406"/>
                    <a:pt x="380163" y="199023"/>
                    <a:pt x="384022" y="189874"/>
                  </a:cubicBezTo>
                  <a:cubicBezTo>
                    <a:pt x="388266" y="179813"/>
                    <a:pt x="396789" y="171355"/>
                    <a:pt x="399069" y="160602"/>
                  </a:cubicBezTo>
                  <a:cubicBezTo>
                    <a:pt x="400578" y="153685"/>
                    <a:pt x="398543" y="146611"/>
                    <a:pt x="399806" y="139662"/>
                  </a:cubicBezTo>
                  <a:cubicBezTo>
                    <a:pt x="401490" y="130387"/>
                    <a:pt x="408680" y="119917"/>
                    <a:pt x="403209" y="108315"/>
                  </a:cubicBezTo>
                  <a:cubicBezTo>
                    <a:pt x="397456" y="96053"/>
                    <a:pt x="392510" y="99858"/>
                    <a:pt x="393738" y="82408"/>
                  </a:cubicBezTo>
                  <a:cubicBezTo>
                    <a:pt x="394124" y="76717"/>
                    <a:pt x="395001" y="71466"/>
                    <a:pt x="397070" y="66624"/>
                  </a:cubicBezTo>
                  <a:lnTo>
                    <a:pt x="357784" y="55714"/>
                  </a:lnTo>
                  <a:lnTo>
                    <a:pt x="325022" y="44300"/>
                  </a:lnTo>
                  <a:lnTo>
                    <a:pt x="310956" y="43798"/>
                  </a:lnTo>
                  <a:lnTo>
                    <a:pt x="284684" y="59109"/>
                  </a:lnTo>
                  <a:lnTo>
                    <a:pt x="275599" y="58166"/>
                  </a:lnTo>
                  <a:lnTo>
                    <a:pt x="260727" y="70837"/>
                  </a:lnTo>
                  <a:lnTo>
                    <a:pt x="251676" y="66655"/>
                  </a:lnTo>
                  <a:cubicBezTo>
                    <a:pt x="251676" y="66655"/>
                    <a:pt x="234805" y="63543"/>
                    <a:pt x="233542" y="61530"/>
                  </a:cubicBezTo>
                  <a:cubicBezTo>
                    <a:pt x="232244" y="59550"/>
                    <a:pt x="230104" y="52129"/>
                    <a:pt x="230104" y="52129"/>
                  </a:cubicBezTo>
                  <a:lnTo>
                    <a:pt x="235997" y="28517"/>
                  </a:lnTo>
                  <a:lnTo>
                    <a:pt x="232454" y="22826"/>
                  </a:lnTo>
                  <a:lnTo>
                    <a:pt x="218809" y="20374"/>
                  </a:lnTo>
                  <a:cubicBezTo>
                    <a:pt x="218809" y="20374"/>
                    <a:pt x="211443" y="18047"/>
                    <a:pt x="208883" y="14400"/>
                  </a:cubicBezTo>
                  <a:cubicBezTo>
                    <a:pt x="206357" y="10753"/>
                    <a:pt x="190853" y="2861"/>
                    <a:pt x="190853" y="2861"/>
                  </a:cubicBezTo>
                  <a:lnTo>
                    <a:pt x="171666" y="2546"/>
                  </a:lnTo>
                  <a:lnTo>
                    <a:pt x="163353" y="8866"/>
                  </a:lnTo>
                  <a:lnTo>
                    <a:pt x="151497" y="7860"/>
                  </a:lnTo>
                  <a:lnTo>
                    <a:pt x="145920" y="0"/>
                  </a:lnTo>
                  <a:lnTo>
                    <a:pt x="136098" y="2798"/>
                  </a:lnTo>
                  <a:lnTo>
                    <a:pt x="122138" y="15469"/>
                  </a:lnTo>
                  <a:lnTo>
                    <a:pt x="102004" y="18393"/>
                  </a:lnTo>
                  <a:lnTo>
                    <a:pt x="88183" y="23832"/>
                  </a:lnTo>
                  <a:lnTo>
                    <a:pt x="79169" y="38390"/>
                  </a:lnTo>
                  <a:lnTo>
                    <a:pt x="75696" y="56689"/>
                  </a:lnTo>
                  <a:lnTo>
                    <a:pt x="86359" y="68951"/>
                  </a:lnTo>
                  <a:lnTo>
                    <a:pt x="80747" y="76119"/>
                  </a:lnTo>
                  <a:lnTo>
                    <a:pt x="59947" y="67725"/>
                  </a:lnTo>
                  <a:lnTo>
                    <a:pt x="50546" y="82093"/>
                  </a:lnTo>
                  <a:lnTo>
                    <a:pt x="38725" y="80301"/>
                  </a:lnTo>
                  <a:lnTo>
                    <a:pt x="20590" y="96147"/>
                  </a:lnTo>
                  <a:lnTo>
                    <a:pt x="27080" y="100014"/>
                  </a:lnTo>
                  <a:lnTo>
                    <a:pt x="29535" y="128532"/>
                  </a:lnTo>
                  <a:lnTo>
                    <a:pt x="17013" y="138405"/>
                  </a:lnTo>
                  <a:lnTo>
                    <a:pt x="0" y="145007"/>
                  </a:lnTo>
                  <a:lnTo>
                    <a:pt x="5157" y="160382"/>
                  </a:lnTo>
                  <a:lnTo>
                    <a:pt x="15224" y="160539"/>
                  </a:lnTo>
                  <a:lnTo>
                    <a:pt x="15820" y="175883"/>
                  </a:lnTo>
                  <a:cubicBezTo>
                    <a:pt x="15820" y="175883"/>
                    <a:pt x="54439" y="186887"/>
                    <a:pt x="56684" y="187799"/>
                  </a:cubicBezTo>
                  <a:cubicBezTo>
                    <a:pt x="58894" y="188680"/>
                    <a:pt x="63735" y="185692"/>
                    <a:pt x="63735" y="185692"/>
                  </a:cubicBezTo>
                  <a:lnTo>
                    <a:pt x="76608" y="195376"/>
                  </a:lnTo>
                  <a:lnTo>
                    <a:pt x="104529" y="205437"/>
                  </a:lnTo>
                  <a:lnTo>
                    <a:pt x="123225" y="236596"/>
                  </a:lnTo>
                  <a:lnTo>
                    <a:pt x="146621" y="254486"/>
                  </a:lnTo>
                  <a:lnTo>
                    <a:pt x="169316" y="261277"/>
                  </a:lnTo>
                  <a:lnTo>
                    <a:pt x="181277" y="255806"/>
                  </a:lnTo>
                  <a:lnTo>
                    <a:pt x="187556" y="261560"/>
                  </a:lnTo>
                  <a:lnTo>
                    <a:pt x="188714" y="270175"/>
                  </a:lnTo>
                  <a:lnTo>
                    <a:pt x="198114" y="279702"/>
                  </a:lnTo>
                  <a:lnTo>
                    <a:pt x="186784" y="303660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67" name="자유형: 도형 308"/>
            <p:cNvSpPr/>
            <p:nvPr/>
          </p:nvSpPr>
          <p:spPr>
            <a:xfrm>
              <a:off x="8980560" y="3892680"/>
              <a:ext cx="540360" cy="384840"/>
            </a:xfrm>
            <a:custGeom>
              <a:avLst/>
              <a:gdLst/>
              <a:ahLst/>
              <a:cxnLst/>
              <a:rect l="l" t="t" r="r" b="b"/>
              <a:pathLst>
                <a:path w="427902" h="313407">
                  <a:moveTo>
                    <a:pt x="334528" y="0"/>
                  </a:moveTo>
                  <a:lnTo>
                    <a:pt x="347156" y="5660"/>
                  </a:lnTo>
                  <a:lnTo>
                    <a:pt x="369921" y="1792"/>
                  </a:lnTo>
                  <a:lnTo>
                    <a:pt x="389248" y="1447"/>
                  </a:lnTo>
                  <a:lnTo>
                    <a:pt x="398999" y="15312"/>
                  </a:lnTo>
                  <a:lnTo>
                    <a:pt x="402191" y="37132"/>
                  </a:lnTo>
                  <a:lnTo>
                    <a:pt x="427902" y="54173"/>
                  </a:lnTo>
                  <a:cubicBezTo>
                    <a:pt x="426289" y="56689"/>
                    <a:pt x="425272" y="59236"/>
                    <a:pt x="423834" y="60871"/>
                  </a:cubicBezTo>
                  <a:cubicBezTo>
                    <a:pt x="418818" y="62537"/>
                    <a:pt x="413276" y="62097"/>
                    <a:pt x="408260" y="63732"/>
                  </a:cubicBezTo>
                  <a:cubicBezTo>
                    <a:pt x="406366" y="64360"/>
                    <a:pt x="393071" y="72284"/>
                    <a:pt x="391493" y="73668"/>
                  </a:cubicBezTo>
                  <a:cubicBezTo>
                    <a:pt x="384267" y="80112"/>
                    <a:pt x="390616" y="96242"/>
                    <a:pt x="381531" y="109762"/>
                  </a:cubicBezTo>
                  <a:cubicBezTo>
                    <a:pt x="379286" y="113126"/>
                    <a:pt x="372166" y="114321"/>
                    <a:pt x="368658" y="116805"/>
                  </a:cubicBezTo>
                  <a:cubicBezTo>
                    <a:pt x="367991" y="126363"/>
                    <a:pt x="373043" y="125546"/>
                    <a:pt x="377146" y="132494"/>
                  </a:cubicBezTo>
                  <a:cubicBezTo>
                    <a:pt x="376164" y="151422"/>
                    <a:pt x="357539" y="151359"/>
                    <a:pt x="356486" y="159942"/>
                  </a:cubicBezTo>
                  <a:cubicBezTo>
                    <a:pt x="355855" y="165350"/>
                    <a:pt x="359117" y="169375"/>
                    <a:pt x="354311" y="174343"/>
                  </a:cubicBezTo>
                  <a:cubicBezTo>
                    <a:pt x="349576" y="179247"/>
                    <a:pt x="342596" y="179153"/>
                    <a:pt x="337299" y="183492"/>
                  </a:cubicBezTo>
                  <a:cubicBezTo>
                    <a:pt x="329968" y="189466"/>
                    <a:pt x="325233" y="206632"/>
                    <a:pt x="308852" y="210154"/>
                  </a:cubicBezTo>
                  <a:cubicBezTo>
                    <a:pt x="297276" y="212638"/>
                    <a:pt x="290086" y="206381"/>
                    <a:pt x="279703" y="203866"/>
                  </a:cubicBezTo>
                  <a:cubicBezTo>
                    <a:pt x="272968" y="208928"/>
                    <a:pt x="268829" y="215436"/>
                    <a:pt x="259990" y="217480"/>
                  </a:cubicBezTo>
                  <a:cubicBezTo>
                    <a:pt x="254623" y="227918"/>
                    <a:pt x="262866" y="231785"/>
                    <a:pt x="271179" y="237068"/>
                  </a:cubicBezTo>
                  <a:cubicBezTo>
                    <a:pt x="274055" y="243765"/>
                    <a:pt x="268619" y="250022"/>
                    <a:pt x="262936" y="253794"/>
                  </a:cubicBezTo>
                  <a:cubicBezTo>
                    <a:pt x="258867" y="254078"/>
                    <a:pt x="254763" y="253764"/>
                    <a:pt x="250764" y="253008"/>
                  </a:cubicBezTo>
                  <a:cubicBezTo>
                    <a:pt x="242627" y="242350"/>
                    <a:pt x="232279" y="249771"/>
                    <a:pt x="225474" y="247255"/>
                  </a:cubicBezTo>
                  <a:cubicBezTo>
                    <a:pt x="224176" y="244425"/>
                    <a:pt x="223229" y="241438"/>
                    <a:pt x="222808" y="238388"/>
                  </a:cubicBezTo>
                  <a:lnTo>
                    <a:pt x="218424" y="235244"/>
                  </a:lnTo>
                  <a:lnTo>
                    <a:pt x="212847" y="235244"/>
                  </a:lnTo>
                  <a:cubicBezTo>
                    <a:pt x="207971" y="238735"/>
                    <a:pt x="189906" y="262472"/>
                    <a:pt x="187591" y="267661"/>
                  </a:cubicBezTo>
                  <a:cubicBezTo>
                    <a:pt x="184294" y="274987"/>
                    <a:pt x="185557" y="283727"/>
                    <a:pt x="179804" y="290141"/>
                  </a:cubicBezTo>
                  <a:cubicBezTo>
                    <a:pt x="174963" y="285425"/>
                    <a:pt x="180436" y="279828"/>
                    <a:pt x="167632" y="277345"/>
                  </a:cubicBezTo>
                  <a:lnTo>
                    <a:pt x="163248" y="279703"/>
                  </a:lnTo>
                  <a:cubicBezTo>
                    <a:pt x="159600" y="288411"/>
                    <a:pt x="162511" y="297907"/>
                    <a:pt x="160828" y="306868"/>
                  </a:cubicBezTo>
                  <a:cubicBezTo>
                    <a:pt x="157565" y="305987"/>
                    <a:pt x="154514" y="304321"/>
                    <a:pt x="152094" y="302183"/>
                  </a:cubicBezTo>
                  <a:lnTo>
                    <a:pt x="147218" y="304007"/>
                  </a:lnTo>
                  <a:cubicBezTo>
                    <a:pt x="144973" y="306868"/>
                    <a:pt x="143289" y="310075"/>
                    <a:pt x="142131" y="313408"/>
                  </a:cubicBezTo>
                  <a:lnTo>
                    <a:pt x="137010" y="311332"/>
                  </a:lnTo>
                  <a:cubicBezTo>
                    <a:pt x="134836" y="306176"/>
                    <a:pt x="138028" y="300863"/>
                    <a:pt x="137010" y="295643"/>
                  </a:cubicBezTo>
                  <a:cubicBezTo>
                    <a:pt x="136449" y="292688"/>
                    <a:pt x="134380" y="290078"/>
                    <a:pt x="134345" y="287028"/>
                  </a:cubicBezTo>
                  <a:cubicBezTo>
                    <a:pt x="134274" y="279577"/>
                    <a:pt x="140203" y="273415"/>
                    <a:pt x="140904" y="266088"/>
                  </a:cubicBezTo>
                  <a:cubicBezTo>
                    <a:pt x="141535" y="259391"/>
                    <a:pt x="137642" y="254172"/>
                    <a:pt x="135537" y="248073"/>
                  </a:cubicBezTo>
                  <a:cubicBezTo>
                    <a:pt x="134169" y="243985"/>
                    <a:pt x="140694" y="231031"/>
                    <a:pt x="141149" y="225592"/>
                  </a:cubicBezTo>
                  <a:lnTo>
                    <a:pt x="138729" y="221913"/>
                  </a:lnTo>
                  <a:lnTo>
                    <a:pt x="133117" y="220593"/>
                  </a:lnTo>
                  <a:cubicBezTo>
                    <a:pt x="125891" y="229553"/>
                    <a:pt x="118560" y="238829"/>
                    <a:pt x="109791" y="246501"/>
                  </a:cubicBezTo>
                  <a:cubicBezTo>
                    <a:pt x="105266" y="250462"/>
                    <a:pt x="102109" y="258354"/>
                    <a:pt x="96426" y="260869"/>
                  </a:cubicBezTo>
                  <a:cubicBezTo>
                    <a:pt x="94988" y="261530"/>
                    <a:pt x="93340" y="261749"/>
                    <a:pt x="91796" y="262190"/>
                  </a:cubicBezTo>
                  <a:cubicBezTo>
                    <a:pt x="80326" y="257662"/>
                    <a:pt x="86009" y="248481"/>
                    <a:pt x="85482" y="239961"/>
                  </a:cubicBezTo>
                  <a:lnTo>
                    <a:pt x="82080" y="236565"/>
                  </a:lnTo>
                  <a:lnTo>
                    <a:pt x="80642" y="237068"/>
                  </a:lnTo>
                  <a:cubicBezTo>
                    <a:pt x="69102" y="240841"/>
                    <a:pt x="70856" y="253732"/>
                    <a:pt x="61420" y="259548"/>
                  </a:cubicBezTo>
                  <a:cubicBezTo>
                    <a:pt x="59736" y="259423"/>
                    <a:pt x="23256" y="261593"/>
                    <a:pt x="22063" y="261907"/>
                  </a:cubicBezTo>
                  <a:lnTo>
                    <a:pt x="21116" y="250305"/>
                  </a:lnTo>
                  <a:lnTo>
                    <a:pt x="35182" y="246123"/>
                  </a:lnTo>
                  <a:lnTo>
                    <a:pt x="30517" y="230528"/>
                  </a:lnTo>
                  <a:lnTo>
                    <a:pt x="13294" y="225404"/>
                  </a:lnTo>
                  <a:lnTo>
                    <a:pt x="1754" y="211412"/>
                  </a:lnTo>
                  <a:lnTo>
                    <a:pt x="0" y="203426"/>
                  </a:lnTo>
                  <a:lnTo>
                    <a:pt x="12803" y="202828"/>
                  </a:lnTo>
                  <a:cubicBezTo>
                    <a:pt x="12803" y="202828"/>
                    <a:pt x="25115" y="206035"/>
                    <a:pt x="28482" y="206035"/>
                  </a:cubicBezTo>
                  <a:cubicBezTo>
                    <a:pt x="31815" y="206035"/>
                    <a:pt x="40269" y="198427"/>
                    <a:pt x="40269" y="198427"/>
                  </a:cubicBezTo>
                  <a:lnTo>
                    <a:pt x="51282" y="195345"/>
                  </a:lnTo>
                  <a:lnTo>
                    <a:pt x="59210" y="204212"/>
                  </a:lnTo>
                  <a:lnTo>
                    <a:pt x="67628" y="199653"/>
                  </a:lnTo>
                  <a:lnTo>
                    <a:pt x="68926" y="181134"/>
                  </a:lnTo>
                  <a:lnTo>
                    <a:pt x="61034" y="164879"/>
                  </a:lnTo>
                  <a:lnTo>
                    <a:pt x="75836" y="153812"/>
                  </a:lnTo>
                  <a:lnTo>
                    <a:pt x="89657" y="148372"/>
                  </a:lnTo>
                  <a:lnTo>
                    <a:pt x="106038" y="151862"/>
                  </a:lnTo>
                  <a:lnTo>
                    <a:pt x="118981" y="142398"/>
                  </a:lnTo>
                  <a:lnTo>
                    <a:pt x="128978" y="144945"/>
                  </a:lnTo>
                  <a:lnTo>
                    <a:pt x="150059" y="141235"/>
                  </a:lnTo>
                  <a:lnTo>
                    <a:pt x="164756" y="136645"/>
                  </a:lnTo>
                  <a:lnTo>
                    <a:pt x="178085" y="108630"/>
                  </a:lnTo>
                  <a:cubicBezTo>
                    <a:pt x="178085" y="108630"/>
                    <a:pt x="176858" y="101776"/>
                    <a:pt x="179138" y="100581"/>
                  </a:cubicBezTo>
                  <a:cubicBezTo>
                    <a:pt x="181453" y="99386"/>
                    <a:pt x="201096" y="98506"/>
                    <a:pt x="201096" y="98506"/>
                  </a:cubicBezTo>
                  <a:lnTo>
                    <a:pt x="217863" y="81024"/>
                  </a:lnTo>
                  <a:lnTo>
                    <a:pt x="229648" y="85238"/>
                  </a:lnTo>
                  <a:lnTo>
                    <a:pt x="240803" y="74925"/>
                  </a:lnTo>
                  <a:lnTo>
                    <a:pt x="262270" y="71844"/>
                  </a:lnTo>
                  <a:lnTo>
                    <a:pt x="262095" y="59927"/>
                  </a:lnTo>
                  <a:lnTo>
                    <a:pt x="275003" y="49080"/>
                  </a:lnTo>
                  <a:lnTo>
                    <a:pt x="279703" y="32353"/>
                  </a:lnTo>
                  <a:lnTo>
                    <a:pt x="276476" y="24682"/>
                  </a:lnTo>
                  <a:lnTo>
                    <a:pt x="284824" y="18362"/>
                  </a:lnTo>
                  <a:lnTo>
                    <a:pt x="310185" y="29241"/>
                  </a:lnTo>
                  <a:lnTo>
                    <a:pt x="319340" y="26945"/>
                  </a:lnTo>
                  <a:lnTo>
                    <a:pt x="334528" y="0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68" name="자유형: 도형 309"/>
            <p:cNvSpPr/>
            <p:nvPr/>
          </p:nvSpPr>
          <p:spPr>
            <a:xfrm>
              <a:off x="7692120" y="3314160"/>
              <a:ext cx="1725120" cy="1181520"/>
            </a:xfrm>
            <a:custGeom>
              <a:avLst/>
              <a:gdLst/>
              <a:ahLst/>
              <a:cxnLst/>
              <a:rect l="l" t="t" r="r" b="b"/>
              <a:pathLst>
                <a:path w="1365907" h="962060">
                  <a:moveTo>
                    <a:pt x="679383" y="268540"/>
                  </a:moveTo>
                  <a:lnTo>
                    <a:pt x="693694" y="266779"/>
                  </a:lnTo>
                  <a:lnTo>
                    <a:pt x="706427" y="264390"/>
                  </a:lnTo>
                  <a:cubicBezTo>
                    <a:pt x="706427" y="264390"/>
                    <a:pt x="720493" y="253637"/>
                    <a:pt x="725439" y="249110"/>
                  </a:cubicBezTo>
                  <a:cubicBezTo>
                    <a:pt x="730350" y="244582"/>
                    <a:pt x="743749" y="245368"/>
                    <a:pt x="743749" y="245368"/>
                  </a:cubicBezTo>
                  <a:cubicBezTo>
                    <a:pt x="743749" y="245368"/>
                    <a:pt x="764549" y="247632"/>
                    <a:pt x="772091" y="244991"/>
                  </a:cubicBezTo>
                  <a:cubicBezTo>
                    <a:pt x="779598" y="242349"/>
                    <a:pt x="783140" y="240337"/>
                    <a:pt x="783140" y="240337"/>
                  </a:cubicBezTo>
                  <a:lnTo>
                    <a:pt x="780650" y="224962"/>
                  </a:lnTo>
                  <a:lnTo>
                    <a:pt x="781843" y="212889"/>
                  </a:lnTo>
                  <a:lnTo>
                    <a:pt x="795663" y="205846"/>
                  </a:lnTo>
                  <a:cubicBezTo>
                    <a:pt x="795663" y="205846"/>
                    <a:pt x="801345" y="224899"/>
                    <a:pt x="802012" y="227289"/>
                  </a:cubicBezTo>
                  <a:cubicBezTo>
                    <a:pt x="802678" y="229710"/>
                    <a:pt x="805940" y="238639"/>
                    <a:pt x="804011" y="248858"/>
                  </a:cubicBezTo>
                  <a:cubicBezTo>
                    <a:pt x="802082" y="259045"/>
                    <a:pt x="808641" y="261466"/>
                    <a:pt x="812780" y="262567"/>
                  </a:cubicBezTo>
                  <a:cubicBezTo>
                    <a:pt x="816954" y="263667"/>
                    <a:pt x="834002" y="283601"/>
                    <a:pt x="836913" y="287908"/>
                  </a:cubicBezTo>
                  <a:cubicBezTo>
                    <a:pt x="839824" y="292216"/>
                    <a:pt x="846735" y="293725"/>
                    <a:pt x="854101" y="293725"/>
                  </a:cubicBezTo>
                  <a:cubicBezTo>
                    <a:pt x="861467" y="293725"/>
                    <a:pt x="882828" y="291932"/>
                    <a:pt x="887108" y="290297"/>
                  </a:cubicBezTo>
                  <a:cubicBezTo>
                    <a:pt x="891352" y="288631"/>
                    <a:pt x="901875" y="282469"/>
                    <a:pt x="901875" y="282469"/>
                  </a:cubicBezTo>
                  <a:lnTo>
                    <a:pt x="931024" y="284513"/>
                  </a:lnTo>
                  <a:lnTo>
                    <a:pt x="935409" y="293473"/>
                  </a:lnTo>
                  <a:lnTo>
                    <a:pt x="940776" y="298378"/>
                  </a:lnTo>
                  <a:lnTo>
                    <a:pt x="960874" y="298693"/>
                  </a:lnTo>
                  <a:lnTo>
                    <a:pt x="990830" y="307999"/>
                  </a:lnTo>
                  <a:lnTo>
                    <a:pt x="1012718" y="309162"/>
                  </a:lnTo>
                  <a:lnTo>
                    <a:pt x="1021242" y="292342"/>
                  </a:lnTo>
                  <a:lnTo>
                    <a:pt x="1048812" y="282311"/>
                  </a:lnTo>
                  <a:lnTo>
                    <a:pt x="1055091" y="287248"/>
                  </a:lnTo>
                  <a:lnTo>
                    <a:pt x="1064281" y="284953"/>
                  </a:lnTo>
                  <a:lnTo>
                    <a:pt x="1070911" y="273791"/>
                  </a:lnTo>
                  <a:lnTo>
                    <a:pt x="1081153" y="262660"/>
                  </a:lnTo>
                  <a:lnTo>
                    <a:pt x="1083223" y="248984"/>
                  </a:lnTo>
                  <a:lnTo>
                    <a:pt x="1110653" y="248606"/>
                  </a:lnTo>
                  <a:lnTo>
                    <a:pt x="1117247" y="239017"/>
                  </a:lnTo>
                  <a:lnTo>
                    <a:pt x="1123596" y="239928"/>
                  </a:lnTo>
                  <a:lnTo>
                    <a:pt x="1144011" y="254831"/>
                  </a:lnTo>
                  <a:lnTo>
                    <a:pt x="1157410" y="266182"/>
                  </a:lnTo>
                  <a:lnTo>
                    <a:pt x="1172739" y="270396"/>
                  </a:lnTo>
                  <a:lnTo>
                    <a:pt x="1188383" y="263509"/>
                  </a:lnTo>
                  <a:lnTo>
                    <a:pt x="1194872" y="267377"/>
                  </a:lnTo>
                  <a:lnTo>
                    <a:pt x="1197328" y="295894"/>
                  </a:lnTo>
                  <a:lnTo>
                    <a:pt x="1184805" y="305736"/>
                  </a:lnTo>
                  <a:lnTo>
                    <a:pt x="1167793" y="312338"/>
                  </a:lnTo>
                  <a:lnTo>
                    <a:pt x="1172985" y="327745"/>
                  </a:lnTo>
                  <a:lnTo>
                    <a:pt x="1183016" y="327901"/>
                  </a:lnTo>
                  <a:lnTo>
                    <a:pt x="1183613" y="343213"/>
                  </a:lnTo>
                  <a:cubicBezTo>
                    <a:pt x="1183613" y="343213"/>
                    <a:pt x="1222267" y="354249"/>
                    <a:pt x="1224477" y="355130"/>
                  </a:cubicBezTo>
                  <a:cubicBezTo>
                    <a:pt x="1226722" y="356042"/>
                    <a:pt x="1231563" y="353054"/>
                    <a:pt x="1231563" y="353054"/>
                  </a:cubicBezTo>
                  <a:lnTo>
                    <a:pt x="1244436" y="362707"/>
                  </a:lnTo>
                  <a:lnTo>
                    <a:pt x="1272357" y="372799"/>
                  </a:lnTo>
                  <a:lnTo>
                    <a:pt x="1291018" y="403958"/>
                  </a:lnTo>
                  <a:lnTo>
                    <a:pt x="1314414" y="421817"/>
                  </a:lnTo>
                  <a:lnTo>
                    <a:pt x="1337109" y="428639"/>
                  </a:lnTo>
                  <a:lnTo>
                    <a:pt x="1349070" y="423169"/>
                  </a:lnTo>
                  <a:lnTo>
                    <a:pt x="1355384" y="428923"/>
                  </a:lnTo>
                  <a:lnTo>
                    <a:pt x="1356542" y="437506"/>
                  </a:lnTo>
                  <a:lnTo>
                    <a:pt x="1365907" y="447064"/>
                  </a:lnTo>
                  <a:lnTo>
                    <a:pt x="1354542" y="471022"/>
                  </a:lnTo>
                  <a:lnTo>
                    <a:pt x="1339389" y="497968"/>
                  </a:lnTo>
                  <a:lnTo>
                    <a:pt x="1330234" y="500263"/>
                  </a:lnTo>
                  <a:lnTo>
                    <a:pt x="1304873" y="489384"/>
                  </a:lnTo>
                  <a:lnTo>
                    <a:pt x="1296525" y="495704"/>
                  </a:lnTo>
                  <a:lnTo>
                    <a:pt x="1299752" y="503375"/>
                  </a:lnTo>
                  <a:lnTo>
                    <a:pt x="1295052" y="520102"/>
                  </a:lnTo>
                  <a:lnTo>
                    <a:pt x="1282144" y="530950"/>
                  </a:lnTo>
                  <a:lnTo>
                    <a:pt x="1282319" y="542866"/>
                  </a:lnTo>
                  <a:lnTo>
                    <a:pt x="1260852" y="545979"/>
                  </a:lnTo>
                  <a:lnTo>
                    <a:pt x="1249698" y="556260"/>
                  </a:lnTo>
                  <a:lnTo>
                    <a:pt x="1237912" y="552047"/>
                  </a:lnTo>
                  <a:lnTo>
                    <a:pt x="1221145" y="569528"/>
                  </a:lnTo>
                  <a:cubicBezTo>
                    <a:pt x="1221145" y="569528"/>
                    <a:pt x="1201502" y="570409"/>
                    <a:pt x="1199187" y="571603"/>
                  </a:cubicBezTo>
                  <a:cubicBezTo>
                    <a:pt x="1196907" y="572798"/>
                    <a:pt x="1198134" y="579652"/>
                    <a:pt x="1198134" y="579652"/>
                  </a:cubicBezTo>
                  <a:lnTo>
                    <a:pt x="1184805" y="607667"/>
                  </a:lnTo>
                  <a:lnTo>
                    <a:pt x="1170108" y="612257"/>
                  </a:lnTo>
                  <a:lnTo>
                    <a:pt x="1149027" y="615967"/>
                  </a:lnTo>
                  <a:lnTo>
                    <a:pt x="1139030" y="613420"/>
                  </a:lnTo>
                  <a:lnTo>
                    <a:pt x="1126087" y="622884"/>
                  </a:lnTo>
                  <a:lnTo>
                    <a:pt x="1109706" y="619394"/>
                  </a:lnTo>
                  <a:lnTo>
                    <a:pt x="1095885" y="624834"/>
                  </a:lnTo>
                  <a:lnTo>
                    <a:pt x="1081083" y="635901"/>
                  </a:lnTo>
                  <a:lnTo>
                    <a:pt x="1088975" y="652156"/>
                  </a:lnTo>
                  <a:lnTo>
                    <a:pt x="1087677" y="670675"/>
                  </a:lnTo>
                  <a:lnTo>
                    <a:pt x="1079259" y="675234"/>
                  </a:lnTo>
                  <a:lnTo>
                    <a:pt x="1071331" y="666399"/>
                  </a:lnTo>
                  <a:lnTo>
                    <a:pt x="1060318" y="669449"/>
                  </a:lnTo>
                  <a:cubicBezTo>
                    <a:pt x="1060318" y="669449"/>
                    <a:pt x="1051864" y="677057"/>
                    <a:pt x="1048532" y="677057"/>
                  </a:cubicBezTo>
                  <a:cubicBezTo>
                    <a:pt x="1045164" y="677057"/>
                    <a:pt x="1032852" y="673850"/>
                    <a:pt x="1032852" y="673850"/>
                  </a:cubicBezTo>
                  <a:lnTo>
                    <a:pt x="1020049" y="674448"/>
                  </a:lnTo>
                  <a:lnTo>
                    <a:pt x="1021803" y="682434"/>
                  </a:lnTo>
                  <a:lnTo>
                    <a:pt x="1033343" y="696426"/>
                  </a:lnTo>
                  <a:lnTo>
                    <a:pt x="1050566" y="701550"/>
                  </a:lnTo>
                  <a:lnTo>
                    <a:pt x="1055231" y="717145"/>
                  </a:lnTo>
                  <a:lnTo>
                    <a:pt x="1041165" y="721327"/>
                  </a:lnTo>
                  <a:lnTo>
                    <a:pt x="1042113" y="732929"/>
                  </a:lnTo>
                  <a:cubicBezTo>
                    <a:pt x="1035483" y="734690"/>
                    <a:pt x="1028818" y="737393"/>
                    <a:pt x="1021663" y="737645"/>
                  </a:cubicBezTo>
                  <a:cubicBezTo>
                    <a:pt x="1018962" y="739595"/>
                    <a:pt x="1016647" y="742016"/>
                    <a:pt x="1014858" y="744719"/>
                  </a:cubicBezTo>
                  <a:lnTo>
                    <a:pt x="1009526" y="745505"/>
                  </a:lnTo>
                  <a:lnTo>
                    <a:pt x="1009526" y="742361"/>
                  </a:lnTo>
                  <a:cubicBezTo>
                    <a:pt x="1024294" y="725478"/>
                    <a:pt x="1012157" y="733715"/>
                    <a:pt x="1011947" y="718560"/>
                  </a:cubicBezTo>
                  <a:lnTo>
                    <a:pt x="1008298" y="716202"/>
                  </a:lnTo>
                  <a:lnTo>
                    <a:pt x="1003458" y="717774"/>
                  </a:lnTo>
                  <a:cubicBezTo>
                    <a:pt x="998512" y="726609"/>
                    <a:pt x="988024" y="723370"/>
                    <a:pt x="981570" y="728496"/>
                  </a:cubicBezTo>
                  <a:cubicBezTo>
                    <a:pt x="977431" y="728685"/>
                    <a:pt x="973292" y="728464"/>
                    <a:pt x="969188" y="727961"/>
                  </a:cubicBezTo>
                  <a:cubicBezTo>
                    <a:pt x="959051" y="736764"/>
                    <a:pt x="952561" y="722270"/>
                    <a:pt x="949229" y="720918"/>
                  </a:cubicBezTo>
                  <a:cubicBezTo>
                    <a:pt x="943231" y="718466"/>
                    <a:pt x="935514" y="725697"/>
                    <a:pt x="930533" y="727961"/>
                  </a:cubicBezTo>
                  <a:lnTo>
                    <a:pt x="927131" y="724566"/>
                  </a:lnTo>
                  <a:cubicBezTo>
                    <a:pt x="926991" y="716831"/>
                    <a:pt x="932603" y="705983"/>
                    <a:pt x="933690" y="696331"/>
                  </a:cubicBezTo>
                  <a:cubicBezTo>
                    <a:pt x="929270" y="689037"/>
                    <a:pt x="925096" y="686616"/>
                    <a:pt x="916432" y="685358"/>
                  </a:cubicBezTo>
                  <a:lnTo>
                    <a:pt x="912048" y="687465"/>
                  </a:lnTo>
                  <a:cubicBezTo>
                    <a:pt x="910434" y="693093"/>
                    <a:pt x="912679" y="701393"/>
                    <a:pt x="913977" y="707053"/>
                  </a:cubicBezTo>
                  <a:lnTo>
                    <a:pt x="910820" y="710731"/>
                  </a:lnTo>
                  <a:lnTo>
                    <a:pt x="905980" y="712303"/>
                  </a:lnTo>
                  <a:cubicBezTo>
                    <a:pt x="893212" y="702871"/>
                    <a:pt x="899350" y="691772"/>
                    <a:pt x="879005" y="680390"/>
                  </a:cubicBezTo>
                  <a:lnTo>
                    <a:pt x="873147" y="680642"/>
                  </a:lnTo>
                  <a:cubicBezTo>
                    <a:pt x="870727" y="683032"/>
                    <a:pt x="868763" y="685798"/>
                    <a:pt x="867325" y="688753"/>
                  </a:cubicBezTo>
                  <a:lnTo>
                    <a:pt x="862449" y="690577"/>
                  </a:lnTo>
                  <a:lnTo>
                    <a:pt x="861502" y="685893"/>
                  </a:lnTo>
                  <a:cubicBezTo>
                    <a:pt x="864659" y="680705"/>
                    <a:pt x="866483" y="670706"/>
                    <a:pt x="862694" y="665487"/>
                  </a:cubicBezTo>
                  <a:cubicBezTo>
                    <a:pt x="857433" y="658224"/>
                    <a:pt x="853224" y="658728"/>
                    <a:pt x="859537" y="648760"/>
                  </a:cubicBezTo>
                  <a:cubicBezTo>
                    <a:pt x="851259" y="641749"/>
                    <a:pt x="862659" y="625494"/>
                    <a:pt x="852242" y="621564"/>
                  </a:cubicBezTo>
                  <a:cubicBezTo>
                    <a:pt x="849926" y="620683"/>
                    <a:pt x="843753" y="622067"/>
                    <a:pt x="841578" y="623136"/>
                  </a:cubicBezTo>
                  <a:cubicBezTo>
                    <a:pt x="837474" y="632065"/>
                    <a:pt x="824531" y="647157"/>
                    <a:pt x="824531" y="656086"/>
                  </a:cubicBezTo>
                  <a:cubicBezTo>
                    <a:pt x="824566" y="667656"/>
                    <a:pt x="834247" y="670172"/>
                    <a:pt x="837685" y="680139"/>
                  </a:cubicBezTo>
                  <a:cubicBezTo>
                    <a:pt x="838632" y="682969"/>
                    <a:pt x="839754" y="685830"/>
                    <a:pt x="840350" y="688753"/>
                  </a:cubicBezTo>
                  <a:cubicBezTo>
                    <a:pt x="841683" y="695388"/>
                    <a:pt x="838878" y="701991"/>
                    <a:pt x="843262" y="708090"/>
                  </a:cubicBezTo>
                  <a:cubicBezTo>
                    <a:pt x="846945" y="713278"/>
                    <a:pt x="853645" y="715888"/>
                    <a:pt x="857854" y="720635"/>
                  </a:cubicBezTo>
                  <a:cubicBezTo>
                    <a:pt x="861923" y="725257"/>
                    <a:pt x="862940" y="732206"/>
                    <a:pt x="867325" y="736325"/>
                  </a:cubicBezTo>
                  <a:cubicBezTo>
                    <a:pt x="869710" y="738588"/>
                    <a:pt x="873077" y="739783"/>
                    <a:pt x="875112" y="742361"/>
                  </a:cubicBezTo>
                  <a:lnTo>
                    <a:pt x="872902" y="745757"/>
                  </a:lnTo>
                  <a:lnTo>
                    <a:pt x="868552" y="747832"/>
                  </a:lnTo>
                  <a:cubicBezTo>
                    <a:pt x="871148" y="760629"/>
                    <a:pt x="880970" y="755158"/>
                    <a:pt x="887494" y="763521"/>
                  </a:cubicBezTo>
                  <a:cubicBezTo>
                    <a:pt x="886301" y="764590"/>
                    <a:pt x="881847" y="768174"/>
                    <a:pt x="880444" y="768489"/>
                  </a:cubicBezTo>
                  <a:cubicBezTo>
                    <a:pt x="879216" y="768804"/>
                    <a:pt x="877848" y="768929"/>
                    <a:pt x="876550" y="769023"/>
                  </a:cubicBezTo>
                  <a:cubicBezTo>
                    <a:pt x="873113" y="769275"/>
                    <a:pt x="867079" y="767294"/>
                    <a:pt x="863431" y="766665"/>
                  </a:cubicBezTo>
                  <a:cubicBezTo>
                    <a:pt x="860204" y="766099"/>
                    <a:pt x="846910" y="765313"/>
                    <a:pt x="845191" y="764056"/>
                  </a:cubicBezTo>
                  <a:cubicBezTo>
                    <a:pt x="843963" y="763113"/>
                    <a:pt x="842911" y="761949"/>
                    <a:pt x="841824" y="760912"/>
                  </a:cubicBezTo>
                  <a:cubicBezTo>
                    <a:pt x="842280" y="757610"/>
                    <a:pt x="842701" y="754309"/>
                    <a:pt x="843016" y="750976"/>
                  </a:cubicBezTo>
                  <a:cubicBezTo>
                    <a:pt x="840806" y="748335"/>
                    <a:pt x="836177" y="746543"/>
                    <a:pt x="832564" y="746260"/>
                  </a:cubicBezTo>
                  <a:lnTo>
                    <a:pt x="831827" y="741575"/>
                  </a:lnTo>
                  <a:cubicBezTo>
                    <a:pt x="833511" y="738840"/>
                    <a:pt x="834493" y="735759"/>
                    <a:pt x="834773" y="732677"/>
                  </a:cubicBezTo>
                  <a:lnTo>
                    <a:pt x="829898" y="730068"/>
                  </a:lnTo>
                  <a:cubicBezTo>
                    <a:pt x="826355" y="730225"/>
                    <a:pt x="822777" y="731105"/>
                    <a:pt x="819690" y="732677"/>
                  </a:cubicBezTo>
                  <a:cubicBezTo>
                    <a:pt x="811553" y="731703"/>
                    <a:pt x="806852" y="729124"/>
                    <a:pt x="803169" y="721956"/>
                  </a:cubicBezTo>
                  <a:cubicBezTo>
                    <a:pt x="795873" y="719629"/>
                    <a:pt x="793593" y="723370"/>
                    <a:pt x="787104" y="724314"/>
                  </a:cubicBezTo>
                  <a:cubicBezTo>
                    <a:pt x="781281" y="725163"/>
                    <a:pt x="775774" y="721547"/>
                    <a:pt x="769846" y="721170"/>
                  </a:cubicBezTo>
                  <a:cubicBezTo>
                    <a:pt x="761708" y="720667"/>
                    <a:pt x="756412" y="723780"/>
                    <a:pt x="748940" y="725100"/>
                  </a:cubicBezTo>
                  <a:cubicBezTo>
                    <a:pt x="746099" y="725603"/>
                    <a:pt x="740452" y="724723"/>
                    <a:pt x="738522" y="726924"/>
                  </a:cubicBezTo>
                  <a:cubicBezTo>
                    <a:pt x="737330" y="728244"/>
                    <a:pt x="736523" y="729910"/>
                    <a:pt x="735576" y="731388"/>
                  </a:cubicBezTo>
                  <a:lnTo>
                    <a:pt x="736558" y="736073"/>
                  </a:lnTo>
                  <a:cubicBezTo>
                    <a:pt x="739610" y="738086"/>
                    <a:pt x="742907" y="739814"/>
                    <a:pt x="746275" y="741293"/>
                  </a:cubicBezTo>
                  <a:lnTo>
                    <a:pt x="748239" y="744185"/>
                  </a:lnTo>
                  <a:cubicBezTo>
                    <a:pt x="746380" y="746763"/>
                    <a:pt x="743749" y="749059"/>
                    <a:pt x="740697" y="750442"/>
                  </a:cubicBezTo>
                  <a:cubicBezTo>
                    <a:pt x="736137" y="752517"/>
                    <a:pt x="730841" y="752768"/>
                    <a:pt x="726351" y="754906"/>
                  </a:cubicBezTo>
                  <a:cubicBezTo>
                    <a:pt x="719651" y="758082"/>
                    <a:pt x="710917" y="762735"/>
                    <a:pt x="703516" y="764307"/>
                  </a:cubicBezTo>
                  <a:cubicBezTo>
                    <a:pt x="700359" y="764967"/>
                    <a:pt x="695483" y="764527"/>
                    <a:pt x="692817" y="765628"/>
                  </a:cubicBezTo>
                  <a:cubicBezTo>
                    <a:pt x="691239" y="766257"/>
                    <a:pt x="690116" y="767451"/>
                    <a:pt x="688678" y="768237"/>
                  </a:cubicBezTo>
                  <a:cubicBezTo>
                    <a:pt x="684258" y="770564"/>
                    <a:pt x="678857" y="770627"/>
                    <a:pt x="674332" y="772671"/>
                  </a:cubicBezTo>
                  <a:cubicBezTo>
                    <a:pt x="670123" y="774588"/>
                    <a:pt x="666931" y="777796"/>
                    <a:pt x="663388" y="780531"/>
                  </a:cubicBezTo>
                  <a:cubicBezTo>
                    <a:pt x="662090" y="787039"/>
                    <a:pt x="669105" y="789964"/>
                    <a:pt x="666299" y="799867"/>
                  </a:cubicBezTo>
                  <a:cubicBezTo>
                    <a:pt x="663458" y="801471"/>
                    <a:pt x="660547" y="802980"/>
                    <a:pt x="657565" y="804300"/>
                  </a:cubicBezTo>
                  <a:lnTo>
                    <a:pt x="658793" y="808482"/>
                  </a:lnTo>
                  <a:cubicBezTo>
                    <a:pt x="669596" y="810054"/>
                    <a:pt x="678471" y="802886"/>
                    <a:pt x="686012" y="797007"/>
                  </a:cubicBezTo>
                  <a:cubicBezTo>
                    <a:pt x="687977" y="775658"/>
                    <a:pt x="711759" y="786222"/>
                    <a:pt x="725860" y="778676"/>
                  </a:cubicBezTo>
                  <a:cubicBezTo>
                    <a:pt x="733927" y="774400"/>
                    <a:pt x="727157" y="768804"/>
                    <a:pt x="745538" y="764842"/>
                  </a:cubicBezTo>
                  <a:cubicBezTo>
                    <a:pt x="763673" y="770532"/>
                    <a:pt x="751361" y="785908"/>
                    <a:pt x="755254" y="790467"/>
                  </a:cubicBezTo>
                  <a:cubicBezTo>
                    <a:pt x="755500" y="790718"/>
                    <a:pt x="758797" y="792604"/>
                    <a:pt x="759639" y="793327"/>
                  </a:cubicBezTo>
                  <a:cubicBezTo>
                    <a:pt x="765847" y="798798"/>
                    <a:pt x="765321" y="807382"/>
                    <a:pt x="764760" y="814236"/>
                  </a:cubicBezTo>
                  <a:cubicBezTo>
                    <a:pt x="761954" y="815808"/>
                    <a:pt x="759358" y="817663"/>
                    <a:pt x="756236" y="818701"/>
                  </a:cubicBezTo>
                  <a:cubicBezTo>
                    <a:pt x="752132" y="820053"/>
                    <a:pt x="718564" y="827536"/>
                    <a:pt x="715407" y="827316"/>
                  </a:cubicBezTo>
                  <a:cubicBezTo>
                    <a:pt x="711654" y="827064"/>
                    <a:pt x="708286" y="824989"/>
                    <a:pt x="704463" y="825241"/>
                  </a:cubicBezTo>
                  <a:cubicBezTo>
                    <a:pt x="701411" y="825429"/>
                    <a:pt x="698359" y="827158"/>
                    <a:pt x="696676" y="829422"/>
                  </a:cubicBezTo>
                  <a:cubicBezTo>
                    <a:pt x="696606" y="844892"/>
                    <a:pt x="710496" y="839578"/>
                    <a:pt x="719055" y="848224"/>
                  </a:cubicBezTo>
                  <a:cubicBezTo>
                    <a:pt x="719721" y="851966"/>
                    <a:pt x="712320" y="860800"/>
                    <a:pt x="712741" y="867309"/>
                  </a:cubicBezTo>
                  <a:cubicBezTo>
                    <a:pt x="712916" y="870422"/>
                    <a:pt x="714951" y="873126"/>
                    <a:pt x="715161" y="876207"/>
                  </a:cubicBezTo>
                  <a:cubicBezTo>
                    <a:pt x="715617" y="883376"/>
                    <a:pt x="709374" y="906422"/>
                    <a:pt x="708111" y="915949"/>
                  </a:cubicBezTo>
                  <a:cubicBezTo>
                    <a:pt x="715232" y="924250"/>
                    <a:pt x="723790" y="919533"/>
                    <a:pt x="728525" y="912018"/>
                  </a:cubicBezTo>
                  <a:cubicBezTo>
                    <a:pt x="729473" y="910509"/>
                    <a:pt x="729262" y="904504"/>
                    <a:pt x="729017" y="902618"/>
                  </a:cubicBezTo>
                  <a:lnTo>
                    <a:pt x="731682" y="903153"/>
                  </a:lnTo>
                  <a:cubicBezTo>
                    <a:pt x="740908" y="911358"/>
                    <a:pt x="740417" y="914094"/>
                    <a:pt x="736067" y="924564"/>
                  </a:cubicBezTo>
                  <a:cubicBezTo>
                    <a:pt x="734699" y="927865"/>
                    <a:pt x="733401" y="931324"/>
                    <a:pt x="731191" y="934248"/>
                  </a:cubicBezTo>
                  <a:cubicBezTo>
                    <a:pt x="730209" y="935568"/>
                    <a:pt x="728666" y="936669"/>
                    <a:pt x="728034" y="938178"/>
                  </a:cubicBezTo>
                  <a:cubicBezTo>
                    <a:pt x="724878" y="945818"/>
                    <a:pt x="726456" y="949685"/>
                    <a:pt x="719546" y="956477"/>
                  </a:cubicBezTo>
                  <a:cubicBezTo>
                    <a:pt x="716144" y="956948"/>
                    <a:pt x="713653" y="959055"/>
                    <a:pt x="710531" y="960124"/>
                  </a:cubicBezTo>
                  <a:cubicBezTo>
                    <a:pt x="705340" y="961916"/>
                    <a:pt x="689555" y="962860"/>
                    <a:pt x="684048" y="961193"/>
                  </a:cubicBezTo>
                  <a:cubicBezTo>
                    <a:pt x="682820" y="960815"/>
                    <a:pt x="677243" y="952515"/>
                    <a:pt x="674577" y="950723"/>
                  </a:cubicBezTo>
                  <a:lnTo>
                    <a:pt x="675524" y="947045"/>
                  </a:lnTo>
                  <a:cubicBezTo>
                    <a:pt x="681768" y="942014"/>
                    <a:pt x="690081" y="945410"/>
                    <a:pt x="697412" y="944435"/>
                  </a:cubicBezTo>
                  <a:lnTo>
                    <a:pt x="700078" y="940002"/>
                  </a:lnTo>
                  <a:lnTo>
                    <a:pt x="696430" y="936858"/>
                  </a:lnTo>
                  <a:cubicBezTo>
                    <a:pt x="688257" y="937581"/>
                    <a:pt x="679699" y="932896"/>
                    <a:pt x="671912" y="931638"/>
                  </a:cubicBezTo>
                  <a:cubicBezTo>
                    <a:pt x="666440" y="930757"/>
                    <a:pt x="661564" y="934027"/>
                    <a:pt x="656092" y="933713"/>
                  </a:cubicBezTo>
                  <a:cubicBezTo>
                    <a:pt x="651532" y="933462"/>
                    <a:pt x="648340" y="931355"/>
                    <a:pt x="644411" y="930852"/>
                  </a:cubicBezTo>
                  <a:cubicBezTo>
                    <a:pt x="642973" y="930664"/>
                    <a:pt x="641500" y="931135"/>
                    <a:pt x="640062" y="931104"/>
                  </a:cubicBezTo>
                  <a:cubicBezTo>
                    <a:pt x="634940" y="931041"/>
                    <a:pt x="617469" y="923117"/>
                    <a:pt x="615017" y="919093"/>
                  </a:cubicBezTo>
                  <a:cubicBezTo>
                    <a:pt x="612961" y="915729"/>
                    <a:pt x="613119" y="908309"/>
                    <a:pt x="616715" y="905762"/>
                  </a:cubicBezTo>
                  <a:cubicBezTo>
                    <a:pt x="620415" y="903153"/>
                    <a:pt x="631994" y="903561"/>
                    <a:pt x="637115" y="901832"/>
                  </a:cubicBezTo>
                  <a:cubicBezTo>
                    <a:pt x="640272" y="900763"/>
                    <a:pt x="642868" y="898782"/>
                    <a:pt x="645639" y="897115"/>
                  </a:cubicBezTo>
                  <a:lnTo>
                    <a:pt x="645148" y="893217"/>
                  </a:lnTo>
                  <a:cubicBezTo>
                    <a:pt x="642166" y="891676"/>
                    <a:pt x="639535" y="889601"/>
                    <a:pt x="637361" y="887180"/>
                  </a:cubicBezTo>
                  <a:cubicBezTo>
                    <a:pt x="638589" y="884193"/>
                    <a:pt x="640167" y="881300"/>
                    <a:pt x="641991" y="878565"/>
                  </a:cubicBezTo>
                  <a:cubicBezTo>
                    <a:pt x="641851" y="870579"/>
                    <a:pt x="630626" y="860675"/>
                    <a:pt x="622786" y="857908"/>
                  </a:cubicBezTo>
                  <a:cubicBezTo>
                    <a:pt x="619742" y="859732"/>
                    <a:pt x="618423" y="862750"/>
                    <a:pt x="616711" y="865486"/>
                  </a:cubicBezTo>
                  <a:cubicBezTo>
                    <a:pt x="605599" y="883344"/>
                    <a:pt x="614613" y="893783"/>
                    <a:pt x="585356" y="903153"/>
                  </a:cubicBezTo>
                  <a:cubicBezTo>
                    <a:pt x="568179" y="898342"/>
                    <a:pt x="579831" y="883973"/>
                    <a:pt x="569799" y="875421"/>
                  </a:cubicBezTo>
                  <a:cubicBezTo>
                    <a:pt x="567604" y="873566"/>
                    <a:pt x="542660" y="870925"/>
                    <a:pt x="538928" y="871491"/>
                  </a:cubicBezTo>
                  <a:cubicBezTo>
                    <a:pt x="511400" y="875798"/>
                    <a:pt x="529384" y="892808"/>
                    <a:pt x="518998" y="912302"/>
                  </a:cubicBezTo>
                  <a:cubicBezTo>
                    <a:pt x="515051" y="910509"/>
                    <a:pt x="510733" y="909409"/>
                    <a:pt x="506356" y="908906"/>
                  </a:cubicBezTo>
                  <a:cubicBezTo>
                    <a:pt x="492578" y="914628"/>
                    <a:pt x="489986" y="906297"/>
                    <a:pt x="477919" y="906799"/>
                  </a:cubicBezTo>
                  <a:cubicBezTo>
                    <a:pt x="474345" y="910007"/>
                    <a:pt x="470472" y="912930"/>
                    <a:pt x="466736" y="915949"/>
                  </a:cubicBezTo>
                  <a:lnTo>
                    <a:pt x="461633" y="916735"/>
                  </a:lnTo>
                  <a:cubicBezTo>
                    <a:pt x="457024" y="912428"/>
                    <a:pt x="445725" y="906076"/>
                    <a:pt x="444863" y="900008"/>
                  </a:cubicBezTo>
                  <a:cubicBezTo>
                    <a:pt x="447420" y="896989"/>
                    <a:pt x="448665" y="893028"/>
                    <a:pt x="448995" y="889286"/>
                  </a:cubicBezTo>
                  <a:lnTo>
                    <a:pt x="446567" y="885640"/>
                  </a:lnTo>
                  <a:cubicBezTo>
                    <a:pt x="428801" y="879131"/>
                    <a:pt x="408972" y="890890"/>
                    <a:pt x="395278" y="871774"/>
                  </a:cubicBezTo>
                  <a:cubicBezTo>
                    <a:pt x="392580" y="868001"/>
                    <a:pt x="388196" y="864794"/>
                    <a:pt x="388957" y="859480"/>
                  </a:cubicBezTo>
                  <a:cubicBezTo>
                    <a:pt x="389101" y="858505"/>
                    <a:pt x="398431" y="845269"/>
                    <a:pt x="400624" y="835710"/>
                  </a:cubicBezTo>
                  <a:cubicBezTo>
                    <a:pt x="399003" y="831466"/>
                    <a:pt x="395288" y="828102"/>
                    <a:pt x="394306" y="823669"/>
                  </a:cubicBezTo>
                  <a:cubicBezTo>
                    <a:pt x="392233" y="814331"/>
                    <a:pt x="397744" y="805841"/>
                    <a:pt x="395762" y="797007"/>
                  </a:cubicBezTo>
                  <a:cubicBezTo>
                    <a:pt x="393373" y="794868"/>
                    <a:pt x="391248" y="792510"/>
                    <a:pt x="389441" y="789932"/>
                  </a:cubicBezTo>
                  <a:cubicBezTo>
                    <a:pt x="392093" y="781505"/>
                    <a:pt x="408646" y="756919"/>
                    <a:pt x="409375" y="751511"/>
                  </a:cubicBezTo>
                  <a:cubicBezTo>
                    <a:pt x="409708" y="749059"/>
                    <a:pt x="407509" y="744719"/>
                    <a:pt x="405731" y="742865"/>
                  </a:cubicBezTo>
                  <a:cubicBezTo>
                    <a:pt x="404289" y="742958"/>
                    <a:pt x="402770" y="742865"/>
                    <a:pt x="401353" y="743147"/>
                  </a:cubicBezTo>
                  <a:cubicBezTo>
                    <a:pt x="398940" y="743588"/>
                    <a:pt x="387751" y="760818"/>
                    <a:pt x="386284" y="763804"/>
                  </a:cubicBezTo>
                  <a:cubicBezTo>
                    <a:pt x="381738" y="772985"/>
                    <a:pt x="383973" y="775689"/>
                    <a:pt x="374372" y="783046"/>
                  </a:cubicBezTo>
                  <a:cubicBezTo>
                    <a:pt x="364568" y="790561"/>
                    <a:pt x="361310" y="782638"/>
                    <a:pt x="350794" y="788360"/>
                  </a:cubicBezTo>
                  <a:lnTo>
                    <a:pt x="351281" y="792290"/>
                  </a:lnTo>
                  <a:cubicBezTo>
                    <a:pt x="355866" y="794711"/>
                    <a:pt x="359573" y="798232"/>
                    <a:pt x="364161" y="800653"/>
                  </a:cubicBezTo>
                  <a:cubicBezTo>
                    <a:pt x="367445" y="807570"/>
                    <a:pt x="368367" y="823763"/>
                    <a:pt x="365620" y="830994"/>
                  </a:cubicBezTo>
                  <a:lnTo>
                    <a:pt x="361246" y="831246"/>
                  </a:lnTo>
                  <a:cubicBezTo>
                    <a:pt x="359159" y="828856"/>
                    <a:pt x="356451" y="826907"/>
                    <a:pt x="353466" y="825492"/>
                  </a:cubicBezTo>
                  <a:cubicBezTo>
                    <a:pt x="350285" y="825712"/>
                    <a:pt x="346721" y="827567"/>
                    <a:pt x="344960" y="829957"/>
                  </a:cubicBezTo>
                  <a:lnTo>
                    <a:pt x="339614" y="830994"/>
                  </a:lnTo>
                  <a:lnTo>
                    <a:pt x="335237" y="827850"/>
                  </a:lnTo>
                  <a:lnTo>
                    <a:pt x="334269" y="823134"/>
                  </a:lnTo>
                  <a:lnTo>
                    <a:pt x="329891" y="820525"/>
                  </a:lnTo>
                  <a:cubicBezTo>
                    <a:pt x="317004" y="822160"/>
                    <a:pt x="319361" y="828448"/>
                    <a:pt x="309231" y="833352"/>
                  </a:cubicBezTo>
                  <a:cubicBezTo>
                    <a:pt x="300188" y="826750"/>
                    <a:pt x="304692" y="809331"/>
                    <a:pt x="290272" y="798295"/>
                  </a:cubicBezTo>
                  <a:lnTo>
                    <a:pt x="285410" y="799616"/>
                  </a:lnTo>
                  <a:cubicBezTo>
                    <a:pt x="284614" y="807917"/>
                    <a:pt x="290286" y="815399"/>
                    <a:pt x="289784" y="823669"/>
                  </a:cubicBezTo>
                  <a:cubicBezTo>
                    <a:pt x="289399" y="830083"/>
                    <a:pt x="283597" y="844797"/>
                    <a:pt x="278847" y="849545"/>
                  </a:cubicBezTo>
                  <a:cubicBezTo>
                    <a:pt x="274649" y="853758"/>
                    <a:pt x="270545" y="853381"/>
                    <a:pt x="265964" y="856336"/>
                  </a:cubicBezTo>
                  <a:cubicBezTo>
                    <a:pt x="263270" y="858065"/>
                    <a:pt x="261176" y="860455"/>
                    <a:pt x="258183" y="861838"/>
                  </a:cubicBezTo>
                  <a:cubicBezTo>
                    <a:pt x="251477" y="864919"/>
                    <a:pt x="239175" y="866554"/>
                    <a:pt x="231936" y="864700"/>
                  </a:cubicBezTo>
                  <a:lnTo>
                    <a:pt x="235338" y="865486"/>
                  </a:lnTo>
                  <a:cubicBezTo>
                    <a:pt x="224517" y="864291"/>
                    <a:pt x="222335" y="856242"/>
                    <a:pt x="210058" y="860266"/>
                  </a:cubicBezTo>
                  <a:lnTo>
                    <a:pt x="207143" y="864700"/>
                  </a:lnTo>
                  <a:lnTo>
                    <a:pt x="203737" y="864700"/>
                  </a:lnTo>
                  <a:cubicBezTo>
                    <a:pt x="198034" y="858600"/>
                    <a:pt x="201064" y="855581"/>
                    <a:pt x="191583" y="850582"/>
                  </a:cubicBezTo>
                  <a:cubicBezTo>
                    <a:pt x="180948" y="851054"/>
                    <a:pt x="168667" y="846023"/>
                    <a:pt x="159744" y="847469"/>
                  </a:cubicBezTo>
                  <a:cubicBezTo>
                    <a:pt x="158948" y="847595"/>
                    <a:pt x="158186" y="848004"/>
                    <a:pt x="157415" y="848193"/>
                  </a:cubicBezTo>
                  <a:cubicBezTo>
                    <a:pt x="156832" y="845332"/>
                    <a:pt x="158267" y="838761"/>
                    <a:pt x="160256" y="836559"/>
                  </a:cubicBezTo>
                  <a:cubicBezTo>
                    <a:pt x="162683" y="833856"/>
                    <a:pt x="166879" y="832629"/>
                    <a:pt x="169232" y="828636"/>
                  </a:cubicBezTo>
                  <a:cubicBezTo>
                    <a:pt x="171537" y="824737"/>
                    <a:pt x="173981" y="819676"/>
                    <a:pt x="175669" y="815494"/>
                  </a:cubicBezTo>
                  <a:cubicBezTo>
                    <a:pt x="176458" y="813576"/>
                    <a:pt x="176279" y="809897"/>
                    <a:pt x="176132" y="808011"/>
                  </a:cubicBezTo>
                  <a:cubicBezTo>
                    <a:pt x="174971" y="792667"/>
                    <a:pt x="171737" y="798358"/>
                    <a:pt x="167159" y="786222"/>
                  </a:cubicBezTo>
                  <a:cubicBezTo>
                    <a:pt x="164616" y="779462"/>
                    <a:pt x="163964" y="771350"/>
                    <a:pt x="156576" y="767232"/>
                  </a:cubicBezTo>
                  <a:cubicBezTo>
                    <a:pt x="151150" y="769149"/>
                    <a:pt x="146257" y="767043"/>
                    <a:pt x="142146" y="764025"/>
                  </a:cubicBezTo>
                  <a:cubicBezTo>
                    <a:pt x="141486" y="763553"/>
                    <a:pt x="140915" y="763427"/>
                    <a:pt x="140459" y="762798"/>
                  </a:cubicBezTo>
                  <a:cubicBezTo>
                    <a:pt x="140371" y="762672"/>
                    <a:pt x="136193" y="753680"/>
                    <a:pt x="136085" y="753366"/>
                  </a:cubicBezTo>
                  <a:cubicBezTo>
                    <a:pt x="135608" y="751951"/>
                    <a:pt x="136744" y="749624"/>
                    <a:pt x="134689" y="745946"/>
                  </a:cubicBezTo>
                  <a:cubicBezTo>
                    <a:pt x="131935" y="745757"/>
                    <a:pt x="122212" y="744437"/>
                    <a:pt x="119977" y="742739"/>
                  </a:cubicBezTo>
                  <a:lnTo>
                    <a:pt x="116287" y="738274"/>
                  </a:lnTo>
                  <a:cubicBezTo>
                    <a:pt x="115295" y="736827"/>
                    <a:pt x="114761" y="735004"/>
                    <a:pt x="113758" y="733557"/>
                  </a:cubicBezTo>
                  <a:cubicBezTo>
                    <a:pt x="110780" y="729282"/>
                    <a:pt x="105508" y="725383"/>
                    <a:pt x="101088" y="722428"/>
                  </a:cubicBezTo>
                  <a:cubicBezTo>
                    <a:pt x="97353" y="713718"/>
                    <a:pt x="104880" y="705229"/>
                    <a:pt x="94652" y="694947"/>
                  </a:cubicBezTo>
                  <a:cubicBezTo>
                    <a:pt x="90506" y="690798"/>
                    <a:pt x="85679" y="686050"/>
                    <a:pt x="81073" y="682309"/>
                  </a:cubicBezTo>
                  <a:cubicBezTo>
                    <a:pt x="78439" y="680170"/>
                    <a:pt x="74206" y="677561"/>
                    <a:pt x="71171" y="675894"/>
                  </a:cubicBezTo>
                  <a:cubicBezTo>
                    <a:pt x="68327" y="674291"/>
                    <a:pt x="64700" y="673379"/>
                    <a:pt x="61971" y="671681"/>
                  </a:cubicBezTo>
                  <a:cubicBezTo>
                    <a:pt x="58463" y="669480"/>
                    <a:pt x="56878" y="664859"/>
                    <a:pt x="54618" y="663003"/>
                  </a:cubicBezTo>
                  <a:cubicBezTo>
                    <a:pt x="51939" y="660802"/>
                    <a:pt x="47372" y="659388"/>
                    <a:pt x="44941" y="657061"/>
                  </a:cubicBezTo>
                  <a:lnTo>
                    <a:pt x="39641" y="648634"/>
                  </a:lnTo>
                  <a:cubicBezTo>
                    <a:pt x="39514" y="648257"/>
                    <a:pt x="35730" y="628795"/>
                    <a:pt x="35723" y="628607"/>
                  </a:cubicBezTo>
                  <a:cubicBezTo>
                    <a:pt x="35600" y="624990"/>
                    <a:pt x="38003" y="619048"/>
                    <a:pt x="38490" y="615213"/>
                  </a:cubicBezTo>
                  <a:cubicBezTo>
                    <a:pt x="39294" y="608924"/>
                    <a:pt x="34418" y="603359"/>
                    <a:pt x="32966" y="597637"/>
                  </a:cubicBezTo>
                  <a:cubicBezTo>
                    <a:pt x="31868" y="593329"/>
                    <a:pt x="33088" y="588582"/>
                    <a:pt x="31134" y="584274"/>
                  </a:cubicBezTo>
                  <a:cubicBezTo>
                    <a:pt x="28206" y="581287"/>
                    <a:pt x="24698" y="579810"/>
                    <a:pt x="21464" y="577357"/>
                  </a:cubicBezTo>
                  <a:cubicBezTo>
                    <a:pt x="16560" y="573616"/>
                    <a:pt x="15862" y="569591"/>
                    <a:pt x="12712" y="564969"/>
                  </a:cubicBezTo>
                  <a:cubicBezTo>
                    <a:pt x="5532" y="554468"/>
                    <a:pt x="-1655" y="550412"/>
                    <a:pt x="337" y="537521"/>
                  </a:cubicBezTo>
                  <a:lnTo>
                    <a:pt x="2372" y="539219"/>
                  </a:lnTo>
                  <a:cubicBezTo>
                    <a:pt x="9376" y="539439"/>
                    <a:pt x="17970" y="533780"/>
                    <a:pt x="23537" y="530541"/>
                  </a:cubicBezTo>
                  <a:cubicBezTo>
                    <a:pt x="24358" y="525825"/>
                    <a:pt x="30861" y="522303"/>
                    <a:pt x="35491" y="520888"/>
                  </a:cubicBezTo>
                  <a:cubicBezTo>
                    <a:pt x="39585" y="517618"/>
                    <a:pt x="40363" y="511456"/>
                    <a:pt x="38266" y="507023"/>
                  </a:cubicBezTo>
                  <a:cubicBezTo>
                    <a:pt x="35309" y="500797"/>
                    <a:pt x="30135" y="496427"/>
                    <a:pt x="31812" y="488976"/>
                  </a:cubicBezTo>
                  <a:lnTo>
                    <a:pt x="39865" y="481021"/>
                  </a:lnTo>
                  <a:lnTo>
                    <a:pt x="40795" y="472123"/>
                  </a:lnTo>
                  <a:cubicBezTo>
                    <a:pt x="43289" y="469199"/>
                    <a:pt x="46105" y="466274"/>
                    <a:pt x="48392" y="463225"/>
                  </a:cubicBezTo>
                  <a:cubicBezTo>
                    <a:pt x="49003" y="462407"/>
                    <a:pt x="49894" y="459893"/>
                    <a:pt x="50469" y="459263"/>
                  </a:cubicBezTo>
                  <a:cubicBezTo>
                    <a:pt x="58021" y="450869"/>
                    <a:pt x="69803" y="451434"/>
                    <a:pt x="73637" y="438292"/>
                  </a:cubicBezTo>
                  <a:cubicBezTo>
                    <a:pt x="74588" y="435022"/>
                    <a:pt x="75914" y="431501"/>
                    <a:pt x="75545" y="428042"/>
                  </a:cubicBezTo>
                  <a:cubicBezTo>
                    <a:pt x="77646" y="425999"/>
                    <a:pt x="79586" y="421943"/>
                    <a:pt x="79699" y="419144"/>
                  </a:cubicBezTo>
                  <a:lnTo>
                    <a:pt x="76475" y="415182"/>
                  </a:lnTo>
                  <a:cubicBezTo>
                    <a:pt x="73283" y="414491"/>
                    <a:pt x="69582" y="413328"/>
                    <a:pt x="66352" y="412950"/>
                  </a:cubicBezTo>
                  <a:cubicBezTo>
                    <a:pt x="62609" y="412542"/>
                    <a:pt x="60476" y="414428"/>
                    <a:pt x="56218" y="411472"/>
                  </a:cubicBezTo>
                  <a:cubicBezTo>
                    <a:pt x="54075" y="408800"/>
                    <a:pt x="52051" y="405467"/>
                    <a:pt x="50939" y="402292"/>
                  </a:cubicBezTo>
                  <a:cubicBezTo>
                    <a:pt x="53643" y="397953"/>
                    <a:pt x="50672" y="393173"/>
                    <a:pt x="54145" y="389180"/>
                  </a:cubicBezTo>
                  <a:lnTo>
                    <a:pt x="64496" y="383018"/>
                  </a:lnTo>
                  <a:lnTo>
                    <a:pt x="65191" y="378553"/>
                  </a:lnTo>
                  <a:cubicBezTo>
                    <a:pt x="61651" y="374246"/>
                    <a:pt x="57596" y="369907"/>
                    <a:pt x="54384" y="365411"/>
                  </a:cubicBezTo>
                  <a:cubicBezTo>
                    <a:pt x="52409" y="362675"/>
                    <a:pt x="53142" y="360412"/>
                    <a:pt x="49083" y="357016"/>
                  </a:cubicBezTo>
                  <a:lnTo>
                    <a:pt x="48389" y="352551"/>
                  </a:lnTo>
                  <a:lnTo>
                    <a:pt x="43320" y="348842"/>
                  </a:lnTo>
                  <a:cubicBezTo>
                    <a:pt x="42159" y="346641"/>
                    <a:pt x="41595" y="342490"/>
                    <a:pt x="42626" y="340164"/>
                  </a:cubicBezTo>
                  <a:cubicBezTo>
                    <a:pt x="38869" y="336171"/>
                    <a:pt x="32418" y="337083"/>
                    <a:pt x="27438" y="334975"/>
                  </a:cubicBezTo>
                  <a:cubicBezTo>
                    <a:pt x="27076" y="334473"/>
                    <a:pt x="24214" y="330448"/>
                    <a:pt x="23993" y="330259"/>
                  </a:cubicBezTo>
                  <a:cubicBezTo>
                    <a:pt x="23523" y="329851"/>
                    <a:pt x="19685" y="328310"/>
                    <a:pt x="18942" y="327776"/>
                  </a:cubicBezTo>
                  <a:cubicBezTo>
                    <a:pt x="16764" y="326267"/>
                    <a:pt x="12242" y="321488"/>
                    <a:pt x="11330" y="319130"/>
                  </a:cubicBezTo>
                  <a:cubicBezTo>
                    <a:pt x="8910" y="312841"/>
                    <a:pt x="16406" y="305924"/>
                    <a:pt x="20541" y="301805"/>
                  </a:cubicBezTo>
                  <a:cubicBezTo>
                    <a:pt x="23435" y="298912"/>
                    <a:pt x="26613" y="297184"/>
                    <a:pt x="28367" y="293379"/>
                  </a:cubicBezTo>
                  <a:lnTo>
                    <a:pt x="27217" y="284450"/>
                  </a:lnTo>
                  <a:lnTo>
                    <a:pt x="31134" y="280488"/>
                  </a:lnTo>
                  <a:lnTo>
                    <a:pt x="30212" y="276306"/>
                  </a:lnTo>
                  <a:cubicBezTo>
                    <a:pt x="31499" y="274263"/>
                    <a:pt x="35940" y="269074"/>
                    <a:pt x="38027" y="267880"/>
                  </a:cubicBezTo>
                  <a:cubicBezTo>
                    <a:pt x="39809" y="266842"/>
                    <a:pt x="44744" y="265993"/>
                    <a:pt x="48392" y="263667"/>
                  </a:cubicBezTo>
                  <a:cubicBezTo>
                    <a:pt x="44797" y="258070"/>
                    <a:pt x="37487" y="248198"/>
                    <a:pt x="36877" y="241375"/>
                  </a:cubicBezTo>
                  <a:cubicBezTo>
                    <a:pt x="37343" y="238451"/>
                    <a:pt x="40963" y="234583"/>
                    <a:pt x="43787" y="233200"/>
                  </a:cubicBezTo>
                  <a:lnTo>
                    <a:pt x="45853" y="225057"/>
                  </a:lnTo>
                  <a:cubicBezTo>
                    <a:pt x="56267" y="220781"/>
                    <a:pt x="53664" y="211726"/>
                    <a:pt x="55078" y="203268"/>
                  </a:cubicBezTo>
                  <a:cubicBezTo>
                    <a:pt x="55590" y="200187"/>
                    <a:pt x="56793" y="196885"/>
                    <a:pt x="57614" y="193836"/>
                  </a:cubicBezTo>
                  <a:cubicBezTo>
                    <a:pt x="60234" y="191320"/>
                    <a:pt x="63816" y="188742"/>
                    <a:pt x="67274" y="187170"/>
                  </a:cubicBezTo>
                  <a:cubicBezTo>
                    <a:pt x="68842" y="185252"/>
                    <a:pt x="69737" y="182611"/>
                    <a:pt x="70340" y="180379"/>
                  </a:cubicBezTo>
                  <a:cubicBezTo>
                    <a:pt x="71234" y="177109"/>
                    <a:pt x="72329" y="173745"/>
                    <a:pt x="72329" y="170318"/>
                  </a:cubicBezTo>
                  <a:cubicBezTo>
                    <a:pt x="72329" y="165790"/>
                    <a:pt x="70817" y="161042"/>
                    <a:pt x="71413" y="156452"/>
                  </a:cubicBezTo>
                  <a:cubicBezTo>
                    <a:pt x="71585" y="155131"/>
                    <a:pt x="72522" y="153559"/>
                    <a:pt x="72567" y="152239"/>
                  </a:cubicBezTo>
                  <a:cubicBezTo>
                    <a:pt x="72855" y="143781"/>
                    <a:pt x="69228" y="135669"/>
                    <a:pt x="77853" y="129223"/>
                  </a:cubicBezTo>
                  <a:cubicBezTo>
                    <a:pt x="80502" y="130670"/>
                    <a:pt x="85693" y="131393"/>
                    <a:pt x="88664" y="130482"/>
                  </a:cubicBezTo>
                  <a:cubicBezTo>
                    <a:pt x="88338" y="127872"/>
                    <a:pt x="89825" y="123816"/>
                    <a:pt x="91656" y="121804"/>
                  </a:cubicBezTo>
                  <a:lnTo>
                    <a:pt x="96493" y="120074"/>
                  </a:lnTo>
                  <a:cubicBezTo>
                    <a:pt x="100892" y="111554"/>
                    <a:pt x="109002" y="111994"/>
                    <a:pt x="115147" y="108692"/>
                  </a:cubicBezTo>
                  <a:lnTo>
                    <a:pt x="118206" y="105705"/>
                  </a:lnTo>
                  <a:lnTo>
                    <a:pt x="119735" y="104228"/>
                  </a:lnTo>
                  <a:lnTo>
                    <a:pt x="120668" y="95330"/>
                  </a:lnTo>
                  <a:cubicBezTo>
                    <a:pt x="123050" y="92374"/>
                    <a:pt x="126635" y="89325"/>
                    <a:pt x="130097" y="87406"/>
                  </a:cubicBezTo>
                  <a:lnTo>
                    <a:pt x="131247" y="82942"/>
                  </a:lnTo>
                  <a:lnTo>
                    <a:pt x="135622" y="78980"/>
                  </a:lnTo>
                  <a:lnTo>
                    <a:pt x="136772" y="69579"/>
                  </a:lnTo>
                  <a:lnTo>
                    <a:pt x="140224" y="65366"/>
                  </a:lnTo>
                  <a:cubicBezTo>
                    <a:pt x="143300" y="65460"/>
                    <a:pt x="147670" y="67536"/>
                    <a:pt x="149908" y="69328"/>
                  </a:cubicBezTo>
                  <a:lnTo>
                    <a:pt x="165093" y="67095"/>
                  </a:lnTo>
                  <a:lnTo>
                    <a:pt x="171768" y="58669"/>
                  </a:lnTo>
                  <a:cubicBezTo>
                    <a:pt x="176535" y="57223"/>
                    <a:pt x="182530" y="54739"/>
                    <a:pt x="187405" y="53953"/>
                  </a:cubicBezTo>
                  <a:cubicBezTo>
                    <a:pt x="187662" y="53922"/>
                    <a:pt x="196894" y="54424"/>
                    <a:pt x="197767" y="54456"/>
                  </a:cubicBezTo>
                  <a:cubicBezTo>
                    <a:pt x="202965" y="51343"/>
                    <a:pt x="203699" y="46124"/>
                    <a:pt x="207901" y="42320"/>
                  </a:cubicBezTo>
                  <a:lnTo>
                    <a:pt x="213201" y="40590"/>
                  </a:lnTo>
                  <a:lnTo>
                    <a:pt x="217803" y="42823"/>
                  </a:lnTo>
                  <a:lnTo>
                    <a:pt x="223328" y="41345"/>
                  </a:lnTo>
                  <a:cubicBezTo>
                    <a:pt x="223436" y="36566"/>
                    <a:pt x="226327" y="31473"/>
                    <a:pt x="230908" y="28957"/>
                  </a:cubicBezTo>
                  <a:lnTo>
                    <a:pt x="228614" y="24492"/>
                  </a:lnTo>
                  <a:cubicBezTo>
                    <a:pt x="230967" y="22228"/>
                    <a:pt x="233219" y="19210"/>
                    <a:pt x="234587" y="16318"/>
                  </a:cubicBezTo>
                  <a:lnTo>
                    <a:pt x="232760" y="12356"/>
                  </a:lnTo>
                  <a:lnTo>
                    <a:pt x="233447" y="7923"/>
                  </a:lnTo>
                  <a:cubicBezTo>
                    <a:pt x="237488" y="10093"/>
                    <a:pt x="244896" y="10501"/>
                    <a:pt x="248867" y="7923"/>
                  </a:cubicBezTo>
                  <a:lnTo>
                    <a:pt x="255181" y="2641"/>
                  </a:lnTo>
                  <a:lnTo>
                    <a:pt x="258334" y="0"/>
                  </a:lnTo>
                  <a:cubicBezTo>
                    <a:pt x="260772" y="3773"/>
                    <a:pt x="258997" y="9181"/>
                    <a:pt x="257159" y="12859"/>
                  </a:cubicBezTo>
                  <a:cubicBezTo>
                    <a:pt x="257184" y="15689"/>
                    <a:pt x="258696" y="18047"/>
                    <a:pt x="260456" y="20217"/>
                  </a:cubicBezTo>
                  <a:cubicBezTo>
                    <a:pt x="264150" y="24744"/>
                    <a:pt x="271699" y="24587"/>
                    <a:pt x="277174" y="23015"/>
                  </a:cubicBezTo>
                  <a:cubicBezTo>
                    <a:pt x="278746" y="22575"/>
                    <a:pt x="280436" y="21348"/>
                    <a:pt x="282011" y="21034"/>
                  </a:cubicBezTo>
                  <a:cubicBezTo>
                    <a:pt x="282323" y="20971"/>
                    <a:pt x="286480" y="21034"/>
                    <a:pt x="287066" y="21034"/>
                  </a:cubicBezTo>
                  <a:cubicBezTo>
                    <a:pt x="287613" y="24052"/>
                    <a:pt x="290356" y="28140"/>
                    <a:pt x="292826" y="30215"/>
                  </a:cubicBezTo>
                  <a:cubicBezTo>
                    <a:pt x="292243" y="34711"/>
                    <a:pt x="293583" y="40025"/>
                    <a:pt x="297200" y="43325"/>
                  </a:cubicBezTo>
                  <a:lnTo>
                    <a:pt x="296049" y="47759"/>
                  </a:lnTo>
                  <a:lnTo>
                    <a:pt x="291208" y="52224"/>
                  </a:lnTo>
                  <a:lnTo>
                    <a:pt x="295811" y="53482"/>
                  </a:lnTo>
                  <a:cubicBezTo>
                    <a:pt x="300002" y="51658"/>
                    <a:pt x="303338" y="52570"/>
                    <a:pt x="306179" y="51721"/>
                  </a:cubicBezTo>
                  <a:cubicBezTo>
                    <a:pt x="309305" y="50809"/>
                    <a:pt x="311560" y="48293"/>
                    <a:pt x="316078" y="47539"/>
                  </a:cubicBezTo>
                  <a:cubicBezTo>
                    <a:pt x="319028" y="50023"/>
                    <a:pt x="326117" y="55054"/>
                    <a:pt x="330337" y="55714"/>
                  </a:cubicBezTo>
                  <a:lnTo>
                    <a:pt x="335637" y="52224"/>
                  </a:lnTo>
                  <a:lnTo>
                    <a:pt x="341161" y="52727"/>
                  </a:lnTo>
                  <a:lnTo>
                    <a:pt x="350376" y="70051"/>
                  </a:lnTo>
                  <a:cubicBezTo>
                    <a:pt x="353779" y="70774"/>
                    <a:pt x="358089" y="73572"/>
                    <a:pt x="360492" y="75742"/>
                  </a:cubicBezTo>
                  <a:cubicBezTo>
                    <a:pt x="363667" y="75428"/>
                    <a:pt x="367532" y="75396"/>
                    <a:pt x="370608" y="74767"/>
                  </a:cubicBezTo>
                  <a:cubicBezTo>
                    <a:pt x="372369" y="74390"/>
                    <a:pt x="374155" y="72944"/>
                    <a:pt x="375919" y="72535"/>
                  </a:cubicBezTo>
                  <a:cubicBezTo>
                    <a:pt x="380703" y="71403"/>
                    <a:pt x="388115" y="73415"/>
                    <a:pt x="391574" y="76496"/>
                  </a:cubicBezTo>
                  <a:cubicBezTo>
                    <a:pt x="394078" y="74893"/>
                    <a:pt x="398551" y="73289"/>
                    <a:pt x="401686" y="73289"/>
                  </a:cubicBezTo>
                  <a:cubicBezTo>
                    <a:pt x="403865" y="70994"/>
                    <a:pt x="408597" y="68133"/>
                    <a:pt x="412027" y="67850"/>
                  </a:cubicBezTo>
                  <a:cubicBezTo>
                    <a:pt x="416871" y="68510"/>
                    <a:pt x="423666" y="71969"/>
                    <a:pt x="427682" y="74264"/>
                  </a:cubicBezTo>
                  <a:lnTo>
                    <a:pt x="432764" y="74044"/>
                  </a:lnTo>
                  <a:cubicBezTo>
                    <a:pt x="435676" y="75742"/>
                    <a:pt x="439306" y="78446"/>
                    <a:pt x="442425" y="79735"/>
                  </a:cubicBezTo>
                  <a:cubicBezTo>
                    <a:pt x="445315" y="80899"/>
                    <a:pt x="448570" y="79326"/>
                    <a:pt x="453449" y="82942"/>
                  </a:cubicBezTo>
                  <a:cubicBezTo>
                    <a:pt x="456494" y="86966"/>
                    <a:pt x="454933" y="92783"/>
                    <a:pt x="455294" y="97279"/>
                  </a:cubicBezTo>
                  <a:cubicBezTo>
                    <a:pt x="455491" y="99700"/>
                    <a:pt x="456873" y="102593"/>
                    <a:pt x="457925" y="104731"/>
                  </a:cubicBezTo>
                  <a:lnTo>
                    <a:pt x="460858" y="110673"/>
                  </a:lnTo>
                  <a:cubicBezTo>
                    <a:pt x="464769" y="116207"/>
                    <a:pt x="473811" y="118691"/>
                    <a:pt x="480634" y="116615"/>
                  </a:cubicBezTo>
                  <a:cubicBezTo>
                    <a:pt x="489568" y="123658"/>
                    <a:pt x="485741" y="126865"/>
                    <a:pt x="488926" y="134915"/>
                  </a:cubicBezTo>
                  <a:cubicBezTo>
                    <a:pt x="494609" y="139379"/>
                    <a:pt x="502876" y="140071"/>
                    <a:pt x="508015" y="145070"/>
                  </a:cubicBezTo>
                  <a:cubicBezTo>
                    <a:pt x="509941" y="146957"/>
                    <a:pt x="515567" y="155980"/>
                    <a:pt x="516307" y="157961"/>
                  </a:cubicBezTo>
                  <a:cubicBezTo>
                    <a:pt x="516528" y="158527"/>
                    <a:pt x="516307" y="158904"/>
                    <a:pt x="516307" y="159502"/>
                  </a:cubicBezTo>
                  <a:cubicBezTo>
                    <a:pt x="516307" y="163023"/>
                    <a:pt x="516083" y="161891"/>
                    <a:pt x="517230" y="165790"/>
                  </a:cubicBezTo>
                  <a:lnTo>
                    <a:pt x="519064" y="172047"/>
                  </a:lnTo>
                  <a:cubicBezTo>
                    <a:pt x="519064" y="174688"/>
                    <a:pt x="516932" y="177581"/>
                    <a:pt x="517900" y="180473"/>
                  </a:cubicBezTo>
                  <a:cubicBezTo>
                    <a:pt x="519460" y="185126"/>
                    <a:pt x="525831" y="199621"/>
                    <a:pt x="523438" y="203991"/>
                  </a:cubicBezTo>
                  <a:lnTo>
                    <a:pt x="513073" y="206727"/>
                  </a:lnTo>
                  <a:lnTo>
                    <a:pt x="505710" y="214650"/>
                  </a:lnTo>
                  <a:cubicBezTo>
                    <a:pt x="503374" y="215907"/>
                    <a:pt x="498597" y="216473"/>
                    <a:pt x="496050" y="215373"/>
                  </a:cubicBezTo>
                  <a:lnTo>
                    <a:pt x="490768" y="217133"/>
                  </a:lnTo>
                  <a:cubicBezTo>
                    <a:pt x="488951" y="220058"/>
                    <a:pt x="486025" y="227509"/>
                    <a:pt x="487530" y="230968"/>
                  </a:cubicBezTo>
                  <a:cubicBezTo>
                    <a:pt x="494812" y="231502"/>
                    <a:pt x="499137" y="227038"/>
                    <a:pt x="508011" y="229993"/>
                  </a:cubicBezTo>
                  <a:lnTo>
                    <a:pt x="516991" y="238419"/>
                  </a:lnTo>
                  <a:cubicBezTo>
                    <a:pt x="520032" y="238200"/>
                    <a:pt x="524638" y="240495"/>
                    <a:pt x="526651" y="242381"/>
                  </a:cubicBezTo>
                  <a:lnTo>
                    <a:pt x="542759" y="243607"/>
                  </a:lnTo>
                  <a:lnTo>
                    <a:pt x="547589" y="240400"/>
                  </a:lnTo>
                  <a:cubicBezTo>
                    <a:pt x="547638" y="237633"/>
                    <a:pt x="549974" y="233577"/>
                    <a:pt x="552191" y="231723"/>
                  </a:cubicBezTo>
                  <a:cubicBezTo>
                    <a:pt x="557842" y="231471"/>
                    <a:pt x="563703" y="237099"/>
                    <a:pt x="566253" y="241123"/>
                  </a:cubicBezTo>
                  <a:lnTo>
                    <a:pt x="569708" y="240558"/>
                  </a:lnTo>
                  <a:lnTo>
                    <a:pt x="576618" y="239394"/>
                  </a:lnTo>
                  <a:cubicBezTo>
                    <a:pt x="579253" y="238545"/>
                    <a:pt x="582743" y="235181"/>
                    <a:pt x="586506" y="233955"/>
                  </a:cubicBezTo>
                  <a:cubicBezTo>
                    <a:pt x="591778" y="235212"/>
                    <a:pt x="598394" y="233766"/>
                    <a:pt x="602614" y="230748"/>
                  </a:cubicBezTo>
                  <a:cubicBezTo>
                    <a:pt x="607444" y="229773"/>
                    <a:pt x="618219" y="237633"/>
                    <a:pt x="622639" y="239646"/>
                  </a:cubicBezTo>
                  <a:cubicBezTo>
                    <a:pt x="628627" y="242381"/>
                    <a:pt x="637291" y="237319"/>
                    <a:pt x="643113" y="241375"/>
                  </a:cubicBezTo>
                  <a:cubicBezTo>
                    <a:pt x="646270" y="244739"/>
                    <a:pt x="650865" y="249959"/>
                    <a:pt x="652339" y="254266"/>
                  </a:cubicBezTo>
                  <a:cubicBezTo>
                    <a:pt x="653321" y="257127"/>
                    <a:pt x="653601" y="260680"/>
                    <a:pt x="654864" y="263415"/>
                  </a:cubicBezTo>
                  <a:cubicBezTo>
                    <a:pt x="657074" y="268320"/>
                    <a:pt x="663493" y="271496"/>
                    <a:pt x="668930" y="272817"/>
                  </a:cubicBezTo>
                  <a:lnTo>
                    <a:pt x="679383" y="268540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69" name="자유형: 도형 310"/>
            <p:cNvSpPr/>
            <p:nvPr/>
          </p:nvSpPr>
          <p:spPr>
            <a:xfrm>
              <a:off x="6300720" y="3781440"/>
              <a:ext cx="1613520" cy="1314720"/>
            </a:xfrm>
            <a:custGeom>
              <a:avLst/>
              <a:gdLst/>
              <a:ahLst/>
              <a:cxnLst/>
              <a:rect l="l" t="t" r="r" b="b"/>
              <a:pathLst>
                <a:path w="1277592" h="1070546">
                  <a:moveTo>
                    <a:pt x="1101669" y="157207"/>
                  </a:moveTo>
                  <a:cubicBezTo>
                    <a:pt x="1099680" y="170097"/>
                    <a:pt x="1106864" y="174153"/>
                    <a:pt x="1114044" y="184655"/>
                  </a:cubicBezTo>
                  <a:cubicBezTo>
                    <a:pt x="1117194" y="189277"/>
                    <a:pt x="1117892" y="193301"/>
                    <a:pt x="1122796" y="197043"/>
                  </a:cubicBezTo>
                  <a:cubicBezTo>
                    <a:pt x="1126030" y="199495"/>
                    <a:pt x="1129538" y="200973"/>
                    <a:pt x="1132467" y="203960"/>
                  </a:cubicBezTo>
                  <a:cubicBezTo>
                    <a:pt x="1134424" y="208267"/>
                    <a:pt x="1133200" y="213015"/>
                    <a:pt x="1134298" y="217354"/>
                  </a:cubicBezTo>
                  <a:cubicBezTo>
                    <a:pt x="1135750" y="223045"/>
                    <a:pt x="1140629" y="228610"/>
                    <a:pt x="1139822" y="234930"/>
                  </a:cubicBezTo>
                  <a:cubicBezTo>
                    <a:pt x="1139335" y="238765"/>
                    <a:pt x="1136932" y="244676"/>
                    <a:pt x="1137055" y="248292"/>
                  </a:cubicBezTo>
                  <a:cubicBezTo>
                    <a:pt x="1137062" y="248481"/>
                    <a:pt x="1140847" y="267943"/>
                    <a:pt x="1140973" y="268351"/>
                  </a:cubicBezTo>
                  <a:lnTo>
                    <a:pt x="1146273" y="276747"/>
                  </a:lnTo>
                  <a:cubicBezTo>
                    <a:pt x="1148700" y="279073"/>
                    <a:pt x="1153271" y="280488"/>
                    <a:pt x="1155951" y="282689"/>
                  </a:cubicBezTo>
                  <a:cubicBezTo>
                    <a:pt x="1158210" y="284544"/>
                    <a:pt x="1159795" y="289197"/>
                    <a:pt x="1163303" y="291367"/>
                  </a:cubicBezTo>
                  <a:cubicBezTo>
                    <a:pt x="1166032" y="293065"/>
                    <a:pt x="1169662" y="294008"/>
                    <a:pt x="1172503" y="295580"/>
                  </a:cubicBezTo>
                  <a:cubicBezTo>
                    <a:pt x="1175538" y="297278"/>
                    <a:pt x="1179771" y="299887"/>
                    <a:pt x="1182406" y="301994"/>
                  </a:cubicBezTo>
                  <a:cubicBezTo>
                    <a:pt x="1187011" y="305736"/>
                    <a:pt x="1191838" y="310483"/>
                    <a:pt x="1195984" y="314633"/>
                  </a:cubicBezTo>
                  <a:cubicBezTo>
                    <a:pt x="1206212" y="324914"/>
                    <a:pt x="1198685" y="333404"/>
                    <a:pt x="1202420" y="342113"/>
                  </a:cubicBezTo>
                  <a:cubicBezTo>
                    <a:pt x="1206844" y="345100"/>
                    <a:pt x="1212116" y="348999"/>
                    <a:pt x="1215090" y="353275"/>
                  </a:cubicBezTo>
                  <a:cubicBezTo>
                    <a:pt x="1216093" y="354721"/>
                    <a:pt x="1216627" y="356513"/>
                    <a:pt x="1217619" y="357959"/>
                  </a:cubicBezTo>
                  <a:lnTo>
                    <a:pt x="1221309" y="362424"/>
                  </a:lnTo>
                  <a:cubicBezTo>
                    <a:pt x="1223547" y="364122"/>
                    <a:pt x="1233267" y="365443"/>
                    <a:pt x="1236021" y="365632"/>
                  </a:cubicBezTo>
                  <a:cubicBezTo>
                    <a:pt x="1238076" y="369310"/>
                    <a:pt x="1236943" y="371637"/>
                    <a:pt x="1237417" y="373051"/>
                  </a:cubicBezTo>
                  <a:cubicBezTo>
                    <a:pt x="1237525" y="373397"/>
                    <a:pt x="1241703" y="382358"/>
                    <a:pt x="1241791" y="382484"/>
                  </a:cubicBezTo>
                  <a:cubicBezTo>
                    <a:pt x="1242250" y="383112"/>
                    <a:pt x="1242822" y="383238"/>
                    <a:pt x="1243478" y="383710"/>
                  </a:cubicBezTo>
                  <a:cubicBezTo>
                    <a:pt x="1247589" y="386729"/>
                    <a:pt x="1252482" y="388835"/>
                    <a:pt x="1257909" y="386917"/>
                  </a:cubicBezTo>
                  <a:cubicBezTo>
                    <a:pt x="1265292" y="391067"/>
                    <a:pt x="1265948" y="399148"/>
                    <a:pt x="1268491" y="405907"/>
                  </a:cubicBezTo>
                  <a:cubicBezTo>
                    <a:pt x="1273069" y="418044"/>
                    <a:pt x="1276303" y="412353"/>
                    <a:pt x="1277464" y="427697"/>
                  </a:cubicBezTo>
                  <a:cubicBezTo>
                    <a:pt x="1277611" y="429614"/>
                    <a:pt x="1277790" y="433262"/>
                    <a:pt x="1277001" y="435211"/>
                  </a:cubicBezTo>
                  <a:cubicBezTo>
                    <a:pt x="1275317" y="439361"/>
                    <a:pt x="1272869" y="444423"/>
                    <a:pt x="1270564" y="448322"/>
                  </a:cubicBezTo>
                  <a:cubicBezTo>
                    <a:pt x="1268211" y="452346"/>
                    <a:pt x="1264019" y="453541"/>
                    <a:pt x="1261588" y="456245"/>
                  </a:cubicBezTo>
                  <a:cubicBezTo>
                    <a:pt x="1259603" y="458477"/>
                    <a:pt x="1258165" y="465017"/>
                    <a:pt x="1258747" y="467879"/>
                  </a:cubicBezTo>
                  <a:cubicBezTo>
                    <a:pt x="1251276" y="469702"/>
                    <a:pt x="1244642" y="473695"/>
                    <a:pt x="1236768" y="474198"/>
                  </a:cubicBezTo>
                  <a:cubicBezTo>
                    <a:pt x="1230563" y="466589"/>
                    <a:pt x="1231205" y="457157"/>
                    <a:pt x="1225343" y="449643"/>
                  </a:cubicBezTo>
                  <a:lnTo>
                    <a:pt x="1219268" y="447536"/>
                  </a:lnTo>
                  <a:lnTo>
                    <a:pt x="1214890" y="450145"/>
                  </a:lnTo>
                  <a:cubicBezTo>
                    <a:pt x="1212158" y="467218"/>
                    <a:pt x="1222334" y="471683"/>
                    <a:pt x="1218051" y="484416"/>
                  </a:cubicBezTo>
                  <a:cubicBezTo>
                    <a:pt x="1214641" y="494541"/>
                    <a:pt x="1198895" y="498188"/>
                    <a:pt x="1189614" y="502181"/>
                  </a:cubicBezTo>
                  <a:cubicBezTo>
                    <a:pt x="1181764" y="505577"/>
                    <a:pt x="1177267" y="512651"/>
                    <a:pt x="1170409" y="516832"/>
                  </a:cubicBezTo>
                  <a:cubicBezTo>
                    <a:pt x="1168014" y="518279"/>
                    <a:pt x="1164867" y="518467"/>
                    <a:pt x="1162145" y="519096"/>
                  </a:cubicBezTo>
                  <a:cubicBezTo>
                    <a:pt x="1148469" y="522335"/>
                    <a:pt x="1140499" y="519253"/>
                    <a:pt x="1132979" y="508469"/>
                  </a:cubicBezTo>
                  <a:cubicBezTo>
                    <a:pt x="1131246" y="505985"/>
                    <a:pt x="1128843" y="503910"/>
                    <a:pt x="1127633" y="501143"/>
                  </a:cubicBezTo>
                  <a:cubicBezTo>
                    <a:pt x="1125707" y="496742"/>
                    <a:pt x="1125732" y="491868"/>
                    <a:pt x="1124718" y="487278"/>
                  </a:cubicBezTo>
                  <a:lnTo>
                    <a:pt x="1120583" y="484134"/>
                  </a:lnTo>
                  <a:lnTo>
                    <a:pt x="1114507" y="484416"/>
                  </a:lnTo>
                  <a:cubicBezTo>
                    <a:pt x="1113553" y="485109"/>
                    <a:pt x="1094580" y="505828"/>
                    <a:pt x="1094573" y="505859"/>
                  </a:cubicBezTo>
                  <a:cubicBezTo>
                    <a:pt x="1090795" y="514285"/>
                    <a:pt x="1100294" y="515795"/>
                    <a:pt x="1100894" y="522586"/>
                  </a:cubicBezTo>
                  <a:cubicBezTo>
                    <a:pt x="1101150" y="525479"/>
                    <a:pt x="1099561" y="530918"/>
                    <a:pt x="1100406" y="533308"/>
                  </a:cubicBezTo>
                  <a:cubicBezTo>
                    <a:pt x="1101136" y="535352"/>
                    <a:pt x="1104893" y="538276"/>
                    <a:pt x="1106482" y="540099"/>
                  </a:cubicBezTo>
                  <a:cubicBezTo>
                    <a:pt x="1108558" y="542458"/>
                    <a:pt x="1109772" y="545318"/>
                    <a:pt x="1111831" y="547677"/>
                  </a:cubicBezTo>
                  <a:cubicBezTo>
                    <a:pt x="1113890" y="550035"/>
                    <a:pt x="1116780" y="551701"/>
                    <a:pt x="1118633" y="554217"/>
                  </a:cubicBezTo>
                  <a:cubicBezTo>
                    <a:pt x="1123606" y="560976"/>
                    <a:pt x="1123613" y="568051"/>
                    <a:pt x="1129573" y="574339"/>
                  </a:cubicBezTo>
                  <a:cubicBezTo>
                    <a:pt x="1134182" y="579212"/>
                    <a:pt x="1141485" y="581098"/>
                    <a:pt x="1146101" y="585846"/>
                  </a:cubicBezTo>
                  <a:cubicBezTo>
                    <a:pt x="1149504" y="589368"/>
                    <a:pt x="1148525" y="594650"/>
                    <a:pt x="1151934" y="598140"/>
                  </a:cubicBezTo>
                  <a:cubicBezTo>
                    <a:pt x="1169206" y="602196"/>
                    <a:pt x="1180031" y="600026"/>
                    <a:pt x="1191554" y="587670"/>
                  </a:cubicBezTo>
                  <a:cubicBezTo>
                    <a:pt x="1192739" y="586413"/>
                    <a:pt x="1193609" y="584903"/>
                    <a:pt x="1194960" y="583771"/>
                  </a:cubicBezTo>
                  <a:cubicBezTo>
                    <a:pt x="1197401" y="581665"/>
                    <a:pt x="1200835" y="580910"/>
                    <a:pt x="1203466" y="579055"/>
                  </a:cubicBezTo>
                  <a:cubicBezTo>
                    <a:pt x="1207714" y="576068"/>
                    <a:pt x="1211291" y="573867"/>
                    <a:pt x="1217079" y="573553"/>
                  </a:cubicBezTo>
                  <a:cubicBezTo>
                    <a:pt x="1229156" y="572924"/>
                    <a:pt x="1240630" y="584526"/>
                    <a:pt x="1251353" y="578803"/>
                  </a:cubicBezTo>
                  <a:cubicBezTo>
                    <a:pt x="1254271" y="577231"/>
                    <a:pt x="1256253" y="574622"/>
                    <a:pt x="1258645" y="572515"/>
                  </a:cubicBezTo>
                  <a:lnTo>
                    <a:pt x="1263991" y="571729"/>
                  </a:lnTo>
                  <a:cubicBezTo>
                    <a:pt x="1264647" y="580627"/>
                    <a:pt x="1263100" y="606975"/>
                    <a:pt x="1260347" y="615118"/>
                  </a:cubicBezTo>
                  <a:cubicBezTo>
                    <a:pt x="1258736" y="619897"/>
                    <a:pt x="1254268" y="623325"/>
                    <a:pt x="1251353" y="627412"/>
                  </a:cubicBezTo>
                  <a:cubicBezTo>
                    <a:pt x="1243099" y="639014"/>
                    <a:pt x="1245007" y="643478"/>
                    <a:pt x="1246007" y="656181"/>
                  </a:cubicBezTo>
                  <a:cubicBezTo>
                    <a:pt x="1246403" y="661212"/>
                    <a:pt x="1242166" y="672939"/>
                    <a:pt x="1242605" y="675266"/>
                  </a:cubicBezTo>
                  <a:cubicBezTo>
                    <a:pt x="1237652" y="682466"/>
                    <a:pt x="1231594" y="682372"/>
                    <a:pt x="1223319" y="683975"/>
                  </a:cubicBezTo>
                  <a:cubicBezTo>
                    <a:pt x="1217023" y="685201"/>
                    <a:pt x="1211091" y="688691"/>
                    <a:pt x="1204441" y="688062"/>
                  </a:cubicBezTo>
                  <a:cubicBezTo>
                    <a:pt x="1197043" y="687370"/>
                    <a:pt x="1191940" y="682025"/>
                    <a:pt x="1186696" y="677875"/>
                  </a:cubicBezTo>
                  <a:cubicBezTo>
                    <a:pt x="1184061" y="675800"/>
                    <a:pt x="1180838" y="674448"/>
                    <a:pt x="1178186" y="672373"/>
                  </a:cubicBezTo>
                  <a:cubicBezTo>
                    <a:pt x="1176043" y="670738"/>
                    <a:pt x="1175103" y="669103"/>
                    <a:pt x="1172114" y="668474"/>
                  </a:cubicBezTo>
                  <a:cubicBezTo>
                    <a:pt x="1161139" y="666147"/>
                    <a:pt x="1157606" y="687685"/>
                    <a:pt x="1154611" y="693564"/>
                  </a:cubicBezTo>
                  <a:cubicBezTo>
                    <a:pt x="1153046" y="696645"/>
                    <a:pt x="1150819" y="699381"/>
                    <a:pt x="1148778" y="702179"/>
                  </a:cubicBezTo>
                  <a:lnTo>
                    <a:pt x="1143186" y="700890"/>
                  </a:lnTo>
                  <a:lnTo>
                    <a:pt x="1141485" y="705072"/>
                  </a:lnTo>
                  <a:cubicBezTo>
                    <a:pt x="1143562" y="714221"/>
                    <a:pt x="1144473" y="723340"/>
                    <a:pt x="1153155" y="729910"/>
                  </a:cubicBezTo>
                  <a:lnTo>
                    <a:pt x="1149749" y="731483"/>
                  </a:lnTo>
                  <a:cubicBezTo>
                    <a:pt x="1150447" y="735507"/>
                    <a:pt x="1153011" y="739123"/>
                    <a:pt x="1153155" y="743242"/>
                  </a:cubicBezTo>
                  <a:cubicBezTo>
                    <a:pt x="1153274" y="746732"/>
                    <a:pt x="1152145" y="750190"/>
                    <a:pt x="1152425" y="753680"/>
                  </a:cubicBezTo>
                  <a:cubicBezTo>
                    <a:pt x="1153008" y="761006"/>
                    <a:pt x="1155572" y="766194"/>
                    <a:pt x="1153881" y="773834"/>
                  </a:cubicBezTo>
                  <a:lnTo>
                    <a:pt x="1149019" y="775658"/>
                  </a:lnTo>
                  <a:cubicBezTo>
                    <a:pt x="1147090" y="773802"/>
                    <a:pt x="1144589" y="772577"/>
                    <a:pt x="1142460" y="770942"/>
                  </a:cubicBezTo>
                  <a:cubicBezTo>
                    <a:pt x="1134536" y="764905"/>
                    <a:pt x="1116521" y="747926"/>
                    <a:pt x="1104539" y="755536"/>
                  </a:cubicBezTo>
                  <a:lnTo>
                    <a:pt x="1100403" y="754750"/>
                  </a:lnTo>
                  <a:cubicBezTo>
                    <a:pt x="1096987" y="749153"/>
                    <a:pt x="1091216" y="744028"/>
                    <a:pt x="1083875" y="743242"/>
                  </a:cubicBezTo>
                  <a:cubicBezTo>
                    <a:pt x="1079610" y="736671"/>
                    <a:pt x="1083240" y="728748"/>
                    <a:pt x="1084362" y="722050"/>
                  </a:cubicBezTo>
                  <a:cubicBezTo>
                    <a:pt x="1085208" y="717020"/>
                    <a:pt x="1083601" y="711958"/>
                    <a:pt x="1083875" y="706895"/>
                  </a:cubicBezTo>
                  <a:cubicBezTo>
                    <a:pt x="1084127" y="702210"/>
                    <a:pt x="1087018" y="688125"/>
                    <a:pt x="1089221" y="684163"/>
                  </a:cubicBezTo>
                  <a:cubicBezTo>
                    <a:pt x="1092367" y="678473"/>
                    <a:pt x="1105942" y="668600"/>
                    <a:pt x="1109155" y="662721"/>
                  </a:cubicBezTo>
                  <a:cubicBezTo>
                    <a:pt x="1115781" y="650553"/>
                    <a:pt x="1094559" y="645334"/>
                    <a:pt x="1090925" y="636561"/>
                  </a:cubicBezTo>
                  <a:cubicBezTo>
                    <a:pt x="1089231" y="632474"/>
                    <a:pt x="1089775" y="626500"/>
                    <a:pt x="1087039" y="622978"/>
                  </a:cubicBezTo>
                  <a:cubicBezTo>
                    <a:pt x="1086092" y="621753"/>
                    <a:pt x="1084597" y="621029"/>
                    <a:pt x="1083633" y="619834"/>
                  </a:cubicBezTo>
                  <a:cubicBezTo>
                    <a:pt x="1081679" y="617413"/>
                    <a:pt x="1081290" y="614175"/>
                    <a:pt x="1079988" y="611471"/>
                  </a:cubicBezTo>
                  <a:lnTo>
                    <a:pt x="1076828" y="612791"/>
                  </a:lnTo>
                  <a:cubicBezTo>
                    <a:pt x="1073538" y="612289"/>
                    <a:pt x="1070321" y="611471"/>
                    <a:pt x="1067108" y="610685"/>
                  </a:cubicBezTo>
                  <a:lnTo>
                    <a:pt x="1063706" y="607541"/>
                  </a:lnTo>
                  <a:cubicBezTo>
                    <a:pt x="1064491" y="602605"/>
                    <a:pt x="1066329" y="597291"/>
                    <a:pt x="1070026" y="593424"/>
                  </a:cubicBezTo>
                  <a:cubicBezTo>
                    <a:pt x="1071731" y="583960"/>
                    <a:pt x="1060573" y="577640"/>
                    <a:pt x="1057630" y="569120"/>
                  </a:cubicBezTo>
                  <a:cubicBezTo>
                    <a:pt x="1053498" y="557172"/>
                    <a:pt x="1057339" y="549123"/>
                    <a:pt x="1058848" y="537490"/>
                  </a:cubicBezTo>
                  <a:lnTo>
                    <a:pt x="1054957" y="535383"/>
                  </a:lnTo>
                  <a:lnTo>
                    <a:pt x="1049612" y="536169"/>
                  </a:lnTo>
                  <a:cubicBezTo>
                    <a:pt x="1045224" y="540728"/>
                    <a:pt x="1037472" y="542174"/>
                    <a:pt x="1034539" y="547928"/>
                  </a:cubicBezTo>
                  <a:cubicBezTo>
                    <a:pt x="1029193" y="558429"/>
                    <a:pt x="1035788" y="569906"/>
                    <a:pt x="1030165" y="580375"/>
                  </a:cubicBezTo>
                  <a:cubicBezTo>
                    <a:pt x="1025051" y="583017"/>
                    <a:pt x="1018888" y="580659"/>
                    <a:pt x="1013395" y="581161"/>
                  </a:cubicBezTo>
                  <a:cubicBezTo>
                    <a:pt x="1008165" y="581602"/>
                    <a:pt x="1003605" y="584212"/>
                    <a:pt x="998564" y="585343"/>
                  </a:cubicBezTo>
                  <a:cubicBezTo>
                    <a:pt x="995050" y="586129"/>
                    <a:pt x="991367" y="586035"/>
                    <a:pt x="987869" y="586884"/>
                  </a:cubicBezTo>
                  <a:cubicBezTo>
                    <a:pt x="981412" y="588519"/>
                    <a:pt x="975940" y="592229"/>
                    <a:pt x="969640" y="594210"/>
                  </a:cubicBezTo>
                  <a:cubicBezTo>
                    <a:pt x="963231" y="593015"/>
                    <a:pt x="957082" y="590374"/>
                    <a:pt x="950435" y="590280"/>
                  </a:cubicBezTo>
                  <a:cubicBezTo>
                    <a:pt x="946114" y="590248"/>
                    <a:pt x="941024" y="589776"/>
                    <a:pt x="936825" y="590028"/>
                  </a:cubicBezTo>
                  <a:cubicBezTo>
                    <a:pt x="933083" y="590248"/>
                    <a:pt x="929421" y="591066"/>
                    <a:pt x="925643" y="590814"/>
                  </a:cubicBezTo>
                  <a:lnTo>
                    <a:pt x="922483" y="594996"/>
                  </a:lnTo>
                  <a:cubicBezTo>
                    <a:pt x="925317" y="601505"/>
                    <a:pt x="945816" y="607037"/>
                    <a:pt x="953354" y="608861"/>
                  </a:cubicBezTo>
                  <a:cubicBezTo>
                    <a:pt x="959773" y="610402"/>
                    <a:pt x="966823" y="609836"/>
                    <a:pt x="972800" y="612791"/>
                  </a:cubicBezTo>
                  <a:cubicBezTo>
                    <a:pt x="974284" y="622161"/>
                    <a:pt x="961692" y="622161"/>
                    <a:pt x="956514" y="627695"/>
                  </a:cubicBezTo>
                  <a:cubicBezTo>
                    <a:pt x="952586" y="631877"/>
                    <a:pt x="955065" y="631059"/>
                    <a:pt x="948980" y="633951"/>
                  </a:cubicBezTo>
                  <a:cubicBezTo>
                    <a:pt x="941898" y="632128"/>
                    <a:pt x="920171" y="630336"/>
                    <a:pt x="916407" y="637599"/>
                  </a:cubicBezTo>
                  <a:cubicBezTo>
                    <a:pt x="912461" y="645239"/>
                    <a:pt x="918656" y="649924"/>
                    <a:pt x="924429" y="654074"/>
                  </a:cubicBezTo>
                  <a:cubicBezTo>
                    <a:pt x="934195" y="654923"/>
                    <a:pt x="942059" y="646906"/>
                    <a:pt x="952137" y="653037"/>
                  </a:cubicBezTo>
                  <a:cubicBezTo>
                    <a:pt x="956486" y="655678"/>
                    <a:pt x="956746" y="661935"/>
                    <a:pt x="955297" y="665865"/>
                  </a:cubicBezTo>
                  <a:cubicBezTo>
                    <a:pt x="954375" y="668348"/>
                    <a:pt x="945735" y="670769"/>
                    <a:pt x="943385" y="673694"/>
                  </a:cubicBezTo>
                  <a:cubicBezTo>
                    <a:pt x="943438" y="676775"/>
                    <a:pt x="944342" y="679919"/>
                    <a:pt x="946058" y="682591"/>
                  </a:cubicBezTo>
                  <a:cubicBezTo>
                    <a:pt x="945374" y="687716"/>
                    <a:pt x="943227" y="692778"/>
                    <a:pt x="943873" y="697998"/>
                  </a:cubicBezTo>
                  <a:cubicBezTo>
                    <a:pt x="947689" y="702431"/>
                    <a:pt x="953410" y="702903"/>
                    <a:pt x="957970" y="706109"/>
                  </a:cubicBezTo>
                  <a:cubicBezTo>
                    <a:pt x="964329" y="710574"/>
                    <a:pt x="968269" y="713907"/>
                    <a:pt x="976199" y="716579"/>
                  </a:cubicBezTo>
                  <a:cubicBezTo>
                    <a:pt x="982681" y="731955"/>
                    <a:pt x="1020821" y="744153"/>
                    <a:pt x="1027976" y="755252"/>
                  </a:cubicBezTo>
                  <a:lnTo>
                    <a:pt x="1025545" y="759969"/>
                  </a:lnTo>
                  <a:cubicBezTo>
                    <a:pt x="1014952" y="759969"/>
                    <a:pt x="1011725" y="759937"/>
                    <a:pt x="1001725" y="756322"/>
                  </a:cubicBezTo>
                  <a:lnTo>
                    <a:pt x="996621" y="757359"/>
                  </a:lnTo>
                  <a:cubicBezTo>
                    <a:pt x="998449" y="774432"/>
                    <a:pt x="1020319" y="762138"/>
                    <a:pt x="1027976" y="766760"/>
                  </a:cubicBezTo>
                  <a:cubicBezTo>
                    <a:pt x="1030891" y="768521"/>
                    <a:pt x="1033922" y="770376"/>
                    <a:pt x="1036725" y="772262"/>
                  </a:cubicBezTo>
                  <a:cubicBezTo>
                    <a:pt x="1037251" y="772608"/>
                    <a:pt x="1044101" y="786159"/>
                    <a:pt x="1045476" y="788203"/>
                  </a:cubicBezTo>
                  <a:cubicBezTo>
                    <a:pt x="1046290" y="789429"/>
                    <a:pt x="1047676" y="790498"/>
                    <a:pt x="1048149" y="791881"/>
                  </a:cubicBezTo>
                  <a:cubicBezTo>
                    <a:pt x="1048644" y="793297"/>
                    <a:pt x="1048931" y="795088"/>
                    <a:pt x="1049121" y="796566"/>
                  </a:cubicBezTo>
                  <a:cubicBezTo>
                    <a:pt x="1049436" y="798987"/>
                    <a:pt x="1046630" y="805653"/>
                    <a:pt x="1045476" y="808074"/>
                  </a:cubicBezTo>
                  <a:cubicBezTo>
                    <a:pt x="1041432" y="810683"/>
                    <a:pt x="1035753" y="811941"/>
                    <a:pt x="1030891" y="810683"/>
                  </a:cubicBezTo>
                  <a:lnTo>
                    <a:pt x="1028944" y="813041"/>
                  </a:lnTo>
                  <a:cubicBezTo>
                    <a:pt x="1025682" y="813827"/>
                    <a:pt x="1022515" y="814897"/>
                    <a:pt x="1019467" y="816185"/>
                  </a:cubicBezTo>
                  <a:cubicBezTo>
                    <a:pt x="1009863" y="814582"/>
                    <a:pt x="1005078" y="805275"/>
                    <a:pt x="994674" y="812255"/>
                  </a:cubicBezTo>
                  <a:cubicBezTo>
                    <a:pt x="991251" y="810683"/>
                    <a:pt x="987957" y="808766"/>
                    <a:pt x="984225" y="807822"/>
                  </a:cubicBezTo>
                  <a:cubicBezTo>
                    <a:pt x="978567" y="806408"/>
                    <a:pt x="972046" y="808168"/>
                    <a:pt x="966967" y="804930"/>
                  </a:cubicBezTo>
                  <a:cubicBezTo>
                    <a:pt x="969331" y="791410"/>
                    <a:pt x="945760" y="789932"/>
                    <a:pt x="940470" y="792385"/>
                  </a:cubicBezTo>
                  <a:cubicBezTo>
                    <a:pt x="937639" y="793705"/>
                    <a:pt x="936850" y="794176"/>
                    <a:pt x="935991" y="794460"/>
                  </a:cubicBezTo>
                  <a:cubicBezTo>
                    <a:pt x="935121" y="794743"/>
                    <a:pt x="934177" y="794869"/>
                    <a:pt x="930992" y="795529"/>
                  </a:cubicBezTo>
                  <a:cubicBezTo>
                    <a:pt x="929435" y="795843"/>
                    <a:pt x="920897" y="801408"/>
                    <a:pt x="918351" y="802572"/>
                  </a:cubicBezTo>
                  <a:cubicBezTo>
                    <a:pt x="914359" y="804426"/>
                    <a:pt x="907277" y="804615"/>
                    <a:pt x="904495" y="807570"/>
                  </a:cubicBezTo>
                  <a:cubicBezTo>
                    <a:pt x="903559" y="817129"/>
                    <a:pt x="909101" y="816752"/>
                    <a:pt x="914945" y="822442"/>
                  </a:cubicBezTo>
                  <a:cubicBezTo>
                    <a:pt x="919764" y="827158"/>
                    <a:pt x="916962" y="832284"/>
                    <a:pt x="919322" y="835522"/>
                  </a:cubicBezTo>
                  <a:cubicBezTo>
                    <a:pt x="922903" y="840459"/>
                    <a:pt x="923963" y="842817"/>
                    <a:pt x="930017" y="845206"/>
                  </a:cubicBezTo>
                  <a:cubicBezTo>
                    <a:pt x="930764" y="845489"/>
                    <a:pt x="942045" y="841622"/>
                    <a:pt x="944599" y="841275"/>
                  </a:cubicBezTo>
                  <a:cubicBezTo>
                    <a:pt x="956875" y="839673"/>
                    <a:pt x="969443" y="841464"/>
                    <a:pt x="981545" y="843383"/>
                  </a:cubicBezTo>
                  <a:lnTo>
                    <a:pt x="983976" y="847029"/>
                  </a:lnTo>
                  <a:cubicBezTo>
                    <a:pt x="982236" y="852311"/>
                    <a:pt x="974375" y="864731"/>
                    <a:pt x="969875" y="868724"/>
                  </a:cubicBezTo>
                  <a:cubicBezTo>
                    <a:pt x="968721" y="869761"/>
                    <a:pt x="967265" y="870453"/>
                    <a:pt x="966231" y="871617"/>
                  </a:cubicBezTo>
                  <a:cubicBezTo>
                    <a:pt x="963786" y="874289"/>
                    <a:pt x="963165" y="877968"/>
                    <a:pt x="960885" y="880766"/>
                  </a:cubicBezTo>
                  <a:cubicBezTo>
                    <a:pt x="957882" y="884445"/>
                    <a:pt x="953519" y="886991"/>
                    <a:pt x="949944" y="890167"/>
                  </a:cubicBezTo>
                  <a:cubicBezTo>
                    <a:pt x="950895" y="893657"/>
                    <a:pt x="948941" y="901581"/>
                    <a:pt x="945570" y="903750"/>
                  </a:cubicBezTo>
                  <a:cubicBezTo>
                    <a:pt x="942206" y="905919"/>
                    <a:pt x="927025" y="903153"/>
                    <a:pt x="921992" y="903498"/>
                  </a:cubicBezTo>
                  <a:cubicBezTo>
                    <a:pt x="917242" y="903813"/>
                    <a:pt x="912854" y="905322"/>
                    <a:pt x="908378" y="906642"/>
                  </a:cubicBezTo>
                  <a:cubicBezTo>
                    <a:pt x="891426" y="911673"/>
                    <a:pt x="896887" y="922615"/>
                    <a:pt x="904492" y="932518"/>
                  </a:cubicBezTo>
                  <a:cubicBezTo>
                    <a:pt x="901423" y="935725"/>
                    <a:pt x="897192" y="937832"/>
                    <a:pt x="892825" y="939310"/>
                  </a:cubicBezTo>
                  <a:lnTo>
                    <a:pt x="886992" y="937234"/>
                  </a:lnTo>
                  <a:cubicBezTo>
                    <a:pt x="885638" y="930160"/>
                    <a:pt x="882937" y="926545"/>
                    <a:pt x="879457" y="920508"/>
                  </a:cubicBezTo>
                  <a:cubicBezTo>
                    <a:pt x="878689" y="919156"/>
                    <a:pt x="878545" y="917647"/>
                    <a:pt x="877760" y="916326"/>
                  </a:cubicBezTo>
                  <a:cubicBezTo>
                    <a:pt x="875301" y="912176"/>
                    <a:pt x="866065" y="906579"/>
                    <a:pt x="861231" y="904819"/>
                  </a:cubicBezTo>
                  <a:cubicBezTo>
                    <a:pt x="859046" y="899851"/>
                    <a:pt x="864178" y="892934"/>
                    <a:pt x="862200" y="889381"/>
                  </a:cubicBezTo>
                  <a:cubicBezTo>
                    <a:pt x="861193" y="887558"/>
                    <a:pt x="856328" y="885105"/>
                    <a:pt x="854423" y="883628"/>
                  </a:cubicBezTo>
                  <a:cubicBezTo>
                    <a:pt x="849565" y="879854"/>
                    <a:pt x="846464" y="871931"/>
                    <a:pt x="839593" y="870831"/>
                  </a:cubicBezTo>
                  <a:cubicBezTo>
                    <a:pt x="833861" y="869887"/>
                    <a:pt x="829894" y="872811"/>
                    <a:pt x="824766" y="867938"/>
                  </a:cubicBezTo>
                  <a:cubicBezTo>
                    <a:pt x="824825" y="858914"/>
                    <a:pt x="813246" y="857626"/>
                    <a:pt x="814797" y="842313"/>
                  </a:cubicBezTo>
                  <a:lnTo>
                    <a:pt x="811152" y="839201"/>
                  </a:lnTo>
                  <a:cubicBezTo>
                    <a:pt x="804940" y="839547"/>
                    <a:pt x="797816" y="843131"/>
                    <a:pt x="792193" y="845457"/>
                  </a:cubicBezTo>
                  <a:cubicBezTo>
                    <a:pt x="789212" y="846716"/>
                    <a:pt x="787019" y="849105"/>
                    <a:pt x="783929" y="850174"/>
                  </a:cubicBezTo>
                  <a:cubicBezTo>
                    <a:pt x="776517" y="852721"/>
                    <a:pt x="772277" y="852941"/>
                    <a:pt x="765942" y="858002"/>
                  </a:cubicBezTo>
                  <a:cubicBezTo>
                    <a:pt x="766173" y="860926"/>
                    <a:pt x="766703" y="863788"/>
                    <a:pt x="767401" y="866649"/>
                  </a:cubicBezTo>
                  <a:lnTo>
                    <a:pt x="762297" y="867435"/>
                  </a:lnTo>
                  <a:cubicBezTo>
                    <a:pt x="756180" y="864196"/>
                    <a:pt x="745615" y="862153"/>
                    <a:pt x="738719" y="864008"/>
                  </a:cubicBezTo>
                  <a:cubicBezTo>
                    <a:pt x="731212" y="858286"/>
                    <a:pt x="724053" y="844137"/>
                    <a:pt x="725105" y="835270"/>
                  </a:cubicBezTo>
                  <a:cubicBezTo>
                    <a:pt x="725481" y="832063"/>
                    <a:pt x="729514" y="822065"/>
                    <a:pt x="731910" y="819833"/>
                  </a:cubicBezTo>
                  <a:cubicBezTo>
                    <a:pt x="735558" y="816437"/>
                    <a:pt x="739399" y="819204"/>
                    <a:pt x="748196" y="809646"/>
                  </a:cubicBezTo>
                  <a:cubicBezTo>
                    <a:pt x="750529" y="807099"/>
                    <a:pt x="752511" y="805967"/>
                    <a:pt x="753542" y="802572"/>
                  </a:cubicBezTo>
                  <a:cubicBezTo>
                    <a:pt x="758109" y="799710"/>
                    <a:pt x="766114" y="802823"/>
                    <a:pt x="769344" y="800245"/>
                  </a:cubicBezTo>
                  <a:cubicBezTo>
                    <a:pt x="773922" y="796534"/>
                    <a:pt x="771126" y="782292"/>
                    <a:pt x="776633" y="774086"/>
                  </a:cubicBezTo>
                  <a:cubicBezTo>
                    <a:pt x="779366" y="770030"/>
                    <a:pt x="783466" y="766980"/>
                    <a:pt x="786844" y="763364"/>
                  </a:cubicBezTo>
                  <a:cubicBezTo>
                    <a:pt x="788956" y="761132"/>
                    <a:pt x="790587" y="758334"/>
                    <a:pt x="793894" y="757359"/>
                  </a:cubicBezTo>
                  <a:lnTo>
                    <a:pt x="798511" y="759969"/>
                  </a:lnTo>
                  <a:cubicBezTo>
                    <a:pt x="802762" y="773142"/>
                    <a:pt x="794606" y="779871"/>
                    <a:pt x="790976" y="791599"/>
                  </a:cubicBezTo>
                  <a:cubicBezTo>
                    <a:pt x="787977" y="801282"/>
                    <a:pt x="788594" y="802854"/>
                    <a:pt x="781740" y="811469"/>
                  </a:cubicBezTo>
                  <a:lnTo>
                    <a:pt x="782712" y="816185"/>
                  </a:lnTo>
                  <a:cubicBezTo>
                    <a:pt x="795718" y="817883"/>
                    <a:pt x="800549" y="813734"/>
                    <a:pt x="810419" y="814079"/>
                  </a:cubicBezTo>
                  <a:cubicBezTo>
                    <a:pt x="814884" y="814236"/>
                    <a:pt x="819122" y="815714"/>
                    <a:pt x="823545" y="816185"/>
                  </a:cubicBezTo>
                  <a:cubicBezTo>
                    <a:pt x="826933" y="805401"/>
                    <a:pt x="836190" y="796692"/>
                    <a:pt x="837155" y="793957"/>
                  </a:cubicBezTo>
                  <a:cubicBezTo>
                    <a:pt x="837284" y="793611"/>
                    <a:pt x="836913" y="781946"/>
                    <a:pt x="836913" y="780280"/>
                  </a:cubicBezTo>
                  <a:cubicBezTo>
                    <a:pt x="836913" y="777764"/>
                    <a:pt x="837719" y="775312"/>
                    <a:pt x="837642" y="772765"/>
                  </a:cubicBezTo>
                  <a:cubicBezTo>
                    <a:pt x="837312" y="762232"/>
                    <a:pt x="829238" y="752485"/>
                    <a:pt x="820627" y="745851"/>
                  </a:cubicBezTo>
                  <a:cubicBezTo>
                    <a:pt x="819560" y="742424"/>
                    <a:pt x="818880" y="733683"/>
                    <a:pt x="820384" y="730414"/>
                  </a:cubicBezTo>
                  <a:cubicBezTo>
                    <a:pt x="821283" y="728496"/>
                    <a:pt x="828350" y="722302"/>
                    <a:pt x="830353" y="719975"/>
                  </a:cubicBezTo>
                  <a:cubicBezTo>
                    <a:pt x="832567" y="717365"/>
                    <a:pt x="834033" y="714379"/>
                    <a:pt x="835945" y="711611"/>
                  </a:cubicBezTo>
                  <a:cubicBezTo>
                    <a:pt x="839775" y="706047"/>
                    <a:pt x="845282" y="703217"/>
                    <a:pt x="851256" y="699852"/>
                  </a:cubicBezTo>
                  <a:cubicBezTo>
                    <a:pt x="878391" y="704160"/>
                    <a:pt x="853511" y="734029"/>
                    <a:pt x="869527" y="743430"/>
                  </a:cubicBezTo>
                  <a:cubicBezTo>
                    <a:pt x="874378" y="746291"/>
                    <a:pt x="896592" y="745254"/>
                    <a:pt x="898409" y="738809"/>
                  </a:cubicBezTo>
                  <a:cubicBezTo>
                    <a:pt x="899101" y="736356"/>
                    <a:pt x="898897" y="733746"/>
                    <a:pt x="899476" y="731294"/>
                  </a:cubicBezTo>
                  <a:cubicBezTo>
                    <a:pt x="901833" y="721138"/>
                    <a:pt x="914548" y="710543"/>
                    <a:pt x="915183" y="706361"/>
                  </a:cubicBezTo>
                  <a:cubicBezTo>
                    <a:pt x="915390" y="705009"/>
                    <a:pt x="913398" y="698658"/>
                    <a:pt x="912510" y="697494"/>
                  </a:cubicBezTo>
                  <a:cubicBezTo>
                    <a:pt x="911511" y="696174"/>
                    <a:pt x="909995" y="695294"/>
                    <a:pt x="908862" y="694099"/>
                  </a:cubicBezTo>
                  <a:cubicBezTo>
                    <a:pt x="898217" y="682780"/>
                    <a:pt x="906944" y="669764"/>
                    <a:pt x="900598" y="662437"/>
                  </a:cubicBezTo>
                  <a:lnTo>
                    <a:pt x="895256" y="661400"/>
                  </a:lnTo>
                  <a:cubicBezTo>
                    <a:pt x="886624" y="664544"/>
                    <a:pt x="884295" y="677875"/>
                    <a:pt x="873621" y="680737"/>
                  </a:cubicBezTo>
                  <a:cubicBezTo>
                    <a:pt x="869524" y="681868"/>
                    <a:pt x="863662" y="679478"/>
                    <a:pt x="859769" y="678316"/>
                  </a:cubicBezTo>
                  <a:cubicBezTo>
                    <a:pt x="857152" y="677529"/>
                    <a:pt x="851841" y="676586"/>
                    <a:pt x="849800" y="675266"/>
                  </a:cubicBezTo>
                  <a:cubicBezTo>
                    <a:pt x="833833" y="664890"/>
                    <a:pt x="842181" y="648383"/>
                    <a:pt x="826709" y="646496"/>
                  </a:cubicBezTo>
                  <a:cubicBezTo>
                    <a:pt x="819950" y="655174"/>
                    <a:pt x="810086" y="658916"/>
                    <a:pt x="805316" y="670801"/>
                  </a:cubicBezTo>
                  <a:cubicBezTo>
                    <a:pt x="799377" y="685672"/>
                    <a:pt x="809181" y="688660"/>
                    <a:pt x="793649" y="705575"/>
                  </a:cubicBezTo>
                  <a:cubicBezTo>
                    <a:pt x="787317" y="712492"/>
                    <a:pt x="775276" y="715448"/>
                    <a:pt x="765696" y="715793"/>
                  </a:cubicBezTo>
                  <a:cubicBezTo>
                    <a:pt x="756531" y="716108"/>
                    <a:pt x="741560" y="708405"/>
                    <a:pt x="733853" y="710825"/>
                  </a:cubicBezTo>
                  <a:cubicBezTo>
                    <a:pt x="728795" y="712397"/>
                    <a:pt x="721899" y="730917"/>
                    <a:pt x="716108" y="735130"/>
                  </a:cubicBezTo>
                  <a:cubicBezTo>
                    <a:pt x="711197" y="738714"/>
                    <a:pt x="705280" y="742833"/>
                    <a:pt x="698850" y="744028"/>
                  </a:cubicBezTo>
                  <a:cubicBezTo>
                    <a:pt x="694753" y="744782"/>
                    <a:pt x="692189" y="743462"/>
                    <a:pt x="688155" y="745600"/>
                  </a:cubicBezTo>
                  <a:cubicBezTo>
                    <a:pt x="678092" y="750913"/>
                    <a:pt x="673693" y="762547"/>
                    <a:pt x="662388" y="767295"/>
                  </a:cubicBezTo>
                  <a:cubicBezTo>
                    <a:pt x="659399" y="768552"/>
                    <a:pt x="656362" y="770030"/>
                    <a:pt x="653397" y="771193"/>
                  </a:cubicBezTo>
                  <a:cubicBezTo>
                    <a:pt x="648136" y="773300"/>
                    <a:pt x="633067" y="775500"/>
                    <a:pt x="629335" y="778519"/>
                  </a:cubicBezTo>
                  <a:lnTo>
                    <a:pt x="628118" y="783235"/>
                  </a:lnTo>
                  <a:cubicBezTo>
                    <a:pt x="631513" y="786348"/>
                    <a:pt x="633758" y="792667"/>
                    <a:pt x="631766" y="796818"/>
                  </a:cubicBezTo>
                  <a:cubicBezTo>
                    <a:pt x="631545" y="797289"/>
                    <a:pt x="628711" y="799459"/>
                    <a:pt x="628118" y="799962"/>
                  </a:cubicBezTo>
                  <a:cubicBezTo>
                    <a:pt x="627521" y="805590"/>
                    <a:pt x="625133" y="810935"/>
                    <a:pt x="622284" y="815903"/>
                  </a:cubicBezTo>
                  <a:cubicBezTo>
                    <a:pt x="617626" y="817820"/>
                    <a:pt x="613905" y="821279"/>
                    <a:pt x="611102" y="825083"/>
                  </a:cubicBezTo>
                  <a:cubicBezTo>
                    <a:pt x="612807" y="833259"/>
                    <a:pt x="617160" y="847470"/>
                    <a:pt x="610860" y="854607"/>
                  </a:cubicBezTo>
                  <a:cubicBezTo>
                    <a:pt x="598825" y="857342"/>
                    <a:pt x="598190" y="864919"/>
                    <a:pt x="595058" y="874478"/>
                  </a:cubicBezTo>
                  <a:cubicBezTo>
                    <a:pt x="591631" y="874383"/>
                    <a:pt x="581209" y="874132"/>
                    <a:pt x="578772" y="876050"/>
                  </a:cubicBezTo>
                  <a:cubicBezTo>
                    <a:pt x="562131" y="889130"/>
                    <a:pt x="580539" y="915572"/>
                    <a:pt x="578772" y="922049"/>
                  </a:cubicBezTo>
                  <a:cubicBezTo>
                    <a:pt x="578280" y="923872"/>
                    <a:pt x="577319" y="925570"/>
                    <a:pt x="576586" y="927299"/>
                  </a:cubicBezTo>
                  <a:lnTo>
                    <a:pt x="572454" y="929909"/>
                  </a:lnTo>
                  <a:cubicBezTo>
                    <a:pt x="569764" y="928337"/>
                    <a:pt x="566547" y="926261"/>
                    <a:pt x="563461" y="925475"/>
                  </a:cubicBezTo>
                  <a:cubicBezTo>
                    <a:pt x="558055" y="924061"/>
                    <a:pt x="552026" y="925979"/>
                    <a:pt x="547900" y="921545"/>
                  </a:cubicBezTo>
                  <a:lnTo>
                    <a:pt x="541583" y="921263"/>
                  </a:lnTo>
                  <a:lnTo>
                    <a:pt x="537448" y="923369"/>
                  </a:lnTo>
                  <a:cubicBezTo>
                    <a:pt x="537076" y="929720"/>
                    <a:pt x="535269" y="931953"/>
                    <a:pt x="529917" y="935914"/>
                  </a:cubicBezTo>
                  <a:cubicBezTo>
                    <a:pt x="530439" y="940505"/>
                    <a:pt x="532140" y="945158"/>
                    <a:pt x="535508" y="948743"/>
                  </a:cubicBezTo>
                  <a:lnTo>
                    <a:pt x="535508" y="953710"/>
                  </a:lnTo>
                  <a:lnTo>
                    <a:pt x="531372" y="956036"/>
                  </a:lnTo>
                  <a:cubicBezTo>
                    <a:pt x="527093" y="952987"/>
                    <a:pt x="521537" y="951572"/>
                    <a:pt x="517517" y="948207"/>
                  </a:cubicBezTo>
                  <a:cubicBezTo>
                    <a:pt x="510109" y="941982"/>
                    <a:pt x="501041" y="934122"/>
                    <a:pt x="490781" y="931984"/>
                  </a:cubicBezTo>
                  <a:cubicBezTo>
                    <a:pt x="484713" y="930758"/>
                    <a:pt x="470286" y="931544"/>
                    <a:pt x="466719" y="926513"/>
                  </a:cubicBezTo>
                  <a:cubicBezTo>
                    <a:pt x="464793" y="923809"/>
                    <a:pt x="464109" y="917238"/>
                    <a:pt x="462344" y="913685"/>
                  </a:cubicBezTo>
                  <a:lnTo>
                    <a:pt x="457970" y="911076"/>
                  </a:lnTo>
                  <a:cubicBezTo>
                    <a:pt x="457858" y="905668"/>
                    <a:pt x="458640" y="900259"/>
                    <a:pt x="458212" y="894883"/>
                  </a:cubicBezTo>
                  <a:cubicBezTo>
                    <a:pt x="457953" y="891645"/>
                    <a:pt x="457167" y="888469"/>
                    <a:pt x="457241" y="885200"/>
                  </a:cubicBezTo>
                  <a:cubicBezTo>
                    <a:pt x="457476" y="874006"/>
                    <a:pt x="461643" y="862405"/>
                    <a:pt x="461373" y="851463"/>
                  </a:cubicBezTo>
                  <a:cubicBezTo>
                    <a:pt x="461296" y="848288"/>
                    <a:pt x="460022" y="845237"/>
                    <a:pt x="460156" y="842061"/>
                  </a:cubicBezTo>
                  <a:cubicBezTo>
                    <a:pt x="460552" y="832786"/>
                    <a:pt x="462404" y="815180"/>
                    <a:pt x="456511" y="807288"/>
                  </a:cubicBezTo>
                  <a:cubicBezTo>
                    <a:pt x="451537" y="800622"/>
                    <a:pt x="440955" y="797478"/>
                    <a:pt x="434388" y="804426"/>
                  </a:cubicBezTo>
                  <a:cubicBezTo>
                    <a:pt x="428709" y="810401"/>
                    <a:pt x="427043" y="820304"/>
                    <a:pt x="424423" y="823511"/>
                  </a:cubicBezTo>
                  <a:cubicBezTo>
                    <a:pt x="423406" y="824738"/>
                    <a:pt x="421792" y="825398"/>
                    <a:pt x="420778" y="826624"/>
                  </a:cubicBezTo>
                  <a:cubicBezTo>
                    <a:pt x="419751" y="827882"/>
                    <a:pt x="417629" y="836182"/>
                    <a:pt x="418102" y="837629"/>
                  </a:cubicBezTo>
                  <a:cubicBezTo>
                    <a:pt x="420666" y="845363"/>
                    <a:pt x="438348" y="851463"/>
                    <a:pt x="427583" y="865580"/>
                  </a:cubicBezTo>
                  <a:cubicBezTo>
                    <a:pt x="418285" y="864982"/>
                    <a:pt x="407800" y="860172"/>
                    <a:pt x="402546" y="870297"/>
                  </a:cubicBezTo>
                  <a:cubicBezTo>
                    <a:pt x="403107" y="873283"/>
                    <a:pt x="404419" y="876113"/>
                    <a:pt x="405702" y="878911"/>
                  </a:cubicBezTo>
                  <a:cubicBezTo>
                    <a:pt x="413286" y="895387"/>
                    <a:pt x="416794" y="885702"/>
                    <a:pt x="425637" y="893563"/>
                  </a:cubicBezTo>
                  <a:lnTo>
                    <a:pt x="424665" y="897493"/>
                  </a:lnTo>
                  <a:lnTo>
                    <a:pt x="419803" y="898782"/>
                  </a:lnTo>
                  <a:cubicBezTo>
                    <a:pt x="417050" y="902649"/>
                    <a:pt x="414082" y="907900"/>
                    <a:pt x="411052" y="911327"/>
                  </a:cubicBezTo>
                  <a:cubicBezTo>
                    <a:pt x="402752" y="920759"/>
                    <a:pt x="385263" y="904347"/>
                    <a:pt x="375807" y="919691"/>
                  </a:cubicBezTo>
                  <a:cubicBezTo>
                    <a:pt x="379072" y="921231"/>
                    <a:pt x="393492" y="931764"/>
                    <a:pt x="395983" y="934342"/>
                  </a:cubicBezTo>
                  <a:lnTo>
                    <a:pt x="396225" y="939561"/>
                  </a:lnTo>
                  <a:lnTo>
                    <a:pt x="393068" y="943491"/>
                  </a:lnTo>
                  <a:cubicBezTo>
                    <a:pt x="387862" y="941385"/>
                    <a:pt x="382036" y="941008"/>
                    <a:pt x="376778" y="939058"/>
                  </a:cubicBezTo>
                  <a:cubicBezTo>
                    <a:pt x="373116" y="937675"/>
                    <a:pt x="369805" y="935537"/>
                    <a:pt x="365841" y="934876"/>
                  </a:cubicBezTo>
                  <a:lnTo>
                    <a:pt x="360979" y="936448"/>
                  </a:lnTo>
                  <a:cubicBezTo>
                    <a:pt x="359541" y="941479"/>
                    <a:pt x="363424" y="953773"/>
                    <a:pt x="359278" y="957106"/>
                  </a:cubicBezTo>
                  <a:cubicBezTo>
                    <a:pt x="359155" y="957200"/>
                    <a:pt x="341600" y="960815"/>
                    <a:pt x="339102" y="961539"/>
                  </a:cubicBezTo>
                  <a:cubicBezTo>
                    <a:pt x="335829" y="962451"/>
                    <a:pt x="325296" y="968802"/>
                    <a:pt x="322332" y="970940"/>
                  </a:cubicBezTo>
                  <a:cubicBezTo>
                    <a:pt x="305502" y="983108"/>
                    <a:pt x="314173" y="995653"/>
                    <a:pt x="309690" y="1010430"/>
                  </a:cubicBezTo>
                  <a:cubicBezTo>
                    <a:pt x="306989" y="1019328"/>
                    <a:pt x="299605" y="1022661"/>
                    <a:pt x="293891" y="1029515"/>
                  </a:cubicBezTo>
                  <a:cubicBezTo>
                    <a:pt x="293632" y="1033351"/>
                    <a:pt x="292674" y="1037155"/>
                    <a:pt x="292674" y="1041022"/>
                  </a:cubicBezTo>
                  <a:cubicBezTo>
                    <a:pt x="292674" y="1046619"/>
                    <a:pt x="294814" y="1050738"/>
                    <a:pt x="291703" y="1056177"/>
                  </a:cubicBezTo>
                  <a:cubicBezTo>
                    <a:pt x="283091" y="1058819"/>
                    <a:pt x="274403" y="1050801"/>
                    <a:pt x="269341" y="1050958"/>
                  </a:cubicBezTo>
                  <a:cubicBezTo>
                    <a:pt x="254328" y="1051398"/>
                    <a:pt x="244394" y="1067371"/>
                    <a:pt x="229964" y="1070546"/>
                  </a:cubicBezTo>
                  <a:lnTo>
                    <a:pt x="224860" y="1068471"/>
                  </a:lnTo>
                  <a:cubicBezTo>
                    <a:pt x="219756" y="1052436"/>
                    <a:pt x="244422" y="1023918"/>
                    <a:pt x="219265" y="1016184"/>
                  </a:cubicBezTo>
                  <a:cubicBezTo>
                    <a:pt x="212615" y="1014109"/>
                    <a:pt x="204088" y="1021560"/>
                    <a:pt x="190583" y="1015901"/>
                  </a:cubicBezTo>
                  <a:lnTo>
                    <a:pt x="192284" y="1011720"/>
                  </a:lnTo>
                  <a:cubicBezTo>
                    <a:pt x="204635" y="1007632"/>
                    <a:pt x="196469" y="993358"/>
                    <a:pt x="198847" y="985057"/>
                  </a:cubicBezTo>
                  <a:cubicBezTo>
                    <a:pt x="202372" y="984271"/>
                    <a:pt x="205943" y="983673"/>
                    <a:pt x="209542" y="983234"/>
                  </a:cubicBezTo>
                  <a:cubicBezTo>
                    <a:pt x="213232" y="979052"/>
                    <a:pt x="211762" y="973204"/>
                    <a:pt x="211489" y="968330"/>
                  </a:cubicBezTo>
                  <a:lnTo>
                    <a:pt x="214891" y="964400"/>
                  </a:lnTo>
                  <a:lnTo>
                    <a:pt x="220967" y="965186"/>
                  </a:lnTo>
                  <a:lnTo>
                    <a:pt x="225828" y="963362"/>
                  </a:lnTo>
                  <a:cubicBezTo>
                    <a:pt x="226239" y="961822"/>
                    <a:pt x="226804" y="960250"/>
                    <a:pt x="227045" y="958646"/>
                  </a:cubicBezTo>
                  <a:cubicBezTo>
                    <a:pt x="227691" y="954402"/>
                    <a:pt x="216242" y="946730"/>
                    <a:pt x="211976" y="946101"/>
                  </a:cubicBezTo>
                  <a:cubicBezTo>
                    <a:pt x="204624" y="945063"/>
                    <a:pt x="187956" y="946007"/>
                    <a:pt x="185479" y="937234"/>
                  </a:cubicBezTo>
                  <a:cubicBezTo>
                    <a:pt x="184550" y="933902"/>
                    <a:pt x="187598" y="931041"/>
                    <a:pt x="188640" y="928085"/>
                  </a:cubicBezTo>
                  <a:cubicBezTo>
                    <a:pt x="190720" y="922143"/>
                    <a:pt x="188335" y="918559"/>
                    <a:pt x="194957" y="914220"/>
                  </a:cubicBezTo>
                  <a:lnTo>
                    <a:pt x="196904" y="908718"/>
                  </a:lnTo>
                  <a:lnTo>
                    <a:pt x="194957" y="904536"/>
                  </a:lnTo>
                  <a:lnTo>
                    <a:pt x="189127" y="902712"/>
                  </a:lnTo>
                  <a:lnTo>
                    <a:pt x="184992" y="904536"/>
                  </a:lnTo>
                  <a:lnTo>
                    <a:pt x="184750" y="905856"/>
                  </a:lnTo>
                  <a:lnTo>
                    <a:pt x="179888" y="905574"/>
                  </a:lnTo>
                  <a:cubicBezTo>
                    <a:pt x="167099" y="889884"/>
                    <a:pt x="195164" y="873409"/>
                    <a:pt x="210030" y="870548"/>
                  </a:cubicBezTo>
                  <a:cubicBezTo>
                    <a:pt x="219543" y="868724"/>
                    <a:pt x="230778" y="872529"/>
                    <a:pt x="240655" y="872120"/>
                  </a:cubicBezTo>
                  <a:lnTo>
                    <a:pt x="242602" y="866617"/>
                  </a:lnTo>
                  <a:lnTo>
                    <a:pt x="241385" y="861933"/>
                  </a:lnTo>
                  <a:cubicBezTo>
                    <a:pt x="235625" y="857405"/>
                    <a:pt x="223643" y="857594"/>
                    <a:pt x="219992" y="853286"/>
                  </a:cubicBezTo>
                  <a:lnTo>
                    <a:pt x="219749" y="848319"/>
                  </a:lnTo>
                  <a:cubicBezTo>
                    <a:pt x="228442" y="846023"/>
                    <a:pt x="234980" y="841401"/>
                    <a:pt x="239196" y="834201"/>
                  </a:cubicBezTo>
                  <a:cubicBezTo>
                    <a:pt x="241024" y="831088"/>
                    <a:pt x="242613" y="822097"/>
                    <a:pt x="239196" y="819581"/>
                  </a:cubicBezTo>
                  <a:cubicBezTo>
                    <a:pt x="237849" y="818575"/>
                    <a:pt x="236274" y="817820"/>
                    <a:pt x="234822" y="816971"/>
                  </a:cubicBezTo>
                  <a:lnTo>
                    <a:pt x="229476" y="817726"/>
                  </a:lnTo>
                  <a:cubicBezTo>
                    <a:pt x="226148" y="821782"/>
                    <a:pt x="223685" y="826310"/>
                    <a:pt x="221212" y="830806"/>
                  </a:cubicBezTo>
                  <a:cubicBezTo>
                    <a:pt x="202411" y="841496"/>
                    <a:pt x="207343" y="828668"/>
                    <a:pt x="184750" y="827662"/>
                  </a:cubicBezTo>
                  <a:cubicBezTo>
                    <a:pt x="176843" y="832849"/>
                    <a:pt x="185199" y="846118"/>
                    <a:pt x="169113" y="849199"/>
                  </a:cubicBezTo>
                  <a:cubicBezTo>
                    <a:pt x="150760" y="852721"/>
                    <a:pt x="153647" y="837345"/>
                    <a:pt x="144159" y="837880"/>
                  </a:cubicBezTo>
                  <a:cubicBezTo>
                    <a:pt x="135884" y="838352"/>
                    <a:pt x="126529" y="849891"/>
                    <a:pt x="119609" y="853035"/>
                  </a:cubicBezTo>
                  <a:lnTo>
                    <a:pt x="116452" y="850677"/>
                  </a:lnTo>
                  <a:cubicBezTo>
                    <a:pt x="122071" y="830083"/>
                    <a:pt x="112944" y="825838"/>
                    <a:pt x="91659" y="828982"/>
                  </a:cubicBezTo>
                  <a:cubicBezTo>
                    <a:pt x="91340" y="822568"/>
                    <a:pt x="91319" y="815934"/>
                    <a:pt x="88499" y="809897"/>
                  </a:cubicBezTo>
                  <a:lnTo>
                    <a:pt x="84125" y="807288"/>
                  </a:lnTo>
                  <a:lnTo>
                    <a:pt x="79509" y="809111"/>
                  </a:lnTo>
                  <a:cubicBezTo>
                    <a:pt x="77267" y="815211"/>
                    <a:pt x="65036" y="821027"/>
                    <a:pt x="58115" y="820084"/>
                  </a:cubicBezTo>
                  <a:cubicBezTo>
                    <a:pt x="57642" y="820022"/>
                    <a:pt x="54166" y="817852"/>
                    <a:pt x="53499" y="817475"/>
                  </a:cubicBezTo>
                  <a:cubicBezTo>
                    <a:pt x="52949" y="811375"/>
                    <a:pt x="49374" y="805716"/>
                    <a:pt x="44509" y="801534"/>
                  </a:cubicBezTo>
                  <a:cubicBezTo>
                    <a:pt x="40563" y="800842"/>
                    <a:pt x="36701" y="799585"/>
                    <a:pt x="33327" y="797604"/>
                  </a:cubicBezTo>
                  <a:cubicBezTo>
                    <a:pt x="34614" y="792290"/>
                    <a:pt x="35193" y="786662"/>
                    <a:pt x="38430" y="781915"/>
                  </a:cubicBezTo>
                  <a:lnTo>
                    <a:pt x="43534" y="782198"/>
                  </a:lnTo>
                  <a:lnTo>
                    <a:pt x="46207" y="786097"/>
                  </a:lnTo>
                  <a:lnTo>
                    <a:pt x="51314" y="788203"/>
                  </a:lnTo>
                  <a:lnTo>
                    <a:pt x="56660" y="787417"/>
                  </a:lnTo>
                  <a:cubicBezTo>
                    <a:pt x="57558" y="785845"/>
                    <a:pt x="58547" y="784336"/>
                    <a:pt x="59333" y="782701"/>
                  </a:cubicBezTo>
                  <a:cubicBezTo>
                    <a:pt x="57144" y="763584"/>
                    <a:pt x="28952" y="770532"/>
                    <a:pt x="22386" y="762829"/>
                  </a:cubicBezTo>
                  <a:cubicBezTo>
                    <a:pt x="18370" y="758145"/>
                    <a:pt x="21383" y="750536"/>
                    <a:pt x="20443" y="745065"/>
                  </a:cubicBezTo>
                  <a:cubicBezTo>
                    <a:pt x="19324" y="738557"/>
                    <a:pt x="14452" y="732834"/>
                    <a:pt x="14122" y="725698"/>
                  </a:cubicBezTo>
                  <a:cubicBezTo>
                    <a:pt x="14038" y="723843"/>
                    <a:pt x="14806" y="722050"/>
                    <a:pt x="15094" y="720226"/>
                  </a:cubicBezTo>
                  <a:cubicBezTo>
                    <a:pt x="16542" y="710983"/>
                    <a:pt x="17005" y="708216"/>
                    <a:pt x="22625" y="700104"/>
                  </a:cubicBezTo>
                  <a:cubicBezTo>
                    <a:pt x="24564" y="697306"/>
                    <a:pt x="27230" y="694885"/>
                    <a:pt x="28458" y="691710"/>
                  </a:cubicBezTo>
                  <a:cubicBezTo>
                    <a:pt x="31545" y="683786"/>
                    <a:pt x="30615" y="658067"/>
                    <a:pt x="40370" y="654325"/>
                  </a:cubicBezTo>
                  <a:cubicBezTo>
                    <a:pt x="42601" y="653476"/>
                    <a:pt x="50055" y="654955"/>
                    <a:pt x="52282" y="655897"/>
                  </a:cubicBezTo>
                  <a:cubicBezTo>
                    <a:pt x="55604" y="657313"/>
                    <a:pt x="64496" y="666116"/>
                    <a:pt x="66383" y="668978"/>
                  </a:cubicBezTo>
                  <a:cubicBezTo>
                    <a:pt x="67235" y="670266"/>
                    <a:pt x="67330" y="671838"/>
                    <a:pt x="68084" y="673159"/>
                  </a:cubicBezTo>
                  <a:cubicBezTo>
                    <a:pt x="71999" y="680076"/>
                    <a:pt x="87289" y="698217"/>
                    <a:pt x="86072" y="705323"/>
                  </a:cubicBezTo>
                  <a:cubicBezTo>
                    <a:pt x="85612" y="707996"/>
                    <a:pt x="79130" y="714379"/>
                    <a:pt x="77807" y="718403"/>
                  </a:cubicBezTo>
                  <a:cubicBezTo>
                    <a:pt x="75552" y="725257"/>
                    <a:pt x="78867" y="726735"/>
                    <a:pt x="80238" y="732772"/>
                  </a:cubicBezTo>
                  <a:cubicBezTo>
                    <a:pt x="81003" y="736136"/>
                    <a:pt x="80579" y="739563"/>
                    <a:pt x="80480" y="742959"/>
                  </a:cubicBezTo>
                  <a:cubicBezTo>
                    <a:pt x="83939" y="746354"/>
                    <a:pt x="89057" y="748210"/>
                    <a:pt x="91905" y="752108"/>
                  </a:cubicBezTo>
                  <a:cubicBezTo>
                    <a:pt x="98990" y="761855"/>
                    <a:pt x="95760" y="776224"/>
                    <a:pt x="104059" y="786883"/>
                  </a:cubicBezTo>
                  <a:lnTo>
                    <a:pt x="108675" y="788455"/>
                  </a:lnTo>
                  <a:cubicBezTo>
                    <a:pt x="113456" y="786820"/>
                    <a:pt x="118475" y="788518"/>
                    <a:pt x="123179" y="789523"/>
                  </a:cubicBezTo>
                  <a:cubicBezTo>
                    <a:pt x="126726" y="790246"/>
                    <a:pt x="130388" y="790215"/>
                    <a:pt x="133955" y="790813"/>
                  </a:cubicBezTo>
                  <a:cubicBezTo>
                    <a:pt x="145183" y="792730"/>
                    <a:pt x="144937" y="797321"/>
                    <a:pt x="153156" y="801000"/>
                  </a:cubicBezTo>
                  <a:cubicBezTo>
                    <a:pt x="154268" y="801502"/>
                    <a:pt x="155492" y="801723"/>
                    <a:pt x="156562" y="802320"/>
                  </a:cubicBezTo>
                  <a:cubicBezTo>
                    <a:pt x="158972" y="803640"/>
                    <a:pt x="160340" y="806124"/>
                    <a:pt x="162395" y="807822"/>
                  </a:cubicBezTo>
                  <a:cubicBezTo>
                    <a:pt x="164391" y="808074"/>
                    <a:pt x="166450" y="808545"/>
                    <a:pt x="168471" y="808608"/>
                  </a:cubicBezTo>
                  <a:cubicBezTo>
                    <a:pt x="171287" y="808640"/>
                    <a:pt x="174837" y="805118"/>
                    <a:pt x="176977" y="803640"/>
                  </a:cubicBezTo>
                  <a:cubicBezTo>
                    <a:pt x="181670" y="800340"/>
                    <a:pt x="187917" y="799176"/>
                    <a:pt x="187917" y="792730"/>
                  </a:cubicBezTo>
                  <a:lnTo>
                    <a:pt x="187917" y="789241"/>
                  </a:lnTo>
                  <a:cubicBezTo>
                    <a:pt x="183764" y="790813"/>
                    <a:pt x="173816" y="790090"/>
                    <a:pt x="170172" y="787669"/>
                  </a:cubicBezTo>
                  <a:cubicBezTo>
                    <a:pt x="166871" y="785499"/>
                    <a:pt x="166247" y="778079"/>
                    <a:pt x="165556" y="774620"/>
                  </a:cubicBezTo>
                  <a:lnTo>
                    <a:pt x="161908" y="771476"/>
                  </a:lnTo>
                  <a:lnTo>
                    <a:pt x="157292" y="773048"/>
                  </a:lnTo>
                  <a:lnTo>
                    <a:pt x="152675" y="771728"/>
                  </a:lnTo>
                  <a:cubicBezTo>
                    <a:pt x="150648" y="767703"/>
                    <a:pt x="149817" y="762453"/>
                    <a:pt x="146842" y="758931"/>
                  </a:cubicBezTo>
                  <a:cubicBezTo>
                    <a:pt x="142247" y="753491"/>
                    <a:pt x="139055" y="750473"/>
                    <a:pt x="137848" y="743242"/>
                  </a:cubicBezTo>
                  <a:lnTo>
                    <a:pt x="133474" y="740349"/>
                  </a:lnTo>
                  <a:lnTo>
                    <a:pt x="127883" y="740632"/>
                  </a:lnTo>
                  <a:cubicBezTo>
                    <a:pt x="123421" y="743745"/>
                    <a:pt x="120507" y="745820"/>
                    <a:pt x="114512" y="745065"/>
                  </a:cubicBezTo>
                  <a:cubicBezTo>
                    <a:pt x="116301" y="740286"/>
                    <a:pt x="115410" y="734941"/>
                    <a:pt x="118156" y="730414"/>
                  </a:cubicBezTo>
                  <a:lnTo>
                    <a:pt x="124232" y="730948"/>
                  </a:lnTo>
                  <a:cubicBezTo>
                    <a:pt x="125810" y="727584"/>
                    <a:pt x="126494" y="723559"/>
                    <a:pt x="125691" y="719975"/>
                  </a:cubicBezTo>
                  <a:cubicBezTo>
                    <a:pt x="128729" y="718843"/>
                    <a:pt x="131573" y="715699"/>
                    <a:pt x="132496" y="712901"/>
                  </a:cubicBezTo>
                  <a:cubicBezTo>
                    <a:pt x="131275" y="710197"/>
                    <a:pt x="128413" y="707776"/>
                    <a:pt x="125445" y="706644"/>
                  </a:cubicBezTo>
                  <a:lnTo>
                    <a:pt x="127876" y="702965"/>
                  </a:lnTo>
                  <a:cubicBezTo>
                    <a:pt x="139504" y="705323"/>
                    <a:pt x="140725" y="713309"/>
                    <a:pt x="145134" y="714221"/>
                  </a:cubicBezTo>
                  <a:cubicBezTo>
                    <a:pt x="153626" y="715951"/>
                    <a:pt x="163826" y="706581"/>
                    <a:pt x="172112" y="715510"/>
                  </a:cubicBezTo>
                  <a:lnTo>
                    <a:pt x="172599" y="719440"/>
                  </a:lnTo>
                  <a:cubicBezTo>
                    <a:pt x="164647" y="727175"/>
                    <a:pt x="170014" y="733338"/>
                    <a:pt x="166524" y="741670"/>
                  </a:cubicBezTo>
                  <a:lnTo>
                    <a:pt x="168225" y="745851"/>
                  </a:lnTo>
                  <a:cubicBezTo>
                    <a:pt x="173739" y="749656"/>
                    <a:pt x="179551" y="753303"/>
                    <a:pt x="185970" y="755787"/>
                  </a:cubicBezTo>
                  <a:cubicBezTo>
                    <a:pt x="189650" y="757201"/>
                    <a:pt x="193642" y="757925"/>
                    <a:pt x="197153" y="759717"/>
                  </a:cubicBezTo>
                  <a:cubicBezTo>
                    <a:pt x="203621" y="762955"/>
                    <a:pt x="205866" y="764056"/>
                    <a:pt x="212713" y="766760"/>
                  </a:cubicBezTo>
                  <a:cubicBezTo>
                    <a:pt x="217683" y="768741"/>
                    <a:pt x="221717" y="772167"/>
                    <a:pt x="226565" y="774337"/>
                  </a:cubicBezTo>
                  <a:cubicBezTo>
                    <a:pt x="230378" y="776066"/>
                    <a:pt x="234675" y="777135"/>
                    <a:pt x="238961" y="776947"/>
                  </a:cubicBezTo>
                  <a:lnTo>
                    <a:pt x="242609" y="773834"/>
                  </a:lnTo>
                  <a:cubicBezTo>
                    <a:pt x="241630" y="765188"/>
                    <a:pt x="238716" y="764276"/>
                    <a:pt x="232640" y="758397"/>
                  </a:cubicBezTo>
                  <a:lnTo>
                    <a:pt x="233128" y="753964"/>
                  </a:lnTo>
                  <a:cubicBezTo>
                    <a:pt x="245149" y="750379"/>
                    <a:pt x="251406" y="762421"/>
                    <a:pt x="260109" y="767011"/>
                  </a:cubicBezTo>
                  <a:cubicBezTo>
                    <a:pt x="273680" y="774212"/>
                    <a:pt x="291625" y="776664"/>
                    <a:pt x="306533" y="771728"/>
                  </a:cubicBezTo>
                  <a:lnTo>
                    <a:pt x="308231" y="767546"/>
                  </a:lnTo>
                  <a:cubicBezTo>
                    <a:pt x="302054" y="765471"/>
                    <a:pt x="295252" y="765188"/>
                    <a:pt x="289275" y="762578"/>
                  </a:cubicBezTo>
                  <a:cubicBezTo>
                    <a:pt x="283649" y="760126"/>
                    <a:pt x="258667" y="739123"/>
                    <a:pt x="255973" y="734344"/>
                  </a:cubicBezTo>
                  <a:lnTo>
                    <a:pt x="256703" y="728842"/>
                  </a:lnTo>
                  <a:cubicBezTo>
                    <a:pt x="252034" y="722773"/>
                    <a:pt x="244244" y="724440"/>
                    <a:pt x="236204" y="716045"/>
                  </a:cubicBezTo>
                  <a:cubicBezTo>
                    <a:pt x="233605" y="713341"/>
                    <a:pt x="232938" y="709662"/>
                    <a:pt x="230451" y="706895"/>
                  </a:cubicBezTo>
                  <a:cubicBezTo>
                    <a:pt x="228308" y="704506"/>
                    <a:pt x="225074" y="703280"/>
                    <a:pt x="222671" y="701142"/>
                  </a:cubicBezTo>
                  <a:cubicBezTo>
                    <a:pt x="219087" y="697966"/>
                    <a:pt x="217592" y="693501"/>
                    <a:pt x="214649" y="689917"/>
                  </a:cubicBezTo>
                  <a:cubicBezTo>
                    <a:pt x="209079" y="683095"/>
                    <a:pt x="198826" y="677938"/>
                    <a:pt x="189373" y="677624"/>
                  </a:cubicBezTo>
                  <a:cubicBezTo>
                    <a:pt x="184069" y="677435"/>
                    <a:pt x="178973" y="679133"/>
                    <a:pt x="173813" y="679951"/>
                  </a:cubicBezTo>
                  <a:cubicBezTo>
                    <a:pt x="170810" y="678504"/>
                    <a:pt x="168776" y="675957"/>
                    <a:pt x="166036" y="674228"/>
                  </a:cubicBezTo>
                  <a:cubicBezTo>
                    <a:pt x="161034" y="671021"/>
                    <a:pt x="147835" y="668380"/>
                    <a:pt x="141728" y="668978"/>
                  </a:cubicBezTo>
                  <a:cubicBezTo>
                    <a:pt x="137687" y="669386"/>
                    <a:pt x="118763" y="676994"/>
                    <a:pt x="113530" y="678913"/>
                  </a:cubicBezTo>
                  <a:cubicBezTo>
                    <a:pt x="109349" y="678284"/>
                    <a:pt x="105227" y="677026"/>
                    <a:pt x="101618" y="675014"/>
                  </a:cubicBezTo>
                  <a:cubicBezTo>
                    <a:pt x="100401" y="671933"/>
                    <a:pt x="100001" y="668568"/>
                    <a:pt x="100401" y="665330"/>
                  </a:cubicBezTo>
                  <a:cubicBezTo>
                    <a:pt x="102603" y="663066"/>
                    <a:pt x="105799" y="661903"/>
                    <a:pt x="108180" y="659828"/>
                  </a:cubicBezTo>
                  <a:cubicBezTo>
                    <a:pt x="111727" y="656746"/>
                    <a:pt x="115087" y="644170"/>
                    <a:pt x="120577" y="644422"/>
                  </a:cubicBezTo>
                  <a:cubicBezTo>
                    <a:pt x="126094" y="644673"/>
                    <a:pt x="154535" y="650332"/>
                    <a:pt x="159470" y="652502"/>
                  </a:cubicBezTo>
                  <a:cubicBezTo>
                    <a:pt x="162823" y="654011"/>
                    <a:pt x="165573" y="656432"/>
                    <a:pt x="169190" y="657469"/>
                  </a:cubicBezTo>
                  <a:lnTo>
                    <a:pt x="174051" y="655929"/>
                  </a:lnTo>
                  <a:cubicBezTo>
                    <a:pt x="178503" y="648037"/>
                    <a:pt x="187605" y="643352"/>
                    <a:pt x="196900" y="648320"/>
                  </a:cubicBezTo>
                  <a:cubicBezTo>
                    <a:pt x="202215" y="651181"/>
                    <a:pt x="211755" y="666084"/>
                    <a:pt x="223882" y="658005"/>
                  </a:cubicBezTo>
                  <a:cubicBezTo>
                    <a:pt x="228122" y="658381"/>
                    <a:pt x="232461" y="659545"/>
                    <a:pt x="236036" y="661651"/>
                  </a:cubicBezTo>
                  <a:lnTo>
                    <a:pt x="238709" y="659042"/>
                  </a:lnTo>
                  <a:cubicBezTo>
                    <a:pt x="236544" y="656652"/>
                    <a:pt x="235941" y="653508"/>
                    <a:pt x="234093" y="650930"/>
                  </a:cubicBezTo>
                  <a:cubicBezTo>
                    <a:pt x="232181" y="648289"/>
                    <a:pt x="229354" y="647032"/>
                    <a:pt x="228747" y="643636"/>
                  </a:cubicBezTo>
                  <a:cubicBezTo>
                    <a:pt x="227238" y="635210"/>
                    <a:pt x="237533" y="622255"/>
                    <a:pt x="244787" y="617476"/>
                  </a:cubicBezTo>
                  <a:cubicBezTo>
                    <a:pt x="248821" y="614836"/>
                    <a:pt x="253960" y="613987"/>
                    <a:pt x="257913" y="611219"/>
                  </a:cubicBezTo>
                  <a:cubicBezTo>
                    <a:pt x="280239" y="610874"/>
                    <a:pt x="275459" y="632442"/>
                    <a:pt x="308147" y="628449"/>
                  </a:cubicBezTo>
                  <a:cubicBezTo>
                    <a:pt x="312226" y="627978"/>
                    <a:pt x="316544" y="628135"/>
                    <a:pt x="320381" y="626626"/>
                  </a:cubicBezTo>
                  <a:lnTo>
                    <a:pt x="323538" y="622696"/>
                  </a:lnTo>
                  <a:lnTo>
                    <a:pt x="323538" y="617476"/>
                  </a:lnTo>
                  <a:cubicBezTo>
                    <a:pt x="321444" y="615150"/>
                    <a:pt x="319648" y="612603"/>
                    <a:pt x="318193" y="609899"/>
                  </a:cubicBezTo>
                  <a:lnTo>
                    <a:pt x="321111" y="606251"/>
                  </a:lnTo>
                  <a:cubicBezTo>
                    <a:pt x="325941" y="605969"/>
                    <a:pt x="338362" y="607100"/>
                    <a:pt x="341771" y="604145"/>
                  </a:cubicBezTo>
                  <a:lnTo>
                    <a:pt x="341042" y="599429"/>
                  </a:lnTo>
                  <a:cubicBezTo>
                    <a:pt x="337271" y="596945"/>
                    <a:pt x="331641" y="592355"/>
                    <a:pt x="327190" y="591348"/>
                  </a:cubicBezTo>
                  <a:cubicBezTo>
                    <a:pt x="310104" y="587418"/>
                    <a:pt x="288433" y="605969"/>
                    <a:pt x="272744" y="591600"/>
                  </a:cubicBezTo>
                  <a:cubicBezTo>
                    <a:pt x="273726" y="586601"/>
                    <a:pt x="274178" y="581287"/>
                    <a:pt x="272256" y="576445"/>
                  </a:cubicBezTo>
                  <a:lnTo>
                    <a:pt x="267882" y="573553"/>
                  </a:lnTo>
                  <a:cubicBezTo>
                    <a:pt x="264406" y="556134"/>
                    <a:pt x="280183" y="564246"/>
                    <a:pt x="283923" y="541672"/>
                  </a:cubicBezTo>
                  <a:cubicBezTo>
                    <a:pt x="284203" y="539942"/>
                    <a:pt x="279100" y="526517"/>
                    <a:pt x="278331" y="523372"/>
                  </a:cubicBezTo>
                  <a:cubicBezTo>
                    <a:pt x="276812" y="522838"/>
                    <a:pt x="275304" y="522115"/>
                    <a:pt x="273712" y="521800"/>
                  </a:cubicBezTo>
                  <a:cubicBezTo>
                    <a:pt x="270793" y="521172"/>
                    <a:pt x="260046" y="527554"/>
                    <a:pt x="256941" y="528843"/>
                  </a:cubicBezTo>
                  <a:cubicBezTo>
                    <a:pt x="251771" y="531044"/>
                    <a:pt x="245612" y="527617"/>
                    <a:pt x="240413" y="530667"/>
                  </a:cubicBezTo>
                  <a:cubicBezTo>
                    <a:pt x="240648" y="535666"/>
                    <a:pt x="240238" y="540697"/>
                    <a:pt x="241630" y="545570"/>
                  </a:cubicBezTo>
                  <a:cubicBezTo>
                    <a:pt x="242265" y="547802"/>
                    <a:pt x="248456" y="562391"/>
                    <a:pt x="248435" y="562580"/>
                  </a:cubicBezTo>
                  <a:cubicBezTo>
                    <a:pt x="247025" y="574528"/>
                    <a:pt x="241736" y="570880"/>
                    <a:pt x="237737" y="579307"/>
                  </a:cubicBezTo>
                  <a:cubicBezTo>
                    <a:pt x="235310" y="584431"/>
                    <a:pt x="236832" y="590154"/>
                    <a:pt x="236523" y="595530"/>
                  </a:cubicBezTo>
                  <a:cubicBezTo>
                    <a:pt x="236228" y="600624"/>
                    <a:pt x="235166" y="607415"/>
                    <a:pt x="231907" y="611723"/>
                  </a:cubicBezTo>
                  <a:cubicBezTo>
                    <a:pt x="230865" y="613106"/>
                    <a:pt x="229392" y="614175"/>
                    <a:pt x="228501" y="615653"/>
                  </a:cubicBezTo>
                  <a:cubicBezTo>
                    <a:pt x="224808" y="621753"/>
                    <a:pt x="224615" y="628009"/>
                    <a:pt x="217319" y="632379"/>
                  </a:cubicBezTo>
                  <a:cubicBezTo>
                    <a:pt x="214158" y="632474"/>
                    <a:pt x="210994" y="632285"/>
                    <a:pt x="207837" y="632128"/>
                  </a:cubicBezTo>
                  <a:lnTo>
                    <a:pt x="204435" y="628732"/>
                  </a:lnTo>
                  <a:lnTo>
                    <a:pt x="205407" y="630807"/>
                  </a:lnTo>
                  <a:cubicBezTo>
                    <a:pt x="204172" y="627381"/>
                    <a:pt x="199100" y="626028"/>
                    <a:pt x="198844" y="622192"/>
                  </a:cubicBezTo>
                  <a:cubicBezTo>
                    <a:pt x="198388" y="615370"/>
                    <a:pt x="208248" y="615967"/>
                    <a:pt x="206378" y="604397"/>
                  </a:cubicBezTo>
                  <a:lnTo>
                    <a:pt x="202488" y="601001"/>
                  </a:lnTo>
                  <a:cubicBezTo>
                    <a:pt x="192228" y="601473"/>
                    <a:pt x="172031" y="612131"/>
                    <a:pt x="159466" y="614867"/>
                  </a:cubicBezTo>
                  <a:cubicBezTo>
                    <a:pt x="156986" y="612980"/>
                    <a:pt x="154906" y="610654"/>
                    <a:pt x="153391" y="608075"/>
                  </a:cubicBezTo>
                  <a:lnTo>
                    <a:pt x="147800" y="607007"/>
                  </a:lnTo>
                  <a:lnTo>
                    <a:pt x="143664" y="609365"/>
                  </a:lnTo>
                  <a:cubicBezTo>
                    <a:pt x="142538" y="612760"/>
                    <a:pt x="141963" y="616313"/>
                    <a:pt x="141721" y="619834"/>
                  </a:cubicBezTo>
                  <a:lnTo>
                    <a:pt x="139045" y="622696"/>
                  </a:lnTo>
                  <a:cubicBezTo>
                    <a:pt x="135614" y="620369"/>
                    <a:pt x="131152" y="619080"/>
                    <a:pt x="126891" y="618797"/>
                  </a:cubicBezTo>
                  <a:cubicBezTo>
                    <a:pt x="119872" y="623733"/>
                    <a:pt x="118069" y="622884"/>
                    <a:pt x="110362" y="625337"/>
                  </a:cubicBezTo>
                  <a:cubicBezTo>
                    <a:pt x="106114" y="624362"/>
                    <a:pt x="100523" y="620338"/>
                    <a:pt x="100155" y="616156"/>
                  </a:cubicBezTo>
                  <a:cubicBezTo>
                    <a:pt x="99194" y="605435"/>
                    <a:pt x="116238" y="598014"/>
                    <a:pt x="119598" y="593958"/>
                  </a:cubicBezTo>
                  <a:cubicBezTo>
                    <a:pt x="121871" y="591192"/>
                    <a:pt x="122246" y="587575"/>
                    <a:pt x="124463" y="584809"/>
                  </a:cubicBezTo>
                  <a:cubicBezTo>
                    <a:pt x="128192" y="580124"/>
                    <a:pt x="137936" y="578017"/>
                    <a:pt x="138803" y="571729"/>
                  </a:cubicBezTo>
                  <a:cubicBezTo>
                    <a:pt x="140160" y="561888"/>
                    <a:pt x="125712" y="555694"/>
                    <a:pt x="129083" y="545318"/>
                  </a:cubicBezTo>
                  <a:cubicBezTo>
                    <a:pt x="131798" y="544061"/>
                    <a:pt x="139995" y="539816"/>
                    <a:pt x="141475" y="537741"/>
                  </a:cubicBezTo>
                  <a:cubicBezTo>
                    <a:pt x="143061" y="535540"/>
                    <a:pt x="142689" y="529409"/>
                    <a:pt x="140991" y="527271"/>
                  </a:cubicBezTo>
                  <a:lnTo>
                    <a:pt x="136856" y="526485"/>
                  </a:lnTo>
                  <a:cubicBezTo>
                    <a:pt x="134246" y="528026"/>
                    <a:pt x="130738" y="528906"/>
                    <a:pt x="127620" y="528591"/>
                  </a:cubicBezTo>
                  <a:cubicBezTo>
                    <a:pt x="127532" y="521517"/>
                    <a:pt x="131531" y="515732"/>
                    <a:pt x="130535" y="508186"/>
                  </a:cubicBezTo>
                  <a:cubicBezTo>
                    <a:pt x="129093" y="497276"/>
                    <a:pt x="119079" y="486900"/>
                    <a:pt x="125673" y="475267"/>
                  </a:cubicBezTo>
                  <a:cubicBezTo>
                    <a:pt x="134639" y="471180"/>
                    <a:pt x="142959" y="465363"/>
                    <a:pt x="153626" y="464797"/>
                  </a:cubicBezTo>
                  <a:lnTo>
                    <a:pt x="156787" y="460867"/>
                  </a:lnTo>
                  <a:cubicBezTo>
                    <a:pt x="156667" y="460175"/>
                    <a:pt x="156394" y="457409"/>
                    <a:pt x="156057" y="456968"/>
                  </a:cubicBezTo>
                  <a:cubicBezTo>
                    <a:pt x="151739" y="450837"/>
                    <a:pt x="143120" y="450020"/>
                    <a:pt x="136354" y="447536"/>
                  </a:cubicBezTo>
                  <a:cubicBezTo>
                    <a:pt x="134527" y="446875"/>
                    <a:pt x="132920" y="445713"/>
                    <a:pt x="131019" y="445177"/>
                  </a:cubicBezTo>
                  <a:cubicBezTo>
                    <a:pt x="129090" y="444675"/>
                    <a:pt x="121885" y="445870"/>
                    <a:pt x="120324" y="447033"/>
                  </a:cubicBezTo>
                  <a:cubicBezTo>
                    <a:pt x="118300" y="448510"/>
                    <a:pt x="113498" y="457943"/>
                    <a:pt x="109629" y="461402"/>
                  </a:cubicBezTo>
                  <a:lnTo>
                    <a:pt x="107682" y="457220"/>
                  </a:lnTo>
                  <a:lnTo>
                    <a:pt x="102821" y="459044"/>
                  </a:lnTo>
                  <a:cubicBezTo>
                    <a:pt x="94164" y="478569"/>
                    <a:pt x="117297" y="473129"/>
                    <a:pt x="100148" y="494069"/>
                  </a:cubicBezTo>
                  <a:cubicBezTo>
                    <a:pt x="94918" y="495107"/>
                    <a:pt x="89204" y="494352"/>
                    <a:pt x="84346" y="496679"/>
                  </a:cubicBezTo>
                  <a:cubicBezTo>
                    <a:pt x="83322" y="500075"/>
                    <a:pt x="81652" y="503344"/>
                    <a:pt x="79242" y="506111"/>
                  </a:cubicBezTo>
                  <a:cubicBezTo>
                    <a:pt x="72928" y="504319"/>
                    <a:pt x="71304" y="501615"/>
                    <a:pt x="66601" y="498251"/>
                  </a:cubicBezTo>
                  <a:cubicBezTo>
                    <a:pt x="64299" y="496616"/>
                    <a:pt x="58663" y="495547"/>
                    <a:pt x="57849" y="492780"/>
                  </a:cubicBezTo>
                  <a:cubicBezTo>
                    <a:pt x="57480" y="491522"/>
                    <a:pt x="57505" y="490139"/>
                    <a:pt x="57365" y="488850"/>
                  </a:cubicBezTo>
                  <a:cubicBezTo>
                    <a:pt x="60458" y="488001"/>
                    <a:pt x="63307" y="485423"/>
                    <a:pt x="64654" y="482844"/>
                  </a:cubicBezTo>
                  <a:lnTo>
                    <a:pt x="62956" y="478128"/>
                  </a:lnTo>
                  <a:cubicBezTo>
                    <a:pt x="59084" y="476902"/>
                    <a:pt x="55263" y="475487"/>
                    <a:pt x="51531" y="473947"/>
                  </a:cubicBezTo>
                  <a:cubicBezTo>
                    <a:pt x="50065" y="471274"/>
                    <a:pt x="47428" y="469105"/>
                    <a:pt x="46182" y="466369"/>
                  </a:cubicBezTo>
                  <a:cubicBezTo>
                    <a:pt x="45354" y="464546"/>
                    <a:pt x="46887" y="457943"/>
                    <a:pt x="48613" y="456686"/>
                  </a:cubicBezTo>
                  <a:cubicBezTo>
                    <a:pt x="54709" y="452346"/>
                    <a:pt x="69652" y="461591"/>
                    <a:pt x="77050" y="461653"/>
                  </a:cubicBezTo>
                  <a:lnTo>
                    <a:pt x="80940" y="458540"/>
                  </a:lnTo>
                  <a:cubicBezTo>
                    <a:pt x="81904" y="446656"/>
                    <a:pt x="77145" y="449422"/>
                    <a:pt x="75591" y="441531"/>
                  </a:cubicBezTo>
                  <a:cubicBezTo>
                    <a:pt x="83757" y="426313"/>
                    <a:pt x="114768" y="438135"/>
                    <a:pt x="105487" y="410938"/>
                  </a:cubicBezTo>
                  <a:cubicBezTo>
                    <a:pt x="104501" y="408046"/>
                    <a:pt x="104336" y="404965"/>
                    <a:pt x="102572" y="402323"/>
                  </a:cubicBezTo>
                  <a:cubicBezTo>
                    <a:pt x="98352" y="401034"/>
                    <a:pt x="93908" y="400248"/>
                    <a:pt x="89446" y="400217"/>
                  </a:cubicBezTo>
                  <a:cubicBezTo>
                    <a:pt x="86019" y="396915"/>
                    <a:pt x="85328" y="392168"/>
                    <a:pt x="82153" y="388709"/>
                  </a:cubicBezTo>
                  <a:lnTo>
                    <a:pt x="76078" y="386886"/>
                  </a:lnTo>
                  <a:lnTo>
                    <a:pt x="73163" y="383238"/>
                  </a:lnTo>
                  <a:cubicBezTo>
                    <a:pt x="74510" y="368681"/>
                    <a:pt x="62952" y="359186"/>
                    <a:pt x="48371" y="355507"/>
                  </a:cubicBezTo>
                  <a:cubicBezTo>
                    <a:pt x="45751" y="356387"/>
                    <a:pt x="43345" y="357708"/>
                    <a:pt x="41079" y="359186"/>
                  </a:cubicBezTo>
                  <a:cubicBezTo>
                    <a:pt x="47627" y="367518"/>
                    <a:pt x="61065" y="388646"/>
                    <a:pt x="41079" y="391602"/>
                  </a:cubicBezTo>
                  <a:lnTo>
                    <a:pt x="33786" y="385314"/>
                  </a:lnTo>
                  <a:cubicBezTo>
                    <a:pt x="29622" y="384559"/>
                    <a:pt x="25497" y="383679"/>
                    <a:pt x="21390" y="382704"/>
                  </a:cubicBezTo>
                  <a:cubicBezTo>
                    <a:pt x="19661" y="379717"/>
                    <a:pt x="20302" y="374938"/>
                    <a:pt x="21878" y="371983"/>
                  </a:cubicBezTo>
                  <a:cubicBezTo>
                    <a:pt x="25129" y="372391"/>
                    <a:pt x="29563" y="371574"/>
                    <a:pt x="32088" y="369625"/>
                  </a:cubicBezTo>
                  <a:cubicBezTo>
                    <a:pt x="33965" y="358117"/>
                    <a:pt x="21334" y="360003"/>
                    <a:pt x="14830" y="354218"/>
                  </a:cubicBezTo>
                  <a:cubicBezTo>
                    <a:pt x="12473" y="352112"/>
                    <a:pt x="10965" y="349407"/>
                    <a:pt x="9239" y="346892"/>
                  </a:cubicBezTo>
                  <a:lnTo>
                    <a:pt x="9965" y="344283"/>
                  </a:lnTo>
                  <a:cubicBezTo>
                    <a:pt x="7650" y="340164"/>
                    <a:pt x="3431" y="337366"/>
                    <a:pt x="0" y="334064"/>
                  </a:cubicBezTo>
                  <a:cubicBezTo>
                    <a:pt x="1007" y="317148"/>
                    <a:pt x="9772" y="309666"/>
                    <a:pt x="28682" y="309760"/>
                  </a:cubicBezTo>
                  <a:cubicBezTo>
                    <a:pt x="36090" y="314004"/>
                    <a:pt x="40500" y="317589"/>
                    <a:pt x="49588" y="318909"/>
                  </a:cubicBezTo>
                  <a:cubicBezTo>
                    <a:pt x="53685" y="323563"/>
                    <a:pt x="54341" y="329914"/>
                    <a:pt x="58824" y="334347"/>
                  </a:cubicBezTo>
                  <a:lnTo>
                    <a:pt x="62959" y="332240"/>
                  </a:lnTo>
                  <a:cubicBezTo>
                    <a:pt x="65110" y="327902"/>
                    <a:pt x="66885" y="322556"/>
                    <a:pt x="71708" y="319947"/>
                  </a:cubicBezTo>
                  <a:cubicBezTo>
                    <a:pt x="73967" y="313061"/>
                    <a:pt x="73223" y="305704"/>
                    <a:pt x="75356" y="298787"/>
                  </a:cubicBezTo>
                  <a:lnTo>
                    <a:pt x="80217" y="297215"/>
                  </a:lnTo>
                  <a:cubicBezTo>
                    <a:pt x="86770" y="303252"/>
                    <a:pt x="83367" y="302686"/>
                    <a:pt x="85079" y="310294"/>
                  </a:cubicBezTo>
                  <a:cubicBezTo>
                    <a:pt x="85728" y="313155"/>
                    <a:pt x="87927" y="316237"/>
                    <a:pt x="87752" y="319161"/>
                  </a:cubicBezTo>
                  <a:cubicBezTo>
                    <a:pt x="87250" y="327776"/>
                    <a:pt x="76569" y="336925"/>
                    <a:pt x="76569" y="343245"/>
                  </a:cubicBezTo>
                  <a:cubicBezTo>
                    <a:pt x="76569" y="349125"/>
                    <a:pt x="87131" y="351671"/>
                    <a:pt x="89941" y="356576"/>
                  </a:cubicBezTo>
                  <a:cubicBezTo>
                    <a:pt x="92136" y="360380"/>
                    <a:pt x="91161" y="366606"/>
                    <a:pt x="92371" y="370945"/>
                  </a:cubicBezTo>
                  <a:cubicBezTo>
                    <a:pt x="103400" y="377799"/>
                    <a:pt x="123362" y="375220"/>
                    <a:pt x="126157" y="376699"/>
                  </a:cubicBezTo>
                  <a:cubicBezTo>
                    <a:pt x="127771" y="377547"/>
                    <a:pt x="129244" y="378616"/>
                    <a:pt x="130774" y="379560"/>
                  </a:cubicBezTo>
                  <a:lnTo>
                    <a:pt x="132475" y="383742"/>
                  </a:lnTo>
                  <a:cubicBezTo>
                    <a:pt x="129286" y="387734"/>
                    <a:pt x="127617" y="394463"/>
                    <a:pt x="129318" y="399179"/>
                  </a:cubicBezTo>
                  <a:cubicBezTo>
                    <a:pt x="134962" y="403046"/>
                    <a:pt x="136554" y="408800"/>
                    <a:pt x="139283" y="414334"/>
                  </a:cubicBezTo>
                  <a:lnTo>
                    <a:pt x="143170" y="416440"/>
                  </a:lnTo>
                  <a:lnTo>
                    <a:pt x="146330" y="412510"/>
                  </a:lnTo>
                  <a:lnTo>
                    <a:pt x="151676" y="411724"/>
                  </a:lnTo>
                  <a:cubicBezTo>
                    <a:pt x="153647" y="406285"/>
                    <a:pt x="152469" y="400374"/>
                    <a:pt x="154836" y="394997"/>
                  </a:cubicBezTo>
                  <a:cubicBezTo>
                    <a:pt x="157513" y="388929"/>
                    <a:pt x="161617" y="383112"/>
                    <a:pt x="166499" y="378271"/>
                  </a:cubicBezTo>
                  <a:cubicBezTo>
                    <a:pt x="167857" y="376918"/>
                    <a:pt x="172813" y="372674"/>
                    <a:pt x="173062" y="371197"/>
                  </a:cubicBezTo>
                  <a:cubicBezTo>
                    <a:pt x="173985" y="365757"/>
                    <a:pt x="170951" y="362896"/>
                    <a:pt x="167471" y="358651"/>
                  </a:cubicBezTo>
                  <a:cubicBezTo>
                    <a:pt x="169348" y="356042"/>
                    <a:pt x="171701" y="353684"/>
                    <a:pt x="174521" y="351860"/>
                  </a:cubicBezTo>
                  <a:lnTo>
                    <a:pt x="171845" y="347930"/>
                  </a:lnTo>
                  <a:cubicBezTo>
                    <a:pt x="162939" y="344597"/>
                    <a:pt x="140114" y="333152"/>
                    <a:pt x="135144" y="326235"/>
                  </a:cubicBezTo>
                  <a:cubicBezTo>
                    <a:pt x="132345" y="322337"/>
                    <a:pt x="133411" y="317274"/>
                    <a:pt x="130525" y="313439"/>
                  </a:cubicBezTo>
                  <a:cubicBezTo>
                    <a:pt x="127150" y="308911"/>
                    <a:pt x="116543" y="302812"/>
                    <a:pt x="115455" y="300862"/>
                  </a:cubicBezTo>
                  <a:cubicBezTo>
                    <a:pt x="112414" y="295486"/>
                    <a:pt x="109776" y="282060"/>
                    <a:pt x="106946" y="279450"/>
                  </a:cubicBezTo>
                  <a:cubicBezTo>
                    <a:pt x="103119" y="275898"/>
                    <a:pt x="97423" y="274766"/>
                    <a:pt x="93094" y="271842"/>
                  </a:cubicBezTo>
                  <a:cubicBezTo>
                    <a:pt x="93613" y="270458"/>
                    <a:pt x="93971" y="268981"/>
                    <a:pt x="94792" y="267660"/>
                  </a:cubicBezTo>
                  <a:cubicBezTo>
                    <a:pt x="96521" y="264925"/>
                    <a:pt x="99696" y="263258"/>
                    <a:pt x="101597" y="260617"/>
                  </a:cubicBezTo>
                  <a:cubicBezTo>
                    <a:pt x="103575" y="257882"/>
                    <a:pt x="104596" y="254643"/>
                    <a:pt x="107188" y="252254"/>
                  </a:cubicBezTo>
                  <a:lnTo>
                    <a:pt x="107430" y="247789"/>
                  </a:lnTo>
                  <a:cubicBezTo>
                    <a:pt x="103754" y="244079"/>
                    <a:pt x="96886" y="244676"/>
                    <a:pt x="91873" y="244142"/>
                  </a:cubicBezTo>
                  <a:cubicBezTo>
                    <a:pt x="90533" y="237885"/>
                    <a:pt x="92347" y="235338"/>
                    <a:pt x="95518" y="229490"/>
                  </a:cubicBezTo>
                  <a:lnTo>
                    <a:pt x="94546" y="225057"/>
                  </a:lnTo>
                  <a:cubicBezTo>
                    <a:pt x="86899" y="224680"/>
                    <a:pt x="86626" y="224491"/>
                    <a:pt x="80694" y="228453"/>
                  </a:cubicBezTo>
                  <a:cubicBezTo>
                    <a:pt x="76082" y="231534"/>
                    <a:pt x="55744" y="229899"/>
                    <a:pt x="50798" y="228704"/>
                  </a:cubicBezTo>
                  <a:cubicBezTo>
                    <a:pt x="49465" y="225340"/>
                    <a:pt x="54120" y="215750"/>
                    <a:pt x="57361" y="213801"/>
                  </a:cubicBezTo>
                  <a:cubicBezTo>
                    <a:pt x="62005" y="211034"/>
                    <a:pt x="71115" y="217417"/>
                    <a:pt x="80452" y="217731"/>
                  </a:cubicBezTo>
                  <a:cubicBezTo>
                    <a:pt x="85847" y="217920"/>
                    <a:pt x="89450" y="213549"/>
                    <a:pt x="94550" y="212763"/>
                  </a:cubicBezTo>
                  <a:cubicBezTo>
                    <a:pt x="98563" y="212166"/>
                    <a:pt x="101554" y="213266"/>
                    <a:pt x="105248" y="210939"/>
                  </a:cubicBezTo>
                  <a:cubicBezTo>
                    <a:pt x="101253" y="203677"/>
                    <a:pt x="95290" y="204495"/>
                    <a:pt x="87987" y="202042"/>
                  </a:cubicBezTo>
                  <a:lnTo>
                    <a:pt x="89688" y="196571"/>
                  </a:lnTo>
                  <a:cubicBezTo>
                    <a:pt x="92592" y="194842"/>
                    <a:pt x="94497" y="192169"/>
                    <a:pt x="97223" y="190283"/>
                  </a:cubicBezTo>
                  <a:cubicBezTo>
                    <a:pt x="103158" y="186196"/>
                    <a:pt x="108444" y="185221"/>
                    <a:pt x="111808" y="177989"/>
                  </a:cubicBezTo>
                  <a:cubicBezTo>
                    <a:pt x="116013" y="168966"/>
                    <a:pt x="107812" y="166482"/>
                    <a:pt x="106942" y="159973"/>
                  </a:cubicBezTo>
                  <a:cubicBezTo>
                    <a:pt x="106430" y="156074"/>
                    <a:pt x="113635" y="137619"/>
                    <a:pt x="115452" y="132242"/>
                  </a:cubicBezTo>
                  <a:cubicBezTo>
                    <a:pt x="118651" y="122779"/>
                    <a:pt x="125793" y="114918"/>
                    <a:pt x="133681" y="108189"/>
                  </a:cubicBezTo>
                  <a:cubicBezTo>
                    <a:pt x="136007" y="108724"/>
                    <a:pt x="138469" y="109038"/>
                    <a:pt x="140732" y="109761"/>
                  </a:cubicBezTo>
                  <a:cubicBezTo>
                    <a:pt x="142402" y="110296"/>
                    <a:pt x="148810" y="118471"/>
                    <a:pt x="149722" y="120232"/>
                  </a:cubicBezTo>
                  <a:cubicBezTo>
                    <a:pt x="154458" y="129318"/>
                    <a:pt x="156534" y="132525"/>
                    <a:pt x="168927" y="132242"/>
                  </a:cubicBezTo>
                  <a:cubicBezTo>
                    <a:pt x="182263" y="111836"/>
                    <a:pt x="143440" y="103662"/>
                    <a:pt x="141458" y="86243"/>
                  </a:cubicBezTo>
                  <a:cubicBezTo>
                    <a:pt x="140813" y="80552"/>
                    <a:pt x="141377" y="75207"/>
                    <a:pt x="143889" y="70020"/>
                  </a:cubicBezTo>
                  <a:cubicBezTo>
                    <a:pt x="147491" y="62568"/>
                    <a:pt x="155832" y="58104"/>
                    <a:pt x="159449" y="50683"/>
                  </a:cubicBezTo>
                  <a:cubicBezTo>
                    <a:pt x="160136" y="49268"/>
                    <a:pt x="160778" y="47885"/>
                    <a:pt x="161213" y="46345"/>
                  </a:cubicBezTo>
                  <a:cubicBezTo>
                    <a:pt x="166257" y="51658"/>
                    <a:pt x="179229" y="55777"/>
                    <a:pt x="186444" y="54205"/>
                  </a:cubicBezTo>
                  <a:cubicBezTo>
                    <a:pt x="193624" y="57286"/>
                    <a:pt x="198153" y="61688"/>
                    <a:pt x="201103" y="68259"/>
                  </a:cubicBezTo>
                  <a:lnTo>
                    <a:pt x="203702" y="74013"/>
                  </a:lnTo>
                  <a:cubicBezTo>
                    <a:pt x="204523" y="77157"/>
                    <a:pt x="198794" y="88633"/>
                    <a:pt x="197258" y="91369"/>
                  </a:cubicBezTo>
                  <a:cubicBezTo>
                    <a:pt x="199205" y="96619"/>
                    <a:pt x="205291" y="98726"/>
                    <a:pt x="207855" y="103725"/>
                  </a:cubicBezTo>
                  <a:cubicBezTo>
                    <a:pt x="209282" y="106995"/>
                    <a:pt x="205361" y="114541"/>
                    <a:pt x="203477" y="117088"/>
                  </a:cubicBezTo>
                  <a:lnTo>
                    <a:pt x="204617" y="121300"/>
                  </a:lnTo>
                  <a:cubicBezTo>
                    <a:pt x="205098" y="121081"/>
                    <a:pt x="209798" y="118974"/>
                    <a:pt x="209935" y="118848"/>
                  </a:cubicBezTo>
                  <a:cubicBezTo>
                    <a:pt x="212306" y="116678"/>
                    <a:pt x="214614" y="112937"/>
                    <a:pt x="216610" y="110422"/>
                  </a:cubicBezTo>
                  <a:lnTo>
                    <a:pt x="220984" y="112403"/>
                  </a:lnTo>
                  <a:cubicBezTo>
                    <a:pt x="222693" y="115075"/>
                    <a:pt x="225204" y="118250"/>
                    <a:pt x="226495" y="121081"/>
                  </a:cubicBezTo>
                  <a:cubicBezTo>
                    <a:pt x="227116" y="122432"/>
                    <a:pt x="226754" y="129790"/>
                    <a:pt x="226730" y="130293"/>
                  </a:cubicBezTo>
                  <a:lnTo>
                    <a:pt x="226263" y="139883"/>
                  </a:lnTo>
                  <a:cubicBezTo>
                    <a:pt x="226382" y="141800"/>
                    <a:pt x="229108" y="151327"/>
                    <a:pt x="230637" y="152993"/>
                  </a:cubicBezTo>
                  <a:cubicBezTo>
                    <a:pt x="233061" y="155666"/>
                    <a:pt x="236814" y="158275"/>
                    <a:pt x="239617" y="160665"/>
                  </a:cubicBezTo>
                  <a:lnTo>
                    <a:pt x="246520" y="157364"/>
                  </a:lnTo>
                  <a:cubicBezTo>
                    <a:pt x="252118" y="154691"/>
                    <a:pt x="253188" y="154754"/>
                    <a:pt x="259565" y="155792"/>
                  </a:cubicBezTo>
                  <a:lnTo>
                    <a:pt x="269545" y="157458"/>
                  </a:lnTo>
                  <a:lnTo>
                    <a:pt x="278510" y="166136"/>
                  </a:lnTo>
                  <a:lnTo>
                    <a:pt x="283116" y="163401"/>
                  </a:lnTo>
                  <a:lnTo>
                    <a:pt x="283810" y="158936"/>
                  </a:lnTo>
                  <a:cubicBezTo>
                    <a:pt x="281306" y="155572"/>
                    <a:pt x="275971" y="145605"/>
                    <a:pt x="277135" y="141863"/>
                  </a:cubicBezTo>
                  <a:lnTo>
                    <a:pt x="281741" y="139379"/>
                  </a:lnTo>
                  <a:cubicBezTo>
                    <a:pt x="284207" y="140354"/>
                    <a:pt x="288661" y="140543"/>
                    <a:pt x="291184" y="139631"/>
                  </a:cubicBezTo>
                  <a:lnTo>
                    <a:pt x="295326" y="135166"/>
                  </a:lnTo>
                  <a:cubicBezTo>
                    <a:pt x="295768" y="135229"/>
                    <a:pt x="300247" y="135858"/>
                    <a:pt x="300374" y="135921"/>
                  </a:cubicBezTo>
                  <a:lnTo>
                    <a:pt x="306821" y="140385"/>
                  </a:lnTo>
                  <a:cubicBezTo>
                    <a:pt x="310799" y="143121"/>
                    <a:pt x="319526" y="148183"/>
                    <a:pt x="324780" y="148277"/>
                  </a:cubicBezTo>
                  <a:cubicBezTo>
                    <a:pt x="329579" y="145448"/>
                    <a:pt x="330259" y="142429"/>
                    <a:pt x="333297" y="139883"/>
                  </a:cubicBezTo>
                  <a:cubicBezTo>
                    <a:pt x="336327" y="137336"/>
                    <a:pt x="340196" y="136392"/>
                    <a:pt x="343651" y="132682"/>
                  </a:cubicBezTo>
                  <a:cubicBezTo>
                    <a:pt x="343743" y="128972"/>
                    <a:pt x="346093" y="121804"/>
                    <a:pt x="349860" y="119572"/>
                  </a:cubicBezTo>
                  <a:cubicBezTo>
                    <a:pt x="354960" y="120986"/>
                    <a:pt x="361046" y="122779"/>
                    <a:pt x="365515" y="125514"/>
                  </a:cubicBezTo>
                  <a:lnTo>
                    <a:pt x="370345" y="121552"/>
                  </a:lnTo>
                  <a:lnTo>
                    <a:pt x="375431" y="120577"/>
                  </a:lnTo>
                  <a:lnTo>
                    <a:pt x="379332" y="111648"/>
                  </a:lnTo>
                  <a:lnTo>
                    <a:pt x="384625" y="107938"/>
                  </a:lnTo>
                  <a:lnTo>
                    <a:pt x="389686" y="107687"/>
                  </a:lnTo>
                  <a:cubicBezTo>
                    <a:pt x="397112" y="104574"/>
                    <a:pt x="403377" y="94890"/>
                    <a:pt x="403945" y="87627"/>
                  </a:cubicBezTo>
                  <a:cubicBezTo>
                    <a:pt x="403570" y="84420"/>
                    <a:pt x="399827" y="80081"/>
                    <a:pt x="396818" y="78477"/>
                  </a:cubicBezTo>
                  <a:cubicBezTo>
                    <a:pt x="401609" y="75868"/>
                    <a:pt x="407305" y="73321"/>
                    <a:pt x="411767" y="70302"/>
                  </a:cubicBezTo>
                  <a:cubicBezTo>
                    <a:pt x="412300" y="69957"/>
                    <a:pt x="417218" y="64046"/>
                    <a:pt x="419842" y="62128"/>
                  </a:cubicBezTo>
                  <a:cubicBezTo>
                    <a:pt x="419947" y="61782"/>
                    <a:pt x="421010" y="58324"/>
                    <a:pt x="420992" y="58166"/>
                  </a:cubicBezTo>
                  <a:cubicBezTo>
                    <a:pt x="420417" y="53733"/>
                    <a:pt x="418639" y="48734"/>
                    <a:pt x="417541" y="44332"/>
                  </a:cubicBezTo>
                  <a:cubicBezTo>
                    <a:pt x="414359" y="42288"/>
                    <a:pt x="411108" y="38955"/>
                    <a:pt x="409249" y="35906"/>
                  </a:cubicBezTo>
                  <a:lnTo>
                    <a:pt x="411771" y="31944"/>
                  </a:lnTo>
                  <a:cubicBezTo>
                    <a:pt x="419302" y="32730"/>
                    <a:pt x="425931" y="24273"/>
                    <a:pt x="429049" y="19305"/>
                  </a:cubicBezTo>
                  <a:cubicBezTo>
                    <a:pt x="432227" y="17261"/>
                    <a:pt x="440313" y="16161"/>
                    <a:pt x="444006" y="16098"/>
                  </a:cubicBezTo>
                  <a:cubicBezTo>
                    <a:pt x="445493" y="16066"/>
                    <a:pt x="447328" y="17041"/>
                    <a:pt x="448836" y="17072"/>
                  </a:cubicBezTo>
                  <a:cubicBezTo>
                    <a:pt x="453586" y="17198"/>
                    <a:pt x="465940" y="17230"/>
                    <a:pt x="470244" y="15092"/>
                  </a:cubicBezTo>
                  <a:cubicBezTo>
                    <a:pt x="472678" y="12010"/>
                    <a:pt x="473909" y="5345"/>
                    <a:pt x="474162" y="1729"/>
                  </a:cubicBezTo>
                  <a:lnTo>
                    <a:pt x="478767" y="0"/>
                  </a:lnTo>
                  <a:lnTo>
                    <a:pt x="483826" y="975"/>
                  </a:lnTo>
                  <a:lnTo>
                    <a:pt x="487063" y="5942"/>
                  </a:lnTo>
                  <a:cubicBezTo>
                    <a:pt x="490013" y="6948"/>
                    <a:pt x="494068" y="7232"/>
                    <a:pt x="497183" y="6917"/>
                  </a:cubicBezTo>
                  <a:lnTo>
                    <a:pt x="502932" y="3458"/>
                  </a:lnTo>
                  <a:lnTo>
                    <a:pt x="507987" y="5439"/>
                  </a:lnTo>
                  <a:cubicBezTo>
                    <a:pt x="511224" y="9369"/>
                    <a:pt x="512392" y="14212"/>
                    <a:pt x="514669" y="18550"/>
                  </a:cubicBezTo>
                  <a:lnTo>
                    <a:pt x="517878" y="23266"/>
                  </a:lnTo>
                  <a:cubicBezTo>
                    <a:pt x="518331" y="23675"/>
                    <a:pt x="522175" y="25436"/>
                    <a:pt x="522954" y="25971"/>
                  </a:cubicBezTo>
                  <a:lnTo>
                    <a:pt x="525876" y="28611"/>
                  </a:lnTo>
                  <a:cubicBezTo>
                    <a:pt x="526444" y="29146"/>
                    <a:pt x="526623" y="29617"/>
                    <a:pt x="527335" y="29932"/>
                  </a:cubicBezTo>
                  <a:cubicBezTo>
                    <a:pt x="530208" y="31315"/>
                    <a:pt x="534768" y="32196"/>
                    <a:pt x="537921" y="33171"/>
                  </a:cubicBezTo>
                  <a:cubicBezTo>
                    <a:pt x="539605" y="36063"/>
                    <a:pt x="542779" y="39176"/>
                    <a:pt x="545743" y="41093"/>
                  </a:cubicBezTo>
                  <a:lnTo>
                    <a:pt x="543663" y="45527"/>
                  </a:lnTo>
                  <a:cubicBezTo>
                    <a:pt x="545470" y="47696"/>
                    <a:pt x="546634" y="52067"/>
                    <a:pt x="545971" y="54708"/>
                  </a:cubicBezTo>
                  <a:lnTo>
                    <a:pt x="552180" y="63385"/>
                  </a:lnTo>
                  <a:lnTo>
                    <a:pt x="557705" y="65335"/>
                  </a:lnTo>
                  <a:cubicBezTo>
                    <a:pt x="557343" y="68133"/>
                    <a:pt x="557820" y="71623"/>
                    <a:pt x="558855" y="74264"/>
                  </a:cubicBezTo>
                  <a:cubicBezTo>
                    <a:pt x="561258" y="72661"/>
                    <a:pt x="566221" y="71403"/>
                    <a:pt x="569210" y="72032"/>
                  </a:cubicBezTo>
                  <a:lnTo>
                    <a:pt x="569904" y="76245"/>
                  </a:lnTo>
                  <a:lnTo>
                    <a:pt x="574506" y="80458"/>
                  </a:lnTo>
                  <a:cubicBezTo>
                    <a:pt x="578280" y="82061"/>
                    <a:pt x="580908" y="80301"/>
                    <a:pt x="584405" y="79703"/>
                  </a:cubicBezTo>
                  <a:cubicBezTo>
                    <a:pt x="589652" y="78823"/>
                    <a:pt x="593942" y="81370"/>
                    <a:pt x="599127" y="80710"/>
                  </a:cubicBezTo>
                  <a:cubicBezTo>
                    <a:pt x="602238" y="79703"/>
                    <a:pt x="606251" y="76465"/>
                    <a:pt x="607657" y="73761"/>
                  </a:cubicBezTo>
                  <a:cubicBezTo>
                    <a:pt x="606924" y="69265"/>
                    <a:pt x="604230" y="67567"/>
                    <a:pt x="602806" y="64109"/>
                  </a:cubicBezTo>
                  <a:cubicBezTo>
                    <a:pt x="601817" y="61719"/>
                    <a:pt x="601382" y="58480"/>
                    <a:pt x="600740" y="55934"/>
                  </a:cubicBezTo>
                  <a:lnTo>
                    <a:pt x="604434" y="51501"/>
                  </a:lnTo>
                  <a:lnTo>
                    <a:pt x="609036" y="53701"/>
                  </a:lnTo>
                  <a:cubicBezTo>
                    <a:pt x="609408" y="53261"/>
                    <a:pt x="612358" y="49991"/>
                    <a:pt x="612487" y="49740"/>
                  </a:cubicBezTo>
                  <a:cubicBezTo>
                    <a:pt x="612775" y="49205"/>
                    <a:pt x="613087" y="46030"/>
                    <a:pt x="613396" y="45307"/>
                  </a:cubicBezTo>
                  <a:cubicBezTo>
                    <a:pt x="614690" y="42194"/>
                    <a:pt x="617682" y="38484"/>
                    <a:pt x="620541" y="36377"/>
                  </a:cubicBezTo>
                  <a:cubicBezTo>
                    <a:pt x="622344" y="31913"/>
                    <a:pt x="620531" y="26725"/>
                    <a:pt x="623765" y="22764"/>
                  </a:cubicBezTo>
                  <a:lnTo>
                    <a:pt x="628833" y="22764"/>
                  </a:lnTo>
                  <a:lnTo>
                    <a:pt x="633891" y="25719"/>
                  </a:lnTo>
                  <a:lnTo>
                    <a:pt x="638497" y="25498"/>
                  </a:lnTo>
                  <a:lnTo>
                    <a:pt x="643313" y="21286"/>
                  </a:lnTo>
                  <a:lnTo>
                    <a:pt x="648389" y="21034"/>
                  </a:lnTo>
                  <a:cubicBezTo>
                    <a:pt x="651595" y="24587"/>
                    <a:pt x="651026" y="29932"/>
                    <a:pt x="651840" y="34145"/>
                  </a:cubicBezTo>
                  <a:cubicBezTo>
                    <a:pt x="652110" y="35560"/>
                    <a:pt x="652956" y="36944"/>
                    <a:pt x="653219" y="38358"/>
                  </a:cubicBezTo>
                  <a:cubicBezTo>
                    <a:pt x="653847" y="41754"/>
                    <a:pt x="653503" y="44458"/>
                    <a:pt x="655285" y="47759"/>
                  </a:cubicBezTo>
                  <a:lnTo>
                    <a:pt x="660350" y="48262"/>
                  </a:lnTo>
                  <a:lnTo>
                    <a:pt x="665180" y="52224"/>
                  </a:lnTo>
                  <a:cubicBezTo>
                    <a:pt x="666141" y="59958"/>
                    <a:pt x="656053" y="67347"/>
                    <a:pt x="662886" y="75019"/>
                  </a:cubicBezTo>
                  <a:cubicBezTo>
                    <a:pt x="658080" y="78572"/>
                    <a:pt x="652552" y="77282"/>
                    <a:pt x="647933" y="80930"/>
                  </a:cubicBezTo>
                  <a:lnTo>
                    <a:pt x="648613" y="85394"/>
                  </a:lnTo>
                  <a:lnTo>
                    <a:pt x="661746" y="98286"/>
                  </a:lnTo>
                  <a:cubicBezTo>
                    <a:pt x="664633" y="96430"/>
                    <a:pt x="668589" y="94732"/>
                    <a:pt x="672080" y="94072"/>
                  </a:cubicBezTo>
                  <a:cubicBezTo>
                    <a:pt x="673241" y="97877"/>
                    <a:pt x="676562" y="104574"/>
                    <a:pt x="680147" y="107183"/>
                  </a:cubicBezTo>
                  <a:cubicBezTo>
                    <a:pt x="679807" y="109573"/>
                    <a:pt x="678860" y="113000"/>
                    <a:pt x="678990" y="115358"/>
                  </a:cubicBezTo>
                  <a:cubicBezTo>
                    <a:pt x="679014" y="115798"/>
                    <a:pt x="680670" y="119068"/>
                    <a:pt x="680842" y="119823"/>
                  </a:cubicBezTo>
                  <a:cubicBezTo>
                    <a:pt x="681582" y="122998"/>
                    <a:pt x="681129" y="125860"/>
                    <a:pt x="682445" y="129223"/>
                  </a:cubicBezTo>
                  <a:lnTo>
                    <a:pt x="677611" y="133185"/>
                  </a:lnTo>
                  <a:lnTo>
                    <a:pt x="667944" y="132682"/>
                  </a:lnTo>
                  <a:cubicBezTo>
                    <a:pt x="667029" y="137775"/>
                    <a:pt x="662739" y="141423"/>
                    <a:pt x="661041" y="146297"/>
                  </a:cubicBezTo>
                  <a:lnTo>
                    <a:pt x="664720" y="150761"/>
                  </a:lnTo>
                  <a:cubicBezTo>
                    <a:pt x="668937" y="150635"/>
                    <a:pt x="673497" y="151924"/>
                    <a:pt x="676997" y="153968"/>
                  </a:cubicBezTo>
                  <a:lnTo>
                    <a:pt x="680386" y="155949"/>
                  </a:lnTo>
                  <a:cubicBezTo>
                    <a:pt x="683441" y="156861"/>
                    <a:pt x="687338" y="156798"/>
                    <a:pt x="690519" y="157458"/>
                  </a:cubicBezTo>
                  <a:cubicBezTo>
                    <a:pt x="701786" y="159754"/>
                    <a:pt x="709724" y="168997"/>
                    <a:pt x="720412" y="167110"/>
                  </a:cubicBezTo>
                  <a:cubicBezTo>
                    <a:pt x="723839" y="164973"/>
                    <a:pt x="727252" y="162646"/>
                    <a:pt x="730774" y="160665"/>
                  </a:cubicBezTo>
                  <a:cubicBezTo>
                    <a:pt x="731521" y="160225"/>
                    <a:pt x="734944" y="158998"/>
                    <a:pt x="735379" y="158684"/>
                  </a:cubicBezTo>
                  <a:cubicBezTo>
                    <a:pt x="736014" y="158212"/>
                    <a:pt x="738329" y="155037"/>
                    <a:pt x="738824" y="154723"/>
                  </a:cubicBezTo>
                  <a:cubicBezTo>
                    <a:pt x="743436" y="151862"/>
                    <a:pt x="749122" y="150069"/>
                    <a:pt x="753794" y="147302"/>
                  </a:cubicBezTo>
                  <a:cubicBezTo>
                    <a:pt x="757295" y="145196"/>
                    <a:pt x="760179" y="141926"/>
                    <a:pt x="763686" y="139851"/>
                  </a:cubicBezTo>
                  <a:cubicBezTo>
                    <a:pt x="765886" y="138561"/>
                    <a:pt x="769435" y="138845"/>
                    <a:pt x="773126" y="135889"/>
                  </a:cubicBezTo>
                  <a:lnTo>
                    <a:pt x="778099" y="137021"/>
                  </a:lnTo>
                  <a:lnTo>
                    <a:pt x="778099" y="137619"/>
                  </a:lnTo>
                  <a:cubicBezTo>
                    <a:pt x="777043" y="138499"/>
                    <a:pt x="777001" y="140354"/>
                    <a:pt x="776801" y="141518"/>
                  </a:cubicBezTo>
                  <a:cubicBezTo>
                    <a:pt x="775486" y="149000"/>
                    <a:pt x="786630" y="153905"/>
                    <a:pt x="792919" y="155949"/>
                  </a:cubicBezTo>
                  <a:lnTo>
                    <a:pt x="798665" y="155477"/>
                  </a:lnTo>
                  <a:cubicBezTo>
                    <a:pt x="806761" y="150101"/>
                    <a:pt x="801397" y="143939"/>
                    <a:pt x="806498" y="139128"/>
                  </a:cubicBezTo>
                  <a:cubicBezTo>
                    <a:pt x="809342" y="138122"/>
                    <a:pt x="814351" y="138468"/>
                    <a:pt x="817080" y="139631"/>
                  </a:cubicBezTo>
                  <a:cubicBezTo>
                    <a:pt x="823524" y="146642"/>
                    <a:pt x="832188" y="153119"/>
                    <a:pt x="840347" y="158433"/>
                  </a:cubicBezTo>
                  <a:cubicBezTo>
                    <a:pt x="846668" y="157993"/>
                    <a:pt x="866616" y="156986"/>
                    <a:pt x="872095" y="160414"/>
                  </a:cubicBezTo>
                  <a:cubicBezTo>
                    <a:pt x="873617" y="161388"/>
                    <a:pt x="875367" y="163401"/>
                    <a:pt x="876700" y="164626"/>
                  </a:cubicBezTo>
                  <a:cubicBezTo>
                    <a:pt x="881229" y="165130"/>
                    <a:pt x="888262" y="163872"/>
                    <a:pt x="892587" y="162898"/>
                  </a:cubicBezTo>
                  <a:lnTo>
                    <a:pt x="892432" y="163558"/>
                  </a:lnTo>
                  <a:cubicBezTo>
                    <a:pt x="895456" y="161545"/>
                    <a:pt x="896740" y="156421"/>
                    <a:pt x="901100" y="153245"/>
                  </a:cubicBezTo>
                  <a:lnTo>
                    <a:pt x="911686" y="150604"/>
                  </a:lnTo>
                  <a:cubicBezTo>
                    <a:pt x="918351" y="148937"/>
                    <a:pt x="919947" y="148874"/>
                    <a:pt x="926029" y="151579"/>
                  </a:cubicBezTo>
                  <a:lnTo>
                    <a:pt x="933086" y="154723"/>
                  </a:lnTo>
                  <a:cubicBezTo>
                    <a:pt x="933855" y="155194"/>
                    <a:pt x="938232" y="160508"/>
                    <a:pt x="941621" y="162646"/>
                  </a:cubicBezTo>
                  <a:lnTo>
                    <a:pt x="946451" y="162142"/>
                  </a:lnTo>
                  <a:lnTo>
                    <a:pt x="955879" y="153748"/>
                  </a:lnTo>
                  <a:cubicBezTo>
                    <a:pt x="955244" y="151610"/>
                    <a:pt x="955911" y="147051"/>
                    <a:pt x="957486" y="145322"/>
                  </a:cubicBezTo>
                  <a:cubicBezTo>
                    <a:pt x="958833" y="143813"/>
                    <a:pt x="961425" y="142838"/>
                    <a:pt x="962786" y="141360"/>
                  </a:cubicBezTo>
                  <a:cubicBezTo>
                    <a:pt x="964764" y="139191"/>
                    <a:pt x="967009" y="135669"/>
                    <a:pt x="968546" y="133185"/>
                  </a:cubicBezTo>
                  <a:cubicBezTo>
                    <a:pt x="969394" y="131802"/>
                    <a:pt x="969756" y="130104"/>
                    <a:pt x="970615" y="128721"/>
                  </a:cubicBezTo>
                  <a:cubicBezTo>
                    <a:pt x="973954" y="123407"/>
                    <a:pt x="982432" y="116081"/>
                    <a:pt x="987175" y="111648"/>
                  </a:cubicBezTo>
                  <a:cubicBezTo>
                    <a:pt x="996681" y="116615"/>
                    <a:pt x="1008926" y="106869"/>
                    <a:pt x="1018025" y="108661"/>
                  </a:cubicBezTo>
                  <a:cubicBezTo>
                    <a:pt x="1022771" y="113818"/>
                    <a:pt x="1030421" y="117119"/>
                    <a:pt x="1037363" y="113126"/>
                  </a:cubicBezTo>
                  <a:cubicBezTo>
                    <a:pt x="1043238" y="114101"/>
                    <a:pt x="1043933" y="116962"/>
                    <a:pt x="1047725" y="119572"/>
                  </a:cubicBezTo>
                  <a:cubicBezTo>
                    <a:pt x="1050667" y="121583"/>
                    <a:pt x="1054550" y="122904"/>
                    <a:pt x="1057385" y="125011"/>
                  </a:cubicBezTo>
                  <a:cubicBezTo>
                    <a:pt x="1060594" y="127400"/>
                    <a:pt x="1063327" y="130827"/>
                    <a:pt x="1066365" y="133437"/>
                  </a:cubicBezTo>
                  <a:cubicBezTo>
                    <a:pt x="1070784" y="137241"/>
                    <a:pt x="1075642" y="141360"/>
                    <a:pt x="1080399" y="144819"/>
                  </a:cubicBezTo>
                  <a:cubicBezTo>
                    <a:pt x="1086285" y="149095"/>
                    <a:pt x="1092714" y="146453"/>
                    <a:pt x="1097923" y="152742"/>
                  </a:cubicBezTo>
                  <a:lnTo>
                    <a:pt x="1101669" y="157207"/>
                  </a:lnTo>
                  <a:close/>
                  <a:moveTo>
                    <a:pt x="340519" y="257567"/>
                  </a:moveTo>
                  <a:lnTo>
                    <a:pt x="358787" y="257033"/>
                  </a:lnTo>
                  <a:lnTo>
                    <a:pt x="367367" y="238639"/>
                  </a:lnTo>
                  <a:lnTo>
                    <a:pt x="378206" y="244425"/>
                  </a:lnTo>
                  <a:cubicBezTo>
                    <a:pt x="378206" y="244425"/>
                    <a:pt x="394166" y="239551"/>
                    <a:pt x="397673" y="230119"/>
                  </a:cubicBezTo>
                  <a:cubicBezTo>
                    <a:pt x="401181" y="220687"/>
                    <a:pt x="405920" y="210814"/>
                    <a:pt x="413637" y="207104"/>
                  </a:cubicBezTo>
                  <a:cubicBezTo>
                    <a:pt x="421350" y="203394"/>
                    <a:pt x="433781" y="196288"/>
                    <a:pt x="431954" y="204148"/>
                  </a:cubicBezTo>
                  <a:cubicBezTo>
                    <a:pt x="430123" y="212040"/>
                    <a:pt x="416878" y="220687"/>
                    <a:pt x="427008" y="223422"/>
                  </a:cubicBezTo>
                  <a:cubicBezTo>
                    <a:pt x="437138" y="226189"/>
                    <a:pt x="442901" y="231313"/>
                    <a:pt x="450545" y="233452"/>
                  </a:cubicBezTo>
                  <a:cubicBezTo>
                    <a:pt x="458184" y="235621"/>
                    <a:pt x="465975" y="237728"/>
                    <a:pt x="465975" y="237728"/>
                  </a:cubicBezTo>
                  <a:lnTo>
                    <a:pt x="483555" y="225906"/>
                  </a:lnTo>
                  <a:lnTo>
                    <a:pt x="495404" y="226880"/>
                  </a:lnTo>
                  <a:lnTo>
                    <a:pt x="510147" y="219052"/>
                  </a:lnTo>
                  <a:lnTo>
                    <a:pt x="521228" y="212763"/>
                  </a:lnTo>
                  <a:lnTo>
                    <a:pt x="527679" y="210468"/>
                  </a:lnTo>
                  <a:cubicBezTo>
                    <a:pt x="527679" y="210468"/>
                    <a:pt x="534154" y="215531"/>
                    <a:pt x="540454" y="209839"/>
                  </a:cubicBezTo>
                  <a:cubicBezTo>
                    <a:pt x="546754" y="204148"/>
                    <a:pt x="550612" y="203268"/>
                    <a:pt x="557890" y="205281"/>
                  </a:cubicBezTo>
                  <a:cubicBezTo>
                    <a:pt x="565169" y="207324"/>
                    <a:pt x="570585" y="209525"/>
                    <a:pt x="570585" y="209525"/>
                  </a:cubicBezTo>
                  <a:lnTo>
                    <a:pt x="587464" y="233169"/>
                  </a:lnTo>
                  <a:cubicBezTo>
                    <a:pt x="587464" y="233169"/>
                    <a:pt x="582265" y="237477"/>
                    <a:pt x="588186" y="242821"/>
                  </a:cubicBezTo>
                  <a:cubicBezTo>
                    <a:pt x="594107" y="248198"/>
                    <a:pt x="597124" y="252662"/>
                    <a:pt x="597124" y="252662"/>
                  </a:cubicBezTo>
                  <a:lnTo>
                    <a:pt x="595170" y="259076"/>
                  </a:lnTo>
                  <a:lnTo>
                    <a:pt x="598607" y="269610"/>
                  </a:lnTo>
                  <a:cubicBezTo>
                    <a:pt x="598607" y="269610"/>
                    <a:pt x="616907" y="264704"/>
                    <a:pt x="622169" y="266277"/>
                  </a:cubicBezTo>
                  <a:cubicBezTo>
                    <a:pt x="627430" y="267849"/>
                    <a:pt x="632260" y="271150"/>
                    <a:pt x="636859" y="274200"/>
                  </a:cubicBezTo>
                  <a:cubicBezTo>
                    <a:pt x="641464" y="277281"/>
                    <a:pt x="647968" y="282186"/>
                    <a:pt x="642085" y="287216"/>
                  </a:cubicBezTo>
                  <a:cubicBezTo>
                    <a:pt x="636199" y="292216"/>
                    <a:pt x="631590" y="300296"/>
                    <a:pt x="633456" y="308031"/>
                  </a:cubicBezTo>
                  <a:cubicBezTo>
                    <a:pt x="635323" y="315797"/>
                    <a:pt x="634049" y="324160"/>
                    <a:pt x="634049" y="324160"/>
                  </a:cubicBezTo>
                  <a:cubicBezTo>
                    <a:pt x="634049" y="324160"/>
                    <a:pt x="628668" y="329693"/>
                    <a:pt x="621909" y="337680"/>
                  </a:cubicBezTo>
                  <a:cubicBezTo>
                    <a:pt x="615153" y="345666"/>
                    <a:pt x="608833" y="352803"/>
                    <a:pt x="608833" y="352803"/>
                  </a:cubicBezTo>
                  <a:cubicBezTo>
                    <a:pt x="608833" y="352803"/>
                    <a:pt x="594837" y="351891"/>
                    <a:pt x="592276" y="358997"/>
                  </a:cubicBezTo>
                  <a:cubicBezTo>
                    <a:pt x="589719" y="366103"/>
                    <a:pt x="575141" y="374969"/>
                    <a:pt x="567522" y="364247"/>
                  </a:cubicBezTo>
                  <a:cubicBezTo>
                    <a:pt x="559904" y="353526"/>
                    <a:pt x="555884" y="352772"/>
                    <a:pt x="555884" y="352772"/>
                  </a:cubicBezTo>
                  <a:lnTo>
                    <a:pt x="536500" y="363745"/>
                  </a:lnTo>
                  <a:lnTo>
                    <a:pt x="529247" y="361261"/>
                  </a:lnTo>
                  <a:lnTo>
                    <a:pt x="518173" y="367518"/>
                  </a:lnTo>
                  <a:lnTo>
                    <a:pt x="507295" y="363305"/>
                  </a:lnTo>
                  <a:lnTo>
                    <a:pt x="494327" y="373617"/>
                  </a:lnTo>
                  <a:cubicBezTo>
                    <a:pt x="494327" y="373617"/>
                    <a:pt x="482563" y="373806"/>
                    <a:pt x="478704" y="378994"/>
                  </a:cubicBezTo>
                  <a:cubicBezTo>
                    <a:pt x="474846" y="384182"/>
                    <a:pt x="461696" y="388489"/>
                    <a:pt x="461254" y="384370"/>
                  </a:cubicBezTo>
                  <a:cubicBezTo>
                    <a:pt x="460815" y="380251"/>
                    <a:pt x="451172" y="380094"/>
                    <a:pt x="448538" y="380943"/>
                  </a:cubicBezTo>
                  <a:cubicBezTo>
                    <a:pt x="445908" y="381792"/>
                    <a:pt x="440404" y="384559"/>
                    <a:pt x="435700" y="383961"/>
                  </a:cubicBezTo>
                  <a:cubicBezTo>
                    <a:pt x="431000" y="383396"/>
                    <a:pt x="431238" y="379088"/>
                    <a:pt x="431238" y="379088"/>
                  </a:cubicBezTo>
                  <a:lnTo>
                    <a:pt x="423020" y="378963"/>
                  </a:lnTo>
                  <a:cubicBezTo>
                    <a:pt x="423020" y="378963"/>
                    <a:pt x="412655" y="370976"/>
                    <a:pt x="422266" y="370882"/>
                  </a:cubicBezTo>
                  <a:cubicBezTo>
                    <a:pt x="431877" y="370819"/>
                    <a:pt x="432028" y="370033"/>
                    <a:pt x="430638" y="362959"/>
                  </a:cubicBezTo>
                  <a:cubicBezTo>
                    <a:pt x="429249" y="355884"/>
                    <a:pt x="413763" y="339283"/>
                    <a:pt x="413763" y="339283"/>
                  </a:cubicBezTo>
                  <a:lnTo>
                    <a:pt x="404731" y="334315"/>
                  </a:lnTo>
                  <a:lnTo>
                    <a:pt x="377420" y="330668"/>
                  </a:lnTo>
                  <a:lnTo>
                    <a:pt x="367862" y="335448"/>
                  </a:lnTo>
                  <a:lnTo>
                    <a:pt x="354490" y="335982"/>
                  </a:lnTo>
                  <a:lnTo>
                    <a:pt x="348212" y="330229"/>
                  </a:lnTo>
                  <a:cubicBezTo>
                    <a:pt x="348212" y="330229"/>
                    <a:pt x="333248" y="331329"/>
                    <a:pt x="336524" y="321204"/>
                  </a:cubicBezTo>
                  <a:cubicBezTo>
                    <a:pt x="339800" y="311080"/>
                    <a:pt x="337832" y="301051"/>
                    <a:pt x="337832" y="301051"/>
                  </a:cubicBezTo>
                  <a:lnTo>
                    <a:pt x="339095" y="283318"/>
                  </a:lnTo>
                  <a:lnTo>
                    <a:pt x="348253" y="281871"/>
                  </a:lnTo>
                  <a:lnTo>
                    <a:pt x="353876" y="274703"/>
                  </a:lnTo>
                  <a:lnTo>
                    <a:pt x="340519" y="257567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70" name="자유형: 도형 311"/>
            <p:cNvSpPr/>
            <p:nvPr/>
          </p:nvSpPr>
          <p:spPr>
            <a:xfrm>
              <a:off x="6504480" y="3048480"/>
              <a:ext cx="1538280" cy="938160"/>
            </a:xfrm>
            <a:custGeom>
              <a:avLst/>
              <a:gdLst/>
              <a:ahLst/>
              <a:cxnLst/>
              <a:rect l="l" t="t" r="r" b="b"/>
              <a:pathLst>
                <a:path w="1217963" h="763818">
                  <a:moveTo>
                    <a:pt x="1001988" y="85282"/>
                  </a:moveTo>
                  <a:cubicBezTo>
                    <a:pt x="1002325" y="90250"/>
                    <a:pt x="1006660" y="91413"/>
                    <a:pt x="1008165" y="94463"/>
                  </a:cubicBezTo>
                  <a:cubicBezTo>
                    <a:pt x="1010480" y="99179"/>
                    <a:pt x="1008947" y="103801"/>
                    <a:pt x="1014240" y="110026"/>
                  </a:cubicBezTo>
                  <a:cubicBezTo>
                    <a:pt x="1017134" y="109272"/>
                    <a:pt x="1020933" y="105876"/>
                    <a:pt x="1022540" y="103738"/>
                  </a:cubicBezTo>
                  <a:lnTo>
                    <a:pt x="1022319" y="94809"/>
                  </a:lnTo>
                  <a:lnTo>
                    <a:pt x="1032052" y="87986"/>
                  </a:lnTo>
                  <a:lnTo>
                    <a:pt x="1037135" y="88017"/>
                  </a:lnTo>
                  <a:lnTo>
                    <a:pt x="1041772" y="91790"/>
                  </a:lnTo>
                  <a:cubicBezTo>
                    <a:pt x="1041407" y="96412"/>
                    <a:pt x="1043410" y="105970"/>
                    <a:pt x="1047342" y="109146"/>
                  </a:cubicBezTo>
                  <a:cubicBezTo>
                    <a:pt x="1050447" y="109586"/>
                    <a:pt x="1055133" y="109806"/>
                    <a:pt x="1058016" y="110718"/>
                  </a:cubicBezTo>
                  <a:cubicBezTo>
                    <a:pt x="1058160" y="110781"/>
                    <a:pt x="1062696" y="113925"/>
                    <a:pt x="1063123" y="114239"/>
                  </a:cubicBezTo>
                  <a:lnTo>
                    <a:pt x="1065347" y="111473"/>
                  </a:lnTo>
                  <a:cubicBezTo>
                    <a:pt x="1067413" y="112007"/>
                    <a:pt x="1069939" y="114302"/>
                    <a:pt x="1070774" y="116031"/>
                  </a:cubicBezTo>
                  <a:lnTo>
                    <a:pt x="1075411" y="114114"/>
                  </a:lnTo>
                  <a:lnTo>
                    <a:pt x="1078655" y="118830"/>
                  </a:lnTo>
                  <a:lnTo>
                    <a:pt x="1083538" y="114931"/>
                  </a:lnTo>
                  <a:lnTo>
                    <a:pt x="1089108" y="117195"/>
                  </a:lnTo>
                  <a:lnTo>
                    <a:pt x="1093746" y="116723"/>
                  </a:lnTo>
                  <a:lnTo>
                    <a:pt x="1096040" y="120905"/>
                  </a:lnTo>
                  <a:lnTo>
                    <a:pt x="1092311" y="127571"/>
                  </a:lnTo>
                  <a:lnTo>
                    <a:pt x="1100000" y="129645"/>
                  </a:lnTo>
                  <a:cubicBezTo>
                    <a:pt x="1104174" y="126722"/>
                    <a:pt x="1110025" y="125369"/>
                    <a:pt x="1115051" y="127287"/>
                  </a:cubicBezTo>
                  <a:cubicBezTo>
                    <a:pt x="1119622" y="126533"/>
                    <a:pt x="1127391" y="120716"/>
                    <a:pt x="1130559" y="117981"/>
                  </a:cubicBezTo>
                  <a:lnTo>
                    <a:pt x="1134028" y="117604"/>
                  </a:lnTo>
                  <a:cubicBezTo>
                    <a:pt x="1138486" y="117069"/>
                    <a:pt x="1139875" y="117069"/>
                    <a:pt x="1141096" y="116660"/>
                  </a:cubicBezTo>
                  <a:cubicBezTo>
                    <a:pt x="1142330" y="116251"/>
                    <a:pt x="1143383" y="115403"/>
                    <a:pt x="1147280" y="113202"/>
                  </a:cubicBezTo>
                  <a:cubicBezTo>
                    <a:pt x="1148511" y="112479"/>
                    <a:pt x="1149065" y="111850"/>
                    <a:pt x="1150433" y="111410"/>
                  </a:cubicBezTo>
                  <a:cubicBezTo>
                    <a:pt x="1155379" y="109806"/>
                    <a:pt x="1162261" y="109177"/>
                    <a:pt x="1167491" y="108203"/>
                  </a:cubicBezTo>
                  <a:cubicBezTo>
                    <a:pt x="1170588" y="109869"/>
                    <a:pt x="1174289" y="111504"/>
                    <a:pt x="1177169" y="113422"/>
                  </a:cubicBezTo>
                  <a:cubicBezTo>
                    <a:pt x="1181662" y="116409"/>
                    <a:pt x="1184209" y="121974"/>
                    <a:pt x="1191834" y="121251"/>
                  </a:cubicBezTo>
                  <a:lnTo>
                    <a:pt x="1190067" y="124143"/>
                  </a:lnTo>
                  <a:lnTo>
                    <a:pt x="1189263" y="128545"/>
                  </a:lnTo>
                  <a:lnTo>
                    <a:pt x="1191003" y="132947"/>
                  </a:lnTo>
                  <a:lnTo>
                    <a:pt x="1195682" y="137254"/>
                  </a:lnTo>
                  <a:lnTo>
                    <a:pt x="1196784" y="138669"/>
                  </a:lnTo>
                  <a:lnTo>
                    <a:pt x="1198401" y="140902"/>
                  </a:lnTo>
                  <a:lnTo>
                    <a:pt x="1199551" y="145618"/>
                  </a:lnTo>
                  <a:lnTo>
                    <a:pt x="1202775" y="150303"/>
                  </a:lnTo>
                  <a:lnTo>
                    <a:pt x="1202996" y="154767"/>
                  </a:lnTo>
                  <a:lnTo>
                    <a:pt x="1201621" y="159232"/>
                  </a:lnTo>
                  <a:lnTo>
                    <a:pt x="1206672" y="161464"/>
                  </a:lnTo>
                  <a:lnTo>
                    <a:pt x="1207826" y="165898"/>
                  </a:lnTo>
                  <a:lnTo>
                    <a:pt x="1211043" y="170110"/>
                  </a:lnTo>
                  <a:lnTo>
                    <a:pt x="1211278" y="174575"/>
                  </a:lnTo>
                  <a:lnTo>
                    <a:pt x="1212428" y="179511"/>
                  </a:lnTo>
                  <a:lnTo>
                    <a:pt x="1217030" y="182498"/>
                  </a:lnTo>
                  <a:lnTo>
                    <a:pt x="1217963" y="186460"/>
                  </a:lnTo>
                  <a:lnTo>
                    <a:pt x="1215880" y="190925"/>
                  </a:lnTo>
                  <a:lnTo>
                    <a:pt x="1211976" y="194887"/>
                  </a:lnTo>
                  <a:lnTo>
                    <a:pt x="1201379" y="199822"/>
                  </a:lnTo>
                  <a:lnTo>
                    <a:pt x="1196321" y="201300"/>
                  </a:lnTo>
                  <a:lnTo>
                    <a:pt x="1195391" y="210702"/>
                  </a:lnTo>
                  <a:lnTo>
                    <a:pt x="1198418" y="216172"/>
                  </a:lnTo>
                  <a:lnTo>
                    <a:pt x="1195265" y="218813"/>
                  </a:lnTo>
                  <a:lnTo>
                    <a:pt x="1188951" y="224095"/>
                  </a:lnTo>
                  <a:cubicBezTo>
                    <a:pt x="1184980" y="226673"/>
                    <a:pt x="1177576" y="226265"/>
                    <a:pt x="1173531" y="224095"/>
                  </a:cubicBezTo>
                  <a:lnTo>
                    <a:pt x="1172840" y="228529"/>
                  </a:lnTo>
                  <a:lnTo>
                    <a:pt x="1174668" y="232490"/>
                  </a:lnTo>
                  <a:cubicBezTo>
                    <a:pt x="1173296" y="235351"/>
                    <a:pt x="1171048" y="238401"/>
                    <a:pt x="1168694" y="240665"/>
                  </a:cubicBezTo>
                  <a:lnTo>
                    <a:pt x="1170988" y="245130"/>
                  </a:lnTo>
                  <a:cubicBezTo>
                    <a:pt x="1166407" y="247645"/>
                    <a:pt x="1163517" y="252738"/>
                    <a:pt x="1163408" y="257518"/>
                  </a:cubicBezTo>
                  <a:lnTo>
                    <a:pt x="1157883" y="258995"/>
                  </a:lnTo>
                  <a:lnTo>
                    <a:pt x="1153282" y="256763"/>
                  </a:lnTo>
                  <a:lnTo>
                    <a:pt x="1147981" y="258492"/>
                  </a:lnTo>
                  <a:cubicBezTo>
                    <a:pt x="1143783" y="262297"/>
                    <a:pt x="1143050" y="267516"/>
                    <a:pt x="1137848" y="270628"/>
                  </a:cubicBezTo>
                  <a:cubicBezTo>
                    <a:pt x="1136974" y="270597"/>
                    <a:pt x="1127742" y="270094"/>
                    <a:pt x="1127486" y="270126"/>
                  </a:cubicBezTo>
                  <a:cubicBezTo>
                    <a:pt x="1122610" y="270912"/>
                    <a:pt x="1116616" y="273396"/>
                    <a:pt x="1111849" y="274842"/>
                  </a:cubicBezTo>
                  <a:lnTo>
                    <a:pt x="1105174" y="283268"/>
                  </a:lnTo>
                  <a:lnTo>
                    <a:pt x="1089989" y="285500"/>
                  </a:lnTo>
                  <a:cubicBezTo>
                    <a:pt x="1087751" y="283708"/>
                    <a:pt x="1083380" y="281633"/>
                    <a:pt x="1080304" y="281538"/>
                  </a:cubicBezTo>
                  <a:lnTo>
                    <a:pt x="1076853" y="285752"/>
                  </a:lnTo>
                  <a:lnTo>
                    <a:pt x="1075702" y="295153"/>
                  </a:lnTo>
                  <a:lnTo>
                    <a:pt x="1071328" y="299114"/>
                  </a:lnTo>
                  <a:lnTo>
                    <a:pt x="1070177" y="303579"/>
                  </a:lnTo>
                  <a:cubicBezTo>
                    <a:pt x="1066715" y="305466"/>
                    <a:pt x="1063127" y="308515"/>
                    <a:pt x="1060749" y="311502"/>
                  </a:cubicBezTo>
                  <a:lnTo>
                    <a:pt x="1059816" y="320400"/>
                  </a:lnTo>
                  <a:lnTo>
                    <a:pt x="1058286" y="321878"/>
                  </a:lnTo>
                  <a:lnTo>
                    <a:pt x="1055228" y="324865"/>
                  </a:lnTo>
                  <a:cubicBezTo>
                    <a:pt x="1049082" y="328166"/>
                    <a:pt x="1040972" y="327726"/>
                    <a:pt x="1036574" y="336247"/>
                  </a:cubicBezTo>
                  <a:lnTo>
                    <a:pt x="1031737" y="337976"/>
                  </a:lnTo>
                  <a:cubicBezTo>
                    <a:pt x="1029909" y="339988"/>
                    <a:pt x="1028422" y="344044"/>
                    <a:pt x="1028745" y="346654"/>
                  </a:cubicBezTo>
                  <a:cubicBezTo>
                    <a:pt x="1025774" y="347565"/>
                    <a:pt x="1020582" y="346842"/>
                    <a:pt x="1017934" y="345396"/>
                  </a:cubicBezTo>
                  <a:cubicBezTo>
                    <a:pt x="1009308" y="351842"/>
                    <a:pt x="1012935" y="359954"/>
                    <a:pt x="1012648" y="368411"/>
                  </a:cubicBezTo>
                  <a:cubicBezTo>
                    <a:pt x="1012602" y="369731"/>
                    <a:pt x="1011666" y="371304"/>
                    <a:pt x="1011494" y="372625"/>
                  </a:cubicBezTo>
                  <a:cubicBezTo>
                    <a:pt x="1010897" y="377215"/>
                    <a:pt x="1012409" y="381963"/>
                    <a:pt x="1012409" y="386490"/>
                  </a:cubicBezTo>
                  <a:cubicBezTo>
                    <a:pt x="1012409" y="389917"/>
                    <a:pt x="1011311" y="393281"/>
                    <a:pt x="1010420" y="396551"/>
                  </a:cubicBezTo>
                  <a:cubicBezTo>
                    <a:pt x="1009817" y="398783"/>
                    <a:pt x="1008923" y="401425"/>
                    <a:pt x="1007355" y="403342"/>
                  </a:cubicBezTo>
                  <a:cubicBezTo>
                    <a:pt x="1003896" y="404883"/>
                    <a:pt x="1000315" y="407493"/>
                    <a:pt x="997695" y="410008"/>
                  </a:cubicBezTo>
                  <a:cubicBezTo>
                    <a:pt x="996877" y="413058"/>
                    <a:pt x="995671" y="416359"/>
                    <a:pt x="995158" y="419440"/>
                  </a:cubicBezTo>
                  <a:cubicBezTo>
                    <a:pt x="993745" y="427898"/>
                    <a:pt x="996348" y="436953"/>
                    <a:pt x="985933" y="441229"/>
                  </a:cubicBezTo>
                  <a:lnTo>
                    <a:pt x="983867" y="449373"/>
                  </a:lnTo>
                  <a:cubicBezTo>
                    <a:pt x="981044" y="450756"/>
                    <a:pt x="977424" y="454623"/>
                    <a:pt x="976957" y="457547"/>
                  </a:cubicBezTo>
                  <a:cubicBezTo>
                    <a:pt x="977568" y="464370"/>
                    <a:pt x="984877" y="474242"/>
                    <a:pt x="988473" y="479839"/>
                  </a:cubicBezTo>
                  <a:cubicBezTo>
                    <a:pt x="984825" y="482134"/>
                    <a:pt x="979890" y="483015"/>
                    <a:pt x="978108" y="484053"/>
                  </a:cubicBezTo>
                  <a:cubicBezTo>
                    <a:pt x="976021" y="485247"/>
                    <a:pt x="971583" y="490435"/>
                    <a:pt x="970292" y="492447"/>
                  </a:cubicBezTo>
                  <a:lnTo>
                    <a:pt x="971215" y="496661"/>
                  </a:lnTo>
                  <a:lnTo>
                    <a:pt x="967297" y="500622"/>
                  </a:lnTo>
                  <a:lnTo>
                    <a:pt x="968444" y="509551"/>
                  </a:lnTo>
                  <a:cubicBezTo>
                    <a:pt x="966690" y="513355"/>
                    <a:pt x="963516" y="515085"/>
                    <a:pt x="960622" y="517946"/>
                  </a:cubicBezTo>
                  <a:cubicBezTo>
                    <a:pt x="956483" y="522096"/>
                    <a:pt x="948990" y="529014"/>
                    <a:pt x="951411" y="535302"/>
                  </a:cubicBezTo>
                  <a:cubicBezTo>
                    <a:pt x="952323" y="537660"/>
                    <a:pt x="956841" y="542439"/>
                    <a:pt x="959022" y="543948"/>
                  </a:cubicBezTo>
                  <a:cubicBezTo>
                    <a:pt x="959766" y="544483"/>
                    <a:pt x="963603" y="546023"/>
                    <a:pt x="964073" y="546432"/>
                  </a:cubicBezTo>
                  <a:cubicBezTo>
                    <a:pt x="964294" y="546621"/>
                    <a:pt x="967157" y="550645"/>
                    <a:pt x="967518" y="551116"/>
                  </a:cubicBezTo>
                  <a:cubicBezTo>
                    <a:pt x="972499" y="553255"/>
                    <a:pt x="978946" y="552343"/>
                    <a:pt x="982706" y="556336"/>
                  </a:cubicBezTo>
                  <a:cubicBezTo>
                    <a:pt x="981671" y="558663"/>
                    <a:pt x="982240" y="562813"/>
                    <a:pt x="983401" y="565014"/>
                  </a:cubicBezTo>
                  <a:lnTo>
                    <a:pt x="988469" y="568724"/>
                  </a:lnTo>
                  <a:lnTo>
                    <a:pt x="989164" y="573157"/>
                  </a:lnTo>
                  <a:cubicBezTo>
                    <a:pt x="993222" y="576584"/>
                    <a:pt x="992486" y="578848"/>
                    <a:pt x="994460" y="581584"/>
                  </a:cubicBezTo>
                  <a:cubicBezTo>
                    <a:pt x="997674" y="586080"/>
                    <a:pt x="1001732" y="590418"/>
                    <a:pt x="1005271" y="594726"/>
                  </a:cubicBezTo>
                  <a:lnTo>
                    <a:pt x="1004577" y="599159"/>
                  </a:lnTo>
                  <a:lnTo>
                    <a:pt x="994225" y="605353"/>
                  </a:lnTo>
                  <a:cubicBezTo>
                    <a:pt x="990749" y="609346"/>
                    <a:pt x="993720" y="614125"/>
                    <a:pt x="991019" y="618464"/>
                  </a:cubicBezTo>
                  <a:cubicBezTo>
                    <a:pt x="992131" y="621608"/>
                    <a:pt x="994155" y="624972"/>
                    <a:pt x="996298" y="627645"/>
                  </a:cubicBezTo>
                  <a:cubicBezTo>
                    <a:pt x="1000557" y="630600"/>
                    <a:pt x="1002682" y="628683"/>
                    <a:pt x="1006432" y="629123"/>
                  </a:cubicBezTo>
                  <a:cubicBezTo>
                    <a:pt x="1009663" y="629500"/>
                    <a:pt x="1013360" y="630663"/>
                    <a:pt x="1016552" y="631355"/>
                  </a:cubicBezTo>
                  <a:lnTo>
                    <a:pt x="1019779" y="635316"/>
                  </a:lnTo>
                  <a:cubicBezTo>
                    <a:pt x="1019670" y="638115"/>
                    <a:pt x="1017724" y="642171"/>
                    <a:pt x="1015626" y="644215"/>
                  </a:cubicBezTo>
                  <a:cubicBezTo>
                    <a:pt x="1015994" y="647673"/>
                    <a:pt x="1014668" y="651194"/>
                    <a:pt x="1013714" y="654464"/>
                  </a:cubicBezTo>
                  <a:cubicBezTo>
                    <a:pt x="1009880" y="667607"/>
                    <a:pt x="998102" y="667041"/>
                    <a:pt x="990546" y="675436"/>
                  </a:cubicBezTo>
                  <a:cubicBezTo>
                    <a:pt x="989971" y="676064"/>
                    <a:pt x="989083" y="678580"/>
                    <a:pt x="988473" y="679366"/>
                  </a:cubicBezTo>
                  <a:cubicBezTo>
                    <a:pt x="986182" y="682415"/>
                    <a:pt x="983369" y="685372"/>
                    <a:pt x="980875" y="688295"/>
                  </a:cubicBezTo>
                  <a:lnTo>
                    <a:pt x="979946" y="697194"/>
                  </a:lnTo>
                  <a:lnTo>
                    <a:pt x="971889" y="705148"/>
                  </a:lnTo>
                  <a:cubicBezTo>
                    <a:pt x="970212" y="712599"/>
                    <a:pt x="975389" y="716969"/>
                    <a:pt x="978343" y="723196"/>
                  </a:cubicBezTo>
                  <a:cubicBezTo>
                    <a:pt x="980440" y="727629"/>
                    <a:pt x="979665" y="733759"/>
                    <a:pt x="975568" y="737061"/>
                  </a:cubicBezTo>
                  <a:cubicBezTo>
                    <a:pt x="970941" y="738476"/>
                    <a:pt x="964435" y="741997"/>
                    <a:pt x="963617" y="746714"/>
                  </a:cubicBezTo>
                  <a:cubicBezTo>
                    <a:pt x="958051" y="749951"/>
                    <a:pt x="949457" y="755580"/>
                    <a:pt x="942452" y="755391"/>
                  </a:cubicBezTo>
                  <a:lnTo>
                    <a:pt x="940418" y="753694"/>
                  </a:lnTo>
                  <a:lnTo>
                    <a:pt x="936710" y="749197"/>
                  </a:lnTo>
                  <a:cubicBezTo>
                    <a:pt x="931505" y="742909"/>
                    <a:pt x="925075" y="745550"/>
                    <a:pt x="919189" y="741274"/>
                  </a:cubicBezTo>
                  <a:cubicBezTo>
                    <a:pt x="914433" y="737816"/>
                    <a:pt x="909574" y="733697"/>
                    <a:pt x="905155" y="729892"/>
                  </a:cubicBezTo>
                  <a:cubicBezTo>
                    <a:pt x="902121" y="727282"/>
                    <a:pt x="899385" y="723856"/>
                    <a:pt x="896175" y="721466"/>
                  </a:cubicBezTo>
                  <a:cubicBezTo>
                    <a:pt x="893341" y="719359"/>
                    <a:pt x="889458" y="718039"/>
                    <a:pt x="886515" y="716027"/>
                  </a:cubicBezTo>
                  <a:cubicBezTo>
                    <a:pt x="882723" y="713417"/>
                    <a:pt x="882029" y="710556"/>
                    <a:pt x="876153" y="709581"/>
                  </a:cubicBezTo>
                  <a:cubicBezTo>
                    <a:pt x="869211" y="713574"/>
                    <a:pt x="861561" y="710273"/>
                    <a:pt x="856815" y="705148"/>
                  </a:cubicBezTo>
                  <a:cubicBezTo>
                    <a:pt x="847716" y="703324"/>
                    <a:pt x="835471" y="713071"/>
                    <a:pt x="825965" y="708104"/>
                  </a:cubicBezTo>
                  <a:cubicBezTo>
                    <a:pt x="821219" y="712568"/>
                    <a:pt x="812745" y="719863"/>
                    <a:pt x="809402" y="725176"/>
                  </a:cubicBezTo>
                  <a:cubicBezTo>
                    <a:pt x="808546" y="726559"/>
                    <a:pt x="808185" y="728257"/>
                    <a:pt x="807332" y="729640"/>
                  </a:cubicBezTo>
                  <a:cubicBezTo>
                    <a:pt x="805800" y="732124"/>
                    <a:pt x="803558" y="735646"/>
                    <a:pt x="801576" y="737816"/>
                  </a:cubicBezTo>
                  <a:cubicBezTo>
                    <a:pt x="800215" y="739293"/>
                    <a:pt x="797623" y="740268"/>
                    <a:pt x="796276" y="741777"/>
                  </a:cubicBezTo>
                  <a:cubicBezTo>
                    <a:pt x="794701" y="743507"/>
                    <a:pt x="794035" y="748065"/>
                    <a:pt x="794670" y="750203"/>
                  </a:cubicBezTo>
                  <a:lnTo>
                    <a:pt x="785241" y="758629"/>
                  </a:lnTo>
                  <a:lnTo>
                    <a:pt x="780411" y="759101"/>
                  </a:lnTo>
                  <a:cubicBezTo>
                    <a:pt x="777023" y="756964"/>
                    <a:pt x="772645" y="751649"/>
                    <a:pt x="771877" y="751178"/>
                  </a:cubicBezTo>
                  <a:lnTo>
                    <a:pt x="764819" y="748034"/>
                  </a:lnTo>
                  <a:cubicBezTo>
                    <a:pt x="758737" y="745330"/>
                    <a:pt x="757141" y="745393"/>
                    <a:pt x="750473" y="747059"/>
                  </a:cubicBezTo>
                  <a:lnTo>
                    <a:pt x="739890" y="749700"/>
                  </a:lnTo>
                  <a:cubicBezTo>
                    <a:pt x="735530" y="752876"/>
                    <a:pt x="734250" y="758032"/>
                    <a:pt x="731223" y="760045"/>
                  </a:cubicBezTo>
                  <a:lnTo>
                    <a:pt x="731377" y="759353"/>
                  </a:lnTo>
                  <a:cubicBezTo>
                    <a:pt x="727049" y="760327"/>
                    <a:pt x="720019" y="761585"/>
                    <a:pt x="715491" y="761082"/>
                  </a:cubicBezTo>
                  <a:cubicBezTo>
                    <a:pt x="714154" y="759856"/>
                    <a:pt x="712401" y="757843"/>
                    <a:pt x="710882" y="756869"/>
                  </a:cubicBezTo>
                  <a:cubicBezTo>
                    <a:pt x="705406" y="753442"/>
                    <a:pt x="685458" y="754448"/>
                    <a:pt x="679134" y="754888"/>
                  </a:cubicBezTo>
                  <a:cubicBezTo>
                    <a:pt x="670978" y="749575"/>
                    <a:pt x="662314" y="743097"/>
                    <a:pt x="655871" y="736086"/>
                  </a:cubicBezTo>
                  <a:cubicBezTo>
                    <a:pt x="653145" y="734923"/>
                    <a:pt x="648133" y="734577"/>
                    <a:pt x="645288" y="735583"/>
                  </a:cubicBezTo>
                  <a:cubicBezTo>
                    <a:pt x="640188" y="740394"/>
                    <a:pt x="645547" y="746556"/>
                    <a:pt x="637455" y="751933"/>
                  </a:cubicBezTo>
                  <a:lnTo>
                    <a:pt x="631710" y="752404"/>
                  </a:lnTo>
                  <a:cubicBezTo>
                    <a:pt x="625420" y="750361"/>
                    <a:pt x="614273" y="745487"/>
                    <a:pt x="615592" y="737973"/>
                  </a:cubicBezTo>
                  <a:cubicBezTo>
                    <a:pt x="615795" y="736809"/>
                    <a:pt x="615834" y="734955"/>
                    <a:pt x="616890" y="734074"/>
                  </a:cubicBezTo>
                  <a:lnTo>
                    <a:pt x="616890" y="733476"/>
                  </a:lnTo>
                  <a:lnTo>
                    <a:pt x="611916" y="732376"/>
                  </a:lnTo>
                  <a:cubicBezTo>
                    <a:pt x="608222" y="735300"/>
                    <a:pt x="604676" y="735017"/>
                    <a:pt x="602477" y="736338"/>
                  </a:cubicBezTo>
                  <a:cubicBezTo>
                    <a:pt x="598969" y="738381"/>
                    <a:pt x="596086" y="741651"/>
                    <a:pt x="592585" y="743758"/>
                  </a:cubicBezTo>
                  <a:cubicBezTo>
                    <a:pt x="587913" y="746556"/>
                    <a:pt x="582230" y="748317"/>
                    <a:pt x="577614" y="751178"/>
                  </a:cubicBezTo>
                  <a:cubicBezTo>
                    <a:pt x="577116" y="751493"/>
                    <a:pt x="574801" y="754668"/>
                    <a:pt x="574170" y="755140"/>
                  </a:cubicBezTo>
                  <a:cubicBezTo>
                    <a:pt x="573731" y="755485"/>
                    <a:pt x="570308" y="756712"/>
                    <a:pt x="569564" y="757120"/>
                  </a:cubicBezTo>
                  <a:cubicBezTo>
                    <a:pt x="566039" y="759101"/>
                    <a:pt x="562626" y="761428"/>
                    <a:pt x="559202" y="763566"/>
                  </a:cubicBezTo>
                  <a:cubicBezTo>
                    <a:pt x="548507" y="765453"/>
                    <a:pt x="540573" y="756240"/>
                    <a:pt x="529310" y="753913"/>
                  </a:cubicBezTo>
                  <a:cubicBezTo>
                    <a:pt x="526128" y="753253"/>
                    <a:pt x="522231" y="753316"/>
                    <a:pt x="519173" y="752404"/>
                  </a:cubicBezTo>
                  <a:lnTo>
                    <a:pt x="515788" y="750424"/>
                  </a:lnTo>
                  <a:cubicBezTo>
                    <a:pt x="512287" y="748379"/>
                    <a:pt x="507727" y="747122"/>
                    <a:pt x="503511" y="747216"/>
                  </a:cubicBezTo>
                  <a:lnTo>
                    <a:pt x="499831" y="742752"/>
                  </a:lnTo>
                  <a:cubicBezTo>
                    <a:pt x="501522" y="737910"/>
                    <a:pt x="505819" y="734262"/>
                    <a:pt x="506731" y="729138"/>
                  </a:cubicBezTo>
                  <a:lnTo>
                    <a:pt x="516398" y="729640"/>
                  </a:lnTo>
                  <a:lnTo>
                    <a:pt x="521235" y="725679"/>
                  </a:lnTo>
                  <a:cubicBezTo>
                    <a:pt x="519920" y="722315"/>
                    <a:pt x="520372" y="719453"/>
                    <a:pt x="519632" y="716278"/>
                  </a:cubicBezTo>
                  <a:cubicBezTo>
                    <a:pt x="519460" y="715523"/>
                    <a:pt x="517805" y="712253"/>
                    <a:pt x="517776" y="711813"/>
                  </a:cubicBezTo>
                  <a:cubicBezTo>
                    <a:pt x="517650" y="709455"/>
                    <a:pt x="518597" y="706028"/>
                    <a:pt x="518934" y="703638"/>
                  </a:cubicBezTo>
                  <a:cubicBezTo>
                    <a:pt x="515353" y="701029"/>
                    <a:pt x="512031" y="694363"/>
                    <a:pt x="510870" y="690528"/>
                  </a:cubicBezTo>
                  <a:cubicBezTo>
                    <a:pt x="507380" y="691188"/>
                    <a:pt x="503423" y="692886"/>
                    <a:pt x="500533" y="694741"/>
                  </a:cubicBezTo>
                  <a:lnTo>
                    <a:pt x="487403" y="681850"/>
                  </a:lnTo>
                  <a:lnTo>
                    <a:pt x="486723" y="677417"/>
                  </a:lnTo>
                  <a:cubicBezTo>
                    <a:pt x="491339" y="673738"/>
                    <a:pt x="496871" y="675059"/>
                    <a:pt x="501673" y="671474"/>
                  </a:cubicBezTo>
                  <a:cubicBezTo>
                    <a:pt x="494847" y="663834"/>
                    <a:pt x="504935" y="656413"/>
                    <a:pt x="503967" y="648679"/>
                  </a:cubicBezTo>
                  <a:lnTo>
                    <a:pt x="499137" y="644717"/>
                  </a:lnTo>
                  <a:lnTo>
                    <a:pt x="494075" y="644215"/>
                  </a:lnTo>
                  <a:cubicBezTo>
                    <a:pt x="492293" y="640913"/>
                    <a:pt x="492637" y="638210"/>
                    <a:pt x="492009" y="634814"/>
                  </a:cubicBezTo>
                  <a:cubicBezTo>
                    <a:pt x="491749" y="633430"/>
                    <a:pt x="490904" y="632016"/>
                    <a:pt x="490627" y="630600"/>
                  </a:cubicBezTo>
                  <a:cubicBezTo>
                    <a:pt x="489817" y="626388"/>
                    <a:pt x="490385" y="621042"/>
                    <a:pt x="487179" y="617489"/>
                  </a:cubicBezTo>
                  <a:lnTo>
                    <a:pt x="482103" y="617741"/>
                  </a:lnTo>
                  <a:lnTo>
                    <a:pt x="477284" y="621954"/>
                  </a:lnTo>
                  <a:lnTo>
                    <a:pt x="472678" y="622206"/>
                  </a:lnTo>
                  <a:lnTo>
                    <a:pt x="467620" y="619219"/>
                  </a:lnTo>
                  <a:lnTo>
                    <a:pt x="462552" y="619219"/>
                  </a:lnTo>
                  <a:cubicBezTo>
                    <a:pt x="459318" y="623180"/>
                    <a:pt x="461131" y="628368"/>
                    <a:pt x="459328" y="632832"/>
                  </a:cubicBezTo>
                  <a:cubicBezTo>
                    <a:pt x="456466" y="634940"/>
                    <a:pt x="453477" y="638649"/>
                    <a:pt x="452183" y="641762"/>
                  </a:cubicBezTo>
                  <a:cubicBezTo>
                    <a:pt x="451874" y="642517"/>
                    <a:pt x="451558" y="645661"/>
                    <a:pt x="451271" y="646226"/>
                  </a:cubicBezTo>
                  <a:cubicBezTo>
                    <a:pt x="451145" y="646447"/>
                    <a:pt x="448195" y="649748"/>
                    <a:pt x="447823" y="650157"/>
                  </a:cubicBezTo>
                  <a:lnTo>
                    <a:pt x="443221" y="647956"/>
                  </a:lnTo>
                  <a:lnTo>
                    <a:pt x="439527" y="652390"/>
                  </a:lnTo>
                  <a:cubicBezTo>
                    <a:pt x="440169" y="654936"/>
                    <a:pt x="440604" y="658174"/>
                    <a:pt x="441593" y="660564"/>
                  </a:cubicBezTo>
                  <a:cubicBezTo>
                    <a:pt x="443017" y="664023"/>
                    <a:pt x="445708" y="665721"/>
                    <a:pt x="446441" y="670217"/>
                  </a:cubicBezTo>
                  <a:cubicBezTo>
                    <a:pt x="445038" y="672920"/>
                    <a:pt x="441021" y="676159"/>
                    <a:pt x="437914" y="677165"/>
                  </a:cubicBezTo>
                  <a:cubicBezTo>
                    <a:pt x="432726" y="677825"/>
                    <a:pt x="428439" y="675278"/>
                    <a:pt x="423192" y="676159"/>
                  </a:cubicBezTo>
                  <a:cubicBezTo>
                    <a:pt x="419695" y="676757"/>
                    <a:pt x="417067" y="678517"/>
                    <a:pt x="413293" y="676913"/>
                  </a:cubicBezTo>
                  <a:lnTo>
                    <a:pt x="408691" y="672701"/>
                  </a:lnTo>
                  <a:lnTo>
                    <a:pt x="407993" y="668487"/>
                  </a:lnTo>
                  <a:cubicBezTo>
                    <a:pt x="405004" y="667859"/>
                    <a:pt x="400041" y="669116"/>
                    <a:pt x="397642" y="670719"/>
                  </a:cubicBezTo>
                  <a:cubicBezTo>
                    <a:pt x="396607" y="668110"/>
                    <a:pt x="396130" y="664588"/>
                    <a:pt x="396491" y="661822"/>
                  </a:cubicBezTo>
                  <a:lnTo>
                    <a:pt x="390967" y="659841"/>
                  </a:lnTo>
                  <a:lnTo>
                    <a:pt x="384755" y="651163"/>
                  </a:lnTo>
                  <a:cubicBezTo>
                    <a:pt x="385418" y="648522"/>
                    <a:pt x="384253" y="644152"/>
                    <a:pt x="382450" y="642014"/>
                  </a:cubicBezTo>
                  <a:lnTo>
                    <a:pt x="384530" y="637549"/>
                  </a:lnTo>
                  <a:cubicBezTo>
                    <a:pt x="381563" y="635663"/>
                    <a:pt x="378392" y="632550"/>
                    <a:pt x="376708" y="629626"/>
                  </a:cubicBezTo>
                  <a:cubicBezTo>
                    <a:pt x="373558" y="628651"/>
                    <a:pt x="368998" y="627771"/>
                    <a:pt x="366122" y="626388"/>
                  </a:cubicBezTo>
                  <a:cubicBezTo>
                    <a:pt x="365410" y="626073"/>
                    <a:pt x="365231" y="625602"/>
                    <a:pt x="364662" y="625098"/>
                  </a:cubicBezTo>
                  <a:lnTo>
                    <a:pt x="361741" y="622457"/>
                  </a:lnTo>
                  <a:cubicBezTo>
                    <a:pt x="360958" y="621891"/>
                    <a:pt x="357117" y="620131"/>
                    <a:pt x="356665" y="619722"/>
                  </a:cubicBezTo>
                  <a:lnTo>
                    <a:pt x="353456" y="615005"/>
                  </a:lnTo>
                  <a:cubicBezTo>
                    <a:pt x="351179" y="610667"/>
                    <a:pt x="350011" y="605825"/>
                    <a:pt x="346773" y="601895"/>
                  </a:cubicBezTo>
                  <a:lnTo>
                    <a:pt x="341719" y="599913"/>
                  </a:lnTo>
                  <a:lnTo>
                    <a:pt x="335970" y="603372"/>
                  </a:lnTo>
                  <a:cubicBezTo>
                    <a:pt x="332855" y="603687"/>
                    <a:pt x="328800" y="603404"/>
                    <a:pt x="325847" y="602397"/>
                  </a:cubicBezTo>
                  <a:lnTo>
                    <a:pt x="322612" y="597430"/>
                  </a:lnTo>
                  <a:lnTo>
                    <a:pt x="317554" y="596455"/>
                  </a:lnTo>
                  <a:lnTo>
                    <a:pt x="312949" y="598185"/>
                  </a:lnTo>
                  <a:cubicBezTo>
                    <a:pt x="312696" y="601800"/>
                    <a:pt x="311465" y="608465"/>
                    <a:pt x="309031" y="611547"/>
                  </a:cubicBezTo>
                  <a:cubicBezTo>
                    <a:pt x="304727" y="613685"/>
                    <a:pt x="292373" y="613654"/>
                    <a:pt x="287623" y="613528"/>
                  </a:cubicBezTo>
                  <a:cubicBezTo>
                    <a:pt x="286111" y="613496"/>
                    <a:pt x="284281" y="612521"/>
                    <a:pt x="282793" y="612553"/>
                  </a:cubicBezTo>
                  <a:cubicBezTo>
                    <a:pt x="279100" y="612616"/>
                    <a:pt x="271018" y="613717"/>
                    <a:pt x="267833" y="615760"/>
                  </a:cubicBezTo>
                  <a:cubicBezTo>
                    <a:pt x="264718" y="620728"/>
                    <a:pt x="258092" y="629217"/>
                    <a:pt x="250558" y="628399"/>
                  </a:cubicBezTo>
                  <a:lnTo>
                    <a:pt x="248032" y="632361"/>
                  </a:lnTo>
                  <a:cubicBezTo>
                    <a:pt x="249895" y="635411"/>
                    <a:pt x="253146" y="638744"/>
                    <a:pt x="256328" y="640787"/>
                  </a:cubicBezTo>
                  <a:cubicBezTo>
                    <a:pt x="257426" y="645189"/>
                    <a:pt x="259204" y="650188"/>
                    <a:pt x="259779" y="654653"/>
                  </a:cubicBezTo>
                  <a:cubicBezTo>
                    <a:pt x="259797" y="654779"/>
                    <a:pt x="258734" y="658237"/>
                    <a:pt x="258629" y="658615"/>
                  </a:cubicBezTo>
                  <a:cubicBezTo>
                    <a:pt x="256005" y="660501"/>
                    <a:pt x="251091" y="666412"/>
                    <a:pt x="250554" y="666789"/>
                  </a:cubicBezTo>
                  <a:cubicBezTo>
                    <a:pt x="246096" y="669776"/>
                    <a:pt x="240396" y="672323"/>
                    <a:pt x="235601" y="674933"/>
                  </a:cubicBezTo>
                  <a:cubicBezTo>
                    <a:pt x="238614" y="676536"/>
                    <a:pt x="242357" y="680875"/>
                    <a:pt x="242732" y="684113"/>
                  </a:cubicBezTo>
                  <a:cubicBezTo>
                    <a:pt x="242164" y="691345"/>
                    <a:pt x="235899" y="701029"/>
                    <a:pt x="228473" y="704142"/>
                  </a:cubicBezTo>
                  <a:lnTo>
                    <a:pt x="223412" y="704393"/>
                  </a:lnTo>
                  <a:lnTo>
                    <a:pt x="218119" y="708104"/>
                  </a:lnTo>
                  <a:lnTo>
                    <a:pt x="214218" y="717032"/>
                  </a:lnTo>
                  <a:lnTo>
                    <a:pt x="209132" y="718039"/>
                  </a:lnTo>
                  <a:lnTo>
                    <a:pt x="204302" y="721969"/>
                  </a:lnTo>
                  <a:cubicBezTo>
                    <a:pt x="199836" y="719234"/>
                    <a:pt x="193747" y="717442"/>
                    <a:pt x="188647" y="716027"/>
                  </a:cubicBezTo>
                  <a:cubicBezTo>
                    <a:pt x="184883" y="718259"/>
                    <a:pt x="182530" y="725428"/>
                    <a:pt x="182438" y="729169"/>
                  </a:cubicBezTo>
                  <a:cubicBezTo>
                    <a:pt x="178983" y="732848"/>
                    <a:pt x="175114" y="733791"/>
                    <a:pt x="172084" y="736338"/>
                  </a:cubicBezTo>
                  <a:cubicBezTo>
                    <a:pt x="169046" y="738885"/>
                    <a:pt x="168365" y="741903"/>
                    <a:pt x="163567" y="744764"/>
                  </a:cubicBezTo>
                  <a:cubicBezTo>
                    <a:pt x="158313" y="744670"/>
                    <a:pt x="149582" y="739576"/>
                    <a:pt x="145608" y="736841"/>
                  </a:cubicBezTo>
                  <a:lnTo>
                    <a:pt x="139161" y="732376"/>
                  </a:lnTo>
                  <a:cubicBezTo>
                    <a:pt x="139031" y="732313"/>
                    <a:pt x="134551" y="731685"/>
                    <a:pt x="134113" y="731622"/>
                  </a:cubicBezTo>
                  <a:lnTo>
                    <a:pt x="129967" y="736086"/>
                  </a:lnTo>
                  <a:cubicBezTo>
                    <a:pt x="127445" y="736998"/>
                    <a:pt x="122994" y="736841"/>
                    <a:pt x="120528" y="735834"/>
                  </a:cubicBezTo>
                  <a:lnTo>
                    <a:pt x="115922" y="738318"/>
                  </a:lnTo>
                  <a:cubicBezTo>
                    <a:pt x="114757" y="742060"/>
                    <a:pt x="120093" y="752027"/>
                    <a:pt x="122597" y="755391"/>
                  </a:cubicBezTo>
                  <a:lnTo>
                    <a:pt x="121903" y="759856"/>
                  </a:lnTo>
                  <a:lnTo>
                    <a:pt x="117297" y="762591"/>
                  </a:lnTo>
                  <a:lnTo>
                    <a:pt x="108331" y="753913"/>
                  </a:lnTo>
                  <a:lnTo>
                    <a:pt x="98352" y="752279"/>
                  </a:lnTo>
                  <a:cubicBezTo>
                    <a:pt x="91979" y="751210"/>
                    <a:pt x="90905" y="751147"/>
                    <a:pt x="85307" y="753819"/>
                  </a:cubicBezTo>
                  <a:lnTo>
                    <a:pt x="78404" y="757152"/>
                  </a:lnTo>
                  <a:cubicBezTo>
                    <a:pt x="75601" y="754731"/>
                    <a:pt x="71851" y="752121"/>
                    <a:pt x="69424" y="749449"/>
                  </a:cubicBezTo>
                  <a:cubicBezTo>
                    <a:pt x="67891" y="747782"/>
                    <a:pt x="65169" y="738255"/>
                    <a:pt x="65050" y="736338"/>
                  </a:cubicBezTo>
                  <a:lnTo>
                    <a:pt x="65517" y="726780"/>
                  </a:lnTo>
                  <a:cubicBezTo>
                    <a:pt x="65541" y="726245"/>
                    <a:pt x="65899" y="718888"/>
                    <a:pt x="65282" y="717536"/>
                  </a:cubicBezTo>
                  <a:cubicBezTo>
                    <a:pt x="63991" y="714706"/>
                    <a:pt x="61479" y="711562"/>
                    <a:pt x="59771" y="708858"/>
                  </a:cubicBezTo>
                  <a:lnTo>
                    <a:pt x="55397" y="706877"/>
                  </a:lnTo>
                  <a:cubicBezTo>
                    <a:pt x="53401" y="709392"/>
                    <a:pt x="51089" y="713134"/>
                    <a:pt x="48722" y="715304"/>
                  </a:cubicBezTo>
                  <a:cubicBezTo>
                    <a:pt x="48585" y="715429"/>
                    <a:pt x="43885" y="717536"/>
                    <a:pt x="43404" y="717787"/>
                  </a:cubicBezTo>
                  <a:lnTo>
                    <a:pt x="42264" y="713574"/>
                  </a:lnTo>
                  <a:cubicBezTo>
                    <a:pt x="44148" y="710996"/>
                    <a:pt x="48069" y="703450"/>
                    <a:pt x="46642" y="700180"/>
                  </a:cubicBezTo>
                  <a:cubicBezTo>
                    <a:pt x="44078" y="695181"/>
                    <a:pt x="37988" y="693075"/>
                    <a:pt x="36045" y="687824"/>
                  </a:cubicBezTo>
                  <a:cubicBezTo>
                    <a:pt x="37582" y="685088"/>
                    <a:pt x="43310" y="673613"/>
                    <a:pt x="42489" y="670500"/>
                  </a:cubicBezTo>
                  <a:lnTo>
                    <a:pt x="39889" y="664714"/>
                  </a:lnTo>
                  <a:cubicBezTo>
                    <a:pt x="36939" y="658174"/>
                    <a:pt x="32411" y="653741"/>
                    <a:pt x="25231" y="650692"/>
                  </a:cubicBezTo>
                  <a:cubicBezTo>
                    <a:pt x="18012" y="652232"/>
                    <a:pt x="5044" y="648113"/>
                    <a:pt x="0" y="642800"/>
                  </a:cubicBezTo>
                  <a:cubicBezTo>
                    <a:pt x="1256" y="638272"/>
                    <a:pt x="1649" y="633305"/>
                    <a:pt x="3339" y="629877"/>
                  </a:cubicBezTo>
                  <a:cubicBezTo>
                    <a:pt x="4072" y="628399"/>
                    <a:pt x="5507" y="627299"/>
                    <a:pt x="6496" y="625978"/>
                  </a:cubicBezTo>
                  <a:cubicBezTo>
                    <a:pt x="8604" y="623118"/>
                    <a:pt x="9471" y="619659"/>
                    <a:pt x="11600" y="616798"/>
                  </a:cubicBezTo>
                  <a:cubicBezTo>
                    <a:pt x="15560" y="611516"/>
                    <a:pt x="20457" y="606925"/>
                    <a:pt x="24242" y="601391"/>
                  </a:cubicBezTo>
                  <a:cubicBezTo>
                    <a:pt x="28363" y="595355"/>
                    <a:pt x="30184" y="588375"/>
                    <a:pt x="34207" y="582307"/>
                  </a:cubicBezTo>
                  <a:cubicBezTo>
                    <a:pt x="36133" y="579414"/>
                    <a:pt x="41244" y="573000"/>
                    <a:pt x="44905" y="572120"/>
                  </a:cubicBezTo>
                  <a:cubicBezTo>
                    <a:pt x="48466" y="571239"/>
                    <a:pt x="52900" y="571742"/>
                    <a:pt x="56572" y="571837"/>
                  </a:cubicBezTo>
                  <a:cubicBezTo>
                    <a:pt x="58842" y="565454"/>
                    <a:pt x="64433" y="561335"/>
                    <a:pt x="71399" y="559291"/>
                  </a:cubicBezTo>
                  <a:cubicBezTo>
                    <a:pt x="75801" y="560392"/>
                    <a:pt x="86714" y="563285"/>
                    <a:pt x="90846" y="562184"/>
                  </a:cubicBezTo>
                  <a:cubicBezTo>
                    <a:pt x="93711" y="561398"/>
                    <a:pt x="99853" y="556336"/>
                    <a:pt x="103729" y="554859"/>
                  </a:cubicBezTo>
                  <a:cubicBezTo>
                    <a:pt x="116024" y="550174"/>
                    <a:pt x="130640" y="556147"/>
                    <a:pt x="137273" y="553537"/>
                  </a:cubicBezTo>
                  <a:cubicBezTo>
                    <a:pt x="149368" y="548790"/>
                    <a:pt x="141149" y="533069"/>
                    <a:pt x="163770" y="532629"/>
                  </a:cubicBezTo>
                  <a:cubicBezTo>
                    <a:pt x="188422" y="532126"/>
                    <a:pt x="185981" y="551242"/>
                    <a:pt x="199745" y="557468"/>
                  </a:cubicBezTo>
                  <a:lnTo>
                    <a:pt x="202902" y="553537"/>
                  </a:lnTo>
                  <a:cubicBezTo>
                    <a:pt x="203691" y="546463"/>
                    <a:pt x="198644" y="542345"/>
                    <a:pt x="197069" y="536025"/>
                  </a:cubicBezTo>
                  <a:cubicBezTo>
                    <a:pt x="196241" y="532692"/>
                    <a:pt x="195634" y="530397"/>
                    <a:pt x="194396" y="527127"/>
                  </a:cubicBezTo>
                  <a:cubicBezTo>
                    <a:pt x="193235" y="524109"/>
                    <a:pt x="193530" y="520776"/>
                    <a:pt x="192449" y="517726"/>
                  </a:cubicBezTo>
                  <a:cubicBezTo>
                    <a:pt x="191074" y="513827"/>
                    <a:pt x="189461" y="508577"/>
                    <a:pt x="187588" y="504929"/>
                  </a:cubicBezTo>
                  <a:cubicBezTo>
                    <a:pt x="184771" y="499427"/>
                    <a:pt x="172540" y="497792"/>
                    <a:pt x="166682" y="498893"/>
                  </a:cubicBezTo>
                  <a:cubicBezTo>
                    <a:pt x="158351" y="500496"/>
                    <a:pt x="151115" y="505841"/>
                    <a:pt x="142619" y="507005"/>
                  </a:cubicBezTo>
                  <a:cubicBezTo>
                    <a:pt x="135849" y="507916"/>
                    <a:pt x="129542" y="505055"/>
                    <a:pt x="122930" y="504395"/>
                  </a:cubicBezTo>
                  <a:cubicBezTo>
                    <a:pt x="116659" y="503766"/>
                    <a:pt x="111899" y="505150"/>
                    <a:pt x="105918" y="505715"/>
                  </a:cubicBezTo>
                  <a:cubicBezTo>
                    <a:pt x="99341" y="506281"/>
                    <a:pt x="92852" y="503106"/>
                    <a:pt x="86229" y="503075"/>
                  </a:cubicBezTo>
                  <a:cubicBezTo>
                    <a:pt x="83441" y="504929"/>
                    <a:pt x="80007" y="505558"/>
                    <a:pt x="76990" y="507005"/>
                  </a:cubicBezTo>
                  <a:cubicBezTo>
                    <a:pt x="72571" y="509111"/>
                    <a:pt x="69859" y="513544"/>
                    <a:pt x="65078" y="515116"/>
                  </a:cubicBezTo>
                  <a:cubicBezTo>
                    <a:pt x="56856" y="517821"/>
                    <a:pt x="43341" y="513859"/>
                    <a:pt x="37371" y="508325"/>
                  </a:cubicBezTo>
                  <a:cubicBezTo>
                    <a:pt x="35098" y="506187"/>
                    <a:pt x="34351" y="503231"/>
                    <a:pt x="32267" y="500999"/>
                  </a:cubicBezTo>
                  <a:cubicBezTo>
                    <a:pt x="27592" y="496000"/>
                    <a:pt x="23649" y="492636"/>
                    <a:pt x="21330" y="486096"/>
                  </a:cubicBezTo>
                  <a:cubicBezTo>
                    <a:pt x="22684" y="481569"/>
                    <a:pt x="27739" y="476726"/>
                    <a:pt x="27893" y="472231"/>
                  </a:cubicBezTo>
                  <a:cubicBezTo>
                    <a:pt x="28005" y="468866"/>
                    <a:pt x="26290" y="465691"/>
                    <a:pt x="26434" y="462295"/>
                  </a:cubicBezTo>
                  <a:cubicBezTo>
                    <a:pt x="31650" y="456101"/>
                    <a:pt x="42408" y="453523"/>
                    <a:pt x="49767" y="449750"/>
                  </a:cubicBezTo>
                  <a:cubicBezTo>
                    <a:pt x="51454" y="448901"/>
                    <a:pt x="63696" y="441481"/>
                    <a:pt x="64836" y="440600"/>
                  </a:cubicBezTo>
                  <a:cubicBezTo>
                    <a:pt x="68673" y="437645"/>
                    <a:pt x="71610" y="433652"/>
                    <a:pt x="75289" y="430413"/>
                  </a:cubicBezTo>
                  <a:cubicBezTo>
                    <a:pt x="77776" y="428213"/>
                    <a:pt x="79368" y="425351"/>
                    <a:pt x="82094" y="423339"/>
                  </a:cubicBezTo>
                  <a:cubicBezTo>
                    <a:pt x="91810" y="416170"/>
                    <a:pt x="102316" y="413278"/>
                    <a:pt x="112962" y="408184"/>
                  </a:cubicBezTo>
                  <a:cubicBezTo>
                    <a:pt x="117279" y="406109"/>
                    <a:pt x="120040" y="401708"/>
                    <a:pt x="123899" y="399035"/>
                  </a:cubicBezTo>
                  <a:cubicBezTo>
                    <a:pt x="128960" y="395513"/>
                    <a:pt x="135639" y="394036"/>
                    <a:pt x="140188" y="389886"/>
                  </a:cubicBezTo>
                  <a:cubicBezTo>
                    <a:pt x="142791" y="387496"/>
                    <a:pt x="143819" y="384258"/>
                    <a:pt x="145779" y="381522"/>
                  </a:cubicBezTo>
                  <a:cubicBezTo>
                    <a:pt x="147495" y="379101"/>
                    <a:pt x="158141" y="371461"/>
                    <a:pt x="161336" y="369763"/>
                  </a:cubicBezTo>
                  <a:cubicBezTo>
                    <a:pt x="166489" y="366996"/>
                    <a:pt x="175447" y="363035"/>
                    <a:pt x="181270" y="366085"/>
                  </a:cubicBezTo>
                  <a:cubicBezTo>
                    <a:pt x="186735" y="368945"/>
                    <a:pt x="189345" y="379605"/>
                    <a:pt x="197069" y="383094"/>
                  </a:cubicBezTo>
                  <a:cubicBezTo>
                    <a:pt x="213309" y="377466"/>
                    <a:pt x="203337" y="357344"/>
                    <a:pt x="206308" y="349892"/>
                  </a:cubicBezTo>
                  <a:cubicBezTo>
                    <a:pt x="210188" y="340114"/>
                    <a:pt x="226379" y="342567"/>
                    <a:pt x="235232" y="340208"/>
                  </a:cubicBezTo>
                  <a:cubicBezTo>
                    <a:pt x="241536" y="338542"/>
                    <a:pt x="249505" y="334517"/>
                    <a:pt x="256138" y="335240"/>
                  </a:cubicBezTo>
                  <a:cubicBezTo>
                    <a:pt x="265367" y="336215"/>
                    <a:pt x="276202" y="345837"/>
                    <a:pt x="280685" y="352753"/>
                  </a:cubicBezTo>
                  <a:lnTo>
                    <a:pt x="285063" y="350395"/>
                  </a:lnTo>
                  <a:cubicBezTo>
                    <a:pt x="285831" y="346874"/>
                    <a:pt x="285273" y="343258"/>
                    <a:pt x="285547" y="339673"/>
                  </a:cubicBezTo>
                  <a:cubicBezTo>
                    <a:pt x="285831" y="335995"/>
                    <a:pt x="287455" y="332442"/>
                    <a:pt x="287248" y="328700"/>
                  </a:cubicBezTo>
                  <a:cubicBezTo>
                    <a:pt x="287174" y="327317"/>
                    <a:pt x="283211" y="316218"/>
                    <a:pt x="282386" y="315369"/>
                  </a:cubicBezTo>
                  <a:cubicBezTo>
                    <a:pt x="276174" y="308956"/>
                    <a:pt x="266560" y="306598"/>
                    <a:pt x="258566" y="302573"/>
                  </a:cubicBezTo>
                  <a:cubicBezTo>
                    <a:pt x="250403" y="298423"/>
                    <a:pt x="242827" y="293297"/>
                    <a:pt x="234015" y="290279"/>
                  </a:cubicBezTo>
                  <a:cubicBezTo>
                    <a:pt x="227572" y="288047"/>
                    <a:pt x="216105" y="286161"/>
                    <a:pt x="211166" y="282168"/>
                  </a:cubicBezTo>
                  <a:cubicBezTo>
                    <a:pt x="211398" y="280281"/>
                    <a:pt x="211394" y="278269"/>
                    <a:pt x="211896" y="276414"/>
                  </a:cubicBezTo>
                  <a:cubicBezTo>
                    <a:pt x="214705" y="266038"/>
                    <a:pt x="244265" y="259970"/>
                    <a:pt x="254672" y="260976"/>
                  </a:cubicBezTo>
                  <a:cubicBezTo>
                    <a:pt x="259102" y="261416"/>
                    <a:pt x="263340" y="262862"/>
                    <a:pt x="267801" y="263083"/>
                  </a:cubicBezTo>
                  <a:cubicBezTo>
                    <a:pt x="271021" y="263240"/>
                    <a:pt x="294965" y="261825"/>
                    <a:pt x="296726" y="260976"/>
                  </a:cubicBezTo>
                  <a:cubicBezTo>
                    <a:pt x="300938" y="258964"/>
                    <a:pt x="302254" y="250066"/>
                    <a:pt x="300858" y="246356"/>
                  </a:cubicBezTo>
                  <a:cubicBezTo>
                    <a:pt x="307957" y="233213"/>
                    <a:pt x="316730" y="243463"/>
                    <a:pt x="326380" y="232239"/>
                  </a:cubicBezTo>
                  <a:cubicBezTo>
                    <a:pt x="325994" y="229975"/>
                    <a:pt x="324731" y="225101"/>
                    <a:pt x="323219" y="223340"/>
                  </a:cubicBezTo>
                  <a:cubicBezTo>
                    <a:pt x="319449" y="218939"/>
                    <a:pt x="308038" y="219096"/>
                    <a:pt x="303285" y="222052"/>
                  </a:cubicBezTo>
                  <a:cubicBezTo>
                    <a:pt x="297238" y="225793"/>
                    <a:pt x="289125" y="232239"/>
                    <a:pt x="281411" y="233025"/>
                  </a:cubicBezTo>
                  <a:cubicBezTo>
                    <a:pt x="275571" y="233622"/>
                    <a:pt x="268724" y="230509"/>
                    <a:pt x="263182" y="232741"/>
                  </a:cubicBezTo>
                  <a:cubicBezTo>
                    <a:pt x="252809" y="236986"/>
                    <a:pt x="247306" y="243621"/>
                    <a:pt x="234499" y="242426"/>
                  </a:cubicBezTo>
                  <a:cubicBezTo>
                    <a:pt x="224075" y="241451"/>
                    <a:pt x="211826" y="237961"/>
                    <a:pt x="202169" y="234313"/>
                  </a:cubicBezTo>
                  <a:cubicBezTo>
                    <a:pt x="194094" y="231264"/>
                    <a:pt x="182877" y="224252"/>
                    <a:pt x="173974" y="225164"/>
                  </a:cubicBezTo>
                  <a:cubicBezTo>
                    <a:pt x="162287" y="226391"/>
                    <a:pt x="155240" y="241074"/>
                    <a:pt x="142861" y="235099"/>
                  </a:cubicBezTo>
                  <a:cubicBezTo>
                    <a:pt x="140122" y="228183"/>
                    <a:pt x="144397" y="220951"/>
                    <a:pt x="143103" y="213939"/>
                  </a:cubicBezTo>
                  <a:cubicBezTo>
                    <a:pt x="142826" y="212430"/>
                    <a:pt x="142037" y="211016"/>
                    <a:pt x="141886" y="209475"/>
                  </a:cubicBezTo>
                  <a:cubicBezTo>
                    <a:pt x="141693" y="207495"/>
                    <a:pt x="143664" y="200231"/>
                    <a:pt x="144804" y="198502"/>
                  </a:cubicBezTo>
                  <a:cubicBezTo>
                    <a:pt x="148929" y="192245"/>
                    <a:pt x="156120" y="188315"/>
                    <a:pt x="156717" y="180203"/>
                  </a:cubicBezTo>
                  <a:cubicBezTo>
                    <a:pt x="154984" y="177594"/>
                    <a:pt x="154044" y="174606"/>
                    <a:pt x="153798" y="171588"/>
                  </a:cubicBezTo>
                  <a:lnTo>
                    <a:pt x="156474" y="166872"/>
                  </a:lnTo>
                  <a:cubicBezTo>
                    <a:pt x="159347" y="165363"/>
                    <a:pt x="162248" y="163791"/>
                    <a:pt x="165468" y="162942"/>
                  </a:cubicBezTo>
                  <a:cubicBezTo>
                    <a:pt x="170933" y="161527"/>
                    <a:pt x="176823" y="162187"/>
                    <a:pt x="182238" y="160615"/>
                  </a:cubicBezTo>
                  <a:cubicBezTo>
                    <a:pt x="194119" y="157094"/>
                    <a:pt x="222258" y="149517"/>
                    <a:pt x="234012" y="149359"/>
                  </a:cubicBezTo>
                  <a:cubicBezTo>
                    <a:pt x="236425" y="149328"/>
                    <a:pt x="238730" y="150523"/>
                    <a:pt x="241062" y="150931"/>
                  </a:cubicBezTo>
                  <a:cubicBezTo>
                    <a:pt x="246713" y="151906"/>
                    <a:pt x="252582" y="150837"/>
                    <a:pt x="258078" y="149611"/>
                  </a:cubicBezTo>
                  <a:cubicBezTo>
                    <a:pt x="263620" y="143448"/>
                    <a:pt x="267075" y="134707"/>
                    <a:pt x="273635" y="129740"/>
                  </a:cubicBezTo>
                  <a:cubicBezTo>
                    <a:pt x="284007" y="121880"/>
                    <a:pt x="304692" y="121439"/>
                    <a:pt x="317389" y="115906"/>
                  </a:cubicBezTo>
                  <a:cubicBezTo>
                    <a:pt x="320396" y="114585"/>
                    <a:pt x="322893" y="112510"/>
                    <a:pt x="325899" y="111189"/>
                  </a:cubicBezTo>
                  <a:cubicBezTo>
                    <a:pt x="330508" y="109146"/>
                    <a:pt x="335633" y="108266"/>
                    <a:pt x="340239" y="106222"/>
                  </a:cubicBezTo>
                  <a:cubicBezTo>
                    <a:pt x="344707" y="104241"/>
                    <a:pt x="348604" y="101348"/>
                    <a:pt x="353122" y="99430"/>
                  </a:cubicBezTo>
                  <a:cubicBezTo>
                    <a:pt x="354441" y="96003"/>
                    <a:pt x="355627" y="92513"/>
                    <a:pt x="356556" y="88961"/>
                  </a:cubicBezTo>
                  <a:cubicBezTo>
                    <a:pt x="383148" y="74780"/>
                    <a:pt x="361976" y="45823"/>
                    <a:pt x="376603" y="30039"/>
                  </a:cubicBezTo>
                  <a:cubicBezTo>
                    <a:pt x="385077" y="20858"/>
                    <a:pt x="390612" y="9760"/>
                    <a:pt x="406148" y="13564"/>
                  </a:cubicBezTo>
                  <a:cubicBezTo>
                    <a:pt x="422224" y="17494"/>
                    <a:pt x="418397" y="10420"/>
                    <a:pt x="427306" y="5012"/>
                  </a:cubicBezTo>
                  <a:cubicBezTo>
                    <a:pt x="433062" y="1522"/>
                    <a:pt x="441155" y="-2565"/>
                    <a:pt x="447451" y="2088"/>
                  </a:cubicBezTo>
                  <a:cubicBezTo>
                    <a:pt x="451608" y="5169"/>
                    <a:pt x="475235" y="16551"/>
                    <a:pt x="479311" y="12212"/>
                  </a:cubicBezTo>
                  <a:cubicBezTo>
                    <a:pt x="483461" y="7779"/>
                    <a:pt x="491251" y="7182"/>
                    <a:pt x="495117" y="12275"/>
                  </a:cubicBezTo>
                  <a:cubicBezTo>
                    <a:pt x="496506" y="14099"/>
                    <a:pt x="499070" y="17872"/>
                    <a:pt x="501908" y="18249"/>
                  </a:cubicBezTo>
                  <a:lnTo>
                    <a:pt x="509298" y="13533"/>
                  </a:lnTo>
                  <a:cubicBezTo>
                    <a:pt x="513171" y="19286"/>
                    <a:pt x="519678" y="26487"/>
                    <a:pt x="526325" y="29914"/>
                  </a:cubicBezTo>
                  <a:lnTo>
                    <a:pt x="525862" y="53275"/>
                  </a:lnTo>
                  <a:cubicBezTo>
                    <a:pt x="527987" y="56199"/>
                    <a:pt x="530404" y="60537"/>
                    <a:pt x="532975" y="63084"/>
                  </a:cubicBezTo>
                  <a:cubicBezTo>
                    <a:pt x="537655" y="67675"/>
                    <a:pt x="543954" y="72014"/>
                    <a:pt x="549139" y="76227"/>
                  </a:cubicBezTo>
                  <a:cubicBezTo>
                    <a:pt x="555789" y="74246"/>
                    <a:pt x="563043" y="76887"/>
                    <a:pt x="568228" y="80534"/>
                  </a:cubicBezTo>
                  <a:cubicBezTo>
                    <a:pt x="577590" y="87137"/>
                    <a:pt x="582430" y="84842"/>
                    <a:pt x="585675" y="75158"/>
                  </a:cubicBezTo>
                  <a:cubicBezTo>
                    <a:pt x="587369" y="70096"/>
                    <a:pt x="591249" y="65317"/>
                    <a:pt x="596868" y="63241"/>
                  </a:cubicBezTo>
                  <a:lnTo>
                    <a:pt x="607359" y="65725"/>
                  </a:lnTo>
                  <a:cubicBezTo>
                    <a:pt x="608433" y="65442"/>
                    <a:pt x="621309" y="62015"/>
                    <a:pt x="621523" y="62015"/>
                  </a:cubicBezTo>
                  <a:cubicBezTo>
                    <a:pt x="622088" y="62015"/>
                    <a:pt x="638953" y="65222"/>
                    <a:pt x="640616" y="65536"/>
                  </a:cubicBezTo>
                  <a:cubicBezTo>
                    <a:pt x="640626" y="61261"/>
                    <a:pt x="643071" y="56293"/>
                    <a:pt x="648575" y="56293"/>
                  </a:cubicBezTo>
                  <a:cubicBezTo>
                    <a:pt x="655320" y="56293"/>
                    <a:pt x="662560" y="57865"/>
                    <a:pt x="669039" y="59531"/>
                  </a:cubicBezTo>
                  <a:lnTo>
                    <a:pt x="675268" y="67675"/>
                  </a:lnTo>
                  <a:cubicBezTo>
                    <a:pt x="680196" y="74120"/>
                    <a:pt x="682308" y="65599"/>
                    <a:pt x="682680" y="62141"/>
                  </a:cubicBezTo>
                  <a:cubicBezTo>
                    <a:pt x="683367" y="55790"/>
                    <a:pt x="683711" y="49030"/>
                    <a:pt x="685802" y="42836"/>
                  </a:cubicBezTo>
                  <a:lnTo>
                    <a:pt x="699436" y="46074"/>
                  </a:lnTo>
                  <a:lnTo>
                    <a:pt x="718700" y="40918"/>
                  </a:lnTo>
                  <a:lnTo>
                    <a:pt x="719724" y="35290"/>
                  </a:lnTo>
                  <a:lnTo>
                    <a:pt x="755461" y="28593"/>
                  </a:lnTo>
                  <a:lnTo>
                    <a:pt x="758937" y="37523"/>
                  </a:lnTo>
                  <a:lnTo>
                    <a:pt x="765205" y="42144"/>
                  </a:lnTo>
                  <a:lnTo>
                    <a:pt x="763451" y="60223"/>
                  </a:lnTo>
                  <a:lnTo>
                    <a:pt x="771344" y="64939"/>
                  </a:lnTo>
                  <a:cubicBezTo>
                    <a:pt x="772670" y="71353"/>
                    <a:pt x="775198" y="79811"/>
                    <a:pt x="775728" y="86162"/>
                  </a:cubicBezTo>
                  <a:cubicBezTo>
                    <a:pt x="775749" y="86382"/>
                    <a:pt x="774118" y="95532"/>
                    <a:pt x="773974" y="96381"/>
                  </a:cubicBezTo>
                  <a:cubicBezTo>
                    <a:pt x="777692" y="102732"/>
                    <a:pt x="791881" y="126690"/>
                    <a:pt x="796774" y="131752"/>
                  </a:cubicBezTo>
                  <a:cubicBezTo>
                    <a:pt x="796922" y="131910"/>
                    <a:pt x="804011" y="136091"/>
                    <a:pt x="804667" y="136468"/>
                  </a:cubicBezTo>
                  <a:lnTo>
                    <a:pt x="832728" y="119176"/>
                  </a:lnTo>
                  <a:lnTo>
                    <a:pt x="837113" y="129394"/>
                  </a:lnTo>
                  <a:lnTo>
                    <a:pt x="833605" y="137254"/>
                  </a:lnTo>
                  <a:cubicBezTo>
                    <a:pt x="834075" y="137569"/>
                    <a:pt x="839684" y="141090"/>
                    <a:pt x="839743" y="141185"/>
                  </a:cubicBezTo>
                  <a:cubicBezTo>
                    <a:pt x="842872" y="145712"/>
                    <a:pt x="846766" y="154924"/>
                    <a:pt x="849390" y="160049"/>
                  </a:cubicBezTo>
                  <a:lnTo>
                    <a:pt x="858159" y="157691"/>
                  </a:lnTo>
                  <a:lnTo>
                    <a:pt x="873943" y="164766"/>
                  </a:lnTo>
                  <a:cubicBezTo>
                    <a:pt x="876416" y="161433"/>
                    <a:pt x="882576" y="157440"/>
                    <a:pt x="887097" y="156905"/>
                  </a:cubicBezTo>
                  <a:lnTo>
                    <a:pt x="891482" y="163980"/>
                  </a:lnTo>
                  <a:cubicBezTo>
                    <a:pt x="897010" y="163665"/>
                    <a:pt x="904920" y="162030"/>
                    <a:pt x="908143" y="157691"/>
                  </a:cubicBezTo>
                  <a:cubicBezTo>
                    <a:pt x="911374" y="153352"/>
                    <a:pt x="913419" y="151214"/>
                    <a:pt x="914282" y="145901"/>
                  </a:cubicBezTo>
                  <a:cubicBezTo>
                    <a:pt x="915436" y="138764"/>
                    <a:pt x="917011" y="131721"/>
                    <a:pt x="918666" y="124678"/>
                  </a:cubicBezTo>
                  <a:lnTo>
                    <a:pt x="910774" y="114459"/>
                  </a:lnTo>
                  <a:lnTo>
                    <a:pt x="915159" y="110529"/>
                  </a:lnTo>
                  <a:cubicBezTo>
                    <a:pt x="928400" y="114617"/>
                    <a:pt x="948825" y="122131"/>
                    <a:pt x="960759" y="128608"/>
                  </a:cubicBezTo>
                  <a:cubicBezTo>
                    <a:pt x="967925" y="132475"/>
                    <a:pt x="974944" y="137632"/>
                    <a:pt x="981805" y="141971"/>
                  </a:cubicBezTo>
                  <a:lnTo>
                    <a:pt x="981805" y="128608"/>
                  </a:lnTo>
                  <a:lnTo>
                    <a:pt x="998466" y="117604"/>
                  </a:lnTo>
                  <a:lnTo>
                    <a:pt x="983558" y="97953"/>
                  </a:lnTo>
                  <a:lnTo>
                    <a:pt x="1001988" y="85282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71" name="자유형: 도형 312"/>
            <p:cNvSpPr/>
            <p:nvPr/>
          </p:nvSpPr>
          <p:spPr>
            <a:xfrm>
              <a:off x="6725160" y="4027680"/>
              <a:ext cx="389160" cy="227520"/>
            </a:xfrm>
            <a:custGeom>
              <a:avLst/>
              <a:gdLst/>
              <a:ahLst/>
              <a:cxnLst/>
              <a:rect l="l" t="t" r="r" b="b"/>
              <a:pathLst>
                <a:path w="308372" h="185417">
                  <a:moveTo>
                    <a:pt x="4464" y="56971"/>
                  </a:moveTo>
                  <a:lnTo>
                    <a:pt x="22732" y="56437"/>
                  </a:lnTo>
                  <a:lnTo>
                    <a:pt x="31312" y="38043"/>
                  </a:lnTo>
                  <a:lnTo>
                    <a:pt x="42151" y="43829"/>
                  </a:lnTo>
                  <a:cubicBezTo>
                    <a:pt x="42151" y="43829"/>
                    <a:pt x="58111" y="38955"/>
                    <a:pt x="61618" y="29523"/>
                  </a:cubicBezTo>
                  <a:cubicBezTo>
                    <a:pt x="65126" y="20090"/>
                    <a:pt x="69865" y="10218"/>
                    <a:pt x="77582" y="6508"/>
                  </a:cubicBezTo>
                  <a:cubicBezTo>
                    <a:pt x="85295" y="2798"/>
                    <a:pt x="97727" y="-4308"/>
                    <a:pt x="95899" y="3552"/>
                  </a:cubicBezTo>
                  <a:cubicBezTo>
                    <a:pt x="94068" y="11444"/>
                    <a:pt x="80823" y="20090"/>
                    <a:pt x="90953" y="22826"/>
                  </a:cubicBezTo>
                  <a:cubicBezTo>
                    <a:pt x="101083" y="25593"/>
                    <a:pt x="106847" y="30717"/>
                    <a:pt x="114490" y="32856"/>
                  </a:cubicBezTo>
                  <a:cubicBezTo>
                    <a:pt x="122130" y="35025"/>
                    <a:pt x="129920" y="37131"/>
                    <a:pt x="129920" y="37131"/>
                  </a:cubicBezTo>
                  <a:lnTo>
                    <a:pt x="147501" y="25309"/>
                  </a:lnTo>
                  <a:lnTo>
                    <a:pt x="159350" y="26284"/>
                  </a:lnTo>
                  <a:lnTo>
                    <a:pt x="174092" y="18455"/>
                  </a:lnTo>
                  <a:lnTo>
                    <a:pt x="185173" y="12167"/>
                  </a:lnTo>
                  <a:lnTo>
                    <a:pt x="191624" y="9872"/>
                  </a:lnTo>
                  <a:cubicBezTo>
                    <a:pt x="191624" y="9872"/>
                    <a:pt x="198099" y="14934"/>
                    <a:pt x="204399" y="9243"/>
                  </a:cubicBezTo>
                  <a:cubicBezTo>
                    <a:pt x="210699" y="3552"/>
                    <a:pt x="214557" y="2672"/>
                    <a:pt x="221835" y="4684"/>
                  </a:cubicBezTo>
                  <a:cubicBezTo>
                    <a:pt x="229114" y="6728"/>
                    <a:pt x="234530" y="8929"/>
                    <a:pt x="234530" y="8929"/>
                  </a:cubicBezTo>
                  <a:lnTo>
                    <a:pt x="251409" y="32573"/>
                  </a:lnTo>
                  <a:cubicBezTo>
                    <a:pt x="251409" y="32573"/>
                    <a:pt x="246210" y="36880"/>
                    <a:pt x="252131" y="42225"/>
                  </a:cubicBezTo>
                  <a:cubicBezTo>
                    <a:pt x="258052" y="47602"/>
                    <a:pt x="261069" y="52066"/>
                    <a:pt x="261069" y="52066"/>
                  </a:cubicBezTo>
                  <a:lnTo>
                    <a:pt x="259115" y="58480"/>
                  </a:lnTo>
                  <a:lnTo>
                    <a:pt x="262553" y="69013"/>
                  </a:lnTo>
                  <a:cubicBezTo>
                    <a:pt x="262553" y="69013"/>
                    <a:pt x="280852" y="64108"/>
                    <a:pt x="286114" y="65680"/>
                  </a:cubicBezTo>
                  <a:cubicBezTo>
                    <a:pt x="291375" y="67252"/>
                    <a:pt x="296206" y="70554"/>
                    <a:pt x="300804" y="73604"/>
                  </a:cubicBezTo>
                  <a:cubicBezTo>
                    <a:pt x="305410" y="76685"/>
                    <a:pt x="311913" y="81590"/>
                    <a:pt x="306030" y="86620"/>
                  </a:cubicBezTo>
                  <a:cubicBezTo>
                    <a:pt x="300145" y="91619"/>
                    <a:pt x="295535" y="99700"/>
                    <a:pt x="297401" y="107435"/>
                  </a:cubicBezTo>
                  <a:cubicBezTo>
                    <a:pt x="299268" y="115200"/>
                    <a:pt x="297994" y="123564"/>
                    <a:pt x="297994" y="123564"/>
                  </a:cubicBezTo>
                  <a:cubicBezTo>
                    <a:pt x="297994" y="123564"/>
                    <a:pt x="292614" y="129097"/>
                    <a:pt x="285854" y="137083"/>
                  </a:cubicBezTo>
                  <a:cubicBezTo>
                    <a:pt x="279099" y="145070"/>
                    <a:pt x="272778" y="152207"/>
                    <a:pt x="272778" y="152207"/>
                  </a:cubicBezTo>
                  <a:cubicBezTo>
                    <a:pt x="272778" y="152207"/>
                    <a:pt x="258782" y="151295"/>
                    <a:pt x="256221" y="158401"/>
                  </a:cubicBezTo>
                  <a:cubicBezTo>
                    <a:pt x="253664" y="165507"/>
                    <a:pt x="239086" y="174373"/>
                    <a:pt x="231468" y="163651"/>
                  </a:cubicBezTo>
                  <a:cubicBezTo>
                    <a:pt x="223849" y="152930"/>
                    <a:pt x="219829" y="152175"/>
                    <a:pt x="219829" y="152175"/>
                  </a:cubicBezTo>
                  <a:lnTo>
                    <a:pt x="200446" y="163148"/>
                  </a:lnTo>
                  <a:lnTo>
                    <a:pt x="193192" y="160665"/>
                  </a:lnTo>
                  <a:lnTo>
                    <a:pt x="182118" y="166921"/>
                  </a:lnTo>
                  <a:lnTo>
                    <a:pt x="171241" y="162709"/>
                  </a:lnTo>
                  <a:lnTo>
                    <a:pt x="158273" y="173021"/>
                  </a:lnTo>
                  <a:cubicBezTo>
                    <a:pt x="158273" y="173021"/>
                    <a:pt x="146508" y="173210"/>
                    <a:pt x="142649" y="178398"/>
                  </a:cubicBezTo>
                  <a:cubicBezTo>
                    <a:pt x="138791" y="183585"/>
                    <a:pt x="125641" y="187893"/>
                    <a:pt x="125199" y="183774"/>
                  </a:cubicBezTo>
                  <a:cubicBezTo>
                    <a:pt x="124760" y="179655"/>
                    <a:pt x="115118" y="179498"/>
                    <a:pt x="112483" y="180347"/>
                  </a:cubicBezTo>
                  <a:cubicBezTo>
                    <a:pt x="109853" y="181196"/>
                    <a:pt x="104349" y="183963"/>
                    <a:pt x="99645" y="183365"/>
                  </a:cubicBezTo>
                  <a:cubicBezTo>
                    <a:pt x="94945" y="182799"/>
                    <a:pt x="95184" y="178492"/>
                    <a:pt x="95184" y="178492"/>
                  </a:cubicBezTo>
                  <a:lnTo>
                    <a:pt x="86965" y="178366"/>
                  </a:lnTo>
                  <a:cubicBezTo>
                    <a:pt x="86965" y="178366"/>
                    <a:pt x="76600" y="170380"/>
                    <a:pt x="86211" y="170286"/>
                  </a:cubicBezTo>
                  <a:cubicBezTo>
                    <a:pt x="95822" y="170223"/>
                    <a:pt x="95973" y="169437"/>
                    <a:pt x="94584" y="162362"/>
                  </a:cubicBezTo>
                  <a:cubicBezTo>
                    <a:pt x="93195" y="155288"/>
                    <a:pt x="77708" y="138687"/>
                    <a:pt x="77708" y="138687"/>
                  </a:cubicBezTo>
                  <a:lnTo>
                    <a:pt x="68676" y="133719"/>
                  </a:lnTo>
                  <a:lnTo>
                    <a:pt x="41365" y="130072"/>
                  </a:lnTo>
                  <a:lnTo>
                    <a:pt x="31807" y="134851"/>
                  </a:lnTo>
                  <a:lnTo>
                    <a:pt x="18435" y="135386"/>
                  </a:lnTo>
                  <a:lnTo>
                    <a:pt x="12157" y="129632"/>
                  </a:lnTo>
                  <a:cubicBezTo>
                    <a:pt x="12157" y="129632"/>
                    <a:pt x="-2807" y="130732"/>
                    <a:pt x="469" y="120608"/>
                  </a:cubicBezTo>
                  <a:cubicBezTo>
                    <a:pt x="3745" y="110484"/>
                    <a:pt x="1777" y="100455"/>
                    <a:pt x="1777" y="100455"/>
                  </a:cubicBezTo>
                  <a:lnTo>
                    <a:pt x="3040" y="82721"/>
                  </a:lnTo>
                  <a:lnTo>
                    <a:pt x="12199" y="81275"/>
                  </a:lnTo>
                  <a:lnTo>
                    <a:pt x="17822" y="74106"/>
                  </a:lnTo>
                  <a:lnTo>
                    <a:pt x="4464" y="56971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miter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72" name="자유형: 도형 313"/>
            <p:cNvSpPr/>
            <p:nvPr/>
          </p:nvSpPr>
          <p:spPr>
            <a:xfrm>
              <a:off x="5594760" y="173520"/>
              <a:ext cx="59400" cy="134280"/>
            </a:xfrm>
            <a:custGeom>
              <a:avLst/>
              <a:gdLst/>
              <a:ahLst/>
              <a:cxnLst/>
              <a:rect l="l" t="t" r="r" b="b"/>
              <a:pathLst>
                <a:path w="47304" h="109635">
                  <a:moveTo>
                    <a:pt x="1277" y="0"/>
                  </a:moveTo>
                  <a:lnTo>
                    <a:pt x="0" y="11539"/>
                  </a:lnTo>
                  <a:lnTo>
                    <a:pt x="224" y="16727"/>
                  </a:lnTo>
                  <a:lnTo>
                    <a:pt x="1375" y="21191"/>
                  </a:lnTo>
                  <a:lnTo>
                    <a:pt x="5286" y="29618"/>
                  </a:lnTo>
                  <a:lnTo>
                    <a:pt x="12652" y="36063"/>
                  </a:lnTo>
                  <a:lnTo>
                    <a:pt x="18173" y="38264"/>
                  </a:lnTo>
                  <a:lnTo>
                    <a:pt x="27371" y="43735"/>
                  </a:lnTo>
                  <a:lnTo>
                    <a:pt x="30317" y="47508"/>
                  </a:lnTo>
                  <a:lnTo>
                    <a:pt x="34049" y="50401"/>
                  </a:lnTo>
                  <a:lnTo>
                    <a:pt x="36817" y="54110"/>
                  </a:lnTo>
                  <a:lnTo>
                    <a:pt x="37967" y="58827"/>
                  </a:lnTo>
                  <a:lnTo>
                    <a:pt x="38199" y="64015"/>
                  </a:lnTo>
                  <a:lnTo>
                    <a:pt x="34509" y="75428"/>
                  </a:lnTo>
                  <a:lnTo>
                    <a:pt x="33825" y="80867"/>
                  </a:lnTo>
                  <a:lnTo>
                    <a:pt x="34961" y="85552"/>
                  </a:lnTo>
                  <a:lnTo>
                    <a:pt x="37041" y="89765"/>
                  </a:lnTo>
                  <a:lnTo>
                    <a:pt x="45495" y="100644"/>
                  </a:lnTo>
                  <a:lnTo>
                    <a:pt x="47305" y="109636"/>
                  </a:lnTo>
                  <a:lnTo>
                    <a:pt x="47305" y="109636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73" name="자유형: 도형 314"/>
            <p:cNvSpPr/>
            <p:nvPr/>
          </p:nvSpPr>
          <p:spPr>
            <a:xfrm>
              <a:off x="6750720" y="-125280"/>
              <a:ext cx="356760" cy="905040"/>
            </a:xfrm>
            <a:custGeom>
              <a:avLst/>
              <a:gdLst/>
              <a:ahLst/>
              <a:cxnLst/>
              <a:rect l="l" t="t" r="r" b="b"/>
              <a:pathLst>
                <a:path w="282838" h="736953">
                  <a:moveTo>
                    <a:pt x="230576" y="0"/>
                  </a:moveTo>
                  <a:lnTo>
                    <a:pt x="246792" y="9181"/>
                  </a:lnTo>
                  <a:cubicBezTo>
                    <a:pt x="246936" y="9652"/>
                    <a:pt x="248048" y="13426"/>
                    <a:pt x="248181" y="13645"/>
                  </a:cubicBezTo>
                  <a:cubicBezTo>
                    <a:pt x="252531" y="20217"/>
                    <a:pt x="256719" y="27008"/>
                    <a:pt x="261289" y="33454"/>
                  </a:cubicBezTo>
                  <a:cubicBezTo>
                    <a:pt x="263408" y="36440"/>
                    <a:pt x="266319" y="40182"/>
                    <a:pt x="268901" y="42855"/>
                  </a:cubicBezTo>
                  <a:cubicBezTo>
                    <a:pt x="270150" y="44144"/>
                    <a:pt x="272563" y="44992"/>
                    <a:pt x="273738" y="46313"/>
                  </a:cubicBezTo>
                  <a:cubicBezTo>
                    <a:pt x="284661" y="58607"/>
                    <a:pt x="285078" y="74359"/>
                    <a:pt x="278561" y="88413"/>
                  </a:cubicBezTo>
                  <a:lnTo>
                    <a:pt x="275804" y="94356"/>
                  </a:lnTo>
                  <a:cubicBezTo>
                    <a:pt x="268992" y="103316"/>
                    <a:pt x="260651" y="111963"/>
                    <a:pt x="253236" y="120577"/>
                  </a:cubicBezTo>
                  <a:cubicBezTo>
                    <a:pt x="250605" y="123659"/>
                    <a:pt x="241867" y="128218"/>
                    <a:pt x="238058" y="129255"/>
                  </a:cubicBezTo>
                  <a:lnTo>
                    <a:pt x="231148" y="129915"/>
                  </a:lnTo>
                  <a:cubicBezTo>
                    <a:pt x="219341" y="131048"/>
                    <a:pt x="194138" y="129224"/>
                    <a:pt x="183727" y="134475"/>
                  </a:cubicBezTo>
                  <a:cubicBezTo>
                    <a:pt x="180686" y="135984"/>
                    <a:pt x="177547" y="138656"/>
                    <a:pt x="175056" y="140731"/>
                  </a:cubicBezTo>
                  <a:cubicBezTo>
                    <a:pt x="171464" y="143718"/>
                    <a:pt x="167532" y="146580"/>
                    <a:pt x="164845" y="150290"/>
                  </a:cubicBezTo>
                  <a:cubicBezTo>
                    <a:pt x="151555" y="168714"/>
                    <a:pt x="166480" y="186227"/>
                    <a:pt x="165070" y="204023"/>
                  </a:cubicBezTo>
                  <a:cubicBezTo>
                    <a:pt x="164333" y="213329"/>
                    <a:pt x="162923" y="223265"/>
                    <a:pt x="161390" y="232477"/>
                  </a:cubicBezTo>
                  <a:cubicBezTo>
                    <a:pt x="157325" y="256970"/>
                    <a:pt x="128386" y="278759"/>
                    <a:pt x="116064" y="299825"/>
                  </a:cubicBezTo>
                  <a:cubicBezTo>
                    <a:pt x="110764" y="308911"/>
                    <a:pt x="106969" y="318815"/>
                    <a:pt x="101549" y="327807"/>
                  </a:cubicBezTo>
                  <a:cubicBezTo>
                    <a:pt x="100788" y="329065"/>
                    <a:pt x="100006" y="329568"/>
                    <a:pt x="99017" y="330700"/>
                  </a:cubicBezTo>
                  <a:cubicBezTo>
                    <a:pt x="93815" y="336642"/>
                    <a:pt x="90665" y="339818"/>
                    <a:pt x="83678" y="344157"/>
                  </a:cubicBezTo>
                  <a:cubicBezTo>
                    <a:pt x="71758" y="351514"/>
                    <a:pt x="66150" y="354533"/>
                    <a:pt x="51828" y="358023"/>
                  </a:cubicBezTo>
                  <a:cubicBezTo>
                    <a:pt x="41003" y="360632"/>
                    <a:pt x="29329" y="362110"/>
                    <a:pt x="18698" y="365191"/>
                  </a:cubicBezTo>
                  <a:cubicBezTo>
                    <a:pt x="17211" y="365632"/>
                    <a:pt x="16586" y="366292"/>
                    <a:pt x="15243" y="367015"/>
                  </a:cubicBezTo>
                  <a:cubicBezTo>
                    <a:pt x="10599" y="369436"/>
                    <a:pt x="2127" y="373460"/>
                    <a:pt x="745" y="378805"/>
                  </a:cubicBezTo>
                  <a:lnTo>
                    <a:pt x="128" y="384905"/>
                  </a:lnTo>
                  <a:cubicBezTo>
                    <a:pt x="-289" y="389055"/>
                    <a:pt x="202" y="393708"/>
                    <a:pt x="3278" y="397135"/>
                  </a:cubicBezTo>
                  <a:cubicBezTo>
                    <a:pt x="9722" y="404273"/>
                    <a:pt x="16491" y="411221"/>
                    <a:pt x="22227" y="418830"/>
                  </a:cubicBezTo>
                  <a:lnTo>
                    <a:pt x="28821" y="427571"/>
                  </a:lnTo>
                  <a:cubicBezTo>
                    <a:pt x="31694" y="431815"/>
                    <a:pt x="32564" y="440588"/>
                    <a:pt x="30441" y="445146"/>
                  </a:cubicBezTo>
                  <a:cubicBezTo>
                    <a:pt x="28446" y="449454"/>
                    <a:pt x="25499" y="453667"/>
                    <a:pt x="23766" y="458038"/>
                  </a:cubicBezTo>
                  <a:lnTo>
                    <a:pt x="20999" y="467596"/>
                  </a:lnTo>
                  <a:cubicBezTo>
                    <a:pt x="17628" y="479261"/>
                    <a:pt x="17937" y="480644"/>
                    <a:pt x="19382" y="493000"/>
                  </a:cubicBezTo>
                  <a:cubicBezTo>
                    <a:pt x="19648" y="495296"/>
                    <a:pt x="19578" y="496616"/>
                    <a:pt x="20066" y="498880"/>
                  </a:cubicBezTo>
                  <a:cubicBezTo>
                    <a:pt x="21034" y="503313"/>
                    <a:pt x="24987" y="517399"/>
                    <a:pt x="26748" y="521392"/>
                  </a:cubicBezTo>
                  <a:cubicBezTo>
                    <a:pt x="28751" y="525951"/>
                    <a:pt x="30445" y="528309"/>
                    <a:pt x="32809" y="532711"/>
                  </a:cubicBezTo>
                  <a:cubicBezTo>
                    <a:pt x="41449" y="548840"/>
                    <a:pt x="48839" y="563397"/>
                    <a:pt x="61278" y="577357"/>
                  </a:cubicBezTo>
                  <a:cubicBezTo>
                    <a:pt x="71145" y="588425"/>
                    <a:pt x="82783" y="598612"/>
                    <a:pt x="90798" y="610937"/>
                  </a:cubicBezTo>
                  <a:lnTo>
                    <a:pt x="87508" y="617477"/>
                  </a:lnTo>
                  <a:cubicBezTo>
                    <a:pt x="92029" y="635429"/>
                    <a:pt x="112248" y="627381"/>
                    <a:pt x="121813" y="634046"/>
                  </a:cubicBezTo>
                  <a:cubicBezTo>
                    <a:pt x="124654" y="638291"/>
                    <a:pt x="122865" y="643195"/>
                    <a:pt x="125721" y="647409"/>
                  </a:cubicBezTo>
                  <a:cubicBezTo>
                    <a:pt x="127236" y="648918"/>
                    <a:pt x="130319" y="650144"/>
                    <a:pt x="132455" y="650396"/>
                  </a:cubicBezTo>
                  <a:lnTo>
                    <a:pt x="136770" y="650867"/>
                  </a:lnTo>
                  <a:cubicBezTo>
                    <a:pt x="143568" y="650270"/>
                    <a:pt x="150787" y="640523"/>
                    <a:pt x="157707" y="637505"/>
                  </a:cubicBezTo>
                  <a:cubicBezTo>
                    <a:pt x="160570" y="636278"/>
                    <a:pt x="164915" y="635429"/>
                    <a:pt x="168062" y="635021"/>
                  </a:cubicBezTo>
                  <a:cubicBezTo>
                    <a:pt x="170223" y="636059"/>
                    <a:pt x="175011" y="639171"/>
                    <a:pt x="176354" y="640963"/>
                  </a:cubicBezTo>
                  <a:cubicBezTo>
                    <a:pt x="180367" y="646340"/>
                    <a:pt x="177947" y="656118"/>
                    <a:pt x="174053" y="661023"/>
                  </a:cubicBezTo>
                  <a:cubicBezTo>
                    <a:pt x="170602" y="663224"/>
                    <a:pt x="164537" y="666556"/>
                    <a:pt x="160236" y="667217"/>
                  </a:cubicBezTo>
                  <a:lnTo>
                    <a:pt x="154263" y="675643"/>
                  </a:lnTo>
                  <a:cubicBezTo>
                    <a:pt x="154628" y="685862"/>
                    <a:pt x="172391" y="692621"/>
                    <a:pt x="171984" y="702620"/>
                  </a:cubicBezTo>
                  <a:cubicBezTo>
                    <a:pt x="171584" y="712492"/>
                    <a:pt x="161243" y="716140"/>
                    <a:pt x="158167" y="724157"/>
                  </a:cubicBezTo>
                  <a:cubicBezTo>
                    <a:pt x="157511" y="727710"/>
                    <a:pt x="160012" y="733935"/>
                    <a:pt x="161818" y="736954"/>
                  </a:cubicBezTo>
                </a:path>
              </a:pathLst>
            </a:custGeom>
            <a:noFill/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74" name="자유형: 도형 315"/>
            <p:cNvSpPr/>
            <p:nvPr/>
          </p:nvSpPr>
          <p:spPr>
            <a:xfrm>
              <a:off x="6955200" y="779760"/>
              <a:ext cx="100440" cy="91800"/>
            </a:xfrm>
            <a:custGeom>
              <a:avLst/>
              <a:gdLst/>
              <a:ahLst/>
              <a:cxnLst/>
              <a:rect l="l" t="t" r="r" b="b"/>
              <a:pathLst>
                <a:path w="79743" h="74924">
                  <a:moveTo>
                    <a:pt x="0" y="0"/>
                  </a:moveTo>
                  <a:lnTo>
                    <a:pt x="9867" y="15658"/>
                  </a:lnTo>
                  <a:lnTo>
                    <a:pt x="27416" y="22355"/>
                  </a:lnTo>
                  <a:lnTo>
                    <a:pt x="43836" y="20531"/>
                  </a:lnTo>
                  <a:lnTo>
                    <a:pt x="52892" y="44867"/>
                  </a:lnTo>
                  <a:lnTo>
                    <a:pt x="66478" y="63134"/>
                  </a:lnTo>
                  <a:lnTo>
                    <a:pt x="79744" y="74925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75" name="자유형: 도형 316"/>
            <p:cNvSpPr/>
            <p:nvPr/>
          </p:nvSpPr>
          <p:spPr>
            <a:xfrm>
              <a:off x="5677200" y="344160"/>
              <a:ext cx="825840" cy="658440"/>
            </a:xfrm>
            <a:custGeom>
              <a:avLst/>
              <a:gdLst/>
              <a:ahLst/>
              <a:cxnLst/>
              <a:rect l="l" t="t" r="r" b="b"/>
              <a:pathLst>
                <a:path w="654088" h="536232">
                  <a:moveTo>
                    <a:pt x="0" y="0"/>
                  </a:moveTo>
                  <a:cubicBezTo>
                    <a:pt x="84" y="283"/>
                    <a:pt x="1196" y="849"/>
                    <a:pt x="1329" y="1163"/>
                  </a:cubicBezTo>
                  <a:cubicBezTo>
                    <a:pt x="1901" y="2484"/>
                    <a:pt x="2445" y="4685"/>
                    <a:pt x="2711" y="6100"/>
                  </a:cubicBezTo>
                  <a:cubicBezTo>
                    <a:pt x="3620" y="11004"/>
                    <a:pt x="2518" y="15815"/>
                    <a:pt x="2483" y="20688"/>
                  </a:cubicBezTo>
                  <a:cubicBezTo>
                    <a:pt x="2434" y="27102"/>
                    <a:pt x="2789" y="33611"/>
                    <a:pt x="2939" y="40025"/>
                  </a:cubicBezTo>
                  <a:cubicBezTo>
                    <a:pt x="4977" y="42351"/>
                    <a:pt x="10800" y="50652"/>
                    <a:pt x="10537" y="53891"/>
                  </a:cubicBezTo>
                  <a:lnTo>
                    <a:pt x="8240" y="82345"/>
                  </a:lnTo>
                  <a:cubicBezTo>
                    <a:pt x="8229" y="82471"/>
                    <a:pt x="9709" y="86212"/>
                    <a:pt x="9843" y="86558"/>
                  </a:cubicBezTo>
                  <a:cubicBezTo>
                    <a:pt x="12764" y="88727"/>
                    <a:pt x="16784" y="90771"/>
                    <a:pt x="20429" y="91777"/>
                  </a:cubicBezTo>
                  <a:lnTo>
                    <a:pt x="24582" y="96714"/>
                  </a:lnTo>
                  <a:cubicBezTo>
                    <a:pt x="25753" y="101304"/>
                    <a:pt x="24361" y="106397"/>
                    <a:pt x="21127" y="110076"/>
                  </a:cubicBezTo>
                  <a:cubicBezTo>
                    <a:pt x="26602" y="116113"/>
                    <a:pt x="31538" y="113409"/>
                    <a:pt x="36540" y="117999"/>
                  </a:cubicBezTo>
                  <a:cubicBezTo>
                    <a:pt x="38553" y="122150"/>
                    <a:pt x="35845" y="126677"/>
                    <a:pt x="37003" y="131110"/>
                  </a:cubicBezTo>
                  <a:cubicBezTo>
                    <a:pt x="39265" y="133217"/>
                    <a:pt x="41387" y="136675"/>
                    <a:pt x="42078" y="139537"/>
                  </a:cubicBezTo>
                  <a:cubicBezTo>
                    <a:pt x="41587" y="142618"/>
                    <a:pt x="38865" y="146862"/>
                    <a:pt x="36319" y="148938"/>
                  </a:cubicBezTo>
                  <a:lnTo>
                    <a:pt x="36084" y="172959"/>
                  </a:lnTo>
                  <a:cubicBezTo>
                    <a:pt x="36080" y="173305"/>
                    <a:pt x="37795" y="176543"/>
                    <a:pt x="37929" y="177172"/>
                  </a:cubicBezTo>
                  <a:cubicBezTo>
                    <a:pt x="38490" y="179813"/>
                    <a:pt x="37364" y="183523"/>
                    <a:pt x="38841" y="186102"/>
                  </a:cubicBezTo>
                  <a:cubicBezTo>
                    <a:pt x="43734" y="194528"/>
                    <a:pt x="59901" y="206287"/>
                    <a:pt x="61402" y="213078"/>
                  </a:cubicBezTo>
                  <a:cubicBezTo>
                    <a:pt x="61381" y="217071"/>
                    <a:pt x="52626" y="228013"/>
                    <a:pt x="48753" y="230150"/>
                  </a:cubicBezTo>
                  <a:cubicBezTo>
                    <a:pt x="47003" y="231125"/>
                    <a:pt x="41513" y="232037"/>
                    <a:pt x="37932" y="234112"/>
                  </a:cubicBezTo>
                  <a:lnTo>
                    <a:pt x="38388" y="238577"/>
                  </a:lnTo>
                  <a:cubicBezTo>
                    <a:pt x="41485" y="241815"/>
                    <a:pt x="56586" y="247726"/>
                    <a:pt x="60490" y="248481"/>
                  </a:cubicBezTo>
                  <a:cubicBezTo>
                    <a:pt x="60658" y="248512"/>
                    <a:pt x="70690" y="247789"/>
                    <a:pt x="71539" y="247726"/>
                  </a:cubicBezTo>
                  <a:cubicBezTo>
                    <a:pt x="78870" y="249801"/>
                    <a:pt x="81554" y="259234"/>
                    <a:pt x="83055" y="265051"/>
                  </a:cubicBezTo>
                  <a:lnTo>
                    <a:pt x="81210" y="269012"/>
                  </a:lnTo>
                  <a:cubicBezTo>
                    <a:pt x="77758" y="271150"/>
                    <a:pt x="72953" y="273445"/>
                    <a:pt x="69919" y="275961"/>
                  </a:cubicBezTo>
                  <a:cubicBezTo>
                    <a:pt x="69813" y="276055"/>
                    <a:pt x="67607" y="280017"/>
                    <a:pt x="67390" y="280426"/>
                  </a:cubicBezTo>
                  <a:cubicBezTo>
                    <a:pt x="71890" y="282815"/>
                    <a:pt x="74942" y="281840"/>
                    <a:pt x="77972" y="282878"/>
                  </a:cubicBezTo>
                  <a:cubicBezTo>
                    <a:pt x="81631" y="284135"/>
                    <a:pt x="82767" y="286965"/>
                    <a:pt x="88113" y="286588"/>
                  </a:cubicBezTo>
                  <a:cubicBezTo>
                    <a:pt x="94136" y="285079"/>
                    <a:pt x="96507" y="278665"/>
                    <a:pt x="100762" y="274954"/>
                  </a:cubicBezTo>
                  <a:cubicBezTo>
                    <a:pt x="113053" y="271496"/>
                    <a:pt x="117658" y="283129"/>
                    <a:pt x="125852" y="287594"/>
                  </a:cubicBezTo>
                  <a:lnTo>
                    <a:pt x="130682" y="287594"/>
                  </a:lnTo>
                  <a:cubicBezTo>
                    <a:pt x="132692" y="283067"/>
                    <a:pt x="131068" y="278130"/>
                    <a:pt x="134130" y="273980"/>
                  </a:cubicBezTo>
                  <a:cubicBezTo>
                    <a:pt x="137364" y="272471"/>
                    <a:pt x="146348" y="269767"/>
                    <a:pt x="150024" y="271496"/>
                  </a:cubicBezTo>
                  <a:cubicBezTo>
                    <a:pt x="154742" y="276181"/>
                    <a:pt x="156194" y="283067"/>
                    <a:pt x="157155" y="289072"/>
                  </a:cubicBezTo>
                  <a:cubicBezTo>
                    <a:pt x="160957" y="295077"/>
                    <a:pt x="167057" y="293725"/>
                    <a:pt x="170505" y="299730"/>
                  </a:cubicBezTo>
                  <a:cubicBezTo>
                    <a:pt x="171368" y="302088"/>
                    <a:pt x="170824" y="306365"/>
                    <a:pt x="169116" y="308377"/>
                  </a:cubicBezTo>
                  <a:cubicBezTo>
                    <a:pt x="170852" y="310798"/>
                    <a:pt x="172634" y="314382"/>
                    <a:pt x="172810" y="317306"/>
                  </a:cubicBezTo>
                  <a:cubicBezTo>
                    <a:pt x="179604" y="319884"/>
                    <a:pt x="186956" y="322242"/>
                    <a:pt x="193530" y="325229"/>
                  </a:cubicBezTo>
                  <a:cubicBezTo>
                    <a:pt x="196195" y="326424"/>
                    <a:pt x="199517" y="330040"/>
                    <a:pt x="201197" y="331989"/>
                  </a:cubicBezTo>
                  <a:cubicBezTo>
                    <a:pt x="203842" y="335071"/>
                    <a:pt x="207164" y="338340"/>
                    <a:pt x="208711" y="342050"/>
                  </a:cubicBezTo>
                  <a:cubicBezTo>
                    <a:pt x="212303" y="350760"/>
                    <a:pt x="213565" y="359877"/>
                    <a:pt x="215316" y="368964"/>
                  </a:cubicBezTo>
                  <a:cubicBezTo>
                    <a:pt x="217434" y="379969"/>
                    <a:pt x="219290" y="396224"/>
                    <a:pt x="230581" y="403456"/>
                  </a:cubicBezTo>
                  <a:lnTo>
                    <a:pt x="235418" y="405436"/>
                  </a:lnTo>
                  <a:cubicBezTo>
                    <a:pt x="241686" y="406128"/>
                    <a:pt x="257075" y="406411"/>
                    <a:pt x="263497" y="405185"/>
                  </a:cubicBezTo>
                  <a:cubicBezTo>
                    <a:pt x="268682" y="404210"/>
                    <a:pt x="273750" y="402072"/>
                    <a:pt x="278917" y="400972"/>
                  </a:cubicBezTo>
                  <a:cubicBezTo>
                    <a:pt x="285329" y="399619"/>
                    <a:pt x="292836" y="399965"/>
                    <a:pt x="298718" y="397041"/>
                  </a:cubicBezTo>
                  <a:cubicBezTo>
                    <a:pt x="305291" y="393740"/>
                    <a:pt x="317210" y="385377"/>
                    <a:pt x="325408" y="385377"/>
                  </a:cubicBezTo>
                  <a:cubicBezTo>
                    <a:pt x="336149" y="385377"/>
                    <a:pt x="340975" y="398959"/>
                    <a:pt x="350277" y="400500"/>
                  </a:cubicBezTo>
                  <a:cubicBezTo>
                    <a:pt x="356711" y="400689"/>
                    <a:pt x="366336" y="392671"/>
                    <a:pt x="370064" y="388867"/>
                  </a:cubicBezTo>
                  <a:cubicBezTo>
                    <a:pt x="376501" y="382295"/>
                    <a:pt x="377525" y="376699"/>
                    <a:pt x="387101" y="372769"/>
                  </a:cubicBezTo>
                  <a:cubicBezTo>
                    <a:pt x="401872" y="366669"/>
                    <a:pt x="407221" y="379403"/>
                    <a:pt x="418860" y="375473"/>
                  </a:cubicBezTo>
                  <a:cubicBezTo>
                    <a:pt x="426457" y="367895"/>
                    <a:pt x="435991" y="362865"/>
                    <a:pt x="444862" y="356671"/>
                  </a:cubicBezTo>
                  <a:cubicBezTo>
                    <a:pt x="448275" y="354281"/>
                    <a:pt x="450660" y="351106"/>
                    <a:pt x="455003" y="349753"/>
                  </a:cubicBezTo>
                  <a:cubicBezTo>
                    <a:pt x="459815" y="348213"/>
                    <a:pt x="465891" y="346704"/>
                    <a:pt x="470889" y="345792"/>
                  </a:cubicBezTo>
                  <a:cubicBezTo>
                    <a:pt x="474365" y="345132"/>
                    <a:pt x="478185" y="345352"/>
                    <a:pt x="481693" y="344786"/>
                  </a:cubicBezTo>
                  <a:cubicBezTo>
                    <a:pt x="485172" y="344220"/>
                    <a:pt x="488792" y="342679"/>
                    <a:pt x="492276" y="342302"/>
                  </a:cubicBezTo>
                  <a:cubicBezTo>
                    <a:pt x="497874" y="341705"/>
                    <a:pt x="507888" y="341107"/>
                    <a:pt x="513465" y="341327"/>
                  </a:cubicBezTo>
                  <a:cubicBezTo>
                    <a:pt x="513648" y="341327"/>
                    <a:pt x="524052" y="343434"/>
                    <a:pt x="524501" y="343560"/>
                  </a:cubicBezTo>
                  <a:cubicBezTo>
                    <a:pt x="545343" y="349408"/>
                    <a:pt x="563183" y="360915"/>
                    <a:pt x="582956" y="368807"/>
                  </a:cubicBezTo>
                  <a:cubicBezTo>
                    <a:pt x="589782" y="371542"/>
                    <a:pt x="602399" y="374529"/>
                    <a:pt x="609902" y="376730"/>
                  </a:cubicBezTo>
                  <a:cubicBezTo>
                    <a:pt x="620011" y="379686"/>
                    <a:pt x="633881" y="396475"/>
                    <a:pt x="637746" y="404461"/>
                  </a:cubicBezTo>
                  <a:cubicBezTo>
                    <a:pt x="644478" y="418327"/>
                    <a:pt x="641440" y="419899"/>
                    <a:pt x="654089" y="431690"/>
                  </a:cubicBezTo>
                  <a:cubicBezTo>
                    <a:pt x="653948" y="435777"/>
                    <a:pt x="653534" y="446530"/>
                    <a:pt x="651780" y="450240"/>
                  </a:cubicBezTo>
                  <a:lnTo>
                    <a:pt x="646031" y="451498"/>
                  </a:lnTo>
                  <a:cubicBezTo>
                    <a:pt x="644737" y="449328"/>
                    <a:pt x="642208" y="447819"/>
                    <a:pt x="640728" y="445807"/>
                  </a:cubicBezTo>
                  <a:cubicBezTo>
                    <a:pt x="637985" y="442034"/>
                    <a:pt x="634968" y="428451"/>
                    <a:pt x="634060" y="424018"/>
                  </a:cubicBezTo>
                  <a:lnTo>
                    <a:pt x="628767" y="422760"/>
                  </a:lnTo>
                  <a:cubicBezTo>
                    <a:pt x="621165" y="427948"/>
                    <a:pt x="623828" y="433104"/>
                    <a:pt x="613038" y="437538"/>
                  </a:cubicBezTo>
                  <a:cubicBezTo>
                    <a:pt x="610951" y="438418"/>
                    <a:pt x="607633" y="438953"/>
                    <a:pt x="605290" y="438607"/>
                  </a:cubicBezTo>
                  <a:lnTo>
                    <a:pt x="601372" y="442820"/>
                  </a:lnTo>
                  <a:cubicBezTo>
                    <a:pt x="602740" y="445115"/>
                    <a:pt x="603753" y="449140"/>
                    <a:pt x="603217" y="451749"/>
                  </a:cubicBezTo>
                  <a:lnTo>
                    <a:pt x="598611" y="457346"/>
                  </a:lnTo>
                  <a:cubicBezTo>
                    <a:pt x="593876" y="463131"/>
                    <a:pt x="594475" y="467973"/>
                    <a:pt x="599993" y="473287"/>
                  </a:cubicBezTo>
                  <a:lnTo>
                    <a:pt x="610141" y="469797"/>
                  </a:lnTo>
                  <a:lnTo>
                    <a:pt x="615420" y="472783"/>
                  </a:lnTo>
                  <a:cubicBezTo>
                    <a:pt x="615813" y="475330"/>
                    <a:pt x="615385" y="484228"/>
                    <a:pt x="614736" y="486146"/>
                  </a:cubicBezTo>
                  <a:cubicBezTo>
                    <a:pt x="613428" y="489982"/>
                    <a:pt x="607949" y="501238"/>
                    <a:pt x="603676" y="503470"/>
                  </a:cubicBezTo>
                  <a:lnTo>
                    <a:pt x="603676" y="507935"/>
                  </a:lnTo>
                  <a:cubicBezTo>
                    <a:pt x="605777" y="509884"/>
                    <a:pt x="610495" y="511834"/>
                    <a:pt x="613585" y="511645"/>
                  </a:cubicBezTo>
                  <a:cubicBezTo>
                    <a:pt x="617068" y="514789"/>
                    <a:pt x="622200" y="520480"/>
                    <a:pt x="620717" y="525259"/>
                  </a:cubicBezTo>
                  <a:cubicBezTo>
                    <a:pt x="616840" y="527271"/>
                    <a:pt x="612793" y="532616"/>
                    <a:pt x="611221" y="536232"/>
                  </a:cubicBez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76" name="자유형: 도형 317"/>
            <p:cNvSpPr/>
            <p:nvPr/>
          </p:nvSpPr>
          <p:spPr>
            <a:xfrm>
              <a:off x="6449400" y="779760"/>
              <a:ext cx="505440" cy="224640"/>
            </a:xfrm>
            <a:custGeom>
              <a:avLst/>
              <a:gdLst/>
              <a:ahLst/>
              <a:cxnLst/>
              <a:rect l="l" t="t" r="r" b="b"/>
              <a:pathLst>
                <a:path w="400500" h="183051">
                  <a:moveTo>
                    <a:pt x="400500" y="0"/>
                  </a:moveTo>
                  <a:cubicBezTo>
                    <a:pt x="388816" y="9275"/>
                    <a:pt x="375224" y="19745"/>
                    <a:pt x="359576" y="23109"/>
                  </a:cubicBezTo>
                  <a:cubicBezTo>
                    <a:pt x="351330" y="24870"/>
                    <a:pt x="341845" y="24430"/>
                    <a:pt x="333486" y="24524"/>
                  </a:cubicBezTo>
                  <a:cubicBezTo>
                    <a:pt x="324201" y="24618"/>
                    <a:pt x="312630" y="24650"/>
                    <a:pt x="303643" y="22103"/>
                  </a:cubicBezTo>
                  <a:cubicBezTo>
                    <a:pt x="292748" y="19022"/>
                    <a:pt x="283993" y="9998"/>
                    <a:pt x="273270" y="8992"/>
                  </a:cubicBezTo>
                  <a:cubicBezTo>
                    <a:pt x="270095" y="8709"/>
                    <a:pt x="267373" y="8898"/>
                    <a:pt x="264136" y="8332"/>
                  </a:cubicBezTo>
                  <a:cubicBezTo>
                    <a:pt x="263385" y="8206"/>
                    <a:pt x="262978" y="7986"/>
                    <a:pt x="262213" y="8017"/>
                  </a:cubicBezTo>
                  <a:cubicBezTo>
                    <a:pt x="256741" y="8112"/>
                    <a:pt x="251122" y="9181"/>
                    <a:pt x="245643" y="9495"/>
                  </a:cubicBezTo>
                  <a:cubicBezTo>
                    <a:pt x="236734" y="10030"/>
                    <a:pt x="228603" y="9967"/>
                    <a:pt x="219718" y="8992"/>
                  </a:cubicBezTo>
                  <a:lnTo>
                    <a:pt x="201460" y="7011"/>
                  </a:lnTo>
                  <a:cubicBezTo>
                    <a:pt x="200124" y="6980"/>
                    <a:pt x="199398" y="7326"/>
                    <a:pt x="198079" y="7515"/>
                  </a:cubicBezTo>
                  <a:cubicBezTo>
                    <a:pt x="191442" y="8489"/>
                    <a:pt x="185451" y="9652"/>
                    <a:pt x="181888" y="15438"/>
                  </a:cubicBezTo>
                  <a:cubicBezTo>
                    <a:pt x="178857" y="44395"/>
                    <a:pt x="208574" y="53985"/>
                    <a:pt x="209044" y="72881"/>
                  </a:cubicBezTo>
                  <a:cubicBezTo>
                    <a:pt x="209268" y="81904"/>
                    <a:pt x="202790" y="91809"/>
                    <a:pt x="195995" y="98034"/>
                  </a:cubicBezTo>
                  <a:cubicBezTo>
                    <a:pt x="191590" y="102090"/>
                    <a:pt x="185725" y="108158"/>
                    <a:pt x="179586" y="110265"/>
                  </a:cubicBezTo>
                  <a:cubicBezTo>
                    <a:pt x="174367" y="112026"/>
                    <a:pt x="168137" y="110013"/>
                    <a:pt x="164626" y="106303"/>
                  </a:cubicBezTo>
                  <a:cubicBezTo>
                    <a:pt x="162206" y="103756"/>
                    <a:pt x="160421" y="100361"/>
                    <a:pt x="158179" y="97625"/>
                  </a:cubicBezTo>
                  <a:cubicBezTo>
                    <a:pt x="148705" y="86149"/>
                    <a:pt x="135765" y="84892"/>
                    <a:pt x="121576" y="90205"/>
                  </a:cubicBezTo>
                  <a:cubicBezTo>
                    <a:pt x="110004" y="94544"/>
                    <a:pt x="109640" y="111491"/>
                    <a:pt x="106623" y="120169"/>
                  </a:cubicBezTo>
                  <a:lnTo>
                    <a:pt x="103550" y="125922"/>
                  </a:lnTo>
                  <a:cubicBezTo>
                    <a:pt x="102950" y="127055"/>
                    <a:pt x="102937" y="127872"/>
                    <a:pt x="102014" y="128815"/>
                  </a:cubicBezTo>
                  <a:cubicBezTo>
                    <a:pt x="97454" y="133437"/>
                    <a:pt x="87850" y="140291"/>
                    <a:pt x="82445" y="144662"/>
                  </a:cubicBezTo>
                  <a:cubicBezTo>
                    <a:pt x="79653" y="151673"/>
                    <a:pt x="78355" y="161011"/>
                    <a:pt x="76008" y="166702"/>
                  </a:cubicBezTo>
                  <a:cubicBezTo>
                    <a:pt x="75517" y="167897"/>
                    <a:pt x="74889" y="168400"/>
                    <a:pt x="74170" y="169500"/>
                  </a:cubicBezTo>
                  <a:lnTo>
                    <a:pt x="70490" y="175128"/>
                  </a:lnTo>
                  <a:cubicBezTo>
                    <a:pt x="66646" y="179436"/>
                    <a:pt x="54222" y="182737"/>
                    <a:pt x="48613" y="183051"/>
                  </a:cubicBezTo>
                  <a:lnTo>
                    <a:pt x="29742" y="183051"/>
                  </a:lnTo>
                  <a:cubicBezTo>
                    <a:pt x="19899" y="183051"/>
                    <a:pt x="9790" y="182706"/>
                    <a:pt x="0" y="181637"/>
                  </a:cubicBez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77" name="자유형: 도형 318"/>
            <p:cNvSpPr/>
            <p:nvPr/>
          </p:nvSpPr>
          <p:spPr>
            <a:xfrm>
              <a:off x="6446520" y="1002960"/>
              <a:ext cx="26280" cy="150480"/>
            </a:xfrm>
            <a:custGeom>
              <a:avLst/>
              <a:gdLst/>
              <a:ahLst/>
              <a:cxnLst/>
              <a:rect l="l" t="t" r="r" b="b"/>
              <a:pathLst>
                <a:path w="21040" h="122746">
                  <a:moveTo>
                    <a:pt x="2106" y="0"/>
                  </a:moveTo>
                  <a:cubicBezTo>
                    <a:pt x="1088" y="1383"/>
                    <a:pt x="1103" y="3301"/>
                    <a:pt x="941" y="4873"/>
                  </a:cubicBezTo>
                  <a:cubicBezTo>
                    <a:pt x="-171" y="15595"/>
                    <a:pt x="13372" y="19148"/>
                    <a:pt x="15737" y="28140"/>
                  </a:cubicBezTo>
                  <a:cubicBezTo>
                    <a:pt x="14155" y="35277"/>
                    <a:pt x="4898" y="39333"/>
                    <a:pt x="3323" y="46470"/>
                  </a:cubicBezTo>
                  <a:lnTo>
                    <a:pt x="4091" y="49426"/>
                  </a:lnTo>
                  <a:lnTo>
                    <a:pt x="5624" y="55368"/>
                  </a:lnTo>
                  <a:cubicBezTo>
                    <a:pt x="5382" y="57726"/>
                    <a:pt x="4593" y="58953"/>
                    <a:pt x="3937" y="61216"/>
                  </a:cubicBezTo>
                  <a:cubicBezTo>
                    <a:pt x="1439" y="69894"/>
                    <a:pt x="-2493" y="78226"/>
                    <a:pt x="2169" y="86810"/>
                  </a:cubicBezTo>
                  <a:cubicBezTo>
                    <a:pt x="5898" y="89891"/>
                    <a:pt x="13057" y="92312"/>
                    <a:pt x="17817" y="93507"/>
                  </a:cubicBezTo>
                  <a:lnTo>
                    <a:pt x="21040" y="97939"/>
                  </a:lnTo>
                  <a:lnTo>
                    <a:pt x="12075" y="122747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78" name="자유형: 도형 319"/>
            <p:cNvSpPr/>
            <p:nvPr/>
          </p:nvSpPr>
          <p:spPr>
            <a:xfrm>
              <a:off x="7879680" y="182160"/>
              <a:ext cx="495720" cy="503640"/>
            </a:xfrm>
            <a:custGeom>
              <a:avLst/>
              <a:gdLst/>
              <a:ahLst/>
              <a:cxnLst/>
              <a:rect l="l" t="t" r="r" b="b"/>
              <a:pathLst>
                <a:path w="392815" h="410232">
                  <a:moveTo>
                    <a:pt x="213246" y="410232"/>
                  </a:moveTo>
                  <a:cubicBezTo>
                    <a:pt x="213246" y="410232"/>
                    <a:pt x="212215" y="358889"/>
                    <a:pt x="212215" y="354959"/>
                  </a:cubicBezTo>
                  <a:cubicBezTo>
                    <a:pt x="212215" y="351028"/>
                    <a:pt x="212215" y="340024"/>
                    <a:pt x="214846" y="336094"/>
                  </a:cubicBezTo>
                  <a:cubicBezTo>
                    <a:pt x="217476" y="332164"/>
                    <a:pt x="224492" y="320373"/>
                    <a:pt x="224492" y="320373"/>
                  </a:cubicBezTo>
                  <a:lnTo>
                    <a:pt x="211338" y="304652"/>
                  </a:lnTo>
                  <a:cubicBezTo>
                    <a:pt x="211338" y="304652"/>
                    <a:pt x="193800" y="305439"/>
                    <a:pt x="190292" y="300722"/>
                  </a:cubicBezTo>
                  <a:cubicBezTo>
                    <a:pt x="186784" y="296006"/>
                    <a:pt x="175384" y="288932"/>
                    <a:pt x="170123" y="290504"/>
                  </a:cubicBezTo>
                  <a:cubicBezTo>
                    <a:pt x="164861" y="292076"/>
                    <a:pt x="151707" y="296006"/>
                    <a:pt x="144692" y="296792"/>
                  </a:cubicBezTo>
                  <a:cubicBezTo>
                    <a:pt x="137677" y="297578"/>
                    <a:pt x="128907" y="293648"/>
                    <a:pt x="124523" y="291290"/>
                  </a:cubicBezTo>
                  <a:cubicBezTo>
                    <a:pt x="120138" y="288932"/>
                    <a:pt x="114000" y="285002"/>
                    <a:pt x="114000" y="278713"/>
                  </a:cubicBezTo>
                  <a:cubicBezTo>
                    <a:pt x="114000" y="272425"/>
                    <a:pt x="114000" y="268495"/>
                    <a:pt x="111369" y="259063"/>
                  </a:cubicBezTo>
                  <a:cubicBezTo>
                    <a:pt x="108738" y="249630"/>
                    <a:pt x="107861" y="237054"/>
                    <a:pt x="114877" y="233909"/>
                  </a:cubicBezTo>
                  <a:cubicBezTo>
                    <a:pt x="121892" y="230765"/>
                    <a:pt x="130661" y="220547"/>
                    <a:pt x="130661" y="220547"/>
                  </a:cubicBezTo>
                  <a:lnTo>
                    <a:pt x="149077" y="197752"/>
                  </a:lnTo>
                  <a:cubicBezTo>
                    <a:pt x="149077" y="197752"/>
                    <a:pt x="155215" y="191464"/>
                    <a:pt x="155215" y="182031"/>
                  </a:cubicBezTo>
                  <a:cubicBezTo>
                    <a:pt x="155215" y="172599"/>
                    <a:pt x="157846" y="160022"/>
                    <a:pt x="152584" y="156878"/>
                  </a:cubicBezTo>
                  <a:cubicBezTo>
                    <a:pt x="147323" y="153734"/>
                    <a:pt x="136800" y="144302"/>
                    <a:pt x="136800" y="144302"/>
                  </a:cubicBezTo>
                  <a:cubicBezTo>
                    <a:pt x="136800" y="144302"/>
                    <a:pt x="127154" y="139585"/>
                    <a:pt x="123646" y="139585"/>
                  </a:cubicBezTo>
                  <a:cubicBezTo>
                    <a:pt x="120138" y="139585"/>
                    <a:pt x="99969" y="140371"/>
                    <a:pt x="94708" y="140371"/>
                  </a:cubicBezTo>
                  <a:cubicBezTo>
                    <a:pt x="89446" y="140371"/>
                    <a:pt x="84184" y="141158"/>
                    <a:pt x="78046" y="132511"/>
                  </a:cubicBezTo>
                  <a:cubicBezTo>
                    <a:pt x="71908" y="123865"/>
                    <a:pt x="64892" y="112860"/>
                    <a:pt x="54369" y="112074"/>
                  </a:cubicBezTo>
                  <a:cubicBezTo>
                    <a:pt x="43846" y="111288"/>
                    <a:pt x="35077" y="105000"/>
                    <a:pt x="32446" y="101856"/>
                  </a:cubicBezTo>
                  <a:cubicBezTo>
                    <a:pt x="29815" y="98712"/>
                    <a:pt x="10523" y="80633"/>
                    <a:pt x="10523" y="80633"/>
                  </a:cubicBezTo>
                  <a:cubicBezTo>
                    <a:pt x="10523" y="80633"/>
                    <a:pt x="11400" y="73559"/>
                    <a:pt x="7892" y="68056"/>
                  </a:cubicBezTo>
                  <a:cubicBezTo>
                    <a:pt x="4385" y="62554"/>
                    <a:pt x="0" y="52336"/>
                    <a:pt x="0" y="52336"/>
                  </a:cubicBezTo>
                  <a:lnTo>
                    <a:pt x="1754" y="24825"/>
                  </a:lnTo>
                  <a:lnTo>
                    <a:pt x="35954" y="6746"/>
                  </a:lnTo>
                  <a:cubicBezTo>
                    <a:pt x="35954" y="6746"/>
                    <a:pt x="54369" y="-3473"/>
                    <a:pt x="64015" y="1244"/>
                  </a:cubicBezTo>
                  <a:cubicBezTo>
                    <a:pt x="73661" y="5960"/>
                    <a:pt x="86815" y="5174"/>
                    <a:pt x="92954" y="4388"/>
                  </a:cubicBezTo>
                  <a:cubicBezTo>
                    <a:pt x="99092" y="3602"/>
                    <a:pt x="109615" y="4388"/>
                    <a:pt x="115754" y="9890"/>
                  </a:cubicBezTo>
                  <a:cubicBezTo>
                    <a:pt x="121892" y="15392"/>
                    <a:pt x="134169" y="18536"/>
                    <a:pt x="142938" y="16964"/>
                  </a:cubicBezTo>
                  <a:cubicBezTo>
                    <a:pt x="151707" y="15392"/>
                    <a:pt x="173630" y="8318"/>
                    <a:pt x="176261" y="20108"/>
                  </a:cubicBezTo>
                  <a:cubicBezTo>
                    <a:pt x="178892" y="31899"/>
                    <a:pt x="187661" y="41331"/>
                    <a:pt x="187661" y="41331"/>
                  </a:cubicBezTo>
                  <a:lnTo>
                    <a:pt x="220107" y="40545"/>
                  </a:lnTo>
                  <a:cubicBezTo>
                    <a:pt x="220107" y="40545"/>
                    <a:pt x="230630" y="29541"/>
                    <a:pt x="234138" y="24825"/>
                  </a:cubicBezTo>
                  <a:cubicBezTo>
                    <a:pt x="237646" y="20108"/>
                    <a:pt x="249046" y="20108"/>
                    <a:pt x="257815" y="24825"/>
                  </a:cubicBezTo>
                  <a:cubicBezTo>
                    <a:pt x="266584" y="29541"/>
                    <a:pt x="274476" y="35829"/>
                    <a:pt x="276230" y="41331"/>
                  </a:cubicBezTo>
                  <a:cubicBezTo>
                    <a:pt x="277984" y="46833"/>
                    <a:pt x="304292" y="119935"/>
                    <a:pt x="305169" y="123865"/>
                  </a:cubicBezTo>
                  <a:cubicBezTo>
                    <a:pt x="306046" y="127795"/>
                    <a:pt x="306922" y="152162"/>
                    <a:pt x="303415" y="157664"/>
                  </a:cubicBezTo>
                  <a:cubicBezTo>
                    <a:pt x="299907" y="163166"/>
                    <a:pt x="298153" y="170241"/>
                    <a:pt x="298153" y="178101"/>
                  </a:cubicBezTo>
                  <a:cubicBezTo>
                    <a:pt x="298153" y="185961"/>
                    <a:pt x="298153" y="217403"/>
                    <a:pt x="298153" y="217403"/>
                  </a:cubicBezTo>
                  <a:cubicBezTo>
                    <a:pt x="298153" y="217403"/>
                    <a:pt x="291138" y="224477"/>
                    <a:pt x="288507" y="229193"/>
                  </a:cubicBezTo>
                  <a:cubicBezTo>
                    <a:pt x="285876" y="233909"/>
                    <a:pt x="282369" y="248844"/>
                    <a:pt x="291138" y="255132"/>
                  </a:cubicBezTo>
                  <a:cubicBezTo>
                    <a:pt x="299907" y="261421"/>
                    <a:pt x="313061" y="269281"/>
                    <a:pt x="320076" y="273211"/>
                  </a:cubicBezTo>
                  <a:cubicBezTo>
                    <a:pt x="327092" y="277141"/>
                    <a:pt x="336738" y="283430"/>
                    <a:pt x="335861" y="290504"/>
                  </a:cubicBezTo>
                  <a:cubicBezTo>
                    <a:pt x="334984" y="297578"/>
                    <a:pt x="334107" y="305439"/>
                    <a:pt x="336738" y="309369"/>
                  </a:cubicBezTo>
                  <a:cubicBezTo>
                    <a:pt x="339369" y="313299"/>
                    <a:pt x="344630" y="318015"/>
                    <a:pt x="348138" y="319587"/>
                  </a:cubicBezTo>
                  <a:cubicBezTo>
                    <a:pt x="351645" y="321159"/>
                    <a:pt x="358661" y="321945"/>
                    <a:pt x="361292" y="327447"/>
                  </a:cubicBezTo>
                  <a:cubicBezTo>
                    <a:pt x="363922" y="332950"/>
                    <a:pt x="371815" y="335308"/>
                    <a:pt x="371815" y="335308"/>
                  </a:cubicBezTo>
                  <a:lnTo>
                    <a:pt x="392815" y="337257"/>
                  </a:lnTo>
                </a:path>
              </a:pathLst>
            </a:custGeom>
            <a:noFill/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79" name="자유형: 도형 320"/>
            <p:cNvSpPr/>
            <p:nvPr/>
          </p:nvSpPr>
          <p:spPr>
            <a:xfrm>
              <a:off x="10746000" y="1694520"/>
              <a:ext cx="98280" cy="44280"/>
            </a:xfrm>
            <a:custGeom>
              <a:avLst/>
              <a:gdLst/>
              <a:ahLst/>
              <a:cxnLst/>
              <a:rect l="l" t="t" r="r" b="b"/>
              <a:pathLst>
                <a:path w="78171" h="36345">
                  <a:moveTo>
                    <a:pt x="3949" y="36346"/>
                  </a:moveTo>
                  <a:cubicBezTo>
                    <a:pt x="3282" y="34397"/>
                    <a:pt x="2090" y="32321"/>
                    <a:pt x="161" y="29932"/>
                  </a:cubicBezTo>
                  <a:cubicBezTo>
                    <a:pt x="-295" y="26914"/>
                    <a:pt x="231" y="22826"/>
                    <a:pt x="1599" y="19997"/>
                  </a:cubicBezTo>
                  <a:cubicBezTo>
                    <a:pt x="4931" y="19179"/>
                    <a:pt x="7772" y="17198"/>
                    <a:pt x="10859" y="16349"/>
                  </a:cubicBezTo>
                  <a:cubicBezTo>
                    <a:pt x="11350" y="16192"/>
                    <a:pt x="13525" y="16507"/>
                    <a:pt x="14016" y="16349"/>
                  </a:cubicBezTo>
                  <a:cubicBezTo>
                    <a:pt x="20049" y="14526"/>
                    <a:pt x="25872" y="8552"/>
                    <a:pt x="32466" y="8238"/>
                  </a:cubicBezTo>
                  <a:cubicBezTo>
                    <a:pt x="35658" y="8080"/>
                    <a:pt x="41516" y="9464"/>
                    <a:pt x="44638" y="10312"/>
                  </a:cubicBezTo>
                  <a:cubicBezTo>
                    <a:pt x="49233" y="8269"/>
                    <a:pt x="52671" y="4810"/>
                    <a:pt x="57266" y="2735"/>
                  </a:cubicBezTo>
                  <a:cubicBezTo>
                    <a:pt x="61089" y="2672"/>
                    <a:pt x="65509" y="3364"/>
                    <a:pt x="69192" y="3018"/>
                  </a:cubicBezTo>
                  <a:cubicBezTo>
                    <a:pt x="72033" y="2735"/>
                    <a:pt x="75050" y="1446"/>
                    <a:pt x="78171" y="0"/>
                  </a:cubicBez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80" name="자유형: 도형 321"/>
            <p:cNvSpPr/>
            <p:nvPr/>
          </p:nvSpPr>
          <p:spPr>
            <a:xfrm>
              <a:off x="4585680" y="1045080"/>
              <a:ext cx="142920" cy="75600"/>
            </a:xfrm>
            <a:custGeom>
              <a:avLst/>
              <a:gdLst/>
              <a:ahLst/>
              <a:cxnLst/>
              <a:rect l="l" t="t" r="r" b="b"/>
              <a:pathLst>
                <a:path w="113508" h="61842">
                  <a:moveTo>
                    <a:pt x="101134" y="6631"/>
                  </a:moveTo>
                  <a:cubicBezTo>
                    <a:pt x="104445" y="14335"/>
                    <a:pt x="112421" y="13989"/>
                    <a:pt x="113509" y="26188"/>
                  </a:cubicBezTo>
                  <a:cubicBezTo>
                    <a:pt x="112548" y="28924"/>
                    <a:pt x="110008" y="32288"/>
                    <a:pt x="107433" y="34017"/>
                  </a:cubicBezTo>
                  <a:cubicBezTo>
                    <a:pt x="96612" y="31345"/>
                    <a:pt x="93715" y="38890"/>
                    <a:pt x="87015" y="38199"/>
                  </a:cubicBezTo>
                  <a:cubicBezTo>
                    <a:pt x="83999" y="34740"/>
                    <a:pt x="82690" y="29426"/>
                    <a:pt x="78267" y="27226"/>
                  </a:cubicBezTo>
                  <a:lnTo>
                    <a:pt x="73163" y="26974"/>
                  </a:lnTo>
                  <a:cubicBezTo>
                    <a:pt x="72030" y="29364"/>
                    <a:pt x="68010" y="32068"/>
                    <a:pt x="65141" y="32445"/>
                  </a:cubicBezTo>
                  <a:lnTo>
                    <a:pt x="58820" y="30621"/>
                  </a:lnTo>
                  <a:lnTo>
                    <a:pt x="53959" y="32445"/>
                  </a:lnTo>
                  <a:cubicBezTo>
                    <a:pt x="53534" y="34803"/>
                    <a:pt x="55414" y="38513"/>
                    <a:pt x="57361" y="40022"/>
                  </a:cubicBezTo>
                  <a:cubicBezTo>
                    <a:pt x="62770" y="42663"/>
                    <a:pt x="70171" y="42192"/>
                    <a:pt x="74619" y="46027"/>
                  </a:cubicBezTo>
                  <a:cubicBezTo>
                    <a:pt x="76159" y="48668"/>
                    <a:pt x="77513" y="51561"/>
                    <a:pt x="78509" y="54422"/>
                  </a:cubicBezTo>
                  <a:lnTo>
                    <a:pt x="76078" y="58856"/>
                  </a:lnTo>
                  <a:cubicBezTo>
                    <a:pt x="68270" y="63509"/>
                    <a:pt x="59764" y="58761"/>
                    <a:pt x="51531" y="59107"/>
                  </a:cubicBezTo>
                  <a:cubicBezTo>
                    <a:pt x="42197" y="59516"/>
                    <a:pt x="35996" y="64327"/>
                    <a:pt x="26087" y="60145"/>
                  </a:cubicBezTo>
                  <a:lnTo>
                    <a:pt x="22358" y="58604"/>
                  </a:lnTo>
                  <a:cubicBezTo>
                    <a:pt x="18086" y="55586"/>
                    <a:pt x="18875" y="49801"/>
                    <a:pt x="17012" y="45776"/>
                  </a:cubicBezTo>
                  <a:cubicBezTo>
                    <a:pt x="14553" y="40494"/>
                    <a:pt x="6240" y="36564"/>
                    <a:pt x="3157" y="32696"/>
                  </a:cubicBezTo>
                  <a:cubicBezTo>
                    <a:pt x="2013" y="31282"/>
                    <a:pt x="337" y="25936"/>
                    <a:pt x="0" y="24081"/>
                  </a:cubicBezTo>
                  <a:cubicBezTo>
                    <a:pt x="575" y="22415"/>
                    <a:pt x="3588" y="15026"/>
                    <a:pt x="4616" y="13895"/>
                  </a:cubicBezTo>
                  <a:cubicBezTo>
                    <a:pt x="5279" y="13140"/>
                    <a:pt x="10428" y="10122"/>
                    <a:pt x="11909" y="8927"/>
                  </a:cubicBezTo>
                  <a:cubicBezTo>
                    <a:pt x="22477" y="11033"/>
                    <a:pt x="24424" y="10656"/>
                    <a:pt x="34758" y="9713"/>
                  </a:cubicBezTo>
                  <a:cubicBezTo>
                    <a:pt x="36655" y="9524"/>
                    <a:pt x="39002" y="9776"/>
                    <a:pt x="40833" y="9430"/>
                  </a:cubicBezTo>
                  <a:cubicBezTo>
                    <a:pt x="45733" y="8518"/>
                    <a:pt x="50041" y="4808"/>
                    <a:pt x="54934" y="3425"/>
                  </a:cubicBezTo>
                  <a:cubicBezTo>
                    <a:pt x="57993" y="2576"/>
                    <a:pt x="62454" y="1632"/>
                    <a:pt x="65629" y="1349"/>
                  </a:cubicBezTo>
                  <a:cubicBezTo>
                    <a:pt x="67688" y="1161"/>
                    <a:pt x="69891" y="1538"/>
                    <a:pt x="71950" y="1349"/>
                  </a:cubicBezTo>
                  <a:cubicBezTo>
                    <a:pt x="73721" y="1192"/>
                    <a:pt x="75524" y="500"/>
                    <a:pt x="77295" y="281"/>
                  </a:cubicBezTo>
                  <a:cubicBezTo>
                    <a:pt x="85500" y="-663"/>
                    <a:pt x="94413" y="783"/>
                    <a:pt x="101604" y="4462"/>
                  </a:cubicBezTo>
                  <a:lnTo>
                    <a:pt x="101134" y="6631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81" name="자유형: 도형 322"/>
            <p:cNvSpPr/>
            <p:nvPr/>
          </p:nvSpPr>
          <p:spPr>
            <a:xfrm>
              <a:off x="4654440" y="1200960"/>
              <a:ext cx="61920" cy="57600"/>
            </a:xfrm>
            <a:custGeom>
              <a:avLst/>
              <a:gdLst/>
              <a:ahLst/>
              <a:cxnLst/>
              <a:rect l="l" t="t" r="r" b="b"/>
              <a:pathLst>
                <a:path w="49376" h="47067">
                  <a:moveTo>
                    <a:pt x="36210" y="0"/>
                  </a:moveTo>
                  <a:cubicBezTo>
                    <a:pt x="39788" y="31"/>
                    <a:pt x="44407" y="1415"/>
                    <a:pt x="47392" y="3144"/>
                  </a:cubicBezTo>
                  <a:cubicBezTo>
                    <a:pt x="49058" y="5093"/>
                    <a:pt x="49837" y="9181"/>
                    <a:pt x="49094" y="11507"/>
                  </a:cubicBezTo>
                  <a:cubicBezTo>
                    <a:pt x="46080" y="11665"/>
                    <a:pt x="41678" y="13142"/>
                    <a:pt x="39370" y="14903"/>
                  </a:cubicBezTo>
                  <a:cubicBezTo>
                    <a:pt x="37448" y="18896"/>
                    <a:pt x="38956" y="20688"/>
                    <a:pt x="39128" y="24304"/>
                  </a:cubicBezTo>
                  <a:cubicBezTo>
                    <a:pt x="39283" y="27543"/>
                    <a:pt x="38528" y="31693"/>
                    <a:pt x="37430" y="34774"/>
                  </a:cubicBezTo>
                  <a:cubicBezTo>
                    <a:pt x="34312" y="36032"/>
                    <a:pt x="30699" y="36818"/>
                    <a:pt x="27707" y="38169"/>
                  </a:cubicBezTo>
                  <a:cubicBezTo>
                    <a:pt x="23266" y="40182"/>
                    <a:pt x="19594" y="44018"/>
                    <a:pt x="16041" y="47068"/>
                  </a:cubicBezTo>
                  <a:lnTo>
                    <a:pt x="10207" y="46282"/>
                  </a:lnTo>
                  <a:cubicBezTo>
                    <a:pt x="9874" y="41125"/>
                    <a:pt x="5682" y="33422"/>
                    <a:pt x="730" y="30592"/>
                  </a:cubicBezTo>
                  <a:lnTo>
                    <a:pt x="0" y="26662"/>
                  </a:lnTo>
                  <a:cubicBezTo>
                    <a:pt x="6195" y="27322"/>
                    <a:pt x="15388" y="23550"/>
                    <a:pt x="18475" y="18550"/>
                  </a:cubicBezTo>
                  <a:cubicBezTo>
                    <a:pt x="19818" y="16412"/>
                    <a:pt x="21586" y="7923"/>
                    <a:pt x="22119" y="5502"/>
                  </a:cubicBezTo>
                  <a:cubicBezTo>
                    <a:pt x="25410" y="1855"/>
                    <a:pt x="31653" y="126"/>
                    <a:pt x="36704" y="0"/>
                  </a:cubicBezTo>
                  <a:lnTo>
                    <a:pt x="36210" y="0"/>
                  </a:lnTo>
                  <a:lnTo>
                    <a:pt x="36210" y="0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82" name="자유형: 도형 323"/>
            <p:cNvSpPr/>
            <p:nvPr/>
          </p:nvSpPr>
          <p:spPr>
            <a:xfrm>
              <a:off x="4717800" y="1272600"/>
              <a:ext cx="41040" cy="28800"/>
            </a:xfrm>
            <a:custGeom>
              <a:avLst/>
              <a:gdLst/>
              <a:ahLst/>
              <a:cxnLst/>
              <a:rect l="l" t="t" r="r" b="b"/>
              <a:pathLst>
                <a:path w="32814" h="23801">
                  <a:moveTo>
                    <a:pt x="12151" y="0"/>
                  </a:moveTo>
                  <a:cubicBezTo>
                    <a:pt x="17963" y="1384"/>
                    <a:pt x="24592" y="723"/>
                    <a:pt x="29896" y="3427"/>
                  </a:cubicBezTo>
                  <a:lnTo>
                    <a:pt x="32814" y="7860"/>
                  </a:lnTo>
                  <a:lnTo>
                    <a:pt x="31843" y="11508"/>
                  </a:lnTo>
                  <a:cubicBezTo>
                    <a:pt x="27816" y="14620"/>
                    <a:pt x="21958" y="14620"/>
                    <a:pt x="17261" y="16758"/>
                  </a:cubicBezTo>
                  <a:cubicBezTo>
                    <a:pt x="12894" y="18739"/>
                    <a:pt x="8482" y="21412"/>
                    <a:pt x="4378" y="23801"/>
                  </a:cubicBezTo>
                  <a:lnTo>
                    <a:pt x="246" y="21977"/>
                  </a:lnTo>
                  <a:lnTo>
                    <a:pt x="0" y="16758"/>
                  </a:lnTo>
                  <a:cubicBezTo>
                    <a:pt x="6261" y="13048"/>
                    <a:pt x="5546" y="7703"/>
                    <a:pt x="8264" y="3679"/>
                  </a:cubicBezTo>
                  <a:cubicBezTo>
                    <a:pt x="8366" y="3521"/>
                    <a:pt x="12112" y="126"/>
                    <a:pt x="12151" y="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83" name="자유형: 도형 324"/>
            <p:cNvSpPr/>
            <p:nvPr/>
          </p:nvSpPr>
          <p:spPr>
            <a:xfrm>
              <a:off x="5715360" y="1389240"/>
              <a:ext cx="26640" cy="28800"/>
            </a:xfrm>
            <a:custGeom>
              <a:avLst/>
              <a:gdLst/>
              <a:ahLst/>
              <a:cxnLst/>
              <a:rect l="l" t="t" r="r" b="b"/>
              <a:pathLst>
                <a:path w="21478" h="23835">
                  <a:moveTo>
                    <a:pt x="3494" y="23836"/>
                  </a:moveTo>
                  <a:cubicBezTo>
                    <a:pt x="2000" y="21321"/>
                    <a:pt x="-512" y="7392"/>
                    <a:pt x="92" y="4751"/>
                  </a:cubicBezTo>
                  <a:cubicBezTo>
                    <a:pt x="137" y="4531"/>
                    <a:pt x="2281" y="726"/>
                    <a:pt x="2519" y="286"/>
                  </a:cubicBezTo>
                  <a:cubicBezTo>
                    <a:pt x="8342" y="-563"/>
                    <a:pt x="16273" y="475"/>
                    <a:pt x="21236" y="3430"/>
                  </a:cubicBezTo>
                  <a:lnTo>
                    <a:pt x="21478" y="8681"/>
                  </a:lnTo>
                  <a:cubicBezTo>
                    <a:pt x="20384" y="10379"/>
                    <a:pt x="13716" y="17139"/>
                    <a:pt x="11520" y="18491"/>
                  </a:cubicBezTo>
                  <a:cubicBezTo>
                    <a:pt x="8612" y="20314"/>
                    <a:pt x="5841" y="21226"/>
                    <a:pt x="3494" y="23836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84" name="자유형: 도형 325"/>
            <p:cNvSpPr/>
            <p:nvPr/>
          </p:nvSpPr>
          <p:spPr>
            <a:xfrm>
              <a:off x="6178320" y="1370520"/>
              <a:ext cx="14760" cy="12600"/>
            </a:xfrm>
            <a:custGeom>
              <a:avLst/>
              <a:gdLst/>
              <a:ahLst/>
              <a:cxnLst/>
              <a:rect l="l" t="t" r="r" b="b"/>
              <a:pathLst>
                <a:path w="11922" h="10438">
                  <a:moveTo>
                    <a:pt x="11923" y="7326"/>
                  </a:moveTo>
                  <a:lnTo>
                    <a:pt x="8022" y="10439"/>
                  </a:lnTo>
                  <a:lnTo>
                    <a:pt x="2676" y="8112"/>
                  </a:lnTo>
                  <a:lnTo>
                    <a:pt x="0" y="4433"/>
                  </a:lnTo>
                  <a:lnTo>
                    <a:pt x="2676" y="0"/>
                  </a:lnTo>
                  <a:lnTo>
                    <a:pt x="8268" y="1038"/>
                  </a:lnTo>
                  <a:cubicBezTo>
                    <a:pt x="9404" y="3176"/>
                    <a:pt x="10649" y="5251"/>
                    <a:pt x="11923" y="7326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85" name="자유형: 도형 326"/>
            <p:cNvSpPr/>
            <p:nvPr/>
          </p:nvSpPr>
          <p:spPr>
            <a:xfrm>
              <a:off x="6222960" y="1388520"/>
              <a:ext cx="37080" cy="20160"/>
            </a:xfrm>
            <a:custGeom>
              <a:avLst/>
              <a:gdLst/>
              <a:ahLst/>
              <a:cxnLst/>
              <a:rect l="l" t="t" r="r" b="b"/>
              <a:pathLst>
                <a:path w="29672" h="16772">
                  <a:moveTo>
                    <a:pt x="28679" y="5202"/>
                  </a:moveTo>
                  <a:cubicBezTo>
                    <a:pt x="30036" y="7560"/>
                    <a:pt x="29970" y="12056"/>
                    <a:pt x="28682" y="14414"/>
                  </a:cubicBezTo>
                  <a:lnTo>
                    <a:pt x="24305" y="16772"/>
                  </a:lnTo>
                  <a:lnTo>
                    <a:pt x="18229" y="16772"/>
                  </a:lnTo>
                  <a:cubicBezTo>
                    <a:pt x="15525" y="12779"/>
                    <a:pt x="7492" y="11742"/>
                    <a:pt x="2918" y="9698"/>
                  </a:cubicBezTo>
                  <a:lnTo>
                    <a:pt x="0" y="6051"/>
                  </a:lnTo>
                  <a:lnTo>
                    <a:pt x="1217" y="1335"/>
                  </a:lnTo>
                  <a:cubicBezTo>
                    <a:pt x="6886" y="-2407"/>
                    <a:pt x="24796" y="2907"/>
                    <a:pt x="24796" y="2907"/>
                  </a:cubicBezTo>
                  <a:lnTo>
                    <a:pt x="28679" y="5202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86" name="자유형: 도형 327"/>
            <p:cNvSpPr/>
            <p:nvPr/>
          </p:nvSpPr>
          <p:spPr>
            <a:xfrm>
              <a:off x="6284160" y="1411920"/>
              <a:ext cx="27360" cy="29520"/>
            </a:xfrm>
            <a:custGeom>
              <a:avLst/>
              <a:gdLst/>
              <a:ahLst/>
              <a:cxnLst/>
              <a:rect l="l" t="t" r="r" b="b"/>
              <a:pathLst>
                <a:path w="22083" h="24384">
                  <a:moveTo>
                    <a:pt x="16737" y="2106"/>
                  </a:moveTo>
                  <a:cubicBezTo>
                    <a:pt x="16846" y="4527"/>
                    <a:pt x="17250" y="9589"/>
                    <a:pt x="18197" y="11791"/>
                  </a:cubicBezTo>
                  <a:cubicBezTo>
                    <a:pt x="19565" y="14903"/>
                    <a:pt x="21795" y="15815"/>
                    <a:pt x="22083" y="20154"/>
                  </a:cubicBezTo>
                  <a:lnTo>
                    <a:pt x="20385" y="24336"/>
                  </a:lnTo>
                  <a:cubicBezTo>
                    <a:pt x="16681" y="24618"/>
                    <a:pt x="13240" y="23644"/>
                    <a:pt x="10013" y="22229"/>
                  </a:cubicBezTo>
                  <a:cubicBezTo>
                    <a:pt x="8168" y="21411"/>
                    <a:pt x="5088" y="20091"/>
                    <a:pt x="3615" y="18833"/>
                  </a:cubicBezTo>
                  <a:cubicBezTo>
                    <a:pt x="-135" y="15626"/>
                    <a:pt x="-517" y="9244"/>
                    <a:pt x="455" y="4968"/>
                  </a:cubicBezTo>
                  <a:cubicBezTo>
                    <a:pt x="2100" y="2767"/>
                    <a:pt x="6246" y="346"/>
                    <a:pt x="9206" y="0"/>
                  </a:cubicBezTo>
                  <a:cubicBezTo>
                    <a:pt x="10841" y="251"/>
                    <a:pt x="15436" y="1100"/>
                    <a:pt x="16737" y="2106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87" name="자유형: 도형 328"/>
            <p:cNvSpPr/>
            <p:nvPr/>
          </p:nvSpPr>
          <p:spPr>
            <a:xfrm>
              <a:off x="6266880" y="1231200"/>
              <a:ext cx="132120" cy="64080"/>
            </a:xfrm>
            <a:custGeom>
              <a:avLst/>
              <a:gdLst/>
              <a:ahLst/>
              <a:cxnLst/>
              <a:rect l="l" t="t" r="r" b="b"/>
              <a:pathLst>
                <a:path w="104968" h="52550">
                  <a:moveTo>
                    <a:pt x="61497" y="13846"/>
                  </a:moveTo>
                  <a:cubicBezTo>
                    <a:pt x="65783" y="14789"/>
                    <a:pt x="70701" y="15764"/>
                    <a:pt x="75110" y="15952"/>
                  </a:cubicBezTo>
                  <a:cubicBezTo>
                    <a:pt x="79190" y="16110"/>
                    <a:pt x="82638" y="15009"/>
                    <a:pt x="86535" y="14632"/>
                  </a:cubicBezTo>
                  <a:cubicBezTo>
                    <a:pt x="91210" y="14223"/>
                    <a:pt x="100302" y="14349"/>
                    <a:pt x="103550" y="17776"/>
                  </a:cubicBezTo>
                  <a:cubicBezTo>
                    <a:pt x="105332" y="22524"/>
                    <a:pt x="105711" y="28403"/>
                    <a:pt x="103063" y="32931"/>
                  </a:cubicBezTo>
                  <a:cubicBezTo>
                    <a:pt x="99997" y="38182"/>
                    <a:pt x="81294" y="51953"/>
                    <a:pt x="74626" y="52550"/>
                  </a:cubicBezTo>
                  <a:lnTo>
                    <a:pt x="70413" y="52204"/>
                  </a:lnTo>
                  <a:cubicBezTo>
                    <a:pt x="67477" y="51953"/>
                    <a:pt x="63815" y="51544"/>
                    <a:pt x="61013" y="50727"/>
                  </a:cubicBezTo>
                  <a:cubicBezTo>
                    <a:pt x="53825" y="48651"/>
                    <a:pt x="51991" y="45507"/>
                    <a:pt x="43025" y="44973"/>
                  </a:cubicBezTo>
                  <a:cubicBezTo>
                    <a:pt x="41657" y="44879"/>
                    <a:pt x="32892" y="45476"/>
                    <a:pt x="31601" y="45759"/>
                  </a:cubicBezTo>
                  <a:cubicBezTo>
                    <a:pt x="30043" y="46105"/>
                    <a:pt x="28265" y="47048"/>
                    <a:pt x="26739" y="47583"/>
                  </a:cubicBezTo>
                  <a:cubicBezTo>
                    <a:pt x="18324" y="50538"/>
                    <a:pt x="12782" y="52267"/>
                    <a:pt x="3648" y="49689"/>
                  </a:cubicBezTo>
                  <a:lnTo>
                    <a:pt x="0" y="46262"/>
                  </a:lnTo>
                  <a:cubicBezTo>
                    <a:pt x="1182" y="35761"/>
                    <a:pt x="7405" y="36484"/>
                    <a:pt x="11182" y="30070"/>
                  </a:cubicBezTo>
                  <a:cubicBezTo>
                    <a:pt x="11842" y="24725"/>
                    <a:pt x="10916" y="18436"/>
                    <a:pt x="12880" y="13343"/>
                  </a:cubicBezTo>
                  <a:cubicBezTo>
                    <a:pt x="14024" y="10388"/>
                    <a:pt x="16605" y="8627"/>
                    <a:pt x="16528" y="4979"/>
                  </a:cubicBezTo>
                  <a:cubicBezTo>
                    <a:pt x="23884" y="75"/>
                    <a:pt x="35133" y="-1655"/>
                    <a:pt x="43506" y="1835"/>
                  </a:cubicBezTo>
                  <a:cubicBezTo>
                    <a:pt x="47501" y="3502"/>
                    <a:pt x="48869" y="6112"/>
                    <a:pt x="51770" y="7841"/>
                  </a:cubicBezTo>
                  <a:lnTo>
                    <a:pt x="55334" y="9193"/>
                  </a:lnTo>
                  <a:cubicBezTo>
                    <a:pt x="57982" y="10167"/>
                    <a:pt x="59624" y="11928"/>
                    <a:pt x="61497" y="13846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88" name="자유형: 도형 329"/>
            <p:cNvSpPr/>
            <p:nvPr/>
          </p:nvSpPr>
          <p:spPr>
            <a:xfrm>
              <a:off x="6334920" y="1311120"/>
              <a:ext cx="104760" cy="99360"/>
            </a:xfrm>
            <a:custGeom>
              <a:avLst/>
              <a:gdLst/>
              <a:ahLst/>
              <a:cxnLst/>
              <a:rect l="l" t="t" r="r" b="b"/>
              <a:pathLst>
                <a:path w="83178" h="81252">
                  <a:moveTo>
                    <a:pt x="54446" y="80753"/>
                  </a:moveTo>
                  <a:cubicBezTo>
                    <a:pt x="53696" y="77640"/>
                    <a:pt x="51767" y="75439"/>
                    <a:pt x="49830" y="72893"/>
                  </a:cubicBezTo>
                  <a:cubicBezTo>
                    <a:pt x="45845" y="67673"/>
                    <a:pt x="44716" y="66793"/>
                    <a:pt x="38893" y="63240"/>
                  </a:cubicBezTo>
                  <a:cubicBezTo>
                    <a:pt x="37459" y="62360"/>
                    <a:pt x="36021" y="61102"/>
                    <a:pt x="34519" y="60348"/>
                  </a:cubicBezTo>
                  <a:cubicBezTo>
                    <a:pt x="31085" y="58650"/>
                    <a:pt x="27062" y="57675"/>
                    <a:pt x="23582" y="55914"/>
                  </a:cubicBezTo>
                  <a:cubicBezTo>
                    <a:pt x="22060" y="55128"/>
                    <a:pt x="20727" y="54059"/>
                    <a:pt x="19205" y="53305"/>
                  </a:cubicBezTo>
                  <a:cubicBezTo>
                    <a:pt x="15774" y="51544"/>
                    <a:pt x="12372" y="50349"/>
                    <a:pt x="9239" y="48054"/>
                  </a:cubicBezTo>
                  <a:cubicBezTo>
                    <a:pt x="5384" y="45256"/>
                    <a:pt x="2610" y="41357"/>
                    <a:pt x="0" y="37615"/>
                  </a:cubicBezTo>
                  <a:cubicBezTo>
                    <a:pt x="2996" y="36075"/>
                    <a:pt x="5928" y="34408"/>
                    <a:pt x="8752" y="32648"/>
                  </a:cubicBezTo>
                  <a:cubicBezTo>
                    <a:pt x="10264" y="29629"/>
                    <a:pt x="11505" y="25227"/>
                    <a:pt x="11428" y="21926"/>
                  </a:cubicBezTo>
                  <a:cubicBezTo>
                    <a:pt x="11393" y="20511"/>
                    <a:pt x="10632" y="18908"/>
                    <a:pt x="10456" y="17493"/>
                  </a:cubicBezTo>
                  <a:cubicBezTo>
                    <a:pt x="10029" y="14066"/>
                    <a:pt x="10127" y="10450"/>
                    <a:pt x="9969" y="7023"/>
                  </a:cubicBezTo>
                  <a:lnTo>
                    <a:pt x="13126" y="3376"/>
                  </a:lnTo>
                  <a:cubicBezTo>
                    <a:pt x="25315" y="5859"/>
                    <a:pt x="30405" y="-2441"/>
                    <a:pt x="38406" y="734"/>
                  </a:cubicBezTo>
                  <a:lnTo>
                    <a:pt x="39623" y="5451"/>
                  </a:lnTo>
                  <a:cubicBezTo>
                    <a:pt x="37164" y="7746"/>
                    <a:pt x="35091" y="11550"/>
                    <a:pt x="34277" y="14600"/>
                  </a:cubicBezTo>
                  <a:cubicBezTo>
                    <a:pt x="37571" y="19034"/>
                    <a:pt x="36859" y="18719"/>
                    <a:pt x="38651" y="23750"/>
                  </a:cubicBezTo>
                  <a:cubicBezTo>
                    <a:pt x="40160" y="27994"/>
                    <a:pt x="43110" y="31673"/>
                    <a:pt x="45944" y="35257"/>
                  </a:cubicBezTo>
                  <a:cubicBezTo>
                    <a:pt x="46782" y="36326"/>
                    <a:pt x="47845" y="38024"/>
                    <a:pt x="48859" y="38904"/>
                  </a:cubicBezTo>
                  <a:cubicBezTo>
                    <a:pt x="55955" y="45067"/>
                    <a:pt x="69119" y="43212"/>
                    <a:pt x="79484" y="53556"/>
                  </a:cubicBezTo>
                  <a:cubicBezTo>
                    <a:pt x="84472" y="58524"/>
                    <a:pt x="83869" y="63680"/>
                    <a:pt x="80866" y="69497"/>
                  </a:cubicBezTo>
                  <a:lnTo>
                    <a:pt x="79242" y="72641"/>
                  </a:lnTo>
                  <a:cubicBezTo>
                    <a:pt x="77373" y="74968"/>
                    <a:pt x="73644" y="76665"/>
                    <a:pt x="70982" y="78143"/>
                  </a:cubicBezTo>
                  <a:cubicBezTo>
                    <a:pt x="70480" y="78426"/>
                    <a:pt x="67141" y="80407"/>
                    <a:pt x="66846" y="80501"/>
                  </a:cubicBezTo>
                  <a:cubicBezTo>
                    <a:pt x="63465" y="81570"/>
                    <a:pt x="57901" y="81350"/>
                    <a:pt x="54446" y="80753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89" name="자유형: 도형 330"/>
            <p:cNvSpPr/>
            <p:nvPr/>
          </p:nvSpPr>
          <p:spPr>
            <a:xfrm>
              <a:off x="6376680" y="1517400"/>
              <a:ext cx="65880" cy="35280"/>
            </a:xfrm>
            <a:custGeom>
              <a:avLst/>
              <a:gdLst/>
              <a:ahLst/>
              <a:cxnLst/>
              <a:rect l="l" t="t" r="r" b="b"/>
              <a:pathLst>
                <a:path w="52344" h="29134">
                  <a:moveTo>
                    <a:pt x="14426" y="4433"/>
                  </a:moveTo>
                  <a:cubicBezTo>
                    <a:pt x="16913" y="9432"/>
                    <a:pt x="24875" y="15092"/>
                    <a:pt x="30712" y="16475"/>
                  </a:cubicBezTo>
                  <a:cubicBezTo>
                    <a:pt x="36942" y="17953"/>
                    <a:pt x="43108" y="16192"/>
                    <a:pt x="49429" y="18550"/>
                  </a:cubicBezTo>
                  <a:lnTo>
                    <a:pt x="52344" y="22481"/>
                  </a:lnTo>
                  <a:lnTo>
                    <a:pt x="49917" y="25625"/>
                  </a:lnTo>
                  <a:cubicBezTo>
                    <a:pt x="46444" y="26379"/>
                    <a:pt x="42544" y="27197"/>
                    <a:pt x="38980" y="27448"/>
                  </a:cubicBezTo>
                  <a:cubicBezTo>
                    <a:pt x="37072" y="27574"/>
                    <a:pt x="35041" y="27260"/>
                    <a:pt x="33143" y="27448"/>
                  </a:cubicBezTo>
                  <a:cubicBezTo>
                    <a:pt x="24784" y="28234"/>
                    <a:pt x="19505" y="30813"/>
                    <a:pt x="10781" y="27448"/>
                  </a:cubicBezTo>
                  <a:cubicBezTo>
                    <a:pt x="6955" y="24210"/>
                    <a:pt x="8477" y="21883"/>
                    <a:pt x="7137" y="18833"/>
                  </a:cubicBezTo>
                  <a:cubicBezTo>
                    <a:pt x="6930" y="18362"/>
                    <a:pt x="4643" y="15847"/>
                    <a:pt x="4219" y="15155"/>
                  </a:cubicBezTo>
                  <a:cubicBezTo>
                    <a:pt x="2002" y="11571"/>
                    <a:pt x="-499" y="5911"/>
                    <a:pt x="86" y="1824"/>
                  </a:cubicBezTo>
                  <a:lnTo>
                    <a:pt x="4948" y="0"/>
                  </a:lnTo>
                  <a:lnTo>
                    <a:pt x="11269" y="2075"/>
                  </a:lnTo>
                  <a:lnTo>
                    <a:pt x="14426" y="4433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90" name="자유형: 도형 331"/>
            <p:cNvSpPr/>
            <p:nvPr/>
          </p:nvSpPr>
          <p:spPr>
            <a:xfrm>
              <a:off x="6505920" y="1537200"/>
              <a:ext cx="33840" cy="19800"/>
            </a:xfrm>
            <a:custGeom>
              <a:avLst/>
              <a:gdLst/>
              <a:ahLst/>
              <a:cxnLst/>
              <a:rect l="l" t="t" r="r" b="b"/>
              <a:pathLst>
                <a:path w="27124" h="16376">
                  <a:moveTo>
                    <a:pt x="26750" y="7074"/>
                  </a:moveTo>
                  <a:cubicBezTo>
                    <a:pt x="22232" y="11979"/>
                    <a:pt x="9730" y="17356"/>
                    <a:pt x="2676" y="16223"/>
                  </a:cubicBezTo>
                  <a:lnTo>
                    <a:pt x="0" y="12293"/>
                  </a:lnTo>
                  <a:cubicBezTo>
                    <a:pt x="915" y="11224"/>
                    <a:pt x="2076" y="9495"/>
                    <a:pt x="3157" y="8646"/>
                  </a:cubicBezTo>
                  <a:cubicBezTo>
                    <a:pt x="5640" y="6666"/>
                    <a:pt x="17868" y="755"/>
                    <a:pt x="21148" y="0"/>
                  </a:cubicBezTo>
                  <a:lnTo>
                    <a:pt x="26490" y="2106"/>
                  </a:lnTo>
                  <a:cubicBezTo>
                    <a:pt x="27083" y="3333"/>
                    <a:pt x="27434" y="5785"/>
                    <a:pt x="26750" y="7074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91" name="자유형: 도형 332"/>
            <p:cNvSpPr/>
            <p:nvPr/>
          </p:nvSpPr>
          <p:spPr>
            <a:xfrm>
              <a:off x="5229720" y="1288800"/>
              <a:ext cx="122760" cy="85320"/>
            </a:xfrm>
            <a:custGeom>
              <a:avLst/>
              <a:gdLst/>
              <a:ahLst/>
              <a:cxnLst/>
              <a:rect l="l" t="t" r="r" b="b"/>
              <a:pathLst>
                <a:path w="97468" h="69857">
                  <a:moveTo>
                    <a:pt x="3157" y="68259"/>
                  </a:moveTo>
                  <a:lnTo>
                    <a:pt x="0" y="65618"/>
                  </a:lnTo>
                  <a:lnTo>
                    <a:pt x="730" y="60147"/>
                  </a:lnTo>
                  <a:cubicBezTo>
                    <a:pt x="9397" y="52696"/>
                    <a:pt x="18079" y="44867"/>
                    <a:pt x="25767" y="36629"/>
                  </a:cubicBezTo>
                  <a:cubicBezTo>
                    <a:pt x="27746" y="34491"/>
                    <a:pt x="36010" y="27448"/>
                    <a:pt x="36704" y="27197"/>
                  </a:cubicBezTo>
                  <a:lnTo>
                    <a:pt x="40349" y="30592"/>
                  </a:lnTo>
                  <a:cubicBezTo>
                    <a:pt x="46740" y="25593"/>
                    <a:pt x="42703" y="19965"/>
                    <a:pt x="53233" y="14903"/>
                  </a:cubicBezTo>
                  <a:cubicBezTo>
                    <a:pt x="57821" y="12702"/>
                    <a:pt x="63156" y="12042"/>
                    <a:pt x="67818" y="9936"/>
                  </a:cubicBezTo>
                  <a:cubicBezTo>
                    <a:pt x="69238" y="9307"/>
                    <a:pt x="70729" y="8080"/>
                    <a:pt x="72192" y="7609"/>
                  </a:cubicBezTo>
                  <a:cubicBezTo>
                    <a:pt x="79554" y="5093"/>
                    <a:pt x="84514" y="4779"/>
                    <a:pt x="91151" y="0"/>
                  </a:cubicBezTo>
                  <a:lnTo>
                    <a:pt x="96496" y="283"/>
                  </a:lnTo>
                  <a:lnTo>
                    <a:pt x="97468" y="4968"/>
                  </a:lnTo>
                  <a:cubicBezTo>
                    <a:pt x="91940" y="15815"/>
                    <a:pt x="81536" y="26757"/>
                    <a:pt x="69999" y="32950"/>
                  </a:cubicBezTo>
                  <a:cubicBezTo>
                    <a:pt x="67337" y="34397"/>
                    <a:pt x="64475" y="34680"/>
                    <a:pt x="61977" y="36629"/>
                  </a:cubicBezTo>
                  <a:cubicBezTo>
                    <a:pt x="57435" y="40151"/>
                    <a:pt x="53671" y="44490"/>
                    <a:pt x="48855" y="47854"/>
                  </a:cubicBezTo>
                  <a:cubicBezTo>
                    <a:pt x="46158" y="49740"/>
                    <a:pt x="43001" y="50841"/>
                    <a:pt x="40345" y="52570"/>
                  </a:cubicBezTo>
                  <a:cubicBezTo>
                    <a:pt x="34098" y="56626"/>
                    <a:pt x="28061" y="64989"/>
                    <a:pt x="21870" y="68511"/>
                  </a:cubicBezTo>
                  <a:cubicBezTo>
                    <a:pt x="17040" y="71246"/>
                    <a:pt x="8482" y="69108"/>
                    <a:pt x="3157" y="6825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92" name="자유형: 도형 333"/>
            <p:cNvSpPr/>
            <p:nvPr/>
          </p:nvSpPr>
          <p:spPr>
            <a:xfrm>
              <a:off x="6422400" y="1222920"/>
              <a:ext cx="182880" cy="250920"/>
            </a:xfrm>
            <a:custGeom>
              <a:avLst/>
              <a:gdLst/>
              <a:ahLst/>
              <a:cxnLst/>
              <a:rect l="l" t="t" r="r" b="b"/>
              <a:pathLst>
                <a:path w="145122" h="204683">
                  <a:moveTo>
                    <a:pt x="137830" y="145605"/>
                  </a:moveTo>
                  <a:cubicBezTo>
                    <a:pt x="140092" y="155289"/>
                    <a:pt x="130534" y="157364"/>
                    <a:pt x="144151" y="168369"/>
                  </a:cubicBezTo>
                  <a:lnTo>
                    <a:pt x="145122" y="173053"/>
                  </a:lnTo>
                  <a:cubicBezTo>
                    <a:pt x="140573" y="177612"/>
                    <a:pt x="131327" y="177738"/>
                    <a:pt x="128594" y="183775"/>
                  </a:cubicBezTo>
                  <a:cubicBezTo>
                    <a:pt x="126135" y="189214"/>
                    <a:pt x="128429" y="195282"/>
                    <a:pt x="123729" y="200250"/>
                  </a:cubicBezTo>
                  <a:cubicBezTo>
                    <a:pt x="120021" y="201948"/>
                    <a:pt x="115135" y="202891"/>
                    <a:pt x="111087" y="202168"/>
                  </a:cubicBezTo>
                  <a:lnTo>
                    <a:pt x="106226" y="201288"/>
                  </a:lnTo>
                  <a:cubicBezTo>
                    <a:pt x="100399" y="199212"/>
                    <a:pt x="96867" y="192044"/>
                    <a:pt x="89210" y="189780"/>
                  </a:cubicBezTo>
                  <a:cubicBezTo>
                    <a:pt x="86526" y="191226"/>
                    <a:pt x="83075" y="193239"/>
                    <a:pt x="80946" y="195282"/>
                  </a:cubicBezTo>
                  <a:cubicBezTo>
                    <a:pt x="79753" y="196445"/>
                    <a:pt x="78964" y="198049"/>
                    <a:pt x="77789" y="199212"/>
                  </a:cubicBezTo>
                  <a:cubicBezTo>
                    <a:pt x="75705" y="201288"/>
                    <a:pt x="72457" y="203300"/>
                    <a:pt x="69767" y="204683"/>
                  </a:cubicBezTo>
                  <a:cubicBezTo>
                    <a:pt x="65428" y="204337"/>
                    <a:pt x="59840" y="202703"/>
                    <a:pt x="55915" y="202608"/>
                  </a:cubicBezTo>
                  <a:cubicBezTo>
                    <a:pt x="52604" y="202545"/>
                    <a:pt x="48654" y="204589"/>
                    <a:pt x="45216" y="204432"/>
                  </a:cubicBezTo>
                  <a:cubicBezTo>
                    <a:pt x="30737" y="203834"/>
                    <a:pt x="6407" y="188019"/>
                    <a:pt x="6327" y="173839"/>
                  </a:cubicBezTo>
                  <a:lnTo>
                    <a:pt x="9003" y="170978"/>
                  </a:lnTo>
                  <a:cubicBezTo>
                    <a:pt x="15506" y="168243"/>
                    <a:pt x="24812" y="168526"/>
                    <a:pt x="30147" y="166796"/>
                  </a:cubicBezTo>
                  <a:cubicBezTo>
                    <a:pt x="32908" y="165885"/>
                    <a:pt x="36310" y="163464"/>
                    <a:pt x="38899" y="162080"/>
                  </a:cubicBezTo>
                  <a:cubicBezTo>
                    <a:pt x="40464" y="159533"/>
                    <a:pt x="41775" y="154251"/>
                    <a:pt x="41084" y="151359"/>
                  </a:cubicBezTo>
                  <a:cubicBezTo>
                    <a:pt x="40762" y="150007"/>
                    <a:pt x="35430" y="140826"/>
                    <a:pt x="34279" y="139600"/>
                  </a:cubicBezTo>
                  <a:cubicBezTo>
                    <a:pt x="33231" y="138468"/>
                    <a:pt x="31659" y="137619"/>
                    <a:pt x="30635" y="136456"/>
                  </a:cubicBezTo>
                  <a:cubicBezTo>
                    <a:pt x="28583" y="134160"/>
                    <a:pt x="27092" y="131268"/>
                    <a:pt x="25044" y="128878"/>
                  </a:cubicBezTo>
                  <a:cubicBezTo>
                    <a:pt x="26208" y="118471"/>
                    <a:pt x="20080" y="119320"/>
                    <a:pt x="16534" y="112686"/>
                  </a:cubicBezTo>
                  <a:cubicBezTo>
                    <a:pt x="11332" y="111271"/>
                    <a:pt x="2994" y="104763"/>
                    <a:pt x="977" y="100110"/>
                  </a:cubicBezTo>
                  <a:cubicBezTo>
                    <a:pt x="739" y="99575"/>
                    <a:pt x="777" y="99229"/>
                    <a:pt x="651" y="98631"/>
                  </a:cubicBezTo>
                  <a:cubicBezTo>
                    <a:pt x="-2018" y="86432"/>
                    <a:pt x="4348" y="79358"/>
                    <a:pt x="4864" y="67976"/>
                  </a:cubicBezTo>
                  <a:cubicBezTo>
                    <a:pt x="5092" y="62914"/>
                    <a:pt x="4257" y="57601"/>
                    <a:pt x="4134" y="52539"/>
                  </a:cubicBezTo>
                  <a:cubicBezTo>
                    <a:pt x="4054" y="49206"/>
                    <a:pt x="4390" y="45653"/>
                    <a:pt x="3892" y="42352"/>
                  </a:cubicBezTo>
                  <a:cubicBezTo>
                    <a:pt x="3443" y="39365"/>
                    <a:pt x="1872" y="36252"/>
                    <a:pt x="1949" y="33202"/>
                  </a:cubicBezTo>
                  <a:cubicBezTo>
                    <a:pt x="1988" y="31693"/>
                    <a:pt x="2626" y="29712"/>
                    <a:pt x="2921" y="28234"/>
                  </a:cubicBezTo>
                  <a:cubicBezTo>
                    <a:pt x="6576" y="27511"/>
                    <a:pt x="13781" y="23990"/>
                    <a:pt x="16531" y="21695"/>
                  </a:cubicBezTo>
                  <a:cubicBezTo>
                    <a:pt x="19821" y="18959"/>
                    <a:pt x="25735" y="8709"/>
                    <a:pt x="26983" y="4685"/>
                  </a:cubicBezTo>
                  <a:cubicBezTo>
                    <a:pt x="27296" y="4465"/>
                    <a:pt x="29709" y="2673"/>
                    <a:pt x="29898" y="2610"/>
                  </a:cubicBezTo>
                  <a:cubicBezTo>
                    <a:pt x="30642" y="2358"/>
                    <a:pt x="45174" y="0"/>
                    <a:pt x="46184" y="0"/>
                  </a:cubicBezTo>
                  <a:lnTo>
                    <a:pt x="52747" y="786"/>
                  </a:lnTo>
                  <a:cubicBezTo>
                    <a:pt x="54312" y="1258"/>
                    <a:pt x="60075" y="5251"/>
                    <a:pt x="61011" y="6540"/>
                  </a:cubicBezTo>
                  <a:cubicBezTo>
                    <a:pt x="61832" y="7640"/>
                    <a:pt x="61885" y="9590"/>
                    <a:pt x="62713" y="10690"/>
                  </a:cubicBezTo>
                  <a:cubicBezTo>
                    <a:pt x="63561" y="11853"/>
                    <a:pt x="65515" y="13048"/>
                    <a:pt x="66599" y="14117"/>
                  </a:cubicBezTo>
                  <a:cubicBezTo>
                    <a:pt x="67613" y="15092"/>
                    <a:pt x="67729" y="16601"/>
                    <a:pt x="68553" y="17545"/>
                  </a:cubicBezTo>
                  <a:cubicBezTo>
                    <a:pt x="72078" y="21538"/>
                    <a:pt x="90276" y="32007"/>
                    <a:pt x="95769" y="33988"/>
                  </a:cubicBezTo>
                  <a:cubicBezTo>
                    <a:pt x="99810" y="35434"/>
                    <a:pt x="104500" y="36064"/>
                    <a:pt x="108411" y="37636"/>
                  </a:cubicBezTo>
                  <a:cubicBezTo>
                    <a:pt x="112483" y="39302"/>
                    <a:pt x="115809" y="43012"/>
                    <a:pt x="119509" y="45307"/>
                  </a:cubicBezTo>
                  <a:cubicBezTo>
                    <a:pt x="121379" y="46470"/>
                    <a:pt x="122652" y="48105"/>
                    <a:pt x="123722" y="49929"/>
                  </a:cubicBezTo>
                  <a:cubicBezTo>
                    <a:pt x="127114" y="55683"/>
                    <a:pt x="128433" y="73762"/>
                    <a:pt x="126640" y="79987"/>
                  </a:cubicBezTo>
                  <a:cubicBezTo>
                    <a:pt x="125423" y="84231"/>
                    <a:pt x="123483" y="85646"/>
                    <a:pt x="123722" y="90709"/>
                  </a:cubicBezTo>
                  <a:cubicBezTo>
                    <a:pt x="123841" y="93192"/>
                    <a:pt x="127001" y="101556"/>
                    <a:pt x="128341" y="103788"/>
                  </a:cubicBezTo>
                  <a:cubicBezTo>
                    <a:pt x="128759" y="104480"/>
                    <a:pt x="131256" y="106932"/>
                    <a:pt x="131498" y="107435"/>
                  </a:cubicBezTo>
                  <a:lnTo>
                    <a:pt x="131986" y="110579"/>
                  </a:lnTo>
                  <a:cubicBezTo>
                    <a:pt x="133712" y="121647"/>
                    <a:pt x="126703" y="137336"/>
                    <a:pt x="137830" y="14560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93" name="자유형: 도형 334"/>
            <p:cNvSpPr/>
            <p:nvPr/>
          </p:nvSpPr>
          <p:spPr>
            <a:xfrm>
              <a:off x="4983120" y="303480"/>
              <a:ext cx="34200" cy="42480"/>
            </a:xfrm>
            <a:custGeom>
              <a:avLst/>
              <a:gdLst/>
              <a:ahLst/>
              <a:cxnLst/>
              <a:rect l="l" t="t" r="r" b="b"/>
              <a:pathLst>
                <a:path w="27425" h="34774">
                  <a:moveTo>
                    <a:pt x="26494" y="7860"/>
                  </a:moveTo>
                  <a:cubicBezTo>
                    <a:pt x="27574" y="10753"/>
                    <a:pt x="27686" y="14841"/>
                    <a:pt x="26981" y="17796"/>
                  </a:cubicBezTo>
                  <a:cubicBezTo>
                    <a:pt x="25238" y="20343"/>
                    <a:pt x="22607" y="23267"/>
                    <a:pt x="19931" y="25122"/>
                  </a:cubicBezTo>
                  <a:cubicBezTo>
                    <a:pt x="18608" y="26002"/>
                    <a:pt x="13192" y="29901"/>
                    <a:pt x="11909" y="30592"/>
                  </a:cubicBezTo>
                  <a:cubicBezTo>
                    <a:pt x="8818" y="32259"/>
                    <a:pt x="5707" y="32227"/>
                    <a:pt x="2431" y="34774"/>
                  </a:cubicBezTo>
                  <a:lnTo>
                    <a:pt x="0" y="32950"/>
                  </a:lnTo>
                  <a:lnTo>
                    <a:pt x="1947" y="27480"/>
                  </a:lnTo>
                  <a:cubicBezTo>
                    <a:pt x="4851" y="27071"/>
                    <a:pt x="8934" y="24870"/>
                    <a:pt x="10698" y="22764"/>
                  </a:cubicBezTo>
                  <a:cubicBezTo>
                    <a:pt x="8443" y="18236"/>
                    <a:pt x="2406" y="17482"/>
                    <a:pt x="488" y="12828"/>
                  </a:cubicBezTo>
                  <a:cubicBezTo>
                    <a:pt x="344" y="9338"/>
                    <a:pt x="1343" y="5031"/>
                    <a:pt x="2918" y="1855"/>
                  </a:cubicBezTo>
                  <a:lnTo>
                    <a:pt x="8022" y="0"/>
                  </a:lnTo>
                  <a:lnTo>
                    <a:pt x="10937" y="2641"/>
                  </a:lnTo>
                  <a:cubicBezTo>
                    <a:pt x="16030" y="3239"/>
                    <a:pt x="22782" y="4496"/>
                    <a:pt x="26494" y="786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94" name="자유형: 도형 335"/>
            <p:cNvSpPr/>
            <p:nvPr/>
          </p:nvSpPr>
          <p:spPr>
            <a:xfrm>
              <a:off x="4769640" y="425520"/>
              <a:ext cx="119520" cy="66960"/>
            </a:xfrm>
            <a:custGeom>
              <a:avLst/>
              <a:gdLst/>
              <a:ahLst/>
              <a:cxnLst/>
              <a:rect l="l" t="t" r="r" b="b"/>
              <a:pathLst>
                <a:path w="94802" h="54888">
                  <a:moveTo>
                    <a:pt x="94320" y="53600"/>
                  </a:moveTo>
                  <a:lnTo>
                    <a:pt x="89458" y="54889"/>
                  </a:lnTo>
                  <a:cubicBezTo>
                    <a:pt x="86421" y="53788"/>
                    <a:pt x="82986" y="51430"/>
                    <a:pt x="80949" y="49135"/>
                  </a:cubicBezTo>
                  <a:cubicBezTo>
                    <a:pt x="74126" y="47500"/>
                    <a:pt x="67321" y="48978"/>
                    <a:pt x="60530" y="47060"/>
                  </a:cubicBezTo>
                  <a:cubicBezTo>
                    <a:pt x="57693" y="46242"/>
                    <a:pt x="52715" y="43759"/>
                    <a:pt x="50323" y="42092"/>
                  </a:cubicBezTo>
                  <a:cubicBezTo>
                    <a:pt x="49018" y="41180"/>
                    <a:pt x="47962" y="39892"/>
                    <a:pt x="46678" y="38948"/>
                  </a:cubicBezTo>
                  <a:cubicBezTo>
                    <a:pt x="40863" y="34735"/>
                    <a:pt x="28870" y="28007"/>
                    <a:pt x="21399" y="31905"/>
                  </a:cubicBezTo>
                  <a:cubicBezTo>
                    <a:pt x="20108" y="36842"/>
                    <a:pt x="14299" y="40269"/>
                    <a:pt x="8757" y="39986"/>
                  </a:cubicBezTo>
                  <a:lnTo>
                    <a:pt x="493" y="34232"/>
                  </a:lnTo>
                  <a:cubicBezTo>
                    <a:pt x="331" y="30993"/>
                    <a:pt x="-973" y="23668"/>
                    <a:pt x="1464" y="21184"/>
                  </a:cubicBezTo>
                  <a:cubicBezTo>
                    <a:pt x="4530" y="18166"/>
                    <a:pt x="7515" y="18669"/>
                    <a:pt x="11188" y="17505"/>
                  </a:cubicBezTo>
                  <a:cubicBezTo>
                    <a:pt x="13629" y="16751"/>
                    <a:pt x="16214" y="15021"/>
                    <a:pt x="18315" y="13669"/>
                  </a:cubicBezTo>
                  <a:cubicBezTo>
                    <a:pt x="23289" y="10525"/>
                    <a:pt x="25955" y="5809"/>
                    <a:pt x="30631" y="2602"/>
                  </a:cubicBezTo>
                  <a:cubicBezTo>
                    <a:pt x="35759" y="-888"/>
                    <a:pt x="41052" y="-762"/>
                    <a:pt x="46433" y="2350"/>
                  </a:cubicBezTo>
                  <a:cubicBezTo>
                    <a:pt x="49060" y="3860"/>
                    <a:pt x="51245" y="7067"/>
                    <a:pt x="53967" y="8356"/>
                  </a:cubicBezTo>
                  <a:cubicBezTo>
                    <a:pt x="59531" y="10997"/>
                    <a:pt x="66858" y="10431"/>
                    <a:pt x="72923" y="11751"/>
                  </a:cubicBezTo>
                  <a:cubicBezTo>
                    <a:pt x="78430" y="15682"/>
                    <a:pt x="79044" y="18826"/>
                    <a:pt x="82169" y="23668"/>
                  </a:cubicBezTo>
                  <a:cubicBezTo>
                    <a:pt x="83734" y="26120"/>
                    <a:pt x="86536" y="28164"/>
                    <a:pt x="87995" y="30585"/>
                  </a:cubicBezTo>
                  <a:cubicBezTo>
                    <a:pt x="88785" y="31905"/>
                    <a:pt x="91963" y="37408"/>
                    <a:pt x="92612" y="38697"/>
                  </a:cubicBezTo>
                  <a:cubicBezTo>
                    <a:pt x="94446" y="42281"/>
                    <a:pt x="95463" y="49858"/>
                    <a:pt x="94320" y="5360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95" name="자유형: 도형 336"/>
            <p:cNvSpPr/>
            <p:nvPr/>
          </p:nvSpPr>
          <p:spPr>
            <a:xfrm>
              <a:off x="4992120" y="1215360"/>
              <a:ext cx="55440" cy="35280"/>
            </a:xfrm>
            <a:custGeom>
              <a:avLst/>
              <a:gdLst/>
              <a:ahLst/>
              <a:cxnLst/>
              <a:rect l="l" t="t" r="r" b="b"/>
              <a:pathLst>
                <a:path w="44116" h="28979">
                  <a:moveTo>
                    <a:pt x="44116" y="6540"/>
                  </a:moveTo>
                  <a:cubicBezTo>
                    <a:pt x="43716" y="9904"/>
                    <a:pt x="42155" y="14212"/>
                    <a:pt x="39984" y="17009"/>
                  </a:cubicBezTo>
                  <a:cubicBezTo>
                    <a:pt x="38448" y="18959"/>
                    <a:pt x="30738" y="25059"/>
                    <a:pt x="28317" y="25908"/>
                  </a:cubicBezTo>
                  <a:cubicBezTo>
                    <a:pt x="26066" y="26662"/>
                    <a:pt x="18471" y="27511"/>
                    <a:pt x="15514" y="28077"/>
                  </a:cubicBezTo>
                  <a:cubicBezTo>
                    <a:pt x="10905" y="28926"/>
                    <a:pt x="5370" y="29838"/>
                    <a:pt x="1094" y="27448"/>
                  </a:cubicBezTo>
                  <a:cubicBezTo>
                    <a:pt x="-2006" y="21789"/>
                    <a:pt x="1736" y="13237"/>
                    <a:pt x="9116" y="12293"/>
                  </a:cubicBezTo>
                  <a:cubicBezTo>
                    <a:pt x="13441" y="13331"/>
                    <a:pt x="18250" y="14023"/>
                    <a:pt x="22730" y="14117"/>
                  </a:cubicBezTo>
                  <a:cubicBezTo>
                    <a:pt x="28521" y="10218"/>
                    <a:pt x="31232" y="3993"/>
                    <a:pt x="36827" y="0"/>
                  </a:cubicBezTo>
                  <a:lnTo>
                    <a:pt x="41689" y="1572"/>
                  </a:lnTo>
                  <a:lnTo>
                    <a:pt x="41689" y="1069"/>
                  </a:lnTo>
                  <a:lnTo>
                    <a:pt x="44116" y="6540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96" name="자유형: 도형 337"/>
            <p:cNvSpPr/>
            <p:nvPr/>
          </p:nvSpPr>
          <p:spPr>
            <a:xfrm>
              <a:off x="5154480" y="1233000"/>
              <a:ext cx="46080" cy="34560"/>
            </a:xfrm>
            <a:custGeom>
              <a:avLst/>
              <a:gdLst/>
              <a:ahLst/>
              <a:cxnLst/>
              <a:rect l="l" t="t" r="r" b="b"/>
              <a:pathLst>
                <a:path w="36704" h="28517">
                  <a:moveTo>
                    <a:pt x="6563" y="28517"/>
                  </a:moveTo>
                  <a:cubicBezTo>
                    <a:pt x="4970" y="26914"/>
                    <a:pt x="2185" y="25593"/>
                    <a:pt x="0" y="24839"/>
                  </a:cubicBezTo>
                  <a:cubicBezTo>
                    <a:pt x="803" y="23424"/>
                    <a:pt x="1652" y="21411"/>
                    <a:pt x="2673" y="20154"/>
                  </a:cubicBezTo>
                  <a:cubicBezTo>
                    <a:pt x="4528" y="17827"/>
                    <a:pt x="7861" y="16066"/>
                    <a:pt x="9965" y="13865"/>
                  </a:cubicBezTo>
                  <a:cubicBezTo>
                    <a:pt x="11105" y="12671"/>
                    <a:pt x="11930" y="11067"/>
                    <a:pt x="13122" y="9935"/>
                  </a:cubicBezTo>
                  <a:cubicBezTo>
                    <a:pt x="14273" y="8866"/>
                    <a:pt x="19587" y="4653"/>
                    <a:pt x="20902" y="3678"/>
                  </a:cubicBezTo>
                  <a:cubicBezTo>
                    <a:pt x="22926" y="2169"/>
                    <a:pt x="26715" y="786"/>
                    <a:pt x="29166" y="0"/>
                  </a:cubicBezTo>
                  <a:lnTo>
                    <a:pt x="34758" y="1069"/>
                  </a:lnTo>
                  <a:lnTo>
                    <a:pt x="36704" y="5250"/>
                  </a:lnTo>
                  <a:cubicBezTo>
                    <a:pt x="34312" y="7797"/>
                    <a:pt x="31443" y="8835"/>
                    <a:pt x="28665" y="10784"/>
                  </a:cubicBezTo>
                  <a:cubicBezTo>
                    <a:pt x="26213" y="12514"/>
                    <a:pt x="24813" y="15406"/>
                    <a:pt x="22604" y="17261"/>
                  </a:cubicBezTo>
                  <a:cubicBezTo>
                    <a:pt x="21418" y="18267"/>
                    <a:pt x="19545" y="18990"/>
                    <a:pt x="18229" y="19871"/>
                  </a:cubicBezTo>
                  <a:cubicBezTo>
                    <a:pt x="14164" y="22669"/>
                    <a:pt x="11140" y="26253"/>
                    <a:pt x="6563" y="28517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97" name="자유형: 도형 338"/>
            <p:cNvSpPr/>
            <p:nvPr/>
          </p:nvSpPr>
          <p:spPr>
            <a:xfrm>
              <a:off x="5231520" y="1302840"/>
              <a:ext cx="15480" cy="17280"/>
            </a:xfrm>
            <a:custGeom>
              <a:avLst/>
              <a:gdLst/>
              <a:ahLst/>
              <a:cxnLst/>
              <a:rect l="l" t="t" r="r" b="b"/>
              <a:pathLst>
                <a:path w="12427" h="14368">
                  <a:moveTo>
                    <a:pt x="12428" y="7263"/>
                  </a:moveTo>
                  <a:cubicBezTo>
                    <a:pt x="11474" y="9810"/>
                    <a:pt x="8222" y="13363"/>
                    <a:pt x="5377" y="14369"/>
                  </a:cubicBezTo>
                  <a:lnTo>
                    <a:pt x="761" y="11507"/>
                  </a:lnTo>
                  <a:cubicBezTo>
                    <a:pt x="-586" y="8898"/>
                    <a:pt x="-21" y="4024"/>
                    <a:pt x="1487" y="1572"/>
                  </a:cubicBezTo>
                  <a:lnTo>
                    <a:pt x="6594" y="0"/>
                  </a:lnTo>
                  <a:lnTo>
                    <a:pt x="11937" y="2106"/>
                  </a:lnTo>
                  <a:lnTo>
                    <a:pt x="12428" y="7263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98" name="자유형: 도형 339"/>
            <p:cNvSpPr/>
            <p:nvPr/>
          </p:nvSpPr>
          <p:spPr>
            <a:xfrm>
              <a:off x="5796360" y="1236600"/>
              <a:ext cx="18000" cy="19080"/>
            </a:xfrm>
            <a:custGeom>
              <a:avLst/>
              <a:gdLst/>
              <a:ahLst/>
              <a:cxnLst/>
              <a:rect l="l" t="t" r="r" b="b"/>
              <a:pathLst>
                <a:path w="14507" h="15940">
                  <a:moveTo>
                    <a:pt x="14432" y="10973"/>
                  </a:moveTo>
                  <a:lnTo>
                    <a:pt x="11271" y="14903"/>
                  </a:lnTo>
                  <a:lnTo>
                    <a:pt x="5680" y="15941"/>
                  </a:lnTo>
                  <a:lnTo>
                    <a:pt x="334" y="13582"/>
                  </a:lnTo>
                  <a:cubicBezTo>
                    <a:pt x="-921" y="9244"/>
                    <a:pt x="1432" y="2106"/>
                    <a:pt x="6168" y="0"/>
                  </a:cubicBezTo>
                  <a:lnTo>
                    <a:pt x="10784" y="1572"/>
                  </a:lnTo>
                  <a:lnTo>
                    <a:pt x="13702" y="5219"/>
                  </a:lnTo>
                  <a:cubicBezTo>
                    <a:pt x="13702" y="5219"/>
                    <a:pt x="14800" y="8332"/>
                    <a:pt x="14432" y="10973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99" name="자유형: 도형 340"/>
            <p:cNvSpPr/>
            <p:nvPr/>
          </p:nvSpPr>
          <p:spPr>
            <a:xfrm>
              <a:off x="5654520" y="308160"/>
              <a:ext cx="23400" cy="36000"/>
            </a:xfrm>
            <a:custGeom>
              <a:avLst/>
              <a:gdLst/>
              <a:ahLst/>
              <a:cxnLst/>
              <a:rect l="l" t="t" r="r" b="b"/>
              <a:pathLst>
                <a:path w="18780" h="29491">
                  <a:moveTo>
                    <a:pt x="0" y="0"/>
                  </a:moveTo>
                  <a:cubicBezTo>
                    <a:pt x="4616" y="3647"/>
                    <a:pt x="2178" y="9338"/>
                    <a:pt x="5412" y="13394"/>
                  </a:cubicBezTo>
                  <a:cubicBezTo>
                    <a:pt x="10120" y="19305"/>
                    <a:pt x="13392" y="16192"/>
                    <a:pt x="18780" y="26977"/>
                  </a:cubicBezTo>
                  <a:lnTo>
                    <a:pt x="18110" y="29492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00" name="자유형: 도형 341"/>
            <p:cNvSpPr/>
            <p:nvPr/>
          </p:nvSpPr>
          <p:spPr>
            <a:xfrm>
              <a:off x="8980560" y="3892680"/>
              <a:ext cx="422280" cy="321480"/>
            </a:xfrm>
            <a:custGeom>
              <a:avLst/>
              <a:gdLst/>
              <a:ahLst/>
              <a:cxnLst/>
              <a:rect l="l" t="t" r="r" b="b"/>
              <a:pathLst>
                <a:path w="334493" h="261938">
                  <a:moveTo>
                    <a:pt x="22063" y="261938"/>
                  </a:moveTo>
                  <a:lnTo>
                    <a:pt x="21116" y="250305"/>
                  </a:lnTo>
                  <a:lnTo>
                    <a:pt x="35182" y="246123"/>
                  </a:lnTo>
                  <a:lnTo>
                    <a:pt x="30517" y="230528"/>
                  </a:lnTo>
                  <a:lnTo>
                    <a:pt x="13294" y="225404"/>
                  </a:lnTo>
                  <a:lnTo>
                    <a:pt x="1754" y="211443"/>
                  </a:lnTo>
                  <a:lnTo>
                    <a:pt x="0" y="203458"/>
                  </a:lnTo>
                  <a:lnTo>
                    <a:pt x="12803" y="202828"/>
                  </a:lnTo>
                  <a:cubicBezTo>
                    <a:pt x="12803" y="202828"/>
                    <a:pt x="25115" y="206035"/>
                    <a:pt x="28482" y="206035"/>
                  </a:cubicBezTo>
                  <a:cubicBezTo>
                    <a:pt x="31815" y="206035"/>
                    <a:pt x="40269" y="198427"/>
                    <a:pt x="40269" y="198427"/>
                  </a:cubicBezTo>
                  <a:lnTo>
                    <a:pt x="51282" y="195377"/>
                  </a:lnTo>
                  <a:lnTo>
                    <a:pt x="59210" y="204212"/>
                  </a:lnTo>
                  <a:lnTo>
                    <a:pt x="67628" y="199653"/>
                  </a:lnTo>
                  <a:lnTo>
                    <a:pt x="68926" y="181134"/>
                  </a:lnTo>
                  <a:lnTo>
                    <a:pt x="61034" y="164879"/>
                  </a:lnTo>
                  <a:lnTo>
                    <a:pt x="75836" y="153812"/>
                  </a:lnTo>
                  <a:lnTo>
                    <a:pt x="89657" y="148372"/>
                  </a:lnTo>
                  <a:lnTo>
                    <a:pt x="106038" y="151862"/>
                  </a:lnTo>
                  <a:lnTo>
                    <a:pt x="118981" y="142398"/>
                  </a:lnTo>
                  <a:lnTo>
                    <a:pt x="128978" y="144945"/>
                  </a:lnTo>
                  <a:lnTo>
                    <a:pt x="150059" y="141235"/>
                  </a:lnTo>
                  <a:lnTo>
                    <a:pt x="164756" y="136645"/>
                  </a:lnTo>
                  <a:lnTo>
                    <a:pt x="178085" y="108630"/>
                  </a:lnTo>
                  <a:cubicBezTo>
                    <a:pt x="178085" y="108630"/>
                    <a:pt x="176858" y="101776"/>
                    <a:pt x="179138" y="100581"/>
                  </a:cubicBezTo>
                  <a:cubicBezTo>
                    <a:pt x="181453" y="99386"/>
                    <a:pt x="201096" y="98506"/>
                    <a:pt x="201096" y="98506"/>
                  </a:cubicBezTo>
                  <a:lnTo>
                    <a:pt x="217863" y="81024"/>
                  </a:lnTo>
                  <a:lnTo>
                    <a:pt x="229648" y="85238"/>
                  </a:lnTo>
                  <a:lnTo>
                    <a:pt x="240803" y="74956"/>
                  </a:lnTo>
                  <a:lnTo>
                    <a:pt x="262270" y="71844"/>
                  </a:lnTo>
                  <a:lnTo>
                    <a:pt x="262095" y="59959"/>
                  </a:lnTo>
                  <a:lnTo>
                    <a:pt x="275003" y="49080"/>
                  </a:lnTo>
                  <a:lnTo>
                    <a:pt x="279703" y="32353"/>
                  </a:lnTo>
                  <a:lnTo>
                    <a:pt x="276476" y="24682"/>
                  </a:lnTo>
                  <a:lnTo>
                    <a:pt x="284824" y="18362"/>
                  </a:lnTo>
                  <a:lnTo>
                    <a:pt x="310185" y="29272"/>
                  </a:lnTo>
                  <a:lnTo>
                    <a:pt x="319340" y="26977"/>
                  </a:lnTo>
                  <a:lnTo>
                    <a:pt x="334493" y="0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01" name="자유형: 도형 342"/>
            <p:cNvSpPr/>
            <p:nvPr/>
          </p:nvSpPr>
          <p:spPr>
            <a:xfrm>
              <a:off x="9403200" y="3892680"/>
              <a:ext cx="117720" cy="66240"/>
            </a:xfrm>
            <a:custGeom>
              <a:avLst/>
              <a:gdLst/>
              <a:ahLst/>
              <a:cxnLst/>
              <a:rect l="l" t="t" r="r" b="b"/>
              <a:pathLst>
                <a:path w="93374" h="54204">
                  <a:moveTo>
                    <a:pt x="0" y="0"/>
                  </a:moveTo>
                  <a:lnTo>
                    <a:pt x="12628" y="5660"/>
                  </a:lnTo>
                  <a:lnTo>
                    <a:pt x="35393" y="1792"/>
                  </a:lnTo>
                  <a:lnTo>
                    <a:pt x="54720" y="1447"/>
                  </a:lnTo>
                  <a:lnTo>
                    <a:pt x="64471" y="15312"/>
                  </a:lnTo>
                  <a:lnTo>
                    <a:pt x="67663" y="37132"/>
                  </a:lnTo>
                  <a:lnTo>
                    <a:pt x="93375" y="54205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02" name="자유형: 도형 343"/>
            <p:cNvSpPr/>
            <p:nvPr/>
          </p:nvSpPr>
          <p:spPr>
            <a:xfrm>
              <a:off x="9167040" y="3637800"/>
              <a:ext cx="249840" cy="254520"/>
            </a:xfrm>
            <a:custGeom>
              <a:avLst/>
              <a:gdLst/>
              <a:ahLst/>
              <a:cxnLst/>
              <a:rect l="l" t="t" r="r" b="b"/>
              <a:pathLst>
                <a:path w="198114" h="207512">
                  <a:moveTo>
                    <a:pt x="20590" y="0"/>
                  </a:moveTo>
                  <a:lnTo>
                    <a:pt x="27080" y="3867"/>
                  </a:lnTo>
                  <a:lnTo>
                    <a:pt x="29535" y="32385"/>
                  </a:lnTo>
                  <a:lnTo>
                    <a:pt x="17013" y="42226"/>
                  </a:lnTo>
                  <a:lnTo>
                    <a:pt x="0" y="48828"/>
                  </a:lnTo>
                  <a:lnTo>
                    <a:pt x="5192" y="64235"/>
                  </a:lnTo>
                  <a:lnTo>
                    <a:pt x="15224" y="64392"/>
                  </a:lnTo>
                  <a:lnTo>
                    <a:pt x="15820" y="79704"/>
                  </a:lnTo>
                  <a:cubicBezTo>
                    <a:pt x="15820" y="79704"/>
                    <a:pt x="54474" y="90740"/>
                    <a:pt x="56684" y="91621"/>
                  </a:cubicBezTo>
                  <a:cubicBezTo>
                    <a:pt x="58929" y="92532"/>
                    <a:pt x="63770" y="89545"/>
                    <a:pt x="63770" y="89545"/>
                  </a:cubicBezTo>
                  <a:lnTo>
                    <a:pt x="76608" y="99229"/>
                  </a:lnTo>
                  <a:lnTo>
                    <a:pt x="104564" y="109290"/>
                  </a:lnTo>
                  <a:lnTo>
                    <a:pt x="123225" y="140449"/>
                  </a:lnTo>
                  <a:lnTo>
                    <a:pt x="146621" y="158339"/>
                  </a:lnTo>
                  <a:lnTo>
                    <a:pt x="169316" y="165130"/>
                  </a:lnTo>
                  <a:lnTo>
                    <a:pt x="181277" y="159659"/>
                  </a:lnTo>
                  <a:lnTo>
                    <a:pt x="187591" y="165413"/>
                  </a:lnTo>
                  <a:lnTo>
                    <a:pt x="188749" y="173997"/>
                  </a:lnTo>
                  <a:lnTo>
                    <a:pt x="198114" y="183555"/>
                  </a:lnTo>
                  <a:lnTo>
                    <a:pt x="186750" y="207513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03" name="자유형: 도형 344"/>
            <p:cNvSpPr/>
            <p:nvPr/>
          </p:nvSpPr>
          <p:spPr>
            <a:xfrm>
              <a:off x="9193320" y="3519720"/>
              <a:ext cx="475200" cy="117720"/>
            </a:xfrm>
            <a:custGeom>
              <a:avLst/>
              <a:gdLst/>
              <a:ahLst/>
              <a:cxnLst/>
              <a:rect l="l" t="t" r="r" b="b"/>
              <a:pathLst>
                <a:path w="376480" h="96147">
                  <a:moveTo>
                    <a:pt x="376480" y="66624"/>
                  </a:moveTo>
                  <a:lnTo>
                    <a:pt x="337194" y="55714"/>
                  </a:lnTo>
                  <a:lnTo>
                    <a:pt x="304432" y="44300"/>
                  </a:lnTo>
                  <a:lnTo>
                    <a:pt x="290366" y="43766"/>
                  </a:lnTo>
                  <a:lnTo>
                    <a:pt x="264094" y="59109"/>
                  </a:lnTo>
                  <a:lnTo>
                    <a:pt x="255009" y="58135"/>
                  </a:lnTo>
                  <a:lnTo>
                    <a:pt x="240136" y="70806"/>
                  </a:lnTo>
                  <a:lnTo>
                    <a:pt x="231086" y="66655"/>
                  </a:lnTo>
                  <a:cubicBezTo>
                    <a:pt x="231086" y="66655"/>
                    <a:pt x="214215" y="63543"/>
                    <a:pt x="212952" y="61530"/>
                  </a:cubicBezTo>
                  <a:cubicBezTo>
                    <a:pt x="211654" y="59518"/>
                    <a:pt x="209514" y="52129"/>
                    <a:pt x="209514" y="52129"/>
                  </a:cubicBezTo>
                  <a:lnTo>
                    <a:pt x="215407" y="28517"/>
                  </a:lnTo>
                  <a:lnTo>
                    <a:pt x="211864" y="22826"/>
                  </a:lnTo>
                  <a:lnTo>
                    <a:pt x="198219" y="20342"/>
                  </a:lnTo>
                  <a:cubicBezTo>
                    <a:pt x="198219" y="20342"/>
                    <a:pt x="190853" y="18016"/>
                    <a:pt x="188293" y="14400"/>
                  </a:cubicBezTo>
                  <a:cubicBezTo>
                    <a:pt x="185767" y="10753"/>
                    <a:pt x="170263" y="2829"/>
                    <a:pt x="170263" y="2829"/>
                  </a:cubicBezTo>
                  <a:lnTo>
                    <a:pt x="151076" y="2546"/>
                  </a:lnTo>
                  <a:lnTo>
                    <a:pt x="142763" y="8866"/>
                  </a:lnTo>
                  <a:lnTo>
                    <a:pt x="130907" y="7860"/>
                  </a:lnTo>
                  <a:lnTo>
                    <a:pt x="125330" y="0"/>
                  </a:lnTo>
                  <a:lnTo>
                    <a:pt x="115508" y="2798"/>
                  </a:lnTo>
                  <a:lnTo>
                    <a:pt x="101548" y="15469"/>
                  </a:lnTo>
                  <a:lnTo>
                    <a:pt x="81414" y="18393"/>
                  </a:lnTo>
                  <a:lnTo>
                    <a:pt x="67593" y="23832"/>
                  </a:lnTo>
                  <a:lnTo>
                    <a:pt x="58579" y="38390"/>
                  </a:lnTo>
                  <a:lnTo>
                    <a:pt x="55106" y="56689"/>
                  </a:lnTo>
                  <a:lnTo>
                    <a:pt x="65804" y="68951"/>
                  </a:lnTo>
                  <a:lnTo>
                    <a:pt x="60157" y="76119"/>
                  </a:lnTo>
                  <a:lnTo>
                    <a:pt x="39357" y="67725"/>
                  </a:lnTo>
                  <a:lnTo>
                    <a:pt x="29956" y="82093"/>
                  </a:lnTo>
                  <a:lnTo>
                    <a:pt x="18135" y="80301"/>
                  </a:lnTo>
                  <a:lnTo>
                    <a:pt x="0" y="96147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04" name="자유형: 도형 345"/>
            <p:cNvSpPr/>
            <p:nvPr/>
          </p:nvSpPr>
          <p:spPr>
            <a:xfrm>
              <a:off x="8697240" y="3566880"/>
              <a:ext cx="495720" cy="126720"/>
            </a:xfrm>
            <a:custGeom>
              <a:avLst/>
              <a:gdLst/>
              <a:ahLst/>
              <a:cxnLst/>
              <a:rect l="l" t="t" r="r" b="b"/>
              <a:pathLst>
                <a:path w="392720" h="103315">
                  <a:moveTo>
                    <a:pt x="0" y="0"/>
                  </a:moveTo>
                  <a:cubicBezTo>
                    <a:pt x="0" y="0"/>
                    <a:pt x="5682" y="19053"/>
                    <a:pt x="6349" y="21442"/>
                  </a:cubicBezTo>
                  <a:cubicBezTo>
                    <a:pt x="7015" y="23832"/>
                    <a:pt x="10278" y="32793"/>
                    <a:pt x="8348" y="42980"/>
                  </a:cubicBezTo>
                  <a:cubicBezTo>
                    <a:pt x="6419" y="53199"/>
                    <a:pt x="12979" y="55620"/>
                    <a:pt x="17118" y="56689"/>
                  </a:cubicBezTo>
                  <a:cubicBezTo>
                    <a:pt x="21292" y="57820"/>
                    <a:pt x="38339" y="77754"/>
                    <a:pt x="41250" y="82061"/>
                  </a:cubicBezTo>
                  <a:cubicBezTo>
                    <a:pt x="44162" y="86338"/>
                    <a:pt x="51072" y="87878"/>
                    <a:pt x="58438" y="87878"/>
                  </a:cubicBezTo>
                  <a:cubicBezTo>
                    <a:pt x="65804" y="87878"/>
                    <a:pt x="87166" y="86086"/>
                    <a:pt x="91446" y="84451"/>
                  </a:cubicBezTo>
                  <a:cubicBezTo>
                    <a:pt x="95690" y="82785"/>
                    <a:pt x="106213" y="76622"/>
                    <a:pt x="106213" y="76622"/>
                  </a:cubicBezTo>
                  <a:lnTo>
                    <a:pt x="135361" y="78666"/>
                  </a:lnTo>
                  <a:lnTo>
                    <a:pt x="139746" y="87627"/>
                  </a:lnTo>
                  <a:lnTo>
                    <a:pt x="145113" y="92532"/>
                  </a:lnTo>
                  <a:lnTo>
                    <a:pt x="165212" y="92846"/>
                  </a:lnTo>
                  <a:lnTo>
                    <a:pt x="195168" y="102153"/>
                  </a:lnTo>
                  <a:lnTo>
                    <a:pt x="217056" y="103316"/>
                  </a:lnTo>
                  <a:lnTo>
                    <a:pt x="225579" y="86495"/>
                  </a:lnTo>
                  <a:lnTo>
                    <a:pt x="253150" y="76465"/>
                  </a:lnTo>
                  <a:lnTo>
                    <a:pt x="259428" y="81401"/>
                  </a:lnTo>
                  <a:lnTo>
                    <a:pt x="268619" y="79106"/>
                  </a:lnTo>
                  <a:lnTo>
                    <a:pt x="275248" y="67944"/>
                  </a:lnTo>
                  <a:lnTo>
                    <a:pt x="285491" y="56814"/>
                  </a:lnTo>
                  <a:lnTo>
                    <a:pt x="287560" y="43137"/>
                  </a:lnTo>
                  <a:lnTo>
                    <a:pt x="314990" y="42760"/>
                  </a:lnTo>
                  <a:lnTo>
                    <a:pt x="321585" y="33171"/>
                  </a:lnTo>
                  <a:lnTo>
                    <a:pt x="327933" y="34082"/>
                  </a:lnTo>
                  <a:lnTo>
                    <a:pt x="348348" y="48985"/>
                  </a:lnTo>
                  <a:lnTo>
                    <a:pt x="361748" y="60336"/>
                  </a:lnTo>
                  <a:lnTo>
                    <a:pt x="377076" y="64518"/>
                  </a:lnTo>
                  <a:lnTo>
                    <a:pt x="392720" y="57663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05" name="자유형: 도형 346"/>
            <p:cNvSpPr/>
            <p:nvPr/>
          </p:nvSpPr>
          <p:spPr>
            <a:xfrm>
              <a:off x="8550360" y="3566880"/>
              <a:ext cx="146520" cy="76680"/>
            </a:xfrm>
            <a:custGeom>
              <a:avLst/>
              <a:gdLst/>
              <a:ahLst/>
              <a:cxnLst/>
              <a:rect l="l" t="t" r="r" b="b"/>
              <a:pathLst>
                <a:path w="116279" h="62693">
                  <a:moveTo>
                    <a:pt x="0" y="62694"/>
                  </a:moveTo>
                  <a:lnTo>
                    <a:pt x="14311" y="60933"/>
                  </a:lnTo>
                  <a:lnTo>
                    <a:pt x="27044" y="58543"/>
                  </a:lnTo>
                  <a:cubicBezTo>
                    <a:pt x="27044" y="58543"/>
                    <a:pt x="41110" y="47791"/>
                    <a:pt x="46056" y="43263"/>
                  </a:cubicBezTo>
                  <a:cubicBezTo>
                    <a:pt x="50967" y="38735"/>
                    <a:pt x="64366" y="39521"/>
                    <a:pt x="64366" y="39521"/>
                  </a:cubicBezTo>
                  <a:cubicBezTo>
                    <a:pt x="64366" y="39521"/>
                    <a:pt x="85166" y="41786"/>
                    <a:pt x="92708" y="39144"/>
                  </a:cubicBezTo>
                  <a:cubicBezTo>
                    <a:pt x="100215" y="36503"/>
                    <a:pt x="103757" y="34491"/>
                    <a:pt x="103757" y="34491"/>
                  </a:cubicBezTo>
                  <a:lnTo>
                    <a:pt x="101267" y="19116"/>
                  </a:lnTo>
                  <a:lnTo>
                    <a:pt x="102460" y="7043"/>
                  </a:lnTo>
                  <a:lnTo>
                    <a:pt x="116280" y="0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06" name="자유형: 도형 347"/>
            <p:cNvSpPr/>
            <p:nvPr/>
          </p:nvSpPr>
          <p:spPr>
            <a:xfrm>
              <a:off x="8514360" y="3204360"/>
              <a:ext cx="430200" cy="439560"/>
            </a:xfrm>
            <a:custGeom>
              <a:avLst/>
              <a:gdLst/>
              <a:ahLst/>
              <a:cxnLst/>
              <a:rect l="l" t="t" r="r" b="b"/>
              <a:pathLst>
                <a:path w="340760" h="357959">
                  <a:moveTo>
                    <a:pt x="28401" y="357960"/>
                  </a:moveTo>
                  <a:cubicBezTo>
                    <a:pt x="28401" y="357960"/>
                    <a:pt x="35417" y="349659"/>
                    <a:pt x="34084" y="347584"/>
                  </a:cubicBezTo>
                  <a:cubicBezTo>
                    <a:pt x="32751" y="345477"/>
                    <a:pt x="39450" y="340070"/>
                    <a:pt x="40117" y="335856"/>
                  </a:cubicBezTo>
                  <a:cubicBezTo>
                    <a:pt x="40783" y="331643"/>
                    <a:pt x="37451" y="327462"/>
                    <a:pt x="31839" y="323374"/>
                  </a:cubicBezTo>
                  <a:cubicBezTo>
                    <a:pt x="26261" y="319287"/>
                    <a:pt x="22017" y="318501"/>
                    <a:pt x="11178" y="306930"/>
                  </a:cubicBezTo>
                  <a:cubicBezTo>
                    <a:pt x="305" y="295329"/>
                    <a:pt x="-1344" y="281935"/>
                    <a:pt x="831" y="276118"/>
                  </a:cubicBezTo>
                  <a:cubicBezTo>
                    <a:pt x="2970" y="270301"/>
                    <a:pt x="8057" y="272408"/>
                    <a:pt x="14546" y="275521"/>
                  </a:cubicBezTo>
                  <a:cubicBezTo>
                    <a:pt x="21035" y="278633"/>
                    <a:pt x="59093" y="283475"/>
                    <a:pt x="59093" y="283475"/>
                  </a:cubicBezTo>
                  <a:cubicBezTo>
                    <a:pt x="59093" y="283475"/>
                    <a:pt x="64144" y="281935"/>
                    <a:pt x="67441" y="277156"/>
                  </a:cubicBezTo>
                  <a:cubicBezTo>
                    <a:pt x="70739" y="272376"/>
                    <a:pt x="66845" y="262189"/>
                    <a:pt x="66950" y="256184"/>
                  </a:cubicBezTo>
                  <a:cubicBezTo>
                    <a:pt x="67021" y="250179"/>
                    <a:pt x="55445" y="247852"/>
                    <a:pt x="40748" y="242066"/>
                  </a:cubicBezTo>
                  <a:cubicBezTo>
                    <a:pt x="26086" y="236282"/>
                    <a:pt x="29383" y="220309"/>
                    <a:pt x="35837" y="215404"/>
                  </a:cubicBezTo>
                  <a:cubicBezTo>
                    <a:pt x="42257" y="210531"/>
                    <a:pt x="44712" y="196351"/>
                    <a:pt x="49096" y="190597"/>
                  </a:cubicBezTo>
                  <a:cubicBezTo>
                    <a:pt x="53446" y="184875"/>
                    <a:pt x="60812" y="182548"/>
                    <a:pt x="64846" y="182548"/>
                  </a:cubicBezTo>
                  <a:cubicBezTo>
                    <a:pt x="68845" y="182548"/>
                    <a:pt x="89540" y="183145"/>
                    <a:pt x="99432" y="182548"/>
                  </a:cubicBezTo>
                  <a:cubicBezTo>
                    <a:pt x="109323" y="181920"/>
                    <a:pt x="107008" y="168934"/>
                    <a:pt x="107008" y="168934"/>
                  </a:cubicBezTo>
                  <a:lnTo>
                    <a:pt x="83612" y="150855"/>
                  </a:lnTo>
                  <a:cubicBezTo>
                    <a:pt x="83612" y="150855"/>
                    <a:pt x="65513" y="149064"/>
                    <a:pt x="60146" y="148435"/>
                  </a:cubicBezTo>
                  <a:cubicBezTo>
                    <a:pt x="54779" y="147837"/>
                    <a:pt x="47413" y="148435"/>
                    <a:pt x="35417" y="143058"/>
                  </a:cubicBezTo>
                  <a:cubicBezTo>
                    <a:pt x="23455" y="137650"/>
                    <a:pt x="31418" y="127431"/>
                    <a:pt x="33101" y="121835"/>
                  </a:cubicBezTo>
                  <a:cubicBezTo>
                    <a:pt x="34750" y="116270"/>
                    <a:pt x="41520" y="112308"/>
                    <a:pt x="41520" y="112308"/>
                  </a:cubicBezTo>
                  <a:lnTo>
                    <a:pt x="62320" y="74736"/>
                  </a:lnTo>
                  <a:lnTo>
                    <a:pt x="87190" y="63040"/>
                  </a:lnTo>
                  <a:lnTo>
                    <a:pt x="106202" y="70586"/>
                  </a:lnTo>
                  <a:cubicBezTo>
                    <a:pt x="106202" y="70586"/>
                    <a:pt x="100835" y="84923"/>
                    <a:pt x="96906" y="90929"/>
                  </a:cubicBezTo>
                  <a:cubicBezTo>
                    <a:pt x="92978" y="96934"/>
                    <a:pt x="98836" y="104668"/>
                    <a:pt x="103746" y="104385"/>
                  </a:cubicBezTo>
                  <a:cubicBezTo>
                    <a:pt x="108622" y="104102"/>
                    <a:pt x="116514" y="103788"/>
                    <a:pt x="116514" y="103788"/>
                  </a:cubicBezTo>
                  <a:lnTo>
                    <a:pt x="126406" y="111208"/>
                  </a:lnTo>
                  <a:lnTo>
                    <a:pt x="157168" y="33454"/>
                  </a:lnTo>
                  <a:lnTo>
                    <a:pt x="166954" y="44898"/>
                  </a:lnTo>
                  <a:lnTo>
                    <a:pt x="174426" y="36157"/>
                  </a:lnTo>
                  <a:lnTo>
                    <a:pt x="182739" y="31473"/>
                  </a:lnTo>
                  <a:lnTo>
                    <a:pt x="195086" y="32825"/>
                  </a:lnTo>
                  <a:lnTo>
                    <a:pt x="209152" y="25625"/>
                  </a:lnTo>
                  <a:lnTo>
                    <a:pt x="235881" y="4653"/>
                  </a:lnTo>
                  <a:lnTo>
                    <a:pt x="249034" y="4245"/>
                  </a:lnTo>
                  <a:lnTo>
                    <a:pt x="286532" y="0"/>
                  </a:lnTo>
                  <a:lnTo>
                    <a:pt x="304666" y="1666"/>
                  </a:lnTo>
                  <a:lnTo>
                    <a:pt x="314383" y="23801"/>
                  </a:lnTo>
                  <a:lnTo>
                    <a:pt x="328694" y="37038"/>
                  </a:lnTo>
                  <a:lnTo>
                    <a:pt x="319749" y="73887"/>
                  </a:lnTo>
                  <a:cubicBezTo>
                    <a:pt x="319749" y="73887"/>
                    <a:pt x="322661" y="79515"/>
                    <a:pt x="332061" y="85521"/>
                  </a:cubicBezTo>
                  <a:cubicBezTo>
                    <a:pt x="341427" y="91526"/>
                    <a:pt x="338095" y="97531"/>
                    <a:pt x="338095" y="100487"/>
                  </a:cubicBezTo>
                  <a:cubicBezTo>
                    <a:pt x="338095" y="103411"/>
                    <a:pt x="340760" y="129821"/>
                    <a:pt x="340760" y="129821"/>
                  </a:cubicBezTo>
                  <a:lnTo>
                    <a:pt x="317469" y="143970"/>
                  </a:lnTo>
                  <a:lnTo>
                    <a:pt x="309262" y="143058"/>
                  </a:lnTo>
                  <a:lnTo>
                    <a:pt x="299755" y="162237"/>
                  </a:lnTo>
                  <a:lnTo>
                    <a:pt x="288671" y="192767"/>
                  </a:lnTo>
                  <a:lnTo>
                    <a:pt x="274570" y="204086"/>
                  </a:lnTo>
                  <a:cubicBezTo>
                    <a:pt x="274570" y="204086"/>
                    <a:pt x="283971" y="219115"/>
                    <a:pt x="283971" y="232257"/>
                  </a:cubicBezTo>
                  <a:cubicBezTo>
                    <a:pt x="283971" y="245399"/>
                    <a:pt x="278780" y="253826"/>
                    <a:pt x="278780" y="253826"/>
                  </a:cubicBezTo>
                  <a:lnTo>
                    <a:pt x="255909" y="263415"/>
                  </a:lnTo>
                  <a:lnTo>
                    <a:pt x="242756" y="273414"/>
                  </a:lnTo>
                  <a:lnTo>
                    <a:pt x="229847" y="274829"/>
                  </a:lnTo>
                  <a:lnTo>
                    <a:pt x="219991" y="273068"/>
                  </a:lnTo>
                  <a:lnTo>
                    <a:pt x="217746" y="245620"/>
                  </a:lnTo>
                  <a:lnTo>
                    <a:pt x="200383" y="248575"/>
                  </a:lnTo>
                  <a:lnTo>
                    <a:pt x="188527" y="245965"/>
                  </a:lnTo>
                  <a:lnTo>
                    <a:pt x="148890" y="266308"/>
                  </a:lnTo>
                  <a:lnTo>
                    <a:pt x="151240" y="285707"/>
                  </a:lnTo>
                  <a:lnTo>
                    <a:pt x="144681" y="295266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07" name="자유형: 도형 348"/>
            <p:cNvSpPr/>
            <p:nvPr/>
          </p:nvSpPr>
          <p:spPr>
            <a:xfrm>
              <a:off x="6725160" y="4027680"/>
              <a:ext cx="389160" cy="227520"/>
            </a:xfrm>
            <a:custGeom>
              <a:avLst/>
              <a:gdLst/>
              <a:ahLst/>
              <a:cxnLst/>
              <a:rect l="l" t="t" r="r" b="b"/>
              <a:pathLst>
                <a:path w="308372" h="185417">
                  <a:moveTo>
                    <a:pt x="4464" y="56971"/>
                  </a:moveTo>
                  <a:lnTo>
                    <a:pt x="22732" y="56437"/>
                  </a:lnTo>
                  <a:lnTo>
                    <a:pt x="31312" y="38043"/>
                  </a:lnTo>
                  <a:lnTo>
                    <a:pt x="42151" y="43829"/>
                  </a:lnTo>
                  <a:cubicBezTo>
                    <a:pt x="42151" y="43829"/>
                    <a:pt x="58111" y="38955"/>
                    <a:pt x="61618" y="29523"/>
                  </a:cubicBezTo>
                  <a:cubicBezTo>
                    <a:pt x="65126" y="20090"/>
                    <a:pt x="69865" y="10218"/>
                    <a:pt x="77582" y="6508"/>
                  </a:cubicBezTo>
                  <a:cubicBezTo>
                    <a:pt x="85295" y="2798"/>
                    <a:pt x="97727" y="-4308"/>
                    <a:pt x="95899" y="3552"/>
                  </a:cubicBezTo>
                  <a:cubicBezTo>
                    <a:pt x="94068" y="11444"/>
                    <a:pt x="80823" y="20090"/>
                    <a:pt x="90953" y="22826"/>
                  </a:cubicBezTo>
                  <a:cubicBezTo>
                    <a:pt x="101083" y="25593"/>
                    <a:pt x="106847" y="30717"/>
                    <a:pt x="114490" y="32856"/>
                  </a:cubicBezTo>
                  <a:cubicBezTo>
                    <a:pt x="122130" y="35025"/>
                    <a:pt x="129920" y="37131"/>
                    <a:pt x="129920" y="37131"/>
                  </a:cubicBezTo>
                  <a:lnTo>
                    <a:pt x="147501" y="25309"/>
                  </a:lnTo>
                  <a:lnTo>
                    <a:pt x="159350" y="26284"/>
                  </a:lnTo>
                  <a:lnTo>
                    <a:pt x="174092" y="18455"/>
                  </a:lnTo>
                  <a:lnTo>
                    <a:pt x="185173" y="12167"/>
                  </a:lnTo>
                  <a:lnTo>
                    <a:pt x="191624" y="9872"/>
                  </a:lnTo>
                  <a:cubicBezTo>
                    <a:pt x="191624" y="9872"/>
                    <a:pt x="198099" y="14934"/>
                    <a:pt x="204399" y="9243"/>
                  </a:cubicBezTo>
                  <a:cubicBezTo>
                    <a:pt x="210699" y="3552"/>
                    <a:pt x="214557" y="2672"/>
                    <a:pt x="221835" y="4684"/>
                  </a:cubicBezTo>
                  <a:cubicBezTo>
                    <a:pt x="229114" y="6728"/>
                    <a:pt x="234530" y="8929"/>
                    <a:pt x="234530" y="8929"/>
                  </a:cubicBezTo>
                  <a:lnTo>
                    <a:pt x="251409" y="32573"/>
                  </a:lnTo>
                  <a:cubicBezTo>
                    <a:pt x="251409" y="32573"/>
                    <a:pt x="246210" y="36880"/>
                    <a:pt x="252131" y="42225"/>
                  </a:cubicBezTo>
                  <a:cubicBezTo>
                    <a:pt x="258052" y="47602"/>
                    <a:pt x="261069" y="52066"/>
                    <a:pt x="261069" y="52066"/>
                  </a:cubicBezTo>
                  <a:lnTo>
                    <a:pt x="259115" y="58480"/>
                  </a:lnTo>
                  <a:lnTo>
                    <a:pt x="262553" y="69013"/>
                  </a:lnTo>
                  <a:cubicBezTo>
                    <a:pt x="262553" y="69013"/>
                    <a:pt x="280852" y="64108"/>
                    <a:pt x="286114" y="65680"/>
                  </a:cubicBezTo>
                  <a:cubicBezTo>
                    <a:pt x="291375" y="67252"/>
                    <a:pt x="296206" y="70554"/>
                    <a:pt x="300804" y="73604"/>
                  </a:cubicBezTo>
                  <a:cubicBezTo>
                    <a:pt x="305410" y="76685"/>
                    <a:pt x="311913" y="81590"/>
                    <a:pt x="306030" y="86620"/>
                  </a:cubicBezTo>
                  <a:cubicBezTo>
                    <a:pt x="300145" y="91619"/>
                    <a:pt x="295535" y="99700"/>
                    <a:pt x="297401" y="107435"/>
                  </a:cubicBezTo>
                  <a:cubicBezTo>
                    <a:pt x="299268" y="115200"/>
                    <a:pt x="297994" y="123564"/>
                    <a:pt x="297994" y="123564"/>
                  </a:cubicBezTo>
                  <a:cubicBezTo>
                    <a:pt x="297994" y="123564"/>
                    <a:pt x="292614" y="129097"/>
                    <a:pt x="285854" y="137083"/>
                  </a:cubicBezTo>
                  <a:cubicBezTo>
                    <a:pt x="279099" y="145070"/>
                    <a:pt x="272778" y="152207"/>
                    <a:pt x="272778" y="152207"/>
                  </a:cubicBezTo>
                  <a:cubicBezTo>
                    <a:pt x="272778" y="152207"/>
                    <a:pt x="258782" y="151295"/>
                    <a:pt x="256221" y="158401"/>
                  </a:cubicBezTo>
                  <a:cubicBezTo>
                    <a:pt x="253664" y="165507"/>
                    <a:pt x="239086" y="174373"/>
                    <a:pt x="231468" y="163651"/>
                  </a:cubicBezTo>
                  <a:cubicBezTo>
                    <a:pt x="223849" y="152930"/>
                    <a:pt x="219829" y="152175"/>
                    <a:pt x="219829" y="152175"/>
                  </a:cubicBezTo>
                  <a:lnTo>
                    <a:pt x="200446" y="163148"/>
                  </a:lnTo>
                  <a:lnTo>
                    <a:pt x="193192" y="160665"/>
                  </a:lnTo>
                  <a:lnTo>
                    <a:pt x="182118" y="166921"/>
                  </a:lnTo>
                  <a:lnTo>
                    <a:pt x="171241" y="162709"/>
                  </a:lnTo>
                  <a:lnTo>
                    <a:pt x="158273" y="173021"/>
                  </a:lnTo>
                  <a:cubicBezTo>
                    <a:pt x="158273" y="173021"/>
                    <a:pt x="146508" y="173210"/>
                    <a:pt x="142649" y="178398"/>
                  </a:cubicBezTo>
                  <a:cubicBezTo>
                    <a:pt x="138791" y="183585"/>
                    <a:pt x="125641" y="187893"/>
                    <a:pt x="125199" y="183774"/>
                  </a:cubicBezTo>
                  <a:cubicBezTo>
                    <a:pt x="124760" y="179655"/>
                    <a:pt x="115118" y="179498"/>
                    <a:pt x="112483" y="180347"/>
                  </a:cubicBezTo>
                  <a:cubicBezTo>
                    <a:pt x="109853" y="181196"/>
                    <a:pt x="104349" y="183963"/>
                    <a:pt x="99645" y="183365"/>
                  </a:cubicBezTo>
                  <a:cubicBezTo>
                    <a:pt x="94945" y="182799"/>
                    <a:pt x="95184" y="178492"/>
                    <a:pt x="95184" y="178492"/>
                  </a:cubicBezTo>
                  <a:lnTo>
                    <a:pt x="86965" y="178366"/>
                  </a:lnTo>
                  <a:cubicBezTo>
                    <a:pt x="86965" y="178366"/>
                    <a:pt x="76600" y="170380"/>
                    <a:pt x="86211" y="170286"/>
                  </a:cubicBezTo>
                  <a:cubicBezTo>
                    <a:pt x="95822" y="170223"/>
                    <a:pt x="95973" y="169437"/>
                    <a:pt x="94584" y="162362"/>
                  </a:cubicBezTo>
                  <a:cubicBezTo>
                    <a:pt x="93195" y="155288"/>
                    <a:pt x="77708" y="138687"/>
                    <a:pt x="77708" y="138687"/>
                  </a:cubicBezTo>
                  <a:lnTo>
                    <a:pt x="68676" y="133719"/>
                  </a:lnTo>
                  <a:lnTo>
                    <a:pt x="41365" y="130072"/>
                  </a:lnTo>
                  <a:lnTo>
                    <a:pt x="31807" y="134851"/>
                  </a:lnTo>
                  <a:lnTo>
                    <a:pt x="18435" y="135386"/>
                  </a:lnTo>
                  <a:lnTo>
                    <a:pt x="12157" y="129632"/>
                  </a:lnTo>
                  <a:cubicBezTo>
                    <a:pt x="12157" y="129632"/>
                    <a:pt x="-2807" y="130732"/>
                    <a:pt x="469" y="120608"/>
                  </a:cubicBezTo>
                  <a:cubicBezTo>
                    <a:pt x="3745" y="110484"/>
                    <a:pt x="1777" y="100455"/>
                    <a:pt x="1777" y="100455"/>
                  </a:cubicBezTo>
                  <a:lnTo>
                    <a:pt x="3040" y="82721"/>
                  </a:lnTo>
                  <a:lnTo>
                    <a:pt x="12199" y="81275"/>
                  </a:lnTo>
                  <a:lnTo>
                    <a:pt x="17822" y="74106"/>
                  </a:lnTo>
                  <a:lnTo>
                    <a:pt x="4464" y="56971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08" name="자유형: 도형 349"/>
            <p:cNvSpPr/>
            <p:nvPr/>
          </p:nvSpPr>
          <p:spPr>
            <a:xfrm>
              <a:off x="6954840" y="3048480"/>
              <a:ext cx="815040" cy="201960"/>
            </a:xfrm>
            <a:custGeom>
              <a:avLst/>
              <a:gdLst/>
              <a:ahLst/>
              <a:cxnLst/>
              <a:rect l="l" t="t" r="r" b="b"/>
              <a:pathLst>
                <a:path w="645357" h="164765">
                  <a:moveTo>
                    <a:pt x="0" y="88961"/>
                  </a:moveTo>
                  <a:cubicBezTo>
                    <a:pt x="26592" y="74780"/>
                    <a:pt x="5419" y="45823"/>
                    <a:pt x="20046" y="30039"/>
                  </a:cubicBezTo>
                  <a:cubicBezTo>
                    <a:pt x="28521" y="20858"/>
                    <a:pt x="34056" y="9760"/>
                    <a:pt x="49592" y="13564"/>
                  </a:cubicBezTo>
                  <a:cubicBezTo>
                    <a:pt x="65667" y="17494"/>
                    <a:pt x="61841" y="10420"/>
                    <a:pt x="70753" y="5012"/>
                  </a:cubicBezTo>
                  <a:cubicBezTo>
                    <a:pt x="76506" y="1522"/>
                    <a:pt x="84598" y="-2565"/>
                    <a:pt x="90895" y="2088"/>
                  </a:cubicBezTo>
                  <a:cubicBezTo>
                    <a:pt x="95051" y="5169"/>
                    <a:pt x="118679" y="16551"/>
                    <a:pt x="122755" y="12212"/>
                  </a:cubicBezTo>
                  <a:cubicBezTo>
                    <a:pt x="126904" y="7779"/>
                    <a:pt x="134695" y="7182"/>
                    <a:pt x="138560" y="12275"/>
                  </a:cubicBezTo>
                  <a:cubicBezTo>
                    <a:pt x="139949" y="14098"/>
                    <a:pt x="142514" y="17872"/>
                    <a:pt x="145351" y="18249"/>
                  </a:cubicBezTo>
                  <a:lnTo>
                    <a:pt x="152742" y="13533"/>
                  </a:lnTo>
                  <a:cubicBezTo>
                    <a:pt x="156615" y="19286"/>
                    <a:pt x="163121" y="26487"/>
                    <a:pt x="169768" y="29914"/>
                  </a:cubicBezTo>
                  <a:lnTo>
                    <a:pt x="169305" y="53306"/>
                  </a:lnTo>
                  <a:cubicBezTo>
                    <a:pt x="171431" y="56230"/>
                    <a:pt x="173848" y="60537"/>
                    <a:pt x="176419" y="63084"/>
                  </a:cubicBezTo>
                  <a:cubicBezTo>
                    <a:pt x="181098" y="67675"/>
                    <a:pt x="187398" y="72014"/>
                    <a:pt x="192582" y="76227"/>
                  </a:cubicBezTo>
                  <a:cubicBezTo>
                    <a:pt x="199233" y="74246"/>
                    <a:pt x="206487" y="76887"/>
                    <a:pt x="211671" y="80534"/>
                  </a:cubicBezTo>
                  <a:cubicBezTo>
                    <a:pt x="221033" y="87169"/>
                    <a:pt x="225874" y="84873"/>
                    <a:pt x="229118" y="75189"/>
                  </a:cubicBezTo>
                  <a:cubicBezTo>
                    <a:pt x="230813" y="70127"/>
                    <a:pt x="234692" y="65317"/>
                    <a:pt x="240311" y="63241"/>
                  </a:cubicBezTo>
                  <a:lnTo>
                    <a:pt x="250803" y="65725"/>
                  </a:lnTo>
                  <a:cubicBezTo>
                    <a:pt x="251876" y="65474"/>
                    <a:pt x="264753" y="62015"/>
                    <a:pt x="264967" y="62015"/>
                  </a:cubicBezTo>
                  <a:cubicBezTo>
                    <a:pt x="265532" y="62015"/>
                    <a:pt x="282397" y="65222"/>
                    <a:pt x="284059" y="65537"/>
                  </a:cubicBezTo>
                  <a:cubicBezTo>
                    <a:pt x="284070" y="61261"/>
                    <a:pt x="286515" y="56293"/>
                    <a:pt x="292018" y="56293"/>
                  </a:cubicBezTo>
                  <a:cubicBezTo>
                    <a:pt x="298763" y="56293"/>
                    <a:pt x="306003" y="57865"/>
                    <a:pt x="312482" y="59531"/>
                  </a:cubicBezTo>
                  <a:lnTo>
                    <a:pt x="318712" y="67675"/>
                  </a:lnTo>
                  <a:cubicBezTo>
                    <a:pt x="323640" y="74120"/>
                    <a:pt x="325752" y="65599"/>
                    <a:pt x="326124" y="62172"/>
                  </a:cubicBezTo>
                  <a:cubicBezTo>
                    <a:pt x="326811" y="55790"/>
                    <a:pt x="327158" y="49030"/>
                    <a:pt x="329245" y="42867"/>
                  </a:cubicBezTo>
                  <a:lnTo>
                    <a:pt x="342880" y="46074"/>
                  </a:lnTo>
                  <a:lnTo>
                    <a:pt x="362144" y="40950"/>
                  </a:lnTo>
                  <a:lnTo>
                    <a:pt x="363168" y="35321"/>
                  </a:lnTo>
                  <a:lnTo>
                    <a:pt x="398904" y="28624"/>
                  </a:lnTo>
                  <a:lnTo>
                    <a:pt x="402381" y="37523"/>
                  </a:lnTo>
                  <a:lnTo>
                    <a:pt x="408649" y="42144"/>
                  </a:lnTo>
                  <a:lnTo>
                    <a:pt x="406895" y="60223"/>
                  </a:lnTo>
                  <a:lnTo>
                    <a:pt x="414787" y="64939"/>
                  </a:lnTo>
                  <a:cubicBezTo>
                    <a:pt x="416113" y="71353"/>
                    <a:pt x="418642" y="79842"/>
                    <a:pt x="419172" y="86162"/>
                  </a:cubicBezTo>
                  <a:cubicBezTo>
                    <a:pt x="419193" y="86414"/>
                    <a:pt x="417562" y="95563"/>
                    <a:pt x="417418" y="96381"/>
                  </a:cubicBezTo>
                  <a:cubicBezTo>
                    <a:pt x="421136" y="102732"/>
                    <a:pt x="435325" y="126690"/>
                    <a:pt x="440218" y="131752"/>
                  </a:cubicBezTo>
                  <a:cubicBezTo>
                    <a:pt x="440365" y="131909"/>
                    <a:pt x="447454" y="136091"/>
                    <a:pt x="448110" y="136468"/>
                  </a:cubicBezTo>
                  <a:lnTo>
                    <a:pt x="476172" y="119176"/>
                  </a:lnTo>
                  <a:lnTo>
                    <a:pt x="480556" y="129394"/>
                  </a:lnTo>
                  <a:lnTo>
                    <a:pt x="477049" y="137254"/>
                  </a:lnTo>
                  <a:cubicBezTo>
                    <a:pt x="477519" y="137569"/>
                    <a:pt x="483127" y="141122"/>
                    <a:pt x="483187" y="141185"/>
                  </a:cubicBezTo>
                  <a:cubicBezTo>
                    <a:pt x="486316" y="145712"/>
                    <a:pt x="490210" y="154924"/>
                    <a:pt x="492833" y="160049"/>
                  </a:cubicBezTo>
                  <a:lnTo>
                    <a:pt x="501602" y="157691"/>
                  </a:lnTo>
                  <a:lnTo>
                    <a:pt x="517387" y="164766"/>
                  </a:lnTo>
                  <a:cubicBezTo>
                    <a:pt x="519860" y="161464"/>
                    <a:pt x="526019" y="157440"/>
                    <a:pt x="530541" y="156905"/>
                  </a:cubicBezTo>
                  <a:lnTo>
                    <a:pt x="534925" y="163980"/>
                  </a:lnTo>
                  <a:cubicBezTo>
                    <a:pt x="540454" y="163665"/>
                    <a:pt x="548363" y="162031"/>
                    <a:pt x="551587" y="157691"/>
                  </a:cubicBezTo>
                  <a:cubicBezTo>
                    <a:pt x="554818" y="153352"/>
                    <a:pt x="556866" y="151215"/>
                    <a:pt x="557725" y="145901"/>
                  </a:cubicBezTo>
                  <a:cubicBezTo>
                    <a:pt x="558879" y="138795"/>
                    <a:pt x="560454" y="131721"/>
                    <a:pt x="562110" y="124678"/>
                  </a:cubicBezTo>
                  <a:lnTo>
                    <a:pt x="554218" y="114459"/>
                  </a:lnTo>
                  <a:lnTo>
                    <a:pt x="558602" y="110529"/>
                  </a:lnTo>
                  <a:cubicBezTo>
                    <a:pt x="571844" y="114648"/>
                    <a:pt x="592273" y="122162"/>
                    <a:pt x="604202" y="128608"/>
                  </a:cubicBezTo>
                  <a:cubicBezTo>
                    <a:pt x="611368" y="132507"/>
                    <a:pt x="618387" y="137632"/>
                    <a:pt x="625248" y="141971"/>
                  </a:cubicBezTo>
                  <a:lnTo>
                    <a:pt x="625248" y="128608"/>
                  </a:lnTo>
                  <a:lnTo>
                    <a:pt x="641910" y="117604"/>
                  </a:lnTo>
                  <a:lnTo>
                    <a:pt x="627002" y="97953"/>
                  </a:lnTo>
                  <a:lnTo>
                    <a:pt x="645358" y="85313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09" name="자유형: 도형 350"/>
            <p:cNvSpPr/>
            <p:nvPr/>
          </p:nvSpPr>
          <p:spPr>
            <a:xfrm>
              <a:off x="7609680" y="2949840"/>
              <a:ext cx="159840" cy="203400"/>
            </a:xfrm>
            <a:custGeom>
              <a:avLst/>
              <a:gdLst/>
              <a:ahLst/>
              <a:cxnLst/>
              <a:rect l="l" t="t" r="r" b="b"/>
              <a:pathLst>
                <a:path w="126904" h="165727">
                  <a:moveTo>
                    <a:pt x="0" y="9841"/>
                  </a:moveTo>
                  <a:cubicBezTo>
                    <a:pt x="11533" y="13928"/>
                    <a:pt x="23358" y="723"/>
                    <a:pt x="34470" y="0"/>
                  </a:cubicBezTo>
                  <a:lnTo>
                    <a:pt x="36298" y="4213"/>
                  </a:lnTo>
                  <a:lnTo>
                    <a:pt x="41840" y="5942"/>
                  </a:lnTo>
                  <a:cubicBezTo>
                    <a:pt x="43962" y="8458"/>
                    <a:pt x="45989" y="11633"/>
                    <a:pt x="47140" y="14620"/>
                  </a:cubicBezTo>
                  <a:cubicBezTo>
                    <a:pt x="58470" y="20154"/>
                    <a:pt x="60907" y="13080"/>
                    <a:pt x="68323" y="14620"/>
                  </a:cubicBezTo>
                  <a:cubicBezTo>
                    <a:pt x="74275" y="16633"/>
                    <a:pt x="77359" y="22355"/>
                    <a:pt x="82613" y="25499"/>
                  </a:cubicBezTo>
                  <a:lnTo>
                    <a:pt x="85370" y="39113"/>
                  </a:lnTo>
                  <a:cubicBezTo>
                    <a:pt x="83651" y="41974"/>
                    <a:pt x="80161" y="48577"/>
                    <a:pt x="80287" y="51973"/>
                  </a:cubicBezTo>
                  <a:lnTo>
                    <a:pt x="84423" y="56689"/>
                  </a:lnTo>
                  <a:lnTo>
                    <a:pt x="80975" y="61374"/>
                  </a:lnTo>
                  <a:cubicBezTo>
                    <a:pt x="81708" y="64297"/>
                    <a:pt x="84665" y="68133"/>
                    <a:pt x="87191" y="70020"/>
                  </a:cubicBezTo>
                  <a:cubicBezTo>
                    <a:pt x="89604" y="74390"/>
                    <a:pt x="81918" y="86432"/>
                    <a:pt x="80480" y="91023"/>
                  </a:cubicBezTo>
                  <a:cubicBezTo>
                    <a:pt x="80431" y="91180"/>
                    <a:pt x="79547" y="100046"/>
                    <a:pt x="79547" y="100423"/>
                  </a:cubicBezTo>
                  <a:cubicBezTo>
                    <a:pt x="79547" y="108976"/>
                    <a:pt x="92621" y="115861"/>
                    <a:pt x="98229" y="121269"/>
                  </a:cubicBezTo>
                  <a:cubicBezTo>
                    <a:pt x="99646" y="122653"/>
                    <a:pt x="101926" y="128784"/>
                    <a:pt x="102161" y="130701"/>
                  </a:cubicBezTo>
                  <a:cubicBezTo>
                    <a:pt x="102537" y="133783"/>
                    <a:pt x="101751" y="136424"/>
                    <a:pt x="102842" y="139600"/>
                  </a:cubicBezTo>
                  <a:cubicBezTo>
                    <a:pt x="111127" y="142083"/>
                    <a:pt x="115206" y="153937"/>
                    <a:pt x="117192" y="160477"/>
                  </a:cubicBezTo>
                  <a:lnTo>
                    <a:pt x="126905" y="165727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10" name="자유형: 도형 351"/>
            <p:cNvSpPr/>
            <p:nvPr/>
          </p:nvSpPr>
          <p:spPr>
            <a:xfrm>
              <a:off x="7770240" y="3153240"/>
              <a:ext cx="239400" cy="54000"/>
            </a:xfrm>
            <a:custGeom>
              <a:avLst/>
              <a:gdLst/>
              <a:ahLst/>
              <a:cxnLst/>
              <a:rect l="l" t="t" r="r" b="b"/>
              <a:pathLst>
                <a:path w="189846" h="44363">
                  <a:moveTo>
                    <a:pt x="0" y="0"/>
                  </a:moveTo>
                  <a:cubicBezTo>
                    <a:pt x="337" y="4968"/>
                    <a:pt x="4672" y="6131"/>
                    <a:pt x="6177" y="9181"/>
                  </a:cubicBezTo>
                  <a:cubicBezTo>
                    <a:pt x="8492" y="13897"/>
                    <a:pt x="6959" y="18519"/>
                    <a:pt x="12252" y="24744"/>
                  </a:cubicBezTo>
                  <a:cubicBezTo>
                    <a:pt x="15146" y="23990"/>
                    <a:pt x="18945" y="20594"/>
                    <a:pt x="20552" y="18456"/>
                  </a:cubicBezTo>
                  <a:lnTo>
                    <a:pt x="20331" y="9527"/>
                  </a:lnTo>
                  <a:lnTo>
                    <a:pt x="30064" y="2704"/>
                  </a:lnTo>
                  <a:lnTo>
                    <a:pt x="35147" y="2735"/>
                  </a:lnTo>
                  <a:lnTo>
                    <a:pt x="39784" y="6509"/>
                  </a:lnTo>
                  <a:cubicBezTo>
                    <a:pt x="39419" y="11130"/>
                    <a:pt x="41422" y="20689"/>
                    <a:pt x="45354" y="23864"/>
                  </a:cubicBezTo>
                  <a:cubicBezTo>
                    <a:pt x="48459" y="24304"/>
                    <a:pt x="53145" y="24524"/>
                    <a:pt x="56028" y="25436"/>
                  </a:cubicBezTo>
                  <a:cubicBezTo>
                    <a:pt x="56172" y="25499"/>
                    <a:pt x="60708" y="28643"/>
                    <a:pt x="61136" y="28957"/>
                  </a:cubicBezTo>
                  <a:lnTo>
                    <a:pt x="63359" y="26191"/>
                  </a:lnTo>
                  <a:cubicBezTo>
                    <a:pt x="65425" y="26725"/>
                    <a:pt x="67951" y="29020"/>
                    <a:pt x="68786" y="30750"/>
                  </a:cubicBezTo>
                  <a:lnTo>
                    <a:pt x="73423" y="28832"/>
                  </a:lnTo>
                  <a:lnTo>
                    <a:pt x="76667" y="33548"/>
                  </a:lnTo>
                  <a:lnTo>
                    <a:pt x="81550" y="29649"/>
                  </a:lnTo>
                  <a:lnTo>
                    <a:pt x="87120" y="31913"/>
                  </a:lnTo>
                  <a:lnTo>
                    <a:pt x="91758" y="31441"/>
                  </a:lnTo>
                  <a:lnTo>
                    <a:pt x="94052" y="35623"/>
                  </a:lnTo>
                  <a:lnTo>
                    <a:pt x="90323" y="42289"/>
                  </a:lnTo>
                  <a:lnTo>
                    <a:pt x="98012" y="44364"/>
                  </a:lnTo>
                  <a:cubicBezTo>
                    <a:pt x="102186" y="41440"/>
                    <a:pt x="108037" y="40088"/>
                    <a:pt x="113063" y="42006"/>
                  </a:cubicBezTo>
                  <a:cubicBezTo>
                    <a:pt x="117634" y="41251"/>
                    <a:pt x="125403" y="35434"/>
                    <a:pt x="128571" y="32699"/>
                  </a:cubicBezTo>
                  <a:lnTo>
                    <a:pt x="132040" y="32322"/>
                  </a:lnTo>
                  <a:cubicBezTo>
                    <a:pt x="136498" y="31787"/>
                    <a:pt x="137887" y="31787"/>
                    <a:pt x="139108" y="31378"/>
                  </a:cubicBezTo>
                  <a:cubicBezTo>
                    <a:pt x="140343" y="30970"/>
                    <a:pt x="141395" y="30121"/>
                    <a:pt x="145292" y="27920"/>
                  </a:cubicBezTo>
                  <a:cubicBezTo>
                    <a:pt x="146523" y="27197"/>
                    <a:pt x="147077" y="26568"/>
                    <a:pt x="148445" y="26128"/>
                  </a:cubicBezTo>
                  <a:cubicBezTo>
                    <a:pt x="153391" y="24524"/>
                    <a:pt x="160273" y="23895"/>
                    <a:pt x="165503" y="22921"/>
                  </a:cubicBezTo>
                  <a:cubicBezTo>
                    <a:pt x="168600" y="24587"/>
                    <a:pt x="172301" y="26222"/>
                    <a:pt x="175181" y="28140"/>
                  </a:cubicBezTo>
                  <a:cubicBezTo>
                    <a:pt x="179674" y="31127"/>
                    <a:pt x="182221" y="36692"/>
                    <a:pt x="189846" y="35969"/>
                  </a:cubicBez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11" name="자유형: 도형 352"/>
            <p:cNvSpPr/>
            <p:nvPr/>
          </p:nvSpPr>
          <p:spPr>
            <a:xfrm>
              <a:off x="6856560" y="1477080"/>
              <a:ext cx="20160" cy="23760"/>
            </a:xfrm>
            <a:custGeom>
              <a:avLst/>
              <a:gdLst/>
              <a:ahLst/>
              <a:cxnLst/>
              <a:rect l="l" t="t" r="r" b="b"/>
              <a:pathLst>
                <a:path w="16184" h="19650">
                  <a:moveTo>
                    <a:pt x="0" y="19651"/>
                  </a:moveTo>
                  <a:lnTo>
                    <a:pt x="2473" y="15186"/>
                  </a:lnTo>
                  <a:lnTo>
                    <a:pt x="12600" y="7766"/>
                  </a:lnTo>
                  <a:lnTo>
                    <a:pt x="16051" y="2830"/>
                  </a:lnTo>
                  <a:lnTo>
                    <a:pt x="16185" y="0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12" name="자유형: 도형 353"/>
            <p:cNvSpPr/>
            <p:nvPr/>
          </p:nvSpPr>
          <p:spPr>
            <a:xfrm>
              <a:off x="6856560" y="1357920"/>
              <a:ext cx="426600" cy="290520"/>
            </a:xfrm>
            <a:custGeom>
              <a:avLst/>
              <a:gdLst/>
              <a:ahLst/>
              <a:cxnLst/>
              <a:rect l="l" t="t" r="r" b="b"/>
              <a:pathLst>
                <a:path w="337877" h="236820">
                  <a:moveTo>
                    <a:pt x="16307" y="96907"/>
                  </a:moveTo>
                  <a:cubicBezTo>
                    <a:pt x="15592" y="94109"/>
                    <a:pt x="19675" y="88072"/>
                    <a:pt x="21635" y="86091"/>
                  </a:cubicBezTo>
                  <a:lnTo>
                    <a:pt x="27381" y="85840"/>
                  </a:lnTo>
                  <a:cubicBezTo>
                    <a:pt x="35442" y="87789"/>
                    <a:pt x="38283" y="97567"/>
                    <a:pt x="44898" y="101466"/>
                  </a:cubicBezTo>
                  <a:cubicBezTo>
                    <a:pt x="48097" y="103321"/>
                    <a:pt x="52303" y="104516"/>
                    <a:pt x="55702" y="106151"/>
                  </a:cubicBezTo>
                  <a:cubicBezTo>
                    <a:pt x="58792" y="107660"/>
                    <a:pt x="62170" y="110490"/>
                    <a:pt x="66064" y="110112"/>
                  </a:cubicBezTo>
                  <a:cubicBezTo>
                    <a:pt x="67421" y="109987"/>
                    <a:pt x="68123" y="109609"/>
                    <a:pt x="69438" y="109295"/>
                  </a:cubicBezTo>
                  <a:lnTo>
                    <a:pt x="76190" y="107629"/>
                  </a:lnTo>
                  <a:cubicBezTo>
                    <a:pt x="78849" y="106622"/>
                    <a:pt x="82841" y="103195"/>
                    <a:pt x="86787" y="101718"/>
                  </a:cubicBezTo>
                  <a:cubicBezTo>
                    <a:pt x="92319" y="99611"/>
                    <a:pt x="98327" y="98353"/>
                    <a:pt x="103350" y="95272"/>
                  </a:cubicBezTo>
                  <a:cubicBezTo>
                    <a:pt x="105041" y="90996"/>
                    <a:pt x="103940" y="86028"/>
                    <a:pt x="104045" y="81658"/>
                  </a:cubicBezTo>
                  <a:cubicBezTo>
                    <a:pt x="104119" y="78702"/>
                    <a:pt x="104178" y="74867"/>
                    <a:pt x="104739" y="72005"/>
                  </a:cubicBezTo>
                  <a:cubicBezTo>
                    <a:pt x="105020" y="70559"/>
                    <a:pt x="106385" y="68987"/>
                    <a:pt x="106809" y="67541"/>
                  </a:cubicBezTo>
                  <a:lnTo>
                    <a:pt x="112877" y="46947"/>
                  </a:lnTo>
                  <a:cubicBezTo>
                    <a:pt x="113807" y="46821"/>
                    <a:pt x="123702" y="45532"/>
                    <a:pt x="123955" y="45438"/>
                  </a:cubicBezTo>
                  <a:cubicBezTo>
                    <a:pt x="127318" y="44180"/>
                    <a:pt x="135804" y="37797"/>
                    <a:pt x="137470" y="34433"/>
                  </a:cubicBezTo>
                  <a:lnTo>
                    <a:pt x="143685" y="34024"/>
                  </a:lnTo>
                  <a:lnTo>
                    <a:pt x="162038" y="59618"/>
                  </a:lnTo>
                  <a:cubicBezTo>
                    <a:pt x="166064" y="56945"/>
                    <a:pt x="169989" y="51066"/>
                    <a:pt x="171845" y="47041"/>
                  </a:cubicBezTo>
                  <a:cubicBezTo>
                    <a:pt x="170267" y="43299"/>
                    <a:pt x="168930" y="39181"/>
                    <a:pt x="168239" y="35219"/>
                  </a:cubicBezTo>
                  <a:cubicBezTo>
                    <a:pt x="171806" y="33459"/>
                    <a:pt x="176577" y="28396"/>
                    <a:pt x="177233" y="24718"/>
                  </a:cubicBezTo>
                  <a:lnTo>
                    <a:pt x="177075" y="18775"/>
                  </a:lnTo>
                  <a:lnTo>
                    <a:pt x="176994" y="15788"/>
                  </a:lnTo>
                  <a:cubicBezTo>
                    <a:pt x="180905" y="10601"/>
                    <a:pt x="187595" y="11575"/>
                    <a:pt x="192888" y="7865"/>
                  </a:cubicBezTo>
                  <a:lnTo>
                    <a:pt x="194954" y="3904"/>
                  </a:lnTo>
                  <a:lnTo>
                    <a:pt x="198945" y="1608"/>
                  </a:lnTo>
                  <a:cubicBezTo>
                    <a:pt x="205782" y="-2353"/>
                    <a:pt x="209546" y="2017"/>
                    <a:pt x="216126" y="3904"/>
                  </a:cubicBezTo>
                  <a:cubicBezTo>
                    <a:pt x="218676" y="4658"/>
                    <a:pt x="229901" y="4658"/>
                    <a:pt x="232700" y="4658"/>
                  </a:cubicBezTo>
                  <a:cubicBezTo>
                    <a:pt x="238182" y="67"/>
                    <a:pt x="248327" y="2143"/>
                    <a:pt x="254795" y="3432"/>
                  </a:cubicBezTo>
                  <a:cubicBezTo>
                    <a:pt x="258074" y="5853"/>
                    <a:pt x="264602" y="12204"/>
                    <a:pt x="264701" y="16291"/>
                  </a:cubicBezTo>
                  <a:cubicBezTo>
                    <a:pt x="264816" y="21039"/>
                    <a:pt x="263473" y="26101"/>
                    <a:pt x="263322" y="30880"/>
                  </a:cubicBezTo>
                  <a:cubicBezTo>
                    <a:pt x="263171" y="35691"/>
                    <a:pt x="263627" y="40690"/>
                    <a:pt x="263778" y="45500"/>
                  </a:cubicBezTo>
                  <a:cubicBezTo>
                    <a:pt x="267913" y="51946"/>
                    <a:pt x="274119" y="53518"/>
                    <a:pt x="273059" y="61913"/>
                  </a:cubicBezTo>
                  <a:lnTo>
                    <a:pt x="272288" y="68044"/>
                  </a:lnTo>
                  <a:cubicBezTo>
                    <a:pt x="274038" y="72980"/>
                    <a:pt x="279194" y="76344"/>
                    <a:pt x="281958" y="80903"/>
                  </a:cubicBezTo>
                  <a:cubicBezTo>
                    <a:pt x="284340" y="94738"/>
                    <a:pt x="259008" y="112408"/>
                    <a:pt x="272754" y="125456"/>
                  </a:cubicBezTo>
                  <a:lnTo>
                    <a:pt x="283109" y="124230"/>
                  </a:lnTo>
                  <a:cubicBezTo>
                    <a:pt x="290149" y="117438"/>
                    <a:pt x="295508" y="119136"/>
                    <a:pt x="304516" y="117281"/>
                  </a:cubicBezTo>
                  <a:cubicBezTo>
                    <a:pt x="311746" y="115803"/>
                    <a:pt x="319676" y="112313"/>
                    <a:pt x="325232" y="107880"/>
                  </a:cubicBezTo>
                  <a:cubicBezTo>
                    <a:pt x="332669" y="113477"/>
                    <a:pt x="336657" y="126430"/>
                    <a:pt x="337878" y="134637"/>
                  </a:cubicBezTo>
                  <a:lnTo>
                    <a:pt x="333981" y="138567"/>
                  </a:lnTo>
                  <a:cubicBezTo>
                    <a:pt x="325303" y="140422"/>
                    <a:pt x="314499" y="143157"/>
                    <a:pt x="309816" y="150703"/>
                  </a:cubicBezTo>
                  <a:cubicBezTo>
                    <a:pt x="309024" y="151992"/>
                    <a:pt x="308925" y="153847"/>
                    <a:pt x="308192" y="155168"/>
                  </a:cubicBezTo>
                  <a:cubicBezTo>
                    <a:pt x="306519" y="158186"/>
                    <a:pt x="304302" y="161204"/>
                    <a:pt x="302408" y="164129"/>
                  </a:cubicBezTo>
                  <a:lnTo>
                    <a:pt x="303724" y="170794"/>
                  </a:lnTo>
                  <a:lnTo>
                    <a:pt x="316716" y="173247"/>
                  </a:lnTo>
                  <a:lnTo>
                    <a:pt x="316716" y="177711"/>
                  </a:lnTo>
                  <a:cubicBezTo>
                    <a:pt x="313601" y="180101"/>
                    <a:pt x="306316" y="186704"/>
                    <a:pt x="305442" y="190571"/>
                  </a:cubicBezTo>
                  <a:lnTo>
                    <a:pt x="299914" y="194061"/>
                  </a:lnTo>
                  <a:lnTo>
                    <a:pt x="294390" y="192803"/>
                  </a:lnTo>
                  <a:lnTo>
                    <a:pt x="290689" y="197268"/>
                  </a:lnTo>
                  <a:lnTo>
                    <a:pt x="294628" y="201481"/>
                  </a:lnTo>
                  <a:lnTo>
                    <a:pt x="279885" y="213334"/>
                  </a:lnTo>
                  <a:cubicBezTo>
                    <a:pt x="275455" y="213775"/>
                    <a:pt x="271537" y="212297"/>
                    <a:pt x="269303" y="212359"/>
                  </a:cubicBezTo>
                  <a:cubicBezTo>
                    <a:pt x="266058" y="212454"/>
                    <a:pt x="262185" y="213366"/>
                    <a:pt x="258948" y="213838"/>
                  </a:cubicBezTo>
                  <a:cubicBezTo>
                    <a:pt x="256271" y="218208"/>
                    <a:pt x="248070" y="225816"/>
                    <a:pt x="243984" y="228709"/>
                  </a:cubicBezTo>
                  <a:cubicBezTo>
                    <a:pt x="240105" y="231413"/>
                    <a:pt x="231893" y="235123"/>
                    <a:pt x="226972" y="236821"/>
                  </a:cubicBezTo>
                  <a:lnTo>
                    <a:pt x="222166" y="234086"/>
                  </a:lnTo>
                  <a:cubicBezTo>
                    <a:pt x="221524" y="230596"/>
                    <a:pt x="218897" y="224119"/>
                    <a:pt x="215667" y="221760"/>
                  </a:cubicBezTo>
                  <a:lnTo>
                    <a:pt x="215667" y="208901"/>
                  </a:lnTo>
                  <a:cubicBezTo>
                    <a:pt x="210152" y="208021"/>
                    <a:pt x="207297" y="211416"/>
                    <a:pt x="205080" y="211605"/>
                  </a:cubicBezTo>
                  <a:cubicBezTo>
                    <a:pt x="200134" y="212077"/>
                    <a:pt x="193785" y="211259"/>
                    <a:pt x="188749" y="211133"/>
                  </a:cubicBezTo>
                  <a:cubicBezTo>
                    <a:pt x="180562" y="216667"/>
                    <a:pt x="171136" y="219025"/>
                    <a:pt x="162273" y="223270"/>
                  </a:cubicBezTo>
                  <a:cubicBezTo>
                    <a:pt x="160550" y="224087"/>
                    <a:pt x="159140" y="226099"/>
                    <a:pt x="157428" y="226980"/>
                  </a:cubicBezTo>
                  <a:cubicBezTo>
                    <a:pt x="153103" y="229181"/>
                    <a:pt x="146393" y="228835"/>
                    <a:pt x="142016" y="226980"/>
                  </a:cubicBezTo>
                  <a:lnTo>
                    <a:pt x="131188" y="229212"/>
                  </a:lnTo>
                  <a:lnTo>
                    <a:pt x="120598" y="225502"/>
                  </a:lnTo>
                  <a:cubicBezTo>
                    <a:pt x="114112" y="226603"/>
                    <a:pt x="106784" y="233205"/>
                    <a:pt x="100120" y="229935"/>
                  </a:cubicBezTo>
                  <a:cubicBezTo>
                    <a:pt x="96384" y="222484"/>
                    <a:pt x="82336" y="191766"/>
                    <a:pt x="77555" y="187112"/>
                  </a:cubicBezTo>
                  <a:cubicBezTo>
                    <a:pt x="69073" y="184880"/>
                    <a:pt x="62304" y="197299"/>
                    <a:pt x="51549" y="197268"/>
                  </a:cubicBezTo>
                  <a:cubicBezTo>
                    <a:pt x="46877" y="194124"/>
                    <a:pt x="42587" y="189753"/>
                    <a:pt x="38883" y="185729"/>
                  </a:cubicBezTo>
                  <a:cubicBezTo>
                    <a:pt x="43646" y="181736"/>
                    <a:pt x="46007" y="175668"/>
                    <a:pt x="43737" y="170008"/>
                  </a:cubicBezTo>
                  <a:lnTo>
                    <a:pt x="38900" y="166078"/>
                  </a:lnTo>
                  <a:cubicBezTo>
                    <a:pt x="39076" y="163060"/>
                    <a:pt x="39974" y="159695"/>
                    <a:pt x="41194" y="156897"/>
                  </a:cubicBezTo>
                  <a:cubicBezTo>
                    <a:pt x="40903" y="154854"/>
                    <a:pt x="38262" y="149508"/>
                    <a:pt x="36592" y="148251"/>
                  </a:cubicBezTo>
                  <a:cubicBezTo>
                    <a:pt x="29886" y="143157"/>
                    <a:pt x="22797" y="138221"/>
                    <a:pt x="16332" y="132907"/>
                  </a:cubicBezTo>
                  <a:cubicBezTo>
                    <a:pt x="14767" y="131618"/>
                    <a:pt x="13701" y="129543"/>
                    <a:pt x="12189" y="128191"/>
                  </a:cubicBezTo>
                  <a:cubicBezTo>
                    <a:pt x="9348" y="125644"/>
                    <a:pt x="5125" y="122909"/>
                    <a:pt x="1379" y="121494"/>
                  </a:cubicBezTo>
                  <a:lnTo>
                    <a:pt x="0" y="116558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13" name="자유형: 도형 354"/>
            <p:cNvSpPr/>
            <p:nvPr/>
          </p:nvSpPr>
          <p:spPr>
            <a:xfrm>
              <a:off x="6821640" y="1501200"/>
              <a:ext cx="41760" cy="197640"/>
            </a:xfrm>
            <a:custGeom>
              <a:avLst/>
              <a:gdLst/>
              <a:ahLst/>
              <a:cxnLst/>
              <a:rect l="l" t="t" r="r" b="b"/>
              <a:pathLst>
                <a:path w="33435" h="161231">
                  <a:moveTo>
                    <a:pt x="27679" y="0"/>
                  </a:moveTo>
                  <a:lnTo>
                    <a:pt x="8681" y="29083"/>
                  </a:lnTo>
                  <a:lnTo>
                    <a:pt x="2354" y="44553"/>
                  </a:lnTo>
                  <a:lnTo>
                    <a:pt x="2129" y="49520"/>
                  </a:lnTo>
                  <a:lnTo>
                    <a:pt x="4430" y="62883"/>
                  </a:lnTo>
                  <a:lnTo>
                    <a:pt x="4195" y="71780"/>
                  </a:lnTo>
                  <a:lnTo>
                    <a:pt x="14795" y="82188"/>
                  </a:lnTo>
                  <a:lnTo>
                    <a:pt x="25136" y="88130"/>
                  </a:lnTo>
                  <a:lnTo>
                    <a:pt x="29980" y="88633"/>
                  </a:lnTo>
                  <a:lnTo>
                    <a:pt x="33190" y="93569"/>
                  </a:lnTo>
                  <a:lnTo>
                    <a:pt x="33435" y="102499"/>
                  </a:lnTo>
                  <a:lnTo>
                    <a:pt x="27206" y="108441"/>
                  </a:lnTo>
                  <a:lnTo>
                    <a:pt x="26985" y="113378"/>
                  </a:lnTo>
                  <a:lnTo>
                    <a:pt x="28830" y="117339"/>
                  </a:lnTo>
                  <a:lnTo>
                    <a:pt x="29286" y="122056"/>
                  </a:lnTo>
                  <a:lnTo>
                    <a:pt x="26290" y="126740"/>
                  </a:lnTo>
                  <a:lnTo>
                    <a:pt x="21004" y="128249"/>
                  </a:lnTo>
                  <a:lnTo>
                    <a:pt x="16170" y="131456"/>
                  </a:lnTo>
                  <a:lnTo>
                    <a:pt x="12484" y="140354"/>
                  </a:lnTo>
                  <a:lnTo>
                    <a:pt x="0" y="161231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14" name="자유형: 도형 355"/>
            <p:cNvSpPr/>
            <p:nvPr/>
          </p:nvSpPr>
          <p:spPr>
            <a:xfrm>
              <a:off x="7212600" y="701280"/>
              <a:ext cx="766440" cy="1192680"/>
            </a:xfrm>
            <a:custGeom>
              <a:avLst/>
              <a:gdLst/>
              <a:ahLst/>
              <a:cxnLst/>
              <a:rect l="l" t="t" r="r" b="b"/>
              <a:pathLst>
                <a:path w="606927" h="971254">
                  <a:moveTo>
                    <a:pt x="0" y="0"/>
                  </a:moveTo>
                  <a:lnTo>
                    <a:pt x="3855" y="26631"/>
                  </a:lnTo>
                  <a:cubicBezTo>
                    <a:pt x="3893" y="26945"/>
                    <a:pt x="2087" y="30247"/>
                    <a:pt x="2006" y="30813"/>
                  </a:cubicBezTo>
                  <a:cubicBezTo>
                    <a:pt x="1165" y="36975"/>
                    <a:pt x="1368" y="44615"/>
                    <a:pt x="2424" y="50778"/>
                  </a:cubicBezTo>
                  <a:lnTo>
                    <a:pt x="13568" y="54991"/>
                  </a:lnTo>
                  <a:cubicBezTo>
                    <a:pt x="19615" y="54488"/>
                    <a:pt x="27942" y="50746"/>
                    <a:pt x="32450" y="47225"/>
                  </a:cubicBezTo>
                  <a:lnTo>
                    <a:pt x="40780" y="51375"/>
                  </a:lnTo>
                  <a:cubicBezTo>
                    <a:pt x="41015" y="51784"/>
                    <a:pt x="43485" y="56092"/>
                    <a:pt x="43502" y="56249"/>
                  </a:cubicBezTo>
                  <a:cubicBezTo>
                    <a:pt x="44057" y="60650"/>
                    <a:pt x="43299" y="66247"/>
                    <a:pt x="43208" y="70743"/>
                  </a:cubicBezTo>
                  <a:lnTo>
                    <a:pt x="50609" y="74893"/>
                  </a:lnTo>
                  <a:cubicBezTo>
                    <a:pt x="50332" y="77629"/>
                    <a:pt x="48466" y="83603"/>
                    <a:pt x="45705" y="85300"/>
                  </a:cubicBezTo>
                  <a:lnTo>
                    <a:pt x="48736" y="89639"/>
                  </a:lnTo>
                  <a:lnTo>
                    <a:pt x="54801" y="98349"/>
                  </a:lnTo>
                  <a:cubicBezTo>
                    <a:pt x="55369" y="99449"/>
                    <a:pt x="55257" y="100204"/>
                    <a:pt x="55548" y="101398"/>
                  </a:cubicBezTo>
                  <a:lnTo>
                    <a:pt x="57045" y="107593"/>
                  </a:lnTo>
                  <a:cubicBezTo>
                    <a:pt x="57810" y="112749"/>
                    <a:pt x="56842" y="121395"/>
                    <a:pt x="60048" y="125891"/>
                  </a:cubicBezTo>
                  <a:cubicBezTo>
                    <a:pt x="62981" y="126992"/>
                    <a:pt x="67327" y="127149"/>
                    <a:pt x="70410" y="126646"/>
                  </a:cubicBezTo>
                  <a:lnTo>
                    <a:pt x="75699" y="130356"/>
                  </a:lnTo>
                  <a:lnTo>
                    <a:pt x="78235" y="139254"/>
                  </a:lnTo>
                  <a:lnTo>
                    <a:pt x="83066" y="139506"/>
                  </a:lnTo>
                  <a:cubicBezTo>
                    <a:pt x="91516" y="134758"/>
                    <a:pt x="101095" y="130199"/>
                    <a:pt x="109075" y="124917"/>
                  </a:cubicBezTo>
                  <a:cubicBezTo>
                    <a:pt x="112232" y="122810"/>
                    <a:pt x="115747" y="118597"/>
                    <a:pt x="118518" y="115987"/>
                  </a:cubicBezTo>
                  <a:cubicBezTo>
                    <a:pt x="118605" y="113283"/>
                    <a:pt x="120517" y="109259"/>
                    <a:pt x="122653" y="107309"/>
                  </a:cubicBezTo>
                  <a:lnTo>
                    <a:pt x="138073" y="105832"/>
                  </a:lnTo>
                  <a:lnTo>
                    <a:pt x="143836" y="108819"/>
                  </a:lnTo>
                  <a:cubicBezTo>
                    <a:pt x="144155" y="111523"/>
                    <a:pt x="142409" y="115893"/>
                    <a:pt x="140135" y="117717"/>
                  </a:cubicBezTo>
                  <a:lnTo>
                    <a:pt x="141062" y="122181"/>
                  </a:lnTo>
                  <a:lnTo>
                    <a:pt x="137834" y="126646"/>
                  </a:lnTo>
                  <a:lnTo>
                    <a:pt x="139223" y="131079"/>
                  </a:lnTo>
                  <a:cubicBezTo>
                    <a:pt x="137733" y="136361"/>
                    <a:pt x="132580" y="139726"/>
                    <a:pt x="130703" y="144945"/>
                  </a:cubicBezTo>
                  <a:lnTo>
                    <a:pt x="131847" y="153371"/>
                  </a:lnTo>
                  <a:lnTo>
                    <a:pt x="137150" y="156106"/>
                  </a:lnTo>
                  <a:lnTo>
                    <a:pt x="138301" y="160791"/>
                  </a:lnTo>
                  <a:lnTo>
                    <a:pt x="148884" y="165256"/>
                  </a:lnTo>
                  <a:cubicBezTo>
                    <a:pt x="151395" y="163369"/>
                    <a:pt x="156376" y="161640"/>
                    <a:pt x="159687" y="161797"/>
                  </a:cubicBezTo>
                  <a:cubicBezTo>
                    <a:pt x="161694" y="163715"/>
                    <a:pt x="162939" y="166702"/>
                    <a:pt x="163770" y="169123"/>
                  </a:cubicBezTo>
                  <a:cubicBezTo>
                    <a:pt x="164517" y="171293"/>
                    <a:pt x="166356" y="177550"/>
                    <a:pt x="168225" y="179373"/>
                  </a:cubicBezTo>
                  <a:cubicBezTo>
                    <a:pt x="170344" y="181417"/>
                    <a:pt x="180113" y="185661"/>
                    <a:pt x="182957" y="186793"/>
                  </a:cubicBezTo>
                  <a:cubicBezTo>
                    <a:pt x="183810" y="183680"/>
                    <a:pt x="185434" y="180002"/>
                    <a:pt x="187563" y="177392"/>
                  </a:cubicBezTo>
                  <a:cubicBezTo>
                    <a:pt x="192547" y="174499"/>
                    <a:pt x="201980" y="172927"/>
                    <a:pt x="207795" y="173902"/>
                  </a:cubicBezTo>
                  <a:lnTo>
                    <a:pt x="211948" y="165004"/>
                  </a:lnTo>
                  <a:lnTo>
                    <a:pt x="217248" y="163526"/>
                  </a:lnTo>
                  <a:lnTo>
                    <a:pt x="223008" y="167237"/>
                  </a:lnTo>
                  <a:lnTo>
                    <a:pt x="233601" y="167740"/>
                  </a:lnTo>
                  <a:cubicBezTo>
                    <a:pt x="236636" y="169941"/>
                    <a:pt x="239761" y="173431"/>
                    <a:pt x="241413" y="176638"/>
                  </a:cubicBezTo>
                  <a:lnTo>
                    <a:pt x="247176" y="176386"/>
                  </a:lnTo>
                  <a:cubicBezTo>
                    <a:pt x="249053" y="173305"/>
                    <a:pt x="252792" y="170004"/>
                    <a:pt x="256145" y="168211"/>
                  </a:cubicBezTo>
                  <a:cubicBezTo>
                    <a:pt x="265928" y="168306"/>
                    <a:pt x="272470" y="178304"/>
                    <a:pt x="272018" y="186290"/>
                  </a:cubicBezTo>
                  <a:cubicBezTo>
                    <a:pt x="271390" y="197389"/>
                    <a:pt x="269948" y="208865"/>
                    <a:pt x="270881" y="219964"/>
                  </a:cubicBezTo>
                  <a:lnTo>
                    <a:pt x="276181" y="224177"/>
                  </a:lnTo>
                  <a:cubicBezTo>
                    <a:pt x="275652" y="231566"/>
                    <a:pt x="278444" y="235622"/>
                    <a:pt x="280324" y="242224"/>
                  </a:cubicBezTo>
                  <a:cubicBezTo>
                    <a:pt x="281116" y="245023"/>
                    <a:pt x="281085" y="248135"/>
                    <a:pt x="281941" y="250902"/>
                  </a:cubicBezTo>
                  <a:cubicBezTo>
                    <a:pt x="283386" y="255587"/>
                    <a:pt x="289458" y="260240"/>
                    <a:pt x="294593" y="261309"/>
                  </a:cubicBezTo>
                  <a:cubicBezTo>
                    <a:pt x="298101" y="262032"/>
                    <a:pt x="300142" y="261749"/>
                    <a:pt x="303871" y="262944"/>
                  </a:cubicBezTo>
                  <a:cubicBezTo>
                    <a:pt x="308063" y="264328"/>
                    <a:pt x="311777" y="267755"/>
                    <a:pt x="316470" y="268006"/>
                  </a:cubicBezTo>
                  <a:cubicBezTo>
                    <a:pt x="327260" y="268572"/>
                    <a:pt x="339765" y="268037"/>
                    <a:pt x="350060" y="271465"/>
                  </a:cubicBezTo>
                  <a:cubicBezTo>
                    <a:pt x="354515" y="274577"/>
                    <a:pt x="357521" y="284293"/>
                    <a:pt x="357647" y="289292"/>
                  </a:cubicBezTo>
                  <a:cubicBezTo>
                    <a:pt x="357668" y="290046"/>
                    <a:pt x="357110" y="293285"/>
                    <a:pt x="357191" y="293757"/>
                  </a:cubicBezTo>
                  <a:cubicBezTo>
                    <a:pt x="357233" y="293945"/>
                    <a:pt x="359054" y="297529"/>
                    <a:pt x="359268" y="297938"/>
                  </a:cubicBezTo>
                  <a:cubicBezTo>
                    <a:pt x="362863" y="299605"/>
                    <a:pt x="370552" y="302843"/>
                    <a:pt x="374694" y="303158"/>
                  </a:cubicBezTo>
                  <a:cubicBezTo>
                    <a:pt x="376399" y="303283"/>
                    <a:pt x="378272" y="302812"/>
                    <a:pt x="379988" y="302906"/>
                  </a:cubicBezTo>
                  <a:cubicBezTo>
                    <a:pt x="385316" y="303158"/>
                    <a:pt x="396898" y="306710"/>
                    <a:pt x="400928" y="309069"/>
                  </a:cubicBezTo>
                  <a:cubicBezTo>
                    <a:pt x="404040" y="310923"/>
                    <a:pt x="405488" y="315105"/>
                    <a:pt x="407376" y="317746"/>
                  </a:cubicBezTo>
                  <a:cubicBezTo>
                    <a:pt x="409642" y="320953"/>
                    <a:pt x="412300" y="324066"/>
                    <a:pt x="414735" y="327147"/>
                  </a:cubicBezTo>
                  <a:cubicBezTo>
                    <a:pt x="410445" y="338341"/>
                    <a:pt x="413472" y="339252"/>
                    <a:pt x="414735" y="349691"/>
                  </a:cubicBezTo>
                  <a:cubicBezTo>
                    <a:pt x="415345" y="354753"/>
                    <a:pt x="411150" y="358243"/>
                    <a:pt x="409210" y="362582"/>
                  </a:cubicBezTo>
                  <a:cubicBezTo>
                    <a:pt x="409014" y="363022"/>
                    <a:pt x="408726" y="366292"/>
                    <a:pt x="408530" y="367015"/>
                  </a:cubicBezTo>
                  <a:cubicBezTo>
                    <a:pt x="407775" y="369813"/>
                    <a:pt x="406678" y="372674"/>
                    <a:pt x="405766" y="375441"/>
                  </a:cubicBezTo>
                  <a:lnTo>
                    <a:pt x="400932" y="379151"/>
                  </a:lnTo>
                  <a:lnTo>
                    <a:pt x="384593" y="381132"/>
                  </a:lnTo>
                  <a:cubicBezTo>
                    <a:pt x="381724" y="383710"/>
                    <a:pt x="377550" y="386697"/>
                    <a:pt x="375165" y="389558"/>
                  </a:cubicBezTo>
                  <a:cubicBezTo>
                    <a:pt x="373207" y="391885"/>
                    <a:pt x="372439" y="395532"/>
                    <a:pt x="370569" y="397985"/>
                  </a:cubicBezTo>
                  <a:cubicBezTo>
                    <a:pt x="370022" y="398676"/>
                    <a:pt x="366066" y="401380"/>
                    <a:pt x="365704" y="401946"/>
                  </a:cubicBezTo>
                  <a:cubicBezTo>
                    <a:pt x="364164" y="404367"/>
                    <a:pt x="363137" y="408643"/>
                    <a:pt x="362091" y="411379"/>
                  </a:cubicBezTo>
                  <a:cubicBezTo>
                    <a:pt x="350404" y="413328"/>
                    <a:pt x="340281" y="420528"/>
                    <a:pt x="335563" y="430401"/>
                  </a:cubicBezTo>
                  <a:cubicBezTo>
                    <a:pt x="335486" y="434362"/>
                    <a:pt x="337643" y="435557"/>
                    <a:pt x="339249" y="438576"/>
                  </a:cubicBezTo>
                  <a:cubicBezTo>
                    <a:pt x="340663" y="441217"/>
                    <a:pt x="341736" y="444235"/>
                    <a:pt x="342943" y="447002"/>
                  </a:cubicBezTo>
                  <a:cubicBezTo>
                    <a:pt x="341336" y="450240"/>
                    <a:pt x="340175" y="454327"/>
                    <a:pt x="339940" y="457880"/>
                  </a:cubicBezTo>
                  <a:cubicBezTo>
                    <a:pt x="343269" y="463131"/>
                    <a:pt x="347724" y="467690"/>
                    <a:pt x="352059" y="472249"/>
                  </a:cubicBezTo>
                  <a:cubicBezTo>
                    <a:pt x="353340" y="473601"/>
                    <a:pt x="354266" y="474261"/>
                    <a:pt x="355353" y="475739"/>
                  </a:cubicBezTo>
                  <a:cubicBezTo>
                    <a:pt x="355732" y="476242"/>
                    <a:pt x="355585" y="476683"/>
                    <a:pt x="355735" y="477280"/>
                  </a:cubicBezTo>
                  <a:lnTo>
                    <a:pt x="356514" y="480424"/>
                  </a:lnTo>
                  <a:cubicBezTo>
                    <a:pt x="356251" y="486618"/>
                    <a:pt x="349874" y="494195"/>
                    <a:pt x="345465" y="498471"/>
                  </a:cubicBezTo>
                  <a:cubicBezTo>
                    <a:pt x="343195" y="500703"/>
                    <a:pt x="340056" y="502401"/>
                    <a:pt x="337867" y="504665"/>
                  </a:cubicBezTo>
                  <a:cubicBezTo>
                    <a:pt x="336657" y="505923"/>
                    <a:pt x="334405" y="510293"/>
                    <a:pt x="334276" y="512117"/>
                  </a:cubicBezTo>
                  <a:cubicBezTo>
                    <a:pt x="336826" y="512494"/>
                    <a:pt x="340561" y="512620"/>
                    <a:pt x="342946" y="513343"/>
                  </a:cubicBezTo>
                  <a:cubicBezTo>
                    <a:pt x="346633" y="514475"/>
                    <a:pt x="347885" y="517399"/>
                    <a:pt x="353294" y="517053"/>
                  </a:cubicBezTo>
                  <a:cubicBezTo>
                    <a:pt x="356076" y="514506"/>
                    <a:pt x="360138" y="511897"/>
                    <a:pt x="363877" y="510607"/>
                  </a:cubicBezTo>
                  <a:lnTo>
                    <a:pt x="368479" y="519788"/>
                  </a:lnTo>
                  <a:cubicBezTo>
                    <a:pt x="367258" y="524033"/>
                    <a:pt x="365859" y="528340"/>
                    <a:pt x="364799" y="532648"/>
                  </a:cubicBezTo>
                  <a:cubicBezTo>
                    <a:pt x="364410" y="534251"/>
                    <a:pt x="364529" y="536012"/>
                    <a:pt x="364108" y="537616"/>
                  </a:cubicBezTo>
                  <a:cubicBezTo>
                    <a:pt x="362617" y="543212"/>
                    <a:pt x="357875" y="555474"/>
                    <a:pt x="358584" y="561134"/>
                  </a:cubicBezTo>
                  <a:cubicBezTo>
                    <a:pt x="358615" y="561354"/>
                    <a:pt x="361744" y="569277"/>
                    <a:pt x="362039" y="570032"/>
                  </a:cubicBezTo>
                  <a:lnTo>
                    <a:pt x="356279" y="573742"/>
                  </a:lnTo>
                  <a:lnTo>
                    <a:pt x="354224" y="578206"/>
                  </a:lnTo>
                  <a:lnTo>
                    <a:pt x="349376" y="581162"/>
                  </a:lnTo>
                  <a:lnTo>
                    <a:pt x="349151" y="585375"/>
                  </a:lnTo>
                  <a:cubicBezTo>
                    <a:pt x="353571" y="591475"/>
                    <a:pt x="360650" y="595562"/>
                    <a:pt x="367788" y="598769"/>
                  </a:cubicBezTo>
                  <a:cubicBezTo>
                    <a:pt x="370590" y="595971"/>
                    <a:pt x="378942" y="594745"/>
                    <a:pt x="382766" y="594808"/>
                  </a:cubicBezTo>
                  <a:lnTo>
                    <a:pt x="390805" y="586381"/>
                  </a:lnTo>
                  <a:cubicBezTo>
                    <a:pt x="394316" y="586287"/>
                    <a:pt x="399189" y="582986"/>
                    <a:pt x="400943" y="580439"/>
                  </a:cubicBezTo>
                  <a:cubicBezTo>
                    <a:pt x="404941" y="580910"/>
                    <a:pt x="407376" y="582954"/>
                    <a:pt x="410834" y="584401"/>
                  </a:cubicBezTo>
                  <a:cubicBezTo>
                    <a:pt x="414416" y="585878"/>
                    <a:pt x="418281" y="586884"/>
                    <a:pt x="421883" y="588362"/>
                  </a:cubicBezTo>
                  <a:cubicBezTo>
                    <a:pt x="426843" y="590374"/>
                    <a:pt x="431782" y="593676"/>
                    <a:pt x="437310" y="594304"/>
                  </a:cubicBezTo>
                  <a:lnTo>
                    <a:pt x="443747" y="603454"/>
                  </a:lnTo>
                  <a:cubicBezTo>
                    <a:pt x="446416" y="604900"/>
                    <a:pt x="450783" y="605749"/>
                    <a:pt x="453880" y="605435"/>
                  </a:cubicBezTo>
                  <a:cubicBezTo>
                    <a:pt x="456792" y="608107"/>
                    <a:pt x="459882" y="611503"/>
                    <a:pt x="463071" y="613861"/>
                  </a:cubicBezTo>
                  <a:cubicBezTo>
                    <a:pt x="466140" y="616093"/>
                    <a:pt x="470188" y="617697"/>
                    <a:pt x="473432" y="619803"/>
                  </a:cubicBezTo>
                  <a:cubicBezTo>
                    <a:pt x="477607" y="622476"/>
                    <a:pt x="483289" y="627978"/>
                    <a:pt x="484029" y="632663"/>
                  </a:cubicBezTo>
                  <a:lnTo>
                    <a:pt x="489098" y="635650"/>
                  </a:lnTo>
                  <a:cubicBezTo>
                    <a:pt x="494064" y="636184"/>
                    <a:pt x="496801" y="633606"/>
                    <a:pt x="500133" y="633418"/>
                  </a:cubicBezTo>
                  <a:cubicBezTo>
                    <a:pt x="509126" y="632883"/>
                    <a:pt x="516794" y="635021"/>
                    <a:pt x="526374" y="632914"/>
                  </a:cubicBezTo>
                  <a:lnTo>
                    <a:pt x="550994" y="642818"/>
                  </a:lnTo>
                  <a:cubicBezTo>
                    <a:pt x="554551" y="642221"/>
                    <a:pt x="558669" y="640492"/>
                    <a:pt x="561591" y="638605"/>
                  </a:cubicBezTo>
                  <a:lnTo>
                    <a:pt x="566421" y="640838"/>
                  </a:lnTo>
                  <a:cubicBezTo>
                    <a:pt x="567421" y="645805"/>
                    <a:pt x="571125" y="646497"/>
                    <a:pt x="574240" y="649516"/>
                  </a:cubicBezTo>
                  <a:cubicBezTo>
                    <a:pt x="577968" y="653100"/>
                    <a:pt x="581252" y="659734"/>
                    <a:pt x="587144" y="660897"/>
                  </a:cubicBezTo>
                  <a:lnTo>
                    <a:pt x="598180" y="660646"/>
                  </a:lnTo>
                  <a:cubicBezTo>
                    <a:pt x="601558" y="662658"/>
                    <a:pt x="605146" y="666274"/>
                    <a:pt x="606928" y="669544"/>
                  </a:cubicBezTo>
                  <a:cubicBezTo>
                    <a:pt x="606503" y="672342"/>
                    <a:pt x="604932" y="675612"/>
                    <a:pt x="603248" y="677970"/>
                  </a:cubicBezTo>
                  <a:cubicBezTo>
                    <a:pt x="595163" y="682309"/>
                    <a:pt x="583966" y="682340"/>
                    <a:pt x="574927" y="682686"/>
                  </a:cubicBezTo>
                  <a:cubicBezTo>
                    <a:pt x="573096" y="687779"/>
                    <a:pt x="568364" y="687654"/>
                    <a:pt x="566642" y="689603"/>
                  </a:cubicBezTo>
                  <a:cubicBezTo>
                    <a:pt x="563569" y="693093"/>
                    <a:pt x="560907" y="698344"/>
                    <a:pt x="558367" y="702243"/>
                  </a:cubicBezTo>
                  <a:cubicBezTo>
                    <a:pt x="552801" y="703689"/>
                    <a:pt x="547437" y="707084"/>
                    <a:pt x="543867" y="711140"/>
                  </a:cubicBezTo>
                  <a:lnTo>
                    <a:pt x="538577" y="712146"/>
                  </a:lnTo>
                  <a:lnTo>
                    <a:pt x="535122" y="716611"/>
                  </a:lnTo>
                  <a:lnTo>
                    <a:pt x="535357" y="720793"/>
                  </a:lnTo>
                  <a:cubicBezTo>
                    <a:pt x="540720" y="723277"/>
                    <a:pt x="546894" y="721988"/>
                    <a:pt x="551464" y="726012"/>
                  </a:cubicBezTo>
                  <a:lnTo>
                    <a:pt x="554909" y="734659"/>
                  </a:lnTo>
                  <a:cubicBezTo>
                    <a:pt x="557469" y="736513"/>
                    <a:pt x="562436" y="737991"/>
                    <a:pt x="565723" y="737897"/>
                  </a:cubicBezTo>
                  <a:lnTo>
                    <a:pt x="566642" y="741859"/>
                  </a:lnTo>
                  <a:cubicBezTo>
                    <a:pt x="565456" y="743714"/>
                    <a:pt x="563657" y="748619"/>
                    <a:pt x="563892" y="750756"/>
                  </a:cubicBezTo>
                  <a:cubicBezTo>
                    <a:pt x="564183" y="753429"/>
                    <a:pt x="565449" y="756259"/>
                    <a:pt x="565948" y="758931"/>
                  </a:cubicBezTo>
                  <a:cubicBezTo>
                    <a:pt x="567098" y="765157"/>
                    <a:pt x="567519" y="771319"/>
                    <a:pt x="569182" y="777482"/>
                  </a:cubicBezTo>
                  <a:cubicBezTo>
                    <a:pt x="568024" y="781349"/>
                    <a:pt x="564941" y="782701"/>
                    <a:pt x="562742" y="785656"/>
                  </a:cubicBezTo>
                  <a:cubicBezTo>
                    <a:pt x="559613" y="789870"/>
                    <a:pt x="560893" y="794932"/>
                    <a:pt x="559746" y="799522"/>
                  </a:cubicBezTo>
                  <a:cubicBezTo>
                    <a:pt x="558873" y="803043"/>
                    <a:pt x="553383" y="807037"/>
                    <a:pt x="552843" y="808451"/>
                  </a:cubicBezTo>
                  <a:cubicBezTo>
                    <a:pt x="550500" y="814614"/>
                    <a:pt x="551089" y="825084"/>
                    <a:pt x="546396" y="830240"/>
                  </a:cubicBezTo>
                  <a:lnTo>
                    <a:pt x="535360" y="831467"/>
                  </a:lnTo>
                  <a:cubicBezTo>
                    <a:pt x="532361" y="835145"/>
                    <a:pt x="535013" y="854324"/>
                    <a:pt x="535360" y="859198"/>
                  </a:cubicBezTo>
                  <a:cubicBezTo>
                    <a:pt x="535588" y="862499"/>
                    <a:pt x="534908" y="865297"/>
                    <a:pt x="536052" y="868599"/>
                  </a:cubicBezTo>
                  <a:cubicBezTo>
                    <a:pt x="537149" y="871743"/>
                    <a:pt x="538879" y="874353"/>
                    <a:pt x="539489" y="877780"/>
                  </a:cubicBezTo>
                  <a:cubicBezTo>
                    <a:pt x="542095" y="892180"/>
                    <a:pt x="530965" y="900355"/>
                    <a:pt x="542039" y="913654"/>
                  </a:cubicBezTo>
                  <a:lnTo>
                    <a:pt x="541345" y="917616"/>
                  </a:lnTo>
                  <a:cubicBezTo>
                    <a:pt x="538072" y="922364"/>
                    <a:pt x="535641" y="921829"/>
                    <a:pt x="532133" y="924313"/>
                  </a:cubicBezTo>
                  <a:cubicBezTo>
                    <a:pt x="528584" y="926828"/>
                    <a:pt x="527914" y="929815"/>
                    <a:pt x="526153" y="933211"/>
                  </a:cubicBezTo>
                  <a:cubicBezTo>
                    <a:pt x="521172" y="942894"/>
                    <a:pt x="519443" y="943303"/>
                    <a:pt x="519239" y="954276"/>
                  </a:cubicBezTo>
                  <a:lnTo>
                    <a:pt x="522933" y="959213"/>
                  </a:lnTo>
                  <a:cubicBezTo>
                    <a:pt x="522273" y="963237"/>
                    <a:pt x="519776" y="967702"/>
                    <a:pt x="517759" y="971255"/>
                  </a:cubicBezTo>
                </a:path>
              </a:pathLst>
            </a:custGeom>
            <a:noFill/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15" name="자유형: 도형 356"/>
            <p:cNvSpPr/>
            <p:nvPr/>
          </p:nvSpPr>
          <p:spPr>
            <a:xfrm>
              <a:off x="7866720" y="1845360"/>
              <a:ext cx="956160" cy="208800"/>
            </a:xfrm>
            <a:custGeom>
              <a:avLst/>
              <a:gdLst/>
              <a:ahLst/>
              <a:cxnLst/>
              <a:rect l="l" t="t" r="r" b="b"/>
              <a:pathLst>
                <a:path w="757137" h="170317">
                  <a:moveTo>
                    <a:pt x="0" y="40025"/>
                  </a:moveTo>
                  <a:lnTo>
                    <a:pt x="5132" y="58890"/>
                  </a:lnTo>
                  <a:cubicBezTo>
                    <a:pt x="6135" y="62600"/>
                    <a:pt x="6433" y="64738"/>
                    <a:pt x="7699" y="68322"/>
                  </a:cubicBezTo>
                  <a:cubicBezTo>
                    <a:pt x="9457" y="73353"/>
                    <a:pt x="18005" y="87564"/>
                    <a:pt x="23112" y="91117"/>
                  </a:cubicBezTo>
                  <a:cubicBezTo>
                    <a:pt x="27360" y="94073"/>
                    <a:pt x="32025" y="96777"/>
                    <a:pt x="36427" y="99543"/>
                  </a:cubicBezTo>
                  <a:cubicBezTo>
                    <a:pt x="40612" y="97688"/>
                    <a:pt x="45646" y="99103"/>
                    <a:pt x="50044" y="98789"/>
                  </a:cubicBezTo>
                  <a:cubicBezTo>
                    <a:pt x="59547" y="98066"/>
                    <a:pt x="62833" y="95519"/>
                    <a:pt x="70764" y="93350"/>
                  </a:cubicBezTo>
                  <a:cubicBezTo>
                    <a:pt x="76317" y="91840"/>
                    <a:pt x="81193" y="94796"/>
                    <a:pt x="86872" y="92092"/>
                  </a:cubicBezTo>
                  <a:lnTo>
                    <a:pt x="91480" y="87658"/>
                  </a:lnTo>
                  <a:lnTo>
                    <a:pt x="96528" y="90142"/>
                  </a:lnTo>
                  <a:cubicBezTo>
                    <a:pt x="99892" y="89168"/>
                    <a:pt x="104056" y="86149"/>
                    <a:pt x="106202" y="83697"/>
                  </a:cubicBezTo>
                  <a:cubicBezTo>
                    <a:pt x="114372" y="82942"/>
                    <a:pt x="121597" y="85835"/>
                    <a:pt x="126922" y="91369"/>
                  </a:cubicBezTo>
                  <a:lnTo>
                    <a:pt x="131752" y="90866"/>
                  </a:lnTo>
                  <a:lnTo>
                    <a:pt x="136351" y="82439"/>
                  </a:lnTo>
                  <a:lnTo>
                    <a:pt x="141654" y="79987"/>
                  </a:lnTo>
                  <a:lnTo>
                    <a:pt x="146713" y="81465"/>
                  </a:lnTo>
                  <a:cubicBezTo>
                    <a:pt x="147207" y="81213"/>
                    <a:pt x="151848" y="78886"/>
                    <a:pt x="152002" y="78729"/>
                  </a:cubicBezTo>
                  <a:cubicBezTo>
                    <a:pt x="153560" y="77346"/>
                    <a:pt x="158807" y="66876"/>
                    <a:pt x="159375" y="65115"/>
                  </a:cubicBezTo>
                  <a:lnTo>
                    <a:pt x="159375" y="60902"/>
                  </a:lnTo>
                  <a:cubicBezTo>
                    <a:pt x="158562" y="57978"/>
                    <a:pt x="155825" y="55305"/>
                    <a:pt x="155917" y="52004"/>
                  </a:cubicBezTo>
                  <a:cubicBezTo>
                    <a:pt x="156001" y="48891"/>
                    <a:pt x="157786" y="46219"/>
                    <a:pt x="156843" y="42855"/>
                  </a:cubicBezTo>
                  <a:cubicBezTo>
                    <a:pt x="155184" y="36944"/>
                    <a:pt x="150778" y="31190"/>
                    <a:pt x="152693" y="25027"/>
                  </a:cubicBezTo>
                  <a:cubicBezTo>
                    <a:pt x="153567" y="22198"/>
                    <a:pt x="156001" y="18330"/>
                    <a:pt x="158674" y="16601"/>
                  </a:cubicBezTo>
                  <a:cubicBezTo>
                    <a:pt x="160084" y="15689"/>
                    <a:pt x="162546" y="15532"/>
                    <a:pt x="163974" y="14620"/>
                  </a:cubicBezTo>
                  <a:cubicBezTo>
                    <a:pt x="165738" y="13488"/>
                    <a:pt x="167029" y="11256"/>
                    <a:pt x="168804" y="10155"/>
                  </a:cubicBezTo>
                  <a:cubicBezTo>
                    <a:pt x="173181" y="7452"/>
                    <a:pt x="179822" y="7263"/>
                    <a:pt x="184694" y="5691"/>
                  </a:cubicBezTo>
                  <a:cubicBezTo>
                    <a:pt x="190075" y="3993"/>
                    <a:pt x="194866" y="1037"/>
                    <a:pt x="200566" y="0"/>
                  </a:cubicBezTo>
                  <a:cubicBezTo>
                    <a:pt x="203520" y="1446"/>
                    <a:pt x="212250" y="4685"/>
                    <a:pt x="215758" y="3490"/>
                  </a:cubicBezTo>
                  <a:lnTo>
                    <a:pt x="226579" y="8678"/>
                  </a:lnTo>
                  <a:cubicBezTo>
                    <a:pt x="228270" y="13111"/>
                    <a:pt x="226789" y="17890"/>
                    <a:pt x="230273" y="21789"/>
                  </a:cubicBezTo>
                  <a:cubicBezTo>
                    <a:pt x="235117" y="27228"/>
                    <a:pt x="239845" y="28297"/>
                    <a:pt x="241683" y="35749"/>
                  </a:cubicBezTo>
                  <a:lnTo>
                    <a:pt x="242462" y="38861"/>
                  </a:lnTo>
                  <a:cubicBezTo>
                    <a:pt x="242185" y="41440"/>
                    <a:pt x="240322" y="44207"/>
                    <a:pt x="239933" y="46816"/>
                  </a:cubicBezTo>
                  <a:cubicBezTo>
                    <a:pt x="239291" y="51061"/>
                    <a:pt x="243704" y="57003"/>
                    <a:pt x="247060" y="59676"/>
                  </a:cubicBezTo>
                  <a:cubicBezTo>
                    <a:pt x="250873" y="61688"/>
                    <a:pt x="259351" y="59267"/>
                    <a:pt x="263171" y="58198"/>
                  </a:cubicBezTo>
                  <a:cubicBezTo>
                    <a:pt x="265111" y="57663"/>
                    <a:pt x="266963" y="56469"/>
                    <a:pt x="268910" y="55966"/>
                  </a:cubicBezTo>
                  <a:cubicBezTo>
                    <a:pt x="272253" y="55117"/>
                    <a:pt x="276279" y="55054"/>
                    <a:pt x="279506" y="53985"/>
                  </a:cubicBezTo>
                  <a:cubicBezTo>
                    <a:pt x="283098" y="52822"/>
                    <a:pt x="286564" y="50432"/>
                    <a:pt x="290100" y="49017"/>
                  </a:cubicBezTo>
                  <a:cubicBezTo>
                    <a:pt x="293327" y="47760"/>
                    <a:pt x="297041" y="47162"/>
                    <a:pt x="300216" y="45810"/>
                  </a:cubicBezTo>
                  <a:cubicBezTo>
                    <a:pt x="304397" y="44049"/>
                    <a:pt x="316337" y="34585"/>
                    <a:pt x="317007" y="30718"/>
                  </a:cubicBezTo>
                  <a:cubicBezTo>
                    <a:pt x="316032" y="28329"/>
                    <a:pt x="315516" y="25090"/>
                    <a:pt x="315867" y="22544"/>
                  </a:cubicBezTo>
                  <a:lnTo>
                    <a:pt x="326944" y="22795"/>
                  </a:lnTo>
                  <a:cubicBezTo>
                    <a:pt x="329894" y="27417"/>
                    <a:pt x="340901" y="36000"/>
                    <a:pt x="346945" y="36158"/>
                  </a:cubicBezTo>
                  <a:cubicBezTo>
                    <a:pt x="354231" y="34837"/>
                    <a:pt x="358226" y="27385"/>
                    <a:pt x="358450" y="21317"/>
                  </a:cubicBezTo>
                  <a:cubicBezTo>
                    <a:pt x="362288" y="16947"/>
                    <a:pt x="373288" y="10438"/>
                    <a:pt x="378476" y="7923"/>
                  </a:cubicBezTo>
                  <a:cubicBezTo>
                    <a:pt x="378662" y="7829"/>
                    <a:pt x="383681" y="7043"/>
                    <a:pt x="384218" y="6948"/>
                  </a:cubicBezTo>
                  <a:cubicBezTo>
                    <a:pt x="388967" y="9873"/>
                    <a:pt x="395158" y="12954"/>
                    <a:pt x="399413" y="16349"/>
                  </a:cubicBezTo>
                  <a:cubicBezTo>
                    <a:pt x="401325" y="17890"/>
                    <a:pt x="401339" y="22166"/>
                    <a:pt x="406772" y="24776"/>
                  </a:cubicBezTo>
                  <a:lnTo>
                    <a:pt x="422452" y="24524"/>
                  </a:lnTo>
                  <a:cubicBezTo>
                    <a:pt x="425090" y="28171"/>
                    <a:pt x="434164" y="39396"/>
                    <a:pt x="439015" y="40842"/>
                  </a:cubicBezTo>
                  <a:cubicBezTo>
                    <a:pt x="442309" y="40151"/>
                    <a:pt x="446486" y="39679"/>
                    <a:pt x="449612" y="38642"/>
                  </a:cubicBezTo>
                  <a:cubicBezTo>
                    <a:pt x="451260" y="38075"/>
                    <a:pt x="452800" y="36283"/>
                    <a:pt x="454445" y="35654"/>
                  </a:cubicBezTo>
                  <a:cubicBezTo>
                    <a:pt x="456445" y="34900"/>
                    <a:pt x="462145" y="34837"/>
                    <a:pt x="464330" y="35152"/>
                  </a:cubicBezTo>
                  <a:cubicBezTo>
                    <a:pt x="467638" y="31378"/>
                    <a:pt x="474523" y="28297"/>
                    <a:pt x="479750" y="30718"/>
                  </a:cubicBezTo>
                  <a:cubicBezTo>
                    <a:pt x="482724" y="32101"/>
                    <a:pt x="485881" y="35372"/>
                    <a:pt x="490097" y="37132"/>
                  </a:cubicBezTo>
                  <a:cubicBezTo>
                    <a:pt x="488694" y="39491"/>
                    <a:pt x="488098" y="43704"/>
                    <a:pt x="488729" y="46313"/>
                  </a:cubicBezTo>
                  <a:lnTo>
                    <a:pt x="485264" y="50778"/>
                  </a:lnTo>
                  <a:cubicBezTo>
                    <a:pt x="484815" y="50904"/>
                    <a:pt x="480090" y="52161"/>
                    <a:pt x="479978" y="52255"/>
                  </a:cubicBezTo>
                  <a:cubicBezTo>
                    <a:pt x="476761" y="54362"/>
                    <a:pt x="473453" y="57915"/>
                    <a:pt x="470549" y="60430"/>
                  </a:cubicBezTo>
                  <a:lnTo>
                    <a:pt x="465719" y="61153"/>
                  </a:lnTo>
                  <a:cubicBezTo>
                    <a:pt x="463186" y="63040"/>
                    <a:pt x="460580" y="67788"/>
                    <a:pt x="461113" y="70806"/>
                  </a:cubicBezTo>
                  <a:lnTo>
                    <a:pt x="455578" y="74296"/>
                  </a:lnTo>
                  <a:lnTo>
                    <a:pt x="445234" y="74045"/>
                  </a:lnTo>
                  <a:cubicBezTo>
                    <a:pt x="441302" y="76717"/>
                    <a:pt x="437629" y="82879"/>
                    <a:pt x="436030" y="86904"/>
                  </a:cubicBezTo>
                  <a:cubicBezTo>
                    <a:pt x="437756" y="91400"/>
                    <a:pt x="441456" y="96022"/>
                    <a:pt x="444554" y="99795"/>
                  </a:cubicBezTo>
                  <a:lnTo>
                    <a:pt x="455350" y="101996"/>
                  </a:lnTo>
                  <a:lnTo>
                    <a:pt x="459500" y="106712"/>
                  </a:lnTo>
                  <a:lnTo>
                    <a:pt x="464782" y="106460"/>
                  </a:lnTo>
                  <a:cubicBezTo>
                    <a:pt x="466122" y="103442"/>
                    <a:pt x="469848" y="99795"/>
                    <a:pt x="472850" y="98066"/>
                  </a:cubicBezTo>
                  <a:cubicBezTo>
                    <a:pt x="478550" y="98254"/>
                    <a:pt x="479897" y="95267"/>
                    <a:pt x="483899" y="93601"/>
                  </a:cubicBezTo>
                  <a:cubicBezTo>
                    <a:pt x="484527" y="93318"/>
                    <a:pt x="487993" y="93129"/>
                    <a:pt x="488729" y="92846"/>
                  </a:cubicBezTo>
                  <a:cubicBezTo>
                    <a:pt x="492272" y="91557"/>
                    <a:pt x="495920" y="89513"/>
                    <a:pt x="499323" y="87910"/>
                  </a:cubicBezTo>
                  <a:cubicBezTo>
                    <a:pt x="502655" y="87344"/>
                    <a:pt x="507952" y="89734"/>
                    <a:pt x="510126" y="91872"/>
                  </a:cubicBezTo>
                  <a:lnTo>
                    <a:pt x="515423" y="89136"/>
                  </a:lnTo>
                  <a:cubicBezTo>
                    <a:pt x="520053" y="91400"/>
                    <a:pt x="526472" y="90771"/>
                    <a:pt x="531102" y="88885"/>
                  </a:cubicBezTo>
                  <a:cubicBezTo>
                    <a:pt x="538398" y="90583"/>
                    <a:pt x="546641" y="95645"/>
                    <a:pt x="548571" y="102499"/>
                  </a:cubicBezTo>
                  <a:lnTo>
                    <a:pt x="544887" y="111428"/>
                  </a:lnTo>
                  <a:cubicBezTo>
                    <a:pt x="549237" y="113409"/>
                    <a:pt x="562145" y="120232"/>
                    <a:pt x="564250" y="124539"/>
                  </a:cubicBezTo>
                  <a:lnTo>
                    <a:pt x="564250" y="129004"/>
                  </a:lnTo>
                  <a:lnTo>
                    <a:pt x="570704" y="131708"/>
                  </a:lnTo>
                  <a:lnTo>
                    <a:pt x="575966" y="129758"/>
                  </a:lnTo>
                  <a:lnTo>
                    <a:pt x="581016" y="131236"/>
                  </a:lnTo>
                  <a:lnTo>
                    <a:pt x="586524" y="128249"/>
                  </a:lnTo>
                  <a:cubicBezTo>
                    <a:pt x="594030" y="129287"/>
                    <a:pt x="605535" y="131173"/>
                    <a:pt x="611849" y="126017"/>
                  </a:cubicBezTo>
                  <a:cubicBezTo>
                    <a:pt x="615112" y="123376"/>
                    <a:pt x="615287" y="120892"/>
                    <a:pt x="620583" y="118377"/>
                  </a:cubicBezTo>
                  <a:cubicBezTo>
                    <a:pt x="627809" y="119697"/>
                    <a:pt x="635526" y="123816"/>
                    <a:pt x="639244" y="129758"/>
                  </a:cubicBezTo>
                  <a:cubicBezTo>
                    <a:pt x="641173" y="132808"/>
                    <a:pt x="640437" y="135449"/>
                    <a:pt x="644085" y="138908"/>
                  </a:cubicBezTo>
                  <a:lnTo>
                    <a:pt x="649416" y="137430"/>
                  </a:lnTo>
                  <a:lnTo>
                    <a:pt x="654468" y="138908"/>
                  </a:lnTo>
                  <a:cubicBezTo>
                    <a:pt x="657730" y="143624"/>
                    <a:pt x="663132" y="147271"/>
                    <a:pt x="668709" y="149566"/>
                  </a:cubicBezTo>
                  <a:cubicBezTo>
                    <a:pt x="672006" y="149850"/>
                    <a:pt x="676426" y="148969"/>
                    <a:pt x="679302" y="147586"/>
                  </a:cubicBezTo>
                  <a:cubicBezTo>
                    <a:pt x="688738" y="149189"/>
                    <a:pt x="694069" y="161451"/>
                    <a:pt x="710135" y="155006"/>
                  </a:cubicBezTo>
                  <a:lnTo>
                    <a:pt x="714975" y="156735"/>
                  </a:lnTo>
                  <a:cubicBezTo>
                    <a:pt x="718413" y="156075"/>
                    <a:pt x="722341" y="154188"/>
                    <a:pt x="725112" y="152271"/>
                  </a:cubicBezTo>
                  <a:lnTo>
                    <a:pt x="730865" y="153748"/>
                  </a:lnTo>
                  <a:cubicBezTo>
                    <a:pt x="731672" y="156138"/>
                    <a:pt x="735706" y="161200"/>
                    <a:pt x="738021" y="162426"/>
                  </a:cubicBezTo>
                  <a:cubicBezTo>
                    <a:pt x="741002" y="163998"/>
                    <a:pt x="745176" y="164816"/>
                    <a:pt x="748368" y="166136"/>
                  </a:cubicBezTo>
                  <a:cubicBezTo>
                    <a:pt x="751350" y="167362"/>
                    <a:pt x="754261" y="168934"/>
                    <a:pt x="757138" y="170318"/>
                  </a:cubicBezTo>
                </a:path>
              </a:pathLst>
            </a:custGeom>
            <a:noFill/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16" name="자유형: 도형 357"/>
            <p:cNvSpPr/>
            <p:nvPr/>
          </p:nvSpPr>
          <p:spPr>
            <a:xfrm>
              <a:off x="7392240" y="1894680"/>
              <a:ext cx="474120" cy="350280"/>
            </a:xfrm>
            <a:custGeom>
              <a:avLst/>
              <a:gdLst/>
              <a:ahLst/>
              <a:cxnLst/>
              <a:rect l="l" t="t" r="r" b="b"/>
              <a:pathLst>
                <a:path w="375690" h="285393">
                  <a:moveTo>
                    <a:pt x="375691" y="0"/>
                  </a:moveTo>
                  <a:cubicBezTo>
                    <a:pt x="371085" y="5597"/>
                    <a:pt x="366206" y="16035"/>
                    <a:pt x="366118" y="23109"/>
                  </a:cubicBezTo>
                  <a:cubicBezTo>
                    <a:pt x="363579" y="24210"/>
                    <a:pt x="356781" y="27951"/>
                    <a:pt x="355083" y="29806"/>
                  </a:cubicBezTo>
                  <a:cubicBezTo>
                    <a:pt x="354662" y="30247"/>
                    <a:pt x="353494" y="33391"/>
                    <a:pt x="353003" y="34020"/>
                  </a:cubicBezTo>
                  <a:cubicBezTo>
                    <a:pt x="351866" y="35434"/>
                    <a:pt x="349734" y="36535"/>
                    <a:pt x="348625" y="37981"/>
                  </a:cubicBezTo>
                  <a:cubicBezTo>
                    <a:pt x="347184" y="39868"/>
                    <a:pt x="345886" y="44584"/>
                    <a:pt x="345879" y="46879"/>
                  </a:cubicBezTo>
                  <a:lnTo>
                    <a:pt x="338039" y="55305"/>
                  </a:lnTo>
                  <a:cubicBezTo>
                    <a:pt x="338043" y="58387"/>
                    <a:pt x="336920" y="62254"/>
                    <a:pt x="335279" y="64958"/>
                  </a:cubicBezTo>
                  <a:cubicBezTo>
                    <a:pt x="332785" y="66279"/>
                    <a:pt x="329077" y="66404"/>
                    <a:pt x="326380" y="66279"/>
                  </a:cubicBezTo>
                  <a:cubicBezTo>
                    <a:pt x="316404" y="65807"/>
                    <a:pt x="311816" y="65367"/>
                    <a:pt x="304674" y="58512"/>
                  </a:cubicBezTo>
                  <a:cubicBezTo>
                    <a:pt x="303520" y="57412"/>
                    <a:pt x="302685" y="55526"/>
                    <a:pt x="301450" y="54551"/>
                  </a:cubicBezTo>
                  <a:cubicBezTo>
                    <a:pt x="297168" y="51155"/>
                    <a:pt x="291250" y="52947"/>
                    <a:pt x="286490" y="50118"/>
                  </a:cubicBezTo>
                  <a:cubicBezTo>
                    <a:pt x="284845" y="54802"/>
                    <a:pt x="288974" y="59141"/>
                    <a:pt x="289714" y="63480"/>
                  </a:cubicBezTo>
                  <a:cubicBezTo>
                    <a:pt x="290236" y="66530"/>
                    <a:pt x="289202" y="70240"/>
                    <a:pt x="289482" y="73384"/>
                  </a:cubicBezTo>
                  <a:cubicBezTo>
                    <a:pt x="289742" y="76277"/>
                    <a:pt x="291264" y="79326"/>
                    <a:pt x="291404" y="82188"/>
                  </a:cubicBezTo>
                  <a:cubicBezTo>
                    <a:pt x="291601" y="86181"/>
                    <a:pt x="290805" y="90771"/>
                    <a:pt x="290528" y="94764"/>
                  </a:cubicBezTo>
                  <a:cubicBezTo>
                    <a:pt x="282990" y="99701"/>
                    <a:pt x="275336" y="105674"/>
                    <a:pt x="269218" y="111994"/>
                  </a:cubicBezTo>
                  <a:lnTo>
                    <a:pt x="258639" y="110768"/>
                  </a:lnTo>
                  <a:lnTo>
                    <a:pt x="259095" y="115453"/>
                  </a:lnTo>
                  <a:lnTo>
                    <a:pt x="263701" y="118440"/>
                  </a:lnTo>
                  <a:lnTo>
                    <a:pt x="263469" y="122873"/>
                  </a:lnTo>
                  <a:lnTo>
                    <a:pt x="257717" y="125608"/>
                  </a:lnTo>
                  <a:cubicBezTo>
                    <a:pt x="254584" y="124005"/>
                    <a:pt x="245622" y="120609"/>
                    <a:pt x="241837" y="121898"/>
                  </a:cubicBezTo>
                  <a:cubicBezTo>
                    <a:pt x="237811" y="125514"/>
                    <a:pt x="233187" y="129790"/>
                    <a:pt x="230332" y="134286"/>
                  </a:cubicBezTo>
                  <a:cubicBezTo>
                    <a:pt x="231739" y="137367"/>
                    <a:pt x="233349" y="144033"/>
                    <a:pt x="231949" y="147397"/>
                  </a:cubicBezTo>
                  <a:lnTo>
                    <a:pt x="226639" y="149629"/>
                  </a:lnTo>
                  <a:cubicBezTo>
                    <a:pt x="222373" y="148718"/>
                    <a:pt x="220297" y="146045"/>
                    <a:pt x="216733" y="144410"/>
                  </a:cubicBezTo>
                  <a:cubicBezTo>
                    <a:pt x="212857" y="142649"/>
                    <a:pt x="201015" y="137713"/>
                    <a:pt x="196504" y="138247"/>
                  </a:cubicBezTo>
                  <a:cubicBezTo>
                    <a:pt x="196195" y="138279"/>
                    <a:pt x="186872" y="140354"/>
                    <a:pt x="186598" y="140449"/>
                  </a:cubicBezTo>
                  <a:cubicBezTo>
                    <a:pt x="182705" y="141800"/>
                    <a:pt x="180611" y="144945"/>
                    <a:pt x="175563" y="143907"/>
                  </a:cubicBezTo>
                  <a:cubicBezTo>
                    <a:pt x="172133" y="143215"/>
                    <a:pt x="168579" y="141423"/>
                    <a:pt x="165187" y="140449"/>
                  </a:cubicBezTo>
                  <a:cubicBezTo>
                    <a:pt x="157292" y="138216"/>
                    <a:pt x="150308" y="139222"/>
                    <a:pt x="144720" y="144913"/>
                  </a:cubicBezTo>
                  <a:cubicBezTo>
                    <a:pt x="142286" y="147397"/>
                    <a:pt x="140402" y="150415"/>
                    <a:pt x="140563" y="153843"/>
                  </a:cubicBezTo>
                  <a:cubicBezTo>
                    <a:pt x="140641" y="155415"/>
                    <a:pt x="141496" y="157175"/>
                    <a:pt x="141714" y="158779"/>
                  </a:cubicBezTo>
                  <a:cubicBezTo>
                    <a:pt x="142093" y="161546"/>
                    <a:pt x="142181" y="164407"/>
                    <a:pt x="142409" y="167205"/>
                  </a:cubicBezTo>
                  <a:lnTo>
                    <a:pt x="132745" y="173619"/>
                  </a:lnTo>
                  <a:lnTo>
                    <a:pt x="131826" y="178084"/>
                  </a:lnTo>
                  <a:lnTo>
                    <a:pt x="126515" y="179059"/>
                  </a:lnTo>
                  <a:cubicBezTo>
                    <a:pt x="123425" y="181511"/>
                    <a:pt x="120286" y="184781"/>
                    <a:pt x="118234" y="187988"/>
                  </a:cubicBezTo>
                  <a:cubicBezTo>
                    <a:pt x="115533" y="188931"/>
                    <a:pt x="110695" y="188176"/>
                    <a:pt x="108342" y="186762"/>
                  </a:cubicBezTo>
                  <a:cubicBezTo>
                    <a:pt x="106367" y="189214"/>
                    <a:pt x="101442" y="192044"/>
                    <a:pt x="97980" y="192201"/>
                  </a:cubicBezTo>
                  <a:cubicBezTo>
                    <a:pt x="95234" y="191038"/>
                    <a:pt x="91084" y="190597"/>
                    <a:pt x="88095" y="190975"/>
                  </a:cubicBezTo>
                  <a:cubicBezTo>
                    <a:pt x="84602" y="194213"/>
                    <a:pt x="79439" y="199715"/>
                    <a:pt x="80270" y="204589"/>
                  </a:cubicBezTo>
                  <a:cubicBezTo>
                    <a:pt x="84325" y="205941"/>
                    <a:pt x="89222" y="212952"/>
                    <a:pt x="90856" y="216191"/>
                  </a:cubicBezTo>
                  <a:lnTo>
                    <a:pt x="89257" y="220656"/>
                  </a:lnTo>
                  <a:cubicBezTo>
                    <a:pt x="86001" y="220404"/>
                    <a:pt x="81578" y="221033"/>
                    <a:pt x="78656" y="222385"/>
                  </a:cubicBezTo>
                  <a:cubicBezTo>
                    <a:pt x="76471" y="224020"/>
                    <a:pt x="74107" y="227950"/>
                    <a:pt x="74282" y="230560"/>
                  </a:cubicBezTo>
                  <a:lnTo>
                    <a:pt x="68989" y="234050"/>
                  </a:lnTo>
                  <a:lnTo>
                    <a:pt x="58393" y="235024"/>
                  </a:lnTo>
                  <a:cubicBezTo>
                    <a:pt x="56221" y="233201"/>
                    <a:pt x="51472" y="231754"/>
                    <a:pt x="48501" y="232069"/>
                  </a:cubicBezTo>
                  <a:lnTo>
                    <a:pt x="47122" y="236753"/>
                  </a:lnTo>
                  <a:cubicBezTo>
                    <a:pt x="42190" y="241564"/>
                    <a:pt x="35905" y="241533"/>
                    <a:pt x="30552" y="246186"/>
                  </a:cubicBezTo>
                  <a:lnTo>
                    <a:pt x="25041" y="246406"/>
                  </a:lnTo>
                  <a:lnTo>
                    <a:pt x="20190" y="250619"/>
                  </a:lnTo>
                  <a:cubicBezTo>
                    <a:pt x="17419" y="251625"/>
                    <a:pt x="12343" y="251814"/>
                    <a:pt x="9590" y="250619"/>
                  </a:cubicBezTo>
                  <a:cubicBezTo>
                    <a:pt x="9590" y="251028"/>
                    <a:pt x="9541" y="254675"/>
                    <a:pt x="9590" y="254832"/>
                  </a:cubicBezTo>
                  <a:cubicBezTo>
                    <a:pt x="11133" y="259643"/>
                    <a:pt x="14648" y="259737"/>
                    <a:pt x="13512" y="267220"/>
                  </a:cubicBezTo>
                  <a:cubicBezTo>
                    <a:pt x="13427" y="267786"/>
                    <a:pt x="13592" y="268195"/>
                    <a:pt x="13291" y="268698"/>
                  </a:cubicBezTo>
                  <a:cubicBezTo>
                    <a:pt x="12224" y="270521"/>
                    <a:pt x="11319" y="271370"/>
                    <a:pt x="10064" y="273068"/>
                  </a:cubicBezTo>
                  <a:cubicBezTo>
                    <a:pt x="7065" y="277156"/>
                    <a:pt x="4167" y="282123"/>
                    <a:pt x="0" y="285393"/>
                  </a:cubicBezTo>
                </a:path>
              </a:pathLst>
            </a:custGeom>
            <a:noFill/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17" name="자유형: 도형 358"/>
            <p:cNvSpPr/>
            <p:nvPr/>
          </p:nvSpPr>
          <p:spPr>
            <a:xfrm>
              <a:off x="7089840" y="2159280"/>
              <a:ext cx="302040" cy="85680"/>
            </a:xfrm>
            <a:custGeom>
              <a:avLst/>
              <a:gdLst/>
              <a:ahLst/>
              <a:cxnLst/>
              <a:rect l="l" t="t" r="r" b="b"/>
              <a:pathLst>
                <a:path w="239287" h="69985">
                  <a:moveTo>
                    <a:pt x="0" y="35840"/>
                  </a:moveTo>
                  <a:lnTo>
                    <a:pt x="7461" y="30495"/>
                  </a:lnTo>
                  <a:cubicBezTo>
                    <a:pt x="11866" y="30810"/>
                    <a:pt x="18956" y="34740"/>
                    <a:pt x="22421" y="36909"/>
                  </a:cubicBezTo>
                  <a:cubicBezTo>
                    <a:pt x="26560" y="37161"/>
                    <a:pt x="28728" y="35432"/>
                    <a:pt x="32306" y="34457"/>
                  </a:cubicBezTo>
                  <a:cubicBezTo>
                    <a:pt x="35624" y="33545"/>
                    <a:pt x="39704" y="33356"/>
                    <a:pt x="42888" y="32225"/>
                  </a:cubicBezTo>
                  <a:lnTo>
                    <a:pt x="46421" y="29929"/>
                  </a:lnTo>
                  <a:cubicBezTo>
                    <a:pt x="51724" y="26439"/>
                    <a:pt x="53370" y="26785"/>
                    <a:pt x="59932" y="26942"/>
                  </a:cubicBezTo>
                  <a:lnTo>
                    <a:pt x="63384" y="27037"/>
                  </a:lnTo>
                  <a:lnTo>
                    <a:pt x="68214" y="23075"/>
                  </a:lnTo>
                  <a:cubicBezTo>
                    <a:pt x="71252" y="22352"/>
                    <a:pt x="75506" y="22069"/>
                    <a:pt x="78583" y="22824"/>
                  </a:cubicBezTo>
                  <a:lnTo>
                    <a:pt x="82483" y="18107"/>
                  </a:lnTo>
                  <a:cubicBezTo>
                    <a:pt x="80845" y="16158"/>
                    <a:pt x="79232" y="11945"/>
                    <a:pt x="79958" y="9461"/>
                  </a:cubicBezTo>
                  <a:cubicBezTo>
                    <a:pt x="83318" y="5782"/>
                    <a:pt x="90716" y="2041"/>
                    <a:pt x="95374" y="29"/>
                  </a:cubicBezTo>
                  <a:cubicBezTo>
                    <a:pt x="99534" y="-317"/>
                    <a:pt x="106869" y="2544"/>
                    <a:pt x="110345" y="4242"/>
                  </a:cubicBezTo>
                  <a:cubicBezTo>
                    <a:pt x="115192" y="2355"/>
                    <a:pt x="121499" y="1727"/>
                    <a:pt x="126677" y="1286"/>
                  </a:cubicBezTo>
                  <a:lnTo>
                    <a:pt x="131282" y="5971"/>
                  </a:lnTo>
                  <a:cubicBezTo>
                    <a:pt x="134306" y="6128"/>
                    <a:pt x="138627" y="7291"/>
                    <a:pt x="141188" y="8707"/>
                  </a:cubicBezTo>
                  <a:cubicBezTo>
                    <a:pt x="142984" y="9681"/>
                    <a:pt x="144454" y="11410"/>
                    <a:pt x="146235" y="12416"/>
                  </a:cubicBezTo>
                  <a:cubicBezTo>
                    <a:pt x="154054" y="16818"/>
                    <a:pt x="160340" y="12479"/>
                    <a:pt x="171561" y="23547"/>
                  </a:cubicBezTo>
                  <a:lnTo>
                    <a:pt x="171336" y="27508"/>
                  </a:lnTo>
                  <a:lnTo>
                    <a:pt x="174083" y="31973"/>
                  </a:lnTo>
                  <a:lnTo>
                    <a:pt x="173185" y="36186"/>
                  </a:lnTo>
                  <a:cubicBezTo>
                    <a:pt x="175767" y="37601"/>
                    <a:pt x="179783" y="38764"/>
                    <a:pt x="182838" y="38670"/>
                  </a:cubicBezTo>
                  <a:cubicBezTo>
                    <a:pt x="187552" y="42663"/>
                    <a:pt x="193817" y="43889"/>
                    <a:pt x="198254" y="48071"/>
                  </a:cubicBezTo>
                  <a:cubicBezTo>
                    <a:pt x="201457" y="48857"/>
                    <a:pt x="206880" y="47191"/>
                    <a:pt x="209307" y="45336"/>
                  </a:cubicBezTo>
                  <a:lnTo>
                    <a:pt x="210843" y="46750"/>
                  </a:lnTo>
                  <a:cubicBezTo>
                    <a:pt x="216831" y="52221"/>
                    <a:pt x="218269" y="49958"/>
                    <a:pt x="224274" y="53007"/>
                  </a:cubicBezTo>
                  <a:cubicBezTo>
                    <a:pt x="226091" y="53951"/>
                    <a:pt x="230925" y="59610"/>
                    <a:pt x="232093" y="61434"/>
                  </a:cubicBezTo>
                  <a:cubicBezTo>
                    <a:pt x="232917" y="62723"/>
                    <a:pt x="233422" y="64735"/>
                    <a:pt x="234394" y="65898"/>
                  </a:cubicBezTo>
                  <a:cubicBezTo>
                    <a:pt x="235548" y="67282"/>
                    <a:pt x="237853" y="68791"/>
                    <a:pt x="239287" y="69986"/>
                  </a:cubicBezTo>
                </a:path>
              </a:pathLst>
            </a:custGeom>
            <a:noFill/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18" name="자유형: 도형 359"/>
            <p:cNvSpPr/>
            <p:nvPr/>
          </p:nvSpPr>
          <p:spPr>
            <a:xfrm>
              <a:off x="7365960" y="2245320"/>
              <a:ext cx="159840" cy="435240"/>
            </a:xfrm>
            <a:custGeom>
              <a:avLst/>
              <a:gdLst/>
              <a:ahLst/>
              <a:cxnLst/>
              <a:rect l="l" t="t" r="r" b="b"/>
              <a:pathLst>
                <a:path w="126809" h="354689">
                  <a:moveTo>
                    <a:pt x="20829" y="0"/>
                  </a:moveTo>
                  <a:cubicBezTo>
                    <a:pt x="24740" y="3521"/>
                    <a:pt x="30622" y="6288"/>
                    <a:pt x="35442" y="8552"/>
                  </a:cubicBezTo>
                  <a:cubicBezTo>
                    <a:pt x="39840" y="13488"/>
                    <a:pt x="35880" y="18016"/>
                    <a:pt x="39114" y="22418"/>
                  </a:cubicBezTo>
                  <a:lnTo>
                    <a:pt x="36122" y="26631"/>
                  </a:lnTo>
                  <a:lnTo>
                    <a:pt x="39346" y="31096"/>
                  </a:lnTo>
                  <a:cubicBezTo>
                    <a:pt x="42874" y="33233"/>
                    <a:pt x="51563" y="33108"/>
                    <a:pt x="55467" y="32573"/>
                  </a:cubicBezTo>
                  <a:lnTo>
                    <a:pt x="60073" y="36032"/>
                  </a:lnTo>
                  <a:cubicBezTo>
                    <a:pt x="58792" y="41660"/>
                    <a:pt x="57958" y="47634"/>
                    <a:pt x="57771" y="53356"/>
                  </a:cubicBezTo>
                  <a:lnTo>
                    <a:pt x="67902" y="58575"/>
                  </a:lnTo>
                  <a:lnTo>
                    <a:pt x="72728" y="57821"/>
                  </a:lnTo>
                  <a:cubicBezTo>
                    <a:pt x="77376" y="60965"/>
                    <a:pt x="78049" y="63511"/>
                    <a:pt x="81024" y="66247"/>
                  </a:cubicBezTo>
                  <a:cubicBezTo>
                    <a:pt x="84770" y="69706"/>
                    <a:pt x="91621" y="71561"/>
                    <a:pt x="96889" y="71435"/>
                  </a:cubicBezTo>
                  <a:cubicBezTo>
                    <a:pt x="102607" y="75805"/>
                    <a:pt x="110236" y="81465"/>
                    <a:pt x="113477" y="87784"/>
                  </a:cubicBezTo>
                  <a:lnTo>
                    <a:pt x="109794" y="96934"/>
                  </a:lnTo>
                  <a:cubicBezTo>
                    <a:pt x="112141" y="99009"/>
                    <a:pt x="114603" y="102467"/>
                    <a:pt x="115308" y="105360"/>
                  </a:cubicBezTo>
                  <a:cubicBezTo>
                    <a:pt x="119672" y="106586"/>
                    <a:pt x="125063" y="113849"/>
                    <a:pt x="126810" y="117245"/>
                  </a:cubicBezTo>
                  <a:cubicBezTo>
                    <a:pt x="124898" y="123250"/>
                    <a:pt x="119850" y="130764"/>
                    <a:pt x="112081" y="131362"/>
                  </a:cubicBezTo>
                  <a:cubicBezTo>
                    <a:pt x="108682" y="128186"/>
                    <a:pt x="101989" y="122495"/>
                    <a:pt x="97366" y="120703"/>
                  </a:cubicBezTo>
                  <a:cubicBezTo>
                    <a:pt x="91579" y="121678"/>
                    <a:pt x="87033" y="118251"/>
                    <a:pt x="81245" y="118471"/>
                  </a:cubicBezTo>
                  <a:cubicBezTo>
                    <a:pt x="77639" y="119854"/>
                    <a:pt x="73703" y="122527"/>
                    <a:pt x="71111" y="125168"/>
                  </a:cubicBezTo>
                  <a:lnTo>
                    <a:pt x="60293" y="126394"/>
                  </a:lnTo>
                  <a:lnTo>
                    <a:pt x="58242" y="130859"/>
                  </a:lnTo>
                  <a:cubicBezTo>
                    <a:pt x="59985" y="133563"/>
                    <a:pt x="63058" y="140826"/>
                    <a:pt x="61220" y="144002"/>
                  </a:cubicBezTo>
                  <a:lnTo>
                    <a:pt x="55464" y="145228"/>
                  </a:lnTo>
                  <a:lnTo>
                    <a:pt x="50409" y="142995"/>
                  </a:lnTo>
                  <a:cubicBezTo>
                    <a:pt x="47589" y="145133"/>
                    <a:pt x="38142" y="152491"/>
                    <a:pt x="36361" y="155383"/>
                  </a:cubicBezTo>
                  <a:cubicBezTo>
                    <a:pt x="35238" y="157175"/>
                    <a:pt x="34554" y="166702"/>
                    <a:pt x="34516" y="168746"/>
                  </a:cubicBezTo>
                  <a:cubicBezTo>
                    <a:pt x="30289" y="170569"/>
                    <a:pt x="21853" y="175663"/>
                    <a:pt x="20015" y="179876"/>
                  </a:cubicBezTo>
                  <a:cubicBezTo>
                    <a:pt x="21541" y="183020"/>
                    <a:pt x="24235" y="186384"/>
                    <a:pt x="26925" y="188805"/>
                  </a:cubicBezTo>
                  <a:cubicBezTo>
                    <a:pt x="28780" y="196257"/>
                    <a:pt x="18184" y="200753"/>
                    <a:pt x="13578" y="204903"/>
                  </a:cubicBezTo>
                  <a:cubicBezTo>
                    <a:pt x="10642" y="207544"/>
                    <a:pt x="7941" y="211129"/>
                    <a:pt x="5300" y="214053"/>
                  </a:cubicBezTo>
                  <a:lnTo>
                    <a:pt x="5300" y="218989"/>
                  </a:lnTo>
                  <a:lnTo>
                    <a:pt x="0" y="221221"/>
                  </a:lnTo>
                  <a:lnTo>
                    <a:pt x="695" y="225937"/>
                  </a:lnTo>
                  <a:cubicBezTo>
                    <a:pt x="5735" y="223957"/>
                    <a:pt x="10775" y="227730"/>
                    <a:pt x="15406" y="228641"/>
                  </a:cubicBezTo>
                  <a:cubicBezTo>
                    <a:pt x="18966" y="229364"/>
                    <a:pt x="21351" y="227478"/>
                    <a:pt x="26241" y="230150"/>
                  </a:cubicBezTo>
                  <a:cubicBezTo>
                    <a:pt x="28577" y="233672"/>
                    <a:pt x="27065" y="235936"/>
                    <a:pt x="27841" y="239049"/>
                  </a:cubicBezTo>
                  <a:cubicBezTo>
                    <a:pt x="28581" y="242035"/>
                    <a:pt x="30359" y="245023"/>
                    <a:pt x="31288" y="247946"/>
                  </a:cubicBezTo>
                  <a:cubicBezTo>
                    <a:pt x="31692" y="249236"/>
                    <a:pt x="31485" y="250965"/>
                    <a:pt x="31983" y="252159"/>
                  </a:cubicBezTo>
                  <a:cubicBezTo>
                    <a:pt x="32516" y="253480"/>
                    <a:pt x="33933" y="255147"/>
                    <a:pt x="34733" y="256373"/>
                  </a:cubicBezTo>
                  <a:cubicBezTo>
                    <a:pt x="35143" y="259611"/>
                    <a:pt x="33597" y="262315"/>
                    <a:pt x="33597" y="265302"/>
                  </a:cubicBezTo>
                  <a:cubicBezTo>
                    <a:pt x="33597" y="268100"/>
                    <a:pt x="34375" y="271402"/>
                    <a:pt x="34733" y="274200"/>
                  </a:cubicBezTo>
                  <a:cubicBezTo>
                    <a:pt x="37841" y="274672"/>
                    <a:pt x="41664" y="274892"/>
                    <a:pt x="44653" y="275709"/>
                  </a:cubicBezTo>
                  <a:cubicBezTo>
                    <a:pt x="50174" y="277156"/>
                    <a:pt x="61497" y="285928"/>
                    <a:pt x="60760" y="291524"/>
                  </a:cubicBezTo>
                  <a:cubicBezTo>
                    <a:pt x="63686" y="292971"/>
                    <a:pt x="68014" y="293851"/>
                    <a:pt x="71343" y="293757"/>
                  </a:cubicBezTo>
                  <a:lnTo>
                    <a:pt x="77330" y="302906"/>
                  </a:lnTo>
                  <a:lnTo>
                    <a:pt x="82385" y="305390"/>
                  </a:lnTo>
                  <a:lnTo>
                    <a:pt x="83076" y="315294"/>
                  </a:lnTo>
                  <a:lnTo>
                    <a:pt x="78242" y="318029"/>
                  </a:lnTo>
                  <a:lnTo>
                    <a:pt x="77095" y="321991"/>
                  </a:lnTo>
                  <a:lnTo>
                    <a:pt x="84454" y="331140"/>
                  </a:lnTo>
                  <a:cubicBezTo>
                    <a:pt x="84388" y="331675"/>
                    <a:pt x="83735" y="337491"/>
                    <a:pt x="83672" y="337617"/>
                  </a:cubicBezTo>
                  <a:cubicBezTo>
                    <a:pt x="82266" y="340447"/>
                    <a:pt x="78733" y="344031"/>
                    <a:pt x="76724" y="346641"/>
                  </a:cubicBezTo>
                  <a:lnTo>
                    <a:pt x="82644" y="354690"/>
                  </a:lnTo>
                </a:path>
              </a:pathLst>
            </a:custGeom>
            <a:noFill/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19" name="자유형: 도형 360"/>
            <p:cNvSpPr/>
            <p:nvPr/>
          </p:nvSpPr>
          <p:spPr>
            <a:xfrm>
              <a:off x="7470360" y="2671200"/>
              <a:ext cx="206280" cy="290520"/>
            </a:xfrm>
            <a:custGeom>
              <a:avLst/>
              <a:gdLst/>
              <a:ahLst/>
              <a:cxnLst/>
              <a:rect l="l" t="t" r="r" b="b"/>
              <a:pathLst>
                <a:path w="163637" h="236659">
                  <a:moveTo>
                    <a:pt x="0" y="8019"/>
                  </a:moveTo>
                  <a:cubicBezTo>
                    <a:pt x="2410" y="8490"/>
                    <a:pt x="4764" y="9088"/>
                    <a:pt x="7152" y="9591"/>
                  </a:cubicBezTo>
                  <a:cubicBezTo>
                    <a:pt x="9769" y="10125"/>
                    <a:pt x="15178" y="3774"/>
                    <a:pt x="15739" y="1636"/>
                  </a:cubicBezTo>
                  <a:cubicBezTo>
                    <a:pt x="16405" y="-880"/>
                    <a:pt x="22165" y="-219"/>
                    <a:pt x="23221" y="1761"/>
                  </a:cubicBezTo>
                  <a:cubicBezTo>
                    <a:pt x="24578" y="4308"/>
                    <a:pt x="30033" y="7641"/>
                    <a:pt x="32415" y="9968"/>
                  </a:cubicBezTo>
                  <a:cubicBezTo>
                    <a:pt x="36491" y="13898"/>
                    <a:pt x="36662" y="14590"/>
                    <a:pt x="35968" y="19683"/>
                  </a:cubicBezTo>
                  <a:cubicBezTo>
                    <a:pt x="35249" y="24965"/>
                    <a:pt x="34421" y="30247"/>
                    <a:pt x="33705" y="35530"/>
                  </a:cubicBezTo>
                  <a:cubicBezTo>
                    <a:pt x="32313" y="45874"/>
                    <a:pt x="56909" y="39428"/>
                    <a:pt x="62693" y="39428"/>
                  </a:cubicBezTo>
                  <a:cubicBezTo>
                    <a:pt x="65194" y="39428"/>
                    <a:pt x="68474" y="43044"/>
                    <a:pt x="69880" y="44773"/>
                  </a:cubicBezTo>
                  <a:lnTo>
                    <a:pt x="77555" y="45308"/>
                  </a:lnTo>
                  <a:cubicBezTo>
                    <a:pt x="84163" y="42415"/>
                    <a:pt x="85174" y="41598"/>
                    <a:pt x="86107" y="35153"/>
                  </a:cubicBezTo>
                  <a:cubicBezTo>
                    <a:pt x="86335" y="33549"/>
                    <a:pt x="88103" y="28015"/>
                    <a:pt x="89162" y="26946"/>
                  </a:cubicBezTo>
                  <a:cubicBezTo>
                    <a:pt x="90379" y="25689"/>
                    <a:pt x="91473" y="24368"/>
                    <a:pt x="92463" y="22953"/>
                  </a:cubicBezTo>
                  <a:lnTo>
                    <a:pt x="101014" y="22167"/>
                  </a:lnTo>
                  <a:lnTo>
                    <a:pt x="104084" y="24525"/>
                  </a:lnTo>
                  <a:lnTo>
                    <a:pt x="100794" y="37290"/>
                  </a:lnTo>
                  <a:lnTo>
                    <a:pt x="102768" y="40655"/>
                  </a:lnTo>
                  <a:cubicBezTo>
                    <a:pt x="107535" y="41126"/>
                    <a:pt x="113081" y="41535"/>
                    <a:pt x="117893" y="41063"/>
                  </a:cubicBezTo>
                  <a:cubicBezTo>
                    <a:pt x="118335" y="50401"/>
                    <a:pt x="117269" y="48641"/>
                    <a:pt x="109128" y="53609"/>
                  </a:cubicBezTo>
                  <a:lnTo>
                    <a:pt x="106276" y="61469"/>
                  </a:lnTo>
                  <a:cubicBezTo>
                    <a:pt x="111250" y="66877"/>
                    <a:pt x="115715" y="77190"/>
                    <a:pt x="118114" y="83698"/>
                  </a:cubicBezTo>
                  <a:lnTo>
                    <a:pt x="125130" y="86245"/>
                  </a:lnTo>
                  <a:lnTo>
                    <a:pt x="129514" y="70335"/>
                  </a:lnTo>
                  <a:lnTo>
                    <a:pt x="136091" y="69140"/>
                  </a:lnTo>
                  <a:lnTo>
                    <a:pt x="142889" y="73071"/>
                  </a:lnTo>
                  <a:lnTo>
                    <a:pt x="153195" y="72096"/>
                  </a:lnTo>
                  <a:lnTo>
                    <a:pt x="154731" y="80931"/>
                  </a:lnTo>
                  <a:lnTo>
                    <a:pt x="159993" y="84673"/>
                  </a:lnTo>
                  <a:lnTo>
                    <a:pt x="163637" y="93350"/>
                  </a:lnTo>
                  <a:lnTo>
                    <a:pt x="160785" y="95740"/>
                  </a:lnTo>
                  <a:cubicBezTo>
                    <a:pt x="156253" y="95331"/>
                    <a:pt x="145916" y="96494"/>
                    <a:pt x="141942" y="98098"/>
                  </a:cubicBezTo>
                  <a:cubicBezTo>
                    <a:pt x="141756" y="98192"/>
                    <a:pt x="137543" y="101714"/>
                    <a:pt x="137112" y="102059"/>
                  </a:cubicBezTo>
                  <a:cubicBezTo>
                    <a:pt x="134997" y="106619"/>
                    <a:pt x="136961" y="111398"/>
                    <a:pt x="136189" y="115957"/>
                  </a:cubicBezTo>
                  <a:cubicBezTo>
                    <a:pt x="135393" y="120641"/>
                    <a:pt x="131731" y="125043"/>
                    <a:pt x="132510" y="130042"/>
                  </a:cubicBezTo>
                  <a:lnTo>
                    <a:pt x="125993" y="138657"/>
                  </a:lnTo>
                  <a:lnTo>
                    <a:pt x="121394" y="139160"/>
                  </a:lnTo>
                  <a:lnTo>
                    <a:pt x="120713" y="143122"/>
                  </a:lnTo>
                  <a:lnTo>
                    <a:pt x="116339" y="147586"/>
                  </a:lnTo>
                  <a:cubicBezTo>
                    <a:pt x="117385" y="154315"/>
                    <a:pt x="116589" y="160698"/>
                    <a:pt x="111043" y="165665"/>
                  </a:cubicBezTo>
                  <a:cubicBezTo>
                    <a:pt x="110331" y="169030"/>
                    <a:pt x="109875" y="176010"/>
                    <a:pt x="111737" y="179280"/>
                  </a:cubicBezTo>
                  <a:lnTo>
                    <a:pt x="108272" y="183461"/>
                  </a:lnTo>
                  <a:cubicBezTo>
                    <a:pt x="108188" y="188240"/>
                    <a:pt x="112148" y="191730"/>
                    <a:pt x="111965" y="196604"/>
                  </a:cubicBezTo>
                  <a:cubicBezTo>
                    <a:pt x="108851" y="198710"/>
                    <a:pt x="106812" y="202106"/>
                    <a:pt x="106199" y="205502"/>
                  </a:cubicBezTo>
                  <a:cubicBezTo>
                    <a:pt x="105950" y="206916"/>
                    <a:pt x="106329" y="208614"/>
                    <a:pt x="105978" y="209966"/>
                  </a:cubicBezTo>
                  <a:cubicBezTo>
                    <a:pt x="105802" y="210626"/>
                    <a:pt x="103894" y="214053"/>
                    <a:pt x="103887" y="214399"/>
                  </a:cubicBezTo>
                  <a:cubicBezTo>
                    <a:pt x="103877" y="214683"/>
                    <a:pt x="105423" y="227228"/>
                    <a:pt x="105504" y="227542"/>
                  </a:cubicBezTo>
                  <a:cubicBezTo>
                    <a:pt x="105823" y="228768"/>
                    <a:pt x="109482" y="233516"/>
                    <a:pt x="110362" y="236660"/>
                  </a:cubicBez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20" name="자유형: 도형 361"/>
            <p:cNvSpPr/>
            <p:nvPr/>
          </p:nvSpPr>
          <p:spPr>
            <a:xfrm>
              <a:off x="8006760" y="3197520"/>
              <a:ext cx="36000" cy="116280"/>
            </a:xfrm>
            <a:custGeom>
              <a:avLst/>
              <a:gdLst/>
              <a:ahLst/>
              <a:cxnLst/>
              <a:rect l="l" t="t" r="r" b="b"/>
              <a:pathLst>
                <a:path w="28703" h="94921">
                  <a:moveTo>
                    <a:pt x="9162" y="94922"/>
                  </a:moveTo>
                  <a:lnTo>
                    <a:pt x="6135" y="89451"/>
                  </a:lnTo>
                  <a:lnTo>
                    <a:pt x="7064" y="80049"/>
                  </a:lnTo>
                  <a:lnTo>
                    <a:pt x="12123" y="78572"/>
                  </a:lnTo>
                  <a:lnTo>
                    <a:pt x="22716" y="73636"/>
                  </a:lnTo>
                  <a:lnTo>
                    <a:pt x="26623" y="69674"/>
                  </a:lnTo>
                  <a:lnTo>
                    <a:pt x="28703" y="65209"/>
                  </a:lnTo>
                  <a:lnTo>
                    <a:pt x="27774" y="61247"/>
                  </a:lnTo>
                  <a:lnTo>
                    <a:pt x="23172" y="58261"/>
                  </a:lnTo>
                  <a:lnTo>
                    <a:pt x="22021" y="53324"/>
                  </a:lnTo>
                  <a:lnTo>
                    <a:pt x="21790" y="48860"/>
                  </a:lnTo>
                  <a:lnTo>
                    <a:pt x="18569" y="44647"/>
                  </a:lnTo>
                  <a:lnTo>
                    <a:pt x="17416" y="40213"/>
                  </a:lnTo>
                  <a:lnTo>
                    <a:pt x="12361" y="37981"/>
                  </a:lnTo>
                  <a:lnTo>
                    <a:pt x="13736" y="33516"/>
                  </a:lnTo>
                  <a:lnTo>
                    <a:pt x="13512" y="29052"/>
                  </a:lnTo>
                  <a:lnTo>
                    <a:pt x="10288" y="24367"/>
                  </a:lnTo>
                  <a:lnTo>
                    <a:pt x="9137" y="19651"/>
                  </a:lnTo>
                  <a:lnTo>
                    <a:pt x="7520" y="17418"/>
                  </a:lnTo>
                  <a:lnTo>
                    <a:pt x="6419" y="16004"/>
                  </a:lnTo>
                  <a:lnTo>
                    <a:pt x="1743" y="11696"/>
                  </a:lnTo>
                  <a:lnTo>
                    <a:pt x="0" y="7294"/>
                  </a:lnTo>
                  <a:lnTo>
                    <a:pt x="800" y="2892"/>
                  </a:lnTo>
                  <a:lnTo>
                    <a:pt x="2571" y="0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21" name="자유형: 도형 362"/>
            <p:cNvSpPr/>
            <p:nvPr/>
          </p:nvSpPr>
          <p:spPr>
            <a:xfrm>
              <a:off x="8016840" y="3314160"/>
              <a:ext cx="535320" cy="334800"/>
            </a:xfrm>
            <a:custGeom>
              <a:avLst/>
              <a:gdLst/>
              <a:ahLst/>
              <a:cxnLst/>
              <a:rect l="l" t="t" r="r" b="b"/>
              <a:pathLst>
                <a:path w="424159" h="272815">
                  <a:moveTo>
                    <a:pt x="424160" y="266937"/>
                  </a:moveTo>
                  <a:lnTo>
                    <a:pt x="411743" y="272816"/>
                  </a:lnTo>
                  <a:cubicBezTo>
                    <a:pt x="406341" y="271464"/>
                    <a:pt x="399922" y="268288"/>
                    <a:pt x="397712" y="263415"/>
                  </a:cubicBezTo>
                  <a:cubicBezTo>
                    <a:pt x="396449" y="260648"/>
                    <a:pt x="396169" y="257127"/>
                    <a:pt x="395151" y="254266"/>
                  </a:cubicBezTo>
                  <a:cubicBezTo>
                    <a:pt x="393678" y="249959"/>
                    <a:pt x="389118" y="244739"/>
                    <a:pt x="385961" y="241374"/>
                  </a:cubicBezTo>
                  <a:cubicBezTo>
                    <a:pt x="380139" y="237319"/>
                    <a:pt x="371474" y="242381"/>
                    <a:pt x="365480" y="239646"/>
                  </a:cubicBezTo>
                  <a:cubicBezTo>
                    <a:pt x="361060" y="237602"/>
                    <a:pt x="350284" y="229741"/>
                    <a:pt x="345455" y="230716"/>
                  </a:cubicBezTo>
                  <a:cubicBezTo>
                    <a:pt x="341235" y="233766"/>
                    <a:pt x="334619" y="235212"/>
                    <a:pt x="329347" y="233955"/>
                  </a:cubicBezTo>
                  <a:cubicBezTo>
                    <a:pt x="325583" y="235149"/>
                    <a:pt x="322093" y="238514"/>
                    <a:pt x="319459" y="239394"/>
                  </a:cubicBezTo>
                  <a:lnTo>
                    <a:pt x="312549" y="240558"/>
                  </a:lnTo>
                  <a:lnTo>
                    <a:pt x="309094" y="241123"/>
                  </a:lnTo>
                  <a:cubicBezTo>
                    <a:pt x="306544" y="237099"/>
                    <a:pt x="300686" y="231471"/>
                    <a:pt x="295032" y="231723"/>
                  </a:cubicBezTo>
                  <a:cubicBezTo>
                    <a:pt x="292815" y="233577"/>
                    <a:pt x="290478" y="237602"/>
                    <a:pt x="290429" y="240369"/>
                  </a:cubicBezTo>
                  <a:lnTo>
                    <a:pt x="285599" y="243607"/>
                  </a:lnTo>
                  <a:lnTo>
                    <a:pt x="269492" y="242349"/>
                  </a:lnTo>
                  <a:cubicBezTo>
                    <a:pt x="267479" y="240463"/>
                    <a:pt x="262873" y="238200"/>
                    <a:pt x="259832" y="238388"/>
                  </a:cubicBezTo>
                  <a:lnTo>
                    <a:pt x="250852" y="229993"/>
                  </a:lnTo>
                  <a:cubicBezTo>
                    <a:pt x="241978" y="227038"/>
                    <a:pt x="237653" y="231471"/>
                    <a:pt x="230371" y="230968"/>
                  </a:cubicBezTo>
                  <a:cubicBezTo>
                    <a:pt x="228866" y="227509"/>
                    <a:pt x="231792" y="220058"/>
                    <a:pt x="233609" y="217102"/>
                  </a:cubicBezTo>
                  <a:lnTo>
                    <a:pt x="238891" y="215373"/>
                  </a:lnTo>
                  <a:cubicBezTo>
                    <a:pt x="241438" y="216442"/>
                    <a:pt x="246215" y="215907"/>
                    <a:pt x="248551" y="214619"/>
                  </a:cubicBezTo>
                  <a:lnTo>
                    <a:pt x="255914" y="206695"/>
                  </a:lnTo>
                  <a:lnTo>
                    <a:pt x="266279" y="203991"/>
                  </a:lnTo>
                  <a:cubicBezTo>
                    <a:pt x="268671" y="199590"/>
                    <a:pt x="262301" y="185126"/>
                    <a:pt x="260740" y="180473"/>
                  </a:cubicBezTo>
                  <a:cubicBezTo>
                    <a:pt x="259772" y="177581"/>
                    <a:pt x="261905" y="174656"/>
                    <a:pt x="261905" y="172047"/>
                  </a:cubicBezTo>
                  <a:lnTo>
                    <a:pt x="260070" y="165790"/>
                  </a:lnTo>
                  <a:cubicBezTo>
                    <a:pt x="258923" y="161860"/>
                    <a:pt x="259148" y="162991"/>
                    <a:pt x="259148" y="159502"/>
                  </a:cubicBezTo>
                  <a:cubicBezTo>
                    <a:pt x="259148" y="158904"/>
                    <a:pt x="259369" y="158496"/>
                    <a:pt x="259148" y="157930"/>
                  </a:cubicBezTo>
                  <a:cubicBezTo>
                    <a:pt x="258408" y="155980"/>
                    <a:pt x="252781" y="146925"/>
                    <a:pt x="250856" y="145070"/>
                  </a:cubicBezTo>
                  <a:cubicBezTo>
                    <a:pt x="245714" y="140039"/>
                    <a:pt x="237449" y="139379"/>
                    <a:pt x="231767" y="134915"/>
                  </a:cubicBezTo>
                  <a:cubicBezTo>
                    <a:pt x="228582" y="126834"/>
                    <a:pt x="232409" y="123658"/>
                    <a:pt x="223475" y="116584"/>
                  </a:cubicBezTo>
                  <a:cubicBezTo>
                    <a:pt x="216656" y="118660"/>
                    <a:pt x="207613" y="116176"/>
                    <a:pt x="203698" y="110642"/>
                  </a:cubicBezTo>
                  <a:lnTo>
                    <a:pt x="200763" y="104699"/>
                  </a:lnTo>
                  <a:cubicBezTo>
                    <a:pt x="199714" y="102561"/>
                    <a:pt x="198332" y="99700"/>
                    <a:pt x="198135" y="97279"/>
                  </a:cubicBezTo>
                  <a:cubicBezTo>
                    <a:pt x="197770" y="92783"/>
                    <a:pt x="199335" y="86935"/>
                    <a:pt x="196290" y="82910"/>
                  </a:cubicBezTo>
                  <a:cubicBezTo>
                    <a:pt x="191411" y="79295"/>
                    <a:pt x="188159" y="80867"/>
                    <a:pt x="185265" y="79703"/>
                  </a:cubicBezTo>
                  <a:cubicBezTo>
                    <a:pt x="182147" y="78446"/>
                    <a:pt x="178517" y="75742"/>
                    <a:pt x="175605" y="74012"/>
                  </a:cubicBezTo>
                  <a:lnTo>
                    <a:pt x="170523" y="74264"/>
                  </a:lnTo>
                  <a:cubicBezTo>
                    <a:pt x="166507" y="71937"/>
                    <a:pt x="159712" y="68479"/>
                    <a:pt x="154868" y="67818"/>
                  </a:cubicBezTo>
                  <a:cubicBezTo>
                    <a:pt x="151434" y="68133"/>
                    <a:pt x="146702" y="70994"/>
                    <a:pt x="144527" y="73258"/>
                  </a:cubicBezTo>
                  <a:cubicBezTo>
                    <a:pt x="141391" y="73258"/>
                    <a:pt x="136919" y="74861"/>
                    <a:pt x="134411" y="76496"/>
                  </a:cubicBezTo>
                  <a:cubicBezTo>
                    <a:pt x="130956" y="73415"/>
                    <a:pt x="123544" y="71372"/>
                    <a:pt x="118760" y="72503"/>
                  </a:cubicBezTo>
                  <a:cubicBezTo>
                    <a:pt x="116995" y="72944"/>
                    <a:pt x="115210" y="74390"/>
                    <a:pt x="113449" y="74735"/>
                  </a:cubicBezTo>
                  <a:cubicBezTo>
                    <a:pt x="110373" y="75396"/>
                    <a:pt x="106507" y="75428"/>
                    <a:pt x="103333" y="75742"/>
                  </a:cubicBezTo>
                  <a:cubicBezTo>
                    <a:pt x="100930" y="73572"/>
                    <a:pt x="96619" y="70774"/>
                    <a:pt x="93217" y="70051"/>
                  </a:cubicBezTo>
                  <a:lnTo>
                    <a:pt x="83999" y="52696"/>
                  </a:lnTo>
                  <a:lnTo>
                    <a:pt x="78478" y="52224"/>
                  </a:lnTo>
                  <a:lnTo>
                    <a:pt x="73177" y="55682"/>
                  </a:lnTo>
                  <a:cubicBezTo>
                    <a:pt x="68958" y="55054"/>
                    <a:pt x="61862" y="49991"/>
                    <a:pt x="58919" y="47507"/>
                  </a:cubicBezTo>
                  <a:cubicBezTo>
                    <a:pt x="54401" y="48293"/>
                    <a:pt x="52142" y="50809"/>
                    <a:pt x="49020" y="51721"/>
                  </a:cubicBezTo>
                  <a:cubicBezTo>
                    <a:pt x="46175" y="52538"/>
                    <a:pt x="42843" y="51658"/>
                    <a:pt x="38651" y="53450"/>
                  </a:cubicBezTo>
                  <a:lnTo>
                    <a:pt x="34049" y="52224"/>
                  </a:lnTo>
                  <a:lnTo>
                    <a:pt x="38890" y="47759"/>
                  </a:lnTo>
                  <a:lnTo>
                    <a:pt x="40040" y="43294"/>
                  </a:lnTo>
                  <a:cubicBezTo>
                    <a:pt x="36424" y="39993"/>
                    <a:pt x="35084" y="34679"/>
                    <a:pt x="35666" y="30183"/>
                  </a:cubicBezTo>
                  <a:cubicBezTo>
                    <a:pt x="33200" y="28108"/>
                    <a:pt x="30457" y="24052"/>
                    <a:pt x="29907" y="21003"/>
                  </a:cubicBezTo>
                  <a:cubicBezTo>
                    <a:pt x="29321" y="21003"/>
                    <a:pt x="25161" y="20940"/>
                    <a:pt x="24849" y="21003"/>
                  </a:cubicBezTo>
                  <a:cubicBezTo>
                    <a:pt x="23277" y="21348"/>
                    <a:pt x="21586" y="22543"/>
                    <a:pt x="20015" y="22983"/>
                  </a:cubicBezTo>
                  <a:cubicBezTo>
                    <a:pt x="14539" y="24555"/>
                    <a:pt x="6991" y="24744"/>
                    <a:pt x="3297" y="20185"/>
                  </a:cubicBezTo>
                  <a:cubicBezTo>
                    <a:pt x="1533" y="18016"/>
                    <a:pt x="21" y="15689"/>
                    <a:pt x="0" y="12859"/>
                  </a:cubicBezTo>
                  <a:cubicBezTo>
                    <a:pt x="1838" y="9181"/>
                    <a:pt x="3613" y="3773"/>
                    <a:pt x="1175" y="0"/>
                  </a:cubicBez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22" name="자유형: 도형 363"/>
            <p:cNvSpPr/>
            <p:nvPr/>
          </p:nvSpPr>
          <p:spPr>
            <a:xfrm>
              <a:off x="7692480" y="3314160"/>
              <a:ext cx="325440" cy="662040"/>
            </a:xfrm>
            <a:custGeom>
              <a:avLst/>
              <a:gdLst/>
              <a:ahLst/>
              <a:cxnLst/>
              <a:rect l="l" t="t" r="r" b="b"/>
              <a:pathLst>
                <a:path w="257997" h="539223">
                  <a:moveTo>
                    <a:pt x="257997" y="0"/>
                  </a:moveTo>
                  <a:lnTo>
                    <a:pt x="254844" y="2641"/>
                  </a:lnTo>
                  <a:lnTo>
                    <a:pt x="248530" y="7923"/>
                  </a:lnTo>
                  <a:cubicBezTo>
                    <a:pt x="244559" y="10501"/>
                    <a:pt x="237155" y="10093"/>
                    <a:pt x="233110" y="7923"/>
                  </a:cubicBezTo>
                  <a:lnTo>
                    <a:pt x="232423" y="12356"/>
                  </a:lnTo>
                  <a:lnTo>
                    <a:pt x="234250" y="16318"/>
                  </a:lnTo>
                  <a:cubicBezTo>
                    <a:pt x="232879" y="19179"/>
                    <a:pt x="230630" y="22228"/>
                    <a:pt x="228277" y="24492"/>
                  </a:cubicBezTo>
                  <a:lnTo>
                    <a:pt x="230571" y="28957"/>
                  </a:lnTo>
                  <a:cubicBezTo>
                    <a:pt x="225990" y="31473"/>
                    <a:pt x="223099" y="36566"/>
                    <a:pt x="222990" y="41345"/>
                  </a:cubicBezTo>
                  <a:lnTo>
                    <a:pt x="217466" y="42823"/>
                  </a:lnTo>
                  <a:lnTo>
                    <a:pt x="212864" y="40590"/>
                  </a:lnTo>
                  <a:lnTo>
                    <a:pt x="207564" y="42320"/>
                  </a:lnTo>
                  <a:cubicBezTo>
                    <a:pt x="203365" y="46124"/>
                    <a:pt x="202632" y="51343"/>
                    <a:pt x="197430" y="54456"/>
                  </a:cubicBezTo>
                  <a:cubicBezTo>
                    <a:pt x="196556" y="54424"/>
                    <a:pt x="187324" y="53922"/>
                    <a:pt x="187068" y="53953"/>
                  </a:cubicBezTo>
                  <a:cubicBezTo>
                    <a:pt x="182193" y="54739"/>
                    <a:pt x="176198" y="57223"/>
                    <a:pt x="171431" y="58669"/>
                  </a:cubicBezTo>
                  <a:lnTo>
                    <a:pt x="164756" y="67095"/>
                  </a:lnTo>
                  <a:lnTo>
                    <a:pt x="149571" y="69328"/>
                  </a:lnTo>
                  <a:cubicBezTo>
                    <a:pt x="147333" y="67536"/>
                    <a:pt x="142963" y="65460"/>
                    <a:pt x="139886" y="65366"/>
                  </a:cubicBezTo>
                  <a:lnTo>
                    <a:pt x="136435" y="69579"/>
                  </a:lnTo>
                  <a:lnTo>
                    <a:pt x="135284" y="78980"/>
                  </a:lnTo>
                  <a:lnTo>
                    <a:pt x="130910" y="82942"/>
                  </a:lnTo>
                  <a:lnTo>
                    <a:pt x="129760" y="87406"/>
                  </a:lnTo>
                  <a:cubicBezTo>
                    <a:pt x="126298" y="89293"/>
                    <a:pt x="122709" y="92343"/>
                    <a:pt x="120331" y="95330"/>
                  </a:cubicBezTo>
                  <a:lnTo>
                    <a:pt x="119398" y="104228"/>
                  </a:lnTo>
                  <a:lnTo>
                    <a:pt x="117869" y="105705"/>
                  </a:lnTo>
                  <a:lnTo>
                    <a:pt x="114810" y="108692"/>
                  </a:lnTo>
                  <a:cubicBezTo>
                    <a:pt x="108664" y="111994"/>
                    <a:pt x="100555" y="111554"/>
                    <a:pt x="96156" y="120074"/>
                  </a:cubicBezTo>
                  <a:lnTo>
                    <a:pt x="91319" y="121804"/>
                  </a:lnTo>
                  <a:cubicBezTo>
                    <a:pt x="89492" y="123816"/>
                    <a:pt x="88004" y="127872"/>
                    <a:pt x="88327" y="130482"/>
                  </a:cubicBezTo>
                  <a:cubicBezTo>
                    <a:pt x="85356" y="131393"/>
                    <a:pt x="80164" y="130670"/>
                    <a:pt x="77516" y="129223"/>
                  </a:cubicBezTo>
                  <a:cubicBezTo>
                    <a:pt x="68891" y="135669"/>
                    <a:pt x="72518" y="143781"/>
                    <a:pt x="72230" y="152239"/>
                  </a:cubicBezTo>
                  <a:cubicBezTo>
                    <a:pt x="72185" y="153559"/>
                    <a:pt x="71248" y="155131"/>
                    <a:pt x="71076" y="156452"/>
                  </a:cubicBezTo>
                  <a:cubicBezTo>
                    <a:pt x="70480" y="161042"/>
                    <a:pt x="71992" y="165790"/>
                    <a:pt x="71992" y="170318"/>
                  </a:cubicBezTo>
                  <a:cubicBezTo>
                    <a:pt x="71992" y="173745"/>
                    <a:pt x="70894" y="177109"/>
                    <a:pt x="70003" y="180379"/>
                  </a:cubicBezTo>
                  <a:cubicBezTo>
                    <a:pt x="69399" y="182611"/>
                    <a:pt x="68505" y="185252"/>
                    <a:pt x="66937" y="187170"/>
                  </a:cubicBezTo>
                  <a:cubicBezTo>
                    <a:pt x="63479" y="188710"/>
                    <a:pt x="59897" y="191320"/>
                    <a:pt x="57277" y="193836"/>
                  </a:cubicBezTo>
                  <a:cubicBezTo>
                    <a:pt x="56460" y="196885"/>
                    <a:pt x="55253" y="200187"/>
                    <a:pt x="54741" y="203268"/>
                  </a:cubicBezTo>
                  <a:cubicBezTo>
                    <a:pt x="53327" y="211726"/>
                    <a:pt x="55930" y="220781"/>
                    <a:pt x="45516" y="225057"/>
                  </a:cubicBezTo>
                  <a:lnTo>
                    <a:pt x="43450" y="233200"/>
                  </a:lnTo>
                  <a:cubicBezTo>
                    <a:pt x="40626" y="234583"/>
                    <a:pt x="37006" y="238451"/>
                    <a:pt x="36540" y="241374"/>
                  </a:cubicBezTo>
                  <a:cubicBezTo>
                    <a:pt x="37150" y="248198"/>
                    <a:pt x="44460" y="258070"/>
                    <a:pt x="48055" y="263667"/>
                  </a:cubicBezTo>
                  <a:cubicBezTo>
                    <a:pt x="44407" y="265962"/>
                    <a:pt x="39472" y="266842"/>
                    <a:pt x="37690" y="267880"/>
                  </a:cubicBezTo>
                  <a:cubicBezTo>
                    <a:pt x="35603" y="269074"/>
                    <a:pt x="31166" y="274263"/>
                    <a:pt x="29875" y="276275"/>
                  </a:cubicBezTo>
                  <a:lnTo>
                    <a:pt x="30797" y="280488"/>
                  </a:lnTo>
                  <a:lnTo>
                    <a:pt x="26879" y="284450"/>
                  </a:lnTo>
                  <a:lnTo>
                    <a:pt x="28030" y="293379"/>
                  </a:lnTo>
                  <a:cubicBezTo>
                    <a:pt x="26276" y="297183"/>
                    <a:pt x="23098" y="298912"/>
                    <a:pt x="20204" y="301774"/>
                  </a:cubicBezTo>
                  <a:cubicBezTo>
                    <a:pt x="16069" y="305924"/>
                    <a:pt x="8573" y="312841"/>
                    <a:pt x="10993" y="319130"/>
                  </a:cubicBezTo>
                  <a:cubicBezTo>
                    <a:pt x="11905" y="321488"/>
                    <a:pt x="16426" y="326266"/>
                    <a:pt x="18605" y="327776"/>
                  </a:cubicBezTo>
                  <a:cubicBezTo>
                    <a:pt x="19352" y="328310"/>
                    <a:pt x="23189" y="329851"/>
                    <a:pt x="23656" y="330259"/>
                  </a:cubicBezTo>
                  <a:cubicBezTo>
                    <a:pt x="23877" y="330448"/>
                    <a:pt x="26742" y="334473"/>
                    <a:pt x="27100" y="334944"/>
                  </a:cubicBezTo>
                  <a:cubicBezTo>
                    <a:pt x="32081" y="337083"/>
                    <a:pt x="38532" y="336171"/>
                    <a:pt x="42289" y="340164"/>
                  </a:cubicBezTo>
                  <a:cubicBezTo>
                    <a:pt x="41257" y="342490"/>
                    <a:pt x="41822" y="346641"/>
                    <a:pt x="42983" y="348842"/>
                  </a:cubicBezTo>
                  <a:lnTo>
                    <a:pt x="48052" y="352551"/>
                  </a:lnTo>
                  <a:lnTo>
                    <a:pt x="48746" y="356984"/>
                  </a:lnTo>
                  <a:cubicBezTo>
                    <a:pt x="52805" y="360412"/>
                    <a:pt x="52068" y="362675"/>
                    <a:pt x="54043" y="365411"/>
                  </a:cubicBezTo>
                  <a:cubicBezTo>
                    <a:pt x="57259" y="369907"/>
                    <a:pt x="61314" y="374246"/>
                    <a:pt x="64853" y="378553"/>
                  </a:cubicBezTo>
                  <a:lnTo>
                    <a:pt x="64159" y="382986"/>
                  </a:lnTo>
                  <a:lnTo>
                    <a:pt x="53804" y="389180"/>
                  </a:lnTo>
                  <a:cubicBezTo>
                    <a:pt x="50335" y="393173"/>
                    <a:pt x="53303" y="397953"/>
                    <a:pt x="50602" y="402292"/>
                  </a:cubicBezTo>
                  <a:cubicBezTo>
                    <a:pt x="51714" y="405436"/>
                    <a:pt x="53738" y="408800"/>
                    <a:pt x="55881" y="411472"/>
                  </a:cubicBezTo>
                  <a:cubicBezTo>
                    <a:pt x="60139" y="414428"/>
                    <a:pt x="62265" y="412510"/>
                    <a:pt x="66014" y="412950"/>
                  </a:cubicBezTo>
                  <a:cubicBezTo>
                    <a:pt x="69245" y="413328"/>
                    <a:pt x="72942" y="414491"/>
                    <a:pt x="76134" y="415182"/>
                  </a:cubicBezTo>
                  <a:lnTo>
                    <a:pt x="79361" y="419144"/>
                  </a:lnTo>
                  <a:cubicBezTo>
                    <a:pt x="79253" y="421943"/>
                    <a:pt x="77306" y="425999"/>
                    <a:pt x="75208" y="428042"/>
                  </a:cubicBezTo>
                  <a:cubicBezTo>
                    <a:pt x="75576" y="431501"/>
                    <a:pt x="74251" y="435022"/>
                    <a:pt x="73297" y="438292"/>
                  </a:cubicBezTo>
                  <a:cubicBezTo>
                    <a:pt x="69463" y="451434"/>
                    <a:pt x="57684" y="450869"/>
                    <a:pt x="50128" y="459263"/>
                  </a:cubicBezTo>
                  <a:cubicBezTo>
                    <a:pt x="49553" y="459892"/>
                    <a:pt x="48665" y="462407"/>
                    <a:pt x="48055" y="463193"/>
                  </a:cubicBezTo>
                  <a:cubicBezTo>
                    <a:pt x="45765" y="466243"/>
                    <a:pt x="42952" y="469199"/>
                    <a:pt x="40458" y="472123"/>
                  </a:cubicBezTo>
                  <a:lnTo>
                    <a:pt x="39528" y="481021"/>
                  </a:lnTo>
                  <a:lnTo>
                    <a:pt x="31471" y="488975"/>
                  </a:lnTo>
                  <a:cubicBezTo>
                    <a:pt x="29794" y="496427"/>
                    <a:pt x="34972" y="500797"/>
                    <a:pt x="37925" y="507023"/>
                  </a:cubicBezTo>
                  <a:cubicBezTo>
                    <a:pt x="40023" y="511456"/>
                    <a:pt x="39247" y="517587"/>
                    <a:pt x="35151" y="520888"/>
                  </a:cubicBezTo>
                  <a:cubicBezTo>
                    <a:pt x="30524" y="522303"/>
                    <a:pt x="24017" y="525825"/>
                    <a:pt x="23200" y="530541"/>
                  </a:cubicBezTo>
                  <a:cubicBezTo>
                    <a:pt x="17633" y="533779"/>
                    <a:pt x="9039" y="539407"/>
                    <a:pt x="2034" y="539219"/>
                  </a:cubicBezTo>
                  <a:lnTo>
                    <a:pt x="0" y="537521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23" name="자유형: 도형 364"/>
            <p:cNvSpPr/>
            <p:nvPr/>
          </p:nvSpPr>
          <p:spPr>
            <a:xfrm>
              <a:off x="6504480" y="3781440"/>
              <a:ext cx="1187640" cy="205200"/>
            </a:xfrm>
            <a:custGeom>
              <a:avLst/>
              <a:gdLst/>
              <a:ahLst/>
              <a:cxnLst/>
              <a:rect l="l" t="t" r="r" b="b"/>
              <a:pathLst>
                <a:path w="940413" h="167370">
                  <a:moveTo>
                    <a:pt x="940414" y="157238"/>
                  </a:moveTo>
                  <a:lnTo>
                    <a:pt x="936710" y="152773"/>
                  </a:lnTo>
                  <a:cubicBezTo>
                    <a:pt x="931501" y="146453"/>
                    <a:pt x="925071" y="149095"/>
                    <a:pt x="919185" y="144819"/>
                  </a:cubicBezTo>
                  <a:cubicBezTo>
                    <a:pt x="914429" y="141392"/>
                    <a:pt x="909574" y="137241"/>
                    <a:pt x="905151" y="133437"/>
                  </a:cubicBezTo>
                  <a:cubicBezTo>
                    <a:pt x="902117" y="130827"/>
                    <a:pt x="899385" y="127400"/>
                    <a:pt x="896171" y="125011"/>
                  </a:cubicBezTo>
                  <a:cubicBezTo>
                    <a:pt x="893337" y="122904"/>
                    <a:pt x="889454" y="121615"/>
                    <a:pt x="886511" y="119572"/>
                  </a:cubicBezTo>
                  <a:cubicBezTo>
                    <a:pt x="882720" y="116962"/>
                    <a:pt x="882025" y="114101"/>
                    <a:pt x="876153" y="113126"/>
                  </a:cubicBezTo>
                  <a:cubicBezTo>
                    <a:pt x="869211" y="117119"/>
                    <a:pt x="861558" y="113818"/>
                    <a:pt x="856812" y="108693"/>
                  </a:cubicBezTo>
                  <a:cubicBezTo>
                    <a:pt x="847713" y="106901"/>
                    <a:pt x="835468" y="116647"/>
                    <a:pt x="825962" y="111648"/>
                  </a:cubicBezTo>
                  <a:cubicBezTo>
                    <a:pt x="821219" y="116113"/>
                    <a:pt x="812741" y="123407"/>
                    <a:pt x="809402" y="128752"/>
                  </a:cubicBezTo>
                  <a:cubicBezTo>
                    <a:pt x="808542" y="130104"/>
                    <a:pt x="808181" y="131833"/>
                    <a:pt x="807332" y="133217"/>
                  </a:cubicBezTo>
                  <a:cubicBezTo>
                    <a:pt x="805796" y="135669"/>
                    <a:pt x="803555" y="139191"/>
                    <a:pt x="801573" y="141360"/>
                  </a:cubicBezTo>
                  <a:cubicBezTo>
                    <a:pt x="800212" y="142869"/>
                    <a:pt x="797619" y="143844"/>
                    <a:pt x="796273" y="145322"/>
                  </a:cubicBezTo>
                  <a:cubicBezTo>
                    <a:pt x="794698" y="147083"/>
                    <a:pt x="794031" y="151610"/>
                    <a:pt x="794666" y="153748"/>
                  </a:cubicBezTo>
                  <a:lnTo>
                    <a:pt x="785237" y="162174"/>
                  </a:lnTo>
                  <a:lnTo>
                    <a:pt x="780407" y="162646"/>
                  </a:lnTo>
                  <a:cubicBezTo>
                    <a:pt x="777019" y="160540"/>
                    <a:pt x="772641" y="155226"/>
                    <a:pt x="771873" y="154723"/>
                  </a:cubicBezTo>
                  <a:lnTo>
                    <a:pt x="764816" y="151610"/>
                  </a:lnTo>
                  <a:cubicBezTo>
                    <a:pt x="758737" y="148906"/>
                    <a:pt x="757141" y="148937"/>
                    <a:pt x="750473" y="150604"/>
                  </a:cubicBezTo>
                  <a:lnTo>
                    <a:pt x="739887" y="153245"/>
                  </a:lnTo>
                  <a:cubicBezTo>
                    <a:pt x="735527" y="156452"/>
                    <a:pt x="734246" y="161577"/>
                    <a:pt x="731219" y="163589"/>
                  </a:cubicBezTo>
                  <a:lnTo>
                    <a:pt x="731373" y="162898"/>
                  </a:lnTo>
                  <a:cubicBezTo>
                    <a:pt x="727049" y="163903"/>
                    <a:pt x="720016" y="165130"/>
                    <a:pt x="715487" y="164658"/>
                  </a:cubicBezTo>
                  <a:cubicBezTo>
                    <a:pt x="714151" y="163432"/>
                    <a:pt x="712400" y="161388"/>
                    <a:pt x="710882" y="160445"/>
                  </a:cubicBezTo>
                  <a:cubicBezTo>
                    <a:pt x="705403" y="156986"/>
                    <a:pt x="685454" y="157993"/>
                    <a:pt x="679133" y="158464"/>
                  </a:cubicBezTo>
                  <a:cubicBezTo>
                    <a:pt x="670975" y="153119"/>
                    <a:pt x="662310" y="146674"/>
                    <a:pt x="655867" y="139631"/>
                  </a:cubicBezTo>
                  <a:cubicBezTo>
                    <a:pt x="653142" y="138499"/>
                    <a:pt x="648129" y="138122"/>
                    <a:pt x="645284" y="139128"/>
                  </a:cubicBezTo>
                  <a:cubicBezTo>
                    <a:pt x="640184" y="143939"/>
                    <a:pt x="645544" y="150132"/>
                    <a:pt x="637452" y="155477"/>
                  </a:cubicBezTo>
                  <a:lnTo>
                    <a:pt x="631706" y="155980"/>
                  </a:lnTo>
                  <a:cubicBezTo>
                    <a:pt x="625417" y="153905"/>
                    <a:pt x="614273" y="149032"/>
                    <a:pt x="615588" y="141518"/>
                  </a:cubicBezTo>
                  <a:cubicBezTo>
                    <a:pt x="615792" y="140385"/>
                    <a:pt x="615830" y="138531"/>
                    <a:pt x="616886" y="137619"/>
                  </a:cubicBezTo>
                  <a:lnTo>
                    <a:pt x="616886" y="137052"/>
                  </a:lnTo>
                  <a:lnTo>
                    <a:pt x="611912" y="135921"/>
                  </a:lnTo>
                  <a:cubicBezTo>
                    <a:pt x="608219" y="138876"/>
                    <a:pt x="604672" y="138593"/>
                    <a:pt x="602473" y="139883"/>
                  </a:cubicBezTo>
                  <a:cubicBezTo>
                    <a:pt x="598965" y="141957"/>
                    <a:pt x="596082" y="145227"/>
                    <a:pt x="592581" y="147302"/>
                  </a:cubicBezTo>
                  <a:cubicBezTo>
                    <a:pt x="587909" y="150101"/>
                    <a:pt x="582227" y="151893"/>
                    <a:pt x="577610" y="154723"/>
                  </a:cubicBezTo>
                  <a:cubicBezTo>
                    <a:pt x="577113" y="155037"/>
                    <a:pt x="574797" y="158244"/>
                    <a:pt x="574166" y="158716"/>
                  </a:cubicBezTo>
                  <a:cubicBezTo>
                    <a:pt x="573731" y="159030"/>
                    <a:pt x="570304" y="160256"/>
                    <a:pt x="569560" y="160696"/>
                  </a:cubicBezTo>
                  <a:cubicBezTo>
                    <a:pt x="566039" y="162646"/>
                    <a:pt x="562622" y="164973"/>
                    <a:pt x="559199" y="167110"/>
                  </a:cubicBezTo>
                  <a:cubicBezTo>
                    <a:pt x="548507" y="169029"/>
                    <a:pt x="540569" y="159785"/>
                    <a:pt x="529306" y="157458"/>
                  </a:cubicBezTo>
                  <a:cubicBezTo>
                    <a:pt x="526128" y="156798"/>
                    <a:pt x="522228" y="156861"/>
                    <a:pt x="519173" y="155980"/>
                  </a:cubicBezTo>
                  <a:lnTo>
                    <a:pt x="515784" y="154000"/>
                  </a:lnTo>
                  <a:cubicBezTo>
                    <a:pt x="512283" y="151955"/>
                    <a:pt x="507723" y="150667"/>
                    <a:pt x="503507" y="150793"/>
                  </a:cubicBezTo>
                  <a:lnTo>
                    <a:pt x="499828" y="146328"/>
                  </a:lnTo>
                  <a:cubicBezTo>
                    <a:pt x="501522" y="141455"/>
                    <a:pt x="505815" y="137807"/>
                    <a:pt x="506731" y="132714"/>
                  </a:cubicBezTo>
                  <a:lnTo>
                    <a:pt x="516398" y="133217"/>
                  </a:lnTo>
                  <a:lnTo>
                    <a:pt x="521231" y="129255"/>
                  </a:lnTo>
                  <a:cubicBezTo>
                    <a:pt x="519916" y="125891"/>
                    <a:pt x="520369" y="122998"/>
                    <a:pt x="519629" y="119823"/>
                  </a:cubicBezTo>
                  <a:cubicBezTo>
                    <a:pt x="519457" y="119099"/>
                    <a:pt x="517801" y="115829"/>
                    <a:pt x="517776" y="115390"/>
                  </a:cubicBezTo>
                  <a:cubicBezTo>
                    <a:pt x="517647" y="113031"/>
                    <a:pt x="518594" y="109604"/>
                    <a:pt x="518934" y="107215"/>
                  </a:cubicBezTo>
                  <a:cubicBezTo>
                    <a:pt x="515352" y="104605"/>
                    <a:pt x="512027" y="97908"/>
                    <a:pt x="510866" y="94072"/>
                  </a:cubicBezTo>
                  <a:cubicBezTo>
                    <a:pt x="507376" y="94732"/>
                    <a:pt x="503419" y="96462"/>
                    <a:pt x="500533" y="98286"/>
                  </a:cubicBezTo>
                  <a:lnTo>
                    <a:pt x="487400" y="85426"/>
                  </a:lnTo>
                  <a:lnTo>
                    <a:pt x="486719" y="80961"/>
                  </a:lnTo>
                  <a:cubicBezTo>
                    <a:pt x="491335" y="77282"/>
                    <a:pt x="496867" y="78603"/>
                    <a:pt x="501673" y="75019"/>
                  </a:cubicBezTo>
                  <a:cubicBezTo>
                    <a:pt x="494843" y="67379"/>
                    <a:pt x="504931" y="59959"/>
                    <a:pt x="503967" y="52255"/>
                  </a:cubicBezTo>
                  <a:lnTo>
                    <a:pt x="499137" y="48293"/>
                  </a:lnTo>
                  <a:lnTo>
                    <a:pt x="494072" y="47791"/>
                  </a:lnTo>
                  <a:cubicBezTo>
                    <a:pt x="492290" y="44458"/>
                    <a:pt x="492633" y="41754"/>
                    <a:pt x="492006" y="38390"/>
                  </a:cubicBezTo>
                  <a:cubicBezTo>
                    <a:pt x="491746" y="36975"/>
                    <a:pt x="490901" y="35560"/>
                    <a:pt x="490627" y="34176"/>
                  </a:cubicBezTo>
                  <a:cubicBezTo>
                    <a:pt x="489813" y="29964"/>
                    <a:pt x="490381" y="24587"/>
                    <a:pt x="487175" y="21034"/>
                  </a:cubicBezTo>
                  <a:lnTo>
                    <a:pt x="482100" y="21286"/>
                  </a:lnTo>
                  <a:lnTo>
                    <a:pt x="477284" y="25498"/>
                  </a:lnTo>
                  <a:lnTo>
                    <a:pt x="472678" y="25750"/>
                  </a:lnTo>
                  <a:lnTo>
                    <a:pt x="467620" y="22795"/>
                  </a:lnTo>
                  <a:lnTo>
                    <a:pt x="462551" y="22795"/>
                  </a:lnTo>
                  <a:cubicBezTo>
                    <a:pt x="459317" y="26757"/>
                    <a:pt x="461131" y="31913"/>
                    <a:pt x="459328" y="36409"/>
                  </a:cubicBezTo>
                  <a:cubicBezTo>
                    <a:pt x="456469" y="38516"/>
                    <a:pt x="453477" y="42194"/>
                    <a:pt x="452183" y="45307"/>
                  </a:cubicBezTo>
                  <a:cubicBezTo>
                    <a:pt x="451874" y="46061"/>
                    <a:pt x="451562" y="49205"/>
                    <a:pt x="451274" y="49771"/>
                  </a:cubicBezTo>
                  <a:cubicBezTo>
                    <a:pt x="451144" y="50023"/>
                    <a:pt x="448194" y="53293"/>
                    <a:pt x="447823" y="53733"/>
                  </a:cubicBezTo>
                  <a:lnTo>
                    <a:pt x="443221" y="51501"/>
                  </a:lnTo>
                  <a:lnTo>
                    <a:pt x="439527" y="55966"/>
                  </a:lnTo>
                  <a:cubicBezTo>
                    <a:pt x="440169" y="58480"/>
                    <a:pt x="440604" y="61719"/>
                    <a:pt x="441593" y="64140"/>
                  </a:cubicBezTo>
                  <a:cubicBezTo>
                    <a:pt x="443017" y="67599"/>
                    <a:pt x="445711" y="69297"/>
                    <a:pt x="446444" y="73793"/>
                  </a:cubicBezTo>
                  <a:cubicBezTo>
                    <a:pt x="445041" y="76466"/>
                    <a:pt x="441025" y="79703"/>
                    <a:pt x="437913" y="80710"/>
                  </a:cubicBezTo>
                  <a:cubicBezTo>
                    <a:pt x="432726" y="81370"/>
                    <a:pt x="428439" y="78854"/>
                    <a:pt x="423192" y="79735"/>
                  </a:cubicBezTo>
                  <a:cubicBezTo>
                    <a:pt x="419694" y="80301"/>
                    <a:pt x="417067" y="82061"/>
                    <a:pt x="413293" y="80458"/>
                  </a:cubicBezTo>
                  <a:lnTo>
                    <a:pt x="408691" y="76245"/>
                  </a:lnTo>
                  <a:lnTo>
                    <a:pt x="407996" y="72063"/>
                  </a:lnTo>
                  <a:cubicBezTo>
                    <a:pt x="405004" y="71403"/>
                    <a:pt x="400041" y="72661"/>
                    <a:pt x="397642" y="74296"/>
                  </a:cubicBezTo>
                  <a:cubicBezTo>
                    <a:pt x="396607" y="71655"/>
                    <a:pt x="396130" y="68133"/>
                    <a:pt x="396491" y="65367"/>
                  </a:cubicBezTo>
                  <a:lnTo>
                    <a:pt x="390966" y="63385"/>
                  </a:lnTo>
                  <a:lnTo>
                    <a:pt x="384758" y="54708"/>
                  </a:lnTo>
                  <a:cubicBezTo>
                    <a:pt x="385417" y="52067"/>
                    <a:pt x="384253" y="47696"/>
                    <a:pt x="382450" y="45558"/>
                  </a:cubicBezTo>
                  <a:lnTo>
                    <a:pt x="384530" y="41094"/>
                  </a:lnTo>
                  <a:cubicBezTo>
                    <a:pt x="381562" y="39207"/>
                    <a:pt x="378392" y="36095"/>
                    <a:pt x="376708" y="33171"/>
                  </a:cubicBezTo>
                  <a:cubicBezTo>
                    <a:pt x="373558" y="32227"/>
                    <a:pt x="368998" y="31347"/>
                    <a:pt x="366122" y="29964"/>
                  </a:cubicBezTo>
                  <a:cubicBezTo>
                    <a:pt x="365410" y="29617"/>
                    <a:pt x="365231" y="29146"/>
                    <a:pt x="364662" y="28643"/>
                  </a:cubicBezTo>
                  <a:lnTo>
                    <a:pt x="361741" y="26002"/>
                  </a:lnTo>
                  <a:cubicBezTo>
                    <a:pt x="360958" y="25436"/>
                    <a:pt x="357117" y="23675"/>
                    <a:pt x="356665" y="23266"/>
                  </a:cubicBezTo>
                  <a:lnTo>
                    <a:pt x="353455" y="18582"/>
                  </a:lnTo>
                  <a:cubicBezTo>
                    <a:pt x="351179" y="14212"/>
                    <a:pt x="350011" y="9401"/>
                    <a:pt x="346773" y="5439"/>
                  </a:cubicBezTo>
                  <a:lnTo>
                    <a:pt x="341719" y="3490"/>
                  </a:lnTo>
                  <a:lnTo>
                    <a:pt x="335970" y="6948"/>
                  </a:lnTo>
                  <a:cubicBezTo>
                    <a:pt x="332855" y="7263"/>
                    <a:pt x="328800" y="6948"/>
                    <a:pt x="325850" y="5942"/>
                  </a:cubicBezTo>
                  <a:lnTo>
                    <a:pt x="322612" y="1006"/>
                  </a:lnTo>
                  <a:lnTo>
                    <a:pt x="317554" y="0"/>
                  </a:lnTo>
                  <a:lnTo>
                    <a:pt x="312949" y="1729"/>
                  </a:lnTo>
                  <a:cubicBezTo>
                    <a:pt x="312696" y="5376"/>
                    <a:pt x="311465" y="12011"/>
                    <a:pt x="309031" y="15123"/>
                  </a:cubicBezTo>
                  <a:cubicBezTo>
                    <a:pt x="304727" y="17230"/>
                    <a:pt x="292373" y="17198"/>
                    <a:pt x="287623" y="17104"/>
                  </a:cubicBezTo>
                  <a:cubicBezTo>
                    <a:pt x="286115" y="17072"/>
                    <a:pt x="284280" y="16098"/>
                    <a:pt x="282793" y="16098"/>
                  </a:cubicBezTo>
                  <a:cubicBezTo>
                    <a:pt x="279099" y="16161"/>
                    <a:pt x="271018" y="17261"/>
                    <a:pt x="267836" y="19336"/>
                  </a:cubicBezTo>
                  <a:cubicBezTo>
                    <a:pt x="264718" y="24304"/>
                    <a:pt x="258092" y="32762"/>
                    <a:pt x="250557" y="31944"/>
                  </a:cubicBezTo>
                  <a:lnTo>
                    <a:pt x="248035" y="35906"/>
                  </a:lnTo>
                  <a:cubicBezTo>
                    <a:pt x="249895" y="38987"/>
                    <a:pt x="253146" y="42320"/>
                    <a:pt x="256328" y="44332"/>
                  </a:cubicBezTo>
                  <a:cubicBezTo>
                    <a:pt x="257425" y="48734"/>
                    <a:pt x="259204" y="53733"/>
                    <a:pt x="259779" y="58198"/>
                  </a:cubicBezTo>
                  <a:cubicBezTo>
                    <a:pt x="259797" y="58355"/>
                    <a:pt x="258734" y="61782"/>
                    <a:pt x="258629" y="62160"/>
                  </a:cubicBezTo>
                  <a:cubicBezTo>
                    <a:pt x="256005" y="64077"/>
                    <a:pt x="251091" y="69957"/>
                    <a:pt x="250554" y="70334"/>
                  </a:cubicBezTo>
                  <a:cubicBezTo>
                    <a:pt x="246096" y="73321"/>
                    <a:pt x="240396" y="75868"/>
                    <a:pt x="235604" y="78509"/>
                  </a:cubicBezTo>
                  <a:cubicBezTo>
                    <a:pt x="238614" y="80081"/>
                    <a:pt x="242356" y="84451"/>
                    <a:pt x="242732" y="87658"/>
                  </a:cubicBezTo>
                  <a:cubicBezTo>
                    <a:pt x="242163" y="94921"/>
                    <a:pt x="235899" y="104605"/>
                    <a:pt x="228473" y="107718"/>
                  </a:cubicBezTo>
                  <a:lnTo>
                    <a:pt x="223411" y="107969"/>
                  </a:lnTo>
                  <a:lnTo>
                    <a:pt x="218118" y="111680"/>
                  </a:lnTo>
                  <a:lnTo>
                    <a:pt x="214218" y="120577"/>
                  </a:lnTo>
                  <a:lnTo>
                    <a:pt x="209132" y="121583"/>
                  </a:lnTo>
                  <a:lnTo>
                    <a:pt x="204301" y="125545"/>
                  </a:lnTo>
                  <a:cubicBezTo>
                    <a:pt x="199836" y="122810"/>
                    <a:pt x="193747" y="121018"/>
                    <a:pt x="188647" y="119603"/>
                  </a:cubicBezTo>
                  <a:cubicBezTo>
                    <a:pt x="184883" y="121835"/>
                    <a:pt x="182533" y="128972"/>
                    <a:pt x="182438" y="132714"/>
                  </a:cubicBezTo>
                  <a:cubicBezTo>
                    <a:pt x="178983" y="136424"/>
                    <a:pt x="175114" y="137336"/>
                    <a:pt x="172083" y="139883"/>
                  </a:cubicBezTo>
                  <a:cubicBezTo>
                    <a:pt x="169046" y="142429"/>
                    <a:pt x="168365" y="145479"/>
                    <a:pt x="163567" y="148309"/>
                  </a:cubicBezTo>
                  <a:cubicBezTo>
                    <a:pt x="158312" y="148214"/>
                    <a:pt x="149585" y="143121"/>
                    <a:pt x="145607" y="140385"/>
                  </a:cubicBezTo>
                  <a:lnTo>
                    <a:pt x="139160" y="135921"/>
                  </a:lnTo>
                  <a:cubicBezTo>
                    <a:pt x="139034" y="135858"/>
                    <a:pt x="134555" y="135261"/>
                    <a:pt x="134113" y="135198"/>
                  </a:cubicBezTo>
                  <a:lnTo>
                    <a:pt x="129970" y="139662"/>
                  </a:lnTo>
                  <a:cubicBezTo>
                    <a:pt x="127445" y="140543"/>
                    <a:pt x="122993" y="140385"/>
                    <a:pt x="120527" y="139410"/>
                  </a:cubicBezTo>
                  <a:lnTo>
                    <a:pt x="115922" y="141863"/>
                  </a:lnTo>
                  <a:cubicBezTo>
                    <a:pt x="114757" y="145637"/>
                    <a:pt x="120093" y="155572"/>
                    <a:pt x="122597" y="158968"/>
                  </a:cubicBezTo>
                  <a:lnTo>
                    <a:pt x="121903" y="163432"/>
                  </a:lnTo>
                  <a:lnTo>
                    <a:pt x="117297" y="166136"/>
                  </a:lnTo>
                  <a:lnTo>
                    <a:pt x="108335" y="157489"/>
                  </a:lnTo>
                  <a:lnTo>
                    <a:pt x="98352" y="155823"/>
                  </a:lnTo>
                  <a:cubicBezTo>
                    <a:pt x="91978" y="154786"/>
                    <a:pt x="90905" y="154723"/>
                    <a:pt x="85307" y="157396"/>
                  </a:cubicBezTo>
                  <a:lnTo>
                    <a:pt x="78404" y="160696"/>
                  </a:lnTo>
                  <a:cubicBezTo>
                    <a:pt x="75601" y="158307"/>
                    <a:pt x="71851" y="155666"/>
                    <a:pt x="69424" y="153025"/>
                  </a:cubicBezTo>
                  <a:cubicBezTo>
                    <a:pt x="67891" y="151327"/>
                    <a:pt x="65169" y="141831"/>
                    <a:pt x="65053" y="139883"/>
                  </a:cubicBezTo>
                  <a:lnTo>
                    <a:pt x="65516" y="130324"/>
                  </a:lnTo>
                  <a:cubicBezTo>
                    <a:pt x="65541" y="129821"/>
                    <a:pt x="65899" y="122432"/>
                    <a:pt x="65281" y="121081"/>
                  </a:cubicBezTo>
                  <a:cubicBezTo>
                    <a:pt x="63991" y="118250"/>
                    <a:pt x="61479" y="115106"/>
                    <a:pt x="59771" y="112403"/>
                  </a:cubicBezTo>
                  <a:lnTo>
                    <a:pt x="55397" y="110453"/>
                  </a:lnTo>
                  <a:cubicBezTo>
                    <a:pt x="53401" y="112969"/>
                    <a:pt x="51089" y="116710"/>
                    <a:pt x="48722" y="118848"/>
                  </a:cubicBezTo>
                  <a:cubicBezTo>
                    <a:pt x="48585" y="118974"/>
                    <a:pt x="43885" y="121112"/>
                    <a:pt x="43404" y="121332"/>
                  </a:cubicBezTo>
                  <a:lnTo>
                    <a:pt x="42264" y="117119"/>
                  </a:lnTo>
                  <a:cubicBezTo>
                    <a:pt x="44148" y="114541"/>
                    <a:pt x="48073" y="107026"/>
                    <a:pt x="46642" y="103756"/>
                  </a:cubicBezTo>
                  <a:cubicBezTo>
                    <a:pt x="44078" y="98726"/>
                    <a:pt x="37988" y="96619"/>
                    <a:pt x="36045" y="91369"/>
                  </a:cubicBezTo>
                  <a:cubicBezTo>
                    <a:pt x="37581" y="88664"/>
                    <a:pt x="43309" y="77157"/>
                    <a:pt x="42489" y="74045"/>
                  </a:cubicBezTo>
                  <a:lnTo>
                    <a:pt x="39889" y="68259"/>
                  </a:lnTo>
                  <a:cubicBezTo>
                    <a:pt x="36939" y="61719"/>
                    <a:pt x="32411" y="57318"/>
                    <a:pt x="25231" y="54236"/>
                  </a:cubicBezTo>
                  <a:cubicBezTo>
                    <a:pt x="18012" y="55777"/>
                    <a:pt x="5044" y="51658"/>
                    <a:pt x="0" y="46345"/>
                  </a:cubicBez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24" name="자유형: 도형 365"/>
            <p:cNvSpPr/>
            <p:nvPr/>
          </p:nvSpPr>
          <p:spPr>
            <a:xfrm>
              <a:off x="7692120" y="3974400"/>
              <a:ext cx="222120" cy="381240"/>
            </a:xfrm>
            <a:custGeom>
              <a:avLst/>
              <a:gdLst/>
              <a:ahLst/>
              <a:cxnLst/>
              <a:rect l="l" t="t" r="r" b="b"/>
              <a:pathLst>
                <a:path w="176259" h="310672">
                  <a:moveTo>
                    <a:pt x="336" y="0"/>
                  </a:moveTo>
                  <a:cubicBezTo>
                    <a:pt x="-1653" y="12890"/>
                    <a:pt x="5531" y="16947"/>
                    <a:pt x="12711" y="27448"/>
                  </a:cubicBezTo>
                  <a:cubicBezTo>
                    <a:pt x="15861" y="32070"/>
                    <a:pt x="16559" y="36095"/>
                    <a:pt x="21463" y="39836"/>
                  </a:cubicBezTo>
                  <a:cubicBezTo>
                    <a:pt x="24697" y="42288"/>
                    <a:pt x="28205" y="43766"/>
                    <a:pt x="31134" y="46753"/>
                  </a:cubicBezTo>
                  <a:cubicBezTo>
                    <a:pt x="33091" y="51061"/>
                    <a:pt x="31867" y="55808"/>
                    <a:pt x="32965" y="60147"/>
                  </a:cubicBezTo>
                  <a:cubicBezTo>
                    <a:pt x="34417" y="65838"/>
                    <a:pt x="39296" y="71403"/>
                    <a:pt x="38489" y="77723"/>
                  </a:cubicBezTo>
                  <a:cubicBezTo>
                    <a:pt x="38002" y="81559"/>
                    <a:pt x="35599" y="87469"/>
                    <a:pt x="35722" y="91085"/>
                  </a:cubicBezTo>
                  <a:cubicBezTo>
                    <a:pt x="35729" y="91274"/>
                    <a:pt x="39513" y="110736"/>
                    <a:pt x="39640" y="111145"/>
                  </a:cubicBezTo>
                  <a:lnTo>
                    <a:pt x="44940" y="119540"/>
                  </a:lnTo>
                  <a:cubicBezTo>
                    <a:pt x="47367" y="121867"/>
                    <a:pt x="51938" y="123281"/>
                    <a:pt x="54618" y="125482"/>
                  </a:cubicBezTo>
                  <a:cubicBezTo>
                    <a:pt x="56876" y="127337"/>
                    <a:pt x="58462" y="131991"/>
                    <a:pt x="61970" y="134160"/>
                  </a:cubicBezTo>
                  <a:cubicBezTo>
                    <a:pt x="64699" y="135858"/>
                    <a:pt x="68329" y="136801"/>
                    <a:pt x="71170" y="138373"/>
                  </a:cubicBezTo>
                  <a:cubicBezTo>
                    <a:pt x="74204" y="140071"/>
                    <a:pt x="78438" y="142680"/>
                    <a:pt x="81072" y="144788"/>
                  </a:cubicBezTo>
                  <a:cubicBezTo>
                    <a:pt x="85678" y="148529"/>
                    <a:pt x="90505" y="153277"/>
                    <a:pt x="94651" y="157426"/>
                  </a:cubicBezTo>
                  <a:cubicBezTo>
                    <a:pt x="104879" y="167708"/>
                    <a:pt x="97352" y="176197"/>
                    <a:pt x="101087" y="184907"/>
                  </a:cubicBezTo>
                  <a:cubicBezTo>
                    <a:pt x="105510" y="187893"/>
                    <a:pt x="110783" y="191792"/>
                    <a:pt x="113757" y="196068"/>
                  </a:cubicBezTo>
                  <a:cubicBezTo>
                    <a:pt x="114760" y="197514"/>
                    <a:pt x="115293" y="199306"/>
                    <a:pt x="116286" y="200753"/>
                  </a:cubicBezTo>
                  <a:lnTo>
                    <a:pt x="119976" y="205218"/>
                  </a:lnTo>
                  <a:cubicBezTo>
                    <a:pt x="122214" y="206916"/>
                    <a:pt x="131934" y="208236"/>
                    <a:pt x="134688" y="208425"/>
                  </a:cubicBezTo>
                  <a:cubicBezTo>
                    <a:pt x="136743" y="212103"/>
                    <a:pt x="135610" y="214430"/>
                    <a:pt x="136083" y="215845"/>
                  </a:cubicBezTo>
                  <a:cubicBezTo>
                    <a:pt x="136192" y="216191"/>
                    <a:pt x="140370" y="225151"/>
                    <a:pt x="140458" y="225277"/>
                  </a:cubicBezTo>
                  <a:cubicBezTo>
                    <a:pt x="140917" y="225906"/>
                    <a:pt x="141489" y="226031"/>
                    <a:pt x="142145" y="226504"/>
                  </a:cubicBezTo>
                  <a:cubicBezTo>
                    <a:pt x="146256" y="229522"/>
                    <a:pt x="151149" y="231628"/>
                    <a:pt x="156576" y="229711"/>
                  </a:cubicBezTo>
                  <a:cubicBezTo>
                    <a:pt x="163959" y="233860"/>
                    <a:pt x="164615" y="241941"/>
                    <a:pt x="167158" y="248701"/>
                  </a:cubicBezTo>
                  <a:cubicBezTo>
                    <a:pt x="171736" y="260837"/>
                    <a:pt x="174970" y="255146"/>
                    <a:pt x="176131" y="270490"/>
                  </a:cubicBezTo>
                  <a:cubicBezTo>
                    <a:pt x="176278" y="272407"/>
                    <a:pt x="176457" y="276055"/>
                    <a:pt x="175668" y="278004"/>
                  </a:cubicBezTo>
                  <a:cubicBezTo>
                    <a:pt x="173984" y="282155"/>
                    <a:pt x="171536" y="287216"/>
                    <a:pt x="169231" y="291115"/>
                  </a:cubicBezTo>
                  <a:cubicBezTo>
                    <a:pt x="166877" y="295139"/>
                    <a:pt x="162686" y="296335"/>
                    <a:pt x="160255" y="299038"/>
                  </a:cubicBezTo>
                  <a:cubicBezTo>
                    <a:pt x="158270" y="301270"/>
                    <a:pt x="156832" y="307810"/>
                    <a:pt x="157414" y="310672"/>
                  </a:cubicBez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25" name="자유형: 도형 366"/>
            <p:cNvSpPr/>
            <p:nvPr/>
          </p:nvSpPr>
          <p:spPr>
            <a:xfrm>
              <a:off x="6685200" y="1418760"/>
              <a:ext cx="191160" cy="61560"/>
            </a:xfrm>
            <a:custGeom>
              <a:avLst/>
              <a:gdLst/>
              <a:ahLst/>
              <a:cxnLst/>
              <a:rect l="l" t="t" r="r" b="b"/>
              <a:pathLst>
                <a:path w="151707" h="50369">
                  <a:moveTo>
                    <a:pt x="151707" y="47539"/>
                  </a:moveTo>
                  <a:lnTo>
                    <a:pt x="139950" y="44993"/>
                  </a:lnTo>
                  <a:lnTo>
                    <a:pt x="122987" y="50369"/>
                  </a:lnTo>
                  <a:lnTo>
                    <a:pt x="119444" y="40654"/>
                  </a:lnTo>
                  <a:lnTo>
                    <a:pt x="100685" y="38516"/>
                  </a:lnTo>
                  <a:lnTo>
                    <a:pt x="87924" y="25656"/>
                  </a:lnTo>
                  <a:lnTo>
                    <a:pt x="70431" y="10879"/>
                  </a:lnTo>
                  <a:lnTo>
                    <a:pt x="43506" y="0"/>
                  </a:lnTo>
                  <a:lnTo>
                    <a:pt x="31166" y="8678"/>
                  </a:lnTo>
                  <a:lnTo>
                    <a:pt x="23333" y="25499"/>
                  </a:lnTo>
                  <a:lnTo>
                    <a:pt x="12992" y="23172"/>
                  </a:lnTo>
                  <a:lnTo>
                    <a:pt x="0" y="34805"/>
                  </a:ln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26" name="자유형: 도형 367"/>
            <p:cNvSpPr/>
            <p:nvPr/>
          </p:nvSpPr>
          <p:spPr>
            <a:xfrm>
              <a:off x="8823240" y="1958760"/>
              <a:ext cx="737280" cy="131760"/>
            </a:xfrm>
            <a:custGeom>
              <a:avLst/>
              <a:gdLst/>
              <a:ahLst/>
              <a:cxnLst/>
              <a:rect l="l" t="t" r="r" b="b"/>
              <a:pathLst>
                <a:path w="583924" h="107435">
                  <a:moveTo>
                    <a:pt x="0" y="77975"/>
                  </a:moveTo>
                  <a:cubicBezTo>
                    <a:pt x="5472" y="79924"/>
                    <a:pt x="11365" y="81685"/>
                    <a:pt x="16697" y="83917"/>
                  </a:cubicBezTo>
                  <a:cubicBezTo>
                    <a:pt x="18275" y="84609"/>
                    <a:pt x="19748" y="86118"/>
                    <a:pt x="21292" y="86904"/>
                  </a:cubicBezTo>
                  <a:cubicBezTo>
                    <a:pt x="22800" y="87658"/>
                    <a:pt x="24975" y="88004"/>
                    <a:pt x="26343" y="88885"/>
                  </a:cubicBezTo>
                  <a:cubicBezTo>
                    <a:pt x="31394" y="91966"/>
                    <a:pt x="36235" y="95708"/>
                    <a:pt x="41075" y="99040"/>
                  </a:cubicBezTo>
                  <a:cubicBezTo>
                    <a:pt x="47845" y="101241"/>
                    <a:pt x="54650" y="95645"/>
                    <a:pt x="61560" y="97311"/>
                  </a:cubicBezTo>
                  <a:cubicBezTo>
                    <a:pt x="68751" y="99009"/>
                    <a:pt x="74083" y="105203"/>
                    <a:pt x="81168" y="107435"/>
                  </a:cubicBezTo>
                  <a:lnTo>
                    <a:pt x="86885" y="106712"/>
                  </a:lnTo>
                  <a:lnTo>
                    <a:pt x="91270" y="102499"/>
                  </a:lnTo>
                  <a:lnTo>
                    <a:pt x="86360" y="93098"/>
                  </a:lnTo>
                  <a:cubicBezTo>
                    <a:pt x="82957" y="86558"/>
                    <a:pt x="81729" y="82408"/>
                    <a:pt x="86885" y="76245"/>
                  </a:cubicBezTo>
                  <a:lnTo>
                    <a:pt x="92673" y="76748"/>
                  </a:lnTo>
                  <a:cubicBezTo>
                    <a:pt x="96461" y="68888"/>
                    <a:pt x="104249" y="66310"/>
                    <a:pt x="104705" y="56374"/>
                  </a:cubicBezTo>
                  <a:cubicBezTo>
                    <a:pt x="110878" y="57852"/>
                    <a:pt x="117578" y="59078"/>
                    <a:pt x="123962" y="59456"/>
                  </a:cubicBezTo>
                  <a:lnTo>
                    <a:pt x="130346" y="67599"/>
                  </a:lnTo>
                  <a:cubicBezTo>
                    <a:pt x="135432" y="67442"/>
                    <a:pt x="141219" y="66750"/>
                    <a:pt x="146271" y="67033"/>
                  </a:cubicBezTo>
                  <a:cubicBezTo>
                    <a:pt x="146376" y="67033"/>
                    <a:pt x="149638" y="68574"/>
                    <a:pt x="149954" y="68699"/>
                  </a:cubicBezTo>
                  <a:cubicBezTo>
                    <a:pt x="152163" y="73699"/>
                    <a:pt x="154479" y="80836"/>
                    <a:pt x="157285" y="85426"/>
                  </a:cubicBezTo>
                  <a:lnTo>
                    <a:pt x="163563" y="90677"/>
                  </a:lnTo>
                  <a:cubicBezTo>
                    <a:pt x="167282" y="92532"/>
                    <a:pt x="172578" y="92186"/>
                    <a:pt x="176367" y="93475"/>
                  </a:cubicBezTo>
                  <a:cubicBezTo>
                    <a:pt x="178927" y="94356"/>
                    <a:pt x="182996" y="97531"/>
                    <a:pt x="185907" y="96651"/>
                  </a:cubicBezTo>
                  <a:lnTo>
                    <a:pt x="187942" y="88633"/>
                  </a:lnTo>
                  <a:lnTo>
                    <a:pt x="194431" y="91148"/>
                  </a:lnTo>
                  <a:lnTo>
                    <a:pt x="198044" y="96336"/>
                  </a:lnTo>
                  <a:lnTo>
                    <a:pt x="203481" y="96336"/>
                  </a:lnTo>
                  <a:lnTo>
                    <a:pt x="202183" y="83697"/>
                  </a:lnTo>
                  <a:cubicBezTo>
                    <a:pt x="206147" y="79515"/>
                    <a:pt x="210251" y="74233"/>
                    <a:pt x="213022" y="69328"/>
                  </a:cubicBezTo>
                  <a:cubicBezTo>
                    <a:pt x="215548" y="64864"/>
                    <a:pt x="215021" y="59078"/>
                    <a:pt x="219476" y="55714"/>
                  </a:cubicBezTo>
                  <a:cubicBezTo>
                    <a:pt x="223685" y="53953"/>
                    <a:pt x="229192" y="53230"/>
                    <a:pt x="233752" y="52727"/>
                  </a:cubicBezTo>
                  <a:cubicBezTo>
                    <a:pt x="241434" y="54834"/>
                    <a:pt x="244837" y="65209"/>
                    <a:pt x="252132" y="65869"/>
                  </a:cubicBezTo>
                  <a:cubicBezTo>
                    <a:pt x="256482" y="63858"/>
                    <a:pt x="258797" y="65146"/>
                    <a:pt x="262726" y="64612"/>
                  </a:cubicBezTo>
                  <a:cubicBezTo>
                    <a:pt x="266514" y="64109"/>
                    <a:pt x="270548" y="62946"/>
                    <a:pt x="274266" y="62160"/>
                  </a:cubicBezTo>
                  <a:cubicBezTo>
                    <a:pt x="285666" y="66058"/>
                    <a:pt x="298153" y="66970"/>
                    <a:pt x="309939" y="69580"/>
                  </a:cubicBezTo>
                  <a:cubicBezTo>
                    <a:pt x="316990" y="71120"/>
                    <a:pt x="324110" y="73384"/>
                    <a:pt x="331090" y="75271"/>
                  </a:cubicBezTo>
                  <a:lnTo>
                    <a:pt x="335931" y="74013"/>
                  </a:lnTo>
                  <a:cubicBezTo>
                    <a:pt x="341789" y="70083"/>
                    <a:pt x="341999" y="61625"/>
                    <a:pt x="345823" y="56217"/>
                  </a:cubicBezTo>
                  <a:cubicBezTo>
                    <a:pt x="350699" y="53136"/>
                    <a:pt x="360310" y="46942"/>
                    <a:pt x="366764" y="47288"/>
                  </a:cubicBezTo>
                  <a:cubicBezTo>
                    <a:pt x="375428" y="54142"/>
                    <a:pt x="382934" y="51595"/>
                    <a:pt x="387705" y="54959"/>
                  </a:cubicBezTo>
                  <a:cubicBezTo>
                    <a:pt x="390546" y="56972"/>
                    <a:pt x="391633" y="60116"/>
                    <a:pt x="395772" y="62128"/>
                  </a:cubicBezTo>
                  <a:cubicBezTo>
                    <a:pt x="397491" y="62977"/>
                    <a:pt x="399911" y="63197"/>
                    <a:pt x="401560" y="64109"/>
                  </a:cubicBezTo>
                  <a:cubicBezTo>
                    <a:pt x="404927" y="66027"/>
                    <a:pt x="407804" y="68888"/>
                    <a:pt x="411206" y="70806"/>
                  </a:cubicBezTo>
                  <a:cubicBezTo>
                    <a:pt x="413977" y="72378"/>
                    <a:pt x="418397" y="73227"/>
                    <a:pt x="420852" y="75019"/>
                  </a:cubicBezTo>
                  <a:cubicBezTo>
                    <a:pt x="424044" y="77314"/>
                    <a:pt x="426359" y="81402"/>
                    <a:pt x="429376" y="83917"/>
                  </a:cubicBezTo>
                  <a:cubicBezTo>
                    <a:pt x="430043" y="84451"/>
                    <a:pt x="433866" y="85898"/>
                    <a:pt x="434427" y="86401"/>
                  </a:cubicBezTo>
                  <a:cubicBezTo>
                    <a:pt x="437444" y="89042"/>
                    <a:pt x="440285" y="92846"/>
                    <a:pt x="442951" y="95802"/>
                  </a:cubicBezTo>
                  <a:cubicBezTo>
                    <a:pt x="447511" y="97688"/>
                    <a:pt x="460665" y="98475"/>
                    <a:pt x="465295" y="98286"/>
                  </a:cubicBezTo>
                  <a:cubicBezTo>
                    <a:pt x="468241" y="98160"/>
                    <a:pt x="472450" y="96902"/>
                    <a:pt x="475397" y="96305"/>
                  </a:cubicBezTo>
                  <a:lnTo>
                    <a:pt x="479325" y="92343"/>
                  </a:lnTo>
                  <a:cubicBezTo>
                    <a:pt x="479746" y="89419"/>
                    <a:pt x="480693" y="85835"/>
                    <a:pt x="480693" y="82942"/>
                  </a:cubicBezTo>
                  <a:cubicBezTo>
                    <a:pt x="480693" y="81496"/>
                    <a:pt x="479957" y="79893"/>
                    <a:pt x="480027" y="78477"/>
                  </a:cubicBezTo>
                  <a:cubicBezTo>
                    <a:pt x="480202" y="72724"/>
                    <a:pt x="481535" y="66027"/>
                    <a:pt x="483921" y="60650"/>
                  </a:cubicBezTo>
                  <a:cubicBezTo>
                    <a:pt x="485955" y="56154"/>
                    <a:pt x="493111" y="50778"/>
                    <a:pt x="497320" y="48042"/>
                  </a:cubicBezTo>
                  <a:cubicBezTo>
                    <a:pt x="500547" y="45904"/>
                    <a:pt x="505037" y="44584"/>
                    <a:pt x="508124" y="42320"/>
                  </a:cubicBezTo>
                  <a:cubicBezTo>
                    <a:pt x="509772" y="41094"/>
                    <a:pt x="511000" y="36944"/>
                    <a:pt x="516156" y="33925"/>
                  </a:cubicBezTo>
                  <a:cubicBezTo>
                    <a:pt x="517594" y="33076"/>
                    <a:pt x="519524" y="32731"/>
                    <a:pt x="520997" y="31945"/>
                  </a:cubicBezTo>
                  <a:cubicBezTo>
                    <a:pt x="531169" y="26537"/>
                    <a:pt x="540780" y="20405"/>
                    <a:pt x="551373" y="15595"/>
                  </a:cubicBezTo>
                  <a:cubicBezTo>
                    <a:pt x="554670" y="14086"/>
                    <a:pt x="558494" y="13205"/>
                    <a:pt x="561721" y="11633"/>
                  </a:cubicBezTo>
                  <a:cubicBezTo>
                    <a:pt x="567929" y="8615"/>
                    <a:pt x="577891" y="3270"/>
                    <a:pt x="583925" y="0"/>
                  </a:cubicBezTo>
                </a:path>
              </a:pathLst>
            </a:custGeom>
            <a:noFill/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27" name="자유형: 도형 368"/>
            <p:cNvSpPr/>
            <p:nvPr/>
          </p:nvSpPr>
          <p:spPr>
            <a:xfrm>
              <a:off x="7925400" y="2054520"/>
              <a:ext cx="897480" cy="1142640"/>
            </a:xfrm>
            <a:custGeom>
              <a:avLst/>
              <a:gdLst/>
              <a:ahLst/>
              <a:cxnLst/>
              <a:rect l="l" t="t" r="r" b="b"/>
              <a:pathLst>
                <a:path w="710636" h="930286">
                  <a:moveTo>
                    <a:pt x="710636" y="0"/>
                  </a:moveTo>
                  <a:cubicBezTo>
                    <a:pt x="700359" y="566"/>
                    <a:pt x="695939" y="7609"/>
                    <a:pt x="693519" y="15846"/>
                  </a:cubicBezTo>
                  <a:lnTo>
                    <a:pt x="687731" y="18582"/>
                  </a:lnTo>
                  <a:cubicBezTo>
                    <a:pt x="684644" y="15218"/>
                    <a:pt x="678611" y="10250"/>
                    <a:pt x="673455" y="10155"/>
                  </a:cubicBezTo>
                  <a:cubicBezTo>
                    <a:pt x="670999" y="13017"/>
                    <a:pt x="667492" y="15972"/>
                    <a:pt x="664019" y="17827"/>
                  </a:cubicBezTo>
                  <a:cubicBezTo>
                    <a:pt x="660476" y="17827"/>
                    <a:pt x="656232" y="17481"/>
                    <a:pt x="652759" y="17827"/>
                  </a:cubicBezTo>
                  <a:lnTo>
                    <a:pt x="647463" y="19556"/>
                  </a:lnTo>
                  <a:cubicBezTo>
                    <a:pt x="647252" y="19714"/>
                    <a:pt x="638659" y="27763"/>
                    <a:pt x="638483" y="27982"/>
                  </a:cubicBezTo>
                  <a:lnTo>
                    <a:pt x="637326" y="31944"/>
                  </a:lnTo>
                  <a:cubicBezTo>
                    <a:pt x="637326" y="32164"/>
                    <a:pt x="639641" y="39899"/>
                    <a:pt x="639886" y="40622"/>
                  </a:cubicBezTo>
                  <a:cubicBezTo>
                    <a:pt x="637431" y="46061"/>
                    <a:pt x="631362" y="48923"/>
                    <a:pt x="627434" y="53230"/>
                  </a:cubicBezTo>
                  <a:cubicBezTo>
                    <a:pt x="626347" y="54425"/>
                    <a:pt x="625680" y="59204"/>
                    <a:pt x="621225" y="61656"/>
                  </a:cubicBezTo>
                  <a:cubicBezTo>
                    <a:pt x="613368" y="66027"/>
                    <a:pt x="603933" y="65304"/>
                    <a:pt x="595935" y="68605"/>
                  </a:cubicBezTo>
                  <a:cubicBezTo>
                    <a:pt x="590007" y="74296"/>
                    <a:pt x="591165" y="81810"/>
                    <a:pt x="582325" y="85929"/>
                  </a:cubicBezTo>
                  <a:cubicBezTo>
                    <a:pt x="581133" y="86495"/>
                    <a:pt x="575696" y="86966"/>
                    <a:pt x="572644" y="88413"/>
                  </a:cubicBezTo>
                  <a:cubicBezTo>
                    <a:pt x="570925" y="91274"/>
                    <a:pt x="566646" y="94418"/>
                    <a:pt x="563454" y="95833"/>
                  </a:cubicBezTo>
                  <a:cubicBezTo>
                    <a:pt x="562612" y="96210"/>
                    <a:pt x="559245" y="96745"/>
                    <a:pt x="558578" y="97059"/>
                  </a:cubicBezTo>
                  <a:lnTo>
                    <a:pt x="553527" y="101021"/>
                  </a:lnTo>
                  <a:cubicBezTo>
                    <a:pt x="550896" y="105234"/>
                    <a:pt x="549949" y="110673"/>
                    <a:pt x="547354" y="114886"/>
                  </a:cubicBezTo>
                  <a:cubicBezTo>
                    <a:pt x="545950" y="117150"/>
                    <a:pt x="539602" y="120389"/>
                    <a:pt x="536760" y="120829"/>
                  </a:cubicBezTo>
                  <a:lnTo>
                    <a:pt x="533042" y="125042"/>
                  </a:lnTo>
                  <a:cubicBezTo>
                    <a:pt x="533884" y="129224"/>
                    <a:pt x="530166" y="143058"/>
                    <a:pt x="527535" y="146580"/>
                  </a:cubicBezTo>
                  <a:lnTo>
                    <a:pt x="522238" y="149535"/>
                  </a:lnTo>
                  <a:lnTo>
                    <a:pt x="517889" y="162677"/>
                  </a:lnTo>
                  <a:lnTo>
                    <a:pt x="520871" y="166639"/>
                  </a:lnTo>
                  <a:lnTo>
                    <a:pt x="531709" y="169846"/>
                  </a:lnTo>
                  <a:cubicBezTo>
                    <a:pt x="535568" y="171953"/>
                    <a:pt x="538128" y="179561"/>
                    <a:pt x="538374" y="183209"/>
                  </a:cubicBezTo>
                  <a:cubicBezTo>
                    <a:pt x="538444" y="184623"/>
                    <a:pt x="536515" y="195911"/>
                    <a:pt x="535357" y="197326"/>
                  </a:cubicBezTo>
                  <a:cubicBezTo>
                    <a:pt x="533218" y="200030"/>
                    <a:pt x="529464" y="202828"/>
                    <a:pt x="526869" y="205249"/>
                  </a:cubicBezTo>
                  <a:cubicBezTo>
                    <a:pt x="525571" y="213738"/>
                    <a:pt x="519187" y="226409"/>
                    <a:pt x="507506" y="225308"/>
                  </a:cubicBezTo>
                  <a:cubicBezTo>
                    <a:pt x="501157" y="224711"/>
                    <a:pt x="492143" y="221850"/>
                    <a:pt x="485899" y="223076"/>
                  </a:cubicBezTo>
                  <a:cubicBezTo>
                    <a:pt x="482567" y="226315"/>
                    <a:pt x="475551" y="232383"/>
                    <a:pt x="470676" y="233735"/>
                  </a:cubicBezTo>
                  <a:cubicBezTo>
                    <a:pt x="465449" y="232760"/>
                    <a:pt x="460047" y="231440"/>
                    <a:pt x="454786" y="230779"/>
                  </a:cubicBezTo>
                  <a:cubicBezTo>
                    <a:pt x="448893" y="229993"/>
                    <a:pt x="443596" y="234049"/>
                    <a:pt x="439850" y="237696"/>
                  </a:cubicBezTo>
                  <a:lnTo>
                    <a:pt x="434792" y="234458"/>
                  </a:lnTo>
                  <a:cubicBezTo>
                    <a:pt x="433105" y="231440"/>
                    <a:pt x="433326" y="228547"/>
                    <a:pt x="432263" y="225560"/>
                  </a:cubicBezTo>
                  <a:cubicBezTo>
                    <a:pt x="431140" y="222385"/>
                    <a:pt x="429008" y="219869"/>
                    <a:pt x="428345" y="216379"/>
                  </a:cubicBezTo>
                  <a:cubicBezTo>
                    <a:pt x="424325" y="212103"/>
                    <a:pt x="416591" y="208833"/>
                    <a:pt x="414086" y="206255"/>
                  </a:cubicBezTo>
                  <a:cubicBezTo>
                    <a:pt x="413897" y="206066"/>
                    <a:pt x="403738" y="192075"/>
                    <a:pt x="403489" y="191635"/>
                  </a:cubicBezTo>
                  <a:cubicBezTo>
                    <a:pt x="403419" y="191509"/>
                    <a:pt x="403075" y="187579"/>
                    <a:pt x="403033" y="187170"/>
                  </a:cubicBezTo>
                  <a:cubicBezTo>
                    <a:pt x="400066" y="186007"/>
                    <a:pt x="396148" y="185221"/>
                    <a:pt x="392893" y="185189"/>
                  </a:cubicBezTo>
                  <a:cubicBezTo>
                    <a:pt x="391009" y="182454"/>
                    <a:pt x="386386" y="179121"/>
                    <a:pt x="383008" y="178021"/>
                  </a:cubicBezTo>
                  <a:cubicBezTo>
                    <a:pt x="382089" y="177738"/>
                    <a:pt x="378806" y="177832"/>
                    <a:pt x="377953" y="177518"/>
                  </a:cubicBezTo>
                  <a:cubicBezTo>
                    <a:pt x="374937" y="176480"/>
                    <a:pt x="371601" y="174468"/>
                    <a:pt x="368721" y="173084"/>
                  </a:cubicBezTo>
                  <a:lnTo>
                    <a:pt x="359745" y="182234"/>
                  </a:lnTo>
                  <a:lnTo>
                    <a:pt x="362274" y="191635"/>
                  </a:lnTo>
                  <a:lnTo>
                    <a:pt x="356988" y="193867"/>
                  </a:lnTo>
                  <a:lnTo>
                    <a:pt x="346623" y="192389"/>
                  </a:lnTo>
                  <a:lnTo>
                    <a:pt x="342498" y="197074"/>
                  </a:lnTo>
                  <a:cubicBezTo>
                    <a:pt x="343290" y="199967"/>
                    <a:pt x="344637" y="203362"/>
                    <a:pt x="345030" y="206255"/>
                  </a:cubicBezTo>
                  <a:cubicBezTo>
                    <a:pt x="345111" y="206884"/>
                    <a:pt x="344227" y="210122"/>
                    <a:pt x="344322" y="210688"/>
                  </a:cubicBezTo>
                  <a:cubicBezTo>
                    <a:pt x="344813" y="213644"/>
                    <a:pt x="346398" y="217197"/>
                    <a:pt x="347328" y="220121"/>
                  </a:cubicBezTo>
                  <a:lnTo>
                    <a:pt x="342017" y="223579"/>
                  </a:lnTo>
                  <a:cubicBezTo>
                    <a:pt x="336798" y="222353"/>
                    <a:pt x="331417" y="220812"/>
                    <a:pt x="326138" y="219869"/>
                  </a:cubicBezTo>
                  <a:cubicBezTo>
                    <a:pt x="321241" y="218989"/>
                    <a:pt x="315064" y="219838"/>
                    <a:pt x="310967" y="216631"/>
                  </a:cubicBezTo>
                  <a:cubicBezTo>
                    <a:pt x="300788" y="219869"/>
                    <a:pt x="287950" y="205280"/>
                    <a:pt x="280117" y="207481"/>
                  </a:cubicBezTo>
                  <a:lnTo>
                    <a:pt x="277132" y="212418"/>
                  </a:lnTo>
                  <a:cubicBezTo>
                    <a:pt x="271856" y="215876"/>
                    <a:pt x="266349" y="213990"/>
                    <a:pt x="261709" y="219115"/>
                  </a:cubicBezTo>
                  <a:lnTo>
                    <a:pt x="258471" y="227792"/>
                  </a:lnTo>
                  <a:cubicBezTo>
                    <a:pt x="255433" y="229742"/>
                    <a:pt x="251140" y="231628"/>
                    <a:pt x="247422" y="232257"/>
                  </a:cubicBezTo>
                  <a:lnTo>
                    <a:pt x="244893" y="236690"/>
                  </a:lnTo>
                  <a:lnTo>
                    <a:pt x="239607" y="237445"/>
                  </a:lnTo>
                  <a:lnTo>
                    <a:pt x="236369" y="228296"/>
                  </a:lnTo>
                  <a:cubicBezTo>
                    <a:pt x="232107" y="224491"/>
                    <a:pt x="226442" y="221787"/>
                    <a:pt x="220514" y="220844"/>
                  </a:cubicBezTo>
                  <a:cubicBezTo>
                    <a:pt x="220065" y="221316"/>
                    <a:pt x="216295" y="225057"/>
                    <a:pt x="216140" y="225308"/>
                  </a:cubicBezTo>
                  <a:cubicBezTo>
                    <a:pt x="215944" y="225623"/>
                    <a:pt x="215207" y="229145"/>
                    <a:pt x="214979" y="229773"/>
                  </a:cubicBezTo>
                  <a:cubicBezTo>
                    <a:pt x="214474" y="231157"/>
                    <a:pt x="213183" y="232823"/>
                    <a:pt x="212903" y="234238"/>
                  </a:cubicBezTo>
                  <a:cubicBezTo>
                    <a:pt x="212412" y="236659"/>
                    <a:pt x="213225" y="240526"/>
                    <a:pt x="212447" y="243859"/>
                  </a:cubicBezTo>
                  <a:cubicBezTo>
                    <a:pt x="209420" y="245997"/>
                    <a:pt x="206259" y="248889"/>
                    <a:pt x="204179" y="251814"/>
                  </a:cubicBezTo>
                  <a:cubicBezTo>
                    <a:pt x="204260" y="268069"/>
                    <a:pt x="194663" y="270238"/>
                    <a:pt x="193582" y="279293"/>
                  </a:cubicBezTo>
                  <a:cubicBezTo>
                    <a:pt x="194372" y="283223"/>
                    <a:pt x="201604" y="289260"/>
                    <a:pt x="205088" y="291650"/>
                  </a:cubicBezTo>
                  <a:cubicBezTo>
                    <a:pt x="206603" y="292687"/>
                    <a:pt x="208672" y="293316"/>
                    <a:pt x="210142" y="294385"/>
                  </a:cubicBezTo>
                  <a:cubicBezTo>
                    <a:pt x="215488" y="298284"/>
                    <a:pt x="228330" y="306742"/>
                    <a:pt x="228326" y="313942"/>
                  </a:cubicBezTo>
                  <a:lnTo>
                    <a:pt x="222815" y="317149"/>
                  </a:lnTo>
                  <a:cubicBezTo>
                    <a:pt x="217849" y="316017"/>
                    <a:pt x="215235" y="317809"/>
                    <a:pt x="211535" y="317652"/>
                  </a:cubicBezTo>
                  <a:cubicBezTo>
                    <a:pt x="206585" y="317432"/>
                    <a:pt x="204607" y="314382"/>
                    <a:pt x="200938" y="312464"/>
                  </a:cubicBezTo>
                  <a:cubicBezTo>
                    <a:pt x="199433" y="311647"/>
                    <a:pt x="197255" y="311395"/>
                    <a:pt x="195655" y="310703"/>
                  </a:cubicBezTo>
                  <a:cubicBezTo>
                    <a:pt x="190243" y="308377"/>
                    <a:pt x="185185" y="303943"/>
                    <a:pt x="181137" y="300076"/>
                  </a:cubicBezTo>
                  <a:lnTo>
                    <a:pt x="176307" y="299825"/>
                  </a:lnTo>
                  <a:cubicBezTo>
                    <a:pt x="173276" y="301711"/>
                    <a:pt x="169909" y="305138"/>
                    <a:pt x="168496" y="308251"/>
                  </a:cubicBezTo>
                  <a:lnTo>
                    <a:pt x="152374" y="310231"/>
                  </a:lnTo>
                  <a:cubicBezTo>
                    <a:pt x="148446" y="306804"/>
                    <a:pt x="147972" y="303849"/>
                    <a:pt x="145930" y="301554"/>
                  </a:cubicBezTo>
                  <a:cubicBezTo>
                    <a:pt x="143721" y="299133"/>
                    <a:pt x="138841" y="296272"/>
                    <a:pt x="135355" y="295612"/>
                  </a:cubicBezTo>
                  <a:lnTo>
                    <a:pt x="130055" y="298347"/>
                  </a:lnTo>
                  <a:cubicBezTo>
                    <a:pt x="126280" y="302623"/>
                    <a:pt x="127014" y="308251"/>
                    <a:pt x="122913" y="312212"/>
                  </a:cubicBezTo>
                  <a:lnTo>
                    <a:pt x="124074" y="321362"/>
                  </a:lnTo>
                  <a:cubicBezTo>
                    <a:pt x="121208" y="322116"/>
                    <a:pt x="116403" y="321802"/>
                    <a:pt x="113709" y="320639"/>
                  </a:cubicBezTo>
                  <a:cubicBezTo>
                    <a:pt x="111513" y="322462"/>
                    <a:pt x="109198" y="326770"/>
                    <a:pt x="109552" y="329537"/>
                  </a:cubicBezTo>
                  <a:lnTo>
                    <a:pt x="104273" y="333498"/>
                  </a:lnTo>
                  <a:cubicBezTo>
                    <a:pt x="97805" y="334347"/>
                    <a:pt x="89053" y="333152"/>
                    <a:pt x="83097" y="330763"/>
                  </a:cubicBezTo>
                  <a:cubicBezTo>
                    <a:pt x="73812" y="332146"/>
                    <a:pt x="71799" y="339000"/>
                    <a:pt x="66555" y="344629"/>
                  </a:cubicBezTo>
                  <a:lnTo>
                    <a:pt x="70161" y="346515"/>
                  </a:lnTo>
                  <a:cubicBezTo>
                    <a:pt x="73006" y="346798"/>
                    <a:pt x="77829" y="344062"/>
                    <a:pt x="79705" y="342396"/>
                  </a:cubicBezTo>
                  <a:cubicBezTo>
                    <a:pt x="84009" y="342553"/>
                    <a:pt x="93112" y="344220"/>
                    <a:pt x="96251" y="347301"/>
                  </a:cubicBezTo>
                  <a:lnTo>
                    <a:pt x="99759" y="353967"/>
                  </a:lnTo>
                  <a:cubicBezTo>
                    <a:pt x="103140" y="353904"/>
                    <a:pt x="109644" y="355130"/>
                    <a:pt x="112169" y="357425"/>
                  </a:cubicBezTo>
                  <a:lnTo>
                    <a:pt x="111047" y="366260"/>
                  </a:lnTo>
                  <a:lnTo>
                    <a:pt x="115659" y="369561"/>
                  </a:lnTo>
                  <a:lnTo>
                    <a:pt x="117297" y="373617"/>
                  </a:lnTo>
                  <a:cubicBezTo>
                    <a:pt x="113965" y="376919"/>
                    <a:pt x="114505" y="381604"/>
                    <a:pt x="114400" y="385659"/>
                  </a:cubicBezTo>
                  <a:cubicBezTo>
                    <a:pt x="114396" y="385880"/>
                    <a:pt x="112281" y="388646"/>
                    <a:pt x="112429" y="390470"/>
                  </a:cubicBezTo>
                  <a:cubicBezTo>
                    <a:pt x="112660" y="393394"/>
                    <a:pt x="112418" y="396381"/>
                    <a:pt x="112246" y="399337"/>
                  </a:cubicBezTo>
                  <a:cubicBezTo>
                    <a:pt x="109542" y="399588"/>
                    <a:pt x="105606" y="401883"/>
                    <a:pt x="104361" y="404084"/>
                  </a:cubicBezTo>
                  <a:lnTo>
                    <a:pt x="103701" y="410970"/>
                  </a:lnTo>
                  <a:lnTo>
                    <a:pt x="101678" y="412888"/>
                  </a:lnTo>
                  <a:lnTo>
                    <a:pt x="97051" y="410372"/>
                  </a:lnTo>
                  <a:lnTo>
                    <a:pt x="98093" y="404744"/>
                  </a:lnTo>
                  <a:cubicBezTo>
                    <a:pt x="96479" y="402921"/>
                    <a:pt x="92838" y="397418"/>
                    <a:pt x="93620" y="394840"/>
                  </a:cubicBezTo>
                  <a:lnTo>
                    <a:pt x="89015" y="390910"/>
                  </a:lnTo>
                  <a:cubicBezTo>
                    <a:pt x="85216" y="391161"/>
                    <a:pt x="80656" y="391067"/>
                    <a:pt x="76955" y="390124"/>
                  </a:cubicBezTo>
                  <a:lnTo>
                    <a:pt x="75058" y="386666"/>
                  </a:lnTo>
                  <a:lnTo>
                    <a:pt x="76955" y="381100"/>
                  </a:lnTo>
                  <a:lnTo>
                    <a:pt x="76296" y="378742"/>
                  </a:lnTo>
                  <a:lnTo>
                    <a:pt x="71034" y="374592"/>
                  </a:lnTo>
                  <a:cubicBezTo>
                    <a:pt x="71824" y="371637"/>
                    <a:pt x="70729" y="366857"/>
                    <a:pt x="69281" y="364185"/>
                  </a:cubicBezTo>
                  <a:lnTo>
                    <a:pt x="66801" y="364939"/>
                  </a:lnTo>
                  <a:cubicBezTo>
                    <a:pt x="64531" y="371133"/>
                    <a:pt x="59231" y="376038"/>
                    <a:pt x="57084" y="382264"/>
                  </a:cubicBezTo>
                  <a:lnTo>
                    <a:pt x="51328" y="385250"/>
                  </a:lnTo>
                  <a:lnTo>
                    <a:pt x="46025" y="384748"/>
                  </a:lnTo>
                  <a:lnTo>
                    <a:pt x="42580" y="389181"/>
                  </a:lnTo>
                  <a:cubicBezTo>
                    <a:pt x="42198" y="392671"/>
                    <a:pt x="47845" y="399682"/>
                    <a:pt x="50178" y="402072"/>
                  </a:cubicBezTo>
                  <a:lnTo>
                    <a:pt x="48105" y="406034"/>
                  </a:lnTo>
                  <a:cubicBezTo>
                    <a:pt x="45106" y="405310"/>
                    <a:pt x="40044" y="406757"/>
                    <a:pt x="37750" y="408517"/>
                  </a:cubicBezTo>
                  <a:cubicBezTo>
                    <a:pt x="34747" y="408612"/>
                    <a:pt x="30026" y="406505"/>
                    <a:pt x="27851" y="404807"/>
                  </a:cubicBezTo>
                  <a:cubicBezTo>
                    <a:pt x="22334" y="405373"/>
                    <a:pt x="20611" y="408486"/>
                    <a:pt x="16816" y="409743"/>
                  </a:cubicBezTo>
                  <a:cubicBezTo>
                    <a:pt x="11604" y="411441"/>
                    <a:pt x="5693" y="410529"/>
                    <a:pt x="1158" y="414208"/>
                  </a:cubicBezTo>
                  <a:cubicBezTo>
                    <a:pt x="1053" y="414617"/>
                    <a:pt x="-21" y="418516"/>
                    <a:pt x="0" y="418673"/>
                  </a:cubicBezTo>
                  <a:cubicBezTo>
                    <a:pt x="25" y="418861"/>
                    <a:pt x="2687" y="427194"/>
                    <a:pt x="2757" y="427319"/>
                  </a:cubicBezTo>
                  <a:cubicBezTo>
                    <a:pt x="4490" y="430275"/>
                    <a:pt x="14280" y="435085"/>
                    <a:pt x="17504" y="436249"/>
                  </a:cubicBezTo>
                  <a:lnTo>
                    <a:pt x="20496" y="440682"/>
                  </a:lnTo>
                  <a:cubicBezTo>
                    <a:pt x="23639" y="440965"/>
                    <a:pt x="27855" y="440021"/>
                    <a:pt x="30619" y="438701"/>
                  </a:cubicBezTo>
                  <a:cubicBezTo>
                    <a:pt x="36736" y="443700"/>
                    <a:pt x="47231" y="438292"/>
                    <a:pt x="56625" y="446152"/>
                  </a:cubicBezTo>
                  <a:cubicBezTo>
                    <a:pt x="68786" y="456277"/>
                    <a:pt x="58354" y="465709"/>
                    <a:pt x="68835" y="473129"/>
                  </a:cubicBezTo>
                  <a:cubicBezTo>
                    <a:pt x="72462" y="474481"/>
                    <a:pt x="79958" y="476556"/>
                    <a:pt x="84013" y="475833"/>
                  </a:cubicBezTo>
                  <a:lnTo>
                    <a:pt x="87464" y="480046"/>
                  </a:lnTo>
                  <a:cubicBezTo>
                    <a:pt x="85321" y="489290"/>
                    <a:pt x="90898" y="490925"/>
                    <a:pt x="91614" y="498125"/>
                  </a:cubicBezTo>
                  <a:cubicBezTo>
                    <a:pt x="86752" y="499572"/>
                    <a:pt x="84265" y="502747"/>
                    <a:pt x="80568" y="504319"/>
                  </a:cubicBezTo>
                  <a:cubicBezTo>
                    <a:pt x="76047" y="506206"/>
                    <a:pt x="69435" y="507275"/>
                    <a:pt x="64444" y="508280"/>
                  </a:cubicBezTo>
                  <a:cubicBezTo>
                    <a:pt x="63816" y="514380"/>
                    <a:pt x="70080" y="519694"/>
                    <a:pt x="71361" y="525605"/>
                  </a:cubicBezTo>
                  <a:cubicBezTo>
                    <a:pt x="65769" y="535383"/>
                    <a:pt x="70329" y="537993"/>
                    <a:pt x="68365" y="543181"/>
                  </a:cubicBezTo>
                  <a:cubicBezTo>
                    <a:pt x="67155" y="546387"/>
                    <a:pt x="63935" y="549154"/>
                    <a:pt x="63752" y="552833"/>
                  </a:cubicBezTo>
                  <a:cubicBezTo>
                    <a:pt x="63728" y="553305"/>
                    <a:pt x="64812" y="556575"/>
                    <a:pt x="64903" y="557298"/>
                  </a:cubicBezTo>
                  <a:cubicBezTo>
                    <a:pt x="65096" y="558870"/>
                    <a:pt x="64622" y="560693"/>
                    <a:pt x="64903" y="562234"/>
                  </a:cubicBezTo>
                  <a:cubicBezTo>
                    <a:pt x="65387" y="564906"/>
                    <a:pt x="67821" y="568428"/>
                    <a:pt x="69758" y="570409"/>
                  </a:cubicBezTo>
                  <a:cubicBezTo>
                    <a:pt x="71894" y="576477"/>
                    <a:pt x="63875" y="584306"/>
                    <a:pt x="59617" y="588016"/>
                  </a:cubicBezTo>
                  <a:lnTo>
                    <a:pt x="54559" y="588739"/>
                  </a:lnTo>
                  <a:lnTo>
                    <a:pt x="56393" y="597888"/>
                  </a:lnTo>
                  <a:lnTo>
                    <a:pt x="66292" y="601630"/>
                  </a:lnTo>
                  <a:cubicBezTo>
                    <a:pt x="66632" y="604523"/>
                    <a:pt x="69179" y="608610"/>
                    <a:pt x="71589" y="610528"/>
                  </a:cubicBezTo>
                  <a:cubicBezTo>
                    <a:pt x="70480" y="617539"/>
                    <a:pt x="73648" y="622853"/>
                    <a:pt x="78032" y="628607"/>
                  </a:cubicBezTo>
                  <a:lnTo>
                    <a:pt x="77885" y="633134"/>
                  </a:lnTo>
                  <a:cubicBezTo>
                    <a:pt x="75503" y="637190"/>
                    <a:pt x="68596" y="641623"/>
                    <a:pt x="63384" y="641592"/>
                  </a:cubicBezTo>
                  <a:lnTo>
                    <a:pt x="55573" y="650521"/>
                  </a:lnTo>
                  <a:lnTo>
                    <a:pt x="45695" y="653760"/>
                  </a:lnTo>
                  <a:cubicBezTo>
                    <a:pt x="44011" y="655772"/>
                    <a:pt x="43096" y="659985"/>
                    <a:pt x="43878" y="662437"/>
                  </a:cubicBezTo>
                  <a:cubicBezTo>
                    <a:pt x="40956" y="663978"/>
                    <a:pt x="37462" y="668474"/>
                    <a:pt x="37452" y="671618"/>
                  </a:cubicBezTo>
                  <a:cubicBezTo>
                    <a:pt x="41044" y="675297"/>
                    <a:pt x="39588" y="680956"/>
                    <a:pt x="40496" y="685295"/>
                  </a:cubicBezTo>
                  <a:cubicBezTo>
                    <a:pt x="40605" y="685830"/>
                    <a:pt x="42324" y="688534"/>
                    <a:pt x="42584" y="689289"/>
                  </a:cubicBezTo>
                  <a:cubicBezTo>
                    <a:pt x="43099" y="690766"/>
                    <a:pt x="43047" y="692496"/>
                    <a:pt x="43534" y="694005"/>
                  </a:cubicBezTo>
                  <a:cubicBezTo>
                    <a:pt x="44502" y="696991"/>
                    <a:pt x="45870" y="700010"/>
                    <a:pt x="47017" y="702965"/>
                  </a:cubicBezTo>
                  <a:cubicBezTo>
                    <a:pt x="51714" y="702808"/>
                    <a:pt x="57326" y="702116"/>
                    <a:pt x="61967" y="702462"/>
                  </a:cubicBezTo>
                  <a:cubicBezTo>
                    <a:pt x="65471" y="702714"/>
                    <a:pt x="67618" y="705669"/>
                    <a:pt x="72336" y="703940"/>
                  </a:cubicBezTo>
                  <a:cubicBezTo>
                    <a:pt x="75110" y="700985"/>
                    <a:pt x="76941" y="694445"/>
                    <a:pt x="77348" y="690735"/>
                  </a:cubicBezTo>
                  <a:cubicBezTo>
                    <a:pt x="80179" y="689508"/>
                    <a:pt x="84230" y="685767"/>
                    <a:pt x="84665" y="682780"/>
                  </a:cubicBezTo>
                  <a:lnTo>
                    <a:pt x="90404" y="680799"/>
                  </a:lnTo>
                  <a:cubicBezTo>
                    <a:pt x="92287" y="684289"/>
                    <a:pt x="93028" y="690703"/>
                    <a:pt x="93224" y="694476"/>
                  </a:cubicBezTo>
                  <a:lnTo>
                    <a:pt x="97840" y="698689"/>
                  </a:lnTo>
                  <a:cubicBezTo>
                    <a:pt x="102347" y="698721"/>
                    <a:pt x="109675" y="700136"/>
                    <a:pt x="113028" y="703154"/>
                  </a:cubicBezTo>
                  <a:cubicBezTo>
                    <a:pt x="114312" y="704318"/>
                    <a:pt x="114961" y="706518"/>
                    <a:pt x="116259" y="707650"/>
                  </a:cubicBezTo>
                  <a:cubicBezTo>
                    <a:pt x="117855" y="709034"/>
                    <a:pt x="124123" y="711517"/>
                    <a:pt x="126407" y="712083"/>
                  </a:cubicBezTo>
                  <a:lnTo>
                    <a:pt x="126203" y="716831"/>
                  </a:lnTo>
                  <a:cubicBezTo>
                    <a:pt x="131780" y="720541"/>
                    <a:pt x="138859" y="724974"/>
                    <a:pt x="146211" y="723497"/>
                  </a:cubicBezTo>
                  <a:cubicBezTo>
                    <a:pt x="151988" y="719975"/>
                    <a:pt x="151929" y="714850"/>
                    <a:pt x="156503" y="710794"/>
                  </a:cubicBezTo>
                  <a:cubicBezTo>
                    <a:pt x="160586" y="709820"/>
                    <a:pt x="164437" y="710763"/>
                    <a:pt x="167275" y="710291"/>
                  </a:cubicBezTo>
                  <a:cubicBezTo>
                    <a:pt x="168699" y="710040"/>
                    <a:pt x="176956" y="707304"/>
                    <a:pt x="177615" y="707273"/>
                  </a:cubicBezTo>
                  <a:cubicBezTo>
                    <a:pt x="178103" y="707273"/>
                    <a:pt x="191194" y="709505"/>
                    <a:pt x="192537" y="709725"/>
                  </a:cubicBezTo>
                  <a:lnTo>
                    <a:pt x="195771" y="713938"/>
                  </a:lnTo>
                  <a:lnTo>
                    <a:pt x="205407" y="716894"/>
                  </a:lnTo>
                  <a:lnTo>
                    <a:pt x="209100" y="721830"/>
                  </a:lnTo>
                  <a:cubicBezTo>
                    <a:pt x="205312" y="724157"/>
                    <a:pt x="197515" y="729816"/>
                    <a:pt x="195596" y="733810"/>
                  </a:cubicBezTo>
                  <a:lnTo>
                    <a:pt x="195371" y="738274"/>
                  </a:lnTo>
                  <a:cubicBezTo>
                    <a:pt x="198321" y="741858"/>
                    <a:pt x="200279" y="746920"/>
                    <a:pt x="199994" y="751417"/>
                  </a:cubicBezTo>
                  <a:cubicBezTo>
                    <a:pt x="202011" y="753460"/>
                    <a:pt x="206831" y="756416"/>
                    <a:pt x="210086" y="756321"/>
                  </a:cubicBezTo>
                  <a:cubicBezTo>
                    <a:pt x="209146" y="759340"/>
                    <a:pt x="212475" y="766446"/>
                    <a:pt x="214004" y="768961"/>
                  </a:cubicBezTo>
                  <a:cubicBezTo>
                    <a:pt x="209700" y="772419"/>
                    <a:pt x="204014" y="774306"/>
                    <a:pt x="198226" y="774023"/>
                  </a:cubicBezTo>
                  <a:cubicBezTo>
                    <a:pt x="196154" y="769998"/>
                    <a:pt x="188808" y="765439"/>
                    <a:pt x="184673" y="763427"/>
                  </a:cubicBezTo>
                  <a:cubicBezTo>
                    <a:pt x="171744" y="757107"/>
                    <a:pt x="162690" y="771916"/>
                    <a:pt x="153090" y="771256"/>
                  </a:cubicBezTo>
                  <a:lnTo>
                    <a:pt x="148754" y="775752"/>
                  </a:lnTo>
                  <a:cubicBezTo>
                    <a:pt x="148733" y="776192"/>
                    <a:pt x="148488" y="780091"/>
                    <a:pt x="148537" y="780248"/>
                  </a:cubicBezTo>
                  <a:cubicBezTo>
                    <a:pt x="149582" y="783361"/>
                    <a:pt x="152009" y="786631"/>
                    <a:pt x="153405" y="789680"/>
                  </a:cubicBezTo>
                  <a:cubicBezTo>
                    <a:pt x="156408" y="796252"/>
                    <a:pt x="158972" y="806345"/>
                    <a:pt x="164030" y="811784"/>
                  </a:cubicBezTo>
                  <a:cubicBezTo>
                    <a:pt x="163630" y="812475"/>
                    <a:pt x="159091" y="820304"/>
                    <a:pt x="159042" y="820493"/>
                  </a:cubicBezTo>
                  <a:cubicBezTo>
                    <a:pt x="158214" y="823983"/>
                    <a:pt x="158734" y="830680"/>
                    <a:pt x="158621" y="834422"/>
                  </a:cubicBezTo>
                  <a:cubicBezTo>
                    <a:pt x="155822" y="837943"/>
                    <a:pt x="147298" y="840836"/>
                    <a:pt x="142847" y="841465"/>
                  </a:cubicBezTo>
                  <a:lnTo>
                    <a:pt x="140806" y="846212"/>
                  </a:lnTo>
                  <a:cubicBezTo>
                    <a:pt x="141693" y="848948"/>
                    <a:pt x="142019" y="852532"/>
                    <a:pt x="141521" y="855393"/>
                  </a:cubicBezTo>
                  <a:cubicBezTo>
                    <a:pt x="125218" y="873126"/>
                    <a:pt x="141504" y="880169"/>
                    <a:pt x="133829" y="890702"/>
                  </a:cubicBezTo>
                  <a:cubicBezTo>
                    <a:pt x="128501" y="892462"/>
                    <a:pt x="128613" y="895386"/>
                    <a:pt x="125579" y="897902"/>
                  </a:cubicBezTo>
                  <a:cubicBezTo>
                    <a:pt x="124263" y="899002"/>
                    <a:pt x="121794" y="899694"/>
                    <a:pt x="120293" y="900637"/>
                  </a:cubicBezTo>
                  <a:cubicBezTo>
                    <a:pt x="118630" y="901706"/>
                    <a:pt x="117174" y="903435"/>
                    <a:pt x="115463" y="904379"/>
                  </a:cubicBezTo>
                  <a:cubicBezTo>
                    <a:pt x="114172" y="905102"/>
                    <a:pt x="111864" y="905605"/>
                    <a:pt x="110405" y="906108"/>
                  </a:cubicBezTo>
                  <a:lnTo>
                    <a:pt x="104880" y="903372"/>
                  </a:lnTo>
                  <a:cubicBezTo>
                    <a:pt x="94182" y="901329"/>
                    <a:pt x="91193" y="914597"/>
                    <a:pt x="82820" y="917521"/>
                  </a:cubicBezTo>
                  <a:cubicBezTo>
                    <a:pt x="79306" y="918779"/>
                    <a:pt x="75917" y="918433"/>
                    <a:pt x="72473" y="920508"/>
                  </a:cubicBezTo>
                  <a:cubicBezTo>
                    <a:pt x="72508" y="923558"/>
                    <a:pt x="69189" y="928274"/>
                    <a:pt x="66871" y="930286"/>
                  </a:cubicBezTo>
                </a:path>
              </a:pathLst>
            </a:custGeom>
            <a:noFill/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28" name="자유형: 도형 369"/>
            <p:cNvSpPr/>
            <p:nvPr/>
          </p:nvSpPr>
          <p:spPr>
            <a:xfrm>
              <a:off x="7346160" y="2680920"/>
              <a:ext cx="263160" cy="336600"/>
            </a:xfrm>
            <a:custGeom>
              <a:avLst/>
              <a:gdLst/>
              <a:ahLst/>
              <a:cxnLst/>
              <a:rect l="l" t="t" r="r" b="b"/>
              <a:pathLst>
                <a:path w="208649" h="274325">
                  <a:moveTo>
                    <a:pt x="208649" y="228641"/>
                  </a:moveTo>
                  <a:cubicBezTo>
                    <a:pt x="201697" y="230999"/>
                    <a:pt x="194453" y="234930"/>
                    <a:pt x="188606" y="239017"/>
                  </a:cubicBezTo>
                  <a:lnTo>
                    <a:pt x="185621" y="247852"/>
                  </a:lnTo>
                  <a:cubicBezTo>
                    <a:pt x="182871" y="249487"/>
                    <a:pt x="174004" y="254140"/>
                    <a:pt x="172355" y="255712"/>
                  </a:cubicBezTo>
                  <a:cubicBezTo>
                    <a:pt x="171127" y="256876"/>
                    <a:pt x="172464" y="259360"/>
                    <a:pt x="173190" y="260554"/>
                  </a:cubicBezTo>
                  <a:lnTo>
                    <a:pt x="161853" y="266025"/>
                  </a:lnTo>
                  <a:cubicBezTo>
                    <a:pt x="161043" y="265239"/>
                    <a:pt x="153007" y="257221"/>
                    <a:pt x="152673" y="257033"/>
                  </a:cubicBezTo>
                  <a:cubicBezTo>
                    <a:pt x="149488" y="254958"/>
                    <a:pt x="142515" y="252726"/>
                    <a:pt x="138772" y="251153"/>
                  </a:cubicBezTo>
                  <a:cubicBezTo>
                    <a:pt x="135602" y="244991"/>
                    <a:pt x="128169" y="232697"/>
                    <a:pt x="121409" y="229931"/>
                  </a:cubicBezTo>
                  <a:cubicBezTo>
                    <a:pt x="115966" y="218517"/>
                    <a:pt x="117239" y="218266"/>
                    <a:pt x="120017" y="206538"/>
                  </a:cubicBezTo>
                  <a:cubicBezTo>
                    <a:pt x="123132" y="193395"/>
                    <a:pt x="93874" y="195314"/>
                    <a:pt x="94783" y="204557"/>
                  </a:cubicBezTo>
                  <a:cubicBezTo>
                    <a:pt x="95081" y="207607"/>
                    <a:pt x="98553" y="217762"/>
                    <a:pt x="98231" y="219115"/>
                  </a:cubicBezTo>
                  <a:lnTo>
                    <a:pt x="94144" y="235967"/>
                  </a:lnTo>
                  <a:lnTo>
                    <a:pt x="97757" y="242476"/>
                  </a:lnTo>
                  <a:cubicBezTo>
                    <a:pt x="90475" y="252285"/>
                    <a:pt x="82025" y="246689"/>
                    <a:pt x="82741" y="264296"/>
                  </a:cubicBezTo>
                  <a:lnTo>
                    <a:pt x="70906" y="274326"/>
                  </a:lnTo>
                  <a:lnTo>
                    <a:pt x="60677" y="248103"/>
                  </a:lnTo>
                  <a:cubicBezTo>
                    <a:pt x="59288" y="244550"/>
                    <a:pt x="49656" y="231911"/>
                    <a:pt x="46317" y="240086"/>
                  </a:cubicBezTo>
                  <a:lnTo>
                    <a:pt x="37951" y="237539"/>
                  </a:lnTo>
                  <a:cubicBezTo>
                    <a:pt x="35169" y="233861"/>
                    <a:pt x="25678" y="215688"/>
                    <a:pt x="26306" y="211569"/>
                  </a:cubicBezTo>
                  <a:cubicBezTo>
                    <a:pt x="26723" y="208833"/>
                    <a:pt x="34124" y="204369"/>
                    <a:pt x="36780" y="202859"/>
                  </a:cubicBezTo>
                  <a:cubicBezTo>
                    <a:pt x="31318" y="201067"/>
                    <a:pt x="21318" y="198961"/>
                    <a:pt x="18227" y="194528"/>
                  </a:cubicBezTo>
                  <a:cubicBezTo>
                    <a:pt x="13366" y="192421"/>
                    <a:pt x="4895" y="188176"/>
                    <a:pt x="1580" y="184592"/>
                  </a:cubicBezTo>
                  <a:cubicBezTo>
                    <a:pt x="-6628" y="175725"/>
                    <a:pt x="19571" y="140606"/>
                    <a:pt x="24615" y="130921"/>
                  </a:cubicBezTo>
                  <a:cubicBezTo>
                    <a:pt x="26625" y="127054"/>
                    <a:pt x="27165" y="114666"/>
                    <a:pt x="27614" y="109793"/>
                  </a:cubicBezTo>
                  <a:cubicBezTo>
                    <a:pt x="28687" y="98254"/>
                    <a:pt x="31613" y="86369"/>
                    <a:pt x="31613" y="74799"/>
                  </a:cubicBezTo>
                  <a:cubicBezTo>
                    <a:pt x="31613" y="70523"/>
                    <a:pt x="33654" y="67599"/>
                    <a:pt x="37109" y="64864"/>
                  </a:cubicBezTo>
                  <a:cubicBezTo>
                    <a:pt x="40329" y="62317"/>
                    <a:pt x="45107" y="56217"/>
                    <a:pt x="50007" y="57978"/>
                  </a:cubicBezTo>
                  <a:cubicBezTo>
                    <a:pt x="54262" y="59487"/>
                    <a:pt x="58555" y="60619"/>
                    <a:pt x="63052" y="61373"/>
                  </a:cubicBezTo>
                  <a:cubicBezTo>
                    <a:pt x="68194" y="59141"/>
                    <a:pt x="73589" y="56563"/>
                    <a:pt x="79086" y="55179"/>
                  </a:cubicBezTo>
                  <a:cubicBezTo>
                    <a:pt x="81429" y="54582"/>
                    <a:pt x="82046" y="44206"/>
                    <a:pt x="87234" y="41943"/>
                  </a:cubicBezTo>
                  <a:cubicBezTo>
                    <a:pt x="92906" y="39490"/>
                    <a:pt x="96694" y="35654"/>
                    <a:pt x="95519" y="29617"/>
                  </a:cubicBezTo>
                  <a:cubicBezTo>
                    <a:pt x="94709" y="25499"/>
                    <a:pt x="93211" y="23990"/>
                    <a:pt x="96803" y="20846"/>
                  </a:cubicBezTo>
                  <a:cubicBezTo>
                    <a:pt x="99911" y="18110"/>
                    <a:pt x="99799" y="19242"/>
                    <a:pt x="99799" y="14997"/>
                  </a:cubicBezTo>
                  <a:cubicBezTo>
                    <a:pt x="99799" y="10030"/>
                    <a:pt x="98964" y="4936"/>
                    <a:pt x="98238" y="0"/>
                  </a:cubicBezTo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29" name="자유형: 도형 370"/>
            <p:cNvSpPr/>
            <p:nvPr/>
          </p:nvSpPr>
          <p:spPr>
            <a:xfrm>
              <a:off x="10746000" y="1689120"/>
              <a:ext cx="123480" cy="104400"/>
            </a:xfrm>
            <a:custGeom>
              <a:avLst/>
              <a:gdLst/>
              <a:ahLst/>
              <a:cxnLst/>
              <a:rect l="l" t="t" r="r" b="b"/>
              <a:pathLst>
                <a:path w="98094" h="85331">
                  <a:moveTo>
                    <a:pt x="94938" y="24146"/>
                  </a:moveTo>
                  <a:cubicBezTo>
                    <a:pt x="98411" y="30623"/>
                    <a:pt x="90519" y="38861"/>
                    <a:pt x="89115" y="45307"/>
                  </a:cubicBezTo>
                  <a:cubicBezTo>
                    <a:pt x="91571" y="49174"/>
                    <a:pt x="96025" y="52318"/>
                    <a:pt x="96902" y="56814"/>
                  </a:cubicBezTo>
                  <a:lnTo>
                    <a:pt x="95429" y="61530"/>
                  </a:lnTo>
                  <a:cubicBezTo>
                    <a:pt x="89186" y="65146"/>
                    <a:pt x="83609" y="65114"/>
                    <a:pt x="77680" y="70428"/>
                  </a:cubicBezTo>
                  <a:cubicBezTo>
                    <a:pt x="74102" y="73604"/>
                    <a:pt x="71507" y="79861"/>
                    <a:pt x="67719" y="82187"/>
                  </a:cubicBezTo>
                  <a:cubicBezTo>
                    <a:pt x="67543" y="82282"/>
                    <a:pt x="63334" y="83602"/>
                    <a:pt x="62843" y="83759"/>
                  </a:cubicBezTo>
                  <a:cubicBezTo>
                    <a:pt x="62352" y="83916"/>
                    <a:pt x="58248" y="85300"/>
                    <a:pt x="58002" y="85331"/>
                  </a:cubicBezTo>
                  <a:lnTo>
                    <a:pt x="52144" y="84545"/>
                  </a:lnTo>
                  <a:cubicBezTo>
                    <a:pt x="51758" y="84388"/>
                    <a:pt x="48461" y="82030"/>
                    <a:pt x="47795" y="81653"/>
                  </a:cubicBezTo>
                  <a:cubicBezTo>
                    <a:pt x="45340" y="80269"/>
                    <a:pt x="34606" y="74861"/>
                    <a:pt x="32221" y="74075"/>
                  </a:cubicBezTo>
                  <a:cubicBezTo>
                    <a:pt x="25591" y="71843"/>
                    <a:pt x="17734" y="71308"/>
                    <a:pt x="10824" y="69359"/>
                  </a:cubicBezTo>
                  <a:cubicBezTo>
                    <a:pt x="8824" y="66781"/>
                    <a:pt x="5492" y="60430"/>
                    <a:pt x="5001" y="57349"/>
                  </a:cubicBezTo>
                  <a:cubicBezTo>
                    <a:pt x="3633" y="48545"/>
                    <a:pt x="7667" y="43546"/>
                    <a:pt x="161" y="34334"/>
                  </a:cubicBezTo>
                  <a:cubicBezTo>
                    <a:pt x="-295" y="31315"/>
                    <a:pt x="231" y="27228"/>
                    <a:pt x="1599" y="24398"/>
                  </a:cubicBezTo>
                  <a:cubicBezTo>
                    <a:pt x="4931" y="23549"/>
                    <a:pt x="7772" y="21600"/>
                    <a:pt x="10824" y="20751"/>
                  </a:cubicBezTo>
                  <a:cubicBezTo>
                    <a:pt x="11350" y="20594"/>
                    <a:pt x="13490" y="20877"/>
                    <a:pt x="13981" y="20751"/>
                  </a:cubicBezTo>
                  <a:cubicBezTo>
                    <a:pt x="20049" y="18927"/>
                    <a:pt x="25872" y="12953"/>
                    <a:pt x="32466" y="12639"/>
                  </a:cubicBezTo>
                  <a:cubicBezTo>
                    <a:pt x="35658" y="12482"/>
                    <a:pt x="41516" y="13865"/>
                    <a:pt x="44638" y="14714"/>
                  </a:cubicBezTo>
                  <a:cubicBezTo>
                    <a:pt x="49233" y="12671"/>
                    <a:pt x="52671" y="9212"/>
                    <a:pt x="57266" y="7137"/>
                  </a:cubicBezTo>
                  <a:cubicBezTo>
                    <a:pt x="61089" y="7074"/>
                    <a:pt x="65509" y="7765"/>
                    <a:pt x="69192" y="7420"/>
                  </a:cubicBezTo>
                  <a:cubicBezTo>
                    <a:pt x="76944" y="6665"/>
                    <a:pt x="86274" y="-1793"/>
                    <a:pt x="94201" y="345"/>
                  </a:cubicBezTo>
                  <a:cubicBezTo>
                    <a:pt x="94482" y="3835"/>
                    <a:pt x="93570" y="8048"/>
                    <a:pt x="92272" y="11318"/>
                  </a:cubicBezTo>
                  <a:cubicBezTo>
                    <a:pt x="93360" y="15878"/>
                    <a:pt x="97253" y="19053"/>
                    <a:pt x="98095" y="23612"/>
                  </a:cubicBezTo>
                  <a:lnTo>
                    <a:pt x="97148" y="24649"/>
                  </a:lnTo>
                  <a:lnTo>
                    <a:pt x="94938" y="24146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30" name="자유형: 도형 371"/>
            <p:cNvSpPr/>
            <p:nvPr/>
          </p:nvSpPr>
          <p:spPr>
            <a:xfrm>
              <a:off x="6518520" y="1584360"/>
              <a:ext cx="20880" cy="24840"/>
            </a:xfrm>
            <a:custGeom>
              <a:avLst/>
              <a:gdLst/>
              <a:ahLst/>
              <a:cxnLst/>
              <a:rect l="l" t="t" r="r" b="b"/>
              <a:pathLst>
                <a:path w="16696" h="20625">
                  <a:moveTo>
                    <a:pt x="12396" y="18299"/>
                  </a:moveTo>
                  <a:lnTo>
                    <a:pt x="8022" y="20625"/>
                  </a:lnTo>
                  <a:cubicBezTo>
                    <a:pt x="1929" y="13300"/>
                    <a:pt x="2259" y="12671"/>
                    <a:pt x="0" y="3899"/>
                  </a:cubicBezTo>
                  <a:lnTo>
                    <a:pt x="1947" y="0"/>
                  </a:lnTo>
                  <a:cubicBezTo>
                    <a:pt x="6552" y="188"/>
                    <a:pt x="11277" y="755"/>
                    <a:pt x="15802" y="1541"/>
                  </a:cubicBezTo>
                  <a:cubicBezTo>
                    <a:pt x="17005" y="4559"/>
                    <a:pt x="16900" y="8961"/>
                    <a:pt x="16044" y="12010"/>
                  </a:cubicBezTo>
                  <a:cubicBezTo>
                    <a:pt x="16044" y="12010"/>
                    <a:pt x="13119" y="16255"/>
                    <a:pt x="12396" y="1829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31" name="자유형: 도형 372"/>
            <p:cNvSpPr/>
            <p:nvPr/>
          </p:nvSpPr>
          <p:spPr>
            <a:xfrm>
              <a:off x="6543360" y="1547640"/>
              <a:ext cx="109440" cy="84960"/>
            </a:xfrm>
            <a:custGeom>
              <a:avLst/>
              <a:gdLst/>
              <a:ahLst/>
              <a:cxnLst/>
              <a:rect l="l" t="t" r="r" b="b"/>
              <a:pathLst>
                <a:path w="87015" h="69516">
                  <a:moveTo>
                    <a:pt x="87015" y="25876"/>
                  </a:moveTo>
                  <a:cubicBezTo>
                    <a:pt x="85286" y="28392"/>
                    <a:pt x="82434" y="31001"/>
                    <a:pt x="79723" y="32668"/>
                  </a:cubicBezTo>
                  <a:lnTo>
                    <a:pt x="73889" y="32668"/>
                  </a:lnTo>
                  <a:lnTo>
                    <a:pt x="70729" y="36598"/>
                  </a:lnTo>
                  <a:lnTo>
                    <a:pt x="71701" y="41282"/>
                  </a:lnTo>
                  <a:lnTo>
                    <a:pt x="68544" y="44961"/>
                  </a:lnTo>
                  <a:cubicBezTo>
                    <a:pt x="65952" y="44584"/>
                    <a:pt x="58231" y="43232"/>
                    <a:pt x="56148" y="43389"/>
                  </a:cubicBezTo>
                  <a:cubicBezTo>
                    <a:pt x="52131" y="43672"/>
                    <a:pt x="45698" y="47602"/>
                    <a:pt x="42047" y="49143"/>
                  </a:cubicBezTo>
                  <a:cubicBezTo>
                    <a:pt x="34365" y="52412"/>
                    <a:pt x="25203" y="53922"/>
                    <a:pt x="18226" y="58544"/>
                  </a:cubicBezTo>
                  <a:cubicBezTo>
                    <a:pt x="12712" y="62222"/>
                    <a:pt x="12694" y="67033"/>
                    <a:pt x="7776" y="69265"/>
                  </a:cubicBezTo>
                  <a:lnTo>
                    <a:pt x="1701" y="69517"/>
                  </a:lnTo>
                  <a:lnTo>
                    <a:pt x="0" y="65335"/>
                  </a:lnTo>
                  <a:lnTo>
                    <a:pt x="2676" y="60650"/>
                  </a:lnTo>
                  <a:cubicBezTo>
                    <a:pt x="10604" y="57821"/>
                    <a:pt x="12884" y="51752"/>
                    <a:pt x="15557" y="45213"/>
                  </a:cubicBezTo>
                  <a:cubicBezTo>
                    <a:pt x="16248" y="43515"/>
                    <a:pt x="17223" y="41723"/>
                    <a:pt x="17745" y="39993"/>
                  </a:cubicBezTo>
                  <a:cubicBezTo>
                    <a:pt x="19524" y="34114"/>
                    <a:pt x="19008" y="23204"/>
                    <a:pt x="25767" y="19871"/>
                  </a:cubicBezTo>
                  <a:cubicBezTo>
                    <a:pt x="27181" y="17104"/>
                    <a:pt x="27623" y="12859"/>
                    <a:pt x="26981" y="9935"/>
                  </a:cubicBezTo>
                  <a:lnTo>
                    <a:pt x="24066" y="6257"/>
                  </a:lnTo>
                  <a:lnTo>
                    <a:pt x="26739" y="1823"/>
                  </a:lnTo>
                  <a:lnTo>
                    <a:pt x="31846" y="0"/>
                  </a:lnTo>
                  <a:cubicBezTo>
                    <a:pt x="38255" y="31"/>
                    <a:pt x="47852" y="8866"/>
                    <a:pt x="54450" y="10187"/>
                  </a:cubicBezTo>
                  <a:cubicBezTo>
                    <a:pt x="60262" y="11350"/>
                    <a:pt x="60350" y="9307"/>
                    <a:pt x="64415" y="8615"/>
                  </a:cubicBezTo>
                  <a:cubicBezTo>
                    <a:pt x="70922" y="7515"/>
                    <a:pt x="75117" y="10344"/>
                    <a:pt x="79488" y="14117"/>
                  </a:cubicBezTo>
                  <a:cubicBezTo>
                    <a:pt x="79919" y="14494"/>
                    <a:pt x="82939" y="16978"/>
                    <a:pt x="83132" y="17230"/>
                  </a:cubicBezTo>
                  <a:cubicBezTo>
                    <a:pt x="84037" y="18425"/>
                    <a:pt x="86303" y="24210"/>
                    <a:pt x="87015" y="25876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32" name="자유형: 도형 373"/>
            <p:cNvSpPr/>
            <p:nvPr/>
          </p:nvSpPr>
          <p:spPr>
            <a:xfrm>
              <a:off x="6422400" y="1611360"/>
              <a:ext cx="76680" cy="52200"/>
            </a:xfrm>
            <a:custGeom>
              <a:avLst/>
              <a:gdLst/>
              <a:ahLst/>
              <a:cxnLst/>
              <a:rect l="l" t="t" r="r" b="b"/>
              <a:pathLst>
                <a:path w="61112" h="42886">
                  <a:moveTo>
                    <a:pt x="47157" y="11508"/>
                  </a:moveTo>
                  <a:cubicBezTo>
                    <a:pt x="48792" y="14557"/>
                    <a:pt x="51402" y="15910"/>
                    <a:pt x="53720" y="18299"/>
                  </a:cubicBezTo>
                  <a:cubicBezTo>
                    <a:pt x="60381" y="25185"/>
                    <a:pt x="65888" y="36881"/>
                    <a:pt x="54692" y="42886"/>
                  </a:cubicBezTo>
                  <a:lnTo>
                    <a:pt x="49101" y="41817"/>
                  </a:lnTo>
                  <a:cubicBezTo>
                    <a:pt x="43281" y="38201"/>
                    <a:pt x="41808" y="31662"/>
                    <a:pt x="36217" y="27983"/>
                  </a:cubicBezTo>
                  <a:cubicBezTo>
                    <a:pt x="30345" y="27385"/>
                    <a:pt x="27188" y="31504"/>
                    <a:pt x="20176" y="29555"/>
                  </a:cubicBezTo>
                  <a:cubicBezTo>
                    <a:pt x="17886" y="27323"/>
                    <a:pt x="15009" y="25310"/>
                    <a:pt x="12884" y="23015"/>
                  </a:cubicBezTo>
                  <a:cubicBezTo>
                    <a:pt x="11870" y="21915"/>
                    <a:pt x="11239" y="20405"/>
                    <a:pt x="10207" y="19337"/>
                  </a:cubicBezTo>
                  <a:cubicBezTo>
                    <a:pt x="9106" y="18205"/>
                    <a:pt x="7394" y="17356"/>
                    <a:pt x="6321" y="16224"/>
                  </a:cubicBezTo>
                  <a:cubicBezTo>
                    <a:pt x="3781" y="13488"/>
                    <a:pt x="-25" y="7483"/>
                    <a:pt x="0" y="3930"/>
                  </a:cubicBezTo>
                  <a:lnTo>
                    <a:pt x="3157" y="0"/>
                  </a:lnTo>
                  <a:cubicBezTo>
                    <a:pt x="8990" y="2893"/>
                    <a:pt x="12779" y="9684"/>
                    <a:pt x="19931" y="9684"/>
                  </a:cubicBezTo>
                  <a:cubicBezTo>
                    <a:pt x="27897" y="9684"/>
                    <a:pt x="33341" y="3710"/>
                    <a:pt x="42050" y="7829"/>
                  </a:cubicBezTo>
                  <a:lnTo>
                    <a:pt x="47157" y="11508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33" name="자유형: 도형 374"/>
            <p:cNvSpPr/>
            <p:nvPr/>
          </p:nvSpPr>
          <p:spPr>
            <a:xfrm>
              <a:off x="6470280" y="1683000"/>
              <a:ext cx="34200" cy="42840"/>
            </a:xfrm>
            <a:custGeom>
              <a:avLst/>
              <a:gdLst/>
              <a:ahLst/>
              <a:cxnLst/>
              <a:rect l="l" t="t" r="r" b="b"/>
              <a:pathLst>
                <a:path w="27305" h="35118">
                  <a:moveTo>
                    <a:pt x="24681" y="30151"/>
                  </a:moveTo>
                  <a:cubicBezTo>
                    <a:pt x="20644" y="33264"/>
                    <a:pt x="14670" y="33358"/>
                    <a:pt x="9851" y="35119"/>
                  </a:cubicBezTo>
                  <a:lnTo>
                    <a:pt x="4260" y="34081"/>
                  </a:lnTo>
                  <a:cubicBezTo>
                    <a:pt x="3274" y="30717"/>
                    <a:pt x="3467" y="27510"/>
                    <a:pt x="3042" y="24146"/>
                  </a:cubicBezTo>
                  <a:cubicBezTo>
                    <a:pt x="2074" y="16411"/>
                    <a:pt x="-2991" y="7985"/>
                    <a:pt x="2555" y="596"/>
                  </a:cubicBezTo>
                  <a:cubicBezTo>
                    <a:pt x="5558" y="-661"/>
                    <a:pt x="11243" y="250"/>
                    <a:pt x="13980" y="1665"/>
                  </a:cubicBezTo>
                  <a:cubicBezTo>
                    <a:pt x="15744" y="4463"/>
                    <a:pt x="18340" y="6067"/>
                    <a:pt x="20542" y="8457"/>
                  </a:cubicBezTo>
                  <a:cubicBezTo>
                    <a:pt x="21921" y="9934"/>
                    <a:pt x="26705" y="18738"/>
                    <a:pt x="27105" y="20467"/>
                  </a:cubicBezTo>
                  <a:cubicBezTo>
                    <a:pt x="27765" y="23297"/>
                    <a:pt x="26751" y="27887"/>
                    <a:pt x="24681" y="30151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34" name="자유형: 도형 375"/>
            <p:cNvSpPr/>
            <p:nvPr/>
          </p:nvSpPr>
          <p:spPr>
            <a:xfrm>
              <a:off x="6343920" y="1837800"/>
              <a:ext cx="63360" cy="27000"/>
            </a:xfrm>
            <a:custGeom>
              <a:avLst/>
              <a:gdLst/>
              <a:ahLst/>
              <a:cxnLst/>
              <a:rect l="l" t="t" r="r" b="b"/>
              <a:pathLst>
                <a:path w="50559" h="22310">
                  <a:moveTo>
                    <a:pt x="47399" y="10550"/>
                  </a:moveTo>
                  <a:lnTo>
                    <a:pt x="50560" y="14228"/>
                  </a:lnTo>
                  <a:cubicBezTo>
                    <a:pt x="49353" y="16147"/>
                    <a:pt x="45491" y="20297"/>
                    <a:pt x="43267" y="21272"/>
                  </a:cubicBezTo>
                  <a:cubicBezTo>
                    <a:pt x="36554" y="24195"/>
                    <a:pt x="24912" y="20202"/>
                    <a:pt x="18230" y="18410"/>
                  </a:cubicBezTo>
                  <a:cubicBezTo>
                    <a:pt x="16318" y="17876"/>
                    <a:pt x="13687" y="17561"/>
                    <a:pt x="11909" y="16838"/>
                  </a:cubicBezTo>
                  <a:lnTo>
                    <a:pt x="2918" y="11336"/>
                  </a:lnTo>
                  <a:cubicBezTo>
                    <a:pt x="2655" y="11116"/>
                    <a:pt x="361" y="8129"/>
                    <a:pt x="0" y="7689"/>
                  </a:cubicBezTo>
                  <a:lnTo>
                    <a:pt x="730" y="1935"/>
                  </a:lnTo>
                  <a:cubicBezTo>
                    <a:pt x="5149" y="-832"/>
                    <a:pt x="12856" y="-612"/>
                    <a:pt x="17019" y="2469"/>
                  </a:cubicBezTo>
                  <a:lnTo>
                    <a:pt x="17503" y="3255"/>
                  </a:lnTo>
                  <a:cubicBezTo>
                    <a:pt x="22575" y="5708"/>
                    <a:pt x="28026" y="8223"/>
                    <a:pt x="33793" y="9009"/>
                  </a:cubicBezTo>
                  <a:cubicBezTo>
                    <a:pt x="38434" y="9607"/>
                    <a:pt x="42734" y="9292"/>
                    <a:pt x="47399" y="1055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35" name="자유형: 도형 376"/>
            <p:cNvSpPr/>
            <p:nvPr/>
          </p:nvSpPr>
          <p:spPr>
            <a:xfrm>
              <a:off x="6502680" y="1816200"/>
              <a:ext cx="56880" cy="55800"/>
            </a:xfrm>
            <a:custGeom>
              <a:avLst/>
              <a:gdLst/>
              <a:ahLst/>
              <a:cxnLst/>
              <a:rect l="l" t="t" r="r" b="b"/>
              <a:pathLst>
                <a:path w="45226" h="45577">
                  <a:moveTo>
                    <a:pt x="44241" y="17091"/>
                  </a:moveTo>
                  <a:cubicBezTo>
                    <a:pt x="36366" y="20675"/>
                    <a:pt x="35973" y="39037"/>
                    <a:pt x="28926" y="45326"/>
                  </a:cubicBezTo>
                  <a:lnTo>
                    <a:pt x="24310" y="45577"/>
                  </a:lnTo>
                  <a:cubicBezTo>
                    <a:pt x="21515" y="43974"/>
                    <a:pt x="18684" y="42370"/>
                    <a:pt x="15804" y="40892"/>
                  </a:cubicBezTo>
                  <a:cubicBezTo>
                    <a:pt x="12605" y="42150"/>
                    <a:pt x="8810" y="43062"/>
                    <a:pt x="5351" y="43502"/>
                  </a:cubicBezTo>
                  <a:lnTo>
                    <a:pt x="1949" y="40358"/>
                  </a:lnTo>
                  <a:cubicBezTo>
                    <a:pt x="-559" y="36208"/>
                    <a:pt x="2264" y="33441"/>
                    <a:pt x="2436" y="29636"/>
                  </a:cubicBezTo>
                  <a:cubicBezTo>
                    <a:pt x="2524" y="27656"/>
                    <a:pt x="-135" y="19921"/>
                    <a:pt x="5" y="14985"/>
                  </a:cubicBezTo>
                  <a:cubicBezTo>
                    <a:pt x="1068" y="12752"/>
                    <a:pt x="4236" y="8696"/>
                    <a:pt x="6568" y="7407"/>
                  </a:cubicBezTo>
                  <a:cubicBezTo>
                    <a:pt x="7761" y="6747"/>
                    <a:pt x="19438" y="3037"/>
                    <a:pt x="21153" y="2723"/>
                  </a:cubicBezTo>
                  <a:cubicBezTo>
                    <a:pt x="22634" y="2408"/>
                    <a:pt x="24289" y="2503"/>
                    <a:pt x="25755" y="2188"/>
                  </a:cubicBezTo>
                  <a:cubicBezTo>
                    <a:pt x="28106" y="1685"/>
                    <a:pt x="30712" y="396"/>
                    <a:pt x="33065" y="82"/>
                  </a:cubicBezTo>
                  <a:cubicBezTo>
                    <a:pt x="39312" y="-704"/>
                    <a:pt x="43795" y="4326"/>
                    <a:pt x="44816" y="9231"/>
                  </a:cubicBezTo>
                  <a:cubicBezTo>
                    <a:pt x="45349" y="11872"/>
                    <a:pt x="45549" y="14545"/>
                    <a:pt x="44241" y="17091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36" name="자유형: 도형 377"/>
            <p:cNvSpPr/>
            <p:nvPr/>
          </p:nvSpPr>
          <p:spPr>
            <a:xfrm>
              <a:off x="6616440" y="1817280"/>
              <a:ext cx="77040" cy="88200"/>
            </a:xfrm>
            <a:custGeom>
              <a:avLst/>
              <a:gdLst/>
              <a:ahLst/>
              <a:cxnLst/>
              <a:rect l="l" t="t" r="r" b="b"/>
              <a:pathLst>
                <a:path w="61172" h="72089">
                  <a:moveTo>
                    <a:pt x="59312" y="40793"/>
                  </a:moveTo>
                  <a:cubicBezTo>
                    <a:pt x="56972" y="42617"/>
                    <a:pt x="52405" y="44063"/>
                    <a:pt x="49343" y="44189"/>
                  </a:cubicBezTo>
                  <a:lnTo>
                    <a:pt x="48614" y="47584"/>
                  </a:lnTo>
                  <a:lnTo>
                    <a:pt x="51290" y="51263"/>
                  </a:lnTo>
                  <a:lnTo>
                    <a:pt x="50803" y="56985"/>
                  </a:lnTo>
                  <a:lnTo>
                    <a:pt x="47154" y="58840"/>
                  </a:lnTo>
                  <a:cubicBezTo>
                    <a:pt x="44608" y="56859"/>
                    <a:pt x="38932" y="55853"/>
                    <a:pt x="35733" y="56734"/>
                  </a:cubicBezTo>
                  <a:cubicBezTo>
                    <a:pt x="33555" y="58683"/>
                    <a:pt x="29914" y="60884"/>
                    <a:pt x="28199" y="63022"/>
                  </a:cubicBezTo>
                  <a:cubicBezTo>
                    <a:pt x="27154" y="64311"/>
                    <a:pt x="26845" y="66481"/>
                    <a:pt x="25768" y="67707"/>
                  </a:cubicBezTo>
                  <a:cubicBezTo>
                    <a:pt x="22478" y="71511"/>
                    <a:pt x="15375" y="72895"/>
                    <a:pt x="10457" y="71637"/>
                  </a:cubicBezTo>
                  <a:lnTo>
                    <a:pt x="6080" y="68776"/>
                  </a:lnTo>
                  <a:lnTo>
                    <a:pt x="4136" y="64594"/>
                  </a:lnTo>
                  <a:cubicBezTo>
                    <a:pt x="5901" y="62110"/>
                    <a:pt x="8559" y="59532"/>
                    <a:pt x="11187" y="57771"/>
                  </a:cubicBezTo>
                  <a:lnTo>
                    <a:pt x="12400" y="53087"/>
                  </a:lnTo>
                  <a:cubicBezTo>
                    <a:pt x="10071" y="50823"/>
                    <a:pt x="7633" y="48622"/>
                    <a:pt x="5108" y="46547"/>
                  </a:cubicBezTo>
                  <a:lnTo>
                    <a:pt x="7784" y="41831"/>
                  </a:lnTo>
                  <a:lnTo>
                    <a:pt x="13130" y="41045"/>
                  </a:lnTo>
                  <a:lnTo>
                    <a:pt x="17016" y="37901"/>
                  </a:lnTo>
                  <a:cubicBezTo>
                    <a:pt x="18644" y="26047"/>
                    <a:pt x="-125" y="11584"/>
                    <a:pt x="1" y="265"/>
                  </a:cubicBezTo>
                  <a:cubicBezTo>
                    <a:pt x="8784" y="-1370"/>
                    <a:pt x="13302" y="4981"/>
                    <a:pt x="20177" y="7842"/>
                  </a:cubicBezTo>
                  <a:cubicBezTo>
                    <a:pt x="23941" y="9414"/>
                    <a:pt x="27897" y="10106"/>
                    <a:pt x="31601" y="12024"/>
                  </a:cubicBezTo>
                  <a:cubicBezTo>
                    <a:pt x="31601" y="12024"/>
                    <a:pt x="37224" y="15011"/>
                    <a:pt x="39624" y="16206"/>
                  </a:cubicBezTo>
                  <a:cubicBezTo>
                    <a:pt x="42966" y="17872"/>
                    <a:pt x="47148" y="18721"/>
                    <a:pt x="50318" y="20639"/>
                  </a:cubicBezTo>
                  <a:cubicBezTo>
                    <a:pt x="51532" y="21394"/>
                    <a:pt x="52883" y="22871"/>
                    <a:pt x="53963" y="23783"/>
                  </a:cubicBezTo>
                  <a:cubicBezTo>
                    <a:pt x="58400" y="27619"/>
                    <a:pt x="62750" y="31078"/>
                    <a:pt x="60610" y="37115"/>
                  </a:cubicBezTo>
                  <a:lnTo>
                    <a:pt x="59312" y="40793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37" name="자유형: 도형 378"/>
            <p:cNvSpPr/>
            <p:nvPr/>
          </p:nvSpPr>
          <p:spPr>
            <a:xfrm>
              <a:off x="6708600" y="1872000"/>
              <a:ext cx="20880" cy="16920"/>
            </a:xfrm>
            <a:custGeom>
              <a:avLst/>
              <a:gdLst/>
              <a:ahLst/>
              <a:cxnLst/>
              <a:rect l="l" t="t" r="r" b="b"/>
              <a:pathLst>
                <a:path w="16756" h="14117">
                  <a:moveTo>
                    <a:pt x="16756" y="7860"/>
                  </a:moveTo>
                  <a:lnTo>
                    <a:pt x="16037" y="13614"/>
                  </a:lnTo>
                  <a:lnTo>
                    <a:pt x="10691" y="14117"/>
                  </a:lnTo>
                  <a:cubicBezTo>
                    <a:pt x="8896" y="11853"/>
                    <a:pt x="4662" y="9558"/>
                    <a:pt x="1701" y="8898"/>
                  </a:cubicBezTo>
                  <a:lnTo>
                    <a:pt x="0" y="4465"/>
                  </a:lnTo>
                  <a:lnTo>
                    <a:pt x="2431" y="0"/>
                  </a:lnTo>
                  <a:lnTo>
                    <a:pt x="8994" y="535"/>
                  </a:lnTo>
                  <a:cubicBezTo>
                    <a:pt x="11526" y="3081"/>
                    <a:pt x="14501" y="5062"/>
                    <a:pt x="16756" y="786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38" name="자유형: 도형 379"/>
            <p:cNvSpPr/>
            <p:nvPr/>
          </p:nvSpPr>
          <p:spPr>
            <a:xfrm>
              <a:off x="6689880" y="1933560"/>
              <a:ext cx="14040" cy="19080"/>
            </a:xfrm>
            <a:custGeom>
              <a:avLst/>
              <a:gdLst/>
              <a:ahLst/>
              <a:cxnLst/>
              <a:rect l="l" t="t" r="r" b="b"/>
              <a:pathLst>
                <a:path w="11424" h="15940">
                  <a:moveTo>
                    <a:pt x="11403" y="9936"/>
                  </a:moveTo>
                  <a:cubicBezTo>
                    <a:pt x="10099" y="12231"/>
                    <a:pt x="6615" y="15061"/>
                    <a:pt x="3886" y="15941"/>
                  </a:cubicBezTo>
                  <a:lnTo>
                    <a:pt x="0" y="14117"/>
                  </a:lnTo>
                  <a:cubicBezTo>
                    <a:pt x="46" y="10596"/>
                    <a:pt x="1038" y="6320"/>
                    <a:pt x="2673" y="3144"/>
                  </a:cubicBezTo>
                  <a:lnTo>
                    <a:pt x="6808" y="0"/>
                  </a:lnTo>
                  <a:lnTo>
                    <a:pt x="11424" y="1289"/>
                  </a:lnTo>
                  <a:lnTo>
                    <a:pt x="11424" y="6540"/>
                  </a:lnTo>
                  <a:lnTo>
                    <a:pt x="11403" y="9936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39" name="자유형: 도형 380"/>
            <p:cNvSpPr/>
            <p:nvPr/>
          </p:nvSpPr>
          <p:spPr>
            <a:xfrm>
              <a:off x="6141240" y="1838160"/>
              <a:ext cx="68040" cy="57960"/>
            </a:xfrm>
            <a:custGeom>
              <a:avLst/>
              <a:gdLst/>
              <a:ahLst/>
              <a:cxnLst/>
              <a:rect l="l" t="t" r="r" b="b"/>
              <a:pathLst>
                <a:path w="54269" h="47582">
                  <a:moveTo>
                    <a:pt x="37713" y="17261"/>
                  </a:moveTo>
                  <a:cubicBezTo>
                    <a:pt x="45517" y="21317"/>
                    <a:pt x="58292" y="29335"/>
                    <a:pt x="53038" y="38956"/>
                  </a:cubicBezTo>
                  <a:cubicBezTo>
                    <a:pt x="50639" y="40811"/>
                    <a:pt x="48071" y="43704"/>
                    <a:pt x="45507" y="45213"/>
                  </a:cubicBezTo>
                  <a:cubicBezTo>
                    <a:pt x="40828" y="48011"/>
                    <a:pt x="33949" y="48168"/>
                    <a:pt x="28733" y="46533"/>
                  </a:cubicBezTo>
                  <a:cubicBezTo>
                    <a:pt x="26597" y="44333"/>
                    <a:pt x="23570" y="42194"/>
                    <a:pt x="20715" y="40780"/>
                  </a:cubicBezTo>
                  <a:cubicBezTo>
                    <a:pt x="19406" y="37887"/>
                    <a:pt x="18021" y="34994"/>
                    <a:pt x="16579" y="32165"/>
                  </a:cubicBezTo>
                  <a:cubicBezTo>
                    <a:pt x="10030" y="31064"/>
                    <a:pt x="7645" y="35812"/>
                    <a:pt x="1998" y="35277"/>
                  </a:cubicBezTo>
                  <a:cubicBezTo>
                    <a:pt x="1815" y="34900"/>
                    <a:pt x="72" y="31284"/>
                    <a:pt x="51" y="31096"/>
                  </a:cubicBezTo>
                  <a:cubicBezTo>
                    <a:pt x="-545" y="26348"/>
                    <a:pt x="4253" y="7169"/>
                    <a:pt x="6614" y="2610"/>
                  </a:cubicBezTo>
                  <a:lnTo>
                    <a:pt x="10746" y="0"/>
                  </a:lnTo>
                  <a:lnTo>
                    <a:pt x="14636" y="2075"/>
                  </a:lnTo>
                  <a:cubicBezTo>
                    <a:pt x="18715" y="14715"/>
                    <a:pt x="27460" y="10659"/>
                    <a:pt x="37239" y="15689"/>
                  </a:cubicBezTo>
                  <a:lnTo>
                    <a:pt x="37713" y="17261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40" name="자유형: 도형 381"/>
            <p:cNvSpPr/>
            <p:nvPr/>
          </p:nvSpPr>
          <p:spPr>
            <a:xfrm>
              <a:off x="6222600" y="1888920"/>
              <a:ext cx="24120" cy="27720"/>
            </a:xfrm>
            <a:custGeom>
              <a:avLst/>
              <a:gdLst/>
              <a:ahLst/>
              <a:cxnLst/>
              <a:rect l="l" t="t" r="r" b="b"/>
              <a:pathLst>
                <a:path w="19439" h="22732">
                  <a:moveTo>
                    <a:pt x="19440" y="19619"/>
                  </a:moveTo>
                  <a:lnTo>
                    <a:pt x="15795" y="22732"/>
                  </a:lnTo>
                  <a:lnTo>
                    <a:pt x="10449" y="20405"/>
                  </a:lnTo>
                  <a:cubicBezTo>
                    <a:pt x="7885" y="14683"/>
                    <a:pt x="5560" y="9181"/>
                    <a:pt x="0" y="5219"/>
                  </a:cubicBezTo>
                  <a:lnTo>
                    <a:pt x="1943" y="1037"/>
                  </a:lnTo>
                  <a:lnTo>
                    <a:pt x="7289" y="0"/>
                  </a:lnTo>
                  <a:cubicBezTo>
                    <a:pt x="18082" y="3458"/>
                    <a:pt x="19383" y="10438"/>
                    <a:pt x="19440" y="1961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41" name="자유형: 도형 382"/>
            <p:cNvSpPr/>
            <p:nvPr/>
          </p:nvSpPr>
          <p:spPr>
            <a:xfrm>
              <a:off x="6018480" y="1917720"/>
              <a:ext cx="24480" cy="15120"/>
            </a:xfrm>
            <a:custGeom>
              <a:avLst/>
              <a:gdLst/>
              <a:ahLst/>
              <a:cxnLst/>
              <a:rect l="l" t="t" r="r" b="b"/>
              <a:pathLst>
                <a:path w="19685" h="12613">
                  <a:moveTo>
                    <a:pt x="19447" y="5219"/>
                  </a:moveTo>
                  <a:cubicBezTo>
                    <a:pt x="13803" y="11130"/>
                    <a:pt x="9067" y="13897"/>
                    <a:pt x="0" y="12042"/>
                  </a:cubicBezTo>
                  <a:lnTo>
                    <a:pt x="1217" y="7043"/>
                  </a:lnTo>
                  <a:lnTo>
                    <a:pt x="5107" y="3930"/>
                  </a:lnTo>
                  <a:lnTo>
                    <a:pt x="10211" y="3144"/>
                  </a:lnTo>
                  <a:lnTo>
                    <a:pt x="14097" y="0"/>
                  </a:lnTo>
                  <a:lnTo>
                    <a:pt x="17984" y="0"/>
                  </a:lnTo>
                  <a:lnTo>
                    <a:pt x="19685" y="1572"/>
                  </a:lnTo>
                  <a:lnTo>
                    <a:pt x="19447" y="5219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42" name="자유형: 도형 383"/>
            <p:cNvSpPr/>
            <p:nvPr/>
          </p:nvSpPr>
          <p:spPr>
            <a:xfrm>
              <a:off x="6139080" y="1927800"/>
              <a:ext cx="21240" cy="18360"/>
            </a:xfrm>
            <a:custGeom>
              <a:avLst/>
              <a:gdLst/>
              <a:ahLst/>
              <a:cxnLst/>
              <a:rect l="l" t="t" r="r" b="b"/>
              <a:pathLst>
                <a:path w="17155" h="15317">
                  <a:moveTo>
                    <a:pt x="11322" y="0"/>
                  </a:moveTo>
                  <a:cubicBezTo>
                    <a:pt x="13595" y="1415"/>
                    <a:pt x="15780" y="3867"/>
                    <a:pt x="17155" y="6005"/>
                  </a:cubicBezTo>
                  <a:lnTo>
                    <a:pt x="16913" y="10438"/>
                  </a:lnTo>
                  <a:cubicBezTo>
                    <a:pt x="14100" y="14180"/>
                    <a:pt x="7863" y="15878"/>
                    <a:pt x="3058" y="15155"/>
                  </a:cubicBezTo>
                  <a:cubicBezTo>
                    <a:pt x="802" y="13268"/>
                    <a:pt x="-439" y="8646"/>
                    <a:pt x="143" y="6005"/>
                  </a:cubicBezTo>
                  <a:lnTo>
                    <a:pt x="2816" y="1572"/>
                  </a:lnTo>
                  <a:cubicBezTo>
                    <a:pt x="5611" y="1258"/>
                    <a:pt x="8639" y="818"/>
                    <a:pt x="11322" y="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43" name="자유형: 도형 384"/>
            <p:cNvSpPr/>
            <p:nvPr/>
          </p:nvSpPr>
          <p:spPr>
            <a:xfrm>
              <a:off x="6313680" y="1932840"/>
              <a:ext cx="23400" cy="21240"/>
            </a:xfrm>
            <a:custGeom>
              <a:avLst/>
              <a:gdLst/>
              <a:ahLst/>
              <a:cxnLst/>
              <a:rect l="l" t="t" r="r" b="b"/>
              <a:pathLst>
                <a:path w="18717" h="17513">
                  <a:moveTo>
                    <a:pt x="18717" y="15155"/>
                  </a:moveTo>
                  <a:lnTo>
                    <a:pt x="14343" y="17513"/>
                  </a:lnTo>
                  <a:cubicBezTo>
                    <a:pt x="11638" y="16570"/>
                    <a:pt x="8236" y="13457"/>
                    <a:pt x="7293" y="10973"/>
                  </a:cubicBezTo>
                  <a:lnTo>
                    <a:pt x="1701" y="8898"/>
                  </a:lnTo>
                  <a:lnTo>
                    <a:pt x="0" y="4716"/>
                  </a:lnTo>
                  <a:lnTo>
                    <a:pt x="3160" y="786"/>
                  </a:lnTo>
                  <a:lnTo>
                    <a:pt x="5588" y="0"/>
                  </a:lnTo>
                  <a:cubicBezTo>
                    <a:pt x="6251" y="314"/>
                    <a:pt x="11902" y="2956"/>
                    <a:pt x="12165" y="3144"/>
                  </a:cubicBezTo>
                  <a:cubicBezTo>
                    <a:pt x="12656" y="3490"/>
                    <a:pt x="12705" y="3867"/>
                    <a:pt x="13052" y="4339"/>
                  </a:cubicBezTo>
                  <a:cubicBezTo>
                    <a:pt x="14438" y="6257"/>
                    <a:pt x="16798" y="8678"/>
                    <a:pt x="17742" y="10722"/>
                  </a:cubicBezTo>
                  <a:cubicBezTo>
                    <a:pt x="17886" y="11004"/>
                    <a:pt x="18598" y="14620"/>
                    <a:pt x="18717" y="1515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44" name="자유형: 도형 385"/>
            <p:cNvSpPr/>
            <p:nvPr/>
          </p:nvSpPr>
          <p:spPr>
            <a:xfrm>
              <a:off x="6356520" y="1939320"/>
              <a:ext cx="18360" cy="15480"/>
            </a:xfrm>
            <a:custGeom>
              <a:avLst/>
              <a:gdLst/>
              <a:ahLst/>
              <a:cxnLst/>
              <a:rect l="l" t="t" r="r" b="b"/>
              <a:pathLst>
                <a:path w="14834" h="12828">
                  <a:moveTo>
                    <a:pt x="10695" y="0"/>
                  </a:moveTo>
                  <a:cubicBezTo>
                    <a:pt x="12996" y="1666"/>
                    <a:pt x="14974" y="5785"/>
                    <a:pt x="14827" y="8395"/>
                  </a:cubicBezTo>
                  <a:lnTo>
                    <a:pt x="12154" y="12828"/>
                  </a:lnTo>
                  <a:lnTo>
                    <a:pt x="5591" y="12294"/>
                  </a:lnTo>
                  <a:cubicBezTo>
                    <a:pt x="3620" y="9936"/>
                    <a:pt x="1747" y="7483"/>
                    <a:pt x="0" y="4999"/>
                  </a:cubicBezTo>
                  <a:lnTo>
                    <a:pt x="1459" y="283"/>
                  </a:lnTo>
                  <a:cubicBezTo>
                    <a:pt x="3546" y="692"/>
                    <a:pt x="8699" y="1069"/>
                    <a:pt x="10695" y="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45" name="자유형: 도형 386"/>
            <p:cNvSpPr/>
            <p:nvPr/>
          </p:nvSpPr>
          <p:spPr>
            <a:xfrm>
              <a:off x="6485400" y="2059200"/>
              <a:ext cx="22320" cy="23400"/>
            </a:xfrm>
            <a:custGeom>
              <a:avLst/>
              <a:gdLst/>
              <a:ahLst/>
              <a:cxnLst/>
              <a:rect l="l" t="t" r="r" b="b"/>
              <a:pathLst>
                <a:path w="17940" h="19201">
                  <a:moveTo>
                    <a:pt x="17545" y="15155"/>
                  </a:moveTo>
                  <a:lnTo>
                    <a:pt x="14385" y="18833"/>
                  </a:lnTo>
                  <a:cubicBezTo>
                    <a:pt x="9471" y="20217"/>
                    <a:pt x="2126" y="17576"/>
                    <a:pt x="288" y="13080"/>
                  </a:cubicBezTo>
                  <a:cubicBezTo>
                    <a:pt x="-368" y="10030"/>
                    <a:pt x="123" y="5723"/>
                    <a:pt x="1501" y="2893"/>
                  </a:cubicBezTo>
                  <a:lnTo>
                    <a:pt x="5149" y="0"/>
                  </a:lnTo>
                  <a:lnTo>
                    <a:pt x="11712" y="535"/>
                  </a:lnTo>
                  <a:lnTo>
                    <a:pt x="15357" y="3679"/>
                  </a:lnTo>
                  <a:cubicBezTo>
                    <a:pt x="15357" y="3679"/>
                    <a:pt x="19148" y="10722"/>
                    <a:pt x="17545" y="1515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46" name="자유형: 도형 387"/>
            <p:cNvSpPr/>
            <p:nvPr/>
          </p:nvSpPr>
          <p:spPr>
            <a:xfrm>
              <a:off x="6109200" y="2012400"/>
              <a:ext cx="27720" cy="24480"/>
            </a:xfrm>
            <a:custGeom>
              <a:avLst/>
              <a:gdLst/>
              <a:ahLst/>
              <a:cxnLst/>
              <a:rect l="l" t="t" r="r" b="b"/>
              <a:pathLst>
                <a:path w="22357" h="20206">
                  <a:moveTo>
                    <a:pt x="19429" y="1937"/>
                  </a:moveTo>
                  <a:cubicBezTo>
                    <a:pt x="21001" y="4453"/>
                    <a:pt x="22105" y="7911"/>
                    <a:pt x="22358" y="10804"/>
                  </a:cubicBezTo>
                  <a:cubicBezTo>
                    <a:pt x="21653" y="15740"/>
                    <a:pt x="17265" y="20299"/>
                    <a:pt x="11421" y="20205"/>
                  </a:cubicBezTo>
                  <a:lnTo>
                    <a:pt x="6801" y="17344"/>
                  </a:lnTo>
                  <a:lnTo>
                    <a:pt x="8261" y="11339"/>
                  </a:lnTo>
                  <a:cubicBezTo>
                    <a:pt x="6286" y="8981"/>
                    <a:pt x="2964" y="6591"/>
                    <a:pt x="0" y="5333"/>
                  </a:cubicBezTo>
                  <a:lnTo>
                    <a:pt x="2915" y="869"/>
                  </a:lnTo>
                  <a:cubicBezTo>
                    <a:pt x="7738" y="-1207"/>
                    <a:pt x="14469" y="963"/>
                    <a:pt x="19429" y="1937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47" name="자유형: 도형 388"/>
            <p:cNvSpPr/>
            <p:nvPr/>
          </p:nvSpPr>
          <p:spPr>
            <a:xfrm>
              <a:off x="6019200" y="2097720"/>
              <a:ext cx="35640" cy="15840"/>
            </a:xfrm>
            <a:custGeom>
              <a:avLst/>
              <a:gdLst/>
              <a:ahLst/>
              <a:cxnLst/>
              <a:rect l="l" t="t" r="r" b="b"/>
              <a:pathLst>
                <a:path w="28440" h="13079">
                  <a:moveTo>
                    <a:pt x="15802" y="1038"/>
                  </a:moveTo>
                  <a:cubicBezTo>
                    <a:pt x="19117" y="880"/>
                    <a:pt x="23161" y="1541"/>
                    <a:pt x="26252" y="2610"/>
                  </a:cubicBezTo>
                  <a:lnTo>
                    <a:pt x="28440" y="6791"/>
                  </a:lnTo>
                  <a:lnTo>
                    <a:pt x="26010" y="11256"/>
                  </a:lnTo>
                  <a:cubicBezTo>
                    <a:pt x="24512" y="11696"/>
                    <a:pt x="22428" y="12608"/>
                    <a:pt x="20906" y="12828"/>
                  </a:cubicBezTo>
                  <a:cubicBezTo>
                    <a:pt x="20534" y="12860"/>
                    <a:pt x="9074" y="13080"/>
                    <a:pt x="8994" y="13080"/>
                  </a:cubicBezTo>
                  <a:cubicBezTo>
                    <a:pt x="6181" y="12608"/>
                    <a:pt x="1533" y="9778"/>
                    <a:pt x="0" y="7577"/>
                  </a:cubicBezTo>
                  <a:lnTo>
                    <a:pt x="1459" y="1824"/>
                  </a:lnTo>
                  <a:lnTo>
                    <a:pt x="6321" y="0"/>
                  </a:lnTo>
                  <a:lnTo>
                    <a:pt x="11667" y="2358"/>
                  </a:lnTo>
                  <a:cubicBezTo>
                    <a:pt x="12922" y="2453"/>
                    <a:pt x="14876" y="1824"/>
                    <a:pt x="15802" y="103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48" name="자유형: 도형 389"/>
            <p:cNvSpPr/>
            <p:nvPr/>
          </p:nvSpPr>
          <p:spPr>
            <a:xfrm>
              <a:off x="6206400" y="2297880"/>
              <a:ext cx="16200" cy="16920"/>
            </a:xfrm>
            <a:custGeom>
              <a:avLst/>
              <a:gdLst/>
              <a:ahLst/>
              <a:cxnLst/>
              <a:rect l="l" t="t" r="r" b="b"/>
              <a:pathLst>
                <a:path w="13118" h="14117">
                  <a:moveTo>
                    <a:pt x="13119" y="9401"/>
                  </a:moveTo>
                  <a:cubicBezTo>
                    <a:pt x="11509" y="11539"/>
                    <a:pt x="7450" y="13740"/>
                    <a:pt x="4616" y="14117"/>
                  </a:cubicBezTo>
                  <a:lnTo>
                    <a:pt x="968" y="10973"/>
                  </a:lnTo>
                  <a:lnTo>
                    <a:pt x="0" y="6257"/>
                  </a:lnTo>
                  <a:lnTo>
                    <a:pt x="2673" y="1823"/>
                  </a:lnTo>
                  <a:lnTo>
                    <a:pt x="7535" y="0"/>
                  </a:lnTo>
                  <a:lnTo>
                    <a:pt x="12154" y="2861"/>
                  </a:lnTo>
                  <a:cubicBezTo>
                    <a:pt x="12410" y="5062"/>
                    <a:pt x="12775" y="7231"/>
                    <a:pt x="13119" y="9401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49" name="자유형: 도형 390"/>
            <p:cNvSpPr/>
            <p:nvPr/>
          </p:nvSpPr>
          <p:spPr>
            <a:xfrm>
              <a:off x="6096960" y="2477160"/>
              <a:ext cx="42480" cy="15840"/>
            </a:xfrm>
            <a:custGeom>
              <a:avLst/>
              <a:gdLst/>
              <a:ahLst/>
              <a:cxnLst/>
              <a:rect l="l" t="t" r="r" b="b"/>
              <a:pathLst>
                <a:path w="33785" h="13047">
                  <a:moveTo>
                    <a:pt x="18963" y="13048"/>
                  </a:moveTo>
                  <a:cubicBezTo>
                    <a:pt x="12810" y="12199"/>
                    <a:pt x="6672" y="12954"/>
                    <a:pt x="487" y="12796"/>
                  </a:cubicBezTo>
                  <a:lnTo>
                    <a:pt x="0" y="9149"/>
                  </a:lnTo>
                  <a:cubicBezTo>
                    <a:pt x="6212" y="4747"/>
                    <a:pt x="14497" y="12451"/>
                    <a:pt x="29654" y="0"/>
                  </a:cubicBezTo>
                  <a:lnTo>
                    <a:pt x="33786" y="786"/>
                  </a:lnTo>
                  <a:lnTo>
                    <a:pt x="33298" y="6257"/>
                  </a:lnTo>
                  <a:cubicBezTo>
                    <a:pt x="31425" y="7105"/>
                    <a:pt x="29321" y="7514"/>
                    <a:pt x="27469" y="8363"/>
                  </a:cubicBezTo>
                  <a:cubicBezTo>
                    <a:pt x="24578" y="9621"/>
                    <a:pt x="21674" y="11476"/>
                    <a:pt x="18963" y="1304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50" name="자유형: 도형 391"/>
            <p:cNvSpPr/>
            <p:nvPr/>
          </p:nvSpPr>
          <p:spPr>
            <a:xfrm>
              <a:off x="6381000" y="2568600"/>
              <a:ext cx="114120" cy="211680"/>
            </a:xfrm>
            <a:custGeom>
              <a:avLst/>
              <a:gdLst/>
              <a:ahLst/>
              <a:cxnLst/>
              <a:rect l="l" t="t" r="r" b="b"/>
              <a:pathLst>
                <a:path w="90487" h="172643">
                  <a:moveTo>
                    <a:pt x="47469" y="71625"/>
                  </a:moveTo>
                  <a:cubicBezTo>
                    <a:pt x="40327" y="73166"/>
                    <a:pt x="31902" y="71028"/>
                    <a:pt x="25346" y="74235"/>
                  </a:cubicBezTo>
                  <a:lnTo>
                    <a:pt x="25588" y="79454"/>
                  </a:lnTo>
                  <a:cubicBezTo>
                    <a:pt x="34890" y="87723"/>
                    <a:pt x="51071" y="80932"/>
                    <a:pt x="61321" y="85742"/>
                  </a:cubicBezTo>
                  <a:lnTo>
                    <a:pt x="63268" y="89924"/>
                  </a:lnTo>
                  <a:cubicBezTo>
                    <a:pt x="60048" y="91999"/>
                    <a:pt x="52909" y="92848"/>
                    <a:pt x="48925" y="93571"/>
                  </a:cubicBezTo>
                  <a:lnTo>
                    <a:pt x="47469" y="97501"/>
                  </a:lnTo>
                  <a:cubicBezTo>
                    <a:pt x="50335" y="99231"/>
                    <a:pt x="56024" y="100142"/>
                    <a:pt x="59381" y="99325"/>
                  </a:cubicBezTo>
                  <a:lnTo>
                    <a:pt x="63026" y="102469"/>
                  </a:lnTo>
                  <a:lnTo>
                    <a:pt x="61808" y="107437"/>
                  </a:lnTo>
                  <a:cubicBezTo>
                    <a:pt x="58690" y="108160"/>
                    <a:pt x="55158" y="109638"/>
                    <a:pt x="52573" y="111367"/>
                  </a:cubicBezTo>
                  <a:lnTo>
                    <a:pt x="50626" y="116586"/>
                  </a:lnTo>
                  <a:cubicBezTo>
                    <a:pt x="51748" y="119039"/>
                    <a:pt x="53937" y="120674"/>
                    <a:pt x="56217" y="122151"/>
                  </a:cubicBezTo>
                  <a:cubicBezTo>
                    <a:pt x="59518" y="124321"/>
                    <a:pt x="63597" y="126301"/>
                    <a:pt x="66670" y="128597"/>
                  </a:cubicBezTo>
                  <a:cubicBezTo>
                    <a:pt x="74152" y="134225"/>
                    <a:pt x="73352" y="143217"/>
                    <a:pt x="73717" y="151109"/>
                  </a:cubicBezTo>
                  <a:cubicBezTo>
                    <a:pt x="78179" y="156391"/>
                    <a:pt x="86183" y="157271"/>
                    <a:pt x="90487" y="162333"/>
                  </a:cubicBezTo>
                  <a:cubicBezTo>
                    <a:pt x="90228" y="165194"/>
                    <a:pt x="88369" y="170288"/>
                    <a:pt x="85871" y="172269"/>
                  </a:cubicBezTo>
                  <a:cubicBezTo>
                    <a:pt x="77905" y="173998"/>
                    <a:pt x="70777" y="169439"/>
                    <a:pt x="65456" y="164692"/>
                  </a:cubicBezTo>
                  <a:lnTo>
                    <a:pt x="64727" y="160258"/>
                  </a:lnTo>
                  <a:lnTo>
                    <a:pt x="58651" y="160258"/>
                  </a:lnTo>
                  <a:cubicBezTo>
                    <a:pt x="53955" y="161956"/>
                    <a:pt x="51327" y="166641"/>
                    <a:pt x="47711" y="169659"/>
                  </a:cubicBezTo>
                  <a:cubicBezTo>
                    <a:pt x="42200" y="169722"/>
                    <a:pt x="37377" y="166075"/>
                    <a:pt x="33859" y="162585"/>
                  </a:cubicBezTo>
                  <a:lnTo>
                    <a:pt x="34347" y="158152"/>
                  </a:lnTo>
                  <a:cubicBezTo>
                    <a:pt x="36332" y="155165"/>
                    <a:pt x="39328" y="153435"/>
                    <a:pt x="41152" y="151109"/>
                  </a:cubicBezTo>
                  <a:cubicBezTo>
                    <a:pt x="44137" y="147241"/>
                    <a:pt x="44996" y="140922"/>
                    <a:pt x="43579" y="136457"/>
                  </a:cubicBezTo>
                  <a:lnTo>
                    <a:pt x="38233" y="134099"/>
                  </a:lnTo>
                  <a:cubicBezTo>
                    <a:pt x="33537" y="136614"/>
                    <a:pt x="31997" y="141519"/>
                    <a:pt x="27296" y="144034"/>
                  </a:cubicBezTo>
                  <a:cubicBezTo>
                    <a:pt x="21873" y="143469"/>
                    <a:pt x="15798" y="145135"/>
                    <a:pt x="11256" y="141676"/>
                  </a:cubicBezTo>
                  <a:lnTo>
                    <a:pt x="9067" y="137495"/>
                  </a:lnTo>
                  <a:cubicBezTo>
                    <a:pt x="9803" y="133030"/>
                    <a:pt x="12799" y="126270"/>
                    <a:pt x="16601" y="123126"/>
                  </a:cubicBezTo>
                  <a:cubicBezTo>
                    <a:pt x="17801" y="122120"/>
                    <a:pt x="19657" y="121428"/>
                    <a:pt x="20975" y="120516"/>
                  </a:cubicBezTo>
                  <a:cubicBezTo>
                    <a:pt x="24950" y="117781"/>
                    <a:pt x="28847" y="113725"/>
                    <a:pt x="28998" y="109009"/>
                  </a:cubicBezTo>
                  <a:lnTo>
                    <a:pt x="23652" y="106399"/>
                  </a:lnTo>
                  <a:cubicBezTo>
                    <a:pt x="18608" y="107374"/>
                    <a:pt x="15275" y="111367"/>
                    <a:pt x="11498" y="114228"/>
                  </a:cubicBezTo>
                  <a:lnTo>
                    <a:pt x="6148" y="112153"/>
                  </a:lnTo>
                  <a:lnTo>
                    <a:pt x="5910" y="106902"/>
                  </a:lnTo>
                  <a:cubicBezTo>
                    <a:pt x="7899" y="104261"/>
                    <a:pt x="9958" y="100111"/>
                    <a:pt x="10526" y="96967"/>
                  </a:cubicBezTo>
                  <a:cubicBezTo>
                    <a:pt x="10758" y="95678"/>
                    <a:pt x="9018" y="78416"/>
                    <a:pt x="8825" y="76844"/>
                  </a:cubicBezTo>
                  <a:cubicBezTo>
                    <a:pt x="8428" y="73669"/>
                    <a:pt x="8898" y="70116"/>
                    <a:pt x="8825" y="66909"/>
                  </a:cubicBezTo>
                  <a:cubicBezTo>
                    <a:pt x="8688" y="61155"/>
                    <a:pt x="7239" y="53358"/>
                    <a:pt x="5422" y="47824"/>
                  </a:cubicBezTo>
                  <a:cubicBezTo>
                    <a:pt x="4956" y="46409"/>
                    <a:pt x="3942" y="45057"/>
                    <a:pt x="3476" y="43642"/>
                  </a:cubicBezTo>
                  <a:cubicBezTo>
                    <a:pt x="2367" y="40247"/>
                    <a:pt x="-492" y="27670"/>
                    <a:pt x="73" y="24557"/>
                  </a:cubicBezTo>
                  <a:cubicBezTo>
                    <a:pt x="1006" y="19401"/>
                    <a:pt x="9498" y="7453"/>
                    <a:pt x="14170" y="4152"/>
                  </a:cubicBezTo>
                  <a:cubicBezTo>
                    <a:pt x="16503" y="2517"/>
                    <a:pt x="20235" y="725"/>
                    <a:pt x="23164" y="253"/>
                  </a:cubicBezTo>
                  <a:cubicBezTo>
                    <a:pt x="29888" y="-879"/>
                    <a:pt x="36062" y="2171"/>
                    <a:pt x="42849" y="1825"/>
                  </a:cubicBezTo>
                  <a:cubicBezTo>
                    <a:pt x="44540" y="4183"/>
                    <a:pt x="44838" y="8900"/>
                    <a:pt x="43821" y="11478"/>
                  </a:cubicBezTo>
                  <a:lnTo>
                    <a:pt x="40176" y="14874"/>
                  </a:lnTo>
                  <a:cubicBezTo>
                    <a:pt x="34999" y="13521"/>
                    <a:pt x="28559" y="9623"/>
                    <a:pt x="23161" y="11478"/>
                  </a:cubicBezTo>
                  <a:cubicBezTo>
                    <a:pt x="21154" y="14150"/>
                    <a:pt x="19877" y="18489"/>
                    <a:pt x="20000" y="21696"/>
                  </a:cubicBezTo>
                  <a:cubicBezTo>
                    <a:pt x="24827" y="29934"/>
                    <a:pt x="29787" y="29745"/>
                    <a:pt x="38959" y="32386"/>
                  </a:cubicBezTo>
                  <a:cubicBezTo>
                    <a:pt x="40429" y="35279"/>
                    <a:pt x="44003" y="45969"/>
                    <a:pt x="44793" y="48610"/>
                  </a:cubicBezTo>
                  <a:cubicBezTo>
                    <a:pt x="45287" y="50245"/>
                    <a:pt x="48963" y="66437"/>
                    <a:pt x="48925" y="67160"/>
                  </a:cubicBezTo>
                  <a:cubicBezTo>
                    <a:pt x="48911" y="67443"/>
                    <a:pt x="47630" y="71122"/>
                    <a:pt x="47469" y="7162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51" name="자유형: 도형 392"/>
            <p:cNvSpPr/>
            <p:nvPr/>
          </p:nvSpPr>
          <p:spPr>
            <a:xfrm>
              <a:off x="6400800" y="2849040"/>
              <a:ext cx="30240" cy="24120"/>
            </a:xfrm>
            <a:custGeom>
              <a:avLst/>
              <a:gdLst/>
              <a:ahLst/>
              <a:cxnLst/>
              <a:rect l="l" t="t" r="r" b="b"/>
              <a:pathLst>
                <a:path w="24338" h="19850">
                  <a:moveTo>
                    <a:pt x="19696" y="17010"/>
                  </a:moveTo>
                  <a:lnTo>
                    <a:pt x="15557" y="19619"/>
                  </a:lnTo>
                  <a:cubicBezTo>
                    <a:pt x="10137" y="20751"/>
                    <a:pt x="4139" y="17513"/>
                    <a:pt x="0" y="14652"/>
                  </a:cubicBezTo>
                  <a:cubicBezTo>
                    <a:pt x="779" y="12011"/>
                    <a:pt x="3476" y="8269"/>
                    <a:pt x="6075" y="6791"/>
                  </a:cubicBezTo>
                  <a:cubicBezTo>
                    <a:pt x="9499" y="6572"/>
                    <a:pt x="13385" y="5691"/>
                    <a:pt x="16525" y="4465"/>
                  </a:cubicBezTo>
                  <a:lnTo>
                    <a:pt x="19443" y="535"/>
                  </a:lnTo>
                  <a:lnTo>
                    <a:pt x="24059" y="0"/>
                  </a:lnTo>
                  <a:cubicBezTo>
                    <a:pt x="24771" y="3521"/>
                    <a:pt x="24031" y="7860"/>
                    <a:pt x="22842" y="11256"/>
                  </a:cubicBezTo>
                  <a:cubicBezTo>
                    <a:pt x="22439" y="12420"/>
                    <a:pt x="20380" y="15218"/>
                    <a:pt x="19696" y="1701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52" name="자유형: 도형 393"/>
            <p:cNvSpPr/>
            <p:nvPr/>
          </p:nvSpPr>
          <p:spPr>
            <a:xfrm>
              <a:off x="6454080" y="2810880"/>
              <a:ext cx="65520" cy="28800"/>
            </a:xfrm>
            <a:custGeom>
              <a:avLst/>
              <a:gdLst/>
              <a:ahLst/>
              <a:cxnLst/>
              <a:rect l="l" t="t" r="r" b="b"/>
              <a:pathLst>
                <a:path w="52260" h="23705">
                  <a:moveTo>
                    <a:pt x="42275" y="10722"/>
                  </a:moveTo>
                  <a:cubicBezTo>
                    <a:pt x="45172" y="11508"/>
                    <a:pt x="49346" y="13866"/>
                    <a:pt x="51044" y="16192"/>
                  </a:cubicBezTo>
                  <a:lnTo>
                    <a:pt x="52261" y="20909"/>
                  </a:lnTo>
                  <a:lnTo>
                    <a:pt x="47887" y="23518"/>
                  </a:lnTo>
                  <a:cubicBezTo>
                    <a:pt x="39672" y="24776"/>
                    <a:pt x="32197" y="19337"/>
                    <a:pt x="24554" y="17513"/>
                  </a:cubicBezTo>
                  <a:cubicBezTo>
                    <a:pt x="24084" y="17387"/>
                    <a:pt x="17728" y="16192"/>
                    <a:pt x="17503" y="16192"/>
                  </a:cubicBezTo>
                  <a:cubicBezTo>
                    <a:pt x="13129" y="16192"/>
                    <a:pt x="11291" y="18047"/>
                    <a:pt x="5591" y="16444"/>
                  </a:cubicBezTo>
                  <a:cubicBezTo>
                    <a:pt x="3181" y="15092"/>
                    <a:pt x="537" y="11634"/>
                    <a:pt x="0" y="9118"/>
                  </a:cubicBezTo>
                  <a:cubicBezTo>
                    <a:pt x="98" y="5942"/>
                    <a:pt x="3915" y="126"/>
                    <a:pt x="8022" y="252"/>
                  </a:cubicBezTo>
                  <a:cubicBezTo>
                    <a:pt x="11379" y="1101"/>
                    <a:pt x="15416" y="2515"/>
                    <a:pt x="18230" y="4433"/>
                  </a:cubicBezTo>
                  <a:cubicBezTo>
                    <a:pt x="23547" y="4150"/>
                    <a:pt x="26869" y="661"/>
                    <a:pt x="31839" y="0"/>
                  </a:cubicBezTo>
                  <a:lnTo>
                    <a:pt x="36704" y="1289"/>
                  </a:lnTo>
                  <a:cubicBezTo>
                    <a:pt x="38865" y="4245"/>
                    <a:pt x="41531" y="7169"/>
                    <a:pt x="42275" y="1072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53" name="자유형: 도형 394"/>
            <p:cNvSpPr/>
            <p:nvPr/>
          </p:nvSpPr>
          <p:spPr>
            <a:xfrm>
              <a:off x="6309720" y="2890080"/>
              <a:ext cx="18000" cy="18360"/>
            </a:xfrm>
            <a:custGeom>
              <a:avLst/>
              <a:gdLst/>
              <a:ahLst/>
              <a:cxnLst/>
              <a:rect l="l" t="t" r="r" b="b"/>
              <a:pathLst>
                <a:path w="14621" h="15154">
                  <a:moveTo>
                    <a:pt x="9756" y="13582"/>
                  </a:moveTo>
                  <a:lnTo>
                    <a:pt x="4895" y="15155"/>
                  </a:lnTo>
                  <a:lnTo>
                    <a:pt x="278" y="13582"/>
                  </a:lnTo>
                  <a:cubicBezTo>
                    <a:pt x="-434" y="10187"/>
                    <a:pt x="310" y="5628"/>
                    <a:pt x="1496" y="2358"/>
                  </a:cubicBezTo>
                  <a:lnTo>
                    <a:pt x="5628" y="0"/>
                  </a:lnTo>
                  <a:lnTo>
                    <a:pt x="11703" y="0"/>
                  </a:lnTo>
                  <a:cubicBezTo>
                    <a:pt x="12994" y="2704"/>
                    <a:pt x="14011" y="5754"/>
                    <a:pt x="14621" y="8646"/>
                  </a:cubicBezTo>
                  <a:lnTo>
                    <a:pt x="14134" y="7860"/>
                  </a:lnTo>
                  <a:cubicBezTo>
                    <a:pt x="13608" y="9527"/>
                    <a:pt x="11008" y="12356"/>
                    <a:pt x="9756" y="1358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54" name="자유형: 도형 395"/>
            <p:cNvSpPr/>
            <p:nvPr/>
          </p:nvSpPr>
          <p:spPr>
            <a:xfrm>
              <a:off x="6114960" y="2971800"/>
              <a:ext cx="28800" cy="17640"/>
            </a:xfrm>
            <a:custGeom>
              <a:avLst/>
              <a:gdLst/>
              <a:ahLst/>
              <a:cxnLst/>
              <a:rect l="l" t="t" r="r" b="b"/>
              <a:pathLst>
                <a:path w="23087" h="14697">
                  <a:moveTo>
                    <a:pt x="21870" y="1650"/>
                  </a:moveTo>
                  <a:lnTo>
                    <a:pt x="23088" y="6334"/>
                  </a:lnTo>
                  <a:lnTo>
                    <a:pt x="19927" y="9227"/>
                  </a:lnTo>
                  <a:cubicBezTo>
                    <a:pt x="16960" y="8755"/>
                    <a:pt x="12077" y="9321"/>
                    <a:pt x="9478" y="10799"/>
                  </a:cubicBezTo>
                  <a:lnTo>
                    <a:pt x="6321" y="14698"/>
                  </a:lnTo>
                  <a:lnTo>
                    <a:pt x="1214" y="14195"/>
                  </a:lnTo>
                  <a:lnTo>
                    <a:pt x="0" y="9730"/>
                  </a:lnTo>
                  <a:cubicBezTo>
                    <a:pt x="2312" y="3002"/>
                    <a:pt x="9379" y="-583"/>
                    <a:pt x="17016" y="78"/>
                  </a:cubicBezTo>
                  <a:cubicBezTo>
                    <a:pt x="18289" y="895"/>
                    <a:pt x="20306" y="1524"/>
                    <a:pt x="21870" y="165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55" name="자유형: 도형 396"/>
            <p:cNvSpPr/>
            <p:nvPr/>
          </p:nvSpPr>
          <p:spPr>
            <a:xfrm>
              <a:off x="6014880" y="3092040"/>
              <a:ext cx="29160" cy="16200"/>
            </a:xfrm>
            <a:custGeom>
              <a:avLst/>
              <a:gdLst/>
              <a:ahLst/>
              <a:cxnLst/>
              <a:rect l="l" t="t" r="r" b="b"/>
              <a:pathLst>
                <a:path w="23336" h="13582">
                  <a:moveTo>
                    <a:pt x="23337" y="5754"/>
                  </a:moveTo>
                  <a:lnTo>
                    <a:pt x="22849" y="9936"/>
                  </a:lnTo>
                  <a:cubicBezTo>
                    <a:pt x="20685" y="11822"/>
                    <a:pt x="16153" y="13488"/>
                    <a:pt x="13129" y="13583"/>
                  </a:cubicBezTo>
                  <a:cubicBezTo>
                    <a:pt x="10635" y="11634"/>
                    <a:pt x="5139" y="10564"/>
                    <a:pt x="1947" y="11225"/>
                  </a:cubicBezTo>
                  <a:lnTo>
                    <a:pt x="0" y="7043"/>
                  </a:lnTo>
                  <a:cubicBezTo>
                    <a:pt x="975" y="4528"/>
                    <a:pt x="4227" y="1038"/>
                    <a:pt x="7050" y="0"/>
                  </a:cubicBezTo>
                  <a:lnTo>
                    <a:pt x="11912" y="1541"/>
                  </a:lnTo>
                  <a:cubicBezTo>
                    <a:pt x="15395" y="1886"/>
                    <a:pt x="20706" y="3553"/>
                    <a:pt x="23337" y="5754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56" name="자유형: 도형 397"/>
            <p:cNvSpPr/>
            <p:nvPr/>
          </p:nvSpPr>
          <p:spPr>
            <a:xfrm>
              <a:off x="6627960" y="3255120"/>
              <a:ext cx="24120" cy="16200"/>
            </a:xfrm>
            <a:custGeom>
              <a:avLst/>
              <a:gdLst/>
              <a:ahLst/>
              <a:cxnLst/>
              <a:rect l="l" t="t" r="r" b="b"/>
              <a:pathLst>
                <a:path w="19446" h="13585">
                  <a:moveTo>
                    <a:pt x="13126" y="254"/>
                  </a:moveTo>
                  <a:cubicBezTo>
                    <a:pt x="15557" y="1921"/>
                    <a:pt x="18065" y="4593"/>
                    <a:pt x="19447" y="7046"/>
                  </a:cubicBezTo>
                  <a:lnTo>
                    <a:pt x="17987" y="12013"/>
                  </a:lnTo>
                  <a:lnTo>
                    <a:pt x="13126" y="13585"/>
                  </a:lnTo>
                  <a:cubicBezTo>
                    <a:pt x="9176" y="13177"/>
                    <a:pt x="4444" y="11982"/>
                    <a:pt x="972" y="10190"/>
                  </a:cubicBezTo>
                  <a:lnTo>
                    <a:pt x="0" y="5474"/>
                  </a:lnTo>
                  <a:lnTo>
                    <a:pt x="3381" y="1575"/>
                  </a:lnTo>
                  <a:cubicBezTo>
                    <a:pt x="5784" y="286"/>
                    <a:pt x="10386" y="-406"/>
                    <a:pt x="13126" y="254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57" name="자유형: 도형 398"/>
            <p:cNvSpPr/>
            <p:nvPr/>
          </p:nvSpPr>
          <p:spPr>
            <a:xfrm>
              <a:off x="6697080" y="3447360"/>
              <a:ext cx="19440" cy="18720"/>
            </a:xfrm>
            <a:custGeom>
              <a:avLst/>
              <a:gdLst/>
              <a:ahLst/>
              <a:cxnLst/>
              <a:rect l="l" t="t" r="r" b="b"/>
              <a:pathLst>
                <a:path w="15556" h="15405">
                  <a:moveTo>
                    <a:pt x="9723" y="251"/>
                  </a:moveTo>
                  <a:cubicBezTo>
                    <a:pt x="12024" y="1698"/>
                    <a:pt x="14304" y="4276"/>
                    <a:pt x="15557" y="6539"/>
                  </a:cubicBezTo>
                  <a:lnTo>
                    <a:pt x="14827" y="12010"/>
                  </a:lnTo>
                  <a:cubicBezTo>
                    <a:pt x="12694" y="13771"/>
                    <a:pt x="8464" y="15249"/>
                    <a:pt x="5591" y="15406"/>
                  </a:cubicBezTo>
                  <a:cubicBezTo>
                    <a:pt x="3248" y="14054"/>
                    <a:pt x="403" y="10627"/>
                    <a:pt x="0" y="8080"/>
                  </a:cubicBezTo>
                  <a:lnTo>
                    <a:pt x="1214" y="3113"/>
                  </a:lnTo>
                  <a:lnTo>
                    <a:pt x="5570" y="0"/>
                  </a:lnTo>
                  <a:lnTo>
                    <a:pt x="9723" y="251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58" name="자유형: 도형 399"/>
            <p:cNvSpPr/>
            <p:nvPr/>
          </p:nvSpPr>
          <p:spPr>
            <a:xfrm>
              <a:off x="6515280" y="3402360"/>
              <a:ext cx="35280" cy="33120"/>
            </a:xfrm>
            <a:custGeom>
              <a:avLst/>
              <a:gdLst/>
              <a:ahLst/>
              <a:cxnLst/>
              <a:rect l="l" t="t" r="r" b="b"/>
              <a:pathLst>
                <a:path w="28104" h="27197">
                  <a:moveTo>
                    <a:pt x="26490" y="11791"/>
                  </a:moveTo>
                  <a:cubicBezTo>
                    <a:pt x="27805" y="13646"/>
                    <a:pt x="28640" y="17482"/>
                    <a:pt x="27707" y="19619"/>
                  </a:cubicBezTo>
                  <a:lnTo>
                    <a:pt x="22846" y="21443"/>
                  </a:lnTo>
                  <a:cubicBezTo>
                    <a:pt x="19959" y="19871"/>
                    <a:pt x="16949" y="17545"/>
                    <a:pt x="14824" y="15186"/>
                  </a:cubicBezTo>
                  <a:lnTo>
                    <a:pt x="10937" y="18331"/>
                  </a:lnTo>
                  <a:lnTo>
                    <a:pt x="10449" y="24053"/>
                  </a:lnTo>
                  <a:lnTo>
                    <a:pt x="8022" y="27197"/>
                  </a:lnTo>
                  <a:lnTo>
                    <a:pt x="2673" y="25122"/>
                  </a:lnTo>
                  <a:lnTo>
                    <a:pt x="0" y="21443"/>
                  </a:lnTo>
                  <a:cubicBezTo>
                    <a:pt x="1617" y="14180"/>
                    <a:pt x="-929" y="6477"/>
                    <a:pt x="4616" y="0"/>
                  </a:cubicBezTo>
                  <a:lnTo>
                    <a:pt x="10449" y="1069"/>
                  </a:lnTo>
                  <a:cubicBezTo>
                    <a:pt x="13855" y="4811"/>
                    <a:pt x="18847" y="8081"/>
                    <a:pt x="24305" y="8646"/>
                  </a:cubicBezTo>
                  <a:lnTo>
                    <a:pt x="26490" y="11791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59" name="자유형: 도형 400"/>
            <p:cNvSpPr/>
            <p:nvPr/>
          </p:nvSpPr>
          <p:spPr>
            <a:xfrm>
              <a:off x="6319080" y="3645000"/>
              <a:ext cx="59040" cy="48600"/>
            </a:xfrm>
            <a:custGeom>
              <a:avLst/>
              <a:gdLst/>
              <a:ahLst/>
              <a:cxnLst/>
              <a:rect l="l" t="t" r="r" b="b"/>
              <a:pathLst>
                <a:path w="46908" h="39741">
                  <a:moveTo>
                    <a:pt x="46909" y="5502"/>
                  </a:moveTo>
                  <a:cubicBezTo>
                    <a:pt x="42394" y="12577"/>
                    <a:pt x="37662" y="12828"/>
                    <a:pt x="31594" y="17009"/>
                  </a:cubicBezTo>
                  <a:cubicBezTo>
                    <a:pt x="27420" y="19840"/>
                    <a:pt x="24428" y="23770"/>
                    <a:pt x="21145" y="27196"/>
                  </a:cubicBezTo>
                  <a:cubicBezTo>
                    <a:pt x="20057" y="28297"/>
                    <a:pt x="18584" y="29209"/>
                    <a:pt x="17500" y="30341"/>
                  </a:cubicBezTo>
                  <a:cubicBezTo>
                    <a:pt x="16343" y="31536"/>
                    <a:pt x="15519" y="33076"/>
                    <a:pt x="14340" y="34239"/>
                  </a:cubicBezTo>
                  <a:cubicBezTo>
                    <a:pt x="12211" y="36378"/>
                    <a:pt x="8966" y="38516"/>
                    <a:pt x="6079" y="39742"/>
                  </a:cubicBezTo>
                  <a:cubicBezTo>
                    <a:pt x="4606" y="37415"/>
                    <a:pt x="2081" y="34806"/>
                    <a:pt x="972" y="32416"/>
                  </a:cubicBezTo>
                  <a:cubicBezTo>
                    <a:pt x="-582" y="29083"/>
                    <a:pt x="-17" y="26883"/>
                    <a:pt x="895" y="23518"/>
                  </a:cubicBezTo>
                  <a:cubicBezTo>
                    <a:pt x="4136" y="11570"/>
                    <a:pt x="16245" y="6823"/>
                    <a:pt x="26985" y="1038"/>
                  </a:cubicBezTo>
                  <a:cubicBezTo>
                    <a:pt x="31457" y="2955"/>
                    <a:pt x="37849" y="3521"/>
                    <a:pt x="41570" y="0"/>
                  </a:cubicBezTo>
                  <a:lnTo>
                    <a:pt x="46418" y="1541"/>
                  </a:lnTo>
                  <a:lnTo>
                    <a:pt x="46909" y="5502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60" name="자유형: 도형 401"/>
            <p:cNvSpPr/>
            <p:nvPr/>
          </p:nvSpPr>
          <p:spPr>
            <a:xfrm>
              <a:off x="6191640" y="3999240"/>
              <a:ext cx="17640" cy="22680"/>
            </a:xfrm>
            <a:custGeom>
              <a:avLst/>
              <a:gdLst/>
              <a:ahLst/>
              <a:cxnLst/>
              <a:rect l="l" t="t" r="r" b="b"/>
              <a:pathLst>
                <a:path w="14355" h="18833">
                  <a:moveTo>
                    <a:pt x="14150" y="15689"/>
                  </a:moveTo>
                  <a:lnTo>
                    <a:pt x="10505" y="18833"/>
                  </a:lnTo>
                  <a:lnTo>
                    <a:pt x="4672" y="18833"/>
                  </a:lnTo>
                  <a:lnTo>
                    <a:pt x="52" y="16223"/>
                  </a:lnTo>
                  <a:cubicBezTo>
                    <a:pt x="-106" y="12671"/>
                    <a:pt x="105" y="8993"/>
                    <a:pt x="540" y="5502"/>
                  </a:cubicBezTo>
                  <a:lnTo>
                    <a:pt x="3700" y="1572"/>
                  </a:lnTo>
                  <a:lnTo>
                    <a:pt x="8562" y="0"/>
                  </a:lnTo>
                  <a:cubicBezTo>
                    <a:pt x="9947" y="975"/>
                    <a:pt x="12659" y="3553"/>
                    <a:pt x="12936" y="5219"/>
                  </a:cubicBezTo>
                  <a:cubicBezTo>
                    <a:pt x="12932" y="5219"/>
                    <a:pt x="15002" y="12923"/>
                    <a:pt x="14150" y="1568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61" name="자유형: 도형 402"/>
            <p:cNvSpPr/>
            <p:nvPr/>
          </p:nvSpPr>
          <p:spPr>
            <a:xfrm>
              <a:off x="6060600" y="3925440"/>
              <a:ext cx="20520" cy="29520"/>
            </a:xfrm>
            <a:custGeom>
              <a:avLst/>
              <a:gdLst/>
              <a:ahLst/>
              <a:cxnLst/>
              <a:rect l="l" t="t" r="r" b="b"/>
              <a:pathLst>
                <a:path w="16635" h="24335">
                  <a:moveTo>
                    <a:pt x="16027" y="20940"/>
                  </a:moveTo>
                  <a:lnTo>
                    <a:pt x="12383" y="24052"/>
                  </a:lnTo>
                  <a:lnTo>
                    <a:pt x="6549" y="24336"/>
                  </a:lnTo>
                  <a:cubicBezTo>
                    <a:pt x="-84" y="20248"/>
                    <a:pt x="-1785" y="7860"/>
                    <a:pt x="1933" y="1855"/>
                  </a:cubicBezTo>
                  <a:lnTo>
                    <a:pt x="6549" y="0"/>
                  </a:lnTo>
                  <a:lnTo>
                    <a:pt x="11895" y="2106"/>
                  </a:lnTo>
                  <a:cubicBezTo>
                    <a:pt x="14529" y="7923"/>
                    <a:pt x="18069" y="14557"/>
                    <a:pt x="16027" y="2094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62" name="자유형: 도형 403"/>
            <p:cNvSpPr/>
            <p:nvPr/>
          </p:nvSpPr>
          <p:spPr>
            <a:xfrm>
              <a:off x="6381720" y="4077000"/>
              <a:ext cx="19440" cy="17280"/>
            </a:xfrm>
            <a:custGeom>
              <a:avLst/>
              <a:gdLst/>
              <a:ahLst/>
              <a:cxnLst/>
              <a:rect l="l" t="t" r="r" b="b"/>
              <a:pathLst>
                <a:path w="15816" h="14241">
                  <a:moveTo>
                    <a:pt x="3641" y="12908"/>
                  </a:moveTo>
                  <a:lnTo>
                    <a:pt x="0" y="9513"/>
                  </a:lnTo>
                  <a:lnTo>
                    <a:pt x="0" y="4545"/>
                  </a:lnTo>
                  <a:lnTo>
                    <a:pt x="3157" y="615"/>
                  </a:lnTo>
                  <a:cubicBezTo>
                    <a:pt x="5714" y="-360"/>
                    <a:pt x="10485" y="-171"/>
                    <a:pt x="12877" y="1149"/>
                  </a:cubicBezTo>
                  <a:lnTo>
                    <a:pt x="15795" y="4797"/>
                  </a:lnTo>
                  <a:cubicBezTo>
                    <a:pt x="15992" y="7469"/>
                    <a:pt x="14845" y="12217"/>
                    <a:pt x="12635" y="14198"/>
                  </a:cubicBezTo>
                  <a:cubicBezTo>
                    <a:pt x="10846" y="14480"/>
                    <a:pt x="5416" y="13317"/>
                    <a:pt x="3641" y="1290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63" name="자유형: 도형 404"/>
            <p:cNvSpPr/>
            <p:nvPr/>
          </p:nvSpPr>
          <p:spPr>
            <a:xfrm>
              <a:off x="6099840" y="4152600"/>
              <a:ext cx="110880" cy="109080"/>
            </a:xfrm>
            <a:custGeom>
              <a:avLst/>
              <a:gdLst/>
              <a:ahLst/>
              <a:cxnLst/>
              <a:rect l="l" t="t" r="r" b="b"/>
              <a:pathLst>
                <a:path w="87990" h="89221">
                  <a:moveTo>
                    <a:pt x="58094" y="46340"/>
                  </a:moveTo>
                  <a:cubicBezTo>
                    <a:pt x="62956" y="48918"/>
                    <a:pt x="68708" y="50522"/>
                    <a:pt x="72921" y="53918"/>
                  </a:cubicBezTo>
                  <a:lnTo>
                    <a:pt x="73167" y="58886"/>
                  </a:lnTo>
                  <a:cubicBezTo>
                    <a:pt x="69557" y="62564"/>
                    <a:pt x="63008" y="60803"/>
                    <a:pt x="58336" y="63098"/>
                  </a:cubicBezTo>
                  <a:cubicBezTo>
                    <a:pt x="53440" y="67437"/>
                    <a:pt x="54776" y="73882"/>
                    <a:pt x="52503" y="79039"/>
                  </a:cubicBezTo>
                  <a:cubicBezTo>
                    <a:pt x="50356" y="83913"/>
                    <a:pt x="44723" y="84604"/>
                    <a:pt x="41321" y="88440"/>
                  </a:cubicBezTo>
                  <a:cubicBezTo>
                    <a:pt x="35277" y="91238"/>
                    <a:pt x="21369" y="86051"/>
                    <a:pt x="18959" y="80328"/>
                  </a:cubicBezTo>
                  <a:cubicBezTo>
                    <a:pt x="16248" y="79605"/>
                    <a:pt x="11488" y="80359"/>
                    <a:pt x="9236" y="81900"/>
                  </a:cubicBezTo>
                  <a:lnTo>
                    <a:pt x="2673" y="81114"/>
                  </a:lnTo>
                  <a:lnTo>
                    <a:pt x="0" y="77467"/>
                  </a:lnTo>
                  <a:cubicBezTo>
                    <a:pt x="1701" y="75203"/>
                    <a:pt x="3132" y="72468"/>
                    <a:pt x="4132" y="69890"/>
                  </a:cubicBezTo>
                  <a:cubicBezTo>
                    <a:pt x="1161" y="65802"/>
                    <a:pt x="1094" y="53823"/>
                    <a:pt x="3160" y="49484"/>
                  </a:cubicBezTo>
                  <a:cubicBezTo>
                    <a:pt x="3739" y="48289"/>
                    <a:pt x="8699" y="43510"/>
                    <a:pt x="9965" y="42441"/>
                  </a:cubicBezTo>
                  <a:cubicBezTo>
                    <a:pt x="18854" y="41404"/>
                    <a:pt x="29233" y="35335"/>
                    <a:pt x="35003" y="29362"/>
                  </a:cubicBezTo>
                  <a:cubicBezTo>
                    <a:pt x="36094" y="28230"/>
                    <a:pt x="36831" y="26815"/>
                    <a:pt x="37918" y="25683"/>
                  </a:cubicBezTo>
                  <a:cubicBezTo>
                    <a:pt x="40770" y="22759"/>
                    <a:pt x="44372" y="20150"/>
                    <a:pt x="47399" y="17351"/>
                  </a:cubicBezTo>
                  <a:cubicBezTo>
                    <a:pt x="48501" y="16314"/>
                    <a:pt x="49592" y="14836"/>
                    <a:pt x="50802" y="13924"/>
                  </a:cubicBezTo>
                  <a:cubicBezTo>
                    <a:pt x="52054" y="13012"/>
                    <a:pt x="53850" y="12447"/>
                    <a:pt x="55176" y="11598"/>
                  </a:cubicBezTo>
                  <a:cubicBezTo>
                    <a:pt x="62395" y="6881"/>
                    <a:pt x="63002" y="5309"/>
                    <a:pt x="71950" y="2165"/>
                  </a:cubicBezTo>
                  <a:cubicBezTo>
                    <a:pt x="75570" y="907"/>
                    <a:pt x="78579" y="-350"/>
                    <a:pt x="82645" y="90"/>
                  </a:cubicBezTo>
                  <a:lnTo>
                    <a:pt x="87990" y="2699"/>
                  </a:lnTo>
                  <a:cubicBezTo>
                    <a:pt x="84083" y="5246"/>
                    <a:pt x="81340" y="9019"/>
                    <a:pt x="77530" y="11566"/>
                  </a:cubicBezTo>
                  <a:cubicBezTo>
                    <a:pt x="73725" y="14144"/>
                    <a:pt x="67793" y="14961"/>
                    <a:pt x="64415" y="17854"/>
                  </a:cubicBezTo>
                  <a:cubicBezTo>
                    <a:pt x="61009" y="20778"/>
                    <a:pt x="55365" y="33638"/>
                    <a:pt x="55176" y="37725"/>
                  </a:cubicBezTo>
                  <a:cubicBezTo>
                    <a:pt x="55113" y="39109"/>
                    <a:pt x="57312" y="44894"/>
                    <a:pt x="58094" y="4634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64" name="자유형: 도형 405"/>
            <p:cNvSpPr/>
            <p:nvPr/>
          </p:nvSpPr>
          <p:spPr>
            <a:xfrm>
              <a:off x="6052680" y="4213440"/>
              <a:ext cx="20160" cy="20160"/>
            </a:xfrm>
            <a:custGeom>
              <a:avLst/>
              <a:gdLst/>
              <a:ahLst/>
              <a:cxnLst/>
              <a:rect l="l" t="t" r="r" b="b"/>
              <a:pathLst>
                <a:path w="16111" h="16573">
                  <a:moveTo>
                    <a:pt x="15331" y="5219"/>
                  </a:moveTo>
                  <a:cubicBezTo>
                    <a:pt x="16695" y="8049"/>
                    <a:pt x="16102" y="13174"/>
                    <a:pt x="14843" y="15941"/>
                  </a:cubicBezTo>
                  <a:cubicBezTo>
                    <a:pt x="11953" y="16884"/>
                    <a:pt x="6982" y="16758"/>
                    <a:pt x="4148" y="15658"/>
                  </a:cubicBezTo>
                  <a:cubicBezTo>
                    <a:pt x="321" y="12639"/>
                    <a:pt x="-100" y="6603"/>
                    <a:pt x="16" y="2327"/>
                  </a:cubicBezTo>
                  <a:lnTo>
                    <a:pt x="4148" y="0"/>
                  </a:lnTo>
                  <a:cubicBezTo>
                    <a:pt x="5267" y="220"/>
                    <a:pt x="8610" y="912"/>
                    <a:pt x="9739" y="786"/>
                  </a:cubicBezTo>
                  <a:cubicBezTo>
                    <a:pt x="11514" y="1383"/>
                    <a:pt x="14173" y="3962"/>
                    <a:pt x="15331" y="521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65" name="자유형: 도형 406"/>
            <p:cNvSpPr/>
            <p:nvPr/>
          </p:nvSpPr>
          <p:spPr>
            <a:xfrm>
              <a:off x="6219720" y="4200120"/>
              <a:ext cx="110520" cy="93240"/>
            </a:xfrm>
            <a:custGeom>
              <a:avLst/>
              <a:gdLst/>
              <a:ahLst/>
              <a:cxnLst/>
              <a:rect l="l" t="t" r="r" b="b"/>
              <a:pathLst>
                <a:path w="87792" h="76326">
                  <a:moveTo>
                    <a:pt x="56882" y="12042"/>
                  </a:moveTo>
                  <a:cubicBezTo>
                    <a:pt x="54311" y="19148"/>
                    <a:pt x="47215" y="20154"/>
                    <a:pt x="45457" y="29304"/>
                  </a:cubicBezTo>
                  <a:lnTo>
                    <a:pt x="47159" y="33485"/>
                  </a:lnTo>
                  <a:cubicBezTo>
                    <a:pt x="50158" y="35183"/>
                    <a:pt x="53090" y="37038"/>
                    <a:pt x="55907" y="38956"/>
                  </a:cubicBezTo>
                  <a:cubicBezTo>
                    <a:pt x="61965" y="38295"/>
                    <a:pt x="68770" y="38830"/>
                    <a:pt x="74382" y="41063"/>
                  </a:cubicBezTo>
                  <a:cubicBezTo>
                    <a:pt x="75711" y="43672"/>
                    <a:pt x="76683" y="46848"/>
                    <a:pt x="77058" y="49677"/>
                  </a:cubicBezTo>
                  <a:cubicBezTo>
                    <a:pt x="80496" y="53010"/>
                    <a:pt x="84288" y="56029"/>
                    <a:pt x="87753" y="59362"/>
                  </a:cubicBezTo>
                  <a:cubicBezTo>
                    <a:pt x="88321" y="68196"/>
                    <a:pt x="82586" y="70491"/>
                    <a:pt x="77058" y="76088"/>
                  </a:cubicBezTo>
                  <a:cubicBezTo>
                    <a:pt x="73775" y="76811"/>
                    <a:pt x="70737" y="75774"/>
                    <a:pt x="67903" y="74516"/>
                  </a:cubicBezTo>
                  <a:cubicBezTo>
                    <a:pt x="63333" y="72504"/>
                    <a:pt x="59590" y="66593"/>
                    <a:pt x="59800" y="61971"/>
                  </a:cubicBezTo>
                  <a:cubicBezTo>
                    <a:pt x="59976" y="58072"/>
                    <a:pt x="62382" y="55085"/>
                    <a:pt x="60042" y="50998"/>
                  </a:cubicBezTo>
                  <a:cubicBezTo>
                    <a:pt x="59499" y="50778"/>
                    <a:pt x="55226" y="48954"/>
                    <a:pt x="54939" y="48891"/>
                  </a:cubicBezTo>
                  <a:cubicBezTo>
                    <a:pt x="54363" y="48797"/>
                    <a:pt x="50070" y="49206"/>
                    <a:pt x="49105" y="49143"/>
                  </a:cubicBezTo>
                  <a:cubicBezTo>
                    <a:pt x="44938" y="48986"/>
                    <a:pt x="40673" y="48105"/>
                    <a:pt x="36464" y="47854"/>
                  </a:cubicBezTo>
                  <a:cubicBezTo>
                    <a:pt x="33882" y="46093"/>
                    <a:pt x="30631" y="43610"/>
                    <a:pt x="27712" y="42351"/>
                  </a:cubicBezTo>
                  <a:cubicBezTo>
                    <a:pt x="20311" y="39207"/>
                    <a:pt x="11763" y="38264"/>
                    <a:pt x="4379" y="34774"/>
                  </a:cubicBezTo>
                  <a:lnTo>
                    <a:pt x="1706" y="30844"/>
                  </a:lnTo>
                  <a:cubicBezTo>
                    <a:pt x="2222" y="27511"/>
                    <a:pt x="2369" y="23770"/>
                    <a:pt x="1945" y="20405"/>
                  </a:cubicBezTo>
                  <a:cubicBezTo>
                    <a:pt x="1762" y="18959"/>
                    <a:pt x="-58" y="11602"/>
                    <a:pt x="1" y="11004"/>
                  </a:cubicBezTo>
                  <a:cubicBezTo>
                    <a:pt x="240" y="8520"/>
                    <a:pt x="3116" y="3616"/>
                    <a:pt x="5105" y="1824"/>
                  </a:cubicBezTo>
                  <a:lnTo>
                    <a:pt x="9967" y="0"/>
                  </a:lnTo>
                  <a:cubicBezTo>
                    <a:pt x="13548" y="849"/>
                    <a:pt x="17803" y="2484"/>
                    <a:pt x="21391" y="2892"/>
                  </a:cubicBezTo>
                  <a:cubicBezTo>
                    <a:pt x="23187" y="3081"/>
                    <a:pt x="25387" y="2578"/>
                    <a:pt x="27225" y="2610"/>
                  </a:cubicBezTo>
                  <a:cubicBezTo>
                    <a:pt x="31967" y="2736"/>
                    <a:pt x="32444" y="3867"/>
                    <a:pt x="35485" y="4464"/>
                  </a:cubicBezTo>
                  <a:cubicBezTo>
                    <a:pt x="37502" y="4842"/>
                    <a:pt x="39793" y="4590"/>
                    <a:pt x="41810" y="4968"/>
                  </a:cubicBezTo>
                  <a:cubicBezTo>
                    <a:pt x="46243" y="5817"/>
                    <a:pt x="54192" y="8646"/>
                    <a:pt x="56882" y="1204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66" name="자유형: 도형 407"/>
            <p:cNvSpPr/>
            <p:nvPr/>
          </p:nvSpPr>
          <p:spPr>
            <a:xfrm>
              <a:off x="6193800" y="4256640"/>
              <a:ext cx="46800" cy="25200"/>
            </a:xfrm>
            <a:custGeom>
              <a:avLst/>
              <a:gdLst/>
              <a:ahLst/>
              <a:cxnLst/>
              <a:rect l="l" t="t" r="r" b="b"/>
              <a:pathLst>
                <a:path w="37434" h="20908">
                  <a:moveTo>
                    <a:pt x="31096" y="19870"/>
                  </a:moveTo>
                  <a:cubicBezTo>
                    <a:pt x="26392" y="19431"/>
                    <a:pt x="23277" y="20908"/>
                    <a:pt x="19934" y="20908"/>
                  </a:cubicBezTo>
                  <a:cubicBezTo>
                    <a:pt x="14185" y="20908"/>
                    <a:pt x="1922" y="16758"/>
                    <a:pt x="0" y="11224"/>
                  </a:cubicBezTo>
                  <a:cubicBezTo>
                    <a:pt x="109" y="8206"/>
                    <a:pt x="1726" y="4307"/>
                    <a:pt x="3648" y="1823"/>
                  </a:cubicBezTo>
                  <a:lnTo>
                    <a:pt x="8510" y="0"/>
                  </a:lnTo>
                  <a:cubicBezTo>
                    <a:pt x="15013" y="4904"/>
                    <a:pt x="29489" y="1604"/>
                    <a:pt x="35733" y="6791"/>
                  </a:cubicBezTo>
                  <a:lnTo>
                    <a:pt x="37434" y="10721"/>
                  </a:lnTo>
                  <a:lnTo>
                    <a:pt x="36217" y="15689"/>
                  </a:lnTo>
                  <a:lnTo>
                    <a:pt x="31096" y="19870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67" name="자유형: 도형 408"/>
            <p:cNvSpPr/>
            <p:nvPr/>
          </p:nvSpPr>
          <p:spPr>
            <a:xfrm>
              <a:off x="6158160" y="4299120"/>
              <a:ext cx="57240" cy="22320"/>
            </a:xfrm>
            <a:custGeom>
              <a:avLst/>
              <a:gdLst/>
              <a:ahLst/>
              <a:cxnLst/>
              <a:rect l="l" t="t" r="r" b="b"/>
              <a:pathLst>
                <a:path w="45694" h="18340">
                  <a:moveTo>
                    <a:pt x="43751" y="6293"/>
                  </a:moveTo>
                  <a:lnTo>
                    <a:pt x="45695" y="10475"/>
                  </a:lnTo>
                  <a:lnTo>
                    <a:pt x="42292" y="14657"/>
                  </a:lnTo>
                  <a:cubicBezTo>
                    <a:pt x="40980" y="15096"/>
                    <a:pt x="39013" y="16040"/>
                    <a:pt x="37676" y="16229"/>
                  </a:cubicBezTo>
                  <a:cubicBezTo>
                    <a:pt x="35859" y="16512"/>
                    <a:pt x="33691" y="16040"/>
                    <a:pt x="31843" y="16229"/>
                  </a:cubicBezTo>
                  <a:cubicBezTo>
                    <a:pt x="28374" y="16543"/>
                    <a:pt x="24575" y="18241"/>
                    <a:pt x="21144" y="18335"/>
                  </a:cubicBezTo>
                  <a:cubicBezTo>
                    <a:pt x="15630" y="18461"/>
                    <a:pt x="10249" y="16417"/>
                    <a:pt x="2915" y="17266"/>
                  </a:cubicBezTo>
                  <a:lnTo>
                    <a:pt x="0" y="13619"/>
                  </a:lnTo>
                  <a:cubicBezTo>
                    <a:pt x="2571" y="9028"/>
                    <a:pt x="5647" y="7330"/>
                    <a:pt x="10207" y="4721"/>
                  </a:cubicBezTo>
                  <a:cubicBezTo>
                    <a:pt x="10737" y="4407"/>
                    <a:pt x="13013" y="2772"/>
                    <a:pt x="13368" y="2646"/>
                  </a:cubicBezTo>
                  <a:cubicBezTo>
                    <a:pt x="14876" y="2080"/>
                    <a:pt x="17096" y="1954"/>
                    <a:pt x="18713" y="1577"/>
                  </a:cubicBezTo>
                  <a:cubicBezTo>
                    <a:pt x="25855" y="-58"/>
                    <a:pt x="35957" y="-1850"/>
                    <a:pt x="41317" y="4218"/>
                  </a:cubicBezTo>
                  <a:lnTo>
                    <a:pt x="43751" y="6293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68" name="자유형: 도형 409"/>
            <p:cNvSpPr/>
            <p:nvPr/>
          </p:nvSpPr>
          <p:spPr>
            <a:xfrm>
              <a:off x="6176880" y="4333320"/>
              <a:ext cx="53640" cy="38520"/>
            </a:xfrm>
            <a:custGeom>
              <a:avLst/>
              <a:gdLst/>
              <a:ahLst/>
              <a:cxnLst/>
              <a:rect l="l" t="t" r="r" b="b"/>
              <a:pathLst>
                <a:path w="42783" h="31794">
                  <a:moveTo>
                    <a:pt x="42784" y="7458"/>
                  </a:moveTo>
                  <a:lnTo>
                    <a:pt x="40114" y="11923"/>
                  </a:lnTo>
                  <a:lnTo>
                    <a:pt x="35498" y="13778"/>
                  </a:lnTo>
                  <a:cubicBezTo>
                    <a:pt x="29967" y="13024"/>
                    <a:pt x="22871" y="11609"/>
                    <a:pt x="17511" y="13495"/>
                  </a:cubicBezTo>
                  <a:cubicBezTo>
                    <a:pt x="12726" y="19060"/>
                    <a:pt x="14789" y="27895"/>
                    <a:pt x="7058" y="31794"/>
                  </a:cubicBezTo>
                  <a:lnTo>
                    <a:pt x="1954" y="29436"/>
                  </a:lnTo>
                  <a:cubicBezTo>
                    <a:pt x="-2069" y="23085"/>
                    <a:pt x="853" y="9565"/>
                    <a:pt x="4143" y="3308"/>
                  </a:cubicBezTo>
                  <a:cubicBezTo>
                    <a:pt x="9155" y="1076"/>
                    <a:pt x="13705" y="1704"/>
                    <a:pt x="18970" y="1202"/>
                  </a:cubicBezTo>
                  <a:cubicBezTo>
                    <a:pt x="20745" y="1044"/>
                    <a:pt x="22544" y="384"/>
                    <a:pt x="24316" y="164"/>
                  </a:cubicBezTo>
                  <a:cubicBezTo>
                    <a:pt x="31689" y="-685"/>
                    <a:pt x="38634" y="1767"/>
                    <a:pt x="42784" y="745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69" name="자유형: 도형 410"/>
            <p:cNvSpPr/>
            <p:nvPr/>
          </p:nvSpPr>
          <p:spPr>
            <a:xfrm>
              <a:off x="6308280" y="4316400"/>
              <a:ext cx="22680" cy="29160"/>
            </a:xfrm>
            <a:custGeom>
              <a:avLst/>
              <a:gdLst/>
              <a:ahLst/>
              <a:cxnLst/>
              <a:rect l="l" t="t" r="r" b="b"/>
              <a:pathLst>
                <a:path w="18350" h="24052">
                  <a:moveTo>
                    <a:pt x="17254" y="10469"/>
                  </a:moveTo>
                  <a:cubicBezTo>
                    <a:pt x="18619" y="13268"/>
                    <a:pt x="18622" y="18047"/>
                    <a:pt x="17742" y="20940"/>
                  </a:cubicBezTo>
                  <a:lnTo>
                    <a:pt x="14097" y="24052"/>
                  </a:lnTo>
                  <a:cubicBezTo>
                    <a:pt x="11540" y="23675"/>
                    <a:pt x="7050" y="21286"/>
                    <a:pt x="5588" y="19368"/>
                  </a:cubicBezTo>
                  <a:cubicBezTo>
                    <a:pt x="5430" y="19147"/>
                    <a:pt x="4086" y="15658"/>
                    <a:pt x="3887" y="15186"/>
                  </a:cubicBezTo>
                  <a:cubicBezTo>
                    <a:pt x="2764" y="12514"/>
                    <a:pt x="828" y="9307"/>
                    <a:pt x="242" y="6539"/>
                  </a:cubicBezTo>
                  <a:cubicBezTo>
                    <a:pt x="-70" y="5093"/>
                    <a:pt x="74" y="3081"/>
                    <a:pt x="0" y="1572"/>
                  </a:cubicBezTo>
                  <a:lnTo>
                    <a:pt x="4862" y="0"/>
                  </a:lnTo>
                  <a:lnTo>
                    <a:pt x="9478" y="1320"/>
                  </a:lnTo>
                  <a:cubicBezTo>
                    <a:pt x="13066" y="3993"/>
                    <a:pt x="13473" y="7986"/>
                    <a:pt x="17254" y="1046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70" name="자유형: 도형 411"/>
            <p:cNvSpPr/>
            <p:nvPr/>
          </p:nvSpPr>
          <p:spPr>
            <a:xfrm>
              <a:off x="6334200" y="4357440"/>
              <a:ext cx="17640" cy="30600"/>
            </a:xfrm>
            <a:custGeom>
              <a:avLst/>
              <a:gdLst/>
              <a:ahLst/>
              <a:cxnLst/>
              <a:rect l="l" t="t" r="r" b="b"/>
              <a:pathLst>
                <a:path w="14135" h="25090">
                  <a:moveTo>
                    <a:pt x="10937" y="25090"/>
                  </a:moveTo>
                  <a:lnTo>
                    <a:pt x="5104" y="25090"/>
                  </a:lnTo>
                  <a:cubicBezTo>
                    <a:pt x="944" y="21286"/>
                    <a:pt x="1908" y="16507"/>
                    <a:pt x="1217" y="11759"/>
                  </a:cubicBezTo>
                  <a:cubicBezTo>
                    <a:pt x="1102" y="10973"/>
                    <a:pt x="-14" y="7515"/>
                    <a:pt x="0" y="7043"/>
                  </a:cubicBezTo>
                  <a:cubicBezTo>
                    <a:pt x="7" y="6823"/>
                    <a:pt x="1305" y="2830"/>
                    <a:pt x="1456" y="2358"/>
                  </a:cubicBezTo>
                  <a:lnTo>
                    <a:pt x="5592" y="0"/>
                  </a:lnTo>
                  <a:cubicBezTo>
                    <a:pt x="6563" y="880"/>
                    <a:pt x="8247" y="2106"/>
                    <a:pt x="8994" y="3144"/>
                  </a:cubicBezTo>
                  <a:cubicBezTo>
                    <a:pt x="9134" y="3333"/>
                    <a:pt x="14098" y="14903"/>
                    <a:pt x="14098" y="14903"/>
                  </a:cubicBezTo>
                  <a:cubicBezTo>
                    <a:pt x="14424" y="17513"/>
                    <a:pt x="12600" y="22889"/>
                    <a:pt x="10937" y="2509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71" name="자유형: 도형 412"/>
            <p:cNvSpPr/>
            <p:nvPr/>
          </p:nvSpPr>
          <p:spPr>
            <a:xfrm>
              <a:off x="6279120" y="4394160"/>
              <a:ext cx="35280" cy="16560"/>
            </a:xfrm>
            <a:custGeom>
              <a:avLst/>
              <a:gdLst/>
              <a:ahLst/>
              <a:cxnLst/>
              <a:rect l="l" t="t" r="r" b="b"/>
              <a:pathLst>
                <a:path w="28194" h="13689">
                  <a:moveTo>
                    <a:pt x="28195" y="3220"/>
                  </a:moveTo>
                  <a:lnTo>
                    <a:pt x="27953" y="6616"/>
                  </a:lnTo>
                  <a:lnTo>
                    <a:pt x="24308" y="9760"/>
                  </a:lnTo>
                  <a:cubicBezTo>
                    <a:pt x="16174" y="9540"/>
                    <a:pt x="14487" y="16520"/>
                    <a:pt x="2676" y="12369"/>
                  </a:cubicBezTo>
                  <a:lnTo>
                    <a:pt x="0" y="8691"/>
                  </a:lnTo>
                  <a:lnTo>
                    <a:pt x="1217" y="4006"/>
                  </a:lnTo>
                  <a:lnTo>
                    <a:pt x="4862" y="862"/>
                  </a:lnTo>
                  <a:cubicBezTo>
                    <a:pt x="10726" y="-1496"/>
                    <a:pt x="22211" y="1554"/>
                    <a:pt x="28195" y="322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72" name="자유형: 도형 413"/>
            <p:cNvSpPr/>
            <p:nvPr/>
          </p:nvSpPr>
          <p:spPr>
            <a:xfrm>
              <a:off x="6297840" y="4410720"/>
              <a:ext cx="128160" cy="103680"/>
            </a:xfrm>
            <a:custGeom>
              <a:avLst/>
              <a:gdLst/>
              <a:ahLst/>
              <a:cxnLst/>
              <a:rect l="l" t="t" r="r" b="b"/>
              <a:pathLst>
                <a:path w="101609" h="84565">
                  <a:moveTo>
                    <a:pt x="75264" y="9515"/>
                  </a:moveTo>
                  <a:cubicBezTo>
                    <a:pt x="78849" y="10459"/>
                    <a:pt x="82995" y="12157"/>
                    <a:pt x="85945" y="14231"/>
                  </a:cubicBezTo>
                  <a:lnTo>
                    <a:pt x="86916" y="18696"/>
                  </a:lnTo>
                  <a:cubicBezTo>
                    <a:pt x="81865" y="26588"/>
                    <a:pt x="73230" y="25959"/>
                    <a:pt x="65772" y="30707"/>
                  </a:cubicBezTo>
                  <a:lnTo>
                    <a:pt x="63096" y="35423"/>
                  </a:lnTo>
                  <a:cubicBezTo>
                    <a:pt x="64004" y="39668"/>
                    <a:pt x="69252" y="43943"/>
                    <a:pt x="73791" y="45076"/>
                  </a:cubicBezTo>
                  <a:cubicBezTo>
                    <a:pt x="77586" y="46050"/>
                    <a:pt x="82777" y="45013"/>
                    <a:pt x="86432" y="46144"/>
                  </a:cubicBezTo>
                  <a:cubicBezTo>
                    <a:pt x="88832" y="46867"/>
                    <a:pt x="92697" y="50452"/>
                    <a:pt x="93483" y="52684"/>
                  </a:cubicBezTo>
                  <a:lnTo>
                    <a:pt x="99804" y="54508"/>
                  </a:lnTo>
                  <a:cubicBezTo>
                    <a:pt x="102564" y="58658"/>
                    <a:pt x="101831" y="64632"/>
                    <a:pt x="99804" y="68876"/>
                  </a:cubicBezTo>
                  <a:cubicBezTo>
                    <a:pt x="99028" y="70511"/>
                    <a:pt x="97678" y="71958"/>
                    <a:pt x="96885" y="73592"/>
                  </a:cubicBezTo>
                  <a:cubicBezTo>
                    <a:pt x="96110" y="75164"/>
                    <a:pt x="95858" y="77334"/>
                    <a:pt x="94938" y="78812"/>
                  </a:cubicBezTo>
                  <a:cubicBezTo>
                    <a:pt x="93707" y="80793"/>
                    <a:pt x="89505" y="83717"/>
                    <a:pt x="87162" y="84565"/>
                  </a:cubicBezTo>
                  <a:lnTo>
                    <a:pt x="82300" y="84063"/>
                  </a:lnTo>
                  <a:lnTo>
                    <a:pt x="81083" y="79598"/>
                  </a:lnTo>
                  <a:cubicBezTo>
                    <a:pt x="83251" y="77397"/>
                    <a:pt x="84479" y="72461"/>
                    <a:pt x="83510" y="69662"/>
                  </a:cubicBezTo>
                  <a:cubicBezTo>
                    <a:pt x="81522" y="65072"/>
                    <a:pt x="75601" y="64223"/>
                    <a:pt x="73791" y="59475"/>
                  </a:cubicBezTo>
                  <a:cubicBezTo>
                    <a:pt x="68845" y="57526"/>
                    <a:pt x="63341" y="54225"/>
                    <a:pt x="58234" y="52936"/>
                  </a:cubicBezTo>
                  <a:cubicBezTo>
                    <a:pt x="53516" y="51741"/>
                    <a:pt x="51019" y="52684"/>
                    <a:pt x="46568" y="53187"/>
                  </a:cubicBezTo>
                  <a:cubicBezTo>
                    <a:pt x="42670" y="53659"/>
                    <a:pt x="39685" y="53502"/>
                    <a:pt x="35869" y="54759"/>
                  </a:cubicBezTo>
                  <a:cubicBezTo>
                    <a:pt x="32954" y="55734"/>
                    <a:pt x="23929" y="59853"/>
                    <a:pt x="22501" y="60513"/>
                  </a:cubicBezTo>
                  <a:cubicBezTo>
                    <a:pt x="17377" y="62903"/>
                    <a:pt x="11648" y="63657"/>
                    <a:pt x="5970" y="62619"/>
                  </a:cubicBezTo>
                  <a:lnTo>
                    <a:pt x="1595" y="59727"/>
                  </a:lnTo>
                  <a:cubicBezTo>
                    <a:pt x="-1270" y="56049"/>
                    <a:pt x="-116" y="48943"/>
                    <a:pt x="3784" y="46144"/>
                  </a:cubicBezTo>
                  <a:cubicBezTo>
                    <a:pt x="10028" y="45767"/>
                    <a:pt x="15507" y="42340"/>
                    <a:pt x="21530" y="40894"/>
                  </a:cubicBezTo>
                  <a:lnTo>
                    <a:pt x="24686" y="36712"/>
                  </a:lnTo>
                  <a:cubicBezTo>
                    <a:pt x="27840" y="37121"/>
                    <a:pt x="33768" y="37718"/>
                    <a:pt x="36841" y="37247"/>
                  </a:cubicBezTo>
                  <a:cubicBezTo>
                    <a:pt x="46329" y="35831"/>
                    <a:pt x="51503" y="28065"/>
                    <a:pt x="48995" y="19986"/>
                  </a:cubicBezTo>
                  <a:cubicBezTo>
                    <a:pt x="47718" y="15867"/>
                    <a:pt x="42983" y="11119"/>
                    <a:pt x="42674" y="7975"/>
                  </a:cubicBezTo>
                  <a:cubicBezTo>
                    <a:pt x="42646" y="7660"/>
                    <a:pt x="43330" y="2818"/>
                    <a:pt x="43403" y="2221"/>
                  </a:cubicBezTo>
                  <a:cubicBezTo>
                    <a:pt x="46866" y="-1049"/>
                    <a:pt x="53804" y="-74"/>
                    <a:pt x="57989" y="1152"/>
                  </a:cubicBezTo>
                  <a:cubicBezTo>
                    <a:pt x="59711" y="1686"/>
                    <a:pt x="61395" y="2881"/>
                    <a:pt x="63092" y="3510"/>
                  </a:cubicBezTo>
                  <a:cubicBezTo>
                    <a:pt x="66880" y="4925"/>
                    <a:pt x="70511" y="5428"/>
                    <a:pt x="73542" y="8226"/>
                  </a:cubicBezTo>
                  <a:lnTo>
                    <a:pt x="75264" y="9515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73" name="자유형: 도형 414"/>
            <p:cNvSpPr/>
            <p:nvPr/>
          </p:nvSpPr>
          <p:spPr>
            <a:xfrm>
              <a:off x="6023880" y="4391280"/>
              <a:ext cx="115560" cy="81000"/>
            </a:xfrm>
            <a:custGeom>
              <a:avLst/>
              <a:gdLst/>
              <a:ahLst/>
              <a:cxnLst/>
              <a:rect l="l" t="t" r="r" b="b"/>
              <a:pathLst>
                <a:path w="91883" h="66171">
                  <a:moveTo>
                    <a:pt x="91884" y="16475"/>
                  </a:moveTo>
                  <a:cubicBezTo>
                    <a:pt x="91800" y="19180"/>
                    <a:pt x="89741" y="23236"/>
                    <a:pt x="87510" y="25090"/>
                  </a:cubicBezTo>
                  <a:cubicBezTo>
                    <a:pt x="86822" y="27511"/>
                    <a:pt x="87510" y="31599"/>
                    <a:pt x="88969" y="33737"/>
                  </a:cubicBezTo>
                  <a:cubicBezTo>
                    <a:pt x="88481" y="37321"/>
                    <a:pt x="86584" y="39867"/>
                    <a:pt x="85321" y="43137"/>
                  </a:cubicBezTo>
                  <a:cubicBezTo>
                    <a:pt x="83904" y="46817"/>
                    <a:pt x="83518" y="51061"/>
                    <a:pt x="81676" y="54645"/>
                  </a:cubicBezTo>
                  <a:cubicBezTo>
                    <a:pt x="79639" y="58576"/>
                    <a:pt x="70918" y="65052"/>
                    <a:pt x="66120" y="65869"/>
                  </a:cubicBezTo>
                  <a:cubicBezTo>
                    <a:pt x="63886" y="66279"/>
                    <a:pt x="60700" y="65869"/>
                    <a:pt x="58340" y="65964"/>
                  </a:cubicBezTo>
                  <a:cubicBezTo>
                    <a:pt x="52920" y="66216"/>
                    <a:pt x="47547" y="66655"/>
                    <a:pt x="42538" y="64329"/>
                  </a:cubicBezTo>
                  <a:cubicBezTo>
                    <a:pt x="42527" y="61814"/>
                    <a:pt x="40861" y="58009"/>
                    <a:pt x="38893" y="56218"/>
                  </a:cubicBezTo>
                  <a:cubicBezTo>
                    <a:pt x="33997" y="57380"/>
                    <a:pt x="29507" y="60085"/>
                    <a:pt x="24796" y="61185"/>
                  </a:cubicBezTo>
                  <a:cubicBezTo>
                    <a:pt x="23084" y="61562"/>
                    <a:pt x="20969" y="61437"/>
                    <a:pt x="19201" y="61688"/>
                  </a:cubicBezTo>
                  <a:cubicBezTo>
                    <a:pt x="17591" y="61939"/>
                    <a:pt x="15697" y="62662"/>
                    <a:pt x="14097" y="62757"/>
                  </a:cubicBezTo>
                  <a:cubicBezTo>
                    <a:pt x="10537" y="62914"/>
                    <a:pt x="5644" y="61971"/>
                    <a:pt x="2673" y="60116"/>
                  </a:cubicBezTo>
                  <a:lnTo>
                    <a:pt x="0" y="56469"/>
                  </a:lnTo>
                  <a:lnTo>
                    <a:pt x="1214" y="53324"/>
                  </a:lnTo>
                  <a:cubicBezTo>
                    <a:pt x="3655" y="53324"/>
                    <a:pt x="8138" y="51973"/>
                    <a:pt x="9478" y="49929"/>
                  </a:cubicBezTo>
                  <a:cubicBezTo>
                    <a:pt x="11288" y="44490"/>
                    <a:pt x="13722" y="39239"/>
                    <a:pt x="15311" y="33737"/>
                  </a:cubicBezTo>
                  <a:cubicBezTo>
                    <a:pt x="24498" y="28926"/>
                    <a:pt x="27563" y="27008"/>
                    <a:pt x="35245" y="20405"/>
                  </a:cubicBezTo>
                  <a:cubicBezTo>
                    <a:pt x="38620" y="19619"/>
                    <a:pt x="44141" y="20468"/>
                    <a:pt x="47157" y="21946"/>
                  </a:cubicBezTo>
                  <a:cubicBezTo>
                    <a:pt x="49988" y="22009"/>
                    <a:pt x="54555" y="20217"/>
                    <a:pt x="56147" y="18047"/>
                  </a:cubicBezTo>
                  <a:cubicBezTo>
                    <a:pt x="58435" y="13426"/>
                    <a:pt x="57505" y="10281"/>
                    <a:pt x="58578" y="7074"/>
                  </a:cubicBezTo>
                  <a:cubicBezTo>
                    <a:pt x="59424" y="4527"/>
                    <a:pt x="62668" y="786"/>
                    <a:pt x="65629" y="0"/>
                  </a:cubicBezTo>
                  <a:cubicBezTo>
                    <a:pt x="73595" y="1446"/>
                    <a:pt x="77383" y="6634"/>
                    <a:pt x="83129" y="10973"/>
                  </a:cubicBezTo>
                  <a:cubicBezTo>
                    <a:pt x="85795" y="12986"/>
                    <a:pt x="88951" y="14809"/>
                    <a:pt x="91884" y="1647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74" name="자유형: 도형 415"/>
            <p:cNvSpPr/>
            <p:nvPr/>
          </p:nvSpPr>
          <p:spPr>
            <a:xfrm>
              <a:off x="6117840" y="4445280"/>
              <a:ext cx="82440" cy="84960"/>
            </a:xfrm>
            <a:custGeom>
              <a:avLst/>
              <a:gdLst/>
              <a:ahLst/>
              <a:cxnLst/>
              <a:rect l="l" t="t" r="r" b="b"/>
              <a:pathLst>
                <a:path w="65628" h="69309">
                  <a:moveTo>
                    <a:pt x="45944" y="12"/>
                  </a:moveTo>
                  <a:cubicBezTo>
                    <a:pt x="53552" y="-176"/>
                    <a:pt x="61146" y="1773"/>
                    <a:pt x="65629" y="7621"/>
                  </a:cubicBezTo>
                  <a:lnTo>
                    <a:pt x="64661" y="12557"/>
                  </a:lnTo>
                  <a:lnTo>
                    <a:pt x="59796" y="14129"/>
                  </a:lnTo>
                  <a:lnTo>
                    <a:pt x="58578" y="18846"/>
                  </a:lnTo>
                  <a:cubicBezTo>
                    <a:pt x="60644" y="23028"/>
                    <a:pt x="62584" y="27398"/>
                    <a:pt x="63444" y="31925"/>
                  </a:cubicBezTo>
                  <a:cubicBezTo>
                    <a:pt x="61697" y="38434"/>
                    <a:pt x="54513" y="41861"/>
                    <a:pt x="47399" y="40823"/>
                  </a:cubicBezTo>
                  <a:lnTo>
                    <a:pt x="43267" y="43433"/>
                  </a:lnTo>
                  <a:cubicBezTo>
                    <a:pt x="40356" y="49595"/>
                    <a:pt x="41489" y="55695"/>
                    <a:pt x="39861" y="59877"/>
                  </a:cubicBezTo>
                  <a:cubicBezTo>
                    <a:pt x="38599" y="63147"/>
                    <a:pt x="32583" y="67769"/>
                    <a:pt x="29166" y="69309"/>
                  </a:cubicBezTo>
                  <a:lnTo>
                    <a:pt x="23575" y="68523"/>
                  </a:lnTo>
                  <a:cubicBezTo>
                    <a:pt x="20857" y="64184"/>
                    <a:pt x="13354" y="53746"/>
                    <a:pt x="9965" y="49972"/>
                  </a:cubicBezTo>
                  <a:cubicBezTo>
                    <a:pt x="6833" y="46451"/>
                    <a:pt x="2515" y="43841"/>
                    <a:pt x="242" y="39754"/>
                  </a:cubicBezTo>
                  <a:lnTo>
                    <a:pt x="0" y="34535"/>
                  </a:lnTo>
                  <a:cubicBezTo>
                    <a:pt x="3262" y="31956"/>
                    <a:pt x="4904" y="29033"/>
                    <a:pt x="8994" y="27209"/>
                  </a:cubicBezTo>
                  <a:cubicBezTo>
                    <a:pt x="13347" y="27775"/>
                    <a:pt x="18114" y="28970"/>
                    <a:pt x="22116" y="30605"/>
                  </a:cubicBezTo>
                  <a:cubicBezTo>
                    <a:pt x="25315" y="30228"/>
                    <a:pt x="29026" y="29159"/>
                    <a:pt x="31839" y="27744"/>
                  </a:cubicBezTo>
                  <a:cubicBezTo>
                    <a:pt x="33309" y="23877"/>
                    <a:pt x="32807" y="20607"/>
                    <a:pt x="33298" y="16739"/>
                  </a:cubicBezTo>
                  <a:cubicBezTo>
                    <a:pt x="34116" y="10262"/>
                    <a:pt x="37434" y="2370"/>
                    <a:pt x="45688" y="1333"/>
                  </a:cubicBezTo>
                  <a:lnTo>
                    <a:pt x="45944" y="12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75" name="자유형: 도형 416"/>
            <p:cNvSpPr/>
            <p:nvPr/>
          </p:nvSpPr>
          <p:spPr>
            <a:xfrm>
              <a:off x="6153480" y="4531320"/>
              <a:ext cx="57960" cy="43200"/>
            </a:xfrm>
            <a:custGeom>
              <a:avLst/>
              <a:gdLst/>
              <a:ahLst/>
              <a:cxnLst/>
              <a:rect l="l" t="t" r="r" b="b"/>
              <a:pathLst>
                <a:path w="46293" h="35593">
                  <a:moveTo>
                    <a:pt x="40103" y="535"/>
                  </a:moveTo>
                  <a:cubicBezTo>
                    <a:pt x="41710" y="2767"/>
                    <a:pt x="44663" y="5754"/>
                    <a:pt x="45695" y="8112"/>
                  </a:cubicBezTo>
                  <a:cubicBezTo>
                    <a:pt x="47094" y="11319"/>
                    <a:pt x="45733" y="25971"/>
                    <a:pt x="44723" y="29555"/>
                  </a:cubicBezTo>
                  <a:cubicBezTo>
                    <a:pt x="41945" y="32479"/>
                    <a:pt x="37115" y="35969"/>
                    <a:pt x="32569" y="35560"/>
                  </a:cubicBezTo>
                  <a:cubicBezTo>
                    <a:pt x="28637" y="30592"/>
                    <a:pt x="22596" y="24996"/>
                    <a:pt x="15799" y="23299"/>
                  </a:cubicBezTo>
                  <a:cubicBezTo>
                    <a:pt x="12266" y="22387"/>
                    <a:pt x="6612" y="22418"/>
                    <a:pt x="2673" y="21726"/>
                  </a:cubicBezTo>
                  <a:lnTo>
                    <a:pt x="0" y="17796"/>
                  </a:lnTo>
                  <a:lnTo>
                    <a:pt x="2754" y="16224"/>
                  </a:lnTo>
                  <a:cubicBezTo>
                    <a:pt x="5802" y="14495"/>
                    <a:pt x="10790" y="15626"/>
                    <a:pt x="14824" y="13614"/>
                  </a:cubicBezTo>
                  <a:cubicBezTo>
                    <a:pt x="15206" y="13426"/>
                    <a:pt x="15318" y="13174"/>
                    <a:pt x="15634" y="12923"/>
                  </a:cubicBezTo>
                  <a:cubicBezTo>
                    <a:pt x="17458" y="11351"/>
                    <a:pt x="19450" y="10533"/>
                    <a:pt x="21386" y="9181"/>
                  </a:cubicBezTo>
                  <a:cubicBezTo>
                    <a:pt x="22604" y="8301"/>
                    <a:pt x="23751" y="6729"/>
                    <a:pt x="25031" y="6037"/>
                  </a:cubicBezTo>
                  <a:cubicBezTo>
                    <a:pt x="26388" y="5282"/>
                    <a:pt x="28538" y="5220"/>
                    <a:pt x="29896" y="4465"/>
                  </a:cubicBezTo>
                  <a:cubicBezTo>
                    <a:pt x="32621" y="2955"/>
                    <a:pt x="33323" y="535"/>
                    <a:pt x="37424" y="0"/>
                  </a:cubicBezTo>
                  <a:lnTo>
                    <a:pt x="40103" y="535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76" name="자유형: 도형 417"/>
            <p:cNvSpPr/>
            <p:nvPr/>
          </p:nvSpPr>
          <p:spPr>
            <a:xfrm>
              <a:off x="6197760" y="4587480"/>
              <a:ext cx="38160" cy="53280"/>
            </a:xfrm>
            <a:custGeom>
              <a:avLst/>
              <a:gdLst/>
              <a:ahLst/>
              <a:cxnLst/>
              <a:rect l="l" t="t" r="r" b="b"/>
              <a:pathLst>
                <a:path w="30600" h="43721">
                  <a:moveTo>
                    <a:pt x="8164" y="42603"/>
                  </a:moveTo>
                  <a:cubicBezTo>
                    <a:pt x="-6649" y="32825"/>
                    <a:pt x="2667" y="16067"/>
                    <a:pt x="5491" y="3396"/>
                  </a:cubicBezTo>
                  <a:lnTo>
                    <a:pt x="9136" y="0"/>
                  </a:lnTo>
                  <a:lnTo>
                    <a:pt x="14969" y="0"/>
                  </a:lnTo>
                  <a:cubicBezTo>
                    <a:pt x="18838" y="2892"/>
                    <a:pt x="20918" y="7043"/>
                    <a:pt x="23721" y="10721"/>
                  </a:cubicBezTo>
                  <a:lnTo>
                    <a:pt x="22749" y="9653"/>
                  </a:lnTo>
                  <a:cubicBezTo>
                    <a:pt x="28168" y="14526"/>
                    <a:pt x="32107" y="25499"/>
                    <a:pt x="30041" y="32164"/>
                  </a:cubicBezTo>
                  <a:lnTo>
                    <a:pt x="27611" y="36849"/>
                  </a:lnTo>
                  <a:cubicBezTo>
                    <a:pt x="27474" y="37038"/>
                    <a:pt x="20258" y="42792"/>
                    <a:pt x="20076" y="42886"/>
                  </a:cubicBezTo>
                  <a:cubicBezTo>
                    <a:pt x="16982" y="44270"/>
                    <a:pt x="11219" y="43766"/>
                    <a:pt x="8164" y="42603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77" name="자유형: 도형 418"/>
            <p:cNvSpPr/>
            <p:nvPr/>
          </p:nvSpPr>
          <p:spPr>
            <a:xfrm>
              <a:off x="6124680" y="4570560"/>
              <a:ext cx="62640" cy="56880"/>
            </a:xfrm>
            <a:custGeom>
              <a:avLst/>
              <a:gdLst/>
              <a:ahLst/>
              <a:cxnLst/>
              <a:rect l="l" t="t" r="r" b="b"/>
              <a:pathLst>
                <a:path w="49897" h="46625">
                  <a:moveTo>
                    <a:pt x="21873" y="45840"/>
                  </a:moveTo>
                  <a:cubicBezTo>
                    <a:pt x="19414" y="41344"/>
                    <a:pt x="23304" y="34961"/>
                    <a:pt x="25030" y="30653"/>
                  </a:cubicBezTo>
                  <a:lnTo>
                    <a:pt x="23812" y="25968"/>
                  </a:lnTo>
                  <a:cubicBezTo>
                    <a:pt x="16843" y="19209"/>
                    <a:pt x="8940" y="23547"/>
                    <a:pt x="2910" y="20215"/>
                  </a:cubicBezTo>
                  <a:cubicBezTo>
                    <a:pt x="1914" y="14681"/>
                    <a:pt x="-1706" y="6569"/>
                    <a:pt x="963" y="1382"/>
                  </a:cubicBezTo>
                  <a:cubicBezTo>
                    <a:pt x="8729" y="-757"/>
                    <a:pt x="23455" y="-285"/>
                    <a:pt x="31105" y="1916"/>
                  </a:cubicBezTo>
                  <a:cubicBezTo>
                    <a:pt x="36065" y="3331"/>
                    <a:pt x="45332" y="9179"/>
                    <a:pt x="48605" y="12889"/>
                  </a:cubicBezTo>
                  <a:cubicBezTo>
                    <a:pt x="49180" y="14870"/>
                    <a:pt x="50180" y="20686"/>
                    <a:pt x="49822" y="22542"/>
                  </a:cubicBezTo>
                  <a:cubicBezTo>
                    <a:pt x="49162" y="26031"/>
                    <a:pt x="46718" y="29648"/>
                    <a:pt x="45935" y="33294"/>
                  </a:cubicBezTo>
                  <a:cubicBezTo>
                    <a:pt x="45542" y="35087"/>
                    <a:pt x="45746" y="37288"/>
                    <a:pt x="45206" y="39017"/>
                  </a:cubicBezTo>
                  <a:cubicBezTo>
                    <a:pt x="44792" y="40369"/>
                    <a:pt x="43476" y="42193"/>
                    <a:pt x="42775" y="43481"/>
                  </a:cubicBezTo>
                  <a:cubicBezTo>
                    <a:pt x="38745" y="44425"/>
                    <a:pt x="34662" y="44582"/>
                    <a:pt x="30621" y="45305"/>
                  </a:cubicBezTo>
                  <a:cubicBezTo>
                    <a:pt x="29123" y="45588"/>
                    <a:pt x="27236" y="46531"/>
                    <a:pt x="25759" y="46626"/>
                  </a:cubicBezTo>
                  <a:cubicBezTo>
                    <a:pt x="25570" y="46626"/>
                    <a:pt x="22269" y="45902"/>
                    <a:pt x="21873" y="4584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78" name="자유형: 도형 419"/>
            <p:cNvSpPr/>
            <p:nvPr/>
          </p:nvSpPr>
          <p:spPr>
            <a:xfrm>
              <a:off x="5923800" y="4539960"/>
              <a:ext cx="126360" cy="81720"/>
            </a:xfrm>
            <a:custGeom>
              <a:avLst/>
              <a:gdLst/>
              <a:ahLst/>
              <a:cxnLst/>
              <a:rect l="l" t="t" r="r" b="b"/>
              <a:pathLst>
                <a:path w="100307" h="66883">
                  <a:moveTo>
                    <a:pt x="93195" y="402"/>
                  </a:moveTo>
                  <a:lnTo>
                    <a:pt x="95871" y="1974"/>
                  </a:lnTo>
                  <a:lnTo>
                    <a:pt x="97818" y="6156"/>
                  </a:lnTo>
                  <a:lnTo>
                    <a:pt x="95141" y="17129"/>
                  </a:lnTo>
                  <a:cubicBezTo>
                    <a:pt x="96495" y="20996"/>
                    <a:pt x="100880" y="24769"/>
                    <a:pt x="100245" y="28888"/>
                  </a:cubicBezTo>
                  <a:cubicBezTo>
                    <a:pt x="95668" y="31623"/>
                    <a:pt x="87740" y="30051"/>
                    <a:pt x="82987" y="28353"/>
                  </a:cubicBezTo>
                  <a:cubicBezTo>
                    <a:pt x="80111" y="29014"/>
                    <a:pt x="76954" y="32786"/>
                    <a:pt x="76182" y="35176"/>
                  </a:cubicBezTo>
                  <a:lnTo>
                    <a:pt x="71079" y="35962"/>
                  </a:lnTo>
                  <a:cubicBezTo>
                    <a:pt x="66638" y="33478"/>
                    <a:pt x="61390" y="32912"/>
                    <a:pt x="56332" y="32284"/>
                  </a:cubicBezTo>
                  <a:lnTo>
                    <a:pt x="52120" y="31749"/>
                  </a:lnTo>
                  <a:cubicBezTo>
                    <a:pt x="46679" y="32158"/>
                    <a:pt x="42259" y="37471"/>
                    <a:pt x="41425" y="41968"/>
                  </a:cubicBezTo>
                  <a:cubicBezTo>
                    <a:pt x="40642" y="46180"/>
                    <a:pt x="43066" y="53097"/>
                    <a:pt x="42154" y="57122"/>
                  </a:cubicBezTo>
                  <a:cubicBezTo>
                    <a:pt x="41723" y="59040"/>
                    <a:pt x="38015" y="64385"/>
                    <a:pt x="36563" y="66020"/>
                  </a:cubicBezTo>
                  <a:cubicBezTo>
                    <a:pt x="28660" y="65454"/>
                    <a:pt x="21483" y="68001"/>
                    <a:pt x="13472" y="66272"/>
                  </a:cubicBezTo>
                  <a:cubicBezTo>
                    <a:pt x="10073" y="62782"/>
                    <a:pt x="4899" y="61021"/>
                    <a:pt x="2047" y="57122"/>
                  </a:cubicBezTo>
                  <a:lnTo>
                    <a:pt x="101" y="53192"/>
                  </a:lnTo>
                  <a:cubicBezTo>
                    <a:pt x="-590" y="48601"/>
                    <a:pt x="2475" y="41496"/>
                    <a:pt x="3258" y="36748"/>
                  </a:cubicBezTo>
                  <a:cubicBezTo>
                    <a:pt x="3889" y="32944"/>
                    <a:pt x="4233" y="29045"/>
                    <a:pt x="4717" y="25241"/>
                  </a:cubicBezTo>
                  <a:cubicBezTo>
                    <a:pt x="7986" y="22034"/>
                    <a:pt x="12409" y="19455"/>
                    <a:pt x="16629" y="17380"/>
                  </a:cubicBezTo>
                  <a:cubicBezTo>
                    <a:pt x="21020" y="17789"/>
                    <a:pt x="23928" y="16531"/>
                    <a:pt x="27811" y="16343"/>
                  </a:cubicBezTo>
                  <a:cubicBezTo>
                    <a:pt x="35620" y="15997"/>
                    <a:pt x="44231" y="19864"/>
                    <a:pt x="51874" y="17129"/>
                  </a:cubicBezTo>
                  <a:cubicBezTo>
                    <a:pt x="60461" y="14047"/>
                    <a:pt x="65863" y="2980"/>
                    <a:pt x="75453" y="653"/>
                  </a:cubicBezTo>
                  <a:cubicBezTo>
                    <a:pt x="81244" y="-761"/>
                    <a:pt x="87260" y="590"/>
                    <a:pt x="93195" y="40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79" name="자유형: 도형 420"/>
            <p:cNvSpPr/>
            <p:nvPr/>
          </p:nvSpPr>
          <p:spPr>
            <a:xfrm>
              <a:off x="5951520" y="4609080"/>
              <a:ext cx="97920" cy="89640"/>
            </a:xfrm>
            <a:custGeom>
              <a:avLst/>
              <a:gdLst/>
              <a:ahLst/>
              <a:cxnLst/>
              <a:rect l="l" t="t" r="r" b="b"/>
              <a:pathLst>
                <a:path w="77887" h="73195">
                  <a:moveTo>
                    <a:pt x="77888" y="33737"/>
                  </a:moveTo>
                  <a:cubicBezTo>
                    <a:pt x="75931" y="40496"/>
                    <a:pt x="71420" y="43420"/>
                    <a:pt x="67193" y="48703"/>
                  </a:cubicBezTo>
                  <a:cubicBezTo>
                    <a:pt x="65685" y="50620"/>
                    <a:pt x="64899" y="52696"/>
                    <a:pt x="63549" y="54645"/>
                  </a:cubicBezTo>
                  <a:cubicBezTo>
                    <a:pt x="58975" y="61185"/>
                    <a:pt x="52478" y="66813"/>
                    <a:pt x="47504" y="73196"/>
                  </a:cubicBezTo>
                  <a:lnTo>
                    <a:pt x="40700" y="71906"/>
                  </a:lnTo>
                  <a:cubicBezTo>
                    <a:pt x="37266" y="68636"/>
                    <a:pt x="36129" y="63888"/>
                    <a:pt x="34140" y="59864"/>
                  </a:cubicBezTo>
                  <a:cubicBezTo>
                    <a:pt x="27984" y="57286"/>
                    <a:pt x="21225" y="58135"/>
                    <a:pt x="14936" y="56217"/>
                  </a:cubicBezTo>
                  <a:cubicBezTo>
                    <a:pt x="11389" y="55117"/>
                    <a:pt x="4553" y="50180"/>
                    <a:pt x="2539" y="47319"/>
                  </a:cubicBezTo>
                  <a:cubicBezTo>
                    <a:pt x="-884" y="42477"/>
                    <a:pt x="-888" y="33139"/>
                    <a:pt x="2781" y="28517"/>
                  </a:cubicBezTo>
                  <a:cubicBezTo>
                    <a:pt x="9478" y="23361"/>
                    <a:pt x="21056" y="25624"/>
                    <a:pt x="27574" y="21694"/>
                  </a:cubicBezTo>
                  <a:cubicBezTo>
                    <a:pt x="36960" y="16066"/>
                    <a:pt x="35196" y="5439"/>
                    <a:pt x="47259" y="0"/>
                  </a:cubicBezTo>
                  <a:cubicBezTo>
                    <a:pt x="50784" y="2798"/>
                    <a:pt x="54267" y="6791"/>
                    <a:pt x="55281" y="10973"/>
                  </a:cubicBezTo>
                  <a:cubicBezTo>
                    <a:pt x="59129" y="12765"/>
                    <a:pt x="59890" y="15091"/>
                    <a:pt x="62573" y="17512"/>
                  </a:cubicBezTo>
                  <a:cubicBezTo>
                    <a:pt x="63380" y="18267"/>
                    <a:pt x="64924" y="18613"/>
                    <a:pt x="65730" y="19336"/>
                  </a:cubicBezTo>
                  <a:cubicBezTo>
                    <a:pt x="66940" y="20437"/>
                    <a:pt x="72107" y="24838"/>
                    <a:pt x="73265" y="25876"/>
                  </a:cubicBezTo>
                  <a:cubicBezTo>
                    <a:pt x="74850" y="27291"/>
                    <a:pt x="77207" y="31787"/>
                    <a:pt x="77888" y="33737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80" name="자유형: 도형 421"/>
            <p:cNvSpPr/>
            <p:nvPr/>
          </p:nvSpPr>
          <p:spPr>
            <a:xfrm>
              <a:off x="5843160" y="4724280"/>
              <a:ext cx="45360" cy="34200"/>
            </a:xfrm>
            <a:custGeom>
              <a:avLst/>
              <a:gdLst/>
              <a:ahLst/>
              <a:cxnLst/>
              <a:rect l="l" t="t" r="r" b="b"/>
              <a:pathLst>
                <a:path w="36214" h="28095">
                  <a:moveTo>
                    <a:pt x="35000" y="3992"/>
                  </a:moveTo>
                  <a:cubicBezTo>
                    <a:pt x="33491" y="6791"/>
                    <a:pt x="32179" y="10784"/>
                    <a:pt x="32323" y="13928"/>
                  </a:cubicBezTo>
                  <a:cubicBezTo>
                    <a:pt x="34417" y="15625"/>
                    <a:pt x="36266" y="19493"/>
                    <a:pt x="36213" y="22039"/>
                  </a:cubicBezTo>
                  <a:lnTo>
                    <a:pt x="33053" y="25938"/>
                  </a:lnTo>
                  <a:cubicBezTo>
                    <a:pt x="32516" y="26158"/>
                    <a:pt x="28752" y="27730"/>
                    <a:pt x="28437" y="27793"/>
                  </a:cubicBezTo>
                  <a:cubicBezTo>
                    <a:pt x="25052" y="28390"/>
                    <a:pt x="9074" y="28045"/>
                    <a:pt x="5588" y="27259"/>
                  </a:cubicBezTo>
                  <a:cubicBezTo>
                    <a:pt x="5710" y="24649"/>
                    <a:pt x="6857" y="21442"/>
                    <a:pt x="8261" y="19147"/>
                  </a:cubicBezTo>
                  <a:cubicBezTo>
                    <a:pt x="7896" y="14745"/>
                    <a:pt x="4599" y="10154"/>
                    <a:pt x="0" y="8426"/>
                  </a:cubicBezTo>
                  <a:lnTo>
                    <a:pt x="3402" y="6350"/>
                  </a:lnTo>
                  <a:cubicBezTo>
                    <a:pt x="4006" y="6318"/>
                    <a:pt x="8966" y="6162"/>
                    <a:pt x="9236" y="6067"/>
                  </a:cubicBezTo>
                  <a:cubicBezTo>
                    <a:pt x="9653" y="5973"/>
                    <a:pt x="12684" y="4023"/>
                    <a:pt x="13368" y="3741"/>
                  </a:cubicBezTo>
                  <a:cubicBezTo>
                    <a:pt x="17388" y="1917"/>
                    <a:pt x="23975" y="-410"/>
                    <a:pt x="28440" y="62"/>
                  </a:cubicBezTo>
                  <a:cubicBezTo>
                    <a:pt x="29843" y="1665"/>
                    <a:pt x="32765" y="3521"/>
                    <a:pt x="35000" y="399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81" name="자유형: 도형 422"/>
            <p:cNvSpPr/>
            <p:nvPr/>
          </p:nvSpPr>
          <p:spPr>
            <a:xfrm>
              <a:off x="5991120" y="4710600"/>
              <a:ext cx="24480" cy="25920"/>
            </a:xfrm>
            <a:custGeom>
              <a:avLst/>
              <a:gdLst/>
              <a:ahLst/>
              <a:cxnLst/>
              <a:rect l="l" t="t" r="r" b="b"/>
              <a:pathLst>
                <a:path w="19637" h="21443">
                  <a:moveTo>
                    <a:pt x="16041" y="21443"/>
                  </a:moveTo>
                  <a:cubicBezTo>
                    <a:pt x="15469" y="21191"/>
                    <a:pt x="10940" y="19274"/>
                    <a:pt x="10695" y="19085"/>
                  </a:cubicBezTo>
                  <a:cubicBezTo>
                    <a:pt x="10449" y="18896"/>
                    <a:pt x="8415" y="16130"/>
                    <a:pt x="8022" y="15689"/>
                  </a:cubicBezTo>
                  <a:cubicBezTo>
                    <a:pt x="4788" y="12074"/>
                    <a:pt x="1154" y="9213"/>
                    <a:pt x="0" y="4434"/>
                  </a:cubicBezTo>
                  <a:lnTo>
                    <a:pt x="2189" y="1038"/>
                  </a:lnTo>
                  <a:cubicBezTo>
                    <a:pt x="5847" y="1069"/>
                    <a:pt x="9793" y="723"/>
                    <a:pt x="13371" y="0"/>
                  </a:cubicBezTo>
                  <a:cubicBezTo>
                    <a:pt x="15707" y="1761"/>
                    <a:pt x="18019" y="4371"/>
                    <a:pt x="19447" y="6792"/>
                  </a:cubicBezTo>
                  <a:lnTo>
                    <a:pt x="18717" y="6540"/>
                  </a:lnTo>
                  <a:cubicBezTo>
                    <a:pt x="20285" y="10847"/>
                    <a:pt x="20131" y="18205"/>
                    <a:pt x="16041" y="21443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82" name="자유형: 도형 423"/>
            <p:cNvSpPr/>
            <p:nvPr/>
          </p:nvSpPr>
          <p:spPr>
            <a:xfrm>
              <a:off x="6057000" y="4726800"/>
              <a:ext cx="41760" cy="59400"/>
            </a:xfrm>
            <a:custGeom>
              <a:avLst/>
              <a:gdLst/>
              <a:ahLst/>
              <a:cxnLst/>
              <a:rect l="l" t="t" r="r" b="b"/>
              <a:pathLst>
                <a:path w="33320" h="48608">
                  <a:moveTo>
                    <a:pt x="14604" y="2075"/>
                  </a:moveTo>
                  <a:cubicBezTo>
                    <a:pt x="15568" y="7420"/>
                    <a:pt x="12338" y="12985"/>
                    <a:pt x="14604" y="18016"/>
                  </a:cubicBezTo>
                  <a:cubicBezTo>
                    <a:pt x="16677" y="22638"/>
                    <a:pt x="22510" y="24052"/>
                    <a:pt x="26028" y="27196"/>
                  </a:cubicBezTo>
                  <a:cubicBezTo>
                    <a:pt x="28000" y="28926"/>
                    <a:pt x="32461" y="36220"/>
                    <a:pt x="33321" y="38672"/>
                  </a:cubicBezTo>
                  <a:lnTo>
                    <a:pt x="31132" y="44174"/>
                  </a:lnTo>
                  <a:cubicBezTo>
                    <a:pt x="27793" y="45149"/>
                    <a:pt x="23099" y="45086"/>
                    <a:pt x="19707" y="44426"/>
                  </a:cubicBezTo>
                  <a:cubicBezTo>
                    <a:pt x="16999" y="46093"/>
                    <a:pt x="13793" y="47602"/>
                    <a:pt x="10714" y="48608"/>
                  </a:cubicBezTo>
                  <a:lnTo>
                    <a:pt x="5610" y="48105"/>
                  </a:lnTo>
                  <a:cubicBezTo>
                    <a:pt x="5414" y="43106"/>
                    <a:pt x="9079" y="39018"/>
                    <a:pt x="8528" y="33988"/>
                  </a:cubicBezTo>
                  <a:cubicBezTo>
                    <a:pt x="7837" y="27668"/>
                    <a:pt x="3302" y="27228"/>
                    <a:pt x="1236" y="22480"/>
                  </a:cubicBezTo>
                  <a:cubicBezTo>
                    <a:pt x="-1086" y="17135"/>
                    <a:pt x="127" y="6917"/>
                    <a:pt x="2695" y="1823"/>
                  </a:cubicBezTo>
                  <a:lnTo>
                    <a:pt x="7311" y="0"/>
                  </a:lnTo>
                  <a:cubicBezTo>
                    <a:pt x="9567" y="818"/>
                    <a:pt x="12166" y="1792"/>
                    <a:pt x="14604" y="207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83" name="자유형: 도형 424"/>
            <p:cNvSpPr/>
            <p:nvPr/>
          </p:nvSpPr>
          <p:spPr>
            <a:xfrm>
              <a:off x="6162480" y="4687920"/>
              <a:ext cx="82080" cy="52560"/>
            </a:xfrm>
            <a:custGeom>
              <a:avLst/>
              <a:gdLst/>
              <a:ahLst/>
              <a:cxnLst/>
              <a:rect l="l" t="t" r="r" b="b"/>
              <a:pathLst>
                <a:path w="65144" h="43141">
                  <a:moveTo>
                    <a:pt x="39381" y="9185"/>
                  </a:moveTo>
                  <a:cubicBezTo>
                    <a:pt x="48252" y="11921"/>
                    <a:pt x="60732" y="8996"/>
                    <a:pt x="65145" y="18586"/>
                  </a:cubicBezTo>
                  <a:lnTo>
                    <a:pt x="63689" y="22768"/>
                  </a:lnTo>
                  <a:cubicBezTo>
                    <a:pt x="56337" y="29937"/>
                    <a:pt x="43074" y="28113"/>
                    <a:pt x="35007" y="32703"/>
                  </a:cubicBezTo>
                  <a:cubicBezTo>
                    <a:pt x="33800" y="33395"/>
                    <a:pt x="32744" y="34779"/>
                    <a:pt x="31601" y="35565"/>
                  </a:cubicBezTo>
                  <a:cubicBezTo>
                    <a:pt x="28931" y="37451"/>
                    <a:pt x="26139" y="38740"/>
                    <a:pt x="23821" y="41067"/>
                  </a:cubicBezTo>
                  <a:lnTo>
                    <a:pt x="13126" y="43142"/>
                  </a:lnTo>
                  <a:cubicBezTo>
                    <a:pt x="8015" y="42230"/>
                    <a:pt x="2350" y="39086"/>
                    <a:pt x="0" y="34779"/>
                  </a:cubicBezTo>
                  <a:lnTo>
                    <a:pt x="3406" y="30880"/>
                  </a:lnTo>
                  <a:lnTo>
                    <a:pt x="9481" y="31383"/>
                  </a:lnTo>
                  <a:lnTo>
                    <a:pt x="12884" y="27736"/>
                  </a:lnTo>
                  <a:cubicBezTo>
                    <a:pt x="14020" y="19466"/>
                    <a:pt x="8713" y="17234"/>
                    <a:pt x="3648" y="11795"/>
                  </a:cubicBezTo>
                  <a:lnTo>
                    <a:pt x="5591" y="6544"/>
                  </a:lnTo>
                  <a:cubicBezTo>
                    <a:pt x="17451" y="6135"/>
                    <a:pt x="22898" y="-4932"/>
                    <a:pt x="35975" y="2646"/>
                  </a:cubicBezTo>
                  <a:lnTo>
                    <a:pt x="35733" y="3432"/>
                  </a:lnTo>
                  <a:cubicBezTo>
                    <a:pt x="36287" y="5286"/>
                    <a:pt x="38114" y="7676"/>
                    <a:pt x="39381" y="918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84" name="자유형: 도형 425"/>
            <p:cNvSpPr/>
            <p:nvPr/>
          </p:nvSpPr>
          <p:spPr>
            <a:xfrm>
              <a:off x="6103440" y="4723560"/>
              <a:ext cx="50040" cy="50400"/>
            </a:xfrm>
            <a:custGeom>
              <a:avLst/>
              <a:gdLst/>
              <a:ahLst/>
              <a:cxnLst/>
              <a:rect l="l" t="t" r="r" b="b"/>
              <a:pathLst>
                <a:path w="39857" h="41446">
                  <a:moveTo>
                    <a:pt x="15550" y="4347"/>
                  </a:moveTo>
                  <a:cubicBezTo>
                    <a:pt x="19369" y="6390"/>
                    <a:pt x="19180" y="8748"/>
                    <a:pt x="20902" y="11672"/>
                  </a:cubicBezTo>
                  <a:cubicBezTo>
                    <a:pt x="21656" y="12930"/>
                    <a:pt x="23063" y="14030"/>
                    <a:pt x="23817" y="15320"/>
                  </a:cubicBezTo>
                  <a:cubicBezTo>
                    <a:pt x="24536" y="16545"/>
                    <a:pt x="24712" y="18369"/>
                    <a:pt x="25518" y="19501"/>
                  </a:cubicBezTo>
                  <a:cubicBezTo>
                    <a:pt x="27977" y="22991"/>
                    <a:pt x="36087" y="28777"/>
                    <a:pt x="39619" y="32581"/>
                  </a:cubicBezTo>
                  <a:lnTo>
                    <a:pt x="39858" y="37800"/>
                  </a:lnTo>
                  <a:lnTo>
                    <a:pt x="36701" y="41447"/>
                  </a:lnTo>
                  <a:cubicBezTo>
                    <a:pt x="27423" y="40629"/>
                    <a:pt x="27072" y="38586"/>
                    <a:pt x="20415" y="35190"/>
                  </a:cubicBezTo>
                  <a:cubicBezTo>
                    <a:pt x="18836" y="34372"/>
                    <a:pt x="16525" y="33996"/>
                    <a:pt x="15069" y="33084"/>
                  </a:cubicBezTo>
                  <a:cubicBezTo>
                    <a:pt x="10614" y="30286"/>
                    <a:pt x="8703" y="24248"/>
                    <a:pt x="10449" y="19752"/>
                  </a:cubicBezTo>
                  <a:cubicBezTo>
                    <a:pt x="8012" y="17363"/>
                    <a:pt x="7401" y="14910"/>
                    <a:pt x="5833" y="12175"/>
                  </a:cubicBezTo>
                  <a:cubicBezTo>
                    <a:pt x="4395" y="9691"/>
                    <a:pt x="2119" y="7113"/>
                    <a:pt x="242" y="4849"/>
                  </a:cubicBezTo>
                  <a:lnTo>
                    <a:pt x="0" y="667"/>
                  </a:lnTo>
                  <a:cubicBezTo>
                    <a:pt x="4711" y="-1187"/>
                    <a:pt x="12189" y="1077"/>
                    <a:pt x="15560" y="4347"/>
                  </a:cubicBezTo>
                  <a:lnTo>
                    <a:pt x="15550" y="4347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85" name="자유형: 도형 426"/>
            <p:cNvSpPr/>
            <p:nvPr/>
          </p:nvSpPr>
          <p:spPr>
            <a:xfrm>
              <a:off x="6083640" y="4795200"/>
              <a:ext cx="61920" cy="38160"/>
            </a:xfrm>
            <a:custGeom>
              <a:avLst/>
              <a:gdLst/>
              <a:ahLst/>
              <a:cxnLst/>
              <a:rect l="l" t="t" r="r" b="b"/>
              <a:pathLst>
                <a:path w="49263" h="31218">
                  <a:moveTo>
                    <a:pt x="47417" y="8965"/>
                  </a:moveTo>
                  <a:cubicBezTo>
                    <a:pt x="34944" y="12016"/>
                    <a:pt x="36680" y="19341"/>
                    <a:pt x="28682" y="23900"/>
                  </a:cubicBezTo>
                  <a:cubicBezTo>
                    <a:pt x="27423" y="24592"/>
                    <a:pt x="21358" y="27138"/>
                    <a:pt x="19934" y="27799"/>
                  </a:cubicBezTo>
                  <a:cubicBezTo>
                    <a:pt x="14385" y="30377"/>
                    <a:pt x="5886" y="32798"/>
                    <a:pt x="0" y="29905"/>
                  </a:cubicBezTo>
                  <a:lnTo>
                    <a:pt x="2427" y="25189"/>
                  </a:lnTo>
                  <a:cubicBezTo>
                    <a:pt x="4991" y="23523"/>
                    <a:pt x="8362" y="22045"/>
                    <a:pt x="11421" y="21259"/>
                  </a:cubicBezTo>
                  <a:cubicBezTo>
                    <a:pt x="13049" y="17863"/>
                    <a:pt x="22126" y="8965"/>
                    <a:pt x="24305" y="6638"/>
                  </a:cubicBezTo>
                  <a:cubicBezTo>
                    <a:pt x="26444" y="4343"/>
                    <a:pt x="29135" y="2143"/>
                    <a:pt x="31597" y="99"/>
                  </a:cubicBezTo>
                  <a:cubicBezTo>
                    <a:pt x="37185" y="-153"/>
                    <a:pt x="44435" y="-153"/>
                    <a:pt x="49094" y="2960"/>
                  </a:cubicBezTo>
                  <a:cubicBezTo>
                    <a:pt x="49834" y="3966"/>
                    <a:pt x="47943" y="8022"/>
                    <a:pt x="47417" y="896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86" name="자유형: 도형 427"/>
            <p:cNvSpPr/>
            <p:nvPr/>
          </p:nvSpPr>
          <p:spPr>
            <a:xfrm>
              <a:off x="6084360" y="4876920"/>
              <a:ext cx="22680" cy="25920"/>
            </a:xfrm>
            <a:custGeom>
              <a:avLst/>
              <a:gdLst/>
              <a:ahLst/>
              <a:cxnLst/>
              <a:rect l="l" t="t" r="r" b="b"/>
              <a:pathLst>
                <a:path w="18202" h="21481">
                  <a:moveTo>
                    <a:pt x="17507" y="4968"/>
                  </a:moveTo>
                  <a:cubicBezTo>
                    <a:pt x="21236" y="15752"/>
                    <a:pt x="9177" y="25059"/>
                    <a:pt x="253" y="20123"/>
                  </a:cubicBezTo>
                  <a:cubicBezTo>
                    <a:pt x="-224" y="16727"/>
                    <a:pt x="-7" y="12765"/>
                    <a:pt x="737" y="9401"/>
                  </a:cubicBezTo>
                  <a:cubicBezTo>
                    <a:pt x="4767" y="6634"/>
                    <a:pt x="6539" y="1604"/>
                    <a:pt x="11436" y="0"/>
                  </a:cubicBezTo>
                  <a:lnTo>
                    <a:pt x="16781" y="2107"/>
                  </a:lnTo>
                  <a:lnTo>
                    <a:pt x="17507" y="4968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87" name="자유형: 도형 428"/>
            <p:cNvSpPr/>
            <p:nvPr/>
          </p:nvSpPr>
          <p:spPr>
            <a:xfrm>
              <a:off x="5475240" y="4694760"/>
              <a:ext cx="21960" cy="18000"/>
            </a:xfrm>
            <a:custGeom>
              <a:avLst/>
              <a:gdLst/>
              <a:ahLst/>
              <a:cxnLst/>
              <a:rect l="l" t="t" r="r" b="b"/>
              <a:pathLst>
                <a:path w="17546" h="14903">
                  <a:moveTo>
                    <a:pt x="17547" y="4968"/>
                  </a:moveTo>
                  <a:cubicBezTo>
                    <a:pt x="15803" y="9244"/>
                    <a:pt x="11566" y="12890"/>
                    <a:pt x="7080" y="14903"/>
                  </a:cubicBezTo>
                  <a:lnTo>
                    <a:pt x="1488" y="14903"/>
                  </a:lnTo>
                  <a:cubicBezTo>
                    <a:pt x="366" y="12074"/>
                    <a:pt x="-139" y="8489"/>
                    <a:pt x="33" y="5502"/>
                  </a:cubicBezTo>
                  <a:cubicBezTo>
                    <a:pt x="1790" y="3333"/>
                    <a:pt x="4986" y="943"/>
                    <a:pt x="7809" y="0"/>
                  </a:cubicBezTo>
                  <a:lnTo>
                    <a:pt x="14372" y="534"/>
                  </a:lnTo>
                  <a:cubicBezTo>
                    <a:pt x="15393" y="2043"/>
                    <a:pt x="16459" y="3521"/>
                    <a:pt x="17547" y="496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88" name="자유형: 도형 429"/>
            <p:cNvSpPr/>
            <p:nvPr/>
          </p:nvSpPr>
          <p:spPr>
            <a:xfrm>
              <a:off x="5410080" y="4651200"/>
              <a:ext cx="51480" cy="72720"/>
            </a:xfrm>
            <a:custGeom>
              <a:avLst/>
              <a:gdLst/>
              <a:ahLst/>
              <a:cxnLst/>
              <a:rect l="l" t="t" r="r" b="b"/>
              <a:pathLst>
                <a:path w="40928" h="59581">
                  <a:moveTo>
                    <a:pt x="27463" y="0"/>
                  </a:moveTo>
                  <a:cubicBezTo>
                    <a:pt x="29522" y="1069"/>
                    <a:pt x="34415" y="4276"/>
                    <a:pt x="35727" y="6005"/>
                  </a:cubicBezTo>
                  <a:cubicBezTo>
                    <a:pt x="36516" y="7043"/>
                    <a:pt x="36737" y="8804"/>
                    <a:pt x="37428" y="9935"/>
                  </a:cubicBezTo>
                  <a:cubicBezTo>
                    <a:pt x="37835" y="10595"/>
                    <a:pt x="40143" y="13142"/>
                    <a:pt x="40343" y="13582"/>
                  </a:cubicBezTo>
                  <a:cubicBezTo>
                    <a:pt x="41529" y="16286"/>
                    <a:pt x="40764" y="21254"/>
                    <a:pt x="39372" y="23770"/>
                  </a:cubicBezTo>
                  <a:cubicBezTo>
                    <a:pt x="32188" y="27008"/>
                    <a:pt x="30553" y="32510"/>
                    <a:pt x="24790" y="36063"/>
                  </a:cubicBezTo>
                  <a:cubicBezTo>
                    <a:pt x="23861" y="40779"/>
                    <a:pt x="20823" y="46627"/>
                    <a:pt x="17985" y="50715"/>
                  </a:cubicBezTo>
                  <a:cubicBezTo>
                    <a:pt x="16038" y="53513"/>
                    <a:pt x="13492" y="55871"/>
                    <a:pt x="11664" y="58795"/>
                  </a:cubicBezTo>
                  <a:lnTo>
                    <a:pt x="6319" y="59581"/>
                  </a:lnTo>
                  <a:cubicBezTo>
                    <a:pt x="3983" y="57820"/>
                    <a:pt x="1667" y="55242"/>
                    <a:pt x="243" y="52790"/>
                  </a:cubicBezTo>
                  <a:cubicBezTo>
                    <a:pt x="-893" y="46816"/>
                    <a:pt x="2130" y="37793"/>
                    <a:pt x="5589" y="32667"/>
                  </a:cubicBezTo>
                  <a:cubicBezTo>
                    <a:pt x="6466" y="31378"/>
                    <a:pt x="8037" y="30089"/>
                    <a:pt x="8749" y="28737"/>
                  </a:cubicBezTo>
                  <a:cubicBezTo>
                    <a:pt x="9539" y="27259"/>
                    <a:pt x="9868" y="25122"/>
                    <a:pt x="10447" y="23518"/>
                  </a:cubicBezTo>
                  <a:cubicBezTo>
                    <a:pt x="11114" y="21694"/>
                    <a:pt x="12036" y="19870"/>
                    <a:pt x="12636" y="18016"/>
                  </a:cubicBezTo>
                  <a:cubicBezTo>
                    <a:pt x="13239" y="16161"/>
                    <a:pt x="13415" y="14117"/>
                    <a:pt x="14095" y="12262"/>
                  </a:cubicBezTo>
                  <a:cubicBezTo>
                    <a:pt x="16175" y="6697"/>
                    <a:pt x="20574" y="1006"/>
                    <a:pt x="27463" y="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89" name="자유형: 도형 430"/>
            <p:cNvSpPr/>
            <p:nvPr/>
          </p:nvSpPr>
          <p:spPr>
            <a:xfrm>
              <a:off x="5183640" y="4633560"/>
              <a:ext cx="39960" cy="53640"/>
            </a:xfrm>
            <a:custGeom>
              <a:avLst/>
              <a:gdLst/>
              <a:ahLst/>
              <a:cxnLst/>
              <a:rect l="l" t="t" r="r" b="b"/>
              <a:pathLst>
                <a:path w="32020" h="43923">
                  <a:moveTo>
                    <a:pt x="25734" y="0"/>
                  </a:moveTo>
                  <a:lnTo>
                    <a:pt x="29462" y="5062"/>
                  </a:lnTo>
                  <a:cubicBezTo>
                    <a:pt x="35538" y="13300"/>
                    <a:pt x="29564" y="18550"/>
                    <a:pt x="24274" y="25373"/>
                  </a:cubicBezTo>
                  <a:cubicBezTo>
                    <a:pt x="23334" y="26568"/>
                    <a:pt x="21837" y="27982"/>
                    <a:pt x="21114" y="29272"/>
                  </a:cubicBezTo>
                  <a:cubicBezTo>
                    <a:pt x="20230" y="30876"/>
                    <a:pt x="20055" y="32919"/>
                    <a:pt x="19171" y="34523"/>
                  </a:cubicBezTo>
                  <a:cubicBezTo>
                    <a:pt x="17708" y="37132"/>
                    <a:pt x="14902" y="39836"/>
                    <a:pt x="13095" y="42351"/>
                  </a:cubicBezTo>
                  <a:lnTo>
                    <a:pt x="8234" y="43923"/>
                  </a:lnTo>
                  <a:cubicBezTo>
                    <a:pt x="5529" y="43295"/>
                    <a:pt x="1446" y="40622"/>
                    <a:pt x="454" y="38170"/>
                  </a:cubicBezTo>
                  <a:cubicBezTo>
                    <a:pt x="-262" y="34774"/>
                    <a:pt x="-93" y="30561"/>
                    <a:pt x="696" y="27196"/>
                  </a:cubicBezTo>
                  <a:cubicBezTo>
                    <a:pt x="5231" y="22292"/>
                    <a:pt x="12916" y="22512"/>
                    <a:pt x="17954" y="18299"/>
                  </a:cubicBezTo>
                  <a:cubicBezTo>
                    <a:pt x="21458" y="11696"/>
                    <a:pt x="18522" y="5785"/>
                    <a:pt x="25734" y="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90" name="자유형: 도형 431"/>
            <p:cNvSpPr/>
            <p:nvPr/>
          </p:nvSpPr>
          <p:spPr>
            <a:xfrm>
              <a:off x="5294520" y="4979160"/>
              <a:ext cx="25920" cy="20520"/>
            </a:xfrm>
            <a:custGeom>
              <a:avLst/>
              <a:gdLst/>
              <a:ahLst/>
              <a:cxnLst/>
              <a:rect l="l" t="t" r="r" b="b"/>
              <a:pathLst>
                <a:path w="20809" h="16863">
                  <a:moveTo>
                    <a:pt x="20809" y="5220"/>
                  </a:moveTo>
                  <a:cubicBezTo>
                    <a:pt x="20666" y="8144"/>
                    <a:pt x="18901" y="13300"/>
                    <a:pt x="16435" y="15407"/>
                  </a:cubicBezTo>
                  <a:cubicBezTo>
                    <a:pt x="12451" y="18110"/>
                    <a:pt x="4351" y="16790"/>
                    <a:pt x="1121" y="13583"/>
                  </a:cubicBezTo>
                  <a:cubicBezTo>
                    <a:pt x="-945" y="9307"/>
                    <a:pt x="-26" y="3804"/>
                    <a:pt x="2822" y="0"/>
                  </a:cubicBezTo>
                  <a:lnTo>
                    <a:pt x="6954" y="786"/>
                  </a:lnTo>
                  <a:lnTo>
                    <a:pt x="2822" y="0"/>
                  </a:lnTo>
                  <a:cubicBezTo>
                    <a:pt x="5463" y="283"/>
                    <a:pt x="7087" y="1478"/>
                    <a:pt x="9399" y="2358"/>
                  </a:cubicBezTo>
                  <a:cubicBezTo>
                    <a:pt x="12924" y="3710"/>
                    <a:pt x="17014" y="4748"/>
                    <a:pt x="20809" y="522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91" name="자유형: 도형 432"/>
            <p:cNvSpPr/>
            <p:nvPr/>
          </p:nvSpPr>
          <p:spPr>
            <a:xfrm>
              <a:off x="6144480" y="4779360"/>
              <a:ext cx="297360" cy="243000"/>
            </a:xfrm>
            <a:custGeom>
              <a:avLst/>
              <a:gdLst/>
              <a:ahLst/>
              <a:cxnLst/>
              <a:rect l="l" t="t" r="r" b="b"/>
              <a:pathLst>
                <a:path w="235646" h="198146">
                  <a:moveTo>
                    <a:pt x="235035" y="90445"/>
                  </a:moveTo>
                  <a:cubicBezTo>
                    <a:pt x="232162" y="91263"/>
                    <a:pt x="228837" y="93180"/>
                    <a:pt x="226775" y="95130"/>
                  </a:cubicBezTo>
                  <a:cubicBezTo>
                    <a:pt x="226056" y="100947"/>
                    <a:pt x="226603" y="106418"/>
                    <a:pt x="224828" y="112139"/>
                  </a:cubicBezTo>
                  <a:cubicBezTo>
                    <a:pt x="223327" y="116982"/>
                    <a:pt x="220419" y="122452"/>
                    <a:pt x="217535" y="126760"/>
                  </a:cubicBezTo>
                  <a:cubicBezTo>
                    <a:pt x="216690" y="128049"/>
                    <a:pt x="213074" y="133646"/>
                    <a:pt x="212190" y="135155"/>
                  </a:cubicBezTo>
                  <a:cubicBezTo>
                    <a:pt x="211337" y="136601"/>
                    <a:pt x="209973" y="138079"/>
                    <a:pt x="209275" y="139588"/>
                  </a:cubicBezTo>
                  <a:cubicBezTo>
                    <a:pt x="207735" y="142889"/>
                    <a:pt x="207521" y="147511"/>
                    <a:pt x="205385" y="150561"/>
                  </a:cubicBezTo>
                  <a:cubicBezTo>
                    <a:pt x="205269" y="150749"/>
                    <a:pt x="202109" y="153139"/>
                    <a:pt x="201740" y="153454"/>
                  </a:cubicBezTo>
                  <a:lnTo>
                    <a:pt x="195907" y="153705"/>
                  </a:lnTo>
                  <a:cubicBezTo>
                    <a:pt x="190225" y="149524"/>
                    <a:pt x="190845" y="146505"/>
                    <a:pt x="187888" y="142449"/>
                  </a:cubicBezTo>
                  <a:cubicBezTo>
                    <a:pt x="186342" y="140342"/>
                    <a:pt x="183104" y="138047"/>
                    <a:pt x="181083" y="136193"/>
                  </a:cubicBezTo>
                  <a:lnTo>
                    <a:pt x="174521" y="135657"/>
                  </a:lnTo>
                  <a:cubicBezTo>
                    <a:pt x="173233" y="139619"/>
                    <a:pt x="175594" y="140972"/>
                    <a:pt x="176218" y="144021"/>
                  </a:cubicBezTo>
                  <a:cubicBezTo>
                    <a:pt x="176734" y="146537"/>
                    <a:pt x="175976" y="151567"/>
                    <a:pt x="175005" y="153957"/>
                  </a:cubicBezTo>
                  <a:cubicBezTo>
                    <a:pt x="169621" y="160560"/>
                    <a:pt x="159266" y="159301"/>
                    <a:pt x="152152" y="163106"/>
                  </a:cubicBezTo>
                  <a:cubicBezTo>
                    <a:pt x="147739" y="165495"/>
                    <a:pt x="145032" y="169740"/>
                    <a:pt x="141703" y="173042"/>
                  </a:cubicBezTo>
                  <a:cubicBezTo>
                    <a:pt x="139307" y="175431"/>
                    <a:pt x="136862" y="177161"/>
                    <a:pt x="135140" y="180116"/>
                  </a:cubicBezTo>
                  <a:cubicBezTo>
                    <a:pt x="128447" y="182945"/>
                    <a:pt x="121323" y="182506"/>
                    <a:pt x="114480" y="184298"/>
                  </a:cubicBezTo>
                  <a:cubicBezTo>
                    <a:pt x="112912" y="184706"/>
                    <a:pt x="111424" y="185713"/>
                    <a:pt x="109860" y="186121"/>
                  </a:cubicBezTo>
                  <a:cubicBezTo>
                    <a:pt x="108250" y="186562"/>
                    <a:pt x="106387" y="186499"/>
                    <a:pt x="104756" y="186907"/>
                  </a:cubicBezTo>
                  <a:cubicBezTo>
                    <a:pt x="100579" y="187913"/>
                    <a:pt x="91841" y="192535"/>
                    <a:pt x="87741" y="194485"/>
                  </a:cubicBezTo>
                  <a:cubicBezTo>
                    <a:pt x="81251" y="197598"/>
                    <a:pt x="67652" y="198981"/>
                    <a:pt x="60517" y="197629"/>
                  </a:cubicBezTo>
                  <a:cubicBezTo>
                    <a:pt x="56978" y="196968"/>
                    <a:pt x="53534" y="195616"/>
                    <a:pt x="49903" y="194925"/>
                  </a:cubicBezTo>
                  <a:cubicBezTo>
                    <a:pt x="45378" y="194044"/>
                    <a:pt x="41762" y="195963"/>
                    <a:pt x="36942" y="194233"/>
                  </a:cubicBezTo>
                  <a:cubicBezTo>
                    <a:pt x="35830" y="191246"/>
                    <a:pt x="35760" y="187064"/>
                    <a:pt x="36455" y="184015"/>
                  </a:cubicBezTo>
                  <a:cubicBezTo>
                    <a:pt x="40341" y="181373"/>
                    <a:pt x="45929" y="180587"/>
                    <a:pt x="48851" y="176972"/>
                  </a:cubicBezTo>
                  <a:lnTo>
                    <a:pt x="49338" y="172539"/>
                  </a:lnTo>
                  <a:cubicBezTo>
                    <a:pt x="45336" y="168734"/>
                    <a:pt x="38714" y="168388"/>
                    <a:pt x="33778" y="165716"/>
                  </a:cubicBezTo>
                  <a:cubicBezTo>
                    <a:pt x="30586" y="162289"/>
                    <a:pt x="30278" y="157290"/>
                    <a:pt x="25998" y="154743"/>
                  </a:cubicBezTo>
                  <a:lnTo>
                    <a:pt x="20895" y="154491"/>
                  </a:lnTo>
                  <a:lnTo>
                    <a:pt x="18222" y="158925"/>
                  </a:lnTo>
                  <a:cubicBezTo>
                    <a:pt x="19081" y="163672"/>
                    <a:pt x="21021" y="168451"/>
                    <a:pt x="20407" y="173325"/>
                  </a:cubicBezTo>
                  <a:lnTo>
                    <a:pt x="16520" y="175652"/>
                  </a:lnTo>
                  <a:lnTo>
                    <a:pt x="11175" y="173576"/>
                  </a:lnTo>
                  <a:cubicBezTo>
                    <a:pt x="9523" y="171060"/>
                    <a:pt x="7260" y="168546"/>
                    <a:pt x="5829" y="165999"/>
                  </a:cubicBezTo>
                  <a:cubicBezTo>
                    <a:pt x="1090" y="157510"/>
                    <a:pt x="-4603" y="135218"/>
                    <a:pt x="6071" y="129118"/>
                  </a:cubicBezTo>
                  <a:cubicBezTo>
                    <a:pt x="7358" y="128395"/>
                    <a:pt x="9382" y="128269"/>
                    <a:pt x="10687" y="127546"/>
                  </a:cubicBezTo>
                  <a:cubicBezTo>
                    <a:pt x="12083" y="126792"/>
                    <a:pt x="13178" y="125188"/>
                    <a:pt x="14574" y="124402"/>
                  </a:cubicBezTo>
                  <a:cubicBezTo>
                    <a:pt x="17359" y="122893"/>
                    <a:pt x="20537" y="122484"/>
                    <a:pt x="23325" y="120503"/>
                  </a:cubicBezTo>
                  <a:cubicBezTo>
                    <a:pt x="27387" y="114655"/>
                    <a:pt x="27601" y="107235"/>
                    <a:pt x="34020" y="102707"/>
                  </a:cubicBezTo>
                  <a:cubicBezTo>
                    <a:pt x="35318" y="101796"/>
                    <a:pt x="37079" y="101261"/>
                    <a:pt x="38394" y="100380"/>
                  </a:cubicBezTo>
                  <a:cubicBezTo>
                    <a:pt x="41267" y="98400"/>
                    <a:pt x="42832" y="96231"/>
                    <a:pt x="46659" y="95382"/>
                  </a:cubicBezTo>
                  <a:lnTo>
                    <a:pt x="52979" y="96168"/>
                  </a:lnTo>
                  <a:lnTo>
                    <a:pt x="56624" y="99594"/>
                  </a:lnTo>
                  <a:lnTo>
                    <a:pt x="61485" y="98526"/>
                  </a:lnTo>
                  <a:lnTo>
                    <a:pt x="64891" y="94627"/>
                  </a:lnTo>
                  <a:cubicBezTo>
                    <a:pt x="64386" y="84597"/>
                    <a:pt x="63601" y="77774"/>
                    <a:pt x="69753" y="68720"/>
                  </a:cubicBezTo>
                  <a:cubicBezTo>
                    <a:pt x="74401" y="67147"/>
                    <a:pt x="79112" y="65669"/>
                    <a:pt x="83608" y="63752"/>
                  </a:cubicBezTo>
                  <a:lnTo>
                    <a:pt x="90171" y="64538"/>
                  </a:lnTo>
                  <a:cubicBezTo>
                    <a:pt x="93167" y="63594"/>
                    <a:pt x="96373" y="62085"/>
                    <a:pt x="98919" y="60356"/>
                  </a:cubicBezTo>
                  <a:cubicBezTo>
                    <a:pt x="101322" y="56583"/>
                    <a:pt x="102673" y="49414"/>
                    <a:pt x="107184" y="47560"/>
                  </a:cubicBezTo>
                  <a:cubicBezTo>
                    <a:pt x="111386" y="50169"/>
                    <a:pt x="111898" y="54948"/>
                    <a:pt x="115206" y="58281"/>
                  </a:cubicBezTo>
                  <a:cubicBezTo>
                    <a:pt x="126062" y="59853"/>
                    <a:pt x="140244" y="49069"/>
                    <a:pt x="143643" y="40233"/>
                  </a:cubicBezTo>
                  <a:cubicBezTo>
                    <a:pt x="145898" y="34385"/>
                    <a:pt x="145435" y="25707"/>
                    <a:pt x="139507" y="21683"/>
                  </a:cubicBezTo>
                  <a:cubicBezTo>
                    <a:pt x="131299" y="20897"/>
                    <a:pt x="124224" y="17029"/>
                    <a:pt x="117875" y="12533"/>
                  </a:cubicBezTo>
                  <a:cubicBezTo>
                    <a:pt x="116118" y="10238"/>
                    <a:pt x="115381" y="5774"/>
                    <a:pt x="115928" y="3101"/>
                  </a:cubicBezTo>
                  <a:lnTo>
                    <a:pt x="119576" y="240"/>
                  </a:lnTo>
                  <a:cubicBezTo>
                    <a:pt x="121285" y="20"/>
                    <a:pt x="126209" y="-263"/>
                    <a:pt x="127837" y="491"/>
                  </a:cubicBezTo>
                  <a:cubicBezTo>
                    <a:pt x="129345" y="1184"/>
                    <a:pt x="130689" y="2472"/>
                    <a:pt x="132214" y="3101"/>
                  </a:cubicBezTo>
                  <a:cubicBezTo>
                    <a:pt x="135982" y="4673"/>
                    <a:pt x="140654" y="5051"/>
                    <a:pt x="144369" y="6779"/>
                  </a:cubicBezTo>
                  <a:cubicBezTo>
                    <a:pt x="145891" y="7472"/>
                    <a:pt x="147210" y="8981"/>
                    <a:pt x="148743" y="9641"/>
                  </a:cubicBezTo>
                  <a:cubicBezTo>
                    <a:pt x="150539" y="10396"/>
                    <a:pt x="152938" y="10584"/>
                    <a:pt x="154818" y="11213"/>
                  </a:cubicBezTo>
                  <a:cubicBezTo>
                    <a:pt x="156614" y="11842"/>
                    <a:pt x="163987" y="14829"/>
                    <a:pt x="165267" y="15646"/>
                  </a:cubicBezTo>
                  <a:cubicBezTo>
                    <a:pt x="168161" y="17533"/>
                    <a:pt x="171943" y="23601"/>
                    <a:pt x="174261" y="26367"/>
                  </a:cubicBezTo>
                  <a:cubicBezTo>
                    <a:pt x="173339" y="30833"/>
                    <a:pt x="175373" y="36272"/>
                    <a:pt x="179607" y="38913"/>
                  </a:cubicBezTo>
                  <a:lnTo>
                    <a:pt x="184468" y="39196"/>
                  </a:lnTo>
                  <a:cubicBezTo>
                    <a:pt x="191757" y="36555"/>
                    <a:pt x="194272" y="29103"/>
                    <a:pt x="199779" y="27688"/>
                  </a:cubicBezTo>
                  <a:lnTo>
                    <a:pt x="204399" y="29260"/>
                  </a:lnTo>
                  <a:cubicBezTo>
                    <a:pt x="206125" y="33819"/>
                    <a:pt x="209212" y="41931"/>
                    <a:pt x="211688" y="45987"/>
                  </a:cubicBezTo>
                  <a:cubicBezTo>
                    <a:pt x="212411" y="47182"/>
                    <a:pt x="213642" y="48188"/>
                    <a:pt x="214364" y="49383"/>
                  </a:cubicBezTo>
                  <a:cubicBezTo>
                    <a:pt x="215136" y="50641"/>
                    <a:pt x="215459" y="52369"/>
                    <a:pt x="216308" y="53565"/>
                  </a:cubicBezTo>
                  <a:cubicBezTo>
                    <a:pt x="217998" y="55954"/>
                    <a:pt x="221152" y="58060"/>
                    <a:pt x="223358" y="60105"/>
                  </a:cubicBezTo>
                  <a:cubicBezTo>
                    <a:pt x="226613" y="63091"/>
                    <a:pt x="231044" y="66549"/>
                    <a:pt x="233081" y="70292"/>
                  </a:cubicBezTo>
                  <a:cubicBezTo>
                    <a:pt x="235793" y="75290"/>
                    <a:pt x="236193" y="85195"/>
                    <a:pt x="235035" y="9044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92" name="자유형: 도형 433"/>
            <p:cNvSpPr/>
            <p:nvPr/>
          </p:nvSpPr>
          <p:spPr>
            <a:xfrm>
              <a:off x="6417360" y="4650480"/>
              <a:ext cx="19800" cy="20520"/>
            </a:xfrm>
            <a:custGeom>
              <a:avLst/>
              <a:gdLst/>
              <a:ahLst/>
              <a:cxnLst/>
              <a:rect l="l" t="t" r="r" b="b"/>
              <a:pathLst>
                <a:path w="16094" h="16978">
                  <a:moveTo>
                    <a:pt x="3457" y="16978"/>
                  </a:moveTo>
                  <a:lnTo>
                    <a:pt x="54" y="13582"/>
                  </a:lnTo>
                  <a:cubicBezTo>
                    <a:pt x="-486" y="8615"/>
                    <a:pt x="3106" y="3930"/>
                    <a:pt x="7343" y="1037"/>
                  </a:cubicBezTo>
                  <a:lnTo>
                    <a:pt x="12689" y="0"/>
                  </a:lnTo>
                  <a:lnTo>
                    <a:pt x="16095" y="3395"/>
                  </a:lnTo>
                  <a:lnTo>
                    <a:pt x="16095" y="6539"/>
                  </a:lnTo>
                  <a:cubicBezTo>
                    <a:pt x="13467" y="11193"/>
                    <a:pt x="9360" y="15658"/>
                    <a:pt x="3457" y="1697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93" name="자유형: 도형 434"/>
            <p:cNvSpPr/>
            <p:nvPr/>
          </p:nvSpPr>
          <p:spPr>
            <a:xfrm>
              <a:off x="6344280" y="4996800"/>
              <a:ext cx="23760" cy="17280"/>
            </a:xfrm>
            <a:custGeom>
              <a:avLst/>
              <a:gdLst/>
              <a:ahLst/>
              <a:cxnLst/>
              <a:rect l="l" t="t" r="r" b="b"/>
              <a:pathLst>
                <a:path w="19004" h="14249">
                  <a:moveTo>
                    <a:pt x="19005" y="4434"/>
                  </a:moveTo>
                  <a:lnTo>
                    <a:pt x="18275" y="10187"/>
                  </a:lnTo>
                  <a:cubicBezTo>
                    <a:pt x="15437" y="14054"/>
                    <a:pt x="8103" y="14558"/>
                    <a:pt x="3448" y="14117"/>
                  </a:cubicBezTo>
                  <a:lnTo>
                    <a:pt x="42" y="11225"/>
                  </a:lnTo>
                  <a:cubicBezTo>
                    <a:pt x="-274" y="8395"/>
                    <a:pt x="1214" y="3522"/>
                    <a:pt x="3690" y="1572"/>
                  </a:cubicBezTo>
                  <a:lnTo>
                    <a:pt x="8552" y="0"/>
                  </a:lnTo>
                  <a:lnTo>
                    <a:pt x="13897" y="1038"/>
                  </a:lnTo>
                  <a:lnTo>
                    <a:pt x="19005" y="4434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94" name="자유형: 도형 435"/>
            <p:cNvSpPr/>
            <p:nvPr/>
          </p:nvSpPr>
          <p:spPr>
            <a:xfrm>
              <a:off x="6041520" y="5047560"/>
              <a:ext cx="69480" cy="21240"/>
            </a:xfrm>
            <a:custGeom>
              <a:avLst/>
              <a:gdLst/>
              <a:ahLst/>
              <a:cxnLst/>
              <a:rect l="l" t="t" r="r" b="b"/>
              <a:pathLst>
                <a:path w="55172" h="17460">
                  <a:moveTo>
                    <a:pt x="55172" y="13048"/>
                  </a:moveTo>
                  <a:lnTo>
                    <a:pt x="54201" y="16726"/>
                  </a:lnTo>
                  <a:cubicBezTo>
                    <a:pt x="45183" y="19210"/>
                    <a:pt x="37771" y="14777"/>
                    <a:pt x="29408" y="12545"/>
                  </a:cubicBezTo>
                  <a:lnTo>
                    <a:pt x="25522" y="11507"/>
                  </a:lnTo>
                  <a:cubicBezTo>
                    <a:pt x="18854" y="10879"/>
                    <a:pt x="13336" y="14809"/>
                    <a:pt x="2918" y="12545"/>
                  </a:cubicBezTo>
                  <a:lnTo>
                    <a:pt x="0" y="8866"/>
                  </a:lnTo>
                  <a:lnTo>
                    <a:pt x="730" y="3395"/>
                  </a:lnTo>
                  <a:cubicBezTo>
                    <a:pt x="2098" y="2924"/>
                    <a:pt x="3946" y="2075"/>
                    <a:pt x="5346" y="1823"/>
                  </a:cubicBezTo>
                  <a:cubicBezTo>
                    <a:pt x="10232" y="974"/>
                    <a:pt x="14280" y="2704"/>
                    <a:pt x="19689" y="2075"/>
                  </a:cubicBezTo>
                  <a:cubicBezTo>
                    <a:pt x="23908" y="1572"/>
                    <a:pt x="27953" y="0"/>
                    <a:pt x="32246" y="0"/>
                  </a:cubicBezTo>
                  <a:lnTo>
                    <a:pt x="35975" y="0"/>
                  </a:lnTo>
                  <a:cubicBezTo>
                    <a:pt x="38830" y="629"/>
                    <a:pt x="43369" y="3332"/>
                    <a:pt x="46428" y="4433"/>
                  </a:cubicBezTo>
                  <a:cubicBezTo>
                    <a:pt x="47694" y="8017"/>
                    <a:pt x="52338" y="10438"/>
                    <a:pt x="55172" y="1304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95" name="자유형: 도형 436"/>
            <p:cNvSpPr/>
            <p:nvPr/>
          </p:nvSpPr>
          <p:spPr>
            <a:xfrm>
              <a:off x="6068880" y="5079240"/>
              <a:ext cx="73440" cy="37080"/>
            </a:xfrm>
            <a:custGeom>
              <a:avLst/>
              <a:gdLst/>
              <a:ahLst/>
              <a:cxnLst/>
              <a:rect l="l" t="t" r="r" b="b"/>
              <a:pathLst>
                <a:path w="58494" h="30342">
                  <a:moveTo>
                    <a:pt x="53717" y="7073"/>
                  </a:moveTo>
                  <a:cubicBezTo>
                    <a:pt x="55358" y="11443"/>
                    <a:pt x="59343" y="15028"/>
                    <a:pt x="58333" y="19901"/>
                  </a:cubicBezTo>
                  <a:lnTo>
                    <a:pt x="55414" y="23831"/>
                  </a:lnTo>
                  <a:cubicBezTo>
                    <a:pt x="47006" y="27133"/>
                    <a:pt x="34333" y="32289"/>
                    <a:pt x="25273" y="29585"/>
                  </a:cubicBezTo>
                  <a:cubicBezTo>
                    <a:pt x="21278" y="28359"/>
                    <a:pt x="19064" y="26001"/>
                    <a:pt x="15795" y="24617"/>
                  </a:cubicBezTo>
                  <a:cubicBezTo>
                    <a:pt x="13982" y="23831"/>
                    <a:pt x="11533" y="23800"/>
                    <a:pt x="9720" y="23045"/>
                  </a:cubicBezTo>
                  <a:cubicBezTo>
                    <a:pt x="5833" y="21379"/>
                    <a:pt x="905" y="16663"/>
                    <a:pt x="0" y="12827"/>
                  </a:cubicBezTo>
                  <a:cubicBezTo>
                    <a:pt x="810" y="6759"/>
                    <a:pt x="8738" y="3803"/>
                    <a:pt x="13610" y="565"/>
                  </a:cubicBezTo>
                  <a:cubicBezTo>
                    <a:pt x="19706" y="470"/>
                    <a:pt x="21414" y="2954"/>
                    <a:pt x="25276" y="3678"/>
                  </a:cubicBezTo>
                  <a:cubicBezTo>
                    <a:pt x="30615" y="4715"/>
                    <a:pt x="38402" y="-441"/>
                    <a:pt x="46182" y="31"/>
                  </a:cubicBezTo>
                  <a:cubicBezTo>
                    <a:pt x="48610" y="2263"/>
                    <a:pt x="52584" y="5155"/>
                    <a:pt x="54204" y="7859"/>
                  </a:cubicBezTo>
                  <a:lnTo>
                    <a:pt x="53717" y="7073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96" name="자유형: 도형 437"/>
            <p:cNvSpPr/>
            <p:nvPr/>
          </p:nvSpPr>
          <p:spPr>
            <a:xfrm>
              <a:off x="6018120" y="5113080"/>
              <a:ext cx="34200" cy="27720"/>
            </a:xfrm>
            <a:custGeom>
              <a:avLst/>
              <a:gdLst/>
              <a:ahLst/>
              <a:cxnLst/>
              <a:rect l="l" t="t" r="r" b="b"/>
              <a:pathLst>
                <a:path w="27239" h="22983">
                  <a:moveTo>
                    <a:pt x="9494" y="503"/>
                  </a:moveTo>
                  <a:cubicBezTo>
                    <a:pt x="12455" y="5313"/>
                    <a:pt x="18818" y="9715"/>
                    <a:pt x="24567" y="11476"/>
                  </a:cubicBezTo>
                  <a:lnTo>
                    <a:pt x="27240" y="15123"/>
                  </a:lnTo>
                  <a:lnTo>
                    <a:pt x="25293" y="20626"/>
                  </a:lnTo>
                  <a:lnTo>
                    <a:pt x="21161" y="22984"/>
                  </a:lnTo>
                  <a:cubicBezTo>
                    <a:pt x="19614" y="22260"/>
                    <a:pt x="17446" y="21537"/>
                    <a:pt x="16057" y="20626"/>
                  </a:cubicBezTo>
                  <a:cubicBezTo>
                    <a:pt x="13356" y="18865"/>
                    <a:pt x="11364" y="16349"/>
                    <a:pt x="8277" y="14620"/>
                  </a:cubicBezTo>
                  <a:cubicBezTo>
                    <a:pt x="5548" y="13048"/>
                    <a:pt x="2661" y="11916"/>
                    <a:pt x="13" y="10155"/>
                  </a:cubicBezTo>
                  <a:cubicBezTo>
                    <a:pt x="-145" y="7169"/>
                    <a:pt x="1129" y="2421"/>
                    <a:pt x="3198" y="0"/>
                  </a:cubicBezTo>
                  <a:lnTo>
                    <a:pt x="9494" y="503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97" name="자유형: 도형 438"/>
            <p:cNvSpPr/>
            <p:nvPr/>
          </p:nvSpPr>
          <p:spPr>
            <a:xfrm>
              <a:off x="6083640" y="5148000"/>
              <a:ext cx="28800" cy="19440"/>
            </a:xfrm>
            <a:custGeom>
              <a:avLst/>
              <a:gdLst/>
              <a:ahLst/>
              <a:cxnLst/>
              <a:rect l="l" t="t" r="r" b="b"/>
              <a:pathLst>
                <a:path w="23121" h="16223">
                  <a:moveTo>
                    <a:pt x="488" y="16223"/>
                  </a:moveTo>
                  <a:lnTo>
                    <a:pt x="0" y="6036"/>
                  </a:lnTo>
                  <a:cubicBezTo>
                    <a:pt x="3167" y="5313"/>
                    <a:pt x="7885" y="4496"/>
                    <a:pt x="10695" y="3144"/>
                  </a:cubicBezTo>
                  <a:cubicBezTo>
                    <a:pt x="12547" y="2264"/>
                    <a:pt x="13743" y="723"/>
                    <a:pt x="15883" y="377"/>
                  </a:cubicBezTo>
                  <a:lnTo>
                    <a:pt x="17991" y="0"/>
                  </a:lnTo>
                  <a:lnTo>
                    <a:pt x="23095" y="2106"/>
                  </a:lnTo>
                  <a:cubicBezTo>
                    <a:pt x="23533" y="7892"/>
                    <a:pt x="18629" y="11036"/>
                    <a:pt x="13862" y="13771"/>
                  </a:cubicBezTo>
                  <a:cubicBezTo>
                    <a:pt x="12912" y="14337"/>
                    <a:pt x="12480" y="14809"/>
                    <a:pt x="11428" y="15186"/>
                  </a:cubicBezTo>
                  <a:cubicBezTo>
                    <a:pt x="9899" y="15689"/>
                    <a:pt x="3150" y="15658"/>
                    <a:pt x="488" y="16223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98" name="자유형: 도형 439"/>
            <p:cNvSpPr/>
            <p:nvPr/>
          </p:nvSpPr>
          <p:spPr>
            <a:xfrm>
              <a:off x="5090040" y="5308560"/>
              <a:ext cx="60840" cy="57960"/>
            </a:xfrm>
            <a:custGeom>
              <a:avLst/>
              <a:gdLst/>
              <a:ahLst/>
              <a:cxnLst/>
              <a:rect l="l" t="t" r="r" b="b"/>
              <a:pathLst>
                <a:path w="48391" h="47549">
                  <a:moveTo>
                    <a:pt x="47420" y="40277"/>
                  </a:moveTo>
                  <a:lnTo>
                    <a:pt x="48391" y="44961"/>
                  </a:lnTo>
                  <a:cubicBezTo>
                    <a:pt x="43765" y="49677"/>
                    <a:pt x="31274" y="46691"/>
                    <a:pt x="25300" y="45747"/>
                  </a:cubicBezTo>
                  <a:cubicBezTo>
                    <a:pt x="23052" y="40560"/>
                    <a:pt x="20916" y="33894"/>
                    <a:pt x="17040" y="29555"/>
                  </a:cubicBezTo>
                  <a:cubicBezTo>
                    <a:pt x="12599" y="27889"/>
                    <a:pt x="4980" y="26851"/>
                    <a:pt x="266" y="27983"/>
                  </a:cubicBezTo>
                  <a:cubicBezTo>
                    <a:pt x="-134" y="25090"/>
                    <a:pt x="-165" y="20029"/>
                    <a:pt x="754" y="17261"/>
                  </a:cubicBezTo>
                  <a:cubicBezTo>
                    <a:pt x="1283" y="15658"/>
                    <a:pt x="2865" y="14149"/>
                    <a:pt x="3430" y="12545"/>
                  </a:cubicBezTo>
                  <a:cubicBezTo>
                    <a:pt x="4794" y="8709"/>
                    <a:pt x="4191" y="5345"/>
                    <a:pt x="7316" y="1824"/>
                  </a:cubicBezTo>
                  <a:lnTo>
                    <a:pt x="10964" y="535"/>
                  </a:lnTo>
                  <a:lnTo>
                    <a:pt x="10477" y="0"/>
                  </a:lnTo>
                  <a:cubicBezTo>
                    <a:pt x="17359" y="0"/>
                    <a:pt x="24508" y="4245"/>
                    <a:pt x="26517" y="10218"/>
                  </a:cubicBezTo>
                  <a:cubicBezTo>
                    <a:pt x="27514" y="13143"/>
                    <a:pt x="27377" y="16758"/>
                    <a:pt x="28706" y="19619"/>
                  </a:cubicBezTo>
                  <a:cubicBezTo>
                    <a:pt x="29243" y="20783"/>
                    <a:pt x="33052" y="26096"/>
                    <a:pt x="34052" y="27197"/>
                  </a:cubicBezTo>
                  <a:cubicBezTo>
                    <a:pt x="36027" y="29398"/>
                    <a:pt x="39131" y="31002"/>
                    <a:pt x="41099" y="33202"/>
                  </a:cubicBezTo>
                  <a:cubicBezTo>
                    <a:pt x="43337" y="35718"/>
                    <a:pt x="44347" y="38233"/>
                    <a:pt x="47420" y="40277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199" name="자유형: 도형 440"/>
            <p:cNvSpPr/>
            <p:nvPr/>
          </p:nvSpPr>
          <p:spPr>
            <a:xfrm>
              <a:off x="6375240" y="5470920"/>
              <a:ext cx="36720" cy="37080"/>
            </a:xfrm>
            <a:custGeom>
              <a:avLst/>
              <a:gdLst/>
              <a:ahLst/>
              <a:cxnLst/>
              <a:rect l="l" t="t" r="r" b="b"/>
              <a:pathLst>
                <a:path w="29348" h="30431">
                  <a:moveTo>
                    <a:pt x="12820" y="11630"/>
                  </a:moveTo>
                  <a:lnTo>
                    <a:pt x="9664" y="15560"/>
                  </a:lnTo>
                  <a:cubicBezTo>
                    <a:pt x="12733" y="18830"/>
                    <a:pt x="14459" y="23609"/>
                    <a:pt x="15009" y="27822"/>
                  </a:cubicBezTo>
                  <a:lnTo>
                    <a:pt x="11119" y="30431"/>
                  </a:lnTo>
                  <a:lnTo>
                    <a:pt x="6258" y="28891"/>
                  </a:lnTo>
                  <a:cubicBezTo>
                    <a:pt x="772" y="21848"/>
                    <a:pt x="-884" y="14554"/>
                    <a:pt x="424" y="6127"/>
                  </a:cubicBezTo>
                  <a:lnTo>
                    <a:pt x="3585" y="2197"/>
                  </a:lnTo>
                  <a:cubicBezTo>
                    <a:pt x="8106" y="1663"/>
                    <a:pt x="15630" y="-538"/>
                    <a:pt x="19871" y="122"/>
                  </a:cubicBezTo>
                  <a:lnTo>
                    <a:pt x="23922" y="1506"/>
                  </a:lnTo>
                  <a:cubicBezTo>
                    <a:pt x="25806" y="2166"/>
                    <a:pt x="28279" y="3675"/>
                    <a:pt x="29349" y="5341"/>
                  </a:cubicBezTo>
                  <a:lnTo>
                    <a:pt x="28861" y="9523"/>
                  </a:lnTo>
                  <a:lnTo>
                    <a:pt x="25217" y="12667"/>
                  </a:lnTo>
                  <a:cubicBezTo>
                    <a:pt x="23691" y="13328"/>
                    <a:pt x="14781" y="11881"/>
                    <a:pt x="12820" y="1163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00" name="자유형: 도형 441"/>
            <p:cNvSpPr/>
            <p:nvPr/>
          </p:nvSpPr>
          <p:spPr>
            <a:xfrm>
              <a:off x="6569280" y="5202360"/>
              <a:ext cx="16920" cy="17640"/>
            </a:xfrm>
            <a:custGeom>
              <a:avLst/>
              <a:gdLst/>
              <a:ahLst/>
              <a:cxnLst/>
              <a:rect l="l" t="t" r="r" b="b"/>
              <a:pathLst>
                <a:path w="13700" h="14651">
                  <a:moveTo>
                    <a:pt x="4838" y="14651"/>
                  </a:moveTo>
                  <a:lnTo>
                    <a:pt x="222" y="13079"/>
                  </a:lnTo>
                  <a:cubicBezTo>
                    <a:pt x="-550" y="10218"/>
                    <a:pt x="773" y="5376"/>
                    <a:pt x="2895" y="3144"/>
                  </a:cubicBezTo>
                  <a:cubicBezTo>
                    <a:pt x="5231" y="1509"/>
                    <a:pt x="8963" y="252"/>
                    <a:pt x="11889" y="0"/>
                  </a:cubicBezTo>
                  <a:cubicBezTo>
                    <a:pt x="13923" y="2264"/>
                    <a:pt x="14116" y="7326"/>
                    <a:pt x="13102" y="9935"/>
                  </a:cubicBezTo>
                  <a:lnTo>
                    <a:pt x="13344" y="9149"/>
                  </a:lnTo>
                  <a:cubicBezTo>
                    <a:pt x="11892" y="11507"/>
                    <a:pt x="7813" y="14180"/>
                    <a:pt x="4838" y="14651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01" name="자유형: 도형 442"/>
            <p:cNvSpPr/>
            <p:nvPr/>
          </p:nvSpPr>
          <p:spPr>
            <a:xfrm>
              <a:off x="6676560" y="5148360"/>
              <a:ext cx="24480" cy="19800"/>
            </a:xfrm>
            <a:custGeom>
              <a:avLst/>
              <a:gdLst/>
              <a:ahLst/>
              <a:cxnLst/>
              <a:rect l="l" t="t" r="r" b="b"/>
              <a:pathLst>
                <a:path w="19694" h="16281">
                  <a:moveTo>
                    <a:pt x="19695" y="11487"/>
                  </a:moveTo>
                  <a:lnTo>
                    <a:pt x="16538" y="15166"/>
                  </a:lnTo>
                  <a:cubicBezTo>
                    <a:pt x="11462" y="16675"/>
                    <a:pt x="4643" y="17021"/>
                    <a:pt x="248" y="13846"/>
                  </a:cubicBezTo>
                  <a:cubicBezTo>
                    <a:pt x="-232" y="10544"/>
                    <a:pt x="13" y="6677"/>
                    <a:pt x="736" y="3407"/>
                  </a:cubicBezTo>
                  <a:cubicBezTo>
                    <a:pt x="2683" y="1426"/>
                    <a:pt x="7313" y="-146"/>
                    <a:pt x="10217" y="11"/>
                  </a:cubicBezTo>
                  <a:cubicBezTo>
                    <a:pt x="16037" y="1269"/>
                    <a:pt x="18923" y="6582"/>
                    <a:pt x="19695" y="11487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02" name="자유형: 도형 443"/>
            <p:cNvSpPr/>
            <p:nvPr/>
          </p:nvSpPr>
          <p:spPr>
            <a:xfrm>
              <a:off x="6634080" y="5168520"/>
              <a:ext cx="54360" cy="57600"/>
            </a:xfrm>
            <a:custGeom>
              <a:avLst/>
              <a:gdLst/>
              <a:ahLst/>
              <a:cxnLst/>
              <a:rect l="l" t="t" r="r" b="b"/>
              <a:pathLst>
                <a:path w="43454" h="47319">
                  <a:moveTo>
                    <a:pt x="43455" y="37635"/>
                  </a:moveTo>
                  <a:lnTo>
                    <a:pt x="39319" y="39711"/>
                  </a:lnTo>
                  <a:cubicBezTo>
                    <a:pt x="36327" y="39962"/>
                    <a:pt x="31441" y="38265"/>
                    <a:pt x="29599" y="36063"/>
                  </a:cubicBezTo>
                  <a:lnTo>
                    <a:pt x="25225" y="36598"/>
                  </a:lnTo>
                  <a:cubicBezTo>
                    <a:pt x="21872" y="39774"/>
                    <a:pt x="20318" y="45905"/>
                    <a:pt x="15502" y="47319"/>
                  </a:cubicBezTo>
                  <a:cubicBezTo>
                    <a:pt x="11664" y="46407"/>
                    <a:pt x="7588" y="45056"/>
                    <a:pt x="4077" y="43389"/>
                  </a:cubicBezTo>
                  <a:cubicBezTo>
                    <a:pt x="3761" y="40339"/>
                    <a:pt x="3169" y="36881"/>
                    <a:pt x="2134" y="33988"/>
                  </a:cubicBezTo>
                  <a:cubicBezTo>
                    <a:pt x="1664" y="32637"/>
                    <a:pt x="468" y="31127"/>
                    <a:pt x="187" y="29806"/>
                  </a:cubicBezTo>
                  <a:cubicBezTo>
                    <a:pt x="-391" y="27071"/>
                    <a:pt x="496" y="6099"/>
                    <a:pt x="1159" y="3113"/>
                  </a:cubicBezTo>
                  <a:lnTo>
                    <a:pt x="4803" y="0"/>
                  </a:lnTo>
                  <a:lnTo>
                    <a:pt x="10879" y="2076"/>
                  </a:lnTo>
                  <a:lnTo>
                    <a:pt x="12096" y="4685"/>
                  </a:lnTo>
                  <a:cubicBezTo>
                    <a:pt x="20805" y="6540"/>
                    <a:pt x="34250" y="6037"/>
                    <a:pt x="38105" y="14903"/>
                  </a:cubicBezTo>
                  <a:cubicBezTo>
                    <a:pt x="38737" y="16349"/>
                    <a:pt x="38730" y="18142"/>
                    <a:pt x="39329" y="19619"/>
                  </a:cubicBezTo>
                  <a:cubicBezTo>
                    <a:pt x="40571" y="22669"/>
                    <a:pt x="42122" y="24116"/>
                    <a:pt x="42479" y="27700"/>
                  </a:cubicBezTo>
                  <a:cubicBezTo>
                    <a:pt x="42823" y="31127"/>
                    <a:pt x="42360" y="34209"/>
                    <a:pt x="43455" y="3763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03" name="자유형: 도형 444"/>
            <p:cNvSpPr/>
            <p:nvPr/>
          </p:nvSpPr>
          <p:spPr>
            <a:xfrm>
              <a:off x="6576120" y="5228280"/>
              <a:ext cx="122400" cy="48240"/>
            </a:xfrm>
            <a:custGeom>
              <a:avLst/>
              <a:gdLst/>
              <a:ahLst/>
              <a:cxnLst/>
              <a:rect l="l" t="t" r="r" b="b"/>
              <a:pathLst>
                <a:path w="97193" h="39497">
                  <a:moveTo>
                    <a:pt x="91118" y="22481"/>
                  </a:moveTo>
                  <a:lnTo>
                    <a:pt x="85281" y="22764"/>
                  </a:lnTo>
                  <a:cubicBezTo>
                    <a:pt x="80188" y="20343"/>
                    <a:pt x="75891" y="16413"/>
                    <a:pt x="69724" y="17010"/>
                  </a:cubicBezTo>
                  <a:lnTo>
                    <a:pt x="64863" y="18582"/>
                  </a:lnTo>
                  <a:cubicBezTo>
                    <a:pt x="62625" y="19840"/>
                    <a:pt x="54473" y="29461"/>
                    <a:pt x="51007" y="31913"/>
                  </a:cubicBezTo>
                  <a:cubicBezTo>
                    <a:pt x="50471" y="32290"/>
                    <a:pt x="38432" y="37793"/>
                    <a:pt x="37882" y="37918"/>
                  </a:cubicBezTo>
                  <a:cubicBezTo>
                    <a:pt x="33062" y="39051"/>
                    <a:pt x="25854" y="37824"/>
                    <a:pt x="20624" y="38453"/>
                  </a:cubicBezTo>
                  <a:cubicBezTo>
                    <a:pt x="14952" y="39114"/>
                    <a:pt x="9803" y="40905"/>
                    <a:pt x="4583" y="37384"/>
                  </a:cubicBezTo>
                  <a:cubicBezTo>
                    <a:pt x="-2071" y="30373"/>
                    <a:pt x="100" y="26317"/>
                    <a:pt x="1423" y="18299"/>
                  </a:cubicBezTo>
                  <a:cubicBezTo>
                    <a:pt x="2075" y="14369"/>
                    <a:pt x="1844" y="11004"/>
                    <a:pt x="4099" y="7326"/>
                  </a:cubicBezTo>
                  <a:cubicBezTo>
                    <a:pt x="10199" y="3050"/>
                    <a:pt x="10753" y="3396"/>
                    <a:pt x="17712" y="1572"/>
                  </a:cubicBezTo>
                  <a:cubicBezTo>
                    <a:pt x="18428" y="1384"/>
                    <a:pt x="21915" y="63"/>
                    <a:pt x="22328" y="0"/>
                  </a:cubicBezTo>
                  <a:lnTo>
                    <a:pt x="26541" y="346"/>
                  </a:lnTo>
                  <a:cubicBezTo>
                    <a:pt x="29267" y="598"/>
                    <a:pt x="32883" y="1006"/>
                    <a:pt x="35454" y="1855"/>
                  </a:cubicBezTo>
                  <a:cubicBezTo>
                    <a:pt x="40726" y="3553"/>
                    <a:pt x="47380" y="10062"/>
                    <a:pt x="52954" y="9684"/>
                  </a:cubicBezTo>
                  <a:cubicBezTo>
                    <a:pt x="58181" y="9339"/>
                    <a:pt x="62656" y="6760"/>
                    <a:pt x="67785" y="6288"/>
                  </a:cubicBezTo>
                  <a:cubicBezTo>
                    <a:pt x="73467" y="5754"/>
                    <a:pt x="79599" y="6572"/>
                    <a:pt x="85281" y="6037"/>
                  </a:cubicBezTo>
                  <a:cubicBezTo>
                    <a:pt x="88824" y="5691"/>
                    <a:pt x="91511" y="4528"/>
                    <a:pt x="95250" y="5251"/>
                  </a:cubicBezTo>
                  <a:lnTo>
                    <a:pt x="97193" y="9432"/>
                  </a:lnTo>
                  <a:cubicBezTo>
                    <a:pt x="95969" y="14684"/>
                    <a:pt x="96193" y="18991"/>
                    <a:pt x="91118" y="22481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04" name="자유형: 도형 445"/>
            <p:cNvSpPr/>
            <p:nvPr/>
          </p:nvSpPr>
          <p:spPr>
            <a:xfrm>
              <a:off x="6714720" y="5203800"/>
              <a:ext cx="45360" cy="81360"/>
            </a:xfrm>
            <a:custGeom>
              <a:avLst/>
              <a:gdLst/>
              <a:ahLst/>
              <a:cxnLst/>
              <a:rect l="l" t="t" r="r" b="b"/>
              <a:pathLst>
                <a:path w="36263" h="66577">
                  <a:moveTo>
                    <a:pt x="36217" y="10863"/>
                  </a:moveTo>
                  <a:cubicBezTo>
                    <a:pt x="36546" y="13598"/>
                    <a:pt x="35112" y="18503"/>
                    <a:pt x="32572" y="20295"/>
                  </a:cubicBezTo>
                  <a:cubicBezTo>
                    <a:pt x="29878" y="20421"/>
                    <a:pt x="26823" y="20987"/>
                    <a:pt x="24308" y="21868"/>
                  </a:cubicBezTo>
                  <a:lnTo>
                    <a:pt x="22849" y="26835"/>
                  </a:lnTo>
                  <a:cubicBezTo>
                    <a:pt x="24427" y="29539"/>
                    <a:pt x="25255" y="32526"/>
                    <a:pt x="26739" y="35199"/>
                  </a:cubicBezTo>
                  <a:cubicBezTo>
                    <a:pt x="27416" y="36424"/>
                    <a:pt x="28872" y="37620"/>
                    <a:pt x="29415" y="38846"/>
                  </a:cubicBezTo>
                  <a:cubicBezTo>
                    <a:pt x="29956" y="40104"/>
                    <a:pt x="30106" y="42210"/>
                    <a:pt x="30384" y="43562"/>
                  </a:cubicBezTo>
                  <a:cubicBezTo>
                    <a:pt x="26273" y="51359"/>
                    <a:pt x="27679" y="59692"/>
                    <a:pt x="24063" y="66043"/>
                  </a:cubicBezTo>
                  <a:lnTo>
                    <a:pt x="18717" y="66577"/>
                  </a:lnTo>
                  <a:cubicBezTo>
                    <a:pt x="14883" y="63370"/>
                    <a:pt x="9232" y="62395"/>
                    <a:pt x="4619" y="60289"/>
                  </a:cubicBezTo>
                  <a:cubicBezTo>
                    <a:pt x="3648" y="57710"/>
                    <a:pt x="1494" y="54472"/>
                    <a:pt x="972" y="51925"/>
                  </a:cubicBezTo>
                  <a:cubicBezTo>
                    <a:pt x="133" y="47870"/>
                    <a:pt x="1571" y="39380"/>
                    <a:pt x="3648" y="35733"/>
                  </a:cubicBezTo>
                  <a:cubicBezTo>
                    <a:pt x="5574" y="32337"/>
                    <a:pt x="7836" y="30891"/>
                    <a:pt x="8994" y="26552"/>
                  </a:cubicBezTo>
                  <a:cubicBezTo>
                    <a:pt x="9145" y="21868"/>
                    <a:pt x="5202" y="17402"/>
                    <a:pt x="729" y="15327"/>
                  </a:cubicBezTo>
                  <a:lnTo>
                    <a:pt x="0" y="10611"/>
                  </a:lnTo>
                  <a:cubicBezTo>
                    <a:pt x="2739" y="10926"/>
                    <a:pt x="7412" y="9322"/>
                    <a:pt x="9239" y="7467"/>
                  </a:cubicBezTo>
                  <a:cubicBezTo>
                    <a:pt x="11347" y="5361"/>
                    <a:pt x="11845" y="2436"/>
                    <a:pt x="14585" y="424"/>
                  </a:cubicBezTo>
                  <a:cubicBezTo>
                    <a:pt x="16395" y="-173"/>
                    <a:pt x="19040" y="-78"/>
                    <a:pt x="20822" y="330"/>
                  </a:cubicBezTo>
                  <a:cubicBezTo>
                    <a:pt x="28661" y="2154"/>
                    <a:pt x="30832" y="6178"/>
                    <a:pt x="36217" y="10863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05" name="자유형: 도형 446"/>
            <p:cNvSpPr/>
            <p:nvPr/>
          </p:nvSpPr>
          <p:spPr>
            <a:xfrm>
              <a:off x="6835680" y="5194440"/>
              <a:ext cx="22320" cy="29520"/>
            </a:xfrm>
            <a:custGeom>
              <a:avLst/>
              <a:gdLst/>
              <a:ahLst/>
              <a:cxnLst/>
              <a:rect l="l" t="t" r="r" b="b"/>
              <a:pathLst>
                <a:path w="17813" h="24335">
                  <a:moveTo>
                    <a:pt x="17073" y="8395"/>
                  </a:moveTo>
                  <a:lnTo>
                    <a:pt x="17813" y="13080"/>
                  </a:lnTo>
                  <a:cubicBezTo>
                    <a:pt x="16017" y="17198"/>
                    <a:pt x="12703" y="21758"/>
                    <a:pt x="8578" y="24336"/>
                  </a:cubicBezTo>
                  <a:lnTo>
                    <a:pt x="4691" y="22481"/>
                  </a:lnTo>
                  <a:cubicBezTo>
                    <a:pt x="3278" y="20468"/>
                    <a:pt x="843" y="16664"/>
                    <a:pt x="313" y="14400"/>
                  </a:cubicBezTo>
                  <a:cubicBezTo>
                    <a:pt x="-707" y="9999"/>
                    <a:pt x="706" y="2421"/>
                    <a:pt x="5417" y="0"/>
                  </a:cubicBezTo>
                  <a:cubicBezTo>
                    <a:pt x="7483" y="755"/>
                    <a:pt x="14470" y="4716"/>
                    <a:pt x="14411" y="7074"/>
                  </a:cubicBezTo>
                  <a:lnTo>
                    <a:pt x="17073" y="8395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06" name="자유형: 도형 447"/>
            <p:cNvSpPr/>
            <p:nvPr/>
          </p:nvSpPr>
          <p:spPr>
            <a:xfrm>
              <a:off x="6716880" y="4981680"/>
              <a:ext cx="134640" cy="120600"/>
            </a:xfrm>
            <a:custGeom>
              <a:avLst/>
              <a:gdLst/>
              <a:ahLst/>
              <a:cxnLst/>
              <a:rect l="l" t="t" r="r" b="b"/>
              <a:pathLst>
                <a:path w="106980" h="98391">
                  <a:moveTo>
                    <a:pt x="52040" y="6797"/>
                  </a:moveTo>
                  <a:cubicBezTo>
                    <a:pt x="55965" y="8966"/>
                    <a:pt x="58953" y="12078"/>
                    <a:pt x="62258" y="14909"/>
                  </a:cubicBezTo>
                  <a:cubicBezTo>
                    <a:pt x="64797" y="17078"/>
                    <a:pt x="68722" y="19814"/>
                    <a:pt x="70518" y="22486"/>
                  </a:cubicBezTo>
                  <a:cubicBezTo>
                    <a:pt x="75260" y="29529"/>
                    <a:pt x="71321" y="38710"/>
                    <a:pt x="75380" y="45753"/>
                  </a:cubicBezTo>
                  <a:cubicBezTo>
                    <a:pt x="78523" y="51192"/>
                    <a:pt x="85121" y="53550"/>
                    <a:pt x="88505" y="59366"/>
                  </a:cubicBezTo>
                  <a:cubicBezTo>
                    <a:pt x="88421" y="62479"/>
                    <a:pt x="88842" y="65969"/>
                    <a:pt x="89723" y="69019"/>
                  </a:cubicBezTo>
                  <a:cubicBezTo>
                    <a:pt x="92357" y="70214"/>
                    <a:pt x="94437" y="71974"/>
                    <a:pt x="96370" y="73893"/>
                  </a:cubicBezTo>
                  <a:cubicBezTo>
                    <a:pt x="97839" y="75370"/>
                    <a:pt x="99888" y="76879"/>
                    <a:pt x="101147" y="78451"/>
                  </a:cubicBezTo>
                  <a:cubicBezTo>
                    <a:pt x="103915" y="81879"/>
                    <a:pt x="105360" y="87003"/>
                    <a:pt x="106980" y="90997"/>
                  </a:cubicBezTo>
                  <a:lnTo>
                    <a:pt x="104553" y="95429"/>
                  </a:lnTo>
                  <a:cubicBezTo>
                    <a:pt x="96622" y="98480"/>
                    <a:pt x="88306" y="92474"/>
                    <a:pt x="80971" y="95178"/>
                  </a:cubicBezTo>
                  <a:lnTo>
                    <a:pt x="77327" y="98291"/>
                  </a:lnTo>
                  <a:cubicBezTo>
                    <a:pt x="72517" y="98825"/>
                    <a:pt x="69280" y="97096"/>
                    <a:pt x="64930" y="95965"/>
                  </a:cubicBezTo>
                  <a:cubicBezTo>
                    <a:pt x="58985" y="94392"/>
                    <a:pt x="51927" y="93606"/>
                    <a:pt x="45726" y="93606"/>
                  </a:cubicBezTo>
                  <a:lnTo>
                    <a:pt x="41352" y="90713"/>
                  </a:lnTo>
                  <a:lnTo>
                    <a:pt x="41594" y="86280"/>
                  </a:lnTo>
                  <a:cubicBezTo>
                    <a:pt x="46094" y="84425"/>
                    <a:pt x="50247" y="80778"/>
                    <a:pt x="52531" y="76879"/>
                  </a:cubicBezTo>
                  <a:lnTo>
                    <a:pt x="52289" y="71911"/>
                  </a:lnTo>
                  <a:lnTo>
                    <a:pt x="48886" y="68767"/>
                  </a:lnTo>
                  <a:cubicBezTo>
                    <a:pt x="43488" y="69302"/>
                    <a:pt x="38377" y="71409"/>
                    <a:pt x="33088" y="71911"/>
                  </a:cubicBezTo>
                  <a:cubicBezTo>
                    <a:pt x="29401" y="72258"/>
                    <a:pt x="24539" y="71755"/>
                    <a:pt x="21176" y="70339"/>
                  </a:cubicBezTo>
                  <a:cubicBezTo>
                    <a:pt x="20393" y="69994"/>
                    <a:pt x="17426" y="67667"/>
                    <a:pt x="16801" y="67447"/>
                  </a:cubicBezTo>
                  <a:cubicBezTo>
                    <a:pt x="14721" y="66724"/>
                    <a:pt x="8253" y="66284"/>
                    <a:pt x="4647" y="65089"/>
                  </a:cubicBezTo>
                  <a:cubicBezTo>
                    <a:pt x="3605" y="63800"/>
                    <a:pt x="210" y="58424"/>
                    <a:pt x="31" y="57008"/>
                  </a:cubicBezTo>
                  <a:cubicBezTo>
                    <a:pt x="-488" y="52984"/>
                    <a:pt x="5619" y="20882"/>
                    <a:pt x="7324" y="16481"/>
                  </a:cubicBezTo>
                  <a:cubicBezTo>
                    <a:pt x="7987" y="14751"/>
                    <a:pt x="13420" y="6922"/>
                    <a:pt x="15100" y="5759"/>
                  </a:cubicBezTo>
                  <a:cubicBezTo>
                    <a:pt x="19425" y="2709"/>
                    <a:pt x="24683" y="3024"/>
                    <a:pt x="29685" y="1829"/>
                  </a:cubicBezTo>
                  <a:cubicBezTo>
                    <a:pt x="31204" y="1452"/>
                    <a:pt x="32786" y="540"/>
                    <a:pt x="34301" y="257"/>
                  </a:cubicBezTo>
                  <a:cubicBezTo>
                    <a:pt x="40043" y="-749"/>
                    <a:pt x="46708" y="1294"/>
                    <a:pt x="51075" y="4690"/>
                  </a:cubicBezTo>
                  <a:lnTo>
                    <a:pt x="52040" y="6797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07" name="자유형: 도형 448"/>
            <p:cNvSpPr/>
            <p:nvPr/>
          </p:nvSpPr>
          <p:spPr>
            <a:xfrm>
              <a:off x="6837120" y="4937400"/>
              <a:ext cx="116640" cy="86040"/>
            </a:xfrm>
            <a:custGeom>
              <a:avLst/>
              <a:gdLst/>
              <a:ahLst/>
              <a:cxnLst/>
              <a:rect l="l" t="t" r="r" b="b"/>
              <a:pathLst>
                <a:path w="92572" h="70303">
                  <a:moveTo>
                    <a:pt x="91880" y="36346"/>
                  </a:moveTo>
                  <a:cubicBezTo>
                    <a:pt x="89015" y="37604"/>
                    <a:pt x="86138" y="39270"/>
                    <a:pt x="83616" y="41031"/>
                  </a:cubicBezTo>
                  <a:cubicBezTo>
                    <a:pt x="79498" y="39994"/>
                    <a:pt x="73995" y="38359"/>
                    <a:pt x="69764" y="38170"/>
                  </a:cubicBezTo>
                  <a:lnTo>
                    <a:pt x="64657" y="38956"/>
                  </a:lnTo>
                  <a:cubicBezTo>
                    <a:pt x="61974" y="39648"/>
                    <a:pt x="43306" y="46031"/>
                    <a:pt x="41078" y="47037"/>
                  </a:cubicBezTo>
                  <a:cubicBezTo>
                    <a:pt x="39132" y="47948"/>
                    <a:pt x="34786" y="51061"/>
                    <a:pt x="33302" y="52539"/>
                  </a:cubicBezTo>
                  <a:cubicBezTo>
                    <a:pt x="28461" y="57380"/>
                    <a:pt x="26515" y="64141"/>
                    <a:pt x="21877" y="69265"/>
                  </a:cubicBezTo>
                  <a:lnTo>
                    <a:pt x="16528" y="70303"/>
                  </a:lnTo>
                  <a:lnTo>
                    <a:pt x="13855" y="66656"/>
                  </a:lnTo>
                  <a:cubicBezTo>
                    <a:pt x="14866" y="63009"/>
                    <a:pt x="15848" y="59362"/>
                    <a:pt x="16770" y="55683"/>
                  </a:cubicBezTo>
                  <a:lnTo>
                    <a:pt x="13126" y="52539"/>
                  </a:lnTo>
                  <a:cubicBezTo>
                    <a:pt x="9734" y="52224"/>
                    <a:pt x="5416" y="52539"/>
                    <a:pt x="2189" y="53576"/>
                  </a:cubicBezTo>
                  <a:lnTo>
                    <a:pt x="0" y="50464"/>
                  </a:lnTo>
                  <a:cubicBezTo>
                    <a:pt x="2641" y="44584"/>
                    <a:pt x="9530" y="39491"/>
                    <a:pt x="11425" y="33706"/>
                  </a:cubicBezTo>
                  <a:cubicBezTo>
                    <a:pt x="11846" y="32448"/>
                    <a:pt x="11344" y="30592"/>
                    <a:pt x="11667" y="29272"/>
                  </a:cubicBezTo>
                  <a:cubicBezTo>
                    <a:pt x="11796" y="28738"/>
                    <a:pt x="15834" y="18865"/>
                    <a:pt x="16044" y="18551"/>
                  </a:cubicBezTo>
                  <a:cubicBezTo>
                    <a:pt x="18037" y="15689"/>
                    <a:pt x="24845" y="12357"/>
                    <a:pt x="28437" y="11508"/>
                  </a:cubicBezTo>
                  <a:lnTo>
                    <a:pt x="28924" y="8898"/>
                  </a:lnTo>
                  <a:cubicBezTo>
                    <a:pt x="35277" y="5565"/>
                    <a:pt x="40973" y="4371"/>
                    <a:pt x="47883" y="2610"/>
                  </a:cubicBezTo>
                  <a:cubicBezTo>
                    <a:pt x="51268" y="1729"/>
                    <a:pt x="54320" y="504"/>
                    <a:pt x="57852" y="0"/>
                  </a:cubicBezTo>
                  <a:lnTo>
                    <a:pt x="63686" y="2076"/>
                  </a:lnTo>
                  <a:lnTo>
                    <a:pt x="64412" y="5754"/>
                  </a:lnTo>
                  <a:cubicBezTo>
                    <a:pt x="61416" y="7011"/>
                    <a:pt x="58140" y="8112"/>
                    <a:pt x="54934" y="8898"/>
                  </a:cubicBezTo>
                  <a:lnTo>
                    <a:pt x="52258" y="13583"/>
                  </a:lnTo>
                  <a:cubicBezTo>
                    <a:pt x="55614" y="13363"/>
                    <a:pt x="60406" y="12828"/>
                    <a:pt x="63686" y="13331"/>
                  </a:cubicBezTo>
                  <a:cubicBezTo>
                    <a:pt x="68495" y="14086"/>
                    <a:pt x="72479" y="16821"/>
                    <a:pt x="76808" y="18551"/>
                  </a:cubicBezTo>
                  <a:cubicBezTo>
                    <a:pt x="78720" y="19305"/>
                    <a:pt x="81003" y="19588"/>
                    <a:pt x="82883" y="20374"/>
                  </a:cubicBezTo>
                  <a:cubicBezTo>
                    <a:pt x="89492" y="23204"/>
                    <a:pt x="94455" y="29713"/>
                    <a:pt x="91880" y="36346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08" name="자유형: 도형 449"/>
            <p:cNvSpPr/>
            <p:nvPr/>
          </p:nvSpPr>
          <p:spPr>
            <a:xfrm>
              <a:off x="6961680" y="4973040"/>
              <a:ext cx="75960" cy="53280"/>
            </a:xfrm>
            <a:custGeom>
              <a:avLst/>
              <a:gdLst/>
              <a:ahLst/>
              <a:cxnLst/>
              <a:rect l="l" t="t" r="r" b="b"/>
              <a:pathLst>
                <a:path w="60509" h="43548">
                  <a:moveTo>
                    <a:pt x="60041" y="34619"/>
                  </a:moveTo>
                  <a:cubicBezTo>
                    <a:pt x="56526" y="35593"/>
                    <a:pt x="51693" y="35561"/>
                    <a:pt x="48129" y="34901"/>
                  </a:cubicBezTo>
                  <a:cubicBezTo>
                    <a:pt x="43632" y="36536"/>
                    <a:pt x="40142" y="40309"/>
                    <a:pt x="36704" y="43265"/>
                  </a:cubicBezTo>
                  <a:cubicBezTo>
                    <a:pt x="31794" y="43925"/>
                    <a:pt x="23982" y="43642"/>
                    <a:pt x="20418" y="40121"/>
                  </a:cubicBezTo>
                  <a:cubicBezTo>
                    <a:pt x="19836" y="37322"/>
                    <a:pt x="19601" y="33298"/>
                    <a:pt x="18471" y="30720"/>
                  </a:cubicBezTo>
                  <a:cubicBezTo>
                    <a:pt x="16381" y="25910"/>
                    <a:pt x="10116" y="22922"/>
                    <a:pt x="4616" y="22860"/>
                  </a:cubicBezTo>
                  <a:lnTo>
                    <a:pt x="972" y="19716"/>
                  </a:lnTo>
                  <a:lnTo>
                    <a:pt x="0" y="15031"/>
                  </a:lnTo>
                  <a:cubicBezTo>
                    <a:pt x="663" y="12138"/>
                    <a:pt x="2859" y="7894"/>
                    <a:pt x="5346" y="5881"/>
                  </a:cubicBezTo>
                  <a:lnTo>
                    <a:pt x="6075" y="127"/>
                  </a:lnTo>
                  <a:cubicBezTo>
                    <a:pt x="9709" y="-250"/>
                    <a:pt x="15339" y="221"/>
                    <a:pt x="18717" y="1417"/>
                  </a:cubicBezTo>
                  <a:cubicBezTo>
                    <a:pt x="20117" y="1919"/>
                    <a:pt x="21463" y="3428"/>
                    <a:pt x="22849" y="4057"/>
                  </a:cubicBezTo>
                  <a:lnTo>
                    <a:pt x="27062" y="5441"/>
                  </a:lnTo>
                  <a:cubicBezTo>
                    <a:pt x="33895" y="7705"/>
                    <a:pt x="38370" y="8239"/>
                    <a:pt x="45698" y="11352"/>
                  </a:cubicBezTo>
                  <a:cubicBezTo>
                    <a:pt x="47217" y="12012"/>
                    <a:pt x="49448" y="12610"/>
                    <a:pt x="50802" y="13459"/>
                  </a:cubicBezTo>
                  <a:cubicBezTo>
                    <a:pt x="53464" y="15093"/>
                    <a:pt x="55208" y="18144"/>
                    <a:pt x="56877" y="20502"/>
                  </a:cubicBezTo>
                  <a:cubicBezTo>
                    <a:pt x="57210" y="20973"/>
                    <a:pt x="59427" y="23897"/>
                    <a:pt x="59553" y="24180"/>
                  </a:cubicBezTo>
                  <a:cubicBezTo>
                    <a:pt x="60795" y="27010"/>
                    <a:pt x="60679" y="31694"/>
                    <a:pt x="60041" y="3461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09" name="자유형: 도형 450"/>
            <p:cNvSpPr/>
            <p:nvPr/>
          </p:nvSpPr>
          <p:spPr>
            <a:xfrm>
              <a:off x="6860880" y="5034240"/>
              <a:ext cx="118080" cy="52920"/>
            </a:xfrm>
            <a:custGeom>
              <a:avLst/>
              <a:gdLst/>
              <a:ahLst/>
              <a:cxnLst/>
              <a:rect l="l" t="t" r="r" b="b"/>
              <a:pathLst>
                <a:path w="93871" h="43389">
                  <a:moveTo>
                    <a:pt x="92610" y="10973"/>
                  </a:moveTo>
                  <a:cubicBezTo>
                    <a:pt x="92406" y="17953"/>
                    <a:pt x="97619" y="30404"/>
                    <a:pt x="88232" y="34491"/>
                  </a:cubicBezTo>
                  <a:cubicBezTo>
                    <a:pt x="85040" y="33328"/>
                    <a:pt x="81512" y="31410"/>
                    <a:pt x="78997" y="29272"/>
                  </a:cubicBezTo>
                  <a:cubicBezTo>
                    <a:pt x="74847" y="31410"/>
                    <a:pt x="70533" y="34711"/>
                    <a:pt x="67330" y="37887"/>
                  </a:cubicBezTo>
                  <a:cubicBezTo>
                    <a:pt x="66815" y="38421"/>
                    <a:pt x="64503" y="41314"/>
                    <a:pt x="64170" y="41565"/>
                  </a:cubicBezTo>
                  <a:cubicBezTo>
                    <a:pt x="63984" y="41691"/>
                    <a:pt x="60024" y="43200"/>
                    <a:pt x="59554" y="43389"/>
                  </a:cubicBezTo>
                  <a:lnTo>
                    <a:pt x="53233" y="42603"/>
                  </a:lnTo>
                  <a:cubicBezTo>
                    <a:pt x="49041" y="38107"/>
                    <a:pt x="48550" y="31850"/>
                    <a:pt x="44484" y="27166"/>
                  </a:cubicBezTo>
                  <a:cubicBezTo>
                    <a:pt x="40826" y="25939"/>
                    <a:pt x="36126" y="23864"/>
                    <a:pt x="32330" y="23267"/>
                  </a:cubicBezTo>
                  <a:cubicBezTo>
                    <a:pt x="21628" y="21569"/>
                    <a:pt x="14655" y="29869"/>
                    <a:pt x="4297" y="20815"/>
                  </a:cubicBezTo>
                  <a:cubicBezTo>
                    <a:pt x="2266" y="19054"/>
                    <a:pt x="351" y="17073"/>
                    <a:pt x="0" y="14369"/>
                  </a:cubicBezTo>
                  <a:lnTo>
                    <a:pt x="2919" y="11759"/>
                  </a:lnTo>
                  <a:lnTo>
                    <a:pt x="8264" y="10973"/>
                  </a:lnTo>
                  <a:lnTo>
                    <a:pt x="10207" y="8867"/>
                  </a:lnTo>
                  <a:cubicBezTo>
                    <a:pt x="16897" y="11508"/>
                    <a:pt x="28917" y="12639"/>
                    <a:pt x="34758" y="7829"/>
                  </a:cubicBezTo>
                  <a:cubicBezTo>
                    <a:pt x="35964" y="6855"/>
                    <a:pt x="36732" y="5188"/>
                    <a:pt x="37918" y="4182"/>
                  </a:cubicBezTo>
                  <a:cubicBezTo>
                    <a:pt x="40058" y="2327"/>
                    <a:pt x="43787" y="598"/>
                    <a:pt x="46666" y="0"/>
                  </a:cubicBezTo>
                  <a:cubicBezTo>
                    <a:pt x="50339" y="880"/>
                    <a:pt x="55835" y="3679"/>
                    <a:pt x="58091" y="4182"/>
                  </a:cubicBezTo>
                  <a:cubicBezTo>
                    <a:pt x="62791" y="5188"/>
                    <a:pt x="64657" y="2987"/>
                    <a:pt x="68302" y="2358"/>
                  </a:cubicBezTo>
                  <a:cubicBezTo>
                    <a:pt x="69070" y="2201"/>
                    <a:pt x="81368" y="2515"/>
                    <a:pt x="81911" y="2610"/>
                  </a:cubicBezTo>
                  <a:lnTo>
                    <a:pt x="85801" y="4434"/>
                  </a:lnTo>
                  <a:cubicBezTo>
                    <a:pt x="88187" y="6162"/>
                    <a:pt x="90368" y="8993"/>
                    <a:pt x="92610" y="10973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10" name="자유형: 도형 451"/>
            <p:cNvSpPr/>
            <p:nvPr/>
          </p:nvSpPr>
          <p:spPr>
            <a:xfrm>
              <a:off x="6937560" y="5184000"/>
              <a:ext cx="75960" cy="74880"/>
            </a:xfrm>
            <a:custGeom>
              <a:avLst/>
              <a:gdLst/>
              <a:ahLst/>
              <a:cxnLst/>
              <a:rect l="l" t="t" r="r" b="b"/>
              <a:pathLst>
                <a:path w="60331" h="61187">
                  <a:moveTo>
                    <a:pt x="48166" y="7326"/>
                  </a:moveTo>
                  <a:cubicBezTo>
                    <a:pt x="51940" y="13677"/>
                    <a:pt x="52786" y="19431"/>
                    <a:pt x="51323" y="26411"/>
                  </a:cubicBezTo>
                  <a:cubicBezTo>
                    <a:pt x="52838" y="29618"/>
                    <a:pt x="55592" y="30718"/>
                    <a:pt x="57398" y="33202"/>
                  </a:cubicBezTo>
                  <a:cubicBezTo>
                    <a:pt x="58068" y="34114"/>
                    <a:pt x="60264" y="40968"/>
                    <a:pt x="60317" y="42069"/>
                  </a:cubicBezTo>
                  <a:cubicBezTo>
                    <a:pt x="60506" y="46031"/>
                    <a:pt x="58875" y="54928"/>
                    <a:pt x="56185" y="58041"/>
                  </a:cubicBezTo>
                  <a:cubicBezTo>
                    <a:pt x="54448" y="59267"/>
                    <a:pt x="49089" y="61279"/>
                    <a:pt x="46945" y="61185"/>
                  </a:cubicBezTo>
                  <a:cubicBezTo>
                    <a:pt x="46521" y="61153"/>
                    <a:pt x="34683" y="58292"/>
                    <a:pt x="34062" y="58041"/>
                  </a:cubicBezTo>
                  <a:cubicBezTo>
                    <a:pt x="27145" y="55085"/>
                    <a:pt x="25057" y="49143"/>
                    <a:pt x="13159" y="50180"/>
                  </a:cubicBezTo>
                  <a:lnTo>
                    <a:pt x="9024" y="52287"/>
                  </a:lnTo>
                  <a:lnTo>
                    <a:pt x="4892" y="51501"/>
                  </a:lnTo>
                  <a:cubicBezTo>
                    <a:pt x="4341" y="45307"/>
                    <a:pt x="-1296" y="39428"/>
                    <a:pt x="276" y="33202"/>
                  </a:cubicBezTo>
                  <a:cubicBezTo>
                    <a:pt x="795" y="31127"/>
                    <a:pt x="9175" y="17230"/>
                    <a:pt x="10971" y="15689"/>
                  </a:cubicBezTo>
                  <a:cubicBezTo>
                    <a:pt x="13331" y="13646"/>
                    <a:pt x="16632" y="12545"/>
                    <a:pt x="18993" y="10187"/>
                  </a:cubicBezTo>
                  <a:cubicBezTo>
                    <a:pt x="20087" y="9087"/>
                    <a:pt x="20834" y="7641"/>
                    <a:pt x="21907" y="6540"/>
                  </a:cubicBezTo>
                  <a:cubicBezTo>
                    <a:pt x="25177" y="3144"/>
                    <a:pt x="29916" y="220"/>
                    <a:pt x="35033" y="0"/>
                  </a:cubicBezTo>
                  <a:cubicBezTo>
                    <a:pt x="41070" y="1132"/>
                    <a:pt x="43171" y="5094"/>
                    <a:pt x="48166" y="7326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11" name="자유형: 도형 452"/>
            <p:cNvSpPr/>
            <p:nvPr/>
          </p:nvSpPr>
          <p:spPr>
            <a:xfrm>
              <a:off x="6991920" y="5428800"/>
              <a:ext cx="33480" cy="26280"/>
            </a:xfrm>
            <a:custGeom>
              <a:avLst/>
              <a:gdLst/>
              <a:ahLst/>
              <a:cxnLst/>
              <a:rect l="l" t="t" r="r" b="b"/>
              <a:pathLst>
                <a:path w="26898" h="21749">
                  <a:moveTo>
                    <a:pt x="25281" y="18582"/>
                  </a:moveTo>
                  <a:cubicBezTo>
                    <a:pt x="21970" y="21505"/>
                    <a:pt x="14004" y="22480"/>
                    <a:pt x="9721" y="21191"/>
                  </a:cubicBezTo>
                  <a:cubicBezTo>
                    <a:pt x="6256" y="20154"/>
                    <a:pt x="405" y="14306"/>
                    <a:pt x="1" y="10973"/>
                  </a:cubicBezTo>
                  <a:cubicBezTo>
                    <a:pt x="-34" y="10690"/>
                    <a:pt x="654" y="5816"/>
                    <a:pt x="731" y="5250"/>
                  </a:cubicBezTo>
                  <a:lnTo>
                    <a:pt x="3888" y="1572"/>
                  </a:lnTo>
                  <a:lnTo>
                    <a:pt x="8518" y="0"/>
                  </a:lnTo>
                  <a:cubicBezTo>
                    <a:pt x="13496" y="4119"/>
                    <a:pt x="24520" y="252"/>
                    <a:pt x="26572" y="10187"/>
                  </a:cubicBezTo>
                  <a:cubicBezTo>
                    <a:pt x="27158" y="13016"/>
                    <a:pt x="27081" y="15972"/>
                    <a:pt x="25281" y="1858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12" name="자유형: 도형 453"/>
            <p:cNvSpPr/>
            <p:nvPr/>
          </p:nvSpPr>
          <p:spPr>
            <a:xfrm>
              <a:off x="6203520" y="5898240"/>
              <a:ext cx="836280" cy="395280"/>
            </a:xfrm>
            <a:custGeom>
              <a:avLst/>
              <a:gdLst/>
              <a:ahLst/>
              <a:cxnLst/>
              <a:rect l="l" t="t" r="r" b="b"/>
              <a:pathLst>
                <a:path w="662356" h="322015">
                  <a:moveTo>
                    <a:pt x="615448" y="25361"/>
                  </a:moveTo>
                  <a:cubicBezTo>
                    <a:pt x="616956" y="30518"/>
                    <a:pt x="615266" y="40390"/>
                    <a:pt x="619338" y="43912"/>
                  </a:cubicBezTo>
                  <a:cubicBezTo>
                    <a:pt x="625547" y="47433"/>
                    <a:pt x="631054" y="44257"/>
                    <a:pt x="636108" y="47842"/>
                  </a:cubicBezTo>
                  <a:cubicBezTo>
                    <a:pt x="635715" y="53595"/>
                    <a:pt x="634295" y="59821"/>
                    <a:pt x="631734" y="65104"/>
                  </a:cubicBezTo>
                  <a:lnTo>
                    <a:pt x="632948" y="69820"/>
                  </a:lnTo>
                  <a:cubicBezTo>
                    <a:pt x="637192" y="71989"/>
                    <a:pt x="639882" y="75919"/>
                    <a:pt x="644372" y="77649"/>
                  </a:cubicBezTo>
                  <a:cubicBezTo>
                    <a:pt x="647880" y="77176"/>
                    <a:pt x="651381" y="76579"/>
                    <a:pt x="654825" y="75825"/>
                  </a:cubicBezTo>
                  <a:lnTo>
                    <a:pt x="656285" y="70071"/>
                  </a:lnTo>
                  <a:cubicBezTo>
                    <a:pt x="660396" y="72523"/>
                    <a:pt x="661883" y="77963"/>
                    <a:pt x="662356" y="82113"/>
                  </a:cubicBezTo>
                  <a:lnTo>
                    <a:pt x="660659" y="86012"/>
                  </a:lnTo>
                  <a:cubicBezTo>
                    <a:pt x="654667" y="84471"/>
                    <a:pt x="645965" y="88716"/>
                    <a:pt x="644369" y="94124"/>
                  </a:cubicBezTo>
                  <a:cubicBezTo>
                    <a:pt x="643583" y="101135"/>
                    <a:pt x="649627" y="106417"/>
                    <a:pt x="647529" y="113460"/>
                  </a:cubicBezTo>
                  <a:cubicBezTo>
                    <a:pt x="643467" y="117170"/>
                    <a:pt x="636648" y="131004"/>
                    <a:pt x="634646" y="136223"/>
                  </a:cubicBezTo>
                  <a:cubicBezTo>
                    <a:pt x="633348" y="139588"/>
                    <a:pt x="632408" y="143078"/>
                    <a:pt x="630271" y="146159"/>
                  </a:cubicBezTo>
                  <a:cubicBezTo>
                    <a:pt x="629352" y="147448"/>
                    <a:pt x="625010" y="153045"/>
                    <a:pt x="623951" y="153988"/>
                  </a:cubicBezTo>
                  <a:cubicBezTo>
                    <a:pt x="620517" y="157038"/>
                    <a:pt x="615185" y="158075"/>
                    <a:pt x="612039" y="161849"/>
                  </a:cubicBezTo>
                  <a:cubicBezTo>
                    <a:pt x="608885" y="165621"/>
                    <a:pt x="606808" y="170652"/>
                    <a:pt x="604017" y="174645"/>
                  </a:cubicBezTo>
                  <a:cubicBezTo>
                    <a:pt x="603059" y="176029"/>
                    <a:pt x="601575" y="177192"/>
                    <a:pt x="600614" y="178575"/>
                  </a:cubicBezTo>
                  <a:cubicBezTo>
                    <a:pt x="599660" y="179927"/>
                    <a:pt x="599081" y="181594"/>
                    <a:pt x="598183" y="183009"/>
                  </a:cubicBezTo>
                  <a:cubicBezTo>
                    <a:pt x="595380" y="187410"/>
                    <a:pt x="591277" y="189548"/>
                    <a:pt x="587734" y="193196"/>
                  </a:cubicBezTo>
                  <a:cubicBezTo>
                    <a:pt x="582097" y="199043"/>
                    <a:pt x="579322" y="206464"/>
                    <a:pt x="574608" y="212815"/>
                  </a:cubicBezTo>
                  <a:cubicBezTo>
                    <a:pt x="573444" y="214387"/>
                    <a:pt x="571542" y="215990"/>
                    <a:pt x="569746" y="216996"/>
                  </a:cubicBezTo>
                  <a:cubicBezTo>
                    <a:pt x="566305" y="218946"/>
                    <a:pt x="563633" y="218506"/>
                    <a:pt x="560023" y="219354"/>
                  </a:cubicBezTo>
                  <a:cubicBezTo>
                    <a:pt x="558469" y="219732"/>
                    <a:pt x="547164" y="223536"/>
                    <a:pt x="545684" y="223788"/>
                  </a:cubicBezTo>
                  <a:cubicBezTo>
                    <a:pt x="543954" y="224102"/>
                    <a:pt x="541650" y="223662"/>
                    <a:pt x="539850" y="223788"/>
                  </a:cubicBezTo>
                  <a:cubicBezTo>
                    <a:pt x="536171" y="224070"/>
                    <a:pt x="532954" y="224856"/>
                    <a:pt x="529155" y="224574"/>
                  </a:cubicBezTo>
                  <a:cubicBezTo>
                    <a:pt x="526581" y="226398"/>
                    <a:pt x="523361" y="227529"/>
                    <a:pt x="520891" y="229290"/>
                  </a:cubicBezTo>
                  <a:cubicBezTo>
                    <a:pt x="516928" y="232088"/>
                    <a:pt x="514122" y="235955"/>
                    <a:pt x="509467" y="238188"/>
                  </a:cubicBezTo>
                  <a:cubicBezTo>
                    <a:pt x="504917" y="240358"/>
                    <a:pt x="498951" y="241741"/>
                    <a:pt x="494072" y="243407"/>
                  </a:cubicBezTo>
                  <a:lnTo>
                    <a:pt x="481514" y="247589"/>
                  </a:lnTo>
                  <a:cubicBezTo>
                    <a:pt x="478413" y="248626"/>
                    <a:pt x="475467" y="250135"/>
                    <a:pt x="472275" y="250984"/>
                  </a:cubicBezTo>
                  <a:cubicBezTo>
                    <a:pt x="468792" y="251928"/>
                    <a:pt x="465351" y="252022"/>
                    <a:pt x="461825" y="252556"/>
                  </a:cubicBezTo>
                  <a:cubicBezTo>
                    <a:pt x="456925" y="253311"/>
                    <a:pt x="451306" y="254286"/>
                    <a:pt x="446511" y="255418"/>
                  </a:cubicBezTo>
                  <a:cubicBezTo>
                    <a:pt x="444852" y="255826"/>
                    <a:pt x="438155" y="257367"/>
                    <a:pt x="436545" y="257776"/>
                  </a:cubicBezTo>
                  <a:cubicBezTo>
                    <a:pt x="434981" y="258216"/>
                    <a:pt x="428285" y="259977"/>
                    <a:pt x="426580" y="260385"/>
                  </a:cubicBezTo>
                  <a:cubicBezTo>
                    <a:pt x="422480" y="261392"/>
                    <a:pt x="412241" y="265196"/>
                    <a:pt x="408351" y="266925"/>
                  </a:cubicBezTo>
                  <a:cubicBezTo>
                    <a:pt x="406920" y="267585"/>
                    <a:pt x="400872" y="270195"/>
                    <a:pt x="399357" y="270855"/>
                  </a:cubicBezTo>
                  <a:cubicBezTo>
                    <a:pt x="395039" y="272742"/>
                    <a:pt x="391275" y="275918"/>
                    <a:pt x="386961" y="277898"/>
                  </a:cubicBezTo>
                  <a:cubicBezTo>
                    <a:pt x="383544" y="279502"/>
                    <a:pt x="371117" y="283117"/>
                    <a:pt x="368002" y="283935"/>
                  </a:cubicBezTo>
                  <a:cubicBezTo>
                    <a:pt x="361127" y="285727"/>
                    <a:pt x="342364" y="286356"/>
                    <a:pt x="334946" y="286010"/>
                  </a:cubicBezTo>
                  <a:cubicBezTo>
                    <a:pt x="330964" y="285853"/>
                    <a:pt x="326786" y="285098"/>
                    <a:pt x="322791" y="285507"/>
                  </a:cubicBezTo>
                  <a:cubicBezTo>
                    <a:pt x="319648" y="285790"/>
                    <a:pt x="310742" y="287614"/>
                    <a:pt x="307480" y="288369"/>
                  </a:cubicBezTo>
                  <a:cubicBezTo>
                    <a:pt x="304253" y="289123"/>
                    <a:pt x="301195" y="290664"/>
                    <a:pt x="297999" y="291513"/>
                  </a:cubicBezTo>
                  <a:cubicBezTo>
                    <a:pt x="292629" y="292927"/>
                    <a:pt x="287017" y="292550"/>
                    <a:pt x="281471" y="292833"/>
                  </a:cubicBezTo>
                  <a:cubicBezTo>
                    <a:pt x="279706" y="292896"/>
                    <a:pt x="277602" y="292833"/>
                    <a:pt x="275879" y="293085"/>
                  </a:cubicBezTo>
                  <a:cubicBezTo>
                    <a:pt x="271372" y="293745"/>
                    <a:pt x="272919" y="294688"/>
                    <a:pt x="267615" y="293871"/>
                  </a:cubicBezTo>
                  <a:lnTo>
                    <a:pt x="265914" y="293588"/>
                  </a:lnTo>
                  <a:cubicBezTo>
                    <a:pt x="263554" y="289720"/>
                    <a:pt x="259734" y="286136"/>
                    <a:pt x="255465" y="283935"/>
                  </a:cubicBezTo>
                  <a:cubicBezTo>
                    <a:pt x="250235" y="284250"/>
                    <a:pt x="245394" y="287205"/>
                    <a:pt x="240396" y="287331"/>
                  </a:cubicBezTo>
                  <a:cubicBezTo>
                    <a:pt x="230090" y="287551"/>
                    <a:pt x="224843" y="280477"/>
                    <a:pt x="211229" y="282112"/>
                  </a:cubicBezTo>
                  <a:cubicBezTo>
                    <a:pt x="204481" y="282898"/>
                    <a:pt x="197840" y="284815"/>
                    <a:pt x="191541" y="287079"/>
                  </a:cubicBezTo>
                  <a:cubicBezTo>
                    <a:pt x="188717" y="288085"/>
                    <a:pt x="185269" y="290004"/>
                    <a:pt x="182305" y="290475"/>
                  </a:cubicBezTo>
                  <a:cubicBezTo>
                    <a:pt x="175016" y="291576"/>
                    <a:pt x="165507" y="288903"/>
                    <a:pt x="157997" y="288903"/>
                  </a:cubicBezTo>
                  <a:cubicBezTo>
                    <a:pt x="156948" y="288903"/>
                    <a:pt x="146260" y="290475"/>
                    <a:pt x="145355" y="290727"/>
                  </a:cubicBezTo>
                  <a:cubicBezTo>
                    <a:pt x="135221" y="293462"/>
                    <a:pt x="123299" y="300662"/>
                    <a:pt x="117644" y="308774"/>
                  </a:cubicBezTo>
                  <a:cubicBezTo>
                    <a:pt x="115771" y="311446"/>
                    <a:pt x="114568" y="315062"/>
                    <a:pt x="112053" y="317389"/>
                  </a:cubicBezTo>
                  <a:cubicBezTo>
                    <a:pt x="108717" y="320470"/>
                    <a:pt x="96728" y="322702"/>
                    <a:pt x="92122" y="321822"/>
                  </a:cubicBezTo>
                  <a:cubicBezTo>
                    <a:pt x="89386" y="319998"/>
                    <a:pt x="86180" y="318332"/>
                    <a:pt x="83613" y="316351"/>
                  </a:cubicBezTo>
                  <a:cubicBezTo>
                    <a:pt x="82308" y="315345"/>
                    <a:pt x="76917" y="311320"/>
                    <a:pt x="75591" y="310346"/>
                  </a:cubicBezTo>
                  <a:cubicBezTo>
                    <a:pt x="74363" y="309434"/>
                    <a:pt x="73398" y="308145"/>
                    <a:pt x="72188" y="307202"/>
                  </a:cubicBezTo>
                  <a:cubicBezTo>
                    <a:pt x="69508" y="305126"/>
                    <a:pt x="66299" y="303554"/>
                    <a:pt x="63437" y="301700"/>
                  </a:cubicBezTo>
                  <a:cubicBezTo>
                    <a:pt x="58764" y="298681"/>
                    <a:pt x="45688" y="289311"/>
                    <a:pt x="43022" y="287331"/>
                  </a:cubicBezTo>
                  <a:cubicBezTo>
                    <a:pt x="40517" y="285475"/>
                    <a:pt x="38472" y="282866"/>
                    <a:pt x="36217" y="280791"/>
                  </a:cubicBezTo>
                  <a:cubicBezTo>
                    <a:pt x="33881" y="278621"/>
                    <a:pt x="31261" y="276672"/>
                    <a:pt x="28924" y="274502"/>
                  </a:cubicBezTo>
                  <a:cubicBezTo>
                    <a:pt x="25427" y="271264"/>
                    <a:pt x="22628" y="267743"/>
                    <a:pt x="19447" y="264315"/>
                  </a:cubicBezTo>
                  <a:cubicBezTo>
                    <a:pt x="17335" y="262052"/>
                    <a:pt x="9095" y="252840"/>
                    <a:pt x="7293" y="250450"/>
                  </a:cubicBezTo>
                  <a:cubicBezTo>
                    <a:pt x="5626" y="248281"/>
                    <a:pt x="2982" y="245608"/>
                    <a:pt x="1947" y="243155"/>
                  </a:cubicBezTo>
                  <a:cubicBezTo>
                    <a:pt x="1410" y="241867"/>
                    <a:pt x="-14" y="234006"/>
                    <a:pt x="0" y="233723"/>
                  </a:cubicBezTo>
                  <a:cubicBezTo>
                    <a:pt x="179" y="229824"/>
                    <a:pt x="2491" y="225642"/>
                    <a:pt x="2915" y="221712"/>
                  </a:cubicBezTo>
                  <a:cubicBezTo>
                    <a:pt x="3266" y="218474"/>
                    <a:pt x="2582" y="214544"/>
                    <a:pt x="2431" y="211243"/>
                  </a:cubicBezTo>
                  <a:cubicBezTo>
                    <a:pt x="5409" y="207501"/>
                    <a:pt x="7819" y="203696"/>
                    <a:pt x="10449" y="199735"/>
                  </a:cubicBezTo>
                  <a:cubicBezTo>
                    <a:pt x="11298" y="198477"/>
                    <a:pt x="12684" y="197157"/>
                    <a:pt x="13368" y="195836"/>
                  </a:cubicBezTo>
                  <a:cubicBezTo>
                    <a:pt x="14217" y="194170"/>
                    <a:pt x="14641" y="192063"/>
                    <a:pt x="15311" y="190334"/>
                  </a:cubicBezTo>
                  <a:cubicBezTo>
                    <a:pt x="17209" y="185398"/>
                    <a:pt x="19769" y="181468"/>
                    <a:pt x="23575" y="177506"/>
                  </a:cubicBezTo>
                  <a:cubicBezTo>
                    <a:pt x="26809" y="174173"/>
                    <a:pt x="37599" y="164552"/>
                    <a:pt x="41321" y="161849"/>
                  </a:cubicBezTo>
                  <a:cubicBezTo>
                    <a:pt x="43899" y="159962"/>
                    <a:pt x="46950" y="158642"/>
                    <a:pt x="49585" y="156881"/>
                  </a:cubicBezTo>
                  <a:cubicBezTo>
                    <a:pt x="52251" y="155088"/>
                    <a:pt x="54495" y="153013"/>
                    <a:pt x="57361" y="151378"/>
                  </a:cubicBezTo>
                  <a:cubicBezTo>
                    <a:pt x="62710" y="148329"/>
                    <a:pt x="68926" y="145467"/>
                    <a:pt x="73893" y="141977"/>
                  </a:cubicBezTo>
                  <a:cubicBezTo>
                    <a:pt x="79368" y="138110"/>
                    <a:pt x="83122" y="132388"/>
                    <a:pt x="86535" y="127074"/>
                  </a:cubicBezTo>
                  <a:cubicBezTo>
                    <a:pt x="87433" y="125660"/>
                    <a:pt x="88008" y="123993"/>
                    <a:pt x="88962" y="122610"/>
                  </a:cubicBezTo>
                  <a:cubicBezTo>
                    <a:pt x="89906" y="121257"/>
                    <a:pt x="94227" y="115975"/>
                    <a:pt x="95283" y="115032"/>
                  </a:cubicBezTo>
                  <a:cubicBezTo>
                    <a:pt x="100197" y="110662"/>
                    <a:pt x="113667" y="105002"/>
                    <a:pt x="119833" y="100663"/>
                  </a:cubicBezTo>
                  <a:cubicBezTo>
                    <a:pt x="123962" y="97739"/>
                    <a:pt x="126101" y="93275"/>
                    <a:pt x="130282" y="90476"/>
                  </a:cubicBezTo>
                  <a:cubicBezTo>
                    <a:pt x="136333" y="86389"/>
                    <a:pt x="143373" y="88338"/>
                    <a:pt x="149729" y="85509"/>
                  </a:cubicBezTo>
                  <a:cubicBezTo>
                    <a:pt x="152665" y="84188"/>
                    <a:pt x="155212" y="82082"/>
                    <a:pt x="157993" y="80541"/>
                  </a:cubicBezTo>
                  <a:cubicBezTo>
                    <a:pt x="160768" y="79000"/>
                    <a:pt x="163851" y="77931"/>
                    <a:pt x="166741" y="76611"/>
                  </a:cubicBezTo>
                  <a:cubicBezTo>
                    <a:pt x="177633" y="71580"/>
                    <a:pt x="182224" y="68436"/>
                    <a:pt x="194936" y="66927"/>
                  </a:cubicBezTo>
                  <a:cubicBezTo>
                    <a:pt x="199843" y="69757"/>
                    <a:pt x="205898" y="71455"/>
                    <a:pt x="211710" y="70606"/>
                  </a:cubicBezTo>
                  <a:cubicBezTo>
                    <a:pt x="212987" y="70385"/>
                    <a:pt x="228771" y="64978"/>
                    <a:pt x="230181" y="64317"/>
                  </a:cubicBezTo>
                  <a:cubicBezTo>
                    <a:pt x="233307" y="62808"/>
                    <a:pt x="235794" y="60922"/>
                    <a:pt x="239175" y="59601"/>
                  </a:cubicBezTo>
                  <a:cubicBezTo>
                    <a:pt x="242283" y="58406"/>
                    <a:pt x="251196" y="54728"/>
                    <a:pt x="252543" y="54131"/>
                  </a:cubicBezTo>
                  <a:cubicBezTo>
                    <a:pt x="255570" y="52778"/>
                    <a:pt x="259032" y="52055"/>
                    <a:pt x="262024" y="50735"/>
                  </a:cubicBezTo>
                  <a:cubicBezTo>
                    <a:pt x="267900" y="48093"/>
                    <a:pt x="272667" y="42937"/>
                    <a:pt x="278794" y="40799"/>
                  </a:cubicBezTo>
                  <a:cubicBezTo>
                    <a:pt x="289135" y="37183"/>
                    <a:pt x="301054" y="39196"/>
                    <a:pt x="311854" y="38190"/>
                  </a:cubicBezTo>
                  <a:cubicBezTo>
                    <a:pt x="320455" y="37341"/>
                    <a:pt x="329130" y="35203"/>
                    <a:pt x="337618" y="33725"/>
                  </a:cubicBezTo>
                  <a:cubicBezTo>
                    <a:pt x="341056" y="33127"/>
                    <a:pt x="344988" y="33033"/>
                    <a:pt x="348317" y="32153"/>
                  </a:cubicBezTo>
                  <a:cubicBezTo>
                    <a:pt x="351267" y="31398"/>
                    <a:pt x="354389" y="29795"/>
                    <a:pt x="357307" y="28757"/>
                  </a:cubicBezTo>
                  <a:cubicBezTo>
                    <a:pt x="361418" y="27342"/>
                    <a:pt x="370327" y="24984"/>
                    <a:pt x="371892" y="24575"/>
                  </a:cubicBezTo>
                  <a:cubicBezTo>
                    <a:pt x="375200" y="23726"/>
                    <a:pt x="379030" y="23915"/>
                    <a:pt x="382341" y="23003"/>
                  </a:cubicBezTo>
                  <a:cubicBezTo>
                    <a:pt x="384502" y="22437"/>
                    <a:pt x="394422" y="18947"/>
                    <a:pt x="396442" y="18036"/>
                  </a:cubicBezTo>
                  <a:cubicBezTo>
                    <a:pt x="399003" y="16904"/>
                    <a:pt x="402454" y="14923"/>
                    <a:pt x="404703" y="13351"/>
                  </a:cubicBezTo>
                  <a:cubicBezTo>
                    <a:pt x="405937" y="12471"/>
                    <a:pt x="407056" y="10930"/>
                    <a:pt x="408351" y="10207"/>
                  </a:cubicBezTo>
                  <a:lnTo>
                    <a:pt x="412967" y="8635"/>
                  </a:lnTo>
                  <a:cubicBezTo>
                    <a:pt x="419004" y="8037"/>
                    <a:pt x="425338" y="11370"/>
                    <a:pt x="431196" y="11496"/>
                  </a:cubicBezTo>
                  <a:cubicBezTo>
                    <a:pt x="432810" y="11559"/>
                    <a:pt x="434897" y="10867"/>
                    <a:pt x="436542" y="10710"/>
                  </a:cubicBezTo>
                  <a:cubicBezTo>
                    <a:pt x="440341" y="10364"/>
                    <a:pt x="444203" y="10741"/>
                    <a:pt x="447966" y="10458"/>
                  </a:cubicBezTo>
                  <a:cubicBezTo>
                    <a:pt x="449661" y="10332"/>
                    <a:pt x="451376" y="9829"/>
                    <a:pt x="453070" y="9672"/>
                  </a:cubicBezTo>
                  <a:cubicBezTo>
                    <a:pt x="458711" y="9138"/>
                    <a:pt x="464446" y="9703"/>
                    <a:pt x="470089" y="9169"/>
                  </a:cubicBezTo>
                  <a:cubicBezTo>
                    <a:pt x="475056" y="8666"/>
                    <a:pt x="481065" y="7723"/>
                    <a:pt x="485888" y="6528"/>
                  </a:cubicBezTo>
                  <a:cubicBezTo>
                    <a:pt x="487375" y="6182"/>
                    <a:pt x="489017" y="5208"/>
                    <a:pt x="490504" y="4987"/>
                  </a:cubicBezTo>
                  <a:cubicBezTo>
                    <a:pt x="492237" y="4705"/>
                    <a:pt x="510688" y="3101"/>
                    <a:pt x="512378" y="2881"/>
                  </a:cubicBezTo>
                  <a:cubicBezTo>
                    <a:pt x="514206" y="2661"/>
                    <a:pt x="516131" y="2787"/>
                    <a:pt x="517969" y="2629"/>
                  </a:cubicBezTo>
                  <a:cubicBezTo>
                    <a:pt x="522922" y="2126"/>
                    <a:pt x="527258" y="775"/>
                    <a:pt x="532312" y="775"/>
                  </a:cubicBezTo>
                  <a:cubicBezTo>
                    <a:pt x="539100" y="775"/>
                    <a:pt x="544821" y="-1144"/>
                    <a:pt x="552001" y="1057"/>
                  </a:cubicBezTo>
                  <a:cubicBezTo>
                    <a:pt x="562559" y="4296"/>
                    <a:pt x="569269" y="20111"/>
                    <a:pt x="580438" y="23538"/>
                  </a:cubicBezTo>
                  <a:cubicBezTo>
                    <a:pt x="585419" y="25079"/>
                    <a:pt x="593378" y="25079"/>
                    <a:pt x="598667" y="24575"/>
                  </a:cubicBezTo>
                  <a:cubicBezTo>
                    <a:pt x="605455" y="23947"/>
                    <a:pt x="608401" y="22154"/>
                    <a:pt x="615448" y="25361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13" name="자유형: 도형 454"/>
            <p:cNvSpPr/>
            <p:nvPr/>
          </p:nvSpPr>
          <p:spPr>
            <a:xfrm>
              <a:off x="7040880" y="5936040"/>
              <a:ext cx="26280" cy="32400"/>
            </a:xfrm>
            <a:custGeom>
              <a:avLst/>
              <a:gdLst/>
              <a:ahLst/>
              <a:cxnLst/>
              <a:rect l="l" t="t" r="r" b="b"/>
              <a:pathLst>
                <a:path w="21123" h="26662">
                  <a:moveTo>
                    <a:pt x="19557" y="10691"/>
                  </a:moveTo>
                  <a:cubicBezTo>
                    <a:pt x="22350" y="14306"/>
                    <a:pt x="21227" y="21412"/>
                    <a:pt x="17614" y="24304"/>
                  </a:cubicBezTo>
                  <a:cubicBezTo>
                    <a:pt x="14443" y="25373"/>
                    <a:pt x="10978" y="26128"/>
                    <a:pt x="7649" y="26662"/>
                  </a:cubicBezTo>
                  <a:cubicBezTo>
                    <a:pt x="5159" y="25625"/>
                    <a:pt x="1847" y="22701"/>
                    <a:pt x="844" y="20374"/>
                  </a:cubicBezTo>
                  <a:cubicBezTo>
                    <a:pt x="-1275" y="15533"/>
                    <a:pt x="746" y="3459"/>
                    <a:pt x="5218" y="0"/>
                  </a:cubicBezTo>
                  <a:lnTo>
                    <a:pt x="10083" y="252"/>
                  </a:lnTo>
                  <a:cubicBezTo>
                    <a:pt x="14829" y="2295"/>
                    <a:pt x="16937" y="6917"/>
                    <a:pt x="19561" y="10722"/>
                  </a:cubicBezTo>
                  <a:lnTo>
                    <a:pt x="19561" y="11225"/>
                  </a:lnTo>
                  <a:lnTo>
                    <a:pt x="19557" y="10691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14" name="자유형: 도형 455"/>
            <p:cNvSpPr/>
            <p:nvPr/>
          </p:nvSpPr>
          <p:spPr>
            <a:xfrm>
              <a:off x="7392960" y="5352840"/>
              <a:ext cx="43920" cy="65880"/>
            </a:xfrm>
            <a:custGeom>
              <a:avLst/>
              <a:gdLst/>
              <a:ahLst/>
              <a:cxnLst/>
              <a:rect l="l" t="t" r="r" b="b"/>
              <a:pathLst>
                <a:path w="35100" h="54025">
                  <a:moveTo>
                    <a:pt x="16370" y="36598"/>
                  </a:moveTo>
                  <a:lnTo>
                    <a:pt x="19772" y="39742"/>
                  </a:lnTo>
                  <a:cubicBezTo>
                    <a:pt x="22996" y="39931"/>
                    <a:pt x="27282" y="39428"/>
                    <a:pt x="30225" y="38170"/>
                  </a:cubicBezTo>
                  <a:lnTo>
                    <a:pt x="35087" y="39459"/>
                  </a:lnTo>
                  <a:cubicBezTo>
                    <a:pt x="35339" y="44490"/>
                    <a:pt x="32217" y="49709"/>
                    <a:pt x="26823" y="51501"/>
                  </a:cubicBezTo>
                  <a:cubicBezTo>
                    <a:pt x="25325" y="52004"/>
                    <a:pt x="23290" y="51910"/>
                    <a:pt x="21719" y="52287"/>
                  </a:cubicBezTo>
                  <a:cubicBezTo>
                    <a:pt x="17966" y="53199"/>
                    <a:pt x="15444" y="54488"/>
                    <a:pt x="11269" y="53859"/>
                  </a:cubicBezTo>
                  <a:cubicBezTo>
                    <a:pt x="8891" y="51941"/>
                    <a:pt x="6752" y="48766"/>
                    <a:pt x="5924" y="45999"/>
                  </a:cubicBezTo>
                  <a:cubicBezTo>
                    <a:pt x="5475" y="44521"/>
                    <a:pt x="5605" y="42792"/>
                    <a:pt x="5194" y="41314"/>
                  </a:cubicBezTo>
                  <a:cubicBezTo>
                    <a:pt x="4819" y="39931"/>
                    <a:pt x="3780" y="38516"/>
                    <a:pt x="3493" y="37132"/>
                  </a:cubicBezTo>
                  <a:cubicBezTo>
                    <a:pt x="3156" y="35497"/>
                    <a:pt x="3454" y="33548"/>
                    <a:pt x="3251" y="31882"/>
                  </a:cubicBezTo>
                  <a:cubicBezTo>
                    <a:pt x="2090" y="22387"/>
                    <a:pt x="-2666" y="11696"/>
                    <a:pt x="2037" y="2358"/>
                  </a:cubicBezTo>
                  <a:lnTo>
                    <a:pt x="6411" y="0"/>
                  </a:lnTo>
                  <a:lnTo>
                    <a:pt x="11515" y="2358"/>
                  </a:lnTo>
                  <a:cubicBezTo>
                    <a:pt x="13683" y="9181"/>
                    <a:pt x="11084" y="14966"/>
                    <a:pt x="11757" y="18299"/>
                  </a:cubicBezTo>
                  <a:cubicBezTo>
                    <a:pt x="12409" y="21506"/>
                    <a:pt x="13497" y="24116"/>
                    <a:pt x="14433" y="27197"/>
                  </a:cubicBezTo>
                  <a:cubicBezTo>
                    <a:pt x="15335" y="30184"/>
                    <a:pt x="15735" y="33517"/>
                    <a:pt x="16370" y="3659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15" name="자유형: 도형 456"/>
            <p:cNvSpPr/>
            <p:nvPr/>
          </p:nvSpPr>
          <p:spPr>
            <a:xfrm>
              <a:off x="7421400" y="5354280"/>
              <a:ext cx="21240" cy="31320"/>
            </a:xfrm>
            <a:custGeom>
              <a:avLst/>
              <a:gdLst/>
              <a:ahLst/>
              <a:cxnLst/>
              <a:rect l="l" t="t" r="r" b="b"/>
              <a:pathLst>
                <a:path w="17163" h="25808">
                  <a:moveTo>
                    <a:pt x="15327" y="23518"/>
                  </a:moveTo>
                  <a:cubicBezTo>
                    <a:pt x="13247" y="25436"/>
                    <a:pt x="8129" y="26191"/>
                    <a:pt x="5358" y="25624"/>
                  </a:cubicBezTo>
                  <a:cubicBezTo>
                    <a:pt x="3390" y="24399"/>
                    <a:pt x="283" y="20437"/>
                    <a:pt x="13" y="18299"/>
                  </a:cubicBezTo>
                  <a:cubicBezTo>
                    <a:pt x="-75" y="17576"/>
                    <a:pt x="311" y="10439"/>
                    <a:pt x="742" y="7577"/>
                  </a:cubicBezTo>
                  <a:cubicBezTo>
                    <a:pt x="1033" y="5660"/>
                    <a:pt x="1907" y="3459"/>
                    <a:pt x="2440" y="1572"/>
                  </a:cubicBezTo>
                  <a:lnTo>
                    <a:pt x="7059" y="0"/>
                  </a:lnTo>
                  <a:lnTo>
                    <a:pt x="12405" y="2358"/>
                  </a:lnTo>
                  <a:cubicBezTo>
                    <a:pt x="17123" y="7955"/>
                    <a:pt x="18775" y="17198"/>
                    <a:pt x="15327" y="2351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16" name="자유형: 도형 457"/>
            <p:cNvSpPr/>
            <p:nvPr/>
          </p:nvSpPr>
          <p:spPr>
            <a:xfrm>
              <a:off x="7061040" y="5043960"/>
              <a:ext cx="50760" cy="38520"/>
            </a:xfrm>
            <a:custGeom>
              <a:avLst/>
              <a:gdLst/>
              <a:ahLst/>
              <a:cxnLst/>
              <a:rect l="l" t="t" r="r" b="b"/>
              <a:pathLst>
                <a:path w="40377" h="31611">
                  <a:moveTo>
                    <a:pt x="40355" y="15291"/>
                  </a:moveTo>
                  <a:cubicBezTo>
                    <a:pt x="40401" y="15511"/>
                    <a:pt x="40432" y="21108"/>
                    <a:pt x="39892" y="22837"/>
                  </a:cubicBezTo>
                  <a:cubicBezTo>
                    <a:pt x="37636" y="30100"/>
                    <a:pt x="31807" y="31483"/>
                    <a:pt x="24391" y="31483"/>
                  </a:cubicBezTo>
                  <a:cubicBezTo>
                    <a:pt x="18485" y="31483"/>
                    <a:pt x="16341" y="32332"/>
                    <a:pt x="10701" y="29660"/>
                  </a:cubicBezTo>
                  <a:cubicBezTo>
                    <a:pt x="6008" y="27459"/>
                    <a:pt x="-222" y="19661"/>
                    <a:pt x="6" y="14756"/>
                  </a:cubicBezTo>
                  <a:cubicBezTo>
                    <a:pt x="153" y="11581"/>
                    <a:pt x="2784" y="6393"/>
                    <a:pt x="5597" y="4381"/>
                  </a:cubicBezTo>
                  <a:cubicBezTo>
                    <a:pt x="9908" y="1299"/>
                    <a:pt x="13423" y="-650"/>
                    <a:pt x="19126" y="199"/>
                  </a:cubicBezTo>
                  <a:cubicBezTo>
                    <a:pt x="24381" y="985"/>
                    <a:pt x="25132" y="1677"/>
                    <a:pt x="29660" y="3783"/>
                  </a:cubicBezTo>
                  <a:cubicBezTo>
                    <a:pt x="33512" y="5544"/>
                    <a:pt x="36472" y="12273"/>
                    <a:pt x="40355" y="15291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17" name="자유형: 도형 458"/>
            <p:cNvSpPr/>
            <p:nvPr/>
          </p:nvSpPr>
          <p:spPr>
            <a:xfrm>
              <a:off x="7118640" y="5005800"/>
              <a:ext cx="63720" cy="64800"/>
            </a:xfrm>
            <a:custGeom>
              <a:avLst/>
              <a:gdLst/>
              <a:ahLst/>
              <a:cxnLst/>
              <a:rect l="l" t="t" r="r" b="b"/>
              <a:pathLst>
                <a:path w="50644" h="53072">
                  <a:moveTo>
                    <a:pt x="45374" y="19588"/>
                  </a:moveTo>
                  <a:lnTo>
                    <a:pt x="50481" y="21946"/>
                  </a:lnTo>
                  <a:cubicBezTo>
                    <a:pt x="50997" y="25153"/>
                    <a:pt x="50253" y="29492"/>
                    <a:pt x="48780" y="32416"/>
                  </a:cubicBezTo>
                  <a:cubicBezTo>
                    <a:pt x="46342" y="34083"/>
                    <a:pt x="43550" y="37383"/>
                    <a:pt x="41245" y="38673"/>
                  </a:cubicBezTo>
                  <a:cubicBezTo>
                    <a:pt x="38369" y="40308"/>
                    <a:pt x="34451" y="40402"/>
                    <a:pt x="32009" y="43137"/>
                  </a:cubicBezTo>
                  <a:cubicBezTo>
                    <a:pt x="31718" y="43452"/>
                    <a:pt x="27814" y="51092"/>
                    <a:pt x="27148" y="52287"/>
                  </a:cubicBezTo>
                  <a:lnTo>
                    <a:pt x="23987" y="53073"/>
                  </a:lnTo>
                  <a:cubicBezTo>
                    <a:pt x="23942" y="47414"/>
                    <a:pt x="28190" y="42257"/>
                    <a:pt x="26664" y="36849"/>
                  </a:cubicBezTo>
                  <a:lnTo>
                    <a:pt x="23016" y="33705"/>
                  </a:lnTo>
                  <a:cubicBezTo>
                    <a:pt x="19217" y="33642"/>
                    <a:pt x="15383" y="33737"/>
                    <a:pt x="11591" y="33988"/>
                  </a:cubicBezTo>
                  <a:lnTo>
                    <a:pt x="8189" y="30844"/>
                  </a:lnTo>
                  <a:cubicBezTo>
                    <a:pt x="8059" y="30341"/>
                    <a:pt x="7098" y="26347"/>
                    <a:pt x="6972" y="26128"/>
                  </a:cubicBezTo>
                  <a:cubicBezTo>
                    <a:pt x="6673" y="25624"/>
                    <a:pt x="4043" y="23424"/>
                    <a:pt x="3569" y="22732"/>
                  </a:cubicBezTo>
                  <a:cubicBezTo>
                    <a:pt x="174" y="17921"/>
                    <a:pt x="-1142" y="9746"/>
                    <a:pt x="1138" y="4433"/>
                  </a:cubicBezTo>
                  <a:cubicBezTo>
                    <a:pt x="3727" y="3176"/>
                    <a:pt x="6393" y="1666"/>
                    <a:pt x="8673" y="0"/>
                  </a:cubicBezTo>
                  <a:cubicBezTo>
                    <a:pt x="12707" y="1761"/>
                    <a:pt x="17182" y="4433"/>
                    <a:pt x="20585" y="7043"/>
                  </a:cubicBezTo>
                  <a:cubicBezTo>
                    <a:pt x="22907" y="8835"/>
                    <a:pt x="22581" y="11036"/>
                    <a:pt x="23987" y="13048"/>
                  </a:cubicBezTo>
                  <a:cubicBezTo>
                    <a:pt x="27344" y="17890"/>
                    <a:pt x="39491" y="20751"/>
                    <a:pt x="45374" y="1958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18" name="자유형: 도형 459"/>
            <p:cNvSpPr/>
            <p:nvPr/>
          </p:nvSpPr>
          <p:spPr>
            <a:xfrm>
              <a:off x="7173360" y="4989600"/>
              <a:ext cx="24480" cy="19800"/>
            </a:xfrm>
            <a:custGeom>
              <a:avLst/>
              <a:gdLst/>
              <a:ahLst/>
              <a:cxnLst/>
              <a:rect l="l" t="t" r="r" b="b"/>
              <a:pathLst>
                <a:path w="19693" h="16417">
                  <a:moveTo>
                    <a:pt x="17258" y="786"/>
                  </a:moveTo>
                  <a:lnTo>
                    <a:pt x="19685" y="4433"/>
                  </a:lnTo>
                  <a:cubicBezTo>
                    <a:pt x="19808" y="7609"/>
                    <a:pt x="18535" y="11979"/>
                    <a:pt x="16528" y="14620"/>
                  </a:cubicBezTo>
                  <a:cubicBezTo>
                    <a:pt x="11891" y="17072"/>
                    <a:pt x="4728" y="17041"/>
                    <a:pt x="242" y="14368"/>
                  </a:cubicBezTo>
                  <a:lnTo>
                    <a:pt x="0" y="9401"/>
                  </a:lnTo>
                  <a:cubicBezTo>
                    <a:pt x="2252" y="5345"/>
                    <a:pt x="6626" y="2232"/>
                    <a:pt x="10926" y="0"/>
                  </a:cubicBezTo>
                  <a:lnTo>
                    <a:pt x="17258" y="786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19" name="자유형: 도형 460"/>
            <p:cNvSpPr/>
            <p:nvPr/>
          </p:nvSpPr>
          <p:spPr>
            <a:xfrm>
              <a:off x="7128000" y="4923720"/>
              <a:ext cx="44640" cy="47520"/>
            </a:xfrm>
            <a:custGeom>
              <a:avLst/>
              <a:gdLst/>
              <a:ahLst/>
              <a:cxnLst/>
              <a:rect l="l" t="t" r="r" b="b"/>
              <a:pathLst>
                <a:path w="35542" h="38916">
                  <a:moveTo>
                    <a:pt x="28513" y="2602"/>
                  </a:moveTo>
                  <a:cubicBezTo>
                    <a:pt x="33084" y="6218"/>
                    <a:pt x="33848" y="11374"/>
                    <a:pt x="34894" y="16437"/>
                  </a:cubicBezTo>
                  <a:lnTo>
                    <a:pt x="35543" y="19581"/>
                  </a:lnTo>
                  <a:cubicBezTo>
                    <a:pt x="35420" y="21372"/>
                    <a:pt x="34290" y="23793"/>
                    <a:pt x="33841" y="25586"/>
                  </a:cubicBezTo>
                  <a:cubicBezTo>
                    <a:pt x="32992" y="28982"/>
                    <a:pt x="32456" y="32566"/>
                    <a:pt x="32144" y="36056"/>
                  </a:cubicBezTo>
                  <a:lnTo>
                    <a:pt x="28495" y="38917"/>
                  </a:lnTo>
                  <a:lnTo>
                    <a:pt x="22904" y="38131"/>
                  </a:lnTo>
                  <a:lnTo>
                    <a:pt x="21933" y="33415"/>
                  </a:lnTo>
                  <a:lnTo>
                    <a:pt x="16587" y="31088"/>
                  </a:lnTo>
                  <a:lnTo>
                    <a:pt x="11483" y="31874"/>
                  </a:lnTo>
                  <a:lnTo>
                    <a:pt x="8081" y="28730"/>
                  </a:lnTo>
                  <a:cubicBezTo>
                    <a:pt x="7302" y="24642"/>
                    <a:pt x="5531" y="19360"/>
                    <a:pt x="3461" y="15651"/>
                  </a:cubicBezTo>
                  <a:cubicBezTo>
                    <a:pt x="2784" y="14424"/>
                    <a:pt x="1328" y="13230"/>
                    <a:pt x="788" y="12003"/>
                  </a:cubicBezTo>
                  <a:cubicBezTo>
                    <a:pt x="-366" y="9331"/>
                    <a:pt x="-225" y="4929"/>
                    <a:pt x="1030" y="2320"/>
                  </a:cubicBezTo>
                  <a:cubicBezTo>
                    <a:pt x="5264" y="-1360"/>
                    <a:pt x="12195" y="338"/>
                    <a:pt x="17316" y="747"/>
                  </a:cubicBezTo>
                  <a:cubicBezTo>
                    <a:pt x="19333" y="905"/>
                    <a:pt x="21662" y="684"/>
                    <a:pt x="23637" y="998"/>
                  </a:cubicBezTo>
                  <a:cubicBezTo>
                    <a:pt x="25265" y="1282"/>
                    <a:pt x="26724" y="2477"/>
                    <a:pt x="28513" y="260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20" name="자유형: 도형 461"/>
            <p:cNvSpPr/>
            <p:nvPr/>
          </p:nvSpPr>
          <p:spPr>
            <a:xfrm>
              <a:off x="7207200" y="4846320"/>
              <a:ext cx="25200" cy="26640"/>
            </a:xfrm>
            <a:custGeom>
              <a:avLst/>
              <a:gdLst/>
              <a:ahLst/>
              <a:cxnLst/>
              <a:rect l="l" t="t" r="r" b="b"/>
              <a:pathLst>
                <a:path w="20171" h="21977">
                  <a:moveTo>
                    <a:pt x="20172" y="14903"/>
                  </a:moveTo>
                  <a:lnTo>
                    <a:pt x="17983" y="20154"/>
                  </a:lnTo>
                  <a:lnTo>
                    <a:pt x="13367" y="21977"/>
                  </a:lnTo>
                  <a:lnTo>
                    <a:pt x="7046" y="21191"/>
                  </a:lnTo>
                  <a:cubicBezTo>
                    <a:pt x="4878" y="18928"/>
                    <a:pt x="2602" y="16727"/>
                    <a:pt x="241" y="14651"/>
                  </a:cubicBezTo>
                  <a:cubicBezTo>
                    <a:pt x="-159" y="11193"/>
                    <a:pt x="-50" y="7388"/>
                    <a:pt x="483" y="3930"/>
                  </a:cubicBezTo>
                  <a:lnTo>
                    <a:pt x="3889" y="0"/>
                  </a:lnTo>
                  <a:lnTo>
                    <a:pt x="9722" y="2106"/>
                  </a:lnTo>
                  <a:cubicBezTo>
                    <a:pt x="12532" y="7137"/>
                    <a:pt x="18621" y="9244"/>
                    <a:pt x="20172" y="14903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21" name="자유형: 도형 462"/>
            <p:cNvSpPr/>
            <p:nvPr/>
          </p:nvSpPr>
          <p:spPr>
            <a:xfrm>
              <a:off x="7354800" y="4965840"/>
              <a:ext cx="36000" cy="42840"/>
            </a:xfrm>
            <a:custGeom>
              <a:avLst/>
              <a:gdLst/>
              <a:ahLst/>
              <a:cxnLst/>
              <a:rect l="l" t="t" r="r" b="b"/>
              <a:pathLst>
                <a:path w="28705" h="35277">
                  <a:moveTo>
                    <a:pt x="27734" y="26914"/>
                  </a:moveTo>
                  <a:lnTo>
                    <a:pt x="28706" y="31630"/>
                  </a:lnTo>
                  <a:lnTo>
                    <a:pt x="25549" y="35277"/>
                  </a:lnTo>
                  <a:cubicBezTo>
                    <a:pt x="19870" y="35246"/>
                    <a:pt x="12248" y="33674"/>
                    <a:pt x="7316" y="31096"/>
                  </a:cubicBezTo>
                  <a:cubicBezTo>
                    <a:pt x="3637" y="26096"/>
                    <a:pt x="5885" y="18173"/>
                    <a:pt x="3430" y="12545"/>
                  </a:cubicBezTo>
                  <a:cubicBezTo>
                    <a:pt x="2020" y="9307"/>
                    <a:pt x="-275" y="8144"/>
                    <a:pt x="27" y="3899"/>
                  </a:cubicBezTo>
                  <a:lnTo>
                    <a:pt x="2942" y="0"/>
                  </a:lnTo>
                  <a:cubicBezTo>
                    <a:pt x="5667" y="566"/>
                    <a:pt x="9435" y="2830"/>
                    <a:pt x="10964" y="4937"/>
                  </a:cubicBezTo>
                  <a:cubicBezTo>
                    <a:pt x="11108" y="5785"/>
                    <a:pt x="11936" y="10313"/>
                    <a:pt x="12423" y="10973"/>
                  </a:cubicBezTo>
                  <a:cubicBezTo>
                    <a:pt x="13949" y="13049"/>
                    <a:pt x="16310" y="14746"/>
                    <a:pt x="18015" y="16727"/>
                  </a:cubicBezTo>
                  <a:cubicBezTo>
                    <a:pt x="18990" y="17858"/>
                    <a:pt x="19674" y="19274"/>
                    <a:pt x="20687" y="20374"/>
                  </a:cubicBezTo>
                  <a:cubicBezTo>
                    <a:pt x="22809" y="22669"/>
                    <a:pt x="25563" y="24587"/>
                    <a:pt x="27734" y="26914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22" name="자유형: 도형 463"/>
            <p:cNvSpPr/>
            <p:nvPr/>
          </p:nvSpPr>
          <p:spPr>
            <a:xfrm>
              <a:off x="7204320" y="4875480"/>
              <a:ext cx="140040" cy="77760"/>
            </a:xfrm>
            <a:custGeom>
              <a:avLst/>
              <a:gdLst/>
              <a:ahLst/>
              <a:cxnLst/>
              <a:rect l="l" t="t" r="r" b="b"/>
              <a:pathLst>
                <a:path w="111228" h="63526">
                  <a:moveTo>
                    <a:pt x="18471" y="58489"/>
                  </a:moveTo>
                  <a:cubicBezTo>
                    <a:pt x="17608" y="55723"/>
                    <a:pt x="15876" y="52579"/>
                    <a:pt x="13852" y="50377"/>
                  </a:cubicBezTo>
                  <a:cubicBezTo>
                    <a:pt x="10358" y="49120"/>
                    <a:pt x="6829" y="47454"/>
                    <a:pt x="3644" y="45661"/>
                  </a:cubicBezTo>
                  <a:lnTo>
                    <a:pt x="4862" y="40945"/>
                  </a:lnTo>
                  <a:cubicBezTo>
                    <a:pt x="7619" y="39562"/>
                    <a:pt x="10207" y="35286"/>
                    <a:pt x="10695" y="32582"/>
                  </a:cubicBezTo>
                  <a:lnTo>
                    <a:pt x="8748" y="28400"/>
                  </a:lnTo>
                  <a:cubicBezTo>
                    <a:pt x="5696" y="26765"/>
                    <a:pt x="2683" y="24753"/>
                    <a:pt x="0" y="22647"/>
                  </a:cubicBezTo>
                  <a:lnTo>
                    <a:pt x="2427" y="19534"/>
                  </a:lnTo>
                  <a:lnTo>
                    <a:pt x="7289" y="17679"/>
                  </a:lnTo>
                  <a:cubicBezTo>
                    <a:pt x="7450" y="16484"/>
                    <a:pt x="8601" y="15321"/>
                    <a:pt x="9478" y="14566"/>
                  </a:cubicBezTo>
                  <a:cubicBezTo>
                    <a:pt x="18580" y="6737"/>
                    <a:pt x="24887" y="14692"/>
                    <a:pt x="34758" y="13246"/>
                  </a:cubicBezTo>
                  <a:cubicBezTo>
                    <a:pt x="34979" y="13214"/>
                    <a:pt x="53292" y="7271"/>
                    <a:pt x="53962" y="6957"/>
                  </a:cubicBezTo>
                  <a:cubicBezTo>
                    <a:pt x="55355" y="6359"/>
                    <a:pt x="56681" y="4850"/>
                    <a:pt x="58094" y="4348"/>
                  </a:cubicBezTo>
                  <a:cubicBezTo>
                    <a:pt x="59578" y="3813"/>
                    <a:pt x="61848" y="3938"/>
                    <a:pt x="63440" y="3562"/>
                  </a:cubicBezTo>
                  <a:cubicBezTo>
                    <a:pt x="66513" y="2838"/>
                    <a:pt x="69596" y="983"/>
                    <a:pt x="72679" y="449"/>
                  </a:cubicBezTo>
                  <a:cubicBezTo>
                    <a:pt x="78790" y="-620"/>
                    <a:pt x="85272" y="386"/>
                    <a:pt x="91151" y="1738"/>
                  </a:cubicBezTo>
                  <a:cubicBezTo>
                    <a:pt x="91302" y="1769"/>
                    <a:pt x="92294" y="1958"/>
                    <a:pt x="92368" y="1989"/>
                  </a:cubicBezTo>
                  <a:cubicBezTo>
                    <a:pt x="95076" y="3938"/>
                    <a:pt x="97942" y="6391"/>
                    <a:pt x="100874" y="8026"/>
                  </a:cubicBezTo>
                  <a:cubicBezTo>
                    <a:pt x="102505" y="8906"/>
                    <a:pt x="104676" y="9410"/>
                    <a:pt x="106223" y="10384"/>
                  </a:cubicBezTo>
                  <a:lnTo>
                    <a:pt x="109629" y="13497"/>
                  </a:lnTo>
                  <a:cubicBezTo>
                    <a:pt x="113007" y="18339"/>
                    <a:pt x="110352" y="29469"/>
                    <a:pt x="107924" y="34437"/>
                  </a:cubicBezTo>
                  <a:cubicBezTo>
                    <a:pt x="106399" y="37550"/>
                    <a:pt x="104048" y="40411"/>
                    <a:pt x="102582" y="43586"/>
                  </a:cubicBezTo>
                  <a:cubicBezTo>
                    <a:pt x="101818" y="45221"/>
                    <a:pt x="101509" y="47233"/>
                    <a:pt x="100636" y="48805"/>
                  </a:cubicBezTo>
                  <a:cubicBezTo>
                    <a:pt x="98990" y="51761"/>
                    <a:pt x="93024" y="56760"/>
                    <a:pt x="89698" y="58206"/>
                  </a:cubicBezTo>
                  <a:cubicBezTo>
                    <a:pt x="84146" y="60627"/>
                    <a:pt x="78446" y="59370"/>
                    <a:pt x="72683" y="58992"/>
                  </a:cubicBezTo>
                  <a:cubicBezTo>
                    <a:pt x="68908" y="58741"/>
                    <a:pt x="57077" y="58992"/>
                    <a:pt x="55425" y="59275"/>
                  </a:cubicBezTo>
                  <a:cubicBezTo>
                    <a:pt x="52401" y="59778"/>
                    <a:pt x="49244" y="61917"/>
                    <a:pt x="46186" y="62671"/>
                  </a:cubicBezTo>
                  <a:cubicBezTo>
                    <a:pt x="43085" y="63394"/>
                    <a:pt x="31520" y="63897"/>
                    <a:pt x="28686" y="63174"/>
                  </a:cubicBezTo>
                  <a:cubicBezTo>
                    <a:pt x="26129" y="62546"/>
                    <a:pt x="21481" y="59559"/>
                    <a:pt x="18471" y="5848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23" name="자유형: 도형 464"/>
            <p:cNvSpPr/>
            <p:nvPr/>
          </p:nvSpPr>
          <p:spPr>
            <a:xfrm>
              <a:off x="7504560" y="5091840"/>
              <a:ext cx="24120" cy="24480"/>
            </a:xfrm>
            <a:custGeom>
              <a:avLst/>
              <a:gdLst/>
              <a:ahLst/>
              <a:cxnLst/>
              <a:rect l="l" t="t" r="r" b="b"/>
              <a:pathLst>
                <a:path w="19321" h="20153">
                  <a:moveTo>
                    <a:pt x="18501" y="16223"/>
                  </a:moveTo>
                  <a:cubicBezTo>
                    <a:pt x="15649" y="17701"/>
                    <a:pt x="12573" y="19054"/>
                    <a:pt x="9507" y="20154"/>
                  </a:cubicBezTo>
                  <a:cubicBezTo>
                    <a:pt x="6512" y="19651"/>
                    <a:pt x="1625" y="17387"/>
                    <a:pt x="29" y="14903"/>
                  </a:cubicBezTo>
                  <a:cubicBezTo>
                    <a:pt x="-427" y="8583"/>
                    <a:pt x="4453" y="943"/>
                    <a:pt x="11942" y="0"/>
                  </a:cubicBezTo>
                  <a:lnTo>
                    <a:pt x="16558" y="1572"/>
                  </a:lnTo>
                  <a:lnTo>
                    <a:pt x="19234" y="4716"/>
                  </a:lnTo>
                  <a:cubicBezTo>
                    <a:pt x="19476" y="8458"/>
                    <a:pt x="19213" y="12514"/>
                    <a:pt x="18501" y="16223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24" name="자유형: 도형 465"/>
            <p:cNvSpPr/>
            <p:nvPr/>
          </p:nvSpPr>
          <p:spPr>
            <a:xfrm>
              <a:off x="7462080" y="5105160"/>
              <a:ext cx="19800" cy="26280"/>
            </a:xfrm>
            <a:custGeom>
              <a:avLst/>
              <a:gdLst/>
              <a:ahLst/>
              <a:cxnLst/>
              <a:rect l="l" t="t" r="r" b="b"/>
              <a:pathLst>
                <a:path w="16057" h="21615">
                  <a:moveTo>
                    <a:pt x="13143" y="172"/>
                  </a:moveTo>
                  <a:lnTo>
                    <a:pt x="16057" y="2782"/>
                  </a:lnTo>
                  <a:cubicBezTo>
                    <a:pt x="16001" y="3316"/>
                    <a:pt x="15665" y="7467"/>
                    <a:pt x="15570" y="7750"/>
                  </a:cubicBezTo>
                  <a:cubicBezTo>
                    <a:pt x="15517" y="7907"/>
                    <a:pt x="10624" y="16710"/>
                    <a:pt x="10466" y="16899"/>
                  </a:cubicBezTo>
                  <a:cubicBezTo>
                    <a:pt x="8800" y="19037"/>
                    <a:pt x="4843" y="21238"/>
                    <a:pt x="1956" y="21615"/>
                  </a:cubicBezTo>
                  <a:cubicBezTo>
                    <a:pt x="-1292" y="16459"/>
                    <a:pt x="13" y="7341"/>
                    <a:pt x="2199" y="1996"/>
                  </a:cubicBezTo>
                  <a:cubicBezTo>
                    <a:pt x="4773" y="266"/>
                    <a:pt x="10091" y="-331"/>
                    <a:pt x="13143" y="17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25" name="자유형: 도형 466"/>
            <p:cNvSpPr/>
            <p:nvPr/>
          </p:nvSpPr>
          <p:spPr>
            <a:xfrm>
              <a:off x="7333560" y="5148360"/>
              <a:ext cx="33480" cy="45720"/>
            </a:xfrm>
            <a:custGeom>
              <a:avLst/>
              <a:gdLst/>
              <a:ahLst/>
              <a:cxnLst/>
              <a:rect l="l" t="t" r="r" b="b"/>
              <a:pathLst>
                <a:path w="26786" h="37384">
                  <a:moveTo>
                    <a:pt x="25365" y="29524"/>
                  </a:moveTo>
                  <a:cubicBezTo>
                    <a:pt x="22341" y="33548"/>
                    <a:pt x="12709" y="35655"/>
                    <a:pt x="7619" y="37384"/>
                  </a:cubicBezTo>
                  <a:lnTo>
                    <a:pt x="1544" y="35560"/>
                  </a:lnTo>
                  <a:cubicBezTo>
                    <a:pt x="-855" y="32322"/>
                    <a:pt x="-143" y="24336"/>
                    <a:pt x="1544" y="20909"/>
                  </a:cubicBezTo>
                  <a:cubicBezTo>
                    <a:pt x="2845" y="18268"/>
                    <a:pt x="6163" y="15658"/>
                    <a:pt x="8107" y="13331"/>
                  </a:cubicBezTo>
                  <a:cubicBezTo>
                    <a:pt x="12274" y="8332"/>
                    <a:pt x="15199" y="2641"/>
                    <a:pt x="21962" y="0"/>
                  </a:cubicBezTo>
                  <a:lnTo>
                    <a:pt x="25621" y="3396"/>
                  </a:lnTo>
                  <a:cubicBezTo>
                    <a:pt x="26989" y="9056"/>
                    <a:pt x="27445" y="23801"/>
                    <a:pt x="25365" y="29524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26" name="자유형: 도형 467"/>
            <p:cNvSpPr/>
            <p:nvPr/>
          </p:nvSpPr>
          <p:spPr>
            <a:xfrm>
              <a:off x="7576560" y="4904280"/>
              <a:ext cx="82440" cy="61920"/>
            </a:xfrm>
            <a:custGeom>
              <a:avLst/>
              <a:gdLst/>
              <a:ahLst/>
              <a:cxnLst/>
              <a:rect l="l" t="t" r="r" b="b"/>
              <a:pathLst>
                <a:path w="65464" h="50737">
                  <a:moveTo>
                    <a:pt x="53140" y="9172"/>
                  </a:moveTo>
                  <a:cubicBezTo>
                    <a:pt x="54241" y="13825"/>
                    <a:pt x="58924" y="17472"/>
                    <a:pt x="63835" y="18856"/>
                  </a:cubicBezTo>
                  <a:cubicBezTo>
                    <a:pt x="67563" y="25868"/>
                    <a:pt x="63940" y="33256"/>
                    <a:pt x="62375" y="40299"/>
                  </a:cubicBezTo>
                  <a:cubicBezTo>
                    <a:pt x="60506" y="42249"/>
                    <a:pt x="53087" y="47279"/>
                    <a:pt x="50463" y="48128"/>
                  </a:cubicBezTo>
                  <a:cubicBezTo>
                    <a:pt x="47850" y="49008"/>
                    <a:pt x="32006" y="50769"/>
                    <a:pt x="28831" y="50738"/>
                  </a:cubicBezTo>
                  <a:cubicBezTo>
                    <a:pt x="26794" y="46619"/>
                    <a:pt x="25275" y="42312"/>
                    <a:pt x="23240" y="38193"/>
                  </a:cubicBezTo>
                  <a:lnTo>
                    <a:pt x="16919" y="37406"/>
                  </a:lnTo>
                  <a:lnTo>
                    <a:pt x="13513" y="34294"/>
                  </a:lnTo>
                  <a:cubicBezTo>
                    <a:pt x="13577" y="31684"/>
                    <a:pt x="15783" y="27503"/>
                    <a:pt x="18375" y="26182"/>
                  </a:cubicBezTo>
                  <a:cubicBezTo>
                    <a:pt x="14247" y="23761"/>
                    <a:pt x="11034" y="24547"/>
                    <a:pt x="7193" y="23289"/>
                  </a:cubicBezTo>
                  <a:cubicBezTo>
                    <a:pt x="-3390" y="19862"/>
                    <a:pt x="-352" y="7726"/>
                    <a:pt x="4036" y="1092"/>
                  </a:cubicBezTo>
                  <a:cubicBezTo>
                    <a:pt x="5884" y="589"/>
                    <a:pt x="10192" y="-40"/>
                    <a:pt x="12058" y="809"/>
                  </a:cubicBezTo>
                  <a:cubicBezTo>
                    <a:pt x="14036" y="3073"/>
                    <a:pt x="17579" y="5274"/>
                    <a:pt x="20564" y="6311"/>
                  </a:cubicBezTo>
                  <a:cubicBezTo>
                    <a:pt x="25405" y="5116"/>
                    <a:pt x="29891" y="2632"/>
                    <a:pt x="33935" y="23"/>
                  </a:cubicBezTo>
                  <a:cubicBezTo>
                    <a:pt x="41431" y="-418"/>
                    <a:pt x="47447" y="5557"/>
                    <a:pt x="53140" y="9172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27" name="자유형: 도형 468"/>
            <p:cNvSpPr/>
            <p:nvPr/>
          </p:nvSpPr>
          <p:spPr>
            <a:xfrm>
              <a:off x="7560720" y="4817880"/>
              <a:ext cx="58680" cy="73440"/>
            </a:xfrm>
            <a:custGeom>
              <a:avLst/>
              <a:gdLst/>
              <a:ahLst/>
              <a:cxnLst/>
              <a:rect l="l" t="t" r="r" b="b"/>
              <a:pathLst>
                <a:path w="46797" h="60147">
                  <a:moveTo>
                    <a:pt x="21031" y="28769"/>
                  </a:moveTo>
                  <a:cubicBezTo>
                    <a:pt x="24889" y="31253"/>
                    <a:pt x="28782" y="31096"/>
                    <a:pt x="32943" y="32416"/>
                  </a:cubicBezTo>
                  <a:cubicBezTo>
                    <a:pt x="39186" y="34460"/>
                    <a:pt x="45812" y="39333"/>
                    <a:pt x="46798" y="45496"/>
                  </a:cubicBezTo>
                  <a:lnTo>
                    <a:pt x="45339" y="49677"/>
                  </a:lnTo>
                  <a:cubicBezTo>
                    <a:pt x="40305" y="55526"/>
                    <a:pt x="32988" y="54173"/>
                    <a:pt x="26134" y="55966"/>
                  </a:cubicBezTo>
                  <a:cubicBezTo>
                    <a:pt x="24570" y="56374"/>
                    <a:pt x="23082" y="57380"/>
                    <a:pt x="21518" y="57790"/>
                  </a:cubicBezTo>
                  <a:cubicBezTo>
                    <a:pt x="18645" y="58544"/>
                    <a:pt x="12191" y="60085"/>
                    <a:pt x="11553" y="60148"/>
                  </a:cubicBezTo>
                  <a:cubicBezTo>
                    <a:pt x="11272" y="60148"/>
                    <a:pt x="5863" y="59425"/>
                    <a:pt x="5232" y="59362"/>
                  </a:cubicBezTo>
                  <a:lnTo>
                    <a:pt x="2556" y="55714"/>
                  </a:lnTo>
                  <a:lnTo>
                    <a:pt x="2313" y="50464"/>
                  </a:lnTo>
                  <a:cubicBezTo>
                    <a:pt x="4597" y="47791"/>
                    <a:pt x="6425" y="43829"/>
                    <a:pt x="7175" y="40528"/>
                  </a:cubicBezTo>
                  <a:cubicBezTo>
                    <a:pt x="6140" y="38139"/>
                    <a:pt x="2741" y="35246"/>
                    <a:pt x="128" y="34272"/>
                  </a:cubicBezTo>
                  <a:cubicBezTo>
                    <a:pt x="-1103" y="26128"/>
                    <a:pt x="6740" y="4590"/>
                    <a:pt x="14955" y="0"/>
                  </a:cubicBezTo>
                  <a:lnTo>
                    <a:pt x="19817" y="534"/>
                  </a:lnTo>
                  <a:cubicBezTo>
                    <a:pt x="29059" y="8804"/>
                    <a:pt x="16951" y="19934"/>
                    <a:pt x="21031" y="2876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28" name="자유형: 도형 469"/>
            <p:cNvSpPr/>
            <p:nvPr/>
          </p:nvSpPr>
          <p:spPr>
            <a:xfrm>
              <a:off x="7657200" y="4749840"/>
              <a:ext cx="33480" cy="20880"/>
            </a:xfrm>
            <a:custGeom>
              <a:avLst/>
              <a:gdLst/>
              <a:ahLst/>
              <a:cxnLst/>
              <a:rect l="l" t="t" r="r" b="b"/>
              <a:pathLst>
                <a:path w="26735" h="17261">
                  <a:moveTo>
                    <a:pt x="25767" y="3144"/>
                  </a:moveTo>
                  <a:lnTo>
                    <a:pt x="26736" y="7609"/>
                  </a:lnTo>
                  <a:cubicBezTo>
                    <a:pt x="26157" y="10375"/>
                    <a:pt x="23884" y="13771"/>
                    <a:pt x="21632" y="15689"/>
                  </a:cubicBezTo>
                  <a:lnTo>
                    <a:pt x="17016" y="17261"/>
                  </a:lnTo>
                  <a:cubicBezTo>
                    <a:pt x="12761" y="15658"/>
                    <a:pt x="2599" y="9652"/>
                    <a:pt x="0" y="6288"/>
                  </a:cubicBezTo>
                  <a:lnTo>
                    <a:pt x="730" y="2358"/>
                  </a:lnTo>
                  <a:lnTo>
                    <a:pt x="4862" y="0"/>
                  </a:lnTo>
                  <a:cubicBezTo>
                    <a:pt x="11267" y="2327"/>
                    <a:pt x="20387" y="-126"/>
                    <a:pt x="25767" y="3144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29" name="자유형: 도형 470"/>
            <p:cNvSpPr/>
            <p:nvPr/>
          </p:nvSpPr>
          <p:spPr>
            <a:xfrm>
              <a:off x="7766280" y="4789800"/>
              <a:ext cx="50040" cy="28080"/>
            </a:xfrm>
            <a:custGeom>
              <a:avLst/>
              <a:gdLst/>
              <a:ahLst/>
              <a:cxnLst/>
              <a:rect l="l" t="t" r="r" b="b"/>
              <a:pathLst>
                <a:path w="39861" h="23067">
                  <a:moveTo>
                    <a:pt x="37680" y="13918"/>
                  </a:moveTo>
                  <a:cubicBezTo>
                    <a:pt x="31871" y="17157"/>
                    <a:pt x="25701" y="19797"/>
                    <a:pt x="19934" y="23067"/>
                  </a:cubicBezTo>
                  <a:lnTo>
                    <a:pt x="14101" y="23067"/>
                  </a:lnTo>
                  <a:cubicBezTo>
                    <a:pt x="8271" y="19452"/>
                    <a:pt x="9572" y="12472"/>
                    <a:pt x="1947" y="9233"/>
                  </a:cubicBezTo>
                  <a:lnTo>
                    <a:pt x="0" y="5051"/>
                  </a:lnTo>
                  <a:lnTo>
                    <a:pt x="1947" y="870"/>
                  </a:lnTo>
                  <a:cubicBezTo>
                    <a:pt x="7064" y="1310"/>
                    <a:pt x="11656" y="-388"/>
                    <a:pt x="16777" y="83"/>
                  </a:cubicBezTo>
                  <a:cubicBezTo>
                    <a:pt x="19622" y="1970"/>
                    <a:pt x="22835" y="3668"/>
                    <a:pt x="26013" y="5051"/>
                  </a:cubicBezTo>
                  <a:cubicBezTo>
                    <a:pt x="29058" y="3889"/>
                    <a:pt x="32299" y="2914"/>
                    <a:pt x="35491" y="2159"/>
                  </a:cubicBezTo>
                  <a:lnTo>
                    <a:pt x="39861" y="4800"/>
                  </a:lnTo>
                  <a:cubicBezTo>
                    <a:pt x="39872" y="7033"/>
                    <a:pt x="39279" y="12000"/>
                    <a:pt x="37680" y="1391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30" name="자유형: 도형 471"/>
            <p:cNvSpPr/>
            <p:nvPr/>
          </p:nvSpPr>
          <p:spPr>
            <a:xfrm>
              <a:off x="7760880" y="4736160"/>
              <a:ext cx="20880" cy="20520"/>
            </a:xfrm>
            <a:custGeom>
              <a:avLst/>
              <a:gdLst/>
              <a:ahLst/>
              <a:cxnLst/>
              <a:rect l="l" t="t" r="r" b="b"/>
              <a:pathLst>
                <a:path w="16770" h="17009">
                  <a:moveTo>
                    <a:pt x="12168" y="17009"/>
                  </a:moveTo>
                  <a:lnTo>
                    <a:pt x="6321" y="16978"/>
                  </a:lnTo>
                  <a:lnTo>
                    <a:pt x="1947" y="14117"/>
                  </a:lnTo>
                  <a:lnTo>
                    <a:pt x="0" y="9935"/>
                  </a:lnTo>
                  <a:cubicBezTo>
                    <a:pt x="284" y="6917"/>
                    <a:pt x="2269" y="2075"/>
                    <a:pt x="4862" y="0"/>
                  </a:cubicBezTo>
                  <a:lnTo>
                    <a:pt x="11425" y="786"/>
                  </a:lnTo>
                  <a:cubicBezTo>
                    <a:pt x="13694" y="2390"/>
                    <a:pt x="16125" y="5817"/>
                    <a:pt x="16770" y="8363"/>
                  </a:cubicBezTo>
                  <a:cubicBezTo>
                    <a:pt x="15223" y="11225"/>
                    <a:pt x="13652" y="14086"/>
                    <a:pt x="12168" y="1700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31" name="자유형: 도형 472"/>
            <p:cNvSpPr/>
            <p:nvPr/>
          </p:nvSpPr>
          <p:spPr>
            <a:xfrm>
              <a:off x="7832880" y="4814280"/>
              <a:ext cx="90360" cy="74160"/>
            </a:xfrm>
            <a:custGeom>
              <a:avLst/>
              <a:gdLst/>
              <a:ahLst/>
              <a:cxnLst/>
              <a:rect l="l" t="t" r="r" b="b"/>
              <a:pathLst>
                <a:path w="71908" h="60711">
                  <a:moveTo>
                    <a:pt x="43502" y="1099"/>
                  </a:moveTo>
                  <a:lnTo>
                    <a:pt x="47147" y="2136"/>
                  </a:lnTo>
                  <a:cubicBezTo>
                    <a:pt x="51412" y="5910"/>
                    <a:pt x="63114" y="19021"/>
                    <a:pt x="62703" y="24869"/>
                  </a:cubicBezTo>
                  <a:cubicBezTo>
                    <a:pt x="62444" y="28610"/>
                    <a:pt x="59799" y="31063"/>
                    <a:pt x="61977" y="35338"/>
                  </a:cubicBezTo>
                  <a:cubicBezTo>
                    <a:pt x="75254" y="42696"/>
                    <a:pt x="75503" y="54392"/>
                    <a:pt x="61002" y="60712"/>
                  </a:cubicBezTo>
                  <a:lnTo>
                    <a:pt x="57116" y="59926"/>
                  </a:lnTo>
                  <a:cubicBezTo>
                    <a:pt x="53941" y="56342"/>
                    <a:pt x="53184" y="51594"/>
                    <a:pt x="49097" y="48670"/>
                  </a:cubicBezTo>
                  <a:cubicBezTo>
                    <a:pt x="43720" y="46626"/>
                    <a:pt x="38514" y="49361"/>
                    <a:pt x="33053" y="47381"/>
                  </a:cubicBezTo>
                  <a:cubicBezTo>
                    <a:pt x="29868" y="44614"/>
                    <a:pt x="26283" y="40212"/>
                    <a:pt x="24305" y="36660"/>
                  </a:cubicBezTo>
                  <a:cubicBezTo>
                    <a:pt x="23582" y="35370"/>
                    <a:pt x="23326" y="33766"/>
                    <a:pt x="22604" y="32478"/>
                  </a:cubicBezTo>
                  <a:cubicBezTo>
                    <a:pt x="21194" y="29931"/>
                    <a:pt x="18668" y="27196"/>
                    <a:pt x="16528" y="25151"/>
                  </a:cubicBezTo>
                  <a:cubicBezTo>
                    <a:pt x="12382" y="24900"/>
                    <a:pt x="7317" y="23800"/>
                    <a:pt x="3645" y="22007"/>
                  </a:cubicBezTo>
                  <a:cubicBezTo>
                    <a:pt x="1596" y="20184"/>
                    <a:pt x="-17" y="16191"/>
                    <a:pt x="0" y="13644"/>
                  </a:cubicBezTo>
                  <a:lnTo>
                    <a:pt x="3402" y="9997"/>
                  </a:lnTo>
                  <a:cubicBezTo>
                    <a:pt x="6693" y="9588"/>
                    <a:pt x="10600" y="9620"/>
                    <a:pt x="13852" y="10248"/>
                  </a:cubicBezTo>
                  <a:cubicBezTo>
                    <a:pt x="16265" y="8676"/>
                    <a:pt x="18124" y="6633"/>
                    <a:pt x="20415" y="4998"/>
                  </a:cubicBezTo>
                  <a:cubicBezTo>
                    <a:pt x="21958" y="3929"/>
                    <a:pt x="30769" y="282"/>
                    <a:pt x="32569" y="61"/>
                  </a:cubicBezTo>
                  <a:cubicBezTo>
                    <a:pt x="34888" y="-253"/>
                    <a:pt x="41124" y="722"/>
                    <a:pt x="43530" y="1099"/>
                  </a:cubicBezTo>
                  <a:lnTo>
                    <a:pt x="43502" y="1099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32" name="자유형: 도형 473"/>
            <p:cNvSpPr/>
            <p:nvPr/>
          </p:nvSpPr>
          <p:spPr>
            <a:xfrm>
              <a:off x="7926480" y="4920840"/>
              <a:ext cx="23760" cy="52560"/>
            </a:xfrm>
            <a:custGeom>
              <a:avLst/>
              <a:gdLst/>
              <a:ahLst/>
              <a:cxnLst/>
              <a:rect l="l" t="t" r="r" b="b"/>
              <a:pathLst>
                <a:path w="19202" h="43035">
                  <a:moveTo>
                    <a:pt x="13126" y="41314"/>
                  </a:moveTo>
                  <a:cubicBezTo>
                    <a:pt x="10526" y="42791"/>
                    <a:pt x="5640" y="43326"/>
                    <a:pt x="2676" y="42886"/>
                  </a:cubicBezTo>
                  <a:lnTo>
                    <a:pt x="0" y="39239"/>
                  </a:lnTo>
                  <a:cubicBezTo>
                    <a:pt x="235" y="33359"/>
                    <a:pt x="3543" y="27794"/>
                    <a:pt x="3406" y="21977"/>
                  </a:cubicBezTo>
                  <a:cubicBezTo>
                    <a:pt x="3332" y="18959"/>
                    <a:pt x="1382" y="15563"/>
                    <a:pt x="1459" y="12545"/>
                  </a:cubicBezTo>
                  <a:cubicBezTo>
                    <a:pt x="1561" y="8552"/>
                    <a:pt x="5047" y="2043"/>
                    <a:pt x="8994" y="0"/>
                  </a:cubicBezTo>
                  <a:lnTo>
                    <a:pt x="14827" y="0"/>
                  </a:lnTo>
                  <a:lnTo>
                    <a:pt x="18229" y="3144"/>
                  </a:lnTo>
                  <a:cubicBezTo>
                    <a:pt x="18520" y="4559"/>
                    <a:pt x="19173" y="6446"/>
                    <a:pt x="19201" y="7860"/>
                  </a:cubicBezTo>
                  <a:cubicBezTo>
                    <a:pt x="19257" y="10281"/>
                    <a:pt x="17903" y="23172"/>
                    <a:pt x="17254" y="25624"/>
                  </a:cubicBezTo>
                  <a:cubicBezTo>
                    <a:pt x="16805" y="27322"/>
                    <a:pt x="15592" y="29178"/>
                    <a:pt x="15311" y="30875"/>
                  </a:cubicBezTo>
                  <a:cubicBezTo>
                    <a:pt x="14645" y="34868"/>
                    <a:pt x="16472" y="36660"/>
                    <a:pt x="13126" y="41314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33" name="자유형: 도형 474"/>
            <p:cNvSpPr/>
            <p:nvPr/>
          </p:nvSpPr>
          <p:spPr>
            <a:xfrm>
              <a:off x="7942320" y="4880520"/>
              <a:ext cx="19800" cy="19080"/>
            </a:xfrm>
            <a:custGeom>
              <a:avLst/>
              <a:gdLst/>
              <a:ahLst/>
              <a:cxnLst/>
              <a:rect l="l" t="t" r="r" b="b"/>
              <a:pathLst>
                <a:path w="15979" h="15940">
                  <a:moveTo>
                    <a:pt x="13382" y="14117"/>
                  </a:moveTo>
                  <a:lnTo>
                    <a:pt x="8752" y="15940"/>
                  </a:lnTo>
                  <a:lnTo>
                    <a:pt x="2918" y="13834"/>
                  </a:lnTo>
                  <a:lnTo>
                    <a:pt x="0" y="10187"/>
                  </a:lnTo>
                  <a:cubicBezTo>
                    <a:pt x="1056" y="5942"/>
                    <a:pt x="5907" y="2861"/>
                    <a:pt x="9239" y="0"/>
                  </a:cubicBezTo>
                  <a:lnTo>
                    <a:pt x="13855" y="1541"/>
                  </a:lnTo>
                  <a:cubicBezTo>
                    <a:pt x="15613" y="3836"/>
                    <a:pt x="16349" y="8300"/>
                    <a:pt x="15802" y="10973"/>
                  </a:cubicBezTo>
                  <a:cubicBezTo>
                    <a:pt x="15030" y="11255"/>
                    <a:pt x="13718" y="13488"/>
                    <a:pt x="13382" y="14117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34" name="자유형: 도형 475"/>
            <p:cNvSpPr/>
            <p:nvPr/>
          </p:nvSpPr>
          <p:spPr>
            <a:xfrm>
              <a:off x="7854840" y="4618080"/>
              <a:ext cx="83160" cy="162720"/>
            </a:xfrm>
            <a:custGeom>
              <a:avLst/>
              <a:gdLst/>
              <a:ahLst/>
              <a:cxnLst/>
              <a:rect l="l" t="t" r="r" b="b"/>
              <a:pathLst>
                <a:path w="66109" h="132808">
                  <a:moveTo>
                    <a:pt x="55415" y="132808"/>
                  </a:moveTo>
                  <a:cubicBezTo>
                    <a:pt x="47403" y="132431"/>
                    <a:pt x="42345" y="127086"/>
                    <a:pt x="35971" y="123659"/>
                  </a:cubicBezTo>
                  <a:cubicBezTo>
                    <a:pt x="34291" y="122747"/>
                    <a:pt x="27911" y="119477"/>
                    <a:pt x="26490" y="118691"/>
                  </a:cubicBezTo>
                  <a:cubicBezTo>
                    <a:pt x="14673" y="112183"/>
                    <a:pt x="1670" y="105077"/>
                    <a:pt x="238" y="91243"/>
                  </a:cubicBezTo>
                  <a:cubicBezTo>
                    <a:pt x="-270" y="86307"/>
                    <a:pt x="347" y="81087"/>
                    <a:pt x="0" y="76089"/>
                  </a:cubicBezTo>
                  <a:cubicBezTo>
                    <a:pt x="6482" y="66970"/>
                    <a:pt x="11747" y="70900"/>
                    <a:pt x="17496" y="67725"/>
                  </a:cubicBezTo>
                  <a:cubicBezTo>
                    <a:pt x="17812" y="67536"/>
                    <a:pt x="25732" y="61216"/>
                    <a:pt x="27465" y="56720"/>
                  </a:cubicBezTo>
                  <a:cubicBezTo>
                    <a:pt x="30096" y="49898"/>
                    <a:pt x="29345" y="46565"/>
                    <a:pt x="29654" y="39993"/>
                  </a:cubicBezTo>
                  <a:cubicBezTo>
                    <a:pt x="29822" y="36409"/>
                    <a:pt x="31369" y="32290"/>
                    <a:pt x="31113" y="28769"/>
                  </a:cubicBezTo>
                  <a:cubicBezTo>
                    <a:pt x="30398" y="19054"/>
                    <a:pt x="15809" y="18677"/>
                    <a:pt x="23091" y="2358"/>
                  </a:cubicBezTo>
                  <a:lnTo>
                    <a:pt x="27465" y="0"/>
                  </a:lnTo>
                  <a:cubicBezTo>
                    <a:pt x="32194" y="441"/>
                    <a:pt x="40570" y="3490"/>
                    <a:pt x="44484" y="6006"/>
                  </a:cubicBezTo>
                  <a:cubicBezTo>
                    <a:pt x="46758" y="7483"/>
                    <a:pt x="53254" y="14117"/>
                    <a:pt x="53962" y="16475"/>
                  </a:cubicBezTo>
                  <a:cubicBezTo>
                    <a:pt x="54036" y="16727"/>
                    <a:pt x="54180" y="20909"/>
                    <a:pt x="54204" y="21443"/>
                  </a:cubicBezTo>
                  <a:cubicBezTo>
                    <a:pt x="53054" y="23738"/>
                    <a:pt x="49655" y="26725"/>
                    <a:pt x="46912" y="27448"/>
                  </a:cubicBezTo>
                  <a:cubicBezTo>
                    <a:pt x="44923" y="30499"/>
                    <a:pt x="43229" y="34020"/>
                    <a:pt x="42050" y="37384"/>
                  </a:cubicBezTo>
                  <a:cubicBezTo>
                    <a:pt x="44362" y="39868"/>
                    <a:pt x="44927" y="42446"/>
                    <a:pt x="46424" y="45213"/>
                  </a:cubicBezTo>
                  <a:cubicBezTo>
                    <a:pt x="47154" y="46596"/>
                    <a:pt x="50006" y="52256"/>
                    <a:pt x="50798" y="53325"/>
                  </a:cubicBezTo>
                  <a:cubicBezTo>
                    <a:pt x="53580" y="57129"/>
                    <a:pt x="60062" y="58702"/>
                    <a:pt x="63924" y="61688"/>
                  </a:cubicBezTo>
                  <a:cubicBezTo>
                    <a:pt x="64415" y="62914"/>
                    <a:pt x="65404" y="64644"/>
                    <a:pt x="65625" y="65870"/>
                  </a:cubicBezTo>
                  <a:cubicBezTo>
                    <a:pt x="66418" y="70272"/>
                    <a:pt x="64640" y="71686"/>
                    <a:pt x="64405" y="74013"/>
                  </a:cubicBezTo>
                  <a:cubicBezTo>
                    <a:pt x="64201" y="76057"/>
                    <a:pt x="66138" y="87973"/>
                    <a:pt x="66110" y="88350"/>
                  </a:cubicBezTo>
                  <a:cubicBezTo>
                    <a:pt x="65990" y="90143"/>
                    <a:pt x="63984" y="97437"/>
                    <a:pt x="63191" y="99355"/>
                  </a:cubicBezTo>
                  <a:cubicBezTo>
                    <a:pt x="62588" y="100801"/>
                    <a:pt x="60971" y="102310"/>
                    <a:pt x="60518" y="103788"/>
                  </a:cubicBezTo>
                  <a:cubicBezTo>
                    <a:pt x="58873" y="109102"/>
                    <a:pt x="61609" y="113880"/>
                    <a:pt x="61732" y="118943"/>
                  </a:cubicBezTo>
                  <a:cubicBezTo>
                    <a:pt x="61837" y="123093"/>
                    <a:pt x="59564" y="130513"/>
                    <a:pt x="55415" y="13280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35" name="자유형: 도형 476"/>
            <p:cNvSpPr/>
            <p:nvPr/>
          </p:nvSpPr>
          <p:spPr>
            <a:xfrm>
              <a:off x="7826040" y="4434120"/>
              <a:ext cx="38520" cy="30600"/>
            </a:xfrm>
            <a:custGeom>
              <a:avLst/>
              <a:gdLst/>
              <a:ahLst/>
              <a:cxnLst/>
              <a:rect l="l" t="t" r="r" b="b"/>
              <a:pathLst>
                <a:path w="30741" h="25175">
                  <a:moveTo>
                    <a:pt x="10327" y="25175"/>
                  </a:moveTo>
                  <a:cubicBezTo>
                    <a:pt x="7724" y="24389"/>
                    <a:pt x="3308" y="21842"/>
                    <a:pt x="1817" y="19704"/>
                  </a:cubicBezTo>
                  <a:cubicBezTo>
                    <a:pt x="-789" y="15962"/>
                    <a:pt x="-631" y="9266"/>
                    <a:pt x="2547" y="5838"/>
                  </a:cubicBezTo>
                  <a:cubicBezTo>
                    <a:pt x="5423" y="2757"/>
                    <a:pt x="8415" y="3543"/>
                    <a:pt x="12028" y="2694"/>
                  </a:cubicBezTo>
                  <a:cubicBezTo>
                    <a:pt x="13666" y="2317"/>
                    <a:pt x="15252" y="1311"/>
                    <a:pt x="16890" y="871"/>
                  </a:cubicBezTo>
                  <a:cubicBezTo>
                    <a:pt x="20148" y="54"/>
                    <a:pt x="24459" y="-135"/>
                    <a:pt x="27827" y="85"/>
                  </a:cubicBezTo>
                  <a:lnTo>
                    <a:pt x="30742" y="3763"/>
                  </a:lnTo>
                  <a:cubicBezTo>
                    <a:pt x="30065" y="5398"/>
                    <a:pt x="29461" y="7473"/>
                    <a:pt x="28570" y="8982"/>
                  </a:cubicBezTo>
                  <a:cubicBezTo>
                    <a:pt x="26350" y="12787"/>
                    <a:pt x="14732" y="23383"/>
                    <a:pt x="10327" y="2517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36" name="자유형: 도형 477"/>
            <p:cNvSpPr/>
            <p:nvPr/>
          </p:nvSpPr>
          <p:spPr>
            <a:xfrm>
              <a:off x="7948080" y="4385880"/>
              <a:ext cx="264960" cy="259920"/>
            </a:xfrm>
            <a:custGeom>
              <a:avLst/>
              <a:gdLst/>
              <a:ahLst/>
              <a:cxnLst/>
              <a:rect l="l" t="t" r="r" b="b"/>
              <a:pathLst>
                <a:path w="210001" h="212000">
                  <a:moveTo>
                    <a:pt x="72672" y="52299"/>
                  </a:moveTo>
                  <a:lnTo>
                    <a:pt x="69999" y="56732"/>
                  </a:lnTo>
                  <a:cubicBezTo>
                    <a:pt x="71094" y="60159"/>
                    <a:pt x="71757" y="69655"/>
                    <a:pt x="71943" y="71132"/>
                  </a:cubicBezTo>
                  <a:cubicBezTo>
                    <a:pt x="72729" y="77358"/>
                    <a:pt x="71617" y="79590"/>
                    <a:pt x="75349" y="85501"/>
                  </a:cubicBezTo>
                  <a:cubicBezTo>
                    <a:pt x="81354" y="95028"/>
                    <a:pt x="86766" y="91380"/>
                    <a:pt x="95034" y="95185"/>
                  </a:cubicBezTo>
                  <a:cubicBezTo>
                    <a:pt x="98363" y="96695"/>
                    <a:pt x="100071" y="99555"/>
                    <a:pt x="102326" y="101976"/>
                  </a:cubicBezTo>
                  <a:cubicBezTo>
                    <a:pt x="103270" y="102983"/>
                    <a:pt x="104975" y="104020"/>
                    <a:pt x="105732" y="105121"/>
                  </a:cubicBezTo>
                  <a:cubicBezTo>
                    <a:pt x="107563" y="107730"/>
                    <a:pt x="109436" y="114333"/>
                    <a:pt x="111078" y="117666"/>
                  </a:cubicBezTo>
                  <a:lnTo>
                    <a:pt x="116182" y="120024"/>
                  </a:lnTo>
                  <a:cubicBezTo>
                    <a:pt x="122169" y="118954"/>
                    <a:pt x="131002" y="110151"/>
                    <a:pt x="135628" y="106158"/>
                  </a:cubicBezTo>
                  <a:cubicBezTo>
                    <a:pt x="136035" y="105812"/>
                    <a:pt x="139017" y="103139"/>
                    <a:pt x="139273" y="103013"/>
                  </a:cubicBezTo>
                  <a:cubicBezTo>
                    <a:pt x="141665" y="101788"/>
                    <a:pt x="146158" y="101096"/>
                    <a:pt x="148996" y="99869"/>
                  </a:cubicBezTo>
                  <a:cubicBezTo>
                    <a:pt x="158333" y="102700"/>
                    <a:pt x="165212" y="101536"/>
                    <a:pt x="174272" y="102762"/>
                  </a:cubicBezTo>
                  <a:cubicBezTo>
                    <a:pt x="178952" y="103391"/>
                    <a:pt x="183536" y="104649"/>
                    <a:pt x="188128" y="105623"/>
                  </a:cubicBezTo>
                  <a:cubicBezTo>
                    <a:pt x="196325" y="107384"/>
                    <a:pt x="207929" y="109711"/>
                    <a:pt x="210002" y="118452"/>
                  </a:cubicBezTo>
                  <a:cubicBezTo>
                    <a:pt x="207694" y="123671"/>
                    <a:pt x="201243" y="133732"/>
                    <a:pt x="200282" y="138323"/>
                  </a:cubicBezTo>
                  <a:cubicBezTo>
                    <a:pt x="199994" y="139675"/>
                    <a:pt x="200282" y="141844"/>
                    <a:pt x="200282" y="143290"/>
                  </a:cubicBezTo>
                  <a:cubicBezTo>
                    <a:pt x="200282" y="146717"/>
                    <a:pt x="201341" y="156873"/>
                    <a:pt x="201499" y="158445"/>
                  </a:cubicBezTo>
                  <a:cubicBezTo>
                    <a:pt x="201976" y="163193"/>
                    <a:pt x="200882" y="170456"/>
                    <a:pt x="199068" y="174920"/>
                  </a:cubicBezTo>
                  <a:cubicBezTo>
                    <a:pt x="196904" y="180234"/>
                    <a:pt x="192519" y="181837"/>
                    <a:pt x="189590" y="186427"/>
                  </a:cubicBezTo>
                  <a:cubicBezTo>
                    <a:pt x="189078" y="188974"/>
                    <a:pt x="190239" y="193377"/>
                    <a:pt x="192263" y="195294"/>
                  </a:cubicBezTo>
                  <a:lnTo>
                    <a:pt x="197371" y="197652"/>
                  </a:lnTo>
                  <a:lnTo>
                    <a:pt x="199068" y="201834"/>
                  </a:lnTo>
                  <a:lnTo>
                    <a:pt x="197851" y="206550"/>
                  </a:lnTo>
                  <a:lnTo>
                    <a:pt x="194207" y="209946"/>
                  </a:lnTo>
                  <a:cubicBezTo>
                    <a:pt x="188001" y="209883"/>
                    <a:pt x="184255" y="213216"/>
                    <a:pt x="177678" y="211518"/>
                  </a:cubicBezTo>
                  <a:lnTo>
                    <a:pt x="173543" y="208657"/>
                  </a:lnTo>
                  <a:cubicBezTo>
                    <a:pt x="172855" y="205607"/>
                    <a:pt x="172280" y="202557"/>
                    <a:pt x="171845" y="199476"/>
                  </a:cubicBezTo>
                  <a:lnTo>
                    <a:pt x="167955" y="197149"/>
                  </a:lnTo>
                  <a:cubicBezTo>
                    <a:pt x="165363" y="199130"/>
                    <a:pt x="162795" y="201645"/>
                    <a:pt x="160908" y="204192"/>
                  </a:cubicBezTo>
                  <a:lnTo>
                    <a:pt x="155559" y="204978"/>
                  </a:lnTo>
                  <a:lnTo>
                    <a:pt x="152156" y="201582"/>
                  </a:lnTo>
                  <a:lnTo>
                    <a:pt x="146811" y="202368"/>
                  </a:lnTo>
                  <a:cubicBezTo>
                    <a:pt x="144664" y="204224"/>
                    <a:pt x="141956" y="207242"/>
                    <a:pt x="139518" y="208657"/>
                  </a:cubicBezTo>
                  <a:cubicBezTo>
                    <a:pt x="133618" y="211990"/>
                    <a:pt x="123176" y="209411"/>
                    <a:pt x="120559" y="203406"/>
                  </a:cubicBezTo>
                  <a:lnTo>
                    <a:pt x="120072" y="200262"/>
                  </a:lnTo>
                  <a:cubicBezTo>
                    <a:pt x="119023" y="193502"/>
                    <a:pt x="118476" y="186459"/>
                    <a:pt x="111081" y="182749"/>
                  </a:cubicBezTo>
                  <a:cubicBezTo>
                    <a:pt x="110450" y="179699"/>
                    <a:pt x="109443" y="176429"/>
                    <a:pt x="109135" y="173348"/>
                  </a:cubicBezTo>
                  <a:cubicBezTo>
                    <a:pt x="108602" y="168035"/>
                    <a:pt x="110152" y="158445"/>
                    <a:pt x="107188" y="154012"/>
                  </a:cubicBezTo>
                  <a:cubicBezTo>
                    <a:pt x="105280" y="152188"/>
                    <a:pt x="100264" y="149893"/>
                    <a:pt x="97468" y="149830"/>
                  </a:cubicBezTo>
                  <a:cubicBezTo>
                    <a:pt x="94125" y="149736"/>
                    <a:pt x="85980" y="152754"/>
                    <a:pt x="83129" y="154515"/>
                  </a:cubicBezTo>
                  <a:cubicBezTo>
                    <a:pt x="80007" y="159294"/>
                    <a:pt x="77506" y="165205"/>
                    <a:pt x="76808" y="170738"/>
                  </a:cubicBezTo>
                  <a:cubicBezTo>
                    <a:pt x="76590" y="172405"/>
                    <a:pt x="76408" y="185139"/>
                    <a:pt x="76078" y="186679"/>
                  </a:cubicBezTo>
                  <a:cubicBezTo>
                    <a:pt x="75212" y="190704"/>
                    <a:pt x="70915" y="196426"/>
                    <a:pt x="67085" y="198690"/>
                  </a:cubicBezTo>
                  <a:cubicBezTo>
                    <a:pt x="56298" y="199193"/>
                    <a:pt x="46512" y="196740"/>
                    <a:pt x="36943" y="192433"/>
                  </a:cubicBezTo>
                  <a:cubicBezTo>
                    <a:pt x="36469" y="192213"/>
                    <a:pt x="32011" y="190201"/>
                    <a:pt x="31839" y="190075"/>
                  </a:cubicBezTo>
                  <a:cubicBezTo>
                    <a:pt x="29177" y="188031"/>
                    <a:pt x="29019" y="184730"/>
                    <a:pt x="28195" y="181963"/>
                  </a:cubicBezTo>
                  <a:cubicBezTo>
                    <a:pt x="23663" y="166903"/>
                    <a:pt x="23298" y="167783"/>
                    <a:pt x="33786" y="154798"/>
                  </a:cubicBezTo>
                  <a:lnTo>
                    <a:pt x="33057" y="150082"/>
                  </a:lnTo>
                  <a:cubicBezTo>
                    <a:pt x="28454" y="147472"/>
                    <a:pt x="24073" y="145177"/>
                    <a:pt x="21632" y="140649"/>
                  </a:cubicBezTo>
                  <a:cubicBezTo>
                    <a:pt x="18563" y="134990"/>
                    <a:pt x="19401" y="128324"/>
                    <a:pt x="17012" y="122634"/>
                  </a:cubicBezTo>
                  <a:cubicBezTo>
                    <a:pt x="16500" y="121407"/>
                    <a:pt x="13392" y="116125"/>
                    <a:pt x="12638" y="114773"/>
                  </a:cubicBezTo>
                  <a:cubicBezTo>
                    <a:pt x="11933" y="113515"/>
                    <a:pt x="10895" y="112384"/>
                    <a:pt x="10211" y="111126"/>
                  </a:cubicBezTo>
                  <a:cubicBezTo>
                    <a:pt x="6100" y="103517"/>
                    <a:pt x="3006" y="94556"/>
                    <a:pt x="1298" y="86287"/>
                  </a:cubicBezTo>
                  <a:cubicBezTo>
                    <a:pt x="1161" y="85627"/>
                    <a:pt x="-14" y="80250"/>
                    <a:pt x="0" y="79999"/>
                  </a:cubicBezTo>
                  <a:lnTo>
                    <a:pt x="1137" y="76163"/>
                  </a:lnTo>
                  <a:cubicBezTo>
                    <a:pt x="3431" y="68428"/>
                    <a:pt x="7047" y="65315"/>
                    <a:pt x="9239" y="59625"/>
                  </a:cubicBezTo>
                  <a:cubicBezTo>
                    <a:pt x="11112" y="54751"/>
                    <a:pt x="10302" y="46860"/>
                    <a:pt x="15560" y="43684"/>
                  </a:cubicBezTo>
                  <a:cubicBezTo>
                    <a:pt x="20667" y="42552"/>
                    <a:pt x="30268" y="39534"/>
                    <a:pt x="33548" y="35824"/>
                  </a:cubicBezTo>
                  <a:cubicBezTo>
                    <a:pt x="37999" y="23468"/>
                    <a:pt x="30829" y="19411"/>
                    <a:pt x="44242" y="6017"/>
                  </a:cubicBezTo>
                  <a:cubicBezTo>
                    <a:pt x="44435" y="5829"/>
                    <a:pt x="47712" y="3250"/>
                    <a:pt x="47887" y="3157"/>
                  </a:cubicBezTo>
                  <a:cubicBezTo>
                    <a:pt x="50416" y="1835"/>
                    <a:pt x="60539" y="-176"/>
                    <a:pt x="63447" y="12"/>
                  </a:cubicBezTo>
                  <a:cubicBezTo>
                    <a:pt x="63914" y="43"/>
                    <a:pt x="76836" y="2496"/>
                    <a:pt x="77299" y="2621"/>
                  </a:cubicBezTo>
                  <a:cubicBezTo>
                    <a:pt x="86436" y="5420"/>
                    <a:pt x="95104" y="14727"/>
                    <a:pt x="95272" y="23530"/>
                  </a:cubicBezTo>
                  <a:cubicBezTo>
                    <a:pt x="93210" y="26894"/>
                    <a:pt x="92021" y="30542"/>
                    <a:pt x="91154" y="34252"/>
                  </a:cubicBezTo>
                  <a:cubicBezTo>
                    <a:pt x="88594" y="45225"/>
                    <a:pt x="82596" y="47111"/>
                    <a:pt x="72672" y="5229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37" name="자유형: 도형 478"/>
            <p:cNvSpPr/>
            <p:nvPr/>
          </p:nvSpPr>
          <p:spPr>
            <a:xfrm>
              <a:off x="7873200" y="4371120"/>
              <a:ext cx="14040" cy="14760"/>
            </a:xfrm>
            <a:custGeom>
              <a:avLst/>
              <a:gdLst/>
              <a:ahLst/>
              <a:cxnLst/>
              <a:rect l="l" t="t" r="r" b="b"/>
              <a:pathLst>
                <a:path w="11307" h="12293">
                  <a:moveTo>
                    <a:pt x="4378" y="12293"/>
                  </a:moveTo>
                  <a:lnTo>
                    <a:pt x="242" y="9684"/>
                  </a:lnTo>
                  <a:lnTo>
                    <a:pt x="0" y="4464"/>
                  </a:lnTo>
                  <a:lnTo>
                    <a:pt x="2676" y="0"/>
                  </a:lnTo>
                  <a:lnTo>
                    <a:pt x="8510" y="0"/>
                  </a:lnTo>
                  <a:cubicBezTo>
                    <a:pt x="10597" y="1824"/>
                    <a:pt x="11695" y="6162"/>
                    <a:pt x="11182" y="8646"/>
                  </a:cubicBezTo>
                  <a:cubicBezTo>
                    <a:pt x="9253" y="10187"/>
                    <a:pt x="6654" y="11287"/>
                    <a:pt x="4378" y="12293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38" name="자유형: 도형 479"/>
            <p:cNvSpPr/>
            <p:nvPr/>
          </p:nvSpPr>
          <p:spPr>
            <a:xfrm>
              <a:off x="8106120" y="4406760"/>
              <a:ext cx="117720" cy="93960"/>
            </a:xfrm>
            <a:custGeom>
              <a:avLst/>
              <a:gdLst/>
              <a:ahLst/>
              <a:cxnLst/>
              <a:rect l="l" t="t" r="r" b="b"/>
              <a:pathLst>
                <a:path w="93346" h="76827">
                  <a:moveTo>
                    <a:pt x="73658" y="31584"/>
                  </a:moveTo>
                  <a:cubicBezTo>
                    <a:pt x="77524" y="32841"/>
                    <a:pt x="81358" y="34225"/>
                    <a:pt x="85083" y="35766"/>
                  </a:cubicBezTo>
                  <a:lnTo>
                    <a:pt x="87514" y="39444"/>
                  </a:lnTo>
                  <a:cubicBezTo>
                    <a:pt x="87928" y="45230"/>
                    <a:pt x="83533" y="49663"/>
                    <a:pt x="82168" y="55134"/>
                  </a:cubicBezTo>
                  <a:cubicBezTo>
                    <a:pt x="83396" y="59316"/>
                    <a:pt x="85346" y="63906"/>
                    <a:pt x="88243" y="67427"/>
                  </a:cubicBezTo>
                  <a:cubicBezTo>
                    <a:pt x="90327" y="69942"/>
                    <a:pt x="92481" y="71420"/>
                    <a:pt x="93347" y="74721"/>
                  </a:cubicBezTo>
                  <a:lnTo>
                    <a:pt x="89215" y="76828"/>
                  </a:lnTo>
                  <a:cubicBezTo>
                    <a:pt x="84452" y="76168"/>
                    <a:pt x="81884" y="74219"/>
                    <a:pt x="77790" y="72647"/>
                  </a:cubicBezTo>
                  <a:cubicBezTo>
                    <a:pt x="71624" y="70289"/>
                    <a:pt x="59393" y="67427"/>
                    <a:pt x="52753" y="66893"/>
                  </a:cubicBezTo>
                  <a:cubicBezTo>
                    <a:pt x="44450" y="66201"/>
                    <a:pt x="44534" y="69660"/>
                    <a:pt x="38652" y="71609"/>
                  </a:cubicBezTo>
                  <a:cubicBezTo>
                    <a:pt x="32948" y="73496"/>
                    <a:pt x="19142" y="70886"/>
                    <a:pt x="13860" y="68465"/>
                  </a:cubicBezTo>
                  <a:cubicBezTo>
                    <a:pt x="12944" y="68025"/>
                    <a:pt x="6030" y="63340"/>
                    <a:pt x="5353" y="62711"/>
                  </a:cubicBezTo>
                  <a:cubicBezTo>
                    <a:pt x="3385" y="60825"/>
                    <a:pt x="1877" y="57555"/>
                    <a:pt x="4" y="55385"/>
                  </a:cubicBezTo>
                  <a:cubicBezTo>
                    <a:pt x="-84" y="52241"/>
                    <a:pt x="1246" y="47053"/>
                    <a:pt x="3165" y="44412"/>
                  </a:cubicBezTo>
                  <a:cubicBezTo>
                    <a:pt x="3964" y="43312"/>
                    <a:pt x="5820" y="42305"/>
                    <a:pt x="6809" y="41268"/>
                  </a:cubicBezTo>
                  <a:cubicBezTo>
                    <a:pt x="7879" y="40167"/>
                    <a:pt x="8622" y="38658"/>
                    <a:pt x="9727" y="37621"/>
                  </a:cubicBezTo>
                  <a:cubicBezTo>
                    <a:pt x="13347" y="34131"/>
                    <a:pt x="17356" y="32055"/>
                    <a:pt x="20422" y="27685"/>
                  </a:cubicBezTo>
                  <a:cubicBezTo>
                    <a:pt x="25182" y="20831"/>
                    <a:pt x="24239" y="11839"/>
                    <a:pt x="28686" y="5708"/>
                  </a:cubicBezTo>
                  <a:cubicBezTo>
                    <a:pt x="29844" y="4104"/>
                    <a:pt x="34502" y="1086"/>
                    <a:pt x="36463" y="206"/>
                  </a:cubicBezTo>
                  <a:cubicBezTo>
                    <a:pt x="46260" y="-1303"/>
                    <a:pt x="56650" y="5676"/>
                    <a:pt x="52753" y="15109"/>
                  </a:cubicBezTo>
                  <a:cubicBezTo>
                    <a:pt x="50304" y="21051"/>
                    <a:pt x="42289" y="21303"/>
                    <a:pt x="39139" y="34288"/>
                  </a:cubicBezTo>
                  <a:cubicBezTo>
                    <a:pt x="38715" y="36048"/>
                    <a:pt x="38866" y="38879"/>
                    <a:pt x="40111" y="40482"/>
                  </a:cubicBezTo>
                  <a:lnTo>
                    <a:pt x="45457" y="43091"/>
                  </a:lnTo>
                  <a:lnTo>
                    <a:pt x="49589" y="40765"/>
                  </a:lnTo>
                  <a:cubicBezTo>
                    <a:pt x="50683" y="37118"/>
                    <a:pt x="51683" y="33439"/>
                    <a:pt x="52507" y="29760"/>
                  </a:cubicBezTo>
                  <a:cubicBezTo>
                    <a:pt x="54819" y="27622"/>
                    <a:pt x="57400" y="25579"/>
                    <a:pt x="60038" y="23755"/>
                  </a:cubicBezTo>
                  <a:cubicBezTo>
                    <a:pt x="66422" y="23850"/>
                    <a:pt x="70761" y="26899"/>
                    <a:pt x="73658" y="31584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39" name="자유형: 도형 480"/>
            <p:cNvSpPr/>
            <p:nvPr/>
          </p:nvSpPr>
          <p:spPr>
            <a:xfrm>
              <a:off x="8326800" y="4638960"/>
              <a:ext cx="30600" cy="28080"/>
            </a:xfrm>
            <a:custGeom>
              <a:avLst/>
              <a:gdLst/>
              <a:ahLst/>
              <a:cxnLst/>
              <a:rect l="l" t="t" r="r" b="b"/>
              <a:pathLst>
                <a:path w="24550" h="23214">
                  <a:moveTo>
                    <a:pt x="24550" y="7609"/>
                  </a:moveTo>
                  <a:lnTo>
                    <a:pt x="24550" y="17796"/>
                  </a:lnTo>
                  <a:cubicBezTo>
                    <a:pt x="19945" y="23046"/>
                    <a:pt x="12901" y="24744"/>
                    <a:pt x="6075" y="21726"/>
                  </a:cubicBezTo>
                  <a:cubicBezTo>
                    <a:pt x="2073" y="19054"/>
                    <a:pt x="589" y="13645"/>
                    <a:pt x="0" y="9432"/>
                  </a:cubicBezTo>
                  <a:cubicBezTo>
                    <a:pt x="487" y="6728"/>
                    <a:pt x="3076" y="2453"/>
                    <a:pt x="5833" y="1069"/>
                  </a:cubicBezTo>
                  <a:cubicBezTo>
                    <a:pt x="9337" y="345"/>
                    <a:pt x="13189" y="0"/>
                    <a:pt x="16774" y="0"/>
                  </a:cubicBezTo>
                  <a:lnTo>
                    <a:pt x="20176" y="2106"/>
                  </a:lnTo>
                  <a:cubicBezTo>
                    <a:pt x="21600" y="3962"/>
                    <a:pt x="23077" y="5785"/>
                    <a:pt x="24550" y="760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40" name="자유형: 도형 481"/>
            <p:cNvSpPr/>
            <p:nvPr/>
          </p:nvSpPr>
          <p:spPr>
            <a:xfrm>
              <a:off x="8330040" y="4472280"/>
              <a:ext cx="85320" cy="66240"/>
            </a:xfrm>
            <a:custGeom>
              <a:avLst/>
              <a:gdLst/>
              <a:ahLst/>
              <a:cxnLst/>
              <a:rect l="l" t="t" r="r" b="b"/>
              <a:pathLst>
                <a:path w="67757" h="54213">
                  <a:moveTo>
                    <a:pt x="66972" y="31089"/>
                  </a:moveTo>
                  <a:cubicBezTo>
                    <a:pt x="68182" y="33604"/>
                    <a:pt x="67911" y="38069"/>
                    <a:pt x="66729" y="40521"/>
                  </a:cubicBezTo>
                  <a:cubicBezTo>
                    <a:pt x="64225" y="42219"/>
                    <a:pt x="61208" y="44358"/>
                    <a:pt x="59195" y="46527"/>
                  </a:cubicBezTo>
                  <a:cubicBezTo>
                    <a:pt x="58104" y="47690"/>
                    <a:pt x="57406" y="49325"/>
                    <a:pt x="56280" y="50457"/>
                  </a:cubicBezTo>
                  <a:cubicBezTo>
                    <a:pt x="53344" y="53381"/>
                    <a:pt x="49398" y="54607"/>
                    <a:pt x="45098" y="54104"/>
                  </a:cubicBezTo>
                  <a:cubicBezTo>
                    <a:pt x="40797" y="53601"/>
                    <a:pt x="37486" y="52689"/>
                    <a:pt x="33996" y="50268"/>
                  </a:cubicBezTo>
                  <a:cubicBezTo>
                    <a:pt x="30604" y="47910"/>
                    <a:pt x="25875" y="45678"/>
                    <a:pt x="24434" y="41811"/>
                  </a:cubicBezTo>
                  <a:cubicBezTo>
                    <a:pt x="25384" y="35113"/>
                    <a:pt x="31852" y="30460"/>
                    <a:pt x="32940" y="23512"/>
                  </a:cubicBezTo>
                  <a:cubicBezTo>
                    <a:pt x="29443" y="25681"/>
                    <a:pt x="26124" y="25084"/>
                    <a:pt x="22245" y="25335"/>
                  </a:cubicBezTo>
                  <a:cubicBezTo>
                    <a:pt x="20579" y="25461"/>
                    <a:pt x="18797" y="26090"/>
                    <a:pt x="17141" y="26121"/>
                  </a:cubicBezTo>
                  <a:cubicBezTo>
                    <a:pt x="11304" y="26279"/>
                    <a:pt x="4633" y="24329"/>
                    <a:pt x="371" y="20651"/>
                  </a:cubicBezTo>
                  <a:cubicBezTo>
                    <a:pt x="-464" y="18827"/>
                    <a:pt x="371" y="10432"/>
                    <a:pt x="371" y="10432"/>
                  </a:cubicBezTo>
                  <a:cubicBezTo>
                    <a:pt x="746" y="9394"/>
                    <a:pt x="2879" y="7036"/>
                    <a:pt x="3773" y="6282"/>
                  </a:cubicBezTo>
                  <a:cubicBezTo>
                    <a:pt x="9498" y="1345"/>
                    <a:pt x="15103" y="-761"/>
                    <a:pt x="23139" y="245"/>
                  </a:cubicBezTo>
                  <a:lnTo>
                    <a:pt x="27352" y="779"/>
                  </a:lnTo>
                  <a:cubicBezTo>
                    <a:pt x="35427" y="3169"/>
                    <a:pt x="43281" y="15274"/>
                    <a:pt x="49959" y="19613"/>
                  </a:cubicBezTo>
                  <a:cubicBezTo>
                    <a:pt x="52123" y="20996"/>
                    <a:pt x="54856" y="21437"/>
                    <a:pt x="56761" y="23260"/>
                  </a:cubicBezTo>
                  <a:cubicBezTo>
                    <a:pt x="59872" y="26247"/>
                    <a:pt x="62425" y="29705"/>
                    <a:pt x="66972" y="3108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41" name="자유형: 도형 482"/>
            <p:cNvSpPr/>
            <p:nvPr/>
          </p:nvSpPr>
          <p:spPr>
            <a:xfrm>
              <a:off x="8507160" y="4706280"/>
              <a:ext cx="35280" cy="15840"/>
            </a:xfrm>
            <a:custGeom>
              <a:avLst/>
              <a:gdLst/>
              <a:ahLst/>
              <a:cxnLst/>
              <a:rect l="l" t="t" r="r" b="b"/>
              <a:pathLst>
                <a:path w="28123" h="13135">
                  <a:moveTo>
                    <a:pt x="26273" y="2948"/>
                  </a:moveTo>
                  <a:cubicBezTo>
                    <a:pt x="27851" y="5338"/>
                    <a:pt x="28447" y="9677"/>
                    <a:pt x="27956" y="12349"/>
                  </a:cubicBezTo>
                  <a:cubicBezTo>
                    <a:pt x="22344" y="10934"/>
                    <a:pt x="16767" y="12255"/>
                    <a:pt x="11190" y="13135"/>
                  </a:cubicBezTo>
                  <a:lnTo>
                    <a:pt x="982" y="8450"/>
                  </a:lnTo>
                  <a:lnTo>
                    <a:pt x="0" y="3986"/>
                  </a:lnTo>
                  <a:lnTo>
                    <a:pt x="2911" y="56"/>
                  </a:lnTo>
                  <a:cubicBezTo>
                    <a:pt x="5998" y="-165"/>
                    <a:pt x="13119" y="339"/>
                    <a:pt x="13119" y="339"/>
                  </a:cubicBezTo>
                  <a:cubicBezTo>
                    <a:pt x="15890" y="1628"/>
                    <a:pt x="23080" y="2759"/>
                    <a:pt x="26273" y="2948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42" name="자유형: 도형 483"/>
            <p:cNvSpPr/>
            <p:nvPr/>
          </p:nvSpPr>
          <p:spPr>
            <a:xfrm>
              <a:off x="8447400" y="4582440"/>
              <a:ext cx="20520" cy="20880"/>
            </a:xfrm>
            <a:custGeom>
              <a:avLst/>
              <a:gdLst/>
              <a:ahLst/>
              <a:cxnLst/>
              <a:rect l="l" t="t" r="r" b="b"/>
              <a:pathLst>
                <a:path w="16415" h="17164">
                  <a:moveTo>
                    <a:pt x="7608" y="0"/>
                  </a:moveTo>
                  <a:lnTo>
                    <a:pt x="16360" y="4433"/>
                  </a:lnTo>
                  <a:cubicBezTo>
                    <a:pt x="16518" y="7986"/>
                    <a:pt x="16335" y="11665"/>
                    <a:pt x="15872" y="15155"/>
                  </a:cubicBezTo>
                  <a:cubicBezTo>
                    <a:pt x="13294" y="16758"/>
                    <a:pt x="8218" y="17513"/>
                    <a:pt x="5177" y="17009"/>
                  </a:cubicBezTo>
                  <a:lnTo>
                    <a:pt x="1042" y="13865"/>
                  </a:lnTo>
                  <a:cubicBezTo>
                    <a:pt x="-410" y="11225"/>
                    <a:pt x="-203" y="6351"/>
                    <a:pt x="800" y="3678"/>
                  </a:cubicBezTo>
                  <a:cubicBezTo>
                    <a:pt x="3101" y="2673"/>
                    <a:pt x="5640" y="1478"/>
                    <a:pt x="7608" y="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43" name="자유형: 도형 484"/>
            <p:cNvSpPr/>
            <p:nvPr/>
          </p:nvSpPr>
          <p:spPr>
            <a:xfrm>
              <a:off x="8509320" y="4498560"/>
              <a:ext cx="97560" cy="78480"/>
            </a:xfrm>
            <a:custGeom>
              <a:avLst/>
              <a:gdLst/>
              <a:ahLst/>
              <a:cxnLst/>
              <a:rect l="l" t="t" r="r" b="b"/>
              <a:pathLst>
                <a:path w="77520" h="64106">
                  <a:moveTo>
                    <a:pt x="66366" y="58100"/>
                  </a:moveTo>
                  <a:cubicBezTo>
                    <a:pt x="65068" y="60427"/>
                    <a:pt x="61420" y="63383"/>
                    <a:pt x="58578" y="64106"/>
                  </a:cubicBezTo>
                  <a:cubicBezTo>
                    <a:pt x="54580" y="63823"/>
                    <a:pt x="50195" y="62974"/>
                    <a:pt x="46407" y="61748"/>
                  </a:cubicBezTo>
                  <a:cubicBezTo>
                    <a:pt x="43916" y="58855"/>
                    <a:pt x="37392" y="53762"/>
                    <a:pt x="35954" y="51812"/>
                  </a:cubicBezTo>
                  <a:cubicBezTo>
                    <a:pt x="33989" y="49109"/>
                    <a:pt x="34691" y="46813"/>
                    <a:pt x="30868" y="44235"/>
                  </a:cubicBezTo>
                  <a:cubicBezTo>
                    <a:pt x="27921" y="42222"/>
                    <a:pt x="24448" y="42129"/>
                    <a:pt x="23081" y="38198"/>
                  </a:cubicBezTo>
                  <a:cubicBezTo>
                    <a:pt x="24694" y="35148"/>
                    <a:pt x="26834" y="32035"/>
                    <a:pt x="29149" y="29332"/>
                  </a:cubicBezTo>
                  <a:cubicBezTo>
                    <a:pt x="28728" y="26879"/>
                    <a:pt x="25606" y="23012"/>
                    <a:pt x="23081" y="22006"/>
                  </a:cubicBezTo>
                  <a:cubicBezTo>
                    <a:pt x="19819" y="20685"/>
                    <a:pt x="14136" y="20434"/>
                    <a:pt x="10207" y="18862"/>
                  </a:cubicBezTo>
                  <a:cubicBezTo>
                    <a:pt x="7015" y="17604"/>
                    <a:pt x="3578" y="15466"/>
                    <a:pt x="737" y="13643"/>
                  </a:cubicBezTo>
                  <a:lnTo>
                    <a:pt x="0" y="8926"/>
                  </a:lnTo>
                  <a:cubicBezTo>
                    <a:pt x="3122" y="-506"/>
                    <a:pt x="13084" y="-978"/>
                    <a:pt x="22344" y="846"/>
                  </a:cubicBezTo>
                  <a:cubicBezTo>
                    <a:pt x="26378" y="1600"/>
                    <a:pt x="30306" y="4053"/>
                    <a:pt x="34270" y="4744"/>
                  </a:cubicBezTo>
                  <a:cubicBezTo>
                    <a:pt x="38093" y="5436"/>
                    <a:pt x="41566" y="4053"/>
                    <a:pt x="45214" y="3707"/>
                  </a:cubicBezTo>
                  <a:cubicBezTo>
                    <a:pt x="47740" y="3456"/>
                    <a:pt x="50651" y="3707"/>
                    <a:pt x="53212" y="3707"/>
                  </a:cubicBezTo>
                  <a:cubicBezTo>
                    <a:pt x="63665" y="3707"/>
                    <a:pt x="69347" y="3613"/>
                    <a:pt x="76573" y="11536"/>
                  </a:cubicBezTo>
                  <a:cubicBezTo>
                    <a:pt x="76678" y="12102"/>
                    <a:pt x="77555" y="15969"/>
                    <a:pt x="77520" y="16283"/>
                  </a:cubicBezTo>
                  <a:cubicBezTo>
                    <a:pt x="77450" y="18641"/>
                    <a:pt x="76152" y="21848"/>
                    <a:pt x="75836" y="24364"/>
                  </a:cubicBezTo>
                  <a:cubicBezTo>
                    <a:pt x="75731" y="25087"/>
                    <a:pt x="75801" y="25496"/>
                    <a:pt x="75591" y="26188"/>
                  </a:cubicBezTo>
                  <a:cubicBezTo>
                    <a:pt x="75100" y="27634"/>
                    <a:pt x="73626" y="29237"/>
                    <a:pt x="72925" y="30621"/>
                  </a:cubicBezTo>
                  <a:cubicBezTo>
                    <a:pt x="71311" y="33796"/>
                    <a:pt x="69417" y="38010"/>
                    <a:pt x="68540" y="41343"/>
                  </a:cubicBezTo>
                  <a:cubicBezTo>
                    <a:pt x="67347" y="45807"/>
                    <a:pt x="66576" y="53447"/>
                    <a:pt x="66366" y="58100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44" name="자유형: 도형 485"/>
            <p:cNvSpPr/>
            <p:nvPr/>
          </p:nvSpPr>
          <p:spPr>
            <a:xfrm>
              <a:off x="8618040" y="4609080"/>
              <a:ext cx="21960" cy="34920"/>
            </a:xfrm>
            <a:custGeom>
              <a:avLst/>
              <a:gdLst/>
              <a:ahLst/>
              <a:cxnLst/>
              <a:rect l="l" t="t" r="r" b="b"/>
              <a:pathLst>
                <a:path w="17794" h="28809">
                  <a:moveTo>
                    <a:pt x="17381" y="25876"/>
                  </a:moveTo>
                  <a:cubicBezTo>
                    <a:pt x="15347" y="27825"/>
                    <a:pt x="10506" y="29052"/>
                    <a:pt x="7665" y="28769"/>
                  </a:cubicBezTo>
                  <a:lnTo>
                    <a:pt x="2544" y="26662"/>
                  </a:lnTo>
                  <a:lnTo>
                    <a:pt x="124" y="23015"/>
                  </a:lnTo>
                  <a:cubicBezTo>
                    <a:pt x="-683" y="10973"/>
                    <a:pt x="2438" y="8803"/>
                    <a:pt x="10085" y="0"/>
                  </a:cubicBezTo>
                  <a:lnTo>
                    <a:pt x="13733" y="2106"/>
                  </a:lnTo>
                  <a:cubicBezTo>
                    <a:pt x="12505" y="6697"/>
                    <a:pt x="13067" y="12199"/>
                    <a:pt x="15417" y="16475"/>
                  </a:cubicBezTo>
                  <a:lnTo>
                    <a:pt x="15662" y="15940"/>
                  </a:lnTo>
                  <a:cubicBezTo>
                    <a:pt x="17241" y="18330"/>
                    <a:pt x="18469" y="23172"/>
                    <a:pt x="17381" y="25876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45" name="자유형: 도형 486"/>
            <p:cNvSpPr/>
            <p:nvPr/>
          </p:nvSpPr>
          <p:spPr>
            <a:xfrm>
              <a:off x="8652600" y="4594680"/>
              <a:ext cx="34560" cy="19080"/>
            </a:xfrm>
            <a:custGeom>
              <a:avLst/>
              <a:gdLst/>
              <a:ahLst/>
              <a:cxnLst/>
              <a:rect l="l" t="t" r="r" b="b"/>
              <a:pathLst>
                <a:path w="27755" h="15867">
                  <a:moveTo>
                    <a:pt x="26974" y="5056"/>
                  </a:moveTo>
                  <a:cubicBezTo>
                    <a:pt x="28342" y="7886"/>
                    <a:pt x="27745" y="13011"/>
                    <a:pt x="26483" y="15778"/>
                  </a:cubicBezTo>
                  <a:cubicBezTo>
                    <a:pt x="20450" y="16407"/>
                    <a:pt x="6699" y="13640"/>
                    <a:pt x="1684" y="10559"/>
                  </a:cubicBezTo>
                  <a:lnTo>
                    <a:pt x="0" y="6377"/>
                  </a:lnTo>
                  <a:lnTo>
                    <a:pt x="1684" y="2447"/>
                  </a:lnTo>
                  <a:cubicBezTo>
                    <a:pt x="11961" y="-2772"/>
                    <a:pt x="17678" y="1441"/>
                    <a:pt x="26974" y="5056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46" name="자유형: 도형 487"/>
            <p:cNvSpPr/>
            <p:nvPr/>
          </p:nvSpPr>
          <p:spPr>
            <a:xfrm>
              <a:off x="8625960" y="4539600"/>
              <a:ext cx="39240" cy="46800"/>
            </a:xfrm>
            <a:custGeom>
              <a:avLst/>
              <a:gdLst/>
              <a:ahLst/>
              <a:cxnLst/>
              <a:rect l="l" t="t" r="r" b="b"/>
              <a:pathLst>
                <a:path w="31358" h="38282">
                  <a:moveTo>
                    <a:pt x="28167" y="21977"/>
                  </a:moveTo>
                  <a:lnTo>
                    <a:pt x="31359" y="25341"/>
                  </a:lnTo>
                  <a:lnTo>
                    <a:pt x="30622" y="30843"/>
                  </a:lnTo>
                  <a:cubicBezTo>
                    <a:pt x="27325" y="36126"/>
                    <a:pt x="19503" y="40150"/>
                    <a:pt x="12873" y="37383"/>
                  </a:cubicBezTo>
                  <a:cubicBezTo>
                    <a:pt x="12488" y="36974"/>
                    <a:pt x="9646" y="34239"/>
                    <a:pt x="9471" y="33988"/>
                  </a:cubicBezTo>
                  <a:cubicBezTo>
                    <a:pt x="7857" y="31472"/>
                    <a:pt x="7927" y="27825"/>
                    <a:pt x="7050" y="25090"/>
                  </a:cubicBezTo>
                  <a:cubicBezTo>
                    <a:pt x="5402" y="20122"/>
                    <a:pt x="2070" y="13488"/>
                    <a:pt x="0" y="8363"/>
                  </a:cubicBezTo>
                  <a:lnTo>
                    <a:pt x="2175" y="3144"/>
                  </a:lnTo>
                  <a:cubicBezTo>
                    <a:pt x="5086" y="1792"/>
                    <a:pt x="8454" y="660"/>
                    <a:pt x="11681" y="0"/>
                  </a:cubicBezTo>
                  <a:lnTo>
                    <a:pt x="16276" y="1572"/>
                  </a:lnTo>
                  <a:cubicBezTo>
                    <a:pt x="18836" y="4401"/>
                    <a:pt x="18415" y="7105"/>
                    <a:pt x="19678" y="10187"/>
                  </a:cubicBezTo>
                  <a:cubicBezTo>
                    <a:pt x="21432" y="14494"/>
                    <a:pt x="27957" y="19870"/>
                    <a:pt x="27957" y="19870"/>
                  </a:cubicBezTo>
                  <a:lnTo>
                    <a:pt x="28167" y="21977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47" name="자유형: 도형 488"/>
            <p:cNvSpPr/>
            <p:nvPr/>
          </p:nvSpPr>
          <p:spPr>
            <a:xfrm>
              <a:off x="8645760" y="4279320"/>
              <a:ext cx="278280" cy="363960"/>
            </a:xfrm>
            <a:custGeom>
              <a:avLst/>
              <a:gdLst/>
              <a:ahLst/>
              <a:cxnLst/>
              <a:rect l="l" t="t" r="r" b="b"/>
              <a:pathLst>
                <a:path w="220446" h="296623">
                  <a:moveTo>
                    <a:pt x="204429" y="86689"/>
                  </a:moveTo>
                  <a:cubicBezTo>
                    <a:pt x="203868" y="91468"/>
                    <a:pt x="201868" y="99863"/>
                    <a:pt x="200290" y="104453"/>
                  </a:cubicBezTo>
                  <a:cubicBezTo>
                    <a:pt x="199237" y="107660"/>
                    <a:pt x="195134" y="117093"/>
                    <a:pt x="193520" y="120143"/>
                  </a:cubicBezTo>
                  <a:cubicBezTo>
                    <a:pt x="190118" y="126557"/>
                    <a:pt x="186505" y="132625"/>
                    <a:pt x="187417" y="140014"/>
                  </a:cubicBezTo>
                  <a:cubicBezTo>
                    <a:pt x="189907" y="140674"/>
                    <a:pt x="195309" y="140516"/>
                    <a:pt x="197624" y="139479"/>
                  </a:cubicBezTo>
                  <a:cubicBezTo>
                    <a:pt x="198010" y="139322"/>
                    <a:pt x="204569" y="134291"/>
                    <a:pt x="205166" y="133725"/>
                  </a:cubicBezTo>
                  <a:cubicBezTo>
                    <a:pt x="207726" y="131367"/>
                    <a:pt x="208989" y="128789"/>
                    <a:pt x="212707" y="127469"/>
                  </a:cubicBezTo>
                  <a:lnTo>
                    <a:pt x="217583" y="127971"/>
                  </a:lnTo>
                  <a:lnTo>
                    <a:pt x="220249" y="131651"/>
                  </a:lnTo>
                  <a:cubicBezTo>
                    <a:pt x="221371" y="139039"/>
                    <a:pt x="217548" y="145642"/>
                    <a:pt x="212707" y="151238"/>
                  </a:cubicBezTo>
                  <a:cubicBezTo>
                    <a:pt x="212357" y="151647"/>
                    <a:pt x="209656" y="154697"/>
                    <a:pt x="209550" y="154917"/>
                  </a:cubicBezTo>
                  <a:cubicBezTo>
                    <a:pt x="205622" y="162935"/>
                    <a:pt x="212041" y="168342"/>
                    <a:pt x="206393" y="176077"/>
                  </a:cubicBezTo>
                  <a:cubicBezTo>
                    <a:pt x="201763" y="177429"/>
                    <a:pt x="195555" y="177083"/>
                    <a:pt x="192047" y="173750"/>
                  </a:cubicBezTo>
                  <a:lnTo>
                    <a:pt x="188645" y="177397"/>
                  </a:lnTo>
                  <a:cubicBezTo>
                    <a:pt x="188294" y="179787"/>
                    <a:pt x="190013" y="183529"/>
                    <a:pt x="191801" y="185226"/>
                  </a:cubicBezTo>
                  <a:cubicBezTo>
                    <a:pt x="195099" y="187018"/>
                    <a:pt x="199062" y="188496"/>
                    <a:pt x="202745" y="189439"/>
                  </a:cubicBezTo>
                  <a:cubicBezTo>
                    <a:pt x="206920" y="194816"/>
                    <a:pt x="203342" y="199595"/>
                    <a:pt x="203692" y="204311"/>
                  </a:cubicBezTo>
                  <a:cubicBezTo>
                    <a:pt x="203938" y="207329"/>
                    <a:pt x="208954" y="213209"/>
                    <a:pt x="210743" y="216102"/>
                  </a:cubicBezTo>
                  <a:lnTo>
                    <a:pt x="209796" y="221824"/>
                  </a:lnTo>
                  <a:cubicBezTo>
                    <a:pt x="205937" y="222107"/>
                    <a:pt x="201658" y="221761"/>
                    <a:pt x="197870" y="221070"/>
                  </a:cubicBezTo>
                  <a:cubicBezTo>
                    <a:pt x="195940" y="218963"/>
                    <a:pt x="194222" y="215851"/>
                    <a:pt x="193520" y="213209"/>
                  </a:cubicBezTo>
                  <a:lnTo>
                    <a:pt x="188154" y="211889"/>
                  </a:lnTo>
                  <a:lnTo>
                    <a:pt x="183769" y="213995"/>
                  </a:lnTo>
                  <a:cubicBezTo>
                    <a:pt x="176192" y="212644"/>
                    <a:pt x="171141" y="206732"/>
                    <a:pt x="164091" y="204060"/>
                  </a:cubicBezTo>
                  <a:lnTo>
                    <a:pt x="159706" y="206418"/>
                  </a:lnTo>
                  <a:cubicBezTo>
                    <a:pt x="159250" y="211260"/>
                    <a:pt x="161881" y="216793"/>
                    <a:pt x="160934" y="221321"/>
                  </a:cubicBezTo>
                  <a:lnTo>
                    <a:pt x="159320" y="224968"/>
                  </a:lnTo>
                  <a:cubicBezTo>
                    <a:pt x="158478" y="226855"/>
                    <a:pt x="156549" y="229275"/>
                    <a:pt x="154620" y="230471"/>
                  </a:cubicBezTo>
                  <a:cubicBezTo>
                    <a:pt x="147499" y="230439"/>
                    <a:pt x="141782" y="235218"/>
                    <a:pt x="138309" y="240406"/>
                  </a:cubicBezTo>
                  <a:cubicBezTo>
                    <a:pt x="137081" y="247040"/>
                    <a:pt x="141326" y="252668"/>
                    <a:pt x="147815" y="255561"/>
                  </a:cubicBezTo>
                  <a:cubicBezTo>
                    <a:pt x="152796" y="255246"/>
                    <a:pt x="160688" y="255403"/>
                    <a:pt x="164091" y="259239"/>
                  </a:cubicBezTo>
                  <a:cubicBezTo>
                    <a:pt x="165845" y="261503"/>
                    <a:pt x="166581" y="265968"/>
                    <a:pt x="166055" y="268640"/>
                  </a:cubicBezTo>
                  <a:lnTo>
                    <a:pt x="163109" y="273074"/>
                  </a:lnTo>
                  <a:cubicBezTo>
                    <a:pt x="158233" y="276375"/>
                    <a:pt x="150691" y="273105"/>
                    <a:pt x="145359" y="272570"/>
                  </a:cubicBezTo>
                  <a:cubicBezTo>
                    <a:pt x="141957" y="272193"/>
                    <a:pt x="137537" y="272602"/>
                    <a:pt x="134205" y="273356"/>
                  </a:cubicBezTo>
                  <a:cubicBezTo>
                    <a:pt x="132276" y="276029"/>
                    <a:pt x="130908" y="280085"/>
                    <a:pt x="130803" y="283292"/>
                  </a:cubicBezTo>
                  <a:cubicBezTo>
                    <a:pt x="129084" y="285556"/>
                    <a:pt x="125261" y="287536"/>
                    <a:pt x="122279" y="287977"/>
                  </a:cubicBezTo>
                  <a:cubicBezTo>
                    <a:pt x="120455" y="288259"/>
                    <a:pt x="118280" y="287725"/>
                    <a:pt x="116456" y="287977"/>
                  </a:cubicBezTo>
                  <a:lnTo>
                    <a:pt x="113194" y="289045"/>
                  </a:lnTo>
                  <a:cubicBezTo>
                    <a:pt x="109441" y="290241"/>
                    <a:pt x="106635" y="292536"/>
                    <a:pt x="102601" y="293479"/>
                  </a:cubicBezTo>
                  <a:cubicBezTo>
                    <a:pt x="97515" y="294642"/>
                    <a:pt x="92394" y="294454"/>
                    <a:pt x="87518" y="296623"/>
                  </a:cubicBezTo>
                  <a:lnTo>
                    <a:pt x="82642" y="295051"/>
                  </a:lnTo>
                  <a:lnTo>
                    <a:pt x="79976" y="291121"/>
                  </a:lnTo>
                  <a:lnTo>
                    <a:pt x="82432" y="285901"/>
                  </a:lnTo>
                  <a:cubicBezTo>
                    <a:pt x="85729" y="284518"/>
                    <a:pt x="89201" y="284581"/>
                    <a:pt x="92394" y="283543"/>
                  </a:cubicBezTo>
                  <a:cubicBezTo>
                    <a:pt x="95866" y="282380"/>
                    <a:pt x="102285" y="278135"/>
                    <a:pt x="104039" y="275180"/>
                  </a:cubicBezTo>
                  <a:lnTo>
                    <a:pt x="101373" y="271502"/>
                  </a:lnTo>
                  <a:cubicBezTo>
                    <a:pt x="97129" y="271218"/>
                    <a:pt x="92534" y="270369"/>
                    <a:pt x="88500" y="269175"/>
                  </a:cubicBezTo>
                  <a:cubicBezTo>
                    <a:pt x="88395" y="267288"/>
                    <a:pt x="88500" y="260182"/>
                    <a:pt x="88991" y="258705"/>
                  </a:cubicBezTo>
                  <a:cubicBezTo>
                    <a:pt x="89097" y="258390"/>
                    <a:pt x="91552" y="254586"/>
                    <a:pt x="91902" y="253989"/>
                  </a:cubicBezTo>
                  <a:cubicBezTo>
                    <a:pt x="93762" y="250813"/>
                    <a:pt x="95410" y="247449"/>
                    <a:pt x="96743" y="244053"/>
                  </a:cubicBezTo>
                  <a:lnTo>
                    <a:pt x="93130" y="240909"/>
                  </a:lnTo>
                  <a:cubicBezTo>
                    <a:pt x="92499" y="240846"/>
                    <a:pt x="87062" y="240123"/>
                    <a:pt x="86781" y="240155"/>
                  </a:cubicBezTo>
                  <a:lnTo>
                    <a:pt x="83730" y="241192"/>
                  </a:lnTo>
                  <a:cubicBezTo>
                    <a:pt x="78433" y="242984"/>
                    <a:pt x="72575" y="244399"/>
                    <a:pt x="69769" y="249304"/>
                  </a:cubicBezTo>
                  <a:lnTo>
                    <a:pt x="64683" y="250342"/>
                  </a:lnTo>
                  <a:cubicBezTo>
                    <a:pt x="63034" y="248015"/>
                    <a:pt x="62157" y="243613"/>
                    <a:pt x="62719" y="240909"/>
                  </a:cubicBezTo>
                  <a:cubicBezTo>
                    <a:pt x="59141" y="238079"/>
                    <a:pt x="56089" y="233520"/>
                    <a:pt x="55914" y="229150"/>
                  </a:cubicBezTo>
                  <a:lnTo>
                    <a:pt x="58088" y="223679"/>
                  </a:lnTo>
                  <a:cubicBezTo>
                    <a:pt x="66857" y="220504"/>
                    <a:pt x="81870" y="222987"/>
                    <a:pt x="87764" y="216102"/>
                  </a:cubicBezTo>
                  <a:cubicBezTo>
                    <a:pt x="89167" y="211480"/>
                    <a:pt x="91376" y="205097"/>
                    <a:pt x="95305" y="201702"/>
                  </a:cubicBezTo>
                  <a:lnTo>
                    <a:pt x="95796" y="197268"/>
                  </a:lnTo>
                  <a:cubicBezTo>
                    <a:pt x="93726" y="194973"/>
                    <a:pt x="91867" y="192300"/>
                    <a:pt x="90429" y="189691"/>
                  </a:cubicBezTo>
                  <a:cubicBezTo>
                    <a:pt x="90640" y="185887"/>
                    <a:pt x="91587" y="181768"/>
                    <a:pt x="92850" y="178183"/>
                  </a:cubicBezTo>
                  <a:lnTo>
                    <a:pt x="90429" y="174253"/>
                  </a:lnTo>
                  <a:lnTo>
                    <a:pt x="85589" y="172681"/>
                  </a:lnTo>
                  <a:cubicBezTo>
                    <a:pt x="78538" y="176045"/>
                    <a:pt x="72751" y="182962"/>
                    <a:pt x="64437" y="184189"/>
                  </a:cubicBezTo>
                  <a:cubicBezTo>
                    <a:pt x="60859" y="184723"/>
                    <a:pt x="52266" y="183685"/>
                    <a:pt x="52266" y="183685"/>
                  </a:cubicBezTo>
                  <a:cubicBezTo>
                    <a:pt x="51634" y="187647"/>
                    <a:pt x="45145" y="188779"/>
                    <a:pt x="42304" y="190980"/>
                  </a:cubicBezTo>
                  <a:cubicBezTo>
                    <a:pt x="38165" y="194250"/>
                    <a:pt x="38060" y="197300"/>
                    <a:pt x="31114" y="200130"/>
                  </a:cubicBezTo>
                  <a:lnTo>
                    <a:pt x="26975" y="197268"/>
                  </a:lnTo>
                  <a:cubicBezTo>
                    <a:pt x="26379" y="194219"/>
                    <a:pt x="25748" y="191169"/>
                    <a:pt x="25046" y="188119"/>
                  </a:cubicBezTo>
                  <a:cubicBezTo>
                    <a:pt x="22099" y="185824"/>
                    <a:pt x="18487" y="184849"/>
                    <a:pt x="15575" y="182899"/>
                  </a:cubicBezTo>
                  <a:cubicBezTo>
                    <a:pt x="13471" y="181485"/>
                    <a:pt x="11857" y="179284"/>
                    <a:pt x="9262" y="177586"/>
                  </a:cubicBezTo>
                  <a:cubicBezTo>
                    <a:pt x="8665" y="177209"/>
                    <a:pt x="8279" y="177083"/>
                    <a:pt x="7788" y="176611"/>
                  </a:cubicBezTo>
                  <a:cubicBezTo>
                    <a:pt x="4035" y="172996"/>
                    <a:pt x="142" y="160073"/>
                    <a:pt x="1" y="155169"/>
                  </a:cubicBezTo>
                  <a:cubicBezTo>
                    <a:pt x="-69" y="151615"/>
                    <a:pt x="2912" y="136586"/>
                    <a:pt x="4877" y="133725"/>
                  </a:cubicBezTo>
                  <a:cubicBezTo>
                    <a:pt x="5157" y="133317"/>
                    <a:pt x="5473" y="133191"/>
                    <a:pt x="5859" y="132876"/>
                  </a:cubicBezTo>
                  <a:cubicBezTo>
                    <a:pt x="7648" y="131241"/>
                    <a:pt x="9121" y="128915"/>
                    <a:pt x="10945" y="127469"/>
                  </a:cubicBezTo>
                  <a:cubicBezTo>
                    <a:pt x="15084" y="124167"/>
                    <a:pt x="24835" y="123978"/>
                    <a:pt x="30132" y="121180"/>
                  </a:cubicBezTo>
                  <a:cubicBezTo>
                    <a:pt x="30413" y="121054"/>
                    <a:pt x="37533" y="115363"/>
                    <a:pt x="37674" y="115175"/>
                  </a:cubicBezTo>
                  <a:cubicBezTo>
                    <a:pt x="39673" y="112786"/>
                    <a:pt x="39919" y="109798"/>
                    <a:pt x="43286" y="108101"/>
                  </a:cubicBezTo>
                  <a:lnTo>
                    <a:pt x="49109" y="107849"/>
                  </a:lnTo>
                  <a:cubicBezTo>
                    <a:pt x="54545" y="109610"/>
                    <a:pt x="56194" y="114546"/>
                    <a:pt x="61035" y="116998"/>
                  </a:cubicBezTo>
                  <a:cubicBezTo>
                    <a:pt x="66261" y="117722"/>
                    <a:pt x="71663" y="115144"/>
                    <a:pt x="74890" y="111528"/>
                  </a:cubicBezTo>
                  <a:lnTo>
                    <a:pt x="79976" y="110742"/>
                  </a:lnTo>
                  <a:lnTo>
                    <a:pt x="92850" y="119357"/>
                  </a:lnTo>
                  <a:cubicBezTo>
                    <a:pt x="96463" y="120709"/>
                    <a:pt x="101584" y="120960"/>
                    <a:pt x="105512" y="121966"/>
                  </a:cubicBezTo>
                  <a:cubicBezTo>
                    <a:pt x="106319" y="122689"/>
                    <a:pt x="112282" y="128475"/>
                    <a:pt x="112317" y="128506"/>
                  </a:cubicBezTo>
                  <a:cubicBezTo>
                    <a:pt x="114808" y="129890"/>
                    <a:pt x="121016" y="130802"/>
                    <a:pt x="123963" y="130330"/>
                  </a:cubicBezTo>
                  <a:lnTo>
                    <a:pt x="128347" y="127971"/>
                  </a:lnTo>
                  <a:lnTo>
                    <a:pt x="127856" y="124325"/>
                  </a:lnTo>
                  <a:cubicBezTo>
                    <a:pt x="125015" y="120300"/>
                    <a:pt x="120034" y="118633"/>
                    <a:pt x="116912" y="114924"/>
                  </a:cubicBezTo>
                  <a:cubicBezTo>
                    <a:pt x="114422" y="111905"/>
                    <a:pt x="111896" y="105931"/>
                    <a:pt x="109160" y="103416"/>
                  </a:cubicBezTo>
                  <a:cubicBezTo>
                    <a:pt x="108038" y="102379"/>
                    <a:pt x="106003" y="101781"/>
                    <a:pt x="104776" y="100806"/>
                  </a:cubicBezTo>
                  <a:cubicBezTo>
                    <a:pt x="103548" y="99800"/>
                    <a:pt x="102531" y="98260"/>
                    <a:pt x="101373" y="97128"/>
                  </a:cubicBezTo>
                  <a:cubicBezTo>
                    <a:pt x="100251" y="96059"/>
                    <a:pt x="98743" y="95115"/>
                    <a:pt x="97725" y="93984"/>
                  </a:cubicBezTo>
                  <a:cubicBezTo>
                    <a:pt x="95831" y="91877"/>
                    <a:pt x="95165" y="89771"/>
                    <a:pt x="94639" y="87192"/>
                  </a:cubicBezTo>
                  <a:cubicBezTo>
                    <a:pt x="92850" y="78483"/>
                    <a:pt x="96322" y="74836"/>
                    <a:pt x="102321" y="68642"/>
                  </a:cubicBezTo>
                  <a:cubicBezTo>
                    <a:pt x="108459" y="67415"/>
                    <a:pt x="114281" y="69019"/>
                    <a:pt x="120315" y="69428"/>
                  </a:cubicBezTo>
                  <a:cubicBezTo>
                    <a:pt x="122876" y="69585"/>
                    <a:pt x="135222" y="69271"/>
                    <a:pt x="137327" y="68642"/>
                  </a:cubicBezTo>
                  <a:cubicBezTo>
                    <a:pt x="144272" y="66535"/>
                    <a:pt x="146763" y="58424"/>
                    <a:pt x="150235" y="53487"/>
                  </a:cubicBezTo>
                  <a:cubicBezTo>
                    <a:pt x="152130" y="50784"/>
                    <a:pt x="154550" y="48111"/>
                    <a:pt x="156795" y="45627"/>
                  </a:cubicBezTo>
                  <a:cubicBezTo>
                    <a:pt x="159952" y="46036"/>
                    <a:pt x="164336" y="45564"/>
                    <a:pt x="167247" y="44338"/>
                  </a:cubicBezTo>
                  <a:cubicBezTo>
                    <a:pt x="166827" y="36572"/>
                    <a:pt x="157707" y="35817"/>
                    <a:pt x="159460" y="22014"/>
                  </a:cubicBezTo>
                  <a:cubicBezTo>
                    <a:pt x="159881" y="18681"/>
                    <a:pt x="160618" y="16041"/>
                    <a:pt x="162126" y="12960"/>
                  </a:cubicBezTo>
                  <a:cubicBezTo>
                    <a:pt x="163424" y="10318"/>
                    <a:pt x="165529" y="6514"/>
                    <a:pt x="167984" y="4596"/>
                  </a:cubicBezTo>
                  <a:cubicBezTo>
                    <a:pt x="168159" y="4408"/>
                    <a:pt x="171667" y="2678"/>
                    <a:pt x="172088" y="2489"/>
                  </a:cubicBezTo>
                  <a:cubicBezTo>
                    <a:pt x="172544" y="2269"/>
                    <a:pt x="176999" y="194"/>
                    <a:pt x="177210" y="131"/>
                  </a:cubicBezTo>
                  <a:cubicBezTo>
                    <a:pt x="179384" y="-309"/>
                    <a:pt x="186400" y="414"/>
                    <a:pt x="188399" y="1451"/>
                  </a:cubicBezTo>
                  <a:cubicBezTo>
                    <a:pt x="191696" y="3118"/>
                    <a:pt x="195800" y="9375"/>
                    <a:pt x="196396" y="12676"/>
                  </a:cubicBezTo>
                  <a:cubicBezTo>
                    <a:pt x="197098" y="16575"/>
                    <a:pt x="194116" y="24938"/>
                    <a:pt x="192047" y="28365"/>
                  </a:cubicBezTo>
                  <a:cubicBezTo>
                    <a:pt x="191240" y="29654"/>
                    <a:pt x="189522" y="30787"/>
                    <a:pt x="188645" y="32044"/>
                  </a:cubicBezTo>
                  <a:cubicBezTo>
                    <a:pt x="186575" y="34906"/>
                    <a:pt x="184821" y="39401"/>
                    <a:pt x="184260" y="42734"/>
                  </a:cubicBezTo>
                  <a:cubicBezTo>
                    <a:pt x="183558" y="46884"/>
                    <a:pt x="185032" y="51507"/>
                    <a:pt x="185873" y="55562"/>
                  </a:cubicBezTo>
                  <a:cubicBezTo>
                    <a:pt x="186505" y="58549"/>
                    <a:pt x="187066" y="63454"/>
                    <a:pt x="188855" y="66032"/>
                  </a:cubicBezTo>
                  <a:cubicBezTo>
                    <a:pt x="190574" y="68422"/>
                    <a:pt x="193976" y="70434"/>
                    <a:pt x="195905" y="72823"/>
                  </a:cubicBezTo>
                  <a:cubicBezTo>
                    <a:pt x="197098" y="74239"/>
                    <a:pt x="199237" y="76942"/>
                    <a:pt x="200045" y="78577"/>
                  </a:cubicBezTo>
                  <a:cubicBezTo>
                    <a:pt x="201553" y="81533"/>
                    <a:pt x="201868" y="84079"/>
                    <a:pt x="204429" y="8668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48" name="자유형: 도형 489"/>
            <p:cNvSpPr/>
            <p:nvPr/>
          </p:nvSpPr>
          <p:spPr>
            <a:xfrm>
              <a:off x="8682840" y="4346280"/>
              <a:ext cx="19800" cy="48600"/>
            </a:xfrm>
            <a:custGeom>
              <a:avLst/>
              <a:gdLst/>
              <a:ahLst/>
              <a:cxnLst/>
              <a:rect l="l" t="t" r="r" b="b"/>
              <a:pathLst>
                <a:path w="16092" h="39741">
                  <a:moveTo>
                    <a:pt x="13126" y="36849"/>
                  </a:moveTo>
                  <a:lnTo>
                    <a:pt x="9478" y="39742"/>
                  </a:lnTo>
                  <a:lnTo>
                    <a:pt x="3409" y="37887"/>
                  </a:lnTo>
                  <a:cubicBezTo>
                    <a:pt x="1831" y="36126"/>
                    <a:pt x="-133" y="31536"/>
                    <a:pt x="7" y="29272"/>
                  </a:cubicBezTo>
                  <a:cubicBezTo>
                    <a:pt x="147" y="27354"/>
                    <a:pt x="1410" y="25185"/>
                    <a:pt x="1691" y="23266"/>
                  </a:cubicBezTo>
                  <a:cubicBezTo>
                    <a:pt x="2252" y="19840"/>
                    <a:pt x="814" y="16821"/>
                    <a:pt x="744" y="13582"/>
                  </a:cubicBezTo>
                  <a:cubicBezTo>
                    <a:pt x="673" y="10407"/>
                    <a:pt x="1726" y="6225"/>
                    <a:pt x="2673" y="3144"/>
                  </a:cubicBezTo>
                  <a:lnTo>
                    <a:pt x="6566" y="0"/>
                  </a:lnTo>
                  <a:lnTo>
                    <a:pt x="12880" y="786"/>
                  </a:lnTo>
                  <a:cubicBezTo>
                    <a:pt x="16879" y="5188"/>
                    <a:pt x="16423" y="10595"/>
                    <a:pt x="15336" y="15940"/>
                  </a:cubicBezTo>
                  <a:cubicBezTo>
                    <a:pt x="14985" y="17450"/>
                    <a:pt x="13933" y="19431"/>
                    <a:pt x="13862" y="20908"/>
                  </a:cubicBezTo>
                  <a:cubicBezTo>
                    <a:pt x="13792" y="22291"/>
                    <a:pt x="14669" y="24178"/>
                    <a:pt x="14845" y="25624"/>
                  </a:cubicBezTo>
                  <a:cubicBezTo>
                    <a:pt x="15195" y="29272"/>
                    <a:pt x="14494" y="33422"/>
                    <a:pt x="13126" y="3684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49" name="자유형: 도형 490"/>
            <p:cNvSpPr/>
            <p:nvPr/>
          </p:nvSpPr>
          <p:spPr>
            <a:xfrm>
              <a:off x="8777160" y="4312800"/>
              <a:ext cx="42840" cy="34560"/>
            </a:xfrm>
            <a:custGeom>
              <a:avLst/>
              <a:gdLst/>
              <a:ahLst/>
              <a:cxnLst/>
              <a:rect l="l" t="t" r="r" b="b"/>
              <a:pathLst>
                <a:path w="34269" h="28296">
                  <a:moveTo>
                    <a:pt x="34270" y="16475"/>
                  </a:moveTo>
                  <a:lnTo>
                    <a:pt x="33568" y="22229"/>
                  </a:lnTo>
                  <a:lnTo>
                    <a:pt x="30411" y="25876"/>
                  </a:lnTo>
                  <a:cubicBezTo>
                    <a:pt x="28938" y="26285"/>
                    <a:pt x="27009" y="27008"/>
                    <a:pt x="25536" y="27197"/>
                  </a:cubicBezTo>
                  <a:cubicBezTo>
                    <a:pt x="22554" y="27543"/>
                    <a:pt x="19046" y="27229"/>
                    <a:pt x="15960" y="27355"/>
                  </a:cubicBezTo>
                  <a:cubicBezTo>
                    <a:pt x="11470" y="27574"/>
                    <a:pt x="7261" y="28549"/>
                    <a:pt x="2666" y="28234"/>
                  </a:cubicBezTo>
                  <a:lnTo>
                    <a:pt x="0" y="25876"/>
                  </a:lnTo>
                  <a:cubicBezTo>
                    <a:pt x="842" y="20186"/>
                    <a:pt x="3858" y="19714"/>
                    <a:pt x="5366" y="16727"/>
                  </a:cubicBezTo>
                  <a:cubicBezTo>
                    <a:pt x="6559" y="14337"/>
                    <a:pt x="7296" y="8772"/>
                    <a:pt x="9015" y="5220"/>
                  </a:cubicBezTo>
                  <a:cubicBezTo>
                    <a:pt x="14908" y="2610"/>
                    <a:pt x="21783" y="2799"/>
                    <a:pt x="27220" y="0"/>
                  </a:cubicBezTo>
                  <a:lnTo>
                    <a:pt x="32586" y="1321"/>
                  </a:lnTo>
                  <a:cubicBezTo>
                    <a:pt x="30657" y="5974"/>
                    <a:pt x="30236" y="12577"/>
                    <a:pt x="34270" y="16475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50" name="자유형: 도형 491"/>
            <p:cNvSpPr/>
            <p:nvPr/>
          </p:nvSpPr>
          <p:spPr>
            <a:xfrm>
              <a:off x="8981280" y="4253400"/>
              <a:ext cx="56880" cy="78120"/>
            </a:xfrm>
            <a:custGeom>
              <a:avLst/>
              <a:gdLst/>
              <a:ahLst/>
              <a:cxnLst/>
              <a:rect l="l" t="t" r="r" b="b"/>
              <a:pathLst>
                <a:path w="45187" h="63751">
                  <a:moveTo>
                    <a:pt x="43954" y="11685"/>
                  </a:moveTo>
                  <a:cubicBezTo>
                    <a:pt x="46023" y="14389"/>
                    <a:pt x="45111" y="19074"/>
                    <a:pt x="43954" y="21903"/>
                  </a:cubicBezTo>
                  <a:cubicBezTo>
                    <a:pt x="42621" y="25142"/>
                    <a:pt x="39675" y="27406"/>
                    <a:pt x="37886" y="30266"/>
                  </a:cubicBezTo>
                  <a:cubicBezTo>
                    <a:pt x="36132" y="33065"/>
                    <a:pt x="34238" y="37184"/>
                    <a:pt x="33010" y="40202"/>
                  </a:cubicBezTo>
                  <a:cubicBezTo>
                    <a:pt x="30169" y="47151"/>
                    <a:pt x="30309" y="55703"/>
                    <a:pt x="27924" y="63469"/>
                  </a:cubicBezTo>
                  <a:lnTo>
                    <a:pt x="23539" y="63752"/>
                  </a:lnTo>
                  <a:cubicBezTo>
                    <a:pt x="21715" y="62243"/>
                    <a:pt x="18523" y="58752"/>
                    <a:pt x="17717" y="56678"/>
                  </a:cubicBezTo>
                  <a:cubicBezTo>
                    <a:pt x="17120" y="55263"/>
                    <a:pt x="17331" y="53345"/>
                    <a:pt x="16734" y="51961"/>
                  </a:cubicBezTo>
                  <a:cubicBezTo>
                    <a:pt x="15401" y="49037"/>
                    <a:pt x="12981" y="47496"/>
                    <a:pt x="12350" y="43881"/>
                  </a:cubicBezTo>
                  <a:cubicBezTo>
                    <a:pt x="9544" y="42592"/>
                    <a:pt x="6387" y="40202"/>
                    <a:pt x="4563" y="37844"/>
                  </a:cubicBezTo>
                  <a:cubicBezTo>
                    <a:pt x="3861" y="32311"/>
                    <a:pt x="6738" y="27185"/>
                    <a:pt x="6036" y="21652"/>
                  </a:cubicBezTo>
                  <a:cubicBezTo>
                    <a:pt x="3756" y="19766"/>
                    <a:pt x="1511" y="17093"/>
                    <a:pt x="213" y="14577"/>
                  </a:cubicBezTo>
                  <a:cubicBezTo>
                    <a:pt x="-489" y="11842"/>
                    <a:pt x="599" y="7126"/>
                    <a:pt x="2633" y="4925"/>
                  </a:cubicBezTo>
                  <a:cubicBezTo>
                    <a:pt x="5755" y="2850"/>
                    <a:pt x="9824" y="1309"/>
                    <a:pt x="13648" y="743"/>
                  </a:cubicBezTo>
                  <a:cubicBezTo>
                    <a:pt x="16208" y="366"/>
                    <a:pt x="20277" y="-357"/>
                    <a:pt x="22803" y="209"/>
                  </a:cubicBezTo>
                  <a:cubicBezTo>
                    <a:pt x="27222" y="1183"/>
                    <a:pt x="35711" y="7975"/>
                    <a:pt x="40306" y="10396"/>
                  </a:cubicBezTo>
                  <a:lnTo>
                    <a:pt x="39815" y="10396"/>
                  </a:lnTo>
                  <a:lnTo>
                    <a:pt x="43954" y="11685"/>
                  </a:ln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51" name="자유형: 도형 492"/>
            <p:cNvSpPr/>
            <p:nvPr/>
          </p:nvSpPr>
          <p:spPr>
            <a:xfrm>
              <a:off x="9239760" y="4209840"/>
              <a:ext cx="51840" cy="50040"/>
            </a:xfrm>
            <a:custGeom>
              <a:avLst/>
              <a:gdLst/>
              <a:ahLst/>
              <a:cxnLst/>
              <a:rect l="l" t="t" r="r" b="b"/>
              <a:pathLst>
                <a:path w="41390" h="40933">
                  <a:moveTo>
                    <a:pt x="39356" y="40661"/>
                  </a:moveTo>
                  <a:cubicBezTo>
                    <a:pt x="35147" y="41667"/>
                    <a:pt x="31885" y="39686"/>
                    <a:pt x="28412" y="38052"/>
                  </a:cubicBezTo>
                  <a:cubicBezTo>
                    <a:pt x="21747" y="34876"/>
                    <a:pt x="17047" y="31669"/>
                    <a:pt x="12382" y="26293"/>
                  </a:cubicBezTo>
                  <a:cubicBezTo>
                    <a:pt x="11365" y="25098"/>
                    <a:pt x="10593" y="23431"/>
                    <a:pt x="9471" y="22363"/>
                  </a:cubicBezTo>
                  <a:cubicBezTo>
                    <a:pt x="8348" y="21262"/>
                    <a:pt x="6419" y="20570"/>
                    <a:pt x="5331" y="19469"/>
                  </a:cubicBezTo>
                  <a:cubicBezTo>
                    <a:pt x="3367" y="17520"/>
                    <a:pt x="1894" y="14345"/>
                    <a:pt x="0" y="12144"/>
                  </a:cubicBezTo>
                  <a:lnTo>
                    <a:pt x="456" y="7710"/>
                  </a:lnTo>
                  <a:lnTo>
                    <a:pt x="3858" y="3812"/>
                  </a:lnTo>
                  <a:cubicBezTo>
                    <a:pt x="6875" y="3277"/>
                    <a:pt x="10453" y="1800"/>
                    <a:pt x="12873" y="133"/>
                  </a:cubicBezTo>
                  <a:cubicBezTo>
                    <a:pt x="15539" y="-276"/>
                    <a:pt x="21011" y="259"/>
                    <a:pt x="23326" y="1705"/>
                  </a:cubicBezTo>
                  <a:cubicBezTo>
                    <a:pt x="27816" y="4503"/>
                    <a:pt x="28097" y="9471"/>
                    <a:pt x="30131" y="13464"/>
                  </a:cubicBezTo>
                  <a:cubicBezTo>
                    <a:pt x="31499" y="16199"/>
                    <a:pt x="33919" y="18118"/>
                    <a:pt x="35708" y="20539"/>
                  </a:cubicBezTo>
                  <a:cubicBezTo>
                    <a:pt x="36936" y="22174"/>
                    <a:pt x="37392" y="24972"/>
                    <a:pt x="38374" y="26796"/>
                  </a:cubicBezTo>
                  <a:cubicBezTo>
                    <a:pt x="39005" y="27958"/>
                    <a:pt x="40373" y="29279"/>
                    <a:pt x="40830" y="30474"/>
                  </a:cubicBezTo>
                  <a:cubicBezTo>
                    <a:pt x="41987" y="33555"/>
                    <a:pt x="41285" y="37894"/>
                    <a:pt x="39356" y="40661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52" name="자유형: 도형 493"/>
            <p:cNvSpPr/>
            <p:nvPr/>
          </p:nvSpPr>
          <p:spPr>
            <a:xfrm>
              <a:off x="8381880" y="4707000"/>
              <a:ext cx="62280" cy="37800"/>
            </a:xfrm>
            <a:custGeom>
              <a:avLst/>
              <a:gdLst/>
              <a:ahLst/>
              <a:cxnLst/>
              <a:rect l="l" t="t" r="r" b="b"/>
              <a:pathLst>
                <a:path w="49588" h="31204">
                  <a:moveTo>
                    <a:pt x="48357" y="28059"/>
                  </a:moveTo>
                  <a:lnTo>
                    <a:pt x="43993" y="30418"/>
                  </a:lnTo>
                  <a:lnTo>
                    <a:pt x="38160" y="30418"/>
                  </a:lnTo>
                  <a:cubicBezTo>
                    <a:pt x="36276" y="28437"/>
                    <a:pt x="31790" y="26991"/>
                    <a:pt x="28921" y="27273"/>
                  </a:cubicBezTo>
                  <a:cubicBezTo>
                    <a:pt x="28374" y="27336"/>
                    <a:pt x="14746" y="31172"/>
                    <a:pt x="14339" y="31204"/>
                  </a:cubicBezTo>
                  <a:cubicBezTo>
                    <a:pt x="14003" y="31235"/>
                    <a:pt x="8464" y="30512"/>
                    <a:pt x="7776" y="30418"/>
                  </a:cubicBezTo>
                  <a:cubicBezTo>
                    <a:pt x="6570" y="26299"/>
                    <a:pt x="4813" y="21394"/>
                    <a:pt x="972" y="18658"/>
                  </a:cubicBezTo>
                  <a:lnTo>
                    <a:pt x="0" y="13942"/>
                  </a:lnTo>
                  <a:cubicBezTo>
                    <a:pt x="2606" y="9604"/>
                    <a:pt x="4984" y="4950"/>
                    <a:pt x="8510" y="1146"/>
                  </a:cubicBezTo>
                  <a:cubicBezTo>
                    <a:pt x="11930" y="-394"/>
                    <a:pt x="16910" y="-143"/>
                    <a:pt x="20499" y="517"/>
                  </a:cubicBezTo>
                  <a:cubicBezTo>
                    <a:pt x="31780" y="2687"/>
                    <a:pt x="34782" y="7434"/>
                    <a:pt x="33786" y="17621"/>
                  </a:cubicBezTo>
                  <a:cubicBezTo>
                    <a:pt x="37220" y="18596"/>
                    <a:pt x="41629" y="18973"/>
                    <a:pt x="45210" y="18658"/>
                  </a:cubicBezTo>
                  <a:lnTo>
                    <a:pt x="49588" y="21268"/>
                  </a:lnTo>
                  <a:cubicBezTo>
                    <a:pt x="48683" y="23280"/>
                    <a:pt x="48455" y="25922"/>
                    <a:pt x="48357" y="28059"/>
                  </a:cubicBezTo>
                  <a:close/>
                </a:path>
              </a:pathLst>
            </a:custGeom>
            <a:solidFill>
              <a:srgbClr val="C5E0B4"/>
            </a:solidFill>
            <a:ln w="9525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53" name="자유형: 도형 494"/>
            <p:cNvSpPr/>
            <p:nvPr/>
          </p:nvSpPr>
          <p:spPr>
            <a:xfrm>
              <a:off x="6750720" y="352440"/>
              <a:ext cx="1767600" cy="859680"/>
            </a:xfrm>
            <a:custGeom>
              <a:avLst/>
              <a:gdLst/>
              <a:ahLst/>
              <a:cxnLst/>
              <a:rect l="l" t="t" r="r" b="b"/>
              <a:pathLst>
                <a:path w="1399503" h="699978">
                  <a:moveTo>
                    <a:pt x="0" y="699979"/>
                  </a:moveTo>
                  <a:cubicBezTo>
                    <a:pt x="2845" y="693282"/>
                    <a:pt x="7054" y="682309"/>
                    <a:pt x="9306" y="675454"/>
                  </a:cubicBezTo>
                  <a:cubicBezTo>
                    <a:pt x="9306" y="675454"/>
                    <a:pt x="10814" y="664230"/>
                    <a:pt x="10832" y="661589"/>
                  </a:cubicBezTo>
                  <a:cubicBezTo>
                    <a:pt x="10874" y="655395"/>
                    <a:pt x="9046" y="646371"/>
                    <a:pt x="10004" y="640523"/>
                  </a:cubicBezTo>
                  <a:cubicBezTo>
                    <a:pt x="10365" y="638354"/>
                    <a:pt x="14869" y="630902"/>
                    <a:pt x="14304" y="628827"/>
                  </a:cubicBezTo>
                  <a:cubicBezTo>
                    <a:pt x="11512" y="618451"/>
                    <a:pt x="8787" y="608264"/>
                    <a:pt x="4020" y="598454"/>
                  </a:cubicBezTo>
                  <a:lnTo>
                    <a:pt x="6433" y="592198"/>
                  </a:lnTo>
                  <a:cubicBezTo>
                    <a:pt x="6433" y="592198"/>
                    <a:pt x="13575" y="590751"/>
                    <a:pt x="15364" y="591034"/>
                  </a:cubicBezTo>
                  <a:cubicBezTo>
                    <a:pt x="17896" y="591412"/>
                    <a:pt x="20934" y="592606"/>
                    <a:pt x="23417" y="593329"/>
                  </a:cubicBezTo>
                  <a:cubicBezTo>
                    <a:pt x="33853" y="592575"/>
                    <a:pt x="42496" y="585312"/>
                    <a:pt x="52605" y="583174"/>
                  </a:cubicBezTo>
                  <a:cubicBezTo>
                    <a:pt x="52910" y="583111"/>
                    <a:pt x="63166" y="582042"/>
                    <a:pt x="63447" y="582042"/>
                  </a:cubicBezTo>
                  <a:cubicBezTo>
                    <a:pt x="70006" y="582137"/>
                    <a:pt x="76331" y="584589"/>
                    <a:pt x="82873" y="582262"/>
                  </a:cubicBezTo>
                  <a:cubicBezTo>
                    <a:pt x="88818" y="579055"/>
                    <a:pt x="91435" y="572452"/>
                    <a:pt x="95458" y="567736"/>
                  </a:cubicBezTo>
                  <a:cubicBezTo>
                    <a:pt x="98692" y="563932"/>
                    <a:pt x="102817" y="559876"/>
                    <a:pt x="106486" y="556417"/>
                  </a:cubicBezTo>
                  <a:cubicBezTo>
                    <a:pt x="121503" y="542206"/>
                    <a:pt x="140683" y="531862"/>
                    <a:pt x="150631" y="513972"/>
                  </a:cubicBezTo>
                  <a:cubicBezTo>
                    <a:pt x="151441" y="512494"/>
                    <a:pt x="153044" y="510230"/>
                    <a:pt x="153626" y="508595"/>
                  </a:cubicBezTo>
                  <a:cubicBezTo>
                    <a:pt x="154868" y="505168"/>
                    <a:pt x="157320" y="492403"/>
                    <a:pt x="158270" y="489762"/>
                  </a:cubicBezTo>
                  <a:cubicBezTo>
                    <a:pt x="159645" y="485926"/>
                    <a:pt x="160789" y="481241"/>
                    <a:pt x="162620" y="477626"/>
                  </a:cubicBezTo>
                  <a:cubicBezTo>
                    <a:pt x="165693" y="471526"/>
                    <a:pt x="171607" y="465395"/>
                    <a:pt x="177513" y="461339"/>
                  </a:cubicBezTo>
                  <a:cubicBezTo>
                    <a:pt x="179327" y="460081"/>
                    <a:pt x="194403" y="452032"/>
                    <a:pt x="199198" y="448731"/>
                  </a:cubicBezTo>
                  <a:cubicBezTo>
                    <a:pt x="204691" y="444958"/>
                    <a:pt x="209696" y="440116"/>
                    <a:pt x="215354" y="436594"/>
                  </a:cubicBezTo>
                  <a:cubicBezTo>
                    <a:pt x="215354" y="436594"/>
                    <a:pt x="235811" y="428294"/>
                    <a:pt x="239358" y="425904"/>
                  </a:cubicBezTo>
                  <a:cubicBezTo>
                    <a:pt x="239933" y="425527"/>
                    <a:pt x="241038" y="424270"/>
                    <a:pt x="241764" y="422823"/>
                  </a:cubicBezTo>
                  <a:cubicBezTo>
                    <a:pt x="242602" y="421157"/>
                    <a:pt x="243016" y="419270"/>
                    <a:pt x="243016" y="419270"/>
                  </a:cubicBezTo>
                  <a:cubicBezTo>
                    <a:pt x="240497" y="415938"/>
                    <a:pt x="234110" y="409146"/>
                    <a:pt x="234731" y="405310"/>
                  </a:cubicBezTo>
                  <a:cubicBezTo>
                    <a:pt x="236530" y="394117"/>
                    <a:pt x="237537" y="380629"/>
                    <a:pt x="246566" y="371794"/>
                  </a:cubicBezTo>
                  <a:lnTo>
                    <a:pt x="252659" y="369719"/>
                  </a:lnTo>
                  <a:cubicBezTo>
                    <a:pt x="257040" y="362047"/>
                    <a:pt x="274561" y="351137"/>
                    <a:pt x="276557" y="346798"/>
                  </a:cubicBezTo>
                  <a:lnTo>
                    <a:pt x="280538" y="338152"/>
                  </a:lnTo>
                  <a:cubicBezTo>
                    <a:pt x="287472" y="335165"/>
                    <a:pt x="293218" y="331046"/>
                    <a:pt x="299034" y="326644"/>
                  </a:cubicBezTo>
                  <a:lnTo>
                    <a:pt x="303853" y="322965"/>
                  </a:lnTo>
                  <a:cubicBezTo>
                    <a:pt x="306996" y="321205"/>
                    <a:pt x="311416" y="320356"/>
                    <a:pt x="314390" y="318407"/>
                  </a:cubicBezTo>
                  <a:cubicBezTo>
                    <a:pt x="319547" y="315074"/>
                    <a:pt x="324608" y="310263"/>
                    <a:pt x="329396" y="306427"/>
                  </a:cubicBezTo>
                  <a:cubicBezTo>
                    <a:pt x="329638" y="306239"/>
                    <a:pt x="340544" y="302906"/>
                    <a:pt x="342382" y="301554"/>
                  </a:cubicBezTo>
                  <a:cubicBezTo>
                    <a:pt x="345184" y="299479"/>
                    <a:pt x="346970" y="295517"/>
                    <a:pt x="349748" y="293410"/>
                  </a:cubicBezTo>
                  <a:cubicBezTo>
                    <a:pt x="351053" y="292404"/>
                    <a:pt x="358422" y="288160"/>
                    <a:pt x="365838" y="283978"/>
                  </a:cubicBezTo>
                  <a:cubicBezTo>
                    <a:pt x="372499" y="280205"/>
                    <a:pt x="379156" y="276464"/>
                    <a:pt x="382334" y="275898"/>
                  </a:cubicBezTo>
                  <a:cubicBezTo>
                    <a:pt x="386526" y="275175"/>
                    <a:pt x="392012" y="279168"/>
                    <a:pt x="395867" y="280048"/>
                  </a:cubicBezTo>
                  <a:cubicBezTo>
                    <a:pt x="395867" y="280048"/>
                    <a:pt x="404647" y="280928"/>
                    <a:pt x="405951" y="280771"/>
                  </a:cubicBezTo>
                  <a:cubicBezTo>
                    <a:pt x="409873" y="280300"/>
                    <a:pt x="432273" y="273508"/>
                    <a:pt x="438450" y="271276"/>
                  </a:cubicBezTo>
                  <a:cubicBezTo>
                    <a:pt x="445764" y="268635"/>
                    <a:pt x="453049" y="263699"/>
                    <a:pt x="459693" y="259957"/>
                  </a:cubicBezTo>
                  <a:cubicBezTo>
                    <a:pt x="461068" y="259171"/>
                    <a:pt x="463109" y="258637"/>
                    <a:pt x="464618" y="258070"/>
                  </a:cubicBezTo>
                  <a:cubicBezTo>
                    <a:pt x="469647" y="258919"/>
                    <a:pt x="474863" y="260083"/>
                    <a:pt x="479925" y="260617"/>
                  </a:cubicBezTo>
                  <a:cubicBezTo>
                    <a:pt x="485053" y="261183"/>
                    <a:pt x="493749" y="261529"/>
                    <a:pt x="494542" y="261969"/>
                  </a:cubicBezTo>
                  <a:cubicBezTo>
                    <a:pt x="499179" y="264453"/>
                    <a:pt x="502665" y="270238"/>
                    <a:pt x="508583" y="270836"/>
                  </a:cubicBezTo>
                  <a:cubicBezTo>
                    <a:pt x="512824" y="271245"/>
                    <a:pt x="518313" y="267346"/>
                    <a:pt x="521744" y="267818"/>
                  </a:cubicBezTo>
                  <a:cubicBezTo>
                    <a:pt x="526953" y="268509"/>
                    <a:pt x="530829" y="271182"/>
                    <a:pt x="536571" y="269955"/>
                  </a:cubicBezTo>
                  <a:cubicBezTo>
                    <a:pt x="538707" y="267818"/>
                    <a:pt x="543316" y="263824"/>
                    <a:pt x="546560" y="262944"/>
                  </a:cubicBezTo>
                  <a:cubicBezTo>
                    <a:pt x="550156" y="264076"/>
                    <a:pt x="564664" y="263856"/>
                    <a:pt x="568540" y="261907"/>
                  </a:cubicBezTo>
                  <a:cubicBezTo>
                    <a:pt x="572549" y="259863"/>
                    <a:pt x="577179" y="256939"/>
                    <a:pt x="581385" y="255398"/>
                  </a:cubicBezTo>
                  <a:cubicBezTo>
                    <a:pt x="582486" y="254989"/>
                    <a:pt x="590379" y="253889"/>
                    <a:pt x="590379" y="253889"/>
                  </a:cubicBezTo>
                  <a:cubicBezTo>
                    <a:pt x="597461" y="253166"/>
                    <a:pt x="610944" y="257379"/>
                    <a:pt x="616553" y="260775"/>
                  </a:cubicBezTo>
                  <a:cubicBezTo>
                    <a:pt x="620415" y="263070"/>
                    <a:pt x="626722" y="269767"/>
                    <a:pt x="631517" y="269861"/>
                  </a:cubicBezTo>
                  <a:cubicBezTo>
                    <a:pt x="634740" y="269358"/>
                    <a:pt x="638220" y="268666"/>
                    <a:pt x="641272" y="267566"/>
                  </a:cubicBezTo>
                  <a:cubicBezTo>
                    <a:pt x="647417" y="269295"/>
                    <a:pt x="655081" y="271119"/>
                    <a:pt x="660722" y="273791"/>
                  </a:cubicBezTo>
                  <a:cubicBezTo>
                    <a:pt x="664412" y="275552"/>
                    <a:pt x="677362" y="283035"/>
                    <a:pt x="680193" y="284324"/>
                  </a:cubicBezTo>
                  <a:cubicBezTo>
                    <a:pt x="686401" y="285393"/>
                    <a:pt x="693645" y="277407"/>
                    <a:pt x="698033" y="274734"/>
                  </a:cubicBezTo>
                  <a:cubicBezTo>
                    <a:pt x="699320" y="273948"/>
                    <a:pt x="734415" y="256939"/>
                    <a:pt x="746236" y="254266"/>
                  </a:cubicBezTo>
                  <a:lnTo>
                    <a:pt x="752419" y="252851"/>
                  </a:lnTo>
                  <a:cubicBezTo>
                    <a:pt x="756012" y="252883"/>
                    <a:pt x="761455" y="254518"/>
                    <a:pt x="765079" y="255178"/>
                  </a:cubicBezTo>
                  <a:lnTo>
                    <a:pt x="775227" y="263541"/>
                  </a:lnTo>
                  <a:cubicBezTo>
                    <a:pt x="786114" y="265176"/>
                    <a:pt x="797949" y="263416"/>
                    <a:pt x="808416" y="260491"/>
                  </a:cubicBezTo>
                  <a:cubicBezTo>
                    <a:pt x="808609" y="260586"/>
                    <a:pt x="820837" y="263227"/>
                    <a:pt x="826056" y="264296"/>
                  </a:cubicBezTo>
                  <a:cubicBezTo>
                    <a:pt x="834734" y="266057"/>
                    <a:pt x="834029" y="265868"/>
                    <a:pt x="841329" y="261058"/>
                  </a:cubicBezTo>
                  <a:cubicBezTo>
                    <a:pt x="843914" y="259360"/>
                    <a:pt x="846506" y="257599"/>
                    <a:pt x="848923" y="255712"/>
                  </a:cubicBezTo>
                  <a:cubicBezTo>
                    <a:pt x="852213" y="256373"/>
                    <a:pt x="856573" y="257756"/>
                    <a:pt x="859877" y="257945"/>
                  </a:cubicBezTo>
                  <a:cubicBezTo>
                    <a:pt x="860593" y="258008"/>
                    <a:pt x="865981" y="256876"/>
                    <a:pt x="867177" y="256813"/>
                  </a:cubicBezTo>
                  <a:cubicBezTo>
                    <a:pt x="871926" y="256561"/>
                    <a:pt x="894863" y="258574"/>
                    <a:pt x="899679" y="257850"/>
                  </a:cubicBezTo>
                  <a:cubicBezTo>
                    <a:pt x="906621" y="256845"/>
                    <a:pt x="910865" y="253197"/>
                    <a:pt x="915323" y="248890"/>
                  </a:cubicBezTo>
                  <a:lnTo>
                    <a:pt x="921932" y="247475"/>
                  </a:lnTo>
                  <a:lnTo>
                    <a:pt x="927316" y="250179"/>
                  </a:lnTo>
                  <a:lnTo>
                    <a:pt x="933602" y="263479"/>
                  </a:lnTo>
                  <a:cubicBezTo>
                    <a:pt x="938790" y="265899"/>
                    <a:pt x="943592" y="270207"/>
                    <a:pt x="947233" y="274263"/>
                  </a:cubicBezTo>
                  <a:cubicBezTo>
                    <a:pt x="949383" y="276621"/>
                    <a:pt x="950730" y="280237"/>
                    <a:pt x="954038" y="281651"/>
                  </a:cubicBezTo>
                  <a:lnTo>
                    <a:pt x="957402" y="281998"/>
                  </a:lnTo>
                  <a:cubicBezTo>
                    <a:pt x="961250" y="280205"/>
                    <a:pt x="968907" y="275898"/>
                    <a:pt x="972730" y="274860"/>
                  </a:cubicBezTo>
                  <a:cubicBezTo>
                    <a:pt x="977402" y="273571"/>
                    <a:pt x="983657" y="274452"/>
                    <a:pt x="988497" y="273445"/>
                  </a:cubicBezTo>
                  <a:lnTo>
                    <a:pt x="995653" y="270050"/>
                  </a:lnTo>
                  <a:cubicBezTo>
                    <a:pt x="997961" y="266560"/>
                    <a:pt x="1000283" y="262064"/>
                    <a:pt x="1003019" y="258888"/>
                  </a:cubicBezTo>
                  <a:cubicBezTo>
                    <a:pt x="1003100" y="258794"/>
                    <a:pt x="1010799" y="256876"/>
                    <a:pt x="1011073" y="256939"/>
                  </a:cubicBezTo>
                  <a:cubicBezTo>
                    <a:pt x="1016376" y="258322"/>
                    <a:pt x="1043252" y="264485"/>
                    <a:pt x="1047234" y="265994"/>
                  </a:cubicBezTo>
                  <a:cubicBezTo>
                    <a:pt x="1049415" y="266811"/>
                    <a:pt x="1051586" y="268635"/>
                    <a:pt x="1053796" y="269295"/>
                  </a:cubicBezTo>
                  <a:cubicBezTo>
                    <a:pt x="1054014" y="269358"/>
                    <a:pt x="1061896" y="270458"/>
                    <a:pt x="1062152" y="270458"/>
                  </a:cubicBezTo>
                  <a:cubicBezTo>
                    <a:pt x="1066701" y="270458"/>
                    <a:pt x="1074874" y="267157"/>
                    <a:pt x="1077779" y="267220"/>
                  </a:cubicBezTo>
                  <a:cubicBezTo>
                    <a:pt x="1084155" y="267377"/>
                    <a:pt x="1090669" y="271307"/>
                    <a:pt x="1096057" y="272062"/>
                  </a:cubicBezTo>
                  <a:cubicBezTo>
                    <a:pt x="1099281" y="272502"/>
                    <a:pt x="1103679" y="271370"/>
                    <a:pt x="1107026" y="271464"/>
                  </a:cubicBezTo>
                  <a:cubicBezTo>
                    <a:pt x="1109982" y="271559"/>
                    <a:pt x="1113304" y="272313"/>
                    <a:pt x="1116261" y="272691"/>
                  </a:cubicBezTo>
                  <a:cubicBezTo>
                    <a:pt x="1116482" y="272722"/>
                    <a:pt x="1124652" y="276369"/>
                    <a:pt x="1127816" y="277250"/>
                  </a:cubicBezTo>
                  <a:cubicBezTo>
                    <a:pt x="1128002" y="277281"/>
                    <a:pt x="1134052" y="277942"/>
                    <a:pt x="1134291" y="277910"/>
                  </a:cubicBezTo>
                  <a:cubicBezTo>
                    <a:pt x="1137872" y="277784"/>
                    <a:pt x="1157238" y="275521"/>
                    <a:pt x="1160272" y="274515"/>
                  </a:cubicBezTo>
                  <a:cubicBezTo>
                    <a:pt x="1160567" y="274389"/>
                    <a:pt x="1169571" y="270270"/>
                    <a:pt x="1169680" y="270207"/>
                  </a:cubicBezTo>
                  <a:cubicBezTo>
                    <a:pt x="1175454" y="266183"/>
                    <a:pt x="1180996" y="260837"/>
                    <a:pt x="1186398" y="256373"/>
                  </a:cubicBezTo>
                  <a:cubicBezTo>
                    <a:pt x="1186485" y="256310"/>
                    <a:pt x="1191129" y="254895"/>
                    <a:pt x="1191554" y="254769"/>
                  </a:cubicBezTo>
                  <a:cubicBezTo>
                    <a:pt x="1197443" y="257064"/>
                    <a:pt x="1203904" y="255115"/>
                    <a:pt x="1209510" y="257159"/>
                  </a:cubicBezTo>
                  <a:cubicBezTo>
                    <a:pt x="1215999" y="255712"/>
                    <a:pt x="1217100" y="251436"/>
                    <a:pt x="1221330" y="248261"/>
                  </a:cubicBezTo>
                  <a:cubicBezTo>
                    <a:pt x="1224084" y="246186"/>
                    <a:pt x="1228041" y="244991"/>
                    <a:pt x="1230812" y="242947"/>
                  </a:cubicBezTo>
                  <a:cubicBezTo>
                    <a:pt x="1233158" y="241186"/>
                    <a:pt x="1239781" y="234993"/>
                    <a:pt x="1241331" y="232352"/>
                  </a:cubicBezTo>
                  <a:cubicBezTo>
                    <a:pt x="1250935" y="230182"/>
                    <a:pt x="1253535" y="227918"/>
                    <a:pt x="1259817" y="221630"/>
                  </a:cubicBezTo>
                  <a:cubicBezTo>
                    <a:pt x="1259915" y="221536"/>
                    <a:pt x="1272462" y="216033"/>
                    <a:pt x="1272964" y="215688"/>
                  </a:cubicBezTo>
                  <a:cubicBezTo>
                    <a:pt x="1273216" y="215531"/>
                    <a:pt x="1276868" y="210971"/>
                    <a:pt x="1277881" y="209557"/>
                  </a:cubicBezTo>
                  <a:cubicBezTo>
                    <a:pt x="1280400" y="206067"/>
                    <a:pt x="1283529" y="201602"/>
                    <a:pt x="1286545" y="198489"/>
                  </a:cubicBezTo>
                  <a:cubicBezTo>
                    <a:pt x="1289695" y="195251"/>
                    <a:pt x="1298601" y="192421"/>
                    <a:pt x="1301979" y="189969"/>
                  </a:cubicBezTo>
                  <a:cubicBezTo>
                    <a:pt x="1305459" y="187422"/>
                    <a:pt x="1333475" y="164690"/>
                    <a:pt x="1335018" y="162583"/>
                  </a:cubicBezTo>
                  <a:lnTo>
                    <a:pt x="1338817" y="155509"/>
                  </a:lnTo>
                  <a:cubicBezTo>
                    <a:pt x="1343205" y="147366"/>
                    <a:pt x="1347534" y="139191"/>
                    <a:pt x="1351883" y="131016"/>
                  </a:cubicBezTo>
                  <a:cubicBezTo>
                    <a:pt x="1352314" y="130199"/>
                    <a:pt x="1353377" y="129161"/>
                    <a:pt x="1353984" y="128438"/>
                  </a:cubicBezTo>
                  <a:lnTo>
                    <a:pt x="1352644" y="121301"/>
                  </a:lnTo>
                  <a:cubicBezTo>
                    <a:pt x="1350887" y="111931"/>
                    <a:pt x="1356699" y="106964"/>
                    <a:pt x="1360354" y="98883"/>
                  </a:cubicBezTo>
                  <a:cubicBezTo>
                    <a:pt x="1362108" y="94984"/>
                    <a:pt x="1360042" y="82816"/>
                    <a:pt x="1359800" y="80050"/>
                  </a:cubicBezTo>
                  <a:cubicBezTo>
                    <a:pt x="1359621" y="78006"/>
                    <a:pt x="1356794" y="62254"/>
                    <a:pt x="1356397" y="56594"/>
                  </a:cubicBezTo>
                  <a:cubicBezTo>
                    <a:pt x="1355720" y="46816"/>
                    <a:pt x="1357485" y="37069"/>
                    <a:pt x="1356485" y="27197"/>
                  </a:cubicBezTo>
                  <a:cubicBezTo>
                    <a:pt x="1358558" y="21128"/>
                    <a:pt x="1368899" y="18330"/>
                    <a:pt x="1374143" y="15280"/>
                  </a:cubicBezTo>
                  <a:cubicBezTo>
                    <a:pt x="1376318" y="13991"/>
                    <a:pt x="1378107" y="11948"/>
                    <a:pt x="1380246" y="10627"/>
                  </a:cubicBezTo>
                  <a:cubicBezTo>
                    <a:pt x="1384280" y="8080"/>
                    <a:pt x="1395154" y="2170"/>
                    <a:pt x="1399503" y="0"/>
                  </a:cubicBezTo>
                </a:path>
              </a:pathLst>
            </a:custGeom>
            <a:noFill/>
            <a:ln w="19050">
              <a:solidFill>
                <a:srgbClr val="000000">
                  <a:lumMod val="50000"/>
                  <a:lumOff val="50000"/>
                </a:srgbClr>
              </a:solidFill>
              <a:round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54" name="타원 212"/>
            <p:cNvSpPr/>
            <p:nvPr/>
          </p:nvSpPr>
          <p:spPr>
            <a:xfrm>
              <a:off x="7247520" y="4434840"/>
              <a:ext cx="136080" cy="132480"/>
            </a:xfrm>
            <a:prstGeom prst="ellipse">
              <a:avLst/>
            </a:prstGeom>
            <a:solidFill>
              <a:srgbClr val="10A06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55" name="타원 213"/>
            <p:cNvSpPr/>
            <p:nvPr/>
          </p:nvSpPr>
          <p:spPr>
            <a:xfrm>
              <a:off x="6847920" y="4082400"/>
              <a:ext cx="136080" cy="132480"/>
            </a:xfrm>
            <a:prstGeom prst="ellipse">
              <a:avLst/>
            </a:prstGeom>
            <a:solidFill>
              <a:srgbClr val="10A06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56" name="타원 214"/>
            <p:cNvSpPr/>
            <p:nvPr/>
          </p:nvSpPr>
          <p:spPr>
            <a:xfrm>
              <a:off x="6336720" y="6067800"/>
              <a:ext cx="136080" cy="132480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57" name="TextBox 215"/>
            <p:cNvSpPr/>
            <p:nvPr/>
          </p:nvSpPr>
          <p:spPr>
            <a:xfrm>
              <a:off x="7046640" y="4001400"/>
              <a:ext cx="245376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  <a:buNone/>
              </a:pPr>
              <a:r>
                <a:rPr lang="en-US" sz="1200" b="0" strike="noStrike" spc="-1">
                  <a:solidFill>
                    <a:srgbClr val="000000"/>
                  </a:solidFill>
                  <a:latin typeface="Times New Roman"/>
                </a:rPr>
                <a:t>Gwangju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258" name="TextBox 216"/>
            <p:cNvSpPr/>
            <p:nvPr/>
          </p:nvSpPr>
          <p:spPr>
            <a:xfrm>
              <a:off x="6430680" y="5976360"/>
              <a:ext cx="209916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  <a:buNone/>
              </a:pPr>
              <a:r>
                <a:rPr lang="en-US" sz="1200" b="1" strike="noStrike" spc="-1">
                  <a:solidFill>
                    <a:srgbClr val="000000"/>
                  </a:solidFill>
                  <a:latin typeface="Times New Roman"/>
                </a:rPr>
                <a:t>Jeju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259" name="TextBox 217"/>
            <p:cNvSpPr/>
            <p:nvPr/>
          </p:nvSpPr>
          <p:spPr>
            <a:xfrm>
              <a:off x="7282080" y="4240440"/>
              <a:ext cx="275904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  <a:buNone/>
              </a:pPr>
              <a:r>
                <a:rPr lang="en-US" sz="1200" b="0" strike="noStrike" spc="-1">
                  <a:solidFill>
                    <a:srgbClr val="000000"/>
                  </a:solidFill>
                  <a:latin typeface="Times New Roman"/>
                </a:rPr>
                <a:t>Boseong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260" name="타원 218"/>
            <p:cNvSpPr/>
            <p:nvPr/>
          </p:nvSpPr>
          <p:spPr>
            <a:xfrm>
              <a:off x="6824160" y="1207440"/>
              <a:ext cx="136080" cy="132480"/>
            </a:xfrm>
            <a:prstGeom prst="ellipse">
              <a:avLst/>
            </a:prstGeom>
            <a:solidFill>
              <a:srgbClr val="874ED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61" name="TextBox 219"/>
            <p:cNvSpPr/>
            <p:nvPr/>
          </p:nvSpPr>
          <p:spPr>
            <a:xfrm>
              <a:off x="6874200" y="1207440"/>
              <a:ext cx="73080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  <a:buNone/>
              </a:pPr>
              <a:r>
                <a:rPr lang="en-US" sz="1200" b="0" strike="noStrike" spc="-1">
                  <a:solidFill>
                    <a:srgbClr val="000000"/>
                  </a:solidFill>
                  <a:latin typeface="Times New Roman"/>
                </a:rPr>
                <a:t>Paju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262" name="타원 220"/>
            <p:cNvSpPr/>
            <p:nvPr/>
          </p:nvSpPr>
          <p:spPr>
            <a:xfrm>
              <a:off x="7074360" y="879480"/>
              <a:ext cx="136080" cy="132480"/>
            </a:xfrm>
            <a:prstGeom prst="ellipse">
              <a:avLst/>
            </a:prstGeom>
            <a:solidFill>
              <a:srgbClr val="874ED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63" name="타원 221"/>
            <p:cNvSpPr/>
            <p:nvPr/>
          </p:nvSpPr>
          <p:spPr>
            <a:xfrm>
              <a:off x="7247520" y="1076040"/>
              <a:ext cx="136080" cy="132480"/>
            </a:xfrm>
            <a:prstGeom prst="ellipse">
              <a:avLst/>
            </a:prstGeom>
            <a:solidFill>
              <a:srgbClr val="874ED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64" name="타원 222"/>
            <p:cNvSpPr/>
            <p:nvPr/>
          </p:nvSpPr>
          <p:spPr>
            <a:xfrm>
              <a:off x="7552080" y="757800"/>
              <a:ext cx="136080" cy="132480"/>
            </a:xfrm>
            <a:prstGeom prst="ellipse">
              <a:avLst/>
            </a:prstGeom>
            <a:solidFill>
              <a:srgbClr val="874ED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65" name="타원 223"/>
            <p:cNvSpPr/>
            <p:nvPr/>
          </p:nvSpPr>
          <p:spPr>
            <a:xfrm>
              <a:off x="8289720" y="839520"/>
              <a:ext cx="136080" cy="132480"/>
            </a:xfrm>
            <a:prstGeom prst="ellipse">
              <a:avLst/>
            </a:prstGeom>
            <a:solidFill>
              <a:srgbClr val="874ED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66" name="TextBox 224"/>
            <p:cNvSpPr/>
            <p:nvPr/>
          </p:nvSpPr>
          <p:spPr>
            <a:xfrm>
              <a:off x="8354880" y="752040"/>
              <a:ext cx="94176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  <a:buNone/>
              </a:pPr>
              <a:r>
                <a:rPr lang="en-US" sz="1200" b="0" strike="noStrike" spc="-1">
                  <a:solidFill>
                    <a:srgbClr val="000000"/>
                  </a:solidFill>
                  <a:latin typeface="Times New Roman"/>
                </a:rPr>
                <a:t>Yanggu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267" name="TextBox 225"/>
            <p:cNvSpPr/>
            <p:nvPr/>
          </p:nvSpPr>
          <p:spPr>
            <a:xfrm>
              <a:off x="7951320" y="945360"/>
              <a:ext cx="99252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  <a:buNone/>
              </a:pPr>
              <a:r>
                <a:rPr lang="en-US" sz="1200" b="0" strike="noStrike" spc="-1">
                  <a:solidFill>
                    <a:srgbClr val="000000"/>
                  </a:solidFill>
                  <a:latin typeface="Times New Roman"/>
                </a:rPr>
                <a:t>Hwacheon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268" name="TextBox 226"/>
            <p:cNvSpPr/>
            <p:nvPr/>
          </p:nvSpPr>
          <p:spPr>
            <a:xfrm>
              <a:off x="6262920" y="792000"/>
              <a:ext cx="113184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  <a:buNone/>
              </a:pPr>
              <a:r>
                <a:rPr lang="en-US" sz="1200" b="0" strike="noStrike" spc="-1">
                  <a:solidFill>
                    <a:srgbClr val="000000"/>
                  </a:solidFill>
                  <a:latin typeface="Times New Roman"/>
                </a:rPr>
                <a:t>Yeoncheon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269" name="TextBox 227"/>
            <p:cNvSpPr/>
            <p:nvPr/>
          </p:nvSpPr>
          <p:spPr>
            <a:xfrm>
              <a:off x="7597800" y="613800"/>
              <a:ext cx="109836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  <a:buNone/>
              </a:pPr>
              <a:r>
                <a:rPr lang="en-US" sz="1200" b="0" strike="noStrike" spc="-1">
                  <a:solidFill>
                    <a:srgbClr val="000000"/>
                  </a:solidFill>
                  <a:latin typeface="Times New Roman"/>
                </a:rPr>
                <a:t>Cheorwon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270" name="TextBox 228"/>
            <p:cNvSpPr/>
            <p:nvPr/>
          </p:nvSpPr>
          <p:spPr>
            <a:xfrm>
              <a:off x="7280640" y="1117800"/>
              <a:ext cx="1160280" cy="27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t">
              <a:spAutoFit/>
            </a:bodyPr>
            <a:lstStyle/>
            <a:p>
              <a:pPr>
                <a:lnSpc>
                  <a:spcPct val="100000"/>
                </a:lnSpc>
                <a:buNone/>
              </a:pPr>
              <a:r>
                <a:rPr lang="en-US" sz="1200" b="0" strike="noStrike" spc="-1">
                  <a:solidFill>
                    <a:srgbClr val="000000"/>
                  </a:solidFill>
                  <a:latin typeface="Times New Roman"/>
                </a:rPr>
                <a:t>Pocheon</a:t>
              </a:r>
              <a:endParaRPr lang="en-US" sz="1200" b="0" strike="noStrike" spc="-1">
                <a:latin typeface="Arial"/>
              </a:endParaRPr>
            </a:p>
          </p:txBody>
        </p:sp>
        <p:sp>
          <p:nvSpPr>
            <p:cNvPr id="271" name="타원 229"/>
            <p:cNvSpPr/>
            <p:nvPr/>
          </p:nvSpPr>
          <p:spPr>
            <a:xfrm>
              <a:off x="7910640" y="911520"/>
              <a:ext cx="136080" cy="132480"/>
            </a:xfrm>
            <a:prstGeom prst="ellipse">
              <a:avLst/>
            </a:prstGeom>
            <a:solidFill>
              <a:srgbClr val="874ED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  <p:sp>
          <p:nvSpPr>
            <p:cNvPr id="272" name="직사각형 230"/>
            <p:cNvSpPr/>
            <p:nvPr/>
          </p:nvSpPr>
          <p:spPr>
            <a:xfrm>
              <a:off x="4112640" y="-633960"/>
              <a:ext cx="7166880" cy="9338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/>
            <a:lstStyle/>
            <a:p>
              <a:endParaRPr lang="ko-KR" altLang="en-US"/>
            </a:p>
          </p:txBody>
        </p:sp>
      </p:grpSp>
      <p:sp>
        <p:nvSpPr>
          <p:cNvPr id="273" name="TextBox 16"/>
          <p:cNvSpPr/>
          <p:nvPr/>
        </p:nvSpPr>
        <p:spPr>
          <a:xfrm>
            <a:off x="2999520" y="1213920"/>
            <a:ext cx="2099160" cy="2721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en-US" sz="1200" b="0" strike="noStrike" spc="-1">
                <a:solidFill>
                  <a:srgbClr val="000000"/>
                </a:solidFill>
                <a:latin typeface="Times New Roman"/>
              </a:rPr>
              <a:t>Japan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274" name="TextBox 231"/>
          <p:cNvSpPr/>
          <p:nvPr/>
        </p:nvSpPr>
        <p:spPr>
          <a:xfrm>
            <a:off x="1992600" y="1648800"/>
            <a:ext cx="2099160" cy="2721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en-US" sz="1200" b="0" strike="noStrike" spc="-1" dirty="0">
                <a:solidFill>
                  <a:srgbClr val="000000"/>
                </a:solidFill>
                <a:latin typeface="Times New Roman"/>
              </a:rPr>
              <a:t>South Korea</a:t>
            </a:r>
            <a:endParaRPr lang="en-US" sz="1200" b="0" strike="noStrike" spc="-1" dirty="0">
              <a:latin typeface="Arial"/>
            </a:endParaRPr>
          </a:p>
        </p:txBody>
      </p:sp>
      <p:sp>
        <p:nvSpPr>
          <p:cNvPr id="275" name="TextBox 232"/>
          <p:cNvSpPr/>
          <p:nvPr/>
        </p:nvSpPr>
        <p:spPr>
          <a:xfrm>
            <a:off x="1477440" y="1355400"/>
            <a:ext cx="2099160" cy="2721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en-US" sz="1200" b="0" strike="noStrike" spc="-1">
                <a:solidFill>
                  <a:srgbClr val="000000"/>
                </a:solidFill>
                <a:latin typeface="Times New Roman"/>
              </a:rPr>
              <a:t>Chin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276" name="TextBox 233"/>
          <p:cNvSpPr/>
          <p:nvPr/>
        </p:nvSpPr>
        <p:spPr>
          <a:xfrm>
            <a:off x="2125749" y="514954"/>
            <a:ext cx="209916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en-US" sz="1200" b="0" strike="noStrike" spc="-1" dirty="0">
                <a:solidFill>
                  <a:srgbClr val="000000"/>
                </a:solidFill>
                <a:latin typeface="Times New Roman"/>
              </a:rPr>
              <a:t>Russia</a:t>
            </a:r>
            <a:endParaRPr lang="en-US" sz="1200" b="0" strike="noStrike" spc="-1" dirty="0">
              <a:latin typeface="Arial"/>
            </a:endParaRPr>
          </a:p>
        </p:txBody>
      </p:sp>
      <p:sp>
        <p:nvSpPr>
          <p:cNvPr id="277" name="TextBox 234"/>
          <p:cNvSpPr/>
          <p:nvPr/>
        </p:nvSpPr>
        <p:spPr>
          <a:xfrm>
            <a:off x="10279440" y="6353640"/>
            <a:ext cx="2099160" cy="2721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en-US" sz="1200" b="0" strike="noStrike" spc="-1">
                <a:solidFill>
                  <a:srgbClr val="000000"/>
                </a:solidFill>
                <a:latin typeface="Times New Roman"/>
              </a:rPr>
              <a:t>South Kore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278" name="타원 238"/>
          <p:cNvSpPr/>
          <p:nvPr/>
        </p:nvSpPr>
        <p:spPr>
          <a:xfrm>
            <a:off x="6330600" y="182520"/>
            <a:ext cx="2644920" cy="1711800"/>
          </a:xfrm>
          <a:prstGeom prst="ellipse">
            <a:avLst/>
          </a:prstGeom>
          <a:noFill/>
          <a:ln w="12700">
            <a:solidFill>
              <a:srgbClr val="7030A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/>
          <a:lstStyle/>
          <a:p>
            <a:endParaRPr lang="ko-KR" altLang="en-US"/>
          </a:p>
        </p:txBody>
      </p:sp>
      <p:sp>
        <p:nvSpPr>
          <p:cNvPr id="279" name="타원 239"/>
          <p:cNvSpPr/>
          <p:nvPr/>
        </p:nvSpPr>
        <p:spPr>
          <a:xfrm>
            <a:off x="6517800" y="3587400"/>
            <a:ext cx="1882080" cy="1344240"/>
          </a:xfrm>
          <a:prstGeom prst="ellipse">
            <a:avLst/>
          </a:prstGeom>
          <a:noFill/>
          <a:ln w="12700">
            <a:solidFill>
              <a:srgbClr val="00B05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/>
          <a:lstStyle/>
          <a:p>
            <a:endParaRPr lang="ko-KR" altLang="en-US"/>
          </a:p>
        </p:txBody>
      </p:sp>
      <p:sp>
        <p:nvSpPr>
          <p:cNvPr id="280" name="타원 241"/>
          <p:cNvSpPr/>
          <p:nvPr/>
        </p:nvSpPr>
        <p:spPr>
          <a:xfrm>
            <a:off x="6132240" y="5602320"/>
            <a:ext cx="1020600" cy="100728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/>
          <a:lstStyle/>
          <a:p>
            <a:endParaRPr lang="ko-KR" altLang="en-US"/>
          </a:p>
        </p:txBody>
      </p:sp>
      <p:sp>
        <p:nvSpPr>
          <p:cNvPr id="281" name="Rectangle 6"/>
          <p:cNvSpPr/>
          <p:nvPr/>
        </p:nvSpPr>
        <p:spPr>
          <a:xfrm>
            <a:off x="4301640" y="4255560"/>
            <a:ext cx="1793160" cy="1828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0" tIns="0" rIns="0" bIns="0" numCol="1" spcCol="0" anchor="t">
            <a:spAutoFit/>
          </a:bodyPr>
          <a:lstStyle/>
          <a:p>
            <a:pPr>
              <a:lnSpc>
                <a:spcPct val="100000"/>
              </a:lnSpc>
              <a:buNone/>
              <a:tabLst>
                <a:tab pos="0" algn="l"/>
              </a:tabLst>
            </a:pPr>
            <a:r>
              <a:rPr lang="en" sz="1200" b="0" strike="noStrike" spc="-1">
                <a:solidFill>
                  <a:srgbClr val="00B050"/>
                </a:solidFill>
                <a:latin typeface="Times New Roman"/>
              </a:rPr>
              <a:t>Southern part of South Kore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282" name="TextBox 243"/>
          <p:cNvSpPr/>
          <p:nvPr/>
        </p:nvSpPr>
        <p:spPr>
          <a:xfrm>
            <a:off x="7131960" y="5920200"/>
            <a:ext cx="6097680" cy="2721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  <a:tabLst>
                <a:tab pos="0" algn="l"/>
              </a:tabLst>
            </a:pPr>
            <a:r>
              <a:rPr lang="en" sz="1200" b="1" strike="noStrike" spc="-1">
                <a:solidFill>
                  <a:srgbClr val="FF0000"/>
                </a:solidFill>
                <a:latin typeface="Times New Roman"/>
              </a:rPr>
              <a:t>Jeju Island, South Korea 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283" name="Rectangle 6"/>
          <p:cNvSpPr/>
          <p:nvPr/>
        </p:nvSpPr>
        <p:spPr>
          <a:xfrm>
            <a:off x="9070560" y="824400"/>
            <a:ext cx="1791720" cy="1828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0" tIns="0" rIns="0" bIns="0" numCol="1" spcCol="0" anchor="t">
            <a:spAutoFit/>
          </a:bodyPr>
          <a:lstStyle/>
          <a:p>
            <a:pPr>
              <a:lnSpc>
                <a:spcPct val="100000"/>
              </a:lnSpc>
              <a:buNone/>
              <a:tabLst>
                <a:tab pos="0" algn="l"/>
              </a:tabLst>
            </a:pPr>
            <a:r>
              <a:rPr lang="en" sz="1200" b="0" strike="noStrike" spc="-1">
                <a:solidFill>
                  <a:srgbClr val="7030A0"/>
                </a:solidFill>
                <a:latin typeface="Times New Roman"/>
              </a:rPr>
              <a:t>Northern part of South Korea</a:t>
            </a:r>
            <a:endParaRPr lang="en-US" sz="1200" b="0" strike="noStrike" spc="-1">
              <a:latin typeface="Arial"/>
            </a:endParaRPr>
          </a:p>
        </p:txBody>
      </p:sp>
      <p:sp>
        <p:nvSpPr>
          <p:cNvPr id="284" name="타원 245"/>
          <p:cNvSpPr/>
          <p:nvPr/>
        </p:nvSpPr>
        <p:spPr>
          <a:xfrm>
            <a:off x="2431080" y="794520"/>
            <a:ext cx="71640" cy="7164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/>
          <a:lstStyle/>
          <a:p>
            <a:endParaRPr lang="ko-KR" altLang="en-US"/>
          </a:p>
        </p:txBody>
      </p:sp>
      <p:sp>
        <p:nvSpPr>
          <p:cNvPr id="285" name="타원 247"/>
          <p:cNvSpPr/>
          <p:nvPr/>
        </p:nvSpPr>
        <p:spPr>
          <a:xfrm>
            <a:off x="1751040" y="1600560"/>
            <a:ext cx="71640" cy="7164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/>
          <a:lstStyle/>
          <a:p>
            <a:endParaRPr lang="ko-KR" altLang="en-US"/>
          </a:p>
        </p:txBody>
      </p:sp>
      <p:sp>
        <p:nvSpPr>
          <p:cNvPr id="286" name="TextBox 7"/>
          <p:cNvSpPr/>
          <p:nvPr/>
        </p:nvSpPr>
        <p:spPr>
          <a:xfrm>
            <a:off x="311400" y="355217"/>
            <a:ext cx="6967440" cy="275545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t">
            <a:spAutoFit/>
          </a:bodyPr>
          <a:lstStyle/>
          <a:p>
            <a:pPr>
              <a:lnSpc>
                <a:spcPct val="100000"/>
              </a:lnSpc>
              <a:buNone/>
            </a:pPr>
            <a:r>
              <a:rPr lang="en-US" sz="1200" b="1" strike="noStrike" spc="-1" dirty="0">
                <a:solidFill>
                  <a:srgbClr val="000000"/>
                </a:solidFill>
                <a:latin typeface="Times New Roman"/>
                <a:ea typeface="굴림"/>
              </a:rPr>
              <a:t>FIGURE S1b </a:t>
            </a:r>
            <a:r>
              <a:rPr lang="en-US" sz="1200" b="0" strike="noStrike" spc="-1" dirty="0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endParaRPr lang="en-US" sz="1200" b="0" strike="noStrike" spc="-1" dirty="0">
              <a:latin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30</TotalTime>
  <Words>35</Words>
  <Application>Microsoft Macintosh PowerPoint</Application>
  <PresentationFormat>와이드스크린</PresentationFormat>
  <Paragraphs>19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subject/>
  <dc:creator>Wiley, Mike</dc:creator>
  <dc:description/>
  <cp:lastModifiedBy>Keun Hwa LEE</cp:lastModifiedBy>
  <cp:revision>94</cp:revision>
  <dcterms:created xsi:type="dcterms:W3CDTF">2024-07-09T02:35:26Z</dcterms:created>
  <dcterms:modified xsi:type="dcterms:W3CDTF">2025-03-03T21:02:15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와이드스크린</vt:lpwstr>
  </property>
  <property fmtid="{D5CDD505-2E9C-101B-9397-08002B2CF9AE}" pid="3" name="Slides">
    <vt:i4>3</vt:i4>
  </property>
</Properties>
</file>